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ppt/charts/chart4.xml" ContentType="application/vnd.openxmlformats-officedocument.drawingml.chart+xml"/>
  <Override PartName="/ppt/charts/style4.xml" ContentType="application/vnd.ms-office.chartstyle+xml"/>
  <Override PartName="/ppt/charts/colors4.xml" ContentType="application/vnd.ms-office.chartcolorstyle+xml"/>
  <Override PartName="/ppt/charts/chart5.xml" ContentType="application/vnd.openxmlformats-officedocument.drawingml.chart+xml"/>
  <Override PartName="/ppt/charts/style5.xml" ContentType="application/vnd.ms-office.chartstyle+xml"/>
  <Override PartName="/ppt/charts/colors5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1632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3" autoAdjust="0"/>
    <p:restoredTop sz="94660"/>
  </p:normalViewPr>
  <p:slideViewPr>
    <p:cSldViewPr snapToGrid="0" showGuides="1">
      <p:cViewPr varScale="1">
        <p:scale>
          <a:sx n="69" d="100"/>
          <a:sy n="69" d="100"/>
        </p:scale>
        <p:origin x="1148" y="32"/>
      </p:cViewPr>
      <p:guideLst>
        <p:guide orient="horz" pos="1632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wFig1AAblikim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wFig1AAblikim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wFig1AAblikim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_rels/chart4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wFig1AAblikim2.xlsx" TargetMode="External"/><Relationship Id="rId2" Type="http://schemas.microsoft.com/office/2011/relationships/chartColorStyle" Target="colors4.xml"/><Relationship Id="rId1" Type="http://schemas.microsoft.com/office/2011/relationships/chartStyle" Target="style4.xml"/></Relationships>
</file>

<file path=ppt/charts/_rels/chart5.xml.rels><?xml version="1.0" encoding="UTF-8" standalone="yes"?>
<Relationships xmlns="http://schemas.openxmlformats.org/package/2006/relationships"><Relationship Id="rId3" Type="http://schemas.openxmlformats.org/officeDocument/2006/relationships/oleObject" Target="file:///D:\NewFig1AAblikim2.xlsx" TargetMode="External"/><Relationship Id="rId2" Type="http://schemas.microsoft.com/office/2011/relationships/chartColorStyle" Target="colors5.xml"/><Relationship Id="rId1" Type="http://schemas.microsoft.com/office/2011/relationships/chartStyle" Target="styl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28448133172544"/>
          <c:y val="5.6514289880431612E-2"/>
          <c:w val="0.82996386519393406"/>
          <c:h val="0.85017522115291155"/>
        </c:manualLayout>
      </c:layout>
      <c:scatterChart>
        <c:scatterStyle val="smoothMarker"/>
        <c:varyColors val="0"/>
        <c:ser>
          <c:idx val="0"/>
          <c:order val="0"/>
          <c:spPr>
            <a:ln w="635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B$4:$B$1373</c:f>
              <c:numCache>
                <c:formatCode>General</c:formatCode>
                <c:ptCount val="1370"/>
                <c:pt idx="0">
                  <c:v>0</c:v>
                </c:pt>
                <c:pt idx="1">
                  <c:v>6.9444444444444454E-13</c:v>
                </c:pt>
                <c:pt idx="2">
                  <c:v>1.3888888888888891E-12</c:v>
                </c:pt>
                <c:pt idx="3">
                  <c:v>6.9458333333333335E-9</c:v>
                </c:pt>
                <c:pt idx="4">
                  <c:v>1.3890277777777778E-8</c:v>
                </c:pt>
                <c:pt idx="5">
                  <c:v>2.0834722222222222E-8</c:v>
                </c:pt>
                <c:pt idx="6">
                  <c:v>9.0279166666666655E-8</c:v>
                </c:pt>
                <c:pt idx="7">
                  <c:v>1.5972361111111111E-7</c:v>
                </c:pt>
                <c:pt idx="8">
                  <c:v>2.2916805555555553E-7</c:v>
                </c:pt>
                <c:pt idx="9">
                  <c:v>2.9861250000000001E-7</c:v>
                </c:pt>
                <c:pt idx="10">
                  <c:v>9.9305555555555567E-7</c:v>
                </c:pt>
                <c:pt idx="11">
                  <c:v>1.6874999999999999E-6</c:v>
                </c:pt>
                <c:pt idx="12">
                  <c:v>2.3819444444444444E-6</c:v>
                </c:pt>
                <c:pt idx="13">
                  <c:v>3.0763888888888889E-6</c:v>
                </c:pt>
                <c:pt idx="14">
                  <c:v>7.0700000000000001E-6</c:v>
                </c:pt>
                <c:pt idx="15">
                  <c:v>1.1063611111111111E-5</c:v>
                </c:pt>
                <c:pt idx="16">
                  <c:v>1.5057222222222223E-5</c:v>
                </c:pt>
                <c:pt idx="17">
                  <c:v>2.2856458333333332E-5</c:v>
                </c:pt>
                <c:pt idx="18">
                  <c:v>3.0655625E-5</c:v>
                </c:pt>
                <c:pt idx="19">
                  <c:v>3.8454791666666665E-5</c:v>
                </c:pt>
                <c:pt idx="20">
                  <c:v>5.0214375000000003E-5</c:v>
                </c:pt>
                <c:pt idx="21">
                  <c:v>6.1973888888888884E-5</c:v>
                </c:pt>
                <c:pt idx="22">
                  <c:v>7.3733333333333341E-5</c:v>
                </c:pt>
                <c:pt idx="23">
                  <c:v>8.3929166666666663E-5</c:v>
                </c:pt>
                <c:pt idx="24">
                  <c:v>9.4124999999999998E-5</c:v>
                </c:pt>
                <c:pt idx="25">
                  <c:v>1.0432083333333333E-4</c:v>
                </c:pt>
                <c:pt idx="26">
                  <c:v>1.0902361111111111E-4</c:v>
                </c:pt>
                <c:pt idx="27">
                  <c:v>1.1372638888888888E-4</c:v>
                </c:pt>
                <c:pt idx="28">
                  <c:v>1.1842916666666666E-4</c:v>
                </c:pt>
                <c:pt idx="29">
                  <c:v>1.2241319444444444E-4</c:v>
                </c:pt>
                <c:pt idx="30">
                  <c:v>1.2639652777777778E-4</c:v>
                </c:pt>
                <c:pt idx="31">
                  <c:v>1.3037986111111112E-4</c:v>
                </c:pt>
                <c:pt idx="32">
                  <c:v>1.3633333333333333E-4</c:v>
                </c:pt>
                <c:pt idx="33">
                  <c:v>1.422861111111111E-4</c:v>
                </c:pt>
                <c:pt idx="34">
                  <c:v>1.4823958333333331E-4</c:v>
                </c:pt>
                <c:pt idx="35">
                  <c:v>1.8638819444444444E-4</c:v>
                </c:pt>
                <c:pt idx="36">
                  <c:v>1.9592569444444447E-4</c:v>
                </c:pt>
                <c:pt idx="37">
                  <c:v>2.0546250000000001E-4</c:v>
                </c:pt>
                <c:pt idx="38">
                  <c:v>2.1499999999999999E-4</c:v>
                </c:pt>
                <c:pt idx="39">
                  <c:v>2.2453680555555554E-4</c:v>
                </c:pt>
                <c:pt idx="40">
                  <c:v>2.285236111111111E-4</c:v>
                </c:pt>
                <c:pt idx="41">
                  <c:v>2.3251041666666665E-4</c:v>
                </c:pt>
                <c:pt idx="42">
                  <c:v>2.3649722222222224E-4</c:v>
                </c:pt>
                <c:pt idx="43">
                  <c:v>2.4049027777777777E-4</c:v>
                </c:pt>
                <c:pt idx="44">
                  <c:v>2.4448263888888892E-4</c:v>
                </c:pt>
                <c:pt idx="45">
                  <c:v>2.4847569444444445E-4</c:v>
                </c:pt>
                <c:pt idx="46">
                  <c:v>2.5500763888888892E-4</c:v>
                </c:pt>
                <c:pt idx="47">
                  <c:v>2.6153888888888889E-4</c:v>
                </c:pt>
                <c:pt idx="48">
                  <c:v>2.680708333333333E-4</c:v>
                </c:pt>
                <c:pt idx="49">
                  <c:v>3.1749097222222224E-4</c:v>
                </c:pt>
                <c:pt idx="50">
                  <c:v>3.2984583333333333E-4</c:v>
                </c:pt>
                <c:pt idx="51">
                  <c:v>3.5455625000000004E-4</c:v>
                </c:pt>
                <c:pt idx="52">
                  <c:v>3.7926666666666665E-4</c:v>
                </c:pt>
                <c:pt idx="53">
                  <c:v>4.0397708333333331E-4</c:v>
                </c:pt>
                <c:pt idx="54">
                  <c:v>4.2868680555555554E-4</c:v>
                </c:pt>
                <c:pt idx="55">
                  <c:v>4.9106250000000007E-4</c:v>
                </c:pt>
                <c:pt idx="56">
                  <c:v>5.534375E-4</c:v>
                </c:pt>
                <c:pt idx="57">
                  <c:v>6.1581319444444448E-4</c:v>
                </c:pt>
                <c:pt idx="58">
                  <c:v>6.7818819444444441E-4</c:v>
                </c:pt>
                <c:pt idx="59">
                  <c:v>7.6279166666666661E-4</c:v>
                </c:pt>
                <c:pt idx="60">
                  <c:v>8.4739583333333336E-4</c:v>
                </c:pt>
                <c:pt idx="61">
                  <c:v>9.3199999999999999E-4</c:v>
                </c:pt>
                <c:pt idx="62">
                  <c:v>1.0166041666666667E-3</c:v>
                </c:pt>
                <c:pt idx="63">
                  <c:v>1.1714375000000002E-3</c:v>
                </c:pt>
                <c:pt idx="64">
                  <c:v>1.3262708333333334E-3</c:v>
                </c:pt>
                <c:pt idx="65">
                  <c:v>1.4811041666666666E-3</c:v>
                </c:pt>
                <c:pt idx="66">
                  <c:v>1.6359375E-3</c:v>
                </c:pt>
                <c:pt idx="67">
                  <c:v>1.7907708333333335E-3</c:v>
                </c:pt>
                <c:pt idx="68">
                  <c:v>1.9832152777777778E-3</c:v>
                </c:pt>
                <c:pt idx="69">
                  <c:v>2.1756597222222225E-3</c:v>
                </c:pt>
                <c:pt idx="70">
                  <c:v>2.3681111111111108E-3</c:v>
                </c:pt>
                <c:pt idx="71">
                  <c:v>2.5605555555555555E-3</c:v>
                </c:pt>
                <c:pt idx="72">
                  <c:v>2.7529999999999998E-3</c:v>
                </c:pt>
                <c:pt idx="73">
                  <c:v>3.0555138888888889E-3</c:v>
                </c:pt>
                <c:pt idx="74">
                  <c:v>3.3580347222222219E-3</c:v>
                </c:pt>
                <c:pt idx="75">
                  <c:v>3.6605486111111109E-3</c:v>
                </c:pt>
                <c:pt idx="76">
                  <c:v>3.9630624999999996E-3</c:v>
                </c:pt>
                <c:pt idx="77">
                  <c:v>4.2655763888888891E-3</c:v>
                </c:pt>
                <c:pt idx="78">
                  <c:v>4.5680902777777777E-3</c:v>
                </c:pt>
                <c:pt idx="79">
                  <c:v>5.0454583333333332E-3</c:v>
                </c:pt>
                <c:pt idx="80">
                  <c:v>5.5228263888888888E-3</c:v>
                </c:pt>
                <c:pt idx="81">
                  <c:v>6.0001944444444451E-3</c:v>
                </c:pt>
                <c:pt idx="82">
                  <c:v>6.4775625000000007E-3</c:v>
                </c:pt>
                <c:pt idx="83">
                  <c:v>6.9549305555555562E-3</c:v>
                </c:pt>
                <c:pt idx="84">
                  <c:v>7.4322916666666669E-3</c:v>
                </c:pt>
                <c:pt idx="85">
                  <c:v>7.9649999999999999E-3</c:v>
                </c:pt>
                <c:pt idx="86">
                  <c:v>8.4976388888888879E-3</c:v>
                </c:pt>
                <c:pt idx="87">
                  <c:v>9.0303472222222226E-3</c:v>
                </c:pt>
                <c:pt idx="88">
                  <c:v>9.5630555555555555E-3</c:v>
                </c:pt>
                <c:pt idx="89">
                  <c:v>1.0095694444444445E-2</c:v>
                </c:pt>
                <c:pt idx="90">
                  <c:v>1.0628402777777778E-2</c:v>
                </c:pt>
                <c:pt idx="91">
                  <c:v>1.1232916666666667E-2</c:v>
                </c:pt>
                <c:pt idx="92">
                  <c:v>1.1837361111111111E-2</c:v>
                </c:pt>
                <c:pt idx="93">
                  <c:v>1.2441875E-2</c:v>
                </c:pt>
                <c:pt idx="94">
                  <c:v>1.3046319444444444E-2</c:v>
                </c:pt>
                <c:pt idx="95">
                  <c:v>1.3650833333333333E-2</c:v>
                </c:pt>
                <c:pt idx="96">
                  <c:v>1.4255277777777778E-2</c:v>
                </c:pt>
                <c:pt idx="97">
                  <c:v>1.4351527777777777E-2</c:v>
                </c:pt>
                <c:pt idx="98">
                  <c:v>1.4447777777777778E-2</c:v>
                </c:pt>
                <c:pt idx="99">
                  <c:v>1.4544027777777777E-2</c:v>
                </c:pt>
                <c:pt idx="100">
                  <c:v>1.4640347222222223E-2</c:v>
                </c:pt>
                <c:pt idx="101">
                  <c:v>1.4736597222222222E-2</c:v>
                </c:pt>
                <c:pt idx="102">
                  <c:v>1.4899444444444446E-2</c:v>
                </c:pt>
                <c:pt idx="103">
                  <c:v>1.5062291666666665E-2</c:v>
                </c:pt>
                <c:pt idx="104">
                  <c:v>1.5225138888888889E-2</c:v>
                </c:pt>
                <c:pt idx="105">
                  <c:v>1.5388055555555556E-2</c:v>
                </c:pt>
                <c:pt idx="106">
                  <c:v>1.5550902777777778E-2</c:v>
                </c:pt>
                <c:pt idx="107">
                  <c:v>1.5880902777777779E-2</c:v>
                </c:pt>
                <c:pt idx="108">
                  <c:v>1.6210833333333334E-2</c:v>
                </c:pt>
                <c:pt idx="109">
                  <c:v>1.6540833333333334E-2</c:v>
                </c:pt>
                <c:pt idx="110">
                  <c:v>1.6870833333333335E-2</c:v>
                </c:pt>
                <c:pt idx="111">
                  <c:v>1.720076388888889E-2</c:v>
                </c:pt>
                <c:pt idx="112">
                  <c:v>1.7843680555555557E-2</c:v>
                </c:pt>
                <c:pt idx="113">
                  <c:v>1.848659722222222E-2</c:v>
                </c:pt>
                <c:pt idx="114">
                  <c:v>1.9129444444444442E-2</c:v>
                </c:pt>
                <c:pt idx="115">
                  <c:v>1.9772361111111112E-2</c:v>
                </c:pt>
                <c:pt idx="116">
                  <c:v>2.0415277777777779E-2</c:v>
                </c:pt>
                <c:pt idx="117">
                  <c:v>2.1175763888888886E-2</c:v>
                </c:pt>
                <c:pt idx="118">
                  <c:v>2.1936250000000001E-2</c:v>
                </c:pt>
                <c:pt idx="119">
                  <c:v>2.2696736111111112E-2</c:v>
                </c:pt>
                <c:pt idx="120">
                  <c:v>2.345722222222222E-2</c:v>
                </c:pt>
                <c:pt idx="121">
                  <c:v>2.4217708333333334E-2</c:v>
                </c:pt>
                <c:pt idx="122">
                  <c:v>2.4978194444444445E-2</c:v>
                </c:pt>
                <c:pt idx="123">
                  <c:v>2.6180347222222223E-2</c:v>
                </c:pt>
                <c:pt idx="124">
                  <c:v>2.7382499999999997E-2</c:v>
                </c:pt>
                <c:pt idx="125">
                  <c:v>2.8584652777777778E-2</c:v>
                </c:pt>
                <c:pt idx="126">
                  <c:v>2.9786874999999997E-2</c:v>
                </c:pt>
                <c:pt idx="127">
                  <c:v>3.0989027777777779E-2</c:v>
                </c:pt>
                <c:pt idx="128">
                  <c:v>3.2191180555555553E-2</c:v>
                </c:pt>
                <c:pt idx="129">
                  <c:v>3.407090277777778E-2</c:v>
                </c:pt>
                <c:pt idx="130">
                  <c:v>3.5950555555555555E-2</c:v>
                </c:pt>
                <c:pt idx="131">
                  <c:v>3.7830277777777775E-2</c:v>
                </c:pt>
                <c:pt idx="132">
                  <c:v>3.9710000000000002E-2</c:v>
                </c:pt>
                <c:pt idx="133">
                  <c:v>4.1589652777777777E-2</c:v>
                </c:pt>
                <c:pt idx="134">
                  <c:v>4.3469374999999998E-2</c:v>
                </c:pt>
                <c:pt idx="135">
                  <c:v>4.6309652777777779E-2</c:v>
                </c:pt>
                <c:pt idx="136">
                  <c:v>4.9149930555555547E-2</c:v>
                </c:pt>
                <c:pt idx="137">
                  <c:v>5.1990208333333329E-2</c:v>
                </c:pt>
                <c:pt idx="138">
                  <c:v>5.4830486111111111E-2</c:v>
                </c:pt>
                <c:pt idx="139">
                  <c:v>5.7670763888888893E-2</c:v>
                </c:pt>
                <c:pt idx="140">
                  <c:v>6.0511041666666668E-2</c:v>
                </c:pt>
                <c:pt idx="141">
                  <c:v>6.4385069444444443E-2</c:v>
                </c:pt>
                <c:pt idx="142">
                  <c:v>6.8259027777777787E-2</c:v>
                </c:pt>
                <c:pt idx="143">
                  <c:v>7.2132638888888892E-2</c:v>
                </c:pt>
                <c:pt idx="144">
                  <c:v>7.6006944444444446E-2</c:v>
                </c:pt>
                <c:pt idx="145">
                  <c:v>7.9881250000000001E-2</c:v>
                </c:pt>
                <c:pt idx="146">
                  <c:v>8.3754861111111106E-2</c:v>
                </c:pt>
                <c:pt idx="147">
                  <c:v>8.8723611111111114E-2</c:v>
                </c:pt>
                <c:pt idx="148">
                  <c:v>9.3691666666666659E-2</c:v>
                </c:pt>
                <c:pt idx="149">
                  <c:v>9.8660416666666667E-2</c:v>
                </c:pt>
                <c:pt idx="150">
                  <c:v>0.10362916666666666</c:v>
                </c:pt>
                <c:pt idx="151">
                  <c:v>0.10859722222222222</c:v>
                </c:pt>
                <c:pt idx="152">
                  <c:v>0.11356597222222221</c:v>
                </c:pt>
                <c:pt idx="153">
                  <c:v>0.12054444444444444</c:v>
                </c:pt>
                <c:pt idx="154">
                  <c:v>0.1275236111111111</c:v>
                </c:pt>
                <c:pt idx="155">
                  <c:v>0.13450208333333333</c:v>
                </c:pt>
                <c:pt idx="156">
                  <c:v>0.14148055555555555</c:v>
                </c:pt>
                <c:pt idx="157">
                  <c:v>0.14845902777777778</c:v>
                </c:pt>
                <c:pt idx="158">
                  <c:v>0.15543819444444443</c:v>
                </c:pt>
                <c:pt idx="159">
                  <c:v>0.16316388888888889</c:v>
                </c:pt>
                <c:pt idx="160">
                  <c:v>0.17088958333333332</c:v>
                </c:pt>
                <c:pt idx="161">
                  <c:v>0.1786152777777778</c:v>
                </c:pt>
                <c:pt idx="162">
                  <c:v>0.18634097222222223</c:v>
                </c:pt>
                <c:pt idx="163">
                  <c:v>0.19406666666666667</c:v>
                </c:pt>
                <c:pt idx="164">
                  <c:v>0.20179166666666665</c:v>
                </c:pt>
                <c:pt idx="165">
                  <c:v>0.20951736111111111</c:v>
                </c:pt>
                <c:pt idx="166">
                  <c:v>0.21724305555555554</c:v>
                </c:pt>
                <c:pt idx="167">
                  <c:v>0.22496875</c:v>
                </c:pt>
                <c:pt idx="168">
                  <c:v>0.23269444444444443</c:v>
                </c:pt>
                <c:pt idx="169">
                  <c:v>0.24042013888888888</c:v>
                </c:pt>
                <c:pt idx="170">
                  <c:v>0.24814583333333332</c:v>
                </c:pt>
                <c:pt idx="171">
                  <c:v>0.25587152777777777</c:v>
                </c:pt>
                <c:pt idx="172">
                  <c:v>0.26359722222222221</c:v>
                </c:pt>
                <c:pt idx="173">
                  <c:v>0.26980486111111113</c:v>
                </c:pt>
                <c:pt idx="174">
                  <c:v>0.27466944444444447</c:v>
                </c:pt>
                <c:pt idx="175">
                  <c:v>0.27854722222222222</c:v>
                </c:pt>
                <c:pt idx="176">
                  <c:v>0.28242499999999998</c:v>
                </c:pt>
                <c:pt idx="177">
                  <c:v>0.28310000000000002</c:v>
                </c:pt>
                <c:pt idx="178">
                  <c:v>0.28377430555555555</c:v>
                </c:pt>
                <c:pt idx="179">
                  <c:v>0.28444930555555559</c:v>
                </c:pt>
                <c:pt idx="180">
                  <c:v>0.28512361111111112</c:v>
                </c:pt>
                <c:pt idx="181">
                  <c:v>0.2857986111111111</c:v>
                </c:pt>
                <c:pt idx="182">
                  <c:v>0.28714722222222222</c:v>
                </c:pt>
                <c:pt idx="183">
                  <c:v>0.28849652777777779</c:v>
                </c:pt>
                <c:pt idx="184">
                  <c:v>0.2898458333333333</c:v>
                </c:pt>
                <c:pt idx="185">
                  <c:v>0.29119513888888893</c:v>
                </c:pt>
                <c:pt idx="186">
                  <c:v>0.29408055555555557</c:v>
                </c:pt>
                <c:pt idx="187">
                  <c:v>0.29696666666666666</c:v>
                </c:pt>
                <c:pt idx="188">
                  <c:v>0.2998520833333333</c:v>
                </c:pt>
                <c:pt idx="189">
                  <c:v>0.30273749999999999</c:v>
                </c:pt>
                <c:pt idx="190">
                  <c:v>0.30562361111111114</c:v>
                </c:pt>
                <c:pt idx="191">
                  <c:v>0.31021874999999999</c:v>
                </c:pt>
                <c:pt idx="192">
                  <c:v>0.31481388888888889</c:v>
                </c:pt>
                <c:pt idx="193">
                  <c:v>0.3194090277777778</c:v>
                </c:pt>
                <c:pt idx="194">
                  <c:v>0.32400416666666665</c:v>
                </c:pt>
                <c:pt idx="195">
                  <c:v>0.32859930555555555</c:v>
                </c:pt>
                <c:pt idx="196">
                  <c:v>0.3356034722222222</c:v>
                </c:pt>
                <c:pt idx="197">
                  <c:v>0.34260833333333335</c:v>
                </c:pt>
                <c:pt idx="198">
                  <c:v>0.34961319444444444</c:v>
                </c:pt>
                <c:pt idx="199">
                  <c:v>0.35661805555555554</c:v>
                </c:pt>
                <c:pt idx="200">
                  <c:v>0.36362222222222224</c:v>
                </c:pt>
                <c:pt idx="201">
                  <c:v>0.37062708333333333</c:v>
                </c:pt>
                <c:pt idx="202">
                  <c:v>0.37763194444444442</c:v>
                </c:pt>
                <c:pt idx="203">
                  <c:v>0.38463680555555552</c:v>
                </c:pt>
                <c:pt idx="204">
                  <c:v>0.39164097222222222</c:v>
                </c:pt>
                <c:pt idx="205">
                  <c:v>0.39941388888888885</c:v>
                </c:pt>
                <c:pt idx="206">
                  <c:v>0.40718611111111108</c:v>
                </c:pt>
                <c:pt idx="207">
                  <c:v>0.41495833333333332</c:v>
                </c:pt>
                <c:pt idx="208">
                  <c:v>0.42273055555555555</c:v>
                </c:pt>
                <c:pt idx="209">
                  <c:v>0.43050347222222218</c:v>
                </c:pt>
                <c:pt idx="210">
                  <c:v>0.43827569444444442</c:v>
                </c:pt>
                <c:pt idx="211">
                  <c:v>0.44604791666666666</c:v>
                </c:pt>
                <c:pt idx="212">
                  <c:v>0.45382013888888889</c:v>
                </c:pt>
                <c:pt idx="213">
                  <c:v>0.46159305555555552</c:v>
                </c:pt>
                <c:pt idx="214">
                  <c:v>0.46936527777777776</c:v>
                </c:pt>
                <c:pt idx="215">
                  <c:v>0.47713749999999999</c:v>
                </c:pt>
                <c:pt idx="216">
                  <c:v>0.48490972222222223</c:v>
                </c:pt>
                <c:pt idx="217">
                  <c:v>0.49268263888888886</c:v>
                </c:pt>
                <c:pt idx="218">
                  <c:v>0.50045486111111104</c:v>
                </c:pt>
                <c:pt idx="219">
                  <c:v>0.50822708333333333</c:v>
                </c:pt>
                <c:pt idx="220">
                  <c:v>0.51600000000000001</c:v>
                </c:pt>
                <c:pt idx="221">
                  <c:v>0.52377222222222219</c:v>
                </c:pt>
                <c:pt idx="222">
                  <c:v>0.53154444444444438</c:v>
                </c:pt>
                <c:pt idx="223">
                  <c:v>0.53931666666666667</c:v>
                </c:pt>
                <c:pt idx="224">
                  <c:v>0.54708958333333335</c:v>
                </c:pt>
                <c:pt idx="225">
                  <c:v>0.55486180555555553</c:v>
                </c:pt>
                <c:pt idx="226">
                  <c:v>0.56263402777777771</c:v>
                </c:pt>
                <c:pt idx="227">
                  <c:v>0.57040625</c:v>
                </c:pt>
                <c:pt idx="228">
                  <c:v>0.57817916666666669</c:v>
                </c:pt>
                <c:pt idx="229">
                  <c:v>0.58595138888888887</c:v>
                </c:pt>
                <c:pt idx="230">
                  <c:v>0.59372361111111105</c:v>
                </c:pt>
                <c:pt idx="231">
                  <c:v>0.60149583333333334</c:v>
                </c:pt>
                <c:pt idx="232">
                  <c:v>0.60926875000000003</c:v>
                </c:pt>
                <c:pt idx="233">
                  <c:v>0.61704097222222221</c:v>
                </c:pt>
                <c:pt idx="234">
                  <c:v>0.62481319444444439</c:v>
                </c:pt>
                <c:pt idx="235">
                  <c:v>0.63258611111111107</c:v>
                </c:pt>
                <c:pt idx="236">
                  <c:v>0.64035833333333336</c:v>
                </c:pt>
                <c:pt idx="237">
                  <c:v>0.64813055555555554</c:v>
                </c:pt>
                <c:pt idx="238">
                  <c:v>0.65590277777777772</c:v>
                </c:pt>
                <c:pt idx="239">
                  <c:v>0.66367569444444441</c:v>
                </c:pt>
                <c:pt idx="240">
                  <c:v>0.6714479166666667</c:v>
                </c:pt>
                <c:pt idx="241">
                  <c:v>0.67922013888888888</c:v>
                </c:pt>
                <c:pt idx="242">
                  <c:v>0.68699236111111106</c:v>
                </c:pt>
                <c:pt idx="243">
                  <c:v>0.69476388888888896</c:v>
                </c:pt>
                <c:pt idx="244">
                  <c:v>0.70253472222222224</c:v>
                </c:pt>
                <c:pt idx="245">
                  <c:v>0.71031250000000001</c:v>
                </c:pt>
                <c:pt idx="246">
                  <c:v>0.7180833333333333</c:v>
                </c:pt>
                <c:pt idx="247">
                  <c:v>0.72585416666666669</c:v>
                </c:pt>
                <c:pt idx="248">
                  <c:v>0.73362500000000008</c:v>
                </c:pt>
                <c:pt idx="249">
                  <c:v>0.74140277777777774</c:v>
                </c:pt>
                <c:pt idx="250">
                  <c:v>0.74917361111111103</c:v>
                </c:pt>
                <c:pt idx="251">
                  <c:v>0.75694444444444442</c:v>
                </c:pt>
                <c:pt idx="252">
                  <c:v>0.76471527777777781</c:v>
                </c:pt>
                <c:pt idx="253">
                  <c:v>0.77248611111111121</c:v>
                </c:pt>
                <c:pt idx="254">
                  <c:v>0.78026388888888887</c:v>
                </c:pt>
                <c:pt idx="255">
                  <c:v>0.78803472222222226</c:v>
                </c:pt>
                <c:pt idx="256">
                  <c:v>0.79580555555555554</c:v>
                </c:pt>
                <c:pt idx="257">
                  <c:v>0.80357638888888894</c:v>
                </c:pt>
                <c:pt idx="258">
                  <c:v>0.8113541666666666</c:v>
                </c:pt>
                <c:pt idx="259">
                  <c:v>0.81912499999999999</c:v>
                </c:pt>
                <c:pt idx="260">
                  <c:v>0.82689583333333339</c:v>
                </c:pt>
                <c:pt idx="261">
                  <c:v>0.83466666666666667</c:v>
                </c:pt>
                <c:pt idx="262">
                  <c:v>0.84243749999999995</c:v>
                </c:pt>
                <c:pt idx="263">
                  <c:v>0.85021527777777772</c:v>
                </c:pt>
                <c:pt idx="264">
                  <c:v>0.85798611111111112</c:v>
                </c:pt>
                <c:pt idx="265">
                  <c:v>0.86575694444444451</c:v>
                </c:pt>
                <c:pt idx="266">
                  <c:v>0.8735277777777779</c:v>
                </c:pt>
                <c:pt idx="267">
                  <c:v>0.88130555555555545</c:v>
                </c:pt>
                <c:pt idx="268">
                  <c:v>0.88907638888888885</c:v>
                </c:pt>
                <c:pt idx="269">
                  <c:v>0.89684722222222224</c:v>
                </c:pt>
                <c:pt idx="270">
                  <c:v>0.90461805555555563</c:v>
                </c:pt>
                <c:pt idx="271">
                  <c:v>0.91239583333333329</c:v>
                </c:pt>
                <c:pt idx="272">
                  <c:v>0.92016666666666669</c:v>
                </c:pt>
                <c:pt idx="273">
                  <c:v>0.92793749999999997</c:v>
                </c:pt>
                <c:pt idx="274">
                  <c:v>0.93570833333333336</c:v>
                </c:pt>
                <c:pt idx="275">
                  <c:v>0.94347916666666665</c:v>
                </c:pt>
                <c:pt idx="276">
                  <c:v>0.95125694444444442</c:v>
                </c:pt>
                <c:pt idx="277">
                  <c:v>0.95902777777777781</c:v>
                </c:pt>
                <c:pt idx="278">
                  <c:v>0.96679861111111109</c:v>
                </c:pt>
                <c:pt idx="279">
                  <c:v>0.97456944444444449</c:v>
                </c:pt>
                <c:pt idx="280">
                  <c:v>0.98234722222222215</c:v>
                </c:pt>
                <c:pt idx="281">
                  <c:v>0.99011805555555554</c:v>
                </c:pt>
                <c:pt idx="282">
                  <c:v>0.99788888888888894</c:v>
                </c:pt>
                <c:pt idx="283">
                  <c:v>1.0056597222222223</c:v>
                </c:pt>
                <c:pt idx="284">
                  <c:v>1.0134305555555554</c:v>
                </c:pt>
                <c:pt idx="285">
                  <c:v>1.0212083333333333</c:v>
                </c:pt>
                <c:pt idx="286">
                  <c:v>1.0289791666666668</c:v>
                </c:pt>
                <c:pt idx="287">
                  <c:v>1.0367500000000001</c:v>
                </c:pt>
                <c:pt idx="288">
                  <c:v>1.0445208333333333</c:v>
                </c:pt>
                <c:pt idx="289">
                  <c:v>1.052298611111111</c:v>
                </c:pt>
                <c:pt idx="290">
                  <c:v>1.0600694444444445</c:v>
                </c:pt>
                <c:pt idx="291">
                  <c:v>1.0664722222222223</c:v>
                </c:pt>
                <c:pt idx="292">
                  <c:v>1.072875</c:v>
                </c:pt>
                <c:pt idx="293">
                  <c:v>1.0792777777777778</c:v>
                </c:pt>
                <c:pt idx="294">
                  <c:v>1.0856805555555555</c:v>
                </c:pt>
                <c:pt idx="295">
                  <c:v>1.0866875</c:v>
                </c:pt>
                <c:pt idx="296">
                  <c:v>1.0876874999999999</c:v>
                </c:pt>
                <c:pt idx="297">
                  <c:v>1.0886944444444444</c:v>
                </c:pt>
                <c:pt idx="298">
                  <c:v>1.0896944444444445</c:v>
                </c:pt>
                <c:pt idx="299">
                  <c:v>1.0907013888888888</c:v>
                </c:pt>
                <c:pt idx="300">
                  <c:v>1.0917013888888889</c:v>
                </c:pt>
                <c:pt idx="301">
                  <c:v>1.0929027777777778</c:v>
                </c:pt>
                <c:pt idx="302">
                  <c:v>1.0940972222222223</c:v>
                </c:pt>
                <c:pt idx="303">
                  <c:v>1.0952916666666668</c:v>
                </c:pt>
                <c:pt idx="304">
                  <c:v>1.0964930555555557</c:v>
                </c:pt>
                <c:pt idx="305">
                  <c:v>1.0976875000000001</c:v>
                </c:pt>
                <c:pt idx="306">
                  <c:v>1.1008819444444444</c:v>
                </c:pt>
                <c:pt idx="307">
                  <c:v>1.1040763888888887</c:v>
                </c:pt>
                <c:pt idx="308">
                  <c:v>1.1072708333333334</c:v>
                </c:pt>
                <c:pt idx="309">
                  <c:v>1.1104652777777777</c:v>
                </c:pt>
                <c:pt idx="310">
                  <c:v>1.1136597222222222</c:v>
                </c:pt>
                <c:pt idx="311">
                  <c:v>1.1177222222222223</c:v>
                </c:pt>
                <c:pt idx="312">
                  <c:v>1.1217916666666667</c:v>
                </c:pt>
                <c:pt idx="313">
                  <c:v>1.1258611111111112</c:v>
                </c:pt>
                <c:pt idx="314">
                  <c:v>1.1299236111111111</c:v>
                </c:pt>
                <c:pt idx="315">
                  <c:v>1.1339930555555555</c:v>
                </c:pt>
                <c:pt idx="316">
                  <c:v>1.1380625</c:v>
                </c:pt>
                <c:pt idx="317">
                  <c:v>1.1421250000000001</c:v>
                </c:pt>
                <c:pt idx="318">
                  <c:v>1.1461944444444445</c:v>
                </c:pt>
                <c:pt idx="319">
                  <c:v>1.150263888888889</c:v>
                </c:pt>
                <c:pt idx="320">
                  <c:v>1.1543263888888888</c:v>
                </c:pt>
                <c:pt idx="321">
                  <c:v>1.1583958333333333</c:v>
                </c:pt>
                <c:pt idx="322">
                  <c:v>1.1624652777777778</c:v>
                </c:pt>
                <c:pt idx="323">
                  <c:v>1.1665347222222222</c:v>
                </c:pt>
                <c:pt idx="324">
                  <c:v>1.1705972222222223</c:v>
                </c:pt>
                <c:pt idx="325">
                  <c:v>1.1738055555555555</c:v>
                </c:pt>
                <c:pt idx="326">
                  <c:v>1.1763888888888889</c:v>
                </c:pt>
                <c:pt idx="327">
                  <c:v>1.1768680555555555</c:v>
                </c:pt>
                <c:pt idx="328">
                  <c:v>1.1773402777777777</c:v>
                </c:pt>
                <c:pt idx="329">
                  <c:v>1.1778194444444443</c:v>
                </c:pt>
                <c:pt idx="330">
                  <c:v>1.1782986111111111</c:v>
                </c:pt>
                <c:pt idx="331">
                  <c:v>1.1787777777777779</c:v>
                </c:pt>
                <c:pt idx="332">
                  <c:v>1.1796597222222223</c:v>
                </c:pt>
                <c:pt idx="333">
                  <c:v>1.1805416666666666</c:v>
                </c:pt>
                <c:pt idx="334">
                  <c:v>1.1814236111111112</c:v>
                </c:pt>
                <c:pt idx="335">
                  <c:v>1.1823055555555555</c:v>
                </c:pt>
                <c:pt idx="336">
                  <c:v>1.1831944444444444</c:v>
                </c:pt>
                <c:pt idx="337">
                  <c:v>1.1856875</c:v>
                </c:pt>
                <c:pt idx="338">
                  <c:v>1.1881805555555556</c:v>
                </c:pt>
                <c:pt idx="339">
                  <c:v>1.1906736111111111</c:v>
                </c:pt>
                <c:pt idx="340">
                  <c:v>1.1931666666666667</c:v>
                </c:pt>
                <c:pt idx="341">
                  <c:v>1.1956597222222223</c:v>
                </c:pt>
                <c:pt idx="342">
                  <c:v>1.1981527777777776</c:v>
                </c:pt>
                <c:pt idx="343">
                  <c:v>1.2006458333333334</c:v>
                </c:pt>
                <c:pt idx="344">
                  <c:v>1.203138888888889</c:v>
                </c:pt>
                <c:pt idx="345">
                  <c:v>1.2056319444444443</c:v>
                </c:pt>
                <c:pt idx="346">
                  <c:v>1.2077083333333332</c:v>
                </c:pt>
                <c:pt idx="347">
                  <c:v>1.2097777777777776</c:v>
                </c:pt>
                <c:pt idx="348">
                  <c:v>1.2118472222222221</c:v>
                </c:pt>
                <c:pt idx="349">
                  <c:v>1.2139236111111111</c:v>
                </c:pt>
                <c:pt idx="350">
                  <c:v>1.2159930555555556</c:v>
                </c:pt>
                <c:pt idx="351">
                  <c:v>1.2180625</c:v>
                </c:pt>
                <c:pt idx="352">
                  <c:v>1.2201388888888889</c:v>
                </c:pt>
                <c:pt idx="353">
                  <c:v>1.2222083333333333</c:v>
                </c:pt>
                <c:pt idx="354">
                  <c:v>1.2225277777777779</c:v>
                </c:pt>
                <c:pt idx="355">
                  <c:v>1.2228472222222222</c:v>
                </c:pt>
                <c:pt idx="356">
                  <c:v>1.2231666666666665</c:v>
                </c:pt>
                <c:pt idx="357">
                  <c:v>1.2234861111111111</c:v>
                </c:pt>
                <c:pt idx="358">
                  <c:v>1.2238055555555556</c:v>
                </c:pt>
                <c:pt idx="359">
                  <c:v>1.2242708333333334</c:v>
                </c:pt>
                <c:pt idx="360">
                  <c:v>1.2247430555555556</c:v>
                </c:pt>
                <c:pt idx="361">
                  <c:v>1.2252083333333332</c:v>
                </c:pt>
                <c:pt idx="362">
                  <c:v>1.2256736111111111</c:v>
                </c:pt>
                <c:pt idx="363">
                  <c:v>1.2265902777777777</c:v>
                </c:pt>
                <c:pt idx="364">
                  <c:v>1.2275069444444444</c:v>
                </c:pt>
                <c:pt idx="365">
                  <c:v>1.2284236111111111</c:v>
                </c:pt>
                <c:pt idx="366">
                  <c:v>1.2293402777777778</c:v>
                </c:pt>
                <c:pt idx="367">
                  <c:v>1.2305555555555556</c:v>
                </c:pt>
                <c:pt idx="368">
                  <c:v>1.2317708333333333</c:v>
                </c:pt>
                <c:pt idx="369">
                  <c:v>1.2329861111111111</c:v>
                </c:pt>
                <c:pt idx="370">
                  <c:v>1.2339791666666666</c:v>
                </c:pt>
                <c:pt idx="371">
                  <c:v>1.2349722222222221</c:v>
                </c:pt>
                <c:pt idx="372">
                  <c:v>1.2359652777777776</c:v>
                </c:pt>
                <c:pt idx="373">
                  <c:v>1.2369583333333334</c:v>
                </c:pt>
                <c:pt idx="374">
                  <c:v>1.2379513888888889</c:v>
                </c:pt>
                <c:pt idx="375">
                  <c:v>1.2389444444444444</c:v>
                </c:pt>
                <c:pt idx="376">
                  <c:v>1.2399374999999999</c:v>
                </c:pt>
                <c:pt idx="377">
                  <c:v>1.240923611111111</c:v>
                </c:pt>
                <c:pt idx="378">
                  <c:v>1.2422499999999999</c:v>
                </c:pt>
                <c:pt idx="379">
                  <c:v>1.2435763888888889</c:v>
                </c:pt>
                <c:pt idx="380">
                  <c:v>1.2445833333333334</c:v>
                </c:pt>
                <c:pt idx="381">
                  <c:v>1.2455972222222222</c:v>
                </c:pt>
                <c:pt idx="382">
                  <c:v>1.2466041666666665</c:v>
                </c:pt>
                <c:pt idx="383">
                  <c:v>1.2476180555555556</c:v>
                </c:pt>
                <c:pt idx="384">
                  <c:v>1.2486250000000001</c:v>
                </c:pt>
                <c:pt idx="385">
                  <c:v>1.249638888888889</c:v>
                </c:pt>
                <c:pt idx="386">
                  <c:v>1.2506458333333335</c:v>
                </c:pt>
                <c:pt idx="387">
                  <c:v>1.2516597222222223</c:v>
                </c:pt>
                <c:pt idx="388">
                  <c:v>1.2528680555555556</c:v>
                </c:pt>
                <c:pt idx="389">
                  <c:v>1.2540763888888888</c:v>
                </c:pt>
                <c:pt idx="390">
                  <c:v>1.2552916666666667</c:v>
                </c:pt>
                <c:pt idx="391">
                  <c:v>1.2565</c:v>
                </c:pt>
                <c:pt idx="392">
                  <c:v>1.2577152777777778</c:v>
                </c:pt>
                <c:pt idx="393">
                  <c:v>1.2589236111111111</c:v>
                </c:pt>
                <c:pt idx="394">
                  <c:v>1.2602638888888889</c:v>
                </c:pt>
                <c:pt idx="395">
                  <c:v>1.2616041666666666</c:v>
                </c:pt>
                <c:pt idx="396">
                  <c:v>1.2629444444444444</c:v>
                </c:pt>
                <c:pt idx="397">
                  <c:v>1.2640416666666667</c:v>
                </c:pt>
                <c:pt idx="398">
                  <c:v>1.2651388888888888</c:v>
                </c:pt>
                <c:pt idx="399">
                  <c:v>1.2662291666666665</c:v>
                </c:pt>
                <c:pt idx="400">
                  <c:v>1.2673263888888888</c:v>
                </c:pt>
                <c:pt idx="401">
                  <c:v>1.2684236111111111</c:v>
                </c:pt>
                <c:pt idx="402">
                  <c:v>1.2695138888888888</c:v>
                </c:pt>
                <c:pt idx="403">
                  <c:v>1.2706111111111111</c:v>
                </c:pt>
                <c:pt idx="404">
                  <c:v>1.2717013888888888</c:v>
                </c:pt>
                <c:pt idx="405">
                  <c:v>1.2727986111111111</c:v>
                </c:pt>
                <c:pt idx="406">
                  <c:v>1.2738958333333334</c:v>
                </c:pt>
                <c:pt idx="407">
                  <c:v>1.2749861111111112</c:v>
                </c:pt>
                <c:pt idx="408">
                  <c:v>1.2760833333333332</c:v>
                </c:pt>
                <c:pt idx="409">
                  <c:v>1.2771736111111112</c:v>
                </c:pt>
                <c:pt idx="410">
                  <c:v>1.2782708333333335</c:v>
                </c:pt>
                <c:pt idx="411">
                  <c:v>1.2793680555555556</c:v>
                </c:pt>
                <c:pt idx="412">
                  <c:v>1.2804583333333333</c:v>
                </c:pt>
                <c:pt idx="413">
                  <c:v>1.2815555555555556</c:v>
                </c:pt>
                <c:pt idx="414">
                  <c:v>1.2824513888888889</c:v>
                </c:pt>
                <c:pt idx="415">
                  <c:v>1.2833472222222222</c:v>
                </c:pt>
                <c:pt idx="416">
                  <c:v>1.2842361111111111</c:v>
                </c:pt>
                <c:pt idx="417">
                  <c:v>1.2851319444444445</c:v>
                </c:pt>
                <c:pt idx="418">
                  <c:v>1.2860277777777778</c:v>
                </c:pt>
                <c:pt idx="419">
                  <c:v>1.2869236111111111</c:v>
                </c:pt>
                <c:pt idx="420">
                  <c:v>1.2878194444444444</c:v>
                </c:pt>
                <c:pt idx="421">
                  <c:v>1.2887083333333333</c:v>
                </c:pt>
                <c:pt idx="422">
                  <c:v>1.2894513888888888</c:v>
                </c:pt>
                <c:pt idx="423">
                  <c:v>1.2900277777777778</c:v>
                </c:pt>
                <c:pt idx="424">
                  <c:v>1.2906041666666668</c:v>
                </c:pt>
                <c:pt idx="425">
                  <c:v>1.2906944444444444</c:v>
                </c:pt>
                <c:pt idx="426">
                  <c:v>1.2907847222222222</c:v>
                </c:pt>
                <c:pt idx="427">
                  <c:v>1.2908819444444444</c:v>
                </c:pt>
                <c:pt idx="428">
                  <c:v>1.2909722222222222</c:v>
                </c:pt>
                <c:pt idx="429">
                  <c:v>1.2910625</c:v>
                </c:pt>
                <c:pt idx="430">
                  <c:v>1.2912083333333333</c:v>
                </c:pt>
                <c:pt idx="431">
                  <c:v>1.2913611111111112</c:v>
                </c:pt>
                <c:pt idx="432">
                  <c:v>1.2915069444444445</c:v>
                </c:pt>
                <c:pt idx="433">
                  <c:v>1.2916527777777778</c:v>
                </c:pt>
                <c:pt idx="434">
                  <c:v>1.2917986111111111</c:v>
                </c:pt>
                <c:pt idx="435">
                  <c:v>1.2920763888888889</c:v>
                </c:pt>
                <c:pt idx="436">
                  <c:v>1.2923541666666667</c:v>
                </c:pt>
                <c:pt idx="437">
                  <c:v>1.2926319444444445</c:v>
                </c:pt>
                <c:pt idx="438">
                  <c:v>1.2929097222222221</c:v>
                </c:pt>
                <c:pt idx="439">
                  <c:v>1.2931874999999999</c:v>
                </c:pt>
                <c:pt idx="440">
                  <c:v>1.2936319444444444</c:v>
                </c:pt>
                <c:pt idx="441">
                  <c:v>1.2940763888888889</c:v>
                </c:pt>
                <c:pt idx="442">
                  <c:v>1.2945277777777777</c:v>
                </c:pt>
                <c:pt idx="443">
                  <c:v>1.2949722222222222</c:v>
                </c:pt>
                <c:pt idx="444">
                  <c:v>1.2954166666666667</c:v>
                </c:pt>
                <c:pt idx="445">
                  <c:v>1.2959930555555557</c:v>
                </c:pt>
                <c:pt idx="446">
                  <c:v>1.2965625000000001</c:v>
                </c:pt>
                <c:pt idx="447">
                  <c:v>1.2971388888888891</c:v>
                </c:pt>
                <c:pt idx="448">
                  <c:v>1.2977083333333335</c:v>
                </c:pt>
                <c:pt idx="449">
                  <c:v>1.2982847222222222</c:v>
                </c:pt>
                <c:pt idx="450">
                  <c:v>1.2988541666666666</c:v>
                </c:pt>
                <c:pt idx="451">
                  <c:v>1.2994305555555556</c:v>
                </c:pt>
                <c:pt idx="452">
                  <c:v>1.3000069444444444</c:v>
                </c:pt>
                <c:pt idx="453">
                  <c:v>1.3004444444444445</c:v>
                </c:pt>
                <c:pt idx="454">
                  <c:v>1.3007847222222222</c:v>
                </c:pt>
                <c:pt idx="455">
                  <c:v>1.3011249999999999</c:v>
                </c:pt>
                <c:pt idx="456">
                  <c:v>1.3014652777777778</c:v>
                </c:pt>
                <c:pt idx="457">
                  <c:v>1.3017986111111111</c:v>
                </c:pt>
                <c:pt idx="458">
                  <c:v>1.3021388888888887</c:v>
                </c:pt>
                <c:pt idx="459">
                  <c:v>1.3024791666666666</c:v>
                </c:pt>
                <c:pt idx="460">
                  <c:v>1.3028194444444443</c:v>
                </c:pt>
                <c:pt idx="461">
                  <c:v>1.3031597222222222</c:v>
                </c:pt>
                <c:pt idx="462">
                  <c:v>1.3034999999999999</c:v>
                </c:pt>
                <c:pt idx="463">
                  <c:v>1.3039236111111112</c:v>
                </c:pt>
                <c:pt idx="464">
                  <c:v>1.3043472222222223</c:v>
                </c:pt>
                <c:pt idx="465">
                  <c:v>1.3047638888888888</c:v>
                </c:pt>
                <c:pt idx="466">
                  <c:v>1.3051874999999999</c:v>
                </c:pt>
                <c:pt idx="467">
                  <c:v>1.3056111111111111</c:v>
                </c:pt>
                <c:pt idx="468">
                  <c:v>1.3059375</c:v>
                </c:pt>
                <c:pt idx="469">
                  <c:v>1.3062152777777778</c:v>
                </c:pt>
                <c:pt idx="470">
                  <c:v>1.306486111111111</c:v>
                </c:pt>
                <c:pt idx="471">
                  <c:v>1.3067638888888888</c:v>
                </c:pt>
                <c:pt idx="472">
                  <c:v>1.3070416666666667</c:v>
                </c:pt>
                <c:pt idx="473">
                  <c:v>1.3073194444444445</c:v>
                </c:pt>
                <c:pt idx="474">
                  <c:v>1.3075972222222223</c:v>
                </c:pt>
                <c:pt idx="475">
                  <c:v>1.3078749999999999</c:v>
                </c:pt>
                <c:pt idx="476">
                  <c:v>1.3081458333333333</c:v>
                </c:pt>
                <c:pt idx="477">
                  <c:v>1.3084583333333333</c:v>
                </c:pt>
                <c:pt idx="478">
                  <c:v>1.3087708333333334</c:v>
                </c:pt>
                <c:pt idx="479">
                  <c:v>1.3090763888888888</c:v>
                </c:pt>
                <c:pt idx="480">
                  <c:v>1.3093888888888889</c:v>
                </c:pt>
                <c:pt idx="481">
                  <c:v>1.3096944444444445</c:v>
                </c:pt>
                <c:pt idx="482">
                  <c:v>1.3100416666666668</c:v>
                </c:pt>
                <c:pt idx="483">
                  <c:v>1.3103888888888888</c:v>
                </c:pt>
                <c:pt idx="484">
                  <c:v>1.3107361111111111</c:v>
                </c:pt>
                <c:pt idx="485">
                  <c:v>1.3110833333333334</c:v>
                </c:pt>
                <c:pt idx="486">
                  <c:v>1.3114305555555557</c:v>
                </c:pt>
                <c:pt idx="487">
                  <c:v>1.3118194444444444</c:v>
                </c:pt>
                <c:pt idx="488">
                  <c:v>1.3122083333333332</c:v>
                </c:pt>
                <c:pt idx="489">
                  <c:v>1.3125902777777778</c:v>
                </c:pt>
                <c:pt idx="490">
                  <c:v>1.3129791666666668</c:v>
                </c:pt>
                <c:pt idx="491">
                  <c:v>1.3133680555555556</c:v>
                </c:pt>
                <c:pt idx="492">
                  <c:v>1.3138472222222222</c:v>
                </c:pt>
                <c:pt idx="493">
                  <c:v>1.3143194444444444</c:v>
                </c:pt>
                <c:pt idx="494">
                  <c:v>1.3147986111111112</c:v>
                </c:pt>
                <c:pt idx="495">
                  <c:v>1.3152777777777778</c:v>
                </c:pt>
                <c:pt idx="496">
                  <c:v>1.3157569444444446</c:v>
                </c:pt>
                <c:pt idx="497">
                  <c:v>1.3162361111111112</c:v>
                </c:pt>
                <c:pt idx="498">
                  <c:v>1.3167152777777777</c:v>
                </c:pt>
                <c:pt idx="499">
                  <c:v>1.3171944444444443</c:v>
                </c:pt>
                <c:pt idx="500">
                  <c:v>1.3176736111111111</c:v>
                </c:pt>
                <c:pt idx="501">
                  <c:v>1.3177430555555556</c:v>
                </c:pt>
                <c:pt idx="502">
                  <c:v>1.3178194444444444</c:v>
                </c:pt>
                <c:pt idx="503">
                  <c:v>1.3178888888888889</c:v>
                </c:pt>
                <c:pt idx="504">
                  <c:v>1.3179583333333333</c:v>
                </c:pt>
                <c:pt idx="505">
                  <c:v>1.3180347222222222</c:v>
                </c:pt>
                <c:pt idx="506">
                  <c:v>1.3181805555555557</c:v>
                </c:pt>
                <c:pt idx="507">
                  <c:v>1.3183194444444446</c:v>
                </c:pt>
                <c:pt idx="508">
                  <c:v>1.3184652777777777</c:v>
                </c:pt>
                <c:pt idx="509">
                  <c:v>1.3186111111111112</c:v>
                </c:pt>
                <c:pt idx="510">
                  <c:v>1.3188263888888889</c:v>
                </c:pt>
                <c:pt idx="511">
                  <c:v>1.319048611111111</c:v>
                </c:pt>
                <c:pt idx="512">
                  <c:v>1.3192638888888888</c:v>
                </c:pt>
                <c:pt idx="513">
                  <c:v>1.3194791666666665</c:v>
                </c:pt>
                <c:pt idx="514">
                  <c:v>1.319763888888889</c:v>
                </c:pt>
                <c:pt idx="515">
                  <c:v>1.3200416666666666</c:v>
                </c:pt>
                <c:pt idx="516">
                  <c:v>1.320326388888889</c:v>
                </c:pt>
                <c:pt idx="517">
                  <c:v>1.3206041666666668</c:v>
                </c:pt>
                <c:pt idx="518">
                  <c:v>1.3208819444444444</c:v>
                </c:pt>
                <c:pt idx="519">
                  <c:v>1.3211666666666666</c:v>
                </c:pt>
                <c:pt idx="520">
                  <c:v>1.3214444444444444</c:v>
                </c:pt>
                <c:pt idx="521">
                  <c:v>1.3217291666666666</c:v>
                </c:pt>
                <c:pt idx="522">
                  <c:v>1.3221041666666666</c:v>
                </c:pt>
                <c:pt idx="523">
                  <c:v>1.3224791666666667</c:v>
                </c:pt>
                <c:pt idx="524">
                  <c:v>1.3228541666666667</c:v>
                </c:pt>
                <c:pt idx="525">
                  <c:v>1.3232361111111111</c:v>
                </c:pt>
                <c:pt idx="526">
                  <c:v>1.3236111111111111</c:v>
                </c:pt>
                <c:pt idx="527">
                  <c:v>1.3239861111111111</c:v>
                </c:pt>
                <c:pt idx="528">
                  <c:v>1.3243611111111111</c:v>
                </c:pt>
                <c:pt idx="529">
                  <c:v>1.3247361111111111</c:v>
                </c:pt>
                <c:pt idx="530">
                  <c:v>1.3251180555555555</c:v>
                </c:pt>
                <c:pt idx="531">
                  <c:v>1.3254930555555555</c:v>
                </c:pt>
                <c:pt idx="532">
                  <c:v>1.3258680555555555</c:v>
                </c:pt>
                <c:pt idx="533">
                  <c:v>1.3262430555555556</c:v>
                </c:pt>
                <c:pt idx="534">
                  <c:v>1.3266249999999999</c:v>
                </c:pt>
                <c:pt idx="535">
                  <c:v>1.3270000000000002</c:v>
                </c:pt>
                <c:pt idx="536">
                  <c:v>1.3273124999999999</c:v>
                </c:pt>
                <c:pt idx="537">
                  <c:v>1.3276250000000001</c:v>
                </c:pt>
                <c:pt idx="538">
                  <c:v>1.3279375</c:v>
                </c:pt>
                <c:pt idx="539">
                  <c:v>1.3282500000000002</c:v>
                </c:pt>
                <c:pt idx="540">
                  <c:v>1.3285625000000001</c:v>
                </c:pt>
                <c:pt idx="541">
                  <c:v>1.328875</c:v>
                </c:pt>
                <c:pt idx="542">
                  <c:v>1.3291875</c:v>
                </c:pt>
                <c:pt idx="543">
                  <c:v>1.3294999999999999</c:v>
                </c:pt>
                <c:pt idx="544">
                  <c:v>1.32975</c:v>
                </c:pt>
                <c:pt idx="545">
                  <c:v>1.3300069444444444</c:v>
                </c:pt>
                <c:pt idx="546">
                  <c:v>1.3302638888888889</c:v>
                </c:pt>
                <c:pt idx="547">
                  <c:v>1.3305208333333334</c:v>
                </c:pt>
                <c:pt idx="548">
                  <c:v>1.3307777777777778</c:v>
                </c:pt>
                <c:pt idx="549">
                  <c:v>1.3310694444444444</c:v>
                </c:pt>
                <c:pt idx="550">
                  <c:v>1.3313611111111112</c:v>
                </c:pt>
                <c:pt idx="551">
                  <c:v>1.3316597222222222</c:v>
                </c:pt>
                <c:pt idx="552">
                  <c:v>1.331951388888889</c:v>
                </c:pt>
                <c:pt idx="553">
                  <c:v>1.3322499999999999</c:v>
                </c:pt>
                <c:pt idx="554">
                  <c:v>1.3325416666666665</c:v>
                </c:pt>
                <c:pt idx="555">
                  <c:v>1.3328402777777777</c:v>
                </c:pt>
                <c:pt idx="556">
                  <c:v>1.3331319444444445</c:v>
                </c:pt>
                <c:pt idx="557">
                  <c:v>1.3334305555555557</c:v>
                </c:pt>
                <c:pt idx="558">
                  <c:v>1.3337222222222223</c:v>
                </c:pt>
                <c:pt idx="559">
                  <c:v>1.3340208333333334</c:v>
                </c:pt>
                <c:pt idx="560">
                  <c:v>1.3342638888888889</c:v>
                </c:pt>
                <c:pt idx="561">
                  <c:v>1.3345069444444444</c:v>
                </c:pt>
                <c:pt idx="562">
                  <c:v>1.3347569444444445</c:v>
                </c:pt>
                <c:pt idx="563">
                  <c:v>1.335</c:v>
                </c:pt>
                <c:pt idx="564">
                  <c:v>1.3352430555555554</c:v>
                </c:pt>
                <c:pt idx="565">
                  <c:v>1.3354930555555555</c:v>
                </c:pt>
                <c:pt idx="566">
                  <c:v>1.3357361111111112</c:v>
                </c:pt>
                <c:pt idx="567">
                  <c:v>1.3359791666666667</c:v>
                </c:pt>
                <c:pt idx="568">
                  <c:v>1.3362708333333333</c:v>
                </c:pt>
                <c:pt idx="569">
                  <c:v>1.3365694444444445</c:v>
                </c:pt>
                <c:pt idx="570">
                  <c:v>1.3368611111111111</c:v>
                </c:pt>
                <c:pt idx="571">
                  <c:v>1.3370972222222224</c:v>
                </c:pt>
                <c:pt idx="572">
                  <c:v>1.3373263888888889</c:v>
                </c:pt>
                <c:pt idx="573">
                  <c:v>1.3375625</c:v>
                </c:pt>
                <c:pt idx="574">
                  <c:v>1.3377916666666667</c:v>
                </c:pt>
                <c:pt idx="575">
                  <c:v>1.3379722222222223</c:v>
                </c:pt>
                <c:pt idx="576">
                  <c:v>1.3381180555555556</c:v>
                </c:pt>
                <c:pt idx="577">
                  <c:v>1.3382569444444443</c:v>
                </c:pt>
                <c:pt idx="578">
                  <c:v>1.3383819444444445</c:v>
                </c:pt>
                <c:pt idx="579">
                  <c:v>1.3384791666666667</c:v>
                </c:pt>
                <c:pt idx="580">
                  <c:v>1.3385763888888889</c:v>
                </c:pt>
                <c:pt idx="581">
                  <c:v>1.3385902777777778</c:v>
                </c:pt>
                <c:pt idx="582">
                  <c:v>1.3386041666666666</c:v>
                </c:pt>
                <c:pt idx="583">
                  <c:v>1.3386180555555556</c:v>
                </c:pt>
                <c:pt idx="584">
                  <c:v>1.3386319444444446</c:v>
                </c:pt>
                <c:pt idx="585">
                  <c:v>1.3386597222222223</c:v>
                </c:pt>
                <c:pt idx="586">
                  <c:v>1.3386875</c:v>
                </c:pt>
                <c:pt idx="587">
                  <c:v>1.3387152777777778</c:v>
                </c:pt>
                <c:pt idx="588">
                  <c:v>1.3387430555555555</c:v>
                </c:pt>
                <c:pt idx="589">
                  <c:v>1.3388263888888889</c:v>
                </c:pt>
                <c:pt idx="590">
                  <c:v>1.3389097222222222</c:v>
                </c:pt>
                <c:pt idx="591">
                  <c:v>1.3389930555555556</c:v>
                </c:pt>
                <c:pt idx="592">
                  <c:v>1.3390833333333334</c:v>
                </c:pt>
                <c:pt idx="593">
                  <c:v>1.3392430555555555</c:v>
                </c:pt>
                <c:pt idx="594">
                  <c:v>1.3394027777777777</c:v>
                </c:pt>
                <c:pt idx="595">
                  <c:v>1.3395694444444444</c:v>
                </c:pt>
                <c:pt idx="596">
                  <c:v>1.3397291666666666</c:v>
                </c:pt>
                <c:pt idx="597">
                  <c:v>1.3398958333333333</c:v>
                </c:pt>
                <c:pt idx="598">
                  <c:v>1.3400833333333333</c:v>
                </c:pt>
                <c:pt idx="599">
                  <c:v>1.3402777777777777</c:v>
                </c:pt>
                <c:pt idx="600">
                  <c:v>1.3404722222222223</c:v>
                </c:pt>
                <c:pt idx="601">
                  <c:v>1.3406666666666667</c:v>
                </c:pt>
                <c:pt idx="602">
                  <c:v>1.3408541666666667</c:v>
                </c:pt>
                <c:pt idx="603">
                  <c:v>1.3410486111111111</c:v>
                </c:pt>
                <c:pt idx="604">
                  <c:v>1.3412430555555557</c:v>
                </c:pt>
                <c:pt idx="605">
                  <c:v>1.3414375000000001</c:v>
                </c:pt>
                <c:pt idx="606">
                  <c:v>1.3415763888888887</c:v>
                </c:pt>
                <c:pt idx="607">
                  <c:v>1.3417222222222223</c:v>
                </c:pt>
                <c:pt idx="608">
                  <c:v>1.3418680555555556</c:v>
                </c:pt>
                <c:pt idx="609">
                  <c:v>1.3419861111111111</c:v>
                </c:pt>
                <c:pt idx="610">
                  <c:v>1.3420972222222221</c:v>
                </c:pt>
                <c:pt idx="611">
                  <c:v>1.3421180555555556</c:v>
                </c:pt>
                <c:pt idx="612">
                  <c:v>1.342138888888889</c:v>
                </c:pt>
                <c:pt idx="613">
                  <c:v>1.3421597222222224</c:v>
                </c:pt>
                <c:pt idx="614">
                  <c:v>1.3421736111111111</c:v>
                </c:pt>
                <c:pt idx="615">
                  <c:v>1.3421944444444445</c:v>
                </c:pt>
                <c:pt idx="616">
                  <c:v>1.3422222222222222</c:v>
                </c:pt>
                <c:pt idx="617">
                  <c:v>1.3422569444444443</c:v>
                </c:pt>
                <c:pt idx="618">
                  <c:v>1.3422847222222223</c:v>
                </c:pt>
                <c:pt idx="619">
                  <c:v>1.3423194444444444</c:v>
                </c:pt>
                <c:pt idx="620">
                  <c:v>1.3423958333333332</c:v>
                </c:pt>
                <c:pt idx="621">
                  <c:v>1.3424791666666667</c:v>
                </c:pt>
                <c:pt idx="622">
                  <c:v>1.3425555555555555</c:v>
                </c:pt>
                <c:pt idx="623">
                  <c:v>1.3426388888888889</c:v>
                </c:pt>
                <c:pt idx="624">
                  <c:v>1.3427361111111111</c:v>
                </c:pt>
                <c:pt idx="625">
                  <c:v>1.3428402777777779</c:v>
                </c:pt>
                <c:pt idx="626">
                  <c:v>1.3429374999999999</c:v>
                </c:pt>
                <c:pt idx="627">
                  <c:v>1.3430347222222223</c:v>
                </c:pt>
                <c:pt idx="628">
                  <c:v>1.3431388888888889</c:v>
                </c:pt>
                <c:pt idx="629">
                  <c:v>1.3432569444444444</c:v>
                </c:pt>
                <c:pt idx="630">
                  <c:v>1.3433819444444444</c:v>
                </c:pt>
                <c:pt idx="631">
                  <c:v>1.3435000000000001</c:v>
                </c:pt>
                <c:pt idx="632">
                  <c:v>1.3436180555555555</c:v>
                </c:pt>
                <c:pt idx="633">
                  <c:v>1.3437430555555556</c:v>
                </c:pt>
                <c:pt idx="634">
                  <c:v>1.3438888888888889</c:v>
                </c:pt>
                <c:pt idx="635">
                  <c:v>1.3440277777777778</c:v>
                </c:pt>
                <c:pt idx="636">
                  <c:v>1.3441736111111111</c:v>
                </c:pt>
                <c:pt idx="637">
                  <c:v>1.3443194444444444</c:v>
                </c:pt>
                <c:pt idx="638">
                  <c:v>1.3444652777777777</c:v>
                </c:pt>
                <c:pt idx="639">
                  <c:v>1.3446319444444443</c:v>
                </c:pt>
                <c:pt idx="640">
                  <c:v>1.3447986111111112</c:v>
                </c:pt>
                <c:pt idx="641">
                  <c:v>1.3449652777777779</c:v>
                </c:pt>
                <c:pt idx="642">
                  <c:v>1.3450972222222222</c:v>
                </c:pt>
                <c:pt idx="643">
                  <c:v>1.3451180555555555</c:v>
                </c:pt>
                <c:pt idx="644">
                  <c:v>1.3451388888888889</c:v>
                </c:pt>
                <c:pt idx="645">
                  <c:v>1.3451597222222222</c:v>
                </c:pt>
                <c:pt idx="646">
                  <c:v>1.3451805555555556</c:v>
                </c:pt>
                <c:pt idx="647">
                  <c:v>1.3452013888888887</c:v>
                </c:pt>
                <c:pt idx="648">
                  <c:v>1.3452430555555557</c:v>
                </c:pt>
                <c:pt idx="649">
                  <c:v>1.3452847222222222</c:v>
                </c:pt>
                <c:pt idx="650">
                  <c:v>1.3453263888888889</c:v>
                </c:pt>
                <c:pt idx="651">
                  <c:v>1.3453680555555556</c:v>
                </c:pt>
                <c:pt idx="652">
                  <c:v>1.3454097222222223</c:v>
                </c:pt>
                <c:pt idx="653">
                  <c:v>1.3455416666666666</c:v>
                </c:pt>
                <c:pt idx="654">
                  <c:v>1.3456666666666666</c:v>
                </c:pt>
                <c:pt idx="655">
                  <c:v>1.3457916666666667</c:v>
                </c:pt>
                <c:pt idx="656">
                  <c:v>1.3459166666666667</c:v>
                </c:pt>
                <c:pt idx="657">
                  <c:v>1.3460416666666666</c:v>
                </c:pt>
                <c:pt idx="658">
                  <c:v>1.3461944444444445</c:v>
                </c:pt>
                <c:pt idx="659">
                  <c:v>1.3463402777777778</c:v>
                </c:pt>
                <c:pt idx="660">
                  <c:v>1.3464861111111111</c:v>
                </c:pt>
                <c:pt idx="661">
                  <c:v>1.3466319444444446</c:v>
                </c:pt>
                <c:pt idx="662">
                  <c:v>1.3467777777777776</c:v>
                </c:pt>
                <c:pt idx="663">
                  <c:v>1.3469305555555555</c:v>
                </c:pt>
                <c:pt idx="664">
                  <c:v>1.3470972222222222</c:v>
                </c:pt>
                <c:pt idx="665">
                  <c:v>1.3472638888888888</c:v>
                </c:pt>
                <c:pt idx="666">
                  <c:v>1.3474305555555555</c:v>
                </c:pt>
                <c:pt idx="667">
                  <c:v>1.3475694444444444</c:v>
                </c:pt>
                <c:pt idx="668">
                  <c:v>1.3476736111111112</c:v>
                </c:pt>
                <c:pt idx="669">
                  <c:v>1.3477777777777777</c:v>
                </c:pt>
                <c:pt idx="670">
                  <c:v>1.3477986111111111</c:v>
                </c:pt>
                <c:pt idx="671">
                  <c:v>1.3478194444444445</c:v>
                </c:pt>
                <c:pt idx="672">
                  <c:v>1.3478333333333334</c:v>
                </c:pt>
                <c:pt idx="673">
                  <c:v>1.3478541666666668</c:v>
                </c:pt>
                <c:pt idx="674">
                  <c:v>1.3478749999999999</c:v>
                </c:pt>
                <c:pt idx="675">
                  <c:v>1.3479097222222223</c:v>
                </c:pt>
                <c:pt idx="676">
                  <c:v>1.3479444444444444</c:v>
                </c:pt>
                <c:pt idx="677">
                  <c:v>1.3479791666666665</c:v>
                </c:pt>
                <c:pt idx="678">
                  <c:v>1.3480138888888891</c:v>
                </c:pt>
                <c:pt idx="679">
                  <c:v>1.3480486111111112</c:v>
                </c:pt>
                <c:pt idx="680">
                  <c:v>1.3481180555555556</c:v>
                </c:pt>
                <c:pt idx="681">
                  <c:v>1.3481875000000001</c:v>
                </c:pt>
                <c:pt idx="682">
                  <c:v>1.3482569444444445</c:v>
                </c:pt>
                <c:pt idx="683">
                  <c:v>1.3483263888888888</c:v>
                </c:pt>
                <c:pt idx="684">
                  <c:v>1.3483958333333335</c:v>
                </c:pt>
                <c:pt idx="685">
                  <c:v>1.3485</c:v>
                </c:pt>
                <c:pt idx="686">
                  <c:v>1.3486041666666666</c:v>
                </c:pt>
                <c:pt idx="687">
                  <c:v>1.3487083333333334</c:v>
                </c:pt>
                <c:pt idx="688">
                  <c:v>1.3488194444444443</c:v>
                </c:pt>
                <c:pt idx="689">
                  <c:v>1.3489236111111111</c:v>
                </c:pt>
                <c:pt idx="690">
                  <c:v>1.3490486111111113</c:v>
                </c:pt>
                <c:pt idx="691">
                  <c:v>1.349173611111111</c:v>
                </c:pt>
                <c:pt idx="692">
                  <c:v>1.3493055555555555</c:v>
                </c:pt>
                <c:pt idx="693">
                  <c:v>1.3494305555555557</c:v>
                </c:pt>
                <c:pt idx="694">
                  <c:v>1.3495625</c:v>
                </c:pt>
                <c:pt idx="695">
                  <c:v>1.3496874999999999</c:v>
                </c:pt>
                <c:pt idx="696">
                  <c:v>1.3498402777777778</c:v>
                </c:pt>
                <c:pt idx="697">
                  <c:v>1.3499930555555555</c:v>
                </c:pt>
                <c:pt idx="698">
                  <c:v>1.3501458333333334</c:v>
                </c:pt>
                <c:pt idx="699">
                  <c:v>1.350298611111111</c:v>
                </c:pt>
                <c:pt idx="700">
                  <c:v>1.3504513888888889</c:v>
                </c:pt>
                <c:pt idx="701">
                  <c:v>1.3506041666666666</c:v>
                </c:pt>
                <c:pt idx="702">
                  <c:v>1.3507569444444445</c:v>
                </c:pt>
                <c:pt idx="703">
                  <c:v>1.3509097222222222</c:v>
                </c:pt>
                <c:pt idx="704">
                  <c:v>1.3510625000000001</c:v>
                </c:pt>
                <c:pt idx="705">
                  <c:v>1.3512152777777777</c:v>
                </c:pt>
                <c:pt idx="706">
                  <c:v>1.3513680555555556</c:v>
                </c:pt>
                <c:pt idx="707">
                  <c:v>1.3515208333333333</c:v>
                </c:pt>
                <c:pt idx="708">
                  <c:v>1.3516736111111112</c:v>
                </c:pt>
                <c:pt idx="709">
                  <c:v>1.3518263888888891</c:v>
                </c:pt>
                <c:pt idx="710">
                  <c:v>1.3519791666666665</c:v>
                </c:pt>
                <c:pt idx="711">
                  <c:v>1.3521319444444444</c:v>
                </c:pt>
                <c:pt idx="712">
                  <c:v>1.3522916666666667</c:v>
                </c:pt>
                <c:pt idx="713">
                  <c:v>1.3524444444444443</c:v>
                </c:pt>
                <c:pt idx="714">
                  <c:v>1.3525972222222222</c:v>
                </c:pt>
                <c:pt idx="715">
                  <c:v>1.3527500000000001</c:v>
                </c:pt>
                <c:pt idx="716">
                  <c:v>1.3529027777777778</c:v>
                </c:pt>
                <c:pt idx="717">
                  <c:v>1.3530555555555557</c:v>
                </c:pt>
                <c:pt idx="718">
                  <c:v>1.3532083333333333</c:v>
                </c:pt>
                <c:pt idx="719">
                  <c:v>1.353361111111111</c:v>
                </c:pt>
                <c:pt idx="720">
                  <c:v>1.3535138888888889</c:v>
                </c:pt>
                <c:pt idx="721">
                  <c:v>1.3536666666666666</c:v>
                </c:pt>
                <c:pt idx="722">
                  <c:v>1.3538194444444445</c:v>
                </c:pt>
                <c:pt idx="723">
                  <c:v>1.3539722222222221</c:v>
                </c:pt>
                <c:pt idx="724">
                  <c:v>1.354125</c:v>
                </c:pt>
                <c:pt idx="725">
                  <c:v>1.3542777777777779</c:v>
                </c:pt>
                <c:pt idx="726">
                  <c:v>1.3544305555555556</c:v>
                </c:pt>
                <c:pt idx="727">
                  <c:v>1.3545833333333333</c:v>
                </c:pt>
                <c:pt idx="728">
                  <c:v>1.3547361111111111</c:v>
                </c:pt>
                <c:pt idx="729">
                  <c:v>1.3548888888888888</c:v>
                </c:pt>
                <c:pt idx="730">
                  <c:v>1.3550416666666667</c:v>
                </c:pt>
                <c:pt idx="731">
                  <c:v>1.3551944444444444</c:v>
                </c:pt>
                <c:pt idx="732">
                  <c:v>1.3553472222222223</c:v>
                </c:pt>
                <c:pt idx="733">
                  <c:v>1.3555000000000001</c:v>
                </c:pt>
                <c:pt idx="734">
                  <c:v>1.3556527777777778</c:v>
                </c:pt>
                <c:pt idx="735">
                  <c:v>1.3558055555555555</c:v>
                </c:pt>
                <c:pt idx="736">
                  <c:v>1.3559583333333334</c:v>
                </c:pt>
                <c:pt idx="737">
                  <c:v>1.356111111111111</c:v>
                </c:pt>
                <c:pt idx="738">
                  <c:v>1.3562638888888889</c:v>
                </c:pt>
                <c:pt idx="739">
                  <c:v>1.3564236111111112</c:v>
                </c:pt>
                <c:pt idx="740">
                  <c:v>1.3565763888888889</c:v>
                </c:pt>
                <c:pt idx="741">
                  <c:v>1.3567291666666668</c:v>
                </c:pt>
                <c:pt idx="742">
                  <c:v>1.3568819444444444</c:v>
                </c:pt>
                <c:pt idx="743">
                  <c:v>1.3570347222222223</c:v>
                </c:pt>
                <c:pt idx="744">
                  <c:v>1.3571875</c:v>
                </c:pt>
                <c:pt idx="745">
                  <c:v>1.3573402777777777</c:v>
                </c:pt>
                <c:pt idx="746">
                  <c:v>1.3574930555555556</c:v>
                </c:pt>
                <c:pt idx="747">
                  <c:v>1.3576458333333332</c:v>
                </c:pt>
                <c:pt idx="748">
                  <c:v>1.3577986111111111</c:v>
                </c:pt>
                <c:pt idx="749">
                  <c:v>1.357951388888889</c:v>
                </c:pt>
                <c:pt idx="750">
                  <c:v>1.3581041666666667</c:v>
                </c:pt>
                <c:pt idx="751">
                  <c:v>1.3582569444444446</c:v>
                </c:pt>
                <c:pt idx="752">
                  <c:v>1.3584097222222222</c:v>
                </c:pt>
                <c:pt idx="753">
                  <c:v>1.3585624999999999</c:v>
                </c:pt>
                <c:pt idx="754">
                  <c:v>1.3587152777777778</c:v>
                </c:pt>
                <c:pt idx="755">
                  <c:v>1.3588680555555555</c:v>
                </c:pt>
                <c:pt idx="756">
                  <c:v>1.3590208333333333</c:v>
                </c:pt>
                <c:pt idx="757">
                  <c:v>1.3591736111111112</c:v>
                </c:pt>
                <c:pt idx="758">
                  <c:v>1.3593263888888889</c:v>
                </c:pt>
                <c:pt idx="759">
                  <c:v>1.3594791666666668</c:v>
                </c:pt>
                <c:pt idx="760">
                  <c:v>1.3596319444444445</c:v>
                </c:pt>
                <c:pt idx="761">
                  <c:v>1.3597847222222221</c:v>
                </c:pt>
                <c:pt idx="762">
                  <c:v>1.3599375</c:v>
                </c:pt>
                <c:pt idx="763">
                  <c:v>1.3600902777777777</c:v>
                </c:pt>
                <c:pt idx="764">
                  <c:v>1.3602430555555556</c:v>
                </c:pt>
                <c:pt idx="765">
                  <c:v>1.3603958333333332</c:v>
                </c:pt>
                <c:pt idx="766">
                  <c:v>1.3605555555555555</c:v>
                </c:pt>
                <c:pt idx="767">
                  <c:v>1.3607083333333334</c:v>
                </c:pt>
                <c:pt idx="768">
                  <c:v>1.3608611111111111</c:v>
                </c:pt>
                <c:pt idx="769">
                  <c:v>1.3610138888888887</c:v>
                </c:pt>
                <c:pt idx="770">
                  <c:v>1.3611666666666666</c:v>
                </c:pt>
                <c:pt idx="771">
                  <c:v>1.3613194444444443</c:v>
                </c:pt>
                <c:pt idx="772">
                  <c:v>1.3614722222222222</c:v>
                </c:pt>
                <c:pt idx="773">
                  <c:v>1.3616250000000001</c:v>
                </c:pt>
                <c:pt idx="774">
                  <c:v>1.3617777777777778</c:v>
                </c:pt>
                <c:pt idx="775">
                  <c:v>1.3619305555555556</c:v>
                </c:pt>
                <c:pt idx="776">
                  <c:v>1.3620833333333333</c:v>
                </c:pt>
                <c:pt idx="777">
                  <c:v>1.362236111111111</c:v>
                </c:pt>
                <c:pt idx="778">
                  <c:v>1.3623888888888889</c:v>
                </c:pt>
                <c:pt idx="779">
                  <c:v>1.3625416666666665</c:v>
                </c:pt>
                <c:pt idx="780">
                  <c:v>1.3626944444444444</c:v>
                </c:pt>
                <c:pt idx="781">
                  <c:v>1.3628472222222223</c:v>
                </c:pt>
                <c:pt idx="782">
                  <c:v>1.363</c:v>
                </c:pt>
                <c:pt idx="783">
                  <c:v>1.3631527777777779</c:v>
                </c:pt>
                <c:pt idx="784">
                  <c:v>1.3633055555555555</c:v>
                </c:pt>
                <c:pt idx="785">
                  <c:v>1.3634583333333334</c:v>
                </c:pt>
                <c:pt idx="786">
                  <c:v>1.3636111111111111</c:v>
                </c:pt>
                <c:pt idx="787">
                  <c:v>1.3637638888888888</c:v>
                </c:pt>
                <c:pt idx="788">
                  <c:v>1.3639166666666667</c:v>
                </c:pt>
                <c:pt idx="789">
                  <c:v>1.3640694444444443</c:v>
                </c:pt>
                <c:pt idx="790">
                  <c:v>1.3642222222222222</c:v>
                </c:pt>
                <c:pt idx="791">
                  <c:v>1.3643750000000001</c:v>
                </c:pt>
                <c:pt idx="792">
                  <c:v>1.3645277777777778</c:v>
                </c:pt>
                <c:pt idx="793">
                  <c:v>1.3646805555555557</c:v>
                </c:pt>
                <c:pt idx="794">
                  <c:v>1.3648402777777777</c:v>
                </c:pt>
                <c:pt idx="795">
                  <c:v>1.3649930555555554</c:v>
                </c:pt>
                <c:pt idx="796">
                  <c:v>1.3651458333333333</c:v>
                </c:pt>
                <c:pt idx="797">
                  <c:v>1.3652986111111112</c:v>
                </c:pt>
                <c:pt idx="798">
                  <c:v>1.3654513888888888</c:v>
                </c:pt>
                <c:pt idx="799">
                  <c:v>1.3656041666666667</c:v>
                </c:pt>
                <c:pt idx="800">
                  <c:v>1.3657569444444444</c:v>
                </c:pt>
                <c:pt idx="801">
                  <c:v>1.3659097222222223</c:v>
                </c:pt>
                <c:pt idx="802">
                  <c:v>1.3660625000000002</c:v>
                </c:pt>
                <c:pt idx="803">
                  <c:v>1.3662152777777776</c:v>
                </c:pt>
                <c:pt idx="804">
                  <c:v>1.3663680555555555</c:v>
                </c:pt>
                <c:pt idx="805">
                  <c:v>1.3665208333333334</c:v>
                </c:pt>
                <c:pt idx="806">
                  <c:v>1.3666736111111111</c:v>
                </c:pt>
                <c:pt idx="807">
                  <c:v>1.366826388888889</c:v>
                </c:pt>
                <c:pt idx="808">
                  <c:v>1.3669791666666666</c:v>
                </c:pt>
                <c:pt idx="809">
                  <c:v>1.3671319444444445</c:v>
                </c:pt>
                <c:pt idx="810">
                  <c:v>1.3672847222222222</c:v>
                </c:pt>
                <c:pt idx="811">
                  <c:v>1.3674374999999999</c:v>
                </c:pt>
                <c:pt idx="812">
                  <c:v>1.3675902777777778</c:v>
                </c:pt>
                <c:pt idx="813">
                  <c:v>1.3677430555555554</c:v>
                </c:pt>
                <c:pt idx="814">
                  <c:v>1.3678958333333333</c:v>
                </c:pt>
                <c:pt idx="815">
                  <c:v>1.3680486111111112</c:v>
                </c:pt>
                <c:pt idx="816">
                  <c:v>1.3682013888888889</c:v>
                </c:pt>
                <c:pt idx="817">
                  <c:v>1.3683541666666668</c:v>
                </c:pt>
                <c:pt idx="818">
                  <c:v>1.3685069444444444</c:v>
                </c:pt>
                <c:pt idx="819">
                  <c:v>1.3686597222222221</c:v>
                </c:pt>
                <c:pt idx="820">
                  <c:v>1.3688125</c:v>
                </c:pt>
                <c:pt idx="821">
                  <c:v>1.3689722222222223</c:v>
                </c:pt>
                <c:pt idx="822">
                  <c:v>1.3691249999999999</c:v>
                </c:pt>
                <c:pt idx="823">
                  <c:v>1.3692777777777778</c:v>
                </c:pt>
                <c:pt idx="824">
                  <c:v>1.3694305555555555</c:v>
                </c:pt>
                <c:pt idx="825">
                  <c:v>1.3695833333333334</c:v>
                </c:pt>
                <c:pt idx="826">
                  <c:v>1.3697361111111113</c:v>
                </c:pt>
                <c:pt idx="827">
                  <c:v>1.3698888888888889</c:v>
                </c:pt>
                <c:pt idx="828">
                  <c:v>1.3700416666666666</c:v>
                </c:pt>
                <c:pt idx="829">
                  <c:v>1.3701944444444445</c:v>
                </c:pt>
                <c:pt idx="830">
                  <c:v>1.3703472222222222</c:v>
                </c:pt>
                <c:pt idx="831">
                  <c:v>1.3705000000000001</c:v>
                </c:pt>
                <c:pt idx="832">
                  <c:v>1.3706527777777777</c:v>
                </c:pt>
                <c:pt idx="833">
                  <c:v>1.3708055555555556</c:v>
                </c:pt>
                <c:pt idx="834">
                  <c:v>1.3709583333333333</c:v>
                </c:pt>
                <c:pt idx="835">
                  <c:v>1.3711111111111112</c:v>
                </c:pt>
                <c:pt idx="836">
                  <c:v>1.3712638888888888</c:v>
                </c:pt>
                <c:pt idx="837">
                  <c:v>1.3714166666666665</c:v>
                </c:pt>
                <c:pt idx="838">
                  <c:v>1.3715694444444444</c:v>
                </c:pt>
                <c:pt idx="839">
                  <c:v>1.3717222222222223</c:v>
                </c:pt>
                <c:pt idx="840">
                  <c:v>1.371875</c:v>
                </c:pt>
                <c:pt idx="841">
                  <c:v>1.3720277777777778</c:v>
                </c:pt>
                <c:pt idx="842">
                  <c:v>1.3721805555555555</c:v>
                </c:pt>
                <c:pt idx="843">
                  <c:v>1.3723333333333334</c:v>
                </c:pt>
                <c:pt idx="844">
                  <c:v>1.3724861111111113</c:v>
                </c:pt>
                <c:pt idx="845">
                  <c:v>1.3726388888888887</c:v>
                </c:pt>
                <c:pt idx="846">
                  <c:v>1.3727916666666666</c:v>
                </c:pt>
                <c:pt idx="847">
                  <c:v>1.3729444444444445</c:v>
                </c:pt>
                <c:pt idx="848">
                  <c:v>1.3731041666666666</c:v>
                </c:pt>
                <c:pt idx="849">
                  <c:v>1.3732569444444445</c:v>
                </c:pt>
                <c:pt idx="850">
                  <c:v>1.3734097222222224</c:v>
                </c:pt>
                <c:pt idx="851">
                  <c:v>1.3735625</c:v>
                </c:pt>
                <c:pt idx="852">
                  <c:v>1.3737152777777779</c:v>
                </c:pt>
                <c:pt idx="853">
                  <c:v>1.3738680555555556</c:v>
                </c:pt>
                <c:pt idx="854">
                  <c:v>1.3740208333333332</c:v>
                </c:pt>
                <c:pt idx="855">
                  <c:v>1.3741736111111111</c:v>
                </c:pt>
                <c:pt idx="856">
                  <c:v>1.3743263888888888</c:v>
                </c:pt>
                <c:pt idx="857">
                  <c:v>1.3744791666666667</c:v>
                </c:pt>
                <c:pt idx="858">
                  <c:v>1.3746458333333333</c:v>
                </c:pt>
                <c:pt idx="859">
                  <c:v>1.3748125</c:v>
                </c:pt>
                <c:pt idx="860">
                  <c:v>1.374986111111111</c:v>
                </c:pt>
                <c:pt idx="861">
                  <c:v>1.3751527777777779</c:v>
                </c:pt>
                <c:pt idx="862">
                  <c:v>1.3753194444444445</c:v>
                </c:pt>
                <c:pt idx="863">
                  <c:v>1.3754930555555556</c:v>
                </c:pt>
                <c:pt idx="864">
                  <c:v>1.3756597222222222</c:v>
                </c:pt>
                <c:pt idx="865">
                  <c:v>1.3758263888888889</c:v>
                </c:pt>
                <c:pt idx="866">
                  <c:v>1.3760000000000001</c:v>
                </c:pt>
                <c:pt idx="867">
                  <c:v>1.3761666666666668</c:v>
                </c:pt>
                <c:pt idx="868">
                  <c:v>1.3763333333333334</c:v>
                </c:pt>
                <c:pt idx="869">
                  <c:v>1.3765069444444444</c:v>
                </c:pt>
                <c:pt idx="870">
                  <c:v>1.3766736111111111</c:v>
                </c:pt>
                <c:pt idx="871">
                  <c:v>1.3768402777777777</c:v>
                </c:pt>
                <c:pt idx="872">
                  <c:v>1.3770069444444446</c:v>
                </c:pt>
                <c:pt idx="873">
                  <c:v>1.3771805555555556</c:v>
                </c:pt>
                <c:pt idx="874">
                  <c:v>1.3773472222222223</c:v>
                </c:pt>
                <c:pt idx="875">
                  <c:v>1.3775138888888887</c:v>
                </c:pt>
                <c:pt idx="876">
                  <c:v>1.3776875</c:v>
                </c:pt>
                <c:pt idx="877">
                  <c:v>1.3778541666666666</c:v>
                </c:pt>
                <c:pt idx="878">
                  <c:v>1.3780208333333333</c:v>
                </c:pt>
                <c:pt idx="879">
                  <c:v>1.3781944444444443</c:v>
                </c:pt>
                <c:pt idx="880">
                  <c:v>1.3783611111111111</c:v>
                </c:pt>
                <c:pt idx="881">
                  <c:v>1.3785277777777778</c:v>
                </c:pt>
                <c:pt idx="882">
                  <c:v>1.3787013888888888</c:v>
                </c:pt>
                <c:pt idx="883">
                  <c:v>1.3788680555555555</c:v>
                </c:pt>
                <c:pt idx="884">
                  <c:v>1.3790347222222221</c:v>
                </c:pt>
                <c:pt idx="885">
                  <c:v>1.3792083333333334</c:v>
                </c:pt>
                <c:pt idx="886">
                  <c:v>1.379375</c:v>
                </c:pt>
                <c:pt idx="887">
                  <c:v>1.3795416666666667</c:v>
                </c:pt>
                <c:pt idx="888">
                  <c:v>1.3797083333333333</c:v>
                </c:pt>
                <c:pt idx="889">
                  <c:v>1.3798819444444443</c:v>
                </c:pt>
                <c:pt idx="890">
                  <c:v>1.380048611111111</c:v>
                </c:pt>
                <c:pt idx="891">
                  <c:v>1.380236111111111</c:v>
                </c:pt>
                <c:pt idx="892">
                  <c:v>1.380423611111111</c:v>
                </c:pt>
                <c:pt idx="893">
                  <c:v>1.380611111111111</c:v>
                </c:pt>
                <c:pt idx="894">
                  <c:v>1.380798611111111</c:v>
                </c:pt>
                <c:pt idx="895">
                  <c:v>1.380986111111111</c:v>
                </c:pt>
                <c:pt idx="896">
                  <c:v>1.3811736111111113</c:v>
                </c:pt>
                <c:pt idx="897">
                  <c:v>1.3813611111111113</c:v>
                </c:pt>
                <c:pt idx="898">
                  <c:v>1.381548611111111</c:v>
                </c:pt>
                <c:pt idx="899">
                  <c:v>1.3817361111111111</c:v>
                </c:pt>
                <c:pt idx="900">
                  <c:v>1.3819236111111111</c:v>
                </c:pt>
                <c:pt idx="901">
                  <c:v>1.3821111111111111</c:v>
                </c:pt>
                <c:pt idx="902">
                  <c:v>1.3822986111111111</c:v>
                </c:pt>
                <c:pt idx="903">
                  <c:v>1.3824861111111111</c:v>
                </c:pt>
                <c:pt idx="904">
                  <c:v>1.3826736111111111</c:v>
                </c:pt>
                <c:pt idx="905">
                  <c:v>1.3828611111111111</c:v>
                </c:pt>
                <c:pt idx="906">
                  <c:v>1.3830763888888891</c:v>
                </c:pt>
                <c:pt idx="907">
                  <c:v>1.3832847222222222</c:v>
                </c:pt>
                <c:pt idx="908">
                  <c:v>1.3835</c:v>
                </c:pt>
                <c:pt idx="909">
                  <c:v>1.3837152777777777</c:v>
                </c:pt>
                <c:pt idx="910">
                  <c:v>1.3839236111111111</c:v>
                </c:pt>
                <c:pt idx="911">
                  <c:v>1.384138888888889</c:v>
                </c:pt>
                <c:pt idx="912">
                  <c:v>1.3843541666666668</c:v>
                </c:pt>
                <c:pt idx="913">
                  <c:v>1.3845624999999999</c:v>
                </c:pt>
                <c:pt idx="914">
                  <c:v>1.3847777777777777</c:v>
                </c:pt>
                <c:pt idx="915">
                  <c:v>1.3850208333333334</c:v>
                </c:pt>
                <c:pt idx="916">
                  <c:v>1.3852638888888889</c:v>
                </c:pt>
                <c:pt idx="917">
                  <c:v>1.3855069444444446</c:v>
                </c:pt>
                <c:pt idx="918">
                  <c:v>1.38575</c:v>
                </c:pt>
                <c:pt idx="919">
                  <c:v>1.3859930555555555</c:v>
                </c:pt>
                <c:pt idx="920">
                  <c:v>1.3862361111111112</c:v>
                </c:pt>
                <c:pt idx="921">
                  <c:v>1.3865138888888888</c:v>
                </c:pt>
                <c:pt idx="922">
                  <c:v>1.3867847222222223</c:v>
                </c:pt>
                <c:pt idx="923">
                  <c:v>1.3870624999999999</c:v>
                </c:pt>
                <c:pt idx="924">
                  <c:v>1.3873402777777777</c:v>
                </c:pt>
                <c:pt idx="925">
                  <c:v>1.3876180555555555</c:v>
                </c:pt>
                <c:pt idx="926">
                  <c:v>1.3878958333333333</c:v>
                </c:pt>
                <c:pt idx="927">
                  <c:v>1.3882152777777779</c:v>
                </c:pt>
                <c:pt idx="928">
                  <c:v>1.3885347222222222</c:v>
                </c:pt>
                <c:pt idx="929">
                  <c:v>1.3888541666666667</c:v>
                </c:pt>
                <c:pt idx="930">
                  <c:v>1.3891736111111113</c:v>
                </c:pt>
                <c:pt idx="931">
                  <c:v>1.3894930555555556</c:v>
                </c:pt>
                <c:pt idx="932">
                  <c:v>1.3898124999999999</c:v>
                </c:pt>
                <c:pt idx="933">
                  <c:v>1.3901874999999999</c:v>
                </c:pt>
                <c:pt idx="934">
                  <c:v>1.3905625000000001</c:v>
                </c:pt>
                <c:pt idx="935">
                  <c:v>1.3909444444444445</c:v>
                </c:pt>
                <c:pt idx="936">
                  <c:v>1.3913194444444446</c:v>
                </c:pt>
                <c:pt idx="937">
                  <c:v>1.3916944444444443</c:v>
                </c:pt>
                <c:pt idx="938">
                  <c:v>1.3920763888888887</c:v>
                </c:pt>
                <c:pt idx="939">
                  <c:v>1.3925347222222222</c:v>
                </c:pt>
                <c:pt idx="940">
                  <c:v>1.393</c:v>
                </c:pt>
                <c:pt idx="941">
                  <c:v>1.3934583333333332</c:v>
                </c:pt>
                <c:pt idx="942">
                  <c:v>1.3939236111111111</c:v>
                </c:pt>
                <c:pt idx="943">
                  <c:v>1.3943888888888889</c:v>
                </c:pt>
                <c:pt idx="944">
                  <c:v>1.3948472222222221</c:v>
                </c:pt>
                <c:pt idx="945">
                  <c:v>1.3954375000000001</c:v>
                </c:pt>
                <c:pt idx="946">
                  <c:v>1.3960208333333333</c:v>
                </c:pt>
                <c:pt idx="947">
                  <c:v>1.3966041666666666</c:v>
                </c:pt>
                <c:pt idx="948">
                  <c:v>1.3971875</c:v>
                </c:pt>
                <c:pt idx="949">
                  <c:v>1.3977708333333334</c:v>
                </c:pt>
                <c:pt idx="950">
                  <c:v>1.3983611111111112</c:v>
                </c:pt>
                <c:pt idx="951">
                  <c:v>1.3991458333333333</c:v>
                </c:pt>
                <c:pt idx="952">
                  <c:v>1.3999375000000001</c:v>
                </c:pt>
                <c:pt idx="953">
                  <c:v>1.4007291666666666</c:v>
                </c:pt>
                <c:pt idx="954">
                  <c:v>1.4015208333333333</c:v>
                </c:pt>
                <c:pt idx="955">
                  <c:v>1.4023055555555555</c:v>
                </c:pt>
                <c:pt idx="956">
                  <c:v>1.4030972222222222</c:v>
                </c:pt>
                <c:pt idx="957">
                  <c:v>1.4042430555555554</c:v>
                </c:pt>
                <c:pt idx="958">
                  <c:v>1.4053819444444444</c:v>
                </c:pt>
                <c:pt idx="959">
                  <c:v>1.4065277777777778</c:v>
                </c:pt>
                <c:pt idx="960">
                  <c:v>1.407673611111111</c:v>
                </c:pt>
                <c:pt idx="961">
                  <c:v>1.4088125</c:v>
                </c:pt>
                <c:pt idx="962">
                  <c:v>1.4099583333333332</c:v>
                </c:pt>
                <c:pt idx="963">
                  <c:v>1.4113611111111111</c:v>
                </c:pt>
                <c:pt idx="964">
                  <c:v>1.4127569444444443</c:v>
                </c:pt>
                <c:pt idx="965">
                  <c:v>1.4141597222222222</c:v>
                </c:pt>
                <c:pt idx="966">
                  <c:v>1.4155625000000001</c:v>
                </c:pt>
                <c:pt idx="967">
                  <c:v>1.4169583333333333</c:v>
                </c:pt>
                <c:pt idx="968">
                  <c:v>1.4183611111111112</c:v>
                </c:pt>
                <c:pt idx="969">
                  <c:v>1.4197638888888888</c:v>
                </c:pt>
                <c:pt idx="970">
                  <c:v>1.4211597222222223</c:v>
                </c:pt>
                <c:pt idx="971">
                  <c:v>1.4225625</c:v>
                </c:pt>
                <c:pt idx="972">
                  <c:v>1.423965277777778</c:v>
                </c:pt>
                <c:pt idx="973">
                  <c:v>1.4242152777777777</c:v>
                </c:pt>
                <c:pt idx="974">
                  <c:v>1.4244583333333332</c:v>
                </c:pt>
                <c:pt idx="975">
                  <c:v>1.4247083333333332</c:v>
                </c:pt>
                <c:pt idx="976">
                  <c:v>1.4249583333333333</c:v>
                </c:pt>
                <c:pt idx="977">
                  <c:v>1.4252083333333334</c:v>
                </c:pt>
                <c:pt idx="978">
                  <c:v>1.425659722222222</c:v>
                </c:pt>
                <c:pt idx="979">
                  <c:v>1.4261041666666667</c:v>
                </c:pt>
                <c:pt idx="980">
                  <c:v>1.4265555555555554</c:v>
                </c:pt>
                <c:pt idx="981">
                  <c:v>1.4270069444444444</c:v>
                </c:pt>
                <c:pt idx="982">
                  <c:v>1.4281388888888888</c:v>
                </c:pt>
                <c:pt idx="983">
                  <c:v>1.4292638888888889</c:v>
                </c:pt>
                <c:pt idx="984">
                  <c:v>1.4303958333333333</c:v>
                </c:pt>
                <c:pt idx="985">
                  <c:v>1.4315208333333334</c:v>
                </c:pt>
                <c:pt idx="986">
                  <c:v>1.4332500000000001</c:v>
                </c:pt>
                <c:pt idx="987">
                  <c:v>1.4349722222222223</c:v>
                </c:pt>
                <c:pt idx="988">
                  <c:v>1.4366944444444445</c:v>
                </c:pt>
                <c:pt idx="989">
                  <c:v>1.4384166666666667</c:v>
                </c:pt>
                <c:pt idx="990">
                  <c:v>1.4401388888888891</c:v>
                </c:pt>
                <c:pt idx="991">
                  <c:v>1.4421180555555557</c:v>
                </c:pt>
                <c:pt idx="992">
                  <c:v>1.4440902777777775</c:v>
                </c:pt>
                <c:pt idx="993">
                  <c:v>1.4460694444444446</c:v>
                </c:pt>
                <c:pt idx="994">
                  <c:v>1.4480416666666664</c:v>
                </c:pt>
                <c:pt idx="995">
                  <c:v>1.4500208333333335</c:v>
                </c:pt>
                <c:pt idx="996">
                  <c:v>1.4525625</c:v>
                </c:pt>
                <c:pt idx="997">
                  <c:v>1.4551041666666666</c:v>
                </c:pt>
                <c:pt idx="998">
                  <c:v>1.4576458333333335</c:v>
                </c:pt>
                <c:pt idx="999">
                  <c:v>1.4601875</c:v>
                </c:pt>
                <c:pt idx="1000">
                  <c:v>1.4627291666666666</c:v>
                </c:pt>
                <c:pt idx="1001">
                  <c:v>1.4661388888888887</c:v>
                </c:pt>
                <c:pt idx="1002">
                  <c:v>1.4695486111111111</c:v>
                </c:pt>
                <c:pt idx="1003">
                  <c:v>1.4729583333333334</c:v>
                </c:pt>
                <c:pt idx="1004">
                  <c:v>1.4763611111111112</c:v>
                </c:pt>
                <c:pt idx="1005">
                  <c:v>1.4797708333333333</c:v>
                </c:pt>
                <c:pt idx="1006">
                  <c:v>1.4837916666666666</c:v>
                </c:pt>
                <c:pt idx="1007">
                  <c:v>1.4878055555555556</c:v>
                </c:pt>
                <c:pt idx="1008">
                  <c:v>1.491826388888889</c:v>
                </c:pt>
                <c:pt idx="1009">
                  <c:v>1.4958402777777779</c:v>
                </c:pt>
                <c:pt idx="1010">
                  <c:v>1.4998611111111113</c:v>
                </c:pt>
                <c:pt idx="1011">
                  <c:v>1.5038749999999999</c:v>
                </c:pt>
                <c:pt idx="1012">
                  <c:v>1.5093888888888889</c:v>
                </c:pt>
                <c:pt idx="1013">
                  <c:v>1.5149027777777777</c:v>
                </c:pt>
                <c:pt idx="1014">
                  <c:v>1.5204166666666667</c:v>
                </c:pt>
                <c:pt idx="1015">
                  <c:v>1.525923611111111</c:v>
                </c:pt>
                <c:pt idx="1016">
                  <c:v>1.5314375</c:v>
                </c:pt>
                <c:pt idx="1017">
                  <c:v>1.5369513888888888</c:v>
                </c:pt>
                <c:pt idx="1018">
                  <c:v>1.5433263888888888</c:v>
                </c:pt>
                <c:pt idx="1019">
                  <c:v>1.5497013888888891</c:v>
                </c:pt>
                <c:pt idx="1020">
                  <c:v>1.5560763888888889</c:v>
                </c:pt>
                <c:pt idx="1021">
                  <c:v>1.5624444444444445</c:v>
                </c:pt>
                <c:pt idx="1022">
                  <c:v>1.5688194444444443</c:v>
                </c:pt>
                <c:pt idx="1023">
                  <c:v>1.5751944444444446</c:v>
                </c:pt>
                <c:pt idx="1024">
                  <c:v>1.5815694444444444</c:v>
                </c:pt>
                <c:pt idx="1025">
                  <c:v>1.5879444444444444</c:v>
                </c:pt>
                <c:pt idx="1026">
                  <c:v>1.5943194444444446</c:v>
                </c:pt>
                <c:pt idx="1027">
                  <c:v>1.6006944444444444</c:v>
                </c:pt>
                <c:pt idx="1028">
                  <c:v>1.6070694444444444</c:v>
                </c:pt>
                <c:pt idx="1029">
                  <c:v>1.6134374999999999</c:v>
                </c:pt>
                <c:pt idx="1030">
                  <c:v>1.6205069444444447</c:v>
                </c:pt>
                <c:pt idx="1031">
                  <c:v>1.627576388888889</c:v>
                </c:pt>
                <c:pt idx="1032">
                  <c:v>1.6334027777777778</c:v>
                </c:pt>
                <c:pt idx="1033">
                  <c:v>1.6392361111111111</c:v>
                </c:pt>
                <c:pt idx="1034">
                  <c:v>1.6450624999999999</c:v>
                </c:pt>
                <c:pt idx="1035">
                  <c:v>1.6508958333333332</c:v>
                </c:pt>
                <c:pt idx="1036">
                  <c:v>1.6567291666666668</c:v>
                </c:pt>
                <c:pt idx="1037">
                  <c:v>1.6576458333333335</c:v>
                </c:pt>
                <c:pt idx="1038">
                  <c:v>1.6585624999999999</c:v>
                </c:pt>
                <c:pt idx="1039">
                  <c:v>1.659486111111111</c:v>
                </c:pt>
                <c:pt idx="1040">
                  <c:v>1.6604027777777779</c:v>
                </c:pt>
                <c:pt idx="1041">
                  <c:v>1.6613194444444446</c:v>
                </c:pt>
                <c:pt idx="1042">
                  <c:v>1.6630694444444445</c:v>
                </c:pt>
                <c:pt idx="1043">
                  <c:v>1.6648263888888888</c:v>
                </c:pt>
                <c:pt idx="1044">
                  <c:v>1.6665763888888887</c:v>
                </c:pt>
                <c:pt idx="1045">
                  <c:v>1.6683263888888888</c:v>
                </c:pt>
                <c:pt idx="1046">
                  <c:v>1.6712361111111111</c:v>
                </c:pt>
                <c:pt idx="1047">
                  <c:v>1.6741527777777778</c:v>
                </c:pt>
                <c:pt idx="1048">
                  <c:v>1.6770624999999999</c:v>
                </c:pt>
                <c:pt idx="1049">
                  <c:v>1.6799722222222222</c:v>
                </c:pt>
                <c:pt idx="1050">
                  <c:v>1.6828888888888889</c:v>
                </c:pt>
                <c:pt idx="1051">
                  <c:v>1.687201388888889</c:v>
                </c:pt>
                <c:pt idx="1052">
                  <c:v>1.6915208333333334</c:v>
                </c:pt>
                <c:pt idx="1053">
                  <c:v>1.6958402777777779</c:v>
                </c:pt>
                <c:pt idx="1054">
                  <c:v>1.7001527777777776</c:v>
                </c:pt>
                <c:pt idx="1055">
                  <c:v>1.7044722222222222</c:v>
                </c:pt>
                <c:pt idx="1056">
                  <c:v>1.710951388888889</c:v>
                </c:pt>
                <c:pt idx="1057">
                  <c:v>1.7174236111111112</c:v>
                </c:pt>
                <c:pt idx="1058">
                  <c:v>1.7239027777777778</c:v>
                </c:pt>
                <c:pt idx="1059">
                  <c:v>1.7303749999999998</c:v>
                </c:pt>
                <c:pt idx="1060">
                  <c:v>1.7368541666666668</c:v>
                </c:pt>
                <c:pt idx="1061">
                  <c:v>1.7433333333333334</c:v>
                </c:pt>
                <c:pt idx="1062">
                  <c:v>1.7514791666666667</c:v>
                </c:pt>
                <c:pt idx="1063">
                  <c:v>1.759625</c:v>
                </c:pt>
                <c:pt idx="1064">
                  <c:v>1.7677708333333335</c:v>
                </c:pt>
                <c:pt idx="1065">
                  <c:v>1.7759166666666668</c:v>
                </c:pt>
                <c:pt idx="1066">
                  <c:v>1.7840625000000001</c:v>
                </c:pt>
                <c:pt idx="1067">
                  <c:v>1.7922083333333334</c:v>
                </c:pt>
                <c:pt idx="1068">
                  <c:v>1.8003541666666669</c:v>
                </c:pt>
                <c:pt idx="1069">
                  <c:v>1.8084999999999998</c:v>
                </c:pt>
                <c:pt idx="1070">
                  <c:v>1.8166458333333333</c:v>
                </c:pt>
                <c:pt idx="1071">
                  <c:v>1.8247916666666666</c:v>
                </c:pt>
                <c:pt idx="1072">
                  <c:v>1.8310763888888888</c:v>
                </c:pt>
                <c:pt idx="1073">
                  <c:v>1.8319930555555557</c:v>
                </c:pt>
                <c:pt idx="1074">
                  <c:v>1.8329097222222221</c:v>
                </c:pt>
                <c:pt idx="1075">
                  <c:v>1.8338263888888888</c:v>
                </c:pt>
                <c:pt idx="1076">
                  <c:v>1.8347361111111111</c:v>
                </c:pt>
                <c:pt idx="1077">
                  <c:v>1.8356527777777778</c:v>
                </c:pt>
                <c:pt idx="1078">
                  <c:v>1.8373541666666666</c:v>
                </c:pt>
                <c:pt idx="1079">
                  <c:v>1.8390555555555554</c:v>
                </c:pt>
                <c:pt idx="1080">
                  <c:v>1.8407569444444445</c:v>
                </c:pt>
                <c:pt idx="1081">
                  <c:v>1.8424583333333333</c:v>
                </c:pt>
                <c:pt idx="1082">
                  <c:v>1.8441597222222224</c:v>
                </c:pt>
                <c:pt idx="1083">
                  <c:v>1.8472152777777777</c:v>
                </c:pt>
                <c:pt idx="1084">
                  <c:v>1.8502777777777779</c:v>
                </c:pt>
                <c:pt idx="1085">
                  <c:v>1.8533333333333335</c:v>
                </c:pt>
                <c:pt idx="1086">
                  <c:v>1.8563888888888889</c:v>
                </c:pt>
                <c:pt idx="1087">
                  <c:v>1.8594444444444445</c:v>
                </c:pt>
                <c:pt idx="1088">
                  <c:v>1.864625</c:v>
                </c:pt>
                <c:pt idx="1089">
                  <c:v>1.8697986111111113</c:v>
                </c:pt>
                <c:pt idx="1090">
                  <c:v>1.8749791666666664</c:v>
                </c:pt>
                <c:pt idx="1091">
                  <c:v>1.8801597222222222</c:v>
                </c:pt>
                <c:pt idx="1092">
                  <c:v>1.8853333333333333</c:v>
                </c:pt>
                <c:pt idx="1093">
                  <c:v>1.8915208333333333</c:v>
                </c:pt>
                <c:pt idx="1094">
                  <c:v>1.8977083333333331</c:v>
                </c:pt>
                <c:pt idx="1095">
                  <c:v>1.9038958333333333</c:v>
                </c:pt>
                <c:pt idx="1096">
                  <c:v>1.9100833333333334</c:v>
                </c:pt>
                <c:pt idx="1097">
                  <c:v>1.9162708333333331</c:v>
                </c:pt>
                <c:pt idx="1098">
                  <c:v>1.9224583333333334</c:v>
                </c:pt>
                <c:pt idx="1099">
                  <c:v>1.9301527777777778</c:v>
                </c:pt>
                <c:pt idx="1100">
                  <c:v>1.9378402777777777</c:v>
                </c:pt>
                <c:pt idx="1101">
                  <c:v>1.9455347222222223</c:v>
                </c:pt>
                <c:pt idx="1102">
                  <c:v>1.9532222222222222</c:v>
                </c:pt>
                <c:pt idx="1103">
                  <c:v>1.9609166666666664</c:v>
                </c:pt>
                <c:pt idx="1104">
                  <c:v>1.9686041666666667</c:v>
                </c:pt>
                <c:pt idx="1105">
                  <c:v>1.9772013888888889</c:v>
                </c:pt>
                <c:pt idx="1106">
                  <c:v>1.9857986111111112</c:v>
                </c:pt>
                <c:pt idx="1107">
                  <c:v>1.9944027777777777</c:v>
                </c:pt>
                <c:pt idx="1108">
                  <c:v>2.0030000000000001</c:v>
                </c:pt>
                <c:pt idx="1109">
                  <c:v>2.011597222222222</c:v>
                </c:pt>
                <c:pt idx="1110">
                  <c:v>2.0201944444444444</c:v>
                </c:pt>
                <c:pt idx="1111">
                  <c:v>2.0287986111111111</c:v>
                </c:pt>
                <c:pt idx="1112">
                  <c:v>2.0373958333333331</c:v>
                </c:pt>
                <c:pt idx="1113">
                  <c:v>2.0459930555555554</c:v>
                </c:pt>
                <c:pt idx="1114">
                  <c:v>2.0545902777777778</c:v>
                </c:pt>
                <c:pt idx="1115">
                  <c:v>2.0631874999999997</c:v>
                </c:pt>
                <c:pt idx="1116">
                  <c:v>2.0717916666666669</c:v>
                </c:pt>
                <c:pt idx="1117">
                  <c:v>2.0803888888888888</c:v>
                </c:pt>
                <c:pt idx="1118">
                  <c:v>2.0889861111111112</c:v>
                </c:pt>
                <c:pt idx="1119">
                  <c:v>2.0975833333333331</c:v>
                </c:pt>
                <c:pt idx="1120">
                  <c:v>2.1061874999999999</c:v>
                </c:pt>
                <c:pt idx="1121">
                  <c:v>2.1147847222222222</c:v>
                </c:pt>
                <c:pt idx="1122">
                  <c:v>2.1233819444444446</c:v>
                </c:pt>
                <c:pt idx="1123">
                  <c:v>2.131979166666667</c:v>
                </c:pt>
                <c:pt idx="1124">
                  <c:v>2.1405763888888889</c:v>
                </c:pt>
                <c:pt idx="1125">
                  <c:v>2.1491805555555556</c:v>
                </c:pt>
                <c:pt idx="1126">
                  <c:v>2.1577777777777776</c:v>
                </c:pt>
                <c:pt idx="1127">
                  <c:v>2.1663749999999999</c:v>
                </c:pt>
                <c:pt idx="1128">
                  <c:v>2.1749722222222223</c:v>
                </c:pt>
                <c:pt idx="1129">
                  <c:v>2.1835763888888886</c:v>
                </c:pt>
                <c:pt idx="1130">
                  <c:v>2.192173611111111</c:v>
                </c:pt>
                <c:pt idx="1131">
                  <c:v>2.2007708333333333</c:v>
                </c:pt>
                <c:pt idx="1132">
                  <c:v>2.2105972222222223</c:v>
                </c:pt>
                <c:pt idx="1133">
                  <c:v>2.2204166666666669</c:v>
                </c:pt>
                <c:pt idx="1134">
                  <c:v>2.2284791666666668</c:v>
                </c:pt>
                <c:pt idx="1135">
                  <c:v>2.2350902777777781</c:v>
                </c:pt>
                <c:pt idx="1136">
                  <c:v>2.2416944444444442</c:v>
                </c:pt>
                <c:pt idx="1137">
                  <c:v>2.2483055555555556</c:v>
                </c:pt>
                <c:pt idx="1138">
                  <c:v>2.2549097222222225</c:v>
                </c:pt>
                <c:pt idx="1139">
                  <c:v>2.2602569444444445</c:v>
                </c:pt>
                <c:pt idx="1140">
                  <c:v>2.2610833333333336</c:v>
                </c:pt>
                <c:pt idx="1141">
                  <c:v>2.2619097222222222</c:v>
                </c:pt>
                <c:pt idx="1142">
                  <c:v>2.2627361111111113</c:v>
                </c:pt>
                <c:pt idx="1143">
                  <c:v>2.2635555555555555</c:v>
                </c:pt>
                <c:pt idx="1144">
                  <c:v>2.2652083333333333</c:v>
                </c:pt>
                <c:pt idx="1145">
                  <c:v>2.2668541666666666</c:v>
                </c:pt>
                <c:pt idx="1146">
                  <c:v>2.2685</c:v>
                </c:pt>
                <c:pt idx="1147">
                  <c:v>2.2710624999999998</c:v>
                </c:pt>
                <c:pt idx="1148">
                  <c:v>2.2736319444444444</c:v>
                </c:pt>
                <c:pt idx="1149">
                  <c:v>2.2761944444444442</c:v>
                </c:pt>
                <c:pt idx="1150">
                  <c:v>2.2787638888888888</c:v>
                </c:pt>
                <c:pt idx="1151">
                  <c:v>2.2824166666666668</c:v>
                </c:pt>
                <c:pt idx="1152">
                  <c:v>2.2860763888888886</c:v>
                </c:pt>
                <c:pt idx="1153">
                  <c:v>2.289736111111111</c:v>
                </c:pt>
                <c:pt idx="1154">
                  <c:v>2.2933888888888889</c:v>
                </c:pt>
                <c:pt idx="1155">
                  <c:v>2.3019513888888889</c:v>
                </c:pt>
                <c:pt idx="1156">
                  <c:v>2.310513888888889</c:v>
                </c:pt>
                <c:pt idx="1157">
                  <c:v>2.3190763888888886</c:v>
                </c:pt>
                <c:pt idx="1158">
                  <c:v>2.327638888888889</c:v>
                </c:pt>
                <c:pt idx="1159">
                  <c:v>2.3362013888888891</c:v>
                </c:pt>
                <c:pt idx="1160">
                  <c:v>2.3447638888888891</c:v>
                </c:pt>
                <c:pt idx="1161">
                  <c:v>2.3533263888888887</c:v>
                </c:pt>
                <c:pt idx="1162">
                  <c:v>2.3618888888888887</c:v>
                </c:pt>
                <c:pt idx="1163">
                  <c:v>2.372798611111111</c:v>
                </c:pt>
                <c:pt idx="1164">
                  <c:v>2.3837013888888889</c:v>
                </c:pt>
                <c:pt idx="1165">
                  <c:v>2.3946111111111108</c:v>
                </c:pt>
                <c:pt idx="1166">
                  <c:v>2.4055208333333331</c:v>
                </c:pt>
                <c:pt idx="1167">
                  <c:v>2.416423611111111</c:v>
                </c:pt>
                <c:pt idx="1168">
                  <c:v>2.4273333333333333</c:v>
                </c:pt>
                <c:pt idx="1169">
                  <c:v>2.4420208333333333</c:v>
                </c:pt>
                <c:pt idx="1170">
                  <c:v>2.4567083333333333</c:v>
                </c:pt>
                <c:pt idx="1171">
                  <c:v>2.4713958333333332</c:v>
                </c:pt>
                <c:pt idx="1172">
                  <c:v>2.4860763888888888</c:v>
                </c:pt>
                <c:pt idx="1173">
                  <c:v>2.5007638888888888</c:v>
                </c:pt>
                <c:pt idx="1174">
                  <c:v>2.5154513888888888</c:v>
                </c:pt>
                <c:pt idx="1175">
                  <c:v>2.5364097222222219</c:v>
                </c:pt>
                <c:pt idx="1176">
                  <c:v>2.5573611111111112</c:v>
                </c:pt>
                <c:pt idx="1177">
                  <c:v>2.5783194444444444</c:v>
                </c:pt>
                <c:pt idx="1178">
                  <c:v>2.5992708333333332</c:v>
                </c:pt>
                <c:pt idx="1179">
                  <c:v>2.6202291666666668</c:v>
                </c:pt>
                <c:pt idx="1180">
                  <c:v>2.6411805555555556</c:v>
                </c:pt>
                <c:pt idx="1181">
                  <c:v>2.6662847222222221</c:v>
                </c:pt>
                <c:pt idx="1182">
                  <c:v>2.6913888888888886</c:v>
                </c:pt>
                <c:pt idx="1183">
                  <c:v>2.7164930555555555</c:v>
                </c:pt>
                <c:pt idx="1184">
                  <c:v>2.7416041666666664</c:v>
                </c:pt>
                <c:pt idx="1185">
                  <c:v>2.7667083333333333</c:v>
                </c:pt>
                <c:pt idx="1186">
                  <c:v>2.7918124999999998</c:v>
                </c:pt>
                <c:pt idx="1187">
                  <c:v>2.8257222222222222</c:v>
                </c:pt>
                <c:pt idx="1188">
                  <c:v>2.8596249999999999</c:v>
                </c:pt>
                <c:pt idx="1189">
                  <c:v>2.8935347222222219</c:v>
                </c:pt>
                <c:pt idx="1190">
                  <c:v>2.9274444444444447</c:v>
                </c:pt>
                <c:pt idx="1191">
                  <c:v>2.9613541666666667</c:v>
                </c:pt>
                <c:pt idx="1192">
                  <c:v>2.9952638888888892</c:v>
                </c:pt>
                <c:pt idx="1193">
                  <c:v>3.0404236111111111</c:v>
                </c:pt>
                <c:pt idx="1194">
                  <c:v>3.0855902777777779</c:v>
                </c:pt>
                <c:pt idx="1195">
                  <c:v>3.1307569444444443</c:v>
                </c:pt>
                <c:pt idx="1196">
                  <c:v>3.1759236111111111</c:v>
                </c:pt>
                <c:pt idx="1197">
                  <c:v>3.2210902777777779</c:v>
                </c:pt>
                <c:pt idx="1198">
                  <c:v>3.2662569444444443</c:v>
                </c:pt>
                <c:pt idx="1199">
                  <c:v>3.3193402777777781</c:v>
                </c:pt>
                <c:pt idx="1200">
                  <c:v>3.3626180555555556</c:v>
                </c:pt>
                <c:pt idx="1201">
                  <c:v>3.4059027777777779</c:v>
                </c:pt>
                <c:pt idx="1202">
                  <c:v>3.4396180555555556</c:v>
                </c:pt>
                <c:pt idx="1203">
                  <c:v>3.4733402777777775</c:v>
                </c:pt>
                <c:pt idx="1204">
                  <c:v>3.5006041666666667</c:v>
                </c:pt>
                <c:pt idx="1205">
                  <c:v>3.5278611111111111</c:v>
                </c:pt>
                <c:pt idx="1206">
                  <c:v>3.5551249999999999</c:v>
                </c:pt>
                <c:pt idx="1207">
                  <c:v>3.5774583333333334</c:v>
                </c:pt>
                <c:pt idx="1208">
                  <c:v>3.5997916666666665</c:v>
                </c:pt>
                <c:pt idx="1209">
                  <c:v>3.6221249999999996</c:v>
                </c:pt>
                <c:pt idx="1210">
                  <c:v>3.6406666666666672</c:v>
                </c:pt>
                <c:pt idx="1211">
                  <c:v>3.6592083333333334</c:v>
                </c:pt>
                <c:pt idx="1212">
                  <c:v>3.6777569444444445</c:v>
                </c:pt>
                <c:pt idx="1213">
                  <c:v>3.6962986111111111</c:v>
                </c:pt>
                <c:pt idx="1214">
                  <c:v>3.7115138888888888</c:v>
                </c:pt>
                <c:pt idx="1215">
                  <c:v>3.7267361111111112</c:v>
                </c:pt>
                <c:pt idx="1216">
                  <c:v>3.7419513888888889</c:v>
                </c:pt>
                <c:pt idx="1217">
                  <c:v>3.7571666666666665</c:v>
                </c:pt>
                <c:pt idx="1218">
                  <c:v>3.7723819444444442</c:v>
                </c:pt>
                <c:pt idx="1219">
                  <c:v>3.7850208333333337</c:v>
                </c:pt>
                <c:pt idx="1220">
                  <c:v>3.7976597222222224</c:v>
                </c:pt>
                <c:pt idx="1221">
                  <c:v>3.8103055555555558</c:v>
                </c:pt>
                <c:pt idx="1222">
                  <c:v>3.8229444444444445</c:v>
                </c:pt>
                <c:pt idx="1223">
                  <c:v>3.8355833333333331</c:v>
                </c:pt>
                <c:pt idx="1224">
                  <c:v>3.8482222222222218</c:v>
                </c:pt>
                <c:pt idx="1225">
                  <c:v>3.8608680555555552</c:v>
                </c:pt>
                <c:pt idx="1226">
                  <c:v>3.8713611111111113</c:v>
                </c:pt>
                <c:pt idx="1227">
                  <c:v>3.8818611111111112</c:v>
                </c:pt>
                <c:pt idx="1228">
                  <c:v>3.8923611111111112</c:v>
                </c:pt>
                <c:pt idx="1229">
                  <c:v>3.9028541666666663</c:v>
                </c:pt>
                <c:pt idx="1230">
                  <c:v>3.9133541666666662</c:v>
                </c:pt>
                <c:pt idx="1231">
                  <c:v>3.9238541666666671</c:v>
                </c:pt>
                <c:pt idx="1232">
                  <c:v>3.9343472222222222</c:v>
                </c:pt>
                <c:pt idx="1233">
                  <c:v>3.9448472222222222</c:v>
                </c:pt>
                <c:pt idx="1234">
                  <c:v>3.9553472222222221</c:v>
                </c:pt>
                <c:pt idx="1235">
                  <c:v>3.9658402777777781</c:v>
                </c:pt>
                <c:pt idx="1236">
                  <c:v>3.9763402777777781</c:v>
                </c:pt>
                <c:pt idx="1237">
                  <c:v>3.9868402777777781</c:v>
                </c:pt>
                <c:pt idx="1238">
                  <c:v>3.997340277777778</c:v>
                </c:pt>
                <c:pt idx="1239">
                  <c:v>4.0060763888888893</c:v>
                </c:pt>
                <c:pt idx="1240">
                  <c:v>4.0148194444444449</c:v>
                </c:pt>
                <c:pt idx="1241">
                  <c:v>4.0235625000000006</c:v>
                </c:pt>
                <c:pt idx="1242">
                  <c:v>4.032298611111111</c:v>
                </c:pt>
                <c:pt idx="1243">
                  <c:v>4.0410416666666666</c:v>
                </c:pt>
                <c:pt idx="1244">
                  <c:v>4.0497847222222223</c:v>
                </c:pt>
                <c:pt idx="1245">
                  <c:v>4.0585208333333336</c:v>
                </c:pt>
                <c:pt idx="1246">
                  <c:v>4.0672638888888883</c:v>
                </c:pt>
                <c:pt idx="1247">
                  <c:v>4.076006944444444</c:v>
                </c:pt>
                <c:pt idx="1248">
                  <c:v>4.0773124999999997</c:v>
                </c:pt>
                <c:pt idx="1249">
                  <c:v>4.0786250000000006</c:v>
                </c:pt>
                <c:pt idx="1250">
                  <c:v>4.0799305555555554</c:v>
                </c:pt>
                <c:pt idx="1251">
                  <c:v>4.0812430555555554</c:v>
                </c:pt>
                <c:pt idx="1252">
                  <c:v>4.0825486111111111</c:v>
                </c:pt>
                <c:pt idx="1253">
                  <c:v>4.0838611111111112</c:v>
                </c:pt>
                <c:pt idx="1254">
                  <c:v>4.0864513888888885</c:v>
                </c:pt>
                <c:pt idx="1255">
                  <c:v>4.0890416666666667</c:v>
                </c:pt>
                <c:pt idx="1256">
                  <c:v>4.091631944444444</c:v>
                </c:pt>
                <c:pt idx="1257">
                  <c:v>4.0942222222222222</c:v>
                </c:pt>
                <c:pt idx="1258">
                  <c:v>4.0968124999999995</c:v>
                </c:pt>
                <c:pt idx="1259">
                  <c:v>4.1018541666666666</c:v>
                </c:pt>
                <c:pt idx="1260">
                  <c:v>4.1068958333333336</c:v>
                </c:pt>
                <c:pt idx="1261">
                  <c:v>4.1119374999999998</c:v>
                </c:pt>
                <c:pt idx="1262">
                  <c:v>4.1169861111111112</c:v>
                </c:pt>
                <c:pt idx="1263">
                  <c:v>4.1220277777777783</c:v>
                </c:pt>
                <c:pt idx="1264">
                  <c:v>4.1294722222222218</c:v>
                </c:pt>
                <c:pt idx="1265">
                  <c:v>4.1369236111111114</c:v>
                </c:pt>
                <c:pt idx="1266">
                  <c:v>4.1443680555555558</c:v>
                </c:pt>
                <c:pt idx="1267">
                  <c:v>4.1518194444444445</c:v>
                </c:pt>
                <c:pt idx="1268">
                  <c:v>4.1592638888888889</c:v>
                </c:pt>
                <c:pt idx="1269">
                  <c:v>4.1667083333333332</c:v>
                </c:pt>
                <c:pt idx="1270">
                  <c:v>4.174159722222222</c:v>
                </c:pt>
                <c:pt idx="1271">
                  <c:v>4.1816041666666672</c:v>
                </c:pt>
                <c:pt idx="1272">
                  <c:v>4.1890555555555551</c:v>
                </c:pt>
                <c:pt idx="1273">
                  <c:v>4.1974652777777779</c:v>
                </c:pt>
                <c:pt idx="1274">
                  <c:v>4.2058819444444442</c:v>
                </c:pt>
                <c:pt idx="1275">
                  <c:v>4.214291666666667</c:v>
                </c:pt>
                <c:pt idx="1276">
                  <c:v>4.2227083333333333</c:v>
                </c:pt>
                <c:pt idx="1277">
                  <c:v>4.2311249999999996</c:v>
                </c:pt>
                <c:pt idx="1278">
                  <c:v>4.2395347222222224</c:v>
                </c:pt>
                <c:pt idx="1279">
                  <c:v>4.2479513888888887</c:v>
                </c:pt>
                <c:pt idx="1280">
                  <c:v>4.2563611111111106</c:v>
                </c:pt>
                <c:pt idx="1281">
                  <c:v>4.2647777777777778</c:v>
                </c:pt>
                <c:pt idx="1282">
                  <c:v>4.2731875000000006</c:v>
                </c:pt>
                <c:pt idx="1283">
                  <c:v>4.2816041666666669</c:v>
                </c:pt>
                <c:pt idx="1284">
                  <c:v>4.2900138888888888</c:v>
                </c:pt>
                <c:pt idx="1285">
                  <c:v>4.2984305555555551</c:v>
                </c:pt>
                <c:pt idx="1286">
                  <c:v>4.3068472222222223</c:v>
                </c:pt>
                <c:pt idx="1287">
                  <c:v>4.3152569444444442</c:v>
                </c:pt>
                <c:pt idx="1288">
                  <c:v>4.3236736111111114</c:v>
                </c:pt>
                <c:pt idx="1289">
                  <c:v>4.3320833333333333</c:v>
                </c:pt>
                <c:pt idx="1290">
                  <c:v>4.3404999999999996</c:v>
                </c:pt>
                <c:pt idx="1291">
                  <c:v>4.3489097222222224</c:v>
                </c:pt>
                <c:pt idx="1292">
                  <c:v>4.3573263888888887</c:v>
                </c:pt>
                <c:pt idx="1293">
                  <c:v>4.3657361111111106</c:v>
                </c:pt>
                <c:pt idx="1294">
                  <c:v>4.3741527777777778</c:v>
                </c:pt>
                <c:pt idx="1295">
                  <c:v>4.3825694444444441</c:v>
                </c:pt>
                <c:pt idx="1296">
                  <c:v>4.3909791666666669</c:v>
                </c:pt>
                <c:pt idx="1297">
                  <c:v>4.3993958333333332</c:v>
                </c:pt>
                <c:pt idx="1298">
                  <c:v>4.4078055555555551</c:v>
                </c:pt>
                <c:pt idx="1299">
                  <c:v>4.4162222222222223</c:v>
                </c:pt>
                <c:pt idx="1300">
                  <c:v>4.4246319444444442</c:v>
                </c:pt>
                <c:pt idx="1301">
                  <c:v>4.4330486111111114</c:v>
                </c:pt>
                <c:pt idx="1302">
                  <c:v>4.4414583333333333</c:v>
                </c:pt>
                <c:pt idx="1303">
                  <c:v>4.4498749999999996</c:v>
                </c:pt>
                <c:pt idx="1304">
                  <c:v>4.4582916666666668</c:v>
                </c:pt>
                <c:pt idx="1305">
                  <c:v>4.4667013888888887</c:v>
                </c:pt>
                <c:pt idx="1306">
                  <c:v>4.4751180555555559</c:v>
                </c:pt>
                <c:pt idx="1307">
                  <c:v>4.4835277777777778</c:v>
                </c:pt>
                <c:pt idx="1308">
                  <c:v>4.4919444444444441</c:v>
                </c:pt>
                <c:pt idx="1309">
                  <c:v>4.5003541666666669</c:v>
                </c:pt>
                <c:pt idx="1310">
                  <c:v>4.5087708333333332</c:v>
                </c:pt>
                <c:pt idx="1311">
                  <c:v>4.5171805555555551</c:v>
                </c:pt>
                <c:pt idx="1312">
                  <c:v>4.5255972222222223</c:v>
                </c:pt>
                <c:pt idx="1313">
                  <c:v>4.5340138888888886</c:v>
                </c:pt>
                <c:pt idx="1314">
                  <c:v>4.5424236111111114</c:v>
                </c:pt>
                <c:pt idx="1315">
                  <c:v>4.5508402777777777</c:v>
                </c:pt>
                <c:pt idx="1316">
                  <c:v>4.5592499999999996</c:v>
                </c:pt>
                <c:pt idx="1317">
                  <c:v>4.5676666666666668</c:v>
                </c:pt>
                <c:pt idx="1318">
                  <c:v>4.5760763888888887</c:v>
                </c:pt>
                <c:pt idx="1319">
                  <c:v>4.5844930555555559</c:v>
                </c:pt>
                <c:pt idx="1320">
                  <c:v>4.5929027777777778</c:v>
                </c:pt>
                <c:pt idx="1321">
                  <c:v>4.6013194444444441</c:v>
                </c:pt>
                <c:pt idx="1322">
                  <c:v>4.6097361111111113</c:v>
                </c:pt>
                <c:pt idx="1323">
                  <c:v>4.6181458333333332</c:v>
                </c:pt>
                <c:pt idx="1324">
                  <c:v>4.6265625000000004</c:v>
                </c:pt>
                <c:pt idx="1325">
                  <c:v>4.6349722222222223</c:v>
                </c:pt>
                <c:pt idx="1326">
                  <c:v>4.6433888888888886</c:v>
                </c:pt>
                <c:pt idx="1327">
                  <c:v>4.6517986111111114</c:v>
                </c:pt>
                <c:pt idx="1328">
                  <c:v>4.6602152777777777</c:v>
                </c:pt>
                <c:pt idx="1329">
                  <c:v>4.6686249999999996</c:v>
                </c:pt>
                <c:pt idx="1330">
                  <c:v>4.6770416666666668</c:v>
                </c:pt>
                <c:pt idx="1331">
                  <c:v>4.6854583333333339</c:v>
                </c:pt>
                <c:pt idx="1332">
                  <c:v>4.6938680555555559</c:v>
                </c:pt>
                <c:pt idx="1333">
                  <c:v>4.7022847222222222</c:v>
                </c:pt>
                <c:pt idx="1334">
                  <c:v>4.7106944444444441</c:v>
                </c:pt>
                <c:pt idx="1335">
                  <c:v>4.7191111111111113</c:v>
                </c:pt>
                <c:pt idx="1336">
                  <c:v>4.7275208333333332</c:v>
                </c:pt>
                <c:pt idx="1337">
                  <c:v>4.7359375000000004</c:v>
                </c:pt>
                <c:pt idx="1338">
                  <c:v>4.7443472222222223</c:v>
                </c:pt>
                <c:pt idx="1339">
                  <c:v>4.7527638888888886</c:v>
                </c:pt>
                <c:pt idx="1340">
                  <c:v>4.7611805555555557</c:v>
                </c:pt>
                <c:pt idx="1341">
                  <c:v>4.7695902777777777</c:v>
                </c:pt>
                <c:pt idx="1342">
                  <c:v>4.778006944444444</c:v>
                </c:pt>
                <c:pt idx="1343">
                  <c:v>4.7864166666666668</c:v>
                </c:pt>
                <c:pt idx="1344">
                  <c:v>4.7948333333333339</c:v>
                </c:pt>
                <c:pt idx="1345">
                  <c:v>4.8032430555555559</c:v>
                </c:pt>
                <c:pt idx="1346">
                  <c:v>4.8116597222222222</c:v>
                </c:pt>
                <c:pt idx="1347">
                  <c:v>4.8200694444444441</c:v>
                </c:pt>
                <c:pt idx="1348">
                  <c:v>4.8284861111111113</c:v>
                </c:pt>
                <c:pt idx="1349">
                  <c:v>4.8369027777777784</c:v>
                </c:pt>
                <c:pt idx="1350">
                  <c:v>4.8453125000000004</c:v>
                </c:pt>
                <c:pt idx="1351">
                  <c:v>4.8537291666666667</c:v>
                </c:pt>
                <c:pt idx="1352">
                  <c:v>4.8621388888888886</c:v>
                </c:pt>
                <c:pt idx="1353">
                  <c:v>4.8705555555555557</c:v>
                </c:pt>
                <c:pt idx="1354">
                  <c:v>4.8789652777777777</c:v>
                </c:pt>
                <c:pt idx="1355">
                  <c:v>4.887381944444444</c:v>
                </c:pt>
                <c:pt idx="1356">
                  <c:v>4.8957916666666668</c:v>
                </c:pt>
                <c:pt idx="1357">
                  <c:v>4.9042083333333339</c:v>
                </c:pt>
                <c:pt idx="1358">
                  <c:v>4.9126250000000002</c:v>
                </c:pt>
                <c:pt idx="1359">
                  <c:v>4.9210347222222222</c:v>
                </c:pt>
                <c:pt idx="1360">
                  <c:v>4.9294513888888885</c:v>
                </c:pt>
                <c:pt idx="1361">
                  <c:v>4.9378611111111113</c:v>
                </c:pt>
                <c:pt idx="1362">
                  <c:v>4.9462777777777784</c:v>
                </c:pt>
                <c:pt idx="1363">
                  <c:v>4.9546875000000004</c:v>
                </c:pt>
                <c:pt idx="1364">
                  <c:v>4.9631041666666667</c:v>
                </c:pt>
                <c:pt idx="1365">
                  <c:v>4.9715138888888886</c:v>
                </c:pt>
                <c:pt idx="1366">
                  <c:v>4.9799305555555557</c:v>
                </c:pt>
                <c:pt idx="1367">
                  <c:v>4.988347222222222</c:v>
                </c:pt>
                <c:pt idx="1368">
                  <c:v>4.996756944444444</c:v>
                </c:pt>
                <c:pt idx="1369">
                  <c:v>5</c:v>
                </c:pt>
              </c:numCache>
            </c:numRef>
          </c:xVal>
          <c:yVal>
            <c:numRef>
              <c:f>Sheet1!$C$4:$C$1373</c:f>
              <c:numCache>
                <c:formatCode>0.00E+00</c:formatCode>
                <c:ptCount val="1370"/>
                <c:pt idx="0">
                  <c:v>9.9999999999999995E-7</c:v>
                </c:pt>
                <c:pt idx="1">
                  <c:v>9.9999999999999995E-7</c:v>
                </c:pt>
                <c:pt idx="2">
                  <c:v>9.9999999999999995E-7</c:v>
                </c:pt>
                <c:pt idx="3">
                  <c:v>9.9999999999999995E-7</c:v>
                </c:pt>
                <c:pt idx="4">
                  <c:v>9.9999999999999995E-7</c:v>
                </c:pt>
                <c:pt idx="5">
                  <c:v>9.9999999999999995E-7</c:v>
                </c:pt>
                <c:pt idx="6">
                  <c:v>9.9999999999999995E-7</c:v>
                </c:pt>
                <c:pt idx="7">
                  <c:v>9.9999999999999995E-7</c:v>
                </c:pt>
                <c:pt idx="8">
                  <c:v>9.9999999999999995E-7</c:v>
                </c:pt>
                <c:pt idx="9">
                  <c:v>9.9999999999999995E-7</c:v>
                </c:pt>
                <c:pt idx="10">
                  <c:v>1.00001E-6</c:v>
                </c:pt>
                <c:pt idx="11">
                  <c:v>1.00001E-6</c:v>
                </c:pt>
                <c:pt idx="12">
                  <c:v>1.0000200000000001E-6</c:v>
                </c:pt>
                <c:pt idx="13">
                  <c:v>1.0000200000000001E-6</c:v>
                </c:pt>
                <c:pt idx="14">
                  <c:v>1.0000500000000001E-6</c:v>
                </c:pt>
                <c:pt idx="15">
                  <c:v>1.00008E-6</c:v>
                </c:pt>
                <c:pt idx="16">
                  <c:v>1.00011E-6</c:v>
                </c:pt>
                <c:pt idx="17">
                  <c:v>1.0001599999999999E-6</c:v>
                </c:pt>
                <c:pt idx="18">
                  <c:v>1.0002200000000001E-6</c:v>
                </c:pt>
                <c:pt idx="19">
                  <c:v>1.0002800000000001E-6</c:v>
                </c:pt>
                <c:pt idx="20">
                  <c:v>1.0003599999999999E-6</c:v>
                </c:pt>
                <c:pt idx="21">
                  <c:v>1.0004500000000001E-6</c:v>
                </c:pt>
                <c:pt idx="22">
                  <c:v>1.00053E-6</c:v>
                </c:pt>
                <c:pt idx="23">
                  <c:v>1.0006E-6</c:v>
                </c:pt>
                <c:pt idx="24">
                  <c:v>1.0006800000000001E-6</c:v>
                </c:pt>
                <c:pt idx="25">
                  <c:v>1.0007499999999999E-6</c:v>
                </c:pt>
                <c:pt idx="26">
                  <c:v>1.00079E-6</c:v>
                </c:pt>
                <c:pt idx="27">
                  <c:v>1.0008199999999999E-6</c:v>
                </c:pt>
                <c:pt idx="28">
                  <c:v>1.0008499999999999E-6</c:v>
                </c:pt>
                <c:pt idx="29">
                  <c:v>1.0008800000000001E-6</c:v>
                </c:pt>
                <c:pt idx="30">
                  <c:v>1.0009100000000001E-6</c:v>
                </c:pt>
                <c:pt idx="31">
                  <c:v>1.0009400000000001E-6</c:v>
                </c:pt>
                <c:pt idx="32">
                  <c:v>1.0009799999999999E-6</c:v>
                </c:pt>
                <c:pt idx="33">
                  <c:v>1.00103E-6</c:v>
                </c:pt>
                <c:pt idx="34">
                  <c:v>1.0010700000000001E-6</c:v>
                </c:pt>
                <c:pt idx="35">
                  <c:v>1.0013400000000001E-6</c:v>
                </c:pt>
                <c:pt idx="36">
                  <c:v>1.0014099999999999E-6</c:v>
                </c:pt>
                <c:pt idx="37">
                  <c:v>1.0014799999999999E-6</c:v>
                </c:pt>
                <c:pt idx="38">
                  <c:v>1.00155E-6</c:v>
                </c:pt>
                <c:pt idx="39">
                  <c:v>1.00162E-6</c:v>
                </c:pt>
                <c:pt idx="40">
                  <c:v>1.00165E-6</c:v>
                </c:pt>
                <c:pt idx="41">
                  <c:v>1.00168E-6</c:v>
                </c:pt>
                <c:pt idx="42">
                  <c:v>1.0017099999999999E-6</c:v>
                </c:pt>
                <c:pt idx="43">
                  <c:v>1.0017399999999999E-6</c:v>
                </c:pt>
                <c:pt idx="44">
                  <c:v>1.00176E-6</c:v>
                </c:pt>
                <c:pt idx="45">
                  <c:v>1.00179E-6</c:v>
                </c:pt>
                <c:pt idx="46">
                  <c:v>1.0018399999999999E-6</c:v>
                </c:pt>
                <c:pt idx="47">
                  <c:v>1.00189E-6</c:v>
                </c:pt>
                <c:pt idx="48">
                  <c:v>1.0019399999999999E-6</c:v>
                </c:pt>
                <c:pt idx="49">
                  <c:v>1.0022900000000001E-6</c:v>
                </c:pt>
                <c:pt idx="50">
                  <c:v>1.00238E-6</c:v>
                </c:pt>
                <c:pt idx="51">
                  <c:v>1.0025600000000001E-6</c:v>
                </c:pt>
                <c:pt idx="52">
                  <c:v>1.00274E-6</c:v>
                </c:pt>
                <c:pt idx="53">
                  <c:v>1.0029200000000001E-6</c:v>
                </c:pt>
                <c:pt idx="54">
                  <c:v>1.0031E-6</c:v>
                </c:pt>
                <c:pt idx="55">
                  <c:v>1.0035499999999999E-6</c:v>
                </c:pt>
                <c:pt idx="56">
                  <c:v>1.0040099999999999E-6</c:v>
                </c:pt>
                <c:pt idx="57">
                  <c:v>1.00446E-6</c:v>
                </c:pt>
                <c:pt idx="58">
                  <c:v>1.00492E-6</c:v>
                </c:pt>
                <c:pt idx="59">
                  <c:v>1.00554E-6</c:v>
                </c:pt>
                <c:pt idx="60">
                  <c:v>1.00616E-6</c:v>
                </c:pt>
                <c:pt idx="61">
                  <c:v>1.0067799999999999E-6</c:v>
                </c:pt>
                <c:pt idx="62">
                  <c:v>1.0074000000000001E-6</c:v>
                </c:pt>
                <c:pt idx="63">
                  <c:v>1.00854E-6</c:v>
                </c:pt>
                <c:pt idx="64">
                  <c:v>1.00969E-6</c:v>
                </c:pt>
                <c:pt idx="65">
                  <c:v>1.0108299999999999E-6</c:v>
                </c:pt>
                <c:pt idx="66">
                  <c:v>1.0119899999999999E-6</c:v>
                </c:pt>
                <c:pt idx="67">
                  <c:v>1.0131399999999999E-6</c:v>
                </c:pt>
                <c:pt idx="68">
                  <c:v>1.0145899999999999E-6</c:v>
                </c:pt>
                <c:pt idx="69">
                  <c:v>1.0160300000000001E-6</c:v>
                </c:pt>
                <c:pt idx="70">
                  <c:v>1.0174899999999999E-6</c:v>
                </c:pt>
                <c:pt idx="71">
                  <c:v>1.01895E-6</c:v>
                </c:pt>
                <c:pt idx="72">
                  <c:v>1.0204100000000001E-6</c:v>
                </c:pt>
                <c:pt idx="73">
                  <c:v>1.0227299999999999E-6</c:v>
                </c:pt>
                <c:pt idx="74">
                  <c:v>1.0250600000000001E-6</c:v>
                </c:pt>
                <c:pt idx="75">
                  <c:v>1.0273999999999999E-6</c:v>
                </c:pt>
                <c:pt idx="76">
                  <c:v>1.02976E-6</c:v>
                </c:pt>
                <c:pt idx="77">
                  <c:v>1.0321400000000001E-6</c:v>
                </c:pt>
                <c:pt idx="78">
                  <c:v>1.0345199999999999E-6</c:v>
                </c:pt>
                <c:pt idx="79">
                  <c:v>1.03832E-6</c:v>
                </c:pt>
                <c:pt idx="80">
                  <c:v>1.0421599999999999E-6</c:v>
                </c:pt>
                <c:pt idx="81">
                  <c:v>1.04603E-6</c:v>
                </c:pt>
                <c:pt idx="82">
                  <c:v>1.0499399999999999E-6</c:v>
                </c:pt>
                <c:pt idx="83">
                  <c:v>1.0538899999999999E-6</c:v>
                </c:pt>
                <c:pt idx="84">
                  <c:v>1.0578700000000001E-6</c:v>
                </c:pt>
                <c:pt idx="85">
                  <c:v>1.0623599999999999E-6</c:v>
                </c:pt>
                <c:pt idx="86">
                  <c:v>1.0668999999999999E-6</c:v>
                </c:pt>
                <c:pt idx="87">
                  <c:v>1.0714799999999999E-6</c:v>
                </c:pt>
                <c:pt idx="88">
                  <c:v>1.07611E-6</c:v>
                </c:pt>
                <c:pt idx="89">
                  <c:v>1.08079E-6</c:v>
                </c:pt>
                <c:pt idx="90">
                  <c:v>1.0855199999999999E-6</c:v>
                </c:pt>
                <c:pt idx="91">
                  <c:v>1.0909400000000001E-6</c:v>
                </c:pt>
                <c:pt idx="92">
                  <c:v>1.0964199999999999E-6</c:v>
                </c:pt>
                <c:pt idx="93">
                  <c:v>1.10197E-6</c:v>
                </c:pt>
                <c:pt idx="94">
                  <c:v>1.1075800000000001E-6</c:v>
                </c:pt>
                <c:pt idx="95">
                  <c:v>1.1132500000000001E-6</c:v>
                </c:pt>
                <c:pt idx="96">
                  <c:v>1.1189899999999999E-6</c:v>
                </c:pt>
                <c:pt idx="97">
                  <c:v>1.1199099999999999E-6</c:v>
                </c:pt>
                <c:pt idx="98">
                  <c:v>1.1208299999999999E-6</c:v>
                </c:pt>
                <c:pt idx="99">
                  <c:v>1.1217500000000001E-6</c:v>
                </c:pt>
                <c:pt idx="100">
                  <c:v>1.1226700000000001E-6</c:v>
                </c:pt>
                <c:pt idx="101">
                  <c:v>1.1235999999999999E-6</c:v>
                </c:pt>
                <c:pt idx="102">
                  <c:v>1.1251700000000001E-6</c:v>
                </c:pt>
                <c:pt idx="103">
                  <c:v>1.12674E-6</c:v>
                </c:pt>
                <c:pt idx="104">
                  <c:v>1.12832E-6</c:v>
                </c:pt>
                <c:pt idx="105">
                  <c:v>1.12991E-6</c:v>
                </c:pt>
                <c:pt idx="106">
                  <c:v>1.1315000000000001E-6</c:v>
                </c:pt>
                <c:pt idx="107">
                  <c:v>1.1347300000000001E-6</c:v>
                </c:pt>
                <c:pt idx="108">
                  <c:v>1.13798E-6</c:v>
                </c:pt>
                <c:pt idx="109">
                  <c:v>1.1412599999999999E-6</c:v>
                </c:pt>
                <c:pt idx="110">
                  <c:v>1.1445499999999999E-6</c:v>
                </c:pt>
                <c:pt idx="111">
                  <c:v>1.14786E-6</c:v>
                </c:pt>
                <c:pt idx="112">
                  <c:v>1.1543699999999999E-6</c:v>
                </c:pt>
                <c:pt idx="113">
                  <c:v>1.1609500000000001E-6</c:v>
                </c:pt>
                <c:pt idx="114">
                  <c:v>1.1676099999999999E-6</c:v>
                </c:pt>
                <c:pt idx="115">
                  <c:v>1.17435E-6</c:v>
                </c:pt>
                <c:pt idx="116">
                  <c:v>1.18116E-6</c:v>
                </c:pt>
                <c:pt idx="117">
                  <c:v>1.1893199999999999E-6</c:v>
                </c:pt>
                <c:pt idx="118">
                  <c:v>1.1975899999999999E-6</c:v>
                </c:pt>
                <c:pt idx="119">
                  <c:v>1.2059599999999999E-6</c:v>
                </c:pt>
                <c:pt idx="120">
                  <c:v>1.2144500000000001E-6</c:v>
                </c:pt>
                <c:pt idx="121">
                  <c:v>1.2230500000000001E-6</c:v>
                </c:pt>
                <c:pt idx="122">
                  <c:v>1.23176E-6</c:v>
                </c:pt>
                <c:pt idx="123">
                  <c:v>1.24577E-6</c:v>
                </c:pt>
                <c:pt idx="124">
                  <c:v>1.26006E-6</c:v>
                </c:pt>
                <c:pt idx="125">
                  <c:v>1.2746400000000001E-6</c:v>
                </c:pt>
                <c:pt idx="126">
                  <c:v>1.28952E-6</c:v>
                </c:pt>
                <c:pt idx="127">
                  <c:v>1.3047E-6</c:v>
                </c:pt>
                <c:pt idx="128">
                  <c:v>1.32019E-6</c:v>
                </c:pt>
                <c:pt idx="129">
                  <c:v>1.34502E-6</c:v>
                </c:pt>
                <c:pt idx="130">
                  <c:v>1.37063E-6</c:v>
                </c:pt>
                <c:pt idx="131">
                  <c:v>1.3970200000000001E-6</c:v>
                </c:pt>
                <c:pt idx="132">
                  <c:v>1.42423E-6</c:v>
                </c:pt>
                <c:pt idx="133">
                  <c:v>1.45226E-6</c:v>
                </c:pt>
                <c:pt idx="134">
                  <c:v>1.4811399999999999E-6</c:v>
                </c:pt>
                <c:pt idx="135">
                  <c:v>1.5264300000000001E-6</c:v>
                </c:pt>
                <c:pt idx="136">
                  <c:v>1.5737799999999999E-6</c:v>
                </c:pt>
                <c:pt idx="137">
                  <c:v>1.62327E-6</c:v>
                </c:pt>
                <c:pt idx="138">
                  <c:v>1.67496E-6</c:v>
                </c:pt>
                <c:pt idx="139">
                  <c:v>1.72896E-6</c:v>
                </c:pt>
                <c:pt idx="140">
                  <c:v>1.7853399999999999E-6</c:v>
                </c:pt>
                <c:pt idx="141">
                  <c:v>1.86626E-6</c:v>
                </c:pt>
                <c:pt idx="142">
                  <c:v>1.9520499999999998E-6</c:v>
                </c:pt>
                <c:pt idx="143">
                  <c:v>2.0429500000000001E-6</c:v>
                </c:pt>
                <c:pt idx="144">
                  <c:v>2.1392600000000002E-6</c:v>
                </c:pt>
                <c:pt idx="145">
                  <c:v>2.2412700000000001E-6</c:v>
                </c:pt>
                <c:pt idx="146">
                  <c:v>2.3493000000000001E-6</c:v>
                </c:pt>
                <c:pt idx="147">
                  <c:v>2.4971799999999999E-6</c:v>
                </c:pt>
                <c:pt idx="148">
                  <c:v>2.65626E-6</c:v>
                </c:pt>
                <c:pt idx="149">
                  <c:v>2.82733E-6</c:v>
                </c:pt>
                <c:pt idx="150">
                  <c:v>3.0112800000000002E-6</c:v>
                </c:pt>
                <c:pt idx="151">
                  <c:v>3.2090199999999998E-6</c:v>
                </c:pt>
                <c:pt idx="152">
                  <c:v>3.4215799999999999E-6</c:v>
                </c:pt>
                <c:pt idx="153">
                  <c:v>3.7472100000000002E-6</c:v>
                </c:pt>
                <c:pt idx="154">
                  <c:v>4.1074699999999997E-6</c:v>
                </c:pt>
                <c:pt idx="155">
                  <c:v>4.50598E-6</c:v>
                </c:pt>
                <c:pt idx="156">
                  <c:v>4.9467200000000001E-6</c:v>
                </c:pt>
                <c:pt idx="157">
                  <c:v>5.4341299999999998E-6</c:v>
                </c:pt>
                <c:pt idx="158">
                  <c:v>5.9730999999999996E-6</c:v>
                </c:pt>
                <c:pt idx="159">
                  <c:v>6.6364499999999998E-6</c:v>
                </c:pt>
                <c:pt idx="160">
                  <c:v>7.3778099999999998E-6</c:v>
                </c:pt>
                <c:pt idx="161">
                  <c:v>8.2062900000000007E-6</c:v>
                </c:pt>
                <c:pt idx="162">
                  <c:v>9.1321000000000002E-6</c:v>
                </c:pt>
                <c:pt idx="163">
                  <c:v>1.01666E-5</c:v>
                </c:pt>
                <c:pt idx="164">
                  <c:v>1.1322600000000001E-5</c:v>
                </c:pt>
                <c:pt idx="165">
                  <c:v>1.2614300000000001E-5</c:v>
                </c:pt>
                <c:pt idx="166">
                  <c:v>1.4057500000000001E-5</c:v>
                </c:pt>
                <c:pt idx="167">
                  <c:v>1.5670100000000001E-5</c:v>
                </c:pt>
                <c:pt idx="168">
                  <c:v>1.7472000000000001E-5</c:v>
                </c:pt>
                <c:pt idx="169">
                  <c:v>1.9485200000000001E-5</c:v>
                </c:pt>
                <c:pt idx="170">
                  <c:v>2.17345E-5</c:v>
                </c:pt>
                <c:pt idx="171">
                  <c:v>2.4247700000000002E-5</c:v>
                </c:pt>
                <c:pt idx="172">
                  <c:v>2.7055699999999999E-5</c:v>
                </c:pt>
                <c:pt idx="173">
                  <c:v>2.9548900000000001E-5</c:v>
                </c:pt>
                <c:pt idx="174">
                  <c:v>3.16639E-5</c:v>
                </c:pt>
                <c:pt idx="175">
                  <c:v>3.3458899999999999E-5</c:v>
                </c:pt>
                <c:pt idx="176">
                  <c:v>3.53568E-5</c:v>
                </c:pt>
                <c:pt idx="177">
                  <c:v>3.5697900000000003E-5</c:v>
                </c:pt>
                <c:pt idx="178">
                  <c:v>3.6042299999999999E-5</c:v>
                </c:pt>
                <c:pt idx="179">
                  <c:v>3.6390000000000002E-5</c:v>
                </c:pt>
                <c:pt idx="180">
                  <c:v>3.67412E-5</c:v>
                </c:pt>
                <c:pt idx="181">
                  <c:v>3.7095699999999998E-5</c:v>
                </c:pt>
                <c:pt idx="182">
                  <c:v>3.7815199999999997E-5</c:v>
                </c:pt>
                <c:pt idx="183">
                  <c:v>3.8548799999999999E-5</c:v>
                </c:pt>
                <c:pt idx="184">
                  <c:v>3.9296699999999999E-5</c:v>
                </c:pt>
                <c:pt idx="185">
                  <c:v>4.0059299999999998E-5</c:v>
                </c:pt>
                <c:pt idx="186">
                  <c:v>4.1740599999999998E-5</c:v>
                </c:pt>
                <c:pt idx="187">
                  <c:v>4.3492899999999998E-5</c:v>
                </c:pt>
                <c:pt idx="188">
                  <c:v>4.5319399999999998E-5</c:v>
                </c:pt>
                <c:pt idx="189">
                  <c:v>4.7223099999999999E-5</c:v>
                </c:pt>
                <c:pt idx="190">
                  <c:v>4.9207399999999999E-5</c:v>
                </c:pt>
                <c:pt idx="191">
                  <c:v>5.2541799999999999E-5</c:v>
                </c:pt>
                <c:pt idx="192">
                  <c:v>5.6103600000000003E-5</c:v>
                </c:pt>
                <c:pt idx="193">
                  <c:v>5.9908199999999997E-5</c:v>
                </c:pt>
                <c:pt idx="194">
                  <c:v>6.3972299999999997E-5</c:v>
                </c:pt>
                <c:pt idx="195">
                  <c:v>6.8313399999999995E-5</c:v>
                </c:pt>
                <c:pt idx="196">
                  <c:v>7.5507100000000001E-5</c:v>
                </c:pt>
                <c:pt idx="197">
                  <c:v>8.3461700000000001E-5</c:v>
                </c:pt>
                <c:pt idx="198">
                  <c:v>9.2257599999999996E-5</c:v>
                </c:pt>
                <c:pt idx="199" formatCode="General">
                  <c:v>1.01984E-4</c:v>
                </c:pt>
                <c:pt idx="200" formatCode="General">
                  <c:v>1.1273900000000001E-4</c:v>
                </c:pt>
                <c:pt idx="201" formatCode="General">
                  <c:v>1.2463200000000001E-4</c:v>
                </c:pt>
                <c:pt idx="202" formatCode="General">
                  <c:v>1.37782E-4</c:v>
                </c:pt>
                <c:pt idx="203" formatCode="General">
                  <c:v>1.52323E-4</c:v>
                </c:pt>
                <c:pt idx="204" formatCode="General">
                  <c:v>1.6840299999999999E-4</c:v>
                </c:pt>
                <c:pt idx="205" formatCode="General">
                  <c:v>1.8824299999999999E-4</c:v>
                </c:pt>
                <c:pt idx="206" formatCode="General">
                  <c:v>2.1042399999999999E-4</c:v>
                </c:pt>
                <c:pt idx="207" formatCode="General">
                  <c:v>2.3522300000000001E-4</c:v>
                </c:pt>
                <c:pt idx="208" formatCode="General">
                  <c:v>2.6294900000000001E-4</c:v>
                </c:pt>
                <c:pt idx="209" formatCode="General">
                  <c:v>2.9394799999999998E-4</c:v>
                </c:pt>
                <c:pt idx="210" formatCode="General">
                  <c:v>3.2860499999999999E-4</c:v>
                </c:pt>
                <c:pt idx="211" formatCode="General">
                  <c:v>3.6735199999999999E-4</c:v>
                </c:pt>
                <c:pt idx="212" formatCode="General">
                  <c:v>4.10672E-4</c:v>
                </c:pt>
                <c:pt idx="213" formatCode="General">
                  <c:v>4.59104E-4</c:v>
                </c:pt>
                <c:pt idx="214" formatCode="General">
                  <c:v>5.1325299999999997E-4</c:v>
                </c:pt>
                <c:pt idx="215" formatCode="General">
                  <c:v>5.7379299999999996E-4</c:v>
                </c:pt>
                <c:pt idx="216" formatCode="General">
                  <c:v>6.41477E-4</c:v>
                </c:pt>
                <c:pt idx="217" formatCode="General">
                  <c:v>7.1714999999999995E-4</c:v>
                </c:pt>
                <c:pt idx="218" formatCode="General">
                  <c:v>8.0175299999999999E-4</c:v>
                </c:pt>
                <c:pt idx="219" formatCode="General">
                  <c:v>8.9634199999999995E-4</c:v>
                </c:pt>
                <c:pt idx="220" formatCode="General">
                  <c:v>1.00209E-3</c:v>
                </c:pt>
                <c:pt idx="221" formatCode="General">
                  <c:v>1.1203299999999999E-3</c:v>
                </c:pt>
                <c:pt idx="222" formatCode="General">
                  <c:v>1.2525100000000001E-3</c:v>
                </c:pt>
                <c:pt idx="223" formatCode="General">
                  <c:v>1.4002999999999999E-3</c:v>
                </c:pt>
                <c:pt idx="224" formatCode="General">
                  <c:v>1.5655300000000001E-3</c:v>
                </c:pt>
                <c:pt idx="225" formatCode="General">
                  <c:v>1.75026E-3</c:v>
                </c:pt>
                <c:pt idx="226" formatCode="General">
                  <c:v>1.9567899999999999E-3</c:v>
                </c:pt>
                <c:pt idx="227" formatCode="General">
                  <c:v>2.1876999999999999E-3</c:v>
                </c:pt>
                <c:pt idx="228" formatCode="General">
                  <c:v>2.4458599999999998E-3</c:v>
                </c:pt>
                <c:pt idx="229" formatCode="General">
                  <c:v>2.73449E-3</c:v>
                </c:pt>
                <c:pt idx="230" formatCode="General">
                  <c:v>3.0571800000000001E-3</c:v>
                </c:pt>
                <c:pt idx="231" formatCode="General">
                  <c:v>3.4179499999999999E-3</c:v>
                </c:pt>
                <c:pt idx="232" formatCode="General">
                  <c:v>3.8213100000000001E-3</c:v>
                </c:pt>
                <c:pt idx="233" formatCode="General">
                  <c:v>4.2722699999999999E-3</c:v>
                </c:pt>
                <c:pt idx="234" formatCode="General">
                  <c:v>4.7764499999999998E-3</c:v>
                </c:pt>
                <c:pt idx="235" formatCode="General">
                  <c:v>5.3401300000000002E-3</c:v>
                </c:pt>
                <c:pt idx="236" formatCode="General">
                  <c:v>5.9703500000000001E-3</c:v>
                </c:pt>
                <c:pt idx="237" formatCode="General">
                  <c:v>6.6749399999999999E-3</c:v>
                </c:pt>
                <c:pt idx="238" formatCode="General">
                  <c:v>7.4626800000000002E-3</c:v>
                </c:pt>
                <c:pt idx="239" formatCode="General">
                  <c:v>8.3434000000000008E-3</c:v>
                </c:pt>
                <c:pt idx="240" formatCode="General">
                  <c:v>9.3280600000000009E-3</c:v>
                </c:pt>
                <c:pt idx="241" formatCode="General">
                  <c:v>1.04289E-2</c:v>
                </c:pt>
                <c:pt idx="242" formatCode="General">
                  <c:v>1.16597E-2</c:v>
                </c:pt>
                <c:pt idx="243" formatCode="General">
                  <c:v>1.30358E-2</c:v>
                </c:pt>
                <c:pt idx="244" formatCode="General">
                  <c:v>1.4574200000000001E-2</c:v>
                </c:pt>
                <c:pt idx="245" formatCode="General">
                  <c:v>1.6294300000000001E-2</c:v>
                </c:pt>
                <c:pt idx="246" formatCode="General">
                  <c:v>1.8217299999999999E-2</c:v>
                </c:pt>
                <c:pt idx="247" formatCode="General">
                  <c:v>2.0367300000000001E-2</c:v>
                </c:pt>
                <c:pt idx="248" formatCode="General">
                  <c:v>2.2771E-2</c:v>
                </c:pt>
                <c:pt idx="249" formatCode="General">
                  <c:v>2.5458399999999999E-2</c:v>
                </c:pt>
                <c:pt idx="250" formatCode="General">
                  <c:v>2.8462999999999999E-2</c:v>
                </c:pt>
                <c:pt idx="251" formatCode="General">
                  <c:v>3.1822099999999999E-2</c:v>
                </c:pt>
                <c:pt idx="252" formatCode="General">
                  <c:v>3.55778E-2</c:v>
                </c:pt>
                <c:pt idx="253" formatCode="General">
                  <c:v>3.9776600000000002E-2</c:v>
                </c:pt>
                <c:pt idx="254" formatCode="General">
                  <c:v>4.44711E-2</c:v>
                </c:pt>
                <c:pt idx="255" formatCode="General">
                  <c:v>4.97195E-2</c:v>
                </c:pt>
                <c:pt idx="256" formatCode="General">
                  <c:v>5.5587400000000002E-2</c:v>
                </c:pt>
                <c:pt idx="257" formatCode="General">
                  <c:v>6.2147800000000003E-2</c:v>
                </c:pt>
                <c:pt idx="258" formatCode="General">
                  <c:v>6.9482500000000003E-2</c:v>
                </c:pt>
                <c:pt idx="259" formatCode="General">
                  <c:v>7.7682799999999996E-2</c:v>
                </c:pt>
                <c:pt idx="260" formatCode="General">
                  <c:v>8.6850899999999995E-2</c:v>
                </c:pt>
                <c:pt idx="261" formatCode="General">
                  <c:v>9.7101000000000007E-2</c:v>
                </c:pt>
                <c:pt idx="262" formatCode="General">
                  <c:v>0.108561</c:v>
                </c:pt>
                <c:pt idx="263" formatCode="General">
                  <c:v>0.12137299999999999</c:v>
                </c:pt>
                <c:pt idx="264" formatCode="General">
                  <c:v>0.13569700000000001</c:v>
                </c:pt>
                <c:pt idx="265" formatCode="General">
                  <c:v>0.15171200000000001</c:v>
                </c:pt>
                <c:pt idx="266" formatCode="General">
                  <c:v>0.16961699999999999</c:v>
                </c:pt>
                <c:pt idx="267" formatCode="General">
                  <c:v>0.189635</c:v>
                </c:pt>
                <c:pt idx="268" formatCode="General">
                  <c:v>0.21201600000000001</c:v>
                </c:pt>
                <c:pt idx="269" formatCode="General">
                  <c:v>0.237038</c:v>
                </c:pt>
                <c:pt idx="270" formatCode="General">
                  <c:v>0.265013</c:v>
                </c:pt>
                <c:pt idx="271" formatCode="General">
                  <c:v>0.29628900000000002</c:v>
                </c:pt>
                <c:pt idx="272" formatCode="General">
                  <c:v>0.33125599999999999</c:v>
                </c:pt>
                <c:pt idx="273" formatCode="General">
                  <c:v>0.37035000000000001</c:v>
                </c:pt>
                <c:pt idx="274" formatCode="General">
                  <c:v>0.41405799999999998</c:v>
                </c:pt>
                <c:pt idx="275" formatCode="General">
                  <c:v>0.462924</c:v>
                </c:pt>
                <c:pt idx="276" formatCode="General">
                  <c:v>0.51755700000000004</c:v>
                </c:pt>
                <c:pt idx="277" formatCode="General">
                  <c:v>0.57863699999999996</c:v>
                </c:pt>
                <c:pt idx="278" formatCode="General">
                  <c:v>0.64692499999999997</c:v>
                </c:pt>
                <c:pt idx="279" formatCode="General">
                  <c:v>0.72327200000000003</c:v>
                </c:pt>
                <c:pt idx="280" formatCode="General">
                  <c:v>0.80862800000000001</c:v>
                </c:pt>
                <c:pt idx="281" formatCode="General">
                  <c:v>0.904057</c:v>
                </c:pt>
                <c:pt idx="282" formatCode="General">
                  <c:v>1.01075</c:v>
                </c:pt>
                <c:pt idx="283" formatCode="General">
                  <c:v>1.1300300000000001</c:v>
                </c:pt>
                <c:pt idx="284" formatCode="General">
                  <c:v>1.2633799999999999</c:v>
                </c:pt>
                <c:pt idx="285" formatCode="General">
                  <c:v>1.4124699999999999</c:v>
                </c:pt>
                <c:pt idx="286" formatCode="General">
                  <c:v>1.5791500000000001</c:v>
                </c:pt>
                <c:pt idx="287" formatCode="General">
                  <c:v>1.7655000000000001</c:v>
                </c:pt>
                <c:pt idx="288" formatCode="General">
                  <c:v>1.97384</c:v>
                </c:pt>
                <c:pt idx="289" formatCode="General">
                  <c:v>2.2067600000000001</c:v>
                </c:pt>
                <c:pt idx="290" formatCode="General">
                  <c:v>2.4671599999999998</c:v>
                </c:pt>
                <c:pt idx="291" formatCode="General">
                  <c:v>2.7046199999999998</c:v>
                </c:pt>
                <c:pt idx="292" formatCode="General">
                  <c:v>2.9649399999999999</c:v>
                </c:pt>
                <c:pt idx="293" formatCode="General">
                  <c:v>3.2503000000000002</c:v>
                </c:pt>
                <c:pt idx="294" formatCode="General">
                  <c:v>3.5631200000000001</c:v>
                </c:pt>
                <c:pt idx="295" formatCode="General">
                  <c:v>3.6148099999999999</c:v>
                </c:pt>
                <c:pt idx="296" formatCode="General">
                  <c:v>3.6672500000000001</c:v>
                </c:pt>
                <c:pt idx="297" formatCode="General">
                  <c:v>3.72045</c:v>
                </c:pt>
                <c:pt idx="298" formatCode="General">
                  <c:v>3.7744200000000001</c:v>
                </c:pt>
                <c:pt idx="299" formatCode="General">
                  <c:v>3.82917</c:v>
                </c:pt>
                <c:pt idx="300" formatCode="General">
                  <c:v>3.8847100000000001</c:v>
                </c:pt>
                <c:pt idx="301" formatCode="General">
                  <c:v>3.952</c:v>
                </c:pt>
                <c:pt idx="302" formatCode="General">
                  <c:v>4.0204599999999999</c:v>
                </c:pt>
                <c:pt idx="303" formatCode="General">
                  <c:v>4.0900999999999996</c:v>
                </c:pt>
                <c:pt idx="304" formatCode="General">
                  <c:v>4.1609400000000001</c:v>
                </c:pt>
                <c:pt idx="305" formatCode="General">
                  <c:v>4.2330199999999998</c:v>
                </c:pt>
                <c:pt idx="306" formatCode="General">
                  <c:v>4.4315199999999999</c:v>
                </c:pt>
                <c:pt idx="307" formatCode="General">
                  <c:v>4.6393300000000002</c:v>
                </c:pt>
                <c:pt idx="308" formatCode="General">
                  <c:v>4.8568800000000003</c:v>
                </c:pt>
                <c:pt idx="309" formatCode="General">
                  <c:v>5.0846299999999998</c:v>
                </c:pt>
                <c:pt idx="310" formatCode="General">
                  <c:v>5.3230599999999999</c:v>
                </c:pt>
                <c:pt idx="311" formatCode="General">
                  <c:v>5.6429200000000002</c:v>
                </c:pt>
                <c:pt idx="312" formatCode="General">
                  <c:v>5.9819899999999997</c:v>
                </c:pt>
                <c:pt idx="313" formatCode="General">
                  <c:v>6.3414299999999999</c:v>
                </c:pt>
                <c:pt idx="314" formatCode="General">
                  <c:v>6.7224500000000003</c:v>
                </c:pt>
                <c:pt idx="315" formatCode="General">
                  <c:v>7.1263399999999999</c:v>
                </c:pt>
                <c:pt idx="316" formatCode="General">
                  <c:v>7.5544900000000004</c:v>
                </c:pt>
                <c:pt idx="317" formatCode="General">
                  <c:v>8.0083500000000001</c:v>
                </c:pt>
                <c:pt idx="318" formatCode="General">
                  <c:v>8.4894499999999997</c:v>
                </c:pt>
                <c:pt idx="319" formatCode="General">
                  <c:v>8.9994200000000006</c:v>
                </c:pt>
                <c:pt idx="320" formatCode="General">
                  <c:v>9.5400100000000005</c:v>
                </c:pt>
                <c:pt idx="321" formatCode="General">
                  <c:v>10.113</c:v>
                </c:pt>
                <c:pt idx="322" formatCode="General">
                  <c:v>10.7204</c:v>
                </c:pt>
                <c:pt idx="323" formatCode="General">
                  <c:v>11.3643</c:v>
                </c:pt>
                <c:pt idx="324" formatCode="General">
                  <c:v>12.046799999999999</c:v>
                </c:pt>
                <c:pt idx="325" formatCode="General">
                  <c:v>12.6142</c:v>
                </c:pt>
                <c:pt idx="326" formatCode="General">
                  <c:v>13.0891</c:v>
                </c:pt>
                <c:pt idx="327" formatCode="General">
                  <c:v>13.1792</c:v>
                </c:pt>
                <c:pt idx="328" formatCode="General">
                  <c:v>13.2699</c:v>
                </c:pt>
                <c:pt idx="329" formatCode="General">
                  <c:v>13.3613</c:v>
                </c:pt>
                <c:pt idx="330" formatCode="General">
                  <c:v>13.4533</c:v>
                </c:pt>
                <c:pt idx="331" formatCode="General">
                  <c:v>13.5459</c:v>
                </c:pt>
                <c:pt idx="332" formatCode="General">
                  <c:v>13.718299999999999</c:v>
                </c:pt>
                <c:pt idx="333" formatCode="General">
                  <c:v>13.893000000000001</c:v>
                </c:pt>
                <c:pt idx="334" formatCode="General">
                  <c:v>14.069800000000001</c:v>
                </c:pt>
                <c:pt idx="335" formatCode="General">
                  <c:v>14.248900000000001</c:v>
                </c:pt>
                <c:pt idx="336" formatCode="General">
                  <c:v>14.430300000000001</c:v>
                </c:pt>
                <c:pt idx="337" formatCode="General">
                  <c:v>14.955399999999999</c:v>
                </c:pt>
                <c:pt idx="338" formatCode="General">
                  <c:v>15.499599999999999</c:v>
                </c:pt>
                <c:pt idx="339" formatCode="General">
                  <c:v>16.063600000000001</c:v>
                </c:pt>
                <c:pt idx="340" formatCode="General">
                  <c:v>16.648</c:v>
                </c:pt>
                <c:pt idx="341" formatCode="General">
                  <c:v>17.253699999999998</c:v>
                </c:pt>
                <c:pt idx="342" formatCode="General">
                  <c:v>17.8813</c:v>
                </c:pt>
                <c:pt idx="343" formatCode="General">
                  <c:v>18.531700000000001</c:v>
                </c:pt>
                <c:pt idx="344" formatCode="General">
                  <c:v>19.2057</c:v>
                </c:pt>
                <c:pt idx="345" formatCode="General">
                  <c:v>19.904199999999999</c:v>
                </c:pt>
                <c:pt idx="346" formatCode="General">
                  <c:v>20.503799999999998</c:v>
                </c:pt>
                <c:pt idx="347" formatCode="General">
                  <c:v>21.121300000000002</c:v>
                </c:pt>
                <c:pt idx="348" formatCode="General">
                  <c:v>21.757400000000001</c:v>
                </c:pt>
                <c:pt idx="349" formatCode="General">
                  <c:v>22.412600000000001</c:v>
                </c:pt>
                <c:pt idx="350" formatCode="General">
                  <c:v>23.087499999999999</c:v>
                </c:pt>
                <c:pt idx="351" formatCode="General">
                  <c:v>23.782599999999999</c:v>
                </c:pt>
                <c:pt idx="352" formatCode="General">
                  <c:v>24.4985</c:v>
                </c:pt>
                <c:pt idx="353" formatCode="General">
                  <c:v>25.235900000000001</c:v>
                </c:pt>
                <c:pt idx="354" formatCode="General">
                  <c:v>25.351600000000001</c:v>
                </c:pt>
                <c:pt idx="355" formatCode="General">
                  <c:v>25.4678</c:v>
                </c:pt>
                <c:pt idx="356" formatCode="General">
                  <c:v>25.584499999999998</c:v>
                </c:pt>
                <c:pt idx="357" formatCode="General">
                  <c:v>25.701799999999999</c:v>
                </c:pt>
                <c:pt idx="358" formatCode="General">
                  <c:v>25.819600000000001</c:v>
                </c:pt>
                <c:pt idx="359" formatCode="General">
                  <c:v>25.9925</c:v>
                </c:pt>
                <c:pt idx="360" formatCode="General">
                  <c:v>26.166699999999999</c:v>
                </c:pt>
                <c:pt idx="361" formatCode="General">
                  <c:v>26.341899999999999</c:v>
                </c:pt>
                <c:pt idx="362" formatCode="General">
                  <c:v>26.5184</c:v>
                </c:pt>
                <c:pt idx="363" formatCode="General">
                  <c:v>26.868300000000001</c:v>
                </c:pt>
                <c:pt idx="364" formatCode="General">
                  <c:v>27.222799999999999</c:v>
                </c:pt>
                <c:pt idx="365" formatCode="General">
                  <c:v>27.581900000000001</c:v>
                </c:pt>
                <c:pt idx="366" formatCode="General">
                  <c:v>27.945799999999998</c:v>
                </c:pt>
                <c:pt idx="367" formatCode="General">
                  <c:v>28.436299999999999</c:v>
                </c:pt>
                <c:pt idx="368" formatCode="General">
                  <c:v>28.935300000000002</c:v>
                </c:pt>
                <c:pt idx="369" formatCode="General">
                  <c:v>29.443100000000001</c:v>
                </c:pt>
                <c:pt idx="370" formatCode="General">
                  <c:v>29.863800000000001</c:v>
                </c:pt>
                <c:pt idx="371" formatCode="General">
                  <c:v>30.290500000000002</c:v>
                </c:pt>
                <c:pt idx="372" formatCode="General">
                  <c:v>30.723299999999998</c:v>
                </c:pt>
                <c:pt idx="373" formatCode="General">
                  <c:v>31.162199999999999</c:v>
                </c:pt>
                <c:pt idx="374" formatCode="General">
                  <c:v>31.607299999999999</c:v>
                </c:pt>
                <c:pt idx="375" formatCode="General">
                  <c:v>32.058700000000002</c:v>
                </c:pt>
                <c:pt idx="376" formatCode="General">
                  <c:v>32.516599999999997</c:v>
                </c:pt>
                <c:pt idx="377" formatCode="General">
                  <c:v>32.980899999999998</c:v>
                </c:pt>
                <c:pt idx="378" formatCode="General">
                  <c:v>33.610300000000002</c:v>
                </c:pt>
                <c:pt idx="379" formatCode="General">
                  <c:v>34.251600000000003</c:v>
                </c:pt>
                <c:pt idx="380" formatCode="General">
                  <c:v>34.749400000000001</c:v>
                </c:pt>
                <c:pt idx="381" formatCode="General">
                  <c:v>35.254300000000001</c:v>
                </c:pt>
                <c:pt idx="382" formatCode="General">
                  <c:v>35.766500000000001</c:v>
                </c:pt>
                <c:pt idx="383" formatCode="General">
                  <c:v>36.286000000000001</c:v>
                </c:pt>
                <c:pt idx="384" formatCode="General">
                  <c:v>36.813000000000002</c:v>
                </c:pt>
                <c:pt idx="385" formatCode="General">
                  <c:v>37.3476</c:v>
                </c:pt>
                <c:pt idx="386" formatCode="General">
                  <c:v>37.889800000000001</c:v>
                </c:pt>
                <c:pt idx="387" formatCode="General">
                  <c:v>38.439700000000002</c:v>
                </c:pt>
                <c:pt idx="388" formatCode="General">
                  <c:v>39.109200000000001</c:v>
                </c:pt>
                <c:pt idx="389" formatCode="General">
                  <c:v>39.790199999999999</c:v>
                </c:pt>
                <c:pt idx="390" formatCode="General">
                  <c:v>40.482799999999997</c:v>
                </c:pt>
                <c:pt idx="391" formatCode="General">
                  <c:v>41.1873</c:v>
                </c:pt>
                <c:pt idx="392" formatCode="General">
                  <c:v>41.903799999999997</c:v>
                </c:pt>
                <c:pt idx="393" formatCode="General">
                  <c:v>42.6325</c:v>
                </c:pt>
                <c:pt idx="394" formatCode="General">
                  <c:v>43.454099999999997</c:v>
                </c:pt>
                <c:pt idx="395" formatCode="General">
                  <c:v>44.291200000000003</c:v>
                </c:pt>
                <c:pt idx="396" formatCode="General">
                  <c:v>45.144100000000002</c:v>
                </c:pt>
                <c:pt idx="397" formatCode="General">
                  <c:v>45.851799999999997</c:v>
                </c:pt>
                <c:pt idx="398" formatCode="General">
                  <c:v>46.570399999999999</c:v>
                </c:pt>
                <c:pt idx="399" formatCode="General">
                  <c:v>47.299799999999998</c:v>
                </c:pt>
                <c:pt idx="400" formatCode="General">
                  <c:v>48.040300000000002</c:v>
                </c:pt>
                <c:pt idx="401" formatCode="General">
                  <c:v>48.792000000000002</c:v>
                </c:pt>
                <c:pt idx="402" formatCode="General">
                  <c:v>49.554900000000004</c:v>
                </c:pt>
                <c:pt idx="403" formatCode="General">
                  <c:v>50.3294</c:v>
                </c:pt>
                <c:pt idx="404" formatCode="General">
                  <c:v>51.115400000000001</c:v>
                </c:pt>
                <c:pt idx="405" formatCode="General">
                  <c:v>51.9131</c:v>
                </c:pt>
                <c:pt idx="406" formatCode="General">
                  <c:v>52.722700000000003</c:v>
                </c:pt>
                <c:pt idx="407" formatCode="General">
                  <c:v>53.5441</c:v>
                </c:pt>
                <c:pt idx="408" formatCode="General">
                  <c:v>54.377600000000001</c:v>
                </c:pt>
                <c:pt idx="409" formatCode="General">
                  <c:v>55.223300000000002</c:v>
                </c:pt>
                <c:pt idx="410" formatCode="General">
                  <c:v>56.081200000000003</c:v>
                </c:pt>
                <c:pt idx="411" formatCode="General">
                  <c:v>56.9514</c:v>
                </c:pt>
                <c:pt idx="412" formatCode="General">
                  <c:v>57.8339</c:v>
                </c:pt>
                <c:pt idx="413" formatCode="General">
                  <c:v>58.728900000000003</c:v>
                </c:pt>
                <c:pt idx="414" formatCode="General">
                  <c:v>59.469499999999996</c:v>
                </c:pt>
                <c:pt idx="415" formatCode="General">
                  <c:v>60.218400000000003</c:v>
                </c:pt>
                <c:pt idx="416" formatCode="General">
                  <c:v>60.9756</c:v>
                </c:pt>
                <c:pt idx="417" formatCode="General">
                  <c:v>61.741199999999999</c:v>
                </c:pt>
                <c:pt idx="418" formatCode="General">
                  <c:v>62.514899999999997</c:v>
                </c:pt>
                <c:pt idx="419" formatCode="General">
                  <c:v>63.296900000000001</c:v>
                </c:pt>
                <c:pt idx="420" formatCode="General">
                  <c:v>64.087000000000003</c:v>
                </c:pt>
                <c:pt idx="421" formatCode="General">
                  <c:v>64.885199999999998</c:v>
                </c:pt>
                <c:pt idx="422" formatCode="General">
                  <c:v>65.553100000000001</c:v>
                </c:pt>
                <c:pt idx="423" formatCode="General">
                  <c:v>66.075500000000005</c:v>
                </c:pt>
                <c:pt idx="424" formatCode="General">
                  <c:v>66.600999999999999</c:v>
                </c:pt>
                <c:pt idx="425" formatCode="General">
                  <c:v>66.684799999999996</c:v>
                </c:pt>
                <c:pt idx="426" formatCode="General">
                  <c:v>66.768699999999995</c:v>
                </c:pt>
                <c:pt idx="427" formatCode="General">
                  <c:v>66.852699999999999</c:v>
                </c:pt>
                <c:pt idx="428" formatCode="General">
                  <c:v>66.936800000000005</c:v>
                </c:pt>
                <c:pt idx="429" formatCode="General">
                  <c:v>67.021000000000001</c:v>
                </c:pt>
                <c:pt idx="430" formatCode="General">
                  <c:v>67.156700000000001</c:v>
                </c:pt>
                <c:pt idx="431" formatCode="General">
                  <c:v>67.292500000000004</c:v>
                </c:pt>
                <c:pt idx="432" formatCode="General">
                  <c:v>67.428600000000003</c:v>
                </c:pt>
                <c:pt idx="433" formatCode="General">
                  <c:v>67.564899999999994</c:v>
                </c:pt>
                <c:pt idx="434" formatCode="General">
                  <c:v>67.701300000000003</c:v>
                </c:pt>
                <c:pt idx="435" formatCode="General">
                  <c:v>67.958600000000004</c:v>
                </c:pt>
                <c:pt idx="436" formatCode="General">
                  <c:v>68.2166</c:v>
                </c:pt>
                <c:pt idx="437" formatCode="General">
                  <c:v>68.475300000000004</c:v>
                </c:pt>
                <c:pt idx="438" formatCode="General">
                  <c:v>68.734700000000004</c:v>
                </c:pt>
                <c:pt idx="439" formatCode="General">
                  <c:v>68.994699999999995</c:v>
                </c:pt>
                <c:pt idx="440" formatCode="General">
                  <c:v>69.413799999999995</c:v>
                </c:pt>
                <c:pt idx="441" formatCode="General">
                  <c:v>69.834599999999995</c:v>
                </c:pt>
                <c:pt idx="442" formatCode="General">
                  <c:v>70.257000000000005</c:v>
                </c:pt>
                <c:pt idx="443" formatCode="General">
                  <c:v>70.680800000000005</c:v>
                </c:pt>
                <c:pt idx="444" formatCode="General">
                  <c:v>71.106099999999998</c:v>
                </c:pt>
                <c:pt idx="445" formatCode="General">
                  <c:v>71.654899999999998</c:v>
                </c:pt>
                <c:pt idx="446" formatCode="General">
                  <c:v>72.205799999999996</c:v>
                </c:pt>
                <c:pt idx="447" formatCode="General">
                  <c:v>72.758600000000001</c:v>
                </c:pt>
                <c:pt idx="448" formatCode="General">
                  <c:v>73.313000000000002</c:v>
                </c:pt>
                <c:pt idx="449" formatCode="General">
                  <c:v>73.868899999999996</c:v>
                </c:pt>
                <c:pt idx="450" formatCode="General">
                  <c:v>74.426000000000002</c:v>
                </c:pt>
                <c:pt idx="451" formatCode="General">
                  <c:v>74.983999999999995</c:v>
                </c:pt>
                <c:pt idx="452" formatCode="General">
                  <c:v>75.542599999999993</c:v>
                </c:pt>
                <c:pt idx="453" formatCode="General">
                  <c:v>75.9696</c:v>
                </c:pt>
                <c:pt idx="454" formatCode="General">
                  <c:v>76.300700000000006</c:v>
                </c:pt>
                <c:pt idx="455" formatCode="General">
                  <c:v>76.631600000000006</c:v>
                </c:pt>
                <c:pt idx="456" formatCode="General">
                  <c:v>76.962400000000002</c:v>
                </c:pt>
                <c:pt idx="457" formatCode="General">
                  <c:v>77.2928</c:v>
                </c:pt>
                <c:pt idx="458" formatCode="General">
                  <c:v>77.622699999999995</c:v>
                </c:pt>
                <c:pt idx="459" formatCode="General">
                  <c:v>77.952100000000002</c:v>
                </c:pt>
                <c:pt idx="460" formatCode="General">
                  <c:v>78.280699999999996</c:v>
                </c:pt>
                <c:pt idx="461" formatCode="General">
                  <c:v>78.608500000000006</c:v>
                </c:pt>
                <c:pt idx="462" formatCode="General">
                  <c:v>78.935299999999998</c:v>
                </c:pt>
                <c:pt idx="463" formatCode="General">
                  <c:v>79.339200000000005</c:v>
                </c:pt>
                <c:pt idx="464" formatCode="General">
                  <c:v>79.741</c:v>
                </c:pt>
                <c:pt idx="465" formatCode="General">
                  <c:v>80.140299999999996</c:v>
                </c:pt>
                <c:pt idx="466" formatCode="General">
                  <c:v>80.536699999999996</c:v>
                </c:pt>
                <c:pt idx="467" formatCode="General">
                  <c:v>80.9298</c:v>
                </c:pt>
                <c:pt idx="468" formatCode="General">
                  <c:v>81.231800000000007</c:v>
                </c:pt>
                <c:pt idx="469" formatCode="General">
                  <c:v>81.485699999999994</c:v>
                </c:pt>
                <c:pt idx="470" formatCode="General">
                  <c:v>81.7376</c:v>
                </c:pt>
                <c:pt idx="471" formatCode="General">
                  <c:v>81.987399999999994</c:v>
                </c:pt>
                <c:pt idx="472" formatCode="General">
                  <c:v>82.234899999999996</c:v>
                </c:pt>
                <c:pt idx="473" formatCode="General">
                  <c:v>82.48</c:v>
                </c:pt>
                <c:pt idx="474" formatCode="General">
                  <c:v>82.722399999999993</c:v>
                </c:pt>
                <c:pt idx="475" formatCode="General">
                  <c:v>82.962000000000003</c:v>
                </c:pt>
                <c:pt idx="476" formatCode="General">
                  <c:v>83.198499999999996</c:v>
                </c:pt>
                <c:pt idx="477" formatCode="General">
                  <c:v>83.459000000000003</c:v>
                </c:pt>
                <c:pt idx="478" formatCode="General">
                  <c:v>83.715199999999996</c:v>
                </c:pt>
                <c:pt idx="479" formatCode="General">
                  <c:v>83.966499999999996</c:v>
                </c:pt>
                <c:pt idx="480" formatCode="General">
                  <c:v>84.212599999999995</c:v>
                </c:pt>
                <c:pt idx="481" formatCode="General">
                  <c:v>84.453100000000006</c:v>
                </c:pt>
                <c:pt idx="482" formatCode="General">
                  <c:v>84.715900000000005</c:v>
                </c:pt>
                <c:pt idx="483" formatCode="General">
                  <c:v>84.970399999999998</c:v>
                </c:pt>
                <c:pt idx="484" formatCode="General">
                  <c:v>85.215999999999994</c:v>
                </c:pt>
                <c:pt idx="485" formatCode="General">
                  <c:v>85.451899999999995</c:v>
                </c:pt>
                <c:pt idx="486" formatCode="General">
                  <c:v>85.677300000000002</c:v>
                </c:pt>
                <c:pt idx="487" formatCode="General">
                  <c:v>85.914900000000003</c:v>
                </c:pt>
                <c:pt idx="488" formatCode="General">
                  <c:v>86.137299999999996</c:v>
                </c:pt>
                <c:pt idx="489" formatCode="General">
                  <c:v>86.343000000000004</c:v>
                </c:pt>
                <c:pt idx="490" formatCode="General">
                  <c:v>86.530500000000004</c:v>
                </c:pt>
                <c:pt idx="491" formatCode="General">
                  <c:v>86.698499999999996</c:v>
                </c:pt>
                <c:pt idx="492" formatCode="General">
                  <c:v>86.876599999999996</c:v>
                </c:pt>
                <c:pt idx="493" formatCode="General">
                  <c:v>87.018699999999995</c:v>
                </c:pt>
                <c:pt idx="494" formatCode="General">
                  <c:v>87.120999999999995</c:v>
                </c:pt>
                <c:pt idx="495" formatCode="General">
                  <c:v>87.179699999999997</c:v>
                </c:pt>
                <c:pt idx="496" formatCode="General">
                  <c:v>87.1905</c:v>
                </c:pt>
                <c:pt idx="497" formatCode="General">
                  <c:v>87.148799999999994</c:v>
                </c:pt>
                <c:pt idx="498" formatCode="General">
                  <c:v>87.049899999999994</c:v>
                </c:pt>
                <c:pt idx="499" formatCode="General">
                  <c:v>86.888499999999993</c:v>
                </c:pt>
                <c:pt idx="500" formatCode="General">
                  <c:v>86.659199999999998</c:v>
                </c:pt>
                <c:pt idx="501" formatCode="General">
                  <c:v>86.618399999999994</c:v>
                </c:pt>
                <c:pt idx="502" formatCode="General">
                  <c:v>86.575999999999993</c:v>
                </c:pt>
                <c:pt idx="503" formatCode="General">
                  <c:v>86.531899999999993</c:v>
                </c:pt>
                <c:pt idx="504" formatCode="General">
                  <c:v>86.486000000000004</c:v>
                </c:pt>
                <c:pt idx="505" formatCode="General">
                  <c:v>86.438400000000001</c:v>
                </c:pt>
                <c:pt idx="506" formatCode="General">
                  <c:v>86.337800000000001</c:v>
                </c:pt>
                <c:pt idx="507" formatCode="General">
                  <c:v>86.229900000000001</c:v>
                </c:pt>
                <c:pt idx="508" formatCode="General">
                  <c:v>86.114699999999999</c:v>
                </c:pt>
                <c:pt idx="509" formatCode="General">
                  <c:v>85.991900000000001</c:v>
                </c:pt>
                <c:pt idx="510" formatCode="General">
                  <c:v>85.791300000000007</c:v>
                </c:pt>
                <c:pt idx="511" formatCode="General">
                  <c:v>85.572299999999998</c:v>
                </c:pt>
                <c:pt idx="512" formatCode="General">
                  <c:v>85.334400000000002</c:v>
                </c:pt>
                <c:pt idx="513" formatCode="General">
                  <c:v>85.076899999999995</c:v>
                </c:pt>
                <c:pt idx="514" formatCode="General">
                  <c:v>84.715699999999998</c:v>
                </c:pt>
                <c:pt idx="515" formatCode="General">
                  <c:v>84.319599999999994</c:v>
                </c:pt>
                <c:pt idx="516" formatCode="General">
                  <c:v>83.8874</c:v>
                </c:pt>
                <c:pt idx="517" formatCode="General">
                  <c:v>83.4178</c:v>
                </c:pt>
                <c:pt idx="518" formatCode="General">
                  <c:v>82.909300000000002</c:v>
                </c:pt>
                <c:pt idx="519" formatCode="General">
                  <c:v>82.360799999999998</c:v>
                </c:pt>
                <c:pt idx="520" formatCode="General">
                  <c:v>81.770799999999994</c:v>
                </c:pt>
                <c:pt idx="521" formatCode="General">
                  <c:v>81.138199999999998</c:v>
                </c:pt>
                <c:pt idx="522" formatCode="General">
                  <c:v>80.220100000000002</c:v>
                </c:pt>
                <c:pt idx="523" formatCode="General">
                  <c:v>79.220299999999995</c:v>
                </c:pt>
                <c:pt idx="524" formatCode="General">
                  <c:v>78.135999999999996</c:v>
                </c:pt>
                <c:pt idx="525" formatCode="General">
                  <c:v>76.965000000000003</c:v>
                </c:pt>
                <c:pt idx="526" formatCode="General">
                  <c:v>75.705299999999994</c:v>
                </c:pt>
                <c:pt idx="527" formatCode="General">
                  <c:v>74.3553</c:v>
                </c:pt>
                <c:pt idx="528" formatCode="General">
                  <c:v>72.913799999999995</c:v>
                </c:pt>
                <c:pt idx="529" formatCode="General">
                  <c:v>71.380399999999995</c:v>
                </c:pt>
                <c:pt idx="530" formatCode="General">
                  <c:v>69.754900000000006</c:v>
                </c:pt>
                <c:pt idx="531" formatCode="General">
                  <c:v>68.037999999999997</c:v>
                </c:pt>
                <c:pt idx="532" formatCode="General">
                  <c:v>66.231200000000001</c:v>
                </c:pt>
                <c:pt idx="533" formatCode="General">
                  <c:v>64.336600000000004</c:v>
                </c:pt>
                <c:pt idx="534" formatCode="General">
                  <c:v>62.357399999999998</c:v>
                </c:pt>
                <c:pt idx="535" formatCode="General">
                  <c:v>60.297400000000003</c:v>
                </c:pt>
                <c:pt idx="536" formatCode="General">
                  <c:v>58.531700000000001</c:v>
                </c:pt>
                <c:pt idx="537" formatCode="General">
                  <c:v>56.717100000000002</c:v>
                </c:pt>
                <c:pt idx="538" formatCode="General">
                  <c:v>54.857399999999998</c:v>
                </c:pt>
                <c:pt idx="539" formatCode="General">
                  <c:v>52.956899999999997</c:v>
                </c:pt>
                <c:pt idx="540" formatCode="General">
                  <c:v>51.020200000000003</c:v>
                </c:pt>
                <c:pt idx="541" formatCode="General">
                  <c:v>49.052300000000002</c:v>
                </c:pt>
                <c:pt idx="542" formatCode="General">
                  <c:v>47.058900000000001</c:v>
                </c:pt>
                <c:pt idx="543" formatCode="General">
                  <c:v>45.0458</c:v>
                </c:pt>
                <c:pt idx="544" formatCode="General">
                  <c:v>43.3872</c:v>
                </c:pt>
                <c:pt idx="545" formatCode="General">
                  <c:v>41.723199999999999</c:v>
                </c:pt>
                <c:pt idx="546" formatCode="General">
                  <c:v>40.057200000000002</c:v>
                </c:pt>
                <c:pt idx="547" formatCode="General">
                  <c:v>38.393099999999997</c:v>
                </c:pt>
                <c:pt idx="548" formatCode="General">
                  <c:v>36.7346</c:v>
                </c:pt>
                <c:pt idx="549" formatCode="General">
                  <c:v>34.832900000000002</c:v>
                </c:pt>
                <c:pt idx="550" formatCode="General">
                  <c:v>32.9497</c:v>
                </c:pt>
                <c:pt idx="551" formatCode="General">
                  <c:v>31.090699999999998</c:v>
                </c:pt>
                <c:pt idx="552" formatCode="General">
                  <c:v>29.261700000000001</c:v>
                </c:pt>
                <c:pt idx="553" formatCode="General">
                  <c:v>27.4682</c:v>
                </c:pt>
                <c:pt idx="554" formatCode="General">
                  <c:v>25.715499999999999</c:v>
                </c:pt>
                <c:pt idx="555" formatCode="General">
                  <c:v>24.008600000000001</c:v>
                </c:pt>
                <c:pt idx="556" formatCode="General">
                  <c:v>22.3522</c:v>
                </c:pt>
                <c:pt idx="557" formatCode="General">
                  <c:v>20.750399999999999</c:v>
                </c:pt>
                <c:pt idx="558" formatCode="General">
                  <c:v>19.2073</c:v>
                </c:pt>
                <c:pt idx="559" formatCode="General">
                  <c:v>17.725999999999999</c:v>
                </c:pt>
                <c:pt idx="560" formatCode="General">
                  <c:v>16.543900000000001</c:v>
                </c:pt>
                <c:pt idx="561" formatCode="General">
                  <c:v>15.4079</c:v>
                </c:pt>
                <c:pt idx="562" formatCode="General">
                  <c:v>14.319000000000001</c:v>
                </c:pt>
                <c:pt idx="563" formatCode="General">
                  <c:v>13.2782</c:v>
                </c:pt>
                <c:pt idx="564" formatCode="General">
                  <c:v>12.286</c:v>
                </c:pt>
                <c:pt idx="565" formatCode="General">
                  <c:v>11.342599999999999</c:v>
                </c:pt>
                <c:pt idx="566" formatCode="General">
                  <c:v>10.4481</c:v>
                </c:pt>
                <c:pt idx="567" formatCode="General">
                  <c:v>9.6023800000000001</c:v>
                </c:pt>
                <c:pt idx="568" formatCode="General">
                  <c:v>8.6530299999999993</c:v>
                </c:pt>
                <c:pt idx="569" formatCode="General">
                  <c:v>7.7717700000000001</c:v>
                </c:pt>
                <c:pt idx="570" formatCode="General">
                  <c:v>6.9569999999999999</c:v>
                </c:pt>
                <c:pt idx="571" formatCode="General">
                  <c:v>6.3570599999999997</c:v>
                </c:pt>
                <c:pt idx="572" formatCode="General">
                  <c:v>5.7965600000000004</c:v>
                </c:pt>
                <c:pt idx="573" formatCode="General">
                  <c:v>5.2742399999999998</c:v>
                </c:pt>
                <c:pt idx="574" formatCode="General">
                  <c:v>4.7887599999999999</c:v>
                </c:pt>
                <c:pt idx="575" formatCode="General">
                  <c:v>4.4402699999999999</c:v>
                </c:pt>
                <c:pt idx="576" formatCode="General">
                  <c:v>4.17422</c:v>
                </c:pt>
                <c:pt idx="577" formatCode="General">
                  <c:v>3.9209100000000001</c:v>
                </c:pt>
                <c:pt idx="578" formatCode="General">
                  <c:v>3.7160000000000002</c:v>
                </c:pt>
                <c:pt idx="579" formatCode="General">
                  <c:v>3.5588199999999999</c:v>
                </c:pt>
                <c:pt idx="580" formatCode="General">
                  <c:v>3.4070200000000002</c:v>
                </c:pt>
                <c:pt idx="581" formatCode="General">
                  <c:v>3.3854500000000001</c:v>
                </c:pt>
                <c:pt idx="582" formatCode="General">
                  <c:v>3.3639800000000002</c:v>
                </c:pt>
                <c:pt idx="583" formatCode="General">
                  <c:v>3.3426200000000001</c:v>
                </c:pt>
                <c:pt idx="584" formatCode="General">
                  <c:v>3.3213699999999999</c:v>
                </c:pt>
                <c:pt idx="585" formatCode="General">
                  <c:v>3.2791999999999999</c:v>
                </c:pt>
                <c:pt idx="586" formatCode="General">
                  <c:v>3.23746</c:v>
                </c:pt>
                <c:pt idx="587" formatCode="General">
                  <c:v>3.1961499999999998</c:v>
                </c:pt>
                <c:pt idx="588" formatCode="General">
                  <c:v>3.1552799999999999</c:v>
                </c:pt>
                <c:pt idx="589" formatCode="General">
                  <c:v>3.03586</c:v>
                </c:pt>
                <c:pt idx="590" formatCode="General">
                  <c:v>2.92015</c:v>
                </c:pt>
                <c:pt idx="591" formatCode="General">
                  <c:v>2.8080599999999998</c:v>
                </c:pt>
                <c:pt idx="592" formatCode="General">
                  <c:v>2.6995300000000002</c:v>
                </c:pt>
                <c:pt idx="593" formatCode="General">
                  <c:v>2.4997600000000002</c:v>
                </c:pt>
                <c:pt idx="594" formatCode="General">
                  <c:v>2.3123900000000002</c:v>
                </c:pt>
                <c:pt idx="595" formatCode="General">
                  <c:v>2.13686</c:v>
                </c:pt>
                <c:pt idx="596" formatCode="General">
                  <c:v>1.9726300000000001</c:v>
                </c:pt>
                <c:pt idx="597" formatCode="General">
                  <c:v>1.8191600000000001</c:v>
                </c:pt>
                <c:pt idx="598" formatCode="General">
                  <c:v>1.65022</c:v>
                </c:pt>
                <c:pt idx="599" formatCode="General">
                  <c:v>1.4948399999999999</c:v>
                </c:pt>
                <c:pt idx="600" formatCode="General">
                  <c:v>1.3521799999999999</c:v>
                </c:pt>
                <c:pt idx="601" formatCode="General">
                  <c:v>1.22143</c:v>
                </c:pt>
                <c:pt idx="602" formatCode="General">
                  <c:v>1.10179</c:v>
                </c:pt>
                <c:pt idx="603" formatCode="General">
                  <c:v>0.99250400000000005</c:v>
                </c:pt>
                <c:pt idx="604" formatCode="General">
                  <c:v>0.892845</c:v>
                </c:pt>
                <c:pt idx="605" formatCode="General">
                  <c:v>0.80211500000000002</c:v>
                </c:pt>
                <c:pt idx="606" formatCode="General">
                  <c:v>0.73967899999999998</c:v>
                </c:pt>
                <c:pt idx="607" formatCode="General">
                  <c:v>0.68160100000000001</c:v>
                </c:pt>
                <c:pt idx="608" formatCode="General">
                  <c:v>0.62762799999999996</c:v>
                </c:pt>
                <c:pt idx="609" formatCode="General">
                  <c:v>0.586816</c:v>
                </c:pt>
                <c:pt idx="610" formatCode="General">
                  <c:v>0.54840199999999995</c:v>
                </c:pt>
                <c:pt idx="611" formatCode="General">
                  <c:v>0.54247500000000004</c:v>
                </c:pt>
                <c:pt idx="612" formatCode="General">
                  <c:v>0.536605</c:v>
                </c:pt>
                <c:pt idx="613" formatCode="General">
                  <c:v>0.53079299999999996</c:v>
                </c:pt>
                <c:pt idx="614" formatCode="General">
                  <c:v>0.525038</c:v>
                </c:pt>
                <c:pt idx="615" formatCode="General">
                  <c:v>0.519339</c:v>
                </c:pt>
                <c:pt idx="616" formatCode="General">
                  <c:v>0.50997400000000004</c:v>
                </c:pt>
                <c:pt idx="617" formatCode="General">
                  <c:v>0.50076200000000004</c:v>
                </c:pt>
                <c:pt idx="618" formatCode="General">
                  <c:v>0.49170000000000003</c:v>
                </c:pt>
                <c:pt idx="619" formatCode="General">
                  <c:v>0.48278700000000002</c:v>
                </c:pt>
                <c:pt idx="620" formatCode="General">
                  <c:v>0.46055099999999999</c:v>
                </c:pt>
                <c:pt idx="621" formatCode="General">
                  <c:v>0.43924800000000003</c:v>
                </c:pt>
                <c:pt idx="622" formatCode="General">
                  <c:v>0.41884199999999999</c:v>
                </c:pt>
                <c:pt idx="623" formatCode="General">
                  <c:v>0.39930199999999999</c:v>
                </c:pt>
                <c:pt idx="624" formatCode="General">
                  <c:v>0.37595099999999998</c:v>
                </c:pt>
                <c:pt idx="625" formatCode="General">
                  <c:v>0.353852</c:v>
                </c:pt>
                <c:pt idx="626" formatCode="General">
                  <c:v>0.33294600000000002</c:v>
                </c:pt>
                <c:pt idx="627" formatCode="General">
                  <c:v>0.31317800000000001</c:v>
                </c:pt>
                <c:pt idx="628" formatCode="General">
                  <c:v>0.29449199999999998</c:v>
                </c:pt>
                <c:pt idx="629" formatCode="General">
                  <c:v>0.27331499999999997</c:v>
                </c:pt>
                <c:pt idx="630" formatCode="General">
                  <c:v>0.25355</c:v>
                </c:pt>
                <c:pt idx="631" formatCode="General">
                  <c:v>0.23511199999999999</c:v>
                </c:pt>
                <c:pt idx="632" formatCode="General">
                  <c:v>0.217922</c:v>
                </c:pt>
                <c:pt idx="633" formatCode="General">
                  <c:v>0.201903</c:v>
                </c:pt>
                <c:pt idx="634" formatCode="General">
                  <c:v>0.18418399999999999</c:v>
                </c:pt>
                <c:pt idx="635" formatCode="General">
                  <c:v>0.16792199999999999</c:v>
                </c:pt>
                <c:pt idx="636" formatCode="General">
                  <c:v>0.15300800000000001</c:v>
                </c:pt>
                <c:pt idx="637" formatCode="General">
                  <c:v>0.13934199999999999</c:v>
                </c:pt>
                <c:pt idx="638" formatCode="General">
                  <c:v>0.12682599999999999</c:v>
                </c:pt>
                <c:pt idx="639" formatCode="General">
                  <c:v>0.113625</c:v>
                </c:pt>
                <c:pt idx="640" formatCode="General">
                  <c:v>0.101726</c:v>
                </c:pt>
                <c:pt idx="641" formatCode="General">
                  <c:v>9.1011700000000001E-2</c:v>
                </c:pt>
                <c:pt idx="642" formatCode="General">
                  <c:v>8.3326300000000006E-2</c:v>
                </c:pt>
                <c:pt idx="643" formatCode="General">
                  <c:v>8.2169400000000004E-2</c:v>
                </c:pt>
                <c:pt idx="644" formatCode="General">
                  <c:v>8.1027600000000005E-2</c:v>
                </c:pt>
                <c:pt idx="645" formatCode="General">
                  <c:v>7.9901E-2</c:v>
                </c:pt>
                <c:pt idx="646" formatCode="General">
                  <c:v>7.8789200000000004E-2</c:v>
                </c:pt>
                <c:pt idx="647" formatCode="General">
                  <c:v>7.76921E-2</c:v>
                </c:pt>
                <c:pt idx="648" formatCode="General">
                  <c:v>7.5541300000000006E-2</c:v>
                </c:pt>
                <c:pt idx="649" formatCode="General">
                  <c:v>7.3447200000000004E-2</c:v>
                </c:pt>
                <c:pt idx="650" formatCode="General">
                  <c:v>7.1408299999999994E-2</c:v>
                </c:pt>
                <c:pt idx="651" formatCode="General">
                  <c:v>6.9423299999999993E-2</c:v>
                </c:pt>
                <c:pt idx="652" formatCode="General">
                  <c:v>6.7490900000000006E-2</c:v>
                </c:pt>
                <c:pt idx="653" formatCode="General">
                  <c:v>6.1955299999999998E-2</c:v>
                </c:pt>
                <c:pt idx="654" formatCode="General">
                  <c:v>5.6854200000000001E-2</c:v>
                </c:pt>
                <c:pt idx="655" formatCode="General">
                  <c:v>5.2155800000000002E-2</c:v>
                </c:pt>
                <c:pt idx="656" formatCode="General">
                  <c:v>4.7829999999999998E-2</c:v>
                </c:pt>
                <c:pt idx="657" formatCode="General">
                  <c:v>4.3848999999999999E-2</c:v>
                </c:pt>
                <c:pt idx="658" formatCode="General">
                  <c:v>3.96151E-2</c:v>
                </c:pt>
                <c:pt idx="659" formatCode="General">
                  <c:v>3.5775399999999999E-2</c:v>
                </c:pt>
                <c:pt idx="660" formatCode="General">
                  <c:v>3.2294999999999997E-2</c:v>
                </c:pt>
                <c:pt idx="661" formatCode="General">
                  <c:v>2.9142000000000001E-2</c:v>
                </c:pt>
                <c:pt idx="662" formatCode="General">
                  <c:v>2.6287100000000001E-2</c:v>
                </c:pt>
                <c:pt idx="663" formatCode="General">
                  <c:v>2.3703200000000001E-2</c:v>
                </c:pt>
                <c:pt idx="664" formatCode="General">
                  <c:v>2.10441E-2</c:v>
                </c:pt>
                <c:pt idx="665" formatCode="General">
                  <c:v>1.8675000000000001E-2</c:v>
                </c:pt>
                <c:pt idx="666" formatCode="General">
                  <c:v>1.65656E-2</c:v>
                </c:pt>
                <c:pt idx="667" formatCode="General">
                  <c:v>1.50522E-2</c:v>
                </c:pt>
                <c:pt idx="668" formatCode="General">
                  <c:v>1.3959299999999999E-2</c:v>
                </c:pt>
                <c:pt idx="669" formatCode="General">
                  <c:v>1.29438E-2</c:v>
                </c:pt>
                <c:pt idx="670" formatCode="General">
                  <c:v>1.2764599999999999E-2</c:v>
                </c:pt>
                <c:pt idx="671" formatCode="General">
                  <c:v>1.25878E-2</c:v>
                </c:pt>
                <c:pt idx="672" formatCode="General">
                  <c:v>1.24134E-2</c:v>
                </c:pt>
                <c:pt idx="673" formatCode="General">
                  <c:v>1.22414E-2</c:v>
                </c:pt>
                <c:pt idx="674" formatCode="General">
                  <c:v>1.2071699999999999E-2</c:v>
                </c:pt>
                <c:pt idx="675" formatCode="General">
                  <c:v>1.17768E-2</c:v>
                </c:pt>
                <c:pt idx="676" formatCode="General">
                  <c:v>1.14889E-2</c:v>
                </c:pt>
                <c:pt idx="677" formatCode="General">
                  <c:v>1.12079E-2</c:v>
                </c:pt>
                <c:pt idx="678" formatCode="General">
                  <c:v>1.09336E-2</c:v>
                </c:pt>
                <c:pt idx="679" formatCode="General">
                  <c:v>1.0665900000000001E-2</c:v>
                </c:pt>
                <c:pt idx="680" formatCode="General">
                  <c:v>1.0148000000000001E-2</c:v>
                </c:pt>
                <c:pt idx="681" formatCode="General">
                  <c:v>9.6546099999999992E-3</c:v>
                </c:pt>
                <c:pt idx="682" formatCode="General">
                  <c:v>9.1847200000000004E-3</c:v>
                </c:pt>
                <c:pt idx="683" formatCode="General">
                  <c:v>8.7372100000000005E-3</c:v>
                </c:pt>
                <c:pt idx="684" formatCode="General">
                  <c:v>8.3110500000000004E-3</c:v>
                </c:pt>
                <c:pt idx="685" formatCode="General">
                  <c:v>7.6970299999999997E-3</c:v>
                </c:pt>
                <c:pt idx="686" formatCode="General">
                  <c:v>7.1275000000000002E-3</c:v>
                </c:pt>
                <c:pt idx="687" formatCode="General">
                  <c:v>6.5993299999999996E-3</c:v>
                </c:pt>
                <c:pt idx="688" formatCode="General">
                  <c:v>6.1095999999999998E-3</c:v>
                </c:pt>
                <c:pt idx="689" formatCode="General">
                  <c:v>5.6555700000000004E-3</c:v>
                </c:pt>
                <c:pt idx="690" formatCode="General">
                  <c:v>5.15249E-3</c:v>
                </c:pt>
                <c:pt idx="691" formatCode="General">
                  <c:v>4.69346E-3</c:v>
                </c:pt>
                <c:pt idx="692" formatCode="General">
                  <c:v>4.2747000000000002E-3</c:v>
                </c:pt>
                <c:pt idx="693" formatCode="General">
                  <c:v>3.8927599999999999E-3</c:v>
                </c:pt>
                <c:pt idx="694" formatCode="General">
                  <c:v>3.54448E-3</c:v>
                </c:pt>
                <c:pt idx="695" formatCode="General">
                  <c:v>3.2269400000000002E-3</c:v>
                </c:pt>
                <c:pt idx="696" formatCode="General">
                  <c:v>2.88266E-3</c:v>
                </c:pt>
                <c:pt idx="697" formatCode="General">
                  <c:v>2.5746800000000002E-3</c:v>
                </c:pt>
                <c:pt idx="698" formatCode="General">
                  <c:v>2.2992400000000001E-3</c:v>
                </c:pt>
                <c:pt idx="699" formatCode="General">
                  <c:v>2.0529599999999999E-3</c:v>
                </c:pt>
                <c:pt idx="700" formatCode="General">
                  <c:v>1.83281E-3</c:v>
                </c:pt>
                <c:pt idx="701" formatCode="General">
                  <c:v>1.63605E-3</c:v>
                </c:pt>
                <c:pt idx="702" formatCode="General">
                  <c:v>1.4602300000000001E-3</c:v>
                </c:pt>
                <c:pt idx="703" formatCode="General">
                  <c:v>1.30316E-3</c:v>
                </c:pt>
                <c:pt idx="704" formatCode="General">
                  <c:v>1.1628599999999999E-3</c:v>
                </c:pt>
                <c:pt idx="705" formatCode="General">
                  <c:v>1.0375600000000001E-3</c:v>
                </c:pt>
                <c:pt idx="706" formatCode="General">
                  <c:v>9.2568000000000001E-4</c:v>
                </c:pt>
                <c:pt idx="707" formatCode="General">
                  <c:v>8.2579400000000003E-4</c:v>
                </c:pt>
                <c:pt idx="708" formatCode="General">
                  <c:v>7.3663000000000005E-4</c:v>
                </c:pt>
                <c:pt idx="709" formatCode="General">
                  <c:v>6.5704900000000004E-4</c:v>
                </c:pt>
                <c:pt idx="710" formatCode="General">
                  <c:v>5.8602899999999996E-4</c:v>
                </c:pt>
                <c:pt idx="711" formatCode="General">
                  <c:v>5.2265600000000003E-4</c:v>
                </c:pt>
                <c:pt idx="712" formatCode="General">
                  <c:v>4.6611500000000002E-4</c:v>
                </c:pt>
                <c:pt idx="713" formatCode="General">
                  <c:v>4.1567200000000001E-4</c:v>
                </c:pt>
                <c:pt idx="714" formatCode="General">
                  <c:v>3.7067600000000001E-4</c:v>
                </c:pt>
                <c:pt idx="715" formatCode="General">
                  <c:v>3.3054100000000001E-4</c:v>
                </c:pt>
                <c:pt idx="716" formatCode="General">
                  <c:v>2.94744E-4</c:v>
                </c:pt>
                <c:pt idx="717" formatCode="General">
                  <c:v>2.6281999999999998E-4</c:v>
                </c:pt>
                <c:pt idx="718" formatCode="General">
                  <c:v>2.3435099999999999E-4</c:v>
                </c:pt>
                <c:pt idx="719" formatCode="General">
                  <c:v>2.08965E-4</c:v>
                </c:pt>
                <c:pt idx="720" formatCode="General">
                  <c:v>1.86329E-4</c:v>
                </c:pt>
                <c:pt idx="721" formatCode="General">
                  <c:v>1.6614599999999999E-4</c:v>
                </c:pt>
                <c:pt idx="722" formatCode="General">
                  <c:v>1.4815100000000001E-4</c:v>
                </c:pt>
                <c:pt idx="723" formatCode="General">
                  <c:v>1.3210699999999999E-4</c:v>
                </c:pt>
                <c:pt idx="724" formatCode="General">
                  <c:v>1.17803E-4</c:v>
                </c:pt>
                <c:pt idx="725" formatCode="General">
                  <c:v>1.0505000000000001E-4</c:v>
                </c:pt>
                <c:pt idx="726">
                  <c:v>9.3681E-5</c:v>
                </c:pt>
                <c:pt idx="727">
                  <c:v>8.3545400000000001E-5</c:v>
                </c:pt>
                <c:pt idx="728">
                  <c:v>7.4509299999999995E-5</c:v>
                </c:pt>
                <c:pt idx="729">
                  <c:v>6.6453599999999997E-5</c:v>
                </c:pt>
                <c:pt idx="730">
                  <c:v>5.9271799999999997E-5</c:v>
                </c:pt>
                <c:pt idx="731">
                  <c:v>5.2868899999999998E-5</c:v>
                </c:pt>
                <c:pt idx="732">
                  <c:v>4.7160400000000003E-5</c:v>
                </c:pt>
                <c:pt idx="733">
                  <c:v>4.2070899999999997E-5</c:v>
                </c:pt>
                <c:pt idx="734">
                  <c:v>3.7533200000000002E-5</c:v>
                </c:pt>
                <c:pt idx="735">
                  <c:v>3.34872E-5</c:v>
                </c:pt>
                <c:pt idx="736">
                  <c:v>2.9879500000000001E-5</c:v>
                </c:pt>
                <c:pt idx="737">
                  <c:v>2.6662600000000001E-5</c:v>
                </c:pt>
                <c:pt idx="738">
                  <c:v>2.3793899999999999E-5</c:v>
                </c:pt>
                <c:pt idx="739">
                  <c:v>2.1235700000000001E-5</c:v>
                </c:pt>
                <c:pt idx="740">
                  <c:v>1.8954099999999999E-5</c:v>
                </c:pt>
                <c:pt idx="741">
                  <c:v>1.6919299999999999E-5</c:v>
                </c:pt>
                <c:pt idx="742">
                  <c:v>1.51043E-5</c:v>
                </c:pt>
                <c:pt idx="743">
                  <c:v>1.3485299999999999E-5</c:v>
                </c:pt>
                <c:pt idx="744">
                  <c:v>1.2041100000000001E-5</c:v>
                </c:pt>
                <c:pt idx="745">
                  <c:v>1.0752599999999999E-5</c:v>
                </c:pt>
                <c:pt idx="746">
                  <c:v>9.6030600000000002E-6</c:v>
                </c:pt>
                <c:pt idx="747">
                  <c:v>8.5773399999999994E-6</c:v>
                </c:pt>
                <c:pt idx="748">
                  <c:v>7.6620299999999992E-6</c:v>
                </c:pt>
                <c:pt idx="749">
                  <c:v>6.8451900000000003E-6</c:v>
                </c:pt>
                <c:pt idx="750">
                  <c:v>6.11614E-6</c:v>
                </c:pt>
                <c:pt idx="751">
                  <c:v>5.4653900000000004E-6</c:v>
                </c:pt>
                <c:pt idx="752">
                  <c:v>4.8844899999999997E-6</c:v>
                </c:pt>
                <c:pt idx="753">
                  <c:v>4.3658699999999996E-6</c:v>
                </c:pt>
                <c:pt idx="754">
                  <c:v>3.90281E-6</c:v>
                </c:pt>
                <c:pt idx="755">
                  <c:v>3.4893100000000001E-6</c:v>
                </c:pt>
                <c:pt idx="756">
                  <c:v>3.12004E-6</c:v>
                </c:pt>
                <c:pt idx="757">
                  <c:v>2.7902200000000001E-6</c:v>
                </c:pt>
                <c:pt idx="758">
                  <c:v>2.4955999999999999E-6</c:v>
                </c:pt>
                <c:pt idx="759">
                  <c:v>2.2324E-6</c:v>
                </c:pt>
                <c:pt idx="760">
                  <c:v>1.99724E-6</c:v>
                </c:pt>
                <c:pt idx="761">
                  <c:v>1.7871100000000001E-6</c:v>
                </c:pt>
                <c:pt idx="762">
                  <c:v>1.5993099999999999E-6</c:v>
                </c:pt>
                <c:pt idx="763">
                  <c:v>1.4314599999999999E-6</c:v>
                </c:pt>
                <c:pt idx="764">
                  <c:v>1.28141E-6</c:v>
                </c:pt>
                <c:pt idx="765">
                  <c:v>1.14726E-6</c:v>
                </c:pt>
                <c:pt idx="766">
                  <c:v>1.02731E-6</c:v>
                </c:pt>
                <c:pt idx="767">
                  <c:v>9.2004599999999998E-7</c:v>
                </c:pt>
                <c:pt idx="768">
                  <c:v>8.2410600000000003E-7</c:v>
                </c:pt>
                <c:pt idx="769">
                  <c:v>7.3828600000000002E-7</c:v>
                </c:pt>
                <c:pt idx="770">
                  <c:v>6.6150700000000002E-7</c:v>
                </c:pt>
                <c:pt idx="771">
                  <c:v>5.9280600000000002E-7</c:v>
                </c:pt>
                <c:pt idx="772">
                  <c:v>5.3132599999999998E-7</c:v>
                </c:pt>
                <c:pt idx="773">
                  <c:v>4.7629900000000002E-7</c:v>
                </c:pt>
                <c:pt idx="774">
                  <c:v>4.2703999999999999E-7</c:v>
                </c:pt>
                <c:pt idx="775">
                  <c:v>3.8293899999999999E-7</c:v>
                </c:pt>
                <c:pt idx="776">
                  <c:v>3.4344899999999999E-7</c:v>
                </c:pt>
                <c:pt idx="777">
                  <c:v>3.0808300000000002E-7</c:v>
                </c:pt>
                <c:pt idx="778">
                  <c:v>2.7640499999999999E-7</c:v>
                </c:pt>
                <c:pt idx="779">
                  <c:v>2.4802599999999997E-7</c:v>
                </c:pt>
                <c:pt idx="780">
                  <c:v>2.2259899999999999E-7</c:v>
                </c:pt>
                <c:pt idx="781">
                  <c:v>1.9981299999999999E-7</c:v>
                </c:pt>
                <c:pt idx="782">
                  <c:v>1.7938999999999999E-7</c:v>
                </c:pt>
                <c:pt idx="783">
                  <c:v>1.6108200000000001E-7</c:v>
                </c:pt>
                <c:pt idx="784">
                  <c:v>1.4466900000000001E-7</c:v>
                </c:pt>
                <c:pt idx="785">
                  <c:v>1.2995E-7</c:v>
                </c:pt>
                <c:pt idx="786">
                  <c:v>1.1675E-7</c:v>
                </c:pt>
                <c:pt idx="787">
                  <c:v>1.04909E-7</c:v>
                </c:pt>
                <c:pt idx="788">
                  <c:v>9.4285500000000001E-8</c:v>
                </c:pt>
                <c:pt idx="789">
                  <c:v>8.4753099999999997E-8</c:v>
                </c:pt>
                <c:pt idx="790">
                  <c:v>7.6198299999999995E-8</c:v>
                </c:pt>
                <c:pt idx="791">
                  <c:v>6.8519200000000004E-8</c:v>
                </c:pt>
                <c:pt idx="792">
                  <c:v>6.1625300000000001E-8</c:v>
                </c:pt>
                <c:pt idx="793">
                  <c:v>5.5435E-8</c:v>
                </c:pt>
                <c:pt idx="794">
                  <c:v>4.98757E-8</c:v>
                </c:pt>
                <c:pt idx="795">
                  <c:v>4.4882100000000003E-8</c:v>
                </c:pt>
                <c:pt idx="796">
                  <c:v>4.0396E-8</c:v>
                </c:pt>
                <c:pt idx="797">
                  <c:v>3.6364900000000003E-8</c:v>
                </c:pt>
                <c:pt idx="798">
                  <c:v>3.2742200000000001E-8</c:v>
                </c:pt>
                <c:pt idx="799">
                  <c:v>2.9485900000000001E-8</c:v>
                </c:pt>
                <c:pt idx="800">
                  <c:v>2.6558300000000002E-8</c:v>
                </c:pt>
                <c:pt idx="801">
                  <c:v>2.39259E-8</c:v>
                </c:pt>
                <c:pt idx="802">
                  <c:v>2.1558500000000001E-8</c:v>
                </c:pt>
                <c:pt idx="803">
                  <c:v>1.9429000000000001E-8</c:v>
                </c:pt>
                <c:pt idx="804">
                  <c:v>1.7513100000000001E-8</c:v>
                </c:pt>
                <c:pt idx="805">
                  <c:v>1.5789099999999999E-8</c:v>
                </c:pt>
                <c:pt idx="806">
                  <c:v>1.4237499999999999E-8</c:v>
                </c:pt>
                <c:pt idx="807">
                  <c:v>1.28409E-8</c:v>
                </c:pt>
                <c:pt idx="808">
                  <c:v>1.15834E-8</c:v>
                </c:pt>
                <c:pt idx="809">
                  <c:v>1.0451099999999999E-8</c:v>
                </c:pt>
                <c:pt idx="810">
                  <c:v>9.4312800000000001E-9</c:v>
                </c:pt>
                <c:pt idx="811">
                  <c:v>8.5125899999999999E-9</c:v>
                </c:pt>
                <c:pt idx="812">
                  <c:v>7.6848600000000007E-9</c:v>
                </c:pt>
                <c:pt idx="813">
                  <c:v>6.9389499999999999E-9</c:v>
                </c:pt>
                <c:pt idx="814">
                  <c:v>6.2666400000000002E-9</c:v>
                </c:pt>
                <c:pt idx="815">
                  <c:v>5.6605599999999997E-9</c:v>
                </c:pt>
                <c:pt idx="816">
                  <c:v>5.1140900000000001E-9</c:v>
                </c:pt>
                <c:pt idx="817">
                  <c:v>4.6212599999999998E-9</c:v>
                </c:pt>
                <c:pt idx="818">
                  <c:v>4.1767299999999999E-9</c:v>
                </c:pt>
                <c:pt idx="819">
                  <c:v>3.7756899999999998E-9</c:v>
                </c:pt>
                <c:pt idx="820">
                  <c:v>3.4138200000000001E-9</c:v>
                </c:pt>
                <c:pt idx="821">
                  <c:v>3.0872299999999999E-9</c:v>
                </c:pt>
                <c:pt idx="822">
                  <c:v>2.79243E-9</c:v>
                </c:pt>
                <c:pt idx="823">
                  <c:v>2.5262699999999998E-9</c:v>
                </c:pt>
                <c:pt idx="824">
                  <c:v>2.2859199999999999E-9</c:v>
                </c:pt>
                <c:pt idx="825">
                  <c:v>2.0688400000000001E-9</c:v>
                </c:pt>
                <c:pt idx="826">
                  <c:v>1.8727399999999999E-9</c:v>
                </c:pt>
                <c:pt idx="827">
                  <c:v>1.69555E-9</c:v>
                </c:pt>
                <c:pt idx="828">
                  <c:v>1.5354299999999999E-9</c:v>
                </c:pt>
                <c:pt idx="829">
                  <c:v>1.39071E-9</c:v>
                </c:pt>
                <c:pt idx="830">
                  <c:v>1.25986E-9</c:v>
                </c:pt>
                <c:pt idx="831">
                  <c:v>1.1415599999999999E-9</c:v>
                </c:pt>
                <c:pt idx="832">
                  <c:v>1.03456E-9</c:v>
                </c:pt>
                <c:pt idx="833">
                  <c:v>9.3777399999999999E-10</c:v>
                </c:pt>
                <c:pt idx="834">
                  <c:v>8.50209E-10</c:v>
                </c:pt>
                <c:pt idx="835">
                  <c:v>7.7097099999999998E-10</c:v>
                </c:pt>
                <c:pt idx="836">
                  <c:v>6.9925399999999997E-10</c:v>
                </c:pt>
                <c:pt idx="837">
                  <c:v>6.3433300000000005E-10</c:v>
                </c:pt>
                <c:pt idx="838">
                  <c:v>5.7555099999999995E-10</c:v>
                </c:pt>
                <c:pt idx="839">
                  <c:v>5.2231799999999999E-10</c:v>
                </c:pt>
                <c:pt idx="840">
                  <c:v>4.7410099999999995E-10</c:v>
                </c:pt>
                <c:pt idx="841">
                  <c:v>4.3041899999999999E-10</c:v>
                </c:pt>
                <c:pt idx="842">
                  <c:v>3.9083900000000001E-10</c:v>
                </c:pt>
                <c:pt idx="843">
                  <c:v>3.5496699999999999E-10</c:v>
                </c:pt>
                <c:pt idx="844">
                  <c:v>3.2245000000000001E-10</c:v>
                </c:pt>
                <c:pt idx="845">
                  <c:v>2.9296900000000001E-10</c:v>
                </c:pt>
                <c:pt idx="846">
                  <c:v>2.6623600000000002E-10</c:v>
                </c:pt>
                <c:pt idx="847">
                  <c:v>2.41989E-10</c:v>
                </c:pt>
                <c:pt idx="848">
                  <c:v>2.1999300000000001E-10</c:v>
                </c:pt>
                <c:pt idx="849">
                  <c:v>2.00035E-10</c:v>
                </c:pt>
                <c:pt idx="850">
                  <c:v>1.81923E-10</c:v>
                </c:pt>
                <c:pt idx="851">
                  <c:v>1.6548399999999999E-10</c:v>
                </c:pt>
                <c:pt idx="852">
                  <c:v>1.5055900000000001E-10</c:v>
                </c:pt>
                <c:pt idx="853">
                  <c:v>1.37007E-10</c:v>
                </c:pt>
                <c:pt idx="854">
                  <c:v>1.24698E-10</c:v>
                </c:pt>
                <c:pt idx="855">
                  <c:v>1.13518E-10</c:v>
                </c:pt>
                <c:pt idx="856">
                  <c:v>1.0336000000000001E-10</c:v>
                </c:pt>
                <c:pt idx="857">
                  <c:v>9.4129200000000006E-11</c:v>
                </c:pt>
                <c:pt idx="858">
                  <c:v>8.4918399999999996E-11</c:v>
                </c:pt>
                <c:pt idx="859">
                  <c:v>7.6626900000000005E-11</c:v>
                </c:pt>
                <c:pt idx="860">
                  <c:v>6.9161200000000005E-11</c:v>
                </c:pt>
                <c:pt idx="861">
                  <c:v>6.2437600000000004E-11</c:v>
                </c:pt>
                <c:pt idx="862">
                  <c:v>5.63808E-11</c:v>
                </c:pt>
                <c:pt idx="863">
                  <c:v>5.0923500000000001E-11</c:v>
                </c:pt>
                <c:pt idx="864">
                  <c:v>4.6005299999999999E-11</c:v>
                </c:pt>
                <c:pt idx="865">
                  <c:v>4.1571699999999997E-11</c:v>
                </c:pt>
                <c:pt idx="866">
                  <c:v>3.75742E-11</c:v>
                </c:pt>
                <c:pt idx="867">
                  <c:v>3.3968999999999998E-11</c:v>
                </c:pt>
                <c:pt idx="868">
                  <c:v>3.0716899999999999E-11</c:v>
                </c:pt>
                <c:pt idx="869">
                  <c:v>2.7782600000000002E-11</c:v>
                </c:pt>
                <c:pt idx="870">
                  <c:v>2.5134399999999998E-11</c:v>
                </c:pt>
                <c:pt idx="871">
                  <c:v>2.27439E-11</c:v>
                </c:pt>
                <c:pt idx="872">
                  <c:v>2.05856E-11</c:v>
                </c:pt>
                <c:pt idx="873">
                  <c:v>1.8636399999999999E-11</c:v>
                </c:pt>
                <c:pt idx="874">
                  <c:v>1.68757E-11</c:v>
                </c:pt>
                <c:pt idx="875">
                  <c:v>1.52848E-11</c:v>
                </c:pt>
                <c:pt idx="876">
                  <c:v>1.3847100000000001E-11</c:v>
                </c:pt>
                <c:pt idx="877">
                  <c:v>1.2547499999999999E-11</c:v>
                </c:pt>
                <c:pt idx="878">
                  <c:v>1.13726E-11</c:v>
                </c:pt>
                <c:pt idx="879">
                  <c:v>1.0309999999999999E-11</c:v>
                </c:pt>
                <c:pt idx="880">
                  <c:v>9.3488000000000007E-12</c:v>
                </c:pt>
                <c:pt idx="881">
                  <c:v>8.4791799999999994E-12</c:v>
                </c:pt>
                <c:pt idx="882">
                  <c:v>7.6922100000000008E-12</c:v>
                </c:pt>
                <c:pt idx="883">
                  <c:v>6.9798799999999999E-12</c:v>
                </c:pt>
                <c:pt idx="884">
                  <c:v>6.3349500000000002E-12</c:v>
                </c:pt>
                <c:pt idx="885">
                  <c:v>5.7509199999999999E-12</c:v>
                </c:pt>
                <c:pt idx="886">
                  <c:v>5.2219300000000001E-12</c:v>
                </c:pt>
                <c:pt idx="887">
                  <c:v>4.7426600000000003E-12</c:v>
                </c:pt>
                <c:pt idx="888">
                  <c:v>4.30836E-12</c:v>
                </c:pt>
                <c:pt idx="889">
                  <c:v>3.9147200000000001E-12</c:v>
                </c:pt>
                <c:pt idx="890">
                  <c:v>3.5578400000000001E-12</c:v>
                </c:pt>
                <c:pt idx="891">
                  <c:v>3.2004999999999999E-12</c:v>
                </c:pt>
                <c:pt idx="892">
                  <c:v>2.87984E-12</c:v>
                </c:pt>
                <c:pt idx="893">
                  <c:v>2.5920299999999998E-12</c:v>
                </c:pt>
                <c:pt idx="894">
                  <c:v>2.33363E-12</c:v>
                </c:pt>
                <c:pt idx="895">
                  <c:v>2.1015600000000002E-12</c:v>
                </c:pt>
                <c:pt idx="896">
                  <c:v>1.8931000000000001E-12</c:v>
                </c:pt>
                <c:pt idx="897">
                  <c:v>1.70578E-12</c:v>
                </c:pt>
                <c:pt idx="898">
                  <c:v>1.5374199999999999E-12</c:v>
                </c:pt>
                <c:pt idx="899">
                  <c:v>1.3860499999999999E-12</c:v>
                </c:pt>
                <c:pt idx="900">
                  <c:v>1.2499299999999999E-12</c:v>
                </c:pt>
                <c:pt idx="901">
                  <c:v>1.12748E-12</c:v>
                </c:pt>
                <c:pt idx="902">
                  <c:v>1.01731E-12</c:v>
                </c:pt>
                <c:pt idx="903">
                  <c:v>9.1815000000000008E-13</c:v>
                </c:pt>
                <c:pt idx="904">
                  <c:v>8.2888099999999997E-13</c:v>
                </c:pt>
                <c:pt idx="905">
                  <c:v>7.4849200000000002E-13</c:v>
                </c:pt>
                <c:pt idx="906">
                  <c:v>6.6670299999999999E-13</c:v>
                </c:pt>
                <c:pt idx="907">
                  <c:v>5.9405699999999998E-13</c:v>
                </c:pt>
                <c:pt idx="908">
                  <c:v>5.29511E-13</c:v>
                </c:pt>
                <c:pt idx="909">
                  <c:v>4.7214199999999999E-13</c:v>
                </c:pt>
                <c:pt idx="910">
                  <c:v>4.2113399999999998E-13</c:v>
                </c:pt>
                <c:pt idx="911">
                  <c:v>3.7576599999999999E-13</c:v>
                </c:pt>
                <c:pt idx="912">
                  <c:v>3.3540000000000001E-13</c:v>
                </c:pt>
                <c:pt idx="913">
                  <c:v>2.9947400000000002E-13</c:v>
                </c:pt>
                <c:pt idx="914">
                  <c:v>2.6748699999999999E-13</c:v>
                </c:pt>
                <c:pt idx="915">
                  <c:v>2.3532800000000002E-13</c:v>
                </c:pt>
                <c:pt idx="916">
                  <c:v>2.0712600000000001E-13</c:v>
                </c:pt>
                <c:pt idx="917">
                  <c:v>1.8238399999999999E-13</c:v>
                </c:pt>
                <c:pt idx="918">
                  <c:v>1.60667E-13</c:v>
                </c:pt>
                <c:pt idx="919">
                  <c:v>1.41599E-13</c:v>
                </c:pt>
                <c:pt idx="920">
                  <c:v>1.24848E-13</c:v>
                </c:pt>
                <c:pt idx="921">
                  <c:v>1.08206E-13</c:v>
                </c:pt>
                <c:pt idx="922">
                  <c:v>9.3834900000000004E-14</c:v>
                </c:pt>
                <c:pt idx="923">
                  <c:v>8.1418400000000006E-14</c:v>
                </c:pt>
                <c:pt idx="924">
                  <c:v>7.0684300000000004E-14</c:v>
                </c:pt>
                <c:pt idx="925">
                  <c:v>6.1399600000000005E-14</c:v>
                </c:pt>
                <c:pt idx="926">
                  <c:v>5.33641E-14</c:v>
                </c:pt>
                <c:pt idx="927">
                  <c:v>4.54182E-14</c:v>
                </c:pt>
                <c:pt idx="928">
                  <c:v>3.8683999999999998E-14</c:v>
                </c:pt>
                <c:pt idx="929">
                  <c:v>3.29723E-14</c:v>
                </c:pt>
                <c:pt idx="930">
                  <c:v>2.8124400000000001E-14</c:v>
                </c:pt>
                <c:pt idx="931">
                  <c:v>2.4006700000000001E-14</c:v>
                </c:pt>
                <c:pt idx="932">
                  <c:v>2.05067E-14</c:v>
                </c:pt>
                <c:pt idx="933">
                  <c:v>1.7038500000000001E-14</c:v>
                </c:pt>
                <c:pt idx="934">
                  <c:v>1.41711E-14</c:v>
                </c:pt>
                <c:pt idx="935">
                  <c:v>1.17979E-14</c:v>
                </c:pt>
                <c:pt idx="936">
                  <c:v>9.8319300000000004E-15</c:v>
                </c:pt>
                <c:pt idx="937">
                  <c:v>8.2015800000000002E-15</c:v>
                </c:pt>
                <c:pt idx="938">
                  <c:v>6.8482999999999997E-15</c:v>
                </c:pt>
                <c:pt idx="939">
                  <c:v>5.4971600000000004E-15</c:v>
                </c:pt>
                <c:pt idx="940">
                  <c:v>4.4191199999999999E-15</c:v>
                </c:pt>
                <c:pt idx="941">
                  <c:v>3.5576300000000002E-15</c:v>
                </c:pt>
                <c:pt idx="942">
                  <c:v>2.8681699999999998E-15</c:v>
                </c:pt>
                <c:pt idx="943">
                  <c:v>2.3156300000000001E-15</c:v>
                </c:pt>
                <c:pt idx="944">
                  <c:v>1.8721999999999999E-15</c:v>
                </c:pt>
                <c:pt idx="945">
                  <c:v>1.4340399999999999E-15</c:v>
                </c:pt>
                <c:pt idx="946">
                  <c:v>1.1010200000000001E-15</c:v>
                </c:pt>
                <c:pt idx="947">
                  <c:v>8.4723099999999998E-16</c:v>
                </c:pt>
                <c:pt idx="948">
                  <c:v>6.5333999999999998E-16</c:v>
                </c:pt>
                <c:pt idx="949">
                  <c:v>5.0489499999999999E-16</c:v>
                </c:pt>
                <c:pt idx="950">
                  <c:v>3.9103000000000002E-16</c:v>
                </c:pt>
                <c:pt idx="951">
                  <c:v>2.7794500000000002E-16</c:v>
                </c:pt>
                <c:pt idx="952">
                  <c:v>1.9843799999999999E-16</c:v>
                </c:pt>
                <c:pt idx="953">
                  <c:v>1.42216E-16</c:v>
                </c:pt>
                <c:pt idx="954">
                  <c:v>1.02254E-16</c:v>
                </c:pt>
                <c:pt idx="955">
                  <c:v>7.3778000000000003E-17</c:v>
                </c:pt>
                <c:pt idx="956">
                  <c:v>5.3449300000000001E-17</c:v>
                </c:pt>
                <c:pt idx="957">
                  <c:v>3.3895999999999999E-17</c:v>
                </c:pt>
                <c:pt idx="958">
                  <c:v>2.17769E-17</c:v>
                </c:pt>
                <c:pt idx="959">
                  <c:v>1.4072800000000001E-17</c:v>
                </c:pt>
                <c:pt idx="960">
                  <c:v>9.0901999999999996E-18</c:v>
                </c:pt>
                <c:pt idx="961">
                  <c:v>5.9008199999999997E-18</c:v>
                </c:pt>
                <c:pt idx="962">
                  <c:v>3.8894000000000003E-18</c:v>
                </c:pt>
                <c:pt idx="963">
                  <c:v>2.4239500000000001E-18</c:v>
                </c:pt>
                <c:pt idx="964">
                  <c:v>1.5429300000000001E-18</c:v>
                </c:pt>
                <c:pt idx="965">
                  <c:v>9.6071399999999992E-19</c:v>
                </c:pt>
                <c:pt idx="966">
                  <c:v>5.8179100000000002E-19</c:v>
                </c:pt>
                <c:pt idx="967">
                  <c:v>3.6234700000000001E-19</c:v>
                </c:pt>
                <c:pt idx="968">
                  <c:v>2.4139300000000002E-19</c:v>
                </c:pt>
                <c:pt idx="969">
                  <c:v>1.6199300000000001E-19</c:v>
                </c:pt>
                <c:pt idx="970">
                  <c:v>1.01339E-19</c:v>
                </c:pt>
                <c:pt idx="971">
                  <c:v>6.0773800000000006E-20</c:v>
                </c:pt>
                <c:pt idx="972">
                  <c:v>4.0122400000000003E-20</c:v>
                </c:pt>
                <c:pt idx="973">
                  <c:v>3.7313600000000002E-20</c:v>
                </c:pt>
                <c:pt idx="974">
                  <c:v>3.4635299999999999E-20</c:v>
                </c:pt>
                <c:pt idx="975">
                  <c:v>3.2150000000000002E-20</c:v>
                </c:pt>
                <c:pt idx="976">
                  <c:v>2.9867400000000003E-20</c:v>
                </c:pt>
                <c:pt idx="977">
                  <c:v>2.7763899999999999E-20</c:v>
                </c:pt>
                <c:pt idx="978">
                  <c:v>2.4364599999999999E-20</c:v>
                </c:pt>
                <c:pt idx="979">
                  <c:v>2.1394000000000001E-20</c:v>
                </c:pt>
                <c:pt idx="980">
                  <c:v>1.87885E-20</c:v>
                </c:pt>
                <c:pt idx="981">
                  <c:v>1.6507099999999999E-20</c:v>
                </c:pt>
                <c:pt idx="982">
                  <c:v>1.1987100000000001E-20</c:v>
                </c:pt>
                <c:pt idx="983">
                  <c:v>8.7661900000000002E-21</c:v>
                </c:pt>
                <c:pt idx="984">
                  <c:v>6.4541899999999999E-21</c:v>
                </c:pt>
                <c:pt idx="985">
                  <c:v>4.7786200000000002E-21</c:v>
                </c:pt>
                <c:pt idx="986">
                  <c:v>3.0358500000000001E-21</c:v>
                </c:pt>
                <c:pt idx="987">
                  <c:v>1.8987399999999999E-21</c:v>
                </c:pt>
                <c:pt idx="988">
                  <c:v>1.1779500000000001E-21</c:v>
                </c:pt>
                <c:pt idx="989">
                  <c:v>7.5022000000000003E-22</c:v>
                </c:pt>
                <c:pt idx="990">
                  <c:v>4.9890200000000002E-22</c:v>
                </c:pt>
                <c:pt idx="991">
                  <c:v>3.2249400000000002E-22</c:v>
                </c:pt>
                <c:pt idx="992">
                  <c:v>2.06192E-22</c:v>
                </c:pt>
                <c:pt idx="993">
                  <c:v>1.2878E-22</c:v>
                </c:pt>
                <c:pt idx="994">
                  <c:v>8.1231499999999998E-23</c:v>
                </c:pt>
                <c:pt idx="995">
                  <c:v>5.3710299999999997E-23</c:v>
                </c:pt>
                <c:pt idx="996">
                  <c:v>3.3724199999999997E-23</c:v>
                </c:pt>
                <c:pt idx="997">
                  <c:v>2.1339499999999999E-23</c:v>
                </c:pt>
                <c:pt idx="998">
                  <c:v>1.28631E-23</c:v>
                </c:pt>
                <c:pt idx="999">
                  <c:v>7.5998600000000003E-24</c:v>
                </c:pt>
                <c:pt idx="1000">
                  <c:v>4.7987899999999999E-24</c:v>
                </c:pt>
                <c:pt idx="1001">
                  <c:v>2.9606599999999999E-24</c:v>
                </c:pt>
                <c:pt idx="1002">
                  <c:v>1.9186599999999999E-24</c:v>
                </c:pt>
                <c:pt idx="1003">
                  <c:v>1.12887E-24</c:v>
                </c:pt>
                <c:pt idx="1004">
                  <c:v>6.0828700000000003E-25</c:v>
                </c:pt>
                <c:pt idx="1005">
                  <c:v>3.6569800000000002E-25</c:v>
                </c:pt>
                <c:pt idx="1006">
                  <c:v>2.8189700000000002E-25</c:v>
                </c:pt>
                <c:pt idx="1007">
                  <c:v>2.4225600000000002E-25</c:v>
                </c:pt>
                <c:pt idx="1008">
                  <c:v>1.4233399999999999E-25</c:v>
                </c:pt>
                <c:pt idx="1009">
                  <c:v>2.8561500000000002E-26</c:v>
                </c:pt>
                <c:pt idx="1010">
                  <c:v>-2.3231599999999999E-27</c:v>
                </c:pt>
                <c:pt idx="1011">
                  <c:v>3.36234E-26</c:v>
                </c:pt>
                <c:pt idx="1012">
                  <c:v>1.12399E-25</c:v>
                </c:pt>
                <c:pt idx="1013">
                  <c:v>1.08911E-25</c:v>
                </c:pt>
                <c:pt idx="1014">
                  <c:v>4.5824899999999999E-26</c:v>
                </c:pt>
                <c:pt idx="1015">
                  <c:v>1.5996099999999999E-26</c:v>
                </c:pt>
                <c:pt idx="1016">
                  <c:v>3.4780600000000001E-26</c:v>
                </c:pt>
                <c:pt idx="1017">
                  <c:v>4.2155199999999999E-26</c:v>
                </c:pt>
                <c:pt idx="1018">
                  <c:v>1.21375E-26</c:v>
                </c:pt>
                <c:pt idx="1019">
                  <c:v>-1.5971600000000001E-26</c:v>
                </c:pt>
                <c:pt idx="1020">
                  <c:v>-7.4191900000000005E-29</c:v>
                </c:pt>
                <c:pt idx="1021">
                  <c:v>2.7904000000000001E-26</c:v>
                </c:pt>
                <c:pt idx="1022">
                  <c:v>1.83075E-26</c:v>
                </c:pt>
                <c:pt idx="1023">
                  <c:v>-1.3782E-26</c:v>
                </c:pt>
                <c:pt idx="1024">
                  <c:v>-1.5014600000000001E-26</c:v>
                </c:pt>
                <c:pt idx="1025">
                  <c:v>1.7075E-26</c:v>
                </c:pt>
                <c:pt idx="1026">
                  <c:v>2.8546099999999998E-26</c:v>
                </c:pt>
                <c:pt idx="1027">
                  <c:v>-2.6289800000000001E-27</c:v>
                </c:pt>
                <c:pt idx="1028">
                  <c:v>-2.73669E-26</c:v>
                </c:pt>
                <c:pt idx="1029">
                  <c:v>-2.95151E-27</c:v>
                </c:pt>
                <c:pt idx="1030">
                  <c:v>4.0518100000000002E-26</c:v>
                </c:pt>
                <c:pt idx="1031">
                  <c:v>2.3825399999999999E-26</c:v>
                </c:pt>
                <c:pt idx="1032">
                  <c:v>-1.5348299999999999E-26</c:v>
                </c:pt>
                <c:pt idx="1033">
                  <c:v>-2.9736199999999999E-26</c:v>
                </c:pt>
                <c:pt idx="1034">
                  <c:v>-1.9867200000000001E-26</c:v>
                </c:pt>
                <c:pt idx="1035">
                  <c:v>-1.07189E-26</c:v>
                </c:pt>
                <c:pt idx="1036">
                  <c:v>-1.3196199999999999E-26</c:v>
                </c:pt>
                <c:pt idx="1037">
                  <c:v>-1.3280600000000001E-26</c:v>
                </c:pt>
                <c:pt idx="1038">
                  <c:v>-1.3270400000000001E-26</c:v>
                </c:pt>
                <c:pt idx="1039">
                  <c:v>-1.3273500000000001E-26</c:v>
                </c:pt>
                <c:pt idx="1040">
                  <c:v>-1.3307900000000001E-26</c:v>
                </c:pt>
                <c:pt idx="1041">
                  <c:v>-1.33538E-26</c:v>
                </c:pt>
                <c:pt idx="1042">
                  <c:v>-1.3489100000000001E-26</c:v>
                </c:pt>
                <c:pt idx="1043">
                  <c:v>-1.36096E-26</c:v>
                </c:pt>
                <c:pt idx="1044">
                  <c:v>-1.3710199999999999E-26</c:v>
                </c:pt>
                <c:pt idx="1045">
                  <c:v>-1.38046E-26</c:v>
                </c:pt>
                <c:pt idx="1046">
                  <c:v>-1.3963299999999999E-26</c:v>
                </c:pt>
                <c:pt idx="1047">
                  <c:v>-1.4137300000000001E-26</c:v>
                </c:pt>
                <c:pt idx="1048">
                  <c:v>-1.43365E-26</c:v>
                </c:pt>
                <c:pt idx="1049">
                  <c:v>-1.4560799999999999E-26</c:v>
                </c:pt>
                <c:pt idx="1050">
                  <c:v>-1.4805799999999999E-26</c:v>
                </c:pt>
                <c:pt idx="1051">
                  <c:v>-1.5204999999999999E-26</c:v>
                </c:pt>
                <c:pt idx="1052">
                  <c:v>-1.5645200000000001E-26</c:v>
                </c:pt>
                <c:pt idx="1053">
                  <c:v>-1.6128100000000001E-26</c:v>
                </c:pt>
                <c:pt idx="1054">
                  <c:v>-1.6656499999999999E-26</c:v>
                </c:pt>
                <c:pt idx="1055">
                  <c:v>-1.7232299999999999E-26</c:v>
                </c:pt>
                <c:pt idx="1056">
                  <c:v>-1.81895E-26</c:v>
                </c:pt>
                <c:pt idx="1057">
                  <c:v>-1.92645E-26</c:v>
                </c:pt>
                <c:pt idx="1058">
                  <c:v>-2.0465499999999999E-26</c:v>
                </c:pt>
                <c:pt idx="1059">
                  <c:v>-2.1801799999999999E-26</c:v>
                </c:pt>
                <c:pt idx="1060">
                  <c:v>-2.3284699999999999E-26</c:v>
                </c:pt>
                <c:pt idx="1061">
                  <c:v>-2.4926700000000001E-26</c:v>
                </c:pt>
                <c:pt idx="1062">
                  <c:v>-2.7239499999999997E-26</c:v>
                </c:pt>
                <c:pt idx="1063">
                  <c:v>-2.9856999999999998E-26</c:v>
                </c:pt>
                <c:pt idx="1064">
                  <c:v>-3.2814499999999999E-26</c:v>
                </c:pt>
                <c:pt idx="1065">
                  <c:v>-3.6152000000000001E-26</c:v>
                </c:pt>
                <c:pt idx="1066">
                  <c:v>-3.9914899999999999E-26</c:v>
                </c:pt>
                <c:pt idx="1067">
                  <c:v>-4.4154399999999998E-26</c:v>
                </c:pt>
                <c:pt idx="1068">
                  <c:v>-4.8928300000000001E-26</c:v>
                </c:pt>
                <c:pt idx="1069">
                  <c:v>-5.4301800000000005E-26</c:v>
                </c:pt>
                <c:pt idx="1070">
                  <c:v>-6.0348300000000001E-26</c:v>
                </c:pt>
                <c:pt idx="1071">
                  <c:v>-6.7150399999999997E-26</c:v>
                </c:pt>
                <c:pt idx="1072">
                  <c:v>-7.2973899999999999E-26</c:v>
                </c:pt>
                <c:pt idx="1073">
                  <c:v>-7.3867400000000002E-26</c:v>
                </c:pt>
                <c:pt idx="1074">
                  <c:v>-7.4772800000000005E-26</c:v>
                </c:pt>
                <c:pt idx="1075">
                  <c:v>-7.5690199999999995E-26</c:v>
                </c:pt>
                <c:pt idx="1076">
                  <c:v>-7.6619800000000003E-26</c:v>
                </c:pt>
                <c:pt idx="1077">
                  <c:v>-7.7561700000000003E-26</c:v>
                </c:pt>
                <c:pt idx="1078">
                  <c:v>-7.9344599999999999E-26</c:v>
                </c:pt>
                <c:pt idx="1079">
                  <c:v>-8.1171699999999998E-26</c:v>
                </c:pt>
                <c:pt idx="1080">
                  <c:v>-8.3044099999999999E-26</c:v>
                </c:pt>
                <c:pt idx="1081">
                  <c:v>-8.4962900000000004E-26</c:v>
                </c:pt>
                <c:pt idx="1082">
                  <c:v>-8.6929399999999998E-26</c:v>
                </c:pt>
                <c:pt idx="1083">
                  <c:v>-9.0586700000000001E-26</c:v>
                </c:pt>
                <c:pt idx="1084">
                  <c:v>-9.4408700000000005E-26</c:v>
                </c:pt>
                <c:pt idx="1085">
                  <c:v>-9.8402500000000004E-26</c:v>
                </c:pt>
                <c:pt idx="1086">
                  <c:v>-1.02576E-25</c:v>
                </c:pt>
                <c:pt idx="1087">
                  <c:v>-1.0693700000000001E-25</c:v>
                </c:pt>
                <c:pt idx="1088">
                  <c:v>-1.14776E-25</c:v>
                </c:pt>
                <c:pt idx="1089">
                  <c:v>-1.2322E-25</c:v>
                </c:pt>
                <c:pt idx="1090">
                  <c:v>-1.32318E-25</c:v>
                </c:pt>
                <c:pt idx="1091">
                  <c:v>-1.4211799999999999E-25</c:v>
                </c:pt>
                <c:pt idx="1092">
                  <c:v>-1.5267600000000001E-25</c:v>
                </c:pt>
                <c:pt idx="1093">
                  <c:v>-1.6636899999999999E-25</c:v>
                </c:pt>
                <c:pt idx="1094">
                  <c:v>-1.8133399999999999E-25</c:v>
                </c:pt>
                <c:pt idx="1095">
                  <c:v>-1.9769199999999999E-25</c:v>
                </c:pt>
                <c:pt idx="1096">
                  <c:v>-2.15571E-25</c:v>
                </c:pt>
                <c:pt idx="1097">
                  <c:v>-2.3511300000000001E-25</c:v>
                </c:pt>
                <c:pt idx="1098">
                  <c:v>-2.5647299999999998E-25</c:v>
                </c:pt>
                <c:pt idx="1099">
                  <c:v>-2.85809E-25</c:v>
                </c:pt>
                <c:pt idx="1100">
                  <c:v>-3.1857399999999999E-25</c:v>
                </c:pt>
                <c:pt idx="1101">
                  <c:v>-3.5516800000000001E-25</c:v>
                </c:pt>
                <c:pt idx="1102">
                  <c:v>-3.9603799999999999E-25</c:v>
                </c:pt>
                <c:pt idx="1103">
                  <c:v>-4.41686E-25</c:v>
                </c:pt>
                <c:pt idx="1104">
                  <c:v>-4.9266799999999999E-25</c:v>
                </c:pt>
                <c:pt idx="1105">
                  <c:v>-5.5675999999999997E-25</c:v>
                </c:pt>
                <c:pt idx="1106">
                  <c:v>-6.2928499999999997E-25</c:v>
                </c:pt>
                <c:pt idx="1107">
                  <c:v>-7.1135100000000001E-25</c:v>
                </c:pt>
                <c:pt idx="1108">
                  <c:v>-8.0421399999999997E-25</c:v>
                </c:pt>
                <c:pt idx="1109">
                  <c:v>-9.0929600000000008E-25</c:v>
                </c:pt>
                <c:pt idx="1110">
                  <c:v>-1.0282E-24</c:v>
                </c:pt>
                <c:pt idx="1111">
                  <c:v>-1.1627600000000001E-24</c:v>
                </c:pt>
                <c:pt idx="1112">
                  <c:v>-1.31502E-24</c:v>
                </c:pt>
                <c:pt idx="1113">
                  <c:v>-1.48731E-24</c:v>
                </c:pt>
                <c:pt idx="1114">
                  <c:v>-1.6822699999999999E-24</c:v>
                </c:pt>
                <c:pt idx="1115">
                  <c:v>-1.9028900000000001E-24</c:v>
                </c:pt>
                <c:pt idx="1116">
                  <c:v>-2.15254E-24</c:v>
                </c:pt>
                <c:pt idx="1117">
                  <c:v>-2.43504E-24</c:v>
                </c:pt>
                <c:pt idx="1118">
                  <c:v>-2.7547200000000001E-24</c:v>
                </c:pt>
                <c:pt idx="1119">
                  <c:v>-3.11646E-24</c:v>
                </c:pt>
                <c:pt idx="1120">
                  <c:v>-3.5258099999999999E-24</c:v>
                </c:pt>
                <c:pt idx="1121">
                  <c:v>-3.9890300000000003E-24</c:v>
                </c:pt>
                <c:pt idx="1122">
                  <c:v>-4.5132000000000001E-24</c:v>
                </c:pt>
                <c:pt idx="1123">
                  <c:v>-5.1063499999999996E-24</c:v>
                </c:pt>
                <c:pt idx="1124">
                  <c:v>-5.7775600000000001E-24</c:v>
                </c:pt>
                <c:pt idx="1125">
                  <c:v>-6.5370899999999996E-24</c:v>
                </c:pt>
                <c:pt idx="1126">
                  <c:v>-7.3965799999999999E-24</c:v>
                </c:pt>
                <c:pt idx="1127">
                  <c:v>-8.3691800000000007E-24</c:v>
                </c:pt>
                <c:pt idx="1128">
                  <c:v>-9.4697599999999993E-24</c:v>
                </c:pt>
                <c:pt idx="1129">
                  <c:v>-1.0715200000000001E-23</c:v>
                </c:pt>
                <c:pt idx="1130">
                  <c:v>-1.21245E-23</c:v>
                </c:pt>
                <c:pt idx="1131">
                  <c:v>-1.37193E-23</c:v>
                </c:pt>
                <c:pt idx="1132">
                  <c:v>-1.5799599999999999E-23</c:v>
                </c:pt>
                <c:pt idx="1133">
                  <c:v>-1.81956E-23</c:v>
                </c:pt>
                <c:pt idx="1134">
                  <c:v>-2.04311E-23</c:v>
                </c:pt>
                <c:pt idx="1135">
                  <c:v>-2.2466799999999999E-23</c:v>
                </c:pt>
                <c:pt idx="1136">
                  <c:v>-2.47053E-23</c:v>
                </c:pt>
                <c:pt idx="1137">
                  <c:v>-2.7167000000000002E-23</c:v>
                </c:pt>
                <c:pt idx="1138">
                  <c:v>-2.9873900000000001E-23</c:v>
                </c:pt>
                <c:pt idx="1139">
                  <c:v>-3.2259799999999998E-23</c:v>
                </c:pt>
                <c:pt idx="1140">
                  <c:v>-3.2644600000000001E-23</c:v>
                </c:pt>
                <c:pt idx="1141">
                  <c:v>-3.3034000000000002E-23</c:v>
                </c:pt>
                <c:pt idx="1142">
                  <c:v>-3.3428100000000003E-23</c:v>
                </c:pt>
                <c:pt idx="1143">
                  <c:v>-3.3826900000000002E-23</c:v>
                </c:pt>
                <c:pt idx="1144">
                  <c:v>-3.46376E-23</c:v>
                </c:pt>
                <c:pt idx="1145">
                  <c:v>-3.5467800000000002E-23</c:v>
                </c:pt>
                <c:pt idx="1146">
                  <c:v>-3.6318000000000003E-23</c:v>
                </c:pt>
                <c:pt idx="1147">
                  <c:v>-3.7682300000000002E-23</c:v>
                </c:pt>
                <c:pt idx="1148">
                  <c:v>-3.9097700000000001E-23</c:v>
                </c:pt>
                <c:pt idx="1149">
                  <c:v>-4.05663E-23</c:v>
                </c:pt>
                <c:pt idx="1150">
                  <c:v>-4.20901E-23</c:v>
                </c:pt>
                <c:pt idx="1151">
                  <c:v>-4.4362299999999999E-23</c:v>
                </c:pt>
                <c:pt idx="1152">
                  <c:v>-4.67571E-23</c:v>
                </c:pt>
                <c:pt idx="1153">
                  <c:v>-4.9281299999999998E-23</c:v>
                </c:pt>
                <c:pt idx="1154">
                  <c:v>-5.1941700000000002E-23</c:v>
                </c:pt>
                <c:pt idx="1155">
                  <c:v>-5.8745900000000003E-23</c:v>
                </c:pt>
                <c:pt idx="1156">
                  <c:v>-6.6440999999999999E-23</c:v>
                </c:pt>
                <c:pt idx="1157">
                  <c:v>-7.5143900000000001E-23</c:v>
                </c:pt>
                <c:pt idx="1158">
                  <c:v>-8.4987099999999996E-23</c:v>
                </c:pt>
                <c:pt idx="1159">
                  <c:v>-9.6119999999999997E-23</c:v>
                </c:pt>
                <c:pt idx="1160">
                  <c:v>-1.0871100000000001E-22</c:v>
                </c:pt>
                <c:pt idx="1161">
                  <c:v>-1.2295199999999999E-22</c:v>
                </c:pt>
                <c:pt idx="1162">
                  <c:v>-1.3905800000000001E-22</c:v>
                </c:pt>
                <c:pt idx="1163">
                  <c:v>-1.62666E-22</c:v>
                </c:pt>
                <c:pt idx="1164">
                  <c:v>-1.9028099999999999E-22</c:v>
                </c:pt>
                <c:pt idx="1165">
                  <c:v>-2.2258300000000001E-22</c:v>
                </c:pt>
                <c:pt idx="1166">
                  <c:v>-2.6036800000000002E-22</c:v>
                </c:pt>
                <c:pt idx="1167">
                  <c:v>-3.0456900000000002E-22</c:v>
                </c:pt>
                <c:pt idx="1168">
                  <c:v>-3.5627400000000001E-22</c:v>
                </c:pt>
                <c:pt idx="1169">
                  <c:v>-4.4002999999999998E-22</c:v>
                </c:pt>
                <c:pt idx="1170">
                  <c:v>-5.4347799999999999E-22</c:v>
                </c:pt>
                <c:pt idx="1171">
                  <c:v>-6.7124599999999999E-22</c:v>
                </c:pt>
                <c:pt idx="1172">
                  <c:v>-8.2905E-22</c:v>
                </c:pt>
                <c:pt idx="1173">
                  <c:v>-1.0239499999999999E-21</c:v>
                </c:pt>
                <c:pt idx="1174">
                  <c:v>-1.26467E-21</c:v>
                </c:pt>
                <c:pt idx="1175">
                  <c:v>-1.70928E-21</c:v>
                </c:pt>
                <c:pt idx="1176">
                  <c:v>-2.3102599999999998E-21</c:v>
                </c:pt>
                <c:pt idx="1177">
                  <c:v>-3.12255E-21</c:v>
                </c:pt>
                <c:pt idx="1178">
                  <c:v>-4.2204200000000003E-21</c:v>
                </c:pt>
                <c:pt idx="1179">
                  <c:v>-5.7042599999999998E-21</c:v>
                </c:pt>
                <c:pt idx="1180">
                  <c:v>-7.7097699999999994E-21</c:v>
                </c:pt>
                <c:pt idx="1181">
                  <c:v>-1.1061499999999999E-20</c:v>
                </c:pt>
                <c:pt idx="1182">
                  <c:v>-1.5870599999999999E-20</c:v>
                </c:pt>
                <c:pt idx="1183">
                  <c:v>-2.27702E-20</c:v>
                </c:pt>
                <c:pt idx="1184">
                  <c:v>-3.2668900000000001E-20</c:v>
                </c:pt>
                <c:pt idx="1185">
                  <c:v>-4.68707E-20</c:v>
                </c:pt>
                <c:pt idx="1186">
                  <c:v>-6.72458E-20</c:v>
                </c:pt>
                <c:pt idx="1187">
                  <c:v>-1.09536E-19</c:v>
                </c:pt>
                <c:pt idx="1188">
                  <c:v>-1.7846599999999999E-19</c:v>
                </c:pt>
                <c:pt idx="1189">
                  <c:v>-2.9078499999999998E-19</c:v>
                </c:pt>
                <c:pt idx="1190">
                  <c:v>-4.7378199999999996E-19</c:v>
                </c:pt>
                <c:pt idx="1191">
                  <c:v>-7.7192900000000001E-19</c:v>
                </c:pt>
                <c:pt idx="1192">
                  <c:v>-1.25768E-18</c:v>
                </c:pt>
                <c:pt idx="1193">
                  <c:v>-2.4130600000000002E-18</c:v>
                </c:pt>
                <c:pt idx="1194">
                  <c:v>-4.6334400000000001E-18</c:v>
                </c:pt>
                <c:pt idx="1195">
                  <c:v>-8.8980900000000007E-18</c:v>
                </c:pt>
                <c:pt idx="1196">
                  <c:v>-1.7087199999999999E-17</c:v>
                </c:pt>
                <c:pt idx="1197">
                  <c:v>-3.28119E-17</c:v>
                </c:pt>
                <c:pt idx="1198">
                  <c:v>-6.30063E-17</c:v>
                </c:pt>
                <c:pt idx="1199">
                  <c:v>-1.35962E-16</c:v>
                </c:pt>
                <c:pt idx="1200">
                  <c:v>-2.5411799999999999E-16</c:v>
                </c:pt>
                <c:pt idx="1201">
                  <c:v>-4.7463499999999997E-16</c:v>
                </c:pt>
                <c:pt idx="1202">
                  <c:v>-7.71677E-16</c:v>
                </c:pt>
                <c:pt idx="1203">
                  <c:v>-1.2543100000000001E-15</c:v>
                </c:pt>
                <c:pt idx="1204">
                  <c:v>-1.8566699999999999E-15</c:v>
                </c:pt>
                <c:pt idx="1205">
                  <c:v>-2.7475999999999999E-15</c:v>
                </c:pt>
                <c:pt idx="1206">
                  <c:v>-4.06594E-15</c:v>
                </c:pt>
                <c:pt idx="1207">
                  <c:v>-5.6047800000000003E-15</c:v>
                </c:pt>
                <c:pt idx="1208">
                  <c:v>-7.7258200000000006E-15</c:v>
                </c:pt>
                <c:pt idx="1209">
                  <c:v>-1.0649500000000001E-14</c:v>
                </c:pt>
                <c:pt idx="1210">
                  <c:v>-1.39013E-14</c:v>
                </c:pt>
                <c:pt idx="1211">
                  <c:v>-1.81456E-14</c:v>
                </c:pt>
                <c:pt idx="1212">
                  <c:v>-2.3685600000000001E-14</c:v>
                </c:pt>
                <c:pt idx="1213">
                  <c:v>-3.0917E-14</c:v>
                </c:pt>
                <c:pt idx="1214">
                  <c:v>-3.84715E-14</c:v>
                </c:pt>
                <c:pt idx="1215">
                  <c:v>-4.7871699999999999E-14</c:v>
                </c:pt>
                <c:pt idx="1216">
                  <c:v>-5.9568499999999998E-14</c:v>
                </c:pt>
                <c:pt idx="1217">
                  <c:v>-7.4123300000000003E-14</c:v>
                </c:pt>
                <c:pt idx="1218">
                  <c:v>-9.2234299999999998E-14</c:v>
                </c:pt>
                <c:pt idx="1219">
                  <c:v>-1.106E-13</c:v>
                </c:pt>
                <c:pt idx="1220">
                  <c:v>-1.3262199999999999E-13</c:v>
                </c:pt>
                <c:pt idx="1221">
                  <c:v>-1.5902800000000001E-13</c:v>
                </c:pt>
                <c:pt idx="1222">
                  <c:v>-1.9069300000000001E-13</c:v>
                </c:pt>
                <c:pt idx="1223">
                  <c:v>-2.28662E-13</c:v>
                </c:pt>
                <c:pt idx="1224">
                  <c:v>-2.7419099999999999E-13</c:v>
                </c:pt>
                <c:pt idx="1225">
                  <c:v>-3.2878399999999998E-13</c:v>
                </c:pt>
                <c:pt idx="1226">
                  <c:v>-3.82298E-13</c:v>
                </c:pt>
                <c:pt idx="1227">
                  <c:v>-4.44522E-13</c:v>
                </c:pt>
                <c:pt idx="1228">
                  <c:v>-5.1687300000000001E-13</c:v>
                </c:pt>
                <c:pt idx="1229">
                  <c:v>-6.0099899999999999E-13</c:v>
                </c:pt>
                <c:pt idx="1230">
                  <c:v>-6.98818E-13</c:v>
                </c:pt>
                <c:pt idx="1231">
                  <c:v>-8.1255700000000001E-13</c:v>
                </c:pt>
                <c:pt idx="1232">
                  <c:v>-9.4480699999999997E-13</c:v>
                </c:pt>
                <c:pt idx="1233">
                  <c:v>-1.0985799999999999E-12</c:v>
                </c:pt>
                <c:pt idx="1234">
                  <c:v>-1.27738E-12</c:v>
                </c:pt>
                <c:pt idx="1235">
                  <c:v>-1.4852799999999999E-12</c:v>
                </c:pt>
                <c:pt idx="1236">
                  <c:v>-1.72702E-12</c:v>
                </c:pt>
                <c:pt idx="1237">
                  <c:v>-2.0080999999999999E-12</c:v>
                </c:pt>
                <c:pt idx="1238">
                  <c:v>-2.33493E-12</c:v>
                </c:pt>
                <c:pt idx="1239">
                  <c:v>-2.64728E-12</c:v>
                </c:pt>
                <c:pt idx="1240">
                  <c:v>-3.0014199999999999E-12</c:v>
                </c:pt>
                <c:pt idx="1241">
                  <c:v>-3.4029199999999998E-12</c:v>
                </c:pt>
                <c:pt idx="1242">
                  <c:v>-3.85814E-12</c:v>
                </c:pt>
                <c:pt idx="1243">
                  <c:v>-4.3742500000000003E-12</c:v>
                </c:pt>
                <c:pt idx="1244">
                  <c:v>-4.9594000000000001E-12</c:v>
                </c:pt>
                <c:pt idx="1245">
                  <c:v>-5.6228200000000001E-12</c:v>
                </c:pt>
                <c:pt idx="1246">
                  <c:v>-6.3749899999999997E-12</c:v>
                </c:pt>
                <c:pt idx="1247">
                  <c:v>-7.22777E-12</c:v>
                </c:pt>
                <c:pt idx="1248">
                  <c:v>-7.3649899999999993E-12</c:v>
                </c:pt>
                <c:pt idx="1249">
                  <c:v>-7.5048200000000003E-12</c:v>
                </c:pt>
                <c:pt idx="1250">
                  <c:v>-7.6472999999999995E-12</c:v>
                </c:pt>
                <c:pt idx="1251">
                  <c:v>-7.7924799999999999E-12</c:v>
                </c:pt>
                <c:pt idx="1252">
                  <c:v>-7.9404299999999999E-12</c:v>
                </c:pt>
                <c:pt idx="1253">
                  <c:v>-8.0911800000000007E-12</c:v>
                </c:pt>
                <c:pt idx="1254">
                  <c:v>-8.3977999999999996E-12</c:v>
                </c:pt>
                <c:pt idx="1255">
                  <c:v>-8.7160400000000001E-12</c:v>
                </c:pt>
                <c:pt idx="1256">
                  <c:v>-9.0463399999999992E-12</c:v>
                </c:pt>
                <c:pt idx="1257">
                  <c:v>-9.3891600000000008E-12</c:v>
                </c:pt>
                <c:pt idx="1258">
                  <c:v>-9.7449699999999998E-12</c:v>
                </c:pt>
                <c:pt idx="1259">
                  <c:v>-1.04771E-11</c:v>
                </c:pt>
                <c:pt idx="1260">
                  <c:v>-1.12642E-11</c:v>
                </c:pt>
                <c:pt idx="1261">
                  <c:v>-1.2110400000000001E-11</c:v>
                </c:pt>
                <c:pt idx="1262">
                  <c:v>-1.30202E-11</c:v>
                </c:pt>
                <c:pt idx="1263">
                  <c:v>-1.3998400000000001E-11</c:v>
                </c:pt>
                <c:pt idx="1264">
                  <c:v>-1.5578800000000001E-11</c:v>
                </c:pt>
                <c:pt idx="1265">
                  <c:v>-1.7337699999999999E-11</c:v>
                </c:pt>
                <c:pt idx="1266">
                  <c:v>-1.9295099999999999E-11</c:v>
                </c:pt>
                <c:pt idx="1267">
                  <c:v>-2.1473499999999999E-11</c:v>
                </c:pt>
                <c:pt idx="1268">
                  <c:v>-2.3897799999999999E-11</c:v>
                </c:pt>
                <c:pt idx="1269">
                  <c:v>-2.6595799999999999E-11</c:v>
                </c:pt>
                <c:pt idx="1270">
                  <c:v>-2.95985E-11</c:v>
                </c:pt>
                <c:pt idx="1271">
                  <c:v>-3.2940099999999998E-11</c:v>
                </c:pt>
                <c:pt idx="1272">
                  <c:v>-3.6658899999999998E-11</c:v>
                </c:pt>
                <c:pt idx="1273">
                  <c:v>-4.1367599999999999E-11</c:v>
                </c:pt>
                <c:pt idx="1274">
                  <c:v>-4.6681100000000002E-11</c:v>
                </c:pt>
                <c:pt idx="1275">
                  <c:v>-5.2676999999999999E-11</c:v>
                </c:pt>
                <c:pt idx="1276">
                  <c:v>-5.9443099999999997E-11</c:v>
                </c:pt>
                <c:pt idx="1277">
                  <c:v>-6.7078199999999997E-11</c:v>
                </c:pt>
                <c:pt idx="1278">
                  <c:v>-7.5693999999999995E-11</c:v>
                </c:pt>
                <c:pt idx="1279">
                  <c:v>-8.5416400000000003E-11</c:v>
                </c:pt>
                <c:pt idx="1280">
                  <c:v>-9.6387499999999994E-11</c:v>
                </c:pt>
                <c:pt idx="1281">
                  <c:v>-1.08768E-10</c:v>
                </c:pt>
                <c:pt idx="1282">
                  <c:v>-1.2273799999999999E-10</c:v>
                </c:pt>
                <c:pt idx="1283">
                  <c:v>-1.3850300000000001E-10</c:v>
                </c:pt>
                <c:pt idx="1284">
                  <c:v>-1.56292E-10</c:v>
                </c:pt>
                <c:pt idx="1285">
                  <c:v>-1.7636700000000001E-10</c:v>
                </c:pt>
                <c:pt idx="1286">
                  <c:v>-1.9901899999999999E-10</c:v>
                </c:pt>
                <c:pt idx="1287">
                  <c:v>-2.24581E-10</c:v>
                </c:pt>
                <c:pt idx="1288">
                  <c:v>-2.5342599999999999E-10</c:v>
                </c:pt>
                <c:pt idx="1289">
                  <c:v>-2.85976E-10</c:v>
                </c:pt>
                <c:pt idx="1290">
                  <c:v>-3.2270699999999999E-10</c:v>
                </c:pt>
                <c:pt idx="1291">
                  <c:v>-3.6415400000000001E-10</c:v>
                </c:pt>
                <c:pt idx="1292">
                  <c:v>-4.1092600000000001E-10</c:v>
                </c:pt>
                <c:pt idx="1293">
                  <c:v>-4.6370399999999999E-10</c:v>
                </c:pt>
                <c:pt idx="1294">
                  <c:v>-5.2326100000000002E-10</c:v>
                </c:pt>
                <c:pt idx="1295">
                  <c:v>-5.90467E-10</c:v>
                </c:pt>
                <c:pt idx="1296">
                  <c:v>-6.66304E-10</c:v>
                </c:pt>
                <c:pt idx="1297">
                  <c:v>-7.51881E-10</c:v>
                </c:pt>
                <c:pt idx="1298">
                  <c:v>-8.4845E-10</c:v>
                </c:pt>
                <c:pt idx="1299">
                  <c:v>-9.5741999999999999E-10</c:v>
                </c:pt>
                <c:pt idx="1300">
                  <c:v>-1.08039E-9</c:v>
                </c:pt>
                <c:pt idx="1301">
                  <c:v>-1.2191500000000001E-9</c:v>
                </c:pt>
                <c:pt idx="1302">
                  <c:v>-1.3757200000000001E-9</c:v>
                </c:pt>
                <c:pt idx="1303">
                  <c:v>-1.55241E-9</c:v>
                </c:pt>
                <c:pt idx="1304">
                  <c:v>-1.7518000000000001E-9</c:v>
                </c:pt>
                <c:pt idx="1305">
                  <c:v>-1.9767799999999999E-9</c:v>
                </c:pt>
                <c:pt idx="1306">
                  <c:v>-2.2306700000000001E-9</c:v>
                </c:pt>
                <c:pt idx="1307">
                  <c:v>-2.5171500000000001E-9</c:v>
                </c:pt>
                <c:pt idx="1308">
                  <c:v>-2.8404400000000002E-9</c:v>
                </c:pt>
                <c:pt idx="1309">
                  <c:v>-3.20524E-9</c:v>
                </c:pt>
                <c:pt idx="1310">
                  <c:v>-3.6168899999999999E-9</c:v>
                </c:pt>
                <c:pt idx="1311">
                  <c:v>-4.0814100000000003E-9</c:v>
                </c:pt>
                <c:pt idx="1312">
                  <c:v>-4.6055800000000001E-9</c:v>
                </c:pt>
                <c:pt idx="1313">
                  <c:v>-5.19708E-9</c:v>
                </c:pt>
                <c:pt idx="1314">
                  <c:v>-5.8645399999999997E-9</c:v>
                </c:pt>
                <c:pt idx="1315">
                  <c:v>-6.6177100000000003E-9</c:v>
                </c:pt>
                <c:pt idx="1316">
                  <c:v>-7.4676200000000007E-9</c:v>
                </c:pt>
                <c:pt idx="1317">
                  <c:v>-8.4266700000000006E-9</c:v>
                </c:pt>
                <c:pt idx="1318">
                  <c:v>-9.5088900000000007E-9</c:v>
                </c:pt>
                <c:pt idx="1319">
                  <c:v>-1.07301E-8</c:v>
                </c:pt>
                <c:pt idx="1320">
                  <c:v>-1.21081E-8</c:v>
                </c:pt>
                <c:pt idx="1321">
                  <c:v>-1.36631E-8</c:v>
                </c:pt>
                <c:pt idx="1322">
                  <c:v>-1.5417799999999999E-8</c:v>
                </c:pt>
                <c:pt idx="1323">
                  <c:v>-1.7397899999999999E-8</c:v>
                </c:pt>
                <c:pt idx="1324">
                  <c:v>-1.9632200000000001E-8</c:v>
                </c:pt>
                <c:pt idx="1325">
                  <c:v>-2.21535E-8</c:v>
                </c:pt>
                <c:pt idx="1326">
                  <c:v>-2.4998599999999999E-8</c:v>
                </c:pt>
                <c:pt idx="1327">
                  <c:v>-2.8209000000000001E-8</c:v>
                </c:pt>
                <c:pt idx="1328">
                  <c:v>-3.18317E-8</c:v>
                </c:pt>
                <c:pt idx="1329">
                  <c:v>-3.5919699999999997E-8</c:v>
                </c:pt>
                <c:pt idx="1330">
                  <c:v>-4.0532600000000001E-8</c:v>
                </c:pt>
                <c:pt idx="1331">
                  <c:v>-4.5738000000000002E-8</c:v>
                </c:pt>
                <c:pt idx="1332">
                  <c:v>-5.1611800000000002E-8</c:v>
                </c:pt>
                <c:pt idx="1333">
                  <c:v>-5.8239899999999999E-8</c:v>
                </c:pt>
                <c:pt idx="1334">
                  <c:v>-6.5719200000000005E-8</c:v>
                </c:pt>
                <c:pt idx="1335">
                  <c:v>-7.4158999999999996E-8</c:v>
                </c:pt>
                <c:pt idx="1336">
                  <c:v>-8.3682600000000001E-8</c:v>
                </c:pt>
                <c:pt idx="1337">
                  <c:v>-9.4429200000000002E-8</c:v>
                </c:pt>
                <c:pt idx="1338">
                  <c:v>-1.06556E-7</c:v>
                </c:pt>
                <c:pt idx="1339">
                  <c:v>-1.2024E-7</c:v>
                </c:pt>
                <c:pt idx="1340">
                  <c:v>-1.3568100000000001E-7</c:v>
                </c:pt>
                <c:pt idx="1341">
                  <c:v>-1.5310499999999999E-7</c:v>
                </c:pt>
                <c:pt idx="1342">
                  <c:v>-1.72767E-7</c:v>
                </c:pt>
                <c:pt idx="1343">
                  <c:v>-1.9495400000000001E-7</c:v>
                </c:pt>
                <c:pt idx="1344">
                  <c:v>-2.19989E-7</c:v>
                </c:pt>
                <c:pt idx="1345">
                  <c:v>-2.4824E-7</c:v>
                </c:pt>
                <c:pt idx="1346">
                  <c:v>-2.8011900000000002E-7</c:v>
                </c:pt>
                <c:pt idx="1347">
                  <c:v>-3.1609099999999999E-7</c:v>
                </c:pt>
                <c:pt idx="1348">
                  <c:v>-3.5668300000000002E-7</c:v>
                </c:pt>
                <c:pt idx="1349">
                  <c:v>-4.0248700000000002E-7</c:v>
                </c:pt>
                <c:pt idx="1350">
                  <c:v>-4.5417300000000003E-7</c:v>
                </c:pt>
                <c:pt idx="1351">
                  <c:v>-5.1249699999999999E-7</c:v>
                </c:pt>
                <c:pt idx="1352">
                  <c:v>-5.7831E-7</c:v>
                </c:pt>
                <c:pt idx="1353">
                  <c:v>-6.5257400000000003E-7</c:v>
                </c:pt>
                <c:pt idx="1354">
                  <c:v>-7.36375E-7</c:v>
                </c:pt>
                <c:pt idx="1355">
                  <c:v>-8.3093700000000002E-7</c:v>
                </c:pt>
                <c:pt idx="1356">
                  <c:v>-9.3764200000000003E-7</c:v>
                </c:pt>
                <c:pt idx="1357">
                  <c:v>-1.05805E-6</c:v>
                </c:pt>
                <c:pt idx="1358">
                  <c:v>-1.19392E-6</c:v>
                </c:pt>
                <c:pt idx="1359">
                  <c:v>-1.34723E-6</c:v>
                </c:pt>
                <c:pt idx="1360">
                  <c:v>-1.5202399999999999E-6</c:v>
                </c:pt>
                <c:pt idx="1361">
                  <c:v>-1.7154600000000001E-6</c:v>
                </c:pt>
                <c:pt idx="1362">
                  <c:v>-1.9357500000000001E-6</c:v>
                </c:pt>
                <c:pt idx="1363">
                  <c:v>-2.1843200000000001E-6</c:v>
                </c:pt>
                <c:pt idx="1364">
                  <c:v>-2.4648199999999998E-6</c:v>
                </c:pt>
                <c:pt idx="1365">
                  <c:v>-2.7813299999999999E-6</c:v>
                </c:pt>
                <c:pt idx="1366">
                  <c:v>-3.13848E-6</c:v>
                </c:pt>
                <c:pt idx="1367">
                  <c:v>-3.5414999999999999E-6</c:v>
                </c:pt>
                <c:pt idx="1368">
                  <c:v>-3.9962699999999998E-6</c:v>
                </c:pt>
                <c:pt idx="1369">
                  <c:v>-4.1867299999999996E-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C541-4D72-BC24-B38DDFB6474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659024"/>
        <c:axId val="382659416"/>
      </c:scatterChart>
      <c:valAx>
        <c:axId val="38265902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none"/>
        <c:minorTickMark val="none"/>
        <c:tickLblPos val="nextTo"/>
        <c:spPr>
          <a:noFill/>
          <a:ln w="63500" cap="flat" cmpd="sng" algn="ctr">
            <a:solidFill>
              <a:schemeClr val="tx1">
                <a:lumMod val="95000"/>
                <a:lumOff val="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659416"/>
        <c:crosses val="autoZero"/>
        <c:crossBetween val="midCat"/>
        <c:majorUnit val="1"/>
      </c:valAx>
      <c:valAx>
        <c:axId val="382659416"/>
        <c:scaling>
          <c:orientation val="minMax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659024"/>
        <c:crosses val="autoZero"/>
        <c:crossBetween val="midCat"/>
        <c:majorUnit val="20"/>
      </c:valAx>
      <c:spPr>
        <a:noFill/>
        <a:ln w="63500">
          <a:solidFill>
            <a:schemeClr val="tx1">
              <a:lumMod val="50000"/>
              <a:lumOff val="50000"/>
            </a:schemeClr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63500" cap="flat" cmpd="sng" algn="ctr">
      <a:noFill/>
      <a:round/>
    </a:ln>
    <a:effectLst/>
  </c:spPr>
  <c:txPr>
    <a:bodyPr/>
    <a:lstStyle/>
    <a:p>
      <a:pPr>
        <a:defRPr sz="14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87472659667543"/>
          <c:y val="3.6286332264022551E-2"/>
          <c:w val="0.83177539005540979"/>
          <c:h val="0.85425974530961413"/>
        </c:manualLayout>
      </c:layout>
      <c:scatterChart>
        <c:scatterStyle val="smoothMarker"/>
        <c:varyColors val="0"/>
        <c:ser>
          <c:idx val="0"/>
          <c:order val="0"/>
          <c:spPr>
            <a:ln w="635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E$4:$E$2039</c:f>
              <c:numCache>
                <c:formatCode>General</c:formatCode>
                <c:ptCount val="2036"/>
                <c:pt idx="0">
                  <c:v>0</c:v>
                </c:pt>
                <c:pt idx="1">
                  <c:v>6.9444444444444454E-13</c:v>
                </c:pt>
                <c:pt idx="2">
                  <c:v>1.3888888888888891E-12</c:v>
                </c:pt>
                <c:pt idx="3">
                  <c:v>6.9458333333333335E-9</c:v>
                </c:pt>
                <c:pt idx="4">
                  <c:v>1.3890277777777778E-8</c:v>
                </c:pt>
                <c:pt idx="5">
                  <c:v>2.0834722222222222E-8</c:v>
                </c:pt>
                <c:pt idx="6">
                  <c:v>9.0279166666666655E-8</c:v>
                </c:pt>
                <c:pt idx="7">
                  <c:v>1.5972361111111111E-7</c:v>
                </c:pt>
                <c:pt idx="8">
                  <c:v>2.2916805555555553E-7</c:v>
                </c:pt>
                <c:pt idx="9">
                  <c:v>2.9861250000000001E-7</c:v>
                </c:pt>
                <c:pt idx="10">
                  <c:v>9.9305555555555567E-7</c:v>
                </c:pt>
                <c:pt idx="11">
                  <c:v>1.6874999999999999E-6</c:v>
                </c:pt>
                <c:pt idx="12">
                  <c:v>2.3819444444444444E-6</c:v>
                </c:pt>
                <c:pt idx="13">
                  <c:v>3.0763888888888889E-6</c:v>
                </c:pt>
                <c:pt idx="14">
                  <c:v>7.0700000000000001E-6</c:v>
                </c:pt>
                <c:pt idx="15">
                  <c:v>1.1063611111111111E-5</c:v>
                </c:pt>
                <c:pt idx="16">
                  <c:v>1.5057222222222223E-5</c:v>
                </c:pt>
                <c:pt idx="17">
                  <c:v>2.2856458333333332E-5</c:v>
                </c:pt>
                <c:pt idx="18">
                  <c:v>3.0655625E-5</c:v>
                </c:pt>
                <c:pt idx="19">
                  <c:v>3.8454861111111109E-5</c:v>
                </c:pt>
                <c:pt idx="20">
                  <c:v>5.0214375000000003E-5</c:v>
                </c:pt>
                <c:pt idx="21">
                  <c:v>6.197381944444444E-5</c:v>
                </c:pt>
                <c:pt idx="22">
                  <c:v>7.3733333333333341E-5</c:v>
                </c:pt>
                <c:pt idx="23">
                  <c:v>8.3929166666666663E-5</c:v>
                </c:pt>
                <c:pt idx="24">
                  <c:v>9.4124999999999998E-5</c:v>
                </c:pt>
                <c:pt idx="25">
                  <c:v>1.0432083333333333E-4</c:v>
                </c:pt>
                <c:pt idx="26">
                  <c:v>1.0902430555555555E-4</c:v>
                </c:pt>
                <c:pt idx="27">
                  <c:v>1.1372708333333333E-4</c:v>
                </c:pt>
                <c:pt idx="28">
                  <c:v>1.1842986111111111E-4</c:v>
                </c:pt>
                <c:pt idx="29">
                  <c:v>1.2241319444444444E-4</c:v>
                </c:pt>
                <c:pt idx="30">
                  <c:v>1.2639652777777778E-4</c:v>
                </c:pt>
                <c:pt idx="31">
                  <c:v>1.3038055555555556E-4</c:v>
                </c:pt>
                <c:pt idx="32">
                  <c:v>1.3633333333333333E-4</c:v>
                </c:pt>
                <c:pt idx="33">
                  <c:v>1.4228680555555554E-4</c:v>
                </c:pt>
                <c:pt idx="34">
                  <c:v>1.4824027777777778E-4</c:v>
                </c:pt>
                <c:pt idx="35">
                  <c:v>1.8639027777777776E-4</c:v>
                </c:pt>
                <c:pt idx="36">
                  <c:v>1.9592777777777777E-4</c:v>
                </c:pt>
                <c:pt idx="37">
                  <c:v>2.054652777777778E-4</c:v>
                </c:pt>
                <c:pt idx="38">
                  <c:v>2.1500277777777778E-4</c:v>
                </c:pt>
                <c:pt idx="39">
                  <c:v>2.2454027777777779E-4</c:v>
                </c:pt>
                <c:pt idx="40">
                  <c:v>2.2852638888888887E-4</c:v>
                </c:pt>
                <c:pt idx="41">
                  <c:v>2.3251319444444443E-4</c:v>
                </c:pt>
                <c:pt idx="42">
                  <c:v>2.3649999999999998E-4</c:v>
                </c:pt>
                <c:pt idx="43">
                  <c:v>2.4049305555555556E-4</c:v>
                </c:pt>
                <c:pt idx="44">
                  <c:v>2.4448541666666668E-4</c:v>
                </c:pt>
                <c:pt idx="45">
                  <c:v>2.4847847222222221E-4</c:v>
                </c:pt>
                <c:pt idx="46">
                  <c:v>2.5501041666666668E-4</c:v>
                </c:pt>
                <c:pt idx="47">
                  <c:v>2.6154236111111109E-4</c:v>
                </c:pt>
                <c:pt idx="48">
                  <c:v>2.6807361111111112E-4</c:v>
                </c:pt>
                <c:pt idx="49">
                  <c:v>3.1749305555555556E-4</c:v>
                </c:pt>
                <c:pt idx="50">
                  <c:v>3.2984791666666665E-4</c:v>
                </c:pt>
                <c:pt idx="51">
                  <c:v>3.5455763888888887E-4</c:v>
                </c:pt>
                <c:pt idx="52">
                  <c:v>3.7926736111111109E-4</c:v>
                </c:pt>
                <c:pt idx="53">
                  <c:v>4.0397708333333331E-4</c:v>
                </c:pt>
                <c:pt idx="54">
                  <c:v>4.2868680555555554E-4</c:v>
                </c:pt>
                <c:pt idx="55">
                  <c:v>4.9112013888888883E-4</c:v>
                </c:pt>
                <c:pt idx="56">
                  <c:v>5.5355416666666663E-4</c:v>
                </c:pt>
                <c:pt idx="57">
                  <c:v>6.1598819444444442E-4</c:v>
                </c:pt>
                <c:pt idx="58">
                  <c:v>6.7842152777777777E-4</c:v>
                </c:pt>
                <c:pt idx="59">
                  <c:v>7.6303472222222224E-4</c:v>
                </c:pt>
                <c:pt idx="60">
                  <c:v>8.4764583333333328E-4</c:v>
                </c:pt>
                <c:pt idx="61">
                  <c:v>9.3225694444444443E-4</c:v>
                </c:pt>
                <c:pt idx="62">
                  <c:v>1.0168680555555556E-3</c:v>
                </c:pt>
                <c:pt idx="63">
                  <c:v>1.1716111111111111E-3</c:v>
                </c:pt>
                <c:pt idx="64">
                  <c:v>1.3263541666666667E-3</c:v>
                </c:pt>
                <c:pt idx="65">
                  <c:v>1.4810972222222222E-3</c:v>
                </c:pt>
                <c:pt idx="66">
                  <c:v>1.6358402777777777E-3</c:v>
                </c:pt>
                <c:pt idx="67">
                  <c:v>1.7905833333333335E-3</c:v>
                </c:pt>
                <c:pt idx="68">
                  <c:v>1.9830208333333332E-3</c:v>
                </c:pt>
                <c:pt idx="69">
                  <c:v>2.1754583333333335E-3</c:v>
                </c:pt>
                <c:pt idx="70">
                  <c:v>2.367888888888889E-3</c:v>
                </c:pt>
                <c:pt idx="71">
                  <c:v>2.5603263888888889E-3</c:v>
                </c:pt>
                <c:pt idx="72">
                  <c:v>2.7527638888888888E-3</c:v>
                </c:pt>
                <c:pt idx="73">
                  <c:v>3.0553263888888891E-3</c:v>
                </c:pt>
                <c:pt idx="74">
                  <c:v>3.3578888888888886E-3</c:v>
                </c:pt>
                <c:pt idx="75">
                  <c:v>3.6604513888888889E-3</c:v>
                </c:pt>
                <c:pt idx="76">
                  <c:v>3.963020833333334E-3</c:v>
                </c:pt>
                <c:pt idx="77">
                  <c:v>4.265583333333333E-3</c:v>
                </c:pt>
                <c:pt idx="78">
                  <c:v>4.5681458333333329E-3</c:v>
                </c:pt>
                <c:pt idx="79">
                  <c:v>5.0455694444444445E-3</c:v>
                </c:pt>
                <c:pt idx="80">
                  <c:v>5.5229930555555553E-3</c:v>
                </c:pt>
                <c:pt idx="81">
                  <c:v>6.0004236111111118E-3</c:v>
                </c:pt>
                <c:pt idx="82">
                  <c:v>6.4778472222222216E-3</c:v>
                </c:pt>
                <c:pt idx="83">
                  <c:v>6.9552777777777772E-3</c:v>
                </c:pt>
                <c:pt idx="84">
                  <c:v>7.4327083333333328E-3</c:v>
                </c:pt>
                <c:pt idx="85">
                  <c:v>7.9654166666666675E-3</c:v>
                </c:pt>
                <c:pt idx="86">
                  <c:v>8.4980555555555556E-3</c:v>
                </c:pt>
                <c:pt idx="87">
                  <c:v>9.0307638888888885E-3</c:v>
                </c:pt>
                <c:pt idx="88">
                  <c:v>9.5634722222222215E-3</c:v>
                </c:pt>
                <c:pt idx="89">
                  <c:v>1.0096180555555556E-2</c:v>
                </c:pt>
                <c:pt idx="90">
                  <c:v>1.0628888888888889E-2</c:v>
                </c:pt>
                <c:pt idx="91">
                  <c:v>1.1233333333333333E-2</c:v>
                </c:pt>
                <c:pt idx="92">
                  <c:v>1.1837847222222224E-2</c:v>
                </c:pt>
                <c:pt idx="93">
                  <c:v>1.2442361111111112E-2</c:v>
                </c:pt>
                <c:pt idx="94">
                  <c:v>1.3046805555555556E-2</c:v>
                </c:pt>
                <c:pt idx="95">
                  <c:v>1.3651319444444445E-2</c:v>
                </c:pt>
                <c:pt idx="96">
                  <c:v>1.4255763888888891E-2</c:v>
                </c:pt>
                <c:pt idx="97">
                  <c:v>1.4352083333333335E-2</c:v>
                </c:pt>
                <c:pt idx="98">
                  <c:v>1.4448333333333332E-2</c:v>
                </c:pt>
                <c:pt idx="99">
                  <c:v>1.4544583333333333E-2</c:v>
                </c:pt>
                <c:pt idx="100">
                  <c:v>1.4640833333333332E-2</c:v>
                </c:pt>
                <c:pt idx="101">
                  <c:v>1.4737083333333333E-2</c:v>
                </c:pt>
                <c:pt idx="102">
                  <c:v>1.4900694444444446E-2</c:v>
                </c:pt>
                <c:pt idx="103">
                  <c:v>1.5064305555555555E-2</c:v>
                </c:pt>
                <c:pt idx="104">
                  <c:v>1.5227916666666667E-2</c:v>
                </c:pt>
                <c:pt idx="105">
                  <c:v>1.5391458333333332E-2</c:v>
                </c:pt>
                <c:pt idx="106">
                  <c:v>1.5555069444444444E-2</c:v>
                </c:pt>
                <c:pt idx="107">
                  <c:v>1.5885972222222225E-2</c:v>
                </c:pt>
                <c:pt idx="108">
                  <c:v>1.6216944444444444E-2</c:v>
                </c:pt>
                <c:pt idx="109">
                  <c:v>1.6547847222222224E-2</c:v>
                </c:pt>
                <c:pt idx="110">
                  <c:v>1.6878749999999998E-2</c:v>
                </c:pt>
                <c:pt idx="111">
                  <c:v>1.7209722222222223E-2</c:v>
                </c:pt>
                <c:pt idx="112">
                  <c:v>1.7852847222222225E-2</c:v>
                </c:pt>
                <c:pt idx="113">
                  <c:v>1.8495972222222223E-2</c:v>
                </c:pt>
                <c:pt idx="114">
                  <c:v>1.9139166666666669E-2</c:v>
                </c:pt>
                <c:pt idx="115">
                  <c:v>1.9782291666666667E-2</c:v>
                </c:pt>
                <c:pt idx="116">
                  <c:v>2.0425486111111113E-2</c:v>
                </c:pt>
                <c:pt idx="117">
                  <c:v>2.118625E-2</c:v>
                </c:pt>
                <c:pt idx="118">
                  <c:v>2.1947013888888887E-2</c:v>
                </c:pt>
                <c:pt idx="119">
                  <c:v>2.2707708333333333E-2</c:v>
                </c:pt>
                <c:pt idx="120">
                  <c:v>2.3468472222222224E-2</c:v>
                </c:pt>
                <c:pt idx="121">
                  <c:v>2.4229236111111108E-2</c:v>
                </c:pt>
                <c:pt idx="122">
                  <c:v>2.4989999999999998E-2</c:v>
                </c:pt>
                <c:pt idx="123">
                  <c:v>2.6192847222222222E-2</c:v>
                </c:pt>
                <c:pt idx="124">
                  <c:v>2.7395625E-2</c:v>
                </c:pt>
                <c:pt idx="125">
                  <c:v>2.8598472222222223E-2</c:v>
                </c:pt>
                <c:pt idx="126">
                  <c:v>2.9801319444444443E-2</c:v>
                </c:pt>
                <c:pt idx="127">
                  <c:v>3.1004097222222221E-2</c:v>
                </c:pt>
                <c:pt idx="128">
                  <c:v>3.2206944444444448E-2</c:v>
                </c:pt>
                <c:pt idx="129">
                  <c:v>3.4088263888888887E-2</c:v>
                </c:pt>
                <c:pt idx="130">
                  <c:v>3.5969652777777777E-2</c:v>
                </c:pt>
                <c:pt idx="131">
                  <c:v>3.7850972222222223E-2</c:v>
                </c:pt>
                <c:pt idx="132">
                  <c:v>3.9732361111111107E-2</c:v>
                </c:pt>
                <c:pt idx="133">
                  <c:v>4.1613680555555553E-2</c:v>
                </c:pt>
                <c:pt idx="134">
                  <c:v>4.3495069444444444E-2</c:v>
                </c:pt>
                <c:pt idx="135">
                  <c:v>4.6339930555555554E-2</c:v>
                </c:pt>
                <c:pt idx="136">
                  <c:v>4.918472222222222E-2</c:v>
                </c:pt>
                <c:pt idx="137">
                  <c:v>5.2029583333333337E-2</c:v>
                </c:pt>
                <c:pt idx="138">
                  <c:v>5.4874444444444441E-2</c:v>
                </c:pt>
                <c:pt idx="139">
                  <c:v>5.7719305555555551E-2</c:v>
                </c:pt>
                <c:pt idx="140">
                  <c:v>6.0564166666666669E-2</c:v>
                </c:pt>
                <c:pt idx="141">
                  <c:v>6.4442569444444445E-2</c:v>
                </c:pt>
                <c:pt idx="142">
                  <c:v>6.8320902777777776E-2</c:v>
                </c:pt>
                <c:pt idx="143">
                  <c:v>7.2199305555555551E-2</c:v>
                </c:pt>
                <c:pt idx="144">
                  <c:v>7.6077777777777786E-2</c:v>
                </c:pt>
                <c:pt idx="145">
                  <c:v>7.9956250000000006E-2</c:v>
                </c:pt>
                <c:pt idx="146">
                  <c:v>8.3834722222222213E-2</c:v>
                </c:pt>
                <c:pt idx="147">
                  <c:v>8.8806250000000003E-2</c:v>
                </c:pt>
                <c:pt idx="148">
                  <c:v>9.3777777777777765E-2</c:v>
                </c:pt>
                <c:pt idx="149">
                  <c:v>9.8749305555555569E-2</c:v>
                </c:pt>
                <c:pt idx="150">
                  <c:v>0.10372083333333333</c:v>
                </c:pt>
                <c:pt idx="151">
                  <c:v>0.10869305555555556</c:v>
                </c:pt>
                <c:pt idx="152">
                  <c:v>0.11366458333333333</c:v>
                </c:pt>
                <c:pt idx="153">
                  <c:v>0.12065208333333334</c:v>
                </c:pt>
                <c:pt idx="154">
                  <c:v>0.12764027777777778</c:v>
                </c:pt>
                <c:pt idx="155">
                  <c:v>0.13462777777777779</c:v>
                </c:pt>
                <c:pt idx="156">
                  <c:v>0.14161597222222222</c:v>
                </c:pt>
                <c:pt idx="157">
                  <c:v>0.14860347222222223</c:v>
                </c:pt>
                <c:pt idx="158">
                  <c:v>0.15559166666666666</c:v>
                </c:pt>
                <c:pt idx="159">
                  <c:v>0.16419444444444445</c:v>
                </c:pt>
                <c:pt idx="160">
                  <c:v>0.17279791666666666</c:v>
                </c:pt>
                <c:pt idx="161">
                  <c:v>0.18140069444444443</c:v>
                </c:pt>
                <c:pt idx="162">
                  <c:v>0.19000416666666667</c:v>
                </c:pt>
                <c:pt idx="163">
                  <c:v>0.19860763888888888</c:v>
                </c:pt>
                <c:pt idx="164">
                  <c:v>0.20721041666666665</c:v>
                </c:pt>
                <c:pt idx="165">
                  <c:v>0.21581388888888889</c:v>
                </c:pt>
                <c:pt idx="166">
                  <c:v>0.22441666666666668</c:v>
                </c:pt>
                <c:pt idx="167">
                  <c:v>0.23302013888888887</c:v>
                </c:pt>
                <c:pt idx="168">
                  <c:v>0.24162361111111111</c:v>
                </c:pt>
                <c:pt idx="169">
                  <c:v>0.24838750000000001</c:v>
                </c:pt>
                <c:pt idx="170">
                  <c:v>0.24941180555555556</c:v>
                </c:pt>
                <c:pt idx="171">
                  <c:v>0.25043541666666669</c:v>
                </c:pt>
                <c:pt idx="172">
                  <c:v>0.25145902777777779</c:v>
                </c:pt>
                <c:pt idx="173">
                  <c:v>0.25248333333333334</c:v>
                </c:pt>
                <c:pt idx="174">
                  <c:v>0.25350694444444444</c:v>
                </c:pt>
                <c:pt idx="175">
                  <c:v>0.25555486111111114</c:v>
                </c:pt>
                <c:pt idx="176">
                  <c:v>0.25760208333333334</c:v>
                </c:pt>
                <c:pt idx="177">
                  <c:v>0.25964999999999999</c:v>
                </c:pt>
                <c:pt idx="178">
                  <c:v>0.2616979166666667</c:v>
                </c:pt>
                <c:pt idx="179">
                  <c:v>0.26495555555555556</c:v>
                </c:pt>
                <c:pt idx="180">
                  <c:v>0.26821319444444441</c:v>
                </c:pt>
                <c:pt idx="181">
                  <c:v>0.27147083333333333</c:v>
                </c:pt>
                <c:pt idx="182">
                  <c:v>0.27472847222222219</c:v>
                </c:pt>
                <c:pt idx="183">
                  <c:v>0.27798680555555555</c:v>
                </c:pt>
                <c:pt idx="184">
                  <c:v>0.28433888888888886</c:v>
                </c:pt>
                <c:pt idx="185">
                  <c:v>0.29069097222222223</c:v>
                </c:pt>
                <c:pt idx="186">
                  <c:v>0.29704305555555555</c:v>
                </c:pt>
                <c:pt idx="187">
                  <c:v>0.30339583333333331</c:v>
                </c:pt>
                <c:pt idx="188">
                  <c:v>0.30974791666666668</c:v>
                </c:pt>
                <c:pt idx="189">
                  <c:v>0.31635625000000001</c:v>
                </c:pt>
                <c:pt idx="190">
                  <c:v>0.32296388888888888</c:v>
                </c:pt>
                <c:pt idx="191">
                  <c:v>0.32957222222222221</c:v>
                </c:pt>
                <c:pt idx="192">
                  <c:v>0.33618055555555559</c:v>
                </c:pt>
                <c:pt idx="193">
                  <c:v>0.34278819444444447</c:v>
                </c:pt>
                <c:pt idx="194">
                  <c:v>0.34939652777777774</c:v>
                </c:pt>
                <c:pt idx="195">
                  <c:v>0.35698958333333336</c:v>
                </c:pt>
                <c:pt idx="196">
                  <c:v>0.36458263888888892</c:v>
                </c:pt>
                <c:pt idx="197">
                  <c:v>0.37217638888888888</c:v>
                </c:pt>
                <c:pt idx="198">
                  <c:v>0.37976944444444449</c:v>
                </c:pt>
                <c:pt idx="199">
                  <c:v>0.3873625</c:v>
                </c:pt>
                <c:pt idx="200">
                  <c:v>0.39495624999999995</c:v>
                </c:pt>
                <c:pt idx="201">
                  <c:v>0.40345902777777776</c:v>
                </c:pt>
                <c:pt idx="202">
                  <c:v>0.41196111111111117</c:v>
                </c:pt>
                <c:pt idx="203">
                  <c:v>0.42046388888888886</c:v>
                </c:pt>
                <c:pt idx="204">
                  <c:v>0.42169027777777779</c:v>
                </c:pt>
                <c:pt idx="205">
                  <c:v>0.42192499999999999</c:v>
                </c:pt>
                <c:pt idx="206">
                  <c:v>0.42215902777777775</c:v>
                </c:pt>
                <c:pt idx="207">
                  <c:v>0.42239374999999996</c:v>
                </c:pt>
                <c:pt idx="208">
                  <c:v>0.42262777777777771</c:v>
                </c:pt>
                <c:pt idx="209">
                  <c:v>0.42309652777777779</c:v>
                </c:pt>
                <c:pt idx="210">
                  <c:v>0.42356527777777775</c:v>
                </c:pt>
                <c:pt idx="211">
                  <c:v>0.42403402777777782</c:v>
                </c:pt>
                <c:pt idx="212">
                  <c:v>0.42495347222222224</c:v>
                </c:pt>
                <c:pt idx="213">
                  <c:v>0.42587361111111116</c:v>
                </c:pt>
                <c:pt idx="214">
                  <c:v>0.42679305555555558</c:v>
                </c:pt>
                <c:pt idx="215">
                  <c:v>0.42771249999999994</c:v>
                </c:pt>
                <c:pt idx="216">
                  <c:v>0.42986666666666667</c:v>
                </c:pt>
                <c:pt idx="217">
                  <c:v>0.4320201388888889</c:v>
                </c:pt>
                <c:pt idx="218">
                  <c:v>0.43417361111111114</c:v>
                </c:pt>
                <c:pt idx="219">
                  <c:v>0.43632777777777776</c:v>
                </c:pt>
                <c:pt idx="220">
                  <c:v>0.43999375000000002</c:v>
                </c:pt>
                <c:pt idx="221">
                  <c:v>0.44366041666666667</c:v>
                </c:pt>
                <c:pt idx="222">
                  <c:v>0.44732638888888887</c:v>
                </c:pt>
                <c:pt idx="223">
                  <c:v>0.45099305555555552</c:v>
                </c:pt>
                <c:pt idx="224">
                  <c:v>0.45465902777777772</c:v>
                </c:pt>
                <c:pt idx="225">
                  <c:v>0.46159097222222223</c:v>
                </c:pt>
                <c:pt idx="226">
                  <c:v>0.4671520833333333</c:v>
                </c:pt>
                <c:pt idx="227">
                  <c:v>0.47271319444444443</c:v>
                </c:pt>
                <c:pt idx="228">
                  <c:v>0.47827430555555556</c:v>
                </c:pt>
                <c:pt idx="229">
                  <c:v>0.48383541666666663</c:v>
                </c:pt>
                <c:pt idx="230">
                  <c:v>0.48939652777777776</c:v>
                </c:pt>
                <c:pt idx="231">
                  <c:v>0.49623194444444441</c:v>
                </c:pt>
                <c:pt idx="232">
                  <c:v>0.50306736111111117</c:v>
                </c:pt>
                <c:pt idx="233">
                  <c:v>0.50990277777777782</c:v>
                </c:pt>
                <c:pt idx="234">
                  <c:v>0.51673819444444447</c:v>
                </c:pt>
                <c:pt idx="235">
                  <c:v>0.52357361111111111</c:v>
                </c:pt>
                <c:pt idx="236">
                  <c:v>0.53040902777777776</c:v>
                </c:pt>
                <c:pt idx="237">
                  <c:v>0.53819513888888892</c:v>
                </c:pt>
                <c:pt idx="238">
                  <c:v>0.54598124999999997</c:v>
                </c:pt>
                <c:pt idx="239">
                  <c:v>0.55376736111111113</c:v>
                </c:pt>
                <c:pt idx="240">
                  <c:v>0.56155416666666669</c:v>
                </c:pt>
                <c:pt idx="241">
                  <c:v>0.56934027777777785</c:v>
                </c:pt>
                <c:pt idx="242">
                  <c:v>0.5771263888888889</c:v>
                </c:pt>
                <c:pt idx="243">
                  <c:v>0.58491249999999995</c:v>
                </c:pt>
                <c:pt idx="244">
                  <c:v>0.5926993055555555</c:v>
                </c:pt>
                <c:pt idx="245">
                  <c:v>0.60048541666666666</c:v>
                </c:pt>
                <c:pt idx="246">
                  <c:v>0.60827152777777771</c:v>
                </c:pt>
                <c:pt idx="247">
                  <c:v>0.61605763888888887</c:v>
                </c:pt>
                <c:pt idx="248">
                  <c:v>0.62384444444444442</c:v>
                </c:pt>
                <c:pt idx="249">
                  <c:v>0.63163055555555558</c:v>
                </c:pt>
                <c:pt idx="250">
                  <c:v>0.63941666666666663</c:v>
                </c:pt>
                <c:pt idx="251">
                  <c:v>0.64720277777777779</c:v>
                </c:pt>
                <c:pt idx="252">
                  <c:v>0.65498958333333335</c:v>
                </c:pt>
                <c:pt idx="253">
                  <c:v>0.66277569444444451</c:v>
                </c:pt>
                <c:pt idx="254">
                  <c:v>0.67056180555555556</c:v>
                </c:pt>
                <c:pt idx="255">
                  <c:v>0.67834791666666672</c:v>
                </c:pt>
                <c:pt idx="256">
                  <c:v>0.68613472222222227</c:v>
                </c:pt>
                <c:pt idx="257">
                  <c:v>0.69392083333333332</c:v>
                </c:pt>
                <c:pt idx="258">
                  <c:v>0.70170833333333338</c:v>
                </c:pt>
                <c:pt idx="259">
                  <c:v>0.70949305555555553</c:v>
                </c:pt>
                <c:pt idx="260">
                  <c:v>0.7172777777777779</c:v>
                </c:pt>
                <c:pt idx="261">
                  <c:v>0.72506249999999994</c:v>
                </c:pt>
                <c:pt idx="262">
                  <c:v>0.73285416666666658</c:v>
                </c:pt>
                <c:pt idx="263">
                  <c:v>0.74063888888888885</c:v>
                </c:pt>
                <c:pt idx="264">
                  <c:v>0.74842361111111111</c:v>
                </c:pt>
                <c:pt idx="265">
                  <c:v>0.75620833333333337</c:v>
                </c:pt>
                <c:pt idx="266">
                  <c:v>0.76400000000000001</c:v>
                </c:pt>
                <c:pt idx="267">
                  <c:v>0.77178472222222216</c:v>
                </c:pt>
                <c:pt idx="268">
                  <c:v>0.77956944444444443</c:v>
                </c:pt>
                <c:pt idx="269">
                  <c:v>0.78735416666666669</c:v>
                </c:pt>
                <c:pt idx="270">
                  <c:v>0.79514583333333333</c:v>
                </c:pt>
                <c:pt idx="271">
                  <c:v>0.80293055555555559</c:v>
                </c:pt>
                <c:pt idx="272">
                  <c:v>0.81071527777777785</c:v>
                </c:pt>
                <c:pt idx="273">
                  <c:v>0.81850000000000012</c:v>
                </c:pt>
                <c:pt idx="274">
                  <c:v>0.82628472222222216</c:v>
                </c:pt>
                <c:pt idx="275">
                  <c:v>0.8340763888888888</c:v>
                </c:pt>
                <c:pt idx="276">
                  <c:v>0.84186111111111106</c:v>
                </c:pt>
                <c:pt idx="277">
                  <c:v>0.84964583333333332</c:v>
                </c:pt>
                <c:pt idx="278">
                  <c:v>0.85743055555555558</c:v>
                </c:pt>
                <c:pt idx="279">
                  <c:v>0.86522222222222223</c:v>
                </c:pt>
                <c:pt idx="280">
                  <c:v>0.87300694444444449</c:v>
                </c:pt>
                <c:pt idx="281">
                  <c:v>0.88079166666666664</c:v>
                </c:pt>
                <c:pt idx="282">
                  <c:v>0.8885763888888889</c:v>
                </c:pt>
                <c:pt idx="283">
                  <c:v>0.89636111111111105</c:v>
                </c:pt>
                <c:pt idx="284">
                  <c:v>0.90415277777777781</c:v>
                </c:pt>
                <c:pt idx="285">
                  <c:v>0.91193750000000007</c:v>
                </c:pt>
                <c:pt idx="286">
                  <c:v>0.91972222222222233</c:v>
                </c:pt>
                <c:pt idx="287">
                  <c:v>0.92750694444444437</c:v>
                </c:pt>
                <c:pt idx="288">
                  <c:v>0.93529861111111101</c:v>
                </c:pt>
                <c:pt idx="289">
                  <c:v>0.94308333333333327</c:v>
                </c:pt>
                <c:pt idx="290">
                  <c:v>0.95086805555555554</c:v>
                </c:pt>
                <c:pt idx="291">
                  <c:v>0.9586527777777778</c:v>
                </c:pt>
                <c:pt idx="292">
                  <c:v>0.96643750000000006</c:v>
                </c:pt>
                <c:pt idx="293">
                  <c:v>0.9742291666666667</c:v>
                </c:pt>
                <c:pt idx="294">
                  <c:v>0.98201388888888885</c:v>
                </c:pt>
                <c:pt idx="295">
                  <c:v>0.98979861111111112</c:v>
                </c:pt>
                <c:pt idx="296">
                  <c:v>0.99758333333333327</c:v>
                </c:pt>
                <c:pt idx="297">
                  <c:v>1.0053749999999999</c:v>
                </c:pt>
                <c:pt idx="298">
                  <c:v>1.0131597222222222</c:v>
                </c:pt>
                <c:pt idx="299">
                  <c:v>1.0209444444444444</c:v>
                </c:pt>
                <c:pt idx="300">
                  <c:v>1.0287291666666667</c:v>
                </c:pt>
                <c:pt idx="301">
                  <c:v>1.0365208333333333</c:v>
                </c:pt>
                <c:pt idx="302">
                  <c:v>1.0443055555555556</c:v>
                </c:pt>
                <c:pt idx="303">
                  <c:v>1.0520902777777779</c:v>
                </c:pt>
                <c:pt idx="304">
                  <c:v>1.0583888888888888</c:v>
                </c:pt>
                <c:pt idx="305">
                  <c:v>1.0646875</c:v>
                </c:pt>
                <c:pt idx="306">
                  <c:v>1.0709861111111112</c:v>
                </c:pt>
                <c:pt idx="307">
                  <c:v>1.0760277777777778</c:v>
                </c:pt>
                <c:pt idx="308">
                  <c:v>1.0810694444444444</c:v>
                </c:pt>
                <c:pt idx="309">
                  <c:v>1.08525</c:v>
                </c:pt>
                <c:pt idx="310">
                  <c:v>1.0859444444444444</c:v>
                </c:pt>
                <c:pt idx="311">
                  <c:v>1.0866388888888889</c:v>
                </c:pt>
                <c:pt idx="312">
                  <c:v>1.0873333333333333</c:v>
                </c:pt>
                <c:pt idx="313">
                  <c:v>1.0880347222222222</c:v>
                </c:pt>
                <c:pt idx="314">
                  <c:v>1.0887291666666667</c:v>
                </c:pt>
                <c:pt idx="315">
                  <c:v>1.090125</c:v>
                </c:pt>
                <c:pt idx="316">
                  <c:v>1.0915138888888889</c:v>
                </c:pt>
                <c:pt idx="317">
                  <c:v>1.0929097222222222</c:v>
                </c:pt>
                <c:pt idx="318">
                  <c:v>1.094298611111111</c:v>
                </c:pt>
                <c:pt idx="319">
                  <c:v>1.0965208333333334</c:v>
                </c:pt>
                <c:pt idx="320">
                  <c:v>1.0987500000000001</c:v>
                </c:pt>
                <c:pt idx="321">
                  <c:v>1.1009722222222222</c:v>
                </c:pt>
                <c:pt idx="322">
                  <c:v>1.1031944444444444</c:v>
                </c:pt>
                <c:pt idx="323">
                  <c:v>1.1054166666666667</c:v>
                </c:pt>
                <c:pt idx="324">
                  <c:v>1.1090694444444444</c:v>
                </c:pt>
                <c:pt idx="325">
                  <c:v>1.1127152777777778</c:v>
                </c:pt>
                <c:pt idx="326">
                  <c:v>1.1163680555555555</c:v>
                </c:pt>
                <c:pt idx="327">
                  <c:v>1.1200208333333332</c:v>
                </c:pt>
                <c:pt idx="328">
                  <c:v>1.1236666666666666</c:v>
                </c:pt>
                <c:pt idx="329">
                  <c:v>1.1266666666666667</c:v>
                </c:pt>
                <c:pt idx="330">
                  <c:v>1.1296597222222222</c:v>
                </c:pt>
                <c:pt idx="331">
                  <c:v>1.1326527777777777</c:v>
                </c:pt>
                <c:pt idx="332">
                  <c:v>1.1356527777777776</c:v>
                </c:pt>
                <c:pt idx="333">
                  <c:v>1.1386458333333334</c:v>
                </c:pt>
                <c:pt idx="334">
                  <c:v>1.1416458333333332</c:v>
                </c:pt>
                <c:pt idx="335">
                  <c:v>1.1446388888888888</c:v>
                </c:pt>
                <c:pt idx="336">
                  <c:v>1.1476388888888889</c:v>
                </c:pt>
                <c:pt idx="337">
                  <c:v>1.1506319444444446</c:v>
                </c:pt>
                <c:pt idx="338">
                  <c:v>1.153125</c:v>
                </c:pt>
                <c:pt idx="339">
                  <c:v>1.1556111111111111</c:v>
                </c:pt>
                <c:pt idx="340">
                  <c:v>1.1576180555555555</c:v>
                </c:pt>
                <c:pt idx="341">
                  <c:v>1.1596180555555555</c:v>
                </c:pt>
                <c:pt idx="342">
                  <c:v>1.1616180555555555</c:v>
                </c:pt>
                <c:pt idx="343">
                  <c:v>1.1636249999999999</c:v>
                </c:pt>
                <c:pt idx="344">
                  <c:v>1.1639444444444444</c:v>
                </c:pt>
                <c:pt idx="345">
                  <c:v>1.1642638888888888</c:v>
                </c:pt>
                <c:pt idx="346">
                  <c:v>1.1645763888888889</c:v>
                </c:pt>
                <c:pt idx="347">
                  <c:v>1.1648958333333335</c:v>
                </c:pt>
                <c:pt idx="348">
                  <c:v>1.1652152777777778</c:v>
                </c:pt>
                <c:pt idx="349">
                  <c:v>1.1658541666666666</c:v>
                </c:pt>
                <c:pt idx="350">
                  <c:v>1.1664930555555555</c:v>
                </c:pt>
                <c:pt idx="351">
                  <c:v>1.1671319444444446</c:v>
                </c:pt>
                <c:pt idx="352">
                  <c:v>1.1677638888888888</c:v>
                </c:pt>
                <c:pt idx="353">
                  <c:v>1.1689930555555554</c:v>
                </c:pt>
                <c:pt idx="354">
                  <c:v>1.1702222222222221</c:v>
                </c:pt>
                <c:pt idx="355">
                  <c:v>1.1714513888888889</c:v>
                </c:pt>
                <c:pt idx="356">
                  <c:v>1.1726805555555555</c:v>
                </c:pt>
                <c:pt idx="357">
                  <c:v>1.1743541666666666</c:v>
                </c:pt>
                <c:pt idx="358">
                  <c:v>1.1760277777777779</c:v>
                </c:pt>
                <c:pt idx="359">
                  <c:v>1.1777083333333334</c:v>
                </c:pt>
                <c:pt idx="360">
                  <c:v>1.1790972222222222</c:v>
                </c:pt>
                <c:pt idx="361">
                  <c:v>1.1804861111111111</c:v>
                </c:pt>
                <c:pt idx="362">
                  <c:v>1.181875</c:v>
                </c:pt>
                <c:pt idx="363">
                  <c:v>1.1832638888888889</c:v>
                </c:pt>
                <c:pt idx="364">
                  <c:v>1.1846527777777778</c:v>
                </c:pt>
                <c:pt idx="365">
                  <c:v>1.1863333333333332</c:v>
                </c:pt>
                <c:pt idx="366">
                  <c:v>1.1880138888888889</c:v>
                </c:pt>
                <c:pt idx="367">
                  <c:v>1.1896875</c:v>
                </c:pt>
                <c:pt idx="368">
                  <c:v>1.1913680555555555</c:v>
                </c:pt>
                <c:pt idx="369">
                  <c:v>1.1930416666666668</c:v>
                </c:pt>
                <c:pt idx="370">
                  <c:v>1.1947222222222222</c:v>
                </c:pt>
                <c:pt idx="371">
                  <c:v>1.1960555555555554</c:v>
                </c:pt>
                <c:pt idx="372">
                  <c:v>1.197138888888889</c:v>
                </c:pt>
                <c:pt idx="373">
                  <c:v>1.1982222222222223</c:v>
                </c:pt>
                <c:pt idx="374">
                  <c:v>1.1983958333333333</c:v>
                </c:pt>
                <c:pt idx="375">
                  <c:v>1.1985694444444446</c:v>
                </c:pt>
                <c:pt idx="376">
                  <c:v>1.1987430555555556</c:v>
                </c:pt>
                <c:pt idx="377">
                  <c:v>1.1989166666666666</c:v>
                </c:pt>
                <c:pt idx="378">
                  <c:v>1.1992638888888889</c:v>
                </c:pt>
                <c:pt idx="379">
                  <c:v>1.1996041666666668</c:v>
                </c:pt>
                <c:pt idx="380">
                  <c:v>1.1999513888888889</c:v>
                </c:pt>
                <c:pt idx="381">
                  <c:v>1.2002986111111111</c:v>
                </c:pt>
                <c:pt idx="382">
                  <c:v>1.2012152777777778</c:v>
                </c:pt>
                <c:pt idx="383">
                  <c:v>1.2021249999999999</c:v>
                </c:pt>
                <c:pt idx="384">
                  <c:v>1.2030416666666668</c:v>
                </c:pt>
                <c:pt idx="385">
                  <c:v>1.2039583333333335</c:v>
                </c:pt>
                <c:pt idx="386">
                  <c:v>1.2051597222222223</c:v>
                </c:pt>
                <c:pt idx="387">
                  <c:v>1.2063611111111112</c:v>
                </c:pt>
                <c:pt idx="388">
                  <c:v>1.2075625000000001</c:v>
                </c:pt>
                <c:pt idx="389">
                  <c:v>1.2087638888888887</c:v>
                </c:pt>
                <c:pt idx="390">
                  <c:v>1.2099652777777776</c:v>
                </c:pt>
                <c:pt idx="391">
                  <c:v>1.2111666666666667</c:v>
                </c:pt>
                <c:pt idx="392">
                  <c:v>1.2121041666666668</c:v>
                </c:pt>
                <c:pt idx="393">
                  <c:v>1.2130486111111112</c:v>
                </c:pt>
                <c:pt idx="394">
                  <c:v>1.2139930555555556</c:v>
                </c:pt>
                <c:pt idx="395">
                  <c:v>1.2149305555555556</c:v>
                </c:pt>
                <c:pt idx="396">
                  <c:v>1.215875</c:v>
                </c:pt>
                <c:pt idx="397">
                  <c:v>1.2168194444444445</c:v>
                </c:pt>
                <c:pt idx="398">
                  <c:v>1.2177708333333332</c:v>
                </c:pt>
                <c:pt idx="399">
                  <c:v>1.2187222222222223</c:v>
                </c:pt>
                <c:pt idx="400">
                  <c:v>1.2196736111111111</c:v>
                </c:pt>
                <c:pt idx="401">
                  <c:v>1.2206180555555557</c:v>
                </c:pt>
                <c:pt idx="402">
                  <c:v>1.2217222222222222</c:v>
                </c:pt>
                <c:pt idx="403">
                  <c:v>1.2228194444444445</c:v>
                </c:pt>
                <c:pt idx="404">
                  <c:v>1.2239166666666668</c:v>
                </c:pt>
                <c:pt idx="405">
                  <c:v>1.2250208333333332</c:v>
                </c:pt>
                <c:pt idx="406">
                  <c:v>1.2261180555555555</c:v>
                </c:pt>
                <c:pt idx="407">
                  <c:v>1.2273819444444445</c:v>
                </c:pt>
                <c:pt idx="408">
                  <c:v>1.2286458333333334</c:v>
                </c:pt>
                <c:pt idx="409">
                  <c:v>1.2299097222222222</c:v>
                </c:pt>
                <c:pt idx="410">
                  <c:v>1.2311666666666667</c:v>
                </c:pt>
                <c:pt idx="411">
                  <c:v>1.2324305555555557</c:v>
                </c:pt>
                <c:pt idx="412">
                  <c:v>1.2336944444444444</c:v>
                </c:pt>
                <c:pt idx="413">
                  <c:v>1.2349583333333334</c:v>
                </c:pt>
                <c:pt idx="414">
                  <c:v>1.2362222222222223</c:v>
                </c:pt>
                <c:pt idx="415">
                  <c:v>1.2372291666666666</c:v>
                </c:pt>
                <c:pt idx="416">
                  <c:v>1.2382361111111111</c:v>
                </c:pt>
                <c:pt idx="417">
                  <c:v>1.2392361111111112</c:v>
                </c:pt>
                <c:pt idx="418">
                  <c:v>1.2402430555555557</c:v>
                </c:pt>
                <c:pt idx="419">
                  <c:v>1.24125</c:v>
                </c:pt>
                <c:pt idx="420">
                  <c:v>1.2422569444444445</c:v>
                </c:pt>
                <c:pt idx="421">
                  <c:v>1.2432638888888889</c:v>
                </c:pt>
                <c:pt idx="422">
                  <c:v>1.2442708333333334</c:v>
                </c:pt>
                <c:pt idx="423">
                  <c:v>1.2452777777777777</c:v>
                </c:pt>
                <c:pt idx="424">
                  <c:v>1.2462847222222222</c:v>
                </c:pt>
                <c:pt idx="425">
                  <c:v>1.2472916666666667</c:v>
                </c:pt>
                <c:pt idx="426">
                  <c:v>1.2482986111111112</c:v>
                </c:pt>
                <c:pt idx="427">
                  <c:v>1.2493055555555554</c:v>
                </c:pt>
                <c:pt idx="428">
                  <c:v>1.2503124999999999</c:v>
                </c:pt>
                <c:pt idx="429">
                  <c:v>1.2514375</c:v>
                </c:pt>
                <c:pt idx="430">
                  <c:v>1.2525625</c:v>
                </c:pt>
                <c:pt idx="431">
                  <c:v>1.2536944444444444</c:v>
                </c:pt>
                <c:pt idx="432">
                  <c:v>1.2548194444444445</c:v>
                </c:pt>
                <c:pt idx="433">
                  <c:v>1.2559444444444443</c:v>
                </c:pt>
                <c:pt idx="434">
                  <c:v>1.2570694444444446</c:v>
                </c:pt>
                <c:pt idx="435">
                  <c:v>1.2581944444444444</c:v>
                </c:pt>
                <c:pt idx="436">
                  <c:v>1.2593194444444444</c:v>
                </c:pt>
                <c:pt idx="437">
                  <c:v>1.2604444444444445</c:v>
                </c:pt>
                <c:pt idx="438">
                  <c:v>1.2615694444444445</c:v>
                </c:pt>
                <c:pt idx="439">
                  <c:v>1.2626944444444443</c:v>
                </c:pt>
                <c:pt idx="440">
                  <c:v>1.263826388888889</c:v>
                </c:pt>
                <c:pt idx="441">
                  <c:v>1.2649513888888888</c:v>
                </c:pt>
                <c:pt idx="442">
                  <c:v>1.2660763888888888</c:v>
                </c:pt>
                <c:pt idx="443">
                  <c:v>1.2672013888888889</c:v>
                </c:pt>
                <c:pt idx="444">
                  <c:v>1.2683263888888889</c:v>
                </c:pt>
                <c:pt idx="445">
                  <c:v>1.269451388888889</c:v>
                </c:pt>
                <c:pt idx="446">
                  <c:v>1.270576388888889</c:v>
                </c:pt>
                <c:pt idx="447">
                  <c:v>1.2717013888888888</c:v>
                </c:pt>
                <c:pt idx="448">
                  <c:v>1.2728263888888889</c:v>
                </c:pt>
                <c:pt idx="449">
                  <c:v>1.2739583333333333</c:v>
                </c:pt>
                <c:pt idx="450">
                  <c:v>1.2750833333333333</c:v>
                </c:pt>
                <c:pt idx="451">
                  <c:v>1.2762083333333334</c:v>
                </c:pt>
                <c:pt idx="452">
                  <c:v>1.2773333333333332</c:v>
                </c:pt>
                <c:pt idx="453">
                  <c:v>1.2784583333333333</c:v>
                </c:pt>
                <c:pt idx="454">
                  <c:v>1.2795833333333333</c:v>
                </c:pt>
                <c:pt idx="455">
                  <c:v>1.2807083333333333</c:v>
                </c:pt>
                <c:pt idx="456">
                  <c:v>1.2818333333333334</c:v>
                </c:pt>
                <c:pt idx="457">
                  <c:v>1.2829583333333334</c:v>
                </c:pt>
                <c:pt idx="458">
                  <c:v>1.2840902777777776</c:v>
                </c:pt>
                <c:pt idx="459">
                  <c:v>1.2852152777777779</c:v>
                </c:pt>
                <c:pt idx="460">
                  <c:v>1.2861458333333333</c:v>
                </c:pt>
                <c:pt idx="461">
                  <c:v>1.287076388888889</c:v>
                </c:pt>
                <c:pt idx="462">
                  <c:v>1.2880069444444444</c:v>
                </c:pt>
                <c:pt idx="463">
                  <c:v>1.2889374999999998</c:v>
                </c:pt>
                <c:pt idx="464">
                  <c:v>1.2896666666666665</c:v>
                </c:pt>
                <c:pt idx="465">
                  <c:v>1.2903958333333334</c:v>
                </c:pt>
                <c:pt idx="466">
                  <c:v>1.2911250000000001</c:v>
                </c:pt>
                <c:pt idx="467">
                  <c:v>1.2918541666666667</c:v>
                </c:pt>
                <c:pt idx="468">
                  <c:v>1.2919791666666667</c:v>
                </c:pt>
                <c:pt idx="469">
                  <c:v>1.2921041666666668</c:v>
                </c:pt>
                <c:pt idx="470">
                  <c:v>1.2922222222222222</c:v>
                </c:pt>
                <c:pt idx="471">
                  <c:v>1.2923472222222223</c:v>
                </c:pt>
                <c:pt idx="472">
                  <c:v>1.2924652777777779</c:v>
                </c:pt>
                <c:pt idx="473">
                  <c:v>1.2926875</c:v>
                </c:pt>
                <c:pt idx="474">
                  <c:v>1.2929027777777777</c:v>
                </c:pt>
                <c:pt idx="475">
                  <c:v>1.2931249999999999</c:v>
                </c:pt>
                <c:pt idx="476">
                  <c:v>1.2933472222222222</c:v>
                </c:pt>
                <c:pt idx="477">
                  <c:v>1.2935624999999999</c:v>
                </c:pt>
                <c:pt idx="478">
                  <c:v>1.2939722222222221</c:v>
                </c:pt>
                <c:pt idx="479">
                  <c:v>1.2943819444444444</c:v>
                </c:pt>
                <c:pt idx="480">
                  <c:v>1.2947916666666666</c:v>
                </c:pt>
                <c:pt idx="481">
                  <c:v>1.2952013888888889</c:v>
                </c:pt>
                <c:pt idx="482">
                  <c:v>1.295611111111111</c:v>
                </c:pt>
                <c:pt idx="483">
                  <c:v>1.2961805555555554</c:v>
                </c:pt>
                <c:pt idx="484">
                  <c:v>1.2967430555555555</c:v>
                </c:pt>
                <c:pt idx="485">
                  <c:v>1.2973125000000001</c:v>
                </c:pt>
                <c:pt idx="486">
                  <c:v>1.2978750000000001</c:v>
                </c:pt>
                <c:pt idx="487">
                  <c:v>1.2984444444444445</c:v>
                </c:pt>
                <c:pt idx="488">
                  <c:v>1.2991874999999999</c:v>
                </c:pt>
                <c:pt idx="489">
                  <c:v>1.2999236111111112</c:v>
                </c:pt>
                <c:pt idx="490">
                  <c:v>1.3006666666666666</c:v>
                </c:pt>
                <c:pt idx="491">
                  <c:v>1.3014097222222223</c:v>
                </c:pt>
                <c:pt idx="492">
                  <c:v>1.3021458333333333</c:v>
                </c:pt>
                <c:pt idx="493">
                  <c:v>1.302888888888889</c:v>
                </c:pt>
                <c:pt idx="494">
                  <c:v>1.3036319444444444</c:v>
                </c:pt>
                <c:pt idx="495">
                  <c:v>1.3043750000000001</c:v>
                </c:pt>
                <c:pt idx="496">
                  <c:v>1.3051111111111111</c:v>
                </c:pt>
                <c:pt idx="497">
                  <c:v>1.3056805555555555</c:v>
                </c:pt>
                <c:pt idx="498">
                  <c:v>1.3061527777777777</c:v>
                </c:pt>
                <c:pt idx="499">
                  <c:v>1.3066249999999999</c:v>
                </c:pt>
                <c:pt idx="500">
                  <c:v>1.3067222222222223</c:v>
                </c:pt>
                <c:pt idx="501">
                  <c:v>1.3068124999999999</c:v>
                </c:pt>
                <c:pt idx="502">
                  <c:v>1.3069097222222223</c:v>
                </c:pt>
                <c:pt idx="503">
                  <c:v>1.3069999999999999</c:v>
                </c:pt>
                <c:pt idx="504">
                  <c:v>1.3070972222222221</c:v>
                </c:pt>
                <c:pt idx="505">
                  <c:v>1.3072708333333334</c:v>
                </c:pt>
                <c:pt idx="506">
                  <c:v>1.307451388888889</c:v>
                </c:pt>
                <c:pt idx="507">
                  <c:v>1.307625</c:v>
                </c:pt>
                <c:pt idx="508">
                  <c:v>1.3078055555555557</c:v>
                </c:pt>
                <c:pt idx="509">
                  <c:v>1.3080763888888889</c:v>
                </c:pt>
                <c:pt idx="510">
                  <c:v>1.3083541666666667</c:v>
                </c:pt>
                <c:pt idx="511">
                  <c:v>1.3086250000000001</c:v>
                </c:pt>
                <c:pt idx="512">
                  <c:v>1.3089027777777777</c:v>
                </c:pt>
                <c:pt idx="513">
                  <c:v>1.3092083333333333</c:v>
                </c:pt>
                <c:pt idx="514">
                  <c:v>1.3095138888888889</c:v>
                </c:pt>
                <c:pt idx="515">
                  <c:v>1.309826388888889</c:v>
                </c:pt>
                <c:pt idx="516">
                  <c:v>1.3101319444444444</c:v>
                </c:pt>
                <c:pt idx="517">
                  <c:v>1.3104444444444445</c:v>
                </c:pt>
                <c:pt idx="518">
                  <c:v>1.3107986111111112</c:v>
                </c:pt>
                <c:pt idx="519">
                  <c:v>1.3111597222222222</c:v>
                </c:pt>
                <c:pt idx="520">
                  <c:v>1.3115208333333332</c:v>
                </c:pt>
                <c:pt idx="521">
                  <c:v>1.3118819444444443</c:v>
                </c:pt>
                <c:pt idx="522">
                  <c:v>1.3122361111111109</c:v>
                </c:pt>
                <c:pt idx="523">
                  <c:v>1.3126319444444445</c:v>
                </c:pt>
                <c:pt idx="524">
                  <c:v>1.3130277777777777</c:v>
                </c:pt>
                <c:pt idx="525">
                  <c:v>1.3133194444444445</c:v>
                </c:pt>
                <c:pt idx="526">
                  <c:v>1.3133680555555556</c:v>
                </c:pt>
                <c:pt idx="527">
                  <c:v>1.3134236111111111</c:v>
                </c:pt>
                <c:pt idx="528">
                  <c:v>1.3134722222222224</c:v>
                </c:pt>
                <c:pt idx="529">
                  <c:v>1.3135208333333332</c:v>
                </c:pt>
                <c:pt idx="530">
                  <c:v>1.3136249999999998</c:v>
                </c:pt>
                <c:pt idx="531">
                  <c:v>1.3137222222222222</c:v>
                </c:pt>
                <c:pt idx="532">
                  <c:v>1.313826388888889</c:v>
                </c:pt>
                <c:pt idx="533">
                  <c:v>1.313923611111111</c:v>
                </c:pt>
                <c:pt idx="534">
                  <c:v>1.3141458333333333</c:v>
                </c:pt>
                <c:pt idx="535">
                  <c:v>1.3143680555555557</c:v>
                </c:pt>
                <c:pt idx="536">
                  <c:v>1.3145902777777778</c:v>
                </c:pt>
                <c:pt idx="537">
                  <c:v>1.3148124999999999</c:v>
                </c:pt>
                <c:pt idx="538">
                  <c:v>1.3151180555555555</c:v>
                </c:pt>
                <c:pt idx="539">
                  <c:v>1.3154236111111111</c:v>
                </c:pt>
                <c:pt idx="540">
                  <c:v>1.3157291666666668</c:v>
                </c:pt>
                <c:pt idx="541">
                  <c:v>1.3160277777777778</c:v>
                </c:pt>
                <c:pt idx="542">
                  <c:v>1.3163333333333334</c:v>
                </c:pt>
                <c:pt idx="543">
                  <c:v>1.3166875</c:v>
                </c:pt>
                <c:pt idx="544">
                  <c:v>1.3170347222222223</c:v>
                </c:pt>
                <c:pt idx="545">
                  <c:v>1.3173819444444443</c:v>
                </c:pt>
                <c:pt idx="546">
                  <c:v>1.317736111111111</c:v>
                </c:pt>
                <c:pt idx="547">
                  <c:v>1.3180833333333333</c:v>
                </c:pt>
                <c:pt idx="548">
                  <c:v>1.3185625000000001</c:v>
                </c:pt>
                <c:pt idx="549">
                  <c:v>1.3190416666666667</c:v>
                </c:pt>
                <c:pt idx="550">
                  <c:v>1.3194027777777779</c:v>
                </c:pt>
                <c:pt idx="551">
                  <c:v>1.3196736111111111</c:v>
                </c:pt>
                <c:pt idx="552">
                  <c:v>1.3199444444444444</c:v>
                </c:pt>
                <c:pt idx="553">
                  <c:v>1.3199861111111111</c:v>
                </c:pt>
                <c:pt idx="554">
                  <c:v>1.3200277777777778</c:v>
                </c:pt>
                <c:pt idx="555">
                  <c:v>1.3200694444444445</c:v>
                </c:pt>
                <c:pt idx="556">
                  <c:v>1.3201041666666666</c:v>
                </c:pt>
                <c:pt idx="557">
                  <c:v>1.3201736111111111</c:v>
                </c:pt>
                <c:pt idx="558">
                  <c:v>1.3202430555555555</c:v>
                </c:pt>
                <c:pt idx="559">
                  <c:v>1.3203125</c:v>
                </c:pt>
                <c:pt idx="560">
                  <c:v>1.3203819444444445</c:v>
                </c:pt>
                <c:pt idx="561">
                  <c:v>1.3205208333333334</c:v>
                </c:pt>
                <c:pt idx="562">
                  <c:v>1.3206597222222223</c:v>
                </c:pt>
                <c:pt idx="563">
                  <c:v>1.3207986111111112</c:v>
                </c:pt>
                <c:pt idx="564">
                  <c:v>1.3209375000000001</c:v>
                </c:pt>
                <c:pt idx="565">
                  <c:v>1.3212222222222221</c:v>
                </c:pt>
                <c:pt idx="566">
                  <c:v>1.3215000000000001</c:v>
                </c:pt>
                <c:pt idx="567">
                  <c:v>1.3217847222222221</c:v>
                </c:pt>
                <c:pt idx="568">
                  <c:v>1.3220624999999999</c:v>
                </c:pt>
                <c:pt idx="569">
                  <c:v>1.3223472222222223</c:v>
                </c:pt>
                <c:pt idx="570">
                  <c:v>1.3226249999999999</c:v>
                </c:pt>
                <c:pt idx="571">
                  <c:v>1.3229097222222221</c:v>
                </c:pt>
                <c:pt idx="572">
                  <c:v>1.3231875</c:v>
                </c:pt>
                <c:pt idx="573">
                  <c:v>1.3234999999999999</c:v>
                </c:pt>
                <c:pt idx="574">
                  <c:v>1.3238125000000001</c:v>
                </c:pt>
                <c:pt idx="575">
                  <c:v>1.324125</c:v>
                </c:pt>
                <c:pt idx="576">
                  <c:v>1.3244374999999999</c:v>
                </c:pt>
                <c:pt idx="577">
                  <c:v>1.3247500000000001</c:v>
                </c:pt>
                <c:pt idx="578">
                  <c:v>1.3251111111111111</c:v>
                </c:pt>
                <c:pt idx="579">
                  <c:v>1.3254722222222222</c:v>
                </c:pt>
                <c:pt idx="580">
                  <c:v>1.3258333333333334</c:v>
                </c:pt>
                <c:pt idx="581">
                  <c:v>1.3261944444444445</c:v>
                </c:pt>
                <c:pt idx="582">
                  <c:v>1.3262499999999999</c:v>
                </c:pt>
                <c:pt idx="583">
                  <c:v>1.326298611111111</c:v>
                </c:pt>
                <c:pt idx="584">
                  <c:v>1.3263541666666667</c:v>
                </c:pt>
                <c:pt idx="585">
                  <c:v>1.3264097222222222</c:v>
                </c:pt>
                <c:pt idx="586">
                  <c:v>1.3264583333333333</c:v>
                </c:pt>
                <c:pt idx="587">
                  <c:v>1.3265347222222224</c:v>
                </c:pt>
                <c:pt idx="588">
                  <c:v>1.326611111111111</c:v>
                </c:pt>
                <c:pt idx="589">
                  <c:v>1.3266805555555556</c:v>
                </c:pt>
                <c:pt idx="590">
                  <c:v>1.3267569444444445</c:v>
                </c:pt>
                <c:pt idx="591">
                  <c:v>1.3269027777777778</c:v>
                </c:pt>
                <c:pt idx="592">
                  <c:v>1.3270486111111111</c:v>
                </c:pt>
                <c:pt idx="593">
                  <c:v>1.3271944444444446</c:v>
                </c:pt>
                <c:pt idx="594">
                  <c:v>1.3273402777777776</c:v>
                </c:pt>
                <c:pt idx="595">
                  <c:v>1.3275486111111112</c:v>
                </c:pt>
                <c:pt idx="596">
                  <c:v>1.3277569444444444</c:v>
                </c:pt>
                <c:pt idx="597">
                  <c:v>1.3279652777777777</c:v>
                </c:pt>
                <c:pt idx="598">
                  <c:v>1.328138888888889</c:v>
                </c:pt>
                <c:pt idx="599">
                  <c:v>1.3283055555555556</c:v>
                </c:pt>
                <c:pt idx="600">
                  <c:v>1.3284791666666667</c:v>
                </c:pt>
                <c:pt idx="601">
                  <c:v>1.3286458333333333</c:v>
                </c:pt>
                <c:pt idx="602">
                  <c:v>1.3288125</c:v>
                </c:pt>
                <c:pt idx="603">
                  <c:v>1.3290277777777777</c:v>
                </c:pt>
                <c:pt idx="604">
                  <c:v>1.3292430555555554</c:v>
                </c:pt>
                <c:pt idx="605">
                  <c:v>1.3294027777777777</c:v>
                </c:pt>
                <c:pt idx="606">
                  <c:v>1.3295347222222222</c:v>
                </c:pt>
                <c:pt idx="607">
                  <c:v>1.3296666666666668</c:v>
                </c:pt>
                <c:pt idx="608">
                  <c:v>1.3296874999999999</c:v>
                </c:pt>
                <c:pt idx="609">
                  <c:v>1.3297083333333333</c:v>
                </c:pt>
                <c:pt idx="610">
                  <c:v>1.3297291666666666</c:v>
                </c:pt>
                <c:pt idx="611">
                  <c:v>1.3297569444444444</c:v>
                </c:pt>
                <c:pt idx="612">
                  <c:v>1.3297986111111111</c:v>
                </c:pt>
                <c:pt idx="613">
                  <c:v>1.3298402777777778</c:v>
                </c:pt>
                <c:pt idx="614">
                  <c:v>1.3298888888888889</c:v>
                </c:pt>
                <c:pt idx="615">
                  <c:v>1.3299305555555554</c:v>
                </c:pt>
                <c:pt idx="616">
                  <c:v>1.3300555555555555</c:v>
                </c:pt>
                <c:pt idx="617">
                  <c:v>1.3301736111111111</c:v>
                </c:pt>
                <c:pt idx="618">
                  <c:v>1.3302986111111113</c:v>
                </c:pt>
                <c:pt idx="619">
                  <c:v>1.3304236111111112</c:v>
                </c:pt>
                <c:pt idx="620">
                  <c:v>1.3305416666666667</c:v>
                </c:pt>
                <c:pt idx="621">
                  <c:v>1.3307499999999999</c:v>
                </c:pt>
                <c:pt idx="622">
                  <c:v>1.3309583333333332</c:v>
                </c:pt>
                <c:pt idx="623">
                  <c:v>1.3311666666666668</c:v>
                </c:pt>
                <c:pt idx="624">
                  <c:v>1.331375</c:v>
                </c:pt>
                <c:pt idx="625">
                  <c:v>1.331576388888889</c:v>
                </c:pt>
                <c:pt idx="626">
                  <c:v>1.3318402777777778</c:v>
                </c:pt>
                <c:pt idx="627">
                  <c:v>1.3321041666666666</c:v>
                </c:pt>
                <c:pt idx="628">
                  <c:v>1.3323680555555555</c:v>
                </c:pt>
                <c:pt idx="629">
                  <c:v>1.3326319444444445</c:v>
                </c:pt>
                <c:pt idx="630">
                  <c:v>1.3328888888888888</c:v>
                </c:pt>
                <c:pt idx="631">
                  <c:v>1.3331527777777779</c:v>
                </c:pt>
                <c:pt idx="632">
                  <c:v>1.3334166666666667</c:v>
                </c:pt>
                <c:pt idx="633">
                  <c:v>1.3336805555555555</c:v>
                </c:pt>
                <c:pt idx="634">
                  <c:v>1.3339444444444446</c:v>
                </c:pt>
                <c:pt idx="635">
                  <c:v>1.3342013888888888</c:v>
                </c:pt>
                <c:pt idx="636">
                  <c:v>1.3344652777777779</c:v>
                </c:pt>
                <c:pt idx="637">
                  <c:v>1.3347291666666667</c:v>
                </c:pt>
                <c:pt idx="638">
                  <c:v>1.3349930555555556</c:v>
                </c:pt>
                <c:pt idx="639">
                  <c:v>1.3352569444444444</c:v>
                </c:pt>
                <c:pt idx="640">
                  <c:v>1.3355138888888889</c:v>
                </c:pt>
                <c:pt idx="641">
                  <c:v>1.3357777777777777</c:v>
                </c:pt>
                <c:pt idx="642">
                  <c:v>1.3360416666666668</c:v>
                </c:pt>
                <c:pt idx="643">
                  <c:v>1.3363055555555556</c:v>
                </c:pt>
                <c:pt idx="644">
                  <c:v>1.3365694444444445</c:v>
                </c:pt>
                <c:pt idx="645">
                  <c:v>1.3368263888888889</c:v>
                </c:pt>
                <c:pt idx="646">
                  <c:v>1.3370902777777778</c:v>
                </c:pt>
                <c:pt idx="647">
                  <c:v>1.3374236111111111</c:v>
                </c:pt>
                <c:pt idx="648">
                  <c:v>1.3377569444444444</c:v>
                </c:pt>
                <c:pt idx="649">
                  <c:v>1.3380833333333333</c:v>
                </c:pt>
                <c:pt idx="650">
                  <c:v>1.3384166666666666</c:v>
                </c:pt>
                <c:pt idx="651">
                  <c:v>1.3386875</c:v>
                </c:pt>
                <c:pt idx="652">
                  <c:v>1.3388958333333334</c:v>
                </c:pt>
                <c:pt idx="653">
                  <c:v>1.3391041666666665</c:v>
                </c:pt>
                <c:pt idx="654">
                  <c:v>1.3391458333333333</c:v>
                </c:pt>
                <c:pt idx="655">
                  <c:v>1.3391805555555556</c:v>
                </c:pt>
                <c:pt idx="656">
                  <c:v>1.3392152777777777</c:v>
                </c:pt>
                <c:pt idx="657">
                  <c:v>1.3392569444444444</c:v>
                </c:pt>
                <c:pt idx="658">
                  <c:v>1.3392916666666665</c:v>
                </c:pt>
                <c:pt idx="659">
                  <c:v>1.3393680555555556</c:v>
                </c:pt>
                <c:pt idx="660">
                  <c:v>1.3394375000000001</c:v>
                </c:pt>
                <c:pt idx="661">
                  <c:v>1.3395138888888889</c:v>
                </c:pt>
                <c:pt idx="662">
                  <c:v>1.3395833333333333</c:v>
                </c:pt>
                <c:pt idx="663">
                  <c:v>1.3396875000000001</c:v>
                </c:pt>
                <c:pt idx="664">
                  <c:v>1.3397916666666667</c:v>
                </c:pt>
                <c:pt idx="665">
                  <c:v>1.3398958333333333</c:v>
                </c:pt>
                <c:pt idx="666">
                  <c:v>1.3400069444444445</c:v>
                </c:pt>
                <c:pt idx="667">
                  <c:v>1.3401597222222221</c:v>
                </c:pt>
                <c:pt idx="668">
                  <c:v>1.3403125</c:v>
                </c:pt>
                <c:pt idx="669">
                  <c:v>1.3404652777777777</c:v>
                </c:pt>
                <c:pt idx="670">
                  <c:v>1.3406180555555556</c:v>
                </c:pt>
                <c:pt idx="671">
                  <c:v>1.3407708333333335</c:v>
                </c:pt>
                <c:pt idx="672">
                  <c:v>1.3409513888888889</c:v>
                </c:pt>
                <c:pt idx="673">
                  <c:v>1.3411319444444445</c:v>
                </c:pt>
                <c:pt idx="674">
                  <c:v>1.3413124999999999</c:v>
                </c:pt>
                <c:pt idx="675">
                  <c:v>1.3414930555555555</c:v>
                </c:pt>
                <c:pt idx="676">
                  <c:v>1.3416736111111112</c:v>
                </c:pt>
                <c:pt idx="677">
                  <c:v>1.3419097222222223</c:v>
                </c:pt>
                <c:pt idx="678">
                  <c:v>1.3421458333333334</c:v>
                </c:pt>
                <c:pt idx="679">
                  <c:v>1.3423888888888889</c:v>
                </c:pt>
                <c:pt idx="680">
                  <c:v>1.3426250000000002</c:v>
                </c:pt>
                <c:pt idx="681">
                  <c:v>1.3428611111111111</c:v>
                </c:pt>
                <c:pt idx="682">
                  <c:v>1.3430972222222222</c:v>
                </c:pt>
                <c:pt idx="683">
                  <c:v>1.3433333333333335</c:v>
                </c:pt>
                <c:pt idx="684">
                  <c:v>1.3435208333333333</c:v>
                </c:pt>
                <c:pt idx="685">
                  <c:v>1.3437083333333333</c:v>
                </c:pt>
                <c:pt idx="686">
                  <c:v>1.3439027777777779</c:v>
                </c:pt>
                <c:pt idx="687">
                  <c:v>1.3439305555555556</c:v>
                </c:pt>
                <c:pt idx="688">
                  <c:v>1.3439583333333334</c:v>
                </c:pt>
                <c:pt idx="689">
                  <c:v>1.3439861111111111</c:v>
                </c:pt>
                <c:pt idx="690">
                  <c:v>1.3440138888888891</c:v>
                </c:pt>
                <c:pt idx="691">
                  <c:v>1.3440416666666668</c:v>
                </c:pt>
                <c:pt idx="692">
                  <c:v>1.3440833333333333</c:v>
                </c:pt>
                <c:pt idx="693">
                  <c:v>1.344125</c:v>
                </c:pt>
                <c:pt idx="694">
                  <c:v>1.3441666666666665</c:v>
                </c:pt>
                <c:pt idx="695">
                  <c:v>1.3442083333333334</c:v>
                </c:pt>
                <c:pt idx="696">
                  <c:v>1.3443194444444444</c:v>
                </c:pt>
                <c:pt idx="697">
                  <c:v>1.3444305555555556</c:v>
                </c:pt>
                <c:pt idx="698">
                  <c:v>1.3445347222222224</c:v>
                </c:pt>
                <c:pt idx="699">
                  <c:v>1.3446458333333333</c:v>
                </c:pt>
                <c:pt idx="700">
                  <c:v>1.3447986111111112</c:v>
                </c:pt>
                <c:pt idx="701">
                  <c:v>1.3449513888888889</c:v>
                </c:pt>
                <c:pt idx="702">
                  <c:v>1.3451041666666668</c:v>
                </c:pt>
                <c:pt idx="703">
                  <c:v>1.3452569444444444</c:v>
                </c:pt>
                <c:pt idx="704">
                  <c:v>1.3454097222222223</c:v>
                </c:pt>
                <c:pt idx="705">
                  <c:v>1.3455972222222223</c:v>
                </c:pt>
                <c:pt idx="706">
                  <c:v>1.3457777777777777</c:v>
                </c:pt>
                <c:pt idx="707">
                  <c:v>1.3459652777777777</c:v>
                </c:pt>
                <c:pt idx="708">
                  <c:v>1.3461458333333334</c:v>
                </c:pt>
                <c:pt idx="709">
                  <c:v>1.3463333333333334</c:v>
                </c:pt>
                <c:pt idx="710">
                  <c:v>1.3465763888888889</c:v>
                </c:pt>
                <c:pt idx="711">
                  <c:v>1.3468125</c:v>
                </c:pt>
                <c:pt idx="712">
                  <c:v>1.3470555555555555</c:v>
                </c:pt>
                <c:pt idx="713">
                  <c:v>1.3472986111111109</c:v>
                </c:pt>
                <c:pt idx="714">
                  <c:v>1.3475416666666666</c:v>
                </c:pt>
                <c:pt idx="715">
                  <c:v>1.3477847222222221</c:v>
                </c:pt>
                <c:pt idx="716">
                  <c:v>1.3480555555555556</c:v>
                </c:pt>
                <c:pt idx="717">
                  <c:v>1.3482777777777777</c:v>
                </c:pt>
                <c:pt idx="718">
                  <c:v>1.3483125</c:v>
                </c:pt>
                <c:pt idx="719">
                  <c:v>1.3483541666666667</c:v>
                </c:pt>
                <c:pt idx="720">
                  <c:v>1.3483888888888889</c:v>
                </c:pt>
                <c:pt idx="721">
                  <c:v>1.3484236111111112</c:v>
                </c:pt>
                <c:pt idx="722">
                  <c:v>1.3484583333333333</c:v>
                </c:pt>
                <c:pt idx="723">
                  <c:v>1.3485347222222224</c:v>
                </c:pt>
                <c:pt idx="724">
                  <c:v>1.3486041666666666</c:v>
                </c:pt>
                <c:pt idx="725">
                  <c:v>1.3486805555555554</c:v>
                </c:pt>
                <c:pt idx="726">
                  <c:v>1.3487500000000001</c:v>
                </c:pt>
                <c:pt idx="727">
                  <c:v>1.3488819444444444</c:v>
                </c:pt>
                <c:pt idx="728">
                  <c:v>1.3490069444444444</c:v>
                </c:pt>
                <c:pt idx="729">
                  <c:v>1.3491388888888889</c:v>
                </c:pt>
                <c:pt idx="730">
                  <c:v>1.3492638888888888</c:v>
                </c:pt>
                <c:pt idx="731">
                  <c:v>1.3493958333333333</c:v>
                </c:pt>
                <c:pt idx="732">
                  <c:v>1.349576388888889</c:v>
                </c:pt>
                <c:pt idx="733">
                  <c:v>1.349763888888889</c:v>
                </c:pt>
                <c:pt idx="734">
                  <c:v>1.349951388888889</c:v>
                </c:pt>
                <c:pt idx="735">
                  <c:v>1.3501319444444444</c:v>
                </c:pt>
                <c:pt idx="736">
                  <c:v>1.3503194444444444</c:v>
                </c:pt>
                <c:pt idx="737">
                  <c:v>1.3505833333333332</c:v>
                </c:pt>
                <c:pt idx="738">
                  <c:v>1.3508472222222223</c:v>
                </c:pt>
                <c:pt idx="739">
                  <c:v>1.3511111111111112</c:v>
                </c:pt>
                <c:pt idx="740">
                  <c:v>1.351375</c:v>
                </c:pt>
                <c:pt idx="741">
                  <c:v>1.3516388888888888</c:v>
                </c:pt>
                <c:pt idx="742">
                  <c:v>1.3519027777777777</c:v>
                </c:pt>
                <c:pt idx="743">
                  <c:v>1.3522430555555556</c:v>
                </c:pt>
                <c:pt idx="744">
                  <c:v>1.3525902777777778</c:v>
                </c:pt>
                <c:pt idx="745">
                  <c:v>1.3529305555555555</c:v>
                </c:pt>
                <c:pt idx="746">
                  <c:v>1.3532708333333334</c:v>
                </c:pt>
                <c:pt idx="747">
                  <c:v>1.3536180555555555</c:v>
                </c:pt>
                <c:pt idx="748">
                  <c:v>1.3539583333333334</c:v>
                </c:pt>
                <c:pt idx="749">
                  <c:v>1.3543055555555557</c:v>
                </c:pt>
                <c:pt idx="750">
                  <c:v>1.3546458333333333</c:v>
                </c:pt>
                <c:pt idx="751">
                  <c:v>1.3549930555555556</c:v>
                </c:pt>
                <c:pt idx="752">
                  <c:v>1.3553333333333333</c:v>
                </c:pt>
                <c:pt idx="753">
                  <c:v>1.3556736111111112</c:v>
                </c:pt>
                <c:pt idx="754">
                  <c:v>1.3560208333333335</c:v>
                </c:pt>
                <c:pt idx="755">
                  <c:v>1.3563611111111111</c:v>
                </c:pt>
                <c:pt idx="756">
                  <c:v>1.3567083333333334</c:v>
                </c:pt>
                <c:pt idx="757">
                  <c:v>1.3570486111111111</c:v>
                </c:pt>
                <c:pt idx="758">
                  <c:v>1.357388888888889</c:v>
                </c:pt>
                <c:pt idx="759">
                  <c:v>1.3577361111111113</c:v>
                </c:pt>
                <c:pt idx="760">
                  <c:v>1.3580763888888889</c:v>
                </c:pt>
                <c:pt idx="761">
                  <c:v>1.3584236111111112</c:v>
                </c:pt>
                <c:pt idx="762">
                  <c:v>1.3587638888888889</c:v>
                </c:pt>
                <c:pt idx="763">
                  <c:v>1.3591111111111109</c:v>
                </c:pt>
                <c:pt idx="764">
                  <c:v>1.3594513888888888</c:v>
                </c:pt>
                <c:pt idx="765">
                  <c:v>1.3597916666666665</c:v>
                </c:pt>
                <c:pt idx="766">
                  <c:v>1.3601388888888888</c:v>
                </c:pt>
                <c:pt idx="767">
                  <c:v>1.3604791666666667</c:v>
                </c:pt>
                <c:pt idx="768">
                  <c:v>1.3608263888888887</c:v>
                </c:pt>
                <c:pt idx="769">
                  <c:v>1.3611666666666666</c:v>
                </c:pt>
                <c:pt idx="770">
                  <c:v>1.3615138888888889</c:v>
                </c:pt>
                <c:pt idx="771">
                  <c:v>1.3618541666666666</c:v>
                </c:pt>
                <c:pt idx="772">
                  <c:v>1.3621944444444445</c:v>
                </c:pt>
                <c:pt idx="773">
                  <c:v>1.3625416666666665</c:v>
                </c:pt>
                <c:pt idx="774">
                  <c:v>1.3628819444444444</c:v>
                </c:pt>
                <c:pt idx="775">
                  <c:v>1.3632291666666667</c:v>
                </c:pt>
                <c:pt idx="776">
                  <c:v>1.3635694444444444</c:v>
                </c:pt>
                <c:pt idx="777">
                  <c:v>1.3639166666666667</c:v>
                </c:pt>
                <c:pt idx="778">
                  <c:v>1.3642569444444443</c:v>
                </c:pt>
                <c:pt idx="779">
                  <c:v>1.3646388888888887</c:v>
                </c:pt>
                <c:pt idx="780">
                  <c:v>1.3650138888888887</c:v>
                </c:pt>
                <c:pt idx="781">
                  <c:v>1.365388888888889</c:v>
                </c:pt>
                <c:pt idx="782">
                  <c:v>1.3657708333333334</c:v>
                </c:pt>
                <c:pt idx="783">
                  <c:v>1.3661458333333334</c:v>
                </c:pt>
                <c:pt idx="784">
                  <c:v>1.3665277777777778</c:v>
                </c:pt>
                <c:pt idx="785">
                  <c:v>1.3669027777777778</c:v>
                </c:pt>
                <c:pt idx="786">
                  <c:v>1.3672847222222222</c:v>
                </c:pt>
                <c:pt idx="787">
                  <c:v>1.3676597222222222</c:v>
                </c:pt>
                <c:pt idx="788">
                  <c:v>1.3680416666666666</c:v>
                </c:pt>
                <c:pt idx="789">
                  <c:v>1.3684166666666666</c:v>
                </c:pt>
                <c:pt idx="790">
                  <c:v>1.368798611111111</c:v>
                </c:pt>
                <c:pt idx="791">
                  <c:v>1.369173611111111</c:v>
                </c:pt>
                <c:pt idx="792">
                  <c:v>1.3695555555555556</c:v>
                </c:pt>
                <c:pt idx="793">
                  <c:v>1.3699305555555557</c:v>
                </c:pt>
                <c:pt idx="794">
                  <c:v>1.3703125</c:v>
                </c:pt>
                <c:pt idx="795">
                  <c:v>1.3706875000000001</c:v>
                </c:pt>
                <c:pt idx="796">
                  <c:v>1.3710694444444445</c:v>
                </c:pt>
                <c:pt idx="797">
                  <c:v>1.3714444444444445</c:v>
                </c:pt>
                <c:pt idx="798">
                  <c:v>1.3718263888888889</c:v>
                </c:pt>
                <c:pt idx="799">
                  <c:v>1.3722013888888889</c:v>
                </c:pt>
                <c:pt idx="800">
                  <c:v>1.3726180555555556</c:v>
                </c:pt>
                <c:pt idx="801">
                  <c:v>1.3730347222222223</c:v>
                </c:pt>
                <c:pt idx="802">
                  <c:v>1.3734583333333332</c:v>
                </c:pt>
                <c:pt idx="803">
                  <c:v>1.3738750000000002</c:v>
                </c:pt>
                <c:pt idx="804">
                  <c:v>1.3742916666666667</c:v>
                </c:pt>
                <c:pt idx="805">
                  <c:v>1.3747083333333332</c:v>
                </c:pt>
                <c:pt idx="806">
                  <c:v>1.3751250000000002</c:v>
                </c:pt>
                <c:pt idx="807">
                  <c:v>1.3755416666666667</c:v>
                </c:pt>
                <c:pt idx="808">
                  <c:v>1.3759652777777778</c:v>
                </c:pt>
                <c:pt idx="809">
                  <c:v>1.3763819444444445</c:v>
                </c:pt>
                <c:pt idx="810">
                  <c:v>1.376798611111111</c:v>
                </c:pt>
                <c:pt idx="811">
                  <c:v>1.3772152777777777</c:v>
                </c:pt>
                <c:pt idx="812">
                  <c:v>1.3776319444444445</c:v>
                </c:pt>
                <c:pt idx="813">
                  <c:v>1.3780486111111112</c:v>
                </c:pt>
                <c:pt idx="814">
                  <c:v>1.3784652777777777</c:v>
                </c:pt>
                <c:pt idx="815">
                  <c:v>1.3788888888888888</c:v>
                </c:pt>
                <c:pt idx="816">
                  <c:v>1.3793055555555556</c:v>
                </c:pt>
                <c:pt idx="817">
                  <c:v>1.3797222222222223</c:v>
                </c:pt>
                <c:pt idx="818">
                  <c:v>1.380138888888889</c:v>
                </c:pt>
                <c:pt idx="819">
                  <c:v>1.3805555555555555</c:v>
                </c:pt>
                <c:pt idx="820">
                  <c:v>1.3809722222222223</c:v>
                </c:pt>
                <c:pt idx="821">
                  <c:v>1.3814444444444445</c:v>
                </c:pt>
                <c:pt idx="822">
                  <c:v>1.3819097222222223</c:v>
                </c:pt>
                <c:pt idx="823">
                  <c:v>1.3823749999999999</c:v>
                </c:pt>
                <c:pt idx="824">
                  <c:v>1.3828402777777777</c:v>
                </c:pt>
                <c:pt idx="825">
                  <c:v>1.3833124999999999</c:v>
                </c:pt>
                <c:pt idx="826">
                  <c:v>1.3837777777777778</c:v>
                </c:pt>
                <c:pt idx="827">
                  <c:v>1.3842430555555556</c:v>
                </c:pt>
                <c:pt idx="828">
                  <c:v>1.3847083333333334</c:v>
                </c:pt>
                <c:pt idx="829">
                  <c:v>1.3851805555555556</c:v>
                </c:pt>
                <c:pt idx="830">
                  <c:v>1.3856458333333332</c:v>
                </c:pt>
                <c:pt idx="831">
                  <c:v>1.3861111111111111</c:v>
                </c:pt>
                <c:pt idx="832">
                  <c:v>1.3865833333333333</c:v>
                </c:pt>
                <c:pt idx="833">
                  <c:v>1.3870486111111111</c:v>
                </c:pt>
                <c:pt idx="834">
                  <c:v>1.3875138888888889</c:v>
                </c:pt>
                <c:pt idx="835">
                  <c:v>1.3879791666666668</c:v>
                </c:pt>
                <c:pt idx="836">
                  <c:v>1.3884513888888887</c:v>
                </c:pt>
                <c:pt idx="837">
                  <c:v>1.3889166666666666</c:v>
                </c:pt>
                <c:pt idx="838">
                  <c:v>1.3893819444444444</c:v>
                </c:pt>
                <c:pt idx="839">
                  <c:v>1.3899027777777777</c:v>
                </c:pt>
                <c:pt idx="840">
                  <c:v>1.3904236111111112</c:v>
                </c:pt>
                <c:pt idx="841">
                  <c:v>1.3909374999999999</c:v>
                </c:pt>
                <c:pt idx="842">
                  <c:v>1.3914583333333335</c:v>
                </c:pt>
                <c:pt idx="843">
                  <c:v>1.3919791666666668</c:v>
                </c:pt>
                <c:pt idx="844">
                  <c:v>1.3925000000000001</c:v>
                </c:pt>
                <c:pt idx="845">
                  <c:v>1.393013888888889</c:v>
                </c:pt>
                <c:pt idx="846">
                  <c:v>1.3935347222222223</c:v>
                </c:pt>
                <c:pt idx="847">
                  <c:v>1.3940555555555556</c:v>
                </c:pt>
                <c:pt idx="848">
                  <c:v>1.3945763888888889</c:v>
                </c:pt>
                <c:pt idx="849">
                  <c:v>1.3950902777777778</c:v>
                </c:pt>
                <c:pt idx="850">
                  <c:v>1.3956111111111111</c:v>
                </c:pt>
                <c:pt idx="851">
                  <c:v>1.3961319444444444</c:v>
                </c:pt>
                <c:pt idx="852">
                  <c:v>1.3966527777777777</c:v>
                </c:pt>
                <c:pt idx="853">
                  <c:v>1.3971666666666667</c:v>
                </c:pt>
                <c:pt idx="854">
                  <c:v>1.3977430555555554</c:v>
                </c:pt>
                <c:pt idx="855">
                  <c:v>1.3983194444444444</c:v>
                </c:pt>
                <c:pt idx="856">
                  <c:v>1.3988888888888888</c:v>
                </c:pt>
                <c:pt idx="857">
                  <c:v>1.3994652777777778</c:v>
                </c:pt>
                <c:pt idx="858">
                  <c:v>1.4000416666666666</c:v>
                </c:pt>
                <c:pt idx="859">
                  <c:v>1.4006111111111113</c:v>
                </c:pt>
                <c:pt idx="860">
                  <c:v>1.4011875</c:v>
                </c:pt>
                <c:pt idx="861">
                  <c:v>1.4017638888888888</c:v>
                </c:pt>
                <c:pt idx="862">
                  <c:v>1.4023333333333332</c:v>
                </c:pt>
                <c:pt idx="863">
                  <c:v>1.4029097222222222</c:v>
                </c:pt>
                <c:pt idx="864">
                  <c:v>1.403486111111111</c:v>
                </c:pt>
                <c:pt idx="865">
                  <c:v>1.4040555555555554</c:v>
                </c:pt>
                <c:pt idx="866">
                  <c:v>1.4046319444444444</c:v>
                </c:pt>
                <c:pt idx="867">
                  <c:v>1.4052083333333334</c:v>
                </c:pt>
                <c:pt idx="868">
                  <c:v>1.4057777777777778</c:v>
                </c:pt>
                <c:pt idx="869">
                  <c:v>1.4064166666666666</c:v>
                </c:pt>
                <c:pt idx="870">
                  <c:v>1.4070625000000001</c:v>
                </c:pt>
                <c:pt idx="871">
                  <c:v>1.4077013888888887</c:v>
                </c:pt>
                <c:pt idx="872">
                  <c:v>1.4083402777777778</c:v>
                </c:pt>
                <c:pt idx="873">
                  <c:v>1.4089791666666667</c:v>
                </c:pt>
                <c:pt idx="874">
                  <c:v>1.4096180555555555</c:v>
                </c:pt>
                <c:pt idx="875">
                  <c:v>1.4102638888888888</c:v>
                </c:pt>
                <c:pt idx="876">
                  <c:v>1.4109027777777778</c:v>
                </c:pt>
                <c:pt idx="877">
                  <c:v>1.4115416666666667</c:v>
                </c:pt>
                <c:pt idx="878">
                  <c:v>1.4121805555555556</c:v>
                </c:pt>
                <c:pt idx="879">
                  <c:v>1.4128194444444444</c:v>
                </c:pt>
                <c:pt idx="880">
                  <c:v>1.4134583333333335</c:v>
                </c:pt>
                <c:pt idx="881">
                  <c:v>1.4141041666666667</c:v>
                </c:pt>
                <c:pt idx="882">
                  <c:v>1.4147430555555556</c:v>
                </c:pt>
                <c:pt idx="883">
                  <c:v>1.4153819444444444</c:v>
                </c:pt>
                <c:pt idx="884">
                  <c:v>1.4161041666666667</c:v>
                </c:pt>
                <c:pt idx="885">
                  <c:v>1.416826388888889</c:v>
                </c:pt>
                <c:pt idx="886">
                  <c:v>1.4175416666666667</c:v>
                </c:pt>
                <c:pt idx="887">
                  <c:v>1.4182638888888888</c:v>
                </c:pt>
                <c:pt idx="888">
                  <c:v>1.4189861111111111</c:v>
                </c:pt>
                <c:pt idx="889">
                  <c:v>1.4197083333333333</c:v>
                </c:pt>
                <c:pt idx="890">
                  <c:v>1.4204236111111113</c:v>
                </c:pt>
                <c:pt idx="891">
                  <c:v>1.4211458333333333</c:v>
                </c:pt>
                <c:pt idx="892">
                  <c:v>1.4218680555555556</c:v>
                </c:pt>
                <c:pt idx="893">
                  <c:v>1.4225902777777779</c:v>
                </c:pt>
                <c:pt idx="894">
                  <c:v>1.4233125000000002</c:v>
                </c:pt>
                <c:pt idx="895">
                  <c:v>1.4240277777777777</c:v>
                </c:pt>
                <c:pt idx="896">
                  <c:v>1.42475</c:v>
                </c:pt>
                <c:pt idx="897">
                  <c:v>1.425472222222222</c:v>
                </c:pt>
                <c:pt idx="898">
                  <c:v>1.4261944444444443</c:v>
                </c:pt>
                <c:pt idx="899">
                  <c:v>1.4269097222222222</c:v>
                </c:pt>
                <c:pt idx="900">
                  <c:v>1.4276319444444445</c:v>
                </c:pt>
                <c:pt idx="901">
                  <c:v>1.4282222222222221</c:v>
                </c:pt>
                <c:pt idx="902">
                  <c:v>1.4288124999999998</c:v>
                </c:pt>
                <c:pt idx="903">
                  <c:v>1.4294027777777778</c:v>
                </c:pt>
                <c:pt idx="904">
                  <c:v>1.4299930555555556</c:v>
                </c:pt>
                <c:pt idx="905">
                  <c:v>1.4305833333333333</c:v>
                </c:pt>
                <c:pt idx="906">
                  <c:v>1.4311736111111111</c:v>
                </c:pt>
                <c:pt idx="907">
                  <c:v>1.4318333333333335</c:v>
                </c:pt>
                <c:pt idx="908">
                  <c:v>1.4324930555555555</c:v>
                </c:pt>
                <c:pt idx="909">
                  <c:v>1.4331597222222223</c:v>
                </c:pt>
                <c:pt idx="910">
                  <c:v>1.4338194444444443</c:v>
                </c:pt>
                <c:pt idx="911">
                  <c:v>1.4344791666666667</c:v>
                </c:pt>
                <c:pt idx="912">
                  <c:v>1.4351388888888887</c:v>
                </c:pt>
                <c:pt idx="913">
                  <c:v>1.4358055555555556</c:v>
                </c:pt>
                <c:pt idx="914">
                  <c:v>1.436465277777778</c:v>
                </c:pt>
                <c:pt idx="915">
                  <c:v>1.437125</c:v>
                </c:pt>
                <c:pt idx="916">
                  <c:v>1.4377847222222222</c:v>
                </c:pt>
                <c:pt idx="917">
                  <c:v>1.4384513888888888</c:v>
                </c:pt>
                <c:pt idx="918">
                  <c:v>1.4391111111111112</c:v>
                </c:pt>
                <c:pt idx="919">
                  <c:v>1.4397708333333332</c:v>
                </c:pt>
                <c:pt idx="920">
                  <c:v>1.4404305555555554</c:v>
                </c:pt>
                <c:pt idx="921">
                  <c:v>1.4405416666666668</c:v>
                </c:pt>
                <c:pt idx="922">
                  <c:v>1.4406527777777778</c:v>
                </c:pt>
                <c:pt idx="923">
                  <c:v>1.4407638888888887</c:v>
                </c:pt>
                <c:pt idx="924">
                  <c:v>1.4408680555555555</c:v>
                </c:pt>
                <c:pt idx="925">
                  <c:v>1.4409791666666669</c:v>
                </c:pt>
                <c:pt idx="926">
                  <c:v>1.4412013888888888</c:v>
                </c:pt>
                <c:pt idx="927">
                  <c:v>1.4414166666666666</c:v>
                </c:pt>
                <c:pt idx="928">
                  <c:v>1.4416388888888889</c:v>
                </c:pt>
                <c:pt idx="929">
                  <c:v>1.4418541666666667</c:v>
                </c:pt>
                <c:pt idx="930">
                  <c:v>1.4423055555555555</c:v>
                </c:pt>
                <c:pt idx="931">
                  <c:v>1.4427638888888887</c:v>
                </c:pt>
                <c:pt idx="932">
                  <c:v>1.4432152777777778</c:v>
                </c:pt>
                <c:pt idx="933">
                  <c:v>1.443673611111111</c:v>
                </c:pt>
                <c:pt idx="934">
                  <c:v>1.4441249999999999</c:v>
                </c:pt>
                <c:pt idx="935">
                  <c:v>1.4447569444444444</c:v>
                </c:pt>
                <c:pt idx="936">
                  <c:v>1.4453888888888891</c:v>
                </c:pt>
                <c:pt idx="937">
                  <c:v>1.4460208333333333</c:v>
                </c:pt>
                <c:pt idx="938">
                  <c:v>1.4466527777777776</c:v>
                </c:pt>
                <c:pt idx="939">
                  <c:v>1.4472847222222223</c:v>
                </c:pt>
                <c:pt idx="940">
                  <c:v>1.4481805555555556</c:v>
                </c:pt>
                <c:pt idx="941">
                  <c:v>1.4490694444444443</c:v>
                </c:pt>
                <c:pt idx="942">
                  <c:v>1.4499652777777776</c:v>
                </c:pt>
                <c:pt idx="943">
                  <c:v>1.4508611111111109</c:v>
                </c:pt>
                <c:pt idx="944">
                  <c:v>1.4517569444444445</c:v>
                </c:pt>
                <c:pt idx="945">
                  <c:v>1.4526458333333332</c:v>
                </c:pt>
                <c:pt idx="946">
                  <c:v>1.4539375000000001</c:v>
                </c:pt>
                <c:pt idx="947">
                  <c:v>1.4552291666666668</c:v>
                </c:pt>
                <c:pt idx="948">
                  <c:v>1.4565208333333333</c:v>
                </c:pt>
                <c:pt idx="949">
                  <c:v>1.4578125</c:v>
                </c:pt>
                <c:pt idx="950">
                  <c:v>1.4591041666666666</c:v>
                </c:pt>
                <c:pt idx="951">
                  <c:v>1.4603958333333331</c:v>
                </c:pt>
                <c:pt idx="952">
                  <c:v>1.4616875</c:v>
                </c:pt>
                <c:pt idx="953">
                  <c:v>1.4629791666666667</c:v>
                </c:pt>
                <c:pt idx="954">
                  <c:v>1.4642638888888888</c:v>
                </c:pt>
                <c:pt idx="955">
                  <c:v>1.4655555555555557</c:v>
                </c:pt>
                <c:pt idx="956">
                  <c:v>1.4668472222222224</c:v>
                </c:pt>
                <c:pt idx="957">
                  <c:v>1.4681388888888889</c:v>
                </c:pt>
                <c:pt idx="958">
                  <c:v>1.4694305555555556</c:v>
                </c:pt>
                <c:pt idx="959">
                  <c:v>1.4707222222222223</c:v>
                </c:pt>
                <c:pt idx="960">
                  <c:v>1.4720138888888887</c:v>
                </c:pt>
                <c:pt idx="961">
                  <c:v>1.4734861111111113</c:v>
                </c:pt>
                <c:pt idx="962">
                  <c:v>1.4749652777777778</c:v>
                </c:pt>
                <c:pt idx="963">
                  <c:v>1.4764444444444444</c:v>
                </c:pt>
                <c:pt idx="964">
                  <c:v>1.4779166666666665</c:v>
                </c:pt>
                <c:pt idx="965">
                  <c:v>1.4793958333333332</c:v>
                </c:pt>
                <c:pt idx="966">
                  <c:v>1.4808749999999999</c:v>
                </c:pt>
                <c:pt idx="967">
                  <c:v>1.4825347222222223</c:v>
                </c:pt>
                <c:pt idx="968">
                  <c:v>1.4841944444444444</c:v>
                </c:pt>
                <c:pt idx="969">
                  <c:v>1.4858541666666667</c:v>
                </c:pt>
                <c:pt idx="970">
                  <c:v>1.4875208333333334</c:v>
                </c:pt>
                <c:pt idx="971">
                  <c:v>1.4891805555555555</c:v>
                </c:pt>
                <c:pt idx="972">
                  <c:v>1.4908402777777778</c:v>
                </c:pt>
                <c:pt idx="973">
                  <c:v>1.4927222222222223</c:v>
                </c:pt>
                <c:pt idx="974">
                  <c:v>1.4946111111111109</c:v>
                </c:pt>
                <c:pt idx="975">
                  <c:v>1.4964930555555553</c:v>
                </c:pt>
                <c:pt idx="976">
                  <c:v>1.4983749999999998</c:v>
                </c:pt>
                <c:pt idx="977">
                  <c:v>1.5002569444444445</c:v>
                </c:pt>
                <c:pt idx="978">
                  <c:v>1.5021388888888889</c:v>
                </c:pt>
                <c:pt idx="979">
                  <c:v>1.5043124999999999</c:v>
                </c:pt>
                <c:pt idx="980">
                  <c:v>1.5064861111111112</c:v>
                </c:pt>
                <c:pt idx="981">
                  <c:v>1.5086527777777778</c:v>
                </c:pt>
                <c:pt idx="982">
                  <c:v>1.5108263888888891</c:v>
                </c:pt>
                <c:pt idx="983">
                  <c:v>1.5129999999999999</c:v>
                </c:pt>
                <c:pt idx="984">
                  <c:v>1.5151736111111112</c:v>
                </c:pt>
                <c:pt idx="985">
                  <c:v>1.5177291666666668</c:v>
                </c:pt>
                <c:pt idx="986">
                  <c:v>1.5202777777777776</c:v>
                </c:pt>
                <c:pt idx="987">
                  <c:v>1.5228333333333335</c:v>
                </c:pt>
                <c:pt idx="988">
                  <c:v>1.5253888888888889</c:v>
                </c:pt>
                <c:pt idx="989">
                  <c:v>1.5279374999999999</c:v>
                </c:pt>
                <c:pt idx="990">
                  <c:v>1.5299583333333333</c:v>
                </c:pt>
                <c:pt idx="991">
                  <c:v>1.5316041666666669</c:v>
                </c:pt>
                <c:pt idx="992">
                  <c:v>1.53325</c:v>
                </c:pt>
                <c:pt idx="993">
                  <c:v>1.5346180555555555</c:v>
                </c:pt>
                <c:pt idx="994">
                  <c:v>1.5359861111111113</c:v>
                </c:pt>
                <c:pt idx="995">
                  <c:v>1.5373541666666666</c:v>
                </c:pt>
                <c:pt idx="996">
                  <c:v>1.5387152777777777</c:v>
                </c:pt>
                <c:pt idx="997">
                  <c:v>1.5400833333333332</c:v>
                </c:pt>
                <c:pt idx="998">
                  <c:v>1.541451388888889</c:v>
                </c:pt>
                <c:pt idx="999">
                  <c:v>1.5428194444444443</c:v>
                </c:pt>
                <c:pt idx="1000">
                  <c:v>1.5441875</c:v>
                </c:pt>
                <c:pt idx="1001">
                  <c:v>1.5455486111111112</c:v>
                </c:pt>
                <c:pt idx="1002">
                  <c:v>1.5469166666666667</c:v>
                </c:pt>
                <c:pt idx="1003">
                  <c:v>1.5485833333333334</c:v>
                </c:pt>
                <c:pt idx="1004">
                  <c:v>1.5502569444444443</c:v>
                </c:pt>
                <c:pt idx="1005">
                  <c:v>1.551923611111111</c:v>
                </c:pt>
                <c:pt idx="1006">
                  <c:v>1.5535902777777779</c:v>
                </c:pt>
                <c:pt idx="1007">
                  <c:v>1.5554861111111111</c:v>
                </c:pt>
                <c:pt idx="1008">
                  <c:v>1.5573888888888887</c:v>
                </c:pt>
                <c:pt idx="1009">
                  <c:v>1.5592847222222221</c:v>
                </c:pt>
                <c:pt idx="1010">
                  <c:v>1.5611805555555556</c:v>
                </c:pt>
                <c:pt idx="1011">
                  <c:v>1.5632708333333334</c:v>
                </c:pt>
                <c:pt idx="1012">
                  <c:v>1.565361111111111</c:v>
                </c:pt>
                <c:pt idx="1013">
                  <c:v>1.5674444444444444</c:v>
                </c:pt>
                <c:pt idx="1014">
                  <c:v>1.5695347222222222</c:v>
                </c:pt>
                <c:pt idx="1015">
                  <c:v>1.5716249999999998</c:v>
                </c:pt>
                <c:pt idx="1016">
                  <c:v>1.5751111111111109</c:v>
                </c:pt>
                <c:pt idx="1017">
                  <c:v>1.5785972222222222</c:v>
                </c:pt>
                <c:pt idx="1018">
                  <c:v>1.5820833333333333</c:v>
                </c:pt>
                <c:pt idx="1019">
                  <c:v>1.585576388888889</c:v>
                </c:pt>
                <c:pt idx="1020">
                  <c:v>1.5890625</c:v>
                </c:pt>
                <c:pt idx="1021">
                  <c:v>1.593576388888889</c:v>
                </c:pt>
                <c:pt idx="1022">
                  <c:v>1.5980833333333331</c:v>
                </c:pt>
                <c:pt idx="1023">
                  <c:v>1.602597222222222</c:v>
                </c:pt>
                <c:pt idx="1024">
                  <c:v>1.6071111111111109</c:v>
                </c:pt>
                <c:pt idx="1025">
                  <c:v>1.6116249999999999</c:v>
                </c:pt>
                <c:pt idx="1026">
                  <c:v>1.6161319444444444</c:v>
                </c:pt>
                <c:pt idx="1027">
                  <c:v>1.6231111111111112</c:v>
                </c:pt>
                <c:pt idx="1028">
                  <c:v>1.6300833333333336</c:v>
                </c:pt>
                <c:pt idx="1029">
                  <c:v>1.6370555555555557</c:v>
                </c:pt>
                <c:pt idx="1030">
                  <c:v>1.6440277777777779</c:v>
                </c:pt>
                <c:pt idx="1031">
                  <c:v>1.651</c:v>
                </c:pt>
                <c:pt idx="1032">
                  <c:v>1.6579722222222222</c:v>
                </c:pt>
                <c:pt idx="1033">
                  <c:v>1.6660277777777777</c:v>
                </c:pt>
                <c:pt idx="1034">
                  <c:v>1.6740833333333331</c:v>
                </c:pt>
                <c:pt idx="1035">
                  <c:v>1.6821388888888891</c:v>
                </c:pt>
                <c:pt idx="1036">
                  <c:v>1.6901875</c:v>
                </c:pt>
                <c:pt idx="1037">
                  <c:v>1.6982430555555554</c:v>
                </c:pt>
                <c:pt idx="1038">
                  <c:v>1.7062986111111111</c:v>
                </c:pt>
                <c:pt idx="1039">
                  <c:v>1.7143541666666666</c:v>
                </c:pt>
                <c:pt idx="1040">
                  <c:v>1.7224097222222221</c:v>
                </c:pt>
                <c:pt idx="1041">
                  <c:v>1.7304652777777778</c:v>
                </c:pt>
                <c:pt idx="1042">
                  <c:v>1.7316458333333336</c:v>
                </c:pt>
                <c:pt idx="1043">
                  <c:v>1.7328333333333334</c:v>
                </c:pt>
                <c:pt idx="1044">
                  <c:v>1.734013888888889</c:v>
                </c:pt>
                <c:pt idx="1045">
                  <c:v>1.7352013888888889</c:v>
                </c:pt>
                <c:pt idx="1046">
                  <c:v>1.7363819444444444</c:v>
                </c:pt>
                <c:pt idx="1047">
                  <c:v>1.7375625000000001</c:v>
                </c:pt>
                <c:pt idx="1048">
                  <c:v>1.7389999999999999</c:v>
                </c:pt>
                <c:pt idx="1049">
                  <c:v>1.7404305555555555</c:v>
                </c:pt>
                <c:pt idx="1050">
                  <c:v>1.7418611111111113</c:v>
                </c:pt>
                <c:pt idx="1051">
                  <c:v>1.7432986111111111</c:v>
                </c:pt>
                <c:pt idx="1052">
                  <c:v>1.7447291666666667</c:v>
                </c:pt>
                <c:pt idx="1053">
                  <c:v>1.7479652777777779</c:v>
                </c:pt>
                <c:pt idx="1054">
                  <c:v>1.7512013888888889</c:v>
                </c:pt>
                <c:pt idx="1055">
                  <c:v>1.7544374999999999</c:v>
                </c:pt>
                <c:pt idx="1056">
                  <c:v>1.7576666666666667</c:v>
                </c:pt>
                <c:pt idx="1057">
                  <c:v>1.7609027777777777</c:v>
                </c:pt>
                <c:pt idx="1058">
                  <c:v>1.7668472222222225</c:v>
                </c:pt>
                <c:pt idx="1059">
                  <c:v>1.7727986111111111</c:v>
                </c:pt>
                <c:pt idx="1060">
                  <c:v>1.7787430555555555</c:v>
                </c:pt>
                <c:pt idx="1061">
                  <c:v>1.7846875</c:v>
                </c:pt>
                <c:pt idx="1062">
                  <c:v>1.7906319444444445</c:v>
                </c:pt>
                <c:pt idx="1063">
                  <c:v>1.7965833333333332</c:v>
                </c:pt>
                <c:pt idx="1064">
                  <c:v>1.804986111111111</c:v>
                </c:pt>
                <c:pt idx="1065">
                  <c:v>1.8133958333333333</c:v>
                </c:pt>
                <c:pt idx="1066">
                  <c:v>1.8218055555555557</c:v>
                </c:pt>
                <c:pt idx="1067">
                  <c:v>1.8302083333333334</c:v>
                </c:pt>
                <c:pt idx="1068">
                  <c:v>1.8386180555555556</c:v>
                </c:pt>
                <c:pt idx="1069">
                  <c:v>1.8470208333333333</c:v>
                </c:pt>
                <c:pt idx="1070">
                  <c:v>1.8554305555555557</c:v>
                </c:pt>
                <c:pt idx="1071">
                  <c:v>1.8638333333333335</c:v>
                </c:pt>
                <c:pt idx="1072">
                  <c:v>1.8722430555555556</c:v>
                </c:pt>
                <c:pt idx="1073">
                  <c:v>1.8806527777777777</c:v>
                </c:pt>
                <c:pt idx="1074">
                  <c:v>1.8890555555555555</c:v>
                </c:pt>
                <c:pt idx="1075">
                  <c:v>1.8974652777777776</c:v>
                </c:pt>
                <c:pt idx="1076">
                  <c:v>1.9058680555555554</c:v>
                </c:pt>
                <c:pt idx="1077">
                  <c:v>1.9142777777777777</c:v>
                </c:pt>
                <c:pt idx="1078">
                  <c:v>1.9226875000000001</c:v>
                </c:pt>
                <c:pt idx="1079">
                  <c:v>1.9310902777777779</c:v>
                </c:pt>
                <c:pt idx="1080">
                  <c:v>1.9395</c:v>
                </c:pt>
                <c:pt idx="1081">
                  <c:v>1.9479027777777778</c:v>
                </c:pt>
                <c:pt idx="1082">
                  <c:v>1.9563125000000001</c:v>
                </c:pt>
                <c:pt idx="1083">
                  <c:v>1.964722222222222</c:v>
                </c:pt>
                <c:pt idx="1084">
                  <c:v>1.973125</c:v>
                </c:pt>
                <c:pt idx="1085">
                  <c:v>1.9815347222222222</c:v>
                </c:pt>
                <c:pt idx="1086">
                  <c:v>1.9899375000000001</c:v>
                </c:pt>
                <c:pt idx="1087">
                  <c:v>1.9983472222222221</c:v>
                </c:pt>
                <c:pt idx="1088">
                  <c:v>2.0067499999999998</c:v>
                </c:pt>
                <c:pt idx="1089">
                  <c:v>2.0151597222222222</c:v>
                </c:pt>
                <c:pt idx="1090">
                  <c:v>2.0235694444444445</c:v>
                </c:pt>
                <c:pt idx="1091">
                  <c:v>2.0319722222222221</c:v>
                </c:pt>
                <c:pt idx="1092">
                  <c:v>2.0403819444444444</c:v>
                </c:pt>
                <c:pt idx="1093">
                  <c:v>2.0487847222222224</c:v>
                </c:pt>
                <c:pt idx="1094">
                  <c:v>2.0571944444444443</c:v>
                </c:pt>
                <c:pt idx="1095">
                  <c:v>2.0656041666666667</c:v>
                </c:pt>
                <c:pt idx="1096">
                  <c:v>2.0740069444444447</c:v>
                </c:pt>
                <c:pt idx="1097">
                  <c:v>2.0824166666666666</c:v>
                </c:pt>
                <c:pt idx="1098">
                  <c:v>2.0908194444444446</c:v>
                </c:pt>
                <c:pt idx="1099">
                  <c:v>2.0992291666666665</c:v>
                </c:pt>
                <c:pt idx="1100">
                  <c:v>2.1076388888888888</c:v>
                </c:pt>
                <c:pt idx="1101">
                  <c:v>2.1160416666666668</c:v>
                </c:pt>
                <c:pt idx="1102">
                  <c:v>2.1244513888888887</c:v>
                </c:pt>
                <c:pt idx="1103">
                  <c:v>2.1328541666666667</c:v>
                </c:pt>
                <c:pt idx="1104">
                  <c:v>2.1412638888888891</c:v>
                </c:pt>
                <c:pt idx="1105">
                  <c:v>2.1496666666666666</c:v>
                </c:pt>
                <c:pt idx="1106">
                  <c:v>2.158076388888889</c:v>
                </c:pt>
                <c:pt idx="1107">
                  <c:v>2.1664861111111109</c:v>
                </c:pt>
                <c:pt idx="1108">
                  <c:v>2.1748888888888889</c:v>
                </c:pt>
                <c:pt idx="1109">
                  <c:v>2.1832986111111108</c:v>
                </c:pt>
                <c:pt idx="1110">
                  <c:v>2.1917013888888892</c:v>
                </c:pt>
                <c:pt idx="1111">
                  <c:v>2.2001111111111111</c:v>
                </c:pt>
                <c:pt idx="1112">
                  <c:v>2.2085208333333335</c:v>
                </c:pt>
                <c:pt idx="1113">
                  <c:v>2.216923611111111</c:v>
                </c:pt>
                <c:pt idx="1114">
                  <c:v>2.2253333333333334</c:v>
                </c:pt>
                <c:pt idx="1115">
                  <c:v>2.2337361111111109</c:v>
                </c:pt>
                <c:pt idx="1116">
                  <c:v>2.2421458333333333</c:v>
                </c:pt>
                <c:pt idx="1117">
                  <c:v>2.2505555555555556</c:v>
                </c:pt>
                <c:pt idx="1118">
                  <c:v>2.2589583333333332</c:v>
                </c:pt>
                <c:pt idx="1119">
                  <c:v>2.2673680555555555</c:v>
                </c:pt>
                <c:pt idx="1120">
                  <c:v>2.2757708333333335</c:v>
                </c:pt>
                <c:pt idx="1121">
                  <c:v>2.2841805555555554</c:v>
                </c:pt>
                <c:pt idx="1122">
                  <c:v>2.2925833333333334</c:v>
                </c:pt>
                <c:pt idx="1123">
                  <c:v>2.3009930555555553</c:v>
                </c:pt>
                <c:pt idx="1124">
                  <c:v>2.3094027777777777</c:v>
                </c:pt>
                <c:pt idx="1125">
                  <c:v>2.3178055555555557</c:v>
                </c:pt>
                <c:pt idx="1126">
                  <c:v>2.3262152777777776</c:v>
                </c:pt>
                <c:pt idx="1127">
                  <c:v>2.3346180555555556</c:v>
                </c:pt>
                <c:pt idx="1128">
                  <c:v>2.3430277777777779</c:v>
                </c:pt>
                <c:pt idx="1129">
                  <c:v>2.3514375000000003</c:v>
                </c:pt>
                <c:pt idx="1130">
                  <c:v>2.3598402777777778</c:v>
                </c:pt>
                <c:pt idx="1131">
                  <c:v>2.3682500000000002</c:v>
                </c:pt>
                <c:pt idx="1132">
                  <c:v>2.3766527777777777</c:v>
                </c:pt>
                <c:pt idx="1133">
                  <c:v>2.3850624999999996</c:v>
                </c:pt>
                <c:pt idx="1134">
                  <c:v>2.393472222222222</c:v>
                </c:pt>
                <c:pt idx="1135">
                  <c:v>2.401875</c:v>
                </c:pt>
                <c:pt idx="1136">
                  <c:v>2.4102847222222223</c:v>
                </c:pt>
                <c:pt idx="1137">
                  <c:v>2.4186874999999999</c:v>
                </c:pt>
                <c:pt idx="1138">
                  <c:v>2.4270972222222222</c:v>
                </c:pt>
                <c:pt idx="1139">
                  <c:v>2.4354999999999998</c:v>
                </c:pt>
                <c:pt idx="1140">
                  <c:v>2.4439097222222221</c:v>
                </c:pt>
                <c:pt idx="1141">
                  <c:v>2.4523194444444445</c:v>
                </c:pt>
                <c:pt idx="1142">
                  <c:v>2.4607222222222225</c:v>
                </c:pt>
                <c:pt idx="1143">
                  <c:v>2.4691319444444444</c:v>
                </c:pt>
                <c:pt idx="1144">
                  <c:v>2.4775347222222224</c:v>
                </c:pt>
                <c:pt idx="1145">
                  <c:v>2.4859444444444447</c:v>
                </c:pt>
                <c:pt idx="1146">
                  <c:v>2.4943541666666667</c:v>
                </c:pt>
                <c:pt idx="1147">
                  <c:v>2.5027569444444442</c:v>
                </c:pt>
                <c:pt idx="1148">
                  <c:v>2.5111666666666665</c:v>
                </c:pt>
                <c:pt idx="1149">
                  <c:v>2.5195694444444445</c:v>
                </c:pt>
                <c:pt idx="1150">
                  <c:v>2.5279791666666664</c:v>
                </c:pt>
                <c:pt idx="1151">
                  <c:v>2.5363888888888888</c:v>
                </c:pt>
                <c:pt idx="1152">
                  <c:v>2.5447916666666668</c:v>
                </c:pt>
                <c:pt idx="1153">
                  <c:v>2.5532013888888891</c:v>
                </c:pt>
                <c:pt idx="1154">
                  <c:v>2.5616041666666667</c:v>
                </c:pt>
                <c:pt idx="1155">
                  <c:v>2.570013888888889</c:v>
                </c:pt>
                <c:pt idx="1156">
                  <c:v>2.5784166666666666</c:v>
                </c:pt>
                <c:pt idx="1157">
                  <c:v>2.5868263888888889</c:v>
                </c:pt>
                <c:pt idx="1158">
                  <c:v>2.5952361111111109</c:v>
                </c:pt>
                <c:pt idx="1159">
                  <c:v>2.6036388888888888</c:v>
                </c:pt>
                <c:pt idx="1160">
                  <c:v>2.6120486111111112</c:v>
                </c:pt>
                <c:pt idx="1161">
                  <c:v>2.6204513888888887</c:v>
                </c:pt>
                <c:pt idx="1162">
                  <c:v>2.6288611111111111</c:v>
                </c:pt>
                <c:pt idx="1163">
                  <c:v>2.6372708333333335</c:v>
                </c:pt>
                <c:pt idx="1164">
                  <c:v>2.645673611111111</c:v>
                </c:pt>
                <c:pt idx="1165">
                  <c:v>2.6540833333333333</c:v>
                </c:pt>
                <c:pt idx="1166">
                  <c:v>2.6624861111111113</c:v>
                </c:pt>
                <c:pt idx="1167">
                  <c:v>2.6708958333333332</c:v>
                </c:pt>
                <c:pt idx="1168">
                  <c:v>2.6793055555555556</c:v>
                </c:pt>
                <c:pt idx="1169">
                  <c:v>2.6877083333333336</c:v>
                </c:pt>
                <c:pt idx="1170">
                  <c:v>2.6961180555555555</c:v>
                </c:pt>
                <c:pt idx="1171">
                  <c:v>2.7045208333333335</c:v>
                </c:pt>
                <c:pt idx="1172">
                  <c:v>2.7129305555555554</c:v>
                </c:pt>
                <c:pt idx="1173">
                  <c:v>2.7213333333333334</c:v>
                </c:pt>
                <c:pt idx="1174">
                  <c:v>2.7297430555555553</c:v>
                </c:pt>
                <c:pt idx="1175">
                  <c:v>2.7381527777777777</c:v>
                </c:pt>
                <c:pt idx="1176">
                  <c:v>2.7465555555555556</c:v>
                </c:pt>
                <c:pt idx="1177">
                  <c:v>2.754965277777778</c:v>
                </c:pt>
                <c:pt idx="1178">
                  <c:v>2.7633680555555555</c:v>
                </c:pt>
                <c:pt idx="1179">
                  <c:v>2.7717777777777779</c:v>
                </c:pt>
                <c:pt idx="1180">
                  <c:v>2.7801874999999998</c:v>
                </c:pt>
                <c:pt idx="1181">
                  <c:v>2.7885902777777778</c:v>
                </c:pt>
                <c:pt idx="1182">
                  <c:v>2.7969999999999997</c:v>
                </c:pt>
                <c:pt idx="1183">
                  <c:v>2.8054027777777781</c:v>
                </c:pt>
                <c:pt idx="1184">
                  <c:v>2.8138125</c:v>
                </c:pt>
                <c:pt idx="1185">
                  <c:v>2.8222222222222224</c:v>
                </c:pt>
                <c:pt idx="1186">
                  <c:v>2.8306249999999999</c:v>
                </c:pt>
                <c:pt idx="1187">
                  <c:v>2.8390347222222223</c:v>
                </c:pt>
                <c:pt idx="1188">
                  <c:v>2.8474375000000003</c:v>
                </c:pt>
                <c:pt idx="1189">
                  <c:v>2.8558472222222222</c:v>
                </c:pt>
                <c:pt idx="1190">
                  <c:v>2.8642569444444441</c:v>
                </c:pt>
                <c:pt idx="1191">
                  <c:v>2.8726597222222221</c:v>
                </c:pt>
                <c:pt idx="1192">
                  <c:v>2.8810694444444445</c:v>
                </c:pt>
                <c:pt idx="1193">
                  <c:v>2.8894722222222224</c:v>
                </c:pt>
                <c:pt idx="1194">
                  <c:v>2.8978819444444444</c:v>
                </c:pt>
                <c:pt idx="1195">
                  <c:v>2.9062847222222223</c:v>
                </c:pt>
                <c:pt idx="1196">
                  <c:v>2.9146944444444443</c:v>
                </c:pt>
                <c:pt idx="1197">
                  <c:v>2.9231041666666671</c:v>
                </c:pt>
                <c:pt idx="1198">
                  <c:v>2.9315069444444442</c:v>
                </c:pt>
                <c:pt idx="1199">
                  <c:v>2.9399166666666665</c:v>
                </c:pt>
                <c:pt idx="1200">
                  <c:v>2.9483194444444445</c:v>
                </c:pt>
                <c:pt idx="1201">
                  <c:v>2.9567291666666664</c:v>
                </c:pt>
                <c:pt idx="1202">
                  <c:v>2.9651388888888892</c:v>
                </c:pt>
                <c:pt idx="1203">
                  <c:v>2.9735416666666663</c:v>
                </c:pt>
                <c:pt idx="1204">
                  <c:v>2.9819513888888891</c:v>
                </c:pt>
                <c:pt idx="1205">
                  <c:v>2.9903541666666666</c:v>
                </c:pt>
                <c:pt idx="1206">
                  <c:v>2.998763888888889</c:v>
                </c:pt>
                <c:pt idx="1207">
                  <c:v>3.0071736111111109</c:v>
                </c:pt>
                <c:pt idx="1208">
                  <c:v>3.0155763888888889</c:v>
                </c:pt>
                <c:pt idx="1209">
                  <c:v>3.0239861111111113</c:v>
                </c:pt>
                <c:pt idx="1210">
                  <c:v>3.0323888888888892</c:v>
                </c:pt>
                <c:pt idx="1211">
                  <c:v>3.0407986111111112</c:v>
                </c:pt>
                <c:pt idx="1212">
                  <c:v>3.0492013888888891</c:v>
                </c:pt>
                <c:pt idx="1213">
                  <c:v>3.0576111111111111</c:v>
                </c:pt>
                <c:pt idx="1214">
                  <c:v>3.066020833333333</c:v>
                </c:pt>
                <c:pt idx="1215">
                  <c:v>3.074423611111111</c:v>
                </c:pt>
                <c:pt idx="1216">
                  <c:v>3.0828333333333333</c:v>
                </c:pt>
                <c:pt idx="1217">
                  <c:v>3.0912361111111113</c:v>
                </c:pt>
                <c:pt idx="1218">
                  <c:v>3.0996458333333332</c:v>
                </c:pt>
                <c:pt idx="1219">
                  <c:v>3.108055555555556</c:v>
                </c:pt>
                <c:pt idx="1220">
                  <c:v>3.1164583333333331</c:v>
                </c:pt>
                <c:pt idx="1221">
                  <c:v>3.1248680555555559</c:v>
                </c:pt>
                <c:pt idx="1222">
                  <c:v>3.1332708333333334</c:v>
                </c:pt>
                <c:pt idx="1223">
                  <c:v>3.1416805555555558</c:v>
                </c:pt>
                <c:pt idx="1224">
                  <c:v>3.1500902777777777</c:v>
                </c:pt>
                <c:pt idx="1225">
                  <c:v>3.1584930555555553</c:v>
                </c:pt>
                <c:pt idx="1226">
                  <c:v>3.1669027777777781</c:v>
                </c:pt>
                <c:pt idx="1227">
                  <c:v>3.1753055555555552</c:v>
                </c:pt>
                <c:pt idx="1228">
                  <c:v>3.183715277777778</c:v>
                </c:pt>
                <c:pt idx="1229">
                  <c:v>3.1921180555555555</c:v>
                </c:pt>
                <c:pt idx="1230">
                  <c:v>3.2005277777777779</c:v>
                </c:pt>
                <c:pt idx="1231">
                  <c:v>3.2089374999999998</c:v>
                </c:pt>
                <c:pt idx="1232">
                  <c:v>3.2173402777777778</c:v>
                </c:pt>
                <c:pt idx="1233">
                  <c:v>3.2257500000000001</c:v>
                </c:pt>
                <c:pt idx="1234">
                  <c:v>3.2341527777777781</c:v>
                </c:pt>
                <c:pt idx="1235">
                  <c:v>3.2425625</c:v>
                </c:pt>
                <c:pt idx="1236">
                  <c:v>3.2509722222222219</c:v>
                </c:pt>
                <c:pt idx="1237">
                  <c:v>3.2593749999999999</c:v>
                </c:pt>
                <c:pt idx="1238">
                  <c:v>3.2677847222222218</c:v>
                </c:pt>
                <c:pt idx="1239">
                  <c:v>3.2761874999999998</c:v>
                </c:pt>
                <c:pt idx="1240">
                  <c:v>3.2845972222222222</c:v>
                </c:pt>
                <c:pt idx="1241">
                  <c:v>3.2930069444444445</c:v>
                </c:pt>
                <c:pt idx="1242">
                  <c:v>3.3014097222222221</c:v>
                </c:pt>
                <c:pt idx="1243">
                  <c:v>3.3098194444444449</c:v>
                </c:pt>
                <c:pt idx="1244">
                  <c:v>3.318222222222222</c:v>
                </c:pt>
                <c:pt idx="1245">
                  <c:v>3.3266319444444448</c:v>
                </c:pt>
                <c:pt idx="1246">
                  <c:v>3.3350347222222223</c:v>
                </c:pt>
                <c:pt idx="1247">
                  <c:v>3.3434444444444447</c:v>
                </c:pt>
                <c:pt idx="1248">
                  <c:v>3.3518541666666666</c:v>
                </c:pt>
                <c:pt idx="1249">
                  <c:v>3.3602569444444446</c:v>
                </c:pt>
                <c:pt idx="1250">
                  <c:v>3.3686666666666669</c:v>
                </c:pt>
                <c:pt idx="1251">
                  <c:v>3.377069444444444</c:v>
                </c:pt>
                <c:pt idx="1252">
                  <c:v>3.3854791666666668</c:v>
                </c:pt>
                <c:pt idx="1253">
                  <c:v>3.3938888888888887</c:v>
                </c:pt>
                <c:pt idx="1254">
                  <c:v>3.4022916666666667</c:v>
                </c:pt>
                <c:pt idx="1255">
                  <c:v>3.4107013888888886</c:v>
                </c:pt>
                <c:pt idx="1256">
                  <c:v>3.4191041666666666</c:v>
                </c:pt>
                <c:pt idx="1257">
                  <c:v>3.427513888888889</c:v>
                </c:pt>
                <c:pt idx="1258">
                  <c:v>3.4359236111111109</c:v>
                </c:pt>
                <c:pt idx="1259">
                  <c:v>3.4443263888888889</c:v>
                </c:pt>
                <c:pt idx="1260">
                  <c:v>3.4527361111111108</c:v>
                </c:pt>
                <c:pt idx="1261">
                  <c:v>3.4611388888888888</c:v>
                </c:pt>
                <c:pt idx="1262">
                  <c:v>3.4695486111111107</c:v>
                </c:pt>
                <c:pt idx="1263">
                  <c:v>3.4779513888888891</c:v>
                </c:pt>
                <c:pt idx="1264">
                  <c:v>3.486361111111111</c:v>
                </c:pt>
                <c:pt idx="1265">
                  <c:v>3.4947708333333334</c:v>
                </c:pt>
                <c:pt idx="1266">
                  <c:v>3.5031736111111109</c:v>
                </c:pt>
                <c:pt idx="1267">
                  <c:v>3.5115833333333337</c:v>
                </c:pt>
                <c:pt idx="1268">
                  <c:v>3.5199861111111108</c:v>
                </c:pt>
                <c:pt idx="1269">
                  <c:v>3.5283958333333336</c:v>
                </c:pt>
                <c:pt idx="1270">
                  <c:v>3.5368055555555555</c:v>
                </c:pt>
                <c:pt idx="1271">
                  <c:v>3.5452083333333335</c:v>
                </c:pt>
                <c:pt idx="1272">
                  <c:v>3.5536180555555554</c:v>
                </c:pt>
                <c:pt idx="1273">
                  <c:v>3.5620208333333334</c:v>
                </c:pt>
                <c:pt idx="1274">
                  <c:v>3.5704305555555558</c:v>
                </c:pt>
                <c:pt idx="1275">
                  <c:v>3.5788402777777777</c:v>
                </c:pt>
                <c:pt idx="1276">
                  <c:v>3.5872430555555557</c:v>
                </c:pt>
                <c:pt idx="1277">
                  <c:v>3.5956527777777776</c:v>
                </c:pt>
                <c:pt idx="1278">
                  <c:v>3.6040555555555556</c:v>
                </c:pt>
                <c:pt idx="1279">
                  <c:v>3.6124652777777775</c:v>
                </c:pt>
                <c:pt idx="1280">
                  <c:v>3.6208680555555555</c:v>
                </c:pt>
                <c:pt idx="1281">
                  <c:v>3.6292777777777778</c:v>
                </c:pt>
                <c:pt idx="1282">
                  <c:v>3.6376875000000002</c:v>
                </c:pt>
                <c:pt idx="1283">
                  <c:v>3.6460902777777777</c:v>
                </c:pt>
                <c:pt idx="1284">
                  <c:v>3.6544999999999996</c:v>
                </c:pt>
                <c:pt idx="1285">
                  <c:v>3.6629027777777776</c:v>
                </c:pt>
                <c:pt idx="1286">
                  <c:v>3.6713124999999995</c:v>
                </c:pt>
                <c:pt idx="1287">
                  <c:v>3.6797222222222223</c:v>
                </c:pt>
                <c:pt idx="1288">
                  <c:v>3.6881249999999999</c:v>
                </c:pt>
                <c:pt idx="1289">
                  <c:v>3.6965347222222222</c:v>
                </c:pt>
                <c:pt idx="1290">
                  <c:v>3.7049374999999998</c:v>
                </c:pt>
                <c:pt idx="1291">
                  <c:v>3.7118055555555554</c:v>
                </c:pt>
                <c:pt idx="1292">
                  <c:v>3.7186736111111114</c:v>
                </c:pt>
                <c:pt idx="1293">
                  <c:v>3.7255347222222226</c:v>
                </c:pt>
                <c:pt idx="1294">
                  <c:v>3.7324027777777777</c:v>
                </c:pt>
                <c:pt idx="1295">
                  <c:v>3.7392638888888889</c:v>
                </c:pt>
                <c:pt idx="1296">
                  <c:v>3.7461319444444445</c:v>
                </c:pt>
                <c:pt idx="1297">
                  <c:v>3.7529930555555557</c:v>
                </c:pt>
                <c:pt idx="1298">
                  <c:v>3.7585902777777775</c:v>
                </c:pt>
                <c:pt idx="1299">
                  <c:v>3.7641875000000002</c:v>
                </c:pt>
                <c:pt idx="1300">
                  <c:v>3.7697847222222221</c:v>
                </c:pt>
                <c:pt idx="1301">
                  <c:v>3.7744166666666668</c:v>
                </c:pt>
                <c:pt idx="1302">
                  <c:v>3.7790555555555558</c:v>
                </c:pt>
                <c:pt idx="1303">
                  <c:v>3.7836875000000001</c:v>
                </c:pt>
                <c:pt idx="1304">
                  <c:v>3.7883194444444448</c:v>
                </c:pt>
                <c:pt idx="1305">
                  <c:v>3.7890277777777777</c:v>
                </c:pt>
                <c:pt idx="1306">
                  <c:v>3.7897361111111114</c:v>
                </c:pt>
                <c:pt idx="1307">
                  <c:v>3.7904444444444443</c:v>
                </c:pt>
                <c:pt idx="1308">
                  <c:v>3.791152777777778</c:v>
                </c:pt>
                <c:pt idx="1309">
                  <c:v>3.7918611111111109</c:v>
                </c:pt>
                <c:pt idx="1310">
                  <c:v>3.792958333333333</c:v>
                </c:pt>
                <c:pt idx="1311">
                  <c:v>3.7940555555555551</c:v>
                </c:pt>
                <c:pt idx="1312">
                  <c:v>3.7951458333333337</c:v>
                </c:pt>
                <c:pt idx="1313">
                  <c:v>3.7962430555555557</c:v>
                </c:pt>
                <c:pt idx="1314">
                  <c:v>3.7979027777777774</c:v>
                </c:pt>
                <c:pt idx="1315">
                  <c:v>3.7995555555555551</c:v>
                </c:pt>
                <c:pt idx="1316">
                  <c:v>3.8012152777777777</c:v>
                </c:pt>
                <c:pt idx="1317">
                  <c:v>3.8028680555555558</c:v>
                </c:pt>
                <c:pt idx="1318">
                  <c:v>3.8052222222222225</c:v>
                </c:pt>
                <c:pt idx="1319">
                  <c:v>3.8075694444444443</c:v>
                </c:pt>
                <c:pt idx="1320">
                  <c:v>3.809923611111111</c:v>
                </c:pt>
                <c:pt idx="1321">
                  <c:v>3.811666666666667</c:v>
                </c:pt>
                <c:pt idx="1322">
                  <c:v>3.8131111111111111</c:v>
                </c:pt>
                <c:pt idx="1323">
                  <c:v>3.8145486111111109</c:v>
                </c:pt>
                <c:pt idx="1324">
                  <c:v>3.8159861111111115</c:v>
                </c:pt>
                <c:pt idx="1325">
                  <c:v>3.8174305555555557</c:v>
                </c:pt>
                <c:pt idx="1326">
                  <c:v>3.8188680555555554</c:v>
                </c:pt>
                <c:pt idx="1327">
                  <c:v>3.8203125</c:v>
                </c:pt>
                <c:pt idx="1328">
                  <c:v>3.8217499999999998</c:v>
                </c:pt>
                <c:pt idx="1329">
                  <c:v>3.8231875000000004</c:v>
                </c:pt>
                <c:pt idx="1330">
                  <c:v>3.8246319444444445</c:v>
                </c:pt>
                <c:pt idx="1331">
                  <c:v>3.8260694444444443</c:v>
                </c:pt>
                <c:pt idx="1332">
                  <c:v>3.8275138888888889</c:v>
                </c:pt>
                <c:pt idx="1333">
                  <c:v>3.8289513888888886</c:v>
                </c:pt>
                <c:pt idx="1334">
                  <c:v>3.8303888888888888</c:v>
                </c:pt>
                <c:pt idx="1335">
                  <c:v>3.8320277777777778</c:v>
                </c:pt>
                <c:pt idx="1336">
                  <c:v>3.8336597222222224</c:v>
                </c:pt>
                <c:pt idx="1337">
                  <c:v>3.8352916666666665</c:v>
                </c:pt>
                <c:pt idx="1338">
                  <c:v>3.836930555555556</c:v>
                </c:pt>
                <c:pt idx="1339">
                  <c:v>3.8385624999999997</c:v>
                </c:pt>
                <c:pt idx="1340">
                  <c:v>3.8408888888888888</c:v>
                </c:pt>
                <c:pt idx="1341">
                  <c:v>3.8432152777777775</c:v>
                </c:pt>
                <c:pt idx="1342">
                  <c:v>3.8455416666666666</c:v>
                </c:pt>
                <c:pt idx="1343">
                  <c:v>3.8478680555555558</c:v>
                </c:pt>
                <c:pt idx="1344">
                  <c:v>3.8501944444444445</c:v>
                </c:pt>
                <c:pt idx="1345">
                  <c:v>3.852881944444444</c:v>
                </c:pt>
                <c:pt idx="1346">
                  <c:v>3.8555625</c:v>
                </c:pt>
                <c:pt idx="1347">
                  <c:v>3.8582430555555556</c:v>
                </c:pt>
                <c:pt idx="1348">
                  <c:v>3.8609305555555555</c:v>
                </c:pt>
                <c:pt idx="1349">
                  <c:v>3.8636111111111116</c:v>
                </c:pt>
                <c:pt idx="1350">
                  <c:v>3.8662916666666667</c:v>
                </c:pt>
                <c:pt idx="1351">
                  <c:v>3.8689791666666666</c:v>
                </c:pt>
                <c:pt idx="1352">
                  <c:v>3.8716597222222218</c:v>
                </c:pt>
                <c:pt idx="1353">
                  <c:v>3.8743402777777778</c:v>
                </c:pt>
                <c:pt idx="1354">
                  <c:v>3.8770277777777777</c:v>
                </c:pt>
                <c:pt idx="1355">
                  <c:v>3.8797083333333333</c:v>
                </c:pt>
                <c:pt idx="1356">
                  <c:v>3.8823888888888893</c:v>
                </c:pt>
                <c:pt idx="1357">
                  <c:v>3.8850763888888888</c:v>
                </c:pt>
                <c:pt idx="1358">
                  <c:v>3.8872638888888886</c:v>
                </c:pt>
                <c:pt idx="1359">
                  <c:v>3.8894444444444445</c:v>
                </c:pt>
                <c:pt idx="1360">
                  <c:v>3.8916319444444443</c:v>
                </c:pt>
                <c:pt idx="1361">
                  <c:v>3.8938194444444445</c:v>
                </c:pt>
                <c:pt idx="1362">
                  <c:v>3.8955902777777776</c:v>
                </c:pt>
                <c:pt idx="1363">
                  <c:v>3.8973611111111111</c:v>
                </c:pt>
                <c:pt idx="1364">
                  <c:v>3.8988333333333332</c:v>
                </c:pt>
                <c:pt idx="1365">
                  <c:v>3.8990763888888891</c:v>
                </c:pt>
                <c:pt idx="1366">
                  <c:v>3.8993263888888885</c:v>
                </c:pt>
                <c:pt idx="1367">
                  <c:v>3.8995694444444444</c:v>
                </c:pt>
                <c:pt idx="1368">
                  <c:v>3.8998124999999999</c:v>
                </c:pt>
                <c:pt idx="1369">
                  <c:v>3.9000555555555554</c:v>
                </c:pt>
                <c:pt idx="1370">
                  <c:v>3.9005486111111112</c:v>
                </c:pt>
                <c:pt idx="1371">
                  <c:v>3.9010416666666665</c:v>
                </c:pt>
                <c:pt idx="1372">
                  <c:v>3.9015277777777775</c:v>
                </c:pt>
                <c:pt idx="1373">
                  <c:v>3.9020208333333333</c:v>
                </c:pt>
                <c:pt idx="1374">
                  <c:v>3.9025069444444442</c:v>
                </c:pt>
                <c:pt idx="1375">
                  <c:v>3.9037222222222221</c:v>
                </c:pt>
                <c:pt idx="1376">
                  <c:v>3.904930555555556</c:v>
                </c:pt>
                <c:pt idx="1377">
                  <c:v>3.9061458333333334</c:v>
                </c:pt>
                <c:pt idx="1378">
                  <c:v>3.9073541666666669</c:v>
                </c:pt>
                <c:pt idx="1379">
                  <c:v>3.9085694444444448</c:v>
                </c:pt>
                <c:pt idx="1380">
                  <c:v>3.9100833333333336</c:v>
                </c:pt>
                <c:pt idx="1381">
                  <c:v>3.9115972222222219</c:v>
                </c:pt>
                <c:pt idx="1382">
                  <c:v>3.9131111111111112</c:v>
                </c:pt>
                <c:pt idx="1383">
                  <c:v>3.9146250000000005</c:v>
                </c:pt>
                <c:pt idx="1384">
                  <c:v>3.9158333333333335</c:v>
                </c:pt>
                <c:pt idx="1385">
                  <c:v>3.9170416666666665</c:v>
                </c:pt>
                <c:pt idx="1386">
                  <c:v>3.91825</c:v>
                </c:pt>
                <c:pt idx="1387">
                  <c:v>3.919215277777778</c:v>
                </c:pt>
                <c:pt idx="1388">
                  <c:v>3.920180555555556</c:v>
                </c:pt>
                <c:pt idx="1389">
                  <c:v>3.9211458333333331</c:v>
                </c:pt>
                <c:pt idx="1390">
                  <c:v>3.9221111111111111</c:v>
                </c:pt>
                <c:pt idx="1391">
                  <c:v>3.9222569444444444</c:v>
                </c:pt>
                <c:pt idx="1392">
                  <c:v>3.9224027777777781</c:v>
                </c:pt>
                <c:pt idx="1393">
                  <c:v>3.9225486111111114</c:v>
                </c:pt>
                <c:pt idx="1394">
                  <c:v>3.9226944444444447</c:v>
                </c:pt>
                <c:pt idx="1395">
                  <c:v>3.922840277777778</c:v>
                </c:pt>
                <c:pt idx="1396">
                  <c:v>3.9231180555555554</c:v>
                </c:pt>
                <c:pt idx="1397">
                  <c:v>3.9234027777777776</c:v>
                </c:pt>
                <c:pt idx="1398">
                  <c:v>3.9236805555555558</c:v>
                </c:pt>
                <c:pt idx="1399">
                  <c:v>3.923965277777778</c:v>
                </c:pt>
                <c:pt idx="1400">
                  <c:v>3.9242500000000002</c:v>
                </c:pt>
                <c:pt idx="1401">
                  <c:v>3.9250347222222222</c:v>
                </c:pt>
                <c:pt idx="1402">
                  <c:v>3.9258263888888885</c:v>
                </c:pt>
                <c:pt idx="1403">
                  <c:v>3.9266111111111108</c:v>
                </c:pt>
                <c:pt idx="1404">
                  <c:v>3.927402777777778</c:v>
                </c:pt>
                <c:pt idx="1405">
                  <c:v>3.9281874999999999</c:v>
                </c:pt>
                <c:pt idx="1406">
                  <c:v>3.9290833333333333</c:v>
                </c:pt>
                <c:pt idx="1407">
                  <c:v>3.9299722222222222</c:v>
                </c:pt>
                <c:pt idx="1408">
                  <c:v>3.9308611111111107</c:v>
                </c:pt>
                <c:pt idx="1409">
                  <c:v>3.9317500000000001</c:v>
                </c:pt>
                <c:pt idx="1410">
                  <c:v>3.9326458333333334</c:v>
                </c:pt>
                <c:pt idx="1411">
                  <c:v>3.9335347222222223</c:v>
                </c:pt>
                <c:pt idx="1412">
                  <c:v>3.9346319444444444</c:v>
                </c:pt>
                <c:pt idx="1413">
                  <c:v>3.9357291666666665</c:v>
                </c:pt>
                <c:pt idx="1414">
                  <c:v>3.9368333333333334</c:v>
                </c:pt>
                <c:pt idx="1415">
                  <c:v>3.9379305555555555</c:v>
                </c:pt>
                <c:pt idx="1416">
                  <c:v>3.9390277777777776</c:v>
                </c:pt>
                <c:pt idx="1417">
                  <c:v>3.9398958333333334</c:v>
                </c:pt>
                <c:pt idx="1418">
                  <c:v>3.9405833333333331</c:v>
                </c:pt>
                <c:pt idx="1419">
                  <c:v>3.9412708333333337</c:v>
                </c:pt>
                <c:pt idx="1420">
                  <c:v>3.9414097222222222</c:v>
                </c:pt>
                <c:pt idx="1421">
                  <c:v>3.9415486111111111</c:v>
                </c:pt>
                <c:pt idx="1422">
                  <c:v>3.9416875</c:v>
                </c:pt>
                <c:pt idx="1423">
                  <c:v>3.9418263888888885</c:v>
                </c:pt>
                <c:pt idx="1424">
                  <c:v>3.9419583333333335</c:v>
                </c:pt>
                <c:pt idx="1425">
                  <c:v>3.9422291666666669</c:v>
                </c:pt>
                <c:pt idx="1426">
                  <c:v>3.9424999999999999</c:v>
                </c:pt>
                <c:pt idx="1427">
                  <c:v>3.942763888888889</c:v>
                </c:pt>
                <c:pt idx="1428">
                  <c:v>3.9430347222222224</c:v>
                </c:pt>
                <c:pt idx="1429">
                  <c:v>3.9433055555555554</c:v>
                </c:pt>
                <c:pt idx="1430">
                  <c:v>3.9438888888888886</c:v>
                </c:pt>
                <c:pt idx="1431">
                  <c:v>3.9444722222222222</c:v>
                </c:pt>
                <c:pt idx="1432">
                  <c:v>3.9450555555555558</c:v>
                </c:pt>
                <c:pt idx="1433">
                  <c:v>3.9456388888888889</c:v>
                </c:pt>
                <c:pt idx="1434">
                  <c:v>3.9462222222222225</c:v>
                </c:pt>
                <c:pt idx="1435">
                  <c:v>3.9469097222222222</c:v>
                </c:pt>
                <c:pt idx="1436">
                  <c:v>3.947597222222222</c:v>
                </c:pt>
                <c:pt idx="1437">
                  <c:v>3.9482847222222222</c:v>
                </c:pt>
                <c:pt idx="1438">
                  <c:v>3.9489791666666667</c:v>
                </c:pt>
                <c:pt idx="1439">
                  <c:v>3.9496666666666669</c:v>
                </c:pt>
                <c:pt idx="1440">
                  <c:v>3.9503541666666666</c:v>
                </c:pt>
                <c:pt idx="1441">
                  <c:v>3.9512708333333331</c:v>
                </c:pt>
                <c:pt idx="1442">
                  <c:v>3.9521875</c:v>
                </c:pt>
                <c:pt idx="1443">
                  <c:v>3.9531041666666669</c:v>
                </c:pt>
                <c:pt idx="1444">
                  <c:v>3.9540208333333333</c:v>
                </c:pt>
                <c:pt idx="1445">
                  <c:v>3.9549374999999998</c:v>
                </c:pt>
                <c:pt idx="1446">
                  <c:v>3.9558541666666667</c:v>
                </c:pt>
                <c:pt idx="1447">
                  <c:v>3.9569930555555555</c:v>
                </c:pt>
                <c:pt idx="1448">
                  <c:v>3.9581249999999999</c:v>
                </c:pt>
                <c:pt idx="1449">
                  <c:v>3.9592569444444443</c:v>
                </c:pt>
                <c:pt idx="1450">
                  <c:v>3.9603958333333336</c:v>
                </c:pt>
                <c:pt idx="1451">
                  <c:v>3.961527777777778</c:v>
                </c:pt>
                <c:pt idx="1452">
                  <c:v>3.962388888888889</c:v>
                </c:pt>
                <c:pt idx="1453">
                  <c:v>3.9632499999999999</c:v>
                </c:pt>
                <c:pt idx="1454">
                  <c:v>3.9641111111111109</c:v>
                </c:pt>
                <c:pt idx="1455">
                  <c:v>3.9649722222222223</c:v>
                </c:pt>
                <c:pt idx="1456">
                  <c:v>3.9658333333333333</c:v>
                </c:pt>
                <c:pt idx="1457">
                  <c:v>3.9666944444444443</c:v>
                </c:pt>
                <c:pt idx="1458">
                  <c:v>3.9675555555555553</c:v>
                </c:pt>
                <c:pt idx="1459">
                  <c:v>3.9684166666666671</c:v>
                </c:pt>
                <c:pt idx="1460">
                  <c:v>3.9692777777777781</c:v>
                </c:pt>
                <c:pt idx="1461">
                  <c:v>3.9701388888888891</c:v>
                </c:pt>
                <c:pt idx="1462">
                  <c:v>3.9709999999999996</c:v>
                </c:pt>
                <c:pt idx="1463">
                  <c:v>3.9718611111111106</c:v>
                </c:pt>
                <c:pt idx="1464">
                  <c:v>3.9727222222222225</c:v>
                </c:pt>
                <c:pt idx="1465">
                  <c:v>3.9735833333333335</c:v>
                </c:pt>
                <c:pt idx="1466">
                  <c:v>3.9744444444444444</c:v>
                </c:pt>
                <c:pt idx="1467">
                  <c:v>3.9753055555555554</c:v>
                </c:pt>
                <c:pt idx="1468">
                  <c:v>3.9761666666666668</c:v>
                </c:pt>
                <c:pt idx="1469">
                  <c:v>3.9770208333333334</c:v>
                </c:pt>
                <c:pt idx="1470">
                  <c:v>3.977881944444444</c:v>
                </c:pt>
                <c:pt idx="1471">
                  <c:v>3.9785902777777777</c:v>
                </c:pt>
                <c:pt idx="1472">
                  <c:v>3.9792986111111111</c:v>
                </c:pt>
                <c:pt idx="1473">
                  <c:v>3.9800069444444444</c:v>
                </c:pt>
                <c:pt idx="1474">
                  <c:v>3.9807152777777777</c:v>
                </c:pt>
                <c:pt idx="1475">
                  <c:v>3.9808263888888891</c:v>
                </c:pt>
                <c:pt idx="1476">
                  <c:v>3.9809305555555556</c:v>
                </c:pt>
                <c:pt idx="1477">
                  <c:v>3.9810416666666666</c:v>
                </c:pt>
                <c:pt idx="1478">
                  <c:v>3.9811458333333336</c:v>
                </c:pt>
                <c:pt idx="1479">
                  <c:v>3.9812569444444446</c:v>
                </c:pt>
                <c:pt idx="1480">
                  <c:v>3.9814444444444441</c:v>
                </c:pt>
                <c:pt idx="1481">
                  <c:v>3.9816388888888889</c:v>
                </c:pt>
                <c:pt idx="1482">
                  <c:v>3.981826388888889</c:v>
                </c:pt>
                <c:pt idx="1483">
                  <c:v>3.982013888888889</c:v>
                </c:pt>
                <c:pt idx="1484">
                  <c:v>3.9822083333333333</c:v>
                </c:pt>
                <c:pt idx="1485">
                  <c:v>3.9825555555555558</c:v>
                </c:pt>
                <c:pt idx="1486">
                  <c:v>3.9829097222222223</c:v>
                </c:pt>
                <c:pt idx="1487">
                  <c:v>3.9832569444444448</c:v>
                </c:pt>
                <c:pt idx="1488">
                  <c:v>3.9836111111111108</c:v>
                </c:pt>
                <c:pt idx="1489">
                  <c:v>3.9839583333333333</c:v>
                </c:pt>
                <c:pt idx="1490">
                  <c:v>3.9844166666666672</c:v>
                </c:pt>
                <c:pt idx="1491">
                  <c:v>3.9848750000000002</c:v>
                </c:pt>
                <c:pt idx="1492">
                  <c:v>3.9853333333333336</c:v>
                </c:pt>
                <c:pt idx="1493">
                  <c:v>3.9857916666666666</c:v>
                </c:pt>
                <c:pt idx="1494">
                  <c:v>3.9862500000000001</c:v>
                </c:pt>
                <c:pt idx="1495">
                  <c:v>3.9867083333333331</c:v>
                </c:pt>
                <c:pt idx="1496">
                  <c:v>3.987166666666667</c:v>
                </c:pt>
                <c:pt idx="1497">
                  <c:v>3.9876319444444444</c:v>
                </c:pt>
                <c:pt idx="1498">
                  <c:v>3.9880902777777782</c:v>
                </c:pt>
                <c:pt idx="1499">
                  <c:v>3.9886041666666667</c:v>
                </c:pt>
                <c:pt idx="1500">
                  <c:v>3.989125</c:v>
                </c:pt>
                <c:pt idx="1501">
                  <c:v>3.9895555555555555</c:v>
                </c:pt>
                <c:pt idx="1502">
                  <c:v>3.989986111111111</c:v>
                </c:pt>
                <c:pt idx="1503">
                  <c:v>3.9903472222222223</c:v>
                </c:pt>
                <c:pt idx="1504">
                  <c:v>3.9904027777777782</c:v>
                </c:pt>
                <c:pt idx="1505">
                  <c:v>3.990465277777778</c:v>
                </c:pt>
                <c:pt idx="1506">
                  <c:v>3.9905208333333335</c:v>
                </c:pt>
                <c:pt idx="1507">
                  <c:v>3.9905833333333329</c:v>
                </c:pt>
                <c:pt idx="1508">
                  <c:v>3.9906388888888893</c:v>
                </c:pt>
                <c:pt idx="1509">
                  <c:v>3.9907569444444442</c:v>
                </c:pt>
                <c:pt idx="1510">
                  <c:v>3.990875</c:v>
                </c:pt>
                <c:pt idx="1511">
                  <c:v>3.9909861111111113</c:v>
                </c:pt>
                <c:pt idx="1512">
                  <c:v>3.9911041666666662</c:v>
                </c:pt>
                <c:pt idx="1513">
                  <c:v>3.9913611111111114</c:v>
                </c:pt>
                <c:pt idx="1514">
                  <c:v>3.9916180555555556</c:v>
                </c:pt>
                <c:pt idx="1515">
                  <c:v>3.9918750000000003</c:v>
                </c:pt>
                <c:pt idx="1516">
                  <c:v>3.9921319444444445</c:v>
                </c:pt>
                <c:pt idx="1517">
                  <c:v>3.9923888888888888</c:v>
                </c:pt>
                <c:pt idx="1518">
                  <c:v>3.9928055555555559</c:v>
                </c:pt>
                <c:pt idx="1519">
                  <c:v>3.9932291666666666</c:v>
                </c:pt>
                <c:pt idx="1520">
                  <c:v>3.9935763888888891</c:v>
                </c:pt>
                <c:pt idx="1521">
                  <c:v>3.9939236111111112</c:v>
                </c:pt>
                <c:pt idx="1522">
                  <c:v>3.9942708333333332</c:v>
                </c:pt>
                <c:pt idx="1523">
                  <c:v>3.9946180555555557</c:v>
                </c:pt>
                <c:pt idx="1524">
                  <c:v>3.9949652777777778</c:v>
                </c:pt>
                <c:pt idx="1525">
                  <c:v>3.9953055555555554</c:v>
                </c:pt>
                <c:pt idx="1526">
                  <c:v>3.9956527777777775</c:v>
                </c:pt>
                <c:pt idx="1527">
                  <c:v>3.996</c:v>
                </c:pt>
                <c:pt idx="1528">
                  <c:v>3.9962847222222218</c:v>
                </c:pt>
                <c:pt idx="1529">
                  <c:v>3.9965625</c:v>
                </c:pt>
                <c:pt idx="1530">
                  <c:v>3.9968472222222222</c:v>
                </c:pt>
                <c:pt idx="1531">
                  <c:v>3.9971319444444444</c:v>
                </c:pt>
                <c:pt idx="1532">
                  <c:v>3.9974097222222227</c:v>
                </c:pt>
                <c:pt idx="1533">
                  <c:v>3.9977361111111112</c:v>
                </c:pt>
                <c:pt idx="1534">
                  <c:v>3.9980625000000001</c:v>
                </c:pt>
                <c:pt idx="1535">
                  <c:v>3.998388888888889</c:v>
                </c:pt>
                <c:pt idx="1536">
                  <c:v>3.9987152777777775</c:v>
                </c:pt>
                <c:pt idx="1537">
                  <c:v>3.9990416666666664</c:v>
                </c:pt>
                <c:pt idx="1538">
                  <c:v>3.9993680555555557</c:v>
                </c:pt>
                <c:pt idx="1539">
                  <c:v>3.9996319444444448</c:v>
                </c:pt>
                <c:pt idx="1540">
                  <c:v>3.9998958333333334</c:v>
                </c:pt>
                <c:pt idx="1541">
                  <c:v>4.0001597222222216</c:v>
                </c:pt>
                <c:pt idx="1542">
                  <c:v>4.0004236111111107</c:v>
                </c:pt>
                <c:pt idx="1543">
                  <c:v>4.0006874999999997</c:v>
                </c:pt>
                <c:pt idx="1544">
                  <c:v>4.0009513888888888</c:v>
                </c:pt>
                <c:pt idx="1545">
                  <c:v>4.0012222222222222</c:v>
                </c:pt>
                <c:pt idx="1546">
                  <c:v>4.0014861111111113</c:v>
                </c:pt>
                <c:pt idx="1547">
                  <c:v>4.0017777777777779</c:v>
                </c:pt>
                <c:pt idx="1548">
                  <c:v>4.0020138888888885</c:v>
                </c:pt>
                <c:pt idx="1549">
                  <c:v>4.0022430555555548</c:v>
                </c:pt>
                <c:pt idx="1550">
                  <c:v>4.0024722222222229</c:v>
                </c:pt>
                <c:pt idx="1551">
                  <c:v>4.002659722222222</c:v>
                </c:pt>
                <c:pt idx="1552">
                  <c:v>4.0028541666666664</c:v>
                </c:pt>
                <c:pt idx="1553">
                  <c:v>4.0030416666666664</c:v>
                </c:pt>
                <c:pt idx="1554">
                  <c:v>4.0032291666666664</c:v>
                </c:pt>
                <c:pt idx="1555">
                  <c:v>4.0034236111111117</c:v>
                </c:pt>
                <c:pt idx="1556">
                  <c:v>4.0037569444444445</c:v>
                </c:pt>
                <c:pt idx="1557">
                  <c:v>4.0040972222222218</c:v>
                </c:pt>
                <c:pt idx="1558">
                  <c:v>4.0043750000000005</c:v>
                </c:pt>
                <c:pt idx="1559">
                  <c:v>4.0046527777777774</c:v>
                </c:pt>
                <c:pt idx="1560">
                  <c:v>4.0049236111111108</c:v>
                </c:pt>
                <c:pt idx="1561">
                  <c:v>4.0052013888888887</c:v>
                </c:pt>
                <c:pt idx="1562">
                  <c:v>4.0054791666666665</c:v>
                </c:pt>
                <c:pt idx="1563">
                  <c:v>4.0057499999999999</c:v>
                </c:pt>
                <c:pt idx="1564">
                  <c:v>4.0060277777777777</c:v>
                </c:pt>
                <c:pt idx="1565">
                  <c:v>4.0063055555555556</c:v>
                </c:pt>
                <c:pt idx="1566">
                  <c:v>4.006520833333334</c:v>
                </c:pt>
                <c:pt idx="1567">
                  <c:v>4.0067361111111106</c:v>
                </c:pt>
                <c:pt idx="1568">
                  <c:v>4.006951388888889</c:v>
                </c:pt>
                <c:pt idx="1569">
                  <c:v>4.0071666666666665</c:v>
                </c:pt>
                <c:pt idx="1570">
                  <c:v>4.007381944444445</c:v>
                </c:pt>
                <c:pt idx="1571">
                  <c:v>4.0075972222222216</c:v>
                </c:pt>
                <c:pt idx="1572">
                  <c:v>4.0078125</c:v>
                </c:pt>
                <c:pt idx="1573">
                  <c:v>4.0080347222222219</c:v>
                </c:pt>
                <c:pt idx="1574">
                  <c:v>4.0082500000000003</c:v>
                </c:pt>
                <c:pt idx="1575">
                  <c:v>4.0084652777777778</c:v>
                </c:pt>
                <c:pt idx="1576">
                  <c:v>4.0086805555555554</c:v>
                </c:pt>
                <c:pt idx="1577">
                  <c:v>4.0089513888888888</c:v>
                </c:pt>
                <c:pt idx="1578">
                  <c:v>4.0092222222222222</c:v>
                </c:pt>
                <c:pt idx="1579">
                  <c:v>4.0095000000000001</c:v>
                </c:pt>
                <c:pt idx="1580">
                  <c:v>4.0097708333333335</c:v>
                </c:pt>
                <c:pt idx="1581">
                  <c:v>4.0100416666666669</c:v>
                </c:pt>
                <c:pt idx="1582">
                  <c:v>4.0103194444444439</c:v>
                </c:pt>
                <c:pt idx="1583">
                  <c:v>4.0105347222222223</c:v>
                </c:pt>
                <c:pt idx="1584">
                  <c:v>4.0107013888888892</c:v>
                </c:pt>
                <c:pt idx="1585">
                  <c:v>4.0108749999999995</c:v>
                </c:pt>
                <c:pt idx="1586">
                  <c:v>4.0109027777777779</c:v>
                </c:pt>
                <c:pt idx="1587">
                  <c:v>4.0109305555555554</c:v>
                </c:pt>
                <c:pt idx="1588">
                  <c:v>4.0109513888888895</c:v>
                </c:pt>
                <c:pt idx="1589">
                  <c:v>4.010979166666667</c:v>
                </c:pt>
                <c:pt idx="1590">
                  <c:v>4.0110069444444445</c:v>
                </c:pt>
                <c:pt idx="1591">
                  <c:v>4.0110486111111108</c:v>
                </c:pt>
                <c:pt idx="1592">
                  <c:v>4.0110833333333336</c:v>
                </c:pt>
                <c:pt idx="1593">
                  <c:v>4.0111250000000007</c:v>
                </c:pt>
                <c:pt idx="1594">
                  <c:v>4.011166666666667</c:v>
                </c:pt>
                <c:pt idx="1595">
                  <c:v>4.0112013888888889</c:v>
                </c:pt>
                <c:pt idx="1596">
                  <c:v>4.0112430555555552</c:v>
                </c:pt>
                <c:pt idx="1597">
                  <c:v>4.0113263888888895</c:v>
                </c:pt>
                <c:pt idx="1598">
                  <c:v>4.0114027777777777</c:v>
                </c:pt>
                <c:pt idx="1599">
                  <c:v>4.0114861111111111</c:v>
                </c:pt>
                <c:pt idx="1600">
                  <c:v>4.0115694444444445</c:v>
                </c:pt>
                <c:pt idx="1601">
                  <c:v>4.0116458333333336</c:v>
                </c:pt>
                <c:pt idx="1602">
                  <c:v>4.0118194444444448</c:v>
                </c:pt>
                <c:pt idx="1603">
                  <c:v>4.0119861111111117</c:v>
                </c:pt>
                <c:pt idx="1604">
                  <c:v>4.0121527777777777</c:v>
                </c:pt>
                <c:pt idx="1605">
                  <c:v>4.0123263888888889</c:v>
                </c:pt>
                <c:pt idx="1606">
                  <c:v>4.0124930555555558</c:v>
                </c:pt>
                <c:pt idx="1607">
                  <c:v>4.0127083333333333</c:v>
                </c:pt>
                <c:pt idx="1608">
                  <c:v>4.0129305555555552</c:v>
                </c:pt>
                <c:pt idx="1609">
                  <c:v>4.0131458333333336</c:v>
                </c:pt>
                <c:pt idx="1610">
                  <c:v>4.0133611111111112</c:v>
                </c:pt>
                <c:pt idx="1611">
                  <c:v>4.0135833333333339</c:v>
                </c:pt>
                <c:pt idx="1612">
                  <c:v>4.0137986111111115</c:v>
                </c:pt>
                <c:pt idx="1613">
                  <c:v>4.0140486111111109</c:v>
                </c:pt>
                <c:pt idx="1614">
                  <c:v>4.0142986111111112</c:v>
                </c:pt>
                <c:pt idx="1615">
                  <c:v>4.0145486111111106</c:v>
                </c:pt>
                <c:pt idx="1616">
                  <c:v>4.0147986111111118</c:v>
                </c:pt>
                <c:pt idx="1617">
                  <c:v>4.0150555555555556</c:v>
                </c:pt>
                <c:pt idx="1618">
                  <c:v>4.0153055555555559</c:v>
                </c:pt>
                <c:pt idx="1619">
                  <c:v>4.0156388888888888</c:v>
                </c:pt>
                <c:pt idx="1620">
                  <c:v>4.0159791666666669</c:v>
                </c:pt>
                <c:pt idx="1621">
                  <c:v>4.0163124999999997</c:v>
                </c:pt>
                <c:pt idx="1622">
                  <c:v>4.0166527777777778</c:v>
                </c:pt>
                <c:pt idx="1623">
                  <c:v>4.0169861111111107</c:v>
                </c:pt>
                <c:pt idx="1624">
                  <c:v>4.0173194444444444</c:v>
                </c:pt>
                <c:pt idx="1625">
                  <c:v>4.0176597222222226</c:v>
                </c:pt>
                <c:pt idx="1626">
                  <c:v>4.0179930555555554</c:v>
                </c:pt>
                <c:pt idx="1627">
                  <c:v>4.0183333333333326</c:v>
                </c:pt>
                <c:pt idx="1628">
                  <c:v>4.0186666666666664</c:v>
                </c:pt>
                <c:pt idx="1629">
                  <c:v>4.0190069444444445</c:v>
                </c:pt>
                <c:pt idx="1630">
                  <c:v>4.0193402777777782</c:v>
                </c:pt>
                <c:pt idx="1631">
                  <c:v>4.0196805555555555</c:v>
                </c:pt>
                <c:pt idx="1632">
                  <c:v>4.0200138888888883</c:v>
                </c:pt>
                <c:pt idx="1633">
                  <c:v>4.0203541666666673</c:v>
                </c:pt>
                <c:pt idx="1634">
                  <c:v>4.0206875000000002</c:v>
                </c:pt>
                <c:pt idx="1635">
                  <c:v>4.0210277777777774</c:v>
                </c:pt>
                <c:pt idx="1636">
                  <c:v>4.0213611111111112</c:v>
                </c:pt>
                <c:pt idx="1637">
                  <c:v>4.0217013888888893</c:v>
                </c:pt>
                <c:pt idx="1638">
                  <c:v>4.0220347222222221</c:v>
                </c:pt>
                <c:pt idx="1639">
                  <c:v>4.0223750000000003</c:v>
                </c:pt>
                <c:pt idx="1640">
                  <c:v>4.0227083333333331</c:v>
                </c:pt>
                <c:pt idx="1641">
                  <c:v>4.0230486111111112</c:v>
                </c:pt>
                <c:pt idx="1642">
                  <c:v>4.0233819444444441</c:v>
                </c:pt>
                <c:pt idx="1643">
                  <c:v>4.0237222222222222</c:v>
                </c:pt>
                <c:pt idx="1644">
                  <c:v>4.0240555555555559</c:v>
                </c:pt>
                <c:pt idx="1645">
                  <c:v>4.0243958333333332</c:v>
                </c:pt>
                <c:pt idx="1646">
                  <c:v>4.024729166666666</c:v>
                </c:pt>
                <c:pt idx="1647">
                  <c:v>4.025069444444445</c:v>
                </c:pt>
                <c:pt idx="1648">
                  <c:v>4.0254027777777779</c:v>
                </c:pt>
                <c:pt idx="1649">
                  <c:v>4.0257430555555551</c:v>
                </c:pt>
                <c:pt idx="1650">
                  <c:v>4.0260763888888889</c:v>
                </c:pt>
                <c:pt idx="1651">
                  <c:v>4.026416666666667</c:v>
                </c:pt>
                <c:pt idx="1652">
                  <c:v>4.0267500000000007</c:v>
                </c:pt>
                <c:pt idx="1653">
                  <c:v>4.0270833333333336</c:v>
                </c:pt>
                <c:pt idx="1654">
                  <c:v>4.0274236111111108</c:v>
                </c:pt>
                <c:pt idx="1655">
                  <c:v>4.0277569444444445</c:v>
                </c:pt>
                <c:pt idx="1656">
                  <c:v>4.0280972222222227</c:v>
                </c:pt>
                <c:pt idx="1657">
                  <c:v>4.0284305555555555</c:v>
                </c:pt>
                <c:pt idx="1658">
                  <c:v>4.0287708333333336</c:v>
                </c:pt>
                <c:pt idx="1659">
                  <c:v>4.0291041666666665</c:v>
                </c:pt>
                <c:pt idx="1660">
                  <c:v>4.0294444444444446</c:v>
                </c:pt>
                <c:pt idx="1661">
                  <c:v>4.0297777777777775</c:v>
                </c:pt>
                <c:pt idx="1662">
                  <c:v>4.0301180555555556</c:v>
                </c:pt>
                <c:pt idx="1663">
                  <c:v>4.0304513888888893</c:v>
                </c:pt>
                <c:pt idx="1664">
                  <c:v>4.0307916666666666</c:v>
                </c:pt>
                <c:pt idx="1665">
                  <c:v>4.0311249999999994</c:v>
                </c:pt>
                <c:pt idx="1666">
                  <c:v>4.0314652777777784</c:v>
                </c:pt>
                <c:pt idx="1667">
                  <c:v>4.0317986111111113</c:v>
                </c:pt>
                <c:pt idx="1668">
                  <c:v>4.0321388888888885</c:v>
                </c:pt>
                <c:pt idx="1669">
                  <c:v>4.0324722222222222</c:v>
                </c:pt>
                <c:pt idx="1670">
                  <c:v>4.0328125000000004</c:v>
                </c:pt>
                <c:pt idx="1671">
                  <c:v>4.0331458333333332</c:v>
                </c:pt>
                <c:pt idx="1672">
                  <c:v>4.0334861111111113</c:v>
                </c:pt>
                <c:pt idx="1673">
                  <c:v>4.0338194444444442</c:v>
                </c:pt>
                <c:pt idx="1674">
                  <c:v>4.0341597222222223</c:v>
                </c:pt>
                <c:pt idx="1675">
                  <c:v>4.034493055555556</c:v>
                </c:pt>
                <c:pt idx="1676">
                  <c:v>4.0348333333333333</c:v>
                </c:pt>
                <c:pt idx="1677">
                  <c:v>4.035166666666667</c:v>
                </c:pt>
                <c:pt idx="1678">
                  <c:v>4.0355069444444442</c:v>
                </c:pt>
                <c:pt idx="1679">
                  <c:v>4.035840277777778</c:v>
                </c:pt>
                <c:pt idx="1680">
                  <c:v>4.0361805555555561</c:v>
                </c:pt>
                <c:pt idx="1681">
                  <c:v>4.036513888888889</c:v>
                </c:pt>
                <c:pt idx="1682">
                  <c:v>4.0368472222222227</c:v>
                </c:pt>
                <c:pt idx="1683">
                  <c:v>4.0371874999999999</c:v>
                </c:pt>
                <c:pt idx="1684">
                  <c:v>4.0375208333333328</c:v>
                </c:pt>
                <c:pt idx="1685">
                  <c:v>4.0378611111111118</c:v>
                </c:pt>
                <c:pt idx="1686">
                  <c:v>4.0381944444444446</c:v>
                </c:pt>
                <c:pt idx="1687">
                  <c:v>4.0385347222222219</c:v>
                </c:pt>
                <c:pt idx="1688">
                  <c:v>4.0388680555555556</c:v>
                </c:pt>
                <c:pt idx="1689">
                  <c:v>4.0392083333333337</c:v>
                </c:pt>
                <c:pt idx="1690">
                  <c:v>4.0395416666666666</c:v>
                </c:pt>
                <c:pt idx="1691">
                  <c:v>4.0399166666666666</c:v>
                </c:pt>
                <c:pt idx="1692">
                  <c:v>4.0402916666666666</c:v>
                </c:pt>
                <c:pt idx="1693">
                  <c:v>4.0406597222222222</c:v>
                </c:pt>
                <c:pt idx="1694">
                  <c:v>4.0410347222222223</c:v>
                </c:pt>
                <c:pt idx="1695">
                  <c:v>4.0414097222222223</c:v>
                </c:pt>
                <c:pt idx="1696">
                  <c:v>4.0417777777777779</c:v>
                </c:pt>
                <c:pt idx="1697">
                  <c:v>4.0421527777777779</c:v>
                </c:pt>
                <c:pt idx="1698">
                  <c:v>4.0425277777777779</c:v>
                </c:pt>
                <c:pt idx="1699">
                  <c:v>4.0428958333333336</c:v>
                </c:pt>
                <c:pt idx="1700">
                  <c:v>4.0432708333333336</c:v>
                </c:pt>
                <c:pt idx="1701">
                  <c:v>4.0436458333333336</c:v>
                </c:pt>
                <c:pt idx="1702">
                  <c:v>4.0440138888888892</c:v>
                </c:pt>
                <c:pt idx="1703">
                  <c:v>4.0443888888888893</c:v>
                </c:pt>
                <c:pt idx="1704">
                  <c:v>4.0447638888888893</c:v>
                </c:pt>
                <c:pt idx="1705">
                  <c:v>4.045131944444444</c:v>
                </c:pt>
                <c:pt idx="1706">
                  <c:v>4.045506944444444</c:v>
                </c:pt>
                <c:pt idx="1707">
                  <c:v>4.045881944444444</c:v>
                </c:pt>
                <c:pt idx="1708">
                  <c:v>4.0462500000000006</c:v>
                </c:pt>
                <c:pt idx="1709">
                  <c:v>4.0466250000000006</c:v>
                </c:pt>
                <c:pt idx="1710">
                  <c:v>4.0469930555555553</c:v>
                </c:pt>
                <c:pt idx="1711">
                  <c:v>4.0473680555555553</c:v>
                </c:pt>
                <c:pt idx="1712">
                  <c:v>4.0477777777777781</c:v>
                </c:pt>
                <c:pt idx="1713">
                  <c:v>4.0481875</c:v>
                </c:pt>
                <c:pt idx="1714">
                  <c:v>4.0486041666666663</c:v>
                </c:pt>
                <c:pt idx="1715">
                  <c:v>4.0490138888888891</c:v>
                </c:pt>
                <c:pt idx="1716">
                  <c:v>4.049423611111111</c:v>
                </c:pt>
                <c:pt idx="1717">
                  <c:v>4.0498333333333338</c:v>
                </c:pt>
                <c:pt idx="1718">
                  <c:v>4.0502430555555557</c:v>
                </c:pt>
                <c:pt idx="1719">
                  <c:v>4.0506527777777777</c:v>
                </c:pt>
                <c:pt idx="1720">
                  <c:v>4.0510624999999996</c:v>
                </c:pt>
                <c:pt idx="1721">
                  <c:v>4.0514791666666667</c:v>
                </c:pt>
                <c:pt idx="1722">
                  <c:v>4.0518888888888887</c:v>
                </c:pt>
                <c:pt idx="1723">
                  <c:v>4.0522986111111114</c:v>
                </c:pt>
                <c:pt idx="1724">
                  <c:v>4.0527083333333334</c:v>
                </c:pt>
                <c:pt idx="1725">
                  <c:v>4.0531180555555553</c:v>
                </c:pt>
                <c:pt idx="1726">
                  <c:v>4.0535277777777781</c:v>
                </c:pt>
                <c:pt idx="1727">
                  <c:v>4.0539375</c:v>
                </c:pt>
                <c:pt idx="1728">
                  <c:v>4.0543541666666671</c:v>
                </c:pt>
                <c:pt idx="1729">
                  <c:v>4.0547638888888891</c:v>
                </c:pt>
                <c:pt idx="1730">
                  <c:v>4.055173611111111</c:v>
                </c:pt>
                <c:pt idx="1731">
                  <c:v>4.0555833333333329</c:v>
                </c:pt>
                <c:pt idx="1732">
                  <c:v>4.0559930555555557</c:v>
                </c:pt>
                <c:pt idx="1733">
                  <c:v>4.0564513888888891</c:v>
                </c:pt>
                <c:pt idx="1734">
                  <c:v>4.0569097222222217</c:v>
                </c:pt>
                <c:pt idx="1735">
                  <c:v>4.0573680555555551</c:v>
                </c:pt>
                <c:pt idx="1736">
                  <c:v>4.0578263888888895</c:v>
                </c:pt>
                <c:pt idx="1737">
                  <c:v>4.058284722222222</c:v>
                </c:pt>
                <c:pt idx="1738">
                  <c:v>4.0587430555555555</c:v>
                </c:pt>
                <c:pt idx="1739">
                  <c:v>4.0592013888888889</c:v>
                </c:pt>
                <c:pt idx="1740">
                  <c:v>4.0596597222222224</c:v>
                </c:pt>
                <c:pt idx="1741">
                  <c:v>4.0601180555555549</c:v>
                </c:pt>
                <c:pt idx="1742">
                  <c:v>4.0605763888888884</c:v>
                </c:pt>
                <c:pt idx="1743">
                  <c:v>4.0610347222222227</c:v>
                </c:pt>
                <c:pt idx="1744">
                  <c:v>4.0614930555555553</c:v>
                </c:pt>
                <c:pt idx="1745">
                  <c:v>4.0619513888888887</c:v>
                </c:pt>
                <c:pt idx="1746">
                  <c:v>4.0624097222222222</c:v>
                </c:pt>
                <c:pt idx="1747">
                  <c:v>4.0628680555555556</c:v>
                </c:pt>
                <c:pt idx="1748">
                  <c:v>4.0633263888888882</c:v>
                </c:pt>
                <c:pt idx="1749">
                  <c:v>4.0637847222222225</c:v>
                </c:pt>
                <c:pt idx="1750">
                  <c:v>4.0642500000000004</c:v>
                </c:pt>
                <c:pt idx="1751">
                  <c:v>4.0647569444444445</c:v>
                </c:pt>
                <c:pt idx="1752">
                  <c:v>4.0652638888888886</c:v>
                </c:pt>
                <c:pt idx="1753">
                  <c:v>4.0657708333333336</c:v>
                </c:pt>
                <c:pt idx="1754">
                  <c:v>4.0662777777777777</c:v>
                </c:pt>
                <c:pt idx="1755">
                  <c:v>4.066791666666667</c:v>
                </c:pt>
                <c:pt idx="1756">
                  <c:v>4.0672986111111111</c:v>
                </c:pt>
                <c:pt idx="1757">
                  <c:v>4.0678055555555561</c:v>
                </c:pt>
                <c:pt idx="1758">
                  <c:v>4.0683125000000002</c:v>
                </c:pt>
                <c:pt idx="1759">
                  <c:v>4.0688263888888887</c:v>
                </c:pt>
                <c:pt idx="1760">
                  <c:v>4.0693333333333337</c:v>
                </c:pt>
                <c:pt idx="1761">
                  <c:v>4.0698402777777778</c:v>
                </c:pt>
                <c:pt idx="1762">
                  <c:v>4.0703472222222228</c:v>
                </c:pt>
                <c:pt idx="1763">
                  <c:v>4.0708611111111113</c:v>
                </c:pt>
                <c:pt idx="1764">
                  <c:v>4.0713680555555563</c:v>
                </c:pt>
                <c:pt idx="1765">
                  <c:v>4.0718750000000004</c:v>
                </c:pt>
                <c:pt idx="1766">
                  <c:v>4.0724375000000004</c:v>
                </c:pt>
                <c:pt idx="1767">
                  <c:v>4.0729999999999995</c:v>
                </c:pt>
                <c:pt idx="1768">
                  <c:v>4.073555555555556</c:v>
                </c:pt>
                <c:pt idx="1769">
                  <c:v>4.0741180555555552</c:v>
                </c:pt>
                <c:pt idx="1770">
                  <c:v>4.0746805555555552</c:v>
                </c:pt>
                <c:pt idx="1771">
                  <c:v>4.0752430555555561</c:v>
                </c:pt>
                <c:pt idx="1772">
                  <c:v>4.0758055555555552</c:v>
                </c:pt>
                <c:pt idx="1773">
                  <c:v>4.0763680555555561</c:v>
                </c:pt>
                <c:pt idx="1774">
                  <c:v>4.0769236111111118</c:v>
                </c:pt>
                <c:pt idx="1775">
                  <c:v>4.0774861111111109</c:v>
                </c:pt>
                <c:pt idx="1776">
                  <c:v>4.0780486111111109</c:v>
                </c:pt>
                <c:pt idx="1777">
                  <c:v>4.078611111111111</c:v>
                </c:pt>
                <c:pt idx="1778">
                  <c:v>4.079173611111111</c:v>
                </c:pt>
                <c:pt idx="1779">
                  <c:v>4.0797291666666666</c:v>
                </c:pt>
                <c:pt idx="1780">
                  <c:v>4.0802916666666667</c:v>
                </c:pt>
                <c:pt idx="1781">
                  <c:v>4.080916666666667</c:v>
                </c:pt>
                <c:pt idx="1782">
                  <c:v>4.0815416666666664</c:v>
                </c:pt>
                <c:pt idx="1783">
                  <c:v>4.0821666666666667</c:v>
                </c:pt>
                <c:pt idx="1784">
                  <c:v>4.082791666666667</c:v>
                </c:pt>
                <c:pt idx="1785">
                  <c:v>4.0834166666666665</c:v>
                </c:pt>
                <c:pt idx="1786">
                  <c:v>4.0840416666666668</c:v>
                </c:pt>
                <c:pt idx="1787">
                  <c:v>4.0846666666666671</c:v>
                </c:pt>
                <c:pt idx="1788">
                  <c:v>4.0852916666666665</c:v>
                </c:pt>
                <c:pt idx="1789">
                  <c:v>4.0859166666666669</c:v>
                </c:pt>
                <c:pt idx="1790">
                  <c:v>4.0865416666666663</c:v>
                </c:pt>
                <c:pt idx="1791">
                  <c:v>4.0871666666666666</c:v>
                </c:pt>
                <c:pt idx="1792">
                  <c:v>4.0877916666666669</c:v>
                </c:pt>
                <c:pt idx="1793">
                  <c:v>4.0884166666666664</c:v>
                </c:pt>
                <c:pt idx="1794">
                  <c:v>4.0890416666666667</c:v>
                </c:pt>
                <c:pt idx="1795">
                  <c:v>4.089666666666667</c:v>
                </c:pt>
                <c:pt idx="1796">
                  <c:v>4.0902916666666673</c:v>
                </c:pt>
                <c:pt idx="1797">
                  <c:v>4.0909166666666668</c:v>
                </c:pt>
                <c:pt idx="1798">
                  <c:v>4.0914236111111109</c:v>
                </c:pt>
                <c:pt idx="1799">
                  <c:v>4.091840277777778</c:v>
                </c:pt>
                <c:pt idx="1800">
                  <c:v>4.0922569444444443</c:v>
                </c:pt>
                <c:pt idx="1801">
                  <c:v>4.0926736111111106</c:v>
                </c:pt>
                <c:pt idx="1802">
                  <c:v>4.0930902777777778</c:v>
                </c:pt>
                <c:pt idx="1803">
                  <c:v>4.0935069444444441</c:v>
                </c:pt>
                <c:pt idx="1804">
                  <c:v>4.0940069444444447</c:v>
                </c:pt>
                <c:pt idx="1805">
                  <c:v>4.0945069444444444</c:v>
                </c:pt>
                <c:pt idx="1806">
                  <c:v>4.0949999999999998</c:v>
                </c:pt>
                <c:pt idx="1807">
                  <c:v>4.0955000000000004</c:v>
                </c:pt>
                <c:pt idx="1808">
                  <c:v>4.0960000000000001</c:v>
                </c:pt>
                <c:pt idx="1809">
                  <c:v>4.0964999999999998</c:v>
                </c:pt>
                <c:pt idx="1810">
                  <c:v>4.0970000000000004</c:v>
                </c:pt>
                <c:pt idx="1811">
                  <c:v>4.0975000000000001</c:v>
                </c:pt>
                <c:pt idx="1812">
                  <c:v>4.0979999999999999</c:v>
                </c:pt>
                <c:pt idx="1813">
                  <c:v>4.0984930555555552</c:v>
                </c:pt>
                <c:pt idx="1814">
                  <c:v>4.0989930555555558</c:v>
                </c:pt>
                <c:pt idx="1815">
                  <c:v>4.0994930555555555</c:v>
                </c:pt>
                <c:pt idx="1816">
                  <c:v>4.0999930555555553</c:v>
                </c:pt>
                <c:pt idx="1817">
                  <c:v>4.1004930555555559</c:v>
                </c:pt>
                <c:pt idx="1818">
                  <c:v>4.1009930555555556</c:v>
                </c:pt>
                <c:pt idx="1819">
                  <c:v>4.1014861111111109</c:v>
                </c:pt>
                <c:pt idx="1820">
                  <c:v>4.1019861111111107</c:v>
                </c:pt>
                <c:pt idx="1821">
                  <c:v>4.1024861111111113</c:v>
                </c:pt>
                <c:pt idx="1822">
                  <c:v>4.102986111111111</c:v>
                </c:pt>
                <c:pt idx="1823">
                  <c:v>4.1034861111111116</c:v>
                </c:pt>
                <c:pt idx="1824">
                  <c:v>4.104055555555556</c:v>
                </c:pt>
                <c:pt idx="1825">
                  <c:v>4.1046319444444448</c:v>
                </c:pt>
                <c:pt idx="1826">
                  <c:v>4.1052083333333336</c:v>
                </c:pt>
                <c:pt idx="1827">
                  <c:v>4.105777777777778</c:v>
                </c:pt>
                <c:pt idx="1828">
                  <c:v>4.1063541666666667</c:v>
                </c:pt>
                <c:pt idx="1829">
                  <c:v>4.1069305555555555</c:v>
                </c:pt>
                <c:pt idx="1830">
                  <c:v>4.1074027777777777</c:v>
                </c:pt>
                <c:pt idx="1831">
                  <c:v>4.1078749999999999</c:v>
                </c:pt>
                <c:pt idx="1832">
                  <c:v>4.1083541666666665</c:v>
                </c:pt>
                <c:pt idx="1833">
                  <c:v>4.1088263888888887</c:v>
                </c:pt>
                <c:pt idx="1834">
                  <c:v>4.1093055555555553</c:v>
                </c:pt>
                <c:pt idx="1835">
                  <c:v>4.1097777777777775</c:v>
                </c:pt>
                <c:pt idx="1836">
                  <c:v>4.1102499999999997</c:v>
                </c:pt>
                <c:pt idx="1837">
                  <c:v>4.1107291666666663</c:v>
                </c:pt>
                <c:pt idx="1838">
                  <c:v>4.1112777777777776</c:v>
                </c:pt>
                <c:pt idx="1839">
                  <c:v>4.1118333333333332</c:v>
                </c:pt>
                <c:pt idx="1840">
                  <c:v>4.1123888888888889</c:v>
                </c:pt>
                <c:pt idx="1841">
                  <c:v>4.1129375000000001</c:v>
                </c:pt>
                <c:pt idx="1842">
                  <c:v>4.1134930555555558</c:v>
                </c:pt>
                <c:pt idx="1843">
                  <c:v>4.1141458333333336</c:v>
                </c:pt>
                <c:pt idx="1844">
                  <c:v>4.1148055555555549</c:v>
                </c:pt>
                <c:pt idx="1845">
                  <c:v>4.1154583333333337</c:v>
                </c:pt>
                <c:pt idx="1846">
                  <c:v>4.1161111111111106</c:v>
                </c:pt>
                <c:pt idx="1847">
                  <c:v>4.1167708333333328</c:v>
                </c:pt>
                <c:pt idx="1848">
                  <c:v>4.1174236111111115</c:v>
                </c:pt>
                <c:pt idx="1849">
                  <c:v>4.1179513888888888</c:v>
                </c:pt>
                <c:pt idx="1850">
                  <c:v>4.118479166666666</c:v>
                </c:pt>
                <c:pt idx="1851">
                  <c:v>4.1190069444444442</c:v>
                </c:pt>
                <c:pt idx="1852">
                  <c:v>4.1195347222222223</c:v>
                </c:pt>
                <c:pt idx="1853">
                  <c:v>4.1200625000000004</c:v>
                </c:pt>
                <c:pt idx="1854">
                  <c:v>4.1205902777777776</c:v>
                </c:pt>
                <c:pt idx="1855">
                  <c:v>4.1211250000000001</c:v>
                </c:pt>
                <c:pt idx="1856">
                  <c:v>4.1216527777777783</c:v>
                </c:pt>
                <c:pt idx="1857">
                  <c:v>4.1221805555555555</c:v>
                </c:pt>
                <c:pt idx="1858">
                  <c:v>4.1227083333333336</c:v>
                </c:pt>
                <c:pt idx="1859">
                  <c:v>4.1232361111111109</c:v>
                </c:pt>
                <c:pt idx="1860">
                  <c:v>4.1239861111111109</c:v>
                </c:pt>
                <c:pt idx="1861">
                  <c:v>4.1247361111111109</c:v>
                </c:pt>
                <c:pt idx="1862">
                  <c:v>4.125486111111111</c:v>
                </c:pt>
                <c:pt idx="1863">
                  <c:v>4.126236111111111</c:v>
                </c:pt>
                <c:pt idx="1864">
                  <c:v>4.1269791666666666</c:v>
                </c:pt>
                <c:pt idx="1865">
                  <c:v>4.1278750000000004</c:v>
                </c:pt>
                <c:pt idx="1866">
                  <c:v>4.1287638888888889</c:v>
                </c:pt>
                <c:pt idx="1867">
                  <c:v>4.1296597222222227</c:v>
                </c:pt>
                <c:pt idx="1868">
                  <c:v>4.1305486111111112</c:v>
                </c:pt>
                <c:pt idx="1869">
                  <c:v>4.131444444444444</c:v>
                </c:pt>
                <c:pt idx="1870">
                  <c:v>4.1323333333333334</c:v>
                </c:pt>
                <c:pt idx="1871">
                  <c:v>4.1335347222222225</c:v>
                </c:pt>
                <c:pt idx="1872">
                  <c:v>4.1347361111111116</c:v>
                </c:pt>
                <c:pt idx="1873">
                  <c:v>4.1359444444444442</c:v>
                </c:pt>
                <c:pt idx="1874">
                  <c:v>4.1371458333333333</c:v>
                </c:pt>
                <c:pt idx="1875">
                  <c:v>4.1383472222222224</c:v>
                </c:pt>
                <c:pt idx="1876">
                  <c:v>4.1395486111111106</c:v>
                </c:pt>
                <c:pt idx="1877">
                  <c:v>4.1409652777777772</c:v>
                </c:pt>
                <c:pt idx="1878">
                  <c:v>4.1423750000000004</c:v>
                </c:pt>
                <c:pt idx="1879">
                  <c:v>4.143791666666667</c:v>
                </c:pt>
                <c:pt idx="1880">
                  <c:v>4.1452083333333336</c:v>
                </c:pt>
                <c:pt idx="1881">
                  <c:v>4.1466180555555558</c:v>
                </c:pt>
                <c:pt idx="1882">
                  <c:v>4.1480347222222225</c:v>
                </c:pt>
                <c:pt idx="1883">
                  <c:v>4.1494444444444447</c:v>
                </c:pt>
                <c:pt idx="1884">
                  <c:v>4.1508611111111113</c:v>
                </c:pt>
                <c:pt idx="1885">
                  <c:v>4.1522708333333336</c:v>
                </c:pt>
                <c:pt idx="1886">
                  <c:v>4.1536875000000002</c:v>
                </c:pt>
                <c:pt idx="1887">
                  <c:v>4.1538958333333333</c:v>
                </c:pt>
                <c:pt idx="1888">
                  <c:v>4.1541111111111109</c:v>
                </c:pt>
                <c:pt idx="1889">
                  <c:v>4.1543194444444449</c:v>
                </c:pt>
                <c:pt idx="1890">
                  <c:v>4.154527777777778</c:v>
                </c:pt>
                <c:pt idx="1891">
                  <c:v>4.1547430555555556</c:v>
                </c:pt>
                <c:pt idx="1892">
                  <c:v>4.1550347222222221</c:v>
                </c:pt>
                <c:pt idx="1893">
                  <c:v>4.1553263888888887</c:v>
                </c:pt>
                <c:pt idx="1894">
                  <c:v>4.1556250000000006</c:v>
                </c:pt>
                <c:pt idx="1895">
                  <c:v>4.1559166666666671</c:v>
                </c:pt>
                <c:pt idx="1896">
                  <c:v>4.1562152777777772</c:v>
                </c:pt>
                <c:pt idx="1897">
                  <c:v>4.1569027777777778</c:v>
                </c:pt>
                <c:pt idx="1898">
                  <c:v>4.1575902777777776</c:v>
                </c:pt>
                <c:pt idx="1899">
                  <c:v>4.1582847222222226</c:v>
                </c:pt>
                <c:pt idx="1900">
                  <c:v>4.1589722222222223</c:v>
                </c:pt>
                <c:pt idx="1901">
                  <c:v>4.1596666666666664</c:v>
                </c:pt>
                <c:pt idx="1902">
                  <c:v>4.1610972222222218</c:v>
                </c:pt>
                <c:pt idx="1903">
                  <c:v>4.162527777777778</c:v>
                </c:pt>
                <c:pt idx="1904">
                  <c:v>4.1639583333333334</c:v>
                </c:pt>
                <c:pt idx="1905">
                  <c:v>4.1653888888888888</c:v>
                </c:pt>
                <c:pt idx="1906">
                  <c:v>4.1668194444444442</c:v>
                </c:pt>
                <c:pt idx="1907">
                  <c:v>4.1682499999999996</c:v>
                </c:pt>
                <c:pt idx="1908">
                  <c:v>4.1706736111111118</c:v>
                </c:pt>
                <c:pt idx="1909">
                  <c:v>4.1730972222222222</c:v>
                </c:pt>
                <c:pt idx="1910">
                  <c:v>4.1755208333333336</c:v>
                </c:pt>
                <c:pt idx="1911">
                  <c:v>4.177944444444444</c:v>
                </c:pt>
                <c:pt idx="1912">
                  <c:v>4.1803680555555554</c:v>
                </c:pt>
                <c:pt idx="1913">
                  <c:v>4.1827916666666667</c:v>
                </c:pt>
                <c:pt idx="1914">
                  <c:v>4.185215277777778</c:v>
                </c:pt>
                <c:pt idx="1915">
                  <c:v>4.1876388888888885</c:v>
                </c:pt>
                <c:pt idx="1916">
                  <c:v>4.1900624999999998</c:v>
                </c:pt>
                <c:pt idx="1917">
                  <c:v>4.1924861111111111</c:v>
                </c:pt>
                <c:pt idx="1918">
                  <c:v>4.1949097222222225</c:v>
                </c:pt>
                <c:pt idx="1919">
                  <c:v>4.1973333333333329</c:v>
                </c:pt>
                <c:pt idx="1920">
                  <c:v>4.2001249999999999</c:v>
                </c:pt>
                <c:pt idx="1921">
                  <c:v>4.2029166666666669</c:v>
                </c:pt>
                <c:pt idx="1922">
                  <c:v>4.2057083333333338</c:v>
                </c:pt>
                <c:pt idx="1923">
                  <c:v>4.2084999999999999</c:v>
                </c:pt>
                <c:pt idx="1924">
                  <c:v>4.2112916666666669</c:v>
                </c:pt>
                <c:pt idx="1925">
                  <c:v>4.214083333333333</c:v>
                </c:pt>
                <c:pt idx="1926">
                  <c:v>4.2174375</c:v>
                </c:pt>
                <c:pt idx="1927">
                  <c:v>4.2207916666666661</c:v>
                </c:pt>
                <c:pt idx="1928">
                  <c:v>4.2241458333333339</c:v>
                </c:pt>
                <c:pt idx="1929">
                  <c:v>4.2275069444444444</c:v>
                </c:pt>
                <c:pt idx="1930">
                  <c:v>4.2308611111111105</c:v>
                </c:pt>
                <c:pt idx="1931">
                  <c:v>4.2342152777777784</c:v>
                </c:pt>
                <c:pt idx="1932">
                  <c:v>4.2383958333333336</c:v>
                </c:pt>
                <c:pt idx="1933">
                  <c:v>4.2425833333333332</c:v>
                </c:pt>
                <c:pt idx="1934">
                  <c:v>4.2467638888888892</c:v>
                </c:pt>
                <c:pt idx="1935">
                  <c:v>4.2509513888888888</c:v>
                </c:pt>
                <c:pt idx="1936">
                  <c:v>4.2551319444444449</c:v>
                </c:pt>
                <c:pt idx="1937">
                  <c:v>4.2593125000000001</c:v>
                </c:pt>
                <c:pt idx="1938">
                  <c:v>4.264576388888889</c:v>
                </c:pt>
                <c:pt idx="1939">
                  <c:v>4.269840277777778</c:v>
                </c:pt>
                <c:pt idx="1940">
                  <c:v>4.2750972222222225</c:v>
                </c:pt>
                <c:pt idx="1941">
                  <c:v>4.2803611111111115</c:v>
                </c:pt>
                <c:pt idx="1942">
                  <c:v>4.2856180555555552</c:v>
                </c:pt>
                <c:pt idx="1943">
                  <c:v>4.2908819444444442</c:v>
                </c:pt>
                <c:pt idx="1944">
                  <c:v>4.2976736111111107</c:v>
                </c:pt>
                <c:pt idx="1945">
                  <c:v>4.3044652777777781</c:v>
                </c:pt>
                <c:pt idx="1946">
                  <c:v>4.3112569444444446</c:v>
                </c:pt>
                <c:pt idx="1947">
                  <c:v>4.3180486111111112</c:v>
                </c:pt>
                <c:pt idx="1948">
                  <c:v>4.3248402777777777</c:v>
                </c:pt>
                <c:pt idx="1949">
                  <c:v>4.3316319444444442</c:v>
                </c:pt>
                <c:pt idx="1950">
                  <c:v>4.339479166666667</c:v>
                </c:pt>
                <c:pt idx="1951">
                  <c:v>4.3473194444444445</c:v>
                </c:pt>
                <c:pt idx="1952">
                  <c:v>4.3551666666666664</c:v>
                </c:pt>
                <c:pt idx="1953">
                  <c:v>4.3630069444444439</c:v>
                </c:pt>
                <c:pt idx="1954">
                  <c:v>4.3708541666666667</c:v>
                </c:pt>
                <c:pt idx="1955">
                  <c:v>4.3786944444444442</c:v>
                </c:pt>
                <c:pt idx="1956">
                  <c:v>4.3865347222222217</c:v>
                </c:pt>
                <c:pt idx="1957">
                  <c:v>4.3943819444444445</c:v>
                </c:pt>
                <c:pt idx="1958">
                  <c:v>4.402222222222222</c:v>
                </c:pt>
                <c:pt idx="1959">
                  <c:v>4.4100694444444448</c:v>
                </c:pt>
                <c:pt idx="1960">
                  <c:v>4.4179097222222223</c:v>
                </c:pt>
                <c:pt idx="1961">
                  <c:v>4.4257569444444442</c:v>
                </c:pt>
                <c:pt idx="1962">
                  <c:v>4.4335972222222226</c:v>
                </c:pt>
                <c:pt idx="1963">
                  <c:v>4.4414444444444445</c:v>
                </c:pt>
                <c:pt idx="1964">
                  <c:v>4.449284722222222</c:v>
                </c:pt>
                <c:pt idx="1965">
                  <c:v>4.4571250000000004</c:v>
                </c:pt>
                <c:pt idx="1966">
                  <c:v>4.4649722222222223</c:v>
                </c:pt>
                <c:pt idx="1967">
                  <c:v>4.4728124999999999</c:v>
                </c:pt>
                <c:pt idx="1968">
                  <c:v>4.4806597222222218</c:v>
                </c:pt>
                <c:pt idx="1969">
                  <c:v>4.4885000000000002</c:v>
                </c:pt>
                <c:pt idx="1970">
                  <c:v>4.4963472222222221</c:v>
                </c:pt>
                <c:pt idx="1971">
                  <c:v>4.5041874999999996</c:v>
                </c:pt>
                <c:pt idx="1972">
                  <c:v>4.512027777777778</c:v>
                </c:pt>
                <c:pt idx="1973">
                  <c:v>4.5198749999999999</c:v>
                </c:pt>
                <c:pt idx="1974">
                  <c:v>4.5277152777777774</c:v>
                </c:pt>
                <c:pt idx="1975">
                  <c:v>4.5355625000000002</c:v>
                </c:pt>
                <c:pt idx="1976">
                  <c:v>4.5434027777777777</c:v>
                </c:pt>
                <c:pt idx="1977">
                  <c:v>4.5512500000000005</c:v>
                </c:pt>
                <c:pt idx="1978">
                  <c:v>4.559090277777778</c:v>
                </c:pt>
                <c:pt idx="1979">
                  <c:v>4.5669305555555555</c:v>
                </c:pt>
                <c:pt idx="1980">
                  <c:v>4.5747777777777783</c:v>
                </c:pt>
                <c:pt idx="1981">
                  <c:v>4.5826180555555558</c:v>
                </c:pt>
                <c:pt idx="1982">
                  <c:v>4.5904652777777777</c:v>
                </c:pt>
                <c:pt idx="1983">
                  <c:v>4.5983055555555561</c:v>
                </c:pt>
                <c:pt idx="1984">
                  <c:v>4.606152777777778</c:v>
                </c:pt>
                <c:pt idx="1985">
                  <c:v>4.6139930555555555</c:v>
                </c:pt>
                <c:pt idx="1986">
                  <c:v>4.621833333333333</c:v>
                </c:pt>
                <c:pt idx="1987">
                  <c:v>4.6296805555555558</c:v>
                </c:pt>
                <c:pt idx="1988">
                  <c:v>4.6375208333333333</c:v>
                </c:pt>
                <c:pt idx="1989">
                  <c:v>4.6453680555555552</c:v>
                </c:pt>
                <c:pt idx="1990">
                  <c:v>4.6532083333333336</c:v>
                </c:pt>
                <c:pt idx="1991">
                  <c:v>4.6610555555555555</c:v>
                </c:pt>
                <c:pt idx="1992">
                  <c:v>4.668895833333333</c:v>
                </c:pt>
                <c:pt idx="1993">
                  <c:v>4.6767430555555558</c:v>
                </c:pt>
                <c:pt idx="1994">
                  <c:v>4.6845833333333333</c:v>
                </c:pt>
                <c:pt idx="1995">
                  <c:v>4.6924236111111108</c:v>
                </c:pt>
                <c:pt idx="1996">
                  <c:v>4.7002708333333336</c:v>
                </c:pt>
                <c:pt idx="1997">
                  <c:v>4.7081111111111111</c:v>
                </c:pt>
                <c:pt idx="1998">
                  <c:v>4.715958333333333</c:v>
                </c:pt>
                <c:pt idx="1999">
                  <c:v>4.7237986111111114</c:v>
                </c:pt>
                <c:pt idx="2000">
                  <c:v>4.7316458333333333</c:v>
                </c:pt>
                <c:pt idx="2001">
                  <c:v>4.7394861111111108</c:v>
                </c:pt>
                <c:pt idx="2002">
                  <c:v>4.7473263888888884</c:v>
                </c:pt>
                <c:pt idx="2003">
                  <c:v>4.7551736111111111</c:v>
                </c:pt>
                <c:pt idx="2004">
                  <c:v>4.7630138888888887</c:v>
                </c:pt>
                <c:pt idx="2005">
                  <c:v>4.7708611111111114</c:v>
                </c:pt>
                <c:pt idx="2006">
                  <c:v>4.778701388888889</c:v>
                </c:pt>
                <c:pt idx="2007">
                  <c:v>4.7865486111111109</c:v>
                </c:pt>
                <c:pt idx="2008">
                  <c:v>4.7943888888888893</c:v>
                </c:pt>
                <c:pt idx="2009">
                  <c:v>4.8022291666666668</c:v>
                </c:pt>
                <c:pt idx="2010">
                  <c:v>4.8100763888888887</c:v>
                </c:pt>
                <c:pt idx="2011">
                  <c:v>4.8179166666666671</c:v>
                </c:pt>
                <c:pt idx="2012">
                  <c:v>4.825763888888889</c:v>
                </c:pt>
                <c:pt idx="2013">
                  <c:v>4.8336041666666665</c:v>
                </c:pt>
                <c:pt idx="2014">
                  <c:v>4.8414513888888884</c:v>
                </c:pt>
                <c:pt idx="2015">
                  <c:v>4.8492916666666668</c:v>
                </c:pt>
                <c:pt idx="2016">
                  <c:v>4.8571388888888887</c:v>
                </c:pt>
                <c:pt idx="2017">
                  <c:v>4.8649791666666662</c:v>
                </c:pt>
                <c:pt idx="2018">
                  <c:v>4.8728194444444446</c:v>
                </c:pt>
                <c:pt idx="2019">
                  <c:v>4.8806666666666665</c:v>
                </c:pt>
                <c:pt idx="2020">
                  <c:v>4.888506944444444</c:v>
                </c:pt>
                <c:pt idx="2021">
                  <c:v>4.8963541666666668</c:v>
                </c:pt>
                <c:pt idx="2022">
                  <c:v>4.9041944444444443</c:v>
                </c:pt>
                <c:pt idx="2023">
                  <c:v>4.9120416666666671</c:v>
                </c:pt>
                <c:pt idx="2024">
                  <c:v>4.9198819444444446</c:v>
                </c:pt>
                <c:pt idx="2025">
                  <c:v>4.9277222222222221</c:v>
                </c:pt>
                <c:pt idx="2026">
                  <c:v>4.9355694444444449</c:v>
                </c:pt>
                <c:pt idx="2027">
                  <c:v>4.9434097222222224</c:v>
                </c:pt>
                <c:pt idx="2028">
                  <c:v>4.9512569444444443</c:v>
                </c:pt>
                <c:pt idx="2029">
                  <c:v>4.9590972222222227</c:v>
                </c:pt>
                <c:pt idx="2030">
                  <c:v>4.9669444444444446</c:v>
                </c:pt>
                <c:pt idx="2031">
                  <c:v>4.9747847222222221</c:v>
                </c:pt>
                <c:pt idx="2032">
                  <c:v>4.9826249999999996</c:v>
                </c:pt>
                <c:pt idx="2033">
                  <c:v>4.9904722222222224</c:v>
                </c:pt>
                <c:pt idx="2034">
                  <c:v>4.9983124999999999</c:v>
                </c:pt>
                <c:pt idx="2035">
                  <c:v>5</c:v>
                </c:pt>
              </c:numCache>
            </c:numRef>
          </c:xVal>
          <c:yVal>
            <c:numRef>
              <c:f>Sheet1!$F$4:$F$2039</c:f>
              <c:numCache>
                <c:formatCode>0.00E+00</c:formatCode>
                <c:ptCount val="2036"/>
                <c:pt idx="0">
                  <c:v>9.9999999999999995E-7</c:v>
                </c:pt>
                <c:pt idx="1">
                  <c:v>9.9999999999999995E-7</c:v>
                </c:pt>
                <c:pt idx="2">
                  <c:v>9.9999999999999995E-7</c:v>
                </c:pt>
                <c:pt idx="3">
                  <c:v>9.9999999999999995E-7</c:v>
                </c:pt>
                <c:pt idx="4">
                  <c:v>9.9999999999999995E-7</c:v>
                </c:pt>
                <c:pt idx="5">
                  <c:v>9.9999999999999995E-7</c:v>
                </c:pt>
                <c:pt idx="6">
                  <c:v>9.9999999999999995E-7</c:v>
                </c:pt>
                <c:pt idx="7">
                  <c:v>9.9999999999999995E-7</c:v>
                </c:pt>
                <c:pt idx="8">
                  <c:v>9.9999999999999995E-7</c:v>
                </c:pt>
                <c:pt idx="9">
                  <c:v>9.9999999999999995E-7</c:v>
                </c:pt>
                <c:pt idx="10">
                  <c:v>1.00001E-6</c:v>
                </c:pt>
                <c:pt idx="11">
                  <c:v>1.00001E-6</c:v>
                </c:pt>
                <c:pt idx="12">
                  <c:v>1.0000200000000001E-6</c:v>
                </c:pt>
                <c:pt idx="13">
                  <c:v>1.0000200000000001E-6</c:v>
                </c:pt>
                <c:pt idx="14">
                  <c:v>1.0000500000000001E-6</c:v>
                </c:pt>
                <c:pt idx="15">
                  <c:v>1.00008E-6</c:v>
                </c:pt>
                <c:pt idx="16">
                  <c:v>1.00011E-6</c:v>
                </c:pt>
                <c:pt idx="17">
                  <c:v>1.0001599999999999E-6</c:v>
                </c:pt>
                <c:pt idx="18">
                  <c:v>1.0002200000000001E-6</c:v>
                </c:pt>
                <c:pt idx="19">
                  <c:v>1.0002800000000001E-6</c:v>
                </c:pt>
                <c:pt idx="20">
                  <c:v>1.0003599999999999E-6</c:v>
                </c:pt>
                <c:pt idx="21">
                  <c:v>1.0004500000000001E-6</c:v>
                </c:pt>
                <c:pt idx="22">
                  <c:v>1.00053E-6</c:v>
                </c:pt>
                <c:pt idx="23">
                  <c:v>1.0006E-6</c:v>
                </c:pt>
                <c:pt idx="24">
                  <c:v>1.0006800000000001E-6</c:v>
                </c:pt>
                <c:pt idx="25">
                  <c:v>1.0007499999999999E-6</c:v>
                </c:pt>
                <c:pt idx="26">
                  <c:v>1.00079E-6</c:v>
                </c:pt>
                <c:pt idx="27">
                  <c:v>1.0008199999999999E-6</c:v>
                </c:pt>
                <c:pt idx="28">
                  <c:v>1.0008499999999999E-6</c:v>
                </c:pt>
                <c:pt idx="29">
                  <c:v>1.0008800000000001E-6</c:v>
                </c:pt>
                <c:pt idx="30">
                  <c:v>1.0009100000000001E-6</c:v>
                </c:pt>
                <c:pt idx="31">
                  <c:v>1.0009400000000001E-6</c:v>
                </c:pt>
                <c:pt idx="32">
                  <c:v>1.0009799999999999E-6</c:v>
                </c:pt>
                <c:pt idx="33">
                  <c:v>1.00103E-6</c:v>
                </c:pt>
                <c:pt idx="34">
                  <c:v>1.0010700000000001E-6</c:v>
                </c:pt>
                <c:pt idx="35">
                  <c:v>1.0013400000000001E-6</c:v>
                </c:pt>
                <c:pt idx="36">
                  <c:v>1.0014099999999999E-6</c:v>
                </c:pt>
                <c:pt idx="37">
                  <c:v>1.0014799999999999E-6</c:v>
                </c:pt>
                <c:pt idx="38">
                  <c:v>1.00155E-6</c:v>
                </c:pt>
                <c:pt idx="39">
                  <c:v>1.00162E-6</c:v>
                </c:pt>
                <c:pt idx="40">
                  <c:v>1.00165E-6</c:v>
                </c:pt>
                <c:pt idx="41">
                  <c:v>1.00168E-6</c:v>
                </c:pt>
                <c:pt idx="42">
                  <c:v>1.0017099999999999E-6</c:v>
                </c:pt>
                <c:pt idx="43">
                  <c:v>1.0017399999999999E-6</c:v>
                </c:pt>
                <c:pt idx="44">
                  <c:v>1.00176E-6</c:v>
                </c:pt>
                <c:pt idx="45">
                  <c:v>1.00179E-6</c:v>
                </c:pt>
                <c:pt idx="46">
                  <c:v>1.0018399999999999E-6</c:v>
                </c:pt>
                <c:pt idx="47">
                  <c:v>1.00189E-6</c:v>
                </c:pt>
                <c:pt idx="48">
                  <c:v>1.0019399999999999E-6</c:v>
                </c:pt>
                <c:pt idx="49">
                  <c:v>1.0022900000000001E-6</c:v>
                </c:pt>
                <c:pt idx="50">
                  <c:v>1.00238E-6</c:v>
                </c:pt>
                <c:pt idx="51">
                  <c:v>1.0025600000000001E-6</c:v>
                </c:pt>
                <c:pt idx="52">
                  <c:v>1.00274E-6</c:v>
                </c:pt>
                <c:pt idx="53">
                  <c:v>1.0029200000000001E-6</c:v>
                </c:pt>
                <c:pt idx="54">
                  <c:v>1.0031E-6</c:v>
                </c:pt>
                <c:pt idx="55">
                  <c:v>1.0035499999999999E-6</c:v>
                </c:pt>
                <c:pt idx="56">
                  <c:v>1.0040099999999999E-6</c:v>
                </c:pt>
                <c:pt idx="57">
                  <c:v>1.00446E-6</c:v>
                </c:pt>
                <c:pt idx="58">
                  <c:v>1.00492E-6</c:v>
                </c:pt>
                <c:pt idx="59">
                  <c:v>1.00554E-6</c:v>
                </c:pt>
                <c:pt idx="60">
                  <c:v>1.00616E-6</c:v>
                </c:pt>
                <c:pt idx="61">
                  <c:v>1.0067799999999999E-6</c:v>
                </c:pt>
                <c:pt idx="62">
                  <c:v>1.0074000000000001E-6</c:v>
                </c:pt>
                <c:pt idx="63">
                  <c:v>1.00854E-6</c:v>
                </c:pt>
                <c:pt idx="64">
                  <c:v>1.0096799999999999E-6</c:v>
                </c:pt>
                <c:pt idx="65">
                  <c:v>1.01082E-6</c:v>
                </c:pt>
                <c:pt idx="66">
                  <c:v>1.01197E-6</c:v>
                </c:pt>
                <c:pt idx="67">
                  <c:v>1.01312E-6</c:v>
                </c:pt>
                <c:pt idx="68">
                  <c:v>1.0145599999999999E-6</c:v>
                </c:pt>
                <c:pt idx="69">
                  <c:v>1.01601E-6</c:v>
                </c:pt>
                <c:pt idx="70">
                  <c:v>1.01746E-6</c:v>
                </c:pt>
                <c:pt idx="71">
                  <c:v>1.01891E-6</c:v>
                </c:pt>
                <c:pt idx="72">
                  <c:v>1.02037E-6</c:v>
                </c:pt>
                <c:pt idx="73">
                  <c:v>1.02268E-6</c:v>
                </c:pt>
                <c:pt idx="74">
                  <c:v>1.0249999999999999E-6</c:v>
                </c:pt>
                <c:pt idx="75">
                  <c:v>1.0273300000000001E-6</c:v>
                </c:pt>
                <c:pt idx="76">
                  <c:v>1.0296799999999999E-6</c:v>
                </c:pt>
                <c:pt idx="77">
                  <c:v>1.0320400000000001E-6</c:v>
                </c:pt>
                <c:pt idx="78">
                  <c:v>1.0344199999999999E-6</c:v>
                </c:pt>
                <c:pt idx="79">
                  <c:v>1.03819E-6</c:v>
                </c:pt>
                <c:pt idx="80">
                  <c:v>1.0419999999999999E-6</c:v>
                </c:pt>
                <c:pt idx="81">
                  <c:v>1.0458400000000001E-6</c:v>
                </c:pt>
                <c:pt idx="82">
                  <c:v>1.04972E-6</c:v>
                </c:pt>
                <c:pt idx="83">
                  <c:v>1.0536299999999999E-6</c:v>
                </c:pt>
                <c:pt idx="84">
                  <c:v>1.0575799999999999E-6</c:v>
                </c:pt>
                <c:pt idx="85">
                  <c:v>1.0620299999999999E-6</c:v>
                </c:pt>
                <c:pt idx="86">
                  <c:v>1.06652E-6</c:v>
                </c:pt>
                <c:pt idx="87">
                  <c:v>1.0710500000000001E-6</c:v>
                </c:pt>
                <c:pt idx="88">
                  <c:v>1.0756299999999999E-6</c:v>
                </c:pt>
                <c:pt idx="89">
                  <c:v>1.0802499999999999E-6</c:v>
                </c:pt>
                <c:pt idx="90">
                  <c:v>1.0849199999999999E-6</c:v>
                </c:pt>
                <c:pt idx="91">
                  <c:v>1.09027E-6</c:v>
                </c:pt>
                <c:pt idx="92">
                  <c:v>1.09567E-6</c:v>
                </c:pt>
                <c:pt idx="93">
                  <c:v>1.10114E-6</c:v>
                </c:pt>
                <c:pt idx="94">
                  <c:v>1.1066600000000001E-6</c:v>
                </c:pt>
                <c:pt idx="95">
                  <c:v>1.11225E-6</c:v>
                </c:pt>
                <c:pt idx="96">
                  <c:v>1.1178900000000001E-6</c:v>
                </c:pt>
                <c:pt idx="97">
                  <c:v>1.1187899999999999E-6</c:v>
                </c:pt>
                <c:pt idx="98">
                  <c:v>1.1197000000000001E-6</c:v>
                </c:pt>
                <c:pt idx="99">
                  <c:v>1.12061E-6</c:v>
                </c:pt>
                <c:pt idx="100">
                  <c:v>1.12151E-6</c:v>
                </c:pt>
                <c:pt idx="101">
                  <c:v>1.12242E-6</c:v>
                </c:pt>
                <c:pt idx="102">
                  <c:v>1.12398E-6</c:v>
                </c:pt>
                <c:pt idx="103">
                  <c:v>1.12553E-6</c:v>
                </c:pt>
                <c:pt idx="104">
                  <c:v>1.1270899999999999E-6</c:v>
                </c:pt>
                <c:pt idx="105">
                  <c:v>1.12865E-6</c:v>
                </c:pt>
                <c:pt idx="106">
                  <c:v>1.1302199999999999E-6</c:v>
                </c:pt>
                <c:pt idx="107">
                  <c:v>1.1334E-6</c:v>
                </c:pt>
                <c:pt idx="108">
                  <c:v>1.1366099999999999E-6</c:v>
                </c:pt>
                <c:pt idx="109">
                  <c:v>1.1398300000000001E-6</c:v>
                </c:pt>
                <c:pt idx="110">
                  <c:v>1.1430699999999999E-6</c:v>
                </c:pt>
                <c:pt idx="111">
                  <c:v>1.1463299999999999E-6</c:v>
                </c:pt>
                <c:pt idx="112">
                  <c:v>1.1527100000000001E-6</c:v>
                </c:pt>
                <c:pt idx="113">
                  <c:v>1.15916E-6</c:v>
                </c:pt>
                <c:pt idx="114">
                  <c:v>1.1656900000000001E-6</c:v>
                </c:pt>
                <c:pt idx="115">
                  <c:v>1.1722800000000001E-6</c:v>
                </c:pt>
                <c:pt idx="116">
                  <c:v>1.17895E-6</c:v>
                </c:pt>
                <c:pt idx="117">
                  <c:v>1.18693E-6</c:v>
                </c:pt>
                <c:pt idx="118">
                  <c:v>1.1950100000000001E-6</c:v>
                </c:pt>
                <c:pt idx="119">
                  <c:v>1.2031899999999999E-6</c:v>
                </c:pt>
                <c:pt idx="120">
                  <c:v>1.21147E-6</c:v>
                </c:pt>
                <c:pt idx="121">
                  <c:v>1.2198599999999999E-6</c:v>
                </c:pt>
                <c:pt idx="122">
                  <c:v>1.2283599999999999E-6</c:v>
                </c:pt>
                <c:pt idx="123">
                  <c:v>1.2419999999999999E-6</c:v>
                </c:pt>
                <c:pt idx="124">
                  <c:v>1.25591E-6</c:v>
                </c:pt>
                <c:pt idx="125">
                  <c:v>1.2700900000000001E-6</c:v>
                </c:pt>
                <c:pt idx="126">
                  <c:v>1.28454E-6</c:v>
                </c:pt>
                <c:pt idx="127">
                  <c:v>1.2992800000000001E-6</c:v>
                </c:pt>
                <c:pt idx="128">
                  <c:v>1.31429E-6</c:v>
                </c:pt>
                <c:pt idx="129">
                  <c:v>1.3383500000000001E-6</c:v>
                </c:pt>
                <c:pt idx="130">
                  <c:v>1.36312E-6</c:v>
                </c:pt>
                <c:pt idx="131">
                  <c:v>1.3886200000000001E-6</c:v>
                </c:pt>
                <c:pt idx="132">
                  <c:v>1.41487E-6</c:v>
                </c:pt>
                <c:pt idx="133">
                  <c:v>1.44188E-6</c:v>
                </c:pt>
                <c:pt idx="134">
                  <c:v>1.4696699999999999E-6</c:v>
                </c:pt>
                <c:pt idx="135">
                  <c:v>1.5132200000000001E-6</c:v>
                </c:pt>
                <c:pt idx="136">
                  <c:v>1.5586500000000001E-6</c:v>
                </c:pt>
                <c:pt idx="137">
                  <c:v>1.6060500000000001E-6</c:v>
                </c:pt>
                <c:pt idx="138">
                  <c:v>1.6554700000000001E-6</c:v>
                </c:pt>
                <c:pt idx="139">
                  <c:v>1.7069900000000001E-6</c:v>
                </c:pt>
                <c:pt idx="140">
                  <c:v>1.7606900000000001E-6</c:v>
                </c:pt>
                <c:pt idx="141">
                  <c:v>1.8375500000000001E-6</c:v>
                </c:pt>
                <c:pt idx="142">
                  <c:v>1.9188300000000001E-6</c:v>
                </c:pt>
                <c:pt idx="143">
                  <c:v>2.0047500000000002E-6</c:v>
                </c:pt>
                <c:pt idx="144">
                  <c:v>2.0955399999999999E-6</c:v>
                </c:pt>
                <c:pt idx="145">
                  <c:v>2.1914700000000001E-6</c:v>
                </c:pt>
                <c:pt idx="146">
                  <c:v>2.2928100000000002E-6</c:v>
                </c:pt>
                <c:pt idx="147">
                  <c:v>2.4310600000000001E-6</c:v>
                </c:pt>
                <c:pt idx="148">
                  <c:v>2.5792900000000002E-6</c:v>
                </c:pt>
                <c:pt idx="149">
                  <c:v>2.73819E-6</c:v>
                </c:pt>
                <c:pt idx="150">
                  <c:v>2.9084800000000001E-6</c:v>
                </c:pt>
                <c:pt idx="151">
                  <c:v>3.09095E-6</c:v>
                </c:pt>
                <c:pt idx="152">
                  <c:v>3.2864500000000001E-6</c:v>
                </c:pt>
                <c:pt idx="153">
                  <c:v>3.5849799999999999E-6</c:v>
                </c:pt>
                <c:pt idx="154">
                  <c:v>3.9137399999999997E-6</c:v>
                </c:pt>
                <c:pt idx="155">
                  <c:v>4.27573E-6</c:v>
                </c:pt>
                <c:pt idx="156">
                  <c:v>4.6742500000000002E-6</c:v>
                </c:pt>
                <c:pt idx="157">
                  <c:v>5.1129200000000003E-6</c:v>
                </c:pt>
                <c:pt idx="158">
                  <c:v>5.5957399999999999E-6</c:v>
                </c:pt>
                <c:pt idx="159">
                  <c:v>6.2573500000000003E-6</c:v>
                </c:pt>
                <c:pt idx="160">
                  <c:v>7.0017000000000002E-6</c:v>
                </c:pt>
                <c:pt idx="161">
                  <c:v>7.8390700000000005E-6</c:v>
                </c:pt>
                <c:pt idx="162">
                  <c:v>8.7809999999999994E-6</c:v>
                </c:pt>
                <c:pt idx="163">
                  <c:v>9.8405000000000001E-6</c:v>
                </c:pt>
                <c:pt idx="164">
                  <c:v>1.1032199999999999E-5</c:v>
                </c:pt>
                <c:pt idx="165">
                  <c:v>1.23724E-5</c:v>
                </c:pt>
                <c:pt idx="166">
                  <c:v>1.3879800000000001E-5</c:v>
                </c:pt>
                <c:pt idx="167">
                  <c:v>1.5574999999999999E-5</c:v>
                </c:pt>
                <c:pt idx="168">
                  <c:v>1.7481499999999999E-5</c:v>
                </c:pt>
                <c:pt idx="169">
                  <c:v>1.9145899999999999E-5</c:v>
                </c:pt>
                <c:pt idx="170">
                  <c:v>1.9411399999999998E-5</c:v>
                </c:pt>
                <c:pt idx="171">
                  <c:v>1.9680699999999999E-5</c:v>
                </c:pt>
                <c:pt idx="172">
                  <c:v>1.9953799999999999E-5</c:v>
                </c:pt>
                <c:pt idx="173">
                  <c:v>2.0230699999999999E-5</c:v>
                </c:pt>
                <c:pt idx="174">
                  <c:v>2.0511599999999999E-5</c:v>
                </c:pt>
                <c:pt idx="175">
                  <c:v>2.1085099999999999E-5</c:v>
                </c:pt>
                <c:pt idx="176">
                  <c:v>2.1675000000000002E-5</c:v>
                </c:pt>
                <c:pt idx="177">
                  <c:v>2.22815E-5</c:v>
                </c:pt>
                <c:pt idx="178">
                  <c:v>2.2905199999999999E-5</c:v>
                </c:pt>
                <c:pt idx="179">
                  <c:v>2.3934099999999998E-5</c:v>
                </c:pt>
                <c:pt idx="180">
                  <c:v>2.5009799999999999E-5</c:v>
                </c:pt>
                <c:pt idx="181">
                  <c:v>2.6134399999999998E-5</c:v>
                </c:pt>
                <c:pt idx="182">
                  <c:v>2.7310100000000001E-5</c:v>
                </c:pt>
                <c:pt idx="183">
                  <c:v>2.8539199999999999E-5</c:v>
                </c:pt>
                <c:pt idx="184">
                  <c:v>3.1098800000000001E-5</c:v>
                </c:pt>
                <c:pt idx="185">
                  <c:v>3.3890100000000003E-5</c:v>
                </c:pt>
                <c:pt idx="186">
                  <c:v>3.6933900000000002E-5</c:v>
                </c:pt>
                <c:pt idx="187">
                  <c:v>4.0253300000000003E-5</c:v>
                </c:pt>
                <c:pt idx="188">
                  <c:v>4.3872999999999998E-5</c:v>
                </c:pt>
                <c:pt idx="189">
                  <c:v>4.7986599999999999E-5</c:v>
                </c:pt>
                <c:pt idx="190">
                  <c:v>5.2488100000000003E-5</c:v>
                </c:pt>
                <c:pt idx="191">
                  <c:v>5.7414000000000003E-5</c:v>
                </c:pt>
                <c:pt idx="192">
                  <c:v>6.2804499999999998E-5</c:v>
                </c:pt>
                <c:pt idx="193">
                  <c:v>6.8703199999999996E-5</c:v>
                </c:pt>
                <c:pt idx="194">
                  <c:v>7.5158200000000002E-5</c:v>
                </c:pt>
                <c:pt idx="195">
                  <c:v>8.3330499999999998E-5</c:v>
                </c:pt>
                <c:pt idx="196">
                  <c:v>9.2394300000000004E-5</c:v>
                </c:pt>
                <c:pt idx="197" formatCode="General">
                  <c:v>1.02447E-4</c:v>
                </c:pt>
                <c:pt idx="198" formatCode="General">
                  <c:v>1.13596E-4</c:v>
                </c:pt>
                <c:pt idx="199" formatCode="General">
                  <c:v>1.2596100000000001E-4</c:v>
                </c:pt>
                <c:pt idx="200" formatCode="General">
                  <c:v>1.3967499999999999E-4</c:v>
                </c:pt>
                <c:pt idx="201" formatCode="General">
                  <c:v>1.5681500000000001E-4</c:v>
                </c:pt>
                <c:pt idx="202" formatCode="General">
                  <c:v>1.7606100000000001E-4</c:v>
                </c:pt>
                <c:pt idx="203" formatCode="General">
                  <c:v>1.9767299999999999E-4</c:v>
                </c:pt>
                <c:pt idx="204" formatCode="General">
                  <c:v>2.0100200000000001E-4</c:v>
                </c:pt>
                <c:pt idx="205" formatCode="General">
                  <c:v>2.01645E-4</c:v>
                </c:pt>
                <c:pt idx="206" formatCode="General">
                  <c:v>2.02289E-4</c:v>
                </c:pt>
                <c:pt idx="207" formatCode="General">
                  <c:v>2.02936E-4</c:v>
                </c:pt>
                <c:pt idx="208" formatCode="General">
                  <c:v>2.03585E-4</c:v>
                </c:pt>
                <c:pt idx="209" formatCode="General">
                  <c:v>2.0488799999999999E-4</c:v>
                </c:pt>
                <c:pt idx="210" formatCode="General">
                  <c:v>2.062E-4</c:v>
                </c:pt>
                <c:pt idx="211" formatCode="General">
                  <c:v>2.0752100000000001E-4</c:v>
                </c:pt>
                <c:pt idx="212" formatCode="General">
                  <c:v>2.1013600000000001E-4</c:v>
                </c:pt>
                <c:pt idx="213" formatCode="General">
                  <c:v>2.12785E-4</c:v>
                </c:pt>
                <c:pt idx="214" formatCode="General">
                  <c:v>2.15467E-4</c:v>
                </c:pt>
                <c:pt idx="215" formatCode="General">
                  <c:v>2.1818299999999999E-4</c:v>
                </c:pt>
                <c:pt idx="216" formatCode="General">
                  <c:v>2.2467799999999999E-4</c:v>
                </c:pt>
                <c:pt idx="217" formatCode="General">
                  <c:v>2.3136599999999999E-4</c:v>
                </c:pt>
                <c:pt idx="218" formatCode="General">
                  <c:v>2.38254E-4</c:v>
                </c:pt>
                <c:pt idx="219" formatCode="General">
                  <c:v>2.4534699999999998E-4</c:v>
                </c:pt>
                <c:pt idx="220" formatCode="General">
                  <c:v>2.5791099999999999E-4</c:v>
                </c:pt>
                <c:pt idx="221" formatCode="General">
                  <c:v>2.71119E-4</c:v>
                </c:pt>
                <c:pt idx="222" formatCode="General">
                  <c:v>2.85004E-4</c:v>
                </c:pt>
                <c:pt idx="223" formatCode="General">
                  <c:v>2.9960099999999998E-4</c:v>
                </c:pt>
                <c:pt idx="224" formatCode="General">
                  <c:v>3.1494599999999998E-4</c:v>
                </c:pt>
                <c:pt idx="225" formatCode="General">
                  <c:v>3.4613999999999999E-4</c:v>
                </c:pt>
                <c:pt idx="226" formatCode="General">
                  <c:v>3.7338699999999998E-4</c:v>
                </c:pt>
                <c:pt idx="227" formatCode="General">
                  <c:v>4.02781E-4</c:v>
                </c:pt>
                <c:pt idx="228" formatCode="General">
                  <c:v>4.3448899999999998E-4</c:v>
                </c:pt>
                <c:pt idx="229" formatCode="General">
                  <c:v>4.6869499999999998E-4</c:v>
                </c:pt>
                <c:pt idx="230" formatCode="General">
                  <c:v>5.0559599999999998E-4</c:v>
                </c:pt>
                <c:pt idx="231" formatCode="General">
                  <c:v>5.5495700000000002E-4</c:v>
                </c:pt>
                <c:pt idx="232" formatCode="General">
                  <c:v>6.0913799999999995E-4</c:v>
                </c:pt>
                <c:pt idx="233" formatCode="General">
                  <c:v>6.6861199999999996E-4</c:v>
                </c:pt>
                <c:pt idx="234" formatCode="General">
                  <c:v>7.3389400000000002E-4</c:v>
                </c:pt>
                <c:pt idx="235" formatCode="General">
                  <c:v>8.0555199999999996E-4</c:v>
                </c:pt>
                <c:pt idx="236" formatCode="General">
                  <c:v>8.8420999999999997E-4</c:v>
                </c:pt>
                <c:pt idx="237" formatCode="General">
                  <c:v>9.8321099999999989E-4</c:v>
                </c:pt>
                <c:pt idx="238" formatCode="General">
                  <c:v>1.0933E-3</c:v>
                </c:pt>
                <c:pt idx="239" formatCode="General">
                  <c:v>1.21572E-3</c:v>
                </c:pt>
                <c:pt idx="240" formatCode="General">
                  <c:v>1.3518499999999999E-3</c:v>
                </c:pt>
                <c:pt idx="241" formatCode="General">
                  <c:v>1.50322E-3</c:v>
                </c:pt>
                <c:pt idx="242" formatCode="General">
                  <c:v>1.6715499999999999E-3</c:v>
                </c:pt>
                <c:pt idx="243" formatCode="General">
                  <c:v>1.8587300000000001E-3</c:v>
                </c:pt>
                <c:pt idx="244" formatCode="General">
                  <c:v>2.0668700000000002E-3</c:v>
                </c:pt>
                <c:pt idx="245" formatCode="General">
                  <c:v>2.29832E-3</c:v>
                </c:pt>
                <c:pt idx="246" formatCode="General">
                  <c:v>2.5556899999999998E-3</c:v>
                </c:pt>
                <c:pt idx="247" formatCode="General">
                  <c:v>2.8418800000000002E-3</c:v>
                </c:pt>
                <c:pt idx="248" formatCode="General">
                  <c:v>3.1601300000000001E-3</c:v>
                </c:pt>
                <c:pt idx="249" formatCode="General">
                  <c:v>3.5140200000000001E-3</c:v>
                </c:pt>
                <c:pt idx="250" formatCode="General">
                  <c:v>3.9075400000000001E-3</c:v>
                </c:pt>
                <c:pt idx="251" formatCode="General">
                  <c:v>4.34513E-3</c:v>
                </c:pt>
                <c:pt idx="252" formatCode="General">
                  <c:v>4.8317200000000003E-3</c:v>
                </c:pt>
                <c:pt idx="253" formatCode="General">
                  <c:v>5.3728100000000004E-3</c:v>
                </c:pt>
                <c:pt idx="254" formatCode="General">
                  <c:v>5.9744999999999998E-3</c:v>
                </c:pt>
                <c:pt idx="255" formatCode="General">
                  <c:v>6.6435699999999997E-3</c:v>
                </c:pt>
                <c:pt idx="256" formatCode="General">
                  <c:v>7.3875700000000004E-3</c:v>
                </c:pt>
                <c:pt idx="257" formatCode="General">
                  <c:v>8.2148900000000007E-3</c:v>
                </c:pt>
                <c:pt idx="258" formatCode="General">
                  <c:v>9.1348599999999999E-3</c:v>
                </c:pt>
                <c:pt idx="259" formatCode="General">
                  <c:v>1.0157899999999999E-2</c:v>
                </c:pt>
                <c:pt idx="260" formatCode="General">
                  <c:v>1.1295400000000001E-2</c:v>
                </c:pt>
                <c:pt idx="261" formatCode="General">
                  <c:v>1.2560399999999999E-2</c:v>
                </c:pt>
                <c:pt idx="262" formatCode="General">
                  <c:v>1.3967E-2</c:v>
                </c:pt>
                <c:pt idx="263" formatCode="General">
                  <c:v>1.55312E-2</c:v>
                </c:pt>
                <c:pt idx="264" formatCode="General">
                  <c:v>1.7270500000000001E-2</c:v>
                </c:pt>
                <c:pt idx="265" formatCode="General">
                  <c:v>1.9204499999999999E-2</c:v>
                </c:pt>
                <c:pt idx="266" formatCode="General">
                  <c:v>2.1355200000000001E-2</c:v>
                </c:pt>
                <c:pt idx="267" formatCode="General">
                  <c:v>2.3746799999999998E-2</c:v>
                </c:pt>
                <c:pt idx="268" formatCode="General">
                  <c:v>2.6406099999999998E-2</c:v>
                </c:pt>
                <c:pt idx="269" formatCode="General">
                  <c:v>2.9363199999999999E-2</c:v>
                </c:pt>
                <c:pt idx="270" formatCode="General">
                  <c:v>3.26515E-2</c:v>
                </c:pt>
                <c:pt idx="271" formatCode="General">
                  <c:v>3.6308100000000003E-2</c:v>
                </c:pt>
                <c:pt idx="272" formatCode="General">
                  <c:v>4.0374100000000003E-2</c:v>
                </c:pt>
                <c:pt idx="273" formatCode="General">
                  <c:v>4.4895400000000002E-2</c:v>
                </c:pt>
                <c:pt idx="274" formatCode="General">
                  <c:v>4.9923000000000002E-2</c:v>
                </c:pt>
                <c:pt idx="275" formatCode="General">
                  <c:v>5.5513600000000003E-2</c:v>
                </c:pt>
                <c:pt idx="276" formatCode="General">
                  <c:v>6.1730100000000003E-2</c:v>
                </c:pt>
                <c:pt idx="277" formatCode="General">
                  <c:v>6.8642800000000004E-2</c:v>
                </c:pt>
                <c:pt idx="278" formatCode="General">
                  <c:v>7.6329499999999995E-2</c:v>
                </c:pt>
                <c:pt idx="279" formatCode="General">
                  <c:v>8.4876900000000005E-2</c:v>
                </c:pt>
                <c:pt idx="280" formatCode="General">
                  <c:v>9.4381300000000001E-2</c:v>
                </c:pt>
                <c:pt idx="281" formatCode="General">
                  <c:v>0.10495</c:v>
                </c:pt>
                <c:pt idx="282" formatCode="General">
                  <c:v>0.116702</c:v>
                </c:pt>
                <c:pt idx="283" formatCode="General">
                  <c:v>0.129769</c:v>
                </c:pt>
                <c:pt idx="284" formatCode="General">
                  <c:v>0.14430000000000001</c:v>
                </c:pt>
                <c:pt idx="285" formatCode="General">
                  <c:v>0.16045699999999999</c:v>
                </c:pt>
                <c:pt idx="286" formatCode="General">
                  <c:v>0.178423</c:v>
                </c:pt>
                <c:pt idx="287" formatCode="General">
                  <c:v>0.19839999999999999</c:v>
                </c:pt>
                <c:pt idx="288" formatCode="General">
                  <c:v>0.220613</c:v>
                </c:pt>
                <c:pt idx="289" formatCode="General">
                  <c:v>0.245312</c:v>
                </c:pt>
                <c:pt idx="290" formatCode="General">
                  <c:v>0.27277499999999999</c:v>
                </c:pt>
                <c:pt idx="291" formatCode="General">
                  <c:v>0.30331200000000003</c:v>
                </c:pt>
                <c:pt idx="292" formatCode="General">
                  <c:v>0.33726600000000001</c:v>
                </c:pt>
                <c:pt idx="293" formatCode="General">
                  <c:v>0.37501899999999999</c:v>
                </c:pt>
                <c:pt idx="294" formatCode="General">
                  <c:v>0.41699599999999998</c:v>
                </c:pt>
                <c:pt idx="295" formatCode="General">
                  <c:v>0.46366800000000002</c:v>
                </c:pt>
                <c:pt idx="296" formatCode="General">
                  <c:v>0.51556100000000005</c:v>
                </c:pt>
                <c:pt idx="297" formatCode="General">
                  <c:v>0.57325700000000002</c:v>
                </c:pt>
                <c:pt idx="298" formatCode="General">
                  <c:v>0.63740300000000005</c:v>
                </c:pt>
                <c:pt idx="299" formatCode="General">
                  <c:v>0.70872000000000002</c:v>
                </c:pt>
                <c:pt idx="300" formatCode="General">
                  <c:v>0.78800800000000004</c:v>
                </c:pt>
                <c:pt idx="301" formatCode="General">
                  <c:v>0.87615399999999999</c:v>
                </c:pt>
                <c:pt idx="302" formatCode="General">
                  <c:v>0.97414699999999999</c:v>
                </c:pt>
                <c:pt idx="303" formatCode="General">
                  <c:v>1.08308</c:v>
                </c:pt>
                <c:pt idx="304" formatCode="General">
                  <c:v>1.18004</c:v>
                </c:pt>
                <c:pt idx="305" formatCode="General">
                  <c:v>1.28566</c:v>
                </c:pt>
                <c:pt idx="306" formatCode="General">
                  <c:v>1.40072</c:v>
                </c:pt>
                <c:pt idx="307" formatCode="General">
                  <c:v>1.50014</c:v>
                </c:pt>
                <c:pt idx="308" formatCode="General">
                  <c:v>1.6066</c:v>
                </c:pt>
                <c:pt idx="309" formatCode="General">
                  <c:v>1.7005699999999999</c:v>
                </c:pt>
                <c:pt idx="310" formatCode="General">
                  <c:v>1.7167600000000001</c:v>
                </c:pt>
                <c:pt idx="311" formatCode="General">
                  <c:v>1.73309</c:v>
                </c:pt>
                <c:pt idx="312" formatCode="General">
                  <c:v>1.7495799999999999</c:v>
                </c:pt>
                <c:pt idx="313" formatCode="General">
                  <c:v>1.76623</c:v>
                </c:pt>
                <c:pt idx="314" formatCode="General">
                  <c:v>1.7830299999999999</c:v>
                </c:pt>
                <c:pt idx="315" formatCode="General">
                  <c:v>1.8171200000000001</c:v>
                </c:pt>
                <c:pt idx="316" formatCode="General">
                  <c:v>1.8518600000000001</c:v>
                </c:pt>
                <c:pt idx="317" formatCode="General">
                  <c:v>1.8872599999999999</c:v>
                </c:pt>
                <c:pt idx="318" formatCode="General">
                  <c:v>1.92333</c:v>
                </c:pt>
                <c:pt idx="319" formatCode="General">
                  <c:v>1.98234</c:v>
                </c:pt>
                <c:pt idx="320" formatCode="General">
                  <c:v>2.0431599999999999</c:v>
                </c:pt>
                <c:pt idx="321" formatCode="General">
                  <c:v>2.1058400000000002</c:v>
                </c:pt>
                <c:pt idx="322" formatCode="General">
                  <c:v>2.1704300000000001</c:v>
                </c:pt>
                <c:pt idx="323" formatCode="General">
                  <c:v>2.23699</c:v>
                </c:pt>
                <c:pt idx="324" formatCode="General">
                  <c:v>2.3507099999999999</c:v>
                </c:pt>
                <c:pt idx="325" formatCode="General">
                  <c:v>2.47018</c:v>
                </c:pt>
                <c:pt idx="326" formatCode="General">
                  <c:v>2.5956899999999998</c:v>
                </c:pt>
                <c:pt idx="327" formatCode="General">
                  <c:v>2.7275499999999999</c:v>
                </c:pt>
                <c:pt idx="328" formatCode="General">
                  <c:v>2.8660600000000001</c:v>
                </c:pt>
                <c:pt idx="329" formatCode="General">
                  <c:v>2.98495</c:v>
                </c:pt>
                <c:pt idx="330" formatCode="General">
                  <c:v>3.1087400000000001</c:v>
                </c:pt>
                <c:pt idx="331" formatCode="General">
                  <c:v>3.2376200000000002</c:v>
                </c:pt>
                <c:pt idx="332" formatCode="General">
                  <c:v>3.37181</c:v>
                </c:pt>
                <c:pt idx="333" formatCode="General">
                  <c:v>3.5115099999999999</c:v>
                </c:pt>
                <c:pt idx="334" formatCode="General">
                  <c:v>3.6569400000000001</c:v>
                </c:pt>
                <c:pt idx="335" formatCode="General">
                  <c:v>3.8083499999999999</c:v>
                </c:pt>
                <c:pt idx="336" formatCode="General">
                  <c:v>3.9659599999999999</c:v>
                </c:pt>
                <c:pt idx="337" formatCode="General">
                  <c:v>4.13002</c:v>
                </c:pt>
                <c:pt idx="338" formatCode="General">
                  <c:v>4.2715199999999998</c:v>
                </c:pt>
                <c:pt idx="339" formatCode="General">
                  <c:v>4.4178100000000002</c:v>
                </c:pt>
                <c:pt idx="340" formatCode="General">
                  <c:v>4.5389799999999996</c:v>
                </c:pt>
                <c:pt idx="341" formatCode="General">
                  <c:v>4.66343</c:v>
                </c:pt>
                <c:pt idx="342" formatCode="General">
                  <c:v>4.7912499999999998</c:v>
                </c:pt>
                <c:pt idx="343" formatCode="General">
                  <c:v>4.9225099999999999</c:v>
                </c:pt>
                <c:pt idx="344" formatCode="General">
                  <c:v>4.9437300000000004</c:v>
                </c:pt>
                <c:pt idx="345" formatCode="General">
                  <c:v>4.9650400000000001</c:v>
                </c:pt>
                <c:pt idx="346" formatCode="General">
                  <c:v>4.98644</c:v>
                </c:pt>
                <c:pt idx="347" formatCode="General">
                  <c:v>5.00793</c:v>
                </c:pt>
                <c:pt idx="348" formatCode="General">
                  <c:v>5.0295199999999998</c:v>
                </c:pt>
                <c:pt idx="349" formatCode="General">
                  <c:v>5.0729600000000001</c:v>
                </c:pt>
                <c:pt idx="350" formatCode="General">
                  <c:v>5.1167600000000002</c:v>
                </c:pt>
                <c:pt idx="351" formatCode="General">
                  <c:v>5.1609499999999997</c:v>
                </c:pt>
                <c:pt idx="352" formatCode="General">
                  <c:v>5.2054999999999998</c:v>
                </c:pt>
                <c:pt idx="353" formatCode="General">
                  <c:v>5.2924499999999997</c:v>
                </c:pt>
                <c:pt idx="354" formatCode="General">
                  <c:v>5.3808100000000003</c:v>
                </c:pt>
                <c:pt idx="355" formatCode="General">
                  <c:v>5.4706299999999999</c:v>
                </c:pt>
                <c:pt idx="356" formatCode="General">
                  <c:v>5.5619199999999998</c:v>
                </c:pt>
                <c:pt idx="357" formatCode="General">
                  <c:v>5.6887699999999999</c:v>
                </c:pt>
                <c:pt idx="358" formatCode="General">
                  <c:v>5.8184500000000003</c:v>
                </c:pt>
                <c:pt idx="359" formatCode="General">
                  <c:v>5.9510199999999998</c:v>
                </c:pt>
                <c:pt idx="360" formatCode="General">
                  <c:v>6.0632900000000003</c:v>
                </c:pt>
                <c:pt idx="361" formatCode="General">
                  <c:v>6.1776299999999997</c:v>
                </c:pt>
                <c:pt idx="362" formatCode="General">
                  <c:v>6.2940699999999996</c:v>
                </c:pt>
                <c:pt idx="363" formatCode="General">
                  <c:v>6.4126500000000002</c:v>
                </c:pt>
                <c:pt idx="364" formatCode="General">
                  <c:v>6.5334000000000003</c:v>
                </c:pt>
                <c:pt idx="365" formatCode="General">
                  <c:v>6.6820899999999996</c:v>
                </c:pt>
                <c:pt idx="366" formatCode="General">
                  <c:v>6.8340699999999996</c:v>
                </c:pt>
                <c:pt idx="367" formatCode="General">
                  <c:v>6.9893900000000002</c:v>
                </c:pt>
                <c:pt idx="368" formatCode="General">
                  <c:v>7.1481399999999997</c:v>
                </c:pt>
                <c:pt idx="369" formatCode="General">
                  <c:v>7.3103699999999998</c:v>
                </c:pt>
                <c:pt idx="370" formatCode="General">
                  <c:v>7.4761600000000001</c:v>
                </c:pt>
                <c:pt idx="371" formatCode="General">
                  <c:v>7.6104900000000004</c:v>
                </c:pt>
                <c:pt idx="372" formatCode="General">
                  <c:v>7.7214200000000002</c:v>
                </c:pt>
                <c:pt idx="373" formatCode="General">
                  <c:v>7.8339100000000004</c:v>
                </c:pt>
                <c:pt idx="374" formatCode="General">
                  <c:v>7.8520099999999999</c:v>
                </c:pt>
                <c:pt idx="375" formatCode="General">
                  <c:v>7.8701499999999998</c:v>
                </c:pt>
                <c:pt idx="376" formatCode="General">
                  <c:v>7.8883299999999998</c:v>
                </c:pt>
                <c:pt idx="377" formatCode="General">
                  <c:v>7.9065500000000002</c:v>
                </c:pt>
                <c:pt idx="378" formatCode="General">
                  <c:v>7.9431099999999999</c:v>
                </c:pt>
                <c:pt idx="379" formatCode="General">
                  <c:v>7.9798400000000003</c:v>
                </c:pt>
                <c:pt idx="380" formatCode="General">
                  <c:v>8.0167300000000008</c:v>
                </c:pt>
                <c:pt idx="381" formatCode="General">
                  <c:v>8.0537799999999997</c:v>
                </c:pt>
                <c:pt idx="382" formatCode="General">
                  <c:v>8.1524900000000002</c:v>
                </c:pt>
                <c:pt idx="383" formatCode="General">
                  <c:v>8.2523700000000009</c:v>
                </c:pt>
                <c:pt idx="384" formatCode="General">
                  <c:v>8.3534100000000002</c:v>
                </c:pt>
                <c:pt idx="385" formatCode="General">
                  <c:v>8.4556299999999993</c:v>
                </c:pt>
                <c:pt idx="386" formatCode="General">
                  <c:v>8.5916899999999998</c:v>
                </c:pt>
                <c:pt idx="387" formatCode="General">
                  <c:v>8.7298200000000001</c:v>
                </c:pt>
                <c:pt idx="388" formatCode="General">
                  <c:v>8.8700600000000005</c:v>
                </c:pt>
                <c:pt idx="389" formatCode="General">
                  <c:v>9.0124200000000005</c:v>
                </c:pt>
                <c:pt idx="390" formatCode="General">
                  <c:v>9.1569400000000005</c:v>
                </c:pt>
                <c:pt idx="391" formatCode="General">
                  <c:v>9.3036300000000001</c:v>
                </c:pt>
                <c:pt idx="392" formatCode="General">
                  <c:v>9.4201300000000003</c:v>
                </c:pt>
                <c:pt idx="393" formatCode="General">
                  <c:v>9.5380099999999999</c:v>
                </c:pt>
                <c:pt idx="394" formatCode="General">
                  <c:v>9.6572499999999994</c:v>
                </c:pt>
                <c:pt idx="395" formatCode="General">
                  <c:v>9.7778799999999997</c:v>
                </c:pt>
                <c:pt idx="396" formatCode="General">
                  <c:v>9.8999100000000002</c:v>
                </c:pt>
                <c:pt idx="397" formatCode="General">
                  <c:v>10.0244</c:v>
                </c:pt>
                <c:pt idx="398" formatCode="General">
                  <c:v>10.1502</c:v>
                </c:pt>
                <c:pt idx="399" formatCode="General">
                  <c:v>10.2776</c:v>
                </c:pt>
                <c:pt idx="400" formatCode="General">
                  <c:v>10.4064</c:v>
                </c:pt>
                <c:pt idx="401" formatCode="General">
                  <c:v>10.5367</c:v>
                </c:pt>
                <c:pt idx="402" formatCode="General">
                  <c:v>10.689500000000001</c:v>
                </c:pt>
                <c:pt idx="403" formatCode="General">
                  <c:v>10.8443</c:v>
                </c:pt>
                <c:pt idx="404" formatCode="General">
                  <c:v>11.001200000000001</c:v>
                </c:pt>
                <c:pt idx="405" formatCode="General">
                  <c:v>11.1601</c:v>
                </c:pt>
                <c:pt idx="406" formatCode="General">
                  <c:v>11.321</c:v>
                </c:pt>
                <c:pt idx="407" formatCode="General">
                  <c:v>11.5082</c:v>
                </c:pt>
                <c:pt idx="408" formatCode="General">
                  <c:v>11.6981</c:v>
                </c:pt>
                <c:pt idx="409" formatCode="General">
                  <c:v>11.8908</c:v>
                </c:pt>
                <c:pt idx="410" formatCode="General">
                  <c:v>12.0862</c:v>
                </c:pt>
                <c:pt idx="411" formatCode="General">
                  <c:v>12.2843</c:v>
                </c:pt>
                <c:pt idx="412" formatCode="General">
                  <c:v>12.485200000000001</c:v>
                </c:pt>
                <c:pt idx="413" formatCode="General">
                  <c:v>12.688800000000001</c:v>
                </c:pt>
                <c:pt idx="414" formatCode="General">
                  <c:v>12.895200000000001</c:v>
                </c:pt>
                <c:pt idx="415" formatCode="General">
                  <c:v>13.0617</c:v>
                </c:pt>
                <c:pt idx="416" formatCode="General">
                  <c:v>13.23</c:v>
                </c:pt>
                <c:pt idx="417" formatCode="General">
                  <c:v>13.399900000000001</c:v>
                </c:pt>
                <c:pt idx="418" formatCode="General">
                  <c:v>13.5716</c:v>
                </c:pt>
                <c:pt idx="419" formatCode="General">
                  <c:v>13.744999999999999</c:v>
                </c:pt>
                <c:pt idx="420" formatCode="General">
                  <c:v>13.9201</c:v>
                </c:pt>
                <c:pt idx="421" formatCode="General">
                  <c:v>14.0968</c:v>
                </c:pt>
                <c:pt idx="422" formatCode="General">
                  <c:v>14.2751</c:v>
                </c:pt>
                <c:pt idx="423" formatCode="General">
                  <c:v>14.455</c:v>
                </c:pt>
                <c:pt idx="424" formatCode="General">
                  <c:v>14.6365</c:v>
                </c:pt>
                <c:pt idx="425" formatCode="General">
                  <c:v>14.8195</c:v>
                </c:pt>
                <c:pt idx="426" formatCode="General">
                  <c:v>15.004</c:v>
                </c:pt>
                <c:pt idx="427" formatCode="General">
                  <c:v>15.19</c:v>
                </c:pt>
                <c:pt idx="428" formatCode="General">
                  <c:v>15.3773</c:v>
                </c:pt>
                <c:pt idx="429" formatCode="General">
                  <c:v>15.5883</c:v>
                </c:pt>
                <c:pt idx="430" formatCode="General">
                  <c:v>15.8009</c:v>
                </c:pt>
                <c:pt idx="431" formatCode="General">
                  <c:v>16.014900000000001</c:v>
                </c:pt>
                <c:pt idx="432" formatCode="General">
                  <c:v>16.2302</c:v>
                </c:pt>
                <c:pt idx="433" formatCode="General">
                  <c:v>16.4468</c:v>
                </c:pt>
                <c:pt idx="434" formatCode="General">
                  <c:v>16.664300000000001</c:v>
                </c:pt>
                <c:pt idx="435" formatCode="General">
                  <c:v>16.8826</c:v>
                </c:pt>
                <c:pt idx="436" formatCode="General">
                  <c:v>17.101600000000001</c:v>
                </c:pt>
                <c:pt idx="437" formatCode="General">
                  <c:v>17.321000000000002</c:v>
                </c:pt>
                <c:pt idx="438" formatCode="General">
                  <c:v>17.540600000000001</c:v>
                </c:pt>
                <c:pt idx="439" formatCode="General">
                  <c:v>17.760000000000002</c:v>
                </c:pt>
                <c:pt idx="440" formatCode="General">
                  <c:v>17.978899999999999</c:v>
                </c:pt>
                <c:pt idx="441" formatCode="General">
                  <c:v>18.196999999999999</c:v>
                </c:pt>
                <c:pt idx="442" formatCode="General">
                  <c:v>18.413900000000002</c:v>
                </c:pt>
                <c:pt idx="443" formatCode="General">
                  <c:v>18.629100000000001</c:v>
                </c:pt>
                <c:pt idx="444" formatCode="General">
                  <c:v>18.842099999999999</c:v>
                </c:pt>
                <c:pt idx="445" formatCode="General">
                  <c:v>19.052199999999999</c:v>
                </c:pt>
                <c:pt idx="446" formatCode="General">
                  <c:v>19.258900000000001</c:v>
                </c:pt>
                <c:pt idx="447" formatCode="General">
                  <c:v>19.461400000000001</c:v>
                </c:pt>
                <c:pt idx="448" formatCode="General">
                  <c:v>19.658799999999999</c:v>
                </c:pt>
                <c:pt idx="449" formatCode="General">
                  <c:v>19.850300000000001</c:v>
                </c:pt>
                <c:pt idx="450" formatCode="General">
                  <c:v>20.034700000000001</c:v>
                </c:pt>
                <c:pt idx="451" formatCode="General">
                  <c:v>20.210799999999999</c:v>
                </c:pt>
                <c:pt idx="452" formatCode="General">
                  <c:v>20.377300000000002</c:v>
                </c:pt>
                <c:pt idx="453" formatCode="General">
                  <c:v>20.532699999999998</c:v>
                </c:pt>
                <c:pt idx="454" formatCode="General">
                  <c:v>20.6753</c:v>
                </c:pt>
                <c:pt idx="455" formatCode="General">
                  <c:v>20.803100000000001</c:v>
                </c:pt>
                <c:pt idx="456" formatCode="General">
                  <c:v>20.914000000000001</c:v>
                </c:pt>
                <c:pt idx="457" formatCode="General">
                  <c:v>21.005600000000001</c:v>
                </c:pt>
                <c:pt idx="458" formatCode="General">
                  <c:v>21.075099999999999</c:v>
                </c:pt>
                <c:pt idx="459" formatCode="General">
                  <c:v>21.119599999999998</c:v>
                </c:pt>
                <c:pt idx="460" formatCode="General">
                  <c:v>21.135200000000001</c:v>
                </c:pt>
                <c:pt idx="461" formatCode="General">
                  <c:v>21.129300000000001</c:v>
                </c:pt>
                <c:pt idx="462" formatCode="General">
                  <c:v>21.099699999999999</c:v>
                </c:pt>
                <c:pt idx="463" formatCode="General">
                  <c:v>21.0442</c:v>
                </c:pt>
                <c:pt idx="464" formatCode="General">
                  <c:v>20.980799999999999</c:v>
                </c:pt>
                <c:pt idx="465" formatCode="General">
                  <c:v>20.898700000000002</c:v>
                </c:pt>
                <c:pt idx="466" formatCode="General">
                  <c:v>20.796500000000002</c:v>
                </c:pt>
                <c:pt idx="467" formatCode="General">
                  <c:v>20.672799999999999</c:v>
                </c:pt>
                <c:pt idx="468" formatCode="General">
                  <c:v>20.649899999999999</c:v>
                </c:pt>
                <c:pt idx="469" formatCode="General">
                  <c:v>20.6264</c:v>
                </c:pt>
                <c:pt idx="470" formatCode="General">
                  <c:v>20.6022</c:v>
                </c:pt>
                <c:pt idx="471" formatCode="General">
                  <c:v>20.577400000000001</c:v>
                </c:pt>
                <c:pt idx="472" formatCode="General">
                  <c:v>20.5518</c:v>
                </c:pt>
                <c:pt idx="473" formatCode="General">
                  <c:v>20.5044</c:v>
                </c:pt>
                <c:pt idx="474" formatCode="General">
                  <c:v>20.454799999999999</c:v>
                </c:pt>
                <c:pt idx="475" formatCode="General">
                  <c:v>20.402999999999999</c:v>
                </c:pt>
                <c:pt idx="476" formatCode="General">
                  <c:v>20.348800000000001</c:v>
                </c:pt>
                <c:pt idx="477" formatCode="General">
                  <c:v>20.292400000000001</c:v>
                </c:pt>
                <c:pt idx="478" formatCode="General">
                  <c:v>20.180399999999999</c:v>
                </c:pt>
                <c:pt idx="479" formatCode="General">
                  <c:v>20.059899999999999</c:v>
                </c:pt>
                <c:pt idx="480" formatCode="General">
                  <c:v>19.930700000000002</c:v>
                </c:pt>
                <c:pt idx="481" formatCode="General">
                  <c:v>19.7925</c:v>
                </c:pt>
                <c:pt idx="482" formatCode="General">
                  <c:v>19.645199999999999</c:v>
                </c:pt>
                <c:pt idx="483" formatCode="General">
                  <c:v>19.426400000000001</c:v>
                </c:pt>
                <c:pt idx="484" formatCode="General">
                  <c:v>19.1892</c:v>
                </c:pt>
                <c:pt idx="485" formatCode="General">
                  <c:v>18.9331</c:v>
                </c:pt>
                <c:pt idx="486" formatCode="General">
                  <c:v>18.657599999999999</c:v>
                </c:pt>
                <c:pt idx="487" formatCode="General">
                  <c:v>18.362500000000001</c:v>
                </c:pt>
                <c:pt idx="488" formatCode="General">
                  <c:v>17.946100000000001</c:v>
                </c:pt>
                <c:pt idx="489" formatCode="General">
                  <c:v>17.495200000000001</c:v>
                </c:pt>
                <c:pt idx="490" formatCode="General">
                  <c:v>17.009699999999999</c:v>
                </c:pt>
                <c:pt idx="491" formatCode="General">
                  <c:v>16.489899999999999</c:v>
                </c:pt>
                <c:pt idx="492" formatCode="General">
                  <c:v>15.9366</c:v>
                </c:pt>
                <c:pt idx="493" formatCode="General">
                  <c:v>15.350899999999999</c:v>
                </c:pt>
                <c:pt idx="494" formatCode="General">
                  <c:v>14.7346</c:v>
                </c:pt>
                <c:pt idx="495" formatCode="General">
                  <c:v>14.0899</c:v>
                </c:pt>
                <c:pt idx="496" formatCode="General">
                  <c:v>13.419499999999999</c:v>
                </c:pt>
                <c:pt idx="497" formatCode="General">
                  <c:v>12.889799999999999</c:v>
                </c:pt>
                <c:pt idx="498" formatCode="General">
                  <c:v>12.4415</c:v>
                </c:pt>
                <c:pt idx="499" formatCode="General">
                  <c:v>11.986499999999999</c:v>
                </c:pt>
                <c:pt idx="500" formatCode="General">
                  <c:v>11.8947</c:v>
                </c:pt>
                <c:pt idx="501" formatCode="General">
                  <c:v>11.8028</c:v>
                </c:pt>
                <c:pt idx="502" formatCode="General">
                  <c:v>11.710599999999999</c:v>
                </c:pt>
                <c:pt idx="503" formatCode="General">
                  <c:v>11.6183</c:v>
                </c:pt>
                <c:pt idx="504" formatCode="General">
                  <c:v>11.525700000000001</c:v>
                </c:pt>
                <c:pt idx="505" formatCode="General">
                  <c:v>11.351599999999999</c:v>
                </c:pt>
                <c:pt idx="506" formatCode="General">
                  <c:v>11.1769</c:v>
                </c:pt>
                <c:pt idx="507" formatCode="General">
                  <c:v>11.0017</c:v>
                </c:pt>
                <c:pt idx="508" formatCode="General">
                  <c:v>10.8261</c:v>
                </c:pt>
                <c:pt idx="509" formatCode="General">
                  <c:v>10.553800000000001</c:v>
                </c:pt>
                <c:pt idx="510" formatCode="General">
                  <c:v>10.281000000000001</c:v>
                </c:pt>
                <c:pt idx="511" formatCode="General">
                  <c:v>10.0078</c:v>
                </c:pt>
                <c:pt idx="512" formatCode="General">
                  <c:v>9.7346000000000004</c:v>
                </c:pt>
                <c:pt idx="513" formatCode="General">
                  <c:v>9.4270099999999992</c:v>
                </c:pt>
                <c:pt idx="514" formatCode="General">
                  <c:v>9.1201399999999992</c:v>
                </c:pt>
                <c:pt idx="515" formatCode="General">
                  <c:v>8.8143899999999995</c:v>
                </c:pt>
                <c:pt idx="516" formatCode="General">
                  <c:v>8.5101899999999997</c:v>
                </c:pt>
                <c:pt idx="517" formatCode="General">
                  <c:v>8.2079299999999993</c:v>
                </c:pt>
                <c:pt idx="518" formatCode="General">
                  <c:v>7.8592500000000003</c:v>
                </c:pt>
                <c:pt idx="519" formatCode="General">
                  <c:v>7.5143899999999997</c:v>
                </c:pt>
                <c:pt idx="520" formatCode="General">
                  <c:v>7.1739600000000001</c:v>
                </c:pt>
                <c:pt idx="521" formatCode="General">
                  <c:v>6.8385800000000003</c:v>
                </c:pt>
                <c:pt idx="522" formatCode="General">
                  <c:v>6.5088299999999997</c:v>
                </c:pt>
                <c:pt idx="523" formatCode="General">
                  <c:v>6.1516000000000002</c:v>
                </c:pt>
                <c:pt idx="524" formatCode="General">
                  <c:v>5.8026600000000004</c:v>
                </c:pt>
                <c:pt idx="525" formatCode="General">
                  <c:v>5.5535199999999998</c:v>
                </c:pt>
                <c:pt idx="526" formatCode="General">
                  <c:v>5.5108100000000002</c:v>
                </c:pt>
                <c:pt idx="527" formatCode="General">
                  <c:v>5.4682500000000003</c:v>
                </c:pt>
                <c:pt idx="528" formatCode="General">
                  <c:v>5.4258499999999996</c:v>
                </c:pt>
                <c:pt idx="529" formatCode="General">
                  <c:v>5.3836000000000004</c:v>
                </c:pt>
                <c:pt idx="530" formatCode="General">
                  <c:v>5.2995700000000001</c:v>
                </c:pt>
                <c:pt idx="531" formatCode="General">
                  <c:v>5.2161799999999996</c:v>
                </c:pt>
                <c:pt idx="532" formatCode="General">
                  <c:v>5.1334299999999997</c:v>
                </c:pt>
                <c:pt idx="533" formatCode="General">
                  <c:v>5.0513399999999997</c:v>
                </c:pt>
                <c:pt idx="534" formatCode="General">
                  <c:v>4.8719400000000004</c:v>
                </c:pt>
                <c:pt idx="535" formatCode="General">
                  <c:v>4.6958799999999998</c:v>
                </c:pt>
                <c:pt idx="536" formatCode="General">
                  <c:v>4.5232400000000004</c:v>
                </c:pt>
                <c:pt idx="537" formatCode="General">
                  <c:v>4.3540900000000002</c:v>
                </c:pt>
                <c:pt idx="538" formatCode="General">
                  <c:v>4.1285999999999996</c:v>
                </c:pt>
                <c:pt idx="539" formatCode="General">
                  <c:v>3.9099300000000001</c:v>
                </c:pt>
                <c:pt idx="540" formatCode="General">
                  <c:v>3.6982300000000001</c:v>
                </c:pt>
                <c:pt idx="541" formatCode="General">
                  <c:v>3.4935900000000002</c:v>
                </c:pt>
                <c:pt idx="542" formatCode="General">
                  <c:v>3.2961100000000001</c:v>
                </c:pt>
                <c:pt idx="543" formatCode="General">
                  <c:v>3.0779100000000001</c:v>
                </c:pt>
                <c:pt idx="544" formatCode="General">
                  <c:v>2.8693200000000001</c:v>
                </c:pt>
                <c:pt idx="545" formatCode="General">
                  <c:v>2.6703600000000001</c:v>
                </c:pt>
                <c:pt idx="546" formatCode="General">
                  <c:v>2.4809899999999998</c:v>
                </c:pt>
                <c:pt idx="547" formatCode="General">
                  <c:v>2.3011499999999998</c:v>
                </c:pt>
                <c:pt idx="548" formatCode="General">
                  <c:v>2.0712000000000002</c:v>
                </c:pt>
                <c:pt idx="549" formatCode="General">
                  <c:v>1.8584000000000001</c:v>
                </c:pt>
                <c:pt idx="550" formatCode="General">
                  <c:v>1.70668</c:v>
                </c:pt>
                <c:pt idx="551" formatCode="General">
                  <c:v>1.6011599999999999</c:v>
                </c:pt>
                <c:pt idx="552" formatCode="General">
                  <c:v>1.5006999999999999</c:v>
                </c:pt>
                <c:pt idx="553" formatCode="General">
                  <c:v>1.4857100000000001</c:v>
                </c:pt>
                <c:pt idx="554" formatCode="General">
                  <c:v>1.47082</c:v>
                </c:pt>
                <c:pt idx="555" formatCode="General">
                  <c:v>1.4560599999999999</c:v>
                </c:pt>
                <c:pt idx="556" formatCode="General">
                  <c:v>1.4414100000000001</c:v>
                </c:pt>
                <c:pt idx="557" formatCode="General">
                  <c:v>1.41717</c:v>
                </c:pt>
                <c:pt idx="558" formatCode="General">
                  <c:v>1.3932500000000001</c:v>
                </c:pt>
                <c:pt idx="559" formatCode="General">
                  <c:v>1.36965</c:v>
                </c:pt>
                <c:pt idx="560" formatCode="General">
                  <c:v>1.34636</c:v>
                </c:pt>
                <c:pt idx="561" formatCode="General">
                  <c:v>1.30037</c:v>
                </c:pt>
                <c:pt idx="562" formatCode="General">
                  <c:v>1.25562</c:v>
                </c:pt>
                <c:pt idx="563" formatCode="General">
                  <c:v>1.2121</c:v>
                </c:pt>
                <c:pt idx="564" formatCode="General">
                  <c:v>1.1698</c:v>
                </c:pt>
                <c:pt idx="565" formatCode="General">
                  <c:v>1.0880300000000001</c:v>
                </c:pt>
                <c:pt idx="566" formatCode="General">
                  <c:v>1.01095</c:v>
                </c:pt>
                <c:pt idx="567" formatCode="General">
                  <c:v>0.938388</c:v>
                </c:pt>
                <c:pt idx="568" formatCode="General">
                  <c:v>0.87017599999999995</c:v>
                </c:pt>
                <c:pt idx="569" formatCode="General">
                  <c:v>0.80613800000000002</c:v>
                </c:pt>
                <c:pt idx="570" formatCode="General">
                  <c:v>0.74609700000000001</c:v>
                </c:pt>
                <c:pt idx="571" formatCode="General">
                  <c:v>0.68987900000000002</c:v>
                </c:pt>
                <c:pt idx="572" formatCode="General">
                  <c:v>0.63730900000000001</c:v>
                </c:pt>
                <c:pt idx="573" formatCode="General">
                  <c:v>0.58297900000000002</c:v>
                </c:pt>
                <c:pt idx="574" formatCode="General">
                  <c:v>0.53269999999999995</c:v>
                </c:pt>
                <c:pt idx="575" formatCode="General">
                  <c:v>0.48624000000000001</c:v>
                </c:pt>
                <c:pt idx="576" formatCode="General">
                  <c:v>0.44337199999999999</c:v>
                </c:pt>
                <c:pt idx="577" formatCode="General">
                  <c:v>0.40387699999999999</c:v>
                </c:pt>
                <c:pt idx="578" formatCode="General">
                  <c:v>0.36213899999999999</c:v>
                </c:pt>
                <c:pt idx="579" formatCode="General">
                  <c:v>0.32430700000000001</c:v>
                </c:pt>
                <c:pt idx="580" formatCode="General">
                  <c:v>0.290076</c:v>
                </c:pt>
                <c:pt idx="581" formatCode="General">
                  <c:v>0.25915899999999997</c:v>
                </c:pt>
                <c:pt idx="582" formatCode="General">
                  <c:v>0.25483899999999998</c:v>
                </c:pt>
                <c:pt idx="583" formatCode="General">
                  <c:v>0.250585</c:v>
                </c:pt>
                <c:pt idx="584" formatCode="General">
                  <c:v>0.246397</c:v>
                </c:pt>
                <c:pt idx="585" formatCode="General">
                  <c:v>0.24227199999999999</c:v>
                </c:pt>
                <c:pt idx="586" formatCode="General">
                  <c:v>0.23821200000000001</c:v>
                </c:pt>
                <c:pt idx="587" formatCode="General">
                  <c:v>0.23272000000000001</c:v>
                </c:pt>
                <c:pt idx="588" formatCode="General">
                  <c:v>0.22734599999999999</c:v>
                </c:pt>
                <c:pt idx="589" formatCode="General">
                  <c:v>0.222085</c:v>
                </c:pt>
                <c:pt idx="590" formatCode="General">
                  <c:v>0.21693699999999999</c:v>
                </c:pt>
                <c:pt idx="591" formatCode="General">
                  <c:v>0.207014</c:v>
                </c:pt>
                <c:pt idx="592" formatCode="General">
                  <c:v>0.19751299999999999</c:v>
                </c:pt>
                <c:pt idx="593" formatCode="General">
                  <c:v>0.188416</c:v>
                </c:pt>
                <c:pt idx="594" formatCode="General">
                  <c:v>0.17971100000000001</c:v>
                </c:pt>
                <c:pt idx="595" formatCode="General">
                  <c:v>0.16802400000000001</c:v>
                </c:pt>
                <c:pt idx="596" formatCode="General">
                  <c:v>0.15704899999999999</c:v>
                </c:pt>
                <c:pt idx="597" formatCode="General">
                  <c:v>0.14674899999999999</c:v>
                </c:pt>
                <c:pt idx="598" formatCode="General">
                  <c:v>0.13880999999999999</c:v>
                </c:pt>
                <c:pt idx="599" formatCode="General">
                  <c:v>0.131276</c:v>
                </c:pt>
                <c:pt idx="600" formatCode="General">
                  <c:v>0.12413</c:v>
                </c:pt>
                <c:pt idx="601" formatCode="General">
                  <c:v>0.117352</c:v>
                </c:pt>
                <c:pt idx="602" formatCode="General">
                  <c:v>0.110926</c:v>
                </c:pt>
                <c:pt idx="603" formatCode="General">
                  <c:v>0.103366</c:v>
                </c:pt>
                <c:pt idx="604" formatCode="General">
                  <c:v>9.6298599999999998E-2</c:v>
                </c:pt>
                <c:pt idx="605" formatCode="General">
                  <c:v>9.1169299999999995E-2</c:v>
                </c:pt>
                <c:pt idx="606" formatCode="General">
                  <c:v>8.7263999999999994E-2</c:v>
                </c:pt>
                <c:pt idx="607" formatCode="General">
                  <c:v>8.3519200000000002E-2</c:v>
                </c:pt>
                <c:pt idx="608" formatCode="General">
                  <c:v>8.2886500000000002E-2</c:v>
                </c:pt>
                <c:pt idx="609" formatCode="General">
                  <c:v>8.2258399999999995E-2</c:v>
                </c:pt>
                <c:pt idx="610" formatCode="General">
                  <c:v>8.1634899999999996E-2</c:v>
                </c:pt>
                <c:pt idx="611" formatCode="General">
                  <c:v>8.1015900000000002E-2</c:v>
                </c:pt>
                <c:pt idx="612" formatCode="General">
                  <c:v>7.9810300000000001E-2</c:v>
                </c:pt>
                <c:pt idx="613" formatCode="General">
                  <c:v>7.8621899999999995E-2</c:v>
                </c:pt>
                <c:pt idx="614" formatCode="General">
                  <c:v>7.7450500000000005E-2</c:v>
                </c:pt>
                <c:pt idx="615" formatCode="General">
                  <c:v>7.62959E-2</c:v>
                </c:pt>
                <c:pt idx="616" formatCode="General">
                  <c:v>7.3214399999999999E-2</c:v>
                </c:pt>
                <c:pt idx="617" formatCode="General">
                  <c:v>7.0252999999999996E-2</c:v>
                </c:pt>
                <c:pt idx="618" formatCode="General">
                  <c:v>6.74072E-2</c:v>
                </c:pt>
                <c:pt idx="619" formatCode="General">
                  <c:v>6.4672900000000005E-2</c:v>
                </c:pt>
                <c:pt idx="620" formatCode="General">
                  <c:v>6.2045900000000001E-2</c:v>
                </c:pt>
                <c:pt idx="621" formatCode="General">
                  <c:v>5.7815400000000003E-2</c:v>
                </c:pt>
                <c:pt idx="622" formatCode="General">
                  <c:v>5.3865299999999998E-2</c:v>
                </c:pt>
                <c:pt idx="623" formatCode="General">
                  <c:v>5.0177899999999998E-2</c:v>
                </c:pt>
                <c:pt idx="624" formatCode="General">
                  <c:v>4.6736600000000003E-2</c:v>
                </c:pt>
                <c:pt idx="625" formatCode="General">
                  <c:v>4.3526000000000002E-2</c:v>
                </c:pt>
                <c:pt idx="626" formatCode="General">
                  <c:v>3.9768499999999998E-2</c:v>
                </c:pt>
                <c:pt idx="627" formatCode="General">
                  <c:v>3.6329199999999999E-2</c:v>
                </c:pt>
                <c:pt idx="628" formatCode="General">
                  <c:v>3.3182299999999998E-2</c:v>
                </c:pt>
                <c:pt idx="629" formatCode="General">
                  <c:v>3.0303799999999999E-2</c:v>
                </c:pt>
                <c:pt idx="630" formatCode="General">
                  <c:v>2.7671600000000001E-2</c:v>
                </c:pt>
                <c:pt idx="631" formatCode="General">
                  <c:v>2.52654E-2</c:v>
                </c:pt>
                <c:pt idx="632" formatCode="General">
                  <c:v>2.3066199999999999E-2</c:v>
                </c:pt>
                <c:pt idx="633" formatCode="General">
                  <c:v>2.10569E-2</c:v>
                </c:pt>
                <c:pt idx="634" formatCode="General">
                  <c:v>1.92214E-2</c:v>
                </c:pt>
                <c:pt idx="635" formatCode="General">
                  <c:v>1.7545000000000002E-2</c:v>
                </c:pt>
                <c:pt idx="636" formatCode="General">
                  <c:v>1.6014199999999999E-2</c:v>
                </c:pt>
                <c:pt idx="637" formatCode="General">
                  <c:v>1.46167E-2</c:v>
                </c:pt>
                <c:pt idx="638" formatCode="General">
                  <c:v>1.3341E-2</c:v>
                </c:pt>
                <c:pt idx="639" formatCode="General">
                  <c:v>1.2176599999999999E-2</c:v>
                </c:pt>
                <c:pt idx="640" formatCode="General">
                  <c:v>1.1114000000000001E-2</c:v>
                </c:pt>
                <c:pt idx="641" formatCode="General">
                  <c:v>1.01444E-2</c:v>
                </c:pt>
                <c:pt idx="642" formatCode="General">
                  <c:v>9.2596699999999994E-3</c:v>
                </c:pt>
                <c:pt idx="643" formatCode="General">
                  <c:v>8.4525099999999999E-3</c:v>
                </c:pt>
                <c:pt idx="644" formatCode="General">
                  <c:v>7.7161499999999997E-3</c:v>
                </c:pt>
                <c:pt idx="645" formatCode="General">
                  <c:v>7.0444000000000001E-3</c:v>
                </c:pt>
                <c:pt idx="646" formatCode="General">
                  <c:v>6.4316199999999999E-3</c:v>
                </c:pt>
                <c:pt idx="647" formatCode="General">
                  <c:v>5.7342299999999999E-3</c:v>
                </c:pt>
                <c:pt idx="648" formatCode="General">
                  <c:v>5.1132399999999998E-3</c:v>
                </c:pt>
                <c:pt idx="649" formatCode="General">
                  <c:v>4.5602699999999999E-3</c:v>
                </c:pt>
                <c:pt idx="650" formatCode="General">
                  <c:v>4.0678700000000003E-3</c:v>
                </c:pt>
                <c:pt idx="651" formatCode="General">
                  <c:v>3.7060299999999999E-3</c:v>
                </c:pt>
                <c:pt idx="652" formatCode="General">
                  <c:v>3.44934E-3</c:v>
                </c:pt>
                <c:pt idx="653" formatCode="General">
                  <c:v>3.2107099999999999E-3</c:v>
                </c:pt>
                <c:pt idx="654" formatCode="General">
                  <c:v>3.1701500000000001E-3</c:v>
                </c:pt>
                <c:pt idx="655" formatCode="General">
                  <c:v>3.1301100000000002E-3</c:v>
                </c:pt>
                <c:pt idx="656" formatCode="General">
                  <c:v>3.0905899999999998E-3</c:v>
                </c:pt>
                <c:pt idx="657" formatCode="General">
                  <c:v>3.0515799999999999E-3</c:v>
                </c:pt>
                <c:pt idx="658" formatCode="General">
                  <c:v>3.0130700000000001E-3</c:v>
                </c:pt>
                <c:pt idx="659" formatCode="General">
                  <c:v>2.9383399999999998E-3</c:v>
                </c:pt>
                <c:pt idx="660" formatCode="General">
                  <c:v>2.8655099999999999E-3</c:v>
                </c:pt>
                <c:pt idx="661" formatCode="General">
                  <c:v>2.79451E-3</c:v>
                </c:pt>
                <c:pt idx="662" formatCode="General">
                  <c:v>2.7253099999999999E-3</c:v>
                </c:pt>
                <c:pt idx="663" formatCode="General">
                  <c:v>2.6294700000000001E-3</c:v>
                </c:pt>
                <c:pt idx="664" formatCode="General">
                  <c:v>2.5370700000000002E-3</c:v>
                </c:pt>
                <c:pt idx="665" formatCode="General">
                  <c:v>2.4479800000000002E-3</c:v>
                </c:pt>
                <c:pt idx="666" formatCode="General">
                  <c:v>2.3620799999999999E-3</c:v>
                </c:pt>
                <c:pt idx="667" formatCode="General">
                  <c:v>2.24179E-3</c:v>
                </c:pt>
                <c:pt idx="668" formatCode="General">
                  <c:v>2.1277499999999999E-3</c:v>
                </c:pt>
                <c:pt idx="669" formatCode="General">
                  <c:v>2.0196300000000001E-3</c:v>
                </c:pt>
                <c:pt idx="670" formatCode="General">
                  <c:v>1.91712E-3</c:v>
                </c:pt>
                <c:pt idx="671" formatCode="General">
                  <c:v>1.81992E-3</c:v>
                </c:pt>
                <c:pt idx="672" formatCode="General">
                  <c:v>1.71177E-3</c:v>
                </c:pt>
                <c:pt idx="673" formatCode="General">
                  <c:v>1.6101799999999999E-3</c:v>
                </c:pt>
                <c:pt idx="674" formatCode="General">
                  <c:v>1.51476E-3</c:v>
                </c:pt>
                <c:pt idx="675" formatCode="General">
                  <c:v>1.42512E-3</c:v>
                </c:pt>
                <c:pt idx="676" formatCode="General">
                  <c:v>1.3409100000000001E-3</c:v>
                </c:pt>
                <c:pt idx="677" formatCode="General">
                  <c:v>1.2380799999999999E-3</c:v>
                </c:pt>
                <c:pt idx="678" formatCode="General">
                  <c:v>1.1433299999999999E-3</c:v>
                </c:pt>
                <c:pt idx="679" formatCode="General">
                  <c:v>1.05601E-3</c:v>
                </c:pt>
                <c:pt idx="680" formatCode="General">
                  <c:v>9.7552299999999995E-4</c:v>
                </c:pt>
                <c:pt idx="681" formatCode="General">
                  <c:v>9.0132999999999999E-4</c:v>
                </c:pt>
                <c:pt idx="682" formatCode="General">
                  <c:v>8.3292700000000002E-4</c:v>
                </c:pt>
                <c:pt idx="683" formatCode="General">
                  <c:v>7.6985499999999995E-4</c:v>
                </c:pt>
                <c:pt idx="684" formatCode="General">
                  <c:v>7.2330500000000004E-4</c:v>
                </c:pt>
                <c:pt idx="685" formatCode="General">
                  <c:v>6.7964800000000004E-4</c:v>
                </c:pt>
                <c:pt idx="686" formatCode="General">
                  <c:v>6.38702E-4</c:v>
                </c:pt>
                <c:pt idx="687" formatCode="General">
                  <c:v>6.3273400000000003E-4</c:v>
                </c:pt>
                <c:pt idx="688" formatCode="General">
                  <c:v>6.2682299999999999E-4</c:v>
                </c:pt>
                <c:pt idx="689" formatCode="General">
                  <c:v>6.2096899999999997E-4</c:v>
                </c:pt>
                <c:pt idx="690" formatCode="General">
                  <c:v>6.1517099999999997E-4</c:v>
                </c:pt>
                <c:pt idx="691" formatCode="General">
                  <c:v>6.0942899999999998E-4</c:v>
                </c:pt>
                <c:pt idx="692" formatCode="General">
                  <c:v>6.0100400000000003E-4</c:v>
                </c:pt>
                <c:pt idx="693" formatCode="General">
                  <c:v>5.9269800000000001E-4</c:v>
                </c:pt>
                <c:pt idx="694" formatCode="General">
                  <c:v>5.8451100000000001E-4</c:v>
                </c:pt>
                <c:pt idx="695" formatCode="General">
                  <c:v>5.7644E-4</c:v>
                </c:pt>
                <c:pt idx="696" formatCode="General">
                  <c:v>5.5627900000000002E-4</c:v>
                </c:pt>
                <c:pt idx="697" formatCode="General">
                  <c:v>5.3684399999999997E-4</c:v>
                </c:pt>
                <c:pt idx="698" formatCode="General">
                  <c:v>5.1811000000000001E-4</c:v>
                </c:pt>
                <c:pt idx="699" formatCode="General">
                  <c:v>5.0004900000000002E-4</c:v>
                </c:pt>
                <c:pt idx="700" formatCode="General">
                  <c:v>4.7567099999999999E-4</c:v>
                </c:pt>
                <c:pt idx="701" formatCode="General">
                  <c:v>4.5251699999999999E-4</c:v>
                </c:pt>
                <c:pt idx="702" formatCode="General">
                  <c:v>4.3052599999999998E-4</c:v>
                </c:pt>
                <c:pt idx="703" formatCode="General">
                  <c:v>4.0963700000000002E-4</c:v>
                </c:pt>
                <c:pt idx="704" formatCode="General">
                  <c:v>3.89794E-4</c:v>
                </c:pt>
                <c:pt idx="705" formatCode="General">
                  <c:v>3.67184E-4</c:v>
                </c:pt>
                <c:pt idx="706" formatCode="General">
                  <c:v>3.4592899999999997E-4</c:v>
                </c:pt>
                <c:pt idx="707" formatCode="General">
                  <c:v>3.2594299999999998E-4</c:v>
                </c:pt>
                <c:pt idx="708" formatCode="General">
                  <c:v>3.0715000000000001E-4</c:v>
                </c:pt>
                <c:pt idx="709" formatCode="General">
                  <c:v>2.8947599999999999E-4</c:v>
                </c:pt>
                <c:pt idx="710" formatCode="General">
                  <c:v>2.6789400000000002E-4</c:v>
                </c:pt>
                <c:pt idx="711" formatCode="General">
                  <c:v>2.4797399999999998E-4</c:v>
                </c:pt>
                <c:pt idx="712" formatCode="General">
                  <c:v>2.2958500000000001E-4</c:v>
                </c:pt>
                <c:pt idx="713" formatCode="General">
                  <c:v>2.12606E-4</c:v>
                </c:pt>
                <c:pt idx="714" formatCode="General">
                  <c:v>1.9692599999999999E-4</c:v>
                </c:pt>
                <c:pt idx="715" formatCode="General">
                  <c:v>1.82442E-4</c:v>
                </c:pt>
                <c:pt idx="716" formatCode="General">
                  <c:v>1.6733199999999999E-4</c:v>
                </c:pt>
                <c:pt idx="717" formatCode="General">
                  <c:v>1.5600999999999999E-4</c:v>
                </c:pt>
                <c:pt idx="718" formatCode="General">
                  <c:v>1.5423499999999999E-4</c:v>
                </c:pt>
                <c:pt idx="719" formatCode="General">
                  <c:v>1.5248099999999999E-4</c:v>
                </c:pt>
                <c:pt idx="720" formatCode="General">
                  <c:v>1.50748E-4</c:v>
                </c:pt>
                <c:pt idx="721" formatCode="General">
                  <c:v>1.4903599999999999E-4</c:v>
                </c:pt>
                <c:pt idx="722" formatCode="General">
                  <c:v>1.47343E-4</c:v>
                </c:pt>
                <c:pt idx="723" formatCode="General">
                  <c:v>1.4401799999999999E-4</c:v>
                </c:pt>
                <c:pt idx="724" formatCode="General">
                  <c:v>1.4077100000000001E-4</c:v>
                </c:pt>
                <c:pt idx="725" formatCode="General">
                  <c:v>1.3760000000000001E-4</c:v>
                </c:pt>
                <c:pt idx="726" formatCode="General">
                  <c:v>1.3450300000000001E-4</c:v>
                </c:pt>
                <c:pt idx="727" formatCode="General">
                  <c:v>1.2922500000000001E-4</c:v>
                </c:pt>
                <c:pt idx="728" formatCode="General">
                  <c:v>1.2416200000000001E-4</c:v>
                </c:pt>
                <c:pt idx="729" formatCode="General">
                  <c:v>1.19305E-4</c:v>
                </c:pt>
                <c:pt idx="730" formatCode="General">
                  <c:v>1.14646E-4</c:v>
                </c:pt>
                <c:pt idx="731" formatCode="General">
                  <c:v>1.1017499999999999E-4</c:v>
                </c:pt>
                <c:pt idx="732" formatCode="General">
                  <c:v>1.04064E-4</c:v>
                </c:pt>
                <c:pt idx="733">
                  <c:v>9.8305600000000003E-5</c:v>
                </c:pt>
                <c:pt idx="734">
                  <c:v>9.2877699999999993E-5</c:v>
                </c:pt>
                <c:pt idx="735">
                  <c:v>8.7761200000000003E-5</c:v>
                </c:pt>
                <c:pt idx="736">
                  <c:v>8.2937500000000003E-5</c:v>
                </c:pt>
                <c:pt idx="737">
                  <c:v>7.6518600000000003E-5</c:v>
                </c:pt>
                <c:pt idx="738">
                  <c:v>7.0615699999999995E-5</c:v>
                </c:pt>
                <c:pt idx="739">
                  <c:v>6.5185900000000002E-5</c:v>
                </c:pt>
                <c:pt idx="740">
                  <c:v>6.0189999999999998E-5</c:v>
                </c:pt>
                <c:pt idx="741">
                  <c:v>5.5592199999999999E-5</c:v>
                </c:pt>
                <c:pt idx="742">
                  <c:v>5.1359600000000002E-5</c:v>
                </c:pt>
                <c:pt idx="743">
                  <c:v>4.63491E-5</c:v>
                </c:pt>
                <c:pt idx="744">
                  <c:v>4.1846800000000001E-5</c:v>
                </c:pt>
                <c:pt idx="745">
                  <c:v>3.7799400000000003E-5</c:v>
                </c:pt>
                <c:pt idx="746">
                  <c:v>3.4159299999999997E-5</c:v>
                </c:pt>
                <c:pt idx="747">
                  <c:v>3.0884099999999998E-5</c:v>
                </c:pt>
                <c:pt idx="748">
                  <c:v>2.7935900000000001E-5</c:v>
                </c:pt>
                <c:pt idx="749">
                  <c:v>2.52808E-5</c:v>
                </c:pt>
                <c:pt idx="750">
                  <c:v>2.28888E-5</c:v>
                </c:pt>
                <c:pt idx="751">
                  <c:v>2.0732599999999999E-5</c:v>
                </c:pt>
                <c:pt idx="752">
                  <c:v>1.8788300000000001E-5</c:v>
                </c:pt>
                <c:pt idx="753">
                  <c:v>1.70342E-5</c:v>
                </c:pt>
                <c:pt idx="754">
                  <c:v>1.5451000000000002E-5</c:v>
                </c:pt>
                <c:pt idx="755">
                  <c:v>1.4021499999999999E-5</c:v>
                </c:pt>
                <c:pt idx="756">
                  <c:v>1.273E-5</c:v>
                </c:pt>
                <c:pt idx="757">
                  <c:v>1.1562900000000001E-5</c:v>
                </c:pt>
                <c:pt idx="758">
                  <c:v>1.0507500000000001E-5</c:v>
                </c:pt>
                <c:pt idx="759">
                  <c:v>9.5528900000000006E-6</c:v>
                </c:pt>
                <c:pt idx="760">
                  <c:v>8.6889599999999999E-6</c:v>
                </c:pt>
                <c:pt idx="761">
                  <c:v>7.9067699999999999E-6</c:v>
                </c:pt>
                <c:pt idx="762">
                  <c:v>7.1982599999999999E-6</c:v>
                </c:pt>
                <c:pt idx="763">
                  <c:v>6.5562199999999997E-6</c:v>
                </c:pt>
                <c:pt idx="764">
                  <c:v>5.9741500000000002E-6</c:v>
                </c:pt>
                <c:pt idx="765">
                  <c:v>5.4462200000000002E-6</c:v>
                </c:pt>
                <c:pt idx="766">
                  <c:v>4.9671799999999999E-6</c:v>
                </c:pt>
                <c:pt idx="767">
                  <c:v>4.5323099999999996E-6</c:v>
                </c:pt>
                <c:pt idx="768">
                  <c:v>4.1373600000000001E-6</c:v>
                </c:pt>
                <c:pt idx="769">
                  <c:v>3.77852E-6</c:v>
                </c:pt>
                <c:pt idx="770">
                  <c:v>3.4523299999999999E-6</c:v>
                </c:pt>
                <c:pt idx="771">
                  <c:v>3.1557000000000001E-6</c:v>
                </c:pt>
                <c:pt idx="772">
                  <c:v>2.8858399999999998E-6</c:v>
                </c:pt>
                <c:pt idx="773">
                  <c:v>2.6402199999999999E-6</c:v>
                </c:pt>
                <c:pt idx="774">
                  <c:v>2.41656E-6</c:v>
                </c:pt>
                <c:pt idx="775">
                  <c:v>2.2128199999999999E-6</c:v>
                </c:pt>
                <c:pt idx="776">
                  <c:v>2.0271399999999999E-6</c:v>
                </c:pt>
                <c:pt idx="777">
                  <c:v>1.8578400000000001E-6</c:v>
                </c:pt>
                <c:pt idx="778">
                  <c:v>1.7034300000000001E-6</c:v>
                </c:pt>
                <c:pt idx="779">
                  <c:v>1.54882E-6</c:v>
                </c:pt>
                <c:pt idx="780">
                  <c:v>1.4089800000000001E-6</c:v>
                </c:pt>
                <c:pt idx="781">
                  <c:v>1.28244E-6</c:v>
                </c:pt>
                <c:pt idx="782">
                  <c:v>1.16786E-6</c:v>
                </c:pt>
                <c:pt idx="783">
                  <c:v>1.0640699999999999E-6</c:v>
                </c:pt>
                <c:pt idx="784">
                  <c:v>9.69999E-7</c:v>
                </c:pt>
                <c:pt idx="785">
                  <c:v>8.84697E-7</c:v>
                </c:pt>
                <c:pt idx="786">
                  <c:v>8.0730799999999999E-7</c:v>
                </c:pt>
                <c:pt idx="787">
                  <c:v>7.3706099999999998E-7</c:v>
                </c:pt>
                <c:pt idx="788">
                  <c:v>6.7326499999999996E-7</c:v>
                </c:pt>
                <c:pt idx="789">
                  <c:v>6.1529999999999996E-7</c:v>
                </c:pt>
                <c:pt idx="790">
                  <c:v>5.62607E-7</c:v>
                </c:pt>
                <c:pt idx="791">
                  <c:v>5.1468199999999995E-7</c:v>
                </c:pt>
                <c:pt idx="792">
                  <c:v>4.71072E-7</c:v>
                </c:pt>
                <c:pt idx="793">
                  <c:v>4.3136999999999998E-7</c:v>
                </c:pt>
                <c:pt idx="794">
                  <c:v>3.9520700000000003E-7</c:v>
                </c:pt>
                <c:pt idx="795">
                  <c:v>3.6225299999999998E-7</c:v>
                </c:pt>
                <c:pt idx="796">
                  <c:v>3.3220799999999998E-7</c:v>
                </c:pt>
                <c:pt idx="797">
                  <c:v>3.0480199999999998E-7</c:v>
                </c:pt>
                <c:pt idx="798">
                  <c:v>2.7979100000000002E-7</c:v>
                </c:pt>
                <c:pt idx="799">
                  <c:v>2.5695599999999999E-7</c:v>
                </c:pt>
                <c:pt idx="800">
                  <c:v>2.3403199999999999E-7</c:v>
                </c:pt>
                <c:pt idx="801">
                  <c:v>2.1327600000000001E-7</c:v>
                </c:pt>
                <c:pt idx="802">
                  <c:v>1.94472E-7</c:v>
                </c:pt>
                <c:pt idx="803">
                  <c:v>1.7742799999999999E-7</c:v>
                </c:pt>
                <c:pt idx="804">
                  <c:v>1.6196900000000001E-7</c:v>
                </c:pt>
                <c:pt idx="805">
                  <c:v>1.4794099999999999E-7</c:v>
                </c:pt>
                <c:pt idx="806">
                  <c:v>1.35204E-7</c:v>
                </c:pt>
                <c:pt idx="807">
                  <c:v>1.23632E-7</c:v>
                </c:pt>
                <c:pt idx="808">
                  <c:v>1.13114E-7</c:v>
                </c:pt>
                <c:pt idx="809">
                  <c:v>1.0354699999999999E-7</c:v>
                </c:pt>
                <c:pt idx="810">
                  <c:v>9.4842199999999994E-8</c:v>
                </c:pt>
                <c:pt idx="811">
                  <c:v>8.6916200000000006E-8</c:v>
                </c:pt>
                <c:pt idx="812">
                  <c:v>7.9695899999999996E-8</c:v>
                </c:pt>
                <c:pt idx="813">
                  <c:v>7.3114899999999998E-8</c:v>
                </c:pt>
                <c:pt idx="814">
                  <c:v>6.7113399999999995E-8</c:v>
                </c:pt>
                <c:pt idx="815">
                  <c:v>6.1637300000000001E-8</c:v>
                </c:pt>
                <c:pt idx="816">
                  <c:v>5.6638199999999998E-8</c:v>
                </c:pt>
                <c:pt idx="817">
                  <c:v>5.2071999999999998E-8</c:v>
                </c:pt>
                <c:pt idx="818">
                  <c:v>4.7899100000000003E-8</c:v>
                </c:pt>
                <c:pt idx="819">
                  <c:v>4.4083499999999999E-8</c:v>
                </c:pt>
                <c:pt idx="820">
                  <c:v>4.0592999999999998E-8</c:v>
                </c:pt>
                <c:pt idx="821">
                  <c:v>3.7038600000000003E-8</c:v>
                </c:pt>
                <c:pt idx="822">
                  <c:v>3.3816999999999998E-8</c:v>
                </c:pt>
                <c:pt idx="823">
                  <c:v>3.0895400000000001E-8</c:v>
                </c:pt>
                <c:pt idx="824">
                  <c:v>2.8244000000000001E-8</c:v>
                </c:pt>
                <c:pt idx="825">
                  <c:v>2.5836500000000001E-8</c:v>
                </c:pt>
                <c:pt idx="826">
                  <c:v>2.36489E-8</c:v>
                </c:pt>
                <c:pt idx="827">
                  <c:v>2.166E-8</c:v>
                </c:pt>
                <c:pt idx="828">
                  <c:v>1.9850599999999998E-8</c:v>
                </c:pt>
                <c:pt idx="829">
                  <c:v>1.8203500000000002E-8</c:v>
                </c:pt>
                <c:pt idx="830">
                  <c:v>1.6703200000000002E-8</c:v>
                </c:pt>
                <c:pt idx="831">
                  <c:v>1.5335800000000002E-8</c:v>
                </c:pt>
                <c:pt idx="832">
                  <c:v>1.4088899999999999E-8</c:v>
                </c:pt>
                <c:pt idx="833">
                  <c:v>1.29511E-8</c:v>
                </c:pt>
                <c:pt idx="834">
                  <c:v>1.19122E-8</c:v>
                </c:pt>
                <c:pt idx="835">
                  <c:v>1.0963100000000001E-8</c:v>
                </c:pt>
                <c:pt idx="836">
                  <c:v>1.00956E-8</c:v>
                </c:pt>
                <c:pt idx="837">
                  <c:v>9.3020800000000002E-9</c:v>
                </c:pt>
                <c:pt idx="838">
                  <c:v>8.5759199999999995E-9</c:v>
                </c:pt>
                <c:pt idx="839">
                  <c:v>7.8405700000000008E-9</c:v>
                </c:pt>
                <c:pt idx="840">
                  <c:v>7.1733300000000001E-9</c:v>
                </c:pt>
                <c:pt idx="841">
                  <c:v>6.5674600000000004E-9</c:v>
                </c:pt>
                <c:pt idx="842">
                  <c:v>6.0169300000000002E-9</c:v>
                </c:pt>
                <c:pt idx="843">
                  <c:v>5.5163500000000003E-9</c:v>
                </c:pt>
                <c:pt idx="844">
                  <c:v>5.0608799999999996E-9</c:v>
                </c:pt>
                <c:pt idx="845">
                  <c:v>4.6461599999999996E-9</c:v>
                </c:pt>
                <c:pt idx="846">
                  <c:v>4.2683100000000001E-9</c:v>
                </c:pt>
                <c:pt idx="847">
                  <c:v>3.9238099999999999E-9</c:v>
                </c:pt>
                <c:pt idx="848">
                  <c:v>3.6095099999999999E-9</c:v>
                </c:pt>
                <c:pt idx="849">
                  <c:v>3.3225799999999999E-9</c:v>
                </c:pt>
                <c:pt idx="850">
                  <c:v>3.0604500000000001E-9</c:v>
                </c:pt>
                <c:pt idx="851">
                  <c:v>2.8208399999999999E-9</c:v>
                </c:pt>
                <c:pt idx="852">
                  <c:v>2.6016700000000002E-9</c:v>
                </c:pt>
                <c:pt idx="853">
                  <c:v>2.4010699999999999E-9</c:v>
                </c:pt>
                <c:pt idx="854">
                  <c:v>2.1988100000000002E-9</c:v>
                </c:pt>
                <c:pt idx="855">
                  <c:v>2.01515E-9</c:v>
                </c:pt>
                <c:pt idx="856">
                  <c:v>1.84824E-9</c:v>
                </c:pt>
                <c:pt idx="857">
                  <c:v>1.69644E-9</c:v>
                </c:pt>
                <c:pt idx="858">
                  <c:v>1.5582799999999999E-9</c:v>
                </c:pt>
                <c:pt idx="859">
                  <c:v>1.4324499999999999E-9</c:v>
                </c:pt>
                <c:pt idx="860">
                  <c:v>1.3177499999999999E-9</c:v>
                </c:pt>
                <c:pt idx="861">
                  <c:v>1.21312E-9</c:v>
                </c:pt>
                <c:pt idx="862">
                  <c:v>1.1176199999999999E-9</c:v>
                </c:pt>
                <c:pt idx="863">
                  <c:v>1.0303799999999999E-9</c:v>
                </c:pt>
                <c:pt idx="864">
                  <c:v>9.5063299999999998E-10</c:v>
                </c:pt>
                <c:pt idx="865">
                  <c:v>8.7768100000000002E-10</c:v>
                </c:pt>
                <c:pt idx="866">
                  <c:v>8.1089899999999995E-10</c:v>
                </c:pt>
                <c:pt idx="867">
                  <c:v>7.4972400000000001E-10</c:v>
                </c:pt>
                <c:pt idx="868">
                  <c:v>6.9364400000000003E-10</c:v>
                </c:pt>
                <c:pt idx="869">
                  <c:v>6.3655499999999998E-10</c:v>
                </c:pt>
                <c:pt idx="870">
                  <c:v>5.8466100000000003E-10</c:v>
                </c:pt>
                <c:pt idx="871">
                  <c:v>5.3745000000000004E-10</c:v>
                </c:pt>
                <c:pt idx="872">
                  <c:v>4.9446199999999998E-10</c:v>
                </c:pt>
                <c:pt idx="873">
                  <c:v>4.5528899999999998E-10</c:v>
                </c:pt>
                <c:pt idx="874">
                  <c:v>4.1956300000000002E-10</c:v>
                </c:pt>
                <c:pt idx="875">
                  <c:v>3.8695399999999998E-10</c:v>
                </c:pt>
                <c:pt idx="876">
                  <c:v>3.5716699999999999E-10</c:v>
                </c:pt>
                <c:pt idx="877">
                  <c:v>3.2993500000000001E-10</c:v>
                </c:pt>
                <c:pt idx="878">
                  <c:v>3.0502100000000001E-10</c:v>
                </c:pt>
                <c:pt idx="879">
                  <c:v>2.8220799999999998E-10</c:v>
                </c:pt>
                <c:pt idx="880">
                  <c:v>2.6130500000000001E-10</c:v>
                </c:pt>
                <c:pt idx="881">
                  <c:v>2.4213600000000002E-10</c:v>
                </c:pt>
                <c:pt idx="882">
                  <c:v>2.2454399999999999E-10</c:v>
                </c:pt>
                <c:pt idx="883">
                  <c:v>2.0838699999999999E-10</c:v>
                </c:pt>
                <c:pt idx="884">
                  <c:v>1.9175600000000001E-10</c:v>
                </c:pt>
                <c:pt idx="885">
                  <c:v>1.7661700000000001E-10</c:v>
                </c:pt>
                <c:pt idx="886">
                  <c:v>1.62825E-10</c:v>
                </c:pt>
                <c:pt idx="887">
                  <c:v>1.5024800000000001E-10</c:v>
                </c:pt>
                <c:pt idx="888">
                  <c:v>1.3876899999999999E-10</c:v>
                </c:pt>
                <c:pt idx="889">
                  <c:v>1.28283E-10</c:v>
                </c:pt>
                <c:pt idx="890">
                  <c:v>1.18695E-10</c:v>
                </c:pt>
                <c:pt idx="891">
                  <c:v>1.0991999999999999E-10</c:v>
                </c:pt>
                <c:pt idx="892">
                  <c:v>1.01883E-10</c:v>
                </c:pt>
                <c:pt idx="893">
                  <c:v>9.4515800000000006E-11</c:v>
                </c:pt>
                <c:pt idx="894">
                  <c:v>8.7756299999999999E-11</c:v>
                </c:pt>
                <c:pt idx="895">
                  <c:v>8.1549399999999995E-11</c:v>
                </c:pt>
                <c:pt idx="896">
                  <c:v>7.5845100000000004E-11</c:v>
                </c:pt>
                <c:pt idx="897">
                  <c:v>7.0598400000000001E-11</c:v>
                </c:pt>
                <c:pt idx="898">
                  <c:v>6.5768800000000001E-11</c:v>
                </c:pt>
                <c:pt idx="899">
                  <c:v>6.1319499999999997E-11</c:v>
                </c:pt>
                <c:pt idx="900">
                  <c:v>5.7217300000000003E-11</c:v>
                </c:pt>
                <c:pt idx="901">
                  <c:v>5.4097800000000002E-11</c:v>
                </c:pt>
                <c:pt idx="902">
                  <c:v>5.1175499999999998E-11</c:v>
                </c:pt>
                <c:pt idx="903">
                  <c:v>4.8436499999999999E-11</c:v>
                </c:pt>
                <c:pt idx="904">
                  <c:v>4.5868000000000001E-11</c:v>
                </c:pt>
                <c:pt idx="905">
                  <c:v>4.34581E-11</c:v>
                </c:pt>
                <c:pt idx="906">
                  <c:v>4.1196000000000002E-11</c:v>
                </c:pt>
                <c:pt idx="907">
                  <c:v>3.88217E-11</c:v>
                </c:pt>
                <c:pt idx="908">
                  <c:v>3.6607500000000001E-11</c:v>
                </c:pt>
                <c:pt idx="909">
                  <c:v>3.4541299999999999E-11</c:v>
                </c:pt>
                <c:pt idx="910">
                  <c:v>3.2611900000000002E-11</c:v>
                </c:pt>
                <c:pt idx="911">
                  <c:v>3.0809299999999998E-11</c:v>
                </c:pt>
                <c:pt idx="912">
                  <c:v>2.91241E-11</c:v>
                </c:pt>
                <c:pt idx="913">
                  <c:v>2.7547700000000001E-11</c:v>
                </c:pt>
                <c:pt idx="914">
                  <c:v>2.60723E-11</c:v>
                </c:pt>
                <c:pt idx="915">
                  <c:v>2.4690600000000001E-11</c:v>
                </c:pt>
                <c:pt idx="916">
                  <c:v>2.33958E-11</c:v>
                </c:pt>
                <c:pt idx="917">
                  <c:v>2.21818E-11</c:v>
                </c:pt>
                <c:pt idx="918">
                  <c:v>2.1042999999999999E-11</c:v>
                </c:pt>
                <c:pt idx="919">
                  <c:v>1.9974100000000001E-11</c:v>
                </c:pt>
                <c:pt idx="920">
                  <c:v>1.8970199999999999E-11</c:v>
                </c:pt>
                <c:pt idx="921">
                  <c:v>1.88102E-11</c:v>
                </c:pt>
                <c:pt idx="922">
                  <c:v>1.86519E-11</c:v>
                </c:pt>
                <c:pt idx="923">
                  <c:v>1.8495199999999999E-11</c:v>
                </c:pt>
                <c:pt idx="924">
                  <c:v>1.8340100000000001E-11</c:v>
                </c:pt>
                <c:pt idx="925">
                  <c:v>1.81865E-11</c:v>
                </c:pt>
                <c:pt idx="926">
                  <c:v>1.7884099999999999E-11</c:v>
                </c:pt>
                <c:pt idx="927">
                  <c:v>1.7587800000000001E-11</c:v>
                </c:pt>
                <c:pt idx="928">
                  <c:v>1.7297399999999999E-11</c:v>
                </c:pt>
                <c:pt idx="929">
                  <c:v>1.7012900000000002E-11</c:v>
                </c:pt>
                <c:pt idx="930">
                  <c:v>1.6439599999999999E-11</c:v>
                </c:pt>
                <c:pt idx="931">
                  <c:v>1.5889700000000001E-11</c:v>
                </c:pt>
                <c:pt idx="932">
                  <c:v>1.53621E-11</c:v>
                </c:pt>
                <c:pt idx="933">
                  <c:v>1.48558E-11</c:v>
                </c:pt>
                <c:pt idx="934">
                  <c:v>1.43699E-11</c:v>
                </c:pt>
                <c:pt idx="935">
                  <c:v>1.37268E-11</c:v>
                </c:pt>
                <c:pt idx="936">
                  <c:v>1.3118799999999999E-11</c:v>
                </c:pt>
                <c:pt idx="937">
                  <c:v>1.25437E-11</c:v>
                </c:pt>
                <c:pt idx="938">
                  <c:v>1.19994E-11</c:v>
                </c:pt>
                <c:pt idx="939">
                  <c:v>1.14842E-11</c:v>
                </c:pt>
                <c:pt idx="940">
                  <c:v>1.08006E-11</c:v>
                </c:pt>
                <c:pt idx="941">
                  <c:v>1.0167000000000001E-11</c:v>
                </c:pt>
                <c:pt idx="942">
                  <c:v>9.5793300000000001E-12</c:v>
                </c:pt>
                <c:pt idx="943">
                  <c:v>9.0337099999999995E-12</c:v>
                </c:pt>
                <c:pt idx="944">
                  <c:v>8.5267E-12</c:v>
                </c:pt>
                <c:pt idx="945">
                  <c:v>8.0551899999999997E-12</c:v>
                </c:pt>
                <c:pt idx="946">
                  <c:v>7.4313699999999997E-12</c:v>
                </c:pt>
                <c:pt idx="947">
                  <c:v>6.86798E-12</c:v>
                </c:pt>
                <c:pt idx="948">
                  <c:v>6.3583400000000001E-12</c:v>
                </c:pt>
                <c:pt idx="949">
                  <c:v>5.89655E-12</c:v>
                </c:pt>
                <c:pt idx="950">
                  <c:v>5.47746E-12</c:v>
                </c:pt>
                <c:pt idx="951">
                  <c:v>5.0965199999999998E-12</c:v>
                </c:pt>
                <c:pt idx="952">
                  <c:v>4.7497299999999998E-12</c:v>
                </c:pt>
                <c:pt idx="953">
                  <c:v>4.4335600000000003E-12</c:v>
                </c:pt>
                <c:pt idx="954">
                  <c:v>4.14488E-12</c:v>
                </c:pt>
                <c:pt idx="955">
                  <c:v>3.88092E-12</c:v>
                </c:pt>
                <c:pt idx="956">
                  <c:v>3.6392299999999996E-12</c:v>
                </c:pt>
                <c:pt idx="957">
                  <c:v>3.4176200000000001E-12</c:v>
                </c:pt>
                <c:pt idx="958">
                  <c:v>3.21415E-12</c:v>
                </c:pt>
                <c:pt idx="959">
                  <c:v>3.0270900000000002E-12</c:v>
                </c:pt>
                <c:pt idx="960">
                  <c:v>2.8548999999999999E-12</c:v>
                </c:pt>
                <c:pt idx="961">
                  <c:v>2.6744E-12</c:v>
                </c:pt>
                <c:pt idx="962">
                  <c:v>2.5097199999999999E-12</c:v>
                </c:pt>
                <c:pt idx="963">
                  <c:v>2.3592299999999998E-12</c:v>
                </c:pt>
                <c:pt idx="964">
                  <c:v>2.2215000000000002E-12</c:v>
                </c:pt>
                <c:pt idx="965">
                  <c:v>2.0952699999999998E-12</c:v>
                </c:pt>
                <c:pt idx="966">
                  <c:v>1.9793999999999998E-12</c:v>
                </c:pt>
                <c:pt idx="967">
                  <c:v>1.8601700000000001E-12</c:v>
                </c:pt>
                <c:pt idx="968">
                  <c:v>1.7515499999999999E-12</c:v>
                </c:pt>
                <c:pt idx="969">
                  <c:v>1.6524199999999999E-12</c:v>
                </c:pt>
                <c:pt idx="970">
                  <c:v>1.5618199999999999E-12</c:v>
                </c:pt>
                <c:pt idx="971">
                  <c:v>1.47889E-12</c:v>
                </c:pt>
                <c:pt idx="972">
                  <c:v>1.40285E-12</c:v>
                </c:pt>
                <c:pt idx="973">
                  <c:v>1.32419E-12</c:v>
                </c:pt>
                <c:pt idx="974">
                  <c:v>1.25267E-12</c:v>
                </c:pt>
                <c:pt idx="975">
                  <c:v>1.1875300000000001E-12</c:v>
                </c:pt>
                <c:pt idx="976">
                  <c:v>1.1280900000000001E-12</c:v>
                </c:pt>
                <c:pt idx="977">
                  <c:v>1.07379E-12</c:v>
                </c:pt>
                <c:pt idx="978">
                  <c:v>1.02411E-12</c:v>
                </c:pt>
                <c:pt idx="979">
                  <c:v>9.7194500000000006E-13</c:v>
                </c:pt>
                <c:pt idx="980">
                  <c:v>9.2470900000000003E-13</c:v>
                </c:pt>
                <c:pt idx="981">
                  <c:v>8.8187100000000003E-13</c:v>
                </c:pt>
                <c:pt idx="982">
                  <c:v>8.4296800000000005E-13</c:v>
                </c:pt>
                <c:pt idx="983">
                  <c:v>8.0759200000000004E-13</c:v>
                </c:pt>
                <c:pt idx="984">
                  <c:v>7.7538699999999998E-13</c:v>
                </c:pt>
                <c:pt idx="985">
                  <c:v>7.4116199999999999E-13</c:v>
                </c:pt>
                <c:pt idx="986">
                  <c:v>7.1044599999999998E-13</c:v>
                </c:pt>
                <c:pt idx="987">
                  <c:v>6.8285599999999999E-13</c:v>
                </c:pt>
                <c:pt idx="988">
                  <c:v>6.5806000000000003E-13</c:v>
                </c:pt>
                <c:pt idx="989">
                  <c:v>6.3577000000000003E-13</c:v>
                </c:pt>
                <c:pt idx="990">
                  <c:v>6.1978499999999997E-13</c:v>
                </c:pt>
                <c:pt idx="991">
                  <c:v>6.0767900000000002E-13</c:v>
                </c:pt>
                <c:pt idx="992">
                  <c:v>5.9638499999999999E-13</c:v>
                </c:pt>
                <c:pt idx="993">
                  <c:v>5.8759899999999997E-13</c:v>
                </c:pt>
                <c:pt idx="994">
                  <c:v>5.7930999999999998E-13</c:v>
                </c:pt>
                <c:pt idx="995">
                  <c:v>5.7149599999999995E-13</c:v>
                </c:pt>
                <c:pt idx="996">
                  <c:v>5.6413199999999998E-13</c:v>
                </c:pt>
                <c:pt idx="997">
                  <c:v>5.5719699999999997E-13</c:v>
                </c:pt>
                <c:pt idx="998">
                  <c:v>5.5067199999999996E-13</c:v>
                </c:pt>
                <c:pt idx="999">
                  <c:v>5.4453799999999998E-13</c:v>
                </c:pt>
                <c:pt idx="1000">
                  <c:v>5.3877700000000004E-13</c:v>
                </c:pt>
                <c:pt idx="1001">
                  <c:v>5.3337399999999996E-13</c:v>
                </c:pt>
                <c:pt idx="1002">
                  <c:v>5.2831399999999998E-13</c:v>
                </c:pt>
                <c:pt idx="1003">
                  <c:v>5.2257999999999998E-13</c:v>
                </c:pt>
                <c:pt idx="1004">
                  <c:v>5.1731100000000002E-13</c:v>
                </c:pt>
                <c:pt idx="1005">
                  <c:v>5.1248500000000001E-13</c:v>
                </c:pt>
                <c:pt idx="1006">
                  <c:v>5.0808099999999996E-13</c:v>
                </c:pt>
                <c:pt idx="1007">
                  <c:v>5.0356199999999997E-13</c:v>
                </c:pt>
                <c:pt idx="1008">
                  <c:v>4.9953900000000004E-13</c:v>
                </c:pt>
                <c:pt idx="1009">
                  <c:v>4.9599099999999996E-13</c:v>
                </c:pt>
                <c:pt idx="1010">
                  <c:v>4.9289400000000002E-13</c:v>
                </c:pt>
                <c:pt idx="1011">
                  <c:v>4.89987E-13</c:v>
                </c:pt>
                <c:pt idx="1012">
                  <c:v>4.8758000000000003E-13</c:v>
                </c:pt>
                <c:pt idx="1013">
                  <c:v>4.8565400000000004E-13</c:v>
                </c:pt>
                <c:pt idx="1014">
                  <c:v>4.8418800000000004E-13</c:v>
                </c:pt>
                <c:pt idx="1015">
                  <c:v>4.8316599999999996E-13</c:v>
                </c:pt>
                <c:pt idx="1016">
                  <c:v>4.8240599999999997E-13</c:v>
                </c:pt>
                <c:pt idx="1017">
                  <c:v>4.8277900000000002E-13</c:v>
                </c:pt>
                <c:pt idx="1018">
                  <c:v>4.8423199999999999E-13</c:v>
                </c:pt>
                <c:pt idx="1019">
                  <c:v>4.8672399999999996E-13</c:v>
                </c:pt>
                <c:pt idx="1020">
                  <c:v>4.9022099999999998E-13</c:v>
                </c:pt>
                <c:pt idx="1021">
                  <c:v>4.9619300000000004E-13</c:v>
                </c:pt>
                <c:pt idx="1022">
                  <c:v>5.0376299999999998E-13</c:v>
                </c:pt>
                <c:pt idx="1023">
                  <c:v>5.1290500000000002E-13</c:v>
                </c:pt>
                <c:pt idx="1024">
                  <c:v>5.2360899999999996E-13</c:v>
                </c:pt>
                <c:pt idx="1025">
                  <c:v>5.3587700000000002E-13</c:v>
                </c:pt>
                <c:pt idx="1026">
                  <c:v>5.4972399999999999E-13</c:v>
                </c:pt>
                <c:pt idx="1027">
                  <c:v>5.74289E-13</c:v>
                </c:pt>
                <c:pt idx="1028">
                  <c:v>6.0282800000000002E-13</c:v>
                </c:pt>
                <c:pt idx="1029">
                  <c:v>6.3553700000000002E-13</c:v>
                </c:pt>
                <c:pt idx="1030">
                  <c:v>6.7266099999999995E-13</c:v>
                </c:pt>
                <c:pt idx="1031">
                  <c:v>7.1449799999999999E-13</c:v>
                </c:pt>
                <c:pt idx="1032">
                  <c:v>7.6139599999999998E-13</c:v>
                </c:pt>
                <c:pt idx="1033">
                  <c:v>8.2240300000000002E-13</c:v>
                </c:pt>
                <c:pt idx="1034">
                  <c:v>8.9141199999999998E-13</c:v>
                </c:pt>
                <c:pt idx="1035">
                  <c:v>9.692369999999999E-13</c:v>
                </c:pt>
                <c:pt idx="1036">
                  <c:v>1.0567999999999999E-12</c:v>
                </c:pt>
                <c:pt idx="1037">
                  <c:v>1.1551600000000001E-12</c:v>
                </c:pt>
                <c:pt idx="1038">
                  <c:v>1.26548E-12</c:v>
                </c:pt>
                <c:pt idx="1039">
                  <c:v>1.3891099999999999E-12</c:v>
                </c:pt>
                <c:pt idx="1040">
                  <c:v>1.5275300000000001E-12</c:v>
                </c:pt>
                <c:pt idx="1041">
                  <c:v>1.6824100000000001E-12</c:v>
                </c:pt>
                <c:pt idx="1042">
                  <c:v>1.7066599999999999E-12</c:v>
                </c:pt>
                <c:pt idx="1043">
                  <c:v>1.73131E-12</c:v>
                </c:pt>
                <c:pt idx="1044">
                  <c:v>1.75636E-12</c:v>
                </c:pt>
                <c:pt idx="1045">
                  <c:v>1.7818300000000001E-12</c:v>
                </c:pt>
                <c:pt idx="1046">
                  <c:v>1.80773E-12</c:v>
                </c:pt>
                <c:pt idx="1047">
                  <c:v>1.8340400000000001E-12</c:v>
                </c:pt>
                <c:pt idx="1048">
                  <c:v>1.8665099999999999E-12</c:v>
                </c:pt>
                <c:pt idx="1049">
                  <c:v>1.8996300000000001E-12</c:v>
                </c:pt>
                <c:pt idx="1050">
                  <c:v>1.9334099999999999E-12</c:v>
                </c:pt>
                <c:pt idx="1051">
                  <c:v>1.9678700000000002E-12</c:v>
                </c:pt>
                <c:pt idx="1052">
                  <c:v>2.0030200000000001E-12</c:v>
                </c:pt>
                <c:pt idx="1053">
                  <c:v>2.0849400000000002E-12</c:v>
                </c:pt>
                <c:pt idx="1054">
                  <c:v>2.1706100000000002E-12</c:v>
                </c:pt>
                <c:pt idx="1055">
                  <c:v>2.2601800000000002E-12</c:v>
                </c:pt>
                <c:pt idx="1056">
                  <c:v>2.3538299999999999E-12</c:v>
                </c:pt>
                <c:pt idx="1057">
                  <c:v>2.4517499999999999E-12</c:v>
                </c:pt>
                <c:pt idx="1058">
                  <c:v>2.64352E-12</c:v>
                </c:pt>
                <c:pt idx="1059">
                  <c:v>2.8516099999999998E-12</c:v>
                </c:pt>
                <c:pt idx="1060">
                  <c:v>3.0774099999999999E-12</c:v>
                </c:pt>
                <c:pt idx="1061">
                  <c:v>3.3223899999999999E-12</c:v>
                </c:pt>
                <c:pt idx="1062">
                  <c:v>3.58817E-12</c:v>
                </c:pt>
                <c:pt idx="1063">
                  <c:v>3.8765099999999996E-12</c:v>
                </c:pt>
                <c:pt idx="1064">
                  <c:v>4.3263899999999997E-12</c:v>
                </c:pt>
                <c:pt idx="1065">
                  <c:v>4.8311100000000004E-12</c:v>
                </c:pt>
                <c:pt idx="1066">
                  <c:v>5.3973300000000004E-12</c:v>
                </c:pt>
                <c:pt idx="1067">
                  <c:v>6.0325299999999999E-12</c:v>
                </c:pt>
                <c:pt idx="1068">
                  <c:v>6.7450800000000002E-12</c:v>
                </c:pt>
                <c:pt idx="1069">
                  <c:v>7.5443699999999997E-12</c:v>
                </c:pt>
                <c:pt idx="1070">
                  <c:v>8.4409400000000002E-12</c:v>
                </c:pt>
                <c:pt idx="1071">
                  <c:v>9.4466200000000008E-12</c:v>
                </c:pt>
                <c:pt idx="1072">
                  <c:v>1.0574699999999999E-11</c:v>
                </c:pt>
                <c:pt idx="1073">
                  <c:v>1.18399E-11</c:v>
                </c:pt>
                <c:pt idx="1074">
                  <c:v>1.32591E-11</c:v>
                </c:pt>
                <c:pt idx="1075">
                  <c:v>1.4851000000000001E-11</c:v>
                </c:pt>
                <c:pt idx="1076">
                  <c:v>1.66364E-11</c:v>
                </c:pt>
                <c:pt idx="1077">
                  <c:v>1.8639000000000001E-11</c:v>
                </c:pt>
                <c:pt idx="1078">
                  <c:v>2.08851E-11</c:v>
                </c:pt>
                <c:pt idx="1079">
                  <c:v>2.3404400000000002E-11</c:v>
                </c:pt>
                <c:pt idx="1080">
                  <c:v>2.6230099999999999E-11</c:v>
                </c:pt>
                <c:pt idx="1081">
                  <c:v>2.93993E-11</c:v>
                </c:pt>
                <c:pt idx="1082">
                  <c:v>3.2954000000000002E-11</c:v>
                </c:pt>
                <c:pt idx="1083">
                  <c:v>3.69408E-11</c:v>
                </c:pt>
                <c:pt idx="1084">
                  <c:v>4.1412499999999998E-11</c:v>
                </c:pt>
                <c:pt idx="1085">
                  <c:v>4.6427899999999998E-11</c:v>
                </c:pt>
                <c:pt idx="1086">
                  <c:v>5.2053099999999997E-11</c:v>
                </c:pt>
                <c:pt idx="1087">
                  <c:v>5.8362300000000002E-11</c:v>
                </c:pt>
                <c:pt idx="1088">
                  <c:v>6.5438600000000002E-11</c:v>
                </c:pt>
                <c:pt idx="1089">
                  <c:v>7.3375299999999997E-11</c:v>
                </c:pt>
                <c:pt idx="1090">
                  <c:v>8.2276999999999999E-11</c:v>
                </c:pt>
                <c:pt idx="1091">
                  <c:v>9.2261100000000002E-11</c:v>
                </c:pt>
                <c:pt idx="1092">
                  <c:v>1.03459E-10</c:v>
                </c:pt>
                <c:pt idx="1093">
                  <c:v>1.16018E-10</c:v>
                </c:pt>
                <c:pt idx="1094">
                  <c:v>1.3010500000000001E-10</c:v>
                </c:pt>
                <c:pt idx="1095">
                  <c:v>1.4590399999999999E-10</c:v>
                </c:pt>
                <c:pt idx="1096">
                  <c:v>1.6362400000000001E-10</c:v>
                </c:pt>
                <c:pt idx="1097">
                  <c:v>1.83498E-10</c:v>
                </c:pt>
                <c:pt idx="1098">
                  <c:v>2.05788E-10</c:v>
                </c:pt>
                <c:pt idx="1099">
                  <c:v>2.30789E-10</c:v>
                </c:pt>
                <c:pt idx="1100">
                  <c:v>2.5882900000000002E-10</c:v>
                </c:pt>
                <c:pt idx="1101">
                  <c:v>2.9027799999999999E-10</c:v>
                </c:pt>
                <c:pt idx="1102">
                  <c:v>3.2554999999999998E-10</c:v>
                </c:pt>
                <c:pt idx="1103">
                  <c:v>3.65111E-10</c:v>
                </c:pt>
                <c:pt idx="1104">
                  <c:v>4.0948100000000003E-10</c:v>
                </c:pt>
                <c:pt idx="1105">
                  <c:v>4.5924600000000001E-10</c:v>
                </c:pt>
                <c:pt idx="1106">
                  <c:v>5.1506099999999999E-10</c:v>
                </c:pt>
                <c:pt idx="1107">
                  <c:v>5.7766099999999996E-10</c:v>
                </c:pt>
                <c:pt idx="1108">
                  <c:v>6.4787099999999996E-10</c:v>
                </c:pt>
                <c:pt idx="1109">
                  <c:v>7.2661699999999999E-10</c:v>
                </c:pt>
                <c:pt idx="1110">
                  <c:v>8.1493699999999995E-10</c:v>
                </c:pt>
                <c:pt idx="1111">
                  <c:v>9.1399299999999999E-10</c:v>
                </c:pt>
                <c:pt idx="1112">
                  <c:v>1.02509E-9</c:v>
                </c:pt>
                <c:pt idx="1113">
                  <c:v>1.1497000000000001E-9</c:v>
                </c:pt>
                <c:pt idx="1114">
                  <c:v>1.2894499999999999E-9</c:v>
                </c:pt>
                <c:pt idx="1115">
                  <c:v>1.4461899999999999E-9</c:v>
                </c:pt>
                <c:pt idx="1116">
                  <c:v>1.6219900000000001E-9</c:v>
                </c:pt>
                <c:pt idx="1117">
                  <c:v>1.81916E-9</c:v>
                </c:pt>
                <c:pt idx="1118">
                  <c:v>2.0402900000000002E-9</c:v>
                </c:pt>
                <c:pt idx="1119">
                  <c:v>2.2883099999999999E-9</c:v>
                </c:pt>
                <c:pt idx="1120">
                  <c:v>2.56648E-9</c:v>
                </c:pt>
                <c:pt idx="1121">
                  <c:v>2.8784699999999999E-9</c:v>
                </c:pt>
                <c:pt idx="1122">
                  <c:v>3.22838E-9</c:v>
                </c:pt>
                <c:pt idx="1123">
                  <c:v>3.6208199999999999E-9</c:v>
                </c:pt>
                <c:pt idx="1124">
                  <c:v>4.0609800000000002E-9</c:v>
                </c:pt>
                <c:pt idx="1125">
                  <c:v>4.5546400000000003E-9</c:v>
                </c:pt>
                <c:pt idx="1126">
                  <c:v>5.1083099999999997E-9</c:v>
                </c:pt>
                <c:pt idx="1127">
                  <c:v>5.7292800000000003E-9</c:v>
                </c:pt>
                <c:pt idx="1128">
                  <c:v>6.4257399999999998E-9</c:v>
                </c:pt>
                <c:pt idx="1129">
                  <c:v>7.2068700000000004E-9</c:v>
                </c:pt>
                <c:pt idx="1130">
                  <c:v>8.0829399999999994E-9</c:v>
                </c:pt>
                <c:pt idx="1131">
                  <c:v>9.0655099999999992E-9</c:v>
                </c:pt>
                <c:pt idx="1132">
                  <c:v>1.01675E-8</c:v>
                </c:pt>
                <c:pt idx="1133">
                  <c:v>1.14035E-8</c:v>
                </c:pt>
                <c:pt idx="1134">
                  <c:v>1.2789699999999999E-8</c:v>
                </c:pt>
                <c:pt idx="1135">
                  <c:v>1.4344399999999999E-8</c:v>
                </c:pt>
                <c:pt idx="1136">
                  <c:v>1.60881E-8</c:v>
                </c:pt>
                <c:pt idx="1137">
                  <c:v>1.80437E-8</c:v>
                </c:pt>
                <c:pt idx="1138">
                  <c:v>2.02371E-8</c:v>
                </c:pt>
                <c:pt idx="1139">
                  <c:v>2.26971E-8</c:v>
                </c:pt>
                <c:pt idx="1140">
                  <c:v>2.5456099999999999E-8</c:v>
                </c:pt>
                <c:pt idx="1141">
                  <c:v>2.8550500000000001E-8</c:v>
                </c:pt>
                <c:pt idx="1142">
                  <c:v>3.2020999999999999E-8</c:v>
                </c:pt>
                <c:pt idx="1143">
                  <c:v>3.5913300000000002E-8</c:v>
                </c:pt>
                <c:pt idx="1144">
                  <c:v>4.0278800000000002E-8</c:v>
                </c:pt>
                <c:pt idx="1145">
                  <c:v>4.51749E-8</c:v>
                </c:pt>
                <c:pt idx="1146">
                  <c:v>5.0666099999999997E-8</c:v>
                </c:pt>
                <c:pt idx="1147">
                  <c:v>5.6824699999999998E-8</c:v>
                </c:pt>
                <c:pt idx="1148">
                  <c:v>6.3732000000000004E-8</c:v>
                </c:pt>
                <c:pt idx="1149">
                  <c:v>7.1478800000000003E-8</c:v>
                </c:pt>
                <c:pt idx="1150">
                  <c:v>8.0167299999999996E-8</c:v>
                </c:pt>
                <c:pt idx="1151">
                  <c:v>8.9911799999999994E-8</c:v>
                </c:pt>
                <c:pt idx="1152">
                  <c:v>1.00841E-7</c:v>
                </c:pt>
                <c:pt idx="1153">
                  <c:v>1.13098E-7</c:v>
                </c:pt>
                <c:pt idx="1154">
                  <c:v>1.26845E-7</c:v>
                </c:pt>
                <c:pt idx="1155">
                  <c:v>1.4226300000000001E-7</c:v>
                </c:pt>
                <c:pt idx="1156">
                  <c:v>1.59555E-7</c:v>
                </c:pt>
                <c:pt idx="1157">
                  <c:v>1.78949E-7</c:v>
                </c:pt>
                <c:pt idx="1158">
                  <c:v>2.0069999999999999E-7</c:v>
                </c:pt>
                <c:pt idx="1159">
                  <c:v>2.2509499999999999E-7</c:v>
                </c:pt>
                <c:pt idx="1160">
                  <c:v>2.5245400000000002E-7</c:v>
                </c:pt>
                <c:pt idx="1161">
                  <c:v>2.8313999999999998E-7</c:v>
                </c:pt>
                <c:pt idx="1162">
                  <c:v>3.1755399999999999E-7</c:v>
                </c:pt>
                <c:pt idx="1163">
                  <c:v>3.5615200000000002E-7</c:v>
                </c:pt>
                <c:pt idx="1164">
                  <c:v>3.9943999999999998E-7</c:v>
                </c:pt>
                <c:pt idx="1165">
                  <c:v>4.47991E-7</c:v>
                </c:pt>
                <c:pt idx="1166">
                  <c:v>5.0244100000000002E-7</c:v>
                </c:pt>
                <c:pt idx="1167">
                  <c:v>5.6351000000000005E-7</c:v>
                </c:pt>
                <c:pt idx="1168">
                  <c:v>6.3200099999999997E-7</c:v>
                </c:pt>
                <c:pt idx="1169">
                  <c:v>7.0881700000000004E-7</c:v>
                </c:pt>
                <c:pt idx="1170">
                  <c:v>7.9496799999999998E-7</c:v>
                </c:pt>
                <c:pt idx="1171">
                  <c:v>8.9159100000000003E-7</c:v>
                </c:pt>
                <c:pt idx="1172">
                  <c:v>9.9995600000000001E-7</c:v>
                </c:pt>
                <c:pt idx="1173">
                  <c:v>1.1214899999999999E-6</c:v>
                </c:pt>
                <c:pt idx="1174">
                  <c:v>1.2578000000000001E-6</c:v>
                </c:pt>
                <c:pt idx="1175">
                  <c:v>1.4106699999999999E-6</c:v>
                </c:pt>
                <c:pt idx="1176">
                  <c:v>1.58212E-6</c:v>
                </c:pt>
                <c:pt idx="1177">
                  <c:v>1.77442E-6</c:v>
                </c:pt>
                <c:pt idx="1178">
                  <c:v>1.9900800000000001E-6</c:v>
                </c:pt>
                <c:pt idx="1179">
                  <c:v>2.2319499999999999E-6</c:v>
                </c:pt>
                <c:pt idx="1180">
                  <c:v>2.5032099999999999E-6</c:v>
                </c:pt>
                <c:pt idx="1181">
                  <c:v>2.8074500000000001E-6</c:v>
                </c:pt>
                <c:pt idx="1182">
                  <c:v>3.1486499999999999E-6</c:v>
                </c:pt>
                <c:pt idx="1183">
                  <c:v>3.53133E-6</c:v>
                </c:pt>
                <c:pt idx="1184">
                  <c:v>3.9605100000000003E-6</c:v>
                </c:pt>
                <c:pt idx="1185">
                  <c:v>4.4418600000000004E-6</c:v>
                </c:pt>
                <c:pt idx="1186">
                  <c:v>4.9817000000000001E-6</c:v>
                </c:pt>
                <c:pt idx="1187">
                  <c:v>5.5871500000000004E-6</c:v>
                </c:pt>
                <c:pt idx="1188">
                  <c:v>6.2661799999999997E-6</c:v>
                </c:pt>
                <c:pt idx="1189">
                  <c:v>7.0277300000000001E-6</c:v>
                </c:pt>
                <c:pt idx="1190">
                  <c:v>7.8818300000000001E-6</c:v>
                </c:pt>
                <c:pt idx="1191">
                  <c:v>8.8397299999999998E-6</c:v>
                </c:pt>
                <c:pt idx="1192">
                  <c:v>9.9140399999999997E-6</c:v>
                </c:pt>
                <c:pt idx="1193">
                  <c:v>1.11189E-5</c:v>
                </c:pt>
                <c:pt idx="1194">
                  <c:v>1.24702E-5</c:v>
                </c:pt>
                <c:pt idx="1195">
                  <c:v>1.3985700000000001E-5</c:v>
                </c:pt>
                <c:pt idx="1196">
                  <c:v>1.5685400000000001E-5</c:v>
                </c:pt>
                <c:pt idx="1197">
                  <c:v>1.75917E-5</c:v>
                </c:pt>
                <c:pt idx="1198">
                  <c:v>1.9729600000000002E-5</c:v>
                </c:pt>
                <c:pt idx="1199">
                  <c:v>2.2127300000000001E-5</c:v>
                </c:pt>
                <c:pt idx="1200">
                  <c:v>2.4816399999999998E-5</c:v>
                </c:pt>
                <c:pt idx="1201">
                  <c:v>2.7832300000000001E-5</c:v>
                </c:pt>
                <c:pt idx="1202">
                  <c:v>3.1214699999999998E-5</c:v>
                </c:pt>
                <c:pt idx="1203">
                  <c:v>3.5008200000000001E-5</c:v>
                </c:pt>
                <c:pt idx="1204">
                  <c:v>3.9262599999999999E-5</c:v>
                </c:pt>
                <c:pt idx="1205">
                  <c:v>4.4033999999999999E-5</c:v>
                </c:pt>
                <c:pt idx="1206">
                  <c:v>4.9385300000000003E-5</c:v>
                </c:pt>
                <c:pt idx="1207">
                  <c:v>5.5386900000000003E-5</c:v>
                </c:pt>
                <c:pt idx="1208">
                  <c:v>6.2117800000000004E-5</c:v>
                </c:pt>
                <c:pt idx="1209">
                  <c:v>6.9666700000000002E-5</c:v>
                </c:pt>
                <c:pt idx="1210">
                  <c:v>7.8132899999999999E-5</c:v>
                </c:pt>
                <c:pt idx="1211">
                  <c:v>8.7627900000000002E-5</c:v>
                </c:pt>
                <c:pt idx="1212">
                  <c:v>9.8276799999999994E-5</c:v>
                </c:pt>
                <c:pt idx="1213" formatCode="General">
                  <c:v>1.1022E-4</c:v>
                </c:pt>
                <c:pt idx="1214" formatCode="General">
                  <c:v>1.23614E-4</c:v>
                </c:pt>
                <c:pt idx="1215" formatCode="General">
                  <c:v>1.3863600000000001E-4</c:v>
                </c:pt>
                <c:pt idx="1216" formatCode="General">
                  <c:v>1.5548299999999999E-4</c:v>
                </c:pt>
                <c:pt idx="1217" formatCode="General">
                  <c:v>1.7437799999999999E-4</c:v>
                </c:pt>
                <c:pt idx="1218" formatCode="General">
                  <c:v>1.95568E-4</c:v>
                </c:pt>
                <c:pt idx="1219" formatCode="General">
                  <c:v>2.1933400000000001E-4</c:v>
                </c:pt>
                <c:pt idx="1220" formatCode="General">
                  <c:v>2.4598699999999997E-4</c:v>
                </c:pt>
                <c:pt idx="1221" formatCode="General">
                  <c:v>2.7587899999999998E-4</c:v>
                </c:pt>
                <c:pt idx="1222" formatCode="General">
                  <c:v>3.0940399999999999E-4</c:v>
                </c:pt>
                <c:pt idx="1223" formatCode="General">
                  <c:v>3.4700300000000002E-4</c:v>
                </c:pt>
                <c:pt idx="1224" formatCode="General">
                  <c:v>3.8916999999999999E-4</c:v>
                </c:pt>
                <c:pt idx="1225" formatCode="General">
                  <c:v>4.3646100000000002E-4</c:v>
                </c:pt>
                <c:pt idx="1226" formatCode="General">
                  <c:v>4.8949900000000001E-4</c:v>
                </c:pt>
                <c:pt idx="1227" formatCode="General">
                  <c:v>5.4898200000000005E-4</c:v>
                </c:pt>
                <c:pt idx="1228" formatCode="General">
                  <c:v>6.1569200000000004E-4</c:v>
                </c:pt>
                <c:pt idx="1229" formatCode="General">
                  <c:v>6.9050899999999996E-4</c:v>
                </c:pt>
                <c:pt idx="1230" formatCode="General">
                  <c:v>7.7441700000000001E-4</c:v>
                </c:pt>
                <c:pt idx="1231" formatCode="General">
                  <c:v>8.6852100000000003E-4</c:v>
                </c:pt>
                <c:pt idx="1232" formatCode="General">
                  <c:v>9.7406000000000001E-4</c:v>
                </c:pt>
                <c:pt idx="1233" formatCode="General">
                  <c:v>1.09242E-3</c:v>
                </c:pt>
                <c:pt idx="1234" formatCode="General">
                  <c:v>1.22517E-3</c:v>
                </c:pt>
                <c:pt idx="1235" formatCode="General">
                  <c:v>1.37404E-3</c:v>
                </c:pt>
                <c:pt idx="1236" formatCode="General">
                  <c:v>1.54101E-3</c:v>
                </c:pt>
                <c:pt idx="1237" formatCode="General">
                  <c:v>1.7282599999999999E-3</c:v>
                </c:pt>
                <c:pt idx="1238" formatCode="General">
                  <c:v>1.93827E-3</c:v>
                </c:pt>
                <c:pt idx="1239" formatCode="General">
                  <c:v>2.1737900000000001E-3</c:v>
                </c:pt>
                <c:pt idx="1240" formatCode="General">
                  <c:v>2.43794E-3</c:v>
                </c:pt>
                <c:pt idx="1241" formatCode="General">
                  <c:v>2.7341700000000002E-3</c:v>
                </c:pt>
                <c:pt idx="1242" formatCode="General">
                  <c:v>3.0664099999999999E-3</c:v>
                </c:pt>
                <c:pt idx="1243" formatCode="General">
                  <c:v>3.4390100000000002E-3</c:v>
                </c:pt>
                <c:pt idx="1244" formatCode="General">
                  <c:v>3.85688E-3</c:v>
                </c:pt>
                <c:pt idx="1245" formatCode="General">
                  <c:v>4.3255300000000002E-3</c:v>
                </c:pt>
                <c:pt idx="1246" formatCode="General">
                  <c:v>4.8511300000000004E-3</c:v>
                </c:pt>
                <c:pt idx="1247" formatCode="General">
                  <c:v>5.4405900000000004E-3</c:v>
                </c:pt>
                <c:pt idx="1248" formatCode="General">
                  <c:v>6.1016600000000001E-3</c:v>
                </c:pt>
                <c:pt idx="1249" formatCode="General">
                  <c:v>6.8430699999999997E-3</c:v>
                </c:pt>
                <c:pt idx="1250" formatCode="General">
                  <c:v>7.6745499999999996E-3</c:v>
                </c:pt>
                <c:pt idx="1251" formatCode="General">
                  <c:v>8.6070699999999997E-3</c:v>
                </c:pt>
                <c:pt idx="1252" formatCode="General">
                  <c:v>9.6528800000000008E-3</c:v>
                </c:pt>
                <c:pt idx="1253" formatCode="General">
                  <c:v>1.08258E-2</c:v>
                </c:pt>
                <c:pt idx="1254" formatCode="General">
                  <c:v>1.21412E-2</c:v>
                </c:pt>
                <c:pt idx="1255" formatCode="General">
                  <c:v>1.3616400000000001E-2</c:v>
                </c:pt>
                <c:pt idx="1256" formatCode="General">
                  <c:v>1.5270799999999999E-2</c:v>
                </c:pt>
                <c:pt idx="1257" formatCode="General">
                  <c:v>1.7126300000000001E-2</c:v>
                </c:pt>
                <c:pt idx="1258" formatCode="General">
                  <c:v>1.9207200000000001E-2</c:v>
                </c:pt>
                <c:pt idx="1259" formatCode="General">
                  <c:v>2.1540900000000002E-2</c:v>
                </c:pt>
                <c:pt idx="1260" formatCode="General">
                  <c:v>2.4158200000000001E-2</c:v>
                </c:pt>
                <c:pt idx="1261" formatCode="General">
                  <c:v>2.70934E-2</c:v>
                </c:pt>
                <c:pt idx="1262" formatCode="General">
                  <c:v>3.0385300000000001E-2</c:v>
                </c:pt>
                <c:pt idx="1263" formatCode="General">
                  <c:v>3.4077099999999999E-2</c:v>
                </c:pt>
                <c:pt idx="1264" formatCode="General">
                  <c:v>3.8217399999999999E-2</c:v>
                </c:pt>
                <c:pt idx="1265" formatCode="General">
                  <c:v>4.2860700000000002E-2</c:v>
                </c:pt>
                <c:pt idx="1266" formatCode="General">
                  <c:v>4.8068100000000002E-2</c:v>
                </c:pt>
                <c:pt idx="1267" formatCode="General">
                  <c:v>5.3908200000000003E-2</c:v>
                </c:pt>
                <c:pt idx="1268" formatCode="General">
                  <c:v>6.0457700000000003E-2</c:v>
                </c:pt>
                <c:pt idx="1269" formatCode="General">
                  <c:v>6.7802799999999996E-2</c:v>
                </c:pt>
                <c:pt idx="1270" formatCode="General">
                  <c:v>7.6040200000000002E-2</c:v>
                </c:pt>
                <c:pt idx="1271" formatCode="General">
                  <c:v>8.5278300000000001E-2</c:v>
                </c:pt>
                <c:pt idx="1272" formatCode="General">
                  <c:v>9.5638500000000001E-2</c:v>
                </c:pt>
                <c:pt idx="1273" formatCode="General">
                  <c:v>0.10725700000000001</c:v>
                </c:pt>
                <c:pt idx="1274" formatCode="General">
                  <c:v>0.12028700000000001</c:v>
                </c:pt>
                <c:pt idx="1275" formatCode="General">
                  <c:v>0.13489999999999999</c:v>
                </c:pt>
                <c:pt idx="1276" formatCode="General">
                  <c:v>0.151287</c:v>
                </c:pt>
                <c:pt idx="1277" formatCode="General">
                  <c:v>0.16966400000000001</c:v>
                </c:pt>
                <c:pt idx="1278" formatCode="General">
                  <c:v>0.190274</c:v>
                </c:pt>
                <c:pt idx="1279" formatCode="General">
                  <c:v>0.21338499999999999</c:v>
                </c:pt>
                <c:pt idx="1280" formatCode="General">
                  <c:v>0.23930399999999999</c:v>
                </c:pt>
                <c:pt idx="1281" formatCode="General">
                  <c:v>0.26836900000000002</c:v>
                </c:pt>
                <c:pt idx="1282" formatCode="General">
                  <c:v>0.30096299999999998</c:v>
                </c:pt>
                <c:pt idx="1283" formatCode="General">
                  <c:v>0.33751399999999998</c:v>
                </c:pt>
                <c:pt idx="1284" formatCode="General">
                  <c:v>0.37850099999999998</c:v>
                </c:pt>
                <c:pt idx="1285" formatCode="General">
                  <c:v>0.42446299999999998</c:v>
                </c:pt>
                <c:pt idx="1286" formatCode="General">
                  <c:v>0.47600300000000001</c:v>
                </c:pt>
                <c:pt idx="1287" formatCode="General">
                  <c:v>0.53379500000000002</c:v>
                </c:pt>
                <c:pt idx="1288" formatCode="General">
                  <c:v>0.59859899999999999</c:v>
                </c:pt>
                <c:pt idx="1289" formatCode="General">
                  <c:v>0.67126200000000003</c:v>
                </c:pt>
                <c:pt idx="1290" formatCode="General">
                  <c:v>0.75273599999999996</c:v>
                </c:pt>
                <c:pt idx="1291" formatCode="General">
                  <c:v>0.826542</c:v>
                </c:pt>
                <c:pt idx="1292" formatCode="General">
                  <c:v>0.90757500000000002</c:v>
                </c:pt>
                <c:pt idx="1293" formatCode="General">
                  <c:v>0.99653999999999998</c:v>
                </c:pt>
                <c:pt idx="1294" formatCode="General">
                  <c:v>1.0942099999999999</c:v>
                </c:pt>
                <c:pt idx="1295" formatCode="General">
                  <c:v>1.2014400000000001</c:v>
                </c:pt>
                <c:pt idx="1296" formatCode="General">
                  <c:v>1.31915</c:v>
                </c:pt>
                <c:pt idx="1297" formatCode="General">
                  <c:v>1.4483600000000001</c:v>
                </c:pt>
                <c:pt idx="1298" formatCode="General">
                  <c:v>1.5629599999999999</c:v>
                </c:pt>
                <c:pt idx="1299" formatCode="General">
                  <c:v>1.6866000000000001</c:v>
                </c:pt>
                <c:pt idx="1300" formatCode="General">
                  <c:v>1.81999</c:v>
                </c:pt>
                <c:pt idx="1301" formatCode="General">
                  <c:v>1.93841</c:v>
                </c:pt>
                <c:pt idx="1302" formatCode="General">
                  <c:v>2.0644900000000002</c:v>
                </c:pt>
                <c:pt idx="1303" formatCode="General">
                  <c:v>2.1987399999999999</c:v>
                </c:pt>
                <c:pt idx="1304" formatCode="General">
                  <c:v>2.3416800000000002</c:v>
                </c:pt>
                <c:pt idx="1305" formatCode="General">
                  <c:v>2.3643200000000002</c:v>
                </c:pt>
                <c:pt idx="1306" formatCode="General">
                  <c:v>2.3871699999999998</c:v>
                </c:pt>
                <c:pt idx="1307" formatCode="General">
                  <c:v>2.4102399999999999</c:v>
                </c:pt>
                <c:pt idx="1308" formatCode="General">
                  <c:v>2.4335399999999998</c:v>
                </c:pt>
                <c:pt idx="1309" formatCode="General">
                  <c:v>2.4570500000000002</c:v>
                </c:pt>
                <c:pt idx="1310" formatCode="General">
                  <c:v>2.4938799999999999</c:v>
                </c:pt>
                <c:pt idx="1311" formatCode="General">
                  <c:v>2.5312600000000001</c:v>
                </c:pt>
                <c:pt idx="1312" formatCode="General">
                  <c:v>2.5691999999999999</c:v>
                </c:pt>
                <c:pt idx="1313" formatCode="General">
                  <c:v>2.6076999999999999</c:v>
                </c:pt>
                <c:pt idx="1314" formatCode="General">
                  <c:v>2.6670199999999999</c:v>
                </c:pt>
                <c:pt idx="1315" formatCode="General">
                  <c:v>2.7276899999999999</c:v>
                </c:pt>
                <c:pt idx="1316" formatCode="General">
                  <c:v>2.78973</c:v>
                </c:pt>
                <c:pt idx="1317" formatCode="General">
                  <c:v>2.85317</c:v>
                </c:pt>
                <c:pt idx="1318" formatCode="General">
                  <c:v>2.9456899999999999</c:v>
                </c:pt>
                <c:pt idx="1319" formatCode="General">
                  <c:v>3.0411800000000002</c:v>
                </c:pt>
                <c:pt idx="1320" formatCode="General">
                  <c:v>3.1397499999999998</c:v>
                </c:pt>
                <c:pt idx="1321" formatCode="General">
                  <c:v>3.2149399999999999</c:v>
                </c:pt>
                <c:pt idx="1322" formatCode="General">
                  <c:v>3.27834</c:v>
                </c:pt>
                <c:pt idx="1323" formatCode="General">
                  <c:v>3.3429899999999999</c:v>
                </c:pt>
                <c:pt idx="1324" formatCode="General">
                  <c:v>3.4089</c:v>
                </c:pt>
                <c:pt idx="1325" formatCode="General">
                  <c:v>3.4761000000000002</c:v>
                </c:pt>
                <c:pt idx="1326" formatCode="General">
                  <c:v>3.54461</c:v>
                </c:pt>
                <c:pt idx="1327" formatCode="General">
                  <c:v>3.6144599999999998</c:v>
                </c:pt>
                <c:pt idx="1328" formatCode="General">
                  <c:v>3.6856800000000001</c:v>
                </c:pt>
                <c:pt idx="1329" formatCode="General">
                  <c:v>3.7582800000000001</c:v>
                </c:pt>
                <c:pt idx="1330" formatCode="General">
                  <c:v>3.8323</c:v>
                </c:pt>
                <c:pt idx="1331" formatCode="General">
                  <c:v>3.9077600000000001</c:v>
                </c:pt>
                <c:pt idx="1332" formatCode="General">
                  <c:v>3.98468</c:v>
                </c:pt>
                <c:pt idx="1333" formatCode="General">
                  <c:v>4.06311</c:v>
                </c:pt>
                <c:pt idx="1334" formatCode="General">
                  <c:v>4.1430600000000002</c:v>
                </c:pt>
                <c:pt idx="1335" formatCode="General">
                  <c:v>4.2356600000000002</c:v>
                </c:pt>
                <c:pt idx="1336" formatCode="General">
                  <c:v>4.3302899999999998</c:v>
                </c:pt>
                <c:pt idx="1337" formatCode="General">
                  <c:v>4.4270100000000001</c:v>
                </c:pt>
                <c:pt idx="1338" formatCode="General">
                  <c:v>4.5258700000000003</c:v>
                </c:pt>
                <c:pt idx="1339" formatCode="General">
                  <c:v>4.6269</c:v>
                </c:pt>
                <c:pt idx="1340" formatCode="General">
                  <c:v>4.77461</c:v>
                </c:pt>
                <c:pt idx="1341" formatCode="General">
                  <c:v>4.9269600000000002</c:v>
                </c:pt>
                <c:pt idx="1342" formatCode="General">
                  <c:v>5.0840899999999998</c:v>
                </c:pt>
                <c:pt idx="1343" formatCode="General">
                  <c:v>5.2461500000000001</c:v>
                </c:pt>
                <c:pt idx="1344" formatCode="General">
                  <c:v>5.4132699999999998</c:v>
                </c:pt>
                <c:pt idx="1345" formatCode="General">
                  <c:v>5.6124400000000003</c:v>
                </c:pt>
                <c:pt idx="1346" formatCode="General">
                  <c:v>5.8187899999999999</c:v>
                </c:pt>
                <c:pt idx="1347" formatCode="General">
                  <c:v>6.03254</c:v>
                </c:pt>
                <c:pt idx="1348" formatCode="General">
                  <c:v>6.2539499999999997</c:v>
                </c:pt>
                <c:pt idx="1349" formatCode="General">
                  <c:v>6.4832599999999996</c:v>
                </c:pt>
                <c:pt idx="1350" formatCode="General">
                  <c:v>6.7207400000000002</c:v>
                </c:pt>
                <c:pt idx="1351" formatCode="General">
                  <c:v>6.9666300000000003</c:v>
                </c:pt>
                <c:pt idx="1352" formatCode="General">
                  <c:v>7.2212100000000001</c:v>
                </c:pt>
                <c:pt idx="1353" formatCode="General">
                  <c:v>7.4847400000000004</c:v>
                </c:pt>
                <c:pt idx="1354" formatCode="General">
                  <c:v>7.7574899999999998</c:v>
                </c:pt>
                <c:pt idx="1355" formatCode="General">
                  <c:v>8.0397300000000005</c:v>
                </c:pt>
                <c:pt idx="1356" formatCode="General">
                  <c:v>8.3317499999999995</c:v>
                </c:pt>
                <c:pt idx="1357" formatCode="General">
                  <c:v>8.6338000000000008</c:v>
                </c:pt>
                <c:pt idx="1358" formatCode="General">
                  <c:v>8.8874899999999997</c:v>
                </c:pt>
                <c:pt idx="1359" formatCode="General">
                  <c:v>9.1481600000000007</c:v>
                </c:pt>
                <c:pt idx="1360" formatCode="General">
                  <c:v>9.4159600000000001</c:v>
                </c:pt>
                <c:pt idx="1361" formatCode="General">
                  <c:v>9.6910100000000003</c:v>
                </c:pt>
                <c:pt idx="1362" formatCode="General">
                  <c:v>9.91934</c:v>
                </c:pt>
                <c:pt idx="1363" formatCode="General">
                  <c:v>10.1526</c:v>
                </c:pt>
                <c:pt idx="1364" formatCode="General">
                  <c:v>10.35</c:v>
                </c:pt>
                <c:pt idx="1365" formatCode="General">
                  <c:v>10.3833</c:v>
                </c:pt>
                <c:pt idx="1366" formatCode="General">
                  <c:v>10.416600000000001</c:v>
                </c:pt>
                <c:pt idx="1367" formatCode="General">
                  <c:v>10.45</c:v>
                </c:pt>
                <c:pt idx="1368" formatCode="General">
                  <c:v>10.483599999999999</c:v>
                </c:pt>
                <c:pt idx="1369" formatCode="General">
                  <c:v>10.517200000000001</c:v>
                </c:pt>
                <c:pt idx="1370" formatCode="General">
                  <c:v>10.5847</c:v>
                </c:pt>
                <c:pt idx="1371" formatCode="General">
                  <c:v>10.6526</c:v>
                </c:pt>
                <c:pt idx="1372" formatCode="General">
                  <c:v>10.7209</c:v>
                </c:pt>
                <c:pt idx="1373" formatCode="General">
                  <c:v>10.7896</c:v>
                </c:pt>
                <c:pt idx="1374" formatCode="General">
                  <c:v>10.858700000000001</c:v>
                </c:pt>
                <c:pt idx="1375" formatCode="General">
                  <c:v>11.0312</c:v>
                </c:pt>
                <c:pt idx="1376" formatCode="General">
                  <c:v>11.206</c:v>
                </c:pt>
                <c:pt idx="1377" formatCode="General">
                  <c:v>11.3833</c:v>
                </c:pt>
                <c:pt idx="1378" formatCode="General">
                  <c:v>11.562900000000001</c:v>
                </c:pt>
                <c:pt idx="1379" formatCode="General">
                  <c:v>11.744999999999999</c:v>
                </c:pt>
                <c:pt idx="1380" formatCode="General">
                  <c:v>11.976100000000001</c:v>
                </c:pt>
                <c:pt idx="1381" formatCode="General">
                  <c:v>12.210900000000001</c:v>
                </c:pt>
                <c:pt idx="1382" formatCode="General">
                  <c:v>12.4495</c:v>
                </c:pt>
                <c:pt idx="1383" formatCode="General">
                  <c:v>12.6919</c:v>
                </c:pt>
                <c:pt idx="1384" formatCode="General">
                  <c:v>12.8881</c:v>
                </c:pt>
                <c:pt idx="1385" formatCode="General">
                  <c:v>13.0867</c:v>
                </c:pt>
                <c:pt idx="1386" formatCode="General">
                  <c:v>13.287599999999999</c:v>
                </c:pt>
                <c:pt idx="1387" formatCode="General">
                  <c:v>13.4495</c:v>
                </c:pt>
                <c:pt idx="1388" formatCode="General">
                  <c:v>13.6129</c:v>
                </c:pt>
                <c:pt idx="1389" formatCode="General">
                  <c:v>13.777699999999999</c:v>
                </c:pt>
                <c:pt idx="1390" formatCode="General">
                  <c:v>13.943899999999999</c:v>
                </c:pt>
                <c:pt idx="1391" formatCode="General">
                  <c:v>13.969099999999999</c:v>
                </c:pt>
                <c:pt idx="1392" formatCode="General">
                  <c:v>13.994300000000001</c:v>
                </c:pt>
                <c:pt idx="1393" formatCode="General">
                  <c:v>14.019600000000001</c:v>
                </c:pt>
                <c:pt idx="1394" formatCode="General">
                  <c:v>14.0449</c:v>
                </c:pt>
                <c:pt idx="1395" formatCode="General">
                  <c:v>14.0702</c:v>
                </c:pt>
                <c:pt idx="1396" formatCode="General">
                  <c:v>14.119300000000001</c:v>
                </c:pt>
                <c:pt idx="1397" formatCode="General">
                  <c:v>14.1685</c:v>
                </c:pt>
                <c:pt idx="1398" formatCode="General">
                  <c:v>14.2178</c:v>
                </c:pt>
                <c:pt idx="1399" formatCode="General">
                  <c:v>14.267200000000001</c:v>
                </c:pt>
                <c:pt idx="1400" formatCode="General">
                  <c:v>14.316800000000001</c:v>
                </c:pt>
                <c:pt idx="1401" formatCode="General">
                  <c:v>14.456099999999999</c:v>
                </c:pt>
                <c:pt idx="1402" formatCode="General">
                  <c:v>14.5962</c:v>
                </c:pt>
                <c:pt idx="1403" formatCode="General">
                  <c:v>14.7371</c:v>
                </c:pt>
                <c:pt idx="1404" formatCode="General">
                  <c:v>14.8787</c:v>
                </c:pt>
                <c:pt idx="1405" formatCode="General">
                  <c:v>15.0212</c:v>
                </c:pt>
                <c:pt idx="1406" formatCode="General">
                  <c:v>15.1829</c:v>
                </c:pt>
                <c:pt idx="1407" formatCode="General">
                  <c:v>15.3454</c:v>
                </c:pt>
                <c:pt idx="1408" formatCode="General">
                  <c:v>15.508699999999999</c:v>
                </c:pt>
                <c:pt idx="1409" formatCode="General">
                  <c:v>15.672800000000001</c:v>
                </c:pt>
                <c:pt idx="1410" formatCode="General">
                  <c:v>15.8375</c:v>
                </c:pt>
                <c:pt idx="1411" formatCode="General">
                  <c:v>16.002800000000001</c:v>
                </c:pt>
                <c:pt idx="1412" formatCode="General">
                  <c:v>16.2074</c:v>
                </c:pt>
                <c:pt idx="1413" formatCode="General">
                  <c:v>16.412600000000001</c:v>
                </c:pt>
                <c:pt idx="1414" formatCode="General">
                  <c:v>16.618099999999998</c:v>
                </c:pt>
                <c:pt idx="1415" formatCode="General">
                  <c:v>16.823699999999999</c:v>
                </c:pt>
                <c:pt idx="1416" formatCode="General">
                  <c:v>17.029199999999999</c:v>
                </c:pt>
                <c:pt idx="1417" formatCode="General">
                  <c:v>17.191099999999999</c:v>
                </c:pt>
                <c:pt idx="1418" formatCode="General">
                  <c:v>17.319199999999999</c:v>
                </c:pt>
                <c:pt idx="1419" formatCode="General">
                  <c:v>17.446999999999999</c:v>
                </c:pt>
                <c:pt idx="1420" formatCode="General">
                  <c:v>17.4725</c:v>
                </c:pt>
                <c:pt idx="1421" formatCode="General">
                  <c:v>17.498000000000001</c:v>
                </c:pt>
                <c:pt idx="1422" formatCode="General">
                  <c:v>17.523499999999999</c:v>
                </c:pt>
                <c:pt idx="1423" formatCode="General">
                  <c:v>17.5489</c:v>
                </c:pt>
                <c:pt idx="1424" formatCode="General">
                  <c:v>17.574300000000001</c:v>
                </c:pt>
                <c:pt idx="1425" formatCode="General">
                  <c:v>17.623899999999999</c:v>
                </c:pt>
                <c:pt idx="1426" formatCode="General">
                  <c:v>17.673400000000001</c:v>
                </c:pt>
                <c:pt idx="1427" formatCode="General">
                  <c:v>17.7227</c:v>
                </c:pt>
                <c:pt idx="1428" formatCode="General">
                  <c:v>17.771999999999998</c:v>
                </c:pt>
                <c:pt idx="1429" formatCode="General">
                  <c:v>17.821100000000001</c:v>
                </c:pt>
                <c:pt idx="1430" formatCode="General">
                  <c:v>17.927399999999999</c:v>
                </c:pt>
                <c:pt idx="1431" formatCode="General">
                  <c:v>18.033000000000001</c:v>
                </c:pt>
                <c:pt idx="1432" formatCode="General">
                  <c:v>18.137899999999998</c:v>
                </c:pt>
                <c:pt idx="1433" formatCode="General">
                  <c:v>18.242000000000001</c:v>
                </c:pt>
                <c:pt idx="1434" formatCode="General">
                  <c:v>18.345300000000002</c:v>
                </c:pt>
                <c:pt idx="1435" formatCode="General">
                  <c:v>18.465900000000001</c:v>
                </c:pt>
                <c:pt idx="1436" formatCode="General">
                  <c:v>18.585000000000001</c:v>
                </c:pt>
                <c:pt idx="1437" formatCode="General">
                  <c:v>18.702400000000001</c:v>
                </c:pt>
                <c:pt idx="1438" formatCode="General">
                  <c:v>18.817799999999998</c:v>
                </c:pt>
                <c:pt idx="1439" formatCode="General">
                  <c:v>18.931100000000001</c:v>
                </c:pt>
                <c:pt idx="1440" formatCode="General">
                  <c:v>19.042100000000001</c:v>
                </c:pt>
                <c:pt idx="1441" formatCode="General">
                  <c:v>19.185600000000001</c:v>
                </c:pt>
                <c:pt idx="1442" formatCode="General">
                  <c:v>19.323899999999998</c:v>
                </c:pt>
                <c:pt idx="1443" formatCode="General">
                  <c:v>19.456199999999999</c:v>
                </c:pt>
                <c:pt idx="1444" formatCode="General">
                  <c:v>19.581700000000001</c:v>
                </c:pt>
                <c:pt idx="1445" formatCode="General">
                  <c:v>19.6996</c:v>
                </c:pt>
                <c:pt idx="1446" formatCode="General">
                  <c:v>19.809000000000001</c:v>
                </c:pt>
                <c:pt idx="1447" formatCode="General">
                  <c:v>19.930900000000001</c:v>
                </c:pt>
                <c:pt idx="1448" formatCode="General">
                  <c:v>20.036000000000001</c:v>
                </c:pt>
                <c:pt idx="1449" formatCode="General">
                  <c:v>20.1218</c:v>
                </c:pt>
                <c:pt idx="1450" formatCode="General">
                  <c:v>20.185700000000001</c:v>
                </c:pt>
                <c:pt idx="1451" formatCode="General">
                  <c:v>20.224599999999999</c:v>
                </c:pt>
                <c:pt idx="1452" formatCode="General">
                  <c:v>20.235399999999998</c:v>
                </c:pt>
                <c:pt idx="1453" formatCode="General">
                  <c:v>20.228300000000001</c:v>
                </c:pt>
                <c:pt idx="1454" formatCode="General">
                  <c:v>20.201699999999999</c:v>
                </c:pt>
                <c:pt idx="1455" formatCode="General">
                  <c:v>20.153600000000001</c:v>
                </c:pt>
                <c:pt idx="1456" formatCode="General">
                  <c:v>20.082100000000001</c:v>
                </c:pt>
                <c:pt idx="1457" formatCode="General">
                  <c:v>19.985399999999998</c:v>
                </c:pt>
                <c:pt idx="1458" formatCode="General">
                  <c:v>19.8612</c:v>
                </c:pt>
                <c:pt idx="1459" formatCode="General">
                  <c:v>19.7073</c:v>
                </c:pt>
                <c:pt idx="1460" formatCode="General">
                  <c:v>19.521699999999999</c:v>
                </c:pt>
                <c:pt idx="1461" formatCode="General">
                  <c:v>19.302</c:v>
                </c:pt>
                <c:pt idx="1462" formatCode="General">
                  <c:v>19.046199999999999</c:v>
                </c:pt>
                <c:pt idx="1463" formatCode="General">
                  <c:v>18.751999999999999</c:v>
                </c:pt>
                <c:pt idx="1464" formatCode="General">
                  <c:v>18.4176</c:v>
                </c:pt>
                <c:pt idx="1465" formatCode="General">
                  <c:v>18.0413</c:v>
                </c:pt>
                <c:pt idx="1466" formatCode="General">
                  <c:v>17.621500000000001</c:v>
                </c:pt>
                <c:pt idx="1467" formatCode="General">
                  <c:v>17.157299999999999</c:v>
                </c:pt>
                <c:pt idx="1468" formatCode="General">
                  <c:v>16.648</c:v>
                </c:pt>
                <c:pt idx="1469" formatCode="General">
                  <c:v>16.093699999999998</c:v>
                </c:pt>
                <c:pt idx="1470" formatCode="General">
                  <c:v>15.494999999999999</c:v>
                </c:pt>
                <c:pt idx="1471" formatCode="General">
                  <c:v>14.9709</c:v>
                </c:pt>
                <c:pt idx="1472" formatCode="General">
                  <c:v>14.419</c:v>
                </c:pt>
                <c:pt idx="1473" formatCode="General">
                  <c:v>13.8409</c:v>
                </c:pt>
                <c:pt idx="1474" formatCode="General">
                  <c:v>13.238899999999999</c:v>
                </c:pt>
                <c:pt idx="1475" formatCode="General">
                  <c:v>13.1447</c:v>
                </c:pt>
                <c:pt idx="1476" formatCode="General">
                  <c:v>13.0501</c:v>
                </c:pt>
                <c:pt idx="1477" formatCode="General">
                  <c:v>12.9549</c:v>
                </c:pt>
                <c:pt idx="1478" formatCode="General">
                  <c:v>12.859299999999999</c:v>
                </c:pt>
                <c:pt idx="1479" formatCode="General">
                  <c:v>12.763299999999999</c:v>
                </c:pt>
                <c:pt idx="1480" formatCode="General">
                  <c:v>12.5938</c:v>
                </c:pt>
                <c:pt idx="1481" formatCode="General">
                  <c:v>12.4231</c:v>
                </c:pt>
                <c:pt idx="1482" formatCode="General">
                  <c:v>12.251099999999999</c:v>
                </c:pt>
                <c:pt idx="1483" formatCode="General">
                  <c:v>12.0779</c:v>
                </c:pt>
                <c:pt idx="1484" formatCode="General">
                  <c:v>11.903499999999999</c:v>
                </c:pt>
                <c:pt idx="1485" formatCode="General">
                  <c:v>11.578099999999999</c:v>
                </c:pt>
                <c:pt idx="1486" formatCode="General">
                  <c:v>11.2494</c:v>
                </c:pt>
                <c:pt idx="1487" formatCode="General">
                  <c:v>10.918100000000001</c:v>
                </c:pt>
                <c:pt idx="1488" formatCode="General">
                  <c:v>10.5846</c:v>
                </c:pt>
                <c:pt idx="1489" formatCode="General">
                  <c:v>10.2493</c:v>
                </c:pt>
                <c:pt idx="1490" formatCode="General">
                  <c:v>9.8102199999999993</c:v>
                </c:pt>
                <c:pt idx="1491" formatCode="General">
                  <c:v>9.3703900000000004</c:v>
                </c:pt>
                <c:pt idx="1492" formatCode="General">
                  <c:v>8.9310899999999993</c:v>
                </c:pt>
                <c:pt idx="1493" formatCode="General">
                  <c:v>8.4936000000000007</c:v>
                </c:pt>
                <c:pt idx="1494" formatCode="General">
                  <c:v>8.0592199999999998</c:v>
                </c:pt>
                <c:pt idx="1495" formatCode="General">
                  <c:v>7.6292499999999999</c:v>
                </c:pt>
                <c:pt idx="1496" formatCode="General">
                  <c:v>7.2049799999999999</c:v>
                </c:pt>
                <c:pt idx="1497" formatCode="General">
                  <c:v>6.7876500000000002</c:v>
                </c:pt>
                <c:pt idx="1498" formatCode="General">
                  <c:v>6.3784999999999998</c:v>
                </c:pt>
                <c:pt idx="1499" formatCode="General">
                  <c:v>5.9257600000000004</c:v>
                </c:pt>
                <c:pt idx="1500" formatCode="General">
                  <c:v>5.4866400000000004</c:v>
                </c:pt>
                <c:pt idx="1501" formatCode="General">
                  <c:v>5.1339300000000003</c:v>
                </c:pt>
                <c:pt idx="1502" formatCode="General">
                  <c:v>4.7923799999999996</c:v>
                </c:pt>
                <c:pt idx="1503" formatCode="General">
                  <c:v>4.5179499999999999</c:v>
                </c:pt>
                <c:pt idx="1504" formatCode="General">
                  <c:v>4.4739000000000004</c:v>
                </c:pt>
                <c:pt idx="1505" formatCode="General">
                  <c:v>4.4300800000000002</c:v>
                </c:pt>
                <c:pt idx="1506" formatCode="General">
                  <c:v>4.3864900000000002</c:v>
                </c:pt>
                <c:pt idx="1507" formatCode="General">
                  <c:v>4.34314</c:v>
                </c:pt>
                <c:pt idx="1508" formatCode="General">
                  <c:v>4.3000100000000003</c:v>
                </c:pt>
                <c:pt idx="1509" formatCode="General">
                  <c:v>4.2144599999999999</c:v>
                </c:pt>
                <c:pt idx="1510" formatCode="General">
                  <c:v>4.1298500000000002</c:v>
                </c:pt>
                <c:pt idx="1511" formatCode="General">
                  <c:v>4.0461999999999998</c:v>
                </c:pt>
                <c:pt idx="1512" formatCode="General">
                  <c:v>3.9635099999999999</c:v>
                </c:pt>
                <c:pt idx="1513" formatCode="General">
                  <c:v>3.7856999999999998</c:v>
                </c:pt>
                <c:pt idx="1514" formatCode="General">
                  <c:v>3.6126399999999999</c:v>
                </c:pt>
                <c:pt idx="1515" formatCode="General">
                  <c:v>3.4443899999999998</c:v>
                </c:pt>
                <c:pt idx="1516" formatCode="General">
                  <c:v>3.2810100000000002</c:v>
                </c:pt>
                <c:pt idx="1517" formatCode="General">
                  <c:v>3.12256</c:v>
                </c:pt>
                <c:pt idx="1518" formatCode="General">
                  <c:v>2.8725100000000001</c:v>
                </c:pt>
                <c:pt idx="1519" formatCode="General">
                  <c:v>2.6359599999999999</c:v>
                </c:pt>
                <c:pt idx="1520" formatCode="General">
                  <c:v>2.4518</c:v>
                </c:pt>
                <c:pt idx="1521" formatCode="General">
                  <c:v>2.2766899999999999</c:v>
                </c:pt>
                <c:pt idx="1522" formatCode="General">
                  <c:v>2.1105399999999999</c:v>
                </c:pt>
                <c:pt idx="1523" formatCode="General">
                  <c:v>1.9532499999999999</c:v>
                </c:pt>
                <c:pt idx="1524" formatCode="General">
                  <c:v>1.8046800000000001</c:v>
                </c:pt>
                <c:pt idx="1525" formatCode="General">
                  <c:v>1.6646399999999999</c:v>
                </c:pt>
                <c:pt idx="1526" formatCode="General">
                  <c:v>1.5329299999999999</c:v>
                </c:pt>
                <c:pt idx="1527" formatCode="General">
                  <c:v>1.40934</c:v>
                </c:pt>
                <c:pt idx="1528" formatCode="General">
                  <c:v>1.3145199999999999</c:v>
                </c:pt>
                <c:pt idx="1529" formatCode="General">
                  <c:v>1.2247699999999999</c:v>
                </c:pt>
                <c:pt idx="1530" formatCode="General">
                  <c:v>1.1399300000000001</c:v>
                </c:pt>
                <c:pt idx="1531" formatCode="General">
                  <c:v>1.0598700000000001</c:v>
                </c:pt>
                <c:pt idx="1532" formatCode="General">
                  <c:v>0.98440399999999995</c:v>
                </c:pt>
                <c:pt idx="1533" formatCode="General">
                  <c:v>0.90276299999999998</c:v>
                </c:pt>
                <c:pt idx="1534" formatCode="General">
                  <c:v>0.82678099999999999</c:v>
                </c:pt>
                <c:pt idx="1535" formatCode="General">
                  <c:v>0.75619400000000003</c:v>
                </c:pt>
                <c:pt idx="1536" formatCode="General">
                  <c:v>0.69073700000000005</c:v>
                </c:pt>
                <c:pt idx="1537" formatCode="General">
                  <c:v>0.63014400000000004</c:v>
                </c:pt>
                <c:pt idx="1538" formatCode="General">
                  <c:v>0.57415300000000002</c:v>
                </c:pt>
                <c:pt idx="1539" formatCode="General">
                  <c:v>0.53180000000000005</c:v>
                </c:pt>
                <c:pt idx="1540" formatCode="General">
                  <c:v>0.49218400000000001</c:v>
                </c:pt>
                <c:pt idx="1541" formatCode="General">
                  <c:v>0.45516800000000002</c:v>
                </c:pt>
                <c:pt idx="1542" formatCode="General">
                  <c:v>0.42061900000000002</c:v>
                </c:pt>
                <c:pt idx="1543" formatCode="General">
                  <c:v>0.388407</c:v>
                </c:pt>
                <c:pt idx="1544" formatCode="General">
                  <c:v>0.35840499999999997</c:v>
                </c:pt>
                <c:pt idx="1545" formatCode="General">
                  <c:v>0.33049000000000001</c:v>
                </c:pt>
                <c:pt idx="1546" formatCode="General">
                  <c:v>0.30454300000000001</c:v>
                </c:pt>
                <c:pt idx="1547" formatCode="General">
                  <c:v>0.277721</c:v>
                </c:pt>
                <c:pt idx="1548" formatCode="General">
                  <c:v>0.25841399999999998</c:v>
                </c:pt>
                <c:pt idx="1549" formatCode="General">
                  <c:v>0.240337</c:v>
                </c:pt>
                <c:pt idx="1550" formatCode="General">
                  <c:v>0.22342500000000001</c:v>
                </c:pt>
                <c:pt idx="1551" formatCode="General">
                  <c:v>0.210258</c:v>
                </c:pt>
                <c:pt idx="1552" formatCode="General">
                  <c:v>0.19780900000000001</c:v>
                </c:pt>
                <c:pt idx="1553" formatCode="General">
                  <c:v>0.18604499999999999</c:v>
                </c:pt>
                <c:pt idx="1554" formatCode="General">
                  <c:v>0.174932</c:v>
                </c:pt>
                <c:pt idx="1555" formatCode="General">
                  <c:v>0.164438</c:v>
                </c:pt>
                <c:pt idx="1556" formatCode="General">
                  <c:v>0.147206</c:v>
                </c:pt>
                <c:pt idx="1557" formatCode="General">
                  <c:v>0.13167699999999999</c:v>
                </c:pt>
                <c:pt idx="1558" formatCode="General">
                  <c:v>0.12019199999999999</c:v>
                </c:pt>
                <c:pt idx="1559" formatCode="General">
                  <c:v>0.10965900000000001</c:v>
                </c:pt>
                <c:pt idx="1560" formatCode="General">
                  <c:v>0.100004</c:v>
                </c:pt>
                <c:pt idx="1561" formatCode="General">
                  <c:v>9.1161599999999995E-2</c:v>
                </c:pt>
                <c:pt idx="1562" formatCode="General">
                  <c:v>8.3068199999999995E-2</c:v>
                </c:pt>
                <c:pt idx="1563" formatCode="General">
                  <c:v>7.5665200000000002E-2</c:v>
                </c:pt>
                <c:pt idx="1564" formatCode="General">
                  <c:v>6.8898000000000001E-2</c:v>
                </c:pt>
                <c:pt idx="1565" formatCode="General">
                  <c:v>6.2715499999999993E-2</c:v>
                </c:pt>
                <c:pt idx="1566" formatCode="General">
                  <c:v>5.8242599999999999E-2</c:v>
                </c:pt>
                <c:pt idx="1567" formatCode="General">
                  <c:v>5.4079099999999998E-2</c:v>
                </c:pt>
                <c:pt idx="1568" formatCode="General">
                  <c:v>5.0204899999999997E-2</c:v>
                </c:pt>
                <c:pt idx="1569" formatCode="General">
                  <c:v>4.6600999999999997E-2</c:v>
                </c:pt>
                <c:pt idx="1570" formatCode="General">
                  <c:v>4.32494E-2</c:v>
                </c:pt>
                <c:pt idx="1571" formatCode="General">
                  <c:v>4.01334E-2</c:v>
                </c:pt>
                <c:pt idx="1572" formatCode="General">
                  <c:v>3.7237100000000002E-2</c:v>
                </c:pt>
                <c:pt idx="1573" formatCode="General">
                  <c:v>3.4545800000000002E-2</c:v>
                </c:pt>
                <c:pt idx="1574" formatCode="General">
                  <c:v>3.20456E-2</c:v>
                </c:pt>
                <c:pt idx="1575" formatCode="General">
                  <c:v>2.9723400000000001E-2</c:v>
                </c:pt>
                <c:pt idx="1576" formatCode="General">
                  <c:v>2.7566899999999998E-2</c:v>
                </c:pt>
                <c:pt idx="1577" formatCode="General">
                  <c:v>2.5064099999999999E-2</c:v>
                </c:pt>
                <c:pt idx="1578" formatCode="General">
                  <c:v>2.2786000000000001E-2</c:v>
                </c:pt>
                <c:pt idx="1579" formatCode="General">
                  <c:v>2.0712999999999999E-2</c:v>
                </c:pt>
                <c:pt idx="1580" formatCode="General">
                  <c:v>1.8827099999999999E-2</c:v>
                </c:pt>
                <c:pt idx="1581" formatCode="General">
                  <c:v>1.7111899999999999E-2</c:v>
                </c:pt>
                <c:pt idx="1582" formatCode="General">
                  <c:v>1.5552099999999999E-2</c:v>
                </c:pt>
                <c:pt idx="1583" formatCode="General">
                  <c:v>1.44131E-2</c:v>
                </c:pt>
                <c:pt idx="1584" formatCode="General">
                  <c:v>1.35774E-2</c:v>
                </c:pt>
                <c:pt idx="1585" formatCode="General">
                  <c:v>1.27901E-2</c:v>
                </c:pt>
                <c:pt idx="1586" formatCode="General">
                  <c:v>1.2670900000000001E-2</c:v>
                </c:pt>
                <c:pt idx="1587" formatCode="General">
                  <c:v>1.2552799999999999E-2</c:v>
                </c:pt>
                <c:pt idx="1588" formatCode="General">
                  <c:v>1.24359E-2</c:v>
                </c:pt>
                <c:pt idx="1589" formatCode="General">
                  <c:v>1.2319999999999999E-2</c:v>
                </c:pt>
                <c:pt idx="1590" formatCode="General">
                  <c:v>1.2205199999999999E-2</c:v>
                </c:pt>
                <c:pt idx="1591" formatCode="General">
                  <c:v>1.2038399999999999E-2</c:v>
                </c:pt>
                <c:pt idx="1592" formatCode="General">
                  <c:v>1.18739E-2</c:v>
                </c:pt>
                <c:pt idx="1593" formatCode="General">
                  <c:v>1.17117E-2</c:v>
                </c:pt>
                <c:pt idx="1594" formatCode="General">
                  <c:v>1.15517E-2</c:v>
                </c:pt>
                <c:pt idx="1595" formatCode="General">
                  <c:v>1.1393800000000001E-2</c:v>
                </c:pt>
                <c:pt idx="1596" formatCode="General">
                  <c:v>1.1238100000000001E-2</c:v>
                </c:pt>
                <c:pt idx="1597" formatCode="General">
                  <c:v>1.0923E-2</c:v>
                </c:pt>
                <c:pt idx="1598" formatCode="General">
                  <c:v>1.06167E-2</c:v>
                </c:pt>
                <c:pt idx="1599" formatCode="General">
                  <c:v>1.0319E-2</c:v>
                </c:pt>
                <c:pt idx="1600" formatCode="General">
                  <c:v>1.0029700000000001E-2</c:v>
                </c:pt>
                <c:pt idx="1601" formatCode="General">
                  <c:v>9.7485000000000002E-3</c:v>
                </c:pt>
                <c:pt idx="1602" formatCode="General">
                  <c:v>9.1896700000000005E-3</c:v>
                </c:pt>
                <c:pt idx="1603" formatCode="General">
                  <c:v>8.6630200000000004E-3</c:v>
                </c:pt>
                <c:pt idx="1604" formatCode="General">
                  <c:v>8.1666900000000008E-3</c:v>
                </c:pt>
                <c:pt idx="1605" formatCode="General">
                  <c:v>7.6989700000000003E-3</c:v>
                </c:pt>
                <c:pt idx="1606" formatCode="General">
                  <c:v>7.2582000000000002E-3</c:v>
                </c:pt>
                <c:pt idx="1607" formatCode="General">
                  <c:v>6.7252900000000001E-3</c:v>
                </c:pt>
                <c:pt idx="1608" formatCode="General">
                  <c:v>6.2318199999999999E-3</c:v>
                </c:pt>
                <c:pt idx="1609" formatCode="General">
                  <c:v>5.7748799999999996E-3</c:v>
                </c:pt>
                <c:pt idx="1610" formatCode="General">
                  <c:v>5.3517699999999996E-3</c:v>
                </c:pt>
                <c:pt idx="1611" formatCode="General">
                  <c:v>4.9599800000000001E-3</c:v>
                </c:pt>
                <c:pt idx="1612" formatCode="General">
                  <c:v>4.5972000000000001E-3</c:v>
                </c:pt>
                <c:pt idx="1613" formatCode="General">
                  <c:v>4.2135000000000002E-3</c:v>
                </c:pt>
                <c:pt idx="1614" formatCode="General">
                  <c:v>3.8622299999999999E-3</c:v>
                </c:pt>
                <c:pt idx="1615" formatCode="General">
                  <c:v>3.5406499999999998E-3</c:v>
                </c:pt>
                <c:pt idx="1616" formatCode="General">
                  <c:v>3.2462400000000001E-3</c:v>
                </c:pt>
                <c:pt idx="1617" formatCode="General">
                  <c:v>2.9766800000000002E-3</c:v>
                </c:pt>
                <c:pt idx="1618" formatCode="General">
                  <c:v>2.7298700000000001E-3</c:v>
                </c:pt>
                <c:pt idx="1619" formatCode="General">
                  <c:v>2.4305799999999999E-3</c:v>
                </c:pt>
                <c:pt idx="1620" formatCode="General">
                  <c:v>2.16468E-3</c:v>
                </c:pt>
                <c:pt idx="1621" formatCode="General">
                  <c:v>1.9284E-3</c:v>
                </c:pt>
                <c:pt idx="1622" formatCode="General">
                  <c:v>1.7183999999999999E-3</c:v>
                </c:pt>
                <c:pt idx="1623" formatCode="General">
                  <c:v>1.53173E-3</c:v>
                </c:pt>
                <c:pt idx="1624" formatCode="General">
                  <c:v>1.3657599999999999E-3</c:v>
                </c:pt>
                <c:pt idx="1625" formatCode="General">
                  <c:v>1.21817E-3</c:v>
                </c:pt>
                <c:pt idx="1626" formatCode="General">
                  <c:v>1.0868900000000001E-3</c:v>
                </c:pt>
                <c:pt idx="1627" formatCode="General">
                  <c:v>9.7008399999999996E-4</c:v>
                </c:pt>
                <c:pt idx="1628" formatCode="General">
                  <c:v>8.6613300000000005E-4</c:v>
                </c:pt>
                <c:pt idx="1629" formatCode="General">
                  <c:v>7.73597E-4</c:v>
                </c:pt>
                <c:pt idx="1630" formatCode="General">
                  <c:v>6.912E-4</c:v>
                </c:pt>
                <c:pt idx="1631" formatCode="General">
                  <c:v>6.1780799999999996E-4</c:v>
                </c:pt>
                <c:pt idx="1632" formatCode="General">
                  <c:v>5.5241800000000005E-4</c:v>
                </c:pt>
                <c:pt idx="1633" formatCode="General">
                  <c:v>4.9413899999999999E-4</c:v>
                </c:pt>
                <c:pt idx="1634" formatCode="General">
                  <c:v>4.4218099999999999E-4</c:v>
                </c:pt>
                <c:pt idx="1635" formatCode="General">
                  <c:v>3.95843E-4</c:v>
                </c:pt>
                <c:pt idx="1636" formatCode="General">
                  <c:v>3.5450299999999999E-4</c:v>
                </c:pt>
                <c:pt idx="1637" formatCode="General">
                  <c:v>3.1761000000000002E-4</c:v>
                </c:pt>
                <c:pt idx="1638" formatCode="General">
                  <c:v>2.8467299999999999E-4</c:v>
                </c:pt>
                <c:pt idx="1639" formatCode="General">
                  <c:v>2.55257E-4</c:v>
                </c:pt>
                <c:pt idx="1640" formatCode="General">
                  <c:v>2.28977E-4</c:v>
                </c:pt>
                <c:pt idx="1641" formatCode="General">
                  <c:v>2.0549000000000001E-4</c:v>
                </c:pt>
                <c:pt idx="1642" formatCode="General">
                  <c:v>1.8448999999999999E-4</c:v>
                </c:pt>
                <c:pt idx="1643" formatCode="General">
                  <c:v>1.6570699999999999E-4</c:v>
                </c:pt>
                <c:pt idx="1644" formatCode="General">
                  <c:v>1.48901E-4</c:v>
                </c:pt>
                <c:pt idx="1645" formatCode="General">
                  <c:v>1.33857E-4</c:v>
                </c:pt>
                <c:pt idx="1646" formatCode="General">
                  <c:v>1.20386E-4</c:v>
                </c:pt>
                <c:pt idx="1647" formatCode="General">
                  <c:v>1.08318E-4</c:v>
                </c:pt>
                <c:pt idx="1648">
                  <c:v>9.7502200000000003E-5</c:v>
                </c:pt>
                <c:pt idx="1649">
                  <c:v>8.7805499999999998E-5</c:v>
                </c:pt>
                <c:pt idx="1650">
                  <c:v>7.9108299999999996E-5</c:v>
                </c:pt>
                <c:pt idx="1651">
                  <c:v>7.1304300000000001E-5</c:v>
                </c:pt>
                <c:pt idx="1652">
                  <c:v>6.4298800000000002E-5</c:v>
                </c:pt>
                <c:pt idx="1653">
                  <c:v>5.8007599999999997E-5</c:v>
                </c:pt>
                <c:pt idx="1654">
                  <c:v>5.2355300000000003E-5</c:v>
                </c:pt>
                <c:pt idx="1655">
                  <c:v>4.7275099999999997E-5</c:v>
                </c:pt>
                <c:pt idx="1656">
                  <c:v>4.2706900000000003E-5</c:v>
                </c:pt>
                <c:pt idx="1657">
                  <c:v>3.8597599999999998E-5</c:v>
                </c:pt>
                <c:pt idx="1658">
                  <c:v>3.48994E-5</c:v>
                </c:pt>
                <c:pt idx="1659">
                  <c:v>3.1569699999999997E-5</c:v>
                </c:pt>
                <c:pt idx="1660">
                  <c:v>2.8570600000000001E-5</c:v>
                </c:pt>
                <c:pt idx="1661">
                  <c:v>2.5868100000000001E-5</c:v>
                </c:pt>
                <c:pt idx="1662">
                  <c:v>2.3431700000000001E-5</c:v>
                </c:pt>
                <c:pt idx="1663">
                  <c:v>2.1234400000000001E-5</c:v>
                </c:pt>
                <c:pt idx="1664">
                  <c:v>1.9251800000000001E-5</c:v>
                </c:pt>
                <c:pt idx="1665">
                  <c:v>1.74622E-5</c:v>
                </c:pt>
                <c:pt idx="1666">
                  <c:v>1.5846E-5</c:v>
                </c:pt>
                <c:pt idx="1667">
                  <c:v>1.4385900000000001E-5</c:v>
                </c:pt>
                <c:pt idx="1668">
                  <c:v>1.30662E-5</c:v>
                </c:pt>
                <c:pt idx="1669">
                  <c:v>1.1872799999999999E-5</c:v>
                </c:pt>
                <c:pt idx="1670">
                  <c:v>1.07933E-5</c:v>
                </c:pt>
                <c:pt idx="1671">
                  <c:v>9.8163199999999992E-6</c:v>
                </c:pt>
                <c:pt idx="1672">
                  <c:v>8.9317299999999999E-6</c:v>
                </c:pt>
                <c:pt idx="1673">
                  <c:v>8.1304700000000008E-6</c:v>
                </c:pt>
                <c:pt idx="1674">
                  <c:v>7.4043800000000001E-6</c:v>
                </c:pt>
                <c:pt idx="1675">
                  <c:v>6.7461100000000004E-6</c:v>
                </c:pt>
                <c:pt idx="1676">
                  <c:v>6.1490799999999996E-6</c:v>
                </c:pt>
                <c:pt idx="1677">
                  <c:v>5.6073499999999998E-6</c:v>
                </c:pt>
                <c:pt idx="1678">
                  <c:v>5.1155899999999999E-6</c:v>
                </c:pt>
                <c:pt idx="1679">
                  <c:v>4.6690100000000004E-6</c:v>
                </c:pt>
                <c:pt idx="1680">
                  <c:v>4.2632699999999999E-6</c:v>
                </c:pt>
                <c:pt idx="1681">
                  <c:v>3.8944899999999999E-6</c:v>
                </c:pt>
                <c:pt idx="1682">
                  <c:v>3.5591500000000001E-6</c:v>
                </c:pt>
                <c:pt idx="1683">
                  <c:v>3.2540999999999999E-6</c:v>
                </c:pt>
                <c:pt idx="1684">
                  <c:v>2.9764699999999998E-6</c:v>
                </c:pt>
                <c:pt idx="1685">
                  <c:v>2.7237100000000001E-6</c:v>
                </c:pt>
                <c:pt idx="1686">
                  <c:v>2.4934699999999999E-6</c:v>
                </c:pt>
                <c:pt idx="1687">
                  <c:v>2.2836800000000001E-6</c:v>
                </c:pt>
                <c:pt idx="1688">
                  <c:v>2.0924300000000001E-6</c:v>
                </c:pt>
                <c:pt idx="1689">
                  <c:v>1.91801E-6</c:v>
                </c:pt>
                <c:pt idx="1690">
                  <c:v>1.75887E-6</c:v>
                </c:pt>
                <c:pt idx="1691">
                  <c:v>1.5988799999999999E-6</c:v>
                </c:pt>
                <c:pt idx="1692">
                  <c:v>1.4541899999999999E-6</c:v>
                </c:pt>
                <c:pt idx="1693">
                  <c:v>1.3232699999999999E-6</c:v>
                </c:pt>
                <c:pt idx="1694">
                  <c:v>1.20475E-6</c:v>
                </c:pt>
                <c:pt idx="1695">
                  <c:v>1.0974000000000001E-6</c:v>
                </c:pt>
                <c:pt idx="1696">
                  <c:v>1.0001299999999999E-6</c:v>
                </c:pt>
                <c:pt idx="1697">
                  <c:v>9.1193399999999999E-7</c:v>
                </c:pt>
                <c:pt idx="1698">
                  <c:v>8.3193500000000004E-7</c:v>
                </c:pt>
                <c:pt idx="1699">
                  <c:v>7.5933300000000004E-7</c:v>
                </c:pt>
                <c:pt idx="1700">
                  <c:v>6.9341099999999999E-7</c:v>
                </c:pt>
                <c:pt idx="1701">
                  <c:v>6.3352699999999995E-7</c:v>
                </c:pt>
                <c:pt idx="1702">
                  <c:v>5.7909899999999996E-7</c:v>
                </c:pt>
                <c:pt idx="1703">
                  <c:v>5.2960699999999996E-7</c:v>
                </c:pt>
                <c:pt idx="1704">
                  <c:v>4.8458099999999999E-7</c:v>
                </c:pt>
                <c:pt idx="1705">
                  <c:v>4.43599E-7</c:v>
                </c:pt>
                <c:pt idx="1706">
                  <c:v>4.0628000000000001E-7</c:v>
                </c:pt>
                <c:pt idx="1707">
                  <c:v>3.7227900000000002E-7</c:v>
                </c:pt>
                <c:pt idx="1708">
                  <c:v>3.4128800000000001E-7</c:v>
                </c:pt>
                <c:pt idx="1709">
                  <c:v>3.1302500000000001E-7</c:v>
                </c:pt>
                <c:pt idx="1710">
                  <c:v>2.8724000000000002E-7</c:v>
                </c:pt>
                <c:pt idx="1711">
                  <c:v>2.6370299999999999E-7</c:v>
                </c:pt>
                <c:pt idx="1712">
                  <c:v>2.4011899999999998E-7</c:v>
                </c:pt>
                <c:pt idx="1713">
                  <c:v>2.1876899999999999E-7</c:v>
                </c:pt>
                <c:pt idx="1714">
                  <c:v>1.9943000000000001E-7</c:v>
                </c:pt>
                <c:pt idx="1715">
                  <c:v>1.8190300000000001E-7</c:v>
                </c:pt>
                <c:pt idx="1716">
                  <c:v>1.6600800000000001E-7</c:v>
                </c:pt>
                <c:pt idx="1717">
                  <c:v>1.5158799999999999E-7</c:v>
                </c:pt>
                <c:pt idx="1718">
                  <c:v>1.38496E-7</c:v>
                </c:pt>
                <c:pt idx="1719">
                  <c:v>1.2660499999999999E-7</c:v>
                </c:pt>
                <c:pt idx="1720">
                  <c:v>1.15798E-7</c:v>
                </c:pt>
                <c:pt idx="1721">
                  <c:v>1.05971E-7</c:v>
                </c:pt>
                <c:pt idx="1722">
                  <c:v>9.7030800000000006E-8</c:v>
                </c:pt>
                <c:pt idx="1723">
                  <c:v>8.8892600000000005E-8</c:v>
                </c:pt>
                <c:pt idx="1724">
                  <c:v>8.1480600000000005E-8</c:v>
                </c:pt>
                <c:pt idx="1725">
                  <c:v>7.4726500000000004E-8</c:v>
                </c:pt>
                <c:pt idx="1726">
                  <c:v>6.8568499999999996E-8</c:v>
                </c:pt>
                <c:pt idx="1727">
                  <c:v>6.2951200000000003E-8</c:v>
                </c:pt>
                <c:pt idx="1728">
                  <c:v>5.7824299999999999E-8</c:v>
                </c:pt>
                <c:pt idx="1729">
                  <c:v>5.31426E-8</c:v>
                </c:pt>
                <c:pt idx="1730">
                  <c:v>4.8865299999999998E-8</c:v>
                </c:pt>
                <c:pt idx="1731">
                  <c:v>4.4955500000000002E-8</c:v>
                </c:pt>
                <c:pt idx="1732">
                  <c:v>4.1379600000000002E-8</c:v>
                </c:pt>
                <c:pt idx="1733">
                  <c:v>3.7745599999999998E-8</c:v>
                </c:pt>
                <c:pt idx="1734">
                  <c:v>3.4452399999999998E-8</c:v>
                </c:pt>
                <c:pt idx="1735">
                  <c:v>3.1466300000000002E-8</c:v>
                </c:pt>
                <c:pt idx="1736">
                  <c:v>2.8756899999999999E-8</c:v>
                </c:pt>
                <c:pt idx="1737">
                  <c:v>2.6297099999999999E-8</c:v>
                </c:pt>
                <c:pt idx="1738">
                  <c:v>2.4062500000000001E-8</c:v>
                </c:pt>
                <c:pt idx="1739">
                  <c:v>2.2031200000000001E-8</c:v>
                </c:pt>
                <c:pt idx="1740">
                  <c:v>2.0183700000000001E-8</c:v>
                </c:pt>
                <c:pt idx="1741">
                  <c:v>1.85022E-8</c:v>
                </c:pt>
                <c:pt idx="1742">
                  <c:v>1.6971E-8</c:v>
                </c:pt>
                <c:pt idx="1743">
                  <c:v>1.5575799999999999E-8</c:v>
                </c:pt>
                <c:pt idx="1744">
                  <c:v>1.4303799999999999E-8</c:v>
                </c:pt>
                <c:pt idx="1745">
                  <c:v>1.3143400000000001E-8</c:v>
                </c:pt>
                <c:pt idx="1746">
                  <c:v>1.20842E-8</c:v>
                </c:pt>
                <c:pt idx="1747">
                  <c:v>1.11168E-8</c:v>
                </c:pt>
                <c:pt idx="1748">
                  <c:v>1.02327E-8</c:v>
                </c:pt>
                <c:pt idx="1749">
                  <c:v>9.4243799999999993E-9</c:v>
                </c:pt>
                <c:pt idx="1750">
                  <c:v>8.6848499999999998E-9</c:v>
                </c:pt>
                <c:pt idx="1751">
                  <c:v>7.9374799999999994E-9</c:v>
                </c:pt>
                <c:pt idx="1752">
                  <c:v>7.2594500000000002E-9</c:v>
                </c:pt>
                <c:pt idx="1753">
                  <c:v>6.6438900000000003E-9</c:v>
                </c:pt>
                <c:pt idx="1754">
                  <c:v>6.08469E-9</c:v>
                </c:pt>
                <c:pt idx="1755">
                  <c:v>5.57632E-9</c:v>
                </c:pt>
                <c:pt idx="1756">
                  <c:v>5.1138600000000004E-9</c:v>
                </c:pt>
                <c:pt idx="1757">
                  <c:v>4.6928899999999999E-9</c:v>
                </c:pt>
                <c:pt idx="1758">
                  <c:v>4.3094299999999997E-9</c:v>
                </c:pt>
                <c:pt idx="1759">
                  <c:v>3.9599099999999998E-9</c:v>
                </c:pt>
                <c:pt idx="1760">
                  <c:v>3.6411100000000001E-9</c:v>
                </c:pt>
                <c:pt idx="1761">
                  <c:v>3.3501500000000001E-9</c:v>
                </c:pt>
                <c:pt idx="1762">
                  <c:v>3.0844299999999999E-9</c:v>
                </c:pt>
                <c:pt idx="1763">
                  <c:v>2.8416000000000002E-9</c:v>
                </c:pt>
                <c:pt idx="1764">
                  <c:v>2.6195500000000001E-9</c:v>
                </c:pt>
                <c:pt idx="1765">
                  <c:v>2.4163799999999999E-9</c:v>
                </c:pt>
                <c:pt idx="1766">
                  <c:v>2.2119899999999999E-9</c:v>
                </c:pt>
                <c:pt idx="1767">
                  <c:v>2.02643E-9</c:v>
                </c:pt>
                <c:pt idx="1768">
                  <c:v>1.85783E-9</c:v>
                </c:pt>
                <c:pt idx="1769">
                  <c:v>1.70452E-9</c:v>
                </c:pt>
                <c:pt idx="1770">
                  <c:v>1.56502E-9</c:v>
                </c:pt>
                <c:pt idx="1771">
                  <c:v>1.4379899999999999E-9</c:v>
                </c:pt>
                <c:pt idx="1772">
                  <c:v>1.32224E-9</c:v>
                </c:pt>
                <c:pt idx="1773">
                  <c:v>1.2166700000000001E-9</c:v>
                </c:pt>
                <c:pt idx="1774">
                  <c:v>1.1203400000000001E-9</c:v>
                </c:pt>
                <c:pt idx="1775">
                  <c:v>1.03237E-9</c:v>
                </c:pt>
                <c:pt idx="1776">
                  <c:v>9.5197699999999993E-10</c:v>
                </c:pt>
                <c:pt idx="1777">
                  <c:v>8.7845799999999997E-10</c:v>
                </c:pt>
                <c:pt idx="1778">
                  <c:v>8.1117899999999998E-10</c:v>
                </c:pt>
                <c:pt idx="1779">
                  <c:v>7.4956800000000001E-10</c:v>
                </c:pt>
                <c:pt idx="1780">
                  <c:v>6.9311E-10</c:v>
                </c:pt>
                <c:pt idx="1781">
                  <c:v>6.3573699999999999E-10</c:v>
                </c:pt>
                <c:pt idx="1782">
                  <c:v>5.8359900000000002E-10</c:v>
                </c:pt>
                <c:pt idx="1783">
                  <c:v>5.3617899999999999E-10</c:v>
                </c:pt>
                <c:pt idx="1784">
                  <c:v>4.9301499999999998E-10</c:v>
                </c:pt>
                <c:pt idx="1785">
                  <c:v>4.5369399999999999E-10</c:v>
                </c:pt>
                <c:pt idx="1786">
                  <c:v>4.1784400000000001E-10</c:v>
                </c:pt>
                <c:pt idx="1787">
                  <c:v>3.8513399999999998E-10</c:v>
                </c:pt>
                <c:pt idx="1788">
                  <c:v>3.5526500000000001E-10</c:v>
                </c:pt>
                <c:pt idx="1789">
                  <c:v>3.27969E-10</c:v>
                </c:pt>
                <c:pt idx="1790">
                  <c:v>3.0300499999999998E-10</c:v>
                </c:pt>
                <c:pt idx="1791">
                  <c:v>2.8015700000000002E-10</c:v>
                </c:pt>
                <c:pt idx="1792">
                  <c:v>2.5922899999999998E-10</c:v>
                </c:pt>
                <c:pt idx="1793">
                  <c:v>2.4004599999999998E-10</c:v>
                </c:pt>
                <c:pt idx="1794">
                  <c:v>2.2244900000000001E-10</c:v>
                </c:pt>
                <c:pt idx="1795">
                  <c:v>2.0629500000000001E-10</c:v>
                </c:pt>
                <c:pt idx="1796">
                  <c:v>1.9145500000000001E-10</c:v>
                </c:pt>
                <c:pt idx="1797">
                  <c:v>1.77812E-10</c:v>
                </c:pt>
                <c:pt idx="1798">
                  <c:v>1.6757E-10</c:v>
                </c:pt>
                <c:pt idx="1799">
                  <c:v>1.59642E-10</c:v>
                </c:pt>
                <c:pt idx="1800">
                  <c:v>1.5213800000000001E-10</c:v>
                </c:pt>
                <c:pt idx="1801">
                  <c:v>1.4503200000000001E-10</c:v>
                </c:pt>
                <c:pt idx="1802">
                  <c:v>1.3830100000000001E-10</c:v>
                </c:pt>
                <c:pt idx="1803">
                  <c:v>1.31924E-10</c:v>
                </c:pt>
                <c:pt idx="1804">
                  <c:v>1.2472000000000001E-10</c:v>
                </c:pt>
                <c:pt idx="1805">
                  <c:v>1.1796199999999999E-10</c:v>
                </c:pt>
                <c:pt idx="1806">
                  <c:v>1.11619E-10</c:v>
                </c:pt>
                <c:pt idx="1807">
                  <c:v>1.05662E-10</c:v>
                </c:pt>
                <c:pt idx="1808">
                  <c:v>1.00067E-10</c:v>
                </c:pt>
                <c:pt idx="1809">
                  <c:v>9.4808799999999999E-11</c:v>
                </c:pt>
                <c:pt idx="1810">
                  <c:v>8.9865099999999998E-11</c:v>
                </c:pt>
                <c:pt idx="1811">
                  <c:v>8.5215199999999999E-11</c:v>
                </c:pt>
                <c:pt idx="1812">
                  <c:v>8.0839800000000003E-11</c:v>
                </c:pt>
                <c:pt idx="1813">
                  <c:v>7.6721099999999996E-11</c:v>
                </c:pt>
                <c:pt idx="1814">
                  <c:v>7.2842400000000006E-11</c:v>
                </c:pt>
                <c:pt idx="1815">
                  <c:v>6.9188200000000004E-11</c:v>
                </c:pt>
                <c:pt idx="1816">
                  <c:v>6.5744099999999999E-11</c:v>
                </c:pt>
                <c:pt idx="1817">
                  <c:v>6.2496800000000005E-11</c:v>
                </c:pt>
                <c:pt idx="1818">
                  <c:v>5.9433800000000005E-11</c:v>
                </c:pt>
                <c:pt idx="1819">
                  <c:v>5.6543600000000003E-11</c:v>
                </c:pt>
                <c:pt idx="1820">
                  <c:v>5.3815200000000003E-11</c:v>
                </c:pt>
                <c:pt idx="1821">
                  <c:v>5.1238700000000001E-11</c:v>
                </c:pt>
                <c:pt idx="1822">
                  <c:v>4.8804600000000001E-11</c:v>
                </c:pt>
                <c:pt idx="1823">
                  <c:v>4.6504200000000002E-11</c:v>
                </c:pt>
                <c:pt idx="1824">
                  <c:v>4.4012400000000001E-11</c:v>
                </c:pt>
                <c:pt idx="1825">
                  <c:v>4.16751E-11</c:v>
                </c:pt>
                <c:pt idx="1826">
                  <c:v>3.9481800000000001E-11</c:v>
                </c:pt>
                <c:pt idx="1827">
                  <c:v>3.74226E-11</c:v>
                </c:pt>
                <c:pt idx="1828">
                  <c:v>3.5488299999999999E-11</c:v>
                </c:pt>
                <c:pt idx="1829">
                  <c:v>3.3670600000000002E-11</c:v>
                </c:pt>
                <c:pt idx="1830">
                  <c:v>3.2249200000000002E-11</c:v>
                </c:pt>
                <c:pt idx="1831">
                  <c:v>3.0898E-11</c:v>
                </c:pt>
                <c:pt idx="1832">
                  <c:v>2.9613200000000001E-11</c:v>
                </c:pt>
                <c:pt idx="1833">
                  <c:v>2.83911E-11</c:v>
                </c:pt>
                <c:pt idx="1834">
                  <c:v>2.7228200000000001E-11</c:v>
                </c:pt>
                <c:pt idx="1835">
                  <c:v>2.61214E-11</c:v>
                </c:pt>
                <c:pt idx="1836">
                  <c:v>2.5067500000000002E-11</c:v>
                </c:pt>
                <c:pt idx="1837">
                  <c:v>2.4063900000000001E-11</c:v>
                </c:pt>
                <c:pt idx="1838">
                  <c:v>2.2954100000000001E-11</c:v>
                </c:pt>
                <c:pt idx="1839">
                  <c:v>2.1904900000000001E-11</c:v>
                </c:pt>
                <c:pt idx="1840">
                  <c:v>2.0912400000000001E-11</c:v>
                </c:pt>
                <c:pt idx="1841">
                  <c:v>1.9973299999999999E-11</c:v>
                </c:pt>
                <c:pt idx="1842">
                  <c:v>1.9084200000000001E-11</c:v>
                </c:pt>
                <c:pt idx="1843">
                  <c:v>1.80927E-11</c:v>
                </c:pt>
                <c:pt idx="1844">
                  <c:v>1.7162500000000001E-11</c:v>
                </c:pt>
                <c:pt idx="1845">
                  <c:v>1.6289399999999999E-11</c:v>
                </c:pt>
                <c:pt idx="1846">
                  <c:v>1.5469299999999999E-11</c:v>
                </c:pt>
                <c:pt idx="1847">
                  <c:v>1.4698700000000001E-11</c:v>
                </c:pt>
                <c:pt idx="1848">
                  <c:v>1.3974200000000001E-11</c:v>
                </c:pt>
                <c:pt idx="1849">
                  <c:v>1.3420999999999999E-11</c:v>
                </c:pt>
                <c:pt idx="1850">
                  <c:v>1.28942E-11</c:v>
                </c:pt>
                <c:pt idx="1851">
                  <c:v>1.23924E-11</c:v>
                </c:pt>
                <c:pt idx="1852">
                  <c:v>1.19143E-11</c:v>
                </c:pt>
                <c:pt idx="1853">
                  <c:v>1.14586E-11</c:v>
                </c:pt>
                <c:pt idx="1854">
                  <c:v>1.1024099999999999E-11</c:v>
                </c:pt>
                <c:pt idx="1855">
                  <c:v>1.0609700000000001E-11</c:v>
                </c:pt>
                <c:pt idx="1856">
                  <c:v>1.02143E-11</c:v>
                </c:pt>
                <c:pt idx="1857">
                  <c:v>9.8369000000000006E-12</c:v>
                </c:pt>
                <c:pt idx="1858">
                  <c:v>9.4766300000000006E-12</c:v>
                </c:pt>
                <c:pt idx="1859">
                  <c:v>9.1325700000000005E-12</c:v>
                </c:pt>
                <c:pt idx="1860">
                  <c:v>8.6709799999999995E-12</c:v>
                </c:pt>
                <c:pt idx="1861">
                  <c:v>8.2380800000000004E-12</c:v>
                </c:pt>
                <c:pt idx="1862">
                  <c:v>7.8318300000000002E-12</c:v>
                </c:pt>
                <c:pt idx="1863">
                  <c:v>7.4503800000000004E-12</c:v>
                </c:pt>
                <c:pt idx="1864">
                  <c:v>7.0919799999999998E-12</c:v>
                </c:pt>
                <c:pt idx="1865">
                  <c:v>6.6932099999999999E-12</c:v>
                </c:pt>
                <c:pt idx="1866">
                  <c:v>6.3223800000000004E-12</c:v>
                </c:pt>
                <c:pt idx="1867">
                  <c:v>5.9772599999999999E-12</c:v>
                </c:pt>
                <c:pt idx="1868">
                  <c:v>5.6558000000000002E-12</c:v>
                </c:pt>
                <c:pt idx="1869">
                  <c:v>5.3561300000000001E-12</c:v>
                </c:pt>
                <c:pt idx="1870">
                  <c:v>5.0765499999999998E-12</c:v>
                </c:pt>
                <c:pt idx="1871">
                  <c:v>4.7285600000000002E-12</c:v>
                </c:pt>
                <c:pt idx="1872">
                  <c:v>4.4109000000000001E-12</c:v>
                </c:pt>
                <c:pt idx="1873">
                  <c:v>4.1205199999999999E-12</c:v>
                </c:pt>
                <c:pt idx="1874">
                  <c:v>3.8547300000000001E-12</c:v>
                </c:pt>
                <c:pt idx="1875">
                  <c:v>3.6111099999999999E-12</c:v>
                </c:pt>
                <c:pt idx="1876">
                  <c:v>3.3875299999999998E-12</c:v>
                </c:pt>
                <c:pt idx="1877">
                  <c:v>3.1478199999999998E-12</c:v>
                </c:pt>
                <c:pt idx="1878">
                  <c:v>2.9304099999999998E-12</c:v>
                </c:pt>
                <c:pt idx="1879">
                  <c:v>2.7329099999999999E-12</c:v>
                </c:pt>
                <c:pt idx="1880">
                  <c:v>2.5531899999999999E-12</c:v>
                </c:pt>
                <c:pt idx="1881">
                  <c:v>2.3893999999999999E-12</c:v>
                </c:pt>
                <c:pt idx="1882">
                  <c:v>2.2398900000000001E-12</c:v>
                </c:pt>
                <c:pt idx="1883">
                  <c:v>2.1032099999999999E-12</c:v>
                </c:pt>
                <c:pt idx="1884">
                  <c:v>1.9780699999999999E-12</c:v>
                </c:pt>
                <c:pt idx="1885">
                  <c:v>1.8633299999999999E-12</c:v>
                </c:pt>
                <c:pt idx="1886">
                  <c:v>1.7579799999999999E-12</c:v>
                </c:pt>
                <c:pt idx="1887">
                  <c:v>1.74302E-12</c:v>
                </c:pt>
                <c:pt idx="1888">
                  <c:v>1.72825E-12</c:v>
                </c:pt>
                <c:pt idx="1889">
                  <c:v>1.71366E-12</c:v>
                </c:pt>
                <c:pt idx="1890">
                  <c:v>1.6992500000000001E-12</c:v>
                </c:pt>
                <c:pt idx="1891">
                  <c:v>1.6850099999999999E-12</c:v>
                </c:pt>
                <c:pt idx="1892">
                  <c:v>1.66544E-12</c:v>
                </c:pt>
                <c:pt idx="1893">
                  <c:v>1.6462099999999999E-12</c:v>
                </c:pt>
                <c:pt idx="1894">
                  <c:v>1.6272999999999999E-12</c:v>
                </c:pt>
                <c:pt idx="1895">
                  <c:v>1.6087099999999999E-12</c:v>
                </c:pt>
                <c:pt idx="1896">
                  <c:v>1.59044E-12</c:v>
                </c:pt>
                <c:pt idx="1897">
                  <c:v>1.5487399999999999E-12</c:v>
                </c:pt>
                <c:pt idx="1898">
                  <c:v>1.50866E-12</c:v>
                </c:pt>
                <c:pt idx="1899">
                  <c:v>1.4701299999999999E-12</c:v>
                </c:pt>
                <c:pt idx="1900">
                  <c:v>1.43306E-12</c:v>
                </c:pt>
                <c:pt idx="1901">
                  <c:v>1.39741E-12</c:v>
                </c:pt>
                <c:pt idx="1902">
                  <c:v>1.32774E-12</c:v>
                </c:pt>
                <c:pt idx="1903">
                  <c:v>1.2633199999999999E-12</c:v>
                </c:pt>
                <c:pt idx="1904">
                  <c:v>1.2036900000000001E-12</c:v>
                </c:pt>
                <c:pt idx="1905">
                  <c:v>1.1484200000000001E-12</c:v>
                </c:pt>
                <c:pt idx="1906">
                  <c:v>1.09715E-12</c:v>
                </c:pt>
                <c:pt idx="1907">
                  <c:v>1.04952E-12</c:v>
                </c:pt>
                <c:pt idx="1908">
                  <c:v>9.7632399999999991E-13</c:v>
                </c:pt>
                <c:pt idx="1909">
                  <c:v>9.1144500000000006E-13</c:v>
                </c:pt>
                <c:pt idx="1910">
                  <c:v>8.5378700000000003E-13</c:v>
                </c:pt>
                <c:pt idx="1911">
                  <c:v>8.0241799999999998E-13</c:v>
                </c:pt>
                <c:pt idx="1912">
                  <c:v>7.56548E-13</c:v>
                </c:pt>
                <c:pt idx="1913">
                  <c:v>7.1550000000000003E-13</c:v>
                </c:pt>
                <c:pt idx="1914">
                  <c:v>6.7869799999999998E-13</c:v>
                </c:pt>
                <c:pt idx="1915">
                  <c:v>6.4564399999999995E-13</c:v>
                </c:pt>
                <c:pt idx="1916">
                  <c:v>6.1591000000000005E-13</c:v>
                </c:pt>
                <c:pt idx="1917">
                  <c:v>5.8912600000000005E-13</c:v>
                </c:pt>
                <c:pt idx="1918">
                  <c:v>5.6497299999999998E-13</c:v>
                </c:pt>
                <c:pt idx="1919">
                  <c:v>5.4317099999999997E-13</c:v>
                </c:pt>
                <c:pt idx="1920">
                  <c:v>5.2067100000000001E-13</c:v>
                </c:pt>
                <c:pt idx="1921">
                  <c:v>5.0064900000000002E-13</c:v>
                </c:pt>
                <c:pt idx="1922">
                  <c:v>4.82829E-13</c:v>
                </c:pt>
                <c:pt idx="1923">
                  <c:v>4.6697600000000001E-13</c:v>
                </c:pt>
                <c:pt idx="1924">
                  <c:v>4.5288699999999999E-13</c:v>
                </c:pt>
                <c:pt idx="1925">
                  <c:v>4.40385E-13</c:v>
                </c:pt>
                <c:pt idx="1926">
                  <c:v>4.2723699999999999E-13</c:v>
                </c:pt>
                <c:pt idx="1927">
                  <c:v>4.15938E-13</c:v>
                </c:pt>
                <c:pt idx="1928">
                  <c:v>4.0629299999999999E-13</c:v>
                </c:pt>
                <c:pt idx="1929">
                  <c:v>3.9813899999999999E-13</c:v>
                </c:pt>
                <c:pt idx="1930">
                  <c:v>3.9133700000000001E-13</c:v>
                </c:pt>
                <c:pt idx="1931">
                  <c:v>3.8576900000000001E-13</c:v>
                </c:pt>
                <c:pt idx="1932">
                  <c:v>3.8040499999999998E-13</c:v>
                </c:pt>
                <c:pt idx="1933">
                  <c:v>3.7664E-13</c:v>
                </c:pt>
                <c:pt idx="1934">
                  <c:v>3.7434E-13</c:v>
                </c:pt>
                <c:pt idx="1935">
                  <c:v>3.7339800000000001E-13</c:v>
                </c:pt>
                <c:pt idx="1936">
                  <c:v>3.7372599999999998E-13</c:v>
                </c:pt>
                <c:pt idx="1937">
                  <c:v>3.75255E-13</c:v>
                </c:pt>
                <c:pt idx="1938">
                  <c:v>3.7880099999999998E-13</c:v>
                </c:pt>
                <c:pt idx="1939">
                  <c:v>3.8408099999999999E-13</c:v>
                </c:pt>
                <c:pt idx="1940">
                  <c:v>3.91044E-13</c:v>
                </c:pt>
                <c:pt idx="1941">
                  <c:v>3.9966100000000001E-13</c:v>
                </c:pt>
                <c:pt idx="1942">
                  <c:v>4.0992199999999998E-13</c:v>
                </c:pt>
                <c:pt idx="1943">
                  <c:v>4.2183899999999998E-13</c:v>
                </c:pt>
                <c:pt idx="1944">
                  <c:v>4.3971300000000002E-13</c:v>
                </c:pt>
                <c:pt idx="1945">
                  <c:v>4.6048100000000004E-13</c:v>
                </c:pt>
                <c:pt idx="1946">
                  <c:v>4.8427300000000003E-13</c:v>
                </c:pt>
                <c:pt idx="1947">
                  <c:v>5.1125399999999995E-13</c:v>
                </c:pt>
                <c:pt idx="1948">
                  <c:v>5.4162699999999997E-13</c:v>
                </c:pt>
                <c:pt idx="1949">
                  <c:v>5.7563000000000004E-13</c:v>
                </c:pt>
                <c:pt idx="1950">
                  <c:v>6.1976999999999999E-13</c:v>
                </c:pt>
                <c:pt idx="1951">
                  <c:v>6.6960099999999997E-13</c:v>
                </c:pt>
                <c:pt idx="1952">
                  <c:v>7.2567699999999998E-13</c:v>
                </c:pt>
                <c:pt idx="1953">
                  <c:v>7.8863000000000004E-13</c:v>
                </c:pt>
                <c:pt idx="1954">
                  <c:v>8.5917299999999998E-13</c:v>
                </c:pt>
                <c:pt idx="1955">
                  <c:v>9.3810700000000001E-13</c:v>
                </c:pt>
                <c:pt idx="1956">
                  <c:v>1.02634E-12</c:v>
                </c:pt>
                <c:pt idx="1957">
                  <c:v>1.12487E-12</c:v>
                </c:pt>
                <c:pt idx="1958">
                  <c:v>1.2348299999999999E-12</c:v>
                </c:pt>
                <c:pt idx="1959">
                  <c:v>1.35748E-12</c:v>
                </c:pt>
                <c:pt idx="1960">
                  <c:v>1.4942399999999999E-12</c:v>
                </c:pt>
                <c:pt idx="1961">
                  <c:v>1.64666E-12</c:v>
                </c:pt>
                <c:pt idx="1962">
                  <c:v>1.8165099999999999E-12</c:v>
                </c:pt>
                <c:pt idx="1963">
                  <c:v>2.0057200000000001E-12</c:v>
                </c:pt>
                <c:pt idx="1964">
                  <c:v>2.2164799999999999E-12</c:v>
                </c:pt>
                <c:pt idx="1965">
                  <c:v>2.4511999999999999E-12</c:v>
                </c:pt>
                <c:pt idx="1966">
                  <c:v>2.7125800000000001E-12</c:v>
                </c:pt>
                <c:pt idx="1967">
                  <c:v>3.0036200000000001E-12</c:v>
                </c:pt>
                <c:pt idx="1968">
                  <c:v>3.32766E-12</c:v>
                </c:pt>
                <c:pt idx="1969">
                  <c:v>3.6884199999999997E-12</c:v>
                </c:pt>
                <c:pt idx="1970">
                  <c:v>4.0900500000000003E-12</c:v>
                </c:pt>
                <c:pt idx="1971">
                  <c:v>4.53716E-12</c:v>
                </c:pt>
                <c:pt idx="1972">
                  <c:v>5.0348700000000003E-12</c:v>
                </c:pt>
                <c:pt idx="1973">
                  <c:v>5.5889100000000003E-12</c:v>
                </c:pt>
                <c:pt idx="1974">
                  <c:v>6.2056399999999998E-12</c:v>
                </c:pt>
                <c:pt idx="1975">
                  <c:v>6.89213E-12</c:v>
                </c:pt>
                <c:pt idx="1976">
                  <c:v>7.6562600000000003E-12</c:v>
                </c:pt>
                <c:pt idx="1977">
                  <c:v>8.5068100000000002E-12</c:v>
                </c:pt>
                <c:pt idx="1978">
                  <c:v>9.4535299999999992E-12</c:v>
                </c:pt>
                <c:pt idx="1979">
                  <c:v>1.05073E-11</c:v>
                </c:pt>
                <c:pt idx="1980">
                  <c:v>1.1680199999999999E-11</c:v>
                </c:pt>
                <c:pt idx="1981">
                  <c:v>1.2985699999999999E-11</c:v>
                </c:pt>
                <c:pt idx="1982">
                  <c:v>1.4438799999999999E-11</c:v>
                </c:pt>
                <c:pt idx="1983">
                  <c:v>1.6056100000000001E-11</c:v>
                </c:pt>
                <c:pt idx="1984">
                  <c:v>1.78563E-11</c:v>
                </c:pt>
                <c:pt idx="1985">
                  <c:v>1.98599E-11</c:v>
                </c:pt>
                <c:pt idx="1986">
                  <c:v>2.2090000000000001E-11</c:v>
                </c:pt>
                <c:pt idx="1987">
                  <c:v>2.4572199999999999E-11</c:v>
                </c:pt>
                <c:pt idx="1988">
                  <c:v>2.7334899999999999E-11</c:v>
                </c:pt>
                <c:pt idx="1989">
                  <c:v>3.0409900000000002E-11</c:v>
                </c:pt>
                <c:pt idx="1990">
                  <c:v>3.3832399999999997E-11</c:v>
                </c:pt>
                <c:pt idx="1991">
                  <c:v>3.7641699999999998E-11</c:v>
                </c:pt>
                <c:pt idx="1992">
                  <c:v>4.1881500000000002E-11</c:v>
                </c:pt>
                <c:pt idx="1993">
                  <c:v>4.6600499999999997E-11</c:v>
                </c:pt>
                <c:pt idx="1994">
                  <c:v>5.1852700000000002E-11</c:v>
                </c:pt>
                <c:pt idx="1995">
                  <c:v>5.7698599999999998E-11</c:v>
                </c:pt>
                <c:pt idx="1996">
                  <c:v>6.4205100000000006E-11</c:v>
                </c:pt>
                <c:pt idx="1997">
                  <c:v>7.1446900000000003E-11</c:v>
                </c:pt>
                <c:pt idx="1998">
                  <c:v>7.9507099999999998E-11</c:v>
                </c:pt>
                <c:pt idx="1999">
                  <c:v>8.8478100000000003E-11</c:v>
                </c:pt>
                <c:pt idx="2000">
                  <c:v>9.8463000000000002E-11</c:v>
                </c:pt>
                <c:pt idx="2001">
                  <c:v>1.09576E-10</c:v>
                </c:pt>
                <c:pt idx="2002">
                  <c:v>1.2194500000000001E-10</c:v>
                </c:pt>
                <c:pt idx="2003">
                  <c:v>1.3571200000000001E-10</c:v>
                </c:pt>
                <c:pt idx="2004">
                  <c:v>1.5103500000000001E-10</c:v>
                </c:pt>
                <c:pt idx="2005">
                  <c:v>1.68089E-10</c:v>
                </c:pt>
                <c:pt idx="2006">
                  <c:v>1.8707000000000001E-10</c:v>
                </c:pt>
                <c:pt idx="2007">
                  <c:v>2.0819600000000001E-10</c:v>
                </c:pt>
                <c:pt idx="2008">
                  <c:v>2.3170900000000001E-10</c:v>
                </c:pt>
                <c:pt idx="2009">
                  <c:v>2.5787999999999999E-10</c:v>
                </c:pt>
                <c:pt idx="2010">
                  <c:v>2.8700800000000001E-10</c:v>
                </c:pt>
                <c:pt idx="2011">
                  <c:v>3.1942699999999998E-10</c:v>
                </c:pt>
                <c:pt idx="2012">
                  <c:v>3.5550899999999999E-10</c:v>
                </c:pt>
                <c:pt idx="2013">
                  <c:v>3.9566899999999998E-10</c:v>
                </c:pt>
                <c:pt idx="2014">
                  <c:v>4.4036699999999997E-10</c:v>
                </c:pt>
                <c:pt idx="2015">
                  <c:v>4.9011500000000002E-10</c:v>
                </c:pt>
                <c:pt idx="2016">
                  <c:v>5.45485E-10</c:v>
                </c:pt>
                <c:pt idx="2017">
                  <c:v>6.0711099999999999E-10</c:v>
                </c:pt>
                <c:pt idx="2018">
                  <c:v>6.7570099999999996E-10</c:v>
                </c:pt>
                <c:pt idx="2019">
                  <c:v>7.5204200000000004E-10</c:v>
                </c:pt>
                <c:pt idx="2020">
                  <c:v>8.3700799999999997E-10</c:v>
                </c:pt>
                <c:pt idx="2021">
                  <c:v>9.3157500000000006E-10</c:v>
                </c:pt>
                <c:pt idx="2022">
                  <c:v>1.03683E-9</c:v>
                </c:pt>
                <c:pt idx="2023">
                  <c:v>1.1539700000000001E-9</c:v>
                </c:pt>
                <c:pt idx="2024">
                  <c:v>1.28435E-9</c:v>
                </c:pt>
                <c:pt idx="2025">
                  <c:v>1.42947E-9</c:v>
                </c:pt>
                <c:pt idx="2026">
                  <c:v>1.59098E-9</c:v>
                </c:pt>
                <c:pt idx="2027">
                  <c:v>1.77074E-9</c:v>
                </c:pt>
                <c:pt idx="2028">
                  <c:v>1.9708100000000001E-9</c:v>
                </c:pt>
                <c:pt idx="2029">
                  <c:v>2.19349E-9</c:v>
                </c:pt>
                <c:pt idx="2030">
                  <c:v>2.44132E-9</c:v>
                </c:pt>
                <c:pt idx="2031">
                  <c:v>2.7171600000000002E-9</c:v>
                </c:pt>
                <c:pt idx="2032">
                  <c:v>3.0241699999999999E-9</c:v>
                </c:pt>
                <c:pt idx="2033">
                  <c:v>3.3658600000000002E-9</c:v>
                </c:pt>
                <c:pt idx="2034">
                  <c:v>3.7461599999999998E-9</c:v>
                </c:pt>
                <c:pt idx="2035">
                  <c:v>3.8333199999999997E-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82E5-4354-85A3-8869235CF08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661768"/>
        <c:axId val="382906920"/>
      </c:scatterChart>
      <c:valAx>
        <c:axId val="382661768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906920"/>
        <c:crosses val="autoZero"/>
        <c:crossBetween val="midCat"/>
        <c:majorUnit val="1"/>
      </c:valAx>
      <c:valAx>
        <c:axId val="382906920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661768"/>
        <c:crosses val="autoZero"/>
        <c:crossBetween val="midCat"/>
        <c:majorUnit val="20"/>
      </c:valAx>
      <c:spPr>
        <a:noFill/>
        <a:ln w="63500">
          <a:solidFill>
            <a:schemeClr val="tx1">
              <a:lumMod val="50000"/>
              <a:lumOff val="50000"/>
            </a:schemeClr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sz="14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47708272577039"/>
          <c:y val="3.0139010401477592E-2"/>
          <c:w val="0.83077695149217456"/>
          <c:h val="0.87110017497812786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I$3</c:f>
              <c:strCache>
                <c:ptCount val="1"/>
                <c:pt idx="0">
                  <c:v>[Bacteria]</c:v>
                </c:pt>
              </c:strCache>
            </c:strRef>
          </c:tx>
          <c:spPr>
            <a:ln w="635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H$4:$H$2199</c:f>
              <c:numCache>
                <c:formatCode>General</c:formatCode>
                <c:ptCount val="2196"/>
                <c:pt idx="0">
                  <c:v>0</c:v>
                </c:pt>
                <c:pt idx="1">
                  <c:v>6.9444444444444454E-13</c:v>
                </c:pt>
                <c:pt idx="2">
                  <c:v>1.3888888888888891E-12</c:v>
                </c:pt>
                <c:pt idx="3">
                  <c:v>6.9458333333333335E-9</c:v>
                </c:pt>
                <c:pt idx="4">
                  <c:v>1.3890277777777778E-8</c:v>
                </c:pt>
                <c:pt idx="5">
                  <c:v>2.0834722222222222E-8</c:v>
                </c:pt>
                <c:pt idx="6">
                  <c:v>9.0279166666666655E-8</c:v>
                </c:pt>
                <c:pt idx="7">
                  <c:v>1.5972361111111111E-7</c:v>
                </c:pt>
                <c:pt idx="8">
                  <c:v>2.2916805555555553E-7</c:v>
                </c:pt>
                <c:pt idx="9">
                  <c:v>2.9861250000000001E-7</c:v>
                </c:pt>
                <c:pt idx="10">
                  <c:v>9.9305555555555567E-7</c:v>
                </c:pt>
                <c:pt idx="11">
                  <c:v>1.6874999999999999E-6</c:v>
                </c:pt>
                <c:pt idx="12">
                  <c:v>2.3819444444444444E-6</c:v>
                </c:pt>
                <c:pt idx="13">
                  <c:v>3.0763888888888889E-6</c:v>
                </c:pt>
                <c:pt idx="14">
                  <c:v>7.0700000000000001E-6</c:v>
                </c:pt>
                <c:pt idx="15">
                  <c:v>1.1063611111111111E-5</c:v>
                </c:pt>
                <c:pt idx="16">
                  <c:v>1.5057222222222223E-5</c:v>
                </c:pt>
                <c:pt idx="17">
                  <c:v>2.2856458333333332E-5</c:v>
                </c:pt>
                <c:pt idx="18">
                  <c:v>3.0655694444444444E-5</c:v>
                </c:pt>
                <c:pt idx="19">
                  <c:v>3.8454999999999997E-5</c:v>
                </c:pt>
                <c:pt idx="20">
                  <c:v>5.0214375000000003E-5</c:v>
                </c:pt>
                <c:pt idx="21">
                  <c:v>6.197381944444444E-5</c:v>
                </c:pt>
                <c:pt idx="22">
                  <c:v>7.3733333333333341E-5</c:v>
                </c:pt>
                <c:pt idx="23">
                  <c:v>8.3929166666666663E-5</c:v>
                </c:pt>
                <c:pt idx="24">
                  <c:v>9.4124999999999998E-5</c:v>
                </c:pt>
                <c:pt idx="25">
                  <c:v>1.0432083333333333E-4</c:v>
                </c:pt>
                <c:pt idx="26">
                  <c:v>1.0902361111111111E-4</c:v>
                </c:pt>
                <c:pt idx="27">
                  <c:v>1.1372708333333333E-4</c:v>
                </c:pt>
                <c:pt idx="28">
                  <c:v>1.1842986111111111E-4</c:v>
                </c:pt>
                <c:pt idx="29">
                  <c:v>1.2241319444444444E-4</c:v>
                </c:pt>
                <c:pt idx="30">
                  <c:v>1.2639652777777778E-4</c:v>
                </c:pt>
                <c:pt idx="31">
                  <c:v>1.3038055555555556E-4</c:v>
                </c:pt>
                <c:pt idx="32">
                  <c:v>1.3633402777777777E-4</c:v>
                </c:pt>
                <c:pt idx="33">
                  <c:v>1.4228680555555554E-4</c:v>
                </c:pt>
                <c:pt idx="34">
                  <c:v>1.4824027777777778E-4</c:v>
                </c:pt>
                <c:pt idx="35">
                  <c:v>1.8639236111111111E-4</c:v>
                </c:pt>
                <c:pt idx="36">
                  <c:v>1.9593055555555556E-4</c:v>
                </c:pt>
                <c:pt idx="37">
                  <c:v>2.0546805555555556E-4</c:v>
                </c:pt>
                <c:pt idx="38">
                  <c:v>2.1500625000000001E-4</c:v>
                </c:pt>
                <c:pt idx="39">
                  <c:v>2.2454374999999999E-4</c:v>
                </c:pt>
                <c:pt idx="40">
                  <c:v>2.2853055555555553E-4</c:v>
                </c:pt>
                <c:pt idx="41">
                  <c:v>2.325173611111111E-4</c:v>
                </c:pt>
                <c:pt idx="42">
                  <c:v>2.3650416666666664E-4</c:v>
                </c:pt>
                <c:pt idx="43">
                  <c:v>2.4049722222222223E-4</c:v>
                </c:pt>
                <c:pt idx="44">
                  <c:v>2.4448958333333332E-4</c:v>
                </c:pt>
                <c:pt idx="45">
                  <c:v>2.4848263888888891E-4</c:v>
                </c:pt>
                <c:pt idx="46">
                  <c:v>2.5501388888888888E-4</c:v>
                </c:pt>
                <c:pt idx="47">
                  <c:v>2.6154583333333335E-4</c:v>
                </c:pt>
                <c:pt idx="48">
                  <c:v>2.6807708333333332E-4</c:v>
                </c:pt>
                <c:pt idx="49">
                  <c:v>3.1749097222222224E-4</c:v>
                </c:pt>
                <c:pt idx="50">
                  <c:v>3.2984513888888889E-4</c:v>
                </c:pt>
                <c:pt idx="51">
                  <c:v>3.5455208333333335E-4</c:v>
                </c:pt>
                <c:pt idx="52">
                  <c:v>3.7925902777777775E-4</c:v>
                </c:pt>
                <c:pt idx="53">
                  <c:v>4.0396597222222222E-4</c:v>
                </c:pt>
                <c:pt idx="54">
                  <c:v>4.2867291666666668E-4</c:v>
                </c:pt>
                <c:pt idx="55">
                  <c:v>4.9117152777777774E-4</c:v>
                </c:pt>
                <c:pt idx="56">
                  <c:v>5.5367013888888892E-4</c:v>
                </c:pt>
                <c:pt idx="57">
                  <c:v>6.1616874999999998E-4</c:v>
                </c:pt>
                <c:pt idx="58">
                  <c:v>6.7866736111111105E-4</c:v>
                </c:pt>
                <c:pt idx="59">
                  <c:v>7.6328472222222216E-4</c:v>
                </c:pt>
                <c:pt idx="60">
                  <c:v>8.4790277777777772E-4</c:v>
                </c:pt>
                <c:pt idx="61">
                  <c:v>9.3252083333333327E-4</c:v>
                </c:pt>
                <c:pt idx="62">
                  <c:v>1.0171388888888888E-3</c:v>
                </c:pt>
                <c:pt idx="63">
                  <c:v>1.1717847222222223E-3</c:v>
                </c:pt>
                <c:pt idx="64">
                  <c:v>1.3264305555555555E-3</c:v>
                </c:pt>
                <c:pt idx="65">
                  <c:v>1.4810694444444446E-3</c:v>
                </c:pt>
                <c:pt idx="66">
                  <c:v>1.6357152777777778E-3</c:v>
                </c:pt>
                <c:pt idx="67">
                  <c:v>1.7903611111111113E-3</c:v>
                </c:pt>
                <c:pt idx="68">
                  <c:v>1.9827847222222222E-3</c:v>
                </c:pt>
                <c:pt idx="69">
                  <c:v>2.1752083333333332E-3</c:v>
                </c:pt>
                <c:pt idx="70">
                  <c:v>2.3676319444444443E-3</c:v>
                </c:pt>
                <c:pt idx="71">
                  <c:v>2.5600555555555554E-3</c:v>
                </c:pt>
                <c:pt idx="72">
                  <c:v>2.7524791666666665E-3</c:v>
                </c:pt>
                <c:pt idx="73">
                  <c:v>3.0550972222222221E-3</c:v>
                </c:pt>
                <c:pt idx="74">
                  <c:v>3.357715277777778E-3</c:v>
                </c:pt>
                <c:pt idx="75">
                  <c:v>3.6603333333333331E-3</c:v>
                </c:pt>
                <c:pt idx="76">
                  <c:v>3.9629444444444443E-3</c:v>
                </c:pt>
                <c:pt idx="77">
                  <c:v>4.2655625000000003E-3</c:v>
                </c:pt>
                <c:pt idx="78">
                  <c:v>4.5681805555555554E-3</c:v>
                </c:pt>
                <c:pt idx="79">
                  <c:v>5.045673611111111E-3</c:v>
                </c:pt>
                <c:pt idx="80">
                  <c:v>5.5231597222222227E-3</c:v>
                </c:pt>
                <c:pt idx="81">
                  <c:v>6.0006527777777784E-3</c:v>
                </c:pt>
                <c:pt idx="82">
                  <c:v>6.478145833333334E-3</c:v>
                </c:pt>
                <c:pt idx="83">
                  <c:v>6.955625E-3</c:v>
                </c:pt>
                <c:pt idx="84">
                  <c:v>7.4331249999999996E-3</c:v>
                </c:pt>
                <c:pt idx="85">
                  <c:v>7.9658333333333334E-3</c:v>
                </c:pt>
                <c:pt idx="86">
                  <c:v>8.4985416666666664E-3</c:v>
                </c:pt>
                <c:pt idx="87">
                  <c:v>9.0312500000000011E-3</c:v>
                </c:pt>
                <c:pt idx="88">
                  <c:v>9.563958333333334E-3</c:v>
                </c:pt>
                <c:pt idx="89">
                  <c:v>1.0096666666666667E-2</c:v>
                </c:pt>
                <c:pt idx="90">
                  <c:v>1.0629375E-2</c:v>
                </c:pt>
                <c:pt idx="91">
                  <c:v>1.1233819444444444E-2</c:v>
                </c:pt>
                <c:pt idx="92">
                  <c:v>1.1838333333333333E-2</c:v>
                </c:pt>
                <c:pt idx="93">
                  <c:v>1.2442847222222221E-2</c:v>
                </c:pt>
                <c:pt idx="94">
                  <c:v>1.304736111111111E-2</c:v>
                </c:pt>
                <c:pt idx="95">
                  <c:v>1.3651805555555556E-2</c:v>
                </c:pt>
                <c:pt idx="96">
                  <c:v>1.4256319444444445E-2</c:v>
                </c:pt>
                <c:pt idx="97">
                  <c:v>1.4352569444444444E-2</c:v>
                </c:pt>
                <c:pt idx="98">
                  <c:v>1.4448819444444445E-2</c:v>
                </c:pt>
                <c:pt idx="99">
                  <c:v>1.4545138888888889E-2</c:v>
                </c:pt>
                <c:pt idx="100">
                  <c:v>1.464138888888889E-2</c:v>
                </c:pt>
                <c:pt idx="101">
                  <c:v>1.4737638888888889E-2</c:v>
                </c:pt>
                <c:pt idx="102">
                  <c:v>1.4902083333333333E-2</c:v>
                </c:pt>
                <c:pt idx="103">
                  <c:v>1.5066458333333333E-2</c:v>
                </c:pt>
                <c:pt idx="104">
                  <c:v>1.5230902777777779E-2</c:v>
                </c:pt>
                <c:pt idx="105">
                  <c:v>1.5395347222222222E-2</c:v>
                </c:pt>
                <c:pt idx="106">
                  <c:v>1.5559722222222221E-2</c:v>
                </c:pt>
                <c:pt idx="107">
                  <c:v>1.589173611111111E-2</c:v>
                </c:pt>
                <c:pt idx="108">
                  <c:v>1.6223750000000002E-2</c:v>
                </c:pt>
                <c:pt idx="109">
                  <c:v>1.6555763888888887E-2</c:v>
                </c:pt>
                <c:pt idx="110">
                  <c:v>1.6887777777777779E-2</c:v>
                </c:pt>
                <c:pt idx="111">
                  <c:v>1.7219791666666668E-2</c:v>
                </c:pt>
                <c:pt idx="112">
                  <c:v>1.7863263888888887E-2</c:v>
                </c:pt>
                <c:pt idx="113">
                  <c:v>1.8506666666666668E-2</c:v>
                </c:pt>
                <c:pt idx="114">
                  <c:v>1.915013888888889E-2</c:v>
                </c:pt>
                <c:pt idx="115">
                  <c:v>1.9793611111111113E-2</c:v>
                </c:pt>
                <c:pt idx="116">
                  <c:v>2.043701388888889E-2</c:v>
                </c:pt>
                <c:pt idx="117">
                  <c:v>2.1198055555555557E-2</c:v>
                </c:pt>
                <c:pt idx="118">
                  <c:v>2.1959166666666668E-2</c:v>
                </c:pt>
                <c:pt idx="119">
                  <c:v>2.2720208333333335E-2</c:v>
                </c:pt>
                <c:pt idx="120">
                  <c:v>2.3481250000000002E-2</c:v>
                </c:pt>
                <c:pt idx="121">
                  <c:v>2.424236111111111E-2</c:v>
                </c:pt>
                <c:pt idx="122">
                  <c:v>2.5003402777777777E-2</c:v>
                </c:pt>
                <c:pt idx="123">
                  <c:v>2.6206944444444442E-2</c:v>
                </c:pt>
                <c:pt idx="124">
                  <c:v>2.7410555555555556E-2</c:v>
                </c:pt>
                <c:pt idx="125">
                  <c:v>2.8614097222222225E-2</c:v>
                </c:pt>
                <c:pt idx="126">
                  <c:v>2.9817638888888887E-2</c:v>
                </c:pt>
                <c:pt idx="127">
                  <c:v>3.1021180555555552E-2</c:v>
                </c:pt>
                <c:pt idx="128">
                  <c:v>3.2224791666666669E-2</c:v>
                </c:pt>
                <c:pt idx="129">
                  <c:v>3.4107986111111106E-2</c:v>
                </c:pt>
                <c:pt idx="130">
                  <c:v>3.5991249999999995E-2</c:v>
                </c:pt>
                <c:pt idx="131">
                  <c:v>3.7874444444444447E-2</c:v>
                </c:pt>
                <c:pt idx="132">
                  <c:v>3.9757708333333336E-2</c:v>
                </c:pt>
                <c:pt idx="133">
                  <c:v>4.1640902777777773E-2</c:v>
                </c:pt>
                <c:pt idx="134">
                  <c:v>4.3524166666666662E-2</c:v>
                </c:pt>
                <c:pt idx="135">
                  <c:v>4.6374236111111106E-2</c:v>
                </c:pt>
                <c:pt idx="136">
                  <c:v>4.9224305555555556E-2</c:v>
                </c:pt>
                <c:pt idx="137">
                  <c:v>5.2074374999999999E-2</c:v>
                </c:pt>
                <c:pt idx="138">
                  <c:v>5.4924444444444442E-2</c:v>
                </c:pt>
                <c:pt idx="139">
                  <c:v>5.7774513888888893E-2</c:v>
                </c:pt>
                <c:pt idx="140">
                  <c:v>6.0624583333333336E-2</c:v>
                </c:pt>
                <c:pt idx="141">
                  <c:v>6.450798611111111E-2</c:v>
                </c:pt>
                <c:pt idx="142">
                  <c:v>6.8391319444444446E-2</c:v>
                </c:pt>
                <c:pt idx="143">
                  <c:v>7.2274999999999992E-2</c:v>
                </c:pt>
                <c:pt idx="144">
                  <c:v>7.6158333333333342E-2</c:v>
                </c:pt>
                <c:pt idx="145">
                  <c:v>8.0041666666666664E-2</c:v>
                </c:pt>
                <c:pt idx="146">
                  <c:v>8.3925E-2</c:v>
                </c:pt>
                <c:pt idx="147">
                  <c:v>8.9370138888888895E-2</c:v>
                </c:pt>
                <c:pt idx="148">
                  <c:v>9.4814583333333327E-2</c:v>
                </c:pt>
                <c:pt idx="149">
                  <c:v>0.10025972222222222</c:v>
                </c:pt>
                <c:pt idx="150">
                  <c:v>0.10570486111111112</c:v>
                </c:pt>
                <c:pt idx="151">
                  <c:v>0.11114930555555556</c:v>
                </c:pt>
                <c:pt idx="152">
                  <c:v>0.11811736111111111</c:v>
                </c:pt>
                <c:pt idx="153">
                  <c:v>0.12508541666666667</c:v>
                </c:pt>
                <c:pt idx="154">
                  <c:v>0.13205277777777777</c:v>
                </c:pt>
                <c:pt idx="155">
                  <c:v>0.13902083333333334</c:v>
                </c:pt>
                <c:pt idx="156">
                  <c:v>0.14598819444444444</c:v>
                </c:pt>
                <c:pt idx="157">
                  <c:v>0.15295625000000002</c:v>
                </c:pt>
                <c:pt idx="158">
                  <c:v>0.16165277777777778</c:v>
                </c:pt>
                <c:pt idx="159">
                  <c:v>0.17034930555555555</c:v>
                </c:pt>
                <c:pt idx="160">
                  <c:v>0.17904652777777777</c:v>
                </c:pt>
                <c:pt idx="161">
                  <c:v>0.18774305555555557</c:v>
                </c:pt>
                <c:pt idx="162">
                  <c:v>0.19643958333333333</c:v>
                </c:pt>
                <c:pt idx="163">
                  <c:v>0.20513611111111113</c:v>
                </c:pt>
                <c:pt idx="164">
                  <c:v>0.21383263888888887</c:v>
                </c:pt>
                <c:pt idx="165">
                  <c:v>0.22252986111111109</c:v>
                </c:pt>
                <c:pt idx="166">
                  <c:v>0.23122638888888888</c:v>
                </c:pt>
                <c:pt idx="167">
                  <c:v>0.23992291666666665</c:v>
                </c:pt>
                <c:pt idx="168">
                  <c:v>0.24861944444444445</c:v>
                </c:pt>
                <c:pt idx="169">
                  <c:v>0.25731597222222224</c:v>
                </c:pt>
                <c:pt idx="170">
                  <c:v>0.26601249999999999</c:v>
                </c:pt>
                <c:pt idx="171">
                  <c:v>0.27470972222222223</c:v>
                </c:pt>
                <c:pt idx="172">
                  <c:v>0.28340625000000003</c:v>
                </c:pt>
                <c:pt idx="173">
                  <c:v>0.29210277777777777</c:v>
                </c:pt>
                <c:pt idx="174">
                  <c:v>0.30079930555555556</c:v>
                </c:pt>
                <c:pt idx="175">
                  <c:v>0.3094958333333333</c:v>
                </c:pt>
                <c:pt idx="176">
                  <c:v>0.31819305555555555</c:v>
                </c:pt>
                <c:pt idx="177">
                  <c:v>0.32688958333333334</c:v>
                </c:pt>
                <c:pt idx="178">
                  <c:v>0.33558611111111114</c:v>
                </c:pt>
                <c:pt idx="179">
                  <c:v>0.34428263888888888</c:v>
                </c:pt>
                <c:pt idx="180">
                  <c:v>0.35297916666666668</c:v>
                </c:pt>
                <c:pt idx="181">
                  <c:v>0.36167569444444442</c:v>
                </c:pt>
                <c:pt idx="182">
                  <c:v>0.37037291666666666</c:v>
                </c:pt>
                <c:pt idx="183">
                  <c:v>0.37906944444444446</c:v>
                </c:pt>
                <c:pt idx="184">
                  <c:v>0.38776597222222225</c:v>
                </c:pt>
                <c:pt idx="185">
                  <c:v>0.39646249999999994</c:v>
                </c:pt>
                <c:pt idx="186">
                  <c:v>0.40515902777777774</c:v>
                </c:pt>
                <c:pt idx="187">
                  <c:v>0.41385624999999998</c:v>
                </c:pt>
                <c:pt idx="188">
                  <c:v>0.42255277777777778</c:v>
                </c:pt>
                <c:pt idx="189">
                  <c:v>0.43124930555555557</c:v>
                </c:pt>
                <c:pt idx="190">
                  <c:v>0.43994583333333337</c:v>
                </c:pt>
                <c:pt idx="191">
                  <c:v>0.44864236111111111</c:v>
                </c:pt>
                <c:pt idx="192">
                  <c:v>0.4573395833333333</c:v>
                </c:pt>
                <c:pt idx="193">
                  <c:v>0.4660361111111111</c:v>
                </c:pt>
                <c:pt idx="194">
                  <c:v>0.47473263888888889</c:v>
                </c:pt>
                <c:pt idx="195">
                  <c:v>0.48342916666666669</c:v>
                </c:pt>
                <c:pt idx="196">
                  <c:v>0.49212569444444443</c:v>
                </c:pt>
                <c:pt idx="197">
                  <c:v>0.50082222222222217</c:v>
                </c:pt>
                <c:pt idx="198">
                  <c:v>0.50951944444444441</c:v>
                </c:pt>
                <c:pt idx="199">
                  <c:v>0.51821597222222227</c:v>
                </c:pt>
                <c:pt idx="200">
                  <c:v>0.52691250000000001</c:v>
                </c:pt>
                <c:pt idx="201">
                  <c:v>0.53560902777777786</c:v>
                </c:pt>
                <c:pt idx="202">
                  <c:v>0.54430555555555549</c:v>
                </c:pt>
                <c:pt idx="203">
                  <c:v>0.55300277777777773</c:v>
                </c:pt>
                <c:pt idx="204">
                  <c:v>0.56169930555555558</c:v>
                </c:pt>
                <c:pt idx="205">
                  <c:v>0.57039583333333332</c:v>
                </c:pt>
                <c:pt idx="206">
                  <c:v>0.57909236111111118</c:v>
                </c:pt>
                <c:pt idx="207">
                  <c:v>0.58778888888888892</c:v>
                </c:pt>
                <c:pt idx="208">
                  <c:v>0.59648541666666666</c:v>
                </c:pt>
                <c:pt idx="209">
                  <c:v>0.6051826388888889</c:v>
                </c:pt>
                <c:pt idx="210">
                  <c:v>0.61387916666666664</c:v>
                </c:pt>
                <c:pt idx="211">
                  <c:v>0.62257569444444449</c:v>
                </c:pt>
                <c:pt idx="212">
                  <c:v>0.63127222222222223</c:v>
                </c:pt>
                <c:pt idx="213">
                  <c:v>0.63996874999999998</c:v>
                </c:pt>
                <c:pt idx="214">
                  <c:v>0.64866597222222222</c:v>
                </c:pt>
                <c:pt idx="215">
                  <c:v>0.65736249999999996</c:v>
                </c:pt>
                <c:pt idx="216">
                  <c:v>0.66605902777777781</c:v>
                </c:pt>
                <c:pt idx="217">
                  <c:v>0.67475555555555555</c:v>
                </c:pt>
                <c:pt idx="218">
                  <c:v>0.6834520833333334</c:v>
                </c:pt>
                <c:pt idx="219">
                  <c:v>0.69214861111111103</c:v>
                </c:pt>
                <c:pt idx="220">
                  <c:v>0.70084722222222229</c:v>
                </c:pt>
                <c:pt idx="221">
                  <c:v>0.70954166666666663</c:v>
                </c:pt>
                <c:pt idx="222">
                  <c:v>0.71823611111111108</c:v>
                </c:pt>
                <c:pt idx="223">
                  <c:v>0.72693750000000001</c:v>
                </c:pt>
                <c:pt idx="224">
                  <c:v>0.73563194444444435</c:v>
                </c:pt>
                <c:pt idx="225">
                  <c:v>0.7443263888888888</c:v>
                </c:pt>
                <c:pt idx="226">
                  <c:v>0.75302777777777774</c:v>
                </c:pt>
                <c:pt idx="227">
                  <c:v>0.7617222222222223</c:v>
                </c:pt>
                <c:pt idx="228">
                  <c:v>0.77041666666666675</c:v>
                </c:pt>
                <c:pt idx="229">
                  <c:v>0.77911805555555558</c:v>
                </c:pt>
                <c:pt idx="230">
                  <c:v>0.78781250000000003</c:v>
                </c:pt>
                <c:pt idx="231">
                  <c:v>0.79650694444444448</c:v>
                </c:pt>
                <c:pt idx="232">
                  <c:v>0.8052083333333333</c:v>
                </c:pt>
                <c:pt idx="233">
                  <c:v>0.81390277777777775</c:v>
                </c:pt>
                <c:pt idx="234">
                  <c:v>0.8225972222222222</c:v>
                </c:pt>
                <c:pt idx="235">
                  <c:v>0.83129861111111103</c:v>
                </c:pt>
                <c:pt idx="236">
                  <c:v>0.83999305555555548</c:v>
                </c:pt>
                <c:pt idx="237">
                  <c:v>0.84868749999999993</c:v>
                </c:pt>
                <c:pt idx="238">
                  <c:v>0.85738194444444449</c:v>
                </c:pt>
                <c:pt idx="239">
                  <c:v>0.86608333333333343</c:v>
                </c:pt>
                <c:pt idx="240">
                  <c:v>0.87477777777777788</c:v>
                </c:pt>
                <c:pt idx="241">
                  <c:v>0.88347222222222221</c:v>
                </c:pt>
                <c:pt idx="242">
                  <c:v>0.89217361111111115</c:v>
                </c:pt>
                <c:pt idx="243">
                  <c:v>0.9008680555555556</c:v>
                </c:pt>
                <c:pt idx="244">
                  <c:v>0.90956249999999994</c:v>
                </c:pt>
                <c:pt idx="245">
                  <c:v>0.91826388888888888</c:v>
                </c:pt>
                <c:pt idx="246">
                  <c:v>0.92695833333333333</c:v>
                </c:pt>
                <c:pt idx="247">
                  <c:v>0.93565277777777767</c:v>
                </c:pt>
                <c:pt idx="248">
                  <c:v>0.94435416666666661</c:v>
                </c:pt>
                <c:pt idx="249">
                  <c:v>0.95304861111111117</c:v>
                </c:pt>
                <c:pt idx="250">
                  <c:v>0.96174305555555561</c:v>
                </c:pt>
                <c:pt idx="251">
                  <c:v>0.97044444444444444</c:v>
                </c:pt>
                <c:pt idx="252">
                  <c:v>0.97913888888888889</c:v>
                </c:pt>
                <c:pt idx="253">
                  <c:v>0.98783333333333334</c:v>
                </c:pt>
                <c:pt idx="254">
                  <c:v>0.99653472222222217</c:v>
                </c:pt>
                <c:pt idx="255">
                  <c:v>1.0052291666666666</c:v>
                </c:pt>
                <c:pt idx="256">
                  <c:v>1.0139236111111112</c:v>
                </c:pt>
                <c:pt idx="257">
                  <c:v>1.0226249999999999</c:v>
                </c:pt>
                <c:pt idx="258">
                  <c:v>1.0313194444444445</c:v>
                </c:pt>
                <c:pt idx="259">
                  <c:v>1.0400138888888888</c:v>
                </c:pt>
                <c:pt idx="260">
                  <c:v>1.0487083333333334</c:v>
                </c:pt>
                <c:pt idx="261">
                  <c:v>1.0574097222222223</c:v>
                </c:pt>
                <c:pt idx="262">
                  <c:v>1.0661041666666666</c:v>
                </c:pt>
                <c:pt idx="263">
                  <c:v>1.0747986111111112</c:v>
                </c:pt>
                <c:pt idx="264">
                  <c:v>1.0834999999999999</c:v>
                </c:pt>
                <c:pt idx="265">
                  <c:v>1.0921944444444445</c:v>
                </c:pt>
                <c:pt idx="266">
                  <c:v>1.0992916666666668</c:v>
                </c:pt>
                <c:pt idx="267">
                  <c:v>1.1063819444444445</c:v>
                </c:pt>
                <c:pt idx="268">
                  <c:v>1.1134791666666668</c:v>
                </c:pt>
                <c:pt idx="269">
                  <c:v>1.1205694444444443</c:v>
                </c:pt>
                <c:pt idx="270">
                  <c:v>1.1276666666666666</c:v>
                </c:pt>
                <c:pt idx="271">
                  <c:v>1.1347569444444443</c:v>
                </c:pt>
                <c:pt idx="272">
                  <c:v>1.1418541666666666</c:v>
                </c:pt>
                <c:pt idx="273">
                  <c:v>1.1489444444444445</c:v>
                </c:pt>
                <c:pt idx="274">
                  <c:v>1.1545347222222222</c:v>
                </c:pt>
                <c:pt idx="275">
                  <c:v>1.1586944444444445</c:v>
                </c:pt>
                <c:pt idx="276">
                  <c:v>1.1628541666666667</c:v>
                </c:pt>
                <c:pt idx="277">
                  <c:v>1.1635763888888888</c:v>
                </c:pt>
                <c:pt idx="278">
                  <c:v>1.1637083333333333</c:v>
                </c:pt>
                <c:pt idx="279">
                  <c:v>1.1638402777777779</c:v>
                </c:pt>
                <c:pt idx="280">
                  <c:v>1.1639722222222222</c:v>
                </c:pt>
                <c:pt idx="281">
                  <c:v>1.1641041666666667</c:v>
                </c:pt>
                <c:pt idx="282">
                  <c:v>1.1643749999999999</c:v>
                </c:pt>
                <c:pt idx="283">
                  <c:v>1.1646388888888888</c:v>
                </c:pt>
                <c:pt idx="284">
                  <c:v>1.1649027777777778</c:v>
                </c:pt>
                <c:pt idx="285">
                  <c:v>1.1656180555555555</c:v>
                </c:pt>
                <c:pt idx="286">
                  <c:v>1.1663263888888888</c:v>
                </c:pt>
                <c:pt idx="287">
                  <c:v>1.1670347222222222</c:v>
                </c:pt>
                <c:pt idx="288">
                  <c:v>1.1680972222222221</c:v>
                </c:pt>
                <c:pt idx="289">
                  <c:v>1.1691597222222221</c:v>
                </c:pt>
                <c:pt idx="290">
                  <c:v>1.1702152777777777</c:v>
                </c:pt>
                <c:pt idx="291">
                  <c:v>1.1712777777777779</c:v>
                </c:pt>
                <c:pt idx="292">
                  <c:v>1.1725069444444445</c:v>
                </c:pt>
                <c:pt idx="293">
                  <c:v>1.1737361111111111</c:v>
                </c:pt>
                <c:pt idx="294">
                  <c:v>1.1749722222222223</c:v>
                </c:pt>
                <c:pt idx="295">
                  <c:v>1.1762013888888889</c:v>
                </c:pt>
                <c:pt idx="296">
                  <c:v>1.178076388888889</c:v>
                </c:pt>
                <c:pt idx="297">
                  <c:v>1.1799513888888891</c:v>
                </c:pt>
                <c:pt idx="298">
                  <c:v>1.1818194444444443</c:v>
                </c:pt>
                <c:pt idx="299">
                  <c:v>1.1836944444444444</c:v>
                </c:pt>
                <c:pt idx="300">
                  <c:v>1.1864305555555557</c:v>
                </c:pt>
                <c:pt idx="301">
                  <c:v>1.1891666666666667</c:v>
                </c:pt>
                <c:pt idx="302">
                  <c:v>1.1919027777777778</c:v>
                </c:pt>
                <c:pt idx="303">
                  <c:v>1.1940138888888889</c:v>
                </c:pt>
                <c:pt idx="304">
                  <c:v>1.1957013888888888</c:v>
                </c:pt>
                <c:pt idx="305">
                  <c:v>1.1973888888888888</c:v>
                </c:pt>
                <c:pt idx="306">
                  <c:v>1.1990763888888889</c:v>
                </c:pt>
                <c:pt idx="307">
                  <c:v>1.2007569444444444</c:v>
                </c:pt>
                <c:pt idx="308">
                  <c:v>1.2024444444444444</c:v>
                </c:pt>
                <c:pt idx="309">
                  <c:v>1.2041319444444445</c:v>
                </c:pt>
                <c:pt idx="310">
                  <c:v>1.2058194444444446</c:v>
                </c:pt>
                <c:pt idx="311">
                  <c:v>1.2081944444444443</c:v>
                </c:pt>
                <c:pt idx="312">
                  <c:v>1.210576388888889</c:v>
                </c:pt>
                <c:pt idx="313">
                  <c:v>1.212951388888889</c:v>
                </c:pt>
                <c:pt idx="314">
                  <c:v>1.2153333333333334</c:v>
                </c:pt>
                <c:pt idx="315">
                  <c:v>1.2177152777777778</c:v>
                </c:pt>
                <c:pt idx="316">
                  <c:v>1.2209027777777777</c:v>
                </c:pt>
                <c:pt idx="317">
                  <c:v>1.2240972222222222</c:v>
                </c:pt>
                <c:pt idx="318">
                  <c:v>1.2272916666666667</c:v>
                </c:pt>
                <c:pt idx="319">
                  <c:v>1.2304861111111112</c:v>
                </c:pt>
                <c:pt idx="320">
                  <c:v>1.2336805555555554</c:v>
                </c:pt>
                <c:pt idx="321">
                  <c:v>1.2368680555555556</c:v>
                </c:pt>
                <c:pt idx="322">
                  <c:v>1.2400625000000001</c:v>
                </c:pt>
                <c:pt idx="323">
                  <c:v>1.2426805555555556</c:v>
                </c:pt>
                <c:pt idx="324">
                  <c:v>1.2453055555555557</c:v>
                </c:pt>
                <c:pt idx="325">
                  <c:v>1.2479236111111112</c:v>
                </c:pt>
                <c:pt idx="326">
                  <c:v>1.2505416666666667</c:v>
                </c:pt>
                <c:pt idx="327">
                  <c:v>1.2531597222222222</c:v>
                </c:pt>
                <c:pt idx="328">
                  <c:v>1.2557847222222223</c:v>
                </c:pt>
                <c:pt idx="329">
                  <c:v>1.2584027777777778</c:v>
                </c:pt>
                <c:pt idx="330">
                  <c:v>1.2610208333333333</c:v>
                </c:pt>
                <c:pt idx="331">
                  <c:v>1.2637361111111112</c:v>
                </c:pt>
                <c:pt idx="332">
                  <c:v>1.2664513888888889</c:v>
                </c:pt>
                <c:pt idx="333">
                  <c:v>1.2691597222222222</c:v>
                </c:pt>
                <c:pt idx="334">
                  <c:v>1.2718750000000001</c:v>
                </c:pt>
                <c:pt idx="335">
                  <c:v>1.2745902777777778</c:v>
                </c:pt>
                <c:pt idx="336">
                  <c:v>1.2768333333333335</c:v>
                </c:pt>
                <c:pt idx="337">
                  <c:v>1.2772152777777779</c:v>
                </c:pt>
                <c:pt idx="338">
                  <c:v>1.2775972222222223</c:v>
                </c:pt>
                <c:pt idx="339">
                  <c:v>1.2779791666666667</c:v>
                </c:pt>
                <c:pt idx="340">
                  <c:v>1.2783611111111111</c:v>
                </c:pt>
                <c:pt idx="341">
                  <c:v>1.2787430555555557</c:v>
                </c:pt>
                <c:pt idx="342">
                  <c:v>1.2795069444444445</c:v>
                </c:pt>
                <c:pt idx="343">
                  <c:v>1.2802708333333332</c:v>
                </c:pt>
                <c:pt idx="344">
                  <c:v>1.2810347222222223</c:v>
                </c:pt>
                <c:pt idx="345">
                  <c:v>1.281798611111111</c:v>
                </c:pt>
                <c:pt idx="346">
                  <c:v>1.2829930555555555</c:v>
                </c:pt>
                <c:pt idx="347">
                  <c:v>1.2841944444444444</c:v>
                </c:pt>
                <c:pt idx="348">
                  <c:v>1.2853888888888889</c:v>
                </c:pt>
                <c:pt idx="349">
                  <c:v>1.2865902777777778</c:v>
                </c:pt>
                <c:pt idx="350">
                  <c:v>1.2877847222222223</c:v>
                </c:pt>
                <c:pt idx="351">
                  <c:v>1.2899930555555554</c:v>
                </c:pt>
                <c:pt idx="352">
                  <c:v>1.2921944444444444</c:v>
                </c:pt>
                <c:pt idx="353">
                  <c:v>1.2943958333333334</c:v>
                </c:pt>
                <c:pt idx="354">
                  <c:v>1.2962291666666665</c:v>
                </c:pt>
                <c:pt idx="355">
                  <c:v>1.2980625000000001</c:v>
                </c:pt>
                <c:pt idx="356">
                  <c:v>1.2998888888888889</c:v>
                </c:pt>
                <c:pt idx="357">
                  <c:v>1.3017222222222222</c:v>
                </c:pt>
                <c:pt idx="358">
                  <c:v>1.3035555555555556</c:v>
                </c:pt>
                <c:pt idx="359">
                  <c:v>1.3053888888888889</c:v>
                </c:pt>
                <c:pt idx="360">
                  <c:v>1.3072152777777779</c:v>
                </c:pt>
                <c:pt idx="361">
                  <c:v>1.309048611111111</c:v>
                </c:pt>
                <c:pt idx="362">
                  <c:v>1.3108819444444444</c:v>
                </c:pt>
                <c:pt idx="363">
                  <c:v>1.3127152777777777</c:v>
                </c:pt>
                <c:pt idx="364">
                  <c:v>1.3145416666666667</c:v>
                </c:pt>
                <c:pt idx="365">
                  <c:v>1.3163749999999999</c:v>
                </c:pt>
                <c:pt idx="366">
                  <c:v>1.3178888888888889</c:v>
                </c:pt>
                <c:pt idx="367">
                  <c:v>1.3194097222222223</c:v>
                </c:pt>
                <c:pt idx="368">
                  <c:v>1.3209236111111111</c:v>
                </c:pt>
                <c:pt idx="369">
                  <c:v>1.3224374999999999</c:v>
                </c:pt>
                <c:pt idx="370">
                  <c:v>1.323951388888889</c:v>
                </c:pt>
                <c:pt idx="371">
                  <c:v>1.3254652777777778</c:v>
                </c:pt>
                <c:pt idx="372">
                  <c:v>1.326986111111111</c:v>
                </c:pt>
                <c:pt idx="373">
                  <c:v>1.3285</c:v>
                </c:pt>
                <c:pt idx="374">
                  <c:v>1.3302430555555556</c:v>
                </c:pt>
                <c:pt idx="375">
                  <c:v>1.3319861111111111</c:v>
                </c:pt>
                <c:pt idx="376">
                  <c:v>1.3337291666666666</c:v>
                </c:pt>
                <c:pt idx="377">
                  <c:v>1.3354722222222222</c:v>
                </c:pt>
                <c:pt idx="378">
                  <c:v>1.3372222222222221</c:v>
                </c:pt>
                <c:pt idx="379">
                  <c:v>1.3389652777777776</c:v>
                </c:pt>
                <c:pt idx="380">
                  <c:v>1.3407083333333332</c:v>
                </c:pt>
                <c:pt idx="381">
                  <c:v>1.3424513888888889</c:v>
                </c:pt>
                <c:pt idx="382">
                  <c:v>1.3441944444444445</c:v>
                </c:pt>
                <c:pt idx="383">
                  <c:v>1.3459375</c:v>
                </c:pt>
                <c:pt idx="384">
                  <c:v>1.3476805555555555</c:v>
                </c:pt>
                <c:pt idx="385">
                  <c:v>1.3494236111111111</c:v>
                </c:pt>
                <c:pt idx="386">
                  <c:v>1.3511736111111112</c:v>
                </c:pt>
                <c:pt idx="387">
                  <c:v>1.3529166666666668</c:v>
                </c:pt>
                <c:pt idx="388">
                  <c:v>1.3546597222222223</c:v>
                </c:pt>
                <c:pt idx="389">
                  <c:v>1.3564027777777778</c:v>
                </c:pt>
                <c:pt idx="390">
                  <c:v>1.3581458333333334</c:v>
                </c:pt>
                <c:pt idx="391">
                  <c:v>1.3598888888888889</c:v>
                </c:pt>
                <c:pt idx="392">
                  <c:v>1.3616319444444445</c:v>
                </c:pt>
                <c:pt idx="393">
                  <c:v>1.3633819444444444</c:v>
                </c:pt>
                <c:pt idx="394">
                  <c:v>1.3651249999999999</c:v>
                </c:pt>
                <c:pt idx="395">
                  <c:v>1.3668680555555555</c:v>
                </c:pt>
                <c:pt idx="396">
                  <c:v>1.368611111111111</c:v>
                </c:pt>
                <c:pt idx="397">
                  <c:v>1.3703541666666665</c:v>
                </c:pt>
                <c:pt idx="398">
                  <c:v>1.3720972222222221</c:v>
                </c:pt>
                <c:pt idx="399">
                  <c:v>1.3738402777777776</c:v>
                </c:pt>
                <c:pt idx="400">
                  <c:v>1.3752569444444445</c:v>
                </c:pt>
                <c:pt idx="401">
                  <c:v>1.3766736111111111</c:v>
                </c:pt>
                <c:pt idx="402">
                  <c:v>1.3780902777777777</c:v>
                </c:pt>
                <c:pt idx="403">
                  <c:v>1.3794999999999999</c:v>
                </c:pt>
                <c:pt idx="404">
                  <c:v>1.3797083333333333</c:v>
                </c:pt>
                <c:pt idx="405">
                  <c:v>1.3799166666666667</c:v>
                </c:pt>
                <c:pt idx="406">
                  <c:v>1.380125</c:v>
                </c:pt>
                <c:pt idx="407">
                  <c:v>1.3803333333333334</c:v>
                </c:pt>
                <c:pt idx="408">
                  <c:v>1.3805416666666668</c:v>
                </c:pt>
                <c:pt idx="409">
                  <c:v>1.3808958333333334</c:v>
                </c:pt>
                <c:pt idx="410">
                  <c:v>1.3812430555555555</c:v>
                </c:pt>
                <c:pt idx="411">
                  <c:v>1.3815972222222221</c:v>
                </c:pt>
                <c:pt idx="412">
                  <c:v>1.3819513888888888</c:v>
                </c:pt>
                <c:pt idx="413">
                  <c:v>1.3823055555555555</c:v>
                </c:pt>
                <c:pt idx="414">
                  <c:v>1.3831527777777777</c:v>
                </c:pt>
                <c:pt idx="415">
                  <c:v>1.3840000000000001</c:v>
                </c:pt>
                <c:pt idx="416">
                  <c:v>1.3848541666666667</c:v>
                </c:pt>
                <c:pt idx="417">
                  <c:v>1.3857013888888889</c:v>
                </c:pt>
                <c:pt idx="418">
                  <c:v>1.3865486111111112</c:v>
                </c:pt>
                <c:pt idx="419">
                  <c:v>1.3876597222222222</c:v>
                </c:pt>
                <c:pt idx="420">
                  <c:v>1.3887638888888889</c:v>
                </c:pt>
                <c:pt idx="421">
                  <c:v>1.389875</c:v>
                </c:pt>
                <c:pt idx="422">
                  <c:v>1.390986111111111</c:v>
                </c:pt>
                <c:pt idx="423">
                  <c:v>1.3920972222222221</c:v>
                </c:pt>
                <c:pt idx="424">
                  <c:v>1.393201388888889</c:v>
                </c:pt>
                <c:pt idx="425">
                  <c:v>1.3943125000000001</c:v>
                </c:pt>
                <c:pt idx="426">
                  <c:v>1.3954236111111111</c:v>
                </c:pt>
                <c:pt idx="427">
                  <c:v>1.3965347222222222</c:v>
                </c:pt>
                <c:pt idx="428">
                  <c:v>1.3974305555555555</c:v>
                </c:pt>
                <c:pt idx="429">
                  <c:v>1.3983333333333332</c:v>
                </c:pt>
                <c:pt idx="430">
                  <c:v>1.3992291666666667</c:v>
                </c:pt>
                <c:pt idx="431">
                  <c:v>1.4001319444444444</c:v>
                </c:pt>
                <c:pt idx="432">
                  <c:v>1.4010277777777778</c:v>
                </c:pt>
                <c:pt idx="433">
                  <c:v>1.4019305555555555</c:v>
                </c:pt>
                <c:pt idx="434">
                  <c:v>1.4029236111111112</c:v>
                </c:pt>
                <c:pt idx="435">
                  <c:v>1.4039097222222223</c:v>
                </c:pt>
                <c:pt idx="436">
                  <c:v>1.4049027777777778</c:v>
                </c:pt>
                <c:pt idx="437">
                  <c:v>1.4058958333333333</c:v>
                </c:pt>
                <c:pt idx="438">
                  <c:v>1.4068888888888889</c:v>
                </c:pt>
                <c:pt idx="439">
                  <c:v>1.4078819444444444</c:v>
                </c:pt>
                <c:pt idx="440">
                  <c:v>1.4088749999999999</c:v>
                </c:pt>
                <c:pt idx="441">
                  <c:v>1.4098680555555556</c:v>
                </c:pt>
                <c:pt idx="442">
                  <c:v>1.4108611111111111</c:v>
                </c:pt>
                <c:pt idx="443">
                  <c:v>1.4118541666666666</c:v>
                </c:pt>
                <c:pt idx="444">
                  <c:v>1.4128472222222221</c:v>
                </c:pt>
                <c:pt idx="445">
                  <c:v>1.4138402777777779</c:v>
                </c:pt>
                <c:pt idx="446">
                  <c:v>1.4148333333333332</c:v>
                </c:pt>
                <c:pt idx="447">
                  <c:v>1.4158263888888889</c:v>
                </c:pt>
                <c:pt idx="448">
                  <c:v>1.4168125</c:v>
                </c:pt>
                <c:pt idx="449">
                  <c:v>1.4178055555555555</c:v>
                </c:pt>
                <c:pt idx="450">
                  <c:v>1.4186319444444444</c:v>
                </c:pt>
                <c:pt idx="451">
                  <c:v>1.4194583333333333</c:v>
                </c:pt>
                <c:pt idx="452">
                  <c:v>1.4202916666666667</c:v>
                </c:pt>
                <c:pt idx="453">
                  <c:v>1.4209236111111112</c:v>
                </c:pt>
                <c:pt idx="454">
                  <c:v>1.4210347222222222</c:v>
                </c:pt>
                <c:pt idx="455">
                  <c:v>1.421138888888889</c:v>
                </c:pt>
                <c:pt idx="456">
                  <c:v>1.4212430555555555</c:v>
                </c:pt>
                <c:pt idx="457">
                  <c:v>1.4213472222222223</c:v>
                </c:pt>
                <c:pt idx="458">
                  <c:v>1.4214513888888889</c:v>
                </c:pt>
                <c:pt idx="459">
                  <c:v>1.4216111111111109</c:v>
                </c:pt>
                <c:pt idx="460">
                  <c:v>1.4217777777777778</c:v>
                </c:pt>
                <c:pt idx="461">
                  <c:v>1.4219374999999999</c:v>
                </c:pt>
                <c:pt idx="462">
                  <c:v>1.4220972222222221</c:v>
                </c:pt>
                <c:pt idx="463">
                  <c:v>1.4223819444444445</c:v>
                </c:pt>
                <c:pt idx="464">
                  <c:v>1.4226597222222224</c:v>
                </c:pt>
                <c:pt idx="465">
                  <c:v>1.4229375000000002</c:v>
                </c:pt>
                <c:pt idx="466">
                  <c:v>1.4232152777777776</c:v>
                </c:pt>
                <c:pt idx="467">
                  <c:v>1.4236319444444445</c:v>
                </c:pt>
                <c:pt idx="468">
                  <c:v>1.4240555555555554</c:v>
                </c:pt>
                <c:pt idx="469">
                  <c:v>1.4244722222222221</c:v>
                </c:pt>
                <c:pt idx="470">
                  <c:v>1.4248888888888891</c:v>
                </c:pt>
                <c:pt idx="471">
                  <c:v>1.4253055555555556</c:v>
                </c:pt>
                <c:pt idx="472">
                  <c:v>1.4257986111111112</c:v>
                </c:pt>
                <c:pt idx="473">
                  <c:v>1.4262847222222221</c:v>
                </c:pt>
                <c:pt idx="474">
                  <c:v>1.4267777777777777</c:v>
                </c:pt>
                <c:pt idx="475">
                  <c:v>1.4272638888888891</c:v>
                </c:pt>
                <c:pt idx="476">
                  <c:v>1.4277569444444442</c:v>
                </c:pt>
                <c:pt idx="477">
                  <c:v>1.4281319444444447</c:v>
                </c:pt>
                <c:pt idx="478">
                  <c:v>1.4284999999999999</c:v>
                </c:pt>
                <c:pt idx="479">
                  <c:v>1.4288749999999999</c:v>
                </c:pt>
                <c:pt idx="480">
                  <c:v>1.4292499999999999</c:v>
                </c:pt>
                <c:pt idx="481">
                  <c:v>1.4296249999999999</c:v>
                </c:pt>
                <c:pt idx="482">
                  <c:v>1.4299930555555556</c:v>
                </c:pt>
                <c:pt idx="483">
                  <c:v>1.4303680555555556</c:v>
                </c:pt>
                <c:pt idx="484">
                  <c:v>1.4307430555555556</c:v>
                </c:pt>
                <c:pt idx="485">
                  <c:v>1.4311111111111112</c:v>
                </c:pt>
                <c:pt idx="486">
                  <c:v>1.4314861111111112</c:v>
                </c:pt>
                <c:pt idx="487">
                  <c:v>1.4318611111111113</c:v>
                </c:pt>
                <c:pt idx="488">
                  <c:v>1.4321388888888891</c:v>
                </c:pt>
                <c:pt idx="489">
                  <c:v>1.4324166666666664</c:v>
                </c:pt>
                <c:pt idx="490">
                  <c:v>1.4326944444444445</c:v>
                </c:pt>
                <c:pt idx="491">
                  <c:v>1.4329722222222223</c:v>
                </c:pt>
                <c:pt idx="492">
                  <c:v>1.4332500000000001</c:v>
                </c:pt>
                <c:pt idx="493">
                  <c:v>1.4336180555555555</c:v>
                </c:pt>
                <c:pt idx="494">
                  <c:v>1.4339930555555553</c:v>
                </c:pt>
                <c:pt idx="495">
                  <c:v>1.4343611111111112</c:v>
                </c:pt>
                <c:pt idx="496">
                  <c:v>1.4347291666666668</c:v>
                </c:pt>
                <c:pt idx="497">
                  <c:v>1.4351041666666668</c:v>
                </c:pt>
                <c:pt idx="498">
                  <c:v>1.4356319444444443</c:v>
                </c:pt>
                <c:pt idx="499">
                  <c:v>1.4361666666666666</c:v>
                </c:pt>
                <c:pt idx="500">
                  <c:v>1.4366944444444445</c:v>
                </c:pt>
                <c:pt idx="501">
                  <c:v>1.4372291666666668</c:v>
                </c:pt>
                <c:pt idx="502">
                  <c:v>1.4377569444444445</c:v>
                </c:pt>
                <c:pt idx="503">
                  <c:v>1.4383541666666666</c:v>
                </c:pt>
                <c:pt idx="504">
                  <c:v>1.438951388888889</c:v>
                </c:pt>
                <c:pt idx="505">
                  <c:v>1.4395416666666667</c:v>
                </c:pt>
                <c:pt idx="506">
                  <c:v>1.4401388888888891</c:v>
                </c:pt>
                <c:pt idx="507">
                  <c:v>1.440736111111111</c:v>
                </c:pt>
                <c:pt idx="508">
                  <c:v>1.4413333333333334</c:v>
                </c:pt>
                <c:pt idx="509">
                  <c:v>1.4419236111111111</c:v>
                </c:pt>
                <c:pt idx="510">
                  <c:v>1.4425208333333333</c:v>
                </c:pt>
                <c:pt idx="511">
                  <c:v>1.4431180555555556</c:v>
                </c:pt>
                <c:pt idx="512">
                  <c:v>1.4437083333333334</c:v>
                </c:pt>
                <c:pt idx="513">
                  <c:v>1.4443055555555557</c:v>
                </c:pt>
                <c:pt idx="514">
                  <c:v>1.4449027777777776</c:v>
                </c:pt>
                <c:pt idx="515">
                  <c:v>1.4456041666666668</c:v>
                </c:pt>
                <c:pt idx="516">
                  <c:v>1.4463055555555555</c:v>
                </c:pt>
                <c:pt idx="517">
                  <c:v>1.4470138888888888</c:v>
                </c:pt>
                <c:pt idx="518">
                  <c:v>1.4475694444444445</c:v>
                </c:pt>
                <c:pt idx="519">
                  <c:v>1.4480069444444446</c:v>
                </c:pt>
                <c:pt idx="520">
                  <c:v>1.4483541666666668</c:v>
                </c:pt>
                <c:pt idx="521">
                  <c:v>1.4487013888888889</c:v>
                </c:pt>
                <c:pt idx="522">
                  <c:v>1.4487569444444444</c:v>
                </c:pt>
                <c:pt idx="523">
                  <c:v>1.4488194444444447</c:v>
                </c:pt>
                <c:pt idx="524">
                  <c:v>1.4488819444444443</c:v>
                </c:pt>
                <c:pt idx="525">
                  <c:v>1.4489374999999998</c:v>
                </c:pt>
                <c:pt idx="526">
                  <c:v>1.4490000000000001</c:v>
                </c:pt>
                <c:pt idx="527">
                  <c:v>1.4491180555555556</c:v>
                </c:pt>
                <c:pt idx="528">
                  <c:v>1.4492361111111112</c:v>
                </c:pt>
                <c:pt idx="529">
                  <c:v>1.4493611111111111</c:v>
                </c:pt>
                <c:pt idx="530">
                  <c:v>1.4494791666666667</c:v>
                </c:pt>
                <c:pt idx="531">
                  <c:v>1.449715277777778</c:v>
                </c:pt>
                <c:pt idx="532">
                  <c:v>1.4499444444444445</c:v>
                </c:pt>
                <c:pt idx="533">
                  <c:v>1.4501736111111112</c:v>
                </c:pt>
                <c:pt idx="534">
                  <c:v>1.4504097222222223</c:v>
                </c:pt>
                <c:pt idx="535">
                  <c:v>1.450638888888889</c:v>
                </c:pt>
                <c:pt idx="536">
                  <c:v>1.4510069444444442</c:v>
                </c:pt>
                <c:pt idx="537">
                  <c:v>1.4513680555555555</c:v>
                </c:pt>
                <c:pt idx="538">
                  <c:v>1.4517291666666665</c:v>
                </c:pt>
                <c:pt idx="539">
                  <c:v>1.452090277777778</c:v>
                </c:pt>
                <c:pt idx="540">
                  <c:v>1.452451388888889</c:v>
                </c:pt>
                <c:pt idx="541">
                  <c:v>1.4530000000000001</c:v>
                </c:pt>
                <c:pt idx="542">
                  <c:v>1.4535416666666665</c:v>
                </c:pt>
                <c:pt idx="543">
                  <c:v>1.4540902777777778</c:v>
                </c:pt>
                <c:pt idx="544">
                  <c:v>1.4546319444444444</c:v>
                </c:pt>
                <c:pt idx="545">
                  <c:v>1.4551805555555555</c:v>
                </c:pt>
                <c:pt idx="546">
                  <c:v>1.4557222222222221</c:v>
                </c:pt>
                <c:pt idx="547">
                  <c:v>1.4564444444444447</c:v>
                </c:pt>
                <c:pt idx="548">
                  <c:v>1.4571597222222221</c:v>
                </c:pt>
                <c:pt idx="549">
                  <c:v>1.4577430555555557</c:v>
                </c:pt>
                <c:pt idx="550">
                  <c:v>1.4583194444444445</c:v>
                </c:pt>
                <c:pt idx="551">
                  <c:v>1.4589027777777779</c:v>
                </c:pt>
                <c:pt idx="552">
                  <c:v>1.459486111111111</c:v>
                </c:pt>
                <c:pt idx="553">
                  <c:v>1.4600694444444444</c:v>
                </c:pt>
                <c:pt idx="554">
                  <c:v>1.4606458333333332</c:v>
                </c:pt>
                <c:pt idx="555">
                  <c:v>1.4607361111111112</c:v>
                </c:pt>
                <c:pt idx="556">
                  <c:v>1.4608333333333332</c:v>
                </c:pt>
                <c:pt idx="557">
                  <c:v>1.460923611111111</c:v>
                </c:pt>
                <c:pt idx="558">
                  <c:v>1.4610138888888891</c:v>
                </c:pt>
                <c:pt idx="559">
                  <c:v>1.461111111111111</c:v>
                </c:pt>
                <c:pt idx="560">
                  <c:v>1.4612847222222223</c:v>
                </c:pt>
                <c:pt idx="561">
                  <c:v>1.4614652777777779</c:v>
                </c:pt>
                <c:pt idx="562">
                  <c:v>1.4616388888888889</c:v>
                </c:pt>
                <c:pt idx="563">
                  <c:v>1.4618194444444443</c:v>
                </c:pt>
                <c:pt idx="564">
                  <c:v>1.4619930555555556</c:v>
                </c:pt>
                <c:pt idx="565">
                  <c:v>1.4622777777777776</c:v>
                </c:pt>
                <c:pt idx="566">
                  <c:v>1.4625625000000002</c:v>
                </c:pt>
                <c:pt idx="567">
                  <c:v>1.4628472222222222</c:v>
                </c:pt>
                <c:pt idx="568">
                  <c:v>1.4631319444444444</c:v>
                </c:pt>
                <c:pt idx="569">
                  <c:v>1.4634166666666668</c:v>
                </c:pt>
                <c:pt idx="570">
                  <c:v>1.4638541666666665</c:v>
                </c:pt>
                <c:pt idx="571">
                  <c:v>1.4642986111111111</c:v>
                </c:pt>
                <c:pt idx="572">
                  <c:v>1.464736111111111</c:v>
                </c:pt>
                <c:pt idx="573">
                  <c:v>1.4651805555555557</c:v>
                </c:pt>
                <c:pt idx="574">
                  <c:v>1.465625</c:v>
                </c:pt>
                <c:pt idx="575">
                  <c:v>1.4661666666666668</c:v>
                </c:pt>
                <c:pt idx="576">
                  <c:v>1.4667152777777779</c:v>
                </c:pt>
                <c:pt idx="577">
                  <c:v>1.4672569444444443</c:v>
                </c:pt>
                <c:pt idx="578">
                  <c:v>1.4678055555555554</c:v>
                </c:pt>
                <c:pt idx="579">
                  <c:v>1.4683472222222222</c:v>
                </c:pt>
                <c:pt idx="580">
                  <c:v>1.4684444444444444</c:v>
                </c:pt>
                <c:pt idx="581">
                  <c:v>1.4685347222222223</c:v>
                </c:pt>
                <c:pt idx="582">
                  <c:v>1.4686319444444444</c:v>
                </c:pt>
                <c:pt idx="583">
                  <c:v>1.4687222222222223</c:v>
                </c:pt>
                <c:pt idx="584">
                  <c:v>1.4688194444444445</c:v>
                </c:pt>
                <c:pt idx="585">
                  <c:v>1.4690000000000001</c:v>
                </c:pt>
                <c:pt idx="586">
                  <c:v>1.4691875000000001</c:v>
                </c:pt>
                <c:pt idx="587">
                  <c:v>1.4693680555555555</c:v>
                </c:pt>
                <c:pt idx="588">
                  <c:v>1.4695486111111111</c:v>
                </c:pt>
                <c:pt idx="589">
                  <c:v>1.4697361111111111</c:v>
                </c:pt>
                <c:pt idx="590">
                  <c:v>1.4700555555555557</c:v>
                </c:pt>
                <c:pt idx="591">
                  <c:v>1.4703819444444444</c:v>
                </c:pt>
                <c:pt idx="592">
                  <c:v>1.4707083333333335</c:v>
                </c:pt>
                <c:pt idx="593">
                  <c:v>1.4710277777777778</c:v>
                </c:pt>
                <c:pt idx="594">
                  <c:v>1.4713541666666667</c:v>
                </c:pt>
                <c:pt idx="595">
                  <c:v>1.4718472222222223</c:v>
                </c:pt>
                <c:pt idx="596">
                  <c:v>1.4723402777777779</c:v>
                </c:pt>
                <c:pt idx="597">
                  <c:v>1.4728402777777776</c:v>
                </c:pt>
                <c:pt idx="598">
                  <c:v>1.4733333333333332</c:v>
                </c:pt>
                <c:pt idx="599">
                  <c:v>1.4738263888888889</c:v>
                </c:pt>
                <c:pt idx="600">
                  <c:v>1.4743888888888887</c:v>
                </c:pt>
                <c:pt idx="601">
                  <c:v>1.4749444444444444</c:v>
                </c:pt>
                <c:pt idx="602">
                  <c:v>1.4754999999999998</c:v>
                </c:pt>
                <c:pt idx="603">
                  <c:v>1.4760625000000001</c:v>
                </c:pt>
                <c:pt idx="604">
                  <c:v>1.4766180555555555</c:v>
                </c:pt>
                <c:pt idx="605">
                  <c:v>1.4771736111111111</c:v>
                </c:pt>
                <c:pt idx="606">
                  <c:v>1.4779374999999999</c:v>
                </c:pt>
                <c:pt idx="607">
                  <c:v>1.4787013888888889</c:v>
                </c:pt>
                <c:pt idx="608">
                  <c:v>1.4794652777777777</c:v>
                </c:pt>
                <c:pt idx="609">
                  <c:v>1.4802291666666667</c:v>
                </c:pt>
                <c:pt idx="610">
                  <c:v>1.4809930555555557</c:v>
                </c:pt>
                <c:pt idx="611">
                  <c:v>1.4817569444444445</c:v>
                </c:pt>
                <c:pt idx="612">
                  <c:v>1.4825208333333333</c:v>
                </c:pt>
                <c:pt idx="613">
                  <c:v>1.4832777777777779</c:v>
                </c:pt>
                <c:pt idx="614">
                  <c:v>1.4840416666666667</c:v>
                </c:pt>
                <c:pt idx="615">
                  <c:v>1.4848888888888887</c:v>
                </c:pt>
                <c:pt idx="616">
                  <c:v>1.4857361111111111</c:v>
                </c:pt>
                <c:pt idx="617">
                  <c:v>1.4865833333333331</c:v>
                </c:pt>
                <c:pt idx="618">
                  <c:v>1.4874305555555556</c:v>
                </c:pt>
                <c:pt idx="619">
                  <c:v>1.4882777777777778</c:v>
                </c:pt>
                <c:pt idx="620">
                  <c:v>1.489125</c:v>
                </c:pt>
                <c:pt idx="621">
                  <c:v>1.4899722222222223</c:v>
                </c:pt>
                <c:pt idx="622">
                  <c:v>1.4906597222222224</c:v>
                </c:pt>
                <c:pt idx="623">
                  <c:v>1.4913541666666668</c:v>
                </c:pt>
                <c:pt idx="624">
                  <c:v>1.4920416666666667</c:v>
                </c:pt>
                <c:pt idx="625">
                  <c:v>1.4921597222222223</c:v>
                </c:pt>
                <c:pt idx="626">
                  <c:v>1.4922777777777778</c:v>
                </c:pt>
                <c:pt idx="627">
                  <c:v>1.4924027777777777</c:v>
                </c:pt>
                <c:pt idx="628">
                  <c:v>1.4925208333333333</c:v>
                </c:pt>
                <c:pt idx="629">
                  <c:v>1.4926388888888888</c:v>
                </c:pt>
                <c:pt idx="630">
                  <c:v>1.4928680555555556</c:v>
                </c:pt>
                <c:pt idx="631">
                  <c:v>1.4930972222222221</c:v>
                </c:pt>
                <c:pt idx="632">
                  <c:v>1.4933263888888888</c:v>
                </c:pt>
                <c:pt idx="633">
                  <c:v>1.4935555555555555</c:v>
                </c:pt>
                <c:pt idx="634">
                  <c:v>1.4939305555555558</c:v>
                </c:pt>
                <c:pt idx="635">
                  <c:v>1.4942986111111112</c:v>
                </c:pt>
                <c:pt idx="636">
                  <c:v>1.494673611111111</c:v>
                </c:pt>
                <c:pt idx="637">
                  <c:v>1.495048611111111</c:v>
                </c:pt>
                <c:pt idx="638">
                  <c:v>1.4955833333333333</c:v>
                </c:pt>
                <c:pt idx="639">
                  <c:v>1.4961180555555555</c:v>
                </c:pt>
                <c:pt idx="640">
                  <c:v>1.4966458333333335</c:v>
                </c:pt>
                <c:pt idx="641">
                  <c:v>1.4971805555555555</c:v>
                </c:pt>
                <c:pt idx="642">
                  <c:v>1.4977152777777778</c:v>
                </c:pt>
                <c:pt idx="643">
                  <c:v>1.4983472222222221</c:v>
                </c:pt>
                <c:pt idx="644">
                  <c:v>1.4989791666666668</c:v>
                </c:pt>
                <c:pt idx="645">
                  <c:v>1.4996041666666666</c:v>
                </c:pt>
                <c:pt idx="646">
                  <c:v>1.5002361111111111</c:v>
                </c:pt>
                <c:pt idx="647">
                  <c:v>1.5008680555555556</c:v>
                </c:pt>
                <c:pt idx="648">
                  <c:v>1.5016180555555556</c:v>
                </c:pt>
                <c:pt idx="649">
                  <c:v>1.5023680555555554</c:v>
                </c:pt>
                <c:pt idx="650">
                  <c:v>1.5031180555555554</c:v>
                </c:pt>
                <c:pt idx="651">
                  <c:v>1.5038680555555557</c:v>
                </c:pt>
                <c:pt idx="652">
                  <c:v>1.5046180555555557</c:v>
                </c:pt>
                <c:pt idx="653">
                  <c:v>1.5053611111111109</c:v>
                </c:pt>
                <c:pt idx="654">
                  <c:v>1.5064305555555557</c:v>
                </c:pt>
                <c:pt idx="655">
                  <c:v>1.5075000000000001</c:v>
                </c:pt>
                <c:pt idx="656">
                  <c:v>1.5085694444444446</c:v>
                </c:pt>
                <c:pt idx="657">
                  <c:v>1.5096319444444444</c:v>
                </c:pt>
                <c:pt idx="658">
                  <c:v>1.5107013888888887</c:v>
                </c:pt>
                <c:pt idx="659">
                  <c:v>1.5117708333333333</c:v>
                </c:pt>
                <c:pt idx="660">
                  <c:v>1.5130416666666668</c:v>
                </c:pt>
                <c:pt idx="661">
                  <c:v>1.5143194444444443</c:v>
                </c:pt>
                <c:pt idx="662">
                  <c:v>1.5155902777777777</c:v>
                </c:pt>
                <c:pt idx="663">
                  <c:v>1.5168680555555556</c:v>
                </c:pt>
                <c:pt idx="664">
                  <c:v>1.5181388888888887</c:v>
                </c:pt>
                <c:pt idx="665">
                  <c:v>1.519409722222222</c:v>
                </c:pt>
                <c:pt idx="666">
                  <c:v>1.5206875</c:v>
                </c:pt>
                <c:pt idx="667">
                  <c:v>1.5219583333333333</c:v>
                </c:pt>
                <c:pt idx="668">
                  <c:v>1.5229444444444444</c:v>
                </c:pt>
                <c:pt idx="669">
                  <c:v>1.5237430555555556</c:v>
                </c:pt>
                <c:pt idx="670">
                  <c:v>1.5245486111111111</c:v>
                </c:pt>
                <c:pt idx="671">
                  <c:v>1.5253472222222222</c:v>
                </c:pt>
                <c:pt idx="672">
                  <c:v>1.5261458333333333</c:v>
                </c:pt>
                <c:pt idx="673">
                  <c:v>1.5262708333333332</c:v>
                </c:pt>
                <c:pt idx="674">
                  <c:v>1.5263888888888888</c:v>
                </c:pt>
                <c:pt idx="675">
                  <c:v>1.5265138888888887</c:v>
                </c:pt>
                <c:pt idx="676">
                  <c:v>1.5266388888888889</c:v>
                </c:pt>
                <c:pt idx="677">
                  <c:v>1.5268819444444444</c:v>
                </c:pt>
                <c:pt idx="678">
                  <c:v>1.5271250000000001</c:v>
                </c:pt>
                <c:pt idx="679">
                  <c:v>1.5273680555555555</c:v>
                </c:pt>
                <c:pt idx="680">
                  <c:v>1.5276180555555556</c:v>
                </c:pt>
                <c:pt idx="681">
                  <c:v>1.5281875</c:v>
                </c:pt>
                <c:pt idx="682">
                  <c:v>1.528763888888889</c:v>
                </c:pt>
                <c:pt idx="683">
                  <c:v>1.5293333333333332</c:v>
                </c:pt>
                <c:pt idx="684">
                  <c:v>1.5299027777777778</c:v>
                </c:pt>
                <c:pt idx="685">
                  <c:v>1.5308611111111112</c:v>
                </c:pt>
                <c:pt idx="686">
                  <c:v>1.5318125</c:v>
                </c:pt>
                <c:pt idx="687">
                  <c:v>1.5327638888888888</c:v>
                </c:pt>
                <c:pt idx="688">
                  <c:v>1.5337152777777778</c:v>
                </c:pt>
                <c:pt idx="689">
                  <c:v>1.534673611111111</c:v>
                </c:pt>
                <c:pt idx="690">
                  <c:v>1.535625</c:v>
                </c:pt>
                <c:pt idx="691">
                  <c:v>1.536576388888889</c:v>
                </c:pt>
                <c:pt idx="692">
                  <c:v>1.5375277777777778</c:v>
                </c:pt>
                <c:pt idx="693">
                  <c:v>1.5386805555555554</c:v>
                </c:pt>
                <c:pt idx="694">
                  <c:v>1.5398333333333334</c:v>
                </c:pt>
                <c:pt idx="695">
                  <c:v>1.5409861111111112</c:v>
                </c:pt>
                <c:pt idx="696">
                  <c:v>1.5421388888888887</c:v>
                </c:pt>
                <c:pt idx="697">
                  <c:v>1.5432916666666667</c:v>
                </c:pt>
                <c:pt idx="698">
                  <c:v>1.5446666666666669</c:v>
                </c:pt>
                <c:pt idx="699">
                  <c:v>1.5460416666666668</c:v>
                </c:pt>
                <c:pt idx="700">
                  <c:v>1.5474166666666669</c:v>
                </c:pt>
                <c:pt idx="701">
                  <c:v>1.5487916666666668</c:v>
                </c:pt>
                <c:pt idx="702">
                  <c:v>1.5501666666666665</c:v>
                </c:pt>
                <c:pt idx="703">
                  <c:v>1.5515416666666666</c:v>
                </c:pt>
                <c:pt idx="704">
                  <c:v>1.553423611111111</c:v>
                </c:pt>
                <c:pt idx="705">
                  <c:v>1.5553055555555555</c:v>
                </c:pt>
                <c:pt idx="706">
                  <c:v>1.5571805555555556</c:v>
                </c:pt>
                <c:pt idx="707">
                  <c:v>1.5590625</c:v>
                </c:pt>
                <c:pt idx="708">
                  <c:v>1.5609444444444447</c:v>
                </c:pt>
                <c:pt idx="709">
                  <c:v>1.5628263888888887</c:v>
                </c:pt>
                <c:pt idx="710">
                  <c:v>1.5650555555555554</c:v>
                </c:pt>
                <c:pt idx="711">
                  <c:v>1.5672847222222221</c:v>
                </c:pt>
                <c:pt idx="712">
                  <c:v>1.5695208333333335</c:v>
                </c:pt>
                <c:pt idx="713">
                  <c:v>1.5717500000000002</c:v>
                </c:pt>
                <c:pt idx="714">
                  <c:v>1.5739861111111111</c:v>
                </c:pt>
                <c:pt idx="715">
                  <c:v>1.5762152777777778</c:v>
                </c:pt>
                <c:pt idx="716">
                  <c:v>1.5784444444444445</c:v>
                </c:pt>
                <c:pt idx="717">
                  <c:v>1.5806805555555554</c:v>
                </c:pt>
                <c:pt idx="718">
                  <c:v>1.5829097222222221</c:v>
                </c:pt>
                <c:pt idx="719">
                  <c:v>1.5854444444444444</c:v>
                </c:pt>
                <c:pt idx="720">
                  <c:v>1.5879861111111109</c:v>
                </c:pt>
                <c:pt idx="721">
                  <c:v>1.5905208333333332</c:v>
                </c:pt>
                <c:pt idx="722">
                  <c:v>1.5930555555555554</c:v>
                </c:pt>
                <c:pt idx="723">
                  <c:v>1.5955972222222221</c:v>
                </c:pt>
                <c:pt idx="724">
                  <c:v>1.5981319444444444</c:v>
                </c:pt>
                <c:pt idx="725">
                  <c:v>1.6011180555555558</c:v>
                </c:pt>
                <c:pt idx="726">
                  <c:v>1.6041041666666667</c:v>
                </c:pt>
                <c:pt idx="727">
                  <c:v>1.6070972222222222</c:v>
                </c:pt>
                <c:pt idx="728">
                  <c:v>1.6100833333333333</c:v>
                </c:pt>
                <c:pt idx="729">
                  <c:v>1.6130694444444447</c:v>
                </c:pt>
                <c:pt idx="730">
                  <c:v>1.6160625000000002</c:v>
                </c:pt>
                <c:pt idx="731">
                  <c:v>1.6190486111111111</c:v>
                </c:pt>
                <c:pt idx="732">
                  <c:v>1.6220347222222222</c:v>
                </c:pt>
                <c:pt idx="733">
                  <c:v>1.6250277777777777</c:v>
                </c:pt>
                <c:pt idx="734">
                  <c:v>1.6278680555555556</c:v>
                </c:pt>
                <c:pt idx="735">
                  <c:v>1.6307083333333332</c:v>
                </c:pt>
                <c:pt idx="736">
                  <c:v>1.633548611111111</c:v>
                </c:pt>
                <c:pt idx="737">
                  <c:v>1.6363888888888889</c:v>
                </c:pt>
                <c:pt idx="738">
                  <c:v>1.6368611111111111</c:v>
                </c:pt>
                <c:pt idx="739">
                  <c:v>1.6373263888888889</c:v>
                </c:pt>
                <c:pt idx="740">
                  <c:v>1.6377916666666668</c:v>
                </c:pt>
                <c:pt idx="741">
                  <c:v>1.6382638888888887</c:v>
                </c:pt>
                <c:pt idx="742">
                  <c:v>1.6387291666666666</c:v>
                </c:pt>
                <c:pt idx="743">
                  <c:v>1.6396666666666666</c:v>
                </c:pt>
                <c:pt idx="744">
                  <c:v>1.6406041666666664</c:v>
                </c:pt>
                <c:pt idx="745">
                  <c:v>1.6415416666666667</c:v>
                </c:pt>
                <c:pt idx="746">
                  <c:v>1.6424791666666667</c:v>
                </c:pt>
                <c:pt idx="747">
                  <c:v>1.644826388888889</c:v>
                </c:pt>
                <c:pt idx="748">
                  <c:v>1.647173611111111</c:v>
                </c:pt>
                <c:pt idx="749">
                  <c:v>1.6495208333333333</c:v>
                </c:pt>
                <c:pt idx="750">
                  <c:v>1.6518680555555556</c:v>
                </c:pt>
                <c:pt idx="751">
                  <c:v>1.6542152777777779</c:v>
                </c:pt>
                <c:pt idx="752">
                  <c:v>1.6576111111111111</c:v>
                </c:pt>
                <c:pt idx="753">
                  <c:v>1.661</c:v>
                </c:pt>
                <c:pt idx="754">
                  <c:v>1.6643958333333333</c:v>
                </c:pt>
                <c:pt idx="755">
                  <c:v>1.6677847222222224</c:v>
                </c:pt>
                <c:pt idx="756">
                  <c:v>1.6711736111111111</c:v>
                </c:pt>
                <c:pt idx="757">
                  <c:v>1.6758194444444443</c:v>
                </c:pt>
                <c:pt idx="758">
                  <c:v>1.6804583333333334</c:v>
                </c:pt>
                <c:pt idx="759">
                  <c:v>1.6851041666666668</c:v>
                </c:pt>
                <c:pt idx="760">
                  <c:v>1.6897430555555555</c:v>
                </c:pt>
                <c:pt idx="761">
                  <c:v>1.6943888888888889</c:v>
                </c:pt>
                <c:pt idx="762">
                  <c:v>1.6990277777777778</c:v>
                </c:pt>
                <c:pt idx="763">
                  <c:v>1.7046249999999998</c:v>
                </c:pt>
                <c:pt idx="764">
                  <c:v>1.7102222222222221</c:v>
                </c:pt>
                <c:pt idx="765">
                  <c:v>1.7158125</c:v>
                </c:pt>
                <c:pt idx="766">
                  <c:v>1.7214097222222222</c:v>
                </c:pt>
                <c:pt idx="767">
                  <c:v>1.7270000000000001</c:v>
                </c:pt>
                <c:pt idx="768">
                  <c:v>1.7325972222222223</c:v>
                </c:pt>
                <c:pt idx="769">
                  <c:v>1.7410833333333333</c:v>
                </c:pt>
                <c:pt idx="770">
                  <c:v>1.7495763888888889</c:v>
                </c:pt>
                <c:pt idx="771">
                  <c:v>1.7580625000000001</c:v>
                </c:pt>
                <c:pt idx="772">
                  <c:v>1.7665486111111111</c:v>
                </c:pt>
                <c:pt idx="773">
                  <c:v>1.7750416666666666</c:v>
                </c:pt>
                <c:pt idx="774">
                  <c:v>1.7835277777777778</c:v>
                </c:pt>
                <c:pt idx="775">
                  <c:v>1.7920208333333334</c:v>
                </c:pt>
                <c:pt idx="776">
                  <c:v>1.8005069444444444</c:v>
                </c:pt>
                <c:pt idx="777">
                  <c:v>1.8089930555555553</c:v>
                </c:pt>
                <c:pt idx="778">
                  <c:v>1.8174861111111109</c:v>
                </c:pt>
                <c:pt idx="779">
                  <c:v>1.8259722222222223</c:v>
                </c:pt>
                <c:pt idx="780">
                  <c:v>1.8344583333333333</c:v>
                </c:pt>
                <c:pt idx="781">
                  <c:v>1.8429513888888889</c:v>
                </c:pt>
                <c:pt idx="782">
                  <c:v>1.8514375000000001</c:v>
                </c:pt>
                <c:pt idx="783">
                  <c:v>1.859923611111111</c:v>
                </c:pt>
                <c:pt idx="784">
                  <c:v>1.8684166666666666</c:v>
                </c:pt>
                <c:pt idx="785">
                  <c:v>1.8769027777777776</c:v>
                </c:pt>
                <c:pt idx="786">
                  <c:v>1.885388888888889</c:v>
                </c:pt>
                <c:pt idx="787">
                  <c:v>1.8938819444444446</c:v>
                </c:pt>
                <c:pt idx="788">
                  <c:v>1.9023680555555555</c:v>
                </c:pt>
                <c:pt idx="789">
                  <c:v>1.9108541666666667</c:v>
                </c:pt>
                <c:pt idx="790">
                  <c:v>1.9193472222222223</c:v>
                </c:pt>
                <c:pt idx="791">
                  <c:v>1.9278333333333333</c:v>
                </c:pt>
                <c:pt idx="792">
                  <c:v>1.9363194444444445</c:v>
                </c:pt>
                <c:pt idx="793">
                  <c:v>1.9448125000000001</c:v>
                </c:pt>
                <c:pt idx="794">
                  <c:v>1.953298611111111</c:v>
                </c:pt>
                <c:pt idx="795">
                  <c:v>1.961784722222222</c:v>
                </c:pt>
                <c:pt idx="796">
                  <c:v>1.9702777777777776</c:v>
                </c:pt>
                <c:pt idx="797">
                  <c:v>1.978763888888889</c:v>
                </c:pt>
                <c:pt idx="798">
                  <c:v>1.98725</c:v>
                </c:pt>
                <c:pt idx="799">
                  <c:v>1.9957430555555555</c:v>
                </c:pt>
                <c:pt idx="800">
                  <c:v>2.0042291666666667</c:v>
                </c:pt>
                <c:pt idx="801">
                  <c:v>2.0127152777777777</c:v>
                </c:pt>
                <c:pt idx="802">
                  <c:v>2.0212083333333335</c:v>
                </c:pt>
                <c:pt idx="803">
                  <c:v>2.0296944444444445</c:v>
                </c:pt>
                <c:pt idx="804">
                  <c:v>2.0381805555555554</c:v>
                </c:pt>
                <c:pt idx="805">
                  <c:v>2.0466736111111112</c:v>
                </c:pt>
                <c:pt idx="806">
                  <c:v>2.0551597222222222</c:v>
                </c:pt>
                <c:pt idx="807">
                  <c:v>2.0636527777777776</c:v>
                </c:pt>
                <c:pt idx="808">
                  <c:v>2.072138888888889</c:v>
                </c:pt>
                <c:pt idx="809">
                  <c:v>2.0806249999999999</c:v>
                </c:pt>
                <c:pt idx="810">
                  <c:v>2.0891180555555553</c:v>
                </c:pt>
                <c:pt idx="811">
                  <c:v>2.0976041666666667</c:v>
                </c:pt>
                <c:pt idx="812">
                  <c:v>2.1060902777777777</c:v>
                </c:pt>
                <c:pt idx="813">
                  <c:v>2.1145833333333335</c:v>
                </c:pt>
                <c:pt idx="814">
                  <c:v>2.1239722222222222</c:v>
                </c:pt>
                <c:pt idx="815">
                  <c:v>2.1333611111111113</c:v>
                </c:pt>
                <c:pt idx="816">
                  <c:v>2.1427499999999999</c:v>
                </c:pt>
                <c:pt idx="817">
                  <c:v>2.1521458333333334</c:v>
                </c:pt>
                <c:pt idx="818">
                  <c:v>2.1615347222222221</c:v>
                </c:pt>
                <c:pt idx="819">
                  <c:v>2.1709236111111112</c:v>
                </c:pt>
                <c:pt idx="820">
                  <c:v>2.1803194444444443</c:v>
                </c:pt>
                <c:pt idx="821">
                  <c:v>2.1897083333333334</c:v>
                </c:pt>
                <c:pt idx="822">
                  <c:v>2.199097222222222</c:v>
                </c:pt>
                <c:pt idx="823">
                  <c:v>2.2084930555555555</c:v>
                </c:pt>
                <c:pt idx="824">
                  <c:v>2.2178819444444446</c:v>
                </c:pt>
                <c:pt idx="825">
                  <c:v>2.2272708333333333</c:v>
                </c:pt>
                <c:pt idx="826">
                  <c:v>2.236659722222222</c:v>
                </c:pt>
                <c:pt idx="827">
                  <c:v>2.2460555555555555</c:v>
                </c:pt>
                <c:pt idx="828">
                  <c:v>2.2554444444444446</c:v>
                </c:pt>
                <c:pt idx="829">
                  <c:v>2.2648333333333333</c:v>
                </c:pt>
                <c:pt idx="830">
                  <c:v>2.2742291666666667</c:v>
                </c:pt>
                <c:pt idx="831">
                  <c:v>2.2836180555555554</c:v>
                </c:pt>
                <c:pt idx="832">
                  <c:v>2.2930069444444445</c:v>
                </c:pt>
                <c:pt idx="833">
                  <c:v>2.302402777777778</c:v>
                </c:pt>
                <c:pt idx="834">
                  <c:v>2.3117916666666667</c:v>
                </c:pt>
                <c:pt idx="835">
                  <c:v>2.3211805555555554</c:v>
                </c:pt>
                <c:pt idx="836">
                  <c:v>2.3305694444444445</c:v>
                </c:pt>
                <c:pt idx="837">
                  <c:v>2.339965277777778</c:v>
                </c:pt>
                <c:pt idx="838">
                  <c:v>2.3493541666666666</c:v>
                </c:pt>
                <c:pt idx="839">
                  <c:v>2.3587430555555557</c:v>
                </c:pt>
                <c:pt idx="840">
                  <c:v>2.3681388888888888</c:v>
                </c:pt>
                <c:pt idx="841">
                  <c:v>2.3775277777777779</c:v>
                </c:pt>
                <c:pt idx="842">
                  <c:v>2.3869166666666666</c:v>
                </c:pt>
                <c:pt idx="843">
                  <c:v>2.3963125000000001</c:v>
                </c:pt>
                <c:pt idx="844">
                  <c:v>2.4057013888888887</c:v>
                </c:pt>
                <c:pt idx="845">
                  <c:v>2.4150902777777778</c:v>
                </c:pt>
                <c:pt idx="846">
                  <c:v>2.4244791666666665</c:v>
                </c:pt>
                <c:pt idx="847">
                  <c:v>2.433875</c:v>
                </c:pt>
                <c:pt idx="848">
                  <c:v>2.4432638888888891</c:v>
                </c:pt>
                <c:pt idx="849">
                  <c:v>2.4526527777777778</c:v>
                </c:pt>
                <c:pt idx="850">
                  <c:v>2.4620486111111108</c:v>
                </c:pt>
                <c:pt idx="851">
                  <c:v>2.4714375</c:v>
                </c:pt>
                <c:pt idx="852">
                  <c:v>2.4808263888888886</c:v>
                </c:pt>
                <c:pt idx="853">
                  <c:v>2.4902222222222221</c:v>
                </c:pt>
                <c:pt idx="854">
                  <c:v>2.4996111111111112</c:v>
                </c:pt>
                <c:pt idx="855">
                  <c:v>2.5089999999999999</c:v>
                </c:pt>
                <c:pt idx="856">
                  <c:v>2.518388888888889</c:v>
                </c:pt>
                <c:pt idx="857">
                  <c:v>2.5277847222222225</c:v>
                </c:pt>
                <c:pt idx="858">
                  <c:v>2.5371736111111112</c:v>
                </c:pt>
                <c:pt idx="859">
                  <c:v>2.5465625000000003</c:v>
                </c:pt>
                <c:pt idx="860">
                  <c:v>2.5559583333333333</c:v>
                </c:pt>
                <c:pt idx="861">
                  <c:v>2.565347222222222</c:v>
                </c:pt>
                <c:pt idx="862">
                  <c:v>2.5747361111111111</c:v>
                </c:pt>
                <c:pt idx="863">
                  <c:v>2.5841319444444446</c:v>
                </c:pt>
                <c:pt idx="864">
                  <c:v>2.5935208333333333</c:v>
                </c:pt>
                <c:pt idx="865">
                  <c:v>2.6029097222222224</c:v>
                </c:pt>
                <c:pt idx="866">
                  <c:v>2.6122986111111111</c:v>
                </c:pt>
                <c:pt idx="867">
                  <c:v>2.6216944444444441</c:v>
                </c:pt>
                <c:pt idx="868">
                  <c:v>2.6310833333333337</c:v>
                </c:pt>
                <c:pt idx="869">
                  <c:v>2.6404722222222223</c:v>
                </c:pt>
                <c:pt idx="870">
                  <c:v>2.6498680555555554</c:v>
                </c:pt>
                <c:pt idx="871">
                  <c:v>2.6592569444444445</c:v>
                </c:pt>
                <c:pt idx="872">
                  <c:v>2.6686458333333332</c:v>
                </c:pt>
                <c:pt idx="873">
                  <c:v>2.6780416666666667</c:v>
                </c:pt>
                <c:pt idx="874">
                  <c:v>2.6874305555555558</c:v>
                </c:pt>
                <c:pt idx="875">
                  <c:v>2.6968194444444444</c:v>
                </c:pt>
                <c:pt idx="876">
                  <c:v>2.7062083333333335</c:v>
                </c:pt>
                <c:pt idx="877">
                  <c:v>2.7156041666666666</c:v>
                </c:pt>
                <c:pt idx="878">
                  <c:v>2.7232569444444441</c:v>
                </c:pt>
                <c:pt idx="879">
                  <c:v>2.7309097222222225</c:v>
                </c:pt>
                <c:pt idx="880">
                  <c:v>2.7385625</c:v>
                </c:pt>
                <c:pt idx="881">
                  <c:v>2.7462222222222223</c:v>
                </c:pt>
                <c:pt idx="882">
                  <c:v>2.7538749999999999</c:v>
                </c:pt>
                <c:pt idx="883">
                  <c:v>2.7615277777777778</c:v>
                </c:pt>
                <c:pt idx="884">
                  <c:v>2.7691805555555553</c:v>
                </c:pt>
                <c:pt idx="885">
                  <c:v>2.7768402777777776</c:v>
                </c:pt>
                <c:pt idx="886">
                  <c:v>2.7828541666666666</c:v>
                </c:pt>
                <c:pt idx="887">
                  <c:v>2.7874444444444446</c:v>
                </c:pt>
                <c:pt idx="888">
                  <c:v>2.7920347222222222</c:v>
                </c:pt>
                <c:pt idx="889">
                  <c:v>2.7927986111111114</c:v>
                </c:pt>
                <c:pt idx="890">
                  <c:v>2.7935625000000002</c:v>
                </c:pt>
                <c:pt idx="891">
                  <c:v>2.794326388888889</c:v>
                </c:pt>
                <c:pt idx="892">
                  <c:v>2.7950902777777777</c:v>
                </c:pt>
                <c:pt idx="893">
                  <c:v>2.795854166666667</c:v>
                </c:pt>
                <c:pt idx="894">
                  <c:v>2.7968958333333336</c:v>
                </c:pt>
                <c:pt idx="895">
                  <c:v>2.7979305555555554</c:v>
                </c:pt>
                <c:pt idx="896">
                  <c:v>2.798965277777778</c:v>
                </c:pt>
                <c:pt idx="897">
                  <c:v>2.8000069444444446</c:v>
                </c:pt>
                <c:pt idx="898">
                  <c:v>2.8020833333333335</c:v>
                </c:pt>
                <c:pt idx="899">
                  <c:v>2.8041597222222219</c:v>
                </c:pt>
                <c:pt idx="900">
                  <c:v>2.8062361111111112</c:v>
                </c:pt>
                <c:pt idx="901">
                  <c:v>2.8083125</c:v>
                </c:pt>
                <c:pt idx="902">
                  <c:v>2.8111944444444443</c:v>
                </c:pt>
                <c:pt idx="903">
                  <c:v>2.8140694444444447</c:v>
                </c:pt>
                <c:pt idx="904">
                  <c:v>2.8169513888888886</c:v>
                </c:pt>
                <c:pt idx="905">
                  <c:v>2.819826388888889</c:v>
                </c:pt>
                <c:pt idx="906">
                  <c:v>2.8220763888888887</c:v>
                </c:pt>
                <c:pt idx="907">
                  <c:v>2.8239444444444444</c:v>
                </c:pt>
                <c:pt idx="908">
                  <c:v>2.8258055555555552</c:v>
                </c:pt>
                <c:pt idx="909">
                  <c:v>2.8276666666666666</c:v>
                </c:pt>
                <c:pt idx="910">
                  <c:v>2.8295277777777779</c:v>
                </c:pt>
                <c:pt idx="911">
                  <c:v>2.8298333333333332</c:v>
                </c:pt>
                <c:pt idx="912">
                  <c:v>2.830138888888889</c:v>
                </c:pt>
                <c:pt idx="913">
                  <c:v>2.8304444444444448</c:v>
                </c:pt>
                <c:pt idx="914">
                  <c:v>2.8307569444444445</c:v>
                </c:pt>
                <c:pt idx="915">
                  <c:v>2.831347222222222</c:v>
                </c:pt>
                <c:pt idx="916">
                  <c:v>2.8319444444444444</c:v>
                </c:pt>
                <c:pt idx="917">
                  <c:v>2.8325416666666667</c:v>
                </c:pt>
                <c:pt idx="918">
                  <c:v>2.8334166666666665</c:v>
                </c:pt>
                <c:pt idx="919">
                  <c:v>2.8342916666666667</c:v>
                </c:pt>
                <c:pt idx="920">
                  <c:v>2.8351666666666664</c:v>
                </c:pt>
                <c:pt idx="921">
                  <c:v>2.8360416666666666</c:v>
                </c:pt>
                <c:pt idx="922">
                  <c:v>2.8371875000000002</c:v>
                </c:pt>
                <c:pt idx="923">
                  <c:v>2.8383402777777778</c:v>
                </c:pt>
                <c:pt idx="924">
                  <c:v>2.8394861111111114</c:v>
                </c:pt>
                <c:pt idx="925">
                  <c:v>2.8406319444444446</c:v>
                </c:pt>
                <c:pt idx="926">
                  <c:v>2.8423958333333337</c:v>
                </c:pt>
                <c:pt idx="927">
                  <c:v>2.8441527777777775</c:v>
                </c:pt>
                <c:pt idx="928">
                  <c:v>2.8459166666666667</c:v>
                </c:pt>
                <c:pt idx="929">
                  <c:v>2.8476805555555553</c:v>
                </c:pt>
                <c:pt idx="930">
                  <c:v>2.85025</c:v>
                </c:pt>
                <c:pt idx="931">
                  <c:v>2.8528194444444446</c:v>
                </c:pt>
                <c:pt idx="932">
                  <c:v>2.8553958333333336</c:v>
                </c:pt>
                <c:pt idx="933">
                  <c:v>2.8573749999999998</c:v>
                </c:pt>
                <c:pt idx="934">
                  <c:v>2.8589652777777776</c:v>
                </c:pt>
                <c:pt idx="935">
                  <c:v>2.8605486111111107</c:v>
                </c:pt>
                <c:pt idx="936">
                  <c:v>2.8621388888888886</c:v>
                </c:pt>
                <c:pt idx="937">
                  <c:v>2.8637291666666669</c:v>
                </c:pt>
                <c:pt idx="938">
                  <c:v>2.8653124999999999</c:v>
                </c:pt>
                <c:pt idx="939">
                  <c:v>2.8669027777777778</c:v>
                </c:pt>
                <c:pt idx="940">
                  <c:v>2.8684930555555557</c:v>
                </c:pt>
                <c:pt idx="941">
                  <c:v>2.8707361111111109</c:v>
                </c:pt>
                <c:pt idx="942">
                  <c:v>2.8729722222222223</c:v>
                </c:pt>
                <c:pt idx="943">
                  <c:v>2.875215277777778</c:v>
                </c:pt>
                <c:pt idx="944">
                  <c:v>2.8774583333333332</c:v>
                </c:pt>
                <c:pt idx="945">
                  <c:v>2.8797013888888894</c:v>
                </c:pt>
                <c:pt idx="946">
                  <c:v>2.8827152777777774</c:v>
                </c:pt>
                <c:pt idx="947">
                  <c:v>2.8857291666666667</c:v>
                </c:pt>
                <c:pt idx="948">
                  <c:v>2.8887430555555556</c:v>
                </c:pt>
                <c:pt idx="949">
                  <c:v>2.8917569444444444</c:v>
                </c:pt>
                <c:pt idx="950">
                  <c:v>2.8947708333333333</c:v>
                </c:pt>
                <c:pt idx="951">
                  <c:v>2.8977847222222226</c:v>
                </c:pt>
                <c:pt idx="952">
                  <c:v>2.900798611111111</c:v>
                </c:pt>
                <c:pt idx="953">
                  <c:v>2.9032638888888886</c:v>
                </c:pt>
                <c:pt idx="954">
                  <c:v>2.9057291666666667</c:v>
                </c:pt>
                <c:pt idx="955">
                  <c:v>2.9081944444444447</c:v>
                </c:pt>
                <c:pt idx="956">
                  <c:v>2.9106597222222224</c:v>
                </c:pt>
                <c:pt idx="957">
                  <c:v>2.913125</c:v>
                </c:pt>
                <c:pt idx="958">
                  <c:v>2.9155902777777776</c:v>
                </c:pt>
                <c:pt idx="959">
                  <c:v>2.9180555555555556</c:v>
                </c:pt>
                <c:pt idx="960">
                  <c:v>2.9205208333333337</c:v>
                </c:pt>
                <c:pt idx="961">
                  <c:v>2.9229861111111113</c:v>
                </c:pt>
                <c:pt idx="962">
                  <c:v>2.9254513888888884</c:v>
                </c:pt>
                <c:pt idx="963">
                  <c:v>2.9279166666666665</c:v>
                </c:pt>
                <c:pt idx="964">
                  <c:v>2.9303819444444446</c:v>
                </c:pt>
                <c:pt idx="965">
                  <c:v>2.9328472222222222</c:v>
                </c:pt>
                <c:pt idx="966">
                  <c:v>2.9348819444444443</c:v>
                </c:pt>
                <c:pt idx="967">
                  <c:v>2.936909722222222</c:v>
                </c:pt>
                <c:pt idx="968">
                  <c:v>2.9389374999999998</c:v>
                </c:pt>
                <c:pt idx="969">
                  <c:v>2.9409722222222223</c:v>
                </c:pt>
                <c:pt idx="970">
                  <c:v>2.9430000000000001</c:v>
                </c:pt>
                <c:pt idx="971">
                  <c:v>2.9450347222222226</c:v>
                </c:pt>
                <c:pt idx="972">
                  <c:v>2.9470625000000004</c:v>
                </c:pt>
                <c:pt idx="973">
                  <c:v>2.9490902777777777</c:v>
                </c:pt>
                <c:pt idx="974">
                  <c:v>2.9511249999999998</c:v>
                </c:pt>
                <c:pt idx="975">
                  <c:v>2.953152777777778</c:v>
                </c:pt>
                <c:pt idx="976">
                  <c:v>2.9551805555555557</c:v>
                </c:pt>
                <c:pt idx="977">
                  <c:v>2.9572152777777778</c:v>
                </c:pt>
                <c:pt idx="978">
                  <c:v>2.9588611111111112</c:v>
                </c:pt>
                <c:pt idx="979">
                  <c:v>2.9605138888888893</c:v>
                </c:pt>
                <c:pt idx="980">
                  <c:v>2.961875</c:v>
                </c:pt>
                <c:pt idx="981">
                  <c:v>2.9632361111111112</c:v>
                </c:pt>
                <c:pt idx="982">
                  <c:v>2.9646041666666667</c:v>
                </c:pt>
                <c:pt idx="983">
                  <c:v>2.9659652777777774</c:v>
                </c:pt>
                <c:pt idx="984">
                  <c:v>2.9673263888888886</c:v>
                </c:pt>
                <c:pt idx="985">
                  <c:v>2.9686874999999997</c:v>
                </c:pt>
                <c:pt idx="986">
                  <c:v>2.9698124999999997</c:v>
                </c:pt>
                <c:pt idx="987">
                  <c:v>2.9706805555555555</c:v>
                </c:pt>
                <c:pt idx="988">
                  <c:v>2.9715486111111109</c:v>
                </c:pt>
                <c:pt idx="989">
                  <c:v>2.972263888888889</c:v>
                </c:pt>
                <c:pt idx="990">
                  <c:v>2.9728541666666666</c:v>
                </c:pt>
                <c:pt idx="991">
                  <c:v>2.9734513888888894</c:v>
                </c:pt>
                <c:pt idx="992">
                  <c:v>2.9740416666666665</c:v>
                </c:pt>
                <c:pt idx="993">
                  <c:v>2.9746319444444445</c:v>
                </c:pt>
                <c:pt idx="994">
                  <c:v>2.9752291666666668</c:v>
                </c:pt>
                <c:pt idx="995">
                  <c:v>2.9758194444444448</c:v>
                </c:pt>
                <c:pt idx="996">
                  <c:v>2.9759236111111109</c:v>
                </c:pt>
                <c:pt idx="997">
                  <c:v>2.9760277777777775</c:v>
                </c:pt>
                <c:pt idx="998">
                  <c:v>2.9761388888888893</c:v>
                </c:pt>
                <c:pt idx="999">
                  <c:v>2.9762430555555555</c:v>
                </c:pt>
                <c:pt idx="1000">
                  <c:v>2.976451388888889</c:v>
                </c:pt>
                <c:pt idx="1001">
                  <c:v>2.9766666666666666</c:v>
                </c:pt>
                <c:pt idx="1002">
                  <c:v>2.9768749999999997</c:v>
                </c:pt>
                <c:pt idx="1003">
                  <c:v>2.9770833333333333</c:v>
                </c:pt>
                <c:pt idx="1004">
                  <c:v>2.9776180555555558</c:v>
                </c:pt>
                <c:pt idx="1005">
                  <c:v>2.9781527777777779</c:v>
                </c:pt>
                <c:pt idx="1006">
                  <c:v>2.9786805555555556</c:v>
                </c:pt>
                <c:pt idx="1007">
                  <c:v>2.9792152777777776</c:v>
                </c:pt>
                <c:pt idx="1008">
                  <c:v>2.9801805555555556</c:v>
                </c:pt>
                <c:pt idx="1009">
                  <c:v>2.9811458333333336</c:v>
                </c:pt>
                <c:pt idx="1010">
                  <c:v>2.9821111111111112</c:v>
                </c:pt>
                <c:pt idx="1011">
                  <c:v>2.9830763888888892</c:v>
                </c:pt>
                <c:pt idx="1012">
                  <c:v>2.9840416666666671</c:v>
                </c:pt>
                <c:pt idx="1013">
                  <c:v>2.9854861111111113</c:v>
                </c:pt>
                <c:pt idx="1014">
                  <c:v>2.9869305555555559</c:v>
                </c:pt>
                <c:pt idx="1015">
                  <c:v>2.988375</c:v>
                </c:pt>
                <c:pt idx="1016">
                  <c:v>2.989826388888889</c:v>
                </c:pt>
                <c:pt idx="1017">
                  <c:v>2.9912708333333335</c:v>
                </c:pt>
                <c:pt idx="1018">
                  <c:v>2.9926388888888886</c:v>
                </c:pt>
                <c:pt idx="1019">
                  <c:v>2.9940069444444442</c:v>
                </c:pt>
                <c:pt idx="1020">
                  <c:v>2.9953819444444445</c:v>
                </c:pt>
                <c:pt idx="1021">
                  <c:v>2.9967499999999996</c:v>
                </c:pt>
                <c:pt idx="1022">
                  <c:v>2.9981180555555556</c:v>
                </c:pt>
                <c:pt idx="1023">
                  <c:v>2.9994861111111111</c:v>
                </c:pt>
                <c:pt idx="1024">
                  <c:v>3.0008541666666662</c:v>
                </c:pt>
                <c:pt idx="1025">
                  <c:v>3.0022222222222221</c:v>
                </c:pt>
                <c:pt idx="1026">
                  <c:v>3.0035972222222225</c:v>
                </c:pt>
                <c:pt idx="1027">
                  <c:v>3.005125</c:v>
                </c:pt>
                <c:pt idx="1028">
                  <c:v>3.0066527777777776</c:v>
                </c:pt>
                <c:pt idx="1029">
                  <c:v>3.0081805555555552</c:v>
                </c:pt>
                <c:pt idx="1030">
                  <c:v>3.0097083333333332</c:v>
                </c:pt>
                <c:pt idx="1031">
                  <c:v>3.0112361111111112</c:v>
                </c:pt>
                <c:pt idx="1032">
                  <c:v>3.0127569444444444</c:v>
                </c:pt>
                <c:pt idx="1033">
                  <c:v>3.014284722222222</c:v>
                </c:pt>
                <c:pt idx="1034">
                  <c:v>3.0158125000000005</c:v>
                </c:pt>
                <c:pt idx="1035">
                  <c:v>3.017340277777778</c:v>
                </c:pt>
                <c:pt idx="1036">
                  <c:v>3.0188680555555556</c:v>
                </c:pt>
                <c:pt idx="1037">
                  <c:v>3.0203958333333332</c:v>
                </c:pt>
                <c:pt idx="1038">
                  <c:v>3.0219236111111107</c:v>
                </c:pt>
                <c:pt idx="1039">
                  <c:v>3.0234513888888892</c:v>
                </c:pt>
                <c:pt idx="1040">
                  <c:v>3.0249791666666668</c:v>
                </c:pt>
                <c:pt idx="1041">
                  <c:v>3.0265069444444443</c:v>
                </c:pt>
                <c:pt idx="1042">
                  <c:v>3.0280347222222224</c:v>
                </c:pt>
                <c:pt idx="1043">
                  <c:v>3.0295624999999999</c:v>
                </c:pt>
                <c:pt idx="1044">
                  <c:v>3.031090277777778</c:v>
                </c:pt>
                <c:pt idx="1045">
                  <c:v>3.0326180555555555</c:v>
                </c:pt>
                <c:pt idx="1046">
                  <c:v>3.0341458333333335</c:v>
                </c:pt>
                <c:pt idx="1047">
                  <c:v>3.0356736111111111</c:v>
                </c:pt>
                <c:pt idx="1048">
                  <c:v>3.0369444444444444</c:v>
                </c:pt>
                <c:pt idx="1049">
                  <c:v>3.0382152777777778</c:v>
                </c:pt>
                <c:pt idx="1050">
                  <c:v>3.0394791666666667</c:v>
                </c:pt>
                <c:pt idx="1051">
                  <c:v>3.0407500000000001</c:v>
                </c:pt>
                <c:pt idx="1052">
                  <c:v>3.0420208333333334</c:v>
                </c:pt>
                <c:pt idx="1053">
                  <c:v>3.0432916666666667</c:v>
                </c:pt>
                <c:pt idx="1054">
                  <c:v>3.0442847222222227</c:v>
                </c:pt>
                <c:pt idx="1055">
                  <c:v>3.0452777777777778</c:v>
                </c:pt>
                <c:pt idx="1056">
                  <c:v>3.0460972222222225</c:v>
                </c:pt>
                <c:pt idx="1057">
                  <c:v>3.0469166666666672</c:v>
                </c:pt>
                <c:pt idx="1058">
                  <c:v>3.0477430555555554</c:v>
                </c:pt>
                <c:pt idx="1059">
                  <c:v>3.0484236111111107</c:v>
                </c:pt>
                <c:pt idx="1060">
                  <c:v>3.0490972222222221</c:v>
                </c:pt>
                <c:pt idx="1061">
                  <c:v>3.049236111111111</c:v>
                </c:pt>
                <c:pt idx="1062">
                  <c:v>3.0493750000000004</c:v>
                </c:pt>
                <c:pt idx="1063">
                  <c:v>3.0495069444444445</c:v>
                </c:pt>
                <c:pt idx="1064">
                  <c:v>3.0496458333333334</c:v>
                </c:pt>
                <c:pt idx="1065">
                  <c:v>3.0497777777777779</c:v>
                </c:pt>
                <c:pt idx="1066">
                  <c:v>3.050013888888889</c:v>
                </c:pt>
                <c:pt idx="1067">
                  <c:v>3.0502499999999997</c:v>
                </c:pt>
                <c:pt idx="1068">
                  <c:v>3.0504791666666664</c:v>
                </c:pt>
                <c:pt idx="1069">
                  <c:v>3.0507152777777775</c:v>
                </c:pt>
                <c:pt idx="1070">
                  <c:v>3.0509513888888886</c:v>
                </c:pt>
                <c:pt idx="1071">
                  <c:v>3.0514374999999996</c:v>
                </c:pt>
                <c:pt idx="1072">
                  <c:v>3.0519236111111114</c:v>
                </c:pt>
                <c:pt idx="1073">
                  <c:v>3.0524097222222224</c:v>
                </c:pt>
                <c:pt idx="1074">
                  <c:v>3.0529027777777782</c:v>
                </c:pt>
                <c:pt idx="1075">
                  <c:v>3.0533888888888892</c:v>
                </c:pt>
                <c:pt idx="1076">
                  <c:v>3.0540625000000001</c:v>
                </c:pt>
                <c:pt idx="1077">
                  <c:v>3.0547361111111111</c:v>
                </c:pt>
                <c:pt idx="1078">
                  <c:v>3.0554166666666669</c:v>
                </c:pt>
                <c:pt idx="1079">
                  <c:v>3.0560902777777779</c:v>
                </c:pt>
                <c:pt idx="1080">
                  <c:v>3.0567638888888888</c:v>
                </c:pt>
                <c:pt idx="1081">
                  <c:v>3.057722222222222</c:v>
                </c:pt>
                <c:pt idx="1082">
                  <c:v>3.0584652777777777</c:v>
                </c:pt>
                <c:pt idx="1083">
                  <c:v>3.058583333333333</c:v>
                </c:pt>
                <c:pt idx="1084">
                  <c:v>3.0587083333333331</c:v>
                </c:pt>
                <c:pt idx="1085">
                  <c:v>3.0588263888888889</c:v>
                </c:pt>
                <c:pt idx="1086">
                  <c:v>3.0589444444444447</c:v>
                </c:pt>
                <c:pt idx="1087">
                  <c:v>3.0590694444444448</c:v>
                </c:pt>
                <c:pt idx="1088">
                  <c:v>3.0592499999999996</c:v>
                </c:pt>
                <c:pt idx="1089">
                  <c:v>3.0594305555555557</c:v>
                </c:pt>
                <c:pt idx="1090">
                  <c:v>3.0596111111111113</c:v>
                </c:pt>
                <c:pt idx="1091">
                  <c:v>3.0597986111111108</c:v>
                </c:pt>
                <c:pt idx="1092">
                  <c:v>3.060138888888889</c:v>
                </c:pt>
                <c:pt idx="1093">
                  <c:v>3.0604722222222223</c:v>
                </c:pt>
                <c:pt idx="1094">
                  <c:v>3.0608124999999999</c:v>
                </c:pt>
                <c:pt idx="1095">
                  <c:v>3.0611527777777781</c:v>
                </c:pt>
                <c:pt idx="1096">
                  <c:v>3.0616319444444446</c:v>
                </c:pt>
                <c:pt idx="1097">
                  <c:v>3.0621180555555556</c:v>
                </c:pt>
                <c:pt idx="1098">
                  <c:v>3.0626041666666666</c:v>
                </c:pt>
                <c:pt idx="1099">
                  <c:v>3.0630833333333336</c:v>
                </c:pt>
                <c:pt idx="1100">
                  <c:v>3.0635694444444446</c:v>
                </c:pt>
                <c:pt idx="1101">
                  <c:v>3.064111111111111</c:v>
                </c:pt>
                <c:pt idx="1102">
                  <c:v>3.0646527777777779</c:v>
                </c:pt>
                <c:pt idx="1103">
                  <c:v>3.0652013888888892</c:v>
                </c:pt>
                <c:pt idx="1104">
                  <c:v>3.0657430555555556</c:v>
                </c:pt>
                <c:pt idx="1105">
                  <c:v>3.066284722222222</c:v>
                </c:pt>
                <c:pt idx="1106">
                  <c:v>3.0669444444444443</c:v>
                </c:pt>
                <c:pt idx="1107">
                  <c:v>3.0676041666666669</c:v>
                </c:pt>
                <c:pt idx="1108">
                  <c:v>3.0682638888888891</c:v>
                </c:pt>
                <c:pt idx="1109">
                  <c:v>3.0689236111111109</c:v>
                </c:pt>
                <c:pt idx="1110">
                  <c:v>3.0695833333333331</c:v>
                </c:pt>
                <c:pt idx="1111">
                  <c:v>3.0701180555555556</c:v>
                </c:pt>
                <c:pt idx="1112">
                  <c:v>3.0706458333333329</c:v>
                </c:pt>
                <c:pt idx="1113">
                  <c:v>3.0711805555555554</c:v>
                </c:pt>
                <c:pt idx="1114">
                  <c:v>3.0712638888888888</c:v>
                </c:pt>
                <c:pt idx="1115">
                  <c:v>3.0713472222222222</c:v>
                </c:pt>
                <c:pt idx="1116">
                  <c:v>3.0714236111111113</c:v>
                </c:pt>
                <c:pt idx="1117">
                  <c:v>3.0715069444444447</c:v>
                </c:pt>
                <c:pt idx="1118">
                  <c:v>3.0715902777777777</c:v>
                </c:pt>
                <c:pt idx="1119">
                  <c:v>3.0717499999999998</c:v>
                </c:pt>
                <c:pt idx="1120">
                  <c:v>3.0719166666666671</c:v>
                </c:pt>
                <c:pt idx="1121">
                  <c:v>3.0720763888888887</c:v>
                </c:pt>
                <c:pt idx="1122">
                  <c:v>3.0722430555555555</c:v>
                </c:pt>
                <c:pt idx="1123">
                  <c:v>3.0725208333333334</c:v>
                </c:pt>
                <c:pt idx="1124">
                  <c:v>3.0728055555555556</c:v>
                </c:pt>
                <c:pt idx="1125">
                  <c:v>3.0730833333333334</c:v>
                </c:pt>
                <c:pt idx="1126">
                  <c:v>3.0733680555555551</c:v>
                </c:pt>
                <c:pt idx="1127">
                  <c:v>3.07375</c:v>
                </c:pt>
                <c:pt idx="1128">
                  <c:v>3.074125</c:v>
                </c:pt>
                <c:pt idx="1129">
                  <c:v>3.0745069444444444</c:v>
                </c:pt>
                <c:pt idx="1130">
                  <c:v>3.0748819444444444</c:v>
                </c:pt>
                <c:pt idx="1131">
                  <c:v>3.0752638888888888</c:v>
                </c:pt>
                <c:pt idx="1132">
                  <c:v>3.0757291666666666</c:v>
                </c:pt>
                <c:pt idx="1133">
                  <c:v>3.0761111111111115</c:v>
                </c:pt>
                <c:pt idx="1134">
                  <c:v>3.0764930555555554</c:v>
                </c:pt>
                <c:pt idx="1135">
                  <c:v>3.0768749999999998</c:v>
                </c:pt>
                <c:pt idx="1136">
                  <c:v>3.077263888888889</c:v>
                </c:pt>
                <c:pt idx="1137">
                  <c:v>3.0776458333333334</c:v>
                </c:pt>
                <c:pt idx="1138">
                  <c:v>3.0780277777777774</c:v>
                </c:pt>
                <c:pt idx="1139">
                  <c:v>3.0783472222222219</c:v>
                </c:pt>
                <c:pt idx="1140">
                  <c:v>3.0786666666666664</c:v>
                </c:pt>
                <c:pt idx="1141">
                  <c:v>3.0789236111111107</c:v>
                </c:pt>
                <c:pt idx="1142">
                  <c:v>3.0791874999999997</c:v>
                </c:pt>
                <c:pt idx="1143">
                  <c:v>3.0794513888888888</c:v>
                </c:pt>
                <c:pt idx="1144">
                  <c:v>3.079708333333333</c:v>
                </c:pt>
                <c:pt idx="1145">
                  <c:v>3.0797569444444446</c:v>
                </c:pt>
                <c:pt idx="1146">
                  <c:v>3.0797986111111109</c:v>
                </c:pt>
                <c:pt idx="1147">
                  <c:v>3.079840277777778</c:v>
                </c:pt>
                <c:pt idx="1148">
                  <c:v>3.0798819444444443</c:v>
                </c:pt>
                <c:pt idx="1149">
                  <c:v>3.0799583333333334</c:v>
                </c:pt>
                <c:pt idx="1150">
                  <c:v>3.0800416666666668</c:v>
                </c:pt>
                <c:pt idx="1151">
                  <c:v>3.0801180555555554</c:v>
                </c:pt>
                <c:pt idx="1152">
                  <c:v>3.080194444444444</c:v>
                </c:pt>
                <c:pt idx="1153">
                  <c:v>3.0804791666666671</c:v>
                </c:pt>
                <c:pt idx="1154">
                  <c:v>3.0807638888888889</c:v>
                </c:pt>
                <c:pt idx="1155">
                  <c:v>3.0810416666666667</c:v>
                </c:pt>
                <c:pt idx="1156">
                  <c:v>3.0813263888888889</c:v>
                </c:pt>
                <c:pt idx="1157">
                  <c:v>3.0816736111111109</c:v>
                </c:pt>
                <c:pt idx="1158">
                  <c:v>3.0820277777777778</c:v>
                </c:pt>
                <c:pt idx="1159">
                  <c:v>3.0823749999999999</c:v>
                </c:pt>
                <c:pt idx="1160">
                  <c:v>3.0827291666666667</c:v>
                </c:pt>
                <c:pt idx="1161">
                  <c:v>3.0830763888888888</c:v>
                </c:pt>
                <c:pt idx="1162">
                  <c:v>3.0834722222222219</c:v>
                </c:pt>
                <c:pt idx="1163">
                  <c:v>3.083868055555556</c:v>
                </c:pt>
                <c:pt idx="1164">
                  <c:v>3.0841736111111113</c:v>
                </c:pt>
                <c:pt idx="1165">
                  <c:v>3.0844097222222224</c:v>
                </c:pt>
                <c:pt idx="1166">
                  <c:v>3.0846388888888892</c:v>
                </c:pt>
                <c:pt idx="1167">
                  <c:v>3.0846736111111115</c:v>
                </c:pt>
                <c:pt idx="1168">
                  <c:v>3.0847083333333329</c:v>
                </c:pt>
                <c:pt idx="1169">
                  <c:v>3.0847430555555553</c:v>
                </c:pt>
                <c:pt idx="1170">
                  <c:v>3.0847777777777776</c:v>
                </c:pt>
                <c:pt idx="1171">
                  <c:v>3.0848472222222223</c:v>
                </c:pt>
                <c:pt idx="1172">
                  <c:v>3.0849166666666665</c:v>
                </c:pt>
                <c:pt idx="1173">
                  <c:v>3.0849861111111112</c:v>
                </c:pt>
                <c:pt idx="1174">
                  <c:v>3.0850486111111115</c:v>
                </c:pt>
                <c:pt idx="1175">
                  <c:v>3.0852013888888887</c:v>
                </c:pt>
                <c:pt idx="1176">
                  <c:v>3.0853541666666664</c:v>
                </c:pt>
                <c:pt idx="1177">
                  <c:v>3.0855069444444445</c:v>
                </c:pt>
                <c:pt idx="1178">
                  <c:v>3.0856527777777778</c:v>
                </c:pt>
                <c:pt idx="1179">
                  <c:v>3.0859583333333331</c:v>
                </c:pt>
                <c:pt idx="1180">
                  <c:v>3.0862638888888889</c:v>
                </c:pt>
                <c:pt idx="1181">
                  <c:v>3.0865694444444443</c:v>
                </c:pt>
                <c:pt idx="1182">
                  <c:v>3.086875</c:v>
                </c:pt>
                <c:pt idx="1183">
                  <c:v>3.0871805555555554</c:v>
                </c:pt>
                <c:pt idx="1184">
                  <c:v>3.0875833333333333</c:v>
                </c:pt>
                <c:pt idx="1185">
                  <c:v>3.0879930555555557</c:v>
                </c:pt>
                <c:pt idx="1186">
                  <c:v>3.0883958333333332</c:v>
                </c:pt>
                <c:pt idx="1187">
                  <c:v>3.0887986111111112</c:v>
                </c:pt>
                <c:pt idx="1188">
                  <c:v>3.0892013888888887</c:v>
                </c:pt>
                <c:pt idx="1189">
                  <c:v>3.08975</c:v>
                </c:pt>
                <c:pt idx="1190">
                  <c:v>3.0902986111111108</c:v>
                </c:pt>
                <c:pt idx="1191">
                  <c:v>3.0908472222222221</c:v>
                </c:pt>
                <c:pt idx="1192">
                  <c:v>3.0913958333333329</c:v>
                </c:pt>
                <c:pt idx="1193">
                  <c:v>3.0919444444444442</c:v>
                </c:pt>
                <c:pt idx="1194">
                  <c:v>3.0924930555555554</c:v>
                </c:pt>
                <c:pt idx="1195">
                  <c:v>3.0930416666666662</c:v>
                </c:pt>
                <c:pt idx="1196">
                  <c:v>3.093590277777778</c:v>
                </c:pt>
                <c:pt idx="1197">
                  <c:v>3.0940416666666666</c:v>
                </c:pt>
                <c:pt idx="1198">
                  <c:v>3.0941111111111113</c:v>
                </c:pt>
                <c:pt idx="1199">
                  <c:v>3.0941805555555555</c:v>
                </c:pt>
                <c:pt idx="1200">
                  <c:v>3.0942500000000002</c:v>
                </c:pt>
                <c:pt idx="1201">
                  <c:v>3.0943194444444444</c:v>
                </c:pt>
                <c:pt idx="1202">
                  <c:v>3.0943888888888891</c:v>
                </c:pt>
                <c:pt idx="1203">
                  <c:v>3.0945277777777775</c:v>
                </c:pt>
                <c:pt idx="1204">
                  <c:v>3.0946666666666665</c:v>
                </c:pt>
                <c:pt idx="1205">
                  <c:v>3.0948055555555558</c:v>
                </c:pt>
                <c:pt idx="1206">
                  <c:v>3.0949444444444447</c:v>
                </c:pt>
                <c:pt idx="1207">
                  <c:v>3.0951944444444446</c:v>
                </c:pt>
                <c:pt idx="1208">
                  <c:v>3.0954375000000001</c:v>
                </c:pt>
                <c:pt idx="1209">
                  <c:v>3.0956874999999999</c:v>
                </c:pt>
                <c:pt idx="1210">
                  <c:v>3.0959374999999998</c:v>
                </c:pt>
                <c:pt idx="1211">
                  <c:v>3.0961805555555557</c:v>
                </c:pt>
                <c:pt idx="1212">
                  <c:v>3.096541666666667</c:v>
                </c:pt>
                <c:pt idx="1213">
                  <c:v>3.096895833333333</c:v>
                </c:pt>
                <c:pt idx="1214">
                  <c:v>3.0972499999999998</c:v>
                </c:pt>
                <c:pt idx="1215">
                  <c:v>3.0976111111111115</c:v>
                </c:pt>
                <c:pt idx="1216">
                  <c:v>3.0979652777777775</c:v>
                </c:pt>
                <c:pt idx="1217">
                  <c:v>3.0984791666666669</c:v>
                </c:pt>
                <c:pt idx="1218">
                  <c:v>3.0989930555555558</c:v>
                </c:pt>
                <c:pt idx="1219">
                  <c:v>3.0995069444444443</c:v>
                </c:pt>
                <c:pt idx="1220">
                  <c:v>3.1000138888888893</c:v>
                </c:pt>
                <c:pt idx="1221">
                  <c:v>3.1005277777777778</c:v>
                </c:pt>
                <c:pt idx="1222">
                  <c:v>3.1010416666666667</c:v>
                </c:pt>
                <c:pt idx="1223">
                  <c:v>3.1017083333333333</c:v>
                </c:pt>
                <c:pt idx="1224">
                  <c:v>3.1023680555555555</c:v>
                </c:pt>
                <c:pt idx="1225">
                  <c:v>3.1030277777777777</c:v>
                </c:pt>
                <c:pt idx="1226">
                  <c:v>3.1035694444444446</c:v>
                </c:pt>
                <c:pt idx="1227">
                  <c:v>3.104111111111111</c:v>
                </c:pt>
                <c:pt idx="1228">
                  <c:v>3.1045486111111114</c:v>
                </c:pt>
                <c:pt idx="1229">
                  <c:v>3.1049791666666668</c:v>
                </c:pt>
                <c:pt idx="1230">
                  <c:v>3.105347222222222</c:v>
                </c:pt>
                <c:pt idx="1231">
                  <c:v>3.1057222222222221</c:v>
                </c:pt>
                <c:pt idx="1232">
                  <c:v>3.1057777777777775</c:v>
                </c:pt>
                <c:pt idx="1233">
                  <c:v>3.1057916666666667</c:v>
                </c:pt>
                <c:pt idx="1234">
                  <c:v>3.1057986111111116</c:v>
                </c:pt>
                <c:pt idx="1235">
                  <c:v>3.1058124999999999</c:v>
                </c:pt>
                <c:pt idx="1236">
                  <c:v>3.1058194444444447</c:v>
                </c:pt>
                <c:pt idx="1237">
                  <c:v>3.1058402777777778</c:v>
                </c:pt>
                <c:pt idx="1238">
                  <c:v>3.105861111111111</c:v>
                </c:pt>
                <c:pt idx="1239">
                  <c:v>3.1058819444444445</c:v>
                </c:pt>
                <c:pt idx="1240">
                  <c:v>3.1059097222222225</c:v>
                </c:pt>
                <c:pt idx="1241">
                  <c:v>3.1059722222222224</c:v>
                </c:pt>
                <c:pt idx="1242">
                  <c:v>3.1060416666666666</c:v>
                </c:pt>
                <c:pt idx="1243">
                  <c:v>3.1061111111111113</c:v>
                </c:pt>
                <c:pt idx="1244">
                  <c:v>3.1062152777777778</c:v>
                </c:pt>
                <c:pt idx="1245">
                  <c:v>3.1063125</c:v>
                </c:pt>
                <c:pt idx="1246">
                  <c:v>3.1064166666666666</c:v>
                </c:pt>
                <c:pt idx="1247">
                  <c:v>3.1065208333333336</c:v>
                </c:pt>
                <c:pt idx="1248">
                  <c:v>3.1066597222222225</c:v>
                </c:pt>
                <c:pt idx="1249">
                  <c:v>3.1068055555555558</c:v>
                </c:pt>
                <c:pt idx="1250">
                  <c:v>3.1069513888888891</c:v>
                </c:pt>
                <c:pt idx="1251">
                  <c:v>3.1070972222222224</c:v>
                </c:pt>
                <c:pt idx="1252">
                  <c:v>3.107388888888889</c:v>
                </c:pt>
                <c:pt idx="1253">
                  <c:v>3.107680555555556</c:v>
                </c:pt>
                <c:pt idx="1254">
                  <c:v>3.1079722222222221</c:v>
                </c:pt>
                <c:pt idx="1255">
                  <c:v>3.1082638888888887</c:v>
                </c:pt>
                <c:pt idx="1256">
                  <c:v>3.1085555555555553</c:v>
                </c:pt>
                <c:pt idx="1257">
                  <c:v>3.1089444444444445</c:v>
                </c:pt>
                <c:pt idx="1258">
                  <c:v>3.1093263888888889</c:v>
                </c:pt>
                <c:pt idx="1259">
                  <c:v>3.1097152777777777</c:v>
                </c:pt>
                <c:pt idx="1260">
                  <c:v>3.1101041666666669</c:v>
                </c:pt>
                <c:pt idx="1261">
                  <c:v>3.1104861111111113</c:v>
                </c:pt>
                <c:pt idx="1262">
                  <c:v>3.1110416666666665</c:v>
                </c:pt>
                <c:pt idx="1263">
                  <c:v>3.1115902777777773</c:v>
                </c:pt>
                <c:pt idx="1264">
                  <c:v>3.1121388888888886</c:v>
                </c:pt>
                <c:pt idx="1265">
                  <c:v>3.1126944444444442</c:v>
                </c:pt>
                <c:pt idx="1266">
                  <c:v>3.1132430555555555</c:v>
                </c:pt>
                <c:pt idx="1267">
                  <c:v>3.1137986111111111</c:v>
                </c:pt>
                <c:pt idx="1268">
                  <c:v>3.114527777777778</c:v>
                </c:pt>
                <c:pt idx="1269">
                  <c:v>3.1152569444444445</c:v>
                </c:pt>
                <c:pt idx="1270">
                  <c:v>3.1159861111111113</c:v>
                </c:pt>
                <c:pt idx="1271">
                  <c:v>3.1167152777777778</c:v>
                </c:pt>
                <c:pt idx="1272">
                  <c:v>3.1174513888888891</c:v>
                </c:pt>
                <c:pt idx="1273">
                  <c:v>3.118180555555556</c:v>
                </c:pt>
                <c:pt idx="1274">
                  <c:v>3.118909722222222</c:v>
                </c:pt>
                <c:pt idx="1275">
                  <c:v>3.1196388888888889</c:v>
                </c:pt>
                <c:pt idx="1276">
                  <c:v>3.1203750000000001</c:v>
                </c:pt>
                <c:pt idx="1277">
                  <c:v>3.121104166666667</c:v>
                </c:pt>
                <c:pt idx="1278">
                  <c:v>3.121833333333333</c:v>
                </c:pt>
                <c:pt idx="1279">
                  <c:v>3.1225624999999999</c:v>
                </c:pt>
                <c:pt idx="1280">
                  <c:v>3.1232986111111112</c:v>
                </c:pt>
                <c:pt idx="1281">
                  <c:v>3.1240277777777781</c:v>
                </c:pt>
                <c:pt idx="1282">
                  <c:v>3.1247569444444441</c:v>
                </c:pt>
                <c:pt idx="1283">
                  <c:v>3.125486111111111</c:v>
                </c:pt>
                <c:pt idx="1284">
                  <c:v>3.1262152777777779</c:v>
                </c:pt>
                <c:pt idx="1285">
                  <c:v>3.1269513888888891</c:v>
                </c:pt>
                <c:pt idx="1286">
                  <c:v>3.1276805555555551</c:v>
                </c:pt>
                <c:pt idx="1287">
                  <c:v>3.128409722222222</c:v>
                </c:pt>
                <c:pt idx="1288">
                  <c:v>3.1291388888888889</c:v>
                </c:pt>
                <c:pt idx="1289">
                  <c:v>3.1299513888888888</c:v>
                </c:pt>
                <c:pt idx="1290">
                  <c:v>3.1307569444444443</c:v>
                </c:pt>
                <c:pt idx="1291">
                  <c:v>3.1315694444444446</c:v>
                </c:pt>
                <c:pt idx="1292">
                  <c:v>3.1323750000000001</c:v>
                </c:pt>
                <c:pt idx="1293">
                  <c:v>3.1331875</c:v>
                </c:pt>
                <c:pt idx="1294">
                  <c:v>3.1339930555555555</c:v>
                </c:pt>
                <c:pt idx="1295">
                  <c:v>3.1346666666666669</c:v>
                </c:pt>
                <c:pt idx="1296">
                  <c:v>3.1353402777777779</c:v>
                </c:pt>
                <c:pt idx="1297">
                  <c:v>3.1360138888888889</c:v>
                </c:pt>
                <c:pt idx="1298">
                  <c:v>3.1366874999999999</c:v>
                </c:pt>
                <c:pt idx="1299">
                  <c:v>3.1372361111111111</c:v>
                </c:pt>
                <c:pt idx="1300">
                  <c:v>3.1377847222222219</c:v>
                </c:pt>
                <c:pt idx="1301">
                  <c:v>3.1383333333333332</c:v>
                </c:pt>
                <c:pt idx="1302">
                  <c:v>3.1388819444444445</c:v>
                </c:pt>
                <c:pt idx="1303">
                  <c:v>3.1394236111111113</c:v>
                </c:pt>
                <c:pt idx="1304">
                  <c:v>3.1399722222222226</c:v>
                </c:pt>
                <c:pt idx="1305">
                  <c:v>3.1405208333333334</c:v>
                </c:pt>
                <c:pt idx="1306">
                  <c:v>3.1410694444444447</c:v>
                </c:pt>
                <c:pt idx="1307">
                  <c:v>3.1417083333333338</c:v>
                </c:pt>
                <c:pt idx="1308">
                  <c:v>3.142347222222222</c:v>
                </c:pt>
                <c:pt idx="1309">
                  <c:v>3.142986111111111</c:v>
                </c:pt>
                <c:pt idx="1310">
                  <c:v>3.1436249999999997</c:v>
                </c:pt>
                <c:pt idx="1311">
                  <c:v>3.1442638888888887</c:v>
                </c:pt>
                <c:pt idx="1312">
                  <c:v>3.1449027777777778</c:v>
                </c:pt>
                <c:pt idx="1313">
                  <c:v>3.1455416666666665</c:v>
                </c:pt>
                <c:pt idx="1314">
                  <c:v>3.1461805555555555</c:v>
                </c:pt>
                <c:pt idx="1315">
                  <c:v>3.1470625000000001</c:v>
                </c:pt>
                <c:pt idx="1316">
                  <c:v>3.1479374999999998</c:v>
                </c:pt>
                <c:pt idx="1317">
                  <c:v>3.1488125</c:v>
                </c:pt>
                <c:pt idx="1318">
                  <c:v>3.1496944444444446</c:v>
                </c:pt>
                <c:pt idx="1319">
                  <c:v>3.1498194444444443</c:v>
                </c:pt>
                <c:pt idx="1320">
                  <c:v>3.1499513888888893</c:v>
                </c:pt>
                <c:pt idx="1321">
                  <c:v>3.1500763888888885</c:v>
                </c:pt>
                <c:pt idx="1322">
                  <c:v>3.1502083333333335</c:v>
                </c:pt>
                <c:pt idx="1323">
                  <c:v>3.1503333333333332</c:v>
                </c:pt>
                <c:pt idx="1324">
                  <c:v>3.1505347222222224</c:v>
                </c:pt>
                <c:pt idx="1325">
                  <c:v>3.1507291666666668</c:v>
                </c:pt>
                <c:pt idx="1326">
                  <c:v>3.1509236111111112</c:v>
                </c:pt>
                <c:pt idx="1327">
                  <c:v>3.151125</c:v>
                </c:pt>
                <c:pt idx="1328">
                  <c:v>3.1515208333333331</c:v>
                </c:pt>
                <c:pt idx="1329">
                  <c:v>3.1519166666666667</c:v>
                </c:pt>
                <c:pt idx="1330">
                  <c:v>3.1523124999999999</c:v>
                </c:pt>
                <c:pt idx="1331">
                  <c:v>3.152708333333333</c:v>
                </c:pt>
                <c:pt idx="1332">
                  <c:v>3.1528472222222224</c:v>
                </c:pt>
                <c:pt idx="1333">
                  <c:v>3.1529791666666664</c:v>
                </c:pt>
                <c:pt idx="1334">
                  <c:v>3.1531180555555554</c:v>
                </c:pt>
                <c:pt idx="1335">
                  <c:v>3.1532500000000003</c:v>
                </c:pt>
                <c:pt idx="1336">
                  <c:v>3.1533888888888888</c:v>
                </c:pt>
                <c:pt idx="1337">
                  <c:v>3.1536597222222227</c:v>
                </c:pt>
                <c:pt idx="1338">
                  <c:v>3.1539305555555552</c:v>
                </c:pt>
                <c:pt idx="1339">
                  <c:v>3.1542013888888891</c:v>
                </c:pt>
                <c:pt idx="1340">
                  <c:v>3.1544722222222221</c:v>
                </c:pt>
                <c:pt idx="1341">
                  <c:v>3.1550833333333332</c:v>
                </c:pt>
                <c:pt idx="1342">
                  <c:v>3.1556944444444444</c:v>
                </c:pt>
                <c:pt idx="1343">
                  <c:v>3.1563055555555555</c:v>
                </c:pt>
                <c:pt idx="1344">
                  <c:v>3.1569236111111114</c:v>
                </c:pt>
                <c:pt idx="1345">
                  <c:v>3.1575347222222225</c:v>
                </c:pt>
                <c:pt idx="1346">
                  <c:v>3.158236111111111</c:v>
                </c:pt>
                <c:pt idx="1347">
                  <c:v>3.1589375</c:v>
                </c:pt>
                <c:pt idx="1348">
                  <c:v>3.1596319444444445</c:v>
                </c:pt>
                <c:pt idx="1349">
                  <c:v>3.1603333333333334</c:v>
                </c:pt>
                <c:pt idx="1350">
                  <c:v>3.1610347222222224</c:v>
                </c:pt>
                <c:pt idx="1351">
                  <c:v>3.1619513888888888</c:v>
                </c:pt>
                <c:pt idx="1352">
                  <c:v>3.1628611111111113</c:v>
                </c:pt>
                <c:pt idx="1353">
                  <c:v>3.1637777777777778</c:v>
                </c:pt>
                <c:pt idx="1354">
                  <c:v>3.1646944444444443</c:v>
                </c:pt>
                <c:pt idx="1355">
                  <c:v>3.1656041666666668</c:v>
                </c:pt>
                <c:pt idx="1356">
                  <c:v>3.1665208333333332</c:v>
                </c:pt>
                <c:pt idx="1357">
                  <c:v>3.1677986111111114</c:v>
                </c:pt>
                <c:pt idx="1358">
                  <c:v>3.169083333333333</c:v>
                </c:pt>
                <c:pt idx="1359">
                  <c:v>3.1703611111111107</c:v>
                </c:pt>
                <c:pt idx="1360">
                  <c:v>3.1716388888888889</c:v>
                </c:pt>
                <c:pt idx="1361">
                  <c:v>3.1729166666666666</c:v>
                </c:pt>
                <c:pt idx="1362">
                  <c:v>3.1742013888888891</c:v>
                </c:pt>
                <c:pt idx="1363">
                  <c:v>3.1756527777777777</c:v>
                </c:pt>
                <c:pt idx="1364">
                  <c:v>3.1770972222222227</c:v>
                </c:pt>
                <c:pt idx="1365">
                  <c:v>3.1785486111111108</c:v>
                </c:pt>
                <c:pt idx="1366">
                  <c:v>3.1799999999999997</c:v>
                </c:pt>
                <c:pt idx="1367">
                  <c:v>3.1814513888888887</c:v>
                </c:pt>
                <c:pt idx="1368">
                  <c:v>3.1828958333333333</c:v>
                </c:pt>
                <c:pt idx="1369">
                  <c:v>3.1843472222222222</c:v>
                </c:pt>
                <c:pt idx="1370">
                  <c:v>3.1857986111111112</c:v>
                </c:pt>
                <c:pt idx="1371">
                  <c:v>3.1872500000000001</c:v>
                </c:pt>
                <c:pt idx="1372">
                  <c:v>3.1886944444444447</c:v>
                </c:pt>
                <c:pt idx="1373">
                  <c:v>3.1901458333333337</c:v>
                </c:pt>
                <c:pt idx="1374">
                  <c:v>3.1915972222222218</c:v>
                </c:pt>
                <c:pt idx="1375">
                  <c:v>3.1930416666666663</c:v>
                </c:pt>
                <c:pt idx="1376">
                  <c:v>3.1944930555555553</c:v>
                </c:pt>
                <c:pt idx="1377">
                  <c:v>3.1955972222222222</c:v>
                </c:pt>
                <c:pt idx="1378">
                  <c:v>3.1957708333333334</c:v>
                </c:pt>
                <c:pt idx="1379">
                  <c:v>3.1959374999999999</c:v>
                </c:pt>
                <c:pt idx="1380">
                  <c:v>3.1961041666666667</c:v>
                </c:pt>
                <c:pt idx="1381">
                  <c:v>3.196277777777778</c:v>
                </c:pt>
                <c:pt idx="1382">
                  <c:v>3.1964444444444444</c:v>
                </c:pt>
                <c:pt idx="1383">
                  <c:v>3.1967569444444446</c:v>
                </c:pt>
                <c:pt idx="1384">
                  <c:v>3.1970625000000004</c:v>
                </c:pt>
                <c:pt idx="1385">
                  <c:v>3.1973750000000001</c:v>
                </c:pt>
                <c:pt idx="1386">
                  <c:v>3.1976805555555554</c:v>
                </c:pt>
                <c:pt idx="1387">
                  <c:v>3.1984097222222223</c:v>
                </c:pt>
                <c:pt idx="1388">
                  <c:v>3.1991388888888892</c:v>
                </c:pt>
                <c:pt idx="1389">
                  <c:v>3.1998611111111113</c:v>
                </c:pt>
                <c:pt idx="1390">
                  <c:v>3.2005902777777782</c:v>
                </c:pt>
                <c:pt idx="1391">
                  <c:v>3.2008472222222224</c:v>
                </c:pt>
                <c:pt idx="1392">
                  <c:v>3.2011041666666666</c:v>
                </c:pt>
                <c:pt idx="1393">
                  <c:v>3.2013541666666665</c:v>
                </c:pt>
                <c:pt idx="1394">
                  <c:v>3.2016111111111107</c:v>
                </c:pt>
                <c:pt idx="1395">
                  <c:v>3.2018680555555554</c:v>
                </c:pt>
                <c:pt idx="1396">
                  <c:v>3.202375</c:v>
                </c:pt>
                <c:pt idx="1397">
                  <c:v>3.2028888888888889</c:v>
                </c:pt>
                <c:pt idx="1398">
                  <c:v>3.2033958333333334</c:v>
                </c:pt>
                <c:pt idx="1399">
                  <c:v>3.2039097222222224</c:v>
                </c:pt>
                <c:pt idx="1400">
                  <c:v>3.2050624999999999</c:v>
                </c:pt>
                <c:pt idx="1401">
                  <c:v>3.2062152777777775</c:v>
                </c:pt>
                <c:pt idx="1402">
                  <c:v>3.2073680555555555</c:v>
                </c:pt>
                <c:pt idx="1403">
                  <c:v>3.2085208333333335</c:v>
                </c:pt>
                <c:pt idx="1404">
                  <c:v>3.2096736111111115</c:v>
                </c:pt>
                <c:pt idx="1405">
                  <c:v>3.2109583333333331</c:v>
                </c:pt>
                <c:pt idx="1406">
                  <c:v>3.21225</c:v>
                </c:pt>
                <c:pt idx="1407">
                  <c:v>3.2135416666666665</c:v>
                </c:pt>
                <c:pt idx="1408">
                  <c:v>3.214833333333333</c:v>
                </c:pt>
                <c:pt idx="1409">
                  <c:v>3.2161180555555555</c:v>
                </c:pt>
                <c:pt idx="1410">
                  <c:v>3.2179097222222222</c:v>
                </c:pt>
                <c:pt idx="1411">
                  <c:v>3.2197013888888888</c:v>
                </c:pt>
                <c:pt idx="1412">
                  <c:v>3.2214861111111111</c:v>
                </c:pt>
                <c:pt idx="1413">
                  <c:v>3.2232777777777781</c:v>
                </c:pt>
                <c:pt idx="1414">
                  <c:v>3.2250624999999999</c:v>
                </c:pt>
                <c:pt idx="1415">
                  <c:v>3.2268541666666666</c:v>
                </c:pt>
                <c:pt idx="1416">
                  <c:v>3.2294791666666667</c:v>
                </c:pt>
                <c:pt idx="1417">
                  <c:v>3.2321111111111112</c:v>
                </c:pt>
                <c:pt idx="1418">
                  <c:v>3.2347430555555552</c:v>
                </c:pt>
                <c:pt idx="1419">
                  <c:v>3.2373680555555557</c:v>
                </c:pt>
                <c:pt idx="1420">
                  <c:v>3.24</c:v>
                </c:pt>
                <c:pt idx="1421">
                  <c:v>3.2426319444444447</c:v>
                </c:pt>
                <c:pt idx="1422">
                  <c:v>3.2455763888888889</c:v>
                </c:pt>
                <c:pt idx="1423">
                  <c:v>3.2485208333333331</c:v>
                </c:pt>
                <c:pt idx="1424">
                  <c:v>3.2514652777777777</c:v>
                </c:pt>
                <c:pt idx="1425">
                  <c:v>3.2544097222222224</c:v>
                </c:pt>
                <c:pt idx="1426">
                  <c:v>3.2573541666666666</c:v>
                </c:pt>
                <c:pt idx="1427">
                  <c:v>3.2603055555555556</c:v>
                </c:pt>
                <c:pt idx="1428">
                  <c:v>3.2635833333333335</c:v>
                </c:pt>
                <c:pt idx="1429">
                  <c:v>3.2668680555555554</c:v>
                </c:pt>
                <c:pt idx="1430">
                  <c:v>3.2701458333333333</c:v>
                </c:pt>
                <c:pt idx="1431">
                  <c:v>3.2734305555555556</c:v>
                </c:pt>
                <c:pt idx="1432">
                  <c:v>3.273923611111111</c:v>
                </c:pt>
                <c:pt idx="1433">
                  <c:v>3.2744236111111111</c:v>
                </c:pt>
                <c:pt idx="1434">
                  <c:v>3.2749166666666669</c:v>
                </c:pt>
                <c:pt idx="1435">
                  <c:v>3.2754166666666671</c:v>
                </c:pt>
                <c:pt idx="1436">
                  <c:v>3.2759097222222224</c:v>
                </c:pt>
                <c:pt idx="1437">
                  <c:v>3.2765416666666667</c:v>
                </c:pt>
                <c:pt idx="1438">
                  <c:v>3.2771805555555558</c:v>
                </c:pt>
                <c:pt idx="1439">
                  <c:v>3.2778125</c:v>
                </c:pt>
                <c:pt idx="1440">
                  <c:v>3.2784513888888891</c:v>
                </c:pt>
                <c:pt idx="1441">
                  <c:v>3.2799444444444443</c:v>
                </c:pt>
                <c:pt idx="1442">
                  <c:v>3.2814375000000005</c:v>
                </c:pt>
                <c:pt idx="1443">
                  <c:v>3.2829305555555557</c:v>
                </c:pt>
                <c:pt idx="1444">
                  <c:v>3.2844236111111109</c:v>
                </c:pt>
                <c:pt idx="1445">
                  <c:v>3.2877152777777781</c:v>
                </c:pt>
                <c:pt idx="1446">
                  <c:v>3.2910138888888891</c:v>
                </c:pt>
                <c:pt idx="1447">
                  <c:v>3.2937569444444446</c:v>
                </c:pt>
                <c:pt idx="1448">
                  <c:v>3.2965</c:v>
                </c:pt>
                <c:pt idx="1449">
                  <c:v>3.2992430555555554</c:v>
                </c:pt>
                <c:pt idx="1450">
                  <c:v>3.3019791666666669</c:v>
                </c:pt>
                <c:pt idx="1451">
                  <c:v>3.3047222222222223</c:v>
                </c:pt>
                <c:pt idx="1452">
                  <c:v>3.3089097222222223</c:v>
                </c:pt>
                <c:pt idx="1453">
                  <c:v>3.313090277777778</c:v>
                </c:pt>
                <c:pt idx="1454">
                  <c:v>3.317277777777778</c:v>
                </c:pt>
                <c:pt idx="1455">
                  <c:v>3.3214583333333332</c:v>
                </c:pt>
                <c:pt idx="1456">
                  <c:v>3.3256458333333336</c:v>
                </c:pt>
                <c:pt idx="1457">
                  <c:v>3.3298263888888888</c:v>
                </c:pt>
                <c:pt idx="1458">
                  <c:v>3.3331041666666668</c:v>
                </c:pt>
                <c:pt idx="1459">
                  <c:v>3.3356944444444441</c:v>
                </c:pt>
                <c:pt idx="1460">
                  <c:v>3.3382847222222223</c:v>
                </c:pt>
                <c:pt idx="1461">
                  <c:v>3.3387638888888889</c:v>
                </c:pt>
                <c:pt idx="1462">
                  <c:v>3.3392430555555559</c:v>
                </c:pt>
                <c:pt idx="1463">
                  <c:v>3.339722222222222</c:v>
                </c:pt>
                <c:pt idx="1464">
                  <c:v>3.340208333333333</c:v>
                </c:pt>
                <c:pt idx="1465">
                  <c:v>3.3410625</c:v>
                </c:pt>
                <c:pt idx="1466">
                  <c:v>3.3419166666666666</c:v>
                </c:pt>
                <c:pt idx="1467">
                  <c:v>3.3427777777777781</c:v>
                </c:pt>
                <c:pt idx="1468">
                  <c:v>3.3436319444444442</c:v>
                </c:pt>
                <c:pt idx="1469">
                  <c:v>3.3462569444444443</c:v>
                </c:pt>
                <c:pt idx="1470">
                  <c:v>3.348875</c:v>
                </c:pt>
                <c:pt idx="1471">
                  <c:v>3.3514999999999997</c:v>
                </c:pt>
                <c:pt idx="1472">
                  <c:v>3.3541249999999998</c:v>
                </c:pt>
                <c:pt idx="1473">
                  <c:v>3.3576666666666668</c:v>
                </c:pt>
                <c:pt idx="1474">
                  <c:v>3.3612152777777777</c:v>
                </c:pt>
                <c:pt idx="1475">
                  <c:v>3.3647638888888891</c:v>
                </c:pt>
                <c:pt idx="1476">
                  <c:v>3.3683125</c:v>
                </c:pt>
                <c:pt idx="1477">
                  <c:v>3.371854166666667</c:v>
                </c:pt>
                <c:pt idx="1478">
                  <c:v>3.3763472222222219</c:v>
                </c:pt>
                <c:pt idx="1479">
                  <c:v>3.3808402777777777</c:v>
                </c:pt>
                <c:pt idx="1480">
                  <c:v>3.3853263888888887</c:v>
                </c:pt>
                <c:pt idx="1481">
                  <c:v>3.3898194444444445</c:v>
                </c:pt>
                <c:pt idx="1482">
                  <c:v>3.3943125000000003</c:v>
                </c:pt>
                <c:pt idx="1483">
                  <c:v>3.4002222222222218</c:v>
                </c:pt>
                <c:pt idx="1484">
                  <c:v>3.4061249999999998</c:v>
                </c:pt>
                <c:pt idx="1485">
                  <c:v>3.4120347222222223</c:v>
                </c:pt>
                <c:pt idx="1486">
                  <c:v>3.4179444444444447</c:v>
                </c:pt>
                <c:pt idx="1487">
                  <c:v>3.4238541666666671</c:v>
                </c:pt>
                <c:pt idx="1488">
                  <c:v>3.4297569444444447</c:v>
                </c:pt>
                <c:pt idx="1489">
                  <c:v>3.4371944444444447</c:v>
                </c:pt>
                <c:pt idx="1490">
                  <c:v>3.4446319444444446</c:v>
                </c:pt>
                <c:pt idx="1491">
                  <c:v>3.4520625000000003</c:v>
                </c:pt>
                <c:pt idx="1492">
                  <c:v>3.4595000000000002</c:v>
                </c:pt>
                <c:pt idx="1493">
                  <c:v>3.4669305555555558</c:v>
                </c:pt>
                <c:pt idx="1494">
                  <c:v>3.4743680555555558</c:v>
                </c:pt>
                <c:pt idx="1495">
                  <c:v>3.4827847222222221</c:v>
                </c:pt>
                <c:pt idx="1496">
                  <c:v>3.4912013888888889</c:v>
                </c:pt>
                <c:pt idx="1497">
                  <c:v>3.4996180555555556</c:v>
                </c:pt>
                <c:pt idx="1498">
                  <c:v>3.5080347222222219</c:v>
                </c:pt>
                <c:pt idx="1499">
                  <c:v>3.5164513888888886</c:v>
                </c:pt>
                <c:pt idx="1500">
                  <c:v>3.5248680555555558</c:v>
                </c:pt>
                <c:pt idx="1501">
                  <c:v>3.5316319444444444</c:v>
                </c:pt>
                <c:pt idx="1502">
                  <c:v>3.5372083333333331</c:v>
                </c:pt>
                <c:pt idx="1503">
                  <c:v>3.5427847222222222</c:v>
                </c:pt>
                <c:pt idx="1504">
                  <c:v>3.5436944444444447</c:v>
                </c:pt>
                <c:pt idx="1505">
                  <c:v>3.5446041666666663</c:v>
                </c:pt>
                <c:pt idx="1506">
                  <c:v>3.5455138888888889</c:v>
                </c:pt>
                <c:pt idx="1507">
                  <c:v>3.5464236111111114</c:v>
                </c:pt>
                <c:pt idx="1508">
                  <c:v>3.5473333333333334</c:v>
                </c:pt>
                <c:pt idx="1509">
                  <c:v>3.548944444444444</c:v>
                </c:pt>
                <c:pt idx="1510">
                  <c:v>3.5505486111111111</c:v>
                </c:pt>
                <c:pt idx="1511">
                  <c:v>3.5521597222222221</c:v>
                </c:pt>
                <c:pt idx="1512">
                  <c:v>3.5537708333333335</c:v>
                </c:pt>
                <c:pt idx="1513">
                  <c:v>3.5553819444444446</c:v>
                </c:pt>
                <c:pt idx="1514">
                  <c:v>3.5587291666666663</c:v>
                </c:pt>
                <c:pt idx="1515">
                  <c:v>3.5620763888888893</c:v>
                </c:pt>
                <c:pt idx="1516">
                  <c:v>3.5654305555555559</c:v>
                </c:pt>
                <c:pt idx="1517">
                  <c:v>3.5687777777777776</c:v>
                </c:pt>
                <c:pt idx="1518">
                  <c:v>3.5721249999999998</c:v>
                </c:pt>
                <c:pt idx="1519">
                  <c:v>3.5783541666666667</c:v>
                </c:pt>
                <c:pt idx="1520">
                  <c:v>3.5845833333333337</c:v>
                </c:pt>
                <c:pt idx="1521">
                  <c:v>3.5908125000000002</c:v>
                </c:pt>
                <c:pt idx="1522">
                  <c:v>3.5970416666666667</c:v>
                </c:pt>
                <c:pt idx="1523">
                  <c:v>3.6032638888888888</c:v>
                </c:pt>
                <c:pt idx="1524">
                  <c:v>3.6094930555555558</c:v>
                </c:pt>
                <c:pt idx="1525">
                  <c:v>3.6184097222222222</c:v>
                </c:pt>
                <c:pt idx="1526">
                  <c:v>3.6273194444444448</c:v>
                </c:pt>
                <c:pt idx="1527">
                  <c:v>3.6362361111111112</c:v>
                </c:pt>
                <c:pt idx="1528">
                  <c:v>3.6451527777777781</c:v>
                </c:pt>
                <c:pt idx="1529">
                  <c:v>3.6540625000000002</c:v>
                </c:pt>
                <c:pt idx="1530">
                  <c:v>3.6629791666666662</c:v>
                </c:pt>
                <c:pt idx="1531">
                  <c:v>3.6718888888888892</c:v>
                </c:pt>
                <c:pt idx="1532">
                  <c:v>3.6808055555555552</c:v>
                </c:pt>
                <c:pt idx="1533">
                  <c:v>3.6897222222222221</c:v>
                </c:pt>
                <c:pt idx="1534">
                  <c:v>3.6986319444444442</c:v>
                </c:pt>
                <c:pt idx="1535">
                  <c:v>3.7075486111111111</c:v>
                </c:pt>
                <c:pt idx="1536">
                  <c:v>3.7164583333333332</c:v>
                </c:pt>
                <c:pt idx="1537">
                  <c:v>3.7253750000000001</c:v>
                </c:pt>
                <c:pt idx="1538">
                  <c:v>3.7342916666666666</c:v>
                </c:pt>
                <c:pt idx="1539">
                  <c:v>3.7432013888888891</c:v>
                </c:pt>
                <c:pt idx="1540">
                  <c:v>3.7521180555555556</c:v>
                </c:pt>
                <c:pt idx="1541">
                  <c:v>3.7610277777777776</c:v>
                </c:pt>
                <c:pt idx="1542">
                  <c:v>3.7699444444444445</c:v>
                </c:pt>
                <c:pt idx="1543">
                  <c:v>3.7788611111111114</c:v>
                </c:pt>
                <c:pt idx="1544">
                  <c:v>3.7877708333333335</c:v>
                </c:pt>
                <c:pt idx="1545">
                  <c:v>3.7966874999999995</c:v>
                </c:pt>
                <c:pt idx="1546">
                  <c:v>3.8055972222222225</c:v>
                </c:pt>
                <c:pt idx="1547">
                  <c:v>3.8145138888888885</c:v>
                </c:pt>
                <c:pt idx="1548">
                  <c:v>3.8234305555555554</c:v>
                </c:pt>
                <c:pt idx="1549">
                  <c:v>3.8323402777777775</c:v>
                </c:pt>
                <c:pt idx="1550">
                  <c:v>3.8412569444444444</c:v>
                </c:pt>
                <c:pt idx="1551">
                  <c:v>3.8501666666666665</c:v>
                </c:pt>
                <c:pt idx="1552">
                  <c:v>3.8590833333333334</c:v>
                </c:pt>
                <c:pt idx="1553">
                  <c:v>3.8679999999999999</c:v>
                </c:pt>
                <c:pt idx="1554">
                  <c:v>3.8769097222222224</c:v>
                </c:pt>
                <c:pt idx="1555">
                  <c:v>3.8858263888888889</c:v>
                </c:pt>
                <c:pt idx="1556">
                  <c:v>3.894736111111111</c:v>
                </c:pt>
                <c:pt idx="1557">
                  <c:v>3.9036527777777779</c:v>
                </c:pt>
                <c:pt idx="1558">
                  <c:v>3.9125694444444448</c:v>
                </c:pt>
                <c:pt idx="1559">
                  <c:v>3.9214791666666668</c:v>
                </c:pt>
                <c:pt idx="1560">
                  <c:v>3.9303958333333338</c:v>
                </c:pt>
                <c:pt idx="1561">
                  <c:v>3.9393055555555558</c:v>
                </c:pt>
                <c:pt idx="1562">
                  <c:v>3.9482222222222219</c:v>
                </c:pt>
                <c:pt idx="1563">
                  <c:v>3.9571388888888888</c:v>
                </c:pt>
                <c:pt idx="1564">
                  <c:v>3.9660486111111108</c:v>
                </c:pt>
                <c:pt idx="1565">
                  <c:v>3.9749652777777778</c:v>
                </c:pt>
                <c:pt idx="1566">
                  <c:v>3.9838749999999998</c:v>
                </c:pt>
                <c:pt idx="1567">
                  <c:v>3.9927916666666667</c:v>
                </c:pt>
                <c:pt idx="1568">
                  <c:v>4.0017083333333332</c:v>
                </c:pt>
                <c:pt idx="1569">
                  <c:v>4.0106180555555557</c:v>
                </c:pt>
                <c:pt idx="1570">
                  <c:v>4.0195347222222226</c:v>
                </c:pt>
                <c:pt idx="1571">
                  <c:v>4.0284444444444443</c:v>
                </c:pt>
                <c:pt idx="1572">
                  <c:v>4.0373611111111112</c:v>
                </c:pt>
                <c:pt idx="1573">
                  <c:v>4.0462777777777781</c:v>
                </c:pt>
                <c:pt idx="1574">
                  <c:v>4.0551875000000006</c:v>
                </c:pt>
                <c:pt idx="1575">
                  <c:v>4.0641041666666666</c:v>
                </c:pt>
                <c:pt idx="1576">
                  <c:v>4.0730138888888892</c:v>
                </c:pt>
                <c:pt idx="1577">
                  <c:v>4.0819305555555552</c:v>
                </c:pt>
                <c:pt idx="1578">
                  <c:v>4.0908472222222221</c:v>
                </c:pt>
                <c:pt idx="1579">
                  <c:v>4.0997569444444446</c:v>
                </c:pt>
                <c:pt idx="1580">
                  <c:v>4.1086736111111106</c:v>
                </c:pt>
                <c:pt idx="1581">
                  <c:v>4.1175833333333332</c:v>
                </c:pt>
                <c:pt idx="1582">
                  <c:v>4.1265000000000001</c:v>
                </c:pt>
                <c:pt idx="1583">
                  <c:v>4.135416666666667</c:v>
                </c:pt>
                <c:pt idx="1584">
                  <c:v>4.1443263888888886</c:v>
                </c:pt>
                <c:pt idx="1585">
                  <c:v>4.1532430555555555</c:v>
                </c:pt>
                <c:pt idx="1586">
                  <c:v>4.162152777777778</c:v>
                </c:pt>
                <c:pt idx="1587">
                  <c:v>4.1710694444444449</c:v>
                </c:pt>
                <c:pt idx="1588">
                  <c:v>4.179986111111111</c:v>
                </c:pt>
                <c:pt idx="1589">
                  <c:v>4.1888958333333335</c:v>
                </c:pt>
                <c:pt idx="1590">
                  <c:v>4.1978125000000004</c:v>
                </c:pt>
                <c:pt idx="1591">
                  <c:v>4.206722222222222</c:v>
                </c:pt>
                <c:pt idx="1592">
                  <c:v>4.2156388888888889</c:v>
                </c:pt>
                <c:pt idx="1593">
                  <c:v>4.224555555555555</c:v>
                </c:pt>
                <c:pt idx="1594">
                  <c:v>4.2334652777777775</c:v>
                </c:pt>
                <c:pt idx="1595">
                  <c:v>4.2423819444444444</c:v>
                </c:pt>
                <c:pt idx="1596">
                  <c:v>4.251291666666666</c:v>
                </c:pt>
                <c:pt idx="1597">
                  <c:v>4.2602083333333329</c:v>
                </c:pt>
                <c:pt idx="1598">
                  <c:v>4.2691249999999998</c:v>
                </c:pt>
                <c:pt idx="1599">
                  <c:v>4.2780347222222224</c:v>
                </c:pt>
                <c:pt idx="1600">
                  <c:v>4.2869513888888893</c:v>
                </c:pt>
                <c:pt idx="1601">
                  <c:v>4.2958611111111109</c:v>
                </c:pt>
                <c:pt idx="1602">
                  <c:v>4.3047777777777778</c:v>
                </c:pt>
                <c:pt idx="1603">
                  <c:v>4.3136944444444447</c:v>
                </c:pt>
                <c:pt idx="1604">
                  <c:v>4.3226041666666664</c:v>
                </c:pt>
                <c:pt idx="1605">
                  <c:v>4.3315208333333333</c:v>
                </c:pt>
                <c:pt idx="1606">
                  <c:v>4.3404305555555558</c:v>
                </c:pt>
                <c:pt idx="1607">
                  <c:v>4.3493472222222227</c:v>
                </c:pt>
                <c:pt idx="1608">
                  <c:v>4.3582638888888887</c:v>
                </c:pt>
                <c:pt idx="1609">
                  <c:v>4.3671736111111112</c:v>
                </c:pt>
                <c:pt idx="1610">
                  <c:v>4.3760902777777773</c:v>
                </c:pt>
                <c:pt idx="1611">
                  <c:v>4.3849999999999998</c:v>
                </c:pt>
                <c:pt idx="1612">
                  <c:v>4.392347222222222</c:v>
                </c:pt>
                <c:pt idx="1613">
                  <c:v>4.399694444444445</c:v>
                </c:pt>
                <c:pt idx="1614">
                  <c:v>4.4070416666666672</c:v>
                </c:pt>
                <c:pt idx="1615">
                  <c:v>4.4143888888888894</c:v>
                </c:pt>
                <c:pt idx="1616">
                  <c:v>4.4217361111111115</c:v>
                </c:pt>
                <c:pt idx="1617">
                  <c:v>4.4290833333333337</c:v>
                </c:pt>
                <c:pt idx="1618">
                  <c:v>4.4364305555555559</c:v>
                </c:pt>
                <c:pt idx="1619">
                  <c:v>4.4437708333333328</c:v>
                </c:pt>
                <c:pt idx="1620">
                  <c:v>4.4496250000000002</c:v>
                </c:pt>
                <c:pt idx="1621">
                  <c:v>4.4542222222222225</c:v>
                </c:pt>
                <c:pt idx="1622">
                  <c:v>4.4588263888888893</c:v>
                </c:pt>
                <c:pt idx="1623">
                  <c:v>4.4595625000000005</c:v>
                </c:pt>
                <c:pt idx="1624">
                  <c:v>4.4603055555555553</c:v>
                </c:pt>
                <c:pt idx="1625">
                  <c:v>4.4610416666666666</c:v>
                </c:pt>
                <c:pt idx="1626">
                  <c:v>4.4617847222222222</c:v>
                </c:pt>
                <c:pt idx="1627">
                  <c:v>4.4625208333333335</c:v>
                </c:pt>
                <c:pt idx="1628">
                  <c:v>4.463541666666667</c:v>
                </c:pt>
                <c:pt idx="1629">
                  <c:v>4.4645625000000004</c:v>
                </c:pt>
                <c:pt idx="1630">
                  <c:v>4.465583333333333</c:v>
                </c:pt>
                <c:pt idx="1631">
                  <c:v>4.4666041666666665</c:v>
                </c:pt>
                <c:pt idx="1632">
                  <c:v>4.4686180555555559</c:v>
                </c:pt>
                <c:pt idx="1633">
                  <c:v>4.4706319444444444</c:v>
                </c:pt>
                <c:pt idx="1634">
                  <c:v>4.472645833333333</c:v>
                </c:pt>
                <c:pt idx="1635">
                  <c:v>4.4746597222222224</c:v>
                </c:pt>
                <c:pt idx="1636">
                  <c:v>4.4774583333333329</c:v>
                </c:pt>
                <c:pt idx="1637">
                  <c:v>4.4802569444444442</c:v>
                </c:pt>
                <c:pt idx="1638">
                  <c:v>4.4830555555555556</c:v>
                </c:pt>
                <c:pt idx="1639">
                  <c:v>4.4858611111111113</c:v>
                </c:pt>
                <c:pt idx="1640">
                  <c:v>4.4880138888888883</c:v>
                </c:pt>
                <c:pt idx="1641">
                  <c:v>4.4897916666666671</c:v>
                </c:pt>
                <c:pt idx="1642">
                  <c:v>4.4915625000000006</c:v>
                </c:pt>
                <c:pt idx="1643">
                  <c:v>4.4919027777777778</c:v>
                </c:pt>
                <c:pt idx="1644">
                  <c:v>4.4922430555555559</c:v>
                </c:pt>
                <c:pt idx="1645">
                  <c:v>4.4925763888888888</c:v>
                </c:pt>
                <c:pt idx="1646">
                  <c:v>4.4929166666666669</c:v>
                </c:pt>
                <c:pt idx="1647">
                  <c:v>4.4935902777777779</c:v>
                </c:pt>
                <c:pt idx="1648">
                  <c:v>4.4942708333333332</c:v>
                </c:pt>
                <c:pt idx="1649">
                  <c:v>4.4949444444444442</c:v>
                </c:pt>
                <c:pt idx="1650">
                  <c:v>4.4956249999999995</c:v>
                </c:pt>
                <c:pt idx="1651">
                  <c:v>4.4974166666666662</c:v>
                </c:pt>
                <c:pt idx="1652">
                  <c:v>4.4992083333333328</c:v>
                </c:pt>
                <c:pt idx="1653">
                  <c:v>4.5009999999999994</c:v>
                </c:pt>
                <c:pt idx="1654">
                  <c:v>4.502791666666667</c:v>
                </c:pt>
                <c:pt idx="1655">
                  <c:v>4.5051736111111111</c:v>
                </c:pt>
                <c:pt idx="1656">
                  <c:v>4.5075625000000006</c:v>
                </c:pt>
                <c:pt idx="1657">
                  <c:v>4.5099444444444439</c:v>
                </c:pt>
                <c:pt idx="1658">
                  <c:v>4.5123333333333333</c:v>
                </c:pt>
                <c:pt idx="1659">
                  <c:v>4.5147152777777775</c:v>
                </c:pt>
                <c:pt idx="1660">
                  <c:v>4.5171041666666669</c:v>
                </c:pt>
                <c:pt idx="1661">
                  <c:v>4.5188402777777776</c:v>
                </c:pt>
                <c:pt idx="1662">
                  <c:v>4.5205833333333336</c:v>
                </c:pt>
                <c:pt idx="1663">
                  <c:v>4.5223263888888887</c:v>
                </c:pt>
                <c:pt idx="1664">
                  <c:v>4.5226111111111118</c:v>
                </c:pt>
                <c:pt idx="1665">
                  <c:v>4.5228888888888887</c:v>
                </c:pt>
                <c:pt idx="1666">
                  <c:v>4.5231736111111109</c:v>
                </c:pt>
                <c:pt idx="1667">
                  <c:v>4.5234583333333331</c:v>
                </c:pt>
                <c:pt idx="1668">
                  <c:v>4.5240208333333332</c:v>
                </c:pt>
                <c:pt idx="1669">
                  <c:v>4.5245902777777776</c:v>
                </c:pt>
                <c:pt idx="1670">
                  <c:v>4.5251527777777776</c:v>
                </c:pt>
                <c:pt idx="1671">
                  <c:v>4.525722222222222</c:v>
                </c:pt>
                <c:pt idx="1672">
                  <c:v>4.5271388888888886</c:v>
                </c:pt>
                <c:pt idx="1673">
                  <c:v>4.5285625000000005</c:v>
                </c:pt>
                <c:pt idx="1674">
                  <c:v>4.5299791666666671</c:v>
                </c:pt>
                <c:pt idx="1675">
                  <c:v>4.5314027777777781</c:v>
                </c:pt>
                <c:pt idx="1676">
                  <c:v>4.5335069444444445</c:v>
                </c:pt>
                <c:pt idx="1677">
                  <c:v>4.5356111111111108</c:v>
                </c:pt>
                <c:pt idx="1678">
                  <c:v>4.5377152777777781</c:v>
                </c:pt>
                <c:pt idx="1679">
                  <c:v>4.5398194444444444</c:v>
                </c:pt>
                <c:pt idx="1680">
                  <c:v>4.5419236111111108</c:v>
                </c:pt>
                <c:pt idx="1681">
                  <c:v>4.5449027777777777</c:v>
                </c:pt>
                <c:pt idx="1682">
                  <c:v>4.5478888888888891</c:v>
                </c:pt>
                <c:pt idx="1683">
                  <c:v>4.5508680555555552</c:v>
                </c:pt>
                <c:pt idx="1684">
                  <c:v>4.5538472222222222</c:v>
                </c:pt>
                <c:pt idx="1685">
                  <c:v>4.5568333333333335</c:v>
                </c:pt>
                <c:pt idx="1686">
                  <c:v>4.5598125000000005</c:v>
                </c:pt>
                <c:pt idx="1687">
                  <c:v>4.5627916666666666</c:v>
                </c:pt>
                <c:pt idx="1688">
                  <c:v>4.5652499999999998</c:v>
                </c:pt>
                <c:pt idx="1689">
                  <c:v>4.5677013888888887</c:v>
                </c:pt>
                <c:pt idx="1690">
                  <c:v>4.5701527777777784</c:v>
                </c:pt>
                <c:pt idx="1691">
                  <c:v>4.5726111111111116</c:v>
                </c:pt>
                <c:pt idx="1692">
                  <c:v>4.5750625000000005</c:v>
                </c:pt>
                <c:pt idx="1693">
                  <c:v>4.5775208333333337</c:v>
                </c:pt>
                <c:pt idx="1694">
                  <c:v>4.5799722222222226</c:v>
                </c:pt>
                <c:pt idx="1695">
                  <c:v>4.5824305555555558</c:v>
                </c:pt>
                <c:pt idx="1696">
                  <c:v>4.5848819444444437</c:v>
                </c:pt>
                <c:pt idx="1697">
                  <c:v>4.5873333333333335</c:v>
                </c:pt>
                <c:pt idx="1698">
                  <c:v>4.5897916666666667</c:v>
                </c:pt>
                <c:pt idx="1699">
                  <c:v>4.5922430555555556</c:v>
                </c:pt>
                <c:pt idx="1700">
                  <c:v>4.5942430555555553</c:v>
                </c:pt>
                <c:pt idx="1701">
                  <c:v>4.5962361111111107</c:v>
                </c:pt>
                <c:pt idx="1702">
                  <c:v>4.5978750000000002</c:v>
                </c:pt>
                <c:pt idx="1703">
                  <c:v>4.5995069444444443</c:v>
                </c:pt>
                <c:pt idx="1704">
                  <c:v>4.6011458333333328</c:v>
                </c:pt>
                <c:pt idx="1705">
                  <c:v>4.6027777777777779</c:v>
                </c:pt>
                <c:pt idx="1706">
                  <c:v>4.6041249999999998</c:v>
                </c:pt>
                <c:pt idx="1707">
                  <c:v>4.6052083333333336</c:v>
                </c:pt>
                <c:pt idx="1708">
                  <c:v>4.6062986111111108</c:v>
                </c:pt>
                <c:pt idx="1709">
                  <c:v>4.6073819444444446</c:v>
                </c:pt>
                <c:pt idx="1710">
                  <c:v>4.6084722222222219</c:v>
                </c:pt>
                <c:pt idx="1711">
                  <c:v>4.6086458333333331</c:v>
                </c:pt>
                <c:pt idx="1712">
                  <c:v>4.6088263888888887</c:v>
                </c:pt>
                <c:pt idx="1713">
                  <c:v>4.6090069444444444</c:v>
                </c:pt>
                <c:pt idx="1714">
                  <c:v>4.6091805555555556</c:v>
                </c:pt>
                <c:pt idx="1715">
                  <c:v>4.6095277777777781</c:v>
                </c:pt>
                <c:pt idx="1716">
                  <c:v>4.6098680555555553</c:v>
                </c:pt>
                <c:pt idx="1717">
                  <c:v>4.6102152777777778</c:v>
                </c:pt>
                <c:pt idx="1718">
                  <c:v>4.6105555555555551</c:v>
                </c:pt>
                <c:pt idx="1719">
                  <c:v>4.6117083333333335</c:v>
                </c:pt>
                <c:pt idx="1720">
                  <c:v>4.6128611111111111</c:v>
                </c:pt>
                <c:pt idx="1721">
                  <c:v>4.614020833333333</c:v>
                </c:pt>
                <c:pt idx="1722">
                  <c:v>4.6151736111111115</c:v>
                </c:pt>
                <c:pt idx="1723">
                  <c:v>4.616326388888889</c:v>
                </c:pt>
                <c:pt idx="1724">
                  <c:v>4.6181180555555557</c:v>
                </c:pt>
                <c:pt idx="1725">
                  <c:v>4.6199166666666667</c:v>
                </c:pt>
                <c:pt idx="1726">
                  <c:v>4.6217083333333333</c:v>
                </c:pt>
                <c:pt idx="1727">
                  <c:v>4.6235069444444443</c:v>
                </c:pt>
                <c:pt idx="1728">
                  <c:v>4.6253055555555553</c:v>
                </c:pt>
                <c:pt idx="1729">
                  <c:v>4.6272986111111116</c:v>
                </c:pt>
                <c:pt idx="1730">
                  <c:v>4.6292986111111105</c:v>
                </c:pt>
                <c:pt idx="1731">
                  <c:v>4.6312986111111112</c:v>
                </c:pt>
                <c:pt idx="1732">
                  <c:v>4.633298611111111</c:v>
                </c:pt>
                <c:pt idx="1733">
                  <c:v>4.6352986111111107</c:v>
                </c:pt>
                <c:pt idx="1734">
                  <c:v>4.6372986111111114</c:v>
                </c:pt>
                <c:pt idx="1735">
                  <c:v>4.6392986111111112</c:v>
                </c:pt>
                <c:pt idx="1736">
                  <c:v>4.641298611111111</c:v>
                </c:pt>
                <c:pt idx="1737">
                  <c:v>4.6432986111111116</c:v>
                </c:pt>
                <c:pt idx="1738">
                  <c:v>4.6452986111111105</c:v>
                </c:pt>
                <c:pt idx="1739">
                  <c:v>4.6472986111111112</c:v>
                </c:pt>
                <c:pt idx="1740">
                  <c:v>4.649298611111111</c:v>
                </c:pt>
                <c:pt idx="1741">
                  <c:v>4.6512986111111108</c:v>
                </c:pt>
                <c:pt idx="1742">
                  <c:v>4.6532986111111114</c:v>
                </c:pt>
                <c:pt idx="1743">
                  <c:v>4.6552986111111112</c:v>
                </c:pt>
                <c:pt idx="1744">
                  <c:v>4.657298611111111</c:v>
                </c:pt>
                <c:pt idx="1745">
                  <c:v>4.6592986111111117</c:v>
                </c:pt>
                <c:pt idx="1746">
                  <c:v>4.6612986111111114</c:v>
                </c:pt>
                <c:pt idx="1747">
                  <c:v>4.6632916666666668</c:v>
                </c:pt>
                <c:pt idx="1748">
                  <c:v>4.6652916666666666</c:v>
                </c:pt>
                <c:pt idx="1749">
                  <c:v>4.6672916666666664</c:v>
                </c:pt>
                <c:pt idx="1750">
                  <c:v>4.6692916666666662</c:v>
                </c:pt>
                <c:pt idx="1751">
                  <c:v>4.6712916666666668</c:v>
                </c:pt>
                <c:pt idx="1752">
                  <c:v>4.6732916666666666</c:v>
                </c:pt>
                <c:pt idx="1753">
                  <c:v>4.6752916666666664</c:v>
                </c:pt>
                <c:pt idx="1754">
                  <c:v>4.6772916666666671</c:v>
                </c:pt>
                <c:pt idx="1755">
                  <c:v>4.6789583333333331</c:v>
                </c:pt>
                <c:pt idx="1756">
                  <c:v>4.6806180555555557</c:v>
                </c:pt>
                <c:pt idx="1757">
                  <c:v>4.6822847222222217</c:v>
                </c:pt>
                <c:pt idx="1758">
                  <c:v>4.6839444444444442</c:v>
                </c:pt>
                <c:pt idx="1759">
                  <c:v>4.6841805555555558</c:v>
                </c:pt>
                <c:pt idx="1760">
                  <c:v>4.6844166666666673</c:v>
                </c:pt>
                <c:pt idx="1761">
                  <c:v>4.6846458333333336</c:v>
                </c:pt>
                <c:pt idx="1762">
                  <c:v>4.6848819444444443</c:v>
                </c:pt>
                <c:pt idx="1763">
                  <c:v>4.6851180555555549</c:v>
                </c:pt>
                <c:pt idx="1764">
                  <c:v>4.6855416666666665</c:v>
                </c:pt>
                <c:pt idx="1765">
                  <c:v>4.685965277777778</c:v>
                </c:pt>
                <c:pt idx="1766">
                  <c:v>4.6863888888888887</c:v>
                </c:pt>
                <c:pt idx="1767">
                  <c:v>4.6868125000000003</c:v>
                </c:pt>
                <c:pt idx="1768">
                  <c:v>4.687388888888889</c:v>
                </c:pt>
                <c:pt idx="1769">
                  <c:v>4.6879722222222222</c:v>
                </c:pt>
                <c:pt idx="1770">
                  <c:v>4.6885555555555563</c:v>
                </c:pt>
                <c:pt idx="1771">
                  <c:v>4.6891388888888885</c:v>
                </c:pt>
                <c:pt idx="1772">
                  <c:v>4.6900277777777779</c:v>
                </c:pt>
                <c:pt idx="1773">
                  <c:v>4.6909166666666664</c:v>
                </c:pt>
                <c:pt idx="1774">
                  <c:v>4.6918055555555558</c:v>
                </c:pt>
                <c:pt idx="1775">
                  <c:v>4.6927013888888887</c:v>
                </c:pt>
                <c:pt idx="1776">
                  <c:v>4.693590277777778</c:v>
                </c:pt>
                <c:pt idx="1777">
                  <c:v>4.6944791666666665</c:v>
                </c:pt>
                <c:pt idx="1778">
                  <c:v>4.6953750000000003</c:v>
                </c:pt>
                <c:pt idx="1779">
                  <c:v>4.6962638888888888</c:v>
                </c:pt>
                <c:pt idx="1780">
                  <c:v>4.6971527777777773</c:v>
                </c:pt>
                <c:pt idx="1781">
                  <c:v>4.6980416666666667</c:v>
                </c:pt>
                <c:pt idx="1782">
                  <c:v>4.6989375000000004</c:v>
                </c:pt>
                <c:pt idx="1783">
                  <c:v>4.7000347222222221</c:v>
                </c:pt>
                <c:pt idx="1784">
                  <c:v>4.7011250000000002</c:v>
                </c:pt>
                <c:pt idx="1785">
                  <c:v>4.7022222222222219</c:v>
                </c:pt>
                <c:pt idx="1786">
                  <c:v>4.7023888888888887</c:v>
                </c:pt>
                <c:pt idx="1787">
                  <c:v>4.7025486111111112</c:v>
                </c:pt>
                <c:pt idx="1788">
                  <c:v>4.7027083333333328</c:v>
                </c:pt>
                <c:pt idx="1789">
                  <c:v>4.7028750000000006</c:v>
                </c:pt>
                <c:pt idx="1790">
                  <c:v>4.7030347222222222</c:v>
                </c:pt>
                <c:pt idx="1791">
                  <c:v>4.7033472222222219</c:v>
                </c:pt>
                <c:pt idx="1792">
                  <c:v>4.7036597222222225</c:v>
                </c:pt>
                <c:pt idx="1793">
                  <c:v>4.7039722222222222</c:v>
                </c:pt>
                <c:pt idx="1794">
                  <c:v>4.7042847222222219</c:v>
                </c:pt>
                <c:pt idx="1795">
                  <c:v>4.7045972222222225</c:v>
                </c:pt>
                <c:pt idx="1796">
                  <c:v>4.7053263888888885</c:v>
                </c:pt>
                <c:pt idx="1797">
                  <c:v>4.7060486111111111</c:v>
                </c:pt>
                <c:pt idx="1798">
                  <c:v>4.7067777777777779</c:v>
                </c:pt>
                <c:pt idx="1799">
                  <c:v>4.7075000000000005</c:v>
                </c:pt>
                <c:pt idx="1800">
                  <c:v>4.7082291666666674</c:v>
                </c:pt>
                <c:pt idx="1801">
                  <c:v>4.709270833333334</c:v>
                </c:pt>
                <c:pt idx="1802">
                  <c:v>4.7101388888888893</c:v>
                </c:pt>
                <c:pt idx="1803">
                  <c:v>4.7110069444444447</c:v>
                </c:pt>
                <c:pt idx="1804">
                  <c:v>4.7117013888888888</c:v>
                </c:pt>
                <c:pt idx="1805">
                  <c:v>4.7118263888888885</c:v>
                </c:pt>
                <c:pt idx="1806">
                  <c:v>4.7119513888888891</c:v>
                </c:pt>
                <c:pt idx="1807">
                  <c:v>4.7120694444444444</c:v>
                </c:pt>
                <c:pt idx="1808">
                  <c:v>4.712194444444445</c:v>
                </c:pt>
                <c:pt idx="1809">
                  <c:v>4.7123194444444447</c:v>
                </c:pt>
                <c:pt idx="1810">
                  <c:v>4.712548611111111</c:v>
                </c:pt>
                <c:pt idx="1811">
                  <c:v>4.7127777777777773</c:v>
                </c:pt>
                <c:pt idx="1812">
                  <c:v>4.7130138888888888</c:v>
                </c:pt>
                <c:pt idx="1813">
                  <c:v>4.7132430555555551</c:v>
                </c:pt>
                <c:pt idx="1814">
                  <c:v>4.7136458333333326</c:v>
                </c:pt>
                <c:pt idx="1815">
                  <c:v>4.7140416666666667</c:v>
                </c:pt>
                <c:pt idx="1816">
                  <c:v>4.7144444444444442</c:v>
                </c:pt>
                <c:pt idx="1817">
                  <c:v>4.7148402777777774</c:v>
                </c:pt>
                <c:pt idx="1818">
                  <c:v>4.7153263888888883</c:v>
                </c:pt>
                <c:pt idx="1819">
                  <c:v>4.7158055555555558</c:v>
                </c:pt>
                <c:pt idx="1820">
                  <c:v>4.7162916666666668</c:v>
                </c:pt>
                <c:pt idx="1821">
                  <c:v>4.7167708333333334</c:v>
                </c:pt>
                <c:pt idx="1822">
                  <c:v>4.7172569444444443</c:v>
                </c:pt>
                <c:pt idx="1823">
                  <c:v>4.7178611111111115</c:v>
                </c:pt>
                <c:pt idx="1824">
                  <c:v>4.7184583333333334</c:v>
                </c:pt>
                <c:pt idx="1825">
                  <c:v>4.7190624999999997</c:v>
                </c:pt>
                <c:pt idx="1826">
                  <c:v>4.7196666666666669</c:v>
                </c:pt>
                <c:pt idx="1827">
                  <c:v>4.7202708333333332</c:v>
                </c:pt>
                <c:pt idx="1828">
                  <c:v>4.7210069444444445</c:v>
                </c:pt>
                <c:pt idx="1829">
                  <c:v>4.7217430555555557</c:v>
                </c:pt>
                <c:pt idx="1830">
                  <c:v>4.722479166666667</c:v>
                </c:pt>
                <c:pt idx="1831">
                  <c:v>4.7232152777777783</c:v>
                </c:pt>
                <c:pt idx="1832">
                  <c:v>4.7239513888888887</c:v>
                </c:pt>
                <c:pt idx="1833">
                  <c:v>4.7240763888888893</c:v>
                </c:pt>
                <c:pt idx="1834">
                  <c:v>4.724201388888889</c:v>
                </c:pt>
                <c:pt idx="1835">
                  <c:v>4.7243194444444452</c:v>
                </c:pt>
                <c:pt idx="1836">
                  <c:v>4.724444444444444</c:v>
                </c:pt>
                <c:pt idx="1837">
                  <c:v>4.7245625000000002</c:v>
                </c:pt>
                <c:pt idx="1838">
                  <c:v>4.7248124999999996</c:v>
                </c:pt>
                <c:pt idx="1839">
                  <c:v>4.7250555555555556</c:v>
                </c:pt>
                <c:pt idx="1840">
                  <c:v>4.7252986111111115</c:v>
                </c:pt>
                <c:pt idx="1841">
                  <c:v>4.7255416666666665</c:v>
                </c:pt>
                <c:pt idx="1842">
                  <c:v>4.7257847222222225</c:v>
                </c:pt>
                <c:pt idx="1843">
                  <c:v>4.7261875</c:v>
                </c:pt>
                <c:pt idx="1844">
                  <c:v>4.7265902777777775</c:v>
                </c:pt>
                <c:pt idx="1845">
                  <c:v>4.726993055555555</c:v>
                </c:pt>
                <c:pt idx="1846">
                  <c:v>4.7273958333333335</c:v>
                </c:pt>
                <c:pt idx="1847">
                  <c:v>4.7277916666666666</c:v>
                </c:pt>
                <c:pt idx="1848">
                  <c:v>4.7283472222222223</c:v>
                </c:pt>
                <c:pt idx="1849">
                  <c:v>4.7289027777777779</c:v>
                </c:pt>
                <c:pt idx="1850">
                  <c:v>4.7294583333333335</c:v>
                </c:pt>
                <c:pt idx="1851">
                  <c:v>4.7300138888888892</c:v>
                </c:pt>
                <c:pt idx="1852">
                  <c:v>4.7305694444444448</c:v>
                </c:pt>
                <c:pt idx="1853">
                  <c:v>4.7312152777777774</c:v>
                </c:pt>
                <c:pt idx="1854">
                  <c:v>4.7318541666666665</c:v>
                </c:pt>
                <c:pt idx="1855">
                  <c:v>4.7324999999999999</c:v>
                </c:pt>
                <c:pt idx="1856">
                  <c:v>4.7331458333333334</c:v>
                </c:pt>
                <c:pt idx="1857">
                  <c:v>4.7337847222222216</c:v>
                </c:pt>
                <c:pt idx="1858">
                  <c:v>4.7344305555555559</c:v>
                </c:pt>
                <c:pt idx="1859">
                  <c:v>4.7350763888888894</c:v>
                </c:pt>
                <c:pt idx="1860">
                  <c:v>4.7356041666666666</c:v>
                </c:pt>
                <c:pt idx="1861">
                  <c:v>4.7361388888888891</c:v>
                </c:pt>
                <c:pt idx="1862">
                  <c:v>4.7366666666666664</c:v>
                </c:pt>
                <c:pt idx="1863">
                  <c:v>4.7371944444444445</c:v>
                </c:pt>
                <c:pt idx="1864">
                  <c:v>4.7376319444444439</c:v>
                </c:pt>
                <c:pt idx="1865">
                  <c:v>4.7377083333333339</c:v>
                </c:pt>
                <c:pt idx="1866">
                  <c:v>4.7377777777777776</c:v>
                </c:pt>
                <c:pt idx="1867">
                  <c:v>4.7378472222222223</c:v>
                </c:pt>
                <c:pt idx="1868">
                  <c:v>4.7379236111111105</c:v>
                </c:pt>
                <c:pt idx="1869">
                  <c:v>4.7379930555555552</c:v>
                </c:pt>
                <c:pt idx="1870">
                  <c:v>4.7380902777777782</c:v>
                </c:pt>
                <c:pt idx="1871">
                  <c:v>4.7381805555555552</c:v>
                </c:pt>
                <c:pt idx="1872">
                  <c:v>4.7382777777777774</c:v>
                </c:pt>
                <c:pt idx="1873">
                  <c:v>4.7383750000000004</c:v>
                </c:pt>
                <c:pt idx="1874">
                  <c:v>4.7386319444444442</c:v>
                </c:pt>
                <c:pt idx="1875">
                  <c:v>4.7388958333333333</c:v>
                </c:pt>
                <c:pt idx="1876">
                  <c:v>4.739152777777778</c:v>
                </c:pt>
                <c:pt idx="1877">
                  <c:v>4.7394166666666671</c:v>
                </c:pt>
                <c:pt idx="1878">
                  <c:v>4.7398194444444446</c:v>
                </c:pt>
                <c:pt idx="1879">
                  <c:v>4.7402152777777777</c:v>
                </c:pt>
                <c:pt idx="1880">
                  <c:v>4.7406180555555553</c:v>
                </c:pt>
                <c:pt idx="1881">
                  <c:v>4.7410208333333328</c:v>
                </c:pt>
                <c:pt idx="1882">
                  <c:v>4.7414166666666668</c:v>
                </c:pt>
                <c:pt idx="1883">
                  <c:v>4.7419652777777781</c:v>
                </c:pt>
                <c:pt idx="1884">
                  <c:v>4.7424027777777784</c:v>
                </c:pt>
                <c:pt idx="1885">
                  <c:v>4.7428333333333335</c:v>
                </c:pt>
                <c:pt idx="1886">
                  <c:v>4.7432708333333338</c:v>
                </c:pt>
                <c:pt idx="1887">
                  <c:v>4.7437083333333332</c:v>
                </c:pt>
                <c:pt idx="1888">
                  <c:v>4.7441458333333335</c:v>
                </c:pt>
                <c:pt idx="1889">
                  <c:v>4.7445763888888886</c:v>
                </c:pt>
                <c:pt idx="1890">
                  <c:v>4.7450138888888889</c:v>
                </c:pt>
                <c:pt idx="1891">
                  <c:v>4.7454513888888892</c:v>
                </c:pt>
                <c:pt idx="1892">
                  <c:v>4.7455208333333339</c:v>
                </c:pt>
                <c:pt idx="1893">
                  <c:v>4.7455833333333333</c:v>
                </c:pt>
                <c:pt idx="1894">
                  <c:v>4.7456527777777779</c:v>
                </c:pt>
                <c:pt idx="1895">
                  <c:v>4.7457152777777774</c:v>
                </c:pt>
                <c:pt idx="1896">
                  <c:v>4.745784722222222</c:v>
                </c:pt>
                <c:pt idx="1897">
                  <c:v>4.745916666666667</c:v>
                </c:pt>
                <c:pt idx="1898">
                  <c:v>4.7460486111111111</c:v>
                </c:pt>
                <c:pt idx="1899">
                  <c:v>4.7461736111111108</c:v>
                </c:pt>
                <c:pt idx="1900">
                  <c:v>4.7463055555555558</c:v>
                </c:pt>
                <c:pt idx="1901">
                  <c:v>4.7465347222222221</c:v>
                </c:pt>
                <c:pt idx="1902">
                  <c:v>4.7467638888888892</c:v>
                </c:pt>
                <c:pt idx="1903">
                  <c:v>4.7469861111111111</c:v>
                </c:pt>
                <c:pt idx="1904">
                  <c:v>4.7472152777777774</c:v>
                </c:pt>
                <c:pt idx="1905">
                  <c:v>4.7475624999999999</c:v>
                </c:pt>
                <c:pt idx="1906">
                  <c:v>4.7479027777777771</c:v>
                </c:pt>
                <c:pt idx="1907">
                  <c:v>4.7482430555555561</c:v>
                </c:pt>
                <c:pt idx="1908">
                  <c:v>4.7485902777777778</c:v>
                </c:pt>
                <c:pt idx="1909">
                  <c:v>4.7489305555555559</c:v>
                </c:pt>
                <c:pt idx="1910">
                  <c:v>4.7493194444444446</c:v>
                </c:pt>
                <c:pt idx="1911">
                  <c:v>4.7497083333333334</c:v>
                </c:pt>
                <c:pt idx="1912">
                  <c:v>4.7500972222222222</c:v>
                </c:pt>
                <c:pt idx="1913">
                  <c:v>4.750486111111111</c:v>
                </c:pt>
                <c:pt idx="1914">
                  <c:v>4.7508749999999997</c:v>
                </c:pt>
                <c:pt idx="1915">
                  <c:v>4.7513125</c:v>
                </c:pt>
                <c:pt idx="1916">
                  <c:v>4.7517569444444439</c:v>
                </c:pt>
                <c:pt idx="1917">
                  <c:v>4.7522013888888885</c:v>
                </c:pt>
                <c:pt idx="1918">
                  <c:v>4.7526388888888889</c:v>
                </c:pt>
                <c:pt idx="1919">
                  <c:v>4.7530833333333327</c:v>
                </c:pt>
                <c:pt idx="1920">
                  <c:v>4.753166666666667</c:v>
                </c:pt>
                <c:pt idx="1921">
                  <c:v>4.753243055555556</c:v>
                </c:pt>
                <c:pt idx="1922">
                  <c:v>4.7533194444444442</c:v>
                </c:pt>
                <c:pt idx="1923">
                  <c:v>4.7534027777777776</c:v>
                </c:pt>
                <c:pt idx="1924">
                  <c:v>4.7534791666666667</c:v>
                </c:pt>
                <c:pt idx="1925">
                  <c:v>4.7535902777777777</c:v>
                </c:pt>
                <c:pt idx="1926">
                  <c:v>4.7536944444444442</c:v>
                </c:pt>
                <c:pt idx="1927">
                  <c:v>4.7537986111111117</c:v>
                </c:pt>
                <c:pt idx="1928">
                  <c:v>4.7539097222222226</c:v>
                </c:pt>
                <c:pt idx="1929">
                  <c:v>4.7541250000000002</c:v>
                </c:pt>
                <c:pt idx="1930">
                  <c:v>4.7543402777777777</c:v>
                </c:pt>
                <c:pt idx="1931">
                  <c:v>4.7545555555555561</c:v>
                </c:pt>
                <c:pt idx="1932">
                  <c:v>4.7547708333333336</c:v>
                </c:pt>
                <c:pt idx="1933">
                  <c:v>4.7550625000000002</c:v>
                </c:pt>
                <c:pt idx="1934">
                  <c:v>4.7553472222222224</c:v>
                </c:pt>
                <c:pt idx="1935">
                  <c:v>4.755638888888889</c:v>
                </c:pt>
                <c:pt idx="1936">
                  <c:v>4.7559236111111112</c:v>
                </c:pt>
                <c:pt idx="1937">
                  <c:v>4.7562152777777778</c:v>
                </c:pt>
                <c:pt idx="1938">
                  <c:v>4.7565833333333334</c:v>
                </c:pt>
                <c:pt idx="1939">
                  <c:v>4.756951388888889</c:v>
                </c:pt>
                <c:pt idx="1940">
                  <c:v>4.7573194444444447</c:v>
                </c:pt>
                <c:pt idx="1941">
                  <c:v>4.7576874999999994</c:v>
                </c:pt>
                <c:pt idx="1942">
                  <c:v>4.7580624999999994</c:v>
                </c:pt>
                <c:pt idx="1943">
                  <c:v>4.7584722222222222</c:v>
                </c:pt>
                <c:pt idx="1944">
                  <c:v>4.7588888888888894</c:v>
                </c:pt>
                <c:pt idx="1945">
                  <c:v>4.7593055555555557</c:v>
                </c:pt>
                <c:pt idx="1946">
                  <c:v>4.759722222222222</c:v>
                </c:pt>
                <c:pt idx="1947">
                  <c:v>4.7601388888888891</c:v>
                </c:pt>
                <c:pt idx="1948">
                  <c:v>4.7602152777777782</c:v>
                </c:pt>
                <c:pt idx="1949">
                  <c:v>4.7602916666666664</c:v>
                </c:pt>
                <c:pt idx="1950">
                  <c:v>4.7603680555555554</c:v>
                </c:pt>
                <c:pt idx="1951">
                  <c:v>4.7604444444444445</c:v>
                </c:pt>
                <c:pt idx="1952">
                  <c:v>4.7605208333333326</c:v>
                </c:pt>
                <c:pt idx="1953">
                  <c:v>4.7606458333333332</c:v>
                </c:pt>
                <c:pt idx="1954">
                  <c:v>4.7607777777777782</c:v>
                </c:pt>
                <c:pt idx="1955">
                  <c:v>4.7609027777777779</c:v>
                </c:pt>
                <c:pt idx="1956">
                  <c:v>4.761034722222222</c:v>
                </c:pt>
                <c:pt idx="1957">
                  <c:v>4.7612499999999995</c:v>
                </c:pt>
                <c:pt idx="1958">
                  <c:v>4.7614652777777779</c:v>
                </c:pt>
                <c:pt idx="1959">
                  <c:v>4.7616805555555555</c:v>
                </c:pt>
                <c:pt idx="1960">
                  <c:v>4.7618888888888886</c:v>
                </c:pt>
                <c:pt idx="1961">
                  <c:v>4.7622083333333336</c:v>
                </c:pt>
                <c:pt idx="1962">
                  <c:v>4.7625277777777777</c:v>
                </c:pt>
                <c:pt idx="1963">
                  <c:v>4.7628472222222218</c:v>
                </c:pt>
                <c:pt idx="1964">
                  <c:v>4.7631666666666668</c:v>
                </c:pt>
                <c:pt idx="1965">
                  <c:v>4.7634861111111109</c:v>
                </c:pt>
                <c:pt idx="1966">
                  <c:v>4.7638611111111109</c:v>
                </c:pt>
                <c:pt idx="1967">
                  <c:v>4.7642430555555553</c:v>
                </c:pt>
                <c:pt idx="1968">
                  <c:v>4.7646180555555553</c:v>
                </c:pt>
                <c:pt idx="1969">
                  <c:v>4.7650000000000006</c:v>
                </c:pt>
                <c:pt idx="1970">
                  <c:v>4.7653750000000006</c:v>
                </c:pt>
                <c:pt idx="1971">
                  <c:v>4.7657986111111112</c:v>
                </c:pt>
                <c:pt idx="1972">
                  <c:v>4.7662222222222219</c:v>
                </c:pt>
                <c:pt idx="1973">
                  <c:v>4.7666458333333335</c:v>
                </c:pt>
                <c:pt idx="1974">
                  <c:v>4.7670624999999998</c:v>
                </c:pt>
                <c:pt idx="1975">
                  <c:v>4.7674861111111113</c:v>
                </c:pt>
                <c:pt idx="1976">
                  <c:v>4.7680277777777782</c:v>
                </c:pt>
                <c:pt idx="1977">
                  <c:v>4.7685694444444442</c:v>
                </c:pt>
                <c:pt idx="1978">
                  <c:v>4.7691111111111111</c:v>
                </c:pt>
                <c:pt idx="1979">
                  <c:v>4.769541666666667</c:v>
                </c:pt>
                <c:pt idx="1980">
                  <c:v>4.7699652777777777</c:v>
                </c:pt>
                <c:pt idx="1981">
                  <c:v>4.7703888888888883</c:v>
                </c:pt>
                <c:pt idx="1982">
                  <c:v>4.7708124999999999</c:v>
                </c:pt>
                <c:pt idx="1983">
                  <c:v>4.7712430555555558</c:v>
                </c:pt>
                <c:pt idx="1984">
                  <c:v>4.7716666666666665</c:v>
                </c:pt>
                <c:pt idx="1985">
                  <c:v>4.7720902777777781</c:v>
                </c:pt>
                <c:pt idx="1986">
                  <c:v>4.7725138888888887</c:v>
                </c:pt>
                <c:pt idx="1987">
                  <c:v>4.7729444444444447</c:v>
                </c:pt>
                <c:pt idx="1988">
                  <c:v>4.7734444444444444</c:v>
                </c:pt>
                <c:pt idx="1989">
                  <c:v>4.7739513888888885</c:v>
                </c:pt>
                <c:pt idx="1990">
                  <c:v>4.7744513888888891</c:v>
                </c:pt>
                <c:pt idx="1991">
                  <c:v>4.7749583333333332</c:v>
                </c:pt>
                <c:pt idx="1992">
                  <c:v>4.7754583333333329</c:v>
                </c:pt>
                <c:pt idx="1993">
                  <c:v>4.7759652777777779</c:v>
                </c:pt>
                <c:pt idx="1994">
                  <c:v>4.7760486111111113</c:v>
                </c:pt>
                <c:pt idx="1995">
                  <c:v>4.7761388888888892</c:v>
                </c:pt>
                <c:pt idx="1996">
                  <c:v>4.7762222222222226</c:v>
                </c:pt>
                <c:pt idx="1997">
                  <c:v>4.776305555555556</c:v>
                </c:pt>
                <c:pt idx="1998">
                  <c:v>4.7763958333333338</c:v>
                </c:pt>
                <c:pt idx="1999">
                  <c:v>4.7765138888888892</c:v>
                </c:pt>
                <c:pt idx="2000">
                  <c:v>4.7766319444444445</c:v>
                </c:pt>
                <c:pt idx="2001">
                  <c:v>4.7767500000000007</c:v>
                </c:pt>
                <c:pt idx="2002">
                  <c:v>4.7768611111111117</c:v>
                </c:pt>
                <c:pt idx="2003">
                  <c:v>4.7771319444444442</c:v>
                </c:pt>
                <c:pt idx="2004">
                  <c:v>4.7773958333333333</c:v>
                </c:pt>
                <c:pt idx="2005">
                  <c:v>4.7776597222222223</c:v>
                </c:pt>
                <c:pt idx="2006">
                  <c:v>4.7779236111111114</c:v>
                </c:pt>
                <c:pt idx="2007">
                  <c:v>4.7782777777777783</c:v>
                </c:pt>
                <c:pt idx="2008">
                  <c:v>4.7786388888888887</c:v>
                </c:pt>
                <c:pt idx="2009">
                  <c:v>4.7789930555555555</c:v>
                </c:pt>
                <c:pt idx="2010">
                  <c:v>4.7793541666666668</c:v>
                </c:pt>
                <c:pt idx="2011">
                  <c:v>4.779715277777778</c:v>
                </c:pt>
                <c:pt idx="2012">
                  <c:v>4.7801597222222227</c:v>
                </c:pt>
                <c:pt idx="2013">
                  <c:v>4.7806111111111109</c:v>
                </c:pt>
                <c:pt idx="2014">
                  <c:v>4.7810625</c:v>
                </c:pt>
                <c:pt idx="2015">
                  <c:v>4.7815138888888891</c:v>
                </c:pt>
                <c:pt idx="2016">
                  <c:v>4.7819583333333338</c:v>
                </c:pt>
                <c:pt idx="2017">
                  <c:v>4.7824097222222219</c:v>
                </c:pt>
                <c:pt idx="2018">
                  <c:v>4.782861111111111</c:v>
                </c:pt>
                <c:pt idx="2019">
                  <c:v>4.7833125000000001</c:v>
                </c:pt>
                <c:pt idx="2020">
                  <c:v>4.7838333333333338</c:v>
                </c:pt>
                <c:pt idx="2021">
                  <c:v>4.7843611111111111</c:v>
                </c:pt>
                <c:pt idx="2022">
                  <c:v>4.7848888888888883</c:v>
                </c:pt>
                <c:pt idx="2023">
                  <c:v>4.7854166666666664</c:v>
                </c:pt>
                <c:pt idx="2024">
                  <c:v>4.7859375000000002</c:v>
                </c:pt>
                <c:pt idx="2025">
                  <c:v>4.7864652777777783</c:v>
                </c:pt>
                <c:pt idx="2026">
                  <c:v>4.7872222222222227</c:v>
                </c:pt>
                <c:pt idx="2027">
                  <c:v>4.7879722222222227</c:v>
                </c:pt>
                <c:pt idx="2028">
                  <c:v>4.7887291666666671</c:v>
                </c:pt>
                <c:pt idx="2029">
                  <c:v>4.7894861111111107</c:v>
                </c:pt>
                <c:pt idx="2030">
                  <c:v>4.7902361111111107</c:v>
                </c:pt>
                <c:pt idx="2031">
                  <c:v>4.7909930555555551</c:v>
                </c:pt>
                <c:pt idx="2032">
                  <c:v>4.7917499999999995</c:v>
                </c:pt>
                <c:pt idx="2033">
                  <c:v>4.7924999999999995</c:v>
                </c:pt>
                <c:pt idx="2034">
                  <c:v>4.7932569444444448</c:v>
                </c:pt>
                <c:pt idx="2035">
                  <c:v>4.7940902777777774</c:v>
                </c:pt>
                <c:pt idx="2036">
                  <c:v>4.7949305555555553</c:v>
                </c:pt>
                <c:pt idx="2037">
                  <c:v>4.7957638888888887</c:v>
                </c:pt>
                <c:pt idx="2038">
                  <c:v>4.7966041666666666</c:v>
                </c:pt>
                <c:pt idx="2039">
                  <c:v>4.7974375</c:v>
                </c:pt>
                <c:pt idx="2040">
                  <c:v>4.7982708333333335</c:v>
                </c:pt>
                <c:pt idx="2041">
                  <c:v>4.7991111111111113</c:v>
                </c:pt>
                <c:pt idx="2042">
                  <c:v>4.7997847222222223</c:v>
                </c:pt>
                <c:pt idx="2043">
                  <c:v>4.8004652777777777</c:v>
                </c:pt>
                <c:pt idx="2044">
                  <c:v>4.8011388888888895</c:v>
                </c:pt>
                <c:pt idx="2045">
                  <c:v>4.8012569444444448</c:v>
                </c:pt>
                <c:pt idx="2046">
                  <c:v>4.8013749999999993</c:v>
                </c:pt>
                <c:pt idx="2047">
                  <c:v>4.8014930555555555</c:v>
                </c:pt>
                <c:pt idx="2048">
                  <c:v>4.8016111111111108</c:v>
                </c:pt>
                <c:pt idx="2049">
                  <c:v>4.8017222222222218</c:v>
                </c:pt>
                <c:pt idx="2050">
                  <c:v>4.8019583333333333</c:v>
                </c:pt>
                <c:pt idx="2051">
                  <c:v>4.802194444444444</c:v>
                </c:pt>
                <c:pt idx="2052">
                  <c:v>4.8024236111111112</c:v>
                </c:pt>
                <c:pt idx="2053">
                  <c:v>4.8026597222222218</c:v>
                </c:pt>
                <c:pt idx="2054">
                  <c:v>4.8028958333333334</c:v>
                </c:pt>
                <c:pt idx="2055">
                  <c:v>4.8031249999999996</c:v>
                </c:pt>
                <c:pt idx="2056">
                  <c:v>4.8035277777777781</c:v>
                </c:pt>
                <c:pt idx="2057">
                  <c:v>4.8039236111111112</c:v>
                </c:pt>
                <c:pt idx="2058">
                  <c:v>4.8043194444444444</c:v>
                </c:pt>
                <c:pt idx="2059">
                  <c:v>4.8047152777777775</c:v>
                </c:pt>
                <c:pt idx="2060">
                  <c:v>4.8051111111111107</c:v>
                </c:pt>
                <c:pt idx="2061">
                  <c:v>4.8055138888888882</c:v>
                </c:pt>
                <c:pt idx="2062">
                  <c:v>4.8061041666666666</c:v>
                </c:pt>
                <c:pt idx="2063">
                  <c:v>4.806694444444445</c:v>
                </c:pt>
                <c:pt idx="2064">
                  <c:v>4.8072847222222217</c:v>
                </c:pt>
                <c:pt idx="2065">
                  <c:v>4.8078750000000001</c:v>
                </c:pt>
                <c:pt idx="2066">
                  <c:v>4.8084652777777777</c:v>
                </c:pt>
                <c:pt idx="2067">
                  <c:v>4.809277777777778</c:v>
                </c:pt>
                <c:pt idx="2068">
                  <c:v>4.8100902777777774</c:v>
                </c:pt>
                <c:pt idx="2069">
                  <c:v>4.8109027777777778</c:v>
                </c:pt>
                <c:pt idx="2070">
                  <c:v>4.8117152777777781</c:v>
                </c:pt>
                <c:pt idx="2071">
                  <c:v>4.8125277777777775</c:v>
                </c:pt>
                <c:pt idx="2072">
                  <c:v>4.8133402777777778</c:v>
                </c:pt>
                <c:pt idx="2073">
                  <c:v>4.8142638888888891</c:v>
                </c:pt>
                <c:pt idx="2074">
                  <c:v>4.8151874999999995</c:v>
                </c:pt>
                <c:pt idx="2075">
                  <c:v>4.8161111111111108</c:v>
                </c:pt>
                <c:pt idx="2076">
                  <c:v>4.8170347222222221</c:v>
                </c:pt>
                <c:pt idx="2077">
                  <c:v>4.817951388888889</c:v>
                </c:pt>
                <c:pt idx="2078">
                  <c:v>4.8188750000000002</c:v>
                </c:pt>
                <c:pt idx="2079">
                  <c:v>4.8197986111111115</c:v>
                </c:pt>
                <c:pt idx="2080">
                  <c:v>4.8207222222222219</c:v>
                </c:pt>
                <c:pt idx="2081">
                  <c:v>4.8216458333333332</c:v>
                </c:pt>
                <c:pt idx="2082">
                  <c:v>4.8225555555555548</c:v>
                </c:pt>
                <c:pt idx="2083">
                  <c:v>4.823458333333333</c:v>
                </c:pt>
                <c:pt idx="2084">
                  <c:v>4.8236111111111111</c:v>
                </c:pt>
                <c:pt idx="2085">
                  <c:v>4.8237638888888892</c:v>
                </c:pt>
                <c:pt idx="2086">
                  <c:v>4.8239166666666664</c:v>
                </c:pt>
                <c:pt idx="2087">
                  <c:v>4.8240694444444445</c:v>
                </c:pt>
                <c:pt idx="2088">
                  <c:v>4.8242152777777774</c:v>
                </c:pt>
                <c:pt idx="2089">
                  <c:v>4.8244999999999996</c:v>
                </c:pt>
                <c:pt idx="2090">
                  <c:v>4.8247847222222218</c:v>
                </c:pt>
                <c:pt idx="2091">
                  <c:v>4.8250694444444449</c:v>
                </c:pt>
                <c:pt idx="2092">
                  <c:v>4.8253541666666671</c:v>
                </c:pt>
                <c:pt idx="2093">
                  <c:v>4.8256388888888893</c:v>
                </c:pt>
                <c:pt idx="2094">
                  <c:v>4.8262291666666668</c:v>
                </c:pt>
                <c:pt idx="2095">
                  <c:v>4.8268194444444443</c:v>
                </c:pt>
                <c:pt idx="2096">
                  <c:v>4.8274097222222228</c:v>
                </c:pt>
                <c:pt idx="2097">
                  <c:v>4.8279999999999994</c:v>
                </c:pt>
                <c:pt idx="2098">
                  <c:v>4.8285902777777778</c:v>
                </c:pt>
                <c:pt idx="2099">
                  <c:v>4.8294999999999995</c:v>
                </c:pt>
                <c:pt idx="2100">
                  <c:v>4.8304027777777776</c:v>
                </c:pt>
                <c:pt idx="2101">
                  <c:v>4.8313055555555557</c:v>
                </c:pt>
                <c:pt idx="2102">
                  <c:v>4.832208333333333</c:v>
                </c:pt>
                <c:pt idx="2103">
                  <c:v>4.8331111111111111</c:v>
                </c:pt>
                <c:pt idx="2104">
                  <c:v>4.834194444444444</c:v>
                </c:pt>
                <c:pt idx="2105">
                  <c:v>4.8352708333333334</c:v>
                </c:pt>
                <c:pt idx="2106">
                  <c:v>4.8363472222222219</c:v>
                </c:pt>
                <c:pt idx="2107">
                  <c:v>4.8374236111111113</c:v>
                </c:pt>
                <c:pt idx="2108">
                  <c:v>4.8385069444444442</c:v>
                </c:pt>
                <c:pt idx="2109">
                  <c:v>4.8395833333333336</c:v>
                </c:pt>
                <c:pt idx="2110">
                  <c:v>4.8409722222222218</c:v>
                </c:pt>
                <c:pt idx="2111">
                  <c:v>4.8423611111111109</c:v>
                </c:pt>
                <c:pt idx="2112">
                  <c:v>4.84375</c:v>
                </c:pt>
                <c:pt idx="2113">
                  <c:v>4.8451388888888891</c:v>
                </c:pt>
                <c:pt idx="2114">
                  <c:v>4.8465277777777782</c:v>
                </c:pt>
                <c:pt idx="2115">
                  <c:v>4.8479236111111117</c:v>
                </c:pt>
                <c:pt idx="2116">
                  <c:v>4.8496319444444449</c:v>
                </c:pt>
                <c:pt idx="2117">
                  <c:v>4.8513472222222216</c:v>
                </c:pt>
                <c:pt idx="2118">
                  <c:v>4.8530625000000001</c:v>
                </c:pt>
                <c:pt idx="2119">
                  <c:v>4.8547708333333333</c:v>
                </c:pt>
                <c:pt idx="2120">
                  <c:v>4.8564861111111108</c:v>
                </c:pt>
                <c:pt idx="2121">
                  <c:v>4.8582013888888893</c:v>
                </c:pt>
                <c:pt idx="2122">
                  <c:v>4.8599166666666669</c:v>
                </c:pt>
                <c:pt idx="2123">
                  <c:v>4.8601597222222219</c:v>
                </c:pt>
                <c:pt idx="2124">
                  <c:v>4.8604097222222222</c:v>
                </c:pt>
                <c:pt idx="2125">
                  <c:v>4.8606597222222225</c:v>
                </c:pt>
                <c:pt idx="2126">
                  <c:v>4.860909722222222</c:v>
                </c:pt>
                <c:pt idx="2127">
                  <c:v>4.8611597222222223</c:v>
                </c:pt>
                <c:pt idx="2128">
                  <c:v>4.861659722222222</c:v>
                </c:pt>
                <c:pt idx="2129">
                  <c:v>4.8621527777777782</c:v>
                </c:pt>
                <c:pt idx="2130">
                  <c:v>4.8626527777777779</c:v>
                </c:pt>
                <c:pt idx="2131">
                  <c:v>4.8631527777777777</c:v>
                </c:pt>
                <c:pt idx="2132">
                  <c:v>4.8640138888888895</c:v>
                </c:pt>
                <c:pt idx="2133">
                  <c:v>4.8648749999999996</c:v>
                </c:pt>
                <c:pt idx="2134">
                  <c:v>4.8657361111111106</c:v>
                </c:pt>
                <c:pt idx="2135">
                  <c:v>4.8665972222222216</c:v>
                </c:pt>
                <c:pt idx="2136">
                  <c:v>4.8674583333333334</c:v>
                </c:pt>
                <c:pt idx="2137">
                  <c:v>4.8687083333333332</c:v>
                </c:pt>
                <c:pt idx="2138">
                  <c:v>4.8699652777777782</c:v>
                </c:pt>
                <c:pt idx="2139">
                  <c:v>4.871215277777778</c:v>
                </c:pt>
                <c:pt idx="2140">
                  <c:v>4.8724652777777777</c:v>
                </c:pt>
                <c:pt idx="2141">
                  <c:v>4.8737222222222218</c:v>
                </c:pt>
                <c:pt idx="2142">
                  <c:v>4.8754722222222222</c:v>
                </c:pt>
                <c:pt idx="2143">
                  <c:v>4.8772222222222217</c:v>
                </c:pt>
                <c:pt idx="2144">
                  <c:v>4.878972222222222</c:v>
                </c:pt>
                <c:pt idx="2145">
                  <c:v>4.8807222222222224</c:v>
                </c:pt>
                <c:pt idx="2146">
                  <c:v>4.8824722222222228</c:v>
                </c:pt>
                <c:pt idx="2147">
                  <c:v>4.8842222222222222</c:v>
                </c:pt>
                <c:pt idx="2148">
                  <c:v>4.8865625000000001</c:v>
                </c:pt>
                <c:pt idx="2149">
                  <c:v>4.8889097222222224</c:v>
                </c:pt>
                <c:pt idx="2150">
                  <c:v>4.8912499999999994</c:v>
                </c:pt>
                <c:pt idx="2151">
                  <c:v>4.8935902777777782</c:v>
                </c:pt>
                <c:pt idx="2152">
                  <c:v>4.8959305555555561</c:v>
                </c:pt>
                <c:pt idx="2153">
                  <c:v>4.8982708333333331</c:v>
                </c:pt>
                <c:pt idx="2154">
                  <c:v>4.9011597222222223</c:v>
                </c:pt>
                <c:pt idx="2155">
                  <c:v>4.9040416666666662</c:v>
                </c:pt>
                <c:pt idx="2156">
                  <c:v>4.9069305555555554</c:v>
                </c:pt>
                <c:pt idx="2157">
                  <c:v>4.9098125000000001</c:v>
                </c:pt>
                <c:pt idx="2158">
                  <c:v>4.9127013888888893</c:v>
                </c:pt>
                <c:pt idx="2159">
                  <c:v>4.9131319444444443</c:v>
                </c:pt>
                <c:pt idx="2160">
                  <c:v>4.9135624999999994</c:v>
                </c:pt>
                <c:pt idx="2161">
                  <c:v>4.9139930555555553</c:v>
                </c:pt>
                <c:pt idx="2162">
                  <c:v>4.9144236111111113</c:v>
                </c:pt>
                <c:pt idx="2163">
                  <c:v>4.9148541666666672</c:v>
                </c:pt>
                <c:pt idx="2164">
                  <c:v>4.9154652777777779</c:v>
                </c:pt>
                <c:pt idx="2165">
                  <c:v>4.9160763888888885</c:v>
                </c:pt>
                <c:pt idx="2166">
                  <c:v>4.9166875000000001</c:v>
                </c:pt>
                <c:pt idx="2167">
                  <c:v>4.9172986111111108</c:v>
                </c:pt>
                <c:pt idx="2168">
                  <c:v>4.9187569444444446</c:v>
                </c:pt>
                <c:pt idx="2169">
                  <c:v>4.920208333333334</c:v>
                </c:pt>
                <c:pt idx="2170">
                  <c:v>4.9216666666666669</c:v>
                </c:pt>
                <c:pt idx="2171">
                  <c:v>4.9231180555555554</c:v>
                </c:pt>
                <c:pt idx="2172">
                  <c:v>4.9255486111111111</c:v>
                </c:pt>
                <c:pt idx="2173">
                  <c:v>4.9279791666666668</c:v>
                </c:pt>
                <c:pt idx="2174">
                  <c:v>4.9304097222222225</c:v>
                </c:pt>
                <c:pt idx="2175">
                  <c:v>4.9328402777777773</c:v>
                </c:pt>
                <c:pt idx="2176">
                  <c:v>4.9352708333333331</c:v>
                </c:pt>
                <c:pt idx="2177">
                  <c:v>4.9376944444444444</c:v>
                </c:pt>
                <c:pt idx="2178">
                  <c:v>4.9401250000000001</c:v>
                </c:pt>
                <c:pt idx="2179">
                  <c:v>4.9425555555555558</c:v>
                </c:pt>
                <c:pt idx="2180">
                  <c:v>4.9456388888888894</c:v>
                </c:pt>
                <c:pt idx="2181">
                  <c:v>4.948722222222222</c:v>
                </c:pt>
                <c:pt idx="2182">
                  <c:v>4.9517986111111112</c:v>
                </c:pt>
                <c:pt idx="2183">
                  <c:v>4.9548819444444439</c:v>
                </c:pt>
                <c:pt idx="2184">
                  <c:v>4.9579652777777783</c:v>
                </c:pt>
                <c:pt idx="2185">
                  <c:v>4.9614722222222225</c:v>
                </c:pt>
                <c:pt idx="2186">
                  <c:v>4.9649861111111111</c:v>
                </c:pt>
                <c:pt idx="2187">
                  <c:v>4.9684930555555553</c:v>
                </c:pt>
                <c:pt idx="2188">
                  <c:v>4.9720069444444439</c:v>
                </c:pt>
                <c:pt idx="2189">
                  <c:v>4.975513888888889</c:v>
                </c:pt>
                <c:pt idx="2190">
                  <c:v>4.9796388888888892</c:v>
                </c:pt>
                <c:pt idx="2191">
                  <c:v>4.9837638888888884</c:v>
                </c:pt>
                <c:pt idx="2192">
                  <c:v>4.9878888888888895</c:v>
                </c:pt>
                <c:pt idx="2193">
                  <c:v>4.9920138888888888</c:v>
                </c:pt>
                <c:pt idx="2194">
                  <c:v>4.9961388888888889</c:v>
                </c:pt>
                <c:pt idx="2195">
                  <c:v>5</c:v>
                </c:pt>
              </c:numCache>
            </c:numRef>
          </c:xVal>
          <c:yVal>
            <c:numRef>
              <c:f>Sheet1!$I$4:$I$2199</c:f>
              <c:numCache>
                <c:formatCode>0.00E+00</c:formatCode>
                <c:ptCount val="2196"/>
                <c:pt idx="0">
                  <c:v>9.9999999999999995E-7</c:v>
                </c:pt>
                <c:pt idx="1">
                  <c:v>9.9999999999999995E-7</c:v>
                </c:pt>
                <c:pt idx="2">
                  <c:v>9.9999999999999995E-7</c:v>
                </c:pt>
                <c:pt idx="3">
                  <c:v>9.9999999999999995E-7</c:v>
                </c:pt>
                <c:pt idx="4">
                  <c:v>9.9999999999999995E-7</c:v>
                </c:pt>
                <c:pt idx="5">
                  <c:v>9.9999999999999995E-7</c:v>
                </c:pt>
                <c:pt idx="6">
                  <c:v>9.9999999999999995E-7</c:v>
                </c:pt>
                <c:pt idx="7">
                  <c:v>9.9999999999999995E-7</c:v>
                </c:pt>
                <c:pt idx="8">
                  <c:v>9.9999999999999995E-7</c:v>
                </c:pt>
                <c:pt idx="9">
                  <c:v>9.9999999999999995E-7</c:v>
                </c:pt>
                <c:pt idx="10">
                  <c:v>1.00001E-6</c:v>
                </c:pt>
                <c:pt idx="11">
                  <c:v>1.00001E-6</c:v>
                </c:pt>
                <c:pt idx="12">
                  <c:v>1.0000200000000001E-6</c:v>
                </c:pt>
                <c:pt idx="13">
                  <c:v>1.0000200000000001E-6</c:v>
                </c:pt>
                <c:pt idx="14">
                  <c:v>1.0000500000000001E-6</c:v>
                </c:pt>
                <c:pt idx="15">
                  <c:v>1.00008E-6</c:v>
                </c:pt>
                <c:pt idx="16">
                  <c:v>1.00011E-6</c:v>
                </c:pt>
                <c:pt idx="17">
                  <c:v>1.0001599999999999E-6</c:v>
                </c:pt>
                <c:pt idx="18">
                  <c:v>1.0002200000000001E-6</c:v>
                </c:pt>
                <c:pt idx="19">
                  <c:v>1.0002800000000001E-6</c:v>
                </c:pt>
                <c:pt idx="20">
                  <c:v>1.0003599999999999E-6</c:v>
                </c:pt>
                <c:pt idx="21">
                  <c:v>1.0004500000000001E-6</c:v>
                </c:pt>
                <c:pt idx="22">
                  <c:v>1.00053E-6</c:v>
                </c:pt>
                <c:pt idx="23">
                  <c:v>1.0006E-6</c:v>
                </c:pt>
                <c:pt idx="24">
                  <c:v>1.0006800000000001E-6</c:v>
                </c:pt>
                <c:pt idx="25">
                  <c:v>1.0007499999999999E-6</c:v>
                </c:pt>
                <c:pt idx="26">
                  <c:v>1.00079E-6</c:v>
                </c:pt>
                <c:pt idx="27">
                  <c:v>1.0008199999999999E-6</c:v>
                </c:pt>
                <c:pt idx="28">
                  <c:v>1.0008499999999999E-6</c:v>
                </c:pt>
                <c:pt idx="29">
                  <c:v>1.0008800000000001E-6</c:v>
                </c:pt>
                <c:pt idx="30">
                  <c:v>1.0009100000000001E-6</c:v>
                </c:pt>
                <c:pt idx="31">
                  <c:v>1.0009400000000001E-6</c:v>
                </c:pt>
                <c:pt idx="32">
                  <c:v>1.0009799999999999E-6</c:v>
                </c:pt>
                <c:pt idx="33">
                  <c:v>1.00103E-6</c:v>
                </c:pt>
                <c:pt idx="34">
                  <c:v>1.0010700000000001E-6</c:v>
                </c:pt>
                <c:pt idx="35">
                  <c:v>1.0013400000000001E-6</c:v>
                </c:pt>
                <c:pt idx="36">
                  <c:v>1.0014099999999999E-6</c:v>
                </c:pt>
                <c:pt idx="37">
                  <c:v>1.0014799999999999E-6</c:v>
                </c:pt>
                <c:pt idx="38">
                  <c:v>1.00155E-6</c:v>
                </c:pt>
                <c:pt idx="39">
                  <c:v>1.00162E-6</c:v>
                </c:pt>
                <c:pt idx="40">
                  <c:v>1.00165E-6</c:v>
                </c:pt>
                <c:pt idx="41">
                  <c:v>1.00168E-6</c:v>
                </c:pt>
                <c:pt idx="42">
                  <c:v>1.0017099999999999E-6</c:v>
                </c:pt>
                <c:pt idx="43">
                  <c:v>1.0017399999999999E-6</c:v>
                </c:pt>
                <c:pt idx="44">
                  <c:v>1.00176E-6</c:v>
                </c:pt>
                <c:pt idx="45">
                  <c:v>1.00179E-6</c:v>
                </c:pt>
                <c:pt idx="46">
                  <c:v>1.0018399999999999E-6</c:v>
                </c:pt>
                <c:pt idx="47">
                  <c:v>1.00189E-6</c:v>
                </c:pt>
                <c:pt idx="48">
                  <c:v>1.0019300000000001E-6</c:v>
                </c:pt>
                <c:pt idx="49">
                  <c:v>1.0022900000000001E-6</c:v>
                </c:pt>
                <c:pt idx="50">
                  <c:v>1.00238E-6</c:v>
                </c:pt>
                <c:pt idx="51">
                  <c:v>1.0025600000000001E-6</c:v>
                </c:pt>
                <c:pt idx="52">
                  <c:v>1.00274E-6</c:v>
                </c:pt>
                <c:pt idx="53">
                  <c:v>1.0029200000000001E-6</c:v>
                </c:pt>
                <c:pt idx="54">
                  <c:v>1.0031E-6</c:v>
                </c:pt>
                <c:pt idx="55">
                  <c:v>1.0035499999999999E-6</c:v>
                </c:pt>
                <c:pt idx="56">
                  <c:v>1.0040099999999999E-6</c:v>
                </c:pt>
                <c:pt idx="57">
                  <c:v>1.00446E-6</c:v>
                </c:pt>
                <c:pt idx="58">
                  <c:v>1.00491E-6</c:v>
                </c:pt>
                <c:pt idx="59">
                  <c:v>1.0055299999999999E-6</c:v>
                </c:pt>
                <c:pt idx="60">
                  <c:v>1.0061500000000001E-6</c:v>
                </c:pt>
                <c:pt idx="61">
                  <c:v>1.0067700000000001E-6</c:v>
                </c:pt>
                <c:pt idx="62">
                  <c:v>1.00739E-6</c:v>
                </c:pt>
                <c:pt idx="63">
                  <c:v>1.0085200000000001E-6</c:v>
                </c:pt>
                <c:pt idx="64">
                  <c:v>1.00966E-6</c:v>
                </c:pt>
                <c:pt idx="65">
                  <c:v>1.0107999999999999E-6</c:v>
                </c:pt>
                <c:pt idx="66">
                  <c:v>1.01194E-6</c:v>
                </c:pt>
                <c:pt idx="67">
                  <c:v>1.01309E-6</c:v>
                </c:pt>
                <c:pt idx="68">
                  <c:v>1.0145199999999999E-6</c:v>
                </c:pt>
                <c:pt idx="69">
                  <c:v>1.0159600000000001E-6</c:v>
                </c:pt>
                <c:pt idx="70">
                  <c:v>1.0174E-6</c:v>
                </c:pt>
                <c:pt idx="71">
                  <c:v>1.0188399999999999E-6</c:v>
                </c:pt>
                <c:pt idx="72">
                  <c:v>1.0202899999999999E-6</c:v>
                </c:pt>
                <c:pt idx="73">
                  <c:v>1.02258E-6</c:v>
                </c:pt>
                <c:pt idx="74">
                  <c:v>1.02488E-6</c:v>
                </c:pt>
                <c:pt idx="75">
                  <c:v>1.02719E-6</c:v>
                </c:pt>
                <c:pt idx="76">
                  <c:v>1.0295099999999999E-6</c:v>
                </c:pt>
                <c:pt idx="77">
                  <c:v>1.0318499999999999E-6</c:v>
                </c:pt>
                <c:pt idx="78">
                  <c:v>1.0342E-6</c:v>
                </c:pt>
                <c:pt idx="79">
                  <c:v>1.03792E-6</c:v>
                </c:pt>
                <c:pt idx="80">
                  <c:v>1.04168E-6</c:v>
                </c:pt>
                <c:pt idx="81">
                  <c:v>1.04547E-6</c:v>
                </c:pt>
                <c:pt idx="82">
                  <c:v>1.0492799999999999E-6</c:v>
                </c:pt>
                <c:pt idx="83">
                  <c:v>1.0531299999999999E-6</c:v>
                </c:pt>
                <c:pt idx="84">
                  <c:v>1.057E-6</c:v>
                </c:pt>
                <c:pt idx="85">
                  <c:v>1.0613600000000001E-6</c:v>
                </c:pt>
                <c:pt idx="86">
                  <c:v>1.0657499999999999E-6</c:v>
                </c:pt>
                <c:pt idx="87">
                  <c:v>1.0701900000000001E-6</c:v>
                </c:pt>
                <c:pt idx="88">
                  <c:v>1.07466E-6</c:v>
                </c:pt>
                <c:pt idx="89">
                  <c:v>1.07917E-6</c:v>
                </c:pt>
                <c:pt idx="90">
                  <c:v>1.08371E-6</c:v>
                </c:pt>
                <c:pt idx="91">
                  <c:v>1.08892E-6</c:v>
                </c:pt>
                <c:pt idx="92">
                  <c:v>1.0941700000000001E-6</c:v>
                </c:pt>
                <c:pt idx="93">
                  <c:v>1.0994800000000001E-6</c:v>
                </c:pt>
                <c:pt idx="94">
                  <c:v>1.10483E-6</c:v>
                </c:pt>
                <c:pt idx="95">
                  <c:v>1.11024E-6</c:v>
                </c:pt>
                <c:pt idx="96">
                  <c:v>1.1156899999999999E-6</c:v>
                </c:pt>
                <c:pt idx="97">
                  <c:v>1.1165700000000001E-6</c:v>
                </c:pt>
                <c:pt idx="98">
                  <c:v>1.1174399999999999E-6</c:v>
                </c:pt>
                <c:pt idx="99">
                  <c:v>1.1183200000000001E-6</c:v>
                </c:pt>
                <c:pt idx="100">
                  <c:v>1.1192E-6</c:v>
                </c:pt>
                <c:pt idx="101">
                  <c:v>1.1200700000000001E-6</c:v>
                </c:pt>
                <c:pt idx="102">
                  <c:v>1.1215800000000001E-6</c:v>
                </c:pt>
                <c:pt idx="103">
                  <c:v>1.12309E-6</c:v>
                </c:pt>
                <c:pt idx="104">
                  <c:v>1.1246E-6</c:v>
                </c:pt>
                <c:pt idx="105">
                  <c:v>1.12611E-6</c:v>
                </c:pt>
                <c:pt idx="106">
                  <c:v>1.12763E-6</c:v>
                </c:pt>
                <c:pt idx="107">
                  <c:v>1.1307100000000001E-6</c:v>
                </c:pt>
                <c:pt idx="108">
                  <c:v>1.1338000000000001E-6</c:v>
                </c:pt>
                <c:pt idx="109">
                  <c:v>1.1369099999999999E-6</c:v>
                </c:pt>
                <c:pt idx="110">
                  <c:v>1.1400399999999999E-6</c:v>
                </c:pt>
                <c:pt idx="111">
                  <c:v>1.14318E-6</c:v>
                </c:pt>
                <c:pt idx="112">
                  <c:v>1.14931E-6</c:v>
                </c:pt>
                <c:pt idx="113">
                  <c:v>1.1555E-6</c:v>
                </c:pt>
                <c:pt idx="114">
                  <c:v>1.16176E-6</c:v>
                </c:pt>
                <c:pt idx="115">
                  <c:v>1.1680699999999999E-6</c:v>
                </c:pt>
                <c:pt idx="116">
                  <c:v>1.17444E-6</c:v>
                </c:pt>
                <c:pt idx="117">
                  <c:v>1.18206E-6</c:v>
                </c:pt>
                <c:pt idx="118">
                  <c:v>1.18976E-6</c:v>
                </c:pt>
                <c:pt idx="119">
                  <c:v>1.1975500000000001E-6</c:v>
                </c:pt>
                <c:pt idx="120">
                  <c:v>1.2054200000000001E-6</c:v>
                </c:pt>
                <c:pt idx="121">
                  <c:v>1.21339E-6</c:v>
                </c:pt>
                <c:pt idx="122">
                  <c:v>1.2214399999999999E-6</c:v>
                </c:pt>
                <c:pt idx="123">
                  <c:v>1.2343500000000001E-6</c:v>
                </c:pt>
                <c:pt idx="124">
                  <c:v>1.2474999999999999E-6</c:v>
                </c:pt>
                <c:pt idx="125">
                  <c:v>1.2608700000000001E-6</c:v>
                </c:pt>
                <c:pt idx="126">
                  <c:v>1.2744700000000001E-6</c:v>
                </c:pt>
                <c:pt idx="127">
                  <c:v>1.2883E-6</c:v>
                </c:pt>
                <c:pt idx="128">
                  <c:v>1.30237E-6</c:v>
                </c:pt>
                <c:pt idx="129">
                  <c:v>1.3248800000000001E-6</c:v>
                </c:pt>
                <c:pt idx="130">
                  <c:v>1.3479799999999999E-6</c:v>
                </c:pt>
                <c:pt idx="131">
                  <c:v>1.3716900000000001E-6</c:v>
                </c:pt>
                <c:pt idx="132">
                  <c:v>1.39602E-6</c:v>
                </c:pt>
                <c:pt idx="133">
                  <c:v>1.421E-6</c:v>
                </c:pt>
                <c:pt idx="134">
                  <c:v>1.44662E-6</c:v>
                </c:pt>
                <c:pt idx="135">
                  <c:v>1.4866600000000001E-6</c:v>
                </c:pt>
                <c:pt idx="136">
                  <c:v>1.52826E-6</c:v>
                </c:pt>
                <c:pt idx="137">
                  <c:v>1.57148E-6</c:v>
                </c:pt>
                <c:pt idx="138">
                  <c:v>1.6163699999999999E-6</c:v>
                </c:pt>
                <c:pt idx="139">
                  <c:v>1.6629800000000001E-6</c:v>
                </c:pt>
                <c:pt idx="140">
                  <c:v>1.7113700000000001E-6</c:v>
                </c:pt>
                <c:pt idx="141">
                  <c:v>1.78028E-6</c:v>
                </c:pt>
                <c:pt idx="142">
                  <c:v>1.85275E-6</c:v>
                </c:pt>
                <c:pt idx="143">
                  <c:v>1.9289599999999998E-6</c:v>
                </c:pt>
                <c:pt idx="144">
                  <c:v>2.00907E-6</c:v>
                </c:pt>
                <c:pt idx="145">
                  <c:v>2.0932600000000001E-6</c:v>
                </c:pt>
                <c:pt idx="146">
                  <c:v>2.1817300000000002E-6</c:v>
                </c:pt>
                <c:pt idx="147">
                  <c:v>2.3133599999999999E-6</c:v>
                </c:pt>
                <c:pt idx="148">
                  <c:v>2.45438E-6</c:v>
                </c:pt>
                <c:pt idx="149">
                  <c:v>2.6054099999999999E-6</c:v>
                </c:pt>
                <c:pt idx="150">
                  <c:v>2.7671199999999999E-6</c:v>
                </c:pt>
                <c:pt idx="151">
                  <c:v>2.9402499999999999E-6</c:v>
                </c:pt>
                <c:pt idx="152">
                  <c:v>3.17966E-6</c:v>
                </c:pt>
                <c:pt idx="153">
                  <c:v>3.4407599999999999E-6</c:v>
                </c:pt>
                <c:pt idx="154">
                  <c:v>3.7254500000000001E-6</c:v>
                </c:pt>
                <c:pt idx="155">
                  <c:v>4.0358000000000004E-6</c:v>
                </c:pt>
                <c:pt idx="156">
                  <c:v>4.3740699999999998E-6</c:v>
                </c:pt>
                <c:pt idx="157">
                  <c:v>4.7427200000000001E-6</c:v>
                </c:pt>
                <c:pt idx="158">
                  <c:v>5.2495399999999997E-6</c:v>
                </c:pt>
                <c:pt idx="159">
                  <c:v>5.8136100000000004E-6</c:v>
                </c:pt>
                <c:pt idx="160">
                  <c:v>6.4412999999999996E-6</c:v>
                </c:pt>
                <c:pt idx="161">
                  <c:v>7.1397200000000001E-6</c:v>
                </c:pt>
                <c:pt idx="162">
                  <c:v>7.9167500000000001E-6</c:v>
                </c:pt>
                <c:pt idx="163">
                  <c:v>8.7811800000000002E-6</c:v>
                </c:pt>
                <c:pt idx="164">
                  <c:v>9.7427499999999992E-6</c:v>
                </c:pt>
                <c:pt idx="165">
                  <c:v>1.08123E-5</c:v>
                </c:pt>
                <c:pt idx="166">
                  <c:v>1.2002E-5</c:v>
                </c:pt>
                <c:pt idx="167">
                  <c:v>1.3325100000000001E-5</c:v>
                </c:pt>
                <c:pt idx="168">
                  <c:v>1.47967E-5</c:v>
                </c:pt>
                <c:pt idx="169">
                  <c:v>1.6433300000000001E-5</c:v>
                </c:pt>
                <c:pt idx="170">
                  <c:v>1.82533E-5</c:v>
                </c:pt>
                <c:pt idx="171">
                  <c:v>2.02773E-5</c:v>
                </c:pt>
                <c:pt idx="172">
                  <c:v>2.2527999999999998E-5</c:v>
                </c:pt>
                <c:pt idx="173">
                  <c:v>2.5030900000000001E-5</c:v>
                </c:pt>
                <c:pt idx="174">
                  <c:v>2.7814099999999999E-5</c:v>
                </c:pt>
                <c:pt idx="175">
                  <c:v>3.0908999999999998E-5</c:v>
                </c:pt>
                <c:pt idx="176">
                  <c:v>3.4350500000000003E-5</c:v>
                </c:pt>
                <c:pt idx="177">
                  <c:v>3.8177299999999998E-5</c:v>
                </c:pt>
                <c:pt idx="178">
                  <c:v>4.2432399999999997E-5</c:v>
                </c:pt>
                <c:pt idx="179">
                  <c:v>4.7163899999999997E-5</c:v>
                </c:pt>
                <c:pt idx="180">
                  <c:v>5.24249E-5</c:v>
                </c:pt>
                <c:pt idx="181">
                  <c:v>5.82748E-5</c:v>
                </c:pt>
                <c:pt idx="182">
                  <c:v>6.4779399999999998E-5</c:v>
                </c:pt>
                <c:pt idx="183">
                  <c:v>7.2012000000000001E-5</c:v>
                </c:pt>
                <c:pt idx="184">
                  <c:v>8.0053899999999996E-5</c:v>
                </c:pt>
                <c:pt idx="185">
                  <c:v>8.8995599999999999E-5</c:v>
                </c:pt>
                <c:pt idx="186">
                  <c:v>9.8937999999999994E-5</c:v>
                </c:pt>
                <c:pt idx="187" formatCode="General">
                  <c:v>1.09993E-4</c:v>
                </c:pt>
                <c:pt idx="188" formatCode="General">
                  <c:v>1.22285E-4</c:v>
                </c:pt>
                <c:pt idx="189" formatCode="General">
                  <c:v>1.35952E-4</c:v>
                </c:pt>
                <c:pt idx="190" formatCode="General">
                  <c:v>1.5114800000000001E-4</c:v>
                </c:pt>
                <c:pt idx="191" formatCode="General">
                  <c:v>1.6804400000000001E-4</c:v>
                </c:pt>
                <c:pt idx="192" formatCode="General">
                  <c:v>1.8683099999999999E-4</c:v>
                </c:pt>
                <c:pt idx="193" formatCode="General">
                  <c:v>2.0771900000000001E-4</c:v>
                </c:pt>
                <c:pt idx="194" formatCode="General">
                  <c:v>2.3094500000000001E-4</c:v>
                </c:pt>
                <c:pt idx="195" formatCode="General">
                  <c:v>2.5676900000000001E-4</c:v>
                </c:pt>
                <c:pt idx="196" formatCode="General">
                  <c:v>2.8548199999999999E-4</c:v>
                </c:pt>
                <c:pt idx="197" formatCode="General">
                  <c:v>3.1740700000000002E-4</c:v>
                </c:pt>
                <c:pt idx="198" formatCode="General">
                  <c:v>3.5290400000000002E-4</c:v>
                </c:pt>
                <c:pt idx="199" formatCode="General">
                  <c:v>3.9237199999999999E-4</c:v>
                </c:pt>
                <c:pt idx="200" formatCode="General">
                  <c:v>4.3625599999999999E-4</c:v>
                </c:pt>
                <c:pt idx="201" formatCode="General">
                  <c:v>4.8504800000000002E-4</c:v>
                </c:pt>
                <c:pt idx="202" formatCode="General">
                  <c:v>5.3930000000000004E-4</c:v>
                </c:pt>
                <c:pt idx="203" formatCode="General">
                  <c:v>5.9962000000000004E-4</c:v>
                </c:pt>
                <c:pt idx="204" formatCode="General">
                  <c:v>6.6668900000000004E-4</c:v>
                </c:pt>
                <c:pt idx="205" formatCode="General">
                  <c:v>7.4125999999999999E-4</c:v>
                </c:pt>
                <c:pt idx="206" formatCode="General">
                  <c:v>8.2417299999999998E-4</c:v>
                </c:pt>
                <c:pt idx="207" formatCode="General">
                  <c:v>9.1636199999999999E-4</c:v>
                </c:pt>
                <c:pt idx="208" formatCode="General">
                  <c:v>1.0188599999999999E-3</c:v>
                </c:pt>
                <c:pt idx="209" formatCode="General">
                  <c:v>1.13283E-3</c:v>
                </c:pt>
                <c:pt idx="210" formatCode="General">
                  <c:v>1.2595499999999999E-3</c:v>
                </c:pt>
                <c:pt idx="211" formatCode="General">
                  <c:v>1.4004499999999999E-3</c:v>
                </c:pt>
                <c:pt idx="212" formatCode="General">
                  <c:v>1.5571000000000001E-3</c:v>
                </c:pt>
                <c:pt idx="213" formatCode="General">
                  <c:v>1.73128E-3</c:v>
                </c:pt>
                <c:pt idx="214" formatCode="General">
                  <c:v>1.9249499999999999E-3</c:v>
                </c:pt>
                <c:pt idx="215" formatCode="General">
                  <c:v>2.1402700000000001E-3</c:v>
                </c:pt>
                <c:pt idx="216" formatCode="General">
                  <c:v>2.3796899999999998E-3</c:v>
                </c:pt>
                <c:pt idx="217" formatCode="General">
                  <c:v>2.6458900000000001E-3</c:v>
                </c:pt>
                <c:pt idx="218" formatCode="General">
                  <c:v>2.9418700000000001E-3</c:v>
                </c:pt>
                <c:pt idx="219" formatCode="General">
                  <c:v>3.2709599999999998E-3</c:v>
                </c:pt>
                <c:pt idx="220" formatCode="General">
                  <c:v>3.63686E-3</c:v>
                </c:pt>
                <c:pt idx="221" formatCode="General">
                  <c:v>4.04369E-3</c:v>
                </c:pt>
                <c:pt idx="222" formatCode="General">
                  <c:v>4.4960399999999998E-3</c:v>
                </c:pt>
                <c:pt idx="223" formatCode="General">
                  <c:v>4.9989800000000001E-3</c:v>
                </c:pt>
                <c:pt idx="224" formatCode="General">
                  <c:v>5.5581800000000002E-3</c:v>
                </c:pt>
                <c:pt idx="225" formatCode="General">
                  <c:v>6.1799400000000001E-3</c:v>
                </c:pt>
                <c:pt idx="226" formatCode="General">
                  <c:v>6.8712499999999998E-3</c:v>
                </c:pt>
                <c:pt idx="227" formatCode="General">
                  <c:v>7.6398899999999999E-3</c:v>
                </c:pt>
                <c:pt idx="228" formatCode="General">
                  <c:v>8.4945100000000003E-3</c:v>
                </c:pt>
                <c:pt idx="229" formatCode="General">
                  <c:v>9.4447300000000001E-3</c:v>
                </c:pt>
                <c:pt idx="230" formatCode="General">
                  <c:v>1.05012E-2</c:v>
                </c:pt>
                <c:pt idx="231" formatCode="General">
                  <c:v>1.1675899999999999E-2</c:v>
                </c:pt>
                <c:pt idx="232" formatCode="General">
                  <c:v>1.2982E-2</c:v>
                </c:pt>
                <c:pt idx="233" formatCode="General">
                  <c:v>1.4434199999999999E-2</c:v>
                </c:pt>
                <c:pt idx="234" formatCode="General">
                  <c:v>1.6048799999999998E-2</c:v>
                </c:pt>
                <c:pt idx="235" formatCode="General">
                  <c:v>1.7843999999999999E-2</c:v>
                </c:pt>
                <c:pt idx="236" formatCode="General">
                  <c:v>1.9839900000000001E-2</c:v>
                </c:pt>
                <c:pt idx="237" formatCode="General">
                  <c:v>2.2059200000000001E-2</c:v>
                </c:pt>
                <c:pt idx="238" formatCode="General">
                  <c:v>2.4526599999999999E-2</c:v>
                </c:pt>
                <c:pt idx="239" formatCode="General">
                  <c:v>2.7269999999999999E-2</c:v>
                </c:pt>
                <c:pt idx="240" formatCode="General">
                  <c:v>3.0320199999999999E-2</c:v>
                </c:pt>
                <c:pt idx="241" formatCode="General">
                  <c:v>3.3711600000000001E-2</c:v>
                </c:pt>
                <c:pt idx="242" formatCode="General">
                  <c:v>3.74822E-2</c:v>
                </c:pt>
                <c:pt idx="243" formatCode="General">
                  <c:v>4.1674500000000003E-2</c:v>
                </c:pt>
                <c:pt idx="244" formatCode="General">
                  <c:v>4.6335599999999998E-2</c:v>
                </c:pt>
                <c:pt idx="245" formatCode="General">
                  <c:v>5.1517899999999998E-2</c:v>
                </c:pt>
                <c:pt idx="246" formatCode="General">
                  <c:v>5.72796E-2</c:v>
                </c:pt>
                <c:pt idx="247" formatCode="General">
                  <c:v>6.3685500000000006E-2</c:v>
                </c:pt>
                <c:pt idx="248" formatCode="General">
                  <c:v>7.0807700000000001E-2</c:v>
                </c:pt>
                <c:pt idx="249" formatCode="General">
                  <c:v>7.8726000000000004E-2</c:v>
                </c:pt>
                <c:pt idx="250" formatCode="General">
                  <c:v>8.7529499999999996E-2</c:v>
                </c:pt>
                <c:pt idx="251" formatCode="General">
                  <c:v>9.7317000000000001E-2</c:v>
                </c:pt>
                <c:pt idx="252" formatCode="General">
                  <c:v>0.108198</c:v>
                </c:pt>
                <c:pt idx="253" formatCode="General">
                  <c:v>0.120296</c:v>
                </c:pt>
                <c:pt idx="254" formatCode="General">
                  <c:v>0.133745</c:v>
                </c:pt>
                <c:pt idx="255" formatCode="General">
                  <c:v>0.148697</c:v>
                </c:pt>
                <c:pt idx="256" formatCode="General">
                  <c:v>0.16531899999999999</c:v>
                </c:pt>
                <c:pt idx="257" formatCode="General">
                  <c:v>0.18379699999999999</c:v>
                </c:pt>
                <c:pt idx="258" formatCode="General">
                  <c:v>0.20433899999999999</c:v>
                </c:pt>
                <c:pt idx="259" formatCode="General">
                  <c:v>0.22717399999999999</c:v>
                </c:pt>
                <c:pt idx="260" formatCode="General">
                  <c:v>0.252558</c:v>
                </c:pt>
                <c:pt idx="261" formatCode="General">
                  <c:v>0.28077400000000002</c:v>
                </c:pt>
                <c:pt idx="262" formatCode="General">
                  <c:v>0.312137</c:v>
                </c:pt>
                <c:pt idx="263" formatCode="General">
                  <c:v>0.34699799999999997</c:v>
                </c:pt>
                <c:pt idx="264" formatCode="General">
                  <c:v>0.385743</c:v>
                </c:pt>
                <c:pt idx="265" formatCode="General">
                  <c:v>0.42880600000000002</c:v>
                </c:pt>
                <c:pt idx="266" formatCode="General">
                  <c:v>0.46745900000000001</c:v>
                </c:pt>
                <c:pt idx="267" formatCode="General">
                  <c:v>0.50958599999999998</c:v>
                </c:pt>
                <c:pt idx="268" formatCode="General">
                  <c:v>0.55549700000000002</c:v>
                </c:pt>
                <c:pt idx="269" formatCode="General">
                  <c:v>0.60553100000000004</c:v>
                </c:pt>
                <c:pt idx="270" formatCode="General">
                  <c:v>0.66005199999999997</c:v>
                </c:pt>
                <c:pt idx="271" formatCode="General">
                  <c:v>0.71946100000000002</c:v>
                </c:pt>
                <c:pt idx="272" formatCode="General">
                  <c:v>0.78419000000000005</c:v>
                </c:pt>
                <c:pt idx="273" formatCode="General">
                  <c:v>0.85470900000000005</c:v>
                </c:pt>
                <c:pt idx="274" formatCode="General">
                  <c:v>0.91468700000000003</c:v>
                </c:pt>
                <c:pt idx="275" formatCode="General">
                  <c:v>0.96202799999999999</c:v>
                </c:pt>
                <c:pt idx="276" formatCode="General">
                  <c:v>1.0118</c:v>
                </c:pt>
                <c:pt idx="277" formatCode="General">
                  <c:v>1.0206200000000001</c:v>
                </c:pt>
                <c:pt idx="278" formatCode="General">
                  <c:v>1.02227</c:v>
                </c:pt>
                <c:pt idx="279" formatCode="General">
                  <c:v>1.02393</c:v>
                </c:pt>
                <c:pt idx="280" formatCode="General">
                  <c:v>1.0255799999999999</c:v>
                </c:pt>
                <c:pt idx="281" formatCode="General">
                  <c:v>1.0272399999999999</c:v>
                </c:pt>
                <c:pt idx="282" formatCode="General">
                  <c:v>1.03057</c:v>
                </c:pt>
                <c:pt idx="283" formatCode="General">
                  <c:v>1.0339</c:v>
                </c:pt>
                <c:pt idx="284" formatCode="General">
                  <c:v>1.03725</c:v>
                </c:pt>
                <c:pt idx="285" formatCode="General">
                  <c:v>1.0462199999999999</c:v>
                </c:pt>
                <c:pt idx="286" formatCode="General">
                  <c:v>1.0552600000000001</c:v>
                </c:pt>
                <c:pt idx="287" formatCode="General">
                  <c:v>1.0643899999999999</c:v>
                </c:pt>
                <c:pt idx="288" formatCode="General">
                  <c:v>1.0781499999999999</c:v>
                </c:pt>
                <c:pt idx="289" formatCode="General">
                  <c:v>1.0920799999999999</c:v>
                </c:pt>
                <c:pt idx="290" formatCode="General">
                  <c:v>1.10619</c:v>
                </c:pt>
                <c:pt idx="291" formatCode="General">
                  <c:v>1.12049</c:v>
                </c:pt>
                <c:pt idx="292" formatCode="General">
                  <c:v>1.1373200000000001</c:v>
                </c:pt>
                <c:pt idx="293" formatCode="General">
                  <c:v>1.1544000000000001</c:v>
                </c:pt>
                <c:pt idx="294" formatCode="General">
                  <c:v>1.17174</c:v>
                </c:pt>
                <c:pt idx="295" formatCode="General">
                  <c:v>1.1893400000000001</c:v>
                </c:pt>
                <c:pt idx="296" formatCode="General">
                  <c:v>1.21662</c:v>
                </c:pt>
                <c:pt idx="297" formatCode="General">
                  <c:v>1.2445200000000001</c:v>
                </c:pt>
                <c:pt idx="298" formatCode="General">
                  <c:v>1.27305</c:v>
                </c:pt>
                <c:pt idx="299" formatCode="General">
                  <c:v>1.30223</c:v>
                </c:pt>
                <c:pt idx="300" formatCode="General">
                  <c:v>1.34602</c:v>
                </c:pt>
                <c:pt idx="301" formatCode="General">
                  <c:v>1.3912599999999999</c:v>
                </c:pt>
                <c:pt idx="302" formatCode="General">
                  <c:v>1.4379999999999999</c:v>
                </c:pt>
                <c:pt idx="303" formatCode="General">
                  <c:v>1.47522</c:v>
                </c:pt>
                <c:pt idx="304" formatCode="General">
                  <c:v>1.50556</c:v>
                </c:pt>
                <c:pt idx="305" formatCode="General">
                  <c:v>1.5365200000000001</c:v>
                </c:pt>
                <c:pt idx="306" formatCode="General">
                  <c:v>1.5681</c:v>
                </c:pt>
                <c:pt idx="307" formatCode="General">
                  <c:v>1.60033</c:v>
                </c:pt>
                <c:pt idx="308" formatCode="General">
                  <c:v>1.6332100000000001</c:v>
                </c:pt>
                <c:pt idx="309" formatCode="General">
                  <c:v>1.66675</c:v>
                </c:pt>
                <c:pt idx="310" formatCode="General">
                  <c:v>1.7009700000000001</c:v>
                </c:pt>
                <c:pt idx="311" formatCode="General">
                  <c:v>1.7504200000000001</c:v>
                </c:pt>
                <c:pt idx="312" formatCode="General">
                  <c:v>1.80128</c:v>
                </c:pt>
                <c:pt idx="313" formatCode="General">
                  <c:v>1.8535900000000001</c:v>
                </c:pt>
                <c:pt idx="314" formatCode="General">
                  <c:v>1.9074</c:v>
                </c:pt>
                <c:pt idx="315" formatCode="General">
                  <c:v>1.9627300000000001</c:v>
                </c:pt>
                <c:pt idx="316" formatCode="General">
                  <c:v>2.0394800000000002</c:v>
                </c:pt>
                <c:pt idx="317" formatCode="General">
                  <c:v>2.1191599999999999</c:v>
                </c:pt>
                <c:pt idx="318" formatCode="General">
                  <c:v>2.20187</c:v>
                </c:pt>
                <c:pt idx="319" formatCode="General">
                  <c:v>2.2877299999999998</c:v>
                </c:pt>
                <c:pt idx="320" formatCode="General">
                  <c:v>2.3768400000000001</c:v>
                </c:pt>
                <c:pt idx="321" formatCode="General">
                  <c:v>2.4693000000000001</c:v>
                </c:pt>
                <c:pt idx="322" formatCode="General">
                  <c:v>2.5652499999999998</c:v>
                </c:pt>
                <c:pt idx="323" formatCode="General">
                  <c:v>2.6466400000000001</c:v>
                </c:pt>
                <c:pt idx="324" formatCode="General">
                  <c:v>2.7305299999999999</c:v>
                </c:pt>
                <c:pt idx="325" formatCode="General">
                  <c:v>2.8169599999999999</c:v>
                </c:pt>
                <c:pt idx="326" formatCode="General">
                  <c:v>2.9060100000000002</c:v>
                </c:pt>
                <c:pt idx="327" formatCode="General">
                  <c:v>2.9977399999999998</c:v>
                </c:pt>
                <c:pt idx="328" formatCode="General">
                  <c:v>3.0922299999999998</c:v>
                </c:pt>
                <c:pt idx="329" formatCode="General">
                  <c:v>3.18954</c:v>
                </c:pt>
                <c:pt idx="330" formatCode="General">
                  <c:v>3.2897500000000002</c:v>
                </c:pt>
                <c:pt idx="331" formatCode="General">
                  <c:v>3.39663</c:v>
                </c:pt>
                <c:pt idx="332" formatCode="General">
                  <c:v>3.5067599999999999</c:v>
                </c:pt>
                <c:pt idx="333" formatCode="General">
                  <c:v>3.6202200000000002</c:v>
                </c:pt>
                <c:pt idx="334" formatCode="General">
                  <c:v>3.7370800000000002</c:v>
                </c:pt>
                <c:pt idx="335" formatCode="General">
                  <c:v>3.8574000000000002</c:v>
                </c:pt>
                <c:pt idx="336" formatCode="General">
                  <c:v>3.9597600000000002</c:v>
                </c:pt>
                <c:pt idx="337" formatCode="General">
                  <c:v>3.9773800000000001</c:v>
                </c:pt>
                <c:pt idx="338" formatCode="General">
                  <c:v>3.9950700000000001</c:v>
                </c:pt>
                <c:pt idx="339" formatCode="General">
                  <c:v>4.0128399999999997</c:v>
                </c:pt>
                <c:pt idx="340" formatCode="General">
                  <c:v>4.0306800000000003</c:v>
                </c:pt>
                <c:pt idx="341" formatCode="General">
                  <c:v>4.0485899999999999</c:v>
                </c:pt>
                <c:pt idx="342" formatCode="General">
                  <c:v>4.0846200000000001</c:v>
                </c:pt>
                <c:pt idx="343" formatCode="General">
                  <c:v>4.1209499999999997</c:v>
                </c:pt>
                <c:pt idx="344" formatCode="General">
                  <c:v>4.1575600000000001</c:v>
                </c:pt>
                <c:pt idx="345" formatCode="General">
                  <c:v>4.1944699999999999</c:v>
                </c:pt>
                <c:pt idx="346" formatCode="General">
                  <c:v>4.2530299999999999</c:v>
                </c:pt>
                <c:pt idx="347" formatCode="General">
                  <c:v>4.3123100000000001</c:v>
                </c:pt>
                <c:pt idx="348" formatCode="General">
                  <c:v>4.3723299999999998</c:v>
                </c:pt>
                <c:pt idx="349" formatCode="General">
                  <c:v>4.43309</c:v>
                </c:pt>
                <c:pt idx="350" formatCode="General">
                  <c:v>4.49458</c:v>
                </c:pt>
                <c:pt idx="351" formatCode="General">
                  <c:v>4.6095699999999997</c:v>
                </c:pt>
                <c:pt idx="352" formatCode="General">
                  <c:v>4.7270899999999996</c:v>
                </c:pt>
                <c:pt idx="353" formatCode="General">
                  <c:v>4.8471799999999998</c:v>
                </c:pt>
                <c:pt idx="354" formatCode="General">
                  <c:v>4.9489999999999998</c:v>
                </c:pt>
                <c:pt idx="355" formatCode="General">
                  <c:v>5.0526</c:v>
                </c:pt>
                <c:pt idx="356" formatCode="General">
                  <c:v>5.1579800000000002</c:v>
                </c:pt>
                <c:pt idx="357" formatCode="General">
                  <c:v>5.2651599999999998</c:v>
                </c:pt>
                <c:pt idx="358" formatCode="General">
                  <c:v>5.3741199999999996</c:v>
                </c:pt>
                <c:pt idx="359" formatCode="General">
                  <c:v>5.4848600000000003</c:v>
                </c:pt>
                <c:pt idx="360" formatCode="General">
                  <c:v>5.5973499999999996</c:v>
                </c:pt>
                <c:pt idx="361" formatCode="General">
                  <c:v>5.7115999999999998</c:v>
                </c:pt>
                <c:pt idx="362" formatCode="General">
                  <c:v>5.8275699999999997</c:v>
                </c:pt>
                <c:pt idx="363" formatCode="General">
                  <c:v>5.9452400000000001</c:v>
                </c:pt>
                <c:pt idx="364" formatCode="General">
                  <c:v>6.0645600000000002</c:v>
                </c:pt>
                <c:pt idx="365" formatCode="General">
                  <c:v>6.1855099999999998</c:v>
                </c:pt>
                <c:pt idx="366" formatCode="General">
                  <c:v>6.2867699999999997</c:v>
                </c:pt>
                <c:pt idx="367" formatCode="General">
                  <c:v>6.3890700000000002</c:v>
                </c:pt>
                <c:pt idx="368" formatCode="General">
                  <c:v>6.4923700000000002</c:v>
                </c:pt>
                <c:pt idx="369" formatCode="General">
                  <c:v>6.5966199999999997</c:v>
                </c:pt>
                <c:pt idx="370" formatCode="General">
                  <c:v>6.7017899999999999</c:v>
                </c:pt>
                <c:pt idx="371" formatCode="General">
                  <c:v>6.8078200000000004</c:v>
                </c:pt>
                <c:pt idx="372" formatCode="General">
                  <c:v>6.9146299999999998</c:v>
                </c:pt>
                <c:pt idx="373" formatCode="General">
                  <c:v>7.02217</c:v>
                </c:pt>
                <c:pt idx="374" formatCode="General">
                  <c:v>7.1467099999999997</c:v>
                </c:pt>
                <c:pt idx="375" formatCode="General">
                  <c:v>7.2719800000000001</c:v>
                </c:pt>
                <c:pt idx="376" formatCode="General">
                  <c:v>7.3978099999999998</c:v>
                </c:pt>
                <c:pt idx="377" formatCode="General">
                  <c:v>7.5240499999999999</c:v>
                </c:pt>
                <c:pt idx="378" formatCode="General">
                  <c:v>7.6504899999999996</c:v>
                </c:pt>
                <c:pt idx="379" formatCode="General">
                  <c:v>7.7769199999999996</c:v>
                </c:pt>
                <c:pt idx="380" formatCode="General">
                  <c:v>7.9031000000000002</c:v>
                </c:pt>
                <c:pt idx="381" formatCode="General">
                  <c:v>8.0287500000000005</c:v>
                </c:pt>
                <c:pt idx="382" formatCode="General">
                  <c:v>8.1535700000000002</c:v>
                </c:pt>
                <c:pt idx="383" formatCode="General">
                  <c:v>8.2772100000000002</c:v>
                </c:pt>
                <c:pt idx="384" formatCode="General">
                  <c:v>8.3992900000000006</c:v>
                </c:pt>
                <c:pt idx="385" formatCode="General">
                  <c:v>8.5193600000000007</c:v>
                </c:pt>
                <c:pt idx="386" formatCode="General">
                  <c:v>8.6369399999999992</c:v>
                </c:pt>
                <c:pt idx="387" formatCode="General">
                  <c:v>8.7514900000000004</c:v>
                </c:pt>
                <c:pt idx="388" formatCode="General">
                  <c:v>8.8623899999999995</c:v>
                </c:pt>
                <c:pt idx="389" formatCode="General">
                  <c:v>8.9689700000000006</c:v>
                </c:pt>
                <c:pt idx="390" formatCode="General">
                  <c:v>9.0704399999999996</c:v>
                </c:pt>
                <c:pt idx="391" formatCode="General">
                  <c:v>9.1659600000000001</c:v>
                </c:pt>
                <c:pt idx="392" formatCode="General">
                  <c:v>9.2545800000000007</c:v>
                </c:pt>
                <c:pt idx="393" formatCode="General">
                  <c:v>9.3352199999999996</c:v>
                </c:pt>
                <c:pt idx="394" formatCode="General">
                  <c:v>9.4067000000000007</c:v>
                </c:pt>
                <c:pt idx="395" formatCode="General">
                  <c:v>9.4677100000000003</c:v>
                </c:pt>
                <c:pt idx="396" formatCode="General">
                  <c:v>9.5167800000000007</c:v>
                </c:pt>
                <c:pt idx="397" formatCode="General">
                  <c:v>9.5523100000000003</c:v>
                </c:pt>
                <c:pt idx="398" formatCode="General">
                  <c:v>9.57254</c:v>
                </c:pt>
                <c:pt idx="399" formatCode="General">
                  <c:v>9.5755300000000005</c:v>
                </c:pt>
                <c:pt idx="400" formatCode="General">
                  <c:v>9.56386</c:v>
                </c:pt>
                <c:pt idx="401" formatCode="General">
                  <c:v>9.5382899999999999</c:v>
                </c:pt>
                <c:pt idx="402" formatCode="General">
                  <c:v>9.49756</c:v>
                </c:pt>
                <c:pt idx="403" formatCode="General">
                  <c:v>9.4403799999999993</c:v>
                </c:pt>
                <c:pt idx="404" formatCode="General">
                  <c:v>9.4305299999999992</c:v>
                </c:pt>
                <c:pt idx="405" formatCode="General">
                  <c:v>9.4202999999999992</c:v>
                </c:pt>
                <c:pt idx="406" formatCode="General">
                  <c:v>9.4096700000000002</c:v>
                </c:pt>
                <c:pt idx="407" formatCode="General">
                  <c:v>9.3986499999999999</c:v>
                </c:pt>
                <c:pt idx="408" formatCode="General">
                  <c:v>9.3872300000000006</c:v>
                </c:pt>
                <c:pt idx="409" formatCode="General">
                  <c:v>9.3668300000000002</c:v>
                </c:pt>
                <c:pt idx="410" formatCode="General">
                  <c:v>9.3452300000000008</c:v>
                </c:pt>
                <c:pt idx="411" formatCode="General">
                  <c:v>9.3224199999999993</c:v>
                </c:pt>
                <c:pt idx="412" formatCode="General">
                  <c:v>9.2983700000000002</c:v>
                </c:pt>
                <c:pt idx="413" formatCode="General">
                  <c:v>9.2730599999999992</c:v>
                </c:pt>
                <c:pt idx="414" formatCode="General">
                  <c:v>9.2071000000000005</c:v>
                </c:pt>
                <c:pt idx="415" formatCode="General">
                  <c:v>9.1334900000000001</c:v>
                </c:pt>
                <c:pt idx="416" formatCode="General">
                  <c:v>9.0519499999999997</c:v>
                </c:pt>
                <c:pt idx="417" formatCode="General">
                  <c:v>8.9622100000000007</c:v>
                </c:pt>
                <c:pt idx="418" formatCode="General">
                  <c:v>8.8640100000000004</c:v>
                </c:pt>
                <c:pt idx="419" formatCode="General">
                  <c:v>8.7223600000000001</c:v>
                </c:pt>
                <c:pt idx="420" formatCode="General">
                  <c:v>8.5653600000000001</c:v>
                </c:pt>
                <c:pt idx="421" formatCode="General">
                  <c:v>8.3926300000000005</c:v>
                </c:pt>
                <c:pt idx="422" formatCode="General">
                  <c:v>8.2039000000000009</c:v>
                </c:pt>
                <c:pt idx="423" formatCode="General">
                  <c:v>7.9990199999999998</c:v>
                </c:pt>
                <c:pt idx="424" formatCode="General">
                  <c:v>7.7779999999999996</c:v>
                </c:pt>
                <c:pt idx="425" formatCode="General">
                  <c:v>7.5410300000000001</c:v>
                </c:pt>
                <c:pt idx="426" formatCode="General">
                  <c:v>7.2884900000000004</c:v>
                </c:pt>
                <c:pt idx="427" formatCode="General">
                  <c:v>7.0209799999999998</c:v>
                </c:pt>
                <c:pt idx="428" formatCode="General">
                  <c:v>6.7938400000000003</c:v>
                </c:pt>
                <c:pt idx="429" formatCode="General">
                  <c:v>6.5579799999999997</c:v>
                </c:pt>
                <c:pt idx="430" formatCode="General">
                  <c:v>6.3140900000000002</c:v>
                </c:pt>
                <c:pt idx="431" formatCode="General">
                  <c:v>6.0629600000000003</c:v>
                </c:pt>
                <c:pt idx="432" formatCode="General">
                  <c:v>5.8054800000000002</c:v>
                </c:pt>
                <c:pt idx="433" formatCode="General">
                  <c:v>5.5426700000000002</c:v>
                </c:pt>
                <c:pt idx="434" formatCode="General">
                  <c:v>5.2476500000000001</c:v>
                </c:pt>
                <c:pt idx="435" formatCode="General">
                  <c:v>4.94909</c:v>
                </c:pt>
                <c:pt idx="436" formatCode="General">
                  <c:v>4.6486999999999998</c:v>
                </c:pt>
                <c:pt idx="437" formatCode="General">
                  <c:v>4.3482900000000004</c:v>
                </c:pt>
                <c:pt idx="438" formatCode="General">
                  <c:v>4.0497300000000003</c:v>
                </c:pt>
                <c:pt idx="439" formatCode="General">
                  <c:v>3.7548699999999999</c:v>
                </c:pt>
                <c:pt idx="440" formatCode="General">
                  <c:v>3.46557</c:v>
                </c:pt>
                <c:pt idx="441" formatCode="General">
                  <c:v>3.1836199999999999</c:v>
                </c:pt>
                <c:pt idx="442" formatCode="General">
                  <c:v>2.9106800000000002</c:v>
                </c:pt>
                <c:pt idx="443" formatCode="General">
                  <c:v>2.6483099999999999</c:v>
                </c:pt>
                <c:pt idx="444" formatCode="General">
                  <c:v>2.39785</c:v>
                </c:pt>
                <c:pt idx="445" formatCode="General">
                  <c:v>2.1604700000000001</c:v>
                </c:pt>
                <c:pt idx="446" formatCode="General">
                  <c:v>1.9370799999999999</c:v>
                </c:pt>
                <c:pt idx="447" formatCode="General">
                  <c:v>1.7283599999999999</c:v>
                </c:pt>
                <c:pt idx="448" formatCode="General">
                  <c:v>1.5347500000000001</c:v>
                </c:pt>
                <c:pt idx="449" formatCode="General">
                  <c:v>1.35642</c:v>
                </c:pt>
                <c:pt idx="450" formatCode="General">
                  <c:v>1.21953</c:v>
                </c:pt>
                <c:pt idx="451" formatCode="General">
                  <c:v>1.0930500000000001</c:v>
                </c:pt>
                <c:pt idx="452" formatCode="General">
                  <c:v>0.97676700000000005</c:v>
                </c:pt>
                <c:pt idx="453" formatCode="General">
                  <c:v>0.89371100000000003</c:v>
                </c:pt>
                <c:pt idx="454" formatCode="General">
                  <c:v>0.88064699999999996</c:v>
                </c:pt>
                <c:pt idx="455" formatCode="General">
                  <c:v>0.86773500000000003</c:v>
                </c:pt>
                <c:pt idx="456" formatCode="General">
                  <c:v>0.85497500000000004</c:v>
                </c:pt>
                <c:pt idx="457" formatCode="General">
                  <c:v>0.84236599999999995</c:v>
                </c:pt>
                <c:pt idx="458" formatCode="General">
                  <c:v>0.82990600000000003</c:v>
                </c:pt>
                <c:pt idx="459" formatCode="General">
                  <c:v>0.81086100000000005</c:v>
                </c:pt>
                <c:pt idx="460" formatCode="General">
                  <c:v>0.79217099999999996</c:v>
                </c:pt>
                <c:pt idx="461" formatCode="General">
                  <c:v>0.77383199999999996</c:v>
                </c:pt>
                <c:pt idx="462" formatCode="General">
                  <c:v>0.75584200000000001</c:v>
                </c:pt>
                <c:pt idx="463" formatCode="General">
                  <c:v>0.72572599999999998</c:v>
                </c:pt>
                <c:pt idx="464" formatCode="General">
                  <c:v>0.696608</c:v>
                </c:pt>
                <c:pt idx="465" formatCode="General">
                  <c:v>0.66846899999999998</c:v>
                </c:pt>
                <c:pt idx="466" formatCode="General">
                  <c:v>0.64128700000000005</c:v>
                </c:pt>
                <c:pt idx="467" formatCode="General">
                  <c:v>0.60238700000000001</c:v>
                </c:pt>
                <c:pt idx="468" formatCode="General">
                  <c:v>0.56551399999999996</c:v>
                </c:pt>
                <c:pt idx="469" formatCode="General">
                  <c:v>0.53059800000000001</c:v>
                </c:pt>
                <c:pt idx="470" formatCode="General">
                  <c:v>0.49756600000000001</c:v>
                </c:pt>
                <c:pt idx="471" formatCode="General">
                  <c:v>0.46634599999999998</c:v>
                </c:pt>
                <c:pt idx="472" formatCode="General">
                  <c:v>0.43188300000000002</c:v>
                </c:pt>
                <c:pt idx="473" formatCode="General">
                  <c:v>0.39970499999999998</c:v>
                </c:pt>
                <c:pt idx="474" formatCode="General">
                  <c:v>0.36969600000000002</c:v>
                </c:pt>
                <c:pt idx="475" formatCode="General">
                  <c:v>0.34174199999999999</c:v>
                </c:pt>
                <c:pt idx="476" formatCode="General">
                  <c:v>0.31573000000000001</c:v>
                </c:pt>
                <c:pt idx="477" formatCode="General">
                  <c:v>0.297182</c:v>
                </c:pt>
                <c:pt idx="478" formatCode="General">
                  <c:v>0.27964600000000001</c:v>
                </c:pt>
                <c:pt idx="479" formatCode="General">
                  <c:v>0.26307700000000001</c:v>
                </c:pt>
                <c:pt idx="480" formatCode="General">
                  <c:v>0.24743000000000001</c:v>
                </c:pt>
                <c:pt idx="481" formatCode="General">
                  <c:v>0.23266100000000001</c:v>
                </c:pt>
                <c:pt idx="482" formatCode="General">
                  <c:v>0.21872900000000001</c:v>
                </c:pt>
                <c:pt idx="483" formatCode="General">
                  <c:v>0.205591</c:v>
                </c:pt>
                <c:pt idx="484" formatCode="General">
                  <c:v>0.19320799999999999</c:v>
                </c:pt>
                <c:pt idx="485" formatCode="General">
                  <c:v>0.18154100000000001</c:v>
                </c:pt>
                <c:pt idx="486" formatCode="General">
                  <c:v>0.17055500000000001</c:v>
                </c:pt>
                <c:pt idx="487" formatCode="General">
                  <c:v>0.16021199999999999</c:v>
                </c:pt>
                <c:pt idx="488" formatCode="General">
                  <c:v>0.15290899999999999</c:v>
                </c:pt>
                <c:pt idx="489" formatCode="General">
                  <c:v>0.14593</c:v>
                </c:pt>
                <c:pt idx="490" formatCode="General">
                  <c:v>0.139263</c:v>
                </c:pt>
                <c:pt idx="491" formatCode="General">
                  <c:v>0.13289400000000001</c:v>
                </c:pt>
                <c:pt idx="492" formatCode="General">
                  <c:v>0.12681100000000001</c:v>
                </c:pt>
                <c:pt idx="493" formatCode="General">
                  <c:v>0.11912399999999999</c:v>
                </c:pt>
                <c:pt idx="494" formatCode="General">
                  <c:v>0.111897</c:v>
                </c:pt>
                <c:pt idx="495" formatCode="General">
                  <c:v>0.105106</c:v>
                </c:pt>
                <c:pt idx="496" formatCode="General">
                  <c:v>9.8724400000000004E-2</c:v>
                </c:pt>
                <c:pt idx="497" formatCode="General">
                  <c:v>9.2730000000000007E-2</c:v>
                </c:pt>
                <c:pt idx="498" formatCode="General">
                  <c:v>8.4767099999999998E-2</c:v>
                </c:pt>
                <c:pt idx="499" formatCode="General">
                  <c:v>7.7491599999999994E-2</c:v>
                </c:pt>
                <c:pt idx="500" formatCode="General">
                  <c:v>7.0846400000000004E-2</c:v>
                </c:pt>
                <c:pt idx="501" formatCode="General">
                  <c:v>6.47784E-2</c:v>
                </c:pt>
                <c:pt idx="502" formatCode="General">
                  <c:v>5.9238600000000002E-2</c:v>
                </c:pt>
                <c:pt idx="503" formatCode="General">
                  <c:v>5.3601099999999999E-2</c:v>
                </c:pt>
                <c:pt idx="504" formatCode="General">
                  <c:v>4.8512699999999999E-2</c:v>
                </c:pt>
                <c:pt idx="505" formatCode="General">
                  <c:v>4.39202E-2</c:v>
                </c:pt>
                <c:pt idx="506" formatCode="General">
                  <c:v>3.9775600000000001E-2</c:v>
                </c:pt>
                <c:pt idx="507" formatCode="General">
                  <c:v>3.6035200000000003E-2</c:v>
                </c:pt>
                <c:pt idx="508" formatCode="General">
                  <c:v>3.2659300000000002E-2</c:v>
                </c:pt>
                <c:pt idx="509" formatCode="General">
                  <c:v>2.9612200000000002E-2</c:v>
                </c:pt>
                <c:pt idx="510" formatCode="General">
                  <c:v>2.6861400000000001E-2</c:v>
                </c:pt>
                <c:pt idx="511" formatCode="General">
                  <c:v>2.4377599999999999E-2</c:v>
                </c:pt>
                <c:pt idx="512" formatCode="General">
                  <c:v>2.2134500000000001E-2</c:v>
                </c:pt>
                <c:pt idx="513" formatCode="General">
                  <c:v>2.01081E-2</c:v>
                </c:pt>
                <c:pt idx="514" formatCode="General">
                  <c:v>1.8277100000000001E-2</c:v>
                </c:pt>
                <c:pt idx="515" formatCode="General">
                  <c:v>1.6340899999999998E-2</c:v>
                </c:pt>
                <c:pt idx="516" formatCode="General">
                  <c:v>1.46214E-2</c:v>
                </c:pt>
                <c:pt idx="517" formatCode="General">
                  <c:v>1.30937E-2</c:v>
                </c:pt>
                <c:pt idx="518" formatCode="General">
                  <c:v>1.19971E-2</c:v>
                </c:pt>
                <c:pt idx="519" formatCode="General">
                  <c:v>1.1207699999999999E-2</c:v>
                </c:pt>
                <c:pt idx="520" formatCode="General">
                  <c:v>1.06277E-2</c:v>
                </c:pt>
                <c:pt idx="521" formatCode="General">
                  <c:v>1.0079899999999999E-2</c:v>
                </c:pt>
                <c:pt idx="522" formatCode="General">
                  <c:v>9.9873099999999992E-3</c:v>
                </c:pt>
                <c:pt idx="523" formatCode="General">
                  <c:v>9.8956600000000006E-3</c:v>
                </c:pt>
                <c:pt idx="524" formatCode="General">
                  <c:v>9.80492E-3</c:v>
                </c:pt>
                <c:pt idx="525" formatCode="General">
                  <c:v>9.7150799999999992E-3</c:v>
                </c:pt>
                <c:pt idx="526" formatCode="General">
                  <c:v>9.6261200000000002E-3</c:v>
                </c:pt>
                <c:pt idx="527" formatCode="General">
                  <c:v>9.4508200000000004E-3</c:v>
                </c:pt>
                <c:pt idx="528" formatCode="General">
                  <c:v>9.2789599999999993E-3</c:v>
                </c:pt>
                <c:pt idx="529" formatCode="General">
                  <c:v>9.1104600000000008E-3</c:v>
                </c:pt>
                <c:pt idx="530" formatCode="General">
                  <c:v>8.94526E-3</c:v>
                </c:pt>
                <c:pt idx="531" formatCode="General">
                  <c:v>8.63505E-3</c:v>
                </c:pt>
                <c:pt idx="532" formatCode="General">
                  <c:v>8.3364300000000006E-3</c:v>
                </c:pt>
                <c:pt idx="533" formatCode="General">
                  <c:v>8.0489299999999993E-3</c:v>
                </c:pt>
                <c:pt idx="534" formatCode="General">
                  <c:v>7.7721200000000004E-3</c:v>
                </c:pt>
                <c:pt idx="535" formatCode="General">
                  <c:v>7.5055699999999996E-3</c:v>
                </c:pt>
                <c:pt idx="536" formatCode="General">
                  <c:v>7.1099800000000001E-3</c:v>
                </c:pt>
                <c:pt idx="537" formatCode="General">
                  <c:v>6.7368799999999998E-3</c:v>
                </c:pt>
                <c:pt idx="538" formatCode="General">
                  <c:v>6.3849299999999996E-3</c:v>
                </c:pt>
                <c:pt idx="539" formatCode="General">
                  <c:v>6.0528600000000002E-3</c:v>
                </c:pt>
                <c:pt idx="540" formatCode="General">
                  <c:v>5.73947E-3</c:v>
                </c:pt>
                <c:pt idx="541" formatCode="General">
                  <c:v>5.2998000000000003E-3</c:v>
                </c:pt>
                <c:pt idx="542" formatCode="General">
                  <c:v>4.8965900000000001E-3</c:v>
                </c:pt>
                <c:pt idx="543" formatCode="General">
                  <c:v>4.5266300000000002E-3</c:v>
                </c:pt>
                <c:pt idx="544" formatCode="General">
                  <c:v>4.1870099999999997E-3</c:v>
                </c:pt>
                <c:pt idx="545" formatCode="General">
                  <c:v>3.8750799999999999E-3</c:v>
                </c:pt>
                <c:pt idx="546" formatCode="General">
                  <c:v>3.58844E-3</c:v>
                </c:pt>
                <c:pt idx="547" formatCode="General">
                  <c:v>3.24647E-3</c:v>
                </c:pt>
                <c:pt idx="548" formatCode="General">
                  <c:v>2.9399999999999999E-3</c:v>
                </c:pt>
                <c:pt idx="549" formatCode="General">
                  <c:v>2.7150500000000001E-3</c:v>
                </c:pt>
                <c:pt idx="550" formatCode="General">
                  <c:v>2.5089399999999999E-3</c:v>
                </c:pt>
                <c:pt idx="551" formatCode="General">
                  <c:v>2.3199800000000001E-3</c:v>
                </c:pt>
                <c:pt idx="552" formatCode="General">
                  <c:v>2.1466300000000001E-3</c:v>
                </c:pt>
                <c:pt idx="553" formatCode="General">
                  <c:v>1.98752E-3</c:v>
                </c:pt>
                <c:pt idx="554" formatCode="General">
                  <c:v>1.8413800000000001E-3</c:v>
                </c:pt>
                <c:pt idx="555" formatCode="General">
                  <c:v>1.8192499999999999E-3</c:v>
                </c:pt>
                <c:pt idx="556" formatCode="General">
                  <c:v>1.7974200000000001E-3</c:v>
                </c:pt>
                <c:pt idx="557" formatCode="General">
                  <c:v>1.7758800000000001E-3</c:v>
                </c:pt>
                <c:pt idx="558" formatCode="General">
                  <c:v>1.7546199999999999E-3</c:v>
                </c:pt>
                <c:pt idx="559" formatCode="General">
                  <c:v>1.73365E-3</c:v>
                </c:pt>
                <c:pt idx="560" formatCode="General">
                  <c:v>1.6942299999999999E-3</c:v>
                </c:pt>
                <c:pt idx="561" formatCode="General">
                  <c:v>1.6558E-3</c:v>
                </c:pt>
                <c:pt idx="562" formatCode="General">
                  <c:v>1.61834E-3</c:v>
                </c:pt>
                <c:pt idx="563" formatCode="General">
                  <c:v>1.5818200000000001E-3</c:v>
                </c:pt>
                <c:pt idx="564" formatCode="General">
                  <c:v>1.5462099999999999E-3</c:v>
                </c:pt>
                <c:pt idx="565" formatCode="General">
                  <c:v>1.4910399999999999E-3</c:v>
                </c:pt>
                <c:pt idx="566" formatCode="General">
                  <c:v>1.4380599999999999E-3</c:v>
                </c:pt>
                <c:pt idx="567" formatCode="General">
                  <c:v>1.3871700000000001E-3</c:v>
                </c:pt>
                <c:pt idx="568" formatCode="General">
                  <c:v>1.33829E-3</c:v>
                </c:pt>
                <c:pt idx="569" formatCode="General">
                  <c:v>1.2913200000000001E-3</c:v>
                </c:pt>
                <c:pt idx="570" formatCode="General">
                  <c:v>1.2217899999999999E-3</c:v>
                </c:pt>
                <c:pt idx="571" formatCode="General">
                  <c:v>1.15643E-3</c:v>
                </c:pt>
                <c:pt idx="572" formatCode="General">
                  <c:v>1.0949499999999999E-3</c:v>
                </c:pt>
                <c:pt idx="573" formatCode="General">
                  <c:v>1.0371200000000001E-3</c:v>
                </c:pt>
                <c:pt idx="574" formatCode="General">
                  <c:v>9.8269099999999995E-4</c:v>
                </c:pt>
                <c:pt idx="575" formatCode="General">
                  <c:v>9.1986499999999996E-4</c:v>
                </c:pt>
                <c:pt idx="576" formatCode="General">
                  <c:v>8.6151999999999995E-4</c:v>
                </c:pt>
                <c:pt idx="577" formatCode="General">
                  <c:v>8.0730899999999998E-4</c:v>
                </c:pt>
                <c:pt idx="578" formatCode="General">
                  <c:v>7.5691199999999999E-4</c:v>
                </c:pt>
                <c:pt idx="579" formatCode="General">
                  <c:v>7.1003600000000004E-4</c:v>
                </c:pt>
                <c:pt idx="580" formatCode="General">
                  <c:v>7.0231299999999998E-4</c:v>
                </c:pt>
                <c:pt idx="581" formatCode="General">
                  <c:v>6.9468399999999999E-4</c:v>
                </c:pt>
                <c:pt idx="582" formatCode="General">
                  <c:v>6.8714899999999996E-4</c:v>
                </c:pt>
                <c:pt idx="583" formatCode="General">
                  <c:v>6.7970599999999997E-4</c:v>
                </c:pt>
                <c:pt idx="584" formatCode="General">
                  <c:v>6.7235400000000001E-4</c:v>
                </c:pt>
                <c:pt idx="585" formatCode="General">
                  <c:v>6.5824399999999999E-4</c:v>
                </c:pt>
                <c:pt idx="586" formatCode="General">
                  <c:v>6.4446800000000004E-4</c:v>
                </c:pt>
                <c:pt idx="587" formatCode="General">
                  <c:v>6.3101699999999999E-4</c:v>
                </c:pt>
                <c:pt idx="588" formatCode="General">
                  <c:v>6.1788399999999997E-4</c:v>
                </c:pt>
                <c:pt idx="589" formatCode="General">
                  <c:v>6.0505900000000002E-4</c:v>
                </c:pt>
                <c:pt idx="590" formatCode="General">
                  <c:v>5.8314700000000001E-4</c:v>
                </c:pt>
                <c:pt idx="591" formatCode="General">
                  <c:v>5.6212999999999999E-4</c:v>
                </c:pt>
                <c:pt idx="592" formatCode="General">
                  <c:v>5.41969E-4</c:v>
                </c:pt>
                <c:pt idx="593" formatCode="General">
                  <c:v>5.2262599999999999E-4</c:v>
                </c:pt>
                <c:pt idx="594" formatCode="General">
                  <c:v>5.0406300000000002E-4</c:v>
                </c:pt>
                <c:pt idx="595" formatCode="General">
                  <c:v>4.77083E-4</c:v>
                </c:pt>
                <c:pt idx="596" formatCode="General">
                  <c:v>4.51736E-4</c:v>
                </c:pt>
                <c:pt idx="597" formatCode="General">
                  <c:v>4.2791299999999998E-4</c:v>
                </c:pt>
                <c:pt idx="598" formatCode="General">
                  <c:v>4.0551299999999998E-4</c:v>
                </c:pt>
                <c:pt idx="599" formatCode="General">
                  <c:v>3.8444299999999999E-4</c:v>
                </c:pt>
                <c:pt idx="600" formatCode="General">
                  <c:v>3.62192E-4</c:v>
                </c:pt>
                <c:pt idx="601" formatCode="General">
                  <c:v>3.4140400000000001E-4</c:v>
                </c:pt>
                <c:pt idx="602" formatCode="General">
                  <c:v>3.2197399999999999E-4</c:v>
                </c:pt>
                <c:pt idx="603" formatCode="General">
                  <c:v>3.03803E-4</c:v>
                </c:pt>
                <c:pt idx="604" formatCode="General">
                  <c:v>2.8680099999999999E-4</c:v>
                </c:pt>
                <c:pt idx="605" formatCode="General">
                  <c:v>2.7088600000000002E-4</c:v>
                </c:pt>
                <c:pt idx="606" formatCode="General">
                  <c:v>2.5074500000000003E-4</c:v>
                </c:pt>
                <c:pt idx="607" formatCode="General">
                  <c:v>2.32315E-4</c:v>
                </c:pt>
                <c:pt idx="608" formatCode="General">
                  <c:v>2.15434E-4</c:v>
                </c:pt>
                <c:pt idx="609" formatCode="General">
                  <c:v>1.9996E-4</c:v>
                </c:pt>
                <c:pt idx="610" formatCode="General">
                  <c:v>1.8576199999999999E-4</c:v>
                </c:pt>
                <c:pt idx="611" formatCode="General">
                  <c:v>1.7272500000000001E-4</c:v>
                </c:pt>
                <c:pt idx="612" formatCode="General">
                  <c:v>1.6074199999999999E-4</c:v>
                </c:pt>
                <c:pt idx="613" formatCode="General">
                  <c:v>1.4972E-4</c:v>
                </c:pt>
                <c:pt idx="614" formatCode="General">
                  <c:v>1.3957299999999999E-4</c:v>
                </c:pt>
                <c:pt idx="615" formatCode="General">
                  <c:v>1.29238E-4</c:v>
                </c:pt>
                <c:pt idx="616" formatCode="General">
                  <c:v>1.1979100000000001E-4</c:v>
                </c:pt>
                <c:pt idx="617" formatCode="General">
                  <c:v>1.11148E-4</c:v>
                </c:pt>
                <c:pt idx="618" formatCode="General">
                  <c:v>1.0323300000000001E-4</c:v>
                </c:pt>
                <c:pt idx="619">
                  <c:v>9.5976099999999997E-5</c:v>
                </c:pt>
                <c:pt idx="620">
                  <c:v>8.9317500000000007E-5</c:v>
                </c:pt>
                <c:pt idx="621">
                  <c:v>8.32015E-5</c:v>
                </c:pt>
                <c:pt idx="622">
                  <c:v>7.8586199999999996E-5</c:v>
                </c:pt>
                <c:pt idx="623">
                  <c:v>7.42738E-5</c:v>
                </c:pt>
                <c:pt idx="624">
                  <c:v>7.0241799999999996E-5</c:v>
                </c:pt>
                <c:pt idx="625">
                  <c:v>6.9572699999999999E-5</c:v>
                </c:pt>
                <c:pt idx="626">
                  <c:v>6.8911099999999998E-5</c:v>
                </c:pt>
                <c:pt idx="627">
                  <c:v>6.8257100000000001E-5</c:v>
                </c:pt>
                <c:pt idx="628">
                  <c:v>6.7610599999999999E-5</c:v>
                </c:pt>
                <c:pt idx="629">
                  <c:v>6.6971399999999994E-5</c:v>
                </c:pt>
                <c:pt idx="630">
                  <c:v>6.5761399999999997E-5</c:v>
                </c:pt>
                <c:pt idx="631">
                  <c:v>6.4577600000000003E-5</c:v>
                </c:pt>
                <c:pt idx="632">
                  <c:v>6.3419500000000005E-5</c:v>
                </c:pt>
                <c:pt idx="633">
                  <c:v>6.2286199999999993E-5</c:v>
                </c:pt>
                <c:pt idx="634">
                  <c:v>6.0494200000000001E-5</c:v>
                </c:pt>
                <c:pt idx="635">
                  <c:v>5.8764000000000002E-5</c:v>
                </c:pt>
                <c:pt idx="636">
                  <c:v>5.7093399999999998E-5</c:v>
                </c:pt>
                <c:pt idx="637">
                  <c:v>5.5479899999999997E-5</c:v>
                </c:pt>
                <c:pt idx="638">
                  <c:v>5.3266700000000003E-5</c:v>
                </c:pt>
                <c:pt idx="639">
                  <c:v>5.1159699999999997E-5</c:v>
                </c:pt>
                <c:pt idx="640">
                  <c:v>4.9153300000000003E-5</c:v>
                </c:pt>
                <c:pt idx="641">
                  <c:v>4.7241999999999999E-5</c:v>
                </c:pt>
                <c:pt idx="642">
                  <c:v>4.5420699999999997E-5</c:v>
                </c:pt>
                <c:pt idx="643">
                  <c:v>4.33793E-5</c:v>
                </c:pt>
                <c:pt idx="644">
                  <c:v>4.1449300000000003E-5</c:v>
                </c:pt>
                <c:pt idx="645">
                  <c:v>3.9623699999999998E-5</c:v>
                </c:pt>
                <c:pt idx="646">
                  <c:v>3.7896099999999998E-5</c:v>
                </c:pt>
                <c:pt idx="647">
                  <c:v>3.6260600000000003E-5</c:v>
                </c:pt>
                <c:pt idx="648">
                  <c:v>3.4427700000000002E-5</c:v>
                </c:pt>
                <c:pt idx="649">
                  <c:v>3.27083E-5</c:v>
                </c:pt>
                <c:pt idx="650">
                  <c:v>3.1094499999999998E-5</c:v>
                </c:pt>
                <c:pt idx="651">
                  <c:v>2.9578799999999999E-5</c:v>
                </c:pt>
                <c:pt idx="652">
                  <c:v>2.8154299999999999E-5</c:v>
                </c:pt>
                <c:pt idx="653">
                  <c:v>2.6815E-5</c:v>
                </c:pt>
                <c:pt idx="654">
                  <c:v>2.50426E-5</c:v>
                </c:pt>
                <c:pt idx="655">
                  <c:v>2.34157E-5</c:v>
                </c:pt>
                <c:pt idx="656">
                  <c:v>2.1920699999999998E-5</c:v>
                </c:pt>
                <c:pt idx="657">
                  <c:v>2.0545300000000001E-5</c:v>
                </c:pt>
                <c:pt idx="658">
                  <c:v>1.9278499999999998E-5</c:v>
                </c:pt>
                <c:pt idx="659">
                  <c:v>1.8110499999999999E-5</c:v>
                </c:pt>
                <c:pt idx="660">
                  <c:v>1.6833500000000001E-5</c:v>
                </c:pt>
                <c:pt idx="661">
                  <c:v>1.56713E-5</c:v>
                </c:pt>
                <c:pt idx="662">
                  <c:v>1.46118E-5</c:v>
                </c:pt>
                <c:pt idx="663">
                  <c:v>1.36447E-5</c:v>
                </c:pt>
                <c:pt idx="664">
                  <c:v>1.2760599999999999E-5</c:v>
                </c:pt>
                <c:pt idx="665">
                  <c:v>1.19512E-5</c:v>
                </c:pt>
                <c:pt idx="666">
                  <c:v>1.12093E-5</c:v>
                </c:pt>
                <c:pt idx="667">
                  <c:v>1.05283E-5</c:v>
                </c:pt>
                <c:pt idx="668">
                  <c:v>1.00407E-5</c:v>
                </c:pt>
                <c:pt idx="669">
                  <c:v>9.6660599999999994E-6</c:v>
                </c:pt>
                <c:pt idx="670">
                  <c:v>9.3103900000000008E-6</c:v>
                </c:pt>
                <c:pt idx="671">
                  <c:v>8.9725499999999993E-6</c:v>
                </c:pt>
                <c:pt idx="672">
                  <c:v>8.6515000000000001E-6</c:v>
                </c:pt>
                <c:pt idx="673">
                  <c:v>8.6038700000000003E-6</c:v>
                </c:pt>
                <c:pt idx="674">
                  <c:v>8.5566000000000004E-6</c:v>
                </c:pt>
                <c:pt idx="675">
                  <c:v>8.5096999999999992E-6</c:v>
                </c:pt>
                <c:pt idx="676">
                  <c:v>8.4631599999999995E-6</c:v>
                </c:pt>
                <c:pt idx="677">
                  <c:v>8.3711399999999996E-6</c:v>
                </c:pt>
                <c:pt idx="678">
                  <c:v>8.2805100000000004E-6</c:v>
                </c:pt>
                <c:pt idx="679">
                  <c:v>8.1912500000000006E-6</c:v>
                </c:pt>
                <c:pt idx="680">
                  <c:v>8.1033400000000002E-6</c:v>
                </c:pt>
                <c:pt idx="681">
                  <c:v>7.9027300000000001E-6</c:v>
                </c:pt>
                <c:pt idx="682">
                  <c:v>7.7090599999999993E-6</c:v>
                </c:pt>
                <c:pt idx="683">
                  <c:v>7.5220500000000003E-6</c:v>
                </c:pt>
                <c:pt idx="684">
                  <c:v>7.34144E-6</c:v>
                </c:pt>
                <c:pt idx="685">
                  <c:v>7.05427E-6</c:v>
                </c:pt>
                <c:pt idx="686">
                  <c:v>6.7829699999999997E-6</c:v>
                </c:pt>
                <c:pt idx="687">
                  <c:v>6.5265199999999998E-6</c:v>
                </c:pt>
                <c:pt idx="688">
                  <c:v>6.2839500000000002E-6</c:v>
                </c:pt>
                <c:pt idx="689">
                  <c:v>6.0543800000000003E-6</c:v>
                </c:pt>
                <c:pt idx="690">
                  <c:v>5.8369900000000003E-6</c:v>
                </c:pt>
                <c:pt idx="691">
                  <c:v>5.6310199999999997E-6</c:v>
                </c:pt>
                <c:pt idx="692">
                  <c:v>5.4357399999999997E-6</c:v>
                </c:pt>
                <c:pt idx="693">
                  <c:v>5.2130400000000002E-6</c:v>
                </c:pt>
                <c:pt idx="694">
                  <c:v>5.0039499999999998E-6</c:v>
                </c:pt>
                <c:pt idx="695">
                  <c:v>4.8074900000000003E-6</c:v>
                </c:pt>
                <c:pt idx="696">
                  <c:v>4.6227499999999999E-6</c:v>
                </c:pt>
                <c:pt idx="697">
                  <c:v>4.4489099999999997E-6</c:v>
                </c:pt>
                <c:pt idx="698">
                  <c:v>4.2546400000000001E-6</c:v>
                </c:pt>
                <c:pt idx="699">
                  <c:v>4.0736299999999998E-6</c:v>
                </c:pt>
                <c:pt idx="700">
                  <c:v>3.9048299999999998E-6</c:v>
                </c:pt>
                <c:pt idx="701">
                  <c:v>3.7472400000000001E-6</c:v>
                </c:pt>
                <c:pt idx="702">
                  <c:v>3.6000100000000001E-6</c:v>
                </c:pt>
                <c:pt idx="703">
                  <c:v>3.46232E-6</c:v>
                </c:pt>
                <c:pt idx="704">
                  <c:v>3.2882300000000001E-6</c:v>
                </c:pt>
                <c:pt idx="705">
                  <c:v>3.1289600000000002E-6</c:v>
                </c:pt>
                <c:pt idx="706">
                  <c:v>2.9830399999999999E-6</c:v>
                </c:pt>
                <c:pt idx="707">
                  <c:v>2.8491700000000002E-6</c:v>
                </c:pt>
                <c:pt idx="708">
                  <c:v>2.7261800000000001E-6</c:v>
                </c:pt>
                <c:pt idx="709">
                  <c:v>2.6130600000000002E-6</c:v>
                </c:pt>
                <c:pt idx="710">
                  <c:v>2.4903300000000001E-6</c:v>
                </c:pt>
                <c:pt idx="711">
                  <c:v>2.3788800000000001E-6</c:v>
                </c:pt>
                <c:pt idx="712">
                  <c:v>2.2775400000000001E-6</c:v>
                </c:pt>
                <c:pt idx="713">
                  <c:v>2.1852899999999998E-6</c:v>
                </c:pt>
                <c:pt idx="714">
                  <c:v>2.1011999999999999E-6</c:v>
                </c:pt>
                <c:pt idx="715">
                  <c:v>2.02449E-6</c:v>
                </c:pt>
                <c:pt idx="716">
                  <c:v>1.9544700000000001E-6</c:v>
                </c:pt>
                <c:pt idx="717">
                  <c:v>1.8904900000000001E-6</c:v>
                </c:pt>
                <c:pt idx="718">
                  <c:v>1.83203E-6</c:v>
                </c:pt>
                <c:pt idx="719">
                  <c:v>1.7716600000000001E-6</c:v>
                </c:pt>
                <c:pt idx="720">
                  <c:v>1.7171400000000001E-6</c:v>
                </c:pt>
                <c:pt idx="721">
                  <c:v>1.6679200000000001E-6</c:v>
                </c:pt>
                <c:pt idx="722">
                  <c:v>1.6235100000000001E-6</c:v>
                </c:pt>
                <c:pt idx="723">
                  <c:v>1.58348E-6</c:v>
                </c:pt>
                <c:pt idx="724">
                  <c:v>1.54747E-6</c:v>
                </c:pt>
                <c:pt idx="725">
                  <c:v>1.50972E-6</c:v>
                </c:pt>
                <c:pt idx="726">
                  <c:v>1.4766E-6</c:v>
                </c:pt>
                <c:pt idx="727">
                  <c:v>1.44768E-6</c:v>
                </c:pt>
                <c:pt idx="728">
                  <c:v>1.4225999999999999E-6</c:v>
                </c:pt>
                <c:pt idx="729">
                  <c:v>1.40106E-6</c:v>
                </c:pt>
                <c:pt idx="730">
                  <c:v>1.3827699999999999E-6</c:v>
                </c:pt>
                <c:pt idx="731">
                  <c:v>1.3675E-6</c:v>
                </c:pt>
                <c:pt idx="732">
                  <c:v>1.35504E-6</c:v>
                </c:pt>
                <c:pt idx="733">
                  <c:v>1.3452000000000001E-6</c:v>
                </c:pt>
                <c:pt idx="734">
                  <c:v>1.3381500000000001E-6</c:v>
                </c:pt>
                <c:pt idx="735">
                  <c:v>1.3332E-6</c:v>
                </c:pt>
                <c:pt idx="736">
                  <c:v>1.3302599999999999E-6</c:v>
                </c:pt>
                <c:pt idx="737">
                  <c:v>1.32924E-6</c:v>
                </c:pt>
                <c:pt idx="738">
                  <c:v>1.32925E-6</c:v>
                </c:pt>
                <c:pt idx="739">
                  <c:v>1.32931E-6</c:v>
                </c:pt>
                <c:pt idx="740">
                  <c:v>1.3294200000000001E-6</c:v>
                </c:pt>
                <c:pt idx="741">
                  <c:v>1.32958E-6</c:v>
                </c:pt>
                <c:pt idx="742">
                  <c:v>1.32978E-6</c:v>
                </c:pt>
                <c:pt idx="743">
                  <c:v>1.33034E-6</c:v>
                </c:pt>
                <c:pt idx="744">
                  <c:v>1.33109E-6</c:v>
                </c:pt>
                <c:pt idx="745">
                  <c:v>1.33202E-6</c:v>
                </c:pt>
                <c:pt idx="746">
                  <c:v>1.3331500000000001E-6</c:v>
                </c:pt>
                <c:pt idx="747">
                  <c:v>1.3367799999999999E-6</c:v>
                </c:pt>
                <c:pt idx="748">
                  <c:v>1.34154E-6</c:v>
                </c:pt>
                <c:pt idx="749">
                  <c:v>1.3474100000000001E-6</c:v>
                </c:pt>
                <c:pt idx="750">
                  <c:v>1.3543699999999999E-6</c:v>
                </c:pt>
                <c:pt idx="751">
                  <c:v>1.3624000000000001E-6</c:v>
                </c:pt>
                <c:pt idx="752">
                  <c:v>1.37586E-6</c:v>
                </c:pt>
                <c:pt idx="753">
                  <c:v>1.3914900000000001E-6</c:v>
                </c:pt>
                <c:pt idx="754">
                  <c:v>1.40926E-6</c:v>
                </c:pt>
                <c:pt idx="755">
                  <c:v>1.4291499999999999E-6</c:v>
                </c:pt>
                <c:pt idx="756">
                  <c:v>1.45117E-6</c:v>
                </c:pt>
                <c:pt idx="757">
                  <c:v>1.48474E-6</c:v>
                </c:pt>
                <c:pt idx="758">
                  <c:v>1.5223199999999999E-6</c:v>
                </c:pt>
                <c:pt idx="759">
                  <c:v>1.5639599999999999E-6</c:v>
                </c:pt>
                <c:pt idx="760">
                  <c:v>1.6097400000000001E-6</c:v>
                </c:pt>
                <c:pt idx="761">
                  <c:v>1.6597500000000001E-6</c:v>
                </c:pt>
                <c:pt idx="762">
                  <c:v>1.7141199999999999E-6</c:v>
                </c:pt>
                <c:pt idx="763">
                  <c:v>1.7856399999999999E-6</c:v>
                </c:pt>
                <c:pt idx="764">
                  <c:v>1.8639799999999999E-6</c:v>
                </c:pt>
                <c:pt idx="765">
                  <c:v>1.9494599999999999E-6</c:v>
                </c:pt>
                <c:pt idx="766">
                  <c:v>2.0424600000000001E-6</c:v>
                </c:pt>
                <c:pt idx="767">
                  <c:v>2.1433899999999998E-6</c:v>
                </c:pt>
                <c:pt idx="768">
                  <c:v>2.2526900000000002E-6</c:v>
                </c:pt>
                <c:pt idx="769">
                  <c:v>2.4356399999999999E-6</c:v>
                </c:pt>
                <c:pt idx="770">
                  <c:v>2.6409699999999998E-6</c:v>
                </c:pt>
                <c:pt idx="771">
                  <c:v>2.8708600000000001E-6</c:v>
                </c:pt>
                <c:pt idx="772">
                  <c:v>3.1277799999999998E-6</c:v>
                </c:pt>
                <c:pt idx="773">
                  <c:v>3.4145000000000001E-6</c:v>
                </c:pt>
                <c:pt idx="774">
                  <c:v>3.7341200000000001E-6</c:v>
                </c:pt>
                <c:pt idx="775">
                  <c:v>4.0900800000000003E-6</c:v>
                </c:pt>
                <c:pt idx="776">
                  <c:v>4.4862499999999996E-6</c:v>
                </c:pt>
                <c:pt idx="777">
                  <c:v>4.9269000000000002E-6</c:v>
                </c:pt>
                <c:pt idx="778">
                  <c:v>5.4168100000000002E-6</c:v>
                </c:pt>
                <c:pt idx="779">
                  <c:v>5.9612699999999996E-6</c:v>
                </c:pt>
                <c:pt idx="780">
                  <c:v>6.5661599999999997E-6</c:v>
                </c:pt>
                <c:pt idx="781">
                  <c:v>7.2380300000000004E-6</c:v>
                </c:pt>
                <c:pt idx="782">
                  <c:v>7.9841300000000008E-6</c:v>
                </c:pt>
                <c:pt idx="783">
                  <c:v>8.8125200000000005E-6</c:v>
                </c:pt>
                <c:pt idx="784">
                  <c:v>9.7321199999999992E-6</c:v>
                </c:pt>
                <c:pt idx="785">
                  <c:v>1.07529E-5</c:v>
                </c:pt>
                <c:pt idx="786">
                  <c:v>1.1885800000000001E-5</c:v>
                </c:pt>
                <c:pt idx="787">
                  <c:v>1.3142999999999999E-5</c:v>
                </c:pt>
                <c:pt idx="788">
                  <c:v>1.4538100000000001E-5</c:v>
                </c:pt>
                <c:pt idx="789">
                  <c:v>1.6086199999999999E-5</c:v>
                </c:pt>
                <c:pt idx="790">
                  <c:v>1.7803900000000001E-5</c:v>
                </c:pt>
                <c:pt idx="791">
                  <c:v>1.9709599999999998E-5</c:v>
                </c:pt>
                <c:pt idx="792">
                  <c:v>2.18239E-5</c:v>
                </c:pt>
                <c:pt idx="793">
                  <c:v>2.41695E-5</c:v>
                </c:pt>
                <c:pt idx="794">
                  <c:v>2.67717E-5</c:v>
                </c:pt>
                <c:pt idx="795">
                  <c:v>2.9658500000000001E-5</c:v>
                </c:pt>
                <c:pt idx="796">
                  <c:v>3.2860800000000002E-5</c:v>
                </c:pt>
                <c:pt idx="797">
                  <c:v>3.6413199999999999E-5</c:v>
                </c:pt>
                <c:pt idx="798">
                  <c:v>4.03537E-5</c:v>
                </c:pt>
                <c:pt idx="799">
                  <c:v>4.4724800000000002E-5</c:v>
                </c:pt>
                <c:pt idx="800">
                  <c:v>4.9573400000000002E-5</c:v>
                </c:pt>
                <c:pt idx="801">
                  <c:v>5.4951699999999998E-5</c:v>
                </c:pt>
                <c:pt idx="802">
                  <c:v>6.0917400000000001E-5</c:v>
                </c:pt>
                <c:pt idx="803">
                  <c:v>6.7534599999999995E-5</c:v>
                </c:pt>
                <c:pt idx="804">
                  <c:v>7.4874400000000003E-5</c:v>
                </c:pt>
                <c:pt idx="805">
                  <c:v>8.3015699999999999E-5</c:v>
                </c:pt>
                <c:pt idx="806">
                  <c:v>9.2045899999999999E-5</c:v>
                </c:pt>
                <c:pt idx="807" formatCode="General">
                  <c:v>1.02062E-4</c:v>
                </c:pt>
                <c:pt idx="808" formatCode="General">
                  <c:v>1.1317200000000001E-4</c:v>
                </c:pt>
                <c:pt idx="809" formatCode="General">
                  <c:v>1.25494E-4</c:v>
                </c:pt>
                <c:pt idx="810" formatCode="General">
                  <c:v>1.3916199999999999E-4</c:v>
                </c:pt>
                <c:pt idx="811" formatCode="General">
                  <c:v>1.54322E-4</c:v>
                </c:pt>
                <c:pt idx="812" formatCode="General">
                  <c:v>1.7113600000000001E-4</c:v>
                </c:pt>
                <c:pt idx="813" formatCode="General">
                  <c:v>1.89786E-4</c:v>
                </c:pt>
                <c:pt idx="814" formatCode="General">
                  <c:v>2.1279900000000001E-4</c:v>
                </c:pt>
                <c:pt idx="815" formatCode="General">
                  <c:v>2.38607E-4</c:v>
                </c:pt>
                <c:pt idx="816" formatCode="General">
                  <c:v>2.6754900000000001E-4</c:v>
                </c:pt>
                <c:pt idx="817" formatCode="General">
                  <c:v>3.00005E-4</c:v>
                </c:pt>
                <c:pt idx="818" formatCode="General">
                  <c:v>3.3640299999999998E-4</c:v>
                </c:pt>
                <c:pt idx="819" formatCode="General">
                  <c:v>3.7721899999999998E-4</c:v>
                </c:pt>
                <c:pt idx="820" formatCode="General">
                  <c:v>4.2299200000000002E-4</c:v>
                </c:pt>
                <c:pt idx="821" formatCode="General">
                  <c:v>4.74322E-4</c:v>
                </c:pt>
                <c:pt idx="822" formatCode="General">
                  <c:v>5.3188400000000005E-4</c:v>
                </c:pt>
                <c:pt idx="823" formatCode="General">
                  <c:v>5.9643599999999999E-4</c:v>
                </c:pt>
                <c:pt idx="824" formatCode="General">
                  <c:v>6.6882499999999995E-4</c:v>
                </c:pt>
                <c:pt idx="825" formatCode="General">
                  <c:v>7.5000299999999995E-4</c:v>
                </c:pt>
                <c:pt idx="826" formatCode="General">
                  <c:v>8.4103599999999998E-4</c:v>
                </c:pt>
                <c:pt idx="827" formatCode="General">
                  <c:v>9.4312300000000003E-4</c:v>
                </c:pt>
                <c:pt idx="828" formatCode="General">
                  <c:v>1.0575999999999999E-3</c:v>
                </c:pt>
                <c:pt idx="829" formatCode="General">
                  <c:v>1.1859800000000001E-3</c:v>
                </c:pt>
                <c:pt idx="830" formatCode="General">
                  <c:v>1.3299500000000001E-3</c:v>
                </c:pt>
                <c:pt idx="831" formatCode="General">
                  <c:v>1.49139E-3</c:v>
                </c:pt>
                <c:pt idx="832" formatCode="General">
                  <c:v>1.6724400000000001E-3</c:v>
                </c:pt>
                <c:pt idx="833" formatCode="General">
                  <c:v>1.87546E-3</c:v>
                </c:pt>
                <c:pt idx="834" formatCode="General">
                  <c:v>2.1031299999999999E-3</c:v>
                </c:pt>
                <c:pt idx="835" formatCode="General">
                  <c:v>2.3584399999999998E-3</c:v>
                </c:pt>
                <c:pt idx="836" formatCode="General">
                  <c:v>2.64475E-3</c:v>
                </c:pt>
                <c:pt idx="837" formatCode="General">
                  <c:v>2.9658100000000001E-3</c:v>
                </c:pt>
                <c:pt idx="838" formatCode="General">
                  <c:v>3.32585E-3</c:v>
                </c:pt>
                <c:pt idx="839" formatCode="General">
                  <c:v>3.7296E-3</c:v>
                </c:pt>
                <c:pt idx="840" formatCode="General">
                  <c:v>4.1823700000000004E-3</c:v>
                </c:pt>
                <c:pt idx="841" formatCode="General">
                  <c:v>4.6901E-3</c:v>
                </c:pt>
                <c:pt idx="842" formatCode="General">
                  <c:v>5.2594599999999997E-3</c:v>
                </c:pt>
                <c:pt idx="843" formatCode="General">
                  <c:v>5.89794E-3</c:v>
                </c:pt>
                <c:pt idx="844" formatCode="General">
                  <c:v>6.6139299999999996E-3</c:v>
                </c:pt>
                <c:pt idx="845" formatCode="General">
                  <c:v>7.4168400000000001E-3</c:v>
                </c:pt>
                <c:pt idx="846" formatCode="General">
                  <c:v>8.3172100000000002E-3</c:v>
                </c:pt>
                <c:pt idx="847" formatCode="General">
                  <c:v>9.3268699999999993E-3</c:v>
                </c:pt>
                <c:pt idx="848" formatCode="General">
                  <c:v>1.0459100000000001E-2</c:v>
                </c:pt>
                <c:pt idx="849" formatCode="General">
                  <c:v>1.1728799999999999E-2</c:v>
                </c:pt>
                <c:pt idx="850" formatCode="General">
                  <c:v>1.3152499999999999E-2</c:v>
                </c:pt>
                <c:pt idx="851" formatCode="General">
                  <c:v>1.4749099999999999E-2</c:v>
                </c:pt>
                <c:pt idx="852" formatCode="General">
                  <c:v>1.6539499999999999E-2</c:v>
                </c:pt>
                <c:pt idx="853" formatCode="General">
                  <c:v>1.85472E-2</c:v>
                </c:pt>
                <c:pt idx="854" formatCode="General">
                  <c:v>2.07986E-2</c:v>
                </c:pt>
                <c:pt idx="855" formatCode="General">
                  <c:v>2.3323300000000002E-2</c:v>
                </c:pt>
                <c:pt idx="856" formatCode="General">
                  <c:v>2.6154299999999998E-2</c:v>
                </c:pt>
                <c:pt idx="857" formatCode="General">
                  <c:v>2.9329000000000001E-2</c:v>
                </c:pt>
                <c:pt idx="858" formatCode="General">
                  <c:v>3.2888899999999999E-2</c:v>
                </c:pt>
                <c:pt idx="859" formatCode="General">
                  <c:v>3.6880900000000001E-2</c:v>
                </c:pt>
                <c:pt idx="860" formatCode="General">
                  <c:v>4.1357199999999997E-2</c:v>
                </c:pt>
                <c:pt idx="861" formatCode="General">
                  <c:v>4.6376800000000003E-2</c:v>
                </c:pt>
                <c:pt idx="862" formatCode="General">
                  <c:v>5.20054E-2</c:v>
                </c:pt>
                <c:pt idx="863" formatCode="General">
                  <c:v>5.8317000000000001E-2</c:v>
                </c:pt>
                <c:pt idx="864" formatCode="General">
                  <c:v>6.5394300000000002E-2</c:v>
                </c:pt>
                <c:pt idx="865" formatCode="General">
                  <c:v>7.3330199999999998E-2</c:v>
                </c:pt>
                <c:pt idx="866" formatCode="General">
                  <c:v>8.2228800000000005E-2</c:v>
                </c:pt>
                <c:pt idx="867" formatCode="General">
                  <c:v>9.2206700000000003E-2</c:v>
                </c:pt>
                <c:pt idx="868" formatCode="General">
                  <c:v>0.103395</c:v>
                </c:pt>
                <c:pt idx="869" formatCode="General">
                  <c:v>0.11594</c:v>
                </c:pt>
                <c:pt idx="870" formatCode="General">
                  <c:v>0.13000500000000001</c:v>
                </c:pt>
                <c:pt idx="871" formatCode="General">
                  <c:v>0.14577699999999999</c:v>
                </c:pt>
                <c:pt idx="872" formatCode="General">
                  <c:v>0.16345999999999999</c:v>
                </c:pt>
                <c:pt idx="873" formatCode="General">
                  <c:v>0.183285</c:v>
                </c:pt>
                <c:pt idx="874" formatCode="General">
                  <c:v>0.205513</c:v>
                </c:pt>
                <c:pt idx="875" formatCode="General">
                  <c:v>0.230434</c:v>
                </c:pt>
                <c:pt idx="876" formatCode="General">
                  <c:v>0.25837300000000002</c:v>
                </c:pt>
                <c:pt idx="877" formatCode="General">
                  <c:v>0.28969299999999998</c:v>
                </c:pt>
                <c:pt idx="878" formatCode="General">
                  <c:v>0.31800600000000001</c:v>
                </c:pt>
                <c:pt idx="879" formatCode="General">
                  <c:v>0.34908</c:v>
                </c:pt>
                <c:pt idx="880" formatCode="General">
                  <c:v>0.383185</c:v>
                </c:pt>
                <c:pt idx="881" formatCode="General">
                  <c:v>0.42061399999999999</c:v>
                </c:pt>
                <c:pt idx="882" formatCode="General">
                  <c:v>0.46168900000000002</c:v>
                </c:pt>
                <c:pt idx="883" formatCode="General">
                  <c:v>0.50676299999999996</c:v>
                </c:pt>
                <c:pt idx="884" formatCode="General">
                  <c:v>0.55622400000000005</c:v>
                </c:pt>
                <c:pt idx="885" formatCode="General">
                  <c:v>0.61049299999999995</c:v>
                </c:pt>
                <c:pt idx="886" formatCode="General">
                  <c:v>0.65680700000000003</c:v>
                </c:pt>
                <c:pt idx="887" formatCode="General">
                  <c:v>0.69451099999999999</c:v>
                </c:pt>
                <c:pt idx="888" formatCode="General">
                  <c:v>0.73436999999999997</c:v>
                </c:pt>
                <c:pt idx="889" formatCode="General">
                  <c:v>0.74121999999999999</c:v>
                </c:pt>
                <c:pt idx="890" formatCode="General">
                  <c:v>0.74813399999999997</c:v>
                </c:pt>
                <c:pt idx="891" formatCode="General">
                  <c:v>0.75511200000000001</c:v>
                </c:pt>
                <c:pt idx="892" formatCode="General">
                  <c:v>0.76215500000000003</c:v>
                </c:pt>
                <c:pt idx="893" formatCode="General">
                  <c:v>0.76926300000000003</c:v>
                </c:pt>
                <c:pt idx="894" formatCode="General">
                  <c:v>0.77901200000000004</c:v>
                </c:pt>
                <c:pt idx="895" formatCode="General">
                  <c:v>0.78888499999999995</c:v>
                </c:pt>
                <c:pt idx="896" formatCode="General">
                  <c:v>0.79888099999999995</c:v>
                </c:pt>
                <c:pt idx="897" formatCode="General">
                  <c:v>0.80900399999999995</c:v>
                </c:pt>
                <c:pt idx="898" formatCode="General">
                  <c:v>0.82967199999999997</c:v>
                </c:pt>
                <c:pt idx="899" formatCode="General">
                  <c:v>0.85086399999999995</c:v>
                </c:pt>
                <c:pt idx="900" formatCode="General">
                  <c:v>0.87259500000000001</c:v>
                </c:pt>
                <c:pt idx="901" formatCode="General">
                  <c:v>0.894876</c:v>
                </c:pt>
                <c:pt idx="902" formatCode="General">
                  <c:v>0.92668399999999995</c:v>
                </c:pt>
                <c:pt idx="903" formatCode="General">
                  <c:v>0.95961300000000005</c:v>
                </c:pt>
                <c:pt idx="904" formatCode="General">
                  <c:v>0.99370400000000003</c:v>
                </c:pt>
                <c:pt idx="905" formatCode="General">
                  <c:v>1.0289999999999999</c:v>
                </c:pt>
                <c:pt idx="906" formatCode="General">
                  <c:v>1.0574699999999999</c:v>
                </c:pt>
                <c:pt idx="907" formatCode="General">
                  <c:v>1.08162</c:v>
                </c:pt>
                <c:pt idx="908" formatCode="General">
                  <c:v>1.10632</c:v>
                </c:pt>
                <c:pt idx="909" formatCode="General">
                  <c:v>1.13157</c:v>
                </c:pt>
                <c:pt idx="910" formatCode="General">
                  <c:v>1.1574</c:v>
                </c:pt>
                <c:pt idx="911" formatCode="General">
                  <c:v>1.1616899999999999</c:v>
                </c:pt>
                <c:pt idx="912" formatCode="General">
                  <c:v>1.1659999999999999</c:v>
                </c:pt>
                <c:pt idx="913" formatCode="General">
                  <c:v>1.1703300000000001</c:v>
                </c:pt>
                <c:pt idx="914" formatCode="General">
                  <c:v>1.1746700000000001</c:v>
                </c:pt>
                <c:pt idx="915" formatCode="General">
                  <c:v>1.1831700000000001</c:v>
                </c:pt>
                <c:pt idx="916" formatCode="General">
                  <c:v>1.1917199999999999</c:v>
                </c:pt>
                <c:pt idx="917" formatCode="General">
                  <c:v>1.2003299999999999</c:v>
                </c:pt>
                <c:pt idx="918" formatCode="General">
                  <c:v>1.21313</c:v>
                </c:pt>
                <c:pt idx="919" formatCode="General">
                  <c:v>1.2260599999999999</c:v>
                </c:pt>
                <c:pt idx="920" formatCode="General">
                  <c:v>1.2391300000000001</c:v>
                </c:pt>
                <c:pt idx="921" formatCode="General">
                  <c:v>1.2523299999999999</c:v>
                </c:pt>
                <c:pt idx="922" formatCode="General">
                  <c:v>1.2698499999999999</c:v>
                </c:pt>
                <c:pt idx="923" formatCode="General">
                  <c:v>1.2876000000000001</c:v>
                </c:pt>
                <c:pt idx="924" formatCode="General">
                  <c:v>1.3056000000000001</c:v>
                </c:pt>
                <c:pt idx="925" formatCode="General">
                  <c:v>1.32385</c:v>
                </c:pt>
                <c:pt idx="926" formatCode="General">
                  <c:v>1.3523499999999999</c:v>
                </c:pt>
                <c:pt idx="927" formatCode="General">
                  <c:v>1.3814599999999999</c:v>
                </c:pt>
                <c:pt idx="928" formatCode="General">
                  <c:v>1.4111899999999999</c:v>
                </c:pt>
                <c:pt idx="929" formatCode="General">
                  <c:v>1.4415500000000001</c:v>
                </c:pt>
                <c:pt idx="930" formatCode="General">
                  <c:v>1.4870300000000001</c:v>
                </c:pt>
                <c:pt idx="931" formatCode="General">
                  <c:v>1.53393</c:v>
                </c:pt>
                <c:pt idx="932" formatCode="General">
                  <c:v>1.58229</c:v>
                </c:pt>
                <c:pt idx="933" formatCode="General">
                  <c:v>1.6205700000000001</c:v>
                </c:pt>
                <c:pt idx="934" formatCode="General">
                  <c:v>1.6518900000000001</c:v>
                </c:pt>
                <c:pt idx="935" formatCode="General">
                  <c:v>1.68381</c:v>
                </c:pt>
                <c:pt idx="936" formatCode="General">
                  <c:v>1.71634</c:v>
                </c:pt>
                <c:pt idx="937" formatCode="General">
                  <c:v>1.7494799999999999</c:v>
                </c:pt>
                <c:pt idx="938" formatCode="General">
                  <c:v>1.78325</c:v>
                </c:pt>
                <c:pt idx="939" formatCode="General">
                  <c:v>1.8176600000000001</c:v>
                </c:pt>
                <c:pt idx="940" formatCode="General">
                  <c:v>1.8527100000000001</c:v>
                </c:pt>
                <c:pt idx="941" formatCode="General">
                  <c:v>1.9033500000000001</c:v>
                </c:pt>
                <c:pt idx="942" formatCode="General">
                  <c:v>1.9553400000000001</c:v>
                </c:pt>
                <c:pt idx="943" formatCode="General">
                  <c:v>2.0087199999999998</c:v>
                </c:pt>
                <c:pt idx="944" formatCode="General">
                  <c:v>2.06351</c:v>
                </c:pt>
                <c:pt idx="945" formatCode="General">
                  <c:v>2.1197699999999999</c:v>
                </c:pt>
                <c:pt idx="946" formatCode="General">
                  <c:v>2.19774</c:v>
                </c:pt>
                <c:pt idx="947" formatCode="General">
                  <c:v>2.2785000000000002</c:v>
                </c:pt>
                <c:pt idx="948" formatCode="General">
                  <c:v>2.3621300000000001</c:v>
                </c:pt>
                <c:pt idx="949" formatCode="General">
                  <c:v>2.4487199999999998</c:v>
                </c:pt>
                <c:pt idx="950" formatCode="General">
                  <c:v>2.5383800000000001</c:v>
                </c:pt>
                <c:pt idx="951" formatCode="General">
                  <c:v>2.6311900000000001</c:v>
                </c:pt>
                <c:pt idx="952" formatCode="General">
                  <c:v>2.7272500000000002</c:v>
                </c:pt>
                <c:pt idx="953" formatCode="General">
                  <c:v>2.8083200000000001</c:v>
                </c:pt>
                <c:pt idx="954" formatCode="General">
                  <c:v>2.8916900000000001</c:v>
                </c:pt>
                <c:pt idx="955" formatCode="General">
                  <c:v>2.9774099999999999</c:v>
                </c:pt>
                <c:pt idx="956" formatCode="General">
                  <c:v>3.0655399999999999</c:v>
                </c:pt>
                <c:pt idx="957" formatCode="General">
                  <c:v>3.15612</c:v>
                </c:pt>
                <c:pt idx="958" formatCode="General">
                  <c:v>3.2492200000000002</c:v>
                </c:pt>
                <c:pt idx="959" formatCode="General">
                  <c:v>3.3448899999999999</c:v>
                </c:pt>
                <c:pt idx="960" formatCode="General">
                  <c:v>3.4431799999999999</c:v>
                </c:pt>
                <c:pt idx="961" formatCode="General">
                  <c:v>3.5441400000000001</c:v>
                </c:pt>
                <c:pt idx="962" formatCode="General">
                  <c:v>3.6478299999999999</c:v>
                </c:pt>
                <c:pt idx="963" formatCode="General">
                  <c:v>3.7543000000000002</c:v>
                </c:pt>
                <c:pt idx="964" formatCode="General">
                  <c:v>3.8635999999999999</c:v>
                </c:pt>
                <c:pt idx="965" formatCode="General">
                  <c:v>3.9757699999999998</c:v>
                </c:pt>
                <c:pt idx="966" formatCode="General">
                  <c:v>4.0703199999999997</c:v>
                </c:pt>
                <c:pt idx="967" formatCode="General">
                  <c:v>4.1668700000000003</c:v>
                </c:pt>
                <c:pt idx="968" formatCode="General">
                  <c:v>4.2654500000000004</c:v>
                </c:pt>
                <c:pt idx="969" formatCode="General">
                  <c:v>4.3660600000000001</c:v>
                </c:pt>
                <c:pt idx="970" formatCode="General">
                  <c:v>4.4687299999999999</c:v>
                </c:pt>
                <c:pt idx="971" formatCode="General">
                  <c:v>4.57348</c:v>
                </c:pt>
                <c:pt idx="972" formatCode="General">
                  <c:v>4.6802999999999999</c:v>
                </c:pt>
                <c:pt idx="973" formatCode="General">
                  <c:v>4.7892200000000003</c:v>
                </c:pt>
                <c:pt idx="974" formatCode="General">
                  <c:v>4.9002299999999996</c:v>
                </c:pt>
                <c:pt idx="975" formatCode="General">
                  <c:v>5.0133299999999998</c:v>
                </c:pt>
                <c:pt idx="976" formatCode="General">
                  <c:v>5.12852</c:v>
                </c:pt>
                <c:pt idx="977" formatCode="General">
                  <c:v>5.2457900000000004</c:v>
                </c:pt>
                <c:pt idx="978" formatCode="General">
                  <c:v>5.3426499999999999</c:v>
                </c:pt>
                <c:pt idx="979" formatCode="General">
                  <c:v>5.4408599999999998</c:v>
                </c:pt>
                <c:pt idx="980" formatCode="General">
                  <c:v>5.5229299999999997</c:v>
                </c:pt>
                <c:pt idx="981" formatCode="General">
                  <c:v>5.6058899999999996</c:v>
                </c:pt>
                <c:pt idx="982" formatCode="General">
                  <c:v>5.68973</c:v>
                </c:pt>
                <c:pt idx="983" formatCode="General">
                  <c:v>5.7744499999999999</c:v>
                </c:pt>
                <c:pt idx="984" formatCode="General">
                  <c:v>5.8600099999999999</c:v>
                </c:pt>
                <c:pt idx="985" formatCode="General">
                  <c:v>5.9464100000000002</c:v>
                </c:pt>
                <c:pt idx="986" formatCode="General">
                  <c:v>6.0184899999999999</c:v>
                </c:pt>
                <c:pt idx="987" formatCode="General">
                  <c:v>6.0742700000000003</c:v>
                </c:pt>
                <c:pt idx="988" formatCode="General">
                  <c:v>6.1303700000000001</c:v>
                </c:pt>
                <c:pt idx="989" formatCode="General">
                  <c:v>6.1768099999999997</c:v>
                </c:pt>
                <c:pt idx="990" formatCode="General">
                  <c:v>6.2155399999999998</c:v>
                </c:pt>
                <c:pt idx="991" formatCode="General">
                  <c:v>6.25441</c:v>
                </c:pt>
                <c:pt idx="992" formatCode="General">
                  <c:v>6.2934099999999997</c:v>
                </c:pt>
                <c:pt idx="993" formatCode="General">
                  <c:v>6.3325500000000003</c:v>
                </c:pt>
                <c:pt idx="994" formatCode="General">
                  <c:v>6.37181</c:v>
                </c:pt>
                <c:pt idx="995" formatCode="General">
                  <c:v>6.4111900000000004</c:v>
                </c:pt>
                <c:pt idx="996" formatCode="General">
                  <c:v>6.4182100000000002</c:v>
                </c:pt>
                <c:pt idx="997" formatCode="General">
                  <c:v>6.42523</c:v>
                </c:pt>
                <c:pt idx="998" formatCode="General">
                  <c:v>6.4322499999999998</c:v>
                </c:pt>
                <c:pt idx="999" formatCode="General">
                  <c:v>6.4392800000000001</c:v>
                </c:pt>
                <c:pt idx="1000" formatCode="General">
                  <c:v>6.4533399999999999</c:v>
                </c:pt>
                <c:pt idx="1001" formatCode="General">
                  <c:v>6.4674199999999997</c:v>
                </c:pt>
                <c:pt idx="1002" formatCode="General">
                  <c:v>6.4815100000000001</c:v>
                </c:pt>
                <c:pt idx="1003" formatCode="General">
                  <c:v>6.4956199999999997</c:v>
                </c:pt>
                <c:pt idx="1004" formatCode="General">
                  <c:v>6.5313100000000004</c:v>
                </c:pt>
                <c:pt idx="1005" formatCode="General">
                  <c:v>6.5670900000000003</c:v>
                </c:pt>
                <c:pt idx="1006" formatCode="General">
                  <c:v>6.6029499999999999</c:v>
                </c:pt>
                <c:pt idx="1007" formatCode="General">
                  <c:v>6.6388999999999996</c:v>
                </c:pt>
                <c:pt idx="1008" formatCode="General">
                  <c:v>6.7042400000000004</c:v>
                </c:pt>
                <c:pt idx="1009" formatCode="General">
                  <c:v>6.7698200000000002</c:v>
                </c:pt>
                <c:pt idx="1010" formatCode="General">
                  <c:v>6.83561</c:v>
                </c:pt>
                <c:pt idx="1011" formatCode="General">
                  <c:v>6.9016000000000002</c:v>
                </c:pt>
                <c:pt idx="1012" formatCode="General">
                  <c:v>6.9677600000000002</c:v>
                </c:pt>
                <c:pt idx="1013" formatCode="General">
                  <c:v>7.0671799999999996</c:v>
                </c:pt>
                <c:pt idx="1014" formatCode="General">
                  <c:v>7.16683</c:v>
                </c:pt>
                <c:pt idx="1015" formatCode="General">
                  <c:v>7.2665899999999999</c:v>
                </c:pt>
                <c:pt idx="1016" formatCode="General">
                  <c:v>7.3663400000000001</c:v>
                </c:pt>
                <c:pt idx="1017" formatCode="General">
                  <c:v>7.4659599999999999</c:v>
                </c:pt>
                <c:pt idx="1018" formatCode="General">
                  <c:v>7.5600300000000002</c:v>
                </c:pt>
                <c:pt idx="1019" formatCode="General">
                  <c:v>7.6537100000000002</c:v>
                </c:pt>
                <c:pt idx="1020" formatCode="General">
                  <c:v>7.7468500000000002</c:v>
                </c:pt>
                <c:pt idx="1021" formatCode="General">
                  <c:v>7.8392999999999997</c:v>
                </c:pt>
                <c:pt idx="1022" formatCode="General">
                  <c:v>7.9308800000000002</c:v>
                </c:pt>
                <c:pt idx="1023" formatCode="General">
                  <c:v>8.0213900000000002</c:v>
                </c:pt>
                <c:pt idx="1024" formatCode="General">
                  <c:v>8.1106099999999994</c:v>
                </c:pt>
                <c:pt idx="1025" formatCode="General">
                  <c:v>8.1983200000000007</c:v>
                </c:pt>
                <c:pt idx="1026" formatCode="General">
                  <c:v>8.2842599999999997</c:v>
                </c:pt>
                <c:pt idx="1027" formatCode="General">
                  <c:v>8.3777000000000008</c:v>
                </c:pt>
                <c:pt idx="1028" formatCode="General">
                  <c:v>8.4681700000000006</c:v>
                </c:pt>
                <c:pt idx="1029" formatCode="General">
                  <c:v>8.5551999999999992</c:v>
                </c:pt>
                <c:pt idx="1030" formatCode="General">
                  <c:v>8.6382600000000007</c:v>
                </c:pt>
                <c:pt idx="1031" formatCode="General">
                  <c:v>8.7167999999999992</c:v>
                </c:pt>
                <c:pt idx="1032" formatCode="General">
                  <c:v>8.7901799999999994</c:v>
                </c:pt>
                <c:pt idx="1033" formatCode="General">
                  <c:v>8.8576999999999995</c:v>
                </c:pt>
                <c:pt idx="1034" formatCode="General">
                  <c:v>8.9186200000000007</c:v>
                </c:pt>
                <c:pt idx="1035" formatCode="General">
                  <c:v>8.9720999999999993</c:v>
                </c:pt>
                <c:pt idx="1036" formatCode="General">
                  <c:v>9.01722</c:v>
                </c:pt>
                <c:pt idx="1037" formatCode="General">
                  <c:v>9.0529899999999994</c:v>
                </c:pt>
                <c:pt idx="1038" formatCode="General">
                  <c:v>9.0783299999999993</c:v>
                </c:pt>
                <c:pt idx="1039" formatCode="General">
                  <c:v>9.09206</c:v>
                </c:pt>
                <c:pt idx="1040" formatCode="General">
                  <c:v>9.0929199999999994</c:v>
                </c:pt>
                <c:pt idx="1041" formatCode="General">
                  <c:v>9.0795499999999993</c:v>
                </c:pt>
                <c:pt idx="1042" formatCode="General">
                  <c:v>9.0504999999999995</c:v>
                </c:pt>
                <c:pt idx="1043" formatCode="General">
                  <c:v>9.0042600000000004</c:v>
                </c:pt>
                <c:pt idx="1044" formatCode="General">
                  <c:v>8.9392399999999999</c:v>
                </c:pt>
                <c:pt idx="1045" formatCode="General">
                  <c:v>8.8538099999999993</c:v>
                </c:pt>
                <c:pt idx="1046" formatCode="General">
                  <c:v>8.7463099999999994</c:v>
                </c:pt>
                <c:pt idx="1047" formatCode="General">
                  <c:v>8.6151300000000006</c:v>
                </c:pt>
                <c:pt idx="1048" formatCode="General">
                  <c:v>8.4869599999999998</c:v>
                </c:pt>
                <c:pt idx="1049" formatCode="General">
                  <c:v>8.3405400000000007</c:v>
                </c:pt>
                <c:pt idx="1050" formatCode="General">
                  <c:v>8.1751500000000004</c:v>
                </c:pt>
                <c:pt idx="1051" formatCode="General">
                  <c:v>7.9901799999999996</c:v>
                </c:pt>
                <c:pt idx="1052" formatCode="General">
                  <c:v>7.7852300000000003</c:v>
                </c:pt>
                <c:pt idx="1053" formatCode="General">
                  <c:v>7.56006</c:v>
                </c:pt>
                <c:pt idx="1054" formatCode="General">
                  <c:v>7.3699300000000001</c:v>
                </c:pt>
                <c:pt idx="1055" formatCode="General">
                  <c:v>7.1676000000000002</c:v>
                </c:pt>
                <c:pt idx="1056" formatCode="General">
                  <c:v>6.9911399999999997</c:v>
                </c:pt>
                <c:pt idx="1057" formatCode="General">
                  <c:v>6.8067299999999999</c:v>
                </c:pt>
                <c:pt idx="1058" formatCode="General">
                  <c:v>6.6146500000000001</c:v>
                </c:pt>
                <c:pt idx="1059" formatCode="General">
                  <c:v>6.45024</c:v>
                </c:pt>
                <c:pt idx="1060" formatCode="General">
                  <c:v>6.2810800000000002</c:v>
                </c:pt>
                <c:pt idx="1061" formatCode="General">
                  <c:v>6.2466999999999997</c:v>
                </c:pt>
                <c:pt idx="1062" formatCode="General">
                  <c:v>6.2121399999999998</c:v>
                </c:pt>
                <c:pt idx="1063" formatCode="General">
                  <c:v>6.1774100000000001</c:v>
                </c:pt>
                <c:pt idx="1064" formatCode="General">
                  <c:v>6.1425000000000001</c:v>
                </c:pt>
                <c:pt idx="1065" formatCode="General">
                  <c:v>6.1074299999999999</c:v>
                </c:pt>
                <c:pt idx="1066" formatCode="General">
                  <c:v>6.0466499999999996</c:v>
                </c:pt>
                <c:pt idx="1067" formatCode="General">
                  <c:v>5.9854000000000003</c:v>
                </c:pt>
                <c:pt idx="1068" formatCode="General">
                  <c:v>5.9236700000000004</c:v>
                </c:pt>
                <c:pt idx="1069" formatCode="General">
                  <c:v>5.8615000000000004</c:v>
                </c:pt>
                <c:pt idx="1070" formatCode="General">
                  <c:v>5.7988799999999996</c:v>
                </c:pt>
                <c:pt idx="1071" formatCode="General">
                  <c:v>5.6669999999999998</c:v>
                </c:pt>
                <c:pt idx="1072" formatCode="General">
                  <c:v>5.5334300000000001</c:v>
                </c:pt>
                <c:pt idx="1073" formatCode="General">
                  <c:v>5.39832</c:v>
                </c:pt>
                <c:pt idx="1074" formatCode="General">
                  <c:v>5.2618499999999999</c:v>
                </c:pt>
                <c:pt idx="1075" formatCode="General">
                  <c:v>5.1241899999999996</c:v>
                </c:pt>
                <c:pt idx="1076" formatCode="General">
                  <c:v>4.9319100000000002</c:v>
                </c:pt>
                <c:pt idx="1077" formatCode="General">
                  <c:v>4.7381900000000003</c:v>
                </c:pt>
                <c:pt idx="1078" formatCode="General">
                  <c:v>4.5435499999999998</c:v>
                </c:pt>
                <c:pt idx="1079" formatCode="General">
                  <c:v>4.3485300000000002</c:v>
                </c:pt>
                <c:pt idx="1080" formatCode="General">
                  <c:v>4.1536900000000001</c:v>
                </c:pt>
                <c:pt idx="1081" formatCode="General">
                  <c:v>3.8799100000000002</c:v>
                </c:pt>
                <c:pt idx="1082" formatCode="General">
                  <c:v>3.6677900000000001</c:v>
                </c:pt>
                <c:pt idx="1083" formatCode="General">
                  <c:v>3.6339100000000002</c:v>
                </c:pt>
                <c:pt idx="1084" formatCode="General">
                  <c:v>3.6001099999999999</c:v>
                </c:pt>
                <c:pt idx="1085" formatCode="General">
                  <c:v>3.56637</c:v>
                </c:pt>
                <c:pt idx="1086" formatCode="General">
                  <c:v>3.5327199999999999</c:v>
                </c:pt>
                <c:pt idx="1087" formatCode="General">
                  <c:v>3.4991400000000001</c:v>
                </c:pt>
                <c:pt idx="1088" formatCode="General">
                  <c:v>3.4481899999999999</c:v>
                </c:pt>
                <c:pt idx="1089" formatCode="General">
                  <c:v>3.3974500000000001</c:v>
                </c:pt>
                <c:pt idx="1090" formatCode="General">
                  <c:v>3.3469199999999999</c:v>
                </c:pt>
                <c:pt idx="1091" formatCode="General">
                  <c:v>3.2966099999999998</c:v>
                </c:pt>
                <c:pt idx="1092" formatCode="General">
                  <c:v>3.20404</c:v>
                </c:pt>
                <c:pt idx="1093" formatCode="General">
                  <c:v>3.1123400000000001</c:v>
                </c:pt>
                <c:pt idx="1094" formatCode="General">
                  <c:v>3.0215900000000002</c:v>
                </c:pt>
                <c:pt idx="1095" formatCode="General">
                  <c:v>2.9318399999999998</c:v>
                </c:pt>
                <c:pt idx="1096" formatCode="General">
                  <c:v>2.8054999999999999</c:v>
                </c:pt>
                <c:pt idx="1097" formatCode="General">
                  <c:v>2.6815099999999998</c:v>
                </c:pt>
                <c:pt idx="1098" formatCode="General">
                  <c:v>2.5600200000000002</c:v>
                </c:pt>
                <c:pt idx="1099" formatCode="General">
                  <c:v>2.4411900000000002</c:v>
                </c:pt>
                <c:pt idx="1100" formatCode="General">
                  <c:v>2.3251400000000002</c:v>
                </c:pt>
                <c:pt idx="1101" formatCode="General">
                  <c:v>2.1981999999999999</c:v>
                </c:pt>
                <c:pt idx="1102" formatCode="General">
                  <c:v>2.0751200000000001</c:v>
                </c:pt>
                <c:pt idx="1103" formatCode="General">
                  <c:v>1.9560200000000001</c:v>
                </c:pt>
                <c:pt idx="1104" formatCode="General">
                  <c:v>1.84104</c:v>
                </c:pt>
                <c:pt idx="1105" formatCode="General">
                  <c:v>1.7302599999999999</c:v>
                </c:pt>
                <c:pt idx="1106" formatCode="General">
                  <c:v>1.6015600000000001</c:v>
                </c:pt>
                <c:pt idx="1107" formatCode="General">
                  <c:v>1.4792799999999999</c:v>
                </c:pt>
                <c:pt idx="1108" formatCode="General">
                  <c:v>1.3634500000000001</c:v>
                </c:pt>
                <c:pt idx="1109" formatCode="General">
                  <c:v>1.2540899999999999</c:v>
                </c:pt>
                <c:pt idx="1110" formatCode="General">
                  <c:v>1.15116</c:v>
                </c:pt>
                <c:pt idx="1111" formatCode="General">
                  <c:v>1.07277</c:v>
                </c:pt>
                <c:pt idx="1112" formatCode="General">
                  <c:v>0.99845300000000003</c:v>
                </c:pt>
                <c:pt idx="1113" formatCode="General">
                  <c:v>0.92813400000000001</c:v>
                </c:pt>
                <c:pt idx="1114" formatCode="General">
                  <c:v>0.917713</c:v>
                </c:pt>
                <c:pt idx="1115" formatCode="General">
                  <c:v>0.90738399999999997</c:v>
                </c:pt>
                <c:pt idx="1116" formatCode="General">
                  <c:v>0.897146</c:v>
                </c:pt>
                <c:pt idx="1117" formatCode="General">
                  <c:v>0.88699799999999995</c:v>
                </c:pt>
                <c:pt idx="1118" formatCode="General">
                  <c:v>0.87694099999999997</c:v>
                </c:pt>
                <c:pt idx="1119" formatCode="General">
                  <c:v>0.85709599999999997</c:v>
                </c:pt>
                <c:pt idx="1120" formatCode="General">
                  <c:v>0.83760800000000002</c:v>
                </c:pt>
                <c:pt idx="1121" formatCode="General">
                  <c:v>0.81847400000000003</c:v>
                </c:pt>
                <c:pt idx="1122" formatCode="General">
                  <c:v>0.79969000000000001</c:v>
                </c:pt>
                <c:pt idx="1123" formatCode="General">
                  <c:v>0.76799600000000001</c:v>
                </c:pt>
                <c:pt idx="1124" formatCode="General">
                  <c:v>0.73732500000000001</c:v>
                </c:pt>
                <c:pt idx="1125" formatCode="General">
                  <c:v>0.70765999999999996</c:v>
                </c:pt>
                <c:pt idx="1126" formatCode="General">
                  <c:v>0.67898199999999997</c:v>
                </c:pt>
                <c:pt idx="1127" formatCode="General">
                  <c:v>0.64195999999999998</c:v>
                </c:pt>
                <c:pt idx="1128" formatCode="General">
                  <c:v>0.60663900000000004</c:v>
                </c:pt>
                <c:pt idx="1129" formatCode="General">
                  <c:v>0.57297100000000001</c:v>
                </c:pt>
                <c:pt idx="1130" formatCode="General">
                  <c:v>0.54090499999999997</c:v>
                </c:pt>
                <c:pt idx="1131" formatCode="General">
                  <c:v>0.51039100000000004</c:v>
                </c:pt>
                <c:pt idx="1132" formatCode="General">
                  <c:v>0.47517300000000001</c:v>
                </c:pt>
                <c:pt idx="1133" formatCode="General">
                  <c:v>0.44760699999999998</c:v>
                </c:pt>
                <c:pt idx="1134" formatCode="General">
                  <c:v>0.421458</c:v>
                </c:pt>
                <c:pt idx="1135" formatCode="General">
                  <c:v>0.39667200000000002</c:v>
                </c:pt>
                <c:pt idx="1136" formatCode="General">
                  <c:v>0.373195</c:v>
                </c:pt>
                <c:pt idx="1137" formatCode="General">
                  <c:v>0.35097499999999998</c:v>
                </c:pt>
                <c:pt idx="1138" formatCode="General">
                  <c:v>0.329959</c:v>
                </c:pt>
                <c:pt idx="1139" formatCode="General">
                  <c:v>0.31341799999999997</c:v>
                </c:pt>
                <c:pt idx="1140" formatCode="General">
                  <c:v>0.29764000000000002</c:v>
                </c:pt>
                <c:pt idx="1141" formatCode="General">
                  <c:v>0.28521400000000002</c:v>
                </c:pt>
                <c:pt idx="1142" formatCode="General">
                  <c:v>0.27326899999999998</c:v>
                </c:pt>
                <c:pt idx="1143" formatCode="General">
                  <c:v>0.26178899999999999</c:v>
                </c:pt>
                <c:pt idx="1144" formatCode="General">
                  <c:v>0.25075999999999998</c:v>
                </c:pt>
                <c:pt idx="1145" formatCode="General">
                  <c:v>0.248975</c:v>
                </c:pt>
                <c:pt idx="1146" formatCode="General">
                  <c:v>0.24720200000000001</c:v>
                </c:pt>
                <c:pt idx="1147" formatCode="General">
                  <c:v>0.24543999999999999</c:v>
                </c:pt>
                <c:pt idx="1148" formatCode="General">
                  <c:v>0.24369099999999999</c:v>
                </c:pt>
                <c:pt idx="1149" formatCode="General">
                  <c:v>0.240562</c:v>
                </c:pt>
                <c:pt idx="1150" formatCode="General">
                  <c:v>0.23747099999999999</c:v>
                </c:pt>
                <c:pt idx="1151" formatCode="General">
                  <c:v>0.23441799999999999</c:v>
                </c:pt>
                <c:pt idx="1152" formatCode="General">
                  <c:v>0.231401</c:v>
                </c:pt>
                <c:pt idx="1153" formatCode="General">
                  <c:v>0.22081000000000001</c:v>
                </c:pt>
                <c:pt idx="1154" formatCode="General">
                  <c:v>0.210678</c:v>
                </c:pt>
                <c:pt idx="1155" formatCode="General">
                  <c:v>0.200987</c:v>
                </c:pt>
                <c:pt idx="1156" formatCode="General">
                  <c:v>0.191722</c:v>
                </c:pt>
                <c:pt idx="1157" formatCode="General">
                  <c:v>0.18079100000000001</c:v>
                </c:pt>
                <c:pt idx="1158" formatCode="General">
                  <c:v>0.17046</c:v>
                </c:pt>
                <c:pt idx="1159" formatCode="General">
                  <c:v>0.16069800000000001</c:v>
                </c:pt>
                <c:pt idx="1160" formatCode="General">
                  <c:v>0.151478</c:v>
                </c:pt>
                <c:pt idx="1161" formatCode="General">
                  <c:v>0.14277200000000001</c:v>
                </c:pt>
                <c:pt idx="1162" formatCode="General">
                  <c:v>0.13353200000000001</c:v>
                </c:pt>
                <c:pt idx="1163" formatCode="General">
                  <c:v>0.124877</c:v>
                </c:pt>
                <c:pt idx="1164" formatCode="General">
                  <c:v>0.11852500000000001</c:v>
                </c:pt>
                <c:pt idx="1165" formatCode="General">
                  <c:v>0.113978</c:v>
                </c:pt>
                <c:pt idx="1166" formatCode="General">
                  <c:v>0.10960300000000001</c:v>
                </c:pt>
                <c:pt idx="1167" formatCode="General">
                  <c:v>0.108948</c:v>
                </c:pt>
                <c:pt idx="1168" formatCode="General">
                  <c:v>0.108296</c:v>
                </c:pt>
                <c:pt idx="1169" formatCode="General">
                  <c:v>0.10764899999999999</c:v>
                </c:pt>
                <c:pt idx="1170" formatCode="General">
                  <c:v>0.107005</c:v>
                </c:pt>
                <c:pt idx="1171" formatCode="General">
                  <c:v>0.105771</c:v>
                </c:pt>
                <c:pt idx="1172" formatCode="General">
                  <c:v>0.10455</c:v>
                </c:pt>
                <c:pt idx="1173" formatCode="General">
                  <c:v>0.10334400000000001</c:v>
                </c:pt>
                <c:pt idx="1174" formatCode="General">
                  <c:v>0.10215200000000001</c:v>
                </c:pt>
                <c:pt idx="1175" formatCode="General">
                  <c:v>9.9564299999999994E-2</c:v>
                </c:pt>
                <c:pt idx="1176" formatCode="General">
                  <c:v>9.7042100000000006E-2</c:v>
                </c:pt>
                <c:pt idx="1177" formatCode="General">
                  <c:v>9.4583399999999998E-2</c:v>
                </c:pt>
                <c:pt idx="1178" formatCode="General">
                  <c:v>9.2186900000000002E-2</c:v>
                </c:pt>
                <c:pt idx="1179" formatCode="General">
                  <c:v>8.7519399999999997E-2</c:v>
                </c:pt>
                <c:pt idx="1180" formatCode="General">
                  <c:v>8.3088300000000004E-2</c:v>
                </c:pt>
                <c:pt idx="1181" formatCode="General">
                  <c:v>7.8882400000000005E-2</c:v>
                </c:pt>
                <c:pt idx="1182" formatCode="General">
                  <c:v>7.4890700000000004E-2</c:v>
                </c:pt>
                <c:pt idx="1183" formatCode="General">
                  <c:v>7.1102600000000002E-2</c:v>
                </c:pt>
                <c:pt idx="1184" formatCode="General">
                  <c:v>6.6394300000000003E-2</c:v>
                </c:pt>
                <c:pt idx="1185" formatCode="General">
                  <c:v>6.2001899999999999E-2</c:v>
                </c:pt>
                <c:pt idx="1186" formatCode="General">
                  <c:v>5.7904700000000003E-2</c:v>
                </c:pt>
                <c:pt idx="1187" formatCode="General">
                  <c:v>5.4083199999999998E-2</c:v>
                </c:pt>
                <c:pt idx="1188" formatCode="General">
                  <c:v>5.0519300000000003E-2</c:v>
                </c:pt>
                <c:pt idx="1189" formatCode="General">
                  <c:v>4.6058300000000003E-2</c:v>
                </c:pt>
                <c:pt idx="1190" formatCode="General">
                  <c:v>4.2001700000000003E-2</c:v>
                </c:pt>
                <c:pt idx="1191" formatCode="General">
                  <c:v>3.8312899999999997E-2</c:v>
                </c:pt>
                <c:pt idx="1192" formatCode="General">
                  <c:v>3.4958500000000003E-2</c:v>
                </c:pt>
                <c:pt idx="1193" formatCode="General">
                  <c:v>3.1908199999999998E-2</c:v>
                </c:pt>
                <c:pt idx="1194" formatCode="General">
                  <c:v>2.9134299999999998E-2</c:v>
                </c:pt>
                <c:pt idx="1195" formatCode="General">
                  <c:v>2.6611300000000001E-2</c:v>
                </c:pt>
                <c:pt idx="1196" formatCode="General">
                  <c:v>2.4316299999999999E-2</c:v>
                </c:pt>
                <c:pt idx="1197" formatCode="General">
                  <c:v>2.2580699999999999E-2</c:v>
                </c:pt>
                <c:pt idx="1198" formatCode="General">
                  <c:v>2.2325600000000001E-2</c:v>
                </c:pt>
                <c:pt idx="1199" formatCode="General">
                  <c:v>2.2073599999999999E-2</c:v>
                </c:pt>
                <c:pt idx="1200" formatCode="General">
                  <c:v>2.18245E-2</c:v>
                </c:pt>
                <c:pt idx="1201" formatCode="General">
                  <c:v>2.1578400000000001E-2</c:v>
                </c:pt>
                <c:pt idx="1202" formatCode="General">
                  <c:v>2.1335199999999999E-2</c:v>
                </c:pt>
                <c:pt idx="1203" formatCode="General">
                  <c:v>2.0857500000000001E-2</c:v>
                </c:pt>
                <c:pt idx="1204" formatCode="General">
                  <c:v>2.0390999999999999E-2</c:v>
                </c:pt>
                <c:pt idx="1205" formatCode="General">
                  <c:v>1.9935600000000001E-2</c:v>
                </c:pt>
                <c:pt idx="1206" formatCode="General">
                  <c:v>1.9490799999999999E-2</c:v>
                </c:pt>
                <c:pt idx="1207" formatCode="General">
                  <c:v>1.8724000000000001E-2</c:v>
                </c:pt>
                <c:pt idx="1208" formatCode="General">
                  <c:v>1.7989000000000002E-2</c:v>
                </c:pt>
                <c:pt idx="1209" formatCode="General">
                  <c:v>1.7284399999999998E-2</c:v>
                </c:pt>
                <c:pt idx="1210" formatCode="General">
                  <c:v>1.6609100000000002E-2</c:v>
                </c:pt>
                <c:pt idx="1211" formatCode="General">
                  <c:v>1.5961699999999999E-2</c:v>
                </c:pt>
                <c:pt idx="1212" formatCode="General">
                  <c:v>1.50768E-2</c:v>
                </c:pt>
                <c:pt idx="1213" formatCode="General">
                  <c:v>1.4243799999999999E-2</c:v>
                </c:pt>
                <c:pt idx="1214" formatCode="General">
                  <c:v>1.3459799999999999E-2</c:v>
                </c:pt>
                <c:pt idx="1215" formatCode="General">
                  <c:v>1.27216E-2</c:v>
                </c:pt>
                <c:pt idx="1216" formatCode="General">
                  <c:v>1.2026500000000001E-2</c:v>
                </c:pt>
                <c:pt idx="1217" formatCode="General">
                  <c:v>1.10971E-2</c:v>
                </c:pt>
                <c:pt idx="1218" formatCode="General">
                  <c:v>1.02442E-2</c:v>
                </c:pt>
                <c:pt idx="1219" formatCode="General">
                  <c:v>9.4613100000000006E-3</c:v>
                </c:pt>
                <c:pt idx="1220" formatCode="General">
                  <c:v>8.7423799999999992E-3</c:v>
                </c:pt>
                <c:pt idx="1221" formatCode="General">
                  <c:v>8.0819499999999992E-3</c:v>
                </c:pt>
                <c:pt idx="1222" formatCode="General">
                  <c:v>7.4750199999999998E-3</c:v>
                </c:pt>
                <c:pt idx="1223" formatCode="General">
                  <c:v>6.76269E-3</c:v>
                </c:pt>
                <c:pt idx="1224" formatCode="General">
                  <c:v>6.12328E-3</c:v>
                </c:pt>
                <c:pt idx="1225" formatCode="General">
                  <c:v>5.5489399999999996E-3</c:v>
                </c:pt>
                <c:pt idx="1226" formatCode="General">
                  <c:v>5.1231699999999998E-3</c:v>
                </c:pt>
                <c:pt idx="1227" formatCode="General">
                  <c:v>4.7327200000000002E-3</c:v>
                </c:pt>
                <c:pt idx="1228" formatCode="General">
                  <c:v>4.4440699999999996E-3</c:v>
                </c:pt>
                <c:pt idx="1229" formatCode="General">
                  <c:v>4.1745200000000001E-3</c:v>
                </c:pt>
                <c:pt idx="1230" formatCode="General">
                  <c:v>3.9574500000000004E-3</c:v>
                </c:pt>
                <c:pt idx="1231" formatCode="General">
                  <c:v>3.7526600000000001E-3</c:v>
                </c:pt>
                <c:pt idx="1232" formatCode="General">
                  <c:v>3.7223E-3</c:v>
                </c:pt>
                <c:pt idx="1233" formatCode="General">
                  <c:v>3.7165900000000001E-3</c:v>
                </c:pt>
                <c:pt idx="1234" formatCode="General">
                  <c:v>3.7108900000000001E-3</c:v>
                </c:pt>
                <c:pt idx="1235" formatCode="General">
                  <c:v>3.7051900000000001E-3</c:v>
                </c:pt>
                <c:pt idx="1236" formatCode="General">
                  <c:v>3.69951E-3</c:v>
                </c:pt>
                <c:pt idx="1237" formatCode="General">
                  <c:v>3.6881700000000002E-3</c:v>
                </c:pt>
                <c:pt idx="1238" formatCode="General">
                  <c:v>3.6768700000000001E-3</c:v>
                </c:pt>
                <c:pt idx="1239" formatCode="General">
                  <c:v>3.6656100000000001E-3</c:v>
                </c:pt>
                <c:pt idx="1240" formatCode="General">
                  <c:v>3.65439E-3</c:v>
                </c:pt>
                <c:pt idx="1241" formatCode="General">
                  <c:v>3.6190699999999998E-3</c:v>
                </c:pt>
                <c:pt idx="1242" formatCode="General">
                  <c:v>3.58413E-3</c:v>
                </c:pt>
                <c:pt idx="1243" formatCode="General">
                  <c:v>3.5495600000000002E-3</c:v>
                </c:pt>
                <c:pt idx="1244" formatCode="General">
                  <c:v>3.4987299999999998E-3</c:v>
                </c:pt>
                <c:pt idx="1245" formatCode="General">
                  <c:v>3.4486999999999999E-3</c:v>
                </c:pt>
                <c:pt idx="1246" formatCode="General">
                  <c:v>3.39945E-3</c:v>
                </c:pt>
                <c:pt idx="1247" formatCode="General">
                  <c:v>3.35096E-3</c:v>
                </c:pt>
                <c:pt idx="1248" formatCode="General">
                  <c:v>3.2834000000000001E-3</c:v>
                </c:pt>
                <c:pt idx="1249" formatCode="General">
                  <c:v>3.21733E-3</c:v>
                </c:pt>
                <c:pt idx="1250" formatCode="General">
                  <c:v>3.15271E-3</c:v>
                </c:pt>
                <c:pt idx="1251" formatCode="General">
                  <c:v>3.0895200000000001E-3</c:v>
                </c:pt>
                <c:pt idx="1252" formatCode="General">
                  <c:v>2.9658000000000002E-3</c:v>
                </c:pt>
                <c:pt idx="1253" formatCode="General">
                  <c:v>2.8475100000000001E-3</c:v>
                </c:pt>
                <c:pt idx="1254" formatCode="General">
                  <c:v>2.7343900000000002E-3</c:v>
                </c:pt>
                <c:pt idx="1255" formatCode="General">
                  <c:v>2.62619E-3</c:v>
                </c:pt>
                <c:pt idx="1256" formatCode="General">
                  <c:v>2.5226900000000002E-3</c:v>
                </c:pt>
                <c:pt idx="1257" formatCode="General">
                  <c:v>2.3925999999999999E-3</c:v>
                </c:pt>
                <c:pt idx="1258" formatCode="General">
                  <c:v>2.2698800000000002E-3</c:v>
                </c:pt>
                <c:pt idx="1259" formatCode="General">
                  <c:v>2.1540600000000002E-3</c:v>
                </c:pt>
                <c:pt idx="1260" formatCode="General">
                  <c:v>2.0447500000000001E-3</c:v>
                </c:pt>
                <c:pt idx="1261" formatCode="General">
                  <c:v>1.9415400000000001E-3</c:v>
                </c:pt>
                <c:pt idx="1262" formatCode="General">
                  <c:v>1.80423E-3</c:v>
                </c:pt>
                <c:pt idx="1263" formatCode="General">
                  <c:v>1.6776E-3</c:v>
                </c:pt>
                <c:pt idx="1264" formatCode="General">
                  <c:v>1.56076E-3</c:v>
                </c:pt>
                <c:pt idx="1265" formatCode="General">
                  <c:v>1.4529E-3</c:v>
                </c:pt>
                <c:pt idx="1266" formatCode="General">
                  <c:v>1.35327E-3</c:v>
                </c:pt>
                <c:pt idx="1267" formatCode="General">
                  <c:v>1.2612000000000001E-3</c:v>
                </c:pt>
                <c:pt idx="1268" formatCode="General">
                  <c:v>1.14971E-3</c:v>
                </c:pt>
                <c:pt idx="1269" formatCode="General">
                  <c:v>1.0491299999999999E-3</c:v>
                </c:pt>
                <c:pt idx="1270" formatCode="General">
                  <c:v>9.5828999999999999E-4</c:v>
                </c:pt>
                <c:pt idx="1271" formatCode="General">
                  <c:v>8.7617999999999995E-4</c:v>
                </c:pt>
                <c:pt idx="1272" formatCode="General">
                  <c:v>8.0188799999999995E-4</c:v>
                </c:pt>
                <c:pt idx="1273" formatCode="General">
                  <c:v>7.3460699999999997E-4</c:v>
                </c:pt>
                <c:pt idx="1274" formatCode="General">
                  <c:v>6.7361899999999998E-4</c:v>
                </c:pt>
                <c:pt idx="1275" formatCode="General">
                  <c:v>6.1828399999999998E-4</c:v>
                </c:pt>
                <c:pt idx="1276" formatCode="General">
                  <c:v>5.6803300000000001E-4</c:v>
                </c:pt>
                <c:pt idx="1277" formatCode="General">
                  <c:v>5.2235599999999997E-4</c:v>
                </c:pt>
                <c:pt idx="1278" formatCode="General">
                  <c:v>4.8079999999999998E-4</c:v>
                </c:pt>
                <c:pt idx="1279" formatCode="General">
                  <c:v>4.4295899999999999E-4</c:v>
                </c:pt>
                <c:pt idx="1280" formatCode="General">
                  <c:v>4.0847000000000002E-4</c:v>
                </c:pt>
                <c:pt idx="1281" formatCode="General">
                  <c:v>3.7700899999999998E-4</c:v>
                </c:pt>
                <c:pt idx="1282" formatCode="General">
                  <c:v>3.4828399999999997E-4</c:v>
                </c:pt>
                <c:pt idx="1283" formatCode="General">
                  <c:v>3.2203400000000001E-4</c:v>
                </c:pt>
                <c:pt idx="1284" formatCode="General">
                  <c:v>2.9802700000000002E-4</c:v>
                </c:pt>
                <c:pt idx="1285" formatCode="General">
                  <c:v>2.7605000000000001E-4</c:v>
                </c:pt>
                <c:pt idx="1286" formatCode="General">
                  <c:v>2.5591600000000002E-4</c:v>
                </c:pt>
                <c:pt idx="1287" formatCode="General">
                  <c:v>2.3745400000000001E-4</c:v>
                </c:pt>
                <c:pt idx="1288" formatCode="General">
                  <c:v>2.20511E-4</c:v>
                </c:pt>
                <c:pt idx="1289" formatCode="General">
                  <c:v>2.0335700000000001E-4</c:v>
                </c:pt>
                <c:pt idx="1290" formatCode="General">
                  <c:v>1.87729E-4</c:v>
                </c:pt>
                <c:pt idx="1291" formatCode="General">
                  <c:v>1.7347799999999999E-4</c:v>
                </c:pt>
                <c:pt idx="1292" formatCode="General">
                  <c:v>1.60469E-4</c:v>
                </c:pt>
                <c:pt idx="1293" formatCode="General">
                  <c:v>1.4858199999999999E-4</c:v>
                </c:pt>
                <c:pt idx="1294" formatCode="General">
                  <c:v>1.37711E-4</c:v>
                </c:pt>
                <c:pt idx="1295" formatCode="General">
                  <c:v>1.2937800000000001E-4</c:v>
                </c:pt>
                <c:pt idx="1296" formatCode="General">
                  <c:v>1.21631E-4</c:v>
                </c:pt>
                <c:pt idx="1297" formatCode="General">
                  <c:v>1.14422E-4</c:v>
                </c:pt>
                <c:pt idx="1298" formatCode="General">
                  <c:v>1.07711E-4</c:v>
                </c:pt>
                <c:pt idx="1299" formatCode="General">
                  <c:v>1.02583E-4</c:v>
                </c:pt>
                <c:pt idx="1300">
                  <c:v>9.7740500000000004E-5</c:v>
                </c:pt>
                <c:pt idx="1301">
                  <c:v>9.3165799999999995E-5</c:v>
                </c:pt>
                <c:pt idx="1302">
                  <c:v>8.8842400000000002E-5</c:v>
                </c:pt>
                <c:pt idx="1303">
                  <c:v>8.4754900000000004E-5</c:v>
                </c:pt>
                <c:pt idx="1304">
                  <c:v>8.0888800000000004E-5</c:v>
                </c:pt>
                <c:pt idx="1305">
                  <c:v>7.7230699999999999E-5</c:v>
                </c:pt>
                <c:pt idx="1306">
                  <c:v>7.3767899999999996E-5</c:v>
                </c:pt>
                <c:pt idx="1307">
                  <c:v>6.9963399999999995E-5</c:v>
                </c:pt>
                <c:pt idx="1308">
                  <c:v>6.6391199999999995E-5</c:v>
                </c:pt>
                <c:pt idx="1309">
                  <c:v>6.3035199999999996E-5</c:v>
                </c:pt>
                <c:pt idx="1310">
                  <c:v>5.9880799999999998E-5</c:v>
                </c:pt>
                <c:pt idx="1311">
                  <c:v>5.6914299999999998E-5</c:v>
                </c:pt>
                <c:pt idx="1312">
                  <c:v>5.4123099999999997E-5</c:v>
                </c:pt>
                <c:pt idx="1313">
                  <c:v>5.1495500000000002E-5</c:v>
                </c:pt>
                <c:pt idx="1314">
                  <c:v>4.9020800000000003E-5</c:v>
                </c:pt>
                <c:pt idx="1315">
                  <c:v>4.5850000000000003E-5</c:v>
                </c:pt>
                <c:pt idx="1316">
                  <c:v>4.29252E-5</c:v>
                </c:pt>
                <c:pt idx="1317">
                  <c:v>4.0224800000000002E-5</c:v>
                </c:pt>
                <c:pt idx="1318">
                  <c:v>3.7729299999999998E-5</c:v>
                </c:pt>
                <c:pt idx="1319">
                  <c:v>3.7380699999999999E-5</c:v>
                </c:pt>
                <c:pt idx="1320">
                  <c:v>3.7036100000000003E-5</c:v>
                </c:pt>
                <c:pt idx="1321">
                  <c:v>3.6695300000000001E-5</c:v>
                </c:pt>
                <c:pt idx="1322">
                  <c:v>3.6358400000000001E-5</c:v>
                </c:pt>
                <c:pt idx="1323">
                  <c:v>3.6025300000000002E-5</c:v>
                </c:pt>
                <c:pt idx="1324">
                  <c:v>3.5520900000000001E-5</c:v>
                </c:pt>
                <c:pt idx="1325">
                  <c:v>3.5025199999999998E-5</c:v>
                </c:pt>
                <c:pt idx="1326">
                  <c:v>3.4538E-5</c:v>
                </c:pt>
                <c:pt idx="1327">
                  <c:v>3.4059100000000001E-5</c:v>
                </c:pt>
                <c:pt idx="1328">
                  <c:v>3.31193E-5</c:v>
                </c:pt>
                <c:pt idx="1329">
                  <c:v>3.2211300000000001E-5</c:v>
                </c:pt>
                <c:pt idx="1330">
                  <c:v>3.1333900000000002E-5</c:v>
                </c:pt>
                <c:pt idx="1331">
                  <c:v>3.0485899999999999E-5</c:v>
                </c:pt>
                <c:pt idx="1332">
                  <c:v>3.0202999999999999E-5</c:v>
                </c:pt>
                <c:pt idx="1333">
                  <c:v>2.9923199999999998E-5</c:v>
                </c:pt>
                <c:pt idx="1334">
                  <c:v>2.9646699999999999E-5</c:v>
                </c:pt>
                <c:pt idx="1335">
                  <c:v>2.9373399999999999E-5</c:v>
                </c:pt>
                <c:pt idx="1336">
                  <c:v>2.9103099999999999E-5</c:v>
                </c:pt>
                <c:pt idx="1337">
                  <c:v>2.85719E-5</c:v>
                </c:pt>
                <c:pt idx="1338">
                  <c:v>2.80527E-5</c:v>
                </c:pt>
                <c:pt idx="1339">
                  <c:v>2.7545100000000002E-5</c:v>
                </c:pt>
                <c:pt idx="1340">
                  <c:v>2.7049000000000001E-5</c:v>
                </c:pt>
                <c:pt idx="1341">
                  <c:v>2.5968600000000001E-5</c:v>
                </c:pt>
                <c:pt idx="1342">
                  <c:v>2.4941500000000002E-5</c:v>
                </c:pt>
                <c:pt idx="1343">
                  <c:v>2.3964999999999998E-5</c:v>
                </c:pt>
                <c:pt idx="1344">
                  <c:v>2.3036000000000001E-5</c:v>
                </c:pt>
                <c:pt idx="1345">
                  <c:v>2.2152000000000001E-5</c:v>
                </c:pt>
                <c:pt idx="1346">
                  <c:v>2.1192500000000001E-5</c:v>
                </c:pt>
                <c:pt idx="1347">
                  <c:v>2.02851E-5</c:v>
                </c:pt>
                <c:pt idx="1348">
                  <c:v>1.9426500000000001E-5</c:v>
                </c:pt>
                <c:pt idx="1349">
                  <c:v>1.8613700000000001E-5</c:v>
                </c:pt>
                <c:pt idx="1350">
                  <c:v>1.78438E-5</c:v>
                </c:pt>
                <c:pt idx="1351">
                  <c:v>1.68995E-5</c:v>
                </c:pt>
                <c:pt idx="1352">
                  <c:v>1.6018599999999999E-5</c:v>
                </c:pt>
                <c:pt idx="1353">
                  <c:v>1.51962E-5</c:v>
                </c:pt>
                <c:pt idx="1354">
                  <c:v>1.4427799999999999E-5</c:v>
                </c:pt>
                <c:pt idx="1355">
                  <c:v>1.3709200000000001E-5</c:v>
                </c:pt>
                <c:pt idx="1356">
                  <c:v>1.30368E-5</c:v>
                </c:pt>
                <c:pt idx="1357">
                  <c:v>1.2166399999999999E-5</c:v>
                </c:pt>
                <c:pt idx="1358">
                  <c:v>1.1371300000000001E-5</c:v>
                </c:pt>
                <c:pt idx="1359">
                  <c:v>1.0644E-5</c:v>
                </c:pt>
                <c:pt idx="1360">
                  <c:v>9.9776499999999992E-6</c:v>
                </c:pt>
                <c:pt idx="1361">
                  <c:v>9.3664700000000005E-6</c:v>
                </c:pt>
                <c:pt idx="1362">
                  <c:v>8.8050900000000008E-6</c:v>
                </c:pt>
                <c:pt idx="1363">
                  <c:v>8.2234800000000004E-6</c:v>
                </c:pt>
                <c:pt idx="1364">
                  <c:v>7.6936399999999997E-6</c:v>
                </c:pt>
                <c:pt idx="1365">
                  <c:v>7.2101800000000003E-6</c:v>
                </c:pt>
                <c:pt idx="1366">
                  <c:v>6.7683799999999997E-6</c:v>
                </c:pt>
                <c:pt idx="1367">
                  <c:v>6.36403E-6</c:v>
                </c:pt>
                <c:pt idx="1368">
                  <c:v>5.9934199999999998E-6</c:v>
                </c:pt>
                <c:pt idx="1369">
                  <c:v>5.6532399999999998E-6</c:v>
                </c:pt>
                <c:pt idx="1370">
                  <c:v>5.3405699999999998E-6</c:v>
                </c:pt>
                <c:pt idx="1371">
                  <c:v>5.0527900000000003E-6</c:v>
                </c:pt>
                <c:pt idx="1372">
                  <c:v>4.7875700000000001E-6</c:v>
                </c:pt>
                <c:pt idx="1373">
                  <c:v>4.5428300000000003E-6</c:v>
                </c:pt>
                <c:pt idx="1374">
                  <c:v>4.3167100000000004E-6</c:v>
                </c:pt>
                <c:pt idx="1375">
                  <c:v>4.1075400000000003E-6</c:v>
                </c:pt>
                <c:pt idx="1376">
                  <c:v>3.9138100000000004E-6</c:v>
                </c:pt>
                <c:pt idx="1377">
                  <c:v>3.7758899999999999E-6</c:v>
                </c:pt>
                <c:pt idx="1378">
                  <c:v>3.7554099999999999E-6</c:v>
                </c:pt>
                <c:pt idx="1379">
                  <c:v>3.7351099999999999E-6</c:v>
                </c:pt>
                <c:pt idx="1380">
                  <c:v>3.7149900000000002E-6</c:v>
                </c:pt>
                <c:pt idx="1381">
                  <c:v>3.69504E-6</c:v>
                </c:pt>
                <c:pt idx="1382">
                  <c:v>3.6752599999999999E-6</c:v>
                </c:pt>
                <c:pt idx="1383">
                  <c:v>3.6395399999999999E-6</c:v>
                </c:pt>
                <c:pt idx="1384">
                  <c:v>3.60438E-6</c:v>
                </c:pt>
                <c:pt idx="1385">
                  <c:v>3.5697700000000001E-6</c:v>
                </c:pt>
                <c:pt idx="1386">
                  <c:v>3.53569E-6</c:v>
                </c:pt>
                <c:pt idx="1387">
                  <c:v>3.4577400000000002E-6</c:v>
                </c:pt>
                <c:pt idx="1388">
                  <c:v>3.38257E-6</c:v>
                </c:pt>
                <c:pt idx="1389">
                  <c:v>3.3100800000000002E-6</c:v>
                </c:pt>
                <c:pt idx="1390">
                  <c:v>3.2401499999999998E-6</c:v>
                </c:pt>
                <c:pt idx="1391">
                  <c:v>3.2161699999999998E-6</c:v>
                </c:pt>
                <c:pt idx="1392">
                  <c:v>3.1924999999999999E-6</c:v>
                </c:pt>
                <c:pt idx="1393">
                  <c:v>3.16912E-6</c:v>
                </c:pt>
                <c:pt idx="1394">
                  <c:v>3.1460200000000002E-6</c:v>
                </c:pt>
                <c:pt idx="1395">
                  <c:v>3.1232200000000001E-6</c:v>
                </c:pt>
                <c:pt idx="1396">
                  <c:v>3.0784399999999999E-6</c:v>
                </c:pt>
                <c:pt idx="1397">
                  <c:v>3.03475E-6</c:v>
                </c:pt>
                <c:pt idx="1398">
                  <c:v>2.9921199999999998E-6</c:v>
                </c:pt>
                <c:pt idx="1399">
                  <c:v>2.9505200000000001E-6</c:v>
                </c:pt>
                <c:pt idx="1400">
                  <c:v>2.86027E-6</c:v>
                </c:pt>
                <c:pt idx="1401">
                  <c:v>2.77478E-6</c:v>
                </c:pt>
                <c:pt idx="1402">
                  <c:v>2.69377E-6</c:v>
                </c:pt>
                <c:pt idx="1403">
                  <c:v>2.6169599999999998E-6</c:v>
                </c:pt>
                <c:pt idx="1404">
                  <c:v>2.5440900000000001E-6</c:v>
                </c:pt>
                <c:pt idx="1405">
                  <c:v>2.4669200000000002E-6</c:v>
                </c:pt>
                <c:pt idx="1406">
                  <c:v>2.39408E-6</c:v>
                </c:pt>
                <c:pt idx="1407">
                  <c:v>2.3253099999999998E-6</c:v>
                </c:pt>
                <c:pt idx="1408">
                  <c:v>2.2603300000000002E-6</c:v>
                </c:pt>
                <c:pt idx="1409">
                  <c:v>2.1989100000000001E-6</c:v>
                </c:pt>
                <c:pt idx="1410">
                  <c:v>2.1192200000000001E-6</c:v>
                </c:pt>
                <c:pt idx="1411">
                  <c:v>2.0453999999999999E-6</c:v>
                </c:pt>
                <c:pt idx="1412">
                  <c:v>1.97696E-6</c:v>
                </c:pt>
                <c:pt idx="1413">
                  <c:v>1.9134499999999999E-6</c:v>
                </c:pt>
                <c:pt idx="1414">
                  <c:v>1.8545E-6</c:v>
                </c:pt>
                <c:pt idx="1415">
                  <c:v>1.7997300000000001E-6</c:v>
                </c:pt>
                <c:pt idx="1416">
                  <c:v>1.7261300000000001E-6</c:v>
                </c:pt>
                <c:pt idx="1417">
                  <c:v>1.6599899999999999E-6</c:v>
                </c:pt>
                <c:pt idx="1418">
                  <c:v>1.6005E-6</c:v>
                </c:pt>
                <c:pt idx="1419">
                  <c:v>1.5469899999999999E-6</c:v>
                </c:pt>
                <c:pt idx="1420">
                  <c:v>1.4988500000000001E-6</c:v>
                </c:pt>
                <c:pt idx="1421">
                  <c:v>1.4555699999999999E-6</c:v>
                </c:pt>
                <c:pt idx="1422">
                  <c:v>1.4122899999999999E-6</c:v>
                </c:pt>
                <c:pt idx="1423">
                  <c:v>1.3739699999999999E-6</c:v>
                </c:pt>
                <c:pt idx="1424">
                  <c:v>1.3401399999999999E-6</c:v>
                </c:pt>
                <c:pt idx="1425">
                  <c:v>1.3103599999999999E-6</c:v>
                </c:pt>
                <c:pt idx="1426">
                  <c:v>1.28428E-6</c:v>
                </c:pt>
                <c:pt idx="1427">
                  <c:v>1.2615699999999999E-6</c:v>
                </c:pt>
                <c:pt idx="1428">
                  <c:v>1.23993E-6</c:v>
                </c:pt>
                <c:pt idx="1429">
                  <c:v>1.2218000000000001E-6</c:v>
                </c:pt>
                <c:pt idx="1430">
                  <c:v>1.2069100000000001E-6</c:v>
                </c:pt>
                <c:pt idx="1431">
                  <c:v>1.195E-6</c:v>
                </c:pt>
                <c:pt idx="1432">
                  <c:v>1.19345E-6</c:v>
                </c:pt>
                <c:pt idx="1433">
                  <c:v>1.1919599999999999E-6</c:v>
                </c:pt>
                <c:pt idx="1434">
                  <c:v>1.1905300000000001E-6</c:v>
                </c:pt>
                <c:pt idx="1435">
                  <c:v>1.1891599999999999E-6</c:v>
                </c:pt>
                <c:pt idx="1436">
                  <c:v>1.1878600000000001E-6</c:v>
                </c:pt>
                <c:pt idx="1437">
                  <c:v>1.1862800000000001E-6</c:v>
                </c:pt>
                <c:pt idx="1438">
                  <c:v>1.18479E-6</c:v>
                </c:pt>
                <c:pt idx="1439">
                  <c:v>1.1834E-6</c:v>
                </c:pt>
                <c:pt idx="1440">
                  <c:v>1.1821099999999999E-6</c:v>
                </c:pt>
                <c:pt idx="1441">
                  <c:v>1.1794300000000001E-6</c:v>
                </c:pt>
                <c:pt idx="1442">
                  <c:v>1.17727E-6</c:v>
                </c:pt>
                <c:pt idx="1443">
                  <c:v>1.17559E-6</c:v>
                </c:pt>
                <c:pt idx="1444">
                  <c:v>1.1743999999999999E-6</c:v>
                </c:pt>
                <c:pt idx="1445">
                  <c:v>1.1734000000000001E-6</c:v>
                </c:pt>
                <c:pt idx="1446">
                  <c:v>1.1745900000000001E-6</c:v>
                </c:pt>
                <c:pt idx="1447">
                  <c:v>1.1771699999999999E-6</c:v>
                </c:pt>
                <c:pt idx="1448">
                  <c:v>1.1811400000000001E-6</c:v>
                </c:pt>
                <c:pt idx="1449">
                  <c:v>1.18647E-6</c:v>
                </c:pt>
                <c:pt idx="1450">
                  <c:v>1.19313E-6</c:v>
                </c:pt>
                <c:pt idx="1451">
                  <c:v>1.20109E-6</c:v>
                </c:pt>
                <c:pt idx="1452">
                  <c:v>1.2156799999999999E-6</c:v>
                </c:pt>
                <c:pt idx="1453">
                  <c:v>1.23319E-6</c:v>
                </c:pt>
                <c:pt idx="1454">
                  <c:v>1.25357E-6</c:v>
                </c:pt>
                <c:pt idx="1455">
                  <c:v>1.2768100000000001E-6</c:v>
                </c:pt>
                <c:pt idx="1456">
                  <c:v>1.3029000000000001E-6</c:v>
                </c:pt>
                <c:pt idx="1457">
                  <c:v>1.3318600000000001E-6</c:v>
                </c:pt>
                <c:pt idx="1458">
                  <c:v>1.3565799999999999E-6</c:v>
                </c:pt>
                <c:pt idx="1459">
                  <c:v>1.37737E-6</c:v>
                </c:pt>
                <c:pt idx="1460">
                  <c:v>1.3993000000000001E-6</c:v>
                </c:pt>
                <c:pt idx="1461">
                  <c:v>1.4034899999999999E-6</c:v>
                </c:pt>
                <c:pt idx="1462">
                  <c:v>1.40772E-6</c:v>
                </c:pt>
                <c:pt idx="1463">
                  <c:v>1.4119899999999999E-6</c:v>
                </c:pt>
                <c:pt idx="1464">
                  <c:v>1.4163000000000001E-6</c:v>
                </c:pt>
                <c:pt idx="1465">
                  <c:v>1.42409E-6</c:v>
                </c:pt>
                <c:pt idx="1466">
                  <c:v>1.432E-6</c:v>
                </c:pt>
                <c:pt idx="1467">
                  <c:v>1.4400500000000001E-6</c:v>
                </c:pt>
                <c:pt idx="1468">
                  <c:v>1.4482200000000001E-6</c:v>
                </c:pt>
                <c:pt idx="1469">
                  <c:v>1.47406E-6</c:v>
                </c:pt>
                <c:pt idx="1470">
                  <c:v>1.50114E-6</c:v>
                </c:pt>
                <c:pt idx="1471">
                  <c:v>1.5294699999999999E-6</c:v>
                </c:pt>
                <c:pt idx="1472">
                  <c:v>1.55909E-6</c:v>
                </c:pt>
                <c:pt idx="1473">
                  <c:v>1.60123E-6</c:v>
                </c:pt>
                <c:pt idx="1474">
                  <c:v>1.64583E-6</c:v>
                </c:pt>
                <c:pt idx="1475">
                  <c:v>1.6929699999999999E-6</c:v>
                </c:pt>
                <c:pt idx="1476">
                  <c:v>1.74272E-6</c:v>
                </c:pt>
                <c:pt idx="1477">
                  <c:v>1.7951899999999999E-6</c:v>
                </c:pt>
                <c:pt idx="1478">
                  <c:v>1.86564E-6</c:v>
                </c:pt>
                <c:pt idx="1479">
                  <c:v>1.9407899999999998E-6</c:v>
                </c:pt>
                <c:pt idx="1480">
                  <c:v>2.02084E-6</c:v>
                </c:pt>
                <c:pt idx="1481">
                  <c:v>2.1060499999999999E-6</c:v>
                </c:pt>
                <c:pt idx="1482">
                  <c:v>2.19665E-6</c:v>
                </c:pt>
                <c:pt idx="1483">
                  <c:v>2.3245200000000001E-6</c:v>
                </c:pt>
                <c:pt idx="1484">
                  <c:v>2.4628700000000002E-6</c:v>
                </c:pt>
                <c:pt idx="1485">
                  <c:v>2.61241E-6</c:v>
                </c:pt>
                <c:pt idx="1486">
                  <c:v>2.7739199999999999E-6</c:v>
                </c:pt>
                <c:pt idx="1487">
                  <c:v>2.9482500000000001E-6</c:v>
                </c:pt>
                <c:pt idx="1488">
                  <c:v>3.1363099999999998E-6</c:v>
                </c:pt>
                <c:pt idx="1489">
                  <c:v>3.3939799999999999E-6</c:v>
                </c:pt>
                <c:pt idx="1490">
                  <c:v>3.6770999999999999E-6</c:v>
                </c:pt>
                <c:pt idx="1491">
                  <c:v>3.9880099999999996E-6</c:v>
                </c:pt>
                <c:pt idx="1492">
                  <c:v>4.3292900000000004E-6</c:v>
                </c:pt>
                <c:pt idx="1493">
                  <c:v>4.7037700000000002E-6</c:v>
                </c:pt>
                <c:pt idx="1494">
                  <c:v>5.1145699999999997E-6</c:v>
                </c:pt>
                <c:pt idx="1495">
                  <c:v>5.6277999999999997E-6</c:v>
                </c:pt>
                <c:pt idx="1496">
                  <c:v>6.1974000000000002E-6</c:v>
                </c:pt>
                <c:pt idx="1497">
                  <c:v>6.8294399999999996E-6</c:v>
                </c:pt>
                <c:pt idx="1498">
                  <c:v>7.5306200000000001E-6</c:v>
                </c:pt>
                <c:pt idx="1499">
                  <c:v>8.3083999999999999E-6</c:v>
                </c:pt>
                <c:pt idx="1500">
                  <c:v>9.1710099999999998E-6</c:v>
                </c:pt>
                <c:pt idx="1501">
                  <c:v>9.9312000000000007E-6</c:v>
                </c:pt>
                <c:pt idx="1502">
                  <c:v>1.0608000000000001E-5</c:v>
                </c:pt>
                <c:pt idx="1503">
                  <c:v>1.1332700000000001E-5</c:v>
                </c:pt>
                <c:pt idx="1504">
                  <c:v>1.1455500000000001E-5</c:v>
                </c:pt>
                <c:pt idx="1505">
                  <c:v>1.15798E-5</c:v>
                </c:pt>
                <c:pt idx="1506">
                  <c:v>1.17054E-5</c:v>
                </c:pt>
                <c:pt idx="1507">
                  <c:v>1.1832500000000001E-5</c:v>
                </c:pt>
                <c:pt idx="1508">
                  <c:v>1.1960999999999999E-5</c:v>
                </c:pt>
                <c:pt idx="1509">
                  <c:v>1.2191999999999999E-5</c:v>
                </c:pt>
                <c:pt idx="1510">
                  <c:v>1.2427499999999999E-5</c:v>
                </c:pt>
                <c:pt idx="1511">
                  <c:v>1.2667799999999999E-5</c:v>
                </c:pt>
                <c:pt idx="1512">
                  <c:v>1.29129E-5</c:v>
                </c:pt>
                <c:pt idx="1513">
                  <c:v>1.31628E-5</c:v>
                </c:pt>
                <c:pt idx="1514">
                  <c:v>1.3699199999999999E-5</c:v>
                </c:pt>
                <c:pt idx="1515">
                  <c:v>1.4258E-5</c:v>
                </c:pt>
                <c:pt idx="1516">
                  <c:v>1.4840200000000001E-5</c:v>
                </c:pt>
                <c:pt idx="1517">
                  <c:v>1.5446799999999999E-5</c:v>
                </c:pt>
                <c:pt idx="1518">
                  <c:v>1.6078799999999999E-5</c:v>
                </c:pt>
                <c:pt idx="1519">
                  <c:v>1.7324900000000001E-5</c:v>
                </c:pt>
                <c:pt idx="1520">
                  <c:v>1.8669799999999999E-5</c:v>
                </c:pt>
                <c:pt idx="1521">
                  <c:v>2.01211E-5</c:v>
                </c:pt>
                <c:pt idx="1522">
                  <c:v>2.1687300000000002E-5</c:v>
                </c:pt>
                <c:pt idx="1523">
                  <c:v>2.3377400000000001E-5</c:v>
                </c:pt>
                <c:pt idx="1524">
                  <c:v>2.5201299999999999E-5</c:v>
                </c:pt>
                <c:pt idx="1525">
                  <c:v>2.8065800000000002E-5</c:v>
                </c:pt>
                <c:pt idx="1526">
                  <c:v>3.1260000000000002E-5</c:v>
                </c:pt>
                <c:pt idx="1527">
                  <c:v>3.4821799999999999E-5</c:v>
                </c:pt>
                <c:pt idx="1528">
                  <c:v>3.8793600000000001E-5</c:v>
                </c:pt>
                <c:pt idx="1529">
                  <c:v>4.3222300000000001E-5</c:v>
                </c:pt>
                <c:pt idx="1530">
                  <c:v>4.8160500000000001E-5</c:v>
                </c:pt>
                <c:pt idx="1531">
                  <c:v>5.3666699999999999E-5</c:v>
                </c:pt>
                <c:pt idx="1532">
                  <c:v>5.9806299999999997E-5</c:v>
                </c:pt>
                <c:pt idx="1533">
                  <c:v>6.6651900000000005E-5</c:v>
                </c:pt>
                <c:pt idx="1534">
                  <c:v>7.4284799999999997E-5</c:v>
                </c:pt>
                <c:pt idx="1535">
                  <c:v>8.2795300000000003E-5</c:v>
                </c:pt>
                <c:pt idx="1536">
                  <c:v>9.22844E-5</c:v>
                </c:pt>
                <c:pt idx="1537" formatCode="General">
                  <c:v>1.02865E-4</c:v>
                </c:pt>
                <c:pt idx="1538" formatCode="General">
                  <c:v>1.1466100000000001E-4</c:v>
                </c:pt>
                <c:pt idx="1539" formatCode="General">
                  <c:v>1.2781399999999999E-4</c:v>
                </c:pt>
                <c:pt idx="1540" formatCode="General">
                  <c:v>1.4247899999999999E-4</c:v>
                </c:pt>
                <c:pt idx="1541" formatCode="General">
                  <c:v>1.5882900000000001E-4</c:v>
                </c:pt>
                <c:pt idx="1542" formatCode="General">
                  <c:v>1.77059E-4</c:v>
                </c:pt>
                <c:pt idx="1543" formatCode="General">
                  <c:v>1.9738500000000001E-4</c:v>
                </c:pt>
                <c:pt idx="1544" formatCode="General">
                  <c:v>2.2004699999999999E-4</c:v>
                </c:pt>
                <c:pt idx="1545" formatCode="General">
                  <c:v>2.45314E-4</c:v>
                </c:pt>
                <c:pt idx="1546" formatCode="General">
                  <c:v>2.7348500000000001E-4</c:v>
                </c:pt>
                <c:pt idx="1547" formatCode="General">
                  <c:v>3.04894E-4</c:v>
                </c:pt>
                <c:pt idx="1548" formatCode="General">
                  <c:v>3.3991400000000003E-4</c:v>
                </c:pt>
                <c:pt idx="1549" formatCode="General">
                  <c:v>3.7895799999999999E-4</c:v>
                </c:pt>
                <c:pt idx="1550" formatCode="General">
                  <c:v>4.2248999999999997E-4</c:v>
                </c:pt>
                <c:pt idx="1551" formatCode="General">
                  <c:v>4.7102500000000002E-4</c:v>
                </c:pt>
                <c:pt idx="1552" formatCode="General">
                  <c:v>5.2513799999999997E-4</c:v>
                </c:pt>
                <c:pt idx="1553" formatCode="General">
                  <c:v>5.8547099999999995E-4</c:v>
                </c:pt>
                <c:pt idx="1554" formatCode="General">
                  <c:v>6.5273700000000002E-4</c:v>
                </c:pt>
                <c:pt idx="1555" formatCode="General">
                  <c:v>7.2773499999999997E-4</c:v>
                </c:pt>
                <c:pt idx="1556" formatCode="General">
                  <c:v>8.1135099999999998E-4</c:v>
                </c:pt>
                <c:pt idx="1557" formatCode="General">
                  <c:v>9.0457700000000005E-4</c:v>
                </c:pt>
                <c:pt idx="1558" formatCode="General">
                  <c:v>1.0085199999999999E-3</c:v>
                </c:pt>
                <c:pt idx="1559" formatCode="General">
                  <c:v>1.1244E-3</c:v>
                </c:pt>
                <c:pt idx="1560" formatCode="General">
                  <c:v>1.2536100000000001E-3</c:v>
                </c:pt>
                <c:pt idx="1561" formatCode="General">
                  <c:v>1.39766E-3</c:v>
                </c:pt>
                <c:pt idx="1562" formatCode="General">
                  <c:v>1.5582599999999999E-3</c:v>
                </c:pt>
                <c:pt idx="1563" formatCode="General">
                  <c:v>1.73733E-3</c:v>
                </c:pt>
                <c:pt idx="1564" formatCode="General">
                  <c:v>1.9369700000000001E-3</c:v>
                </c:pt>
                <c:pt idx="1565" formatCode="General">
                  <c:v>2.1595500000000001E-3</c:v>
                </c:pt>
                <c:pt idx="1566" formatCode="General">
                  <c:v>2.40771E-3</c:v>
                </c:pt>
                <c:pt idx="1567" formatCode="General">
                  <c:v>2.68439E-3</c:v>
                </c:pt>
                <c:pt idx="1568" formatCode="General">
                  <c:v>2.99286E-3</c:v>
                </c:pt>
                <c:pt idx="1569" formatCode="General">
                  <c:v>3.3367900000000001E-3</c:v>
                </c:pt>
                <c:pt idx="1570" formatCode="General">
                  <c:v>3.7202300000000002E-3</c:v>
                </c:pt>
                <c:pt idx="1571" formatCode="General">
                  <c:v>4.1477299999999996E-3</c:v>
                </c:pt>
                <c:pt idx="1572" formatCode="General">
                  <c:v>4.6243600000000001E-3</c:v>
                </c:pt>
                <c:pt idx="1573" formatCode="General">
                  <c:v>5.1557699999999996E-3</c:v>
                </c:pt>
                <c:pt idx="1574" formatCode="General">
                  <c:v>5.74823E-3</c:v>
                </c:pt>
                <c:pt idx="1575" formatCode="General">
                  <c:v>6.4087700000000003E-3</c:v>
                </c:pt>
                <c:pt idx="1576" formatCode="General">
                  <c:v>7.1452099999999999E-3</c:v>
                </c:pt>
                <c:pt idx="1577" formatCode="General">
                  <c:v>7.9662799999999992E-3</c:v>
                </c:pt>
                <c:pt idx="1578" formatCode="General">
                  <c:v>8.8816899999999994E-3</c:v>
                </c:pt>
                <c:pt idx="1579" formatCode="General">
                  <c:v>9.9022799999999994E-3</c:v>
                </c:pt>
                <c:pt idx="1580" formatCode="General">
                  <c:v>1.1040100000000001E-2</c:v>
                </c:pt>
                <c:pt idx="1581" formatCode="General">
                  <c:v>1.2308700000000001E-2</c:v>
                </c:pt>
                <c:pt idx="1582" formatCode="General">
                  <c:v>1.37231E-2</c:v>
                </c:pt>
                <c:pt idx="1583" formatCode="General">
                  <c:v>1.52999E-2</c:v>
                </c:pt>
                <c:pt idx="1584" formatCode="General">
                  <c:v>1.7058E-2</c:v>
                </c:pt>
                <c:pt idx="1585" formatCode="General">
                  <c:v>1.9018E-2</c:v>
                </c:pt>
                <c:pt idx="1586" formatCode="General">
                  <c:v>2.1203199999999998E-2</c:v>
                </c:pt>
                <c:pt idx="1587" formatCode="General">
                  <c:v>2.3639400000000001E-2</c:v>
                </c:pt>
                <c:pt idx="1588" formatCode="General">
                  <c:v>2.63555E-2</c:v>
                </c:pt>
                <c:pt idx="1589" formatCode="General">
                  <c:v>2.9383699999999999E-2</c:v>
                </c:pt>
                <c:pt idx="1590" formatCode="General">
                  <c:v>3.2759700000000003E-2</c:v>
                </c:pt>
                <c:pt idx="1591" formatCode="General">
                  <c:v>3.65235E-2</c:v>
                </c:pt>
                <c:pt idx="1592" formatCode="General">
                  <c:v>4.0719699999999998E-2</c:v>
                </c:pt>
                <c:pt idx="1593" formatCode="General">
                  <c:v>4.5397800000000002E-2</c:v>
                </c:pt>
                <c:pt idx="1594" formatCode="General">
                  <c:v>5.0613199999999997E-2</c:v>
                </c:pt>
                <c:pt idx="1595" formatCode="General">
                  <c:v>5.6427699999999997E-2</c:v>
                </c:pt>
                <c:pt idx="1596" formatCode="General">
                  <c:v>6.2909900000000005E-2</c:v>
                </c:pt>
                <c:pt idx="1597" formatCode="General">
                  <c:v>7.0136400000000002E-2</c:v>
                </c:pt>
                <c:pt idx="1598" formatCode="General">
                  <c:v>7.8192800000000007E-2</c:v>
                </c:pt>
                <c:pt idx="1599" formatCode="General">
                  <c:v>8.7174199999999993E-2</c:v>
                </c:pt>
                <c:pt idx="1600" formatCode="General">
                  <c:v>9.7186700000000001E-2</c:v>
                </c:pt>
                <c:pt idx="1601" formatCode="General">
                  <c:v>0.108349</c:v>
                </c:pt>
                <c:pt idx="1602" formatCode="General">
                  <c:v>0.120792</c:v>
                </c:pt>
                <c:pt idx="1603" formatCode="General">
                  <c:v>0.134663</c:v>
                </c:pt>
                <c:pt idx="1604" formatCode="General">
                  <c:v>0.15012500000000001</c:v>
                </c:pt>
                <c:pt idx="1605" formatCode="General">
                  <c:v>0.16736200000000001</c:v>
                </c:pt>
                <c:pt idx="1606" formatCode="General">
                  <c:v>0.18657599999999999</c:v>
                </c:pt>
                <c:pt idx="1607" formatCode="General">
                  <c:v>0.20799400000000001</c:v>
                </c:pt>
                <c:pt idx="1608" formatCode="General">
                  <c:v>0.23186699999999999</c:v>
                </c:pt>
                <c:pt idx="1609" formatCode="General">
                  <c:v>0.25847700000000001</c:v>
                </c:pt>
                <c:pt idx="1610" formatCode="General">
                  <c:v>0.28813499999999997</c:v>
                </c:pt>
                <c:pt idx="1611" formatCode="General">
                  <c:v>0.321191</c:v>
                </c:pt>
                <c:pt idx="1612" formatCode="General">
                  <c:v>0.35126099999999999</c:v>
                </c:pt>
                <c:pt idx="1613" formatCode="General">
                  <c:v>0.38413999999999998</c:v>
                </c:pt>
                <c:pt idx="1614" formatCode="General">
                  <c:v>0.42008899999999999</c:v>
                </c:pt>
                <c:pt idx="1615" formatCode="General">
                  <c:v>0.459393</c:v>
                </c:pt>
                <c:pt idx="1616" formatCode="General">
                  <c:v>0.502363</c:v>
                </c:pt>
                <c:pt idx="1617" formatCode="General">
                  <c:v>0.54934000000000005</c:v>
                </c:pt>
                <c:pt idx="1618" formatCode="General">
                  <c:v>0.60069300000000003</c:v>
                </c:pt>
                <c:pt idx="1619" formatCode="General">
                  <c:v>0.65682600000000002</c:v>
                </c:pt>
                <c:pt idx="1620" formatCode="General">
                  <c:v>0.70524699999999996</c:v>
                </c:pt>
                <c:pt idx="1621" formatCode="General">
                  <c:v>0.74579300000000004</c:v>
                </c:pt>
                <c:pt idx="1622" formatCode="General">
                  <c:v>0.78865700000000005</c:v>
                </c:pt>
                <c:pt idx="1623" formatCode="General">
                  <c:v>0.79577600000000004</c:v>
                </c:pt>
                <c:pt idx="1624" formatCode="General">
                  <c:v>0.80295799999999995</c:v>
                </c:pt>
                <c:pt idx="1625" formatCode="General">
                  <c:v>0.81020499999999995</c:v>
                </c:pt>
                <c:pt idx="1626" formatCode="General">
                  <c:v>0.81751799999999997</c:v>
                </c:pt>
                <c:pt idx="1627" formatCode="General">
                  <c:v>0.82489500000000004</c:v>
                </c:pt>
                <c:pt idx="1628" formatCode="General">
                  <c:v>0.83518099999999995</c:v>
                </c:pt>
                <c:pt idx="1629" formatCode="General">
                  <c:v>0.84559300000000004</c:v>
                </c:pt>
                <c:pt idx="1630" formatCode="General">
                  <c:v>0.85613499999999998</c:v>
                </c:pt>
                <c:pt idx="1631" formatCode="General">
                  <c:v>0.86680800000000002</c:v>
                </c:pt>
                <c:pt idx="1632" formatCode="General">
                  <c:v>0.88825100000000001</c:v>
                </c:pt>
                <c:pt idx="1633" formatCode="General">
                  <c:v>0.91022199999999998</c:v>
                </c:pt>
                <c:pt idx="1634" formatCode="General">
                  <c:v>0.93273200000000001</c:v>
                </c:pt>
                <c:pt idx="1635" formatCode="General">
                  <c:v>0.95579400000000003</c:v>
                </c:pt>
                <c:pt idx="1636" formatCode="General">
                  <c:v>0.988819</c:v>
                </c:pt>
                <c:pt idx="1637" formatCode="General">
                  <c:v>1.02298</c:v>
                </c:pt>
                <c:pt idx="1638" formatCode="General">
                  <c:v>1.0583</c:v>
                </c:pt>
                <c:pt idx="1639" formatCode="General">
                  <c:v>1.09484</c:v>
                </c:pt>
                <c:pt idx="1640" formatCode="General">
                  <c:v>1.1238300000000001</c:v>
                </c:pt>
                <c:pt idx="1641" formatCode="General">
                  <c:v>1.14825</c:v>
                </c:pt>
                <c:pt idx="1642" formatCode="General">
                  <c:v>1.1731799999999999</c:v>
                </c:pt>
                <c:pt idx="1643" formatCode="General">
                  <c:v>1.1779999999999999</c:v>
                </c:pt>
                <c:pt idx="1644" formatCode="General">
                  <c:v>1.1828399999999999</c:v>
                </c:pt>
                <c:pt idx="1645" formatCode="General">
                  <c:v>1.1876899999999999</c:v>
                </c:pt>
                <c:pt idx="1646" formatCode="General">
                  <c:v>1.1925600000000001</c:v>
                </c:pt>
                <c:pt idx="1647" formatCode="General">
                  <c:v>1.2023699999999999</c:v>
                </c:pt>
                <c:pt idx="1648" formatCode="General">
                  <c:v>1.2122599999999999</c:v>
                </c:pt>
                <c:pt idx="1649" formatCode="General">
                  <c:v>1.2222299999999999</c:v>
                </c:pt>
                <c:pt idx="1650" formatCode="General">
                  <c:v>1.23228</c:v>
                </c:pt>
                <c:pt idx="1651" formatCode="General">
                  <c:v>1.2593000000000001</c:v>
                </c:pt>
                <c:pt idx="1652" formatCode="General">
                  <c:v>1.28691</c:v>
                </c:pt>
                <c:pt idx="1653" formatCode="General">
                  <c:v>1.31511</c:v>
                </c:pt>
                <c:pt idx="1654" formatCode="General">
                  <c:v>1.3439300000000001</c:v>
                </c:pt>
                <c:pt idx="1655" formatCode="General">
                  <c:v>1.38324</c:v>
                </c:pt>
                <c:pt idx="1656" formatCode="General">
                  <c:v>1.4236899999999999</c:v>
                </c:pt>
                <c:pt idx="1657" formatCode="General">
                  <c:v>1.4653099999999999</c:v>
                </c:pt>
                <c:pt idx="1658" formatCode="General">
                  <c:v>1.50813</c:v>
                </c:pt>
                <c:pt idx="1659" formatCode="General">
                  <c:v>1.55217</c:v>
                </c:pt>
                <c:pt idx="1660" formatCode="General">
                  <c:v>1.5974900000000001</c:v>
                </c:pt>
                <c:pt idx="1661" formatCode="General">
                  <c:v>1.6313800000000001</c:v>
                </c:pt>
                <c:pt idx="1662" formatCode="General">
                  <c:v>1.6659900000000001</c:v>
                </c:pt>
                <c:pt idx="1663" formatCode="General">
                  <c:v>1.7013100000000001</c:v>
                </c:pt>
                <c:pt idx="1664" formatCode="General">
                  <c:v>1.70712</c:v>
                </c:pt>
                <c:pt idx="1665" formatCode="General">
                  <c:v>1.71295</c:v>
                </c:pt>
                <c:pt idx="1666" formatCode="General">
                  <c:v>1.7188000000000001</c:v>
                </c:pt>
                <c:pt idx="1667" formatCode="General">
                  <c:v>1.72468</c:v>
                </c:pt>
                <c:pt idx="1668" formatCode="General">
                  <c:v>1.73648</c:v>
                </c:pt>
                <c:pt idx="1669" formatCode="General">
                  <c:v>1.7483500000000001</c:v>
                </c:pt>
                <c:pt idx="1670" formatCode="General">
                  <c:v>1.76031</c:v>
                </c:pt>
                <c:pt idx="1671" formatCode="General">
                  <c:v>1.7723500000000001</c:v>
                </c:pt>
                <c:pt idx="1672" formatCode="General">
                  <c:v>1.80291</c:v>
                </c:pt>
                <c:pt idx="1673" formatCode="General">
                  <c:v>1.83399</c:v>
                </c:pt>
                <c:pt idx="1674" formatCode="General">
                  <c:v>1.86558</c:v>
                </c:pt>
                <c:pt idx="1675" formatCode="General">
                  <c:v>1.89771</c:v>
                </c:pt>
                <c:pt idx="1676" formatCode="General">
                  <c:v>1.9463200000000001</c:v>
                </c:pt>
                <c:pt idx="1677" formatCode="General">
                  <c:v>1.9961500000000001</c:v>
                </c:pt>
                <c:pt idx="1678" formatCode="General">
                  <c:v>2.0472199999999998</c:v>
                </c:pt>
                <c:pt idx="1679" formatCode="General">
                  <c:v>2.0995599999999999</c:v>
                </c:pt>
                <c:pt idx="1680" formatCode="General">
                  <c:v>2.1532</c:v>
                </c:pt>
                <c:pt idx="1681" formatCode="General">
                  <c:v>2.2314799999999999</c:v>
                </c:pt>
                <c:pt idx="1682" formatCode="General">
                  <c:v>2.3125100000000001</c:v>
                </c:pt>
                <c:pt idx="1683" formatCode="General">
                  <c:v>2.3963800000000002</c:v>
                </c:pt>
                <c:pt idx="1684" formatCode="General">
                  <c:v>2.48319</c:v>
                </c:pt>
                <c:pt idx="1685" formatCode="General">
                  <c:v>2.5730300000000002</c:v>
                </c:pt>
                <c:pt idx="1686" formatCode="General">
                  <c:v>2.6659799999999998</c:v>
                </c:pt>
                <c:pt idx="1687" formatCode="General">
                  <c:v>2.76214</c:v>
                </c:pt>
                <c:pt idx="1688" formatCode="General">
                  <c:v>2.8437800000000002</c:v>
                </c:pt>
                <c:pt idx="1689" formatCode="General">
                  <c:v>2.9277099999999998</c:v>
                </c:pt>
                <c:pt idx="1690" formatCode="General">
                  <c:v>3.0139900000000002</c:v>
                </c:pt>
                <c:pt idx="1691" formatCode="General">
                  <c:v>3.1026600000000002</c:v>
                </c:pt>
                <c:pt idx="1692" formatCode="General">
                  <c:v>3.1937899999999999</c:v>
                </c:pt>
                <c:pt idx="1693" formatCode="General">
                  <c:v>3.28742</c:v>
                </c:pt>
                <c:pt idx="1694" formatCode="General">
                  <c:v>3.38361</c:v>
                </c:pt>
                <c:pt idx="1695" formatCode="General">
                  <c:v>3.4824000000000002</c:v>
                </c:pt>
                <c:pt idx="1696" formatCode="General">
                  <c:v>3.58385</c:v>
                </c:pt>
                <c:pt idx="1697" formatCode="General">
                  <c:v>3.6880000000000002</c:v>
                </c:pt>
                <c:pt idx="1698" formatCode="General">
                  <c:v>3.7949099999999998</c:v>
                </c:pt>
                <c:pt idx="1699" formatCode="General">
                  <c:v>3.90462</c:v>
                </c:pt>
                <c:pt idx="1700" formatCode="General">
                  <c:v>3.9959799999999999</c:v>
                </c:pt>
                <c:pt idx="1701" formatCode="General">
                  <c:v>4.0892400000000002</c:v>
                </c:pt>
                <c:pt idx="1702" formatCode="General">
                  <c:v>4.1670199999999999</c:v>
                </c:pt>
                <c:pt idx="1703" formatCode="General">
                  <c:v>4.2460899999999997</c:v>
                </c:pt>
                <c:pt idx="1704" formatCode="General">
                  <c:v>4.3264699999999996</c:v>
                </c:pt>
                <c:pt idx="1705" formatCode="General">
                  <c:v>4.4081599999999996</c:v>
                </c:pt>
                <c:pt idx="1706" formatCode="General">
                  <c:v>4.4763299999999999</c:v>
                </c:pt>
                <c:pt idx="1707" formatCode="General">
                  <c:v>4.5320799999999997</c:v>
                </c:pt>
                <c:pt idx="1708" formatCode="General">
                  <c:v>4.5884200000000002</c:v>
                </c:pt>
                <c:pt idx="1709" formatCode="General">
                  <c:v>4.6453499999999996</c:v>
                </c:pt>
                <c:pt idx="1710" formatCode="General">
                  <c:v>4.7028600000000003</c:v>
                </c:pt>
                <c:pt idx="1711" formatCode="General">
                  <c:v>4.7123699999999999</c:v>
                </c:pt>
                <c:pt idx="1712" formatCode="General">
                  <c:v>4.7218999999999998</c:v>
                </c:pt>
                <c:pt idx="1713" formatCode="General">
                  <c:v>4.7314299999999996</c:v>
                </c:pt>
                <c:pt idx="1714" formatCode="General">
                  <c:v>4.74099</c:v>
                </c:pt>
                <c:pt idx="1715" formatCode="General">
                  <c:v>4.7594000000000003</c:v>
                </c:pt>
                <c:pt idx="1716" formatCode="General">
                  <c:v>4.7778700000000001</c:v>
                </c:pt>
                <c:pt idx="1717" formatCode="General">
                  <c:v>4.7964000000000002</c:v>
                </c:pt>
                <c:pt idx="1718" formatCode="General">
                  <c:v>4.8149899999999999</c:v>
                </c:pt>
                <c:pt idx="1719" formatCode="General">
                  <c:v>4.8779300000000001</c:v>
                </c:pt>
                <c:pt idx="1720" formatCode="General">
                  <c:v>4.9415300000000002</c:v>
                </c:pt>
                <c:pt idx="1721" formatCode="General">
                  <c:v>5.0057999999999998</c:v>
                </c:pt>
                <c:pt idx="1722" formatCode="General">
                  <c:v>5.0707199999999997</c:v>
                </c:pt>
                <c:pt idx="1723" formatCode="General">
                  <c:v>5.1363099999999999</c:v>
                </c:pt>
                <c:pt idx="1724" formatCode="General">
                  <c:v>5.23963</c:v>
                </c:pt>
                <c:pt idx="1725" formatCode="General">
                  <c:v>5.3445299999999998</c:v>
                </c:pt>
                <c:pt idx="1726" formatCode="General">
                  <c:v>5.4509699999999999</c:v>
                </c:pt>
                <c:pt idx="1727" formatCode="General">
                  <c:v>5.5589399999999998</c:v>
                </c:pt>
                <c:pt idx="1728" formatCode="General">
                  <c:v>5.6684000000000001</c:v>
                </c:pt>
                <c:pt idx="1729" formatCode="General">
                  <c:v>5.7920299999999996</c:v>
                </c:pt>
                <c:pt idx="1730" formatCode="General">
                  <c:v>5.9173999999999998</c:v>
                </c:pt>
                <c:pt idx="1731" formatCode="General">
                  <c:v>6.0444300000000002</c:v>
                </c:pt>
                <c:pt idx="1732" formatCode="General">
                  <c:v>6.1730400000000003</c:v>
                </c:pt>
                <c:pt idx="1733" formatCode="General">
                  <c:v>6.3031199999999998</c:v>
                </c:pt>
                <c:pt idx="1734" formatCode="General">
                  <c:v>6.4345400000000001</c:v>
                </c:pt>
                <c:pt idx="1735" formatCode="General">
                  <c:v>6.5671499999999998</c:v>
                </c:pt>
                <c:pt idx="1736" formatCode="General">
                  <c:v>6.7008000000000001</c:v>
                </c:pt>
                <c:pt idx="1737" formatCode="General">
                  <c:v>6.8352899999999996</c:v>
                </c:pt>
                <c:pt idx="1738" formatCode="General">
                  <c:v>6.9703799999999996</c:v>
                </c:pt>
                <c:pt idx="1739" formatCode="General">
                  <c:v>7.1058399999999997</c:v>
                </c:pt>
                <c:pt idx="1740" formatCode="General">
                  <c:v>7.2413499999999997</c:v>
                </c:pt>
                <c:pt idx="1741" formatCode="General">
                  <c:v>7.3765900000000002</c:v>
                </c:pt>
                <c:pt idx="1742" formatCode="General">
                  <c:v>7.5111600000000003</c:v>
                </c:pt>
                <c:pt idx="1743" formatCode="General">
                  <c:v>7.6446300000000003</c:v>
                </c:pt>
                <c:pt idx="1744" formatCode="General">
                  <c:v>7.7764899999999999</c:v>
                </c:pt>
                <c:pt idx="1745" formatCode="General">
                  <c:v>7.9061500000000002</c:v>
                </c:pt>
                <c:pt idx="1746" formatCode="General">
                  <c:v>8.0329700000000006</c:v>
                </c:pt>
                <c:pt idx="1747" formatCode="General">
                  <c:v>8.1561900000000005</c:v>
                </c:pt>
                <c:pt idx="1748" formatCode="General">
                  <c:v>8.2749500000000005</c:v>
                </c:pt>
                <c:pt idx="1749" formatCode="General">
                  <c:v>8.38828</c:v>
                </c:pt>
                <c:pt idx="1750" formatCode="General">
                  <c:v>8.4950700000000001</c:v>
                </c:pt>
                <c:pt idx="1751" formatCode="General">
                  <c:v>8.5940499999999993</c:v>
                </c:pt>
                <c:pt idx="1752" formatCode="General">
                  <c:v>8.6837999999999997</c:v>
                </c:pt>
                <c:pt idx="1753" formatCode="General">
                  <c:v>8.7627000000000006</c:v>
                </c:pt>
                <c:pt idx="1754" formatCode="General">
                  <c:v>8.8289000000000009</c:v>
                </c:pt>
                <c:pt idx="1755" formatCode="General">
                  <c:v>8.8728300000000004</c:v>
                </c:pt>
                <c:pt idx="1756" formatCode="General">
                  <c:v>8.9052500000000006</c:v>
                </c:pt>
                <c:pt idx="1757" formatCode="General">
                  <c:v>8.9247099999999993</c:v>
                </c:pt>
                <c:pt idx="1758" formatCode="General">
                  <c:v>8.9296600000000002</c:v>
                </c:pt>
                <c:pt idx="1759" formatCode="General">
                  <c:v>8.9291</c:v>
                </c:pt>
                <c:pt idx="1760" formatCode="General">
                  <c:v>8.92821</c:v>
                </c:pt>
                <c:pt idx="1761" formatCode="General">
                  <c:v>8.9269800000000004</c:v>
                </c:pt>
                <c:pt idx="1762" formatCode="General">
                  <c:v>8.9254200000000008</c:v>
                </c:pt>
                <c:pt idx="1763" formatCode="General">
                  <c:v>8.9235100000000003</c:v>
                </c:pt>
                <c:pt idx="1764" formatCode="General">
                  <c:v>8.9192</c:v>
                </c:pt>
                <c:pt idx="1765" formatCode="General">
                  <c:v>8.9137199999999996</c:v>
                </c:pt>
                <c:pt idx="1766" formatCode="General">
                  <c:v>8.9070599999999995</c:v>
                </c:pt>
                <c:pt idx="1767" formatCode="General">
                  <c:v>8.8991699999999998</c:v>
                </c:pt>
                <c:pt idx="1768" formatCode="General">
                  <c:v>8.88626</c:v>
                </c:pt>
                <c:pt idx="1769" formatCode="General">
                  <c:v>8.8709000000000007</c:v>
                </c:pt>
                <c:pt idx="1770" formatCode="General">
                  <c:v>8.8529999999999998</c:v>
                </c:pt>
                <c:pt idx="1771" formatCode="General">
                  <c:v>8.8324700000000007</c:v>
                </c:pt>
                <c:pt idx="1772" formatCode="General">
                  <c:v>8.7957199999999993</c:v>
                </c:pt>
                <c:pt idx="1773" formatCode="General">
                  <c:v>8.7522900000000003</c:v>
                </c:pt>
                <c:pt idx="1774" formatCode="General">
                  <c:v>8.7018400000000007</c:v>
                </c:pt>
                <c:pt idx="1775" formatCode="General">
                  <c:v>8.64405</c:v>
                </c:pt>
                <c:pt idx="1776" formatCode="General">
                  <c:v>8.5786099999999994</c:v>
                </c:pt>
                <c:pt idx="1777" formatCode="General">
                  <c:v>8.5051900000000007</c:v>
                </c:pt>
                <c:pt idx="1778" formatCode="General">
                  <c:v>8.4235000000000007</c:v>
                </c:pt>
                <c:pt idx="1779" formatCode="General">
                  <c:v>8.33324</c:v>
                </c:pt>
                <c:pt idx="1780" formatCode="General">
                  <c:v>8.2341300000000004</c:v>
                </c:pt>
                <c:pt idx="1781" formatCode="General">
                  <c:v>8.1259200000000007</c:v>
                </c:pt>
                <c:pt idx="1782" formatCode="General">
                  <c:v>8.0084</c:v>
                </c:pt>
                <c:pt idx="1783" formatCode="General">
                  <c:v>7.8506900000000002</c:v>
                </c:pt>
                <c:pt idx="1784" formatCode="General">
                  <c:v>7.6783200000000003</c:v>
                </c:pt>
                <c:pt idx="1785" formatCode="General">
                  <c:v>7.4911199999999996</c:v>
                </c:pt>
                <c:pt idx="1786" formatCode="General">
                  <c:v>7.4621300000000002</c:v>
                </c:pt>
                <c:pt idx="1787" formatCode="General">
                  <c:v>7.4328200000000004</c:v>
                </c:pt>
                <c:pt idx="1788" formatCode="General">
                  <c:v>7.4031900000000004</c:v>
                </c:pt>
                <c:pt idx="1789" formatCode="General">
                  <c:v>7.3732199999999999</c:v>
                </c:pt>
                <c:pt idx="1790" formatCode="General">
                  <c:v>7.3429399999999996</c:v>
                </c:pt>
                <c:pt idx="1791" formatCode="General">
                  <c:v>7.2836699999999999</c:v>
                </c:pt>
                <c:pt idx="1792" formatCode="General">
                  <c:v>7.2232099999999999</c:v>
                </c:pt>
                <c:pt idx="1793" formatCode="General">
                  <c:v>7.1615599999999997</c:v>
                </c:pt>
                <c:pt idx="1794" formatCode="General">
                  <c:v>7.0987200000000001</c:v>
                </c:pt>
                <c:pt idx="1795" formatCode="General">
                  <c:v>7.0347099999999996</c:v>
                </c:pt>
                <c:pt idx="1796" formatCode="General">
                  <c:v>6.8817199999999996</c:v>
                </c:pt>
                <c:pt idx="1797" formatCode="General">
                  <c:v>6.7225999999999999</c:v>
                </c:pt>
                <c:pt idx="1798" formatCode="General">
                  <c:v>6.5575400000000004</c:v>
                </c:pt>
                <c:pt idx="1799" formatCode="General">
                  <c:v>6.3867700000000003</c:v>
                </c:pt>
                <c:pt idx="1800" formatCode="General">
                  <c:v>6.2105600000000001</c:v>
                </c:pt>
                <c:pt idx="1801" formatCode="General">
                  <c:v>5.9486999999999997</c:v>
                </c:pt>
                <c:pt idx="1802" formatCode="General">
                  <c:v>5.7233799999999997</c:v>
                </c:pt>
                <c:pt idx="1803" formatCode="General">
                  <c:v>5.4922500000000003</c:v>
                </c:pt>
                <c:pt idx="1804" formatCode="General">
                  <c:v>5.30314</c:v>
                </c:pt>
                <c:pt idx="1805" formatCode="General">
                  <c:v>5.2695100000000004</c:v>
                </c:pt>
                <c:pt idx="1806" formatCode="General">
                  <c:v>5.2358099999999999</c:v>
                </c:pt>
                <c:pt idx="1807" formatCode="General">
                  <c:v>5.2020200000000001</c:v>
                </c:pt>
                <c:pt idx="1808" formatCode="General">
                  <c:v>5.1681600000000003</c:v>
                </c:pt>
                <c:pt idx="1809" formatCode="General">
                  <c:v>5.13422</c:v>
                </c:pt>
                <c:pt idx="1810" formatCode="General">
                  <c:v>5.0697400000000004</c:v>
                </c:pt>
                <c:pt idx="1811" formatCode="General">
                  <c:v>5.0050299999999996</c:v>
                </c:pt>
                <c:pt idx="1812" formatCode="General">
                  <c:v>4.9400899999999996</c:v>
                </c:pt>
                <c:pt idx="1813" formatCode="General">
                  <c:v>4.8749599999999997</c:v>
                </c:pt>
                <c:pt idx="1814" formatCode="General">
                  <c:v>4.7628500000000003</c:v>
                </c:pt>
                <c:pt idx="1815" formatCode="General">
                  <c:v>4.6503100000000002</c:v>
                </c:pt>
                <c:pt idx="1816" formatCode="General">
                  <c:v>4.5374699999999999</c:v>
                </c:pt>
                <c:pt idx="1817" formatCode="General">
                  <c:v>4.4244199999999996</c:v>
                </c:pt>
                <c:pt idx="1818" formatCode="General">
                  <c:v>4.2873000000000001</c:v>
                </c:pt>
                <c:pt idx="1819" formatCode="General">
                  <c:v>4.1502400000000002</c:v>
                </c:pt>
                <c:pt idx="1820" formatCode="General">
                  <c:v>4.0134499999999997</c:v>
                </c:pt>
                <c:pt idx="1821" formatCode="General">
                  <c:v>3.8771200000000001</c:v>
                </c:pt>
                <c:pt idx="1822" formatCode="General">
                  <c:v>3.7414700000000001</c:v>
                </c:pt>
                <c:pt idx="1823" formatCode="General">
                  <c:v>3.5735299999999999</c:v>
                </c:pt>
                <c:pt idx="1824" formatCode="General">
                  <c:v>3.4073500000000001</c:v>
                </c:pt>
                <c:pt idx="1825" formatCode="General">
                  <c:v>3.2433100000000001</c:v>
                </c:pt>
                <c:pt idx="1826" formatCode="General">
                  <c:v>3.0817899999999998</c:v>
                </c:pt>
                <c:pt idx="1827" formatCode="General">
                  <c:v>2.9231500000000001</c:v>
                </c:pt>
                <c:pt idx="1828" formatCode="General">
                  <c:v>2.7335400000000001</c:v>
                </c:pt>
                <c:pt idx="1829" formatCode="General">
                  <c:v>2.54935</c:v>
                </c:pt>
                <c:pt idx="1830" formatCode="General">
                  <c:v>2.37113</c:v>
                </c:pt>
                <c:pt idx="1831" formatCode="General">
                  <c:v>2.19936</c:v>
                </c:pt>
                <c:pt idx="1832" formatCode="General">
                  <c:v>2.0344600000000002</c:v>
                </c:pt>
                <c:pt idx="1833" formatCode="General">
                  <c:v>2.0078</c:v>
                </c:pt>
                <c:pt idx="1834" formatCode="General">
                  <c:v>1.9813400000000001</c:v>
                </c:pt>
                <c:pt idx="1835" formatCode="General">
                  <c:v>1.95509</c:v>
                </c:pt>
                <c:pt idx="1836" formatCode="General">
                  <c:v>1.9290400000000001</c:v>
                </c:pt>
                <c:pt idx="1837" formatCode="General">
                  <c:v>1.9031899999999999</c:v>
                </c:pt>
                <c:pt idx="1838" formatCode="General">
                  <c:v>1.8521099999999999</c:v>
                </c:pt>
                <c:pt idx="1839" formatCode="General">
                  <c:v>1.8018700000000001</c:v>
                </c:pt>
                <c:pt idx="1840" formatCode="General">
                  <c:v>1.75247</c:v>
                </c:pt>
                <c:pt idx="1841" formatCode="General">
                  <c:v>1.70391</c:v>
                </c:pt>
                <c:pt idx="1842" formatCode="General">
                  <c:v>1.6561999999999999</c:v>
                </c:pt>
                <c:pt idx="1843" formatCode="General">
                  <c:v>1.57969</c:v>
                </c:pt>
                <c:pt idx="1844" formatCode="General">
                  <c:v>1.50552</c:v>
                </c:pt>
                <c:pt idx="1845" formatCode="General">
                  <c:v>1.4336899999999999</c:v>
                </c:pt>
                <c:pt idx="1846" formatCode="General">
                  <c:v>1.3642300000000001</c:v>
                </c:pt>
                <c:pt idx="1847" formatCode="General">
                  <c:v>1.2971299999999999</c:v>
                </c:pt>
                <c:pt idx="1848" formatCode="General">
                  <c:v>1.2082900000000001</c:v>
                </c:pt>
                <c:pt idx="1849" formatCode="General">
                  <c:v>1.12392</c:v>
                </c:pt>
                <c:pt idx="1850" formatCode="General">
                  <c:v>1.0439700000000001</c:v>
                </c:pt>
                <c:pt idx="1851" formatCode="General">
                  <c:v>0.96836299999999997</c:v>
                </c:pt>
                <c:pt idx="1852" formatCode="General">
                  <c:v>0.89702599999999999</c:v>
                </c:pt>
                <c:pt idx="1853" formatCode="General">
                  <c:v>0.81952199999999997</c:v>
                </c:pt>
                <c:pt idx="1854" formatCode="General">
                  <c:v>0.74744100000000002</c:v>
                </c:pt>
                <c:pt idx="1855" formatCode="General">
                  <c:v>0.68058399999999997</c:v>
                </c:pt>
                <c:pt idx="1856" formatCode="General">
                  <c:v>0.61873500000000003</c:v>
                </c:pt>
                <c:pt idx="1857" formatCode="General">
                  <c:v>0.56166499999999997</c:v>
                </c:pt>
                <c:pt idx="1858" formatCode="General">
                  <c:v>0.50913600000000003</c:v>
                </c:pt>
                <c:pt idx="1859" formatCode="General">
                  <c:v>0.460899</c:v>
                </c:pt>
                <c:pt idx="1860" formatCode="General">
                  <c:v>0.42415599999999998</c:v>
                </c:pt>
                <c:pt idx="1861" formatCode="General">
                  <c:v>0.39002500000000001</c:v>
                </c:pt>
                <c:pt idx="1862" formatCode="General">
                  <c:v>0.35836699999999999</c:v>
                </c:pt>
                <c:pt idx="1863" formatCode="General">
                  <c:v>0.329042</c:v>
                </c:pt>
                <c:pt idx="1864" formatCode="General">
                  <c:v>0.30662600000000001</c:v>
                </c:pt>
                <c:pt idx="1865" formatCode="General">
                  <c:v>0.30305700000000002</c:v>
                </c:pt>
                <c:pt idx="1866" formatCode="General">
                  <c:v>0.29952600000000001</c:v>
                </c:pt>
                <c:pt idx="1867" formatCode="General">
                  <c:v>0.29603299999999999</c:v>
                </c:pt>
                <c:pt idx="1868" formatCode="General">
                  <c:v>0.29257699999999998</c:v>
                </c:pt>
                <c:pt idx="1869" formatCode="General">
                  <c:v>0.28915800000000003</c:v>
                </c:pt>
                <c:pt idx="1870" formatCode="General">
                  <c:v>0.28470400000000001</c:v>
                </c:pt>
                <c:pt idx="1871" formatCode="General">
                  <c:v>0.28031400000000001</c:v>
                </c:pt>
                <c:pt idx="1872" formatCode="General">
                  <c:v>0.27598499999999998</c:v>
                </c:pt>
                <c:pt idx="1873" formatCode="General">
                  <c:v>0.27171899999999999</c:v>
                </c:pt>
                <c:pt idx="1874" formatCode="General">
                  <c:v>0.26033099999999998</c:v>
                </c:pt>
                <c:pt idx="1875" formatCode="General">
                  <c:v>0.249388</c:v>
                </c:pt>
                <c:pt idx="1876" formatCode="General">
                  <c:v>0.238875</c:v>
                </c:pt>
                <c:pt idx="1877" formatCode="General">
                  <c:v>0.22877900000000001</c:v>
                </c:pt>
                <c:pt idx="1878" formatCode="General">
                  <c:v>0.21404300000000001</c:v>
                </c:pt>
                <c:pt idx="1879" formatCode="General">
                  <c:v>0.200208</c:v>
                </c:pt>
                <c:pt idx="1880" formatCode="General">
                  <c:v>0.187224</c:v>
                </c:pt>
                <c:pt idx="1881" formatCode="General">
                  <c:v>0.17504800000000001</c:v>
                </c:pt>
                <c:pt idx="1882" formatCode="General">
                  <c:v>0.163633</c:v>
                </c:pt>
                <c:pt idx="1883" formatCode="General">
                  <c:v>0.14922199999999999</c:v>
                </c:pt>
                <c:pt idx="1884" formatCode="General">
                  <c:v>0.13861000000000001</c:v>
                </c:pt>
                <c:pt idx="1885" formatCode="General">
                  <c:v>0.12873499999999999</c:v>
                </c:pt>
                <c:pt idx="1886" formatCode="General">
                  <c:v>0.11955</c:v>
                </c:pt>
                <c:pt idx="1887" formatCode="General">
                  <c:v>0.111009</c:v>
                </c:pt>
                <c:pt idx="1888" formatCode="General">
                  <c:v>0.103072</c:v>
                </c:pt>
                <c:pt idx="1889" formatCode="General">
                  <c:v>9.5698099999999994E-2</c:v>
                </c:pt>
                <c:pt idx="1890" formatCode="General">
                  <c:v>8.8849300000000006E-2</c:v>
                </c:pt>
                <c:pt idx="1891" formatCode="General">
                  <c:v>8.2490300000000003E-2</c:v>
                </c:pt>
                <c:pt idx="1892" formatCode="General">
                  <c:v>8.1557400000000002E-2</c:v>
                </c:pt>
                <c:pt idx="1893" formatCode="General">
                  <c:v>8.0634999999999998E-2</c:v>
                </c:pt>
                <c:pt idx="1894" formatCode="General">
                  <c:v>7.9723100000000005E-2</c:v>
                </c:pt>
                <c:pt idx="1895" formatCode="General">
                  <c:v>7.8821600000000006E-2</c:v>
                </c:pt>
                <c:pt idx="1896" formatCode="General">
                  <c:v>7.7930299999999994E-2</c:v>
                </c:pt>
                <c:pt idx="1897" formatCode="General">
                  <c:v>7.6219400000000007E-2</c:v>
                </c:pt>
                <c:pt idx="1898" formatCode="General">
                  <c:v>7.4546200000000007E-2</c:v>
                </c:pt>
                <c:pt idx="1899" formatCode="General">
                  <c:v>7.2910100000000005E-2</c:v>
                </c:pt>
                <c:pt idx="1900" formatCode="General">
                  <c:v>7.1310200000000004E-2</c:v>
                </c:pt>
                <c:pt idx="1901" formatCode="General">
                  <c:v>6.8600800000000003E-2</c:v>
                </c:pt>
                <c:pt idx="1902" formatCode="General">
                  <c:v>6.5995499999999999E-2</c:v>
                </c:pt>
                <c:pt idx="1903" formatCode="General">
                  <c:v>6.3490400000000002E-2</c:v>
                </c:pt>
                <c:pt idx="1904" formatCode="General">
                  <c:v>6.1081799999999999E-2</c:v>
                </c:pt>
                <c:pt idx="1905" formatCode="General">
                  <c:v>5.76249E-2</c:v>
                </c:pt>
                <c:pt idx="1906" formatCode="General">
                  <c:v>5.4367199999999997E-2</c:v>
                </c:pt>
                <c:pt idx="1907" formatCode="General">
                  <c:v>5.12974E-2</c:v>
                </c:pt>
                <c:pt idx="1908" formatCode="General">
                  <c:v>4.8404700000000002E-2</c:v>
                </c:pt>
                <c:pt idx="1909" formatCode="General">
                  <c:v>4.5679299999999999E-2</c:v>
                </c:pt>
                <c:pt idx="1910" formatCode="General">
                  <c:v>4.27868E-2</c:v>
                </c:pt>
                <c:pt idx="1911" formatCode="General">
                  <c:v>4.0082699999999999E-2</c:v>
                </c:pt>
                <c:pt idx="1912" formatCode="General">
                  <c:v>3.7554799999999999E-2</c:v>
                </c:pt>
                <c:pt idx="1913" formatCode="General">
                  <c:v>3.5191600000000003E-2</c:v>
                </c:pt>
                <c:pt idx="1914" formatCode="General">
                  <c:v>3.2982400000000002E-2</c:v>
                </c:pt>
                <c:pt idx="1915" formatCode="General">
                  <c:v>3.06384E-2</c:v>
                </c:pt>
                <c:pt idx="1916" formatCode="General">
                  <c:v>2.84675E-2</c:v>
                </c:pt>
                <c:pt idx="1917" formatCode="General">
                  <c:v>2.6456799999999999E-2</c:v>
                </c:pt>
                <c:pt idx="1918" formatCode="General">
                  <c:v>2.4594399999999999E-2</c:v>
                </c:pt>
                <c:pt idx="1919" formatCode="General">
                  <c:v>2.2869E-2</c:v>
                </c:pt>
                <c:pt idx="1920" formatCode="General">
                  <c:v>2.2573099999999999E-2</c:v>
                </c:pt>
                <c:pt idx="1921" formatCode="General">
                  <c:v>2.2281200000000001E-2</c:v>
                </c:pt>
                <c:pt idx="1922" formatCode="General">
                  <c:v>2.19933E-2</c:v>
                </c:pt>
                <c:pt idx="1923" formatCode="General">
                  <c:v>2.1709300000000001E-2</c:v>
                </c:pt>
                <c:pt idx="1924" formatCode="General">
                  <c:v>2.14291E-2</c:v>
                </c:pt>
                <c:pt idx="1925" formatCode="General">
                  <c:v>2.1059899999999999E-2</c:v>
                </c:pt>
                <c:pt idx="1926" formatCode="General">
                  <c:v>2.0697400000000001E-2</c:v>
                </c:pt>
                <c:pt idx="1927" formatCode="General">
                  <c:v>2.0341399999999999E-2</c:v>
                </c:pt>
                <c:pt idx="1928" formatCode="General">
                  <c:v>1.99919E-2</c:v>
                </c:pt>
                <c:pt idx="1929" formatCode="General">
                  <c:v>1.9300600000000001E-2</c:v>
                </c:pt>
                <c:pt idx="1930" formatCode="General">
                  <c:v>1.8634499999999998E-2</c:v>
                </c:pt>
                <c:pt idx="1931" formatCode="General">
                  <c:v>1.79927E-2</c:v>
                </c:pt>
                <c:pt idx="1932" formatCode="General">
                  <c:v>1.7374199999999999E-2</c:v>
                </c:pt>
                <c:pt idx="1933" formatCode="General">
                  <c:v>1.6584499999999999E-2</c:v>
                </c:pt>
                <c:pt idx="1934" formatCode="General">
                  <c:v>1.5832700000000002E-2</c:v>
                </c:pt>
                <c:pt idx="1935" formatCode="General">
                  <c:v>1.5117E-2</c:v>
                </c:pt>
                <c:pt idx="1936" formatCode="General">
                  <c:v>1.44356E-2</c:v>
                </c:pt>
                <c:pt idx="1937" formatCode="General">
                  <c:v>1.37869E-2</c:v>
                </c:pt>
                <c:pt idx="1938" formatCode="General">
                  <c:v>1.30004E-2</c:v>
                </c:pt>
                <c:pt idx="1939" formatCode="General">
                  <c:v>1.2261599999999999E-2</c:v>
                </c:pt>
                <c:pt idx="1940" formatCode="General">
                  <c:v>1.15675E-2</c:v>
                </c:pt>
                <c:pt idx="1941" formatCode="General">
                  <c:v>1.09152E-2</c:v>
                </c:pt>
                <c:pt idx="1942" formatCode="General">
                  <c:v>1.0302199999999999E-2</c:v>
                </c:pt>
                <c:pt idx="1943" formatCode="General">
                  <c:v>9.6570200000000005E-3</c:v>
                </c:pt>
                <c:pt idx="1944" formatCode="General">
                  <c:v>9.0550500000000003E-3</c:v>
                </c:pt>
                <c:pt idx="1945" formatCode="General">
                  <c:v>8.4932400000000009E-3</c:v>
                </c:pt>
                <c:pt idx="1946" formatCode="General">
                  <c:v>7.9687999999999998E-3</c:v>
                </c:pt>
                <c:pt idx="1947" formatCode="General">
                  <c:v>7.4791099999999998E-3</c:v>
                </c:pt>
                <c:pt idx="1948" formatCode="General">
                  <c:v>7.3924200000000002E-3</c:v>
                </c:pt>
                <c:pt idx="1949" formatCode="General">
                  <c:v>7.3068200000000003E-3</c:v>
                </c:pt>
                <c:pt idx="1950" formatCode="General">
                  <c:v>7.2222900000000001E-3</c:v>
                </c:pt>
                <c:pt idx="1951" formatCode="General">
                  <c:v>7.1388199999999997E-3</c:v>
                </c:pt>
                <c:pt idx="1952" formatCode="General">
                  <c:v>7.0563800000000001E-3</c:v>
                </c:pt>
                <c:pt idx="1953" formatCode="General">
                  <c:v>6.9197299999999998E-3</c:v>
                </c:pt>
                <c:pt idx="1954" formatCode="General">
                  <c:v>6.7859399999999999E-3</c:v>
                </c:pt>
                <c:pt idx="1955" formatCode="General">
                  <c:v>6.6549399999999998E-3</c:v>
                </c:pt>
                <c:pt idx="1956" formatCode="General">
                  <c:v>6.52667E-3</c:v>
                </c:pt>
                <c:pt idx="1957" formatCode="General">
                  <c:v>6.31958E-3</c:v>
                </c:pt>
                <c:pt idx="1958" formatCode="General">
                  <c:v>6.1195900000000003E-3</c:v>
                </c:pt>
                <c:pt idx="1959" formatCode="General">
                  <c:v>5.9264499999999998E-3</c:v>
                </c:pt>
                <c:pt idx="1960" formatCode="General">
                  <c:v>5.7399E-3</c:v>
                </c:pt>
                <c:pt idx="1961" formatCode="General">
                  <c:v>5.4742599999999999E-3</c:v>
                </c:pt>
                <c:pt idx="1962" formatCode="General">
                  <c:v>5.2219199999999997E-3</c:v>
                </c:pt>
                <c:pt idx="1963" formatCode="General">
                  <c:v>4.9821700000000002E-3</c:v>
                </c:pt>
                <c:pt idx="1964" formatCode="General">
                  <c:v>4.75436E-3</c:v>
                </c:pt>
                <c:pt idx="1965" formatCode="General">
                  <c:v>4.5378500000000004E-3</c:v>
                </c:pt>
                <c:pt idx="1966" formatCode="General">
                  <c:v>4.2943399999999998E-3</c:v>
                </c:pt>
                <c:pt idx="1967" formatCode="General">
                  <c:v>4.0650199999999999E-3</c:v>
                </c:pt>
                <c:pt idx="1968" formatCode="General">
                  <c:v>3.8490099999999999E-3</c:v>
                </c:pt>
                <c:pt idx="1969" formatCode="General">
                  <c:v>3.6454999999999999E-3</c:v>
                </c:pt>
                <c:pt idx="1970" formatCode="General">
                  <c:v>3.4537000000000001E-3</c:v>
                </c:pt>
                <c:pt idx="1971" formatCode="General">
                  <c:v>3.2530599999999999E-3</c:v>
                </c:pt>
                <c:pt idx="1972" formatCode="General">
                  <c:v>3.0651300000000001E-3</c:v>
                </c:pt>
                <c:pt idx="1973" formatCode="General">
                  <c:v>2.8890500000000002E-3</c:v>
                </c:pt>
                <c:pt idx="1974" formatCode="General">
                  <c:v>2.7240300000000001E-3</c:v>
                </c:pt>
                <c:pt idx="1975" formatCode="General">
                  <c:v>2.5693199999999999E-3</c:v>
                </c:pt>
                <c:pt idx="1976" formatCode="General">
                  <c:v>2.3842999999999998E-3</c:v>
                </c:pt>
                <c:pt idx="1977" formatCode="General">
                  <c:v>2.2138599999999998E-3</c:v>
                </c:pt>
                <c:pt idx="1978" formatCode="General">
                  <c:v>2.0567699999999999E-3</c:v>
                </c:pt>
                <c:pt idx="1979" formatCode="General">
                  <c:v>1.9422599999999999E-3</c:v>
                </c:pt>
                <c:pt idx="1980" formatCode="General">
                  <c:v>1.8347599999999999E-3</c:v>
                </c:pt>
                <c:pt idx="1981" formatCode="General">
                  <c:v>1.7338099999999999E-3</c:v>
                </c:pt>
                <c:pt idx="1982" formatCode="General">
                  <c:v>1.63898E-3</c:v>
                </c:pt>
                <c:pt idx="1983" formatCode="General">
                  <c:v>1.54988E-3</c:v>
                </c:pt>
                <c:pt idx="1984" formatCode="General">
                  <c:v>1.46613E-3</c:v>
                </c:pt>
                <c:pt idx="1985" formatCode="General">
                  <c:v>1.3873799999999999E-3</c:v>
                </c:pt>
                <c:pt idx="1986" formatCode="General">
                  <c:v>1.3133000000000001E-3</c:v>
                </c:pt>
                <c:pt idx="1987" formatCode="General">
                  <c:v>1.24361E-3</c:v>
                </c:pt>
                <c:pt idx="1988" formatCode="General">
                  <c:v>1.16636E-3</c:v>
                </c:pt>
                <c:pt idx="1989" formatCode="General">
                  <c:v>1.09442E-3</c:v>
                </c:pt>
                <c:pt idx="1990" formatCode="General">
                  <c:v>1.0273999999999999E-3</c:v>
                </c:pt>
                <c:pt idx="1991" formatCode="General">
                  <c:v>9.6495000000000001E-4</c:v>
                </c:pt>
                <c:pt idx="1992" formatCode="General">
                  <c:v>9.0671700000000003E-4</c:v>
                </c:pt>
                <c:pt idx="1993" formatCode="General">
                  <c:v>8.5239699999999996E-4</c:v>
                </c:pt>
                <c:pt idx="1994" formatCode="General">
                  <c:v>8.43496E-4</c:v>
                </c:pt>
                <c:pt idx="1995" formatCode="General">
                  <c:v>8.3469999999999996E-4</c:v>
                </c:pt>
                <c:pt idx="1996" formatCode="General">
                  <c:v>8.2600600000000001E-4</c:v>
                </c:pt>
                <c:pt idx="1997" formatCode="General">
                  <c:v>8.1741400000000003E-4</c:v>
                </c:pt>
                <c:pt idx="1998" formatCode="General">
                  <c:v>8.08922E-4</c:v>
                </c:pt>
                <c:pt idx="1999" formatCode="General">
                  <c:v>7.9745200000000003E-4</c:v>
                </c:pt>
                <c:pt idx="2000" formatCode="General">
                  <c:v>7.86164E-4</c:v>
                </c:pt>
                <c:pt idx="2001" formatCode="General">
                  <c:v>7.7505599999999999E-4</c:v>
                </c:pt>
                <c:pt idx="2002" formatCode="General">
                  <c:v>7.6412500000000005E-4</c:v>
                </c:pt>
                <c:pt idx="2003" formatCode="General">
                  <c:v>7.40235E-4</c:v>
                </c:pt>
                <c:pt idx="2004" formatCode="General">
                  <c:v>7.1718300000000003E-4</c:v>
                </c:pt>
                <c:pt idx="2005" formatCode="General">
                  <c:v>6.9493699999999996E-4</c:v>
                </c:pt>
                <c:pt idx="2006" formatCode="General">
                  <c:v>6.7346500000000004E-4</c:v>
                </c:pt>
                <c:pt idx="2007" formatCode="General">
                  <c:v>6.4550399999999998E-4</c:v>
                </c:pt>
                <c:pt idx="2008" formatCode="General">
                  <c:v>6.1884600000000004E-4</c:v>
                </c:pt>
                <c:pt idx="2009" formatCode="General">
                  <c:v>5.9342399999999995E-4</c:v>
                </c:pt>
                <c:pt idx="2010" formatCode="General">
                  <c:v>5.6917700000000003E-4</c:v>
                </c:pt>
                <c:pt idx="2011" formatCode="General">
                  <c:v>5.4604499999999999E-4</c:v>
                </c:pt>
                <c:pt idx="2012" formatCode="General">
                  <c:v>5.1851000000000002E-4</c:v>
                </c:pt>
                <c:pt idx="2013" formatCode="General">
                  <c:v>4.9253800000000005E-4</c:v>
                </c:pt>
                <c:pt idx="2014" formatCode="General">
                  <c:v>4.6803200000000001E-4</c:v>
                </c:pt>
                <c:pt idx="2015" formatCode="General">
                  <c:v>4.4490099999999999E-4</c:v>
                </c:pt>
                <c:pt idx="2016" formatCode="General">
                  <c:v>4.2306100000000002E-4</c:v>
                </c:pt>
                <c:pt idx="2017" formatCode="General">
                  <c:v>4.02433E-4</c:v>
                </c:pt>
                <c:pt idx="2018" formatCode="General">
                  <c:v>3.8294300000000001E-4</c:v>
                </c:pt>
                <c:pt idx="2019" formatCode="General">
                  <c:v>3.6452099999999997E-4</c:v>
                </c:pt>
                <c:pt idx="2020" formatCode="General">
                  <c:v>3.4424599999999998E-4</c:v>
                </c:pt>
                <c:pt idx="2021" formatCode="General">
                  <c:v>3.25249E-4</c:v>
                </c:pt>
                <c:pt idx="2022" formatCode="General">
                  <c:v>3.07442E-4</c:v>
                </c:pt>
                <c:pt idx="2023" formatCode="General">
                  <c:v>2.9074299999999999E-4</c:v>
                </c:pt>
                <c:pt idx="2024" formatCode="General">
                  <c:v>2.7507600000000002E-4</c:v>
                </c:pt>
                <c:pt idx="2025" formatCode="General">
                  <c:v>2.6037100000000002E-4</c:v>
                </c:pt>
                <c:pt idx="2026" formatCode="General">
                  <c:v>2.4083000000000001E-4</c:v>
                </c:pt>
                <c:pt idx="2027" formatCode="General">
                  <c:v>2.22959E-4</c:v>
                </c:pt>
                <c:pt idx="2028" formatCode="General">
                  <c:v>2.0660200000000001E-4</c:v>
                </c:pt>
                <c:pt idx="2029" formatCode="General">
                  <c:v>1.91616E-4</c:v>
                </c:pt>
                <c:pt idx="2030" formatCode="General">
                  <c:v>1.77875E-4</c:v>
                </c:pt>
                <c:pt idx="2031" formatCode="General">
                  <c:v>1.65265E-4</c:v>
                </c:pt>
                <c:pt idx="2032" formatCode="General">
                  <c:v>1.5368200000000001E-4</c:v>
                </c:pt>
                <c:pt idx="2033" formatCode="General">
                  <c:v>1.43034E-4</c:v>
                </c:pt>
                <c:pt idx="2034" formatCode="General">
                  <c:v>1.33237E-4</c:v>
                </c:pt>
                <c:pt idx="2035" formatCode="General">
                  <c:v>1.2328299999999999E-4</c:v>
                </c:pt>
                <c:pt idx="2036" formatCode="General">
                  <c:v>1.1419E-4</c:v>
                </c:pt>
                <c:pt idx="2037" formatCode="General">
                  <c:v>1.05875E-4</c:v>
                </c:pt>
                <c:pt idx="2038">
                  <c:v>9.8263299999999998E-5</c:v>
                </c:pt>
                <c:pt idx="2039">
                  <c:v>9.12894E-5</c:v>
                </c:pt>
                <c:pt idx="2040">
                  <c:v>8.4893400000000003E-5</c:v>
                </c:pt>
                <c:pt idx="2041">
                  <c:v>7.9022000000000003E-5</c:v>
                </c:pt>
                <c:pt idx="2042">
                  <c:v>7.4620600000000002E-5</c:v>
                </c:pt>
                <c:pt idx="2043">
                  <c:v>7.0508100000000003E-5</c:v>
                </c:pt>
                <c:pt idx="2044">
                  <c:v>6.6663199999999996E-5</c:v>
                </c:pt>
                <c:pt idx="2045">
                  <c:v>6.6024699999999998E-5</c:v>
                </c:pt>
                <c:pt idx="2046">
                  <c:v>6.5393600000000004E-5</c:v>
                </c:pt>
                <c:pt idx="2047">
                  <c:v>6.4769699999999998E-5</c:v>
                </c:pt>
                <c:pt idx="2048">
                  <c:v>6.41529E-5</c:v>
                </c:pt>
                <c:pt idx="2049">
                  <c:v>6.3543100000000005E-5</c:v>
                </c:pt>
                <c:pt idx="2050">
                  <c:v>6.2344300000000005E-5</c:v>
                </c:pt>
                <c:pt idx="2051">
                  <c:v>6.1172400000000004E-5</c:v>
                </c:pt>
                <c:pt idx="2052">
                  <c:v>6.00269E-5</c:v>
                </c:pt>
                <c:pt idx="2053">
                  <c:v>5.8906999999999997E-5</c:v>
                </c:pt>
                <c:pt idx="2054">
                  <c:v>5.7812200000000002E-5</c:v>
                </c:pt>
                <c:pt idx="2055">
                  <c:v>5.6741699999999999E-5</c:v>
                </c:pt>
                <c:pt idx="2056">
                  <c:v>5.4976299999999997E-5</c:v>
                </c:pt>
                <c:pt idx="2057">
                  <c:v>5.3276699999999998E-5</c:v>
                </c:pt>
                <c:pt idx="2058">
                  <c:v>5.164E-5</c:v>
                </c:pt>
                <c:pt idx="2059">
                  <c:v>5.00637E-5</c:v>
                </c:pt>
                <c:pt idx="2060">
                  <c:v>4.8545199999999997E-5</c:v>
                </c:pt>
                <c:pt idx="2061">
                  <c:v>4.7082100000000001E-5</c:v>
                </c:pt>
                <c:pt idx="2062">
                  <c:v>4.5005700000000002E-5</c:v>
                </c:pt>
                <c:pt idx="2063">
                  <c:v>4.30394E-5</c:v>
                </c:pt>
                <c:pt idx="2064">
                  <c:v>4.1176800000000002E-5</c:v>
                </c:pt>
                <c:pt idx="2065">
                  <c:v>3.94115E-5</c:v>
                </c:pt>
                <c:pt idx="2066">
                  <c:v>3.7737800000000003E-5</c:v>
                </c:pt>
                <c:pt idx="2067">
                  <c:v>3.5573500000000001E-5</c:v>
                </c:pt>
                <c:pt idx="2068">
                  <c:v>3.3559700000000003E-5</c:v>
                </c:pt>
                <c:pt idx="2069">
                  <c:v>3.1684499999999998E-5</c:v>
                </c:pt>
                <c:pt idx="2070">
                  <c:v>2.9936900000000001E-5</c:v>
                </c:pt>
                <c:pt idx="2071">
                  <c:v>2.8307199999999999E-5</c:v>
                </c:pt>
                <c:pt idx="2072">
                  <c:v>2.6786300000000001E-5</c:v>
                </c:pt>
                <c:pt idx="2073">
                  <c:v>2.5181000000000002E-5</c:v>
                </c:pt>
                <c:pt idx="2074">
                  <c:v>2.3694200000000001E-5</c:v>
                </c:pt>
                <c:pt idx="2075">
                  <c:v>2.2315900000000001E-5</c:v>
                </c:pt>
                <c:pt idx="2076">
                  <c:v>2.1037199999999999E-5</c:v>
                </c:pt>
                <c:pt idx="2077">
                  <c:v>1.9849700000000001E-5</c:v>
                </c:pt>
                <c:pt idx="2078">
                  <c:v>1.8746E-5</c:v>
                </c:pt>
                <c:pt idx="2079">
                  <c:v>1.7719300000000002E-5</c:v>
                </c:pt>
                <c:pt idx="2080">
                  <c:v>1.6763399999999999E-5</c:v>
                </c:pt>
                <c:pt idx="2081">
                  <c:v>1.5872800000000002E-5</c:v>
                </c:pt>
                <c:pt idx="2082">
                  <c:v>1.5056500000000001E-5</c:v>
                </c:pt>
                <c:pt idx="2083">
                  <c:v>1.42937E-5</c:v>
                </c:pt>
                <c:pt idx="2084">
                  <c:v>1.41708E-5</c:v>
                </c:pt>
                <c:pt idx="2085">
                  <c:v>1.40494E-5</c:v>
                </c:pt>
                <c:pt idx="2086">
                  <c:v>1.3929300000000001E-5</c:v>
                </c:pt>
                <c:pt idx="2087">
                  <c:v>1.38106E-5</c:v>
                </c:pt>
                <c:pt idx="2088">
                  <c:v>1.3693099999999999E-5</c:v>
                </c:pt>
                <c:pt idx="2089">
                  <c:v>1.3476799999999999E-5</c:v>
                </c:pt>
                <c:pt idx="2090">
                  <c:v>1.3264900000000001E-5</c:v>
                </c:pt>
                <c:pt idx="2091">
                  <c:v>1.30574E-5</c:v>
                </c:pt>
                <c:pt idx="2092">
                  <c:v>1.2854099999999999E-5</c:v>
                </c:pt>
                <c:pt idx="2093">
                  <c:v>1.26549E-5</c:v>
                </c:pt>
                <c:pt idx="2094">
                  <c:v>1.2253699999999999E-5</c:v>
                </c:pt>
                <c:pt idx="2095">
                  <c:v>1.1868999999999999E-5</c:v>
                </c:pt>
                <c:pt idx="2096">
                  <c:v>1.15002E-5</c:v>
                </c:pt>
                <c:pt idx="2097">
                  <c:v>1.1146400000000001E-5</c:v>
                </c:pt>
                <c:pt idx="2098">
                  <c:v>1.0807E-5</c:v>
                </c:pt>
                <c:pt idx="2099">
                  <c:v>1.0313699999999999E-5</c:v>
                </c:pt>
                <c:pt idx="2100">
                  <c:v>9.8501000000000008E-6</c:v>
                </c:pt>
                <c:pt idx="2101">
                  <c:v>9.4141399999999996E-6</c:v>
                </c:pt>
                <c:pt idx="2102">
                  <c:v>9.0038800000000006E-6</c:v>
                </c:pt>
                <c:pt idx="2103">
                  <c:v>8.6175500000000002E-6</c:v>
                </c:pt>
                <c:pt idx="2104">
                  <c:v>8.1856E-6</c:v>
                </c:pt>
                <c:pt idx="2105">
                  <c:v>7.7828699999999992E-6</c:v>
                </c:pt>
                <c:pt idx="2106">
                  <c:v>7.4070499999999997E-6</c:v>
                </c:pt>
                <c:pt idx="2107">
                  <c:v>7.0560300000000003E-6</c:v>
                </c:pt>
                <c:pt idx="2108">
                  <c:v>6.7278899999999997E-6</c:v>
                </c:pt>
                <c:pt idx="2109">
                  <c:v>6.4208899999999999E-6</c:v>
                </c:pt>
                <c:pt idx="2110">
                  <c:v>6.0540400000000002E-6</c:v>
                </c:pt>
                <c:pt idx="2111">
                  <c:v>5.7165299999999998E-6</c:v>
                </c:pt>
                <c:pt idx="2112">
                  <c:v>5.4056000000000004E-6</c:v>
                </c:pt>
                <c:pt idx="2113">
                  <c:v>5.1188E-6</c:v>
                </c:pt>
                <c:pt idx="2114">
                  <c:v>4.8539299999999998E-6</c:v>
                </c:pt>
                <c:pt idx="2115">
                  <c:v>4.6090000000000003E-6</c:v>
                </c:pt>
                <c:pt idx="2116">
                  <c:v>4.3318300000000002E-6</c:v>
                </c:pt>
                <c:pt idx="2117">
                  <c:v>4.0793699999999999E-6</c:v>
                </c:pt>
                <c:pt idx="2118">
                  <c:v>3.8490400000000002E-6</c:v>
                </c:pt>
                <c:pt idx="2119">
                  <c:v>3.6385500000000001E-6</c:v>
                </c:pt>
                <c:pt idx="2120">
                  <c:v>3.4458900000000001E-6</c:v>
                </c:pt>
                <c:pt idx="2121">
                  <c:v>3.2692899999999999E-6</c:v>
                </c:pt>
                <c:pt idx="2122">
                  <c:v>3.10718E-6</c:v>
                </c:pt>
                <c:pt idx="2123">
                  <c:v>3.0847299999999999E-6</c:v>
                </c:pt>
                <c:pt idx="2124">
                  <c:v>3.0625599999999999E-6</c:v>
                </c:pt>
                <c:pt idx="2125">
                  <c:v>3.0406600000000001E-6</c:v>
                </c:pt>
                <c:pt idx="2126">
                  <c:v>3.0190299999999998E-6</c:v>
                </c:pt>
                <c:pt idx="2127">
                  <c:v>2.99765E-6</c:v>
                </c:pt>
                <c:pt idx="2128">
                  <c:v>2.9556600000000001E-6</c:v>
                </c:pt>
                <c:pt idx="2129">
                  <c:v>2.9146699999999998E-6</c:v>
                </c:pt>
                <c:pt idx="2130">
                  <c:v>2.8746599999999999E-6</c:v>
                </c:pt>
                <c:pt idx="2131">
                  <c:v>2.8355799999999999E-6</c:v>
                </c:pt>
                <c:pt idx="2132">
                  <c:v>2.7701700000000002E-6</c:v>
                </c:pt>
                <c:pt idx="2133">
                  <c:v>2.7073700000000001E-6</c:v>
                </c:pt>
                <c:pt idx="2134">
                  <c:v>2.6470600000000002E-6</c:v>
                </c:pt>
                <c:pt idx="2135">
                  <c:v>2.58912E-6</c:v>
                </c:pt>
                <c:pt idx="2136">
                  <c:v>2.5334499999999999E-6</c:v>
                </c:pt>
                <c:pt idx="2137">
                  <c:v>2.4562899999999998E-6</c:v>
                </c:pt>
                <c:pt idx="2138">
                  <c:v>2.3834100000000002E-6</c:v>
                </c:pt>
                <c:pt idx="2139">
                  <c:v>2.31453E-6</c:v>
                </c:pt>
                <c:pt idx="2140">
                  <c:v>2.2493799999999999E-6</c:v>
                </c:pt>
                <c:pt idx="2141">
                  <c:v>2.1877499999999999E-6</c:v>
                </c:pt>
                <c:pt idx="2142">
                  <c:v>2.1070700000000001E-6</c:v>
                </c:pt>
                <c:pt idx="2143">
                  <c:v>2.03227E-6</c:v>
                </c:pt>
                <c:pt idx="2144">
                  <c:v>1.9628699999999999E-6</c:v>
                </c:pt>
                <c:pt idx="2145">
                  <c:v>1.8984300000000001E-6</c:v>
                </c:pt>
                <c:pt idx="2146">
                  <c:v>1.83855E-6</c:v>
                </c:pt>
                <c:pt idx="2147">
                  <c:v>1.7828699999999999E-6</c:v>
                </c:pt>
                <c:pt idx="2148">
                  <c:v>1.7144099999999999E-6</c:v>
                </c:pt>
                <c:pt idx="2149">
                  <c:v>1.65219E-6</c:v>
                </c:pt>
                <c:pt idx="2150">
                  <c:v>1.5956100000000001E-6</c:v>
                </c:pt>
                <c:pt idx="2151">
                  <c:v>1.54414E-6</c:v>
                </c:pt>
                <c:pt idx="2152">
                  <c:v>1.4973E-6</c:v>
                </c:pt>
                <c:pt idx="2153">
                  <c:v>1.45466E-6</c:v>
                </c:pt>
                <c:pt idx="2154">
                  <c:v>1.4073799999999999E-6</c:v>
                </c:pt>
                <c:pt idx="2155">
                  <c:v>1.3653300000000001E-6</c:v>
                </c:pt>
                <c:pt idx="2156">
                  <c:v>1.32799E-6</c:v>
                </c:pt>
                <c:pt idx="2157">
                  <c:v>1.2949099999999999E-6</c:v>
                </c:pt>
                <c:pt idx="2158">
                  <c:v>1.2656800000000001E-6</c:v>
                </c:pt>
                <c:pt idx="2159">
                  <c:v>1.26162E-6</c:v>
                </c:pt>
                <c:pt idx="2160">
                  <c:v>1.25763E-6</c:v>
                </c:pt>
                <c:pt idx="2161">
                  <c:v>1.2537299999999999E-6</c:v>
                </c:pt>
                <c:pt idx="2162">
                  <c:v>1.24989E-6</c:v>
                </c:pt>
                <c:pt idx="2163">
                  <c:v>1.2461400000000001E-6</c:v>
                </c:pt>
                <c:pt idx="2164">
                  <c:v>1.2409400000000001E-6</c:v>
                </c:pt>
                <c:pt idx="2165">
                  <c:v>1.23589E-6</c:v>
                </c:pt>
                <c:pt idx="2166">
                  <c:v>1.23098E-6</c:v>
                </c:pt>
                <c:pt idx="2167">
                  <c:v>1.2262100000000001E-6</c:v>
                </c:pt>
                <c:pt idx="2168">
                  <c:v>1.2154E-6</c:v>
                </c:pt>
                <c:pt idx="2169">
                  <c:v>1.2053299999999999E-6</c:v>
                </c:pt>
                <c:pt idx="2170">
                  <c:v>1.1959700000000001E-6</c:v>
                </c:pt>
                <c:pt idx="2171">
                  <c:v>1.1873099999999999E-6</c:v>
                </c:pt>
                <c:pt idx="2172">
                  <c:v>1.1742900000000001E-6</c:v>
                </c:pt>
                <c:pt idx="2173">
                  <c:v>1.1629999999999999E-6</c:v>
                </c:pt>
                <c:pt idx="2174">
                  <c:v>1.1533400000000001E-6</c:v>
                </c:pt>
                <c:pt idx="2175">
                  <c:v>1.1452099999999999E-6</c:v>
                </c:pt>
                <c:pt idx="2176">
                  <c:v>1.1385500000000001E-6</c:v>
                </c:pt>
                <c:pt idx="2177">
                  <c:v>1.13327E-6</c:v>
                </c:pt>
                <c:pt idx="2178">
                  <c:v>1.12931E-6</c:v>
                </c:pt>
                <c:pt idx="2179">
                  <c:v>1.12661E-6</c:v>
                </c:pt>
                <c:pt idx="2180">
                  <c:v>1.12493E-6</c:v>
                </c:pt>
                <c:pt idx="2181">
                  <c:v>1.12512E-6</c:v>
                </c:pt>
                <c:pt idx="2182">
                  <c:v>1.1270899999999999E-6</c:v>
                </c:pt>
                <c:pt idx="2183">
                  <c:v>1.1307700000000001E-6</c:v>
                </c:pt>
                <c:pt idx="2184">
                  <c:v>1.1361199999999999E-6</c:v>
                </c:pt>
                <c:pt idx="2185">
                  <c:v>1.1441800000000001E-6</c:v>
                </c:pt>
                <c:pt idx="2186">
                  <c:v>1.1542699999999999E-6</c:v>
                </c:pt>
                <c:pt idx="2187">
                  <c:v>1.1663599999999999E-6</c:v>
                </c:pt>
                <c:pt idx="2188">
                  <c:v>1.1804200000000001E-6</c:v>
                </c:pt>
                <c:pt idx="2189">
                  <c:v>1.19641E-6</c:v>
                </c:pt>
                <c:pt idx="2190">
                  <c:v>1.21767E-6</c:v>
                </c:pt>
                <c:pt idx="2191">
                  <c:v>1.24158E-6</c:v>
                </c:pt>
                <c:pt idx="2192">
                  <c:v>1.2681599999999999E-6</c:v>
                </c:pt>
                <c:pt idx="2193">
                  <c:v>1.29743E-6</c:v>
                </c:pt>
                <c:pt idx="2194">
                  <c:v>1.3294299999999999E-6</c:v>
                </c:pt>
                <c:pt idx="2195">
                  <c:v>1.36193E-6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015A-41BC-A133-7928482A0FC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661376"/>
        <c:axId val="382659808"/>
      </c:scatterChart>
      <c:valAx>
        <c:axId val="382661376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659808"/>
        <c:crosses val="autoZero"/>
        <c:crossBetween val="midCat"/>
        <c:majorUnit val="1"/>
      </c:valAx>
      <c:valAx>
        <c:axId val="382659808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661376"/>
        <c:crosses val="autoZero"/>
        <c:crossBetween val="midCat"/>
        <c:majorUnit val="20"/>
      </c:valAx>
      <c:spPr>
        <a:noFill/>
        <a:ln w="63500">
          <a:solidFill>
            <a:schemeClr val="tx1">
              <a:lumMod val="50000"/>
              <a:lumOff val="50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en-US"/>
    </a:p>
  </c:txPr>
  <c:externalData r:id="rId3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683695841438827"/>
          <c:y val="4.6424009885118425E-2"/>
          <c:w val="0.84030467906003137"/>
          <c:h val="0.84923065268073938"/>
        </c:manualLayout>
      </c:layout>
      <c:scatterChart>
        <c:scatterStyle val="smoothMarker"/>
        <c:varyColors val="0"/>
        <c:ser>
          <c:idx val="0"/>
          <c:order val="0"/>
          <c:spPr>
            <a:ln w="635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K$4:$K$2066</c:f>
              <c:numCache>
                <c:formatCode>General</c:formatCode>
                <c:ptCount val="2063"/>
                <c:pt idx="0">
                  <c:v>0</c:v>
                </c:pt>
                <c:pt idx="1">
                  <c:v>6.9444444444444454E-13</c:v>
                </c:pt>
                <c:pt idx="2">
                  <c:v>1.3888888888888891E-12</c:v>
                </c:pt>
                <c:pt idx="3">
                  <c:v>6.9458333333333335E-9</c:v>
                </c:pt>
                <c:pt idx="4">
                  <c:v>1.3890277777777778E-8</c:v>
                </c:pt>
                <c:pt idx="5">
                  <c:v>2.0834722222222222E-8</c:v>
                </c:pt>
                <c:pt idx="6">
                  <c:v>9.0279166666666655E-8</c:v>
                </c:pt>
                <c:pt idx="7">
                  <c:v>1.5972361111111111E-7</c:v>
                </c:pt>
                <c:pt idx="8">
                  <c:v>2.2916805555555553E-7</c:v>
                </c:pt>
                <c:pt idx="9">
                  <c:v>2.9861250000000001E-7</c:v>
                </c:pt>
                <c:pt idx="10">
                  <c:v>9.9305555555555567E-7</c:v>
                </c:pt>
                <c:pt idx="11">
                  <c:v>1.6874999999999999E-6</c:v>
                </c:pt>
                <c:pt idx="12">
                  <c:v>2.3819444444444444E-6</c:v>
                </c:pt>
                <c:pt idx="13">
                  <c:v>3.0763888888888889E-6</c:v>
                </c:pt>
                <c:pt idx="14">
                  <c:v>7.0700000000000001E-6</c:v>
                </c:pt>
                <c:pt idx="15">
                  <c:v>1.1063611111111111E-5</c:v>
                </c:pt>
                <c:pt idx="16">
                  <c:v>1.5057152777777779E-5</c:v>
                </c:pt>
                <c:pt idx="17">
                  <c:v>2.2856458333333332E-5</c:v>
                </c:pt>
                <c:pt idx="18">
                  <c:v>3.0655763888888888E-5</c:v>
                </c:pt>
                <c:pt idx="19">
                  <c:v>3.8455069444444448E-5</c:v>
                </c:pt>
                <c:pt idx="20">
                  <c:v>5.0214375000000003E-5</c:v>
                </c:pt>
                <c:pt idx="21">
                  <c:v>6.1973749999999996E-5</c:v>
                </c:pt>
                <c:pt idx="22">
                  <c:v>7.3733333333333341E-5</c:v>
                </c:pt>
                <c:pt idx="23">
                  <c:v>8.3929166666666663E-5</c:v>
                </c:pt>
                <c:pt idx="24">
                  <c:v>9.4124999999999998E-5</c:v>
                </c:pt>
                <c:pt idx="25">
                  <c:v>1.0432083333333333E-4</c:v>
                </c:pt>
                <c:pt idx="26">
                  <c:v>1.0902361111111111E-4</c:v>
                </c:pt>
                <c:pt idx="27">
                  <c:v>1.1372708333333333E-4</c:v>
                </c:pt>
                <c:pt idx="28">
                  <c:v>1.1842986111111111E-4</c:v>
                </c:pt>
                <c:pt idx="29">
                  <c:v>1.2241319444444444E-4</c:v>
                </c:pt>
                <c:pt idx="30">
                  <c:v>1.2639722222222222E-4</c:v>
                </c:pt>
                <c:pt idx="31">
                  <c:v>1.3038055555555556E-4</c:v>
                </c:pt>
                <c:pt idx="32">
                  <c:v>1.3633402777777777E-4</c:v>
                </c:pt>
                <c:pt idx="33">
                  <c:v>1.4228749999999998E-4</c:v>
                </c:pt>
                <c:pt idx="34">
                  <c:v>1.4824097222222222E-4</c:v>
                </c:pt>
                <c:pt idx="35">
                  <c:v>1.8639513888888889E-4</c:v>
                </c:pt>
                <c:pt idx="36">
                  <c:v>1.9593333333333334E-4</c:v>
                </c:pt>
                <c:pt idx="37">
                  <c:v>2.0547152777777779E-4</c:v>
                </c:pt>
                <c:pt idx="38">
                  <c:v>2.1501041666666665E-4</c:v>
                </c:pt>
                <c:pt idx="39">
                  <c:v>2.2454861111111113E-4</c:v>
                </c:pt>
                <c:pt idx="40">
                  <c:v>2.2853541666666667E-4</c:v>
                </c:pt>
                <c:pt idx="41">
                  <c:v>2.3252222222222224E-4</c:v>
                </c:pt>
                <c:pt idx="42">
                  <c:v>2.3650833333333331E-4</c:v>
                </c:pt>
                <c:pt idx="43">
                  <c:v>2.405013888888889E-4</c:v>
                </c:pt>
                <c:pt idx="44">
                  <c:v>2.4449444444444446E-4</c:v>
                </c:pt>
                <c:pt idx="45">
                  <c:v>2.4848749999999999E-4</c:v>
                </c:pt>
                <c:pt idx="46">
                  <c:v>2.5501875000000002E-4</c:v>
                </c:pt>
                <c:pt idx="47">
                  <c:v>2.6155000000000004E-4</c:v>
                </c:pt>
                <c:pt idx="48">
                  <c:v>2.6808125000000001E-4</c:v>
                </c:pt>
                <c:pt idx="49">
                  <c:v>3.1749097222222224E-4</c:v>
                </c:pt>
                <c:pt idx="50">
                  <c:v>3.2984375E-4</c:v>
                </c:pt>
                <c:pt idx="51">
                  <c:v>3.5454861111111109E-4</c:v>
                </c:pt>
                <c:pt idx="52">
                  <c:v>3.7925347222222218E-4</c:v>
                </c:pt>
                <c:pt idx="53">
                  <c:v>4.0395902777777781E-4</c:v>
                </c:pt>
                <c:pt idx="54">
                  <c:v>4.286638888888889E-4</c:v>
                </c:pt>
                <c:pt idx="55">
                  <c:v>4.9124444444444441E-4</c:v>
                </c:pt>
                <c:pt idx="56">
                  <c:v>5.5382569444444442E-4</c:v>
                </c:pt>
                <c:pt idx="57">
                  <c:v>6.1640624999999998E-4</c:v>
                </c:pt>
                <c:pt idx="58">
                  <c:v>6.7898749999999999E-4</c:v>
                </c:pt>
                <c:pt idx="59">
                  <c:v>7.6361111111111107E-4</c:v>
                </c:pt>
                <c:pt idx="60">
                  <c:v>8.4824305555555564E-4</c:v>
                </c:pt>
                <c:pt idx="61">
                  <c:v>9.3286805555555549E-4</c:v>
                </c:pt>
                <c:pt idx="62">
                  <c:v>1.0174930555555556E-3</c:v>
                </c:pt>
                <c:pt idx="63">
                  <c:v>1.1720138888888889E-3</c:v>
                </c:pt>
                <c:pt idx="64">
                  <c:v>1.3265347222222222E-3</c:v>
                </c:pt>
                <c:pt idx="65">
                  <c:v>1.4810555555555556E-3</c:v>
                </c:pt>
                <c:pt idx="66">
                  <c:v>1.6355763888888891E-3</c:v>
                </c:pt>
                <c:pt idx="67">
                  <c:v>1.7900972222222222E-3</c:v>
                </c:pt>
                <c:pt idx="68">
                  <c:v>1.9825069444444443E-3</c:v>
                </c:pt>
                <c:pt idx="69">
                  <c:v>2.174916666666667E-3</c:v>
                </c:pt>
                <c:pt idx="70">
                  <c:v>2.3673263888888889E-3</c:v>
                </c:pt>
                <c:pt idx="71">
                  <c:v>2.5597361111111112E-3</c:v>
                </c:pt>
                <c:pt idx="72">
                  <c:v>2.752145833333333E-3</c:v>
                </c:pt>
                <c:pt idx="73">
                  <c:v>3.054833333333333E-3</c:v>
                </c:pt>
                <c:pt idx="74">
                  <c:v>3.3575138888888886E-3</c:v>
                </c:pt>
                <c:pt idx="75">
                  <c:v>3.6602013888888891E-3</c:v>
                </c:pt>
                <c:pt idx="76">
                  <c:v>3.9628819444444442E-3</c:v>
                </c:pt>
                <c:pt idx="77">
                  <c:v>4.2655625000000003E-3</c:v>
                </c:pt>
                <c:pt idx="78">
                  <c:v>4.5682500000000003E-3</c:v>
                </c:pt>
                <c:pt idx="79">
                  <c:v>5.0458194444444448E-3</c:v>
                </c:pt>
                <c:pt idx="80">
                  <c:v>5.5233958333333333E-3</c:v>
                </c:pt>
                <c:pt idx="81">
                  <c:v>6.0009652777777778E-3</c:v>
                </c:pt>
                <c:pt idx="82">
                  <c:v>6.4785416666666672E-3</c:v>
                </c:pt>
                <c:pt idx="83">
                  <c:v>6.9561111111111108E-3</c:v>
                </c:pt>
                <c:pt idx="84">
                  <c:v>7.4336805555555554E-3</c:v>
                </c:pt>
                <c:pt idx="85">
                  <c:v>7.9663888888888892E-3</c:v>
                </c:pt>
                <c:pt idx="86">
                  <c:v>8.4990972222222221E-3</c:v>
                </c:pt>
                <c:pt idx="87">
                  <c:v>9.0318055555555568E-3</c:v>
                </c:pt>
                <c:pt idx="88">
                  <c:v>9.5645833333333329E-3</c:v>
                </c:pt>
                <c:pt idx="89">
                  <c:v>1.0097291666666668E-2</c:v>
                </c:pt>
                <c:pt idx="90">
                  <c:v>1.0630000000000001E-2</c:v>
                </c:pt>
                <c:pt idx="91">
                  <c:v>1.1234513888888889E-2</c:v>
                </c:pt>
                <c:pt idx="92">
                  <c:v>1.1839027777777778E-2</c:v>
                </c:pt>
                <c:pt idx="93">
                  <c:v>1.2443541666666667E-2</c:v>
                </c:pt>
                <c:pt idx="94">
                  <c:v>1.3047986111111113E-2</c:v>
                </c:pt>
                <c:pt idx="95">
                  <c:v>1.3652500000000001E-2</c:v>
                </c:pt>
                <c:pt idx="96">
                  <c:v>1.425701388888889E-2</c:v>
                </c:pt>
                <c:pt idx="97">
                  <c:v>1.4353333333333334E-2</c:v>
                </c:pt>
                <c:pt idx="98">
                  <c:v>1.4449583333333333E-2</c:v>
                </c:pt>
                <c:pt idx="99">
                  <c:v>1.4545833333333334E-2</c:v>
                </c:pt>
                <c:pt idx="100">
                  <c:v>1.4642083333333332E-2</c:v>
                </c:pt>
                <c:pt idx="101">
                  <c:v>1.4738402777777777E-2</c:v>
                </c:pt>
                <c:pt idx="102">
                  <c:v>1.4903819444444445E-2</c:v>
                </c:pt>
                <c:pt idx="103">
                  <c:v>1.5069305555555555E-2</c:v>
                </c:pt>
                <c:pt idx="104">
                  <c:v>1.5234722222222221E-2</c:v>
                </c:pt>
                <c:pt idx="105">
                  <c:v>1.5400208333333333E-2</c:v>
                </c:pt>
                <c:pt idx="106">
                  <c:v>1.5565625E-2</c:v>
                </c:pt>
                <c:pt idx="107">
                  <c:v>1.5899097222222221E-2</c:v>
                </c:pt>
                <c:pt idx="108">
                  <c:v>1.62325E-2</c:v>
                </c:pt>
                <c:pt idx="109">
                  <c:v>1.6565902777777777E-2</c:v>
                </c:pt>
                <c:pt idx="110">
                  <c:v>1.6899375000000001E-2</c:v>
                </c:pt>
                <c:pt idx="111">
                  <c:v>1.7232777777777777E-2</c:v>
                </c:pt>
                <c:pt idx="112">
                  <c:v>1.7876597222222221E-2</c:v>
                </c:pt>
                <c:pt idx="113">
                  <c:v>1.8520416666666668E-2</c:v>
                </c:pt>
                <c:pt idx="114">
                  <c:v>1.9164236111111111E-2</c:v>
                </c:pt>
                <c:pt idx="115">
                  <c:v>1.9808055555555554E-2</c:v>
                </c:pt>
                <c:pt idx="116">
                  <c:v>2.0451875000000001E-2</c:v>
                </c:pt>
                <c:pt idx="117">
                  <c:v>2.1213333333333334E-2</c:v>
                </c:pt>
                <c:pt idx="118">
                  <c:v>2.1974791666666667E-2</c:v>
                </c:pt>
                <c:pt idx="119">
                  <c:v>2.273625E-2</c:v>
                </c:pt>
                <c:pt idx="120">
                  <c:v>2.3497708333333332E-2</c:v>
                </c:pt>
                <c:pt idx="121">
                  <c:v>2.4259166666666665E-2</c:v>
                </c:pt>
                <c:pt idx="122">
                  <c:v>2.5020624999999998E-2</c:v>
                </c:pt>
                <c:pt idx="123">
                  <c:v>2.6225138888888892E-2</c:v>
                </c:pt>
                <c:pt idx="124">
                  <c:v>2.7429652777777778E-2</c:v>
                </c:pt>
                <c:pt idx="125">
                  <c:v>2.8634166666666665E-2</c:v>
                </c:pt>
                <c:pt idx="126">
                  <c:v>2.9838680555555556E-2</c:v>
                </c:pt>
                <c:pt idx="127">
                  <c:v>3.1043194444444443E-2</c:v>
                </c:pt>
                <c:pt idx="128">
                  <c:v>3.2247708333333333E-2</c:v>
                </c:pt>
                <c:pt idx="129">
                  <c:v>3.4133402777777773E-2</c:v>
                </c:pt>
                <c:pt idx="130">
                  <c:v>3.6019027777777782E-2</c:v>
                </c:pt>
                <c:pt idx="131">
                  <c:v>3.7904652777777777E-2</c:v>
                </c:pt>
                <c:pt idx="132">
                  <c:v>3.9790347222222223E-2</c:v>
                </c:pt>
                <c:pt idx="133">
                  <c:v>4.1675972222222218E-2</c:v>
                </c:pt>
                <c:pt idx="134">
                  <c:v>4.3561666666666665E-2</c:v>
                </c:pt>
                <c:pt idx="135">
                  <c:v>4.6418472222222222E-2</c:v>
                </c:pt>
                <c:pt idx="136">
                  <c:v>4.9275277777777779E-2</c:v>
                </c:pt>
                <c:pt idx="137">
                  <c:v>5.2132083333333336E-2</c:v>
                </c:pt>
                <c:pt idx="138">
                  <c:v>5.4988888888888886E-2</c:v>
                </c:pt>
                <c:pt idx="139">
                  <c:v>5.7845763888888888E-2</c:v>
                </c:pt>
                <c:pt idx="140">
                  <c:v>6.0702569444444444E-2</c:v>
                </c:pt>
                <c:pt idx="141">
                  <c:v>6.4592430555555552E-2</c:v>
                </c:pt>
                <c:pt idx="142">
                  <c:v>6.8482291666666667E-2</c:v>
                </c:pt>
                <c:pt idx="143">
                  <c:v>7.2372222222222213E-2</c:v>
                </c:pt>
                <c:pt idx="144">
                  <c:v>7.6261805555555548E-2</c:v>
                </c:pt>
                <c:pt idx="145">
                  <c:v>8.0152083333333332E-2</c:v>
                </c:pt>
                <c:pt idx="146">
                  <c:v>8.4041666666666667E-2</c:v>
                </c:pt>
                <c:pt idx="147">
                  <c:v>9.0102083333333347E-2</c:v>
                </c:pt>
                <c:pt idx="148">
                  <c:v>9.6161805555555563E-2</c:v>
                </c:pt>
                <c:pt idx="149">
                  <c:v>0.10222152777777779</c:v>
                </c:pt>
                <c:pt idx="150">
                  <c:v>0.10828194444444443</c:v>
                </c:pt>
                <c:pt idx="151">
                  <c:v>0.11434166666666666</c:v>
                </c:pt>
                <c:pt idx="152">
                  <c:v>0.12158472222222222</c:v>
                </c:pt>
                <c:pt idx="153">
                  <c:v>0.12882847222222221</c:v>
                </c:pt>
                <c:pt idx="154">
                  <c:v>0.13607152777777778</c:v>
                </c:pt>
                <c:pt idx="155">
                  <c:v>0.14331527777777778</c:v>
                </c:pt>
                <c:pt idx="156">
                  <c:v>0.15055833333333332</c:v>
                </c:pt>
                <c:pt idx="157">
                  <c:v>0.15780138888888889</c:v>
                </c:pt>
                <c:pt idx="158">
                  <c:v>0.16727569444444446</c:v>
                </c:pt>
                <c:pt idx="159">
                  <c:v>0.17674930555555557</c:v>
                </c:pt>
                <c:pt idx="160">
                  <c:v>0.18622291666666665</c:v>
                </c:pt>
                <c:pt idx="161">
                  <c:v>0.19569652777777777</c:v>
                </c:pt>
                <c:pt idx="162">
                  <c:v>0.20517083333333336</c:v>
                </c:pt>
                <c:pt idx="163">
                  <c:v>0.21464444444444447</c:v>
                </c:pt>
                <c:pt idx="164">
                  <c:v>0.22545347222222223</c:v>
                </c:pt>
                <c:pt idx="165">
                  <c:v>0.23626180555555554</c:v>
                </c:pt>
                <c:pt idx="166">
                  <c:v>0.24707083333333332</c:v>
                </c:pt>
                <c:pt idx="167">
                  <c:v>0.25787986111111111</c:v>
                </c:pt>
                <c:pt idx="168">
                  <c:v>0.26868819444444447</c:v>
                </c:pt>
                <c:pt idx="169">
                  <c:v>0.27949722222222223</c:v>
                </c:pt>
                <c:pt idx="170">
                  <c:v>0.29030624999999999</c:v>
                </c:pt>
                <c:pt idx="171">
                  <c:v>0.3011152777777778</c:v>
                </c:pt>
                <c:pt idx="172">
                  <c:v>0.31192361111111111</c:v>
                </c:pt>
                <c:pt idx="173">
                  <c:v>0.32273263888888892</c:v>
                </c:pt>
                <c:pt idx="174">
                  <c:v>0.33354166666666668</c:v>
                </c:pt>
                <c:pt idx="175">
                  <c:v>0.34228263888888888</c:v>
                </c:pt>
                <c:pt idx="176">
                  <c:v>0.34945347222222223</c:v>
                </c:pt>
                <c:pt idx="177">
                  <c:v>0.35662361111111113</c:v>
                </c:pt>
                <c:pt idx="178">
                  <c:v>0.35781875000000002</c:v>
                </c:pt>
                <c:pt idx="179">
                  <c:v>0.35901319444444446</c:v>
                </c:pt>
                <c:pt idx="180">
                  <c:v>0.36020763888888885</c:v>
                </c:pt>
                <c:pt idx="181">
                  <c:v>0.36140208333333335</c:v>
                </c:pt>
                <c:pt idx="182">
                  <c:v>0.36259722222222224</c:v>
                </c:pt>
                <c:pt idx="183">
                  <c:v>0.36492916666666669</c:v>
                </c:pt>
                <c:pt idx="184">
                  <c:v>0.36726180555555554</c:v>
                </c:pt>
                <c:pt idx="185">
                  <c:v>0.36959444444444445</c:v>
                </c:pt>
                <c:pt idx="186">
                  <c:v>0.37192638888888885</c:v>
                </c:pt>
                <c:pt idx="187">
                  <c:v>0.3756173611111111</c:v>
                </c:pt>
                <c:pt idx="188">
                  <c:v>0.3793083333333333</c:v>
                </c:pt>
                <c:pt idx="189">
                  <c:v>0.38299930555555556</c:v>
                </c:pt>
                <c:pt idx="190">
                  <c:v>0.38668958333333331</c:v>
                </c:pt>
                <c:pt idx="191">
                  <c:v>0.39038055555555556</c:v>
                </c:pt>
                <c:pt idx="192">
                  <c:v>0.39990486111111118</c:v>
                </c:pt>
                <c:pt idx="193">
                  <c:v>0.40715833333333334</c:v>
                </c:pt>
                <c:pt idx="194">
                  <c:v>0.41441250000000002</c:v>
                </c:pt>
                <c:pt idx="195">
                  <c:v>0.42166597222222219</c:v>
                </c:pt>
                <c:pt idx="196">
                  <c:v>0.42892013888888886</c:v>
                </c:pt>
                <c:pt idx="197">
                  <c:v>0.43617361111111114</c:v>
                </c:pt>
                <c:pt idx="198">
                  <c:v>0.44490902777777774</c:v>
                </c:pt>
                <c:pt idx="199">
                  <c:v>0.45364444444444446</c:v>
                </c:pt>
                <c:pt idx="200">
                  <c:v>0.46237986111111112</c:v>
                </c:pt>
                <c:pt idx="201">
                  <c:v>0.47111527777777773</c:v>
                </c:pt>
                <c:pt idx="202">
                  <c:v>0.47985069444444445</c:v>
                </c:pt>
                <c:pt idx="203">
                  <c:v>0.48858611111111111</c:v>
                </c:pt>
                <c:pt idx="204">
                  <c:v>0.49837291666666672</c:v>
                </c:pt>
                <c:pt idx="205">
                  <c:v>0.50815902777777777</c:v>
                </c:pt>
                <c:pt idx="206">
                  <c:v>0.51794513888888893</c:v>
                </c:pt>
                <c:pt idx="207">
                  <c:v>0.52773194444444438</c:v>
                </c:pt>
                <c:pt idx="208">
                  <c:v>0.53536388888888886</c:v>
                </c:pt>
                <c:pt idx="209">
                  <c:v>0.53653055555555562</c:v>
                </c:pt>
                <c:pt idx="210">
                  <c:v>0.53769652777777777</c:v>
                </c:pt>
                <c:pt idx="211">
                  <c:v>0.53886319444444442</c:v>
                </c:pt>
                <c:pt idx="212">
                  <c:v>0.54002916666666667</c:v>
                </c:pt>
                <c:pt idx="213">
                  <c:v>0.54119513888888893</c:v>
                </c:pt>
                <c:pt idx="214">
                  <c:v>0.54352777777777772</c:v>
                </c:pt>
                <c:pt idx="215">
                  <c:v>0.54586041666666663</c:v>
                </c:pt>
                <c:pt idx="216">
                  <c:v>0.54819305555555553</c:v>
                </c:pt>
                <c:pt idx="217">
                  <c:v>0.55052569444444444</c:v>
                </c:pt>
                <c:pt idx="218">
                  <c:v>0.55453333333333332</c:v>
                </c:pt>
                <c:pt idx="219">
                  <c:v>0.55854097222222221</c:v>
                </c:pt>
                <c:pt idx="220">
                  <c:v>0.5625486111111111</c:v>
                </c:pt>
                <c:pt idx="221">
                  <c:v>0.56655555555555559</c:v>
                </c:pt>
                <c:pt idx="222">
                  <c:v>0.57056319444444448</c:v>
                </c:pt>
                <c:pt idx="223">
                  <c:v>0.58078680555555551</c:v>
                </c:pt>
                <c:pt idx="224">
                  <c:v>0.58810208333333336</c:v>
                </c:pt>
                <c:pt idx="225">
                  <c:v>0.5954173611111111</c:v>
                </c:pt>
                <c:pt idx="226">
                  <c:v>0.60273263888888884</c:v>
                </c:pt>
                <c:pt idx="227">
                  <c:v>0.61004791666666669</c:v>
                </c:pt>
                <c:pt idx="228">
                  <c:v>0.61736319444444443</c:v>
                </c:pt>
                <c:pt idx="229">
                  <c:v>0.62598888888888893</c:v>
                </c:pt>
                <c:pt idx="230">
                  <c:v>0.63461388888888892</c:v>
                </c:pt>
                <c:pt idx="231">
                  <c:v>0.64323958333333331</c:v>
                </c:pt>
                <c:pt idx="232">
                  <c:v>0.65186527777777781</c:v>
                </c:pt>
                <c:pt idx="233">
                  <c:v>0.66049097222222219</c:v>
                </c:pt>
                <c:pt idx="234">
                  <c:v>0.66911666666666669</c:v>
                </c:pt>
                <c:pt idx="235">
                  <c:v>0.67898749999999997</c:v>
                </c:pt>
                <c:pt idx="236">
                  <c:v>0.68885833333333335</c:v>
                </c:pt>
                <c:pt idx="237">
                  <c:v>0.69872916666666662</c:v>
                </c:pt>
                <c:pt idx="238">
                  <c:v>0.70859722222222221</c:v>
                </c:pt>
                <c:pt idx="239">
                  <c:v>0.71847222222222218</c:v>
                </c:pt>
                <c:pt idx="240">
                  <c:v>0.72834027777777777</c:v>
                </c:pt>
                <c:pt idx="241">
                  <c:v>0.73821527777777773</c:v>
                </c:pt>
                <c:pt idx="242">
                  <c:v>0.74808333333333332</c:v>
                </c:pt>
                <c:pt idx="243">
                  <c:v>0.75795138888888891</c:v>
                </c:pt>
                <c:pt idx="244">
                  <c:v>0.76782638888888899</c:v>
                </c:pt>
                <c:pt idx="245">
                  <c:v>0.77769444444444447</c:v>
                </c:pt>
                <c:pt idx="246">
                  <c:v>0.78756944444444443</c:v>
                </c:pt>
                <c:pt idx="247">
                  <c:v>0.79743749999999991</c:v>
                </c:pt>
                <c:pt idx="248">
                  <c:v>0.8073055555555555</c:v>
                </c:pt>
                <c:pt idx="249">
                  <c:v>0.81718055555555558</c:v>
                </c:pt>
                <c:pt idx="250">
                  <c:v>0.82704861111111116</c:v>
                </c:pt>
                <c:pt idx="251">
                  <c:v>0.83692361111111113</c:v>
                </c:pt>
                <c:pt idx="252">
                  <c:v>0.84679166666666672</c:v>
                </c:pt>
                <c:pt idx="253">
                  <c:v>0.8566597222222222</c:v>
                </c:pt>
                <c:pt idx="254">
                  <c:v>0.86653472222222216</c:v>
                </c:pt>
                <c:pt idx="255">
                  <c:v>0.87640277777777775</c:v>
                </c:pt>
                <c:pt idx="256">
                  <c:v>0.88627777777777783</c:v>
                </c:pt>
                <c:pt idx="257">
                  <c:v>0.89614583333333342</c:v>
                </c:pt>
                <c:pt idx="258">
                  <c:v>0.9060138888888889</c:v>
                </c:pt>
                <c:pt idx="259">
                  <c:v>0.91588888888888897</c:v>
                </c:pt>
                <c:pt idx="260">
                  <c:v>0.92575694444444434</c:v>
                </c:pt>
                <c:pt idx="261">
                  <c:v>0.93563194444444442</c:v>
                </c:pt>
                <c:pt idx="262">
                  <c:v>0.94550000000000001</c:v>
                </c:pt>
                <c:pt idx="263">
                  <c:v>0.9553680555555556</c:v>
                </c:pt>
                <c:pt idx="264">
                  <c:v>0.96524305555555556</c:v>
                </c:pt>
                <c:pt idx="265">
                  <c:v>0.97511111111111115</c:v>
                </c:pt>
                <c:pt idx="266">
                  <c:v>0.98498611111111123</c:v>
                </c:pt>
                <c:pt idx="267">
                  <c:v>0.9948541666666666</c:v>
                </c:pt>
                <c:pt idx="268">
                  <c:v>1.0047222222222223</c:v>
                </c:pt>
                <c:pt idx="269">
                  <c:v>1.0145972222222222</c:v>
                </c:pt>
                <c:pt idx="270">
                  <c:v>1.0244652777777778</c:v>
                </c:pt>
                <c:pt idx="271">
                  <c:v>1.0343402777777777</c:v>
                </c:pt>
                <c:pt idx="272">
                  <c:v>1.0442083333333334</c:v>
                </c:pt>
                <c:pt idx="273">
                  <c:v>1.0540763888888889</c:v>
                </c:pt>
                <c:pt idx="274">
                  <c:v>1.0639513888888887</c:v>
                </c:pt>
                <c:pt idx="275">
                  <c:v>1.0738194444444444</c:v>
                </c:pt>
                <c:pt idx="276">
                  <c:v>1.0836944444444445</c:v>
                </c:pt>
                <c:pt idx="277">
                  <c:v>1.0935625</c:v>
                </c:pt>
                <c:pt idx="278">
                  <c:v>1.1034305555555557</c:v>
                </c:pt>
                <c:pt idx="279">
                  <c:v>1.1133055555555555</c:v>
                </c:pt>
                <c:pt idx="280">
                  <c:v>1.123173611111111</c:v>
                </c:pt>
                <c:pt idx="281">
                  <c:v>1.1330486111111111</c:v>
                </c:pt>
                <c:pt idx="282">
                  <c:v>1.1429166666666666</c:v>
                </c:pt>
                <c:pt idx="283">
                  <c:v>1.1527847222222223</c:v>
                </c:pt>
                <c:pt idx="284">
                  <c:v>1.1626597222222221</c:v>
                </c:pt>
                <c:pt idx="285">
                  <c:v>1.1725277777777778</c:v>
                </c:pt>
                <c:pt idx="286">
                  <c:v>1.1824027777777779</c:v>
                </c:pt>
                <c:pt idx="287">
                  <c:v>1.1905138888888889</c:v>
                </c:pt>
                <c:pt idx="288">
                  <c:v>1.1986250000000001</c:v>
                </c:pt>
                <c:pt idx="289">
                  <c:v>1.2067430555555556</c:v>
                </c:pt>
                <c:pt idx="290">
                  <c:v>1.2148541666666668</c:v>
                </c:pt>
                <c:pt idx="291">
                  <c:v>1.2229652777777777</c:v>
                </c:pt>
                <c:pt idx="292">
                  <c:v>1.2310833333333333</c:v>
                </c:pt>
                <c:pt idx="293">
                  <c:v>1.2391944444444445</c:v>
                </c:pt>
                <c:pt idx="294">
                  <c:v>1.2473125</c:v>
                </c:pt>
                <c:pt idx="295">
                  <c:v>1.2538125</c:v>
                </c:pt>
                <c:pt idx="296">
                  <c:v>1.2590069444444445</c:v>
                </c:pt>
                <c:pt idx="297">
                  <c:v>1.2642083333333334</c:v>
                </c:pt>
                <c:pt idx="298">
                  <c:v>1.2650277777777779</c:v>
                </c:pt>
                <c:pt idx="299">
                  <c:v>1.2658541666666667</c:v>
                </c:pt>
                <c:pt idx="300">
                  <c:v>1.2666805555555556</c:v>
                </c:pt>
                <c:pt idx="301">
                  <c:v>1.2675069444444444</c:v>
                </c:pt>
                <c:pt idx="302">
                  <c:v>1.2683333333333333</c:v>
                </c:pt>
                <c:pt idx="303">
                  <c:v>1.2695069444444445</c:v>
                </c:pt>
                <c:pt idx="304">
                  <c:v>1.270673611111111</c:v>
                </c:pt>
                <c:pt idx="305">
                  <c:v>1.2718472222222224</c:v>
                </c:pt>
                <c:pt idx="306">
                  <c:v>1.2730208333333335</c:v>
                </c:pt>
                <c:pt idx="307">
                  <c:v>1.2752569444444444</c:v>
                </c:pt>
                <c:pt idx="308">
                  <c:v>1.2774930555555555</c:v>
                </c:pt>
                <c:pt idx="309">
                  <c:v>1.2797291666666666</c:v>
                </c:pt>
                <c:pt idx="310">
                  <c:v>1.2819722222222223</c:v>
                </c:pt>
                <c:pt idx="311">
                  <c:v>1.2851180555555555</c:v>
                </c:pt>
                <c:pt idx="312">
                  <c:v>1.2882638888888889</c:v>
                </c:pt>
                <c:pt idx="313">
                  <c:v>1.2914097222222223</c:v>
                </c:pt>
                <c:pt idx="314">
                  <c:v>1.2945555555555557</c:v>
                </c:pt>
                <c:pt idx="315">
                  <c:v>1.2969444444444445</c:v>
                </c:pt>
                <c:pt idx="316">
                  <c:v>1.2988819444444446</c:v>
                </c:pt>
                <c:pt idx="317">
                  <c:v>1.3008194444444445</c:v>
                </c:pt>
                <c:pt idx="318">
                  <c:v>1.3011736111111112</c:v>
                </c:pt>
                <c:pt idx="319">
                  <c:v>1.3015277777777778</c:v>
                </c:pt>
                <c:pt idx="320">
                  <c:v>1.3018819444444445</c:v>
                </c:pt>
                <c:pt idx="321">
                  <c:v>1.3022361111111111</c:v>
                </c:pt>
                <c:pt idx="322">
                  <c:v>1.3029444444444445</c:v>
                </c:pt>
                <c:pt idx="323">
                  <c:v>1.3036527777777778</c:v>
                </c:pt>
                <c:pt idx="324">
                  <c:v>1.3043541666666667</c:v>
                </c:pt>
                <c:pt idx="325">
                  <c:v>1.3050625</c:v>
                </c:pt>
                <c:pt idx="326">
                  <c:v>1.307076388888889</c:v>
                </c:pt>
                <c:pt idx="327">
                  <c:v>1.3090902777777778</c:v>
                </c:pt>
                <c:pt idx="328">
                  <c:v>1.3110972222222221</c:v>
                </c:pt>
                <c:pt idx="329">
                  <c:v>1.3131111111111111</c:v>
                </c:pt>
                <c:pt idx="330">
                  <c:v>1.3157777777777777</c:v>
                </c:pt>
                <c:pt idx="331">
                  <c:v>1.3184513888888889</c:v>
                </c:pt>
                <c:pt idx="332">
                  <c:v>1.3211180555555555</c:v>
                </c:pt>
                <c:pt idx="333">
                  <c:v>1.3237847222222223</c:v>
                </c:pt>
                <c:pt idx="334">
                  <c:v>1.3264583333333333</c:v>
                </c:pt>
                <c:pt idx="335">
                  <c:v>1.3291250000000001</c:v>
                </c:pt>
                <c:pt idx="336">
                  <c:v>1.3311319444444445</c:v>
                </c:pt>
                <c:pt idx="337">
                  <c:v>1.3331388888888889</c:v>
                </c:pt>
                <c:pt idx="338">
                  <c:v>1.3351388888888889</c:v>
                </c:pt>
                <c:pt idx="339">
                  <c:v>1.3354930555555555</c:v>
                </c:pt>
                <c:pt idx="340">
                  <c:v>1.3358402777777778</c:v>
                </c:pt>
                <c:pt idx="341">
                  <c:v>1.3361874999999999</c:v>
                </c:pt>
                <c:pt idx="342">
                  <c:v>1.3365416666666665</c:v>
                </c:pt>
                <c:pt idx="343">
                  <c:v>1.3372430555555557</c:v>
                </c:pt>
                <c:pt idx="344">
                  <c:v>1.3379375</c:v>
                </c:pt>
                <c:pt idx="345">
                  <c:v>1.3386388888888889</c:v>
                </c:pt>
                <c:pt idx="346">
                  <c:v>1.3393402777777779</c:v>
                </c:pt>
                <c:pt idx="347">
                  <c:v>1.3411458333333333</c:v>
                </c:pt>
                <c:pt idx="348">
                  <c:v>1.3429444444444445</c:v>
                </c:pt>
                <c:pt idx="349">
                  <c:v>1.3447500000000001</c:v>
                </c:pt>
                <c:pt idx="350">
                  <c:v>1.3465486111111111</c:v>
                </c:pt>
                <c:pt idx="351">
                  <c:v>1.3489583333333333</c:v>
                </c:pt>
                <c:pt idx="352">
                  <c:v>1.3513680555555556</c:v>
                </c:pt>
                <c:pt idx="353">
                  <c:v>1.3537777777777777</c:v>
                </c:pt>
                <c:pt idx="354">
                  <c:v>1.3561875000000001</c:v>
                </c:pt>
                <c:pt idx="355">
                  <c:v>1.3585972222222222</c:v>
                </c:pt>
                <c:pt idx="356">
                  <c:v>1.3605347222222224</c:v>
                </c:pt>
                <c:pt idx="357">
                  <c:v>1.3624722222222223</c:v>
                </c:pt>
                <c:pt idx="358">
                  <c:v>1.3644097222222222</c:v>
                </c:pt>
                <c:pt idx="359">
                  <c:v>1.3663472222222222</c:v>
                </c:pt>
                <c:pt idx="360">
                  <c:v>1.3682847222222221</c:v>
                </c:pt>
                <c:pt idx="361">
                  <c:v>1.3702222222222222</c:v>
                </c:pt>
                <c:pt idx="362">
                  <c:v>1.3721597222222224</c:v>
                </c:pt>
                <c:pt idx="363">
                  <c:v>1.3740972222222223</c:v>
                </c:pt>
                <c:pt idx="364">
                  <c:v>1.3764097222222222</c:v>
                </c:pt>
                <c:pt idx="365">
                  <c:v>1.3787222222222222</c:v>
                </c:pt>
                <c:pt idx="366">
                  <c:v>1.3810347222222223</c:v>
                </c:pt>
                <c:pt idx="367">
                  <c:v>1.3828749999999999</c:v>
                </c:pt>
                <c:pt idx="368">
                  <c:v>1.3843680555555555</c:v>
                </c:pt>
                <c:pt idx="369">
                  <c:v>1.3858611111111112</c:v>
                </c:pt>
                <c:pt idx="370">
                  <c:v>1.387361111111111</c:v>
                </c:pt>
                <c:pt idx="371">
                  <c:v>1.3888541666666667</c:v>
                </c:pt>
                <c:pt idx="372">
                  <c:v>1.3903472222222222</c:v>
                </c:pt>
                <c:pt idx="373">
                  <c:v>1.3927291666666666</c:v>
                </c:pt>
                <c:pt idx="374">
                  <c:v>1.3951041666666666</c:v>
                </c:pt>
                <c:pt idx="375">
                  <c:v>1.3974861111111112</c:v>
                </c:pt>
                <c:pt idx="376">
                  <c:v>1.399861111111111</c:v>
                </c:pt>
                <c:pt idx="377">
                  <c:v>1.4022430555555556</c:v>
                </c:pt>
                <c:pt idx="378">
                  <c:v>1.4056944444444446</c:v>
                </c:pt>
                <c:pt idx="379">
                  <c:v>1.4091527777777779</c:v>
                </c:pt>
                <c:pt idx="380">
                  <c:v>1.4126111111111113</c:v>
                </c:pt>
                <c:pt idx="381">
                  <c:v>1.4160625</c:v>
                </c:pt>
                <c:pt idx="382">
                  <c:v>1.4195208333333333</c:v>
                </c:pt>
                <c:pt idx="383">
                  <c:v>1.4229791666666667</c:v>
                </c:pt>
                <c:pt idx="384">
                  <c:v>1.4264305555555554</c:v>
                </c:pt>
                <c:pt idx="385">
                  <c:v>1.4298888888888888</c:v>
                </c:pt>
                <c:pt idx="386">
                  <c:v>1.4333472222222221</c:v>
                </c:pt>
                <c:pt idx="387">
                  <c:v>1.4368055555555554</c:v>
                </c:pt>
                <c:pt idx="388">
                  <c:v>1.4402569444444444</c:v>
                </c:pt>
                <c:pt idx="389">
                  <c:v>1.4437152777777778</c:v>
                </c:pt>
                <c:pt idx="390">
                  <c:v>1.4471736111111111</c:v>
                </c:pt>
                <c:pt idx="391">
                  <c:v>1.4506250000000001</c:v>
                </c:pt>
                <c:pt idx="392">
                  <c:v>1.4535</c:v>
                </c:pt>
                <c:pt idx="393">
                  <c:v>1.456375</c:v>
                </c:pt>
                <c:pt idx="394">
                  <c:v>1.4592500000000002</c:v>
                </c:pt>
                <c:pt idx="395">
                  <c:v>1.4621180555555555</c:v>
                </c:pt>
                <c:pt idx="396">
                  <c:v>1.4649930555555557</c:v>
                </c:pt>
                <c:pt idx="397">
                  <c:v>1.4678680555555557</c:v>
                </c:pt>
                <c:pt idx="398">
                  <c:v>1.4707430555555554</c:v>
                </c:pt>
                <c:pt idx="399">
                  <c:v>1.4736180555555558</c:v>
                </c:pt>
                <c:pt idx="400">
                  <c:v>1.4764861111111109</c:v>
                </c:pt>
                <c:pt idx="401">
                  <c:v>1.4793611111111113</c:v>
                </c:pt>
                <c:pt idx="402">
                  <c:v>1.4822361111111111</c:v>
                </c:pt>
                <c:pt idx="403">
                  <c:v>1.485111111111111</c:v>
                </c:pt>
                <c:pt idx="404">
                  <c:v>1.487986111111111</c:v>
                </c:pt>
                <c:pt idx="405">
                  <c:v>1.4908541666666666</c:v>
                </c:pt>
                <c:pt idx="406">
                  <c:v>1.4937291666666666</c:v>
                </c:pt>
                <c:pt idx="407">
                  <c:v>1.4966041666666667</c:v>
                </c:pt>
                <c:pt idx="408">
                  <c:v>1.4994791666666667</c:v>
                </c:pt>
                <c:pt idx="409">
                  <c:v>1.5018194444444444</c:v>
                </c:pt>
                <c:pt idx="410">
                  <c:v>1.5041666666666667</c:v>
                </c:pt>
                <c:pt idx="411">
                  <c:v>1.5065138888888889</c:v>
                </c:pt>
                <c:pt idx="412">
                  <c:v>1.5088611111111112</c:v>
                </c:pt>
                <c:pt idx="413">
                  <c:v>1.5091874999999999</c:v>
                </c:pt>
                <c:pt idx="414">
                  <c:v>1.5095138888888888</c:v>
                </c:pt>
                <c:pt idx="415">
                  <c:v>1.5098472222222221</c:v>
                </c:pt>
                <c:pt idx="416">
                  <c:v>1.5101736111111113</c:v>
                </c:pt>
                <c:pt idx="417">
                  <c:v>1.5105</c:v>
                </c:pt>
                <c:pt idx="418">
                  <c:v>1.5111111111111111</c:v>
                </c:pt>
                <c:pt idx="419">
                  <c:v>1.5117222222222222</c:v>
                </c:pt>
                <c:pt idx="420">
                  <c:v>1.5123263888888889</c:v>
                </c:pt>
                <c:pt idx="421">
                  <c:v>1.5129375</c:v>
                </c:pt>
                <c:pt idx="422">
                  <c:v>1.5137847222222223</c:v>
                </c:pt>
                <c:pt idx="423">
                  <c:v>1.5146319444444445</c:v>
                </c:pt>
                <c:pt idx="424">
                  <c:v>1.5154791666666667</c:v>
                </c:pt>
                <c:pt idx="425">
                  <c:v>1.5163263888888889</c:v>
                </c:pt>
                <c:pt idx="426">
                  <c:v>1.517263888888889</c:v>
                </c:pt>
                <c:pt idx="427">
                  <c:v>1.518201388888889</c:v>
                </c:pt>
                <c:pt idx="428">
                  <c:v>1.5191388888888888</c:v>
                </c:pt>
                <c:pt idx="429">
                  <c:v>1.5200763888888889</c:v>
                </c:pt>
                <c:pt idx="430">
                  <c:v>1.5210138888888891</c:v>
                </c:pt>
                <c:pt idx="431">
                  <c:v>1.5220555555555557</c:v>
                </c:pt>
                <c:pt idx="432">
                  <c:v>1.5230972222222223</c:v>
                </c:pt>
                <c:pt idx="433">
                  <c:v>1.5241388888888889</c:v>
                </c:pt>
                <c:pt idx="434">
                  <c:v>1.5251805555555558</c:v>
                </c:pt>
                <c:pt idx="435">
                  <c:v>1.5262222222222224</c:v>
                </c:pt>
                <c:pt idx="436">
                  <c:v>1.5274583333333334</c:v>
                </c:pt>
                <c:pt idx="437">
                  <c:v>1.5287013888888887</c:v>
                </c:pt>
                <c:pt idx="438">
                  <c:v>1.5299444444444443</c:v>
                </c:pt>
                <c:pt idx="439">
                  <c:v>1.5309652777777778</c:v>
                </c:pt>
                <c:pt idx="440">
                  <c:v>1.531986111111111</c:v>
                </c:pt>
                <c:pt idx="441">
                  <c:v>1.5330069444444445</c:v>
                </c:pt>
                <c:pt idx="442">
                  <c:v>1.5340277777777778</c:v>
                </c:pt>
                <c:pt idx="443">
                  <c:v>1.535048611111111</c:v>
                </c:pt>
                <c:pt idx="444">
                  <c:v>1.5360694444444445</c:v>
                </c:pt>
                <c:pt idx="445">
                  <c:v>1.5370902777777777</c:v>
                </c:pt>
                <c:pt idx="446">
                  <c:v>1.5381111111111112</c:v>
                </c:pt>
                <c:pt idx="447">
                  <c:v>1.5391319444444445</c:v>
                </c:pt>
                <c:pt idx="448">
                  <c:v>1.5403680555555557</c:v>
                </c:pt>
                <c:pt idx="449">
                  <c:v>1.5416041666666667</c:v>
                </c:pt>
                <c:pt idx="450">
                  <c:v>1.542847222222222</c:v>
                </c:pt>
                <c:pt idx="451">
                  <c:v>1.5437986111111113</c:v>
                </c:pt>
                <c:pt idx="452">
                  <c:v>1.5439722222222223</c:v>
                </c:pt>
                <c:pt idx="453">
                  <c:v>1.5441388888888889</c:v>
                </c:pt>
                <c:pt idx="454">
                  <c:v>1.5443055555555556</c:v>
                </c:pt>
                <c:pt idx="455">
                  <c:v>1.5444722222222222</c:v>
                </c:pt>
                <c:pt idx="456">
                  <c:v>1.5446388888888891</c:v>
                </c:pt>
                <c:pt idx="457">
                  <c:v>1.5449305555555555</c:v>
                </c:pt>
                <c:pt idx="458">
                  <c:v>1.5452291666666667</c:v>
                </c:pt>
                <c:pt idx="459">
                  <c:v>1.5455208333333335</c:v>
                </c:pt>
                <c:pt idx="460">
                  <c:v>1.5458194444444444</c:v>
                </c:pt>
                <c:pt idx="461">
                  <c:v>1.5464097222222222</c:v>
                </c:pt>
                <c:pt idx="462">
                  <c:v>1.5469999999999999</c:v>
                </c:pt>
                <c:pt idx="463">
                  <c:v>1.5475902777777779</c:v>
                </c:pt>
                <c:pt idx="464">
                  <c:v>1.5481805555555557</c:v>
                </c:pt>
                <c:pt idx="465">
                  <c:v>1.5488472222222223</c:v>
                </c:pt>
                <c:pt idx="466">
                  <c:v>1.5495208333333332</c:v>
                </c:pt>
                <c:pt idx="467">
                  <c:v>1.5501944444444447</c:v>
                </c:pt>
                <c:pt idx="468">
                  <c:v>1.5508680555555556</c:v>
                </c:pt>
                <c:pt idx="469">
                  <c:v>1.5515416666666666</c:v>
                </c:pt>
                <c:pt idx="470">
                  <c:v>1.5523541666666665</c:v>
                </c:pt>
                <c:pt idx="471">
                  <c:v>1.5531736111111112</c:v>
                </c:pt>
                <c:pt idx="472">
                  <c:v>1.5539930555555554</c:v>
                </c:pt>
                <c:pt idx="473">
                  <c:v>1.5548055555555556</c:v>
                </c:pt>
                <c:pt idx="474">
                  <c:v>1.555625</c:v>
                </c:pt>
                <c:pt idx="475">
                  <c:v>1.5565277777777777</c:v>
                </c:pt>
                <c:pt idx="476">
                  <c:v>1.5574305555555554</c:v>
                </c:pt>
                <c:pt idx="477">
                  <c:v>1.5583333333333333</c:v>
                </c:pt>
                <c:pt idx="478">
                  <c:v>1.5592361111111113</c:v>
                </c:pt>
                <c:pt idx="479">
                  <c:v>1.5601388888888887</c:v>
                </c:pt>
                <c:pt idx="480">
                  <c:v>1.5610416666666667</c:v>
                </c:pt>
                <c:pt idx="481">
                  <c:v>1.561951388888889</c:v>
                </c:pt>
                <c:pt idx="482">
                  <c:v>1.5628541666666669</c:v>
                </c:pt>
                <c:pt idx="483">
                  <c:v>1.5637986111111111</c:v>
                </c:pt>
                <c:pt idx="484">
                  <c:v>1.5647430555555555</c:v>
                </c:pt>
                <c:pt idx="485">
                  <c:v>1.5656944444444443</c:v>
                </c:pt>
                <c:pt idx="486">
                  <c:v>1.5666388888888889</c:v>
                </c:pt>
                <c:pt idx="487">
                  <c:v>1.5675833333333336</c:v>
                </c:pt>
                <c:pt idx="488">
                  <c:v>1.5685347222222223</c:v>
                </c:pt>
                <c:pt idx="489">
                  <c:v>1.5694791666666668</c:v>
                </c:pt>
                <c:pt idx="490">
                  <c:v>1.5696666666666668</c:v>
                </c:pt>
                <c:pt idx="491">
                  <c:v>1.5698541666666668</c:v>
                </c:pt>
                <c:pt idx="492">
                  <c:v>1.5700347222222222</c:v>
                </c:pt>
                <c:pt idx="493">
                  <c:v>1.5702222222222222</c:v>
                </c:pt>
                <c:pt idx="494">
                  <c:v>1.5704097222222222</c:v>
                </c:pt>
                <c:pt idx="495">
                  <c:v>1.5707222222222224</c:v>
                </c:pt>
                <c:pt idx="496">
                  <c:v>1.5710347222222223</c:v>
                </c:pt>
                <c:pt idx="497">
                  <c:v>1.571347222222222</c:v>
                </c:pt>
                <c:pt idx="498">
                  <c:v>1.5716666666666665</c:v>
                </c:pt>
                <c:pt idx="499">
                  <c:v>1.5721041666666666</c:v>
                </c:pt>
                <c:pt idx="500">
                  <c:v>1.5725486111111109</c:v>
                </c:pt>
                <c:pt idx="501">
                  <c:v>1.5729930555555556</c:v>
                </c:pt>
                <c:pt idx="502">
                  <c:v>1.5734305555555554</c:v>
                </c:pt>
                <c:pt idx="503">
                  <c:v>1.5739652777777779</c:v>
                </c:pt>
                <c:pt idx="504">
                  <c:v>1.5744930555555556</c:v>
                </c:pt>
                <c:pt idx="505">
                  <c:v>1.5750208333333335</c:v>
                </c:pt>
                <c:pt idx="506">
                  <c:v>1.5755555555555556</c:v>
                </c:pt>
                <c:pt idx="507">
                  <c:v>1.5760833333333333</c:v>
                </c:pt>
                <c:pt idx="508">
                  <c:v>1.5768541666666667</c:v>
                </c:pt>
                <c:pt idx="509">
                  <c:v>1.5776180555555555</c:v>
                </c:pt>
                <c:pt idx="510">
                  <c:v>1.5783888888888891</c:v>
                </c:pt>
                <c:pt idx="511">
                  <c:v>1.5791527777777778</c:v>
                </c:pt>
                <c:pt idx="512">
                  <c:v>1.5799236111111112</c:v>
                </c:pt>
                <c:pt idx="513">
                  <c:v>1.580875</c:v>
                </c:pt>
                <c:pt idx="514">
                  <c:v>1.5818333333333334</c:v>
                </c:pt>
                <c:pt idx="515">
                  <c:v>1.5827916666666666</c:v>
                </c:pt>
                <c:pt idx="516">
                  <c:v>1.58375</c:v>
                </c:pt>
                <c:pt idx="517">
                  <c:v>1.5845069444444444</c:v>
                </c:pt>
                <c:pt idx="518">
                  <c:v>1.5846597222222221</c:v>
                </c:pt>
                <c:pt idx="519">
                  <c:v>1.5848055555555556</c:v>
                </c:pt>
                <c:pt idx="520">
                  <c:v>1.5849583333333335</c:v>
                </c:pt>
                <c:pt idx="521">
                  <c:v>1.5851111111111111</c:v>
                </c:pt>
                <c:pt idx="522">
                  <c:v>1.585263888888889</c:v>
                </c:pt>
                <c:pt idx="523">
                  <c:v>1.5855625</c:v>
                </c:pt>
                <c:pt idx="524">
                  <c:v>1.5858680555555555</c:v>
                </c:pt>
                <c:pt idx="525">
                  <c:v>1.5861736111111111</c:v>
                </c:pt>
                <c:pt idx="526">
                  <c:v>1.5864722222222223</c:v>
                </c:pt>
                <c:pt idx="527">
                  <c:v>1.5869305555555555</c:v>
                </c:pt>
                <c:pt idx="528">
                  <c:v>1.587388888888889</c:v>
                </c:pt>
                <c:pt idx="529">
                  <c:v>1.5878541666666668</c:v>
                </c:pt>
                <c:pt idx="530">
                  <c:v>1.5883125</c:v>
                </c:pt>
                <c:pt idx="531">
                  <c:v>1.5888680555555554</c:v>
                </c:pt>
                <c:pt idx="532">
                  <c:v>1.5894305555555557</c:v>
                </c:pt>
                <c:pt idx="533">
                  <c:v>1.5899861111111111</c:v>
                </c:pt>
                <c:pt idx="534">
                  <c:v>1.5905486111111111</c:v>
                </c:pt>
                <c:pt idx="535">
                  <c:v>1.5911041666666668</c:v>
                </c:pt>
                <c:pt idx="536">
                  <c:v>1.59175</c:v>
                </c:pt>
                <c:pt idx="537">
                  <c:v>1.5924027777777778</c:v>
                </c:pt>
                <c:pt idx="538">
                  <c:v>1.5929305555555557</c:v>
                </c:pt>
                <c:pt idx="539">
                  <c:v>1.5934583333333332</c:v>
                </c:pt>
                <c:pt idx="540">
                  <c:v>1.5939930555555555</c:v>
                </c:pt>
                <c:pt idx="541">
                  <c:v>1.5945208333333334</c:v>
                </c:pt>
                <c:pt idx="542">
                  <c:v>1.5950486111111111</c:v>
                </c:pt>
                <c:pt idx="543">
                  <c:v>1.5955833333333334</c:v>
                </c:pt>
                <c:pt idx="544">
                  <c:v>1.5961111111111113</c:v>
                </c:pt>
                <c:pt idx="545">
                  <c:v>1.5966388888888887</c:v>
                </c:pt>
                <c:pt idx="546">
                  <c:v>1.5972638888888888</c:v>
                </c:pt>
                <c:pt idx="547">
                  <c:v>1.5978888888888889</c:v>
                </c:pt>
                <c:pt idx="548">
                  <c:v>1.598513888888889</c:v>
                </c:pt>
                <c:pt idx="549">
                  <c:v>1.5991319444444445</c:v>
                </c:pt>
                <c:pt idx="550">
                  <c:v>1.5997569444444446</c:v>
                </c:pt>
                <c:pt idx="551">
                  <c:v>1.6004791666666667</c:v>
                </c:pt>
                <c:pt idx="552">
                  <c:v>1.6011944444444444</c:v>
                </c:pt>
                <c:pt idx="553">
                  <c:v>1.6019166666666669</c:v>
                </c:pt>
                <c:pt idx="554">
                  <c:v>1.6026388888888889</c:v>
                </c:pt>
                <c:pt idx="555">
                  <c:v>1.6033541666666666</c:v>
                </c:pt>
                <c:pt idx="556">
                  <c:v>1.6040763888888887</c:v>
                </c:pt>
                <c:pt idx="557">
                  <c:v>1.6047916666666668</c:v>
                </c:pt>
                <c:pt idx="558">
                  <c:v>1.6055138888888889</c:v>
                </c:pt>
                <c:pt idx="559">
                  <c:v>1.6062291666666666</c:v>
                </c:pt>
                <c:pt idx="560">
                  <c:v>1.6069513888888891</c:v>
                </c:pt>
                <c:pt idx="561">
                  <c:v>1.6076666666666666</c:v>
                </c:pt>
                <c:pt idx="562">
                  <c:v>1.6083888888888889</c:v>
                </c:pt>
                <c:pt idx="563">
                  <c:v>1.6091111111111109</c:v>
                </c:pt>
                <c:pt idx="564">
                  <c:v>1.6098263888888888</c:v>
                </c:pt>
                <c:pt idx="565">
                  <c:v>1.6105486111111111</c:v>
                </c:pt>
                <c:pt idx="566">
                  <c:v>1.6112638888888888</c:v>
                </c:pt>
                <c:pt idx="567">
                  <c:v>1.6119861111111113</c:v>
                </c:pt>
                <c:pt idx="568">
                  <c:v>1.6127013888888888</c:v>
                </c:pt>
                <c:pt idx="569">
                  <c:v>1.6134236111111111</c:v>
                </c:pt>
                <c:pt idx="570">
                  <c:v>1.614138888888889</c:v>
                </c:pt>
                <c:pt idx="571">
                  <c:v>1.6148611111111111</c:v>
                </c:pt>
                <c:pt idx="572">
                  <c:v>1.6155833333333334</c:v>
                </c:pt>
                <c:pt idx="573">
                  <c:v>1.6162986111111111</c:v>
                </c:pt>
                <c:pt idx="574">
                  <c:v>1.6171805555555554</c:v>
                </c:pt>
                <c:pt idx="575">
                  <c:v>1.6180555555555556</c:v>
                </c:pt>
                <c:pt idx="576">
                  <c:v>1.6189374999999999</c:v>
                </c:pt>
                <c:pt idx="577">
                  <c:v>1.6198125000000001</c:v>
                </c:pt>
                <c:pt idx="578">
                  <c:v>1.6206944444444447</c:v>
                </c:pt>
                <c:pt idx="579">
                  <c:v>1.621388888888889</c:v>
                </c:pt>
                <c:pt idx="580">
                  <c:v>1.6220902777777777</c:v>
                </c:pt>
                <c:pt idx="581">
                  <c:v>1.6227916666666669</c:v>
                </c:pt>
                <c:pt idx="582">
                  <c:v>1.6228888888888888</c:v>
                </c:pt>
                <c:pt idx="583">
                  <c:v>1.6229930555555556</c:v>
                </c:pt>
                <c:pt idx="584">
                  <c:v>1.6230972222222224</c:v>
                </c:pt>
                <c:pt idx="585">
                  <c:v>1.6231944444444446</c:v>
                </c:pt>
                <c:pt idx="586">
                  <c:v>1.6234027777777778</c:v>
                </c:pt>
                <c:pt idx="587">
                  <c:v>1.6236041666666665</c:v>
                </c:pt>
                <c:pt idx="588">
                  <c:v>1.6238124999999999</c:v>
                </c:pt>
                <c:pt idx="589">
                  <c:v>1.6240138888888889</c:v>
                </c:pt>
                <c:pt idx="590">
                  <c:v>1.6244583333333331</c:v>
                </c:pt>
                <c:pt idx="591">
                  <c:v>1.6249097222222222</c:v>
                </c:pt>
                <c:pt idx="592">
                  <c:v>1.6253541666666669</c:v>
                </c:pt>
                <c:pt idx="593">
                  <c:v>1.6257986111111111</c:v>
                </c:pt>
                <c:pt idx="594">
                  <c:v>1.626451388888889</c:v>
                </c:pt>
                <c:pt idx="595">
                  <c:v>1.6270972222222222</c:v>
                </c:pt>
                <c:pt idx="596">
                  <c:v>1.62775</c:v>
                </c:pt>
                <c:pt idx="597">
                  <c:v>1.6283958333333333</c:v>
                </c:pt>
                <c:pt idx="598">
                  <c:v>1.6290486111111111</c:v>
                </c:pt>
                <c:pt idx="599">
                  <c:v>1.6298263888888889</c:v>
                </c:pt>
                <c:pt idx="600">
                  <c:v>1.6306041666666669</c:v>
                </c:pt>
                <c:pt idx="601">
                  <c:v>1.6313819444444444</c:v>
                </c:pt>
                <c:pt idx="602">
                  <c:v>1.6321597222222222</c:v>
                </c:pt>
                <c:pt idx="603">
                  <c:v>1.6329374999999999</c:v>
                </c:pt>
                <c:pt idx="604">
                  <c:v>1.6337152777777779</c:v>
                </c:pt>
                <c:pt idx="605">
                  <c:v>1.6344930555555557</c:v>
                </c:pt>
                <c:pt idx="606">
                  <c:v>1.6352708333333332</c:v>
                </c:pt>
                <c:pt idx="607">
                  <c:v>1.6360208333333333</c:v>
                </c:pt>
                <c:pt idx="608">
                  <c:v>1.6367638888888889</c:v>
                </c:pt>
                <c:pt idx="609">
                  <c:v>1.6375138888888889</c:v>
                </c:pt>
                <c:pt idx="610">
                  <c:v>1.6382569444444446</c:v>
                </c:pt>
                <c:pt idx="611">
                  <c:v>1.6390069444444444</c:v>
                </c:pt>
                <c:pt idx="612">
                  <c:v>1.6397499999999998</c:v>
                </c:pt>
                <c:pt idx="613">
                  <c:v>1.6405000000000001</c:v>
                </c:pt>
                <c:pt idx="614">
                  <c:v>1.6412430555555555</c:v>
                </c:pt>
                <c:pt idx="615">
                  <c:v>1.6419930555555555</c:v>
                </c:pt>
                <c:pt idx="616">
                  <c:v>1.6427361111111112</c:v>
                </c:pt>
                <c:pt idx="617">
                  <c:v>1.643486111111111</c:v>
                </c:pt>
                <c:pt idx="618">
                  <c:v>1.6442291666666666</c:v>
                </c:pt>
                <c:pt idx="619">
                  <c:v>1.6449791666666667</c:v>
                </c:pt>
                <c:pt idx="620">
                  <c:v>1.6457222222222223</c:v>
                </c:pt>
                <c:pt idx="621">
                  <c:v>1.6467361111111112</c:v>
                </c:pt>
                <c:pt idx="622">
                  <c:v>1.6477569444444444</c:v>
                </c:pt>
                <c:pt idx="623">
                  <c:v>1.6487708333333333</c:v>
                </c:pt>
                <c:pt idx="624">
                  <c:v>1.6497847222222222</c:v>
                </c:pt>
                <c:pt idx="625">
                  <c:v>1.6507986111111113</c:v>
                </c:pt>
                <c:pt idx="626">
                  <c:v>1.6519236111111111</c:v>
                </c:pt>
                <c:pt idx="627">
                  <c:v>1.6530416666666667</c:v>
                </c:pt>
                <c:pt idx="628">
                  <c:v>1.6541666666666666</c:v>
                </c:pt>
                <c:pt idx="629">
                  <c:v>1.6552847222222222</c:v>
                </c:pt>
                <c:pt idx="630">
                  <c:v>1.6564097222222223</c:v>
                </c:pt>
                <c:pt idx="631">
                  <c:v>1.6575277777777779</c:v>
                </c:pt>
                <c:pt idx="632">
                  <c:v>1.6590694444444445</c:v>
                </c:pt>
                <c:pt idx="633">
                  <c:v>1.6606041666666667</c:v>
                </c:pt>
                <c:pt idx="634">
                  <c:v>1.6621388888888888</c:v>
                </c:pt>
                <c:pt idx="635">
                  <c:v>1.6636736111111112</c:v>
                </c:pt>
                <c:pt idx="636">
                  <c:v>1.6652152777777778</c:v>
                </c:pt>
                <c:pt idx="637">
                  <c:v>1.66675</c:v>
                </c:pt>
                <c:pt idx="638">
                  <c:v>1.6682847222222221</c:v>
                </c:pt>
                <c:pt idx="639">
                  <c:v>1.6698194444444445</c:v>
                </c:pt>
                <c:pt idx="640">
                  <c:v>1.6713611111111113</c:v>
                </c:pt>
                <c:pt idx="641">
                  <c:v>1.6728958333333332</c:v>
                </c:pt>
                <c:pt idx="642">
                  <c:v>1.6744305555555554</c:v>
                </c:pt>
                <c:pt idx="643">
                  <c:v>1.6759652777777776</c:v>
                </c:pt>
                <c:pt idx="644">
                  <c:v>1.6777638888888888</c:v>
                </c:pt>
                <c:pt idx="645">
                  <c:v>1.6795625000000001</c:v>
                </c:pt>
                <c:pt idx="646">
                  <c:v>1.6813611111111111</c:v>
                </c:pt>
                <c:pt idx="647">
                  <c:v>1.6831666666666669</c:v>
                </c:pt>
                <c:pt idx="648">
                  <c:v>1.6845486111111112</c:v>
                </c:pt>
                <c:pt idx="649">
                  <c:v>1.6848125</c:v>
                </c:pt>
                <c:pt idx="650">
                  <c:v>1.6850694444444445</c:v>
                </c:pt>
                <c:pt idx="651">
                  <c:v>1.6853263888888887</c:v>
                </c:pt>
                <c:pt idx="652">
                  <c:v>1.6855902777777778</c:v>
                </c:pt>
                <c:pt idx="653">
                  <c:v>1.6858472222222221</c:v>
                </c:pt>
                <c:pt idx="654">
                  <c:v>1.6862986111111111</c:v>
                </c:pt>
                <c:pt idx="655">
                  <c:v>1.68675</c:v>
                </c:pt>
                <c:pt idx="656">
                  <c:v>1.6872083333333332</c:v>
                </c:pt>
                <c:pt idx="657">
                  <c:v>1.6876597222222223</c:v>
                </c:pt>
                <c:pt idx="658">
                  <c:v>1.6885902777777779</c:v>
                </c:pt>
                <c:pt idx="659">
                  <c:v>1.6895277777777777</c:v>
                </c:pt>
                <c:pt idx="660">
                  <c:v>1.6904583333333334</c:v>
                </c:pt>
                <c:pt idx="661">
                  <c:v>1.6913888888888888</c:v>
                </c:pt>
                <c:pt idx="662">
                  <c:v>1.6926319444444444</c:v>
                </c:pt>
                <c:pt idx="663">
                  <c:v>1.6938749999999998</c:v>
                </c:pt>
                <c:pt idx="664">
                  <c:v>1.6951111111111112</c:v>
                </c:pt>
                <c:pt idx="665">
                  <c:v>1.6952916666666664</c:v>
                </c:pt>
                <c:pt idx="666">
                  <c:v>1.6954791666666664</c:v>
                </c:pt>
                <c:pt idx="667">
                  <c:v>1.6956597222222223</c:v>
                </c:pt>
                <c:pt idx="668">
                  <c:v>1.6958402777777779</c:v>
                </c:pt>
                <c:pt idx="669">
                  <c:v>1.6960277777777779</c:v>
                </c:pt>
                <c:pt idx="670">
                  <c:v>1.6963750000000002</c:v>
                </c:pt>
                <c:pt idx="671">
                  <c:v>1.6967291666666666</c:v>
                </c:pt>
                <c:pt idx="672">
                  <c:v>1.6970833333333335</c:v>
                </c:pt>
                <c:pt idx="673">
                  <c:v>1.6974374999999999</c:v>
                </c:pt>
                <c:pt idx="674">
                  <c:v>1.6983263888888891</c:v>
                </c:pt>
                <c:pt idx="675">
                  <c:v>1.6992222222222222</c:v>
                </c:pt>
                <c:pt idx="676">
                  <c:v>1.7001111111111109</c:v>
                </c:pt>
                <c:pt idx="677">
                  <c:v>1.7010000000000001</c:v>
                </c:pt>
                <c:pt idx="678">
                  <c:v>1.7023402777777776</c:v>
                </c:pt>
                <c:pt idx="679">
                  <c:v>1.7036805555555556</c:v>
                </c:pt>
                <c:pt idx="680">
                  <c:v>1.7050277777777776</c:v>
                </c:pt>
                <c:pt idx="681">
                  <c:v>1.7063680555555556</c:v>
                </c:pt>
                <c:pt idx="682">
                  <c:v>1.7077083333333332</c:v>
                </c:pt>
                <c:pt idx="683">
                  <c:v>1.7095763888888889</c:v>
                </c:pt>
                <c:pt idx="684">
                  <c:v>1.7114513888888887</c:v>
                </c:pt>
                <c:pt idx="685">
                  <c:v>1.7133194444444444</c:v>
                </c:pt>
                <c:pt idx="686">
                  <c:v>1.7151944444444445</c:v>
                </c:pt>
                <c:pt idx="687">
                  <c:v>1.7170625000000002</c:v>
                </c:pt>
                <c:pt idx="688">
                  <c:v>1.719423611111111</c:v>
                </c:pt>
                <c:pt idx="689">
                  <c:v>1.7217777777777779</c:v>
                </c:pt>
                <c:pt idx="690">
                  <c:v>1.7241319444444445</c:v>
                </c:pt>
                <c:pt idx="691">
                  <c:v>1.7264930555555555</c:v>
                </c:pt>
                <c:pt idx="692">
                  <c:v>1.7288472222222222</c:v>
                </c:pt>
                <c:pt idx="693">
                  <c:v>1.7312013888888889</c:v>
                </c:pt>
                <c:pt idx="694">
                  <c:v>1.7339236111111112</c:v>
                </c:pt>
                <c:pt idx="695">
                  <c:v>1.7366458333333332</c:v>
                </c:pt>
                <c:pt idx="696">
                  <c:v>1.7393680555555555</c:v>
                </c:pt>
                <c:pt idx="697">
                  <c:v>1.7420902777777778</c:v>
                </c:pt>
                <c:pt idx="698">
                  <c:v>1.7448125000000001</c:v>
                </c:pt>
                <c:pt idx="699">
                  <c:v>1.7475347222222222</c:v>
                </c:pt>
                <c:pt idx="700">
                  <c:v>1.7519930555555554</c:v>
                </c:pt>
                <c:pt idx="701">
                  <c:v>1.7564513888888889</c:v>
                </c:pt>
                <c:pt idx="702">
                  <c:v>1.7609097222222223</c:v>
                </c:pt>
                <c:pt idx="703">
                  <c:v>1.7653680555555555</c:v>
                </c:pt>
                <c:pt idx="704">
                  <c:v>1.769826388888889</c:v>
                </c:pt>
                <c:pt idx="705">
                  <c:v>1.774284722222222</c:v>
                </c:pt>
                <c:pt idx="706">
                  <c:v>1.7787430555555555</c:v>
                </c:pt>
                <c:pt idx="707">
                  <c:v>1.7832083333333335</c:v>
                </c:pt>
                <c:pt idx="708">
                  <c:v>1.7876666666666665</c:v>
                </c:pt>
                <c:pt idx="709">
                  <c:v>1.792125</c:v>
                </c:pt>
                <c:pt idx="710">
                  <c:v>1.7965833333333332</c:v>
                </c:pt>
                <c:pt idx="711">
                  <c:v>1.8010416666666667</c:v>
                </c:pt>
                <c:pt idx="712">
                  <c:v>1.8064305555555558</c:v>
                </c:pt>
                <c:pt idx="713">
                  <c:v>1.811826388888889</c:v>
                </c:pt>
                <c:pt idx="714">
                  <c:v>1.8172222222222223</c:v>
                </c:pt>
                <c:pt idx="715">
                  <c:v>1.8226180555555556</c:v>
                </c:pt>
                <c:pt idx="716">
                  <c:v>1.8233819444444446</c:v>
                </c:pt>
                <c:pt idx="717">
                  <c:v>1.8241458333333334</c:v>
                </c:pt>
                <c:pt idx="718">
                  <c:v>1.8249097222222221</c:v>
                </c:pt>
                <c:pt idx="719">
                  <c:v>1.8256736111111109</c:v>
                </c:pt>
                <c:pt idx="720">
                  <c:v>1.8264375000000002</c:v>
                </c:pt>
                <c:pt idx="721">
                  <c:v>1.8275138888888889</c:v>
                </c:pt>
                <c:pt idx="722">
                  <c:v>1.8285902777777778</c:v>
                </c:pt>
                <c:pt idx="723">
                  <c:v>1.8294791666666665</c:v>
                </c:pt>
                <c:pt idx="724">
                  <c:v>1.8303680555555555</c:v>
                </c:pt>
                <c:pt idx="725">
                  <c:v>1.8312569444444446</c:v>
                </c:pt>
                <c:pt idx="726">
                  <c:v>1.8320416666666666</c:v>
                </c:pt>
                <c:pt idx="727">
                  <c:v>1.8328194444444446</c:v>
                </c:pt>
                <c:pt idx="728">
                  <c:v>1.8335972222222223</c:v>
                </c:pt>
                <c:pt idx="729">
                  <c:v>1.8343819444444447</c:v>
                </c:pt>
                <c:pt idx="730">
                  <c:v>1.8351597222222222</c:v>
                </c:pt>
                <c:pt idx="731">
                  <c:v>1.8364444444444445</c:v>
                </c:pt>
                <c:pt idx="732">
                  <c:v>1.8377291666666666</c:v>
                </c:pt>
                <c:pt idx="733">
                  <c:v>1.8390138888888887</c:v>
                </c:pt>
                <c:pt idx="734">
                  <c:v>1.8402986111111113</c:v>
                </c:pt>
                <c:pt idx="735">
                  <c:v>1.8429583333333335</c:v>
                </c:pt>
                <c:pt idx="736">
                  <c:v>1.8456111111111111</c:v>
                </c:pt>
                <c:pt idx="737">
                  <c:v>1.8482708333333335</c:v>
                </c:pt>
                <c:pt idx="738">
                  <c:v>1.8509305555555557</c:v>
                </c:pt>
                <c:pt idx="739">
                  <c:v>1.8548333333333333</c:v>
                </c:pt>
                <c:pt idx="740">
                  <c:v>1.8587361111111111</c:v>
                </c:pt>
                <c:pt idx="741">
                  <c:v>1.8626388888888887</c:v>
                </c:pt>
                <c:pt idx="742">
                  <c:v>1.8665347222222222</c:v>
                </c:pt>
                <c:pt idx="743">
                  <c:v>1.8704375</c:v>
                </c:pt>
                <c:pt idx="744">
                  <c:v>1.8749652777777777</c:v>
                </c:pt>
                <c:pt idx="745">
                  <c:v>1.8794861111111112</c:v>
                </c:pt>
                <c:pt idx="746">
                  <c:v>1.8840138888888889</c:v>
                </c:pt>
                <c:pt idx="747">
                  <c:v>1.888534722222222</c:v>
                </c:pt>
                <c:pt idx="748">
                  <c:v>1.8930625000000001</c:v>
                </c:pt>
                <c:pt idx="749">
                  <c:v>1.8980555555555554</c:v>
                </c:pt>
                <c:pt idx="750">
                  <c:v>1.9030486111111111</c:v>
                </c:pt>
                <c:pt idx="751">
                  <c:v>1.9080416666666666</c:v>
                </c:pt>
                <c:pt idx="752">
                  <c:v>1.9130416666666668</c:v>
                </c:pt>
                <c:pt idx="753">
                  <c:v>1.918034722222222</c:v>
                </c:pt>
                <c:pt idx="754">
                  <c:v>1.9230277777777778</c:v>
                </c:pt>
                <c:pt idx="755">
                  <c:v>1.9280208333333333</c:v>
                </c:pt>
                <c:pt idx="756">
                  <c:v>1.9330138888888888</c:v>
                </c:pt>
                <c:pt idx="757">
                  <c:v>1.9391874999999998</c:v>
                </c:pt>
                <c:pt idx="758">
                  <c:v>1.9453611111111113</c:v>
                </c:pt>
                <c:pt idx="759">
                  <c:v>1.9515277777777778</c:v>
                </c:pt>
                <c:pt idx="760">
                  <c:v>1.957701388888889</c:v>
                </c:pt>
                <c:pt idx="761">
                  <c:v>1.9638680555555554</c:v>
                </c:pt>
                <c:pt idx="762">
                  <c:v>1.9700416666666667</c:v>
                </c:pt>
                <c:pt idx="763">
                  <c:v>1.9776805555555557</c:v>
                </c:pt>
                <c:pt idx="764">
                  <c:v>1.9853194444444446</c:v>
                </c:pt>
                <c:pt idx="765">
                  <c:v>1.9929583333333334</c:v>
                </c:pt>
                <c:pt idx="766">
                  <c:v>1.9940694444444444</c:v>
                </c:pt>
                <c:pt idx="767">
                  <c:v>1.9942847222222222</c:v>
                </c:pt>
                <c:pt idx="768">
                  <c:v>1.9944999999999999</c:v>
                </c:pt>
                <c:pt idx="769">
                  <c:v>1.9947152777777777</c:v>
                </c:pt>
                <c:pt idx="770">
                  <c:v>1.9949305555555554</c:v>
                </c:pt>
                <c:pt idx="771">
                  <c:v>1.9953611111111111</c:v>
                </c:pt>
                <c:pt idx="772">
                  <c:v>1.995784722222222</c:v>
                </c:pt>
                <c:pt idx="773">
                  <c:v>1.996215277777778</c:v>
                </c:pt>
                <c:pt idx="774">
                  <c:v>1.997138888888889</c:v>
                </c:pt>
                <c:pt idx="775">
                  <c:v>1.9980555555555555</c:v>
                </c:pt>
                <c:pt idx="776">
                  <c:v>1.9989722222222222</c:v>
                </c:pt>
                <c:pt idx="777">
                  <c:v>2.0004999999999997</c:v>
                </c:pt>
                <c:pt idx="778">
                  <c:v>2.0020347222222221</c:v>
                </c:pt>
                <c:pt idx="779">
                  <c:v>2.0035625000000001</c:v>
                </c:pt>
                <c:pt idx="780">
                  <c:v>2.0050902777777777</c:v>
                </c:pt>
                <c:pt idx="781">
                  <c:v>2.0070208333333333</c:v>
                </c:pt>
                <c:pt idx="782">
                  <c:v>2.0089513888888888</c:v>
                </c:pt>
                <c:pt idx="783">
                  <c:v>2.0108819444444443</c:v>
                </c:pt>
                <c:pt idx="784">
                  <c:v>2.0128124999999999</c:v>
                </c:pt>
                <c:pt idx="785">
                  <c:v>2.0156805555555555</c:v>
                </c:pt>
                <c:pt idx="786">
                  <c:v>2.0185416666666667</c:v>
                </c:pt>
                <c:pt idx="787">
                  <c:v>2.0214097222222223</c:v>
                </c:pt>
                <c:pt idx="788">
                  <c:v>2.024270833333333</c:v>
                </c:pt>
                <c:pt idx="789">
                  <c:v>2.0271319444444447</c:v>
                </c:pt>
                <c:pt idx="790">
                  <c:v>2.0316666666666667</c:v>
                </c:pt>
                <c:pt idx="791">
                  <c:v>2.0362013888888888</c:v>
                </c:pt>
                <c:pt idx="792">
                  <c:v>2.0407361111111109</c:v>
                </c:pt>
                <c:pt idx="793">
                  <c:v>2.0452708333333334</c:v>
                </c:pt>
                <c:pt idx="794">
                  <c:v>2.0498055555555554</c:v>
                </c:pt>
                <c:pt idx="795">
                  <c:v>2.056673611111111</c:v>
                </c:pt>
                <c:pt idx="796">
                  <c:v>2.0635416666666666</c:v>
                </c:pt>
                <c:pt idx="797">
                  <c:v>2.0704166666666666</c:v>
                </c:pt>
                <c:pt idx="798">
                  <c:v>2.0772847222222222</c:v>
                </c:pt>
                <c:pt idx="799">
                  <c:v>2.0841527777777777</c:v>
                </c:pt>
                <c:pt idx="800">
                  <c:v>2.0910208333333333</c:v>
                </c:pt>
                <c:pt idx="801">
                  <c:v>2.0998958333333331</c:v>
                </c:pt>
                <c:pt idx="802">
                  <c:v>2.1087708333333333</c:v>
                </c:pt>
                <c:pt idx="803">
                  <c:v>2.1176458333333334</c:v>
                </c:pt>
                <c:pt idx="804">
                  <c:v>2.1246944444444442</c:v>
                </c:pt>
                <c:pt idx="805">
                  <c:v>2.1257361111111113</c:v>
                </c:pt>
                <c:pt idx="806">
                  <c:v>2.1267777777777779</c:v>
                </c:pt>
                <c:pt idx="807">
                  <c:v>2.1278263888888889</c:v>
                </c:pt>
                <c:pt idx="808">
                  <c:v>2.1288680555555555</c:v>
                </c:pt>
                <c:pt idx="809">
                  <c:v>2.1299166666666665</c:v>
                </c:pt>
                <c:pt idx="810">
                  <c:v>2.1320069444444445</c:v>
                </c:pt>
                <c:pt idx="811">
                  <c:v>2.1340902777777777</c:v>
                </c:pt>
                <c:pt idx="812">
                  <c:v>2.1361805555555553</c:v>
                </c:pt>
                <c:pt idx="813">
                  <c:v>2.1382708333333333</c:v>
                </c:pt>
                <c:pt idx="814">
                  <c:v>2.1419930555555555</c:v>
                </c:pt>
                <c:pt idx="815">
                  <c:v>2.1457222222222225</c:v>
                </c:pt>
                <c:pt idx="816">
                  <c:v>2.1494444444444443</c:v>
                </c:pt>
                <c:pt idx="817">
                  <c:v>2.1531666666666665</c:v>
                </c:pt>
                <c:pt idx="818">
                  <c:v>2.1568888888888891</c:v>
                </c:pt>
                <c:pt idx="819">
                  <c:v>2.1619930555555555</c:v>
                </c:pt>
                <c:pt idx="820">
                  <c:v>2.1670902777777781</c:v>
                </c:pt>
                <c:pt idx="821">
                  <c:v>2.1721874999999997</c:v>
                </c:pt>
                <c:pt idx="822">
                  <c:v>2.1772847222222222</c:v>
                </c:pt>
                <c:pt idx="823">
                  <c:v>2.1823888888888887</c:v>
                </c:pt>
                <c:pt idx="824">
                  <c:v>2.1898402777777779</c:v>
                </c:pt>
                <c:pt idx="825">
                  <c:v>2.1972916666666666</c:v>
                </c:pt>
                <c:pt idx="826">
                  <c:v>2.2047500000000002</c:v>
                </c:pt>
                <c:pt idx="827">
                  <c:v>2.212201388888889</c:v>
                </c:pt>
                <c:pt idx="828">
                  <c:v>2.2196527777777777</c:v>
                </c:pt>
                <c:pt idx="829">
                  <c:v>2.2271111111111113</c:v>
                </c:pt>
                <c:pt idx="830">
                  <c:v>2.2370486111111112</c:v>
                </c:pt>
                <c:pt idx="831">
                  <c:v>2.2469930555555555</c:v>
                </c:pt>
                <c:pt idx="832">
                  <c:v>2.2569374999999998</c:v>
                </c:pt>
                <c:pt idx="833">
                  <c:v>2.2668750000000002</c:v>
                </c:pt>
                <c:pt idx="834">
                  <c:v>2.2768194444444445</c:v>
                </c:pt>
                <c:pt idx="835">
                  <c:v>2.2867638888888888</c:v>
                </c:pt>
                <c:pt idx="836">
                  <c:v>2.2967083333333336</c:v>
                </c:pt>
                <c:pt idx="837">
                  <c:v>2.3066458333333335</c:v>
                </c:pt>
                <c:pt idx="838">
                  <c:v>2.3165902777777778</c:v>
                </c:pt>
                <c:pt idx="839">
                  <c:v>2.3265347222222221</c:v>
                </c:pt>
                <c:pt idx="840">
                  <c:v>2.3364722222222221</c:v>
                </c:pt>
                <c:pt idx="841">
                  <c:v>2.3464166666666668</c:v>
                </c:pt>
                <c:pt idx="842">
                  <c:v>2.3563611111111111</c:v>
                </c:pt>
                <c:pt idx="843">
                  <c:v>2.3646249999999998</c:v>
                </c:pt>
                <c:pt idx="844">
                  <c:v>2.3728958333333332</c:v>
                </c:pt>
                <c:pt idx="845">
                  <c:v>2.3811666666666667</c:v>
                </c:pt>
                <c:pt idx="846">
                  <c:v>2.3894305555555557</c:v>
                </c:pt>
                <c:pt idx="847">
                  <c:v>2.3977013888888887</c:v>
                </c:pt>
                <c:pt idx="848">
                  <c:v>2.4059652777777778</c:v>
                </c:pt>
                <c:pt idx="849">
                  <c:v>2.4142361111111112</c:v>
                </c:pt>
                <c:pt idx="850">
                  <c:v>2.4225069444444443</c:v>
                </c:pt>
                <c:pt idx="851">
                  <c:v>2.4307708333333333</c:v>
                </c:pt>
                <c:pt idx="852">
                  <c:v>2.4374166666666666</c:v>
                </c:pt>
                <c:pt idx="853">
                  <c:v>2.4440555555555554</c:v>
                </c:pt>
                <c:pt idx="854">
                  <c:v>2.4507013888888891</c:v>
                </c:pt>
                <c:pt idx="855">
                  <c:v>2.4573472222222223</c:v>
                </c:pt>
                <c:pt idx="856">
                  <c:v>2.4639861111111112</c:v>
                </c:pt>
                <c:pt idx="857">
                  <c:v>2.4706319444444444</c:v>
                </c:pt>
                <c:pt idx="858">
                  <c:v>2.4772708333333333</c:v>
                </c:pt>
                <c:pt idx="859">
                  <c:v>2.4839166666666666</c:v>
                </c:pt>
                <c:pt idx="860">
                  <c:v>2.4905624999999998</c:v>
                </c:pt>
                <c:pt idx="861">
                  <c:v>2.4915902777777776</c:v>
                </c:pt>
                <c:pt idx="862">
                  <c:v>2.4926180555555555</c:v>
                </c:pt>
                <c:pt idx="863">
                  <c:v>2.493451388888889</c:v>
                </c:pt>
                <c:pt idx="864">
                  <c:v>2.4942847222222224</c:v>
                </c:pt>
                <c:pt idx="865">
                  <c:v>2.4951111111111111</c:v>
                </c:pt>
                <c:pt idx="866">
                  <c:v>2.4959444444444445</c:v>
                </c:pt>
                <c:pt idx="867">
                  <c:v>2.496777777777778</c:v>
                </c:pt>
                <c:pt idx="868">
                  <c:v>2.4976041666666666</c:v>
                </c:pt>
                <c:pt idx="869">
                  <c:v>2.4984375000000001</c:v>
                </c:pt>
                <c:pt idx="870">
                  <c:v>2.4992638888888887</c:v>
                </c:pt>
                <c:pt idx="871">
                  <c:v>2.5003541666666669</c:v>
                </c:pt>
                <c:pt idx="872">
                  <c:v>2.5014444444444446</c:v>
                </c:pt>
                <c:pt idx="873">
                  <c:v>2.5025277777777779</c:v>
                </c:pt>
                <c:pt idx="874">
                  <c:v>2.5036180555555556</c:v>
                </c:pt>
                <c:pt idx="875">
                  <c:v>2.5054861111111113</c:v>
                </c:pt>
                <c:pt idx="876">
                  <c:v>2.5073541666666666</c:v>
                </c:pt>
                <c:pt idx="877">
                  <c:v>2.5092222222222222</c:v>
                </c:pt>
                <c:pt idx="878">
                  <c:v>2.5110902777777775</c:v>
                </c:pt>
                <c:pt idx="879">
                  <c:v>2.5138333333333334</c:v>
                </c:pt>
                <c:pt idx="880">
                  <c:v>2.5165833333333336</c:v>
                </c:pt>
                <c:pt idx="881">
                  <c:v>2.5193333333333334</c:v>
                </c:pt>
                <c:pt idx="882">
                  <c:v>2.5220763888888889</c:v>
                </c:pt>
                <c:pt idx="883">
                  <c:v>2.5242291666666667</c:v>
                </c:pt>
                <c:pt idx="884">
                  <c:v>2.5245694444444444</c:v>
                </c:pt>
                <c:pt idx="885">
                  <c:v>2.5249166666666669</c:v>
                </c:pt>
                <c:pt idx="886">
                  <c:v>2.525263888888889</c:v>
                </c:pt>
                <c:pt idx="887">
                  <c:v>2.525611111111111</c:v>
                </c:pt>
                <c:pt idx="888">
                  <c:v>2.526284722222222</c:v>
                </c:pt>
                <c:pt idx="889">
                  <c:v>2.5269583333333334</c:v>
                </c:pt>
                <c:pt idx="890">
                  <c:v>2.5276319444444444</c:v>
                </c:pt>
                <c:pt idx="891">
                  <c:v>2.5283055555555558</c:v>
                </c:pt>
                <c:pt idx="892">
                  <c:v>2.5300833333333332</c:v>
                </c:pt>
                <c:pt idx="893">
                  <c:v>2.5318680555555555</c:v>
                </c:pt>
                <c:pt idx="894">
                  <c:v>2.5336527777777778</c:v>
                </c:pt>
                <c:pt idx="895">
                  <c:v>2.5354375</c:v>
                </c:pt>
                <c:pt idx="896">
                  <c:v>2.5378124999999998</c:v>
                </c:pt>
                <c:pt idx="897">
                  <c:v>2.5401944444444444</c:v>
                </c:pt>
                <c:pt idx="898">
                  <c:v>2.5425694444444447</c:v>
                </c:pt>
                <c:pt idx="899">
                  <c:v>2.5449444444444445</c:v>
                </c:pt>
                <c:pt idx="900">
                  <c:v>2.5473263888888891</c:v>
                </c:pt>
                <c:pt idx="901">
                  <c:v>2.5492708333333334</c:v>
                </c:pt>
                <c:pt idx="902">
                  <c:v>2.5512152777777777</c:v>
                </c:pt>
                <c:pt idx="903">
                  <c:v>2.5531597222222224</c:v>
                </c:pt>
                <c:pt idx="904">
                  <c:v>2.5551041666666667</c:v>
                </c:pt>
                <c:pt idx="905">
                  <c:v>2.557048611111111</c:v>
                </c:pt>
                <c:pt idx="906">
                  <c:v>2.5589930555555553</c:v>
                </c:pt>
                <c:pt idx="907">
                  <c:v>2.5609375000000001</c:v>
                </c:pt>
                <c:pt idx="908">
                  <c:v>2.5628819444444444</c:v>
                </c:pt>
                <c:pt idx="909">
                  <c:v>2.5651875</c:v>
                </c:pt>
                <c:pt idx="910">
                  <c:v>2.5674930555555555</c:v>
                </c:pt>
                <c:pt idx="911">
                  <c:v>2.5697986111111111</c:v>
                </c:pt>
                <c:pt idx="912">
                  <c:v>2.5721041666666666</c:v>
                </c:pt>
                <c:pt idx="913">
                  <c:v>2.5744097222222222</c:v>
                </c:pt>
                <c:pt idx="914">
                  <c:v>2.5767152777777778</c:v>
                </c:pt>
                <c:pt idx="915">
                  <c:v>2.5790208333333333</c:v>
                </c:pt>
                <c:pt idx="916">
                  <c:v>2.5813263888888889</c:v>
                </c:pt>
                <c:pt idx="917">
                  <c:v>2.5839722222222221</c:v>
                </c:pt>
                <c:pt idx="918">
                  <c:v>2.5866180555555554</c:v>
                </c:pt>
                <c:pt idx="919">
                  <c:v>2.5892569444444447</c:v>
                </c:pt>
                <c:pt idx="920">
                  <c:v>2.5919027777777779</c:v>
                </c:pt>
                <c:pt idx="921">
                  <c:v>2.5945486111111111</c:v>
                </c:pt>
                <c:pt idx="922">
                  <c:v>2.5977569444444444</c:v>
                </c:pt>
                <c:pt idx="923">
                  <c:v>2.6009652777777776</c:v>
                </c:pt>
                <c:pt idx="924">
                  <c:v>2.6041736111111113</c:v>
                </c:pt>
                <c:pt idx="925">
                  <c:v>2.6046736111111111</c:v>
                </c:pt>
                <c:pt idx="926">
                  <c:v>2.6051666666666669</c:v>
                </c:pt>
                <c:pt idx="927">
                  <c:v>2.6056597222222222</c:v>
                </c:pt>
                <c:pt idx="928">
                  <c:v>2.6061597222222224</c:v>
                </c:pt>
                <c:pt idx="929">
                  <c:v>2.6066527777777777</c:v>
                </c:pt>
                <c:pt idx="930">
                  <c:v>2.6073819444444446</c:v>
                </c:pt>
                <c:pt idx="931">
                  <c:v>2.6081041666666667</c:v>
                </c:pt>
                <c:pt idx="932">
                  <c:v>2.6088333333333331</c:v>
                </c:pt>
                <c:pt idx="933">
                  <c:v>2.6095555555555556</c:v>
                </c:pt>
                <c:pt idx="934">
                  <c:v>2.6108055555555554</c:v>
                </c:pt>
                <c:pt idx="935">
                  <c:v>2.6120555555555556</c:v>
                </c:pt>
                <c:pt idx="936">
                  <c:v>2.6133125000000001</c:v>
                </c:pt>
                <c:pt idx="937">
                  <c:v>2.6145624999999999</c:v>
                </c:pt>
                <c:pt idx="938">
                  <c:v>2.616326388888889</c:v>
                </c:pt>
                <c:pt idx="939">
                  <c:v>2.6180902777777777</c:v>
                </c:pt>
                <c:pt idx="940">
                  <c:v>2.6198611111111112</c:v>
                </c:pt>
                <c:pt idx="941">
                  <c:v>2.6212708333333334</c:v>
                </c:pt>
                <c:pt idx="942">
                  <c:v>2.6224444444444446</c:v>
                </c:pt>
                <c:pt idx="943">
                  <c:v>2.6236111111111109</c:v>
                </c:pt>
                <c:pt idx="944">
                  <c:v>2.6247777777777777</c:v>
                </c:pt>
                <c:pt idx="945">
                  <c:v>2.6259513888888888</c:v>
                </c:pt>
                <c:pt idx="946">
                  <c:v>2.6261597222222224</c:v>
                </c:pt>
                <c:pt idx="947">
                  <c:v>2.6263749999999999</c:v>
                </c:pt>
                <c:pt idx="948">
                  <c:v>2.6265902777777779</c:v>
                </c:pt>
                <c:pt idx="949">
                  <c:v>2.6268055555555554</c:v>
                </c:pt>
                <c:pt idx="950">
                  <c:v>2.6271666666666667</c:v>
                </c:pt>
                <c:pt idx="951">
                  <c:v>2.6275277777777779</c:v>
                </c:pt>
                <c:pt idx="952">
                  <c:v>2.6278958333333335</c:v>
                </c:pt>
                <c:pt idx="953">
                  <c:v>2.6284236111111108</c:v>
                </c:pt>
                <c:pt idx="954">
                  <c:v>2.6289583333333333</c:v>
                </c:pt>
                <c:pt idx="955">
                  <c:v>2.6294930555555553</c:v>
                </c:pt>
                <c:pt idx="956">
                  <c:v>2.6300277777777774</c:v>
                </c:pt>
                <c:pt idx="957">
                  <c:v>2.6306944444444444</c:v>
                </c:pt>
                <c:pt idx="958">
                  <c:v>2.6313541666666667</c:v>
                </c:pt>
                <c:pt idx="959">
                  <c:v>2.6320138888888889</c:v>
                </c:pt>
                <c:pt idx="960">
                  <c:v>2.6326805555555555</c:v>
                </c:pt>
                <c:pt idx="961">
                  <c:v>2.6337430555555557</c:v>
                </c:pt>
                <c:pt idx="962">
                  <c:v>2.6348055555555554</c:v>
                </c:pt>
                <c:pt idx="963">
                  <c:v>2.6358680555555556</c:v>
                </c:pt>
                <c:pt idx="964">
                  <c:v>2.6369305555555553</c:v>
                </c:pt>
                <c:pt idx="965">
                  <c:v>2.6384652777777777</c:v>
                </c:pt>
                <c:pt idx="966">
                  <c:v>2.64</c:v>
                </c:pt>
                <c:pt idx="967">
                  <c:v>2.6415347222222221</c:v>
                </c:pt>
                <c:pt idx="968">
                  <c:v>2.6427708333333335</c:v>
                </c:pt>
                <c:pt idx="969">
                  <c:v>2.6437777777777778</c:v>
                </c:pt>
                <c:pt idx="970">
                  <c:v>2.6447847222222221</c:v>
                </c:pt>
                <c:pt idx="971">
                  <c:v>2.6457916666666668</c:v>
                </c:pt>
                <c:pt idx="972">
                  <c:v>2.646798611111111</c:v>
                </c:pt>
                <c:pt idx="973">
                  <c:v>2.6478055555555557</c:v>
                </c:pt>
                <c:pt idx="974">
                  <c:v>2.6488125</c:v>
                </c:pt>
                <c:pt idx="975">
                  <c:v>2.6498194444444443</c:v>
                </c:pt>
                <c:pt idx="976">
                  <c:v>2.6506180555555554</c:v>
                </c:pt>
                <c:pt idx="977">
                  <c:v>2.6514236111111114</c:v>
                </c:pt>
                <c:pt idx="978">
                  <c:v>2.6522291666666669</c:v>
                </c:pt>
                <c:pt idx="979">
                  <c:v>2.6530347222222224</c:v>
                </c:pt>
                <c:pt idx="980">
                  <c:v>2.6538402777777779</c:v>
                </c:pt>
                <c:pt idx="981">
                  <c:v>2.6548055555555554</c:v>
                </c:pt>
                <c:pt idx="982">
                  <c:v>2.6557708333333334</c:v>
                </c:pt>
                <c:pt idx="983">
                  <c:v>2.656736111111111</c:v>
                </c:pt>
                <c:pt idx="984">
                  <c:v>2.6577083333333333</c:v>
                </c:pt>
                <c:pt idx="985">
                  <c:v>2.6578680555555554</c:v>
                </c:pt>
                <c:pt idx="986">
                  <c:v>2.6580347222222223</c:v>
                </c:pt>
                <c:pt idx="987">
                  <c:v>2.6582013888888887</c:v>
                </c:pt>
                <c:pt idx="988">
                  <c:v>2.6583680555555556</c:v>
                </c:pt>
                <c:pt idx="989">
                  <c:v>2.6586527777777778</c:v>
                </c:pt>
                <c:pt idx="990">
                  <c:v>2.6589444444444443</c:v>
                </c:pt>
                <c:pt idx="991">
                  <c:v>2.6592361111111114</c:v>
                </c:pt>
                <c:pt idx="992">
                  <c:v>2.6596666666666668</c:v>
                </c:pt>
                <c:pt idx="993">
                  <c:v>2.660090277777778</c:v>
                </c:pt>
                <c:pt idx="994">
                  <c:v>2.6605208333333334</c:v>
                </c:pt>
                <c:pt idx="995">
                  <c:v>2.6609513888888889</c:v>
                </c:pt>
                <c:pt idx="996">
                  <c:v>2.6615416666666665</c:v>
                </c:pt>
                <c:pt idx="997">
                  <c:v>2.6621250000000001</c:v>
                </c:pt>
                <c:pt idx="998">
                  <c:v>2.6627152777777776</c:v>
                </c:pt>
                <c:pt idx="999">
                  <c:v>2.6633055555555556</c:v>
                </c:pt>
                <c:pt idx="1000">
                  <c:v>2.6642638888888888</c:v>
                </c:pt>
                <c:pt idx="1001">
                  <c:v>2.6652291666666668</c:v>
                </c:pt>
                <c:pt idx="1002">
                  <c:v>2.6661874999999999</c:v>
                </c:pt>
                <c:pt idx="1003">
                  <c:v>2.6671527777777775</c:v>
                </c:pt>
                <c:pt idx="1004">
                  <c:v>2.6681180555555555</c:v>
                </c:pt>
                <c:pt idx="1005">
                  <c:v>2.6700902777777777</c:v>
                </c:pt>
                <c:pt idx="1006">
                  <c:v>2.6720625</c:v>
                </c:pt>
                <c:pt idx="1007">
                  <c:v>2.6736597222222223</c:v>
                </c:pt>
                <c:pt idx="1008">
                  <c:v>2.6752500000000001</c:v>
                </c:pt>
                <c:pt idx="1009">
                  <c:v>2.676840277777778</c:v>
                </c:pt>
                <c:pt idx="1010">
                  <c:v>2.6784305555555554</c:v>
                </c:pt>
                <c:pt idx="1011">
                  <c:v>2.6800277777777777</c:v>
                </c:pt>
                <c:pt idx="1012">
                  <c:v>2.6816180555555555</c:v>
                </c:pt>
                <c:pt idx="1013">
                  <c:v>2.6832083333333334</c:v>
                </c:pt>
                <c:pt idx="1014">
                  <c:v>2.6848055555555557</c:v>
                </c:pt>
                <c:pt idx="1015">
                  <c:v>2.6863958333333331</c:v>
                </c:pt>
                <c:pt idx="1016">
                  <c:v>2.687986111111111</c:v>
                </c:pt>
                <c:pt idx="1017">
                  <c:v>2.6895763888888888</c:v>
                </c:pt>
                <c:pt idx="1018">
                  <c:v>2.6911736111111111</c:v>
                </c:pt>
                <c:pt idx="1019">
                  <c:v>2.692763888888889</c:v>
                </c:pt>
                <c:pt idx="1020">
                  <c:v>2.6943541666666664</c:v>
                </c:pt>
                <c:pt idx="1021">
                  <c:v>2.6959444444444443</c:v>
                </c:pt>
                <c:pt idx="1022">
                  <c:v>2.6975416666666665</c:v>
                </c:pt>
                <c:pt idx="1023">
                  <c:v>2.697784722222222</c:v>
                </c:pt>
                <c:pt idx="1024">
                  <c:v>2.6980208333333335</c:v>
                </c:pt>
                <c:pt idx="1025">
                  <c:v>2.698263888888889</c:v>
                </c:pt>
                <c:pt idx="1026">
                  <c:v>2.6985069444444445</c:v>
                </c:pt>
                <c:pt idx="1027">
                  <c:v>2.69875</c:v>
                </c:pt>
                <c:pt idx="1028">
                  <c:v>2.6992291666666666</c:v>
                </c:pt>
                <c:pt idx="1029">
                  <c:v>2.699715277777778</c:v>
                </c:pt>
                <c:pt idx="1030">
                  <c:v>2.7002013888888889</c:v>
                </c:pt>
                <c:pt idx="1031">
                  <c:v>2.7006805555555555</c:v>
                </c:pt>
                <c:pt idx="1032">
                  <c:v>2.7015486111111113</c:v>
                </c:pt>
                <c:pt idx="1033">
                  <c:v>2.7024097222222219</c:v>
                </c:pt>
                <c:pt idx="1034">
                  <c:v>2.7032777777777777</c:v>
                </c:pt>
                <c:pt idx="1035">
                  <c:v>2.7041388888888891</c:v>
                </c:pt>
                <c:pt idx="1036">
                  <c:v>2.7050069444444444</c:v>
                </c:pt>
                <c:pt idx="1037">
                  <c:v>2.706159722222222</c:v>
                </c:pt>
                <c:pt idx="1038">
                  <c:v>2.7073125</c:v>
                </c:pt>
                <c:pt idx="1039">
                  <c:v>2.708465277777778</c:v>
                </c:pt>
                <c:pt idx="1040">
                  <c:v>2.7096180555555556</c:v>
                </c:pt>
                <c:pt idx="1041">
                  <c:v>2.7107708333333336</c:v>
                </c:pt>
                <c:pt idx="1042">
                  <c:v>2.7122847222222224</c:v>
                </c:pt>
                <c:pt idx="1043">
                  <c:v>2.7137916666666668</c:v>
                </c:pt>
                <c:pt idx="1044">
                  <c:v>2.7153055555555556</c:v>
                </c:pt>
                <c:pt idx="1045">
                  <c:v>2.7168125000000001</c:v>
                </c:pt>
                <c:pt idx="1046">
                  <c:v>2.7183263888888889</c:v>
                </c:pt>
                <c:pt idx="1047">
                  <c:v>2.7198333333333333</c:v>
                </c:pt>
                <c:pt idx="1048">
                  <c:v>2.7213472222222221</c:v>
                </c:pt>
                <c:pt idx="1049">
                  <c:v>2.7228541666666666</c:v>
                </c:pt>
                <c:pt idx="1050">
                  <c:v>2.7243680555555558</c:v>
                </c:pt>
                <c:pt idx="1051">
                  <c:v>2.7258819444444446</c:v>
                </c:pt>
                <c:pt idx="1052">
                  <c:v>2.7273888888888891</c:v>
                </c:pt>
                <c:pt idx="1053">
                  <c:v>2.7289027777777779</c:v>
                </c:pt>
                <c:pt idx="1054">
                  <c:v>2.7304097222222223</c:v>
                </c:pt>
                <c:pt idx="1055">
                  <c:v>2.7319236111111111</c:v>
                </c:pt>
                <c:pt idx="1056">
                  <c:v>2.7334305555555556</c:v>
                </c:pt>
                <c:pt idx="1057">
                  <c:v>2.7349444444444444</c:v>
                </c:pt>
                <c:pt idx="1058">
                  <c:v>2.7364513888888888</c:v>
                </c:pt>
                <c:pt idx="1059">
                  <c:v>2.7379652777777777</c:v>
                </c:pt>
                <c:pt idx="1060">
                  <c:v>2.7394722222222225</c:v>
                </c:pt>
                <c:pt idx="1061">
                  <c:v>2.7409861111111109</c:v>
                </c:pt>
                <c:pt idx="1062">
                  <c:v>2.7422361111111111</c:v>
                </c:pt>
                <c:pt idx="1063">
                  <c:v>2.7434930555555557</c:v>
                </c:pt>
                <c:pt idx="1064">
                  <c:v>2.7447430555555554</c:v>
                </c:pt>
                <c:pt idx="1065">
                  <c:v>2.746</c:v>
                </c:pt>
                <c:pt idx="1066">
                  <c:v>2.7461805555555556</c:v>
                </c:pt>
                <c:pt idx="1067">
                  <c:v>2.7463611111111113</c:v>
                </c:pt>
                <c:pt idx="1068">
                  <c:v>2.7465416666666664</c:v>
                </c:pt>
                <c:pt idx="1069">
                  <c:v>2.7467291666666664</c:v>
                </c:pt>
                <c:pt idx="1070">
                  <c:v>2.7469097222222225</c:v>
                </c:pt>
                <c:pt idx="1071">
                  <c:v>2.7472013888888887</c:v>
                </c:pt>
                <c:pt idx="1072">
                  <c:v>2.7474930555555557</c:v>
                </c:pt>
                <c:pt idx="1073">
                  <c:v>2.7477916666666666</c:v>
                </c:pt>
                <c:pt idx="1074">
                  <c:v>2.7480833333333332</c:v>
                </c:pt>
                <c:pt idx="1075">
                  <c:v>2.7486388888888889</c:v>
                </c:pt>
                <c:pt idx="1076">
                  <c:v>2.7491875000000001</c:v>
                </c:pt>
                <c:pt idx="1077">
                  <c:v>2.7497430555555558</c:v>
                </c:pt>
                <c:pt idx="1078">
                  <c:v>2.750298611111111</c:v>
                </c:pt>
                <c:pt idx="1079">
                  <c:v>2.7509791666666668</c:v>
                </c:pt>
                <c:pt idx="1080">
                  <c:v>2.7516666666666669</c:v>
                </c:pt>
                <c:pt idx="1081">
                  <c:v>2.7523472222222223</c:v>
                </c:pt>
                <c:pt idx="1082">
                  <c:v>2.753034722222222</c:v>
                </c:pt>
                <c:pt idx="1083">
                  <c:v>2.7537152777777778</c:v>
                </c:pt>
                <c:pt idx="1084">
                  <c:v>2.754402777777778</c:v>
                </c:pt>
                <c:pt idx="1085">
                  <c:v>2.7550833333333333</c:v>
                </c:pt>
                <c:pt idx="1086">
                  <c:v>2.7556319444444446</c:v>
                </c:pt>
                <c:pt idx="1087">
                  <c:v>2.7561805555555554</c:v>
                </c:pt>
                <c:pt idx="1088">
                  <c:v>2.7567291666666667</c:v>
                </c:pt>
                <c:pt idx="1089">
                  <c:v>2.7572777777777779</c:v>
                </c:pt>
                <c:pt idx="1090">
                  <c:v>2.7578263888888888</c:v>
                </c:pt>
                <c:pt idx="1091">
                  <c:v>2.758375</c:v>
                </c:pt>
                <c:pt idx="1092">
                  <c:v>2.7589166666666669</c:v>
                </c:pt>
                <c:pt idx="1093">
                  <c:v>2.7594652777777777</c:v>
                </c:pt>
                <c:pt idx="1094">
                  <c:v>2.7599166666666668</c:v>
                </c:pt>
                <c:pt idx="1095">
                  <c:v>2.7603680555555554</c:v>
                </c:pt>
                <c:pt idx="1096">
                  <c:v>2.7604305555555557</c:v>
                </c:pt>
                <c:pt idx="1097">
                  <c:v>2.7604930555555556</c:v>
                </c:pt>
                <c:pt idx="1098">
                  <c:v>2.7605555555555554</c:v>
                </c:pt>
                <c:pt idx="1099">
                  <c:v>2.7606180555555557</c:v>
                </c:pt>
                <c:pt idx="1100">
                  <c:v>2.7607361111111111</c:v>
                </c:pt>
                <c:pt idx="1101">
                  <c:v>2.7608611111111112</c:v>
                </c:pt>
                <c:pt idx="1102">
                  <c:v>2.7609861111111114</c:v>
                </c:pt>
                <c:pt idx="1103">
                  <c:v>2.7612013888888889</c:v>
                </c:pt>
                <c:pt idx="1104">
                  <c:v>2.7614166666666669</c:v>
                </c:pt>
                <c:pt idx="1105">
                  <c:v>2.761625</c:v>
                </c:pt>
                <c:pt idx="1106">
                  <c:v>2.761840277777778</c:v>
                </c:pt>
                <c:pt idx="1107">
                  <c:v>2.7621944444444444</c:v>
                </c:pt>
                <c:pt idx="1108">
                  <c:v>2.7625486111111113</c:v>
                </c:pt>
                <c:pt idx="1109">
                  <c:v>2.7629027777777777</c:v>
                </c:pt>
                <c:pt idx="1110">
                  <c:v>2.7632569444444446</c:v>
                </c:pt>
                <c:pt idx="1111">
                  <c:v>2.7638472222222221</c:v>
                </c:pt>
                <c:pt idx="1112">
                  <c:v>2.7644305555555557</c:v>
                </c:pt>
                <c:pt idx="1113">
                  <c:v>2.7650138888888889</c:v>
                </c:pt>
                <c:pt idx="1114">
                  <c:v>2.765597222222222</c:v>
                </c:pt>
                <c:pt idx="1115">
                  <c:v>2.7661875</c:v>
                </c:pt>
                <c:pt idx="1116">
                  <c:v>2.7669444444444444</c:v>
                </c:pt>
                <c:pt idx="1117">
                  <c:v>2.7677083333333332</c:v>
                </c:pt>
                <c:pt idx="1118">
                  <c:v>2.768472222222222</c:v>
                </c:pt>
                <c:pt idx="1119">
                  <c:v>2.7692361111111108</c:v>
                </c:pt>
                <c:pt idx="1120">
                  <c:v>2.77</c:v>
                </c:pt>
                <c:pt idx="1121">
                  <c:v>2.7709166666666665</c:v>
                </c:pt>
                <c:pt idx="1122">
                  <c:v>2.771826388888889</c:v>
                </c:pt>
                <c:pt idx="1123">
                  <c:v>2.7727430555555554</c:v>
                </c:pt>
                <c:pt idx="1124">
                  <c:v>2.7735069444444442</c:v>
                </c:pt>
                <c:pt idx="1125">
                  <c:v>2.7742638888888891</c:v>
                </c:pt>
                <c:pt idx="1126">
                  <c:v>2.7750277777777779</c:v>
                </c:pt>
                <c:pt idx="1127">
                  <c:v>2.7757847222222223</c:v>
                </c:pt>
                <c:pt idx="1128">
                  <c:v>2.7765416666666667</c:v>
                </c:pt>
                <c:pt idx="1129">
                  <c:v>2.7766944444444444</c:v>
                </c:pt>
                <c:pt idx="1130">
                  <c:v>2.776847222222222</c:v>
                </c:pt>
                <c:pt idx="1131">
                  <c:v>2.7770000000000001</c:v>
                </c:pt>
                <c:pt idx="1132">
                  <c:v>2.7771527777777778</c:v>
                </c:pt>
                <c:pt idx="1133">
                  <c:v>2.7773055555555555</c:v>
                </c:pt>
                <c:pt idx="1134">
                  <c:v>2.7775763888888889</c:v>
                </c:pt>
                <c:pt idx="1135">
                  <c:v>2.7778472222222224</c:v>
                </c:pt>
                <c:pt idx="1136">
                  <c:v>2.7781180555555554</c:v>
                </c:pt>
                <c:pt idx="1137">
                  <c:v>2.7783819444444444</c:v>
                </c:pt>
                <c:pt idx="1138">
                  <c:v>2.7788124999999999</c:v>
                </c:pt>
                <c:pt idx="1139">
                  <c:v>2.779236111111111</c:v>
                </c:pt>
                <c:pt idx="1140">
                  <c:v>2.7796597222222221</c:v>
                </c:pt>
                <c:pt idx="1141">
                  <c:v>2.7800833333333332</c:v>
                </c:pt>
                <c:pt idx="1142">
                  <c:v>2.7806736111111112</c:v>
                </c:pt>
                <c:pt idx="1143">
                  <c:v>2.7812569444444444</c:v>
                </c:pt>
                <c:pt idx="1144">
                  <c:v>2.7818402777777775</c:v>
                </c:pt>
                <c:pt idx="1145">
                  <c:v>2.7824236111111111</c:v>
                </c:pt>
                <c:pt idx="1146">
                  <c:v>2.782513888888889</c:v>
                </c:pt>
                <c:pt idx="1147">
                  <c:v>2.7825972222222224</c:v>
                </c:pt>
                <c:pt idx="1148">
                  <c:v>2.7826875000000002</c:v>
                </c:pt>
                <c:pt idx="1149">
                  <c:v>2.7827777777777776</c:v>
                </c:pt>
                <c:pt idx="1150">
                  <c:v>2.7829097222222221</c:v>
                </c:pt>
                <c:pt idx="1151">
                  <c:v>2.783048611111111</c:v>
                </c:pt>
                <c:pt idx="1152">
                  <c:v>2.7831874999999999</c:v>
                </c:pt>
                <c:pt idx="1153">
                  <c:v>2.7833263888888888</c:v>
                </c:pt>
                <c:pt idx="1154">
                  <c:v>2.7836319444444442</c:v>
                </c:pt>
                <c:pt idx="1155">
                  <c:v>2.7839375</c:v>
                </c:pt>
                <c:pt idx="1156">
                  <c:v>2.7842430555555557</c:v>
                </c:pt>
                <c:pt idx="1157">
                  <c:v>2.7845555555555559</c:v>
                </c:pt>
                <c:pt idx="1158">
                  <c:v>2.7850555555555556</c:v>
                </c:pt>
                <c:pt idx="1159">
                  <c:v>2.7855555555555553</c:v>
                </c:pt>
                <c:pt idx="1160">
                  <c:v>2.7860555555555555</c:v>
                </c:pt>
                <c:pt idx="1161">
                  <c:v>2.7865555555555557</c:v>
                </c:pt>
                <c:pt idx="1162">
                  <c:v>2.7870555555555558</c:v>
                </c:pt>
                <c:pt idx="1163">
                  <c:v>2.7877430555555556</c:v>
                </c:pt>
                <c:pt idx="1164">
                  <c:v>2.7884236111111109</c:v>
                </c:pt>
                <c:pt idx="1165">
                  <c:v>2.7891041666666667</c:v>
                </c:pt>
                <c:pt idx="1166">
                  <c:v>2.7897847222222221</c:v>
                </c:pt>
                <c:pt idx="1167">
                  <c:v>2.7904652777777779</c:v>
                </c:pt>
                <c:pt idx="1168">
                  <c:v>2.7913819444444448</c:v>
                </c:pt>
                <c:pt idx="1169">
                  <c:v>2.7922916666666668</c:v>
                </c:pt>
                <c:pt idx="1170">
                  <c:v>2.7932013888888889</c:v>
                </c:pt>
                <c:pt idx="1171">
                  <c:v>2.7941180555555558</c:v>
                </c:pt>
                <c:pt idx="1172">
                  <c:v>2.7950277777777779</c:v>
                </c:pt>
                <c:pt idx="1173">
                  <c:v>2.7951736111111112</c:v>
                </c:pt>
                <c:pt idx="1174">
                  <c:v>2.7953194444444445</c:v>
                </c:pt>
                <c:pt idx="1175">
                  <c:v>2.7954652777777778</c:v>
                </c:pt>
                <c:pt idx="1176">
                  <c:v>2.7956180555555554</c:v>
                </c:pt>
                <c:pt idx="1177">
                  <c:v>2.7957638888888892</c:v>
                </c:pt>
                <c:pt idx="1178">
                  <c:v>2.7959791666666667</c:v>
                </c:pt>
                <c:pt idx="1179">
                  <c:v>2.7961944444444446</c:v>
                </c:pt>
                <c:pt idx="1180">
                  <c:v>2.7964097222222222</c:v>
                </c:pt>
                <c:pt idx="1181">
                  <c:v>2.7966249999999997</c:v>
                </c:pt>
                <c:pt idx="1182">
                  <c:v>2.7968402777777777</c:v>
                </c:pt>
                <c:pt idx="1183">
                  <c:v>2.7972569444444444</c:v>
                </c:pt>
                <c:pt idx="1184">
                  <c:v>2.7976666666666667</c:v>
                </c:pt>
                <c:pt idx="1185">
                  <c:v>2.798083333333333</c:v>
                </c:pt>
                <c:pt idx="1186">
                  <c:v>2.7984930555555554</c:v>
                </c:pt>
                <c:pt idx="1187">
                  <c:v>2.7989097222222221</c:v>
                </c:pt>
                <c:pt idx="1188">
                  <c:v>2.7997013888888889</c:v>
                </c:pt>
                <c:pt idx="1189">
                  <c:v>2.8004930555555556</c:v>
                </c:pt>
                <c:pt idx="1190">
                  <c:v>2.8012847222222224</c:v>
                </c:pt>
                <c:pt idx="1191">
                  <c:v>2.8020763888888887</c:v>
                </c:pt>
                <c:pt idx="1192">
                  <c:v>2.802861111111111</c:v>
                </c:pt>
                <c:pt idx="1193">
                  <c:v>2.8036527777777778</c:v>
                </c:pt>
                <c:pt idx="1194">
                  <c:v>2.8044444444444445</c:v>
                </c:pt>
                <c:pt idx="1195">
                  <c:v>2.8052361111111113</c:v>
                </c:pt>
                <c:pt idx="1196">
                  <c:v>2.8062708333333335</c:v>
                </c:pt>
                <c:pt idx="1197">
                  <c:v>2.8073125000000001</c:v>
                </c:pt>
                <c:pt idx="1198">
                  <c:v>2.8083472222222223</c:v>
                </c:pt>
                <c:pt idx="1199">
                  <c:v>2.8084930555555556</c:v>
                </c:pt>
                <c:pt idx="1200">
                  <c:v>2.8086319444444445</c:v>
                </c:pt>
                <c:pt idx="1201">
                  <c:v>2.8087777777777778</c:v>
                </c:pt>
                <c:pt idx="1202">
                  <c:v>2.8089166666666667</c:v>
                </c:pt>
                <c:pt idx="1203">
                  <c:v>2.8090625</c:v>
                </c:pt>
                <c:pt idx="1204">
                  <c:v>2.8092986111111111</c:v>
                </c:pt>
                <c:pt idx="1205">
                  <c:v>2.8095277777777778</c:v>
                </c:pt>
                <c:pt idx="1206">
                  <c:v>2.8097638888888889</c:v>
                </c:pt>
                <c:pt idx="1207">
                  <c:v>2.8099930555555557</c:v>
                </c:pt>
                <c:pt idx="1208">
                  <c:v>2.8103819444444444</c:v>
                </c:pt>
                <c:pt idx="1209">
                  <c:v>2.8107638888888888</c:v>
                </c:pt>
                <c:pt idx="1210">
                  <c:v>2.8111527777777776</c:v>
                </c:pt>
                <c:pt idx="1211">
                  <c:v>2.8115347222222224</c:v>
                </c:pt>
                <c:pt idx="1212">
                  <c:v>2.8122361111111109</c:v>
                </c:pt>
                <c:pt idx="1213">
                  <c:v>2.8129374999999999</c:v>
                </c:pt>
                <c:pt idx="1214">
                  <c:v>2.8135138888888891</c:v>
                </c:pt>
                <c:pt idx="1215">
                  <c:v>2.8140902777777779</c:v>
                </c:pt>
                <c:pt idx="1216">
                  <c:v>2.8146597222222223</c:v>
                </c:pt>
                <c:pt idx="1217">
                  <c:v>2.8152361111111111</c:v>
                </c:pt>
                <c:pt idx="1218">
                  <c:v>2.8158124999999998</c:v>
                </c:pt>
                <c:pt idx="1219">
                  <c:v>2.8163888888888886</c:v>
                </c:pt>
                <c:pt idx="1220">
                  <c:v>2.8169583333333335</c:v>
                </c:pt>
                <c:pt idx="1221">
                  <c:v>2.8175347222222222</c:v>
                </c:pt>
                <c:pt idx="1222">
                  <c:v>2.817652777777778</c:v>
                </c:pt>
                <c:pt idx="1223">
                  <c:v>2.8177708333333333</c:v>
                </c:pt>
                <c:pt idx="1224">
                  <c:v>2.8178888888888891</c:v>
                </c:pt>
                <c:pt idx="1225">
                  <c:v>2.8180069444444444</c:v>
                </c:pt>
                <c:pt idx="1226">
                  <c:v>2.8181249999999998</c:v>
                </c:pt>
                <c:pt idx="1227">
                  <c:v>2.8183680555555553</c:v>
                </c:pt>
                <c:pt idx="1228">
                  <c:v>2.8186041666666668</c:v>
                </c:pt>
                <c:pt idx="1229">
                  <c:v>2.8188402777777779</c:v>
                </c:pt>
                <c:pt idx="1230">
                  <c:v>2.8190763888888886</c:v>
                </c:pt>
                <c:pt idx="1231">
                  <c:v>2.8195416666666664</c:v>
                </c:pt>
                <c:pt idx="1232">
                  <c:v>2.8200069444444442</c:v>
                </c:pt>
                <c:pt idx="1233">
                  <c:v>2.820472222222222</c:v>
                </c:pt>
                <c:pt idx="1234">
                  <c:v>2.8209444444444443</c:v>
                </c:pt>
                <c:pt idx="1235">
                  <c:v>2.8216041666666669</c:v>
                </c:pt>
                <c:pt idx="1236">
                  <c:v>2.8222708333333335</c:v>
                </c:pt>
                <c:pt idx="1237">
                  <c:v>2.8229305555555557</c:v>
                </c:pt>
                <c:pt idx="1238">
                  <c:v>2.8235972222222223</c:v>
                </c:pt>
                <c:pt idx="1239">
                  <c:v>2.8242638888888889</c:v>
                </c:pt>
                <c:pt idx="1240">
                  <c:v>2.8250486111111113</c:v>
                </c:pt>
                <c:pt idx="1241">
                  <c:v>2.8256666666666668</c:v>
                </c:pt>
                <c:pt idx="1242">
                  <c:v>2.8262847222222223</c:v>
                </c:pt>
                <c:pt idx="1243">
                  <c:v>2.8269027777777778</c:v>
                </c:pt>
                <c:pt idx="1244">
                  <c:v>2.8275138888888889</c:v>
                </c:pt>
                <c:pt idx="1245">
                  <c:v>2.8276041666666667</c:v>
                </c:pt>
                <c:pt idx="1246">
                  <c:v>2.8276875000000001</c:v>
                </c:pt>
                <c:pt idx="1247">
                  <c:v>2.8277777777777779</c:v>
                </c:pt>
                <c:pt idx="1248">
                  <c:v>2.8278611111111109</c:v>
                </c:pt>
                <c:pt idx="1249">
                  <c:v>2.8280347222222222</c:v>
                </c:pt>
                <c:pt idx="1250">
                  <c:v>2.8282083333333334</c:v>
                </c:pt>
                <c:pt idx="1251">
                  <c:v>2.8283819444444442</c:v>
                </c:pt>
                <c:pt idx="1252">
                  <c:v>2.8286180555555558</c:v>
                </c:pt>
                <c:pt idx="1253">
                  <c:v>2.8288472222222221</c:v>
                </c:pt>
                <c:pt idx="1254">
                  <c:v>2.8290833333333336</c:v>
                </c:pt>
                <c:pt idx="1255">
                  <c:v>2.8293124999999999</c:v>
                </c:pt>
                <c:pt idx="1256">
                  <c:v>2.8296319444444444</c:v>
                </c:pt>
                <c:pt idx="1257">
                  <c:v>2.8299583333333334</c:v>
                </c:pt>
                <c:pt idx="1258">
                  <c:v>2.8302777777777779</c:v>
                </c:pt>
                <c:pt idx="1259">
                  <c:v>2.830597222222222</c:v>
                </c:pt>
                <c:pt idx="1260">
                  <c:v>2.8311666666666668</c:v>
                </c:pt>
                <c:pt idx="1261">
                  <c:v>2.8317291666666669</c:v>
                </c:pt>
                <c:pt idx="1262">
                  <c:v>2.8322916666666669</c:v>
                </c:pt>
                <c:pt idx="1263">
                  <c:v>2.8328541666666665</c:v>
                </c:pt>
                <c:pt idx="1264">
                  <c:v>2.8334236111111113</c:v>
                </c:pt>
                <c:pt idx="1265">
                  <c:v>2.8343124999999998</c:v>
                </c:pt>
                <c:pt idx="1266">
                  <c:v>2.8352013888888887</c:v>
                </c:pt>
                <c:pt idx="1267">
                  <c:v>2.8360833333333333</c:v>
                </c:pt>
                <c:pt idx="1268">
                  <c:v>2.8369722222222222</c:v>
                </c:pt>
                <c:pt idx="1269">
                  <c:v>2.8378611111111112</c:v>
                </c:pt>
                <c:pt idx="1270">
                  <c:v>2.8391388888888889</c:v>
                </c:pt>
                <c:pt idx="1271">
                  <c:v>2.8404097222222222</c:v>
                </c:pt>
                <c:pt idx="1272">
                  <c:v>2.8416874999999999</c:v>
                </c:pt>
                <c:pt idx="1273">
                  <c:v>2.8429652777777776</c:v>
                </c:pt>
                <c:pt idx="1274">
                  <c:v>2.844236111111111</c:v>
                </c:pt>
                <c:pt idx="1275">
                  <c:v>2.8455138888888887</c:v>
                </c:pt>
                <c:pt idx="1276">
                  <c:v>2.846784722222222</c:v>
                </c:pt>
                <c:pt idx="1277">
                  <c:v>2.8480625000000002</c:v>
                </c:pt>
                <c:pt idx="1278">
                  <c:v>2.8493402777777779</c:v>
                </c:pt>
                <c:pt idx="1279">
                  <c:v>2.8506111111111112</c:v>
                </c:pt>
                <c:pt idx="1280">
                  <c:v>2.8518888888888889</c:v>
                </c:pt>
                <c:pt idx="1281">
                  <c:v>2.8531597222222222</c:v>
                </c:pt>
                <c:pt idx="1282">
                  <c:v>2.8549513888888889</c:v>
                </c:pt>
                <c:pt idx="1283">
                  <c:v>2.8567361111111111</c:v>
                </c:pt>
                <c:pt idx="1284">
                  <c:v>2.8585277777777778</c:v>
                </c:pt>
                <c:pt idx="1285">
                  <c:v>2.8603125</c:v>
                </c:pt>
                <c:pt idx="1286">
                  <c:v>2.8621041666666667</c:v>
                </c:pt>
                <c:pt idx="1287">
                  <c:v>2.8638888888888889</c:v>
                </c:pt>
                <c:pt idx="1288">
                  <c:v>2.8656805555555556</c:v>
                </c:pt>
                <c:pt idx="1289">
                  <c:v>2.8674652777777774</c:v>
                </c:pt>
                <c:pt idx="1290">
                  <c:v>2.869256944444444</c:v>
                </c:pt>
                <c:pt idx="1291">
                  <c:v>2.8710416666666667</c:v>
                </c:pt>
                <c:pt idx="1292">
                  <c:v>2.8728333333333333</c:v>
                </c:pt>
                <c:pt idx="1293">
                  <c:v>2.8746180555555556</c:v>
                </c:pt>
                <c:pt idx="1294">
                  <c:v>2.8766388888888885</c:v>
                </c:pt>
                <c:pt idx="1295">
                  <c:v>2.8786597222222223</c:v>
                </c:pt>
                <c:pt idx="1296">
                  <c:v>2.8806736111111113</c:v>
                </c:pt>
                <c:pt idx="1297">
                  <c:v>2.8826944444444442</c:v>
                </c:pt>
                <c:pt idx="1298">
                  <c:v>2.8843749999999999</c:v>
                </c:pt>
                <c:pt idx="1299">
                  <c:v>2.8860486111111112</c:v>
                </c:pt>
                <c:pt idx="1300">
                  <c:v>2.8877291666666665</c:v>
                </c:pt>
                <c:pt idx="1301">
                  <c:v>2.8894097222222221</c:v>
                </c:pt>
                <c:pt idx="1302">
                  <c:v>2.8910833333333334</c:v>
                </c:pt>
                <c:pt idx="1303">
                  <c:v>2.8927638888888887</c:v>
                </c:pt>
                <c:pt idx="1304">
                  <c:v>2.8931111111111112</c:v>
                </c:pt>
                <c:pt idx="1305">
                  <c:v>2.8934583333333332</c:v>
                </c:pt>
                <c:pt idx="1306">
                  <c:v>2.8938055555555553</c:v>
                </c:pt>
                <c:pt idx="1307">
                  <c:v>2.8941527777777778</c:v>
                </c:pt>
                <c:pt idx="1308">
                  <c:v>2.8944999999999999</c:v>
                </c:pt>
                <c:pt idx="1309">
                  <c:v>2.8948472222222223</c:v>
                </c:pt>
                <c:pt idx="1310">
                  <c:v>2.895402777777778</c:v>
                </c:pt>
                <c:pt idx="1311">
                  <c:v>2.8959513888888888</c:v>
                </c:pt>
                <c:pt idx="1312">
                  <c:v>2.8965000000000001</c:v>
                </c:pt>
                <c:pt idx="1313">
                  <c:v>2.8970486111111109</c:v>
                </c:pt>
                <c:pt idx="1314">
                  <c:v>2.8975972222222222</c:v>
                </c:pt>
                <c:pt idx="1315">
                  <c:v>2.8981458333333334</c:v>
                </c:pt>
                <c:pt idx="1316">
                  <c:v>2.8990972222222222</c:v>
                </c:pt>
                <c:pt idx="1317">
                  <c:v>2.900048611111111</c:v>
                </c:pt>
                <c:pt idx="1318">
                  <c:v>2.9009999999999998</c:v>
                </c:pt>
                <c:pt idx="1319">
                  <c:v>2.901951388888889</c:v>
                </c:pt>
                <c:pt idx="1320">
                  <c:v>2.9029027777777778</c:v>
                </c:pt>
                <c:pt idx="1321">
                  <c:v>2.9038541666666666</c:v>
                </c:pt>
                <c:pt idx="1322">
                  <c:v>2.9061944444444445</c:v>
                </c:pt>
                <c:pt idx="1323">
                  <c:v>2.908534722222222</c:v>
                </c:pt>
                <c:pt idx="1324">
                  <c:v>2.9108680555555555</c:v>
                </c:pt>
                <c:pt idx="1325">
                  <c:v>2.9132083333333338</c:v>
                </c:pt>
                <c:pt idx="1326">
                  <c:v>2.9155486111111113</c:v>
                </c:pt>
                <c:pt idx="1327">
                  <c:v>2.9178819444444444</c:v>
                </c:pt>
                <c:pt idx="1328">
                  <c:v>2.921013888888889</c:v>
                </c:pt>
                <c:pt idx="1329">
                  <c:v>2.9241458333333337</c:v>
                </c:pt>
                <c:pt idx="1330">
                  <c:v>2.9272777777777774</c:v>
                </c:pt>
                <c:pt idx="1331">
                  <c:v>2.9304097222222221</c:v>
                </c:pt>
                <c:pt idx="1332">
                  <c:v>2.9335416666666667</c:v>
                </c:pt>
                <c:pt idx="1333">
                  <c:v>2.9366736111111114</c:v>
                </c:pt>
                <c:pt idx="1334">
                  <c:v>2.9404999999999997</c:v>
                </c:pt>
                <c:pt idx="1335">
                  <c:v>2.944319444444444</c:v>
                </c:pt>
                <c:pt idx="1336">
                  <c:v>2.9481388888888889</c:v>
                </c:pt>
                <c:pt idx="1337">
                  <c:v>2.9519583333333332</c:v>
                </c:pt>
                <c:pt idx="1338">
                  <c:v>2.9557777777777776</c:v>
                </c:pt>
                <c:pt idx="1339">
                  <c:v>2.959597222222222</c:v>
                </c:pt>
                <c:pt idx="1340">
                  <c:v>2.9634166666666664</c:v>
                </c:pt>
                <c:pt idx="1341">
                  <c:v>2.9672361111111107</c:v>
                </c:pt>
                <c:pt idx="1342">
                  <c:v>2.9710555555555556</c:v>
                </c:pt>
                <c:pt idx="1343">
                  <c:v>2.9748749999999999</c:v>
                </c:pt>
                <c:pt idx="1344">
                  <c:v>2.9786944444444443</c:v>
                </c:pt>
                <c:pt idx="1345">
                  <c:v>2.9825138888888887</c:v>
                </c:pt>
                <c:pt idx="1346">
                  <c:v>2.9863333333333331</c:v>
                </c:pt>
                <c:pt idx="1347">
                  <c:v>2.987034722222222</c:v>
                </c:pt>
                <c:pt idx="1348">
                  <c:v>2.9877361111111114</c:v>
                </c:pt>
                <c:pt idx="1349">
                  <c:v>2.9884305555555555</c:v>
                </c:pt>
                <c:pt idx="1350">
                  <c:v>2.9891319444444449</c:v>
                </c:pt>
                <c:pt idx="1351">
                  <c:v>2.9898333333333329</c:v>
                </c:pt>
                <c:pt idx="1352">
                  <c:v>2.9912291666666664</c:v>
                </c:pt>
                <c:pt idx="1353">
                  <c:v>2.9926249999999999</c:v>
                </c:pt>
                <c:pt idx="1354">
                  <c:v>2.9940208333333334</c:v>
                </c:pt>
                <c:pt idx="1355">
                  <c:v>2.9954236111111112</c:v>
                </c:pt>
                <c:pt idx="1356">
                  <c:v>2.9968194444444447</c:v>
                </c:pt>
                <c:pt idx="1357">
                  <c:v>3.0001944444444444</c:v>
                </c:pt>
                <c:pt idx="1358">
                  <c:v>3.0035763888888884</c:v>
                </c:pt>
                <c:pt idx="1359">
                  <c:v>3.006951388888889</c:v>
                </c:pt>
                <c:pt idx="1360">
                  <c:v>3.0103333333333335</c:v>
                </c:pt>
                <c:pt idx="1361">
                  <c:v>3.0137083333333332</c:v>
                </c:pt>
                <c:pt idx="1362">
                  <c:v>3.0192916666666667</c:v>
                </c:pt>
                <c:pt idx="1363">
                  <c:v>3.0248680555555558</c:v>
                </c:pt>
                <c:pt idx="1364">
                  <c:v>3.0304513888888893</c:v>
                </c:pt>
                <c:pt idx="1365">
                  <c:v>3.036027777777778</c:v>
                </c:pt>
                <c:pt idx="1366">
                  <c:v>3.0416041666666667</c:v>
                </c:pt>
                <c:pt idx="1367">
                  <c:v>3.0471874999999997</c:v>
                </c:pt>
                <c:pt idx="1368">
                  <c:v>3.0558472222222224</c:v>
                </c:pt>
                <c:pt idx="1369">
                  <c:v>3.0645138888888885</c:v>
                </c:pt>
                <c:pt idx="1370">
                  <c:v>3.0731736111111112</c:v>
                </c:pt>
                <c:pt idx="1371">
                  <c:v>3.0818402777777782</c:v>
                </c:pt>
                <c:pt idx="1372">
                  <c:v>3.0904999999999996</c:v>
                </c:pt>
                <c:pt idx="1373">
                  <c:v>3.0991666666666666</c:v>
                </c:pt>
                <c:pt idx="1374">
                  <c:v>3.1078333333333332</c:v>
                </c:pt>
                <c:pt idx="1375">
                  <c:v>3.1164930555555554</c:v>
                </c:pt>
                <c:pt idx="1376">
                  <c:v>3.125159722222222</c:v>
                </c:pt>
                <c:pt idx="1377">
                  <c:v>3.1338194444444443</c:v>
                </c:pt>
                <c:pt idx="1378">
                  <c:v>3.1424861111111113</c:v>
                </c:pt>
                <c:pt idx="1379">
                  <c:v>3.1511458333333331</c:v>
                </c:pt>
                <c:pt idx="1380">
                  <c:v>3.1598125000000001</c:v>
                </c:pt>
                <c:pt idx="1381">
                  <c:v>3.1684722222222224</c:v>
                </c:pt>
                <c:pt idx="1382">
                  <c:v>3.177138888888889</c:v>
                </c:pt>
                <c:pt idx="1383">
                  <c:v>3.1857986111111112</c:v>
                </c:pt>
                <c:pt idx="1384">
                  <c:v>3.1944652777777778</c:v>
                </c:pt>
                <c:pt idx="1385">
                  <c:v>3.203125</c:v>
                </c:pt>
                <c:pt idx="1386">
                  <c:v>3.2117916666666662</c:v>
                </c:pt>
                <c:pt idx="1387">
                  <c:v>3.2204513888888888</c:v>
                </c:pt>
                <c:pt idx="1388">
                  <c:v>3.2291180555555559</c:v>
                </c:pt>
                <c:pt idx="1389">
                  <c:v>3.2377777777777776</c:v>
                </c:pt>
                <c:pt idx="1390">
                  <c:v>3.2464444444444447</c:v>
                </c:pt>
                <c:pt idx="1391">
                  <c:v>3.2551111111111108</c:v>
                </c:pt>
                <c:pt idx="1392">
                  <c:v>3.2637708333333331</c:v>
                </c:pt>
                <c:pt idx="1393">
                  <c:v>3.2724375000000001</c:v>
                </c:pt>
                <c:pt idx="1394">
                  <c:v>3.2810972222222219</c:v>
                </c:pt>
                <c:pt idx="1395">
                  <c:v>3.2897638888888889</c:v>
                </c:pt>
                <c:pt idx="1396">
                  <c:v>3.2984236111111107</c:v>
                </c:pt>
                <c:pt idx="1397">
                  <c:v>3.3070902777777778</c:v>
                </c:pt>
                <c:pt idx="1398">
                  <c:v>3.3157500000000004</c:v>
                </c:pt>
                <c:pt idx="1399">
                  <c:v>3.3244166666666666</c:v>
                </c:pt>
                <c:pt idx="1400">
                  <c:v>3.3330763888888888</c:v>
                </c:pt>
                <c:pt idx="1401">
                  <c:v>3.3417430555555554</c:v>
                </c:pt>
                <c:pt idx="1402">
                  <c:v>3.3504027777777776</c:v>
                </c:pt>
                <c:pt idx="1403">
                  <c:v>3.3590694444444447</c:v>
                </c:pt>
                <c:pt idx="1404">
                  <c:v>3.3677291666666664</c:v>
                </c:pt>
                <c:pt idx="1405">
                  <c:v>3.3763958333333335</c:v>
                </c:pt>
                <c:pt idx="1406">
                  <c:v>3.3850555555555553</c:v>
                </c:pt>
                <c:pt idx="1407">
                  <c:v>3.3937222222222223</c:v>
                </c:pt>
                <c:pt idx="1408">
                  <c:v>3.4023888888888885</c:v>
                </c:pt>
                <c:pt idx="1409">
                  <c:v>3.4110486111111111</c:v>
                </c:pt>
                <c:pt idx="1410">
                  <c:v>3.4197152777777782</c:v>
                </c:pt>
                <c:pt idx="1411">
                  <c:v>3.428375</c:v>
                </c:pt>
                <c:pt idx="1412">
                  <c:v>3.4370416666666666</c:v>
                </c:pt>
                <c:pt idx="1413">
                  <c:v>3.4467083333333335</c:v>
                </c:pt>
                <c:pt idx="1414">
                  <c:v>3.4563750000000004</c:v>
                </c:pt>
                <c:pt idx="1415">
                  <c:v>3.4660416666666669</c:v>
                </c:pt>
                <c:pt idx="1416">
                  <c:v>3.4757083333333338</c:v>
                </c:pt>
                <c:pt idx="1417">
                  <c:v>3.4853749999999999</c:v>
                </c:pt>
                <c:pt idx="1418">
                  <c:v>3.4950416666666664</c:v>
                </c:pt>
                <c:pt idx="1419">
                  <c:v>3.5047083333333333</c:v>
                </c:pt>
                <c:pt idx="1420">
                  <c:v>3.5143749999999998</c:v>
                </c:pt>
                <c:pt idx="1421">
                  <c:v>3.5240416666666667</c:v>
                </c:pt>
                <c:pt idx="1422">
                  <c:v>3.5337083333333332</c:v>
                </c:pt>
                <c:pt idx="1423">
                  <c:v>3.5433750000000002</c:v>
                </c:pt>
                <c:pt idx="1424">
                  <c:v>3.5530416666666667</c:v>
                </c:pt>
                <c:pt idx="1425">
                  <c:v>3.5544999999999995</c:v>
                </c:pt>
                <c:pt idx="1426">
                  <c:v>3.5559652777777777</c:v>
                </c:pt>
                <c:pt idx="1427">
                  <c:v>3.5574236111111111</c:v>
                </c:pt>
                <c:pt idx="1428">
                  <c:v>3.5588888888888892</c:v>
                </c:pt>
                <c:pt idx="1429">
                  <c:v>3.5603472222222221</c:v>
                </c:pt>
                <c:pt idx="1430">
                  <c:v>3.5618125000000003</c:v>
                </c:pt>
                <c:pt idx="1431">
                  <c:v>3.5635694444444446</c:v>
                </c:pt>
                <c:pt idx="1432">
                  <c:v>3.5653263888888889</c:v>
                </c:pt>
                <c:pt idx="1433">
                  <c:v>3.5670833333333336</c:v>
                </c:pt>
                <c:pt idx="1434">
                  <c:v>3.5688402777777779</c:v>
                </c:pt>
                <c:pt idx="1435">
                  <c:v>3.5705972222222222</c:v>
                </c:pt>
                <c:pt idx="1436">
                  <c:v>3.5749236111111111</c:v>
                </c:pt>
                <c:pt idx="1437">
                  <c:v>3.5792430555555552</c:v>
                </c:pt>
                <c:pt idx="1438">
                  <c:v>3.5835624999999998</c:v>
                </c:pt>
                <c:pt idx="1439">
                  <c:v>3.5878888888888891</c:v>
                </c:pt>
                <c:pt idx="1440">
                  <c:v>3.5922083333333332</c:v>
                </c:pt>
                <c:pt idx="1441">
                  <c:v>3.5986666666666665</c:v>
                </c:pt>
                <c:pt idx="1442">
                  <c:v>3.6051250000000001</c:v>
                </c:pt>
                <c:pt idx="1443">
                  <c:v>3.611576388888889</c:v>
                </c:pt>
                <c:pt idx="1444">
                  <c:v>3.6180347222222222</c:v>
                </c:pt>
                <c:pt idx="1445">
                  <c:v>3.6244861111111111</c:v>
                </c:pt>
                <c:pt idx="1446">
                  <c:v>3.6309444444444448</c:v>
                </c:pt>
                <c:pt idx="1447">
                  <c:v>3.6374027777777775</c:v>
                </c:pt>
                <c:pt idx="1448">
                  <c:v>3.6438541666666664</c:v>
                </c:pt>
                <c:pt idx="1449">
                  <c:v>3.6503125000000001</c:v>
                </c:pt>
                <c:pt idx="1450">
                  <c:v>3.6567708333333333</c:v>
                </c:pt>
                <c:pt idx="1451">
                  <c:v>3.6632222222222222</c:v>
                </c:pt>
                <c:pt idx="1452">
                  <c:v>3.6696805555555558</c:v>
                </c:pt>
                <c:pt idx="1453">
                  <c:v>3.6761388888888891</c:v>
                </c:pt>
                <c:pt idx="1454">
                  <c:v>3.6825902777777779</c:v>
                </c:pt>
                <c:pt idx="1455">
                  <c:v>3.6890486111111107</c:v>
                </c:pt>
                <c:pt idx="1456">
                  <c:v>3.6955000000000005</c:v>
                </c:pt>
                <c:pt idx="1457">
                  <c:v>3.7019583333333332</c:v>
                </c:pt>
                <c:pt idx="1458">
                  <c:v>3.7073055555555561</c:v>
                </c:pt>
                <c:pt idx="1459">
                  <c:v>3.712652777777778</c:v>
                </c:pt>
                <c:pt idx="1460">
                  <c:v>3.718</c:v>
                </c:pt>
                <c:pt idx="1461">
                  <c:v>3.7233472222222224</c:v>
                </c:pt>
                <c:pt idx="1462">
                  <c:v>3.7286875000000004</c:v>
                </c:pt>
                <c:pt idx="1463">
                  <c:v>3.7340347222222223</c:v>
                </c:pt>
                <c:pt idx="1464">
                  <c:v>3.7393819444444443</c:v>
                </c:pt>
                <c:pt idx="1465">
                  <c:v>3.7447291666666667</c:v>
                </c:pt>
                <c:pt idx="1466">
                  <c:v>3.7500763888888886</c:v>
                </c:pt>
                <c:pt idx="1467">
                  <c:v>3.7544791666666666</c:v>
                </c:pt>
                <c:pt idx="1468">
                  <c:v>3.7588819444444446</c:v>
                </c:pt>
                <c:pt idx="1469">
                  <c:v>3.7632847222222221</c:v>
                </c:pt>
                <c:pt idx="1470">
                  <c:v>3.7676875000000001</c:v>
                </c:pt>
                <c:pt idx="1471">
                  <c:v>3.7720902777777781</c:v>
                </c:pt>
                <c:pt idx="1472">
                  <c:v>3.7764930555555551</c:v>
                </c:pt>
                <c:pt idx="1473">
                  <c:v>3.7808958333333331</c:v>
                </c:pt>
                <c:pt idx="1474">
                  <c:v>3.7852986111111111</c:v>
                </c:pt>
                <c:pt idx="1475">
                  <c:v>3.7887847222222226</c:v>
                </c:pt>
                <c:pt idx="1476">
                  <c:v>3.7913194444444445</c:v>
                </c:pt>
                <c:pt idx="1477">
                  <c:v>3.7938541666666663</c:v>
                </c:pt>
                <c:pt idx="1478">
                  <c:v>3.7943194444444441</c:v>
                </c:pt>
                <c:pt idx="1479">
                  <c:v>3.7944027777777776</c:v>
                </c:pt>
                <c:pt idx="1480">
                  <c:v>3.7944861111111114</c:v>
                </c:pt>
                <c:pt idx="1481">
                  <c:v>3.7945694444444444</c:v>
                </c:pt>
                <c:pt idx="1482">
                  <c:v>3.7946527777777779</c:v>
                </c:pt>
                <c:pt idx="1483">
                  <c:v>3.7948194444444443</c:v>
                </c:pt>
                <c:pt idx="1484">
                  <c:v>3.7949930555555556</c:v>
                </c:pt>
                <c:pt idx="1485">
                  <c:v>3.795159722222222</c:v>
                </c:pt>
                <c:pt idx="1486">
                  <c:v>3.7953263888888893</c:v>
                </c:pt>
                <c:pt idx="1487">
                  <c:v>3.7959166666666664</c:v>
                </c:pt>
                <c:pt idx="1488">
                  <c:v>3.7965138888888887</c:v>
                </c:pt>
                <c:pt idx="1489">
                  <c:v>3.7971111111111111</c:v>
                </c:pt>
                <c:pt idx="1490">
                  <c:v>3.797708333333333</c:v>
                </c:pt>
                <c:pt idx="1491">
                  <c:v>3.798965277777778</c:v>
                </c:pt>
                <c:pt idx="1492">
                  <c:v>3.8002291666666665</c:v>
                </c:pt>
                <c:pt idx="1493">
                  <c:v>3.8014861111111111</c:v>
                </c:pt>
                <c:pt idx="1494">
                  <c:v>3.8027500000000001</c:v>
                </c:pt>
                <c:pt idx="1495">
                  <c:v>3.8044791666666664</c:v>
                </c:pt>
                <c:pt idx="1496">
                  <c:v>3.8062083333333332</c:v>
                </c:pt>
                <c:pt idx="1497">
                  <c:v>3.8079375000000004</c:v>
                </c:pt>
                <c:pt idx="1498">
                  <c:v>3.8096666666666668</c:v>
                </c:pt>
                <c:pt idx="1499">
                  <c:v>3.8109861111111107</c:v>
                </c:pt>
                <c:pt idx="1500">
                  <c:v>3.8123124999999995</c:v>
                </c:pt>
                <c:pt idx="1501">
                  <c:v>3.8136319444444444</c:v>
                </c:pt>
                <c:pt idx="1502">
                  <c:v>3.8149513888888889</c:v>
                </c:pt>
                <c:pt idx="1503">
                  <c:v>3.8162708333333337</c:v>
                </c:pt>
                <c:pt idx="1504">
                  <c:v>3.8175902777777777</c:v>
                </c:pt>
                <c:pt idx="1505">
                  <c:v>3.8189166666666665</c:v>
                </c:pt>
                <c:pt idx="1506">
                  <c:v>3.8202361111111114</c:v>
                </c:pt>
                <c:pt idx="1507">
                  <c:v>3.8215555555555554</c:v>
                </c:pt>
                <c:pt idx="1508">
                  <c:v>3.8228680555555559</c:v>
                </c:pt>
                <c:pt idx="1509">
                  <c:v>3.8241874999999999</c:v>
                </c:pt>
                <c:pt idx="1510">
                  <c:v>3.8255069444444443</c:v>
                </c:pt>
                <c:pt idx="1511">
                  <c:v>3.8268263888888892</c:v>
                </c:pt>
                <c:pt idx="1512">
                  <c:v>3.8283194444444444</c:v>
                </c:pt>
                <c:pt idx="1513">
                  <c:v>3.8298125000000001</c:v>
                </c:pt>
                <c:pt idx="1514">
                  <c:v>3.8313055555555553</c:v>
                </c:pt>
                <c:pt idx="1515">
                  <c:v>3.832798611111111</c:v>
                </c:pt>
                <c:pt idx="1516">
                  <c:v>3.8342986111111115</c:v>
                </c:pt>
                <c:pt idx="1517">
                  <c:v>3.8357916666666667</c:v>
                </c:pt>
                <c:pt idx="1518">
                  <c:v>3.8372847222222219</c:v>
                </c:pt>
                <c:pt idx="1519">
                  <c:v>3.8387777777777781</c:v>
                </c:pt>
                <c:pt idx="1520">
                  <c:v>3.8402708333333333</c:v>
                </c:pt>
                <c:pt idx="1521">
                  <c:v>3.841763888888889</c:v>
                </c:pt>
                <c:pt idx="1522">
                  <c:v>3.8432569444444442</c:v>
                </c:pt>
                <c:pt idx="1523">
                  <c:v>3.8447499999999999</c:v>
                </c:pt>
                <c:pt idx="1524">
                  <c:v>3.8462430555555556</c:v>
                </c:pt>
                <c:pt idx="1525">
                  <c:v>3.8477430555555556</c:v>
                </c:pt>
                <c:pt idx="1526">
                  <c:v>3.8492361111111109</c:v>
                </c:pt>
                <c:pt idx="1527">
                  <c:v>3.850729166666667</c:v>
                </c:pt>
                <c:pt idx="1528">
                  <c:v>3.8522222222222222</c:v>
                </c:pt>
                <c:pt idx="1529">
                  <c:v>3.8538958333333331</c:v>
                </c:pt>
                <c:pt idx="1530">
                  <c:v>3.8555625</c:v>
                </c:pt>
                <c:pt idx="1531">
                  <c:v>3.8568888888888888</c:v>
                </c:pt>
                <c:pt idx="1532">
                  <c:v>3.8582083333333332</c:v>
                </c:pt>
                <c:pt idx="1533">
                  <c:v>3.8595277777777781</c:v>
                </c:pt>
                <c:pt idx="1534">
                  <c:v>3.8608472222222221</c:v>
                </c:pt>
                <c:pt idx="1535">
                  <c:v>3.862166666666667</c:v>
                </c:pt>
                <c:pt idx="1536">
                  <c:v>3.8634930555555558</c:v>
                </c:pt>
                <c:pt idx="1537">
                  <c:v>3.8648124999999998</c:v>
                </c:pt>
                <c:pt idx="1538">
                  <c:v>3.8661319444444442</c:v>
                </c:pt>
                <c:pt idx="1539">
                  <c:v>3.8674513888888891</c:v>
                </c:pt>
                <c:pt idx="1540">
                  <c:v>3.868770833333333</c:v>
                </c:pt>
                <c:pt idx="1541">
                  <c:v>3.8700972222222219</c:v>
                </c:pt>
                <c:pt idx="1542">
                  <c:v>3.8716527777777778</c:v>
                </c:pt>
                <c:pt idx="1543">
                  <c:v>3.8732083333333334</c:v>
                </c:pt>
                <c:pt idx="1544">
                  <c:v>3.8747708333333333</c:v>
                </c:pt>
                <c:pt idx="1545">
                  <c:v>3.8763263888888888</c:v>
                </c:pt>
                <c:pt idx="1546">
                  <c:v>3.8778819444444443</c:v>
                </c:pt>
                <c:pt idx="1547">
                  <c:v>3.8794444444444443</c:v>
                </c:pt>
                <c:pt idx="1548">
                  <c:v>3.8810000000000002</c:v>
                </c:pt>
                <c:pt idx="1549">
                  <c:v>3.8825555555555558</c:v>
                </c:pt>
                <c:pt idx="1550">
                  <c:v>3.8841180555555557</c:v>
                </c:pt>
                <c:pt idx="1551">
                  <c:v>3.8856736111111112</c:v>
                </c:pt>
                <c:pt idx="1552">
                  <c:v>3.8872291666666663</c:v>
                </c:pt>
                <c:pt idx="1553">
                  <c:v>3.8887916666666666</c:v>
                </c:pt>
                <c:pt idx="1554">
                  <c:v>3.8903472222222226</c:v>
                </c:pt>
                <c:pt idx="1555">
                  <c:v>3.8919027777777777</c:v>
                </c:pt>
                <c:pt idx="1556">
                  <c:v>3.8934652777777781</c:v>
                </c:pt>
                <c:pt idx="1557">
                  <c:v>3.8950208333333332</c:v>
                </c:pt>
                <c:pt idx="1558">
                  <c:v>3.8965763888888887</c:v>
                </c:pt>
                <c:pt idx="1559">
                  <c:v>3.8981388888888886</c:v>
                </c:pt>
                <c:pt idx="1560">
                  <c:v>3.899430555555556</c:v>
                </c:pt>
                <c:pt idx="1561">
                  <c:v>3.9007291666666668</c:v>
                </c:pt>
                <c:pt idx="1562">
                  <c:v>3.9020208333333333</c:v>
                </c:pt>
                <c:pt idx="1563">
                  <c:v>3.9033194444444441</c:v>
                </c:pt>
                <c:pt idx="1564">
                  <c:v>3.9046111111111115</c:v>
                </c:pt>
                <c:pt idx="1565">
                  <c:v>3.9059097222222223</c:v>
                </c:pt>
                <c:pt idx="1566">
                  <c:v>3.9072013888888888</c:v>
                </c:pt>
                <c:pt idx="1567">
                  <c:v>3.9084930555555553</c:v>
                </c:pt>
                <c:pt idx="1568">
                  <c:v>3.9095486111111111</c:v>
                </c:pt>
                <c:pt idx="1569">
                  <c:v>3.9105972222222225</c:v>
                </c:pt>
                <c:pt idx="1570">
                  <c:v>3.9116527777777774</c:v>
                </c:pt>
                <c:pt idx="1571">
                  <c:v>3.9127013888888889</c:v>
                </c:pt>
                <c:pt idx="1572">
                  <c:v>3.9137569444444447</c:v>
                </c:pt>
                <c:pt idx="1573">
                  <c:v>3.9148055555555552</c:v>
                </c:pt>
                <c:pt idx="1574">
                  <c:v>3.915861111111111</c:v>
                </c:pt>
                <c:pt idx="1575">
                  <c:v>3.9169097222222224</c:v>
                </c:pt>
                <c:pt idx="1576">
                  <c:v>3.9181458333333334</c:v>
                </c:pt>
                <c:pt idx="1577">
                  <c:v>3.9193888888888888</c:v>
                </c:pt>
                <c:pt idx="1578">
                  <c:v>3.9206249999999998</c:v>
                </c:pt>
                <c:pt idx="1579">
                  <c:v>3.9218611111111108</c:v>
                </c:pt>
                <c:pt idx="1580">
                  <c:v>3.9230972222222222</c:v>
                </c:pt>
                <c:pt idx="1581">
                  <c:v>3.9243333333333332</c:v>
                </c:pt>
                <c:pt idx="1582">
                  <c:v>3.9258541666666664</c:v>
                </c:pt>
                <c:pt idx="1583">
                  <c:v>3.9273680555555552</c:v>
                </c:pt>
                <c:pt idx="1584">
                  <c:v>3.9288888888888893</c:v>
                </c:pt>
                <c:pt idx="1585">
                  <c:v>3.9304027777777777</c:v>
                </c:pt>
                <c:pt idx="1586">
                  <c:v>3.9319236111111113</c:v>
                </c:pt>
                <c:pt idx="1587">
                  <c:v>3.9334374999999997</c:v>
                </c:pt>
                <c:pt idx="1588">
                  <c:v>3.9346944444444443</c:v>
                </c:pt>
                <c:pt idx="1589">
                  <c:v>3.9359513888888893</c:v>
                </c:pt>
                <c:pt idx="1590">
                  <c:v>3.9372083333333334</c:v>
                </c:pt>
                <c:pt idx="1591">
                  <c:v>3.938465277777778</c:v>
                </c:pt>
                <c:pt idx="1592">
                  <c:v>3.9386458333333332</c:v>
                </c:pt>
                <c:pt idx="1593">
                  <c:v>3.9388263888888888</c:v>
                </c:pt>
                <c:pt idx="1594">
                  <c:v>3.9390069444444444</c:v>
                </c:pt>
                <c:pt idx="1595">
                  <c:v>3.9391875000000001</c:v>
                </c:pt>
                <c:pt idx="1596">
                  <c:v>3.9393750000000001</c:v>
                </c:pt>
                <c:pt idx="1597">
                  <c:v>3.9396666666666667</c:v>
                </c:pt>
                <c:pt idx="1598">
                  <c:v>3.9399652777777781</c:v>
                </c:pt>
                <c:pt idx="1599">
                  <c:v>3.9402569444444446</c:v>
                </c:pt>
                <c:pt idx="1600">
                  <c:v>3.9405555555555551</c:v>
                </c:pt>
                <c:pt idx="1601">
                  <c:v>3.9410972222222225</c:v>
                </c:pt>
                <c:pt idx="1602">
                  <c:v>3.9416388888888889</c:v>
                </c:pt>
                <c:pt idx="1603">
                  <c:v>3.942173611111111</c:v>
                </c:pt>
                <c:pt idx="1604">
                  <c:v>3.9427152777777779</c:v>
                </c:pt>
                <c:pt idx="1605">
                  <c:v>3.9434027777777776</c:v>
                </c:pt>
                <c:pt idx="1606">
                  <c:v>3.9440902777777778</c:v>
                </c:pt>
                <c:pt idx="1607">
                  <c:v>3.9447777777777775</c:v>
                </c:pt>
                <c:pt idx="1608">
                  <c:v>3.9453333333333331</c:v>
                </c:pt>
                <c:pt idx="1609">
                  <c:v>3.9458888888888888</c:v>
                </c:pt>
                <c:pt idx="1610">
                  <c:v>3.9464444444444444</c:v>
                </c:pt>
                <c:pt idx="1611">
                  <c:v>3.947006944444444</c:v>
                </c:pt>
                <c:pt idx="1612">
                  <c:v>3.9475624999999996</c:v>
                </c:pt>
                <c:pt idx="1613">
                  <c:v>3.9481180555555557</c:v>
                </c:pt>
                <c:pt idx="1614">
                  <c:v>3.9486736111111114</c:v>
                </c:pt>
                <c:pt idx="1615">
                  <c:v>3.949229166666667</c:v>
                </c:pt>
                <c:pt idx="1616">
                  <c:v>3.9497847222222218</c:v>
                </c:pt>
                <c:pt idx="1617">
                  <c:v>3.9503402777777774</c:v>
                </c:pt>
                <c:pt idx="1618">
                  <c:v>3.9508958333333335</c:v>
                </c:pt>
                <c:pt idx="1619">
                  <c:v>3.9514444444444443</c:v>
                </c:pt>
                <c:pt idx="1620">
                  <c:v>3.9519861111111108</c:v>
                </c:pt>
                <c:pt idx="1621">
                  <c:v>3.9525277777777781</c:v>
                </c:pt>
                <c:pt idx="1622">
                  <c:v>3.9530763888888889</c:v>
                </c:pt>
                <c:pt idx="1623">
                  <c:v>3.9536180555555558</c:v>
                </c:pt>
                <c:pt idx="1624">
                  <c:v>3.9542569444444444</c:v>
                </c:pt>
                <c:pt idx="1625">
                  <c:v>3.9549027777777779</c:v>
                </c:pt>
                <c:pt idx="1626">
                  <c:v>3.9554236111111112</c:v>
                </c:pt>
                <c:pt idx="1627">
                  <c:v>3.9559513888888889</c:v>
                </c:pt>
                <c:pt idx="1628">
                  <c:v>3.9564722222222222</c:v>
                </c:pt>
                <c:pt idx="1629">
                  <c:v>3.9569930555555555</c:v>
                </c:pt>
                <c:pt idx="1630">
                  <c:v>3.9575208333333332</c:v>
                </c:pt>
                <c:pt idx="1631">
                  <c:v>3.9580416666666665</c:v>
                </c:pt>
                <c:pt idx="1632">
                  <c:v>3.9585624999999998</c:v>
                </c:pt>
                <c:pt idx="1633">
                  <c:v>3.9590833333333331</c:v>
                </c:pt>
                <c:pt idx="1634">
                  <c:v>3.9597916666666668</c:v>
                </c:pt>
                <c:pt idx="1635">
                  <c:v>3.9605000000000001</c:v>
                </c:pt>
                <c:pt idx="1636">
                  <c:v>3.9610625000000002</c:v>
                </c:pt>
                <c:pt idx="1637">
                  <c:v>3.9614722222222225</c:v>
                </c:pt>
                <c:pt idx="1638">
                  <c:v>3.9618819444444444</c:v>
                </c:pt>
                <c:pt idx="1639">
                  <c:v>3.9619652777777774</c:v>
                </c:pt>
                <c:pt idx="1640">
                  <c:v>3.9620416666666669</c:v>
                </c:pt>
                <c:pt idx="1641">
                  <c:v>3.9621249999999999</c:v>
                </c:pt>
                <c:pt idx="1642">
                  <c:v>3.9622083333333333</c:v>
                </c:pt>
                <c:pt idx="1643">
                  <c:v>3.9623611111111114</c:v>
                </c:pt>
                <c:pt idx="1644">
                  <c:v>3.9625138888888891</c:v>
                </c:pt>
                <c:pt idx="1645">
                  <c:v>3.962659722222222</c:v>
                </c:pt>
                <c:pt idx="1646">
                  <c:v>3.9628125000000001</c:v>
                </c:pt>
                <c:pt idx="1647">
                  <c:v>3.9632638888888891</c:v>
                </c:pt>
                <c:pt idx="1648">
                  <c:v>3.9637083333333334</c:v>
                </c:pt>
                <c:pt idx="1649">
                  <c:v>3.9641597222222225</c:v>
                </c:pt>
                <c:pt idx="1650">
                  <c:v>3.9646111111111111</c:v>
                </c:pt>
                <c:pt idx="1651">
                  <c:v>3.9651944444444447</c:v>
                </c:pt>
                <c:pt idx="1652">
                  <c:v>3.9657847222222218</c:v>
                </c:pt>
                <c:pt idx="1653">
                  <c:v>3.9663749999999998</c:v>
                </c:pt>
                <c:pt idx="1654">
                  <c:v>3.9669583333333334</c:v>
                </c:pt>
                <c:pt idx="1655">
                  <c:v>3.9675486111111113</c:v>
                </c:pt>
                <c:pt idx="1656">
                  <c:v>3.9681319444444441</c:v>
                </c:pt>
                <c:pt idx="1657">
                  <c:v>3.968722222222222</c:v>
                </c:pt>
                <c:pt idx="1658">
                  <c:v>3.9693055555555556</c:v>
                </c:pt>
                <c:pt idx="1659">
                  <c:v>3.9701874999999998</c:v>
                </c:pt>
                <c:pt idx="1660">
                  <c:v>3.9710763888888891</c:v>
                </c:pt>
                <c:pt idx="1661">
                  <c:v>3.9719583333333333</c:v>
                </c:pt>
                <c:pt idx="1662">
                  <c:v>3.9728402777777778</c:v>
                </c:pt>
                <c:pt idx="1663">
                  <c:v>3.9737222222222219</c:v>
                </c:pt>
                <c:pt idx="1664">
                  <c:v>3.9746041666666669</c:v>
                </c:pt>
                <c:pt idx="1665">
                  <c:v>3.9754861111111111</c:v>
                </c:pt>
                <c:pt idx="1666">
                  <c:v>3.9763680555555556</c:v>
                </c:pt>
                <c:pt idx="1667">
                  <c:v>3.9772499999999997</c:v>
                </c:pt>
                <c:pt idx="1668">
                  <c:v>3.9781388888888891</c:v>
                </c:pt>
                <c:pt idx="1669">
                  <c:v>3.9790208333333332</c:v>
                </c:pt>
                <c:pt idx="1670">
                  <c:v>3.9800069444444444</c:v>
                </c:pt>
                <c:pt idx="1671">
                  <c:v>3.9809930555555555</c:v>
                </c:pt>
                <c:pt idx="1672">
                  <c:v>3.9819791666666666</c:v>
                </c:pt>
                <c:pt idx="1673">
                  <c:v>3.9829652777777778</c:v>
                </c:pt>
                <c:pt idx="1674">
                  <c:v>3.9839513888888893</c:v>
                </c:pt>
                <c:pt idx="1675">
                  <c:v>3.9849375000000005</c:v>
                </c:pt>
                <c:pt idx="1676">
                  <c:v>3.9859236111111107</c:v>
                </c:pt>
                <c:pt idx="1677">
                  <c:v>3.9869027777777779</c:v>
                </c:pt>
                <c:pt idx="1678">
                  <c:v>3.987888888888889</c:v>
                </c:pt>
                <c:pt idx="1679">
                  <c:v>3.9888749999999997</c:v>
                </c:pt>
                <c:pt idx="1680">
                  <c:v>3.9898611111111109</c:v>
                </c:pt>
                <c:pt idx="1681">
                  <c:v>3.990847222222222</c:v>
                </c:pt>
                <c:pt idx="1682">
                  <c:v>3.991972222222222</c:v>
                </c:pt>
                <c:pt idx="1683">
                  <c:v>3.9930972222222225</c:v>
                </c:pt>
                <c:pt idx="1684">
                  <c:v>3.9942222222222226</c:v>
                </c:pt>
                <c:pt idx="1685">
                  <c:v>3.9953472222222222</c:v>
                </c:pt>
                <c:pt idx="1686">
                  <c:v>3.9964652777777778</c:v>
                </c:pt>
                <c:pt idx="1687">
                  <c:v>3.9975902777777774</c:v>
                </c:pt>
                <c:pt idx="1688">
                  <c:v>3.9987152777777775</c:v>
                </c:pt>
                <c:pt idx="1689">
                  <c:v>3.999840277777778</c:v>
                </c:pt>
                <c:pt idx="1690">
                  <c:v>4.0009583333333332</c:v>
                </c:pt>
                <c:pt idx="1691">
                  <c:v>4.0020833333333332</c:v>
                </c:pt>
                <c:pt idx="1692">
                  <c:v>4.0032083333333333</c:v>
                </c:pt>
                <c:pt idx="1693">
                  <c:v>4.0041319444444445</c:v>
                </c:pt>
                <c:pt idx="1694">
                  <c:v>4.0048888888888889</c:v>
                </c:pt>
                <c:pt idx="1695">
                  <c:v>4.0056458333333333</c:v>
                </c:pt>
                <c:pt idx="1696">
                  <c:v>4.0057777777777774</c:v>
                </c:pt>
                <c:pt idx="1697">
                  <c:v>4.0059097222222224</c:v>
                </c:pt>
                <c:pt idx="1698">
                  <c:v>4.0060416666666665</c:v>
                </c:pt>
                <c:pt idx="1699">
                  <c:v>4.006180555555555</c:v>
                </c:pt>
                <c:pt idx="1700">
                  <c:v>4.0063124999999999</c:v>
                </c:pt>
                <c:pt idx="1701">
                  <c:v>4.006576388888889</c:v>
                </c:pt>
                <c:pt idx="1702">
                  <c:v>4.0068472222222216</c:v>
                </c:pt>
                <c:pt idx="1703">
                  <c:v>4.0071111111111106</c:v>
                </c:pt>
                <c:pt idx="1704">
                  <c:v>4.007381944444445</c:v>
                </c:pt>
                <c:pt idx="1705">
                  <c:v>4.0078055555555556</c:v>
                </c:pt>
                <c:pt idx="1706">
                  <c:v>4.0082361111111107</c:v>
                </c:pt>
                <c:pt idx="1707">
                  <c:v>4.0086597222222222</c:v>
                </c:pt>
                <c:pt idx="1708">
                  <c:v>4.0090902777777782</c:v>
                </c:pt>
                <c:pt idx="1709">
                  <c:v>4.0097777777777779</c:v>
                </c:pt>
                <c:pt idx="1710">
                  <c:v>4.0104583333333332</c:v>
                </c:pt>
                <c:pt idx="1711">
                  <c:v>4.0111458333333339</c:v>
                </c:pt>
                <c:pt idx="1712">
                  <c:v>4.0118333333333336</c:v>
                </c:pt>
                <c:pt idx="1713">
                  <c:v>4.0125208333333333</c:v>
                </c:pt>
                <c:pt idx="1714">
                  <c:v>4.0133055555555552</c:v>
                </c:pt>
                <c:pt idx="1715">
                  <c:v>4.014090277777778</c:v>
                </c:pt>
                <c:pt idx="1716">
                  <c:v>4.014875</c:v>
                </c:pt>
                <c:pt idx="1717">
                  <c:v>4.0156597222222228</c:v>
                </c:pt>
                <c:pt idx="1718">
                  <c:v>4.0164513888888882</c:v>
                </c:pt>
                <c:pt idx="1719">
                  <c:v>4.017236111111111</c:v>
                </c:pt>
                <c:pt idx="1720">
                  <c:v>4.0178819444444445</c:v>
                </c:pt>
                <c:pt idx="1721">
                  <c:v>4.0185347222222223</c:v>
                </c:pt>
                <c:pt idx="1722">
                  <c:v>4.0191875000000001</c:v>
                </c:pt>
                <c:pt idx="1723">
                  <c:v>4.019840277777778</c:v>
                </c:pt>
                <c:pt idx="1724">
                  <c:v>4.0204930555555558</c:v>
                </c:pt>
                <c:pt idx="1725">
                  <c:v>4.0213263888888893</c:v>
                </c:pt>
                <c:pt idx="1726">
                  <c:v>4.0221666666666671</c:v>
                </c:pt>
                <c:pt idx="1727">
                  <c:v>4.0228541666666668</c:v>
                </c:pt>
                <c:pt idx="1728">
                  <c:v>4.0233888888888893</c:v>
                </c:pt>
                <c:pt idx="1729">
                  <c:v>4.023923611111111</c:v>
                </c:pt>
                <c:pt idx="1730">
                  <c:v>4.0240208333333332</c:v>
                </c:pt>
                <c:pt idx="1731">
                  <c:v>4.0241249999999997</c:v>
                </c:pt>
                <c:pt idx="1732">
                  <c:v>4.0242291666666672</c:v>
                </c:pt>
                <c:pt idx="1733">
                  <c:v>4.0243333333333329</c:v>
                </c:pt>
                <c:pt idx="1734">
                  <c:v>4.0245416666666669</c:v>
                </c:pt>
                <c:pt idx="1735">
                  <c:v>4.02475</c:v>
                </c:pt>
                <c:pt idx="1736">
                  <c:v>4.0249513888888888</c:v>
                </c:pt>
                <c:pt idx="1737">
                  <c:v>4.025159722222222</c:v>
                </c:pt>
                <c:pt idx="1738">
                  <c:v>4.0257361111111116</c:v>
                </c:pt>
                <c:pt idx="1739">
                  <c:v>4.0263125000000004</c:v>
                </c:pt>
                <c:pt idx="1740">
                  <c:v>4.0268819444444448</c:v>
                </c:pt>
                <c:pt idx="1741">
                  <c:v>4.0274583333333336</c:v>
                </c:pt>
                <c:pt idx="1742">
                  <c:v>4.0282847222222218</c:v>
                </c:pt>
                <c:pt idx="1743">
                  <c:v>4.0291180555555561</c:v>
                </c:pt>
                <c:pt idx="1744">
                  <c:v>4.0297916666666662</c:v>
                </c:pt>
                <c:pt idx="1745">
                  <c:v>4.0304652777777781</c:v>
                </c:pt>
                <c:pt idx="1746">
                  <c:v>4.031138888888889</c:v>
                </c:pt>
                <c:pt idx="1747">
                  <c:v>4.0318125</c:v>
                </c:pt>
                <c:pt idx="1748">
                  <c:v>4.032486111111111</c:v>
                </c:pt>
                <c:pt idx="1749">
                  <c:v>4.0334097222222223</c:v>
                </c:pt>
                <c:pt idx="1750">
                  <c:v>4.0343333333333327</c:v>
                </c:pt>
                <c:pt idx="1751">
                  <c:v>4.0352500000000004</c:v>
                </c:pt>
                <c:pt idx="1752">
                  <c:v>4.0361736111111108</c:v>
                </c:pt>
                <c:pt idx="1753">
                  <c:v>4.0370972222222221</c:v>
                </c:pt>
                <c:pt idx="1754">
                  <c:v>4.0383680555555559</c:v>
                </c:pt>
                <c:pt idx="1755">
                  <c:v>4.0396458333333332</c:v>
                </c:pt>
                <c:pt idx="1756">
                  <c:v>4.0409236111111113</c:v>
                </c:pt>
                <c:pt idx="1757">
                  <c:v>4.0422013888888895</c:v>
                </c:pt>
                <c:pt idx="1758">
                  <c:v>4.0434791666666667</c:v>
                </c:pt>
                <c:pt idx="1759">
                  <c:v>4.044756944444444</c:v>
                </c:pt>
                <c:pt idx="1760">
                  <c:v>4.0461805555555559</c:v>
                </c:pt>
                <c:pt idx="1761">
                  <c:v>4.0476041666666669</c:v>
                </c:pt>
                <c:pt idx="1762">
                  <c:v>4.0490208333333335</c:v>
                </c:pt>
                <c:pt idx="1763">
                  <c:v>4.0504444444444445</c:v>
                </c:pt>
                <c:pt idx="1764">
                  <c:v>4.0518680555555555</c:v>
                </c:pt>
                <c:pt idx="1765">
                  <c:v>4.0532916666666665</c:v>
                </c:pt>
                <c:pt idx="1766">
                  <c:v>4.0549027777777784</c:v>
                </c:pt>
                <c:pt idx="1767">
                  <c:v>4.0565208333333338</c:v>
                </c:pt>
                <c:pt idx="1768">
                  <c:v>4.0581388888888892</c:v>
                </c:pt>
                <c:pt idx="1769">
                  <c:v>4.0597569444444446</c:v>
                </c:pt>
                <c:pt idx="1770">
                  <c:v>4.0613680555555556</c:v>
                </c:pt>
                <c:pt idx="1771">
                  <c:v>4.0616597222222222</c:v>
                </c:pt>
                <c:pt idx="1772">
                  <c:v>4.0619444444444444</c:v>
                </c:pt>
                <c:pt idx="1773">
                  <c:v>4.0622361111111109</c:v>
                </c:pt>
                <c:pt idx="1774">
                  <c:v>4.0625208333333331</c:v>
                </c:pt>
                <c:pt idx="1775">
                  <c:v>4.0628124999999997</c:v>
                </c:pt>
                <c:pt idx="1776">
                  <c:v>4.0633749999999997</c:v>
                </c:pt>
                <c:pt idx="1777">
                  <c:v>4.0639444444444441</c:v>
                </c:pt>
                <c:pt idx="1778">
                  <c:v>4.0645138888888885</c:v>
                </c:pt>
                <c:pt idx="1779">
                  <c:v>4.0650763888888886</c:v>
                </c:pt>
                <c:pt idx="1780">
                  <c:v>4.0659305555555552</c:v>
                </c:pt>
                <c:pt idx="1781">
                  <c:v>4.0667777777777774</c:v>
                </c:pt>
                <c:pt idx="1782">
                  <c:v>4.0676250000000005</c:v>
                </c:pt>
                <c:pt idx="1783">
                  <c:v>4.0684791666666662</c:v>
                </c:pt>
                <c:pt idx="1784">
                  <c:v>4.0696805555555553</c:v>
                </c:pt>
                <c:pt idx="1785">
                  <c:v>4.0708819444444444</c:v>
                </c:pt>
                <c:pt idx="1786">
                  <c:v>4.0720833333333335</c:v>
                </c:pt>
                <c:pt idx="1787">
                  <c:v>4.0732847222222217</c:v>
                </c:pt>
                <c:pt idx="1788">
                  <c:v>4.0744861111111117</c:v>
                </c:pt>
                <c:pt idx="1789">
                  <c:v>4.0758124999999996</c:v>
                </c:pt>
                <c:pt idx="1790">
                  <c:v>4.077131944444444</c:v>
                </c:pt>
                <c:pt idx="1791">
                  <c:v>4.0784583333333329</c:v>
                </c:pt>
                <c:pt idx="1792">
                  <c:v>4.0797777777777782</c:v>
                </c:pt>
                <c:pt idx="1793">
                  <c:v>4.081104166666667</c:v>
                </c:pt>
                <c:pt idx="1794">
                  <c:v>4.0831249999999999</c:v>
                </c:pt>
                <c:pt idx="1795">
                  <c:v>4.0851458333333328</c:v>
                </c:pt>
                <c:pt idx="1796">
                  <c:v>4.087173611111111</c:v>
                </c:pt>
                <c:pt idx="1797">
                  <c:v>4.0891944444444439</c:v>
                </c:pt>
                <c:pt idx="1798">
                  <c:v>4.0912152777777777</c:v>
                </c:pt>
                <c:pt idx="1799">
                  <c:v>4.0932361111111115</c:v>
                </c:pt>
                <c:pt idx="1800">
                  <c:v>4.0959583333333338</c:v>
                </c:pt>
                <c:pt idx="1801">
                  <c:v>4.0986874999999996</c:v>
                </c:pt>
                <c:pt idx="1802">
                  <c:v>4.1014097222222219</c:v>
                </c:pt>
                <c:pt idx="1803">
                  <c:v>4.1041319444444442</c:v>
                </c:pt>
                <c:pt idx="1804">
                  <c:v>4.1068611111111109</c:v>
                </c:pt>
                <c:pt idx="1805">
                  <c:v>4.1095833333333331</c:v>
                </c:pt>
                <c:pt idx="1806">
                  <c:v>4.1123124999999998</c:v>
                </c:pt>
                <c:pt idx="1807">
                  <c:v>4.1150347222222221</c:v>
                </c:pt>
                <c:pt idx="1808">
                  <c:v>4.1177569444444444</c:v>
                </c:pt>
                <c:pt idx="1809">
                  <c:v>4.1209652777777777</c:v>
                </c:pt>
                <c:pt idx="1810">
                  <c:v>4.1241736111111118</c:v>
                </c:pt>
                <c:pt idx="1811">
                  <c:v>4.1273888888888886</c:v>
                </c:pt>
                <c:pt idx="1812">
                  <c:v>4.1305972222222227</c:v>
                </c:pt>
                <c:pt idx="1813">
                  <c:v>4.1331944444444444</c:v>
                </c:pt>
                <c:pt idx="1814">
                  <c:v>4.1336805555555554</c:v>
                </c:pt>
                <c:pt idx="1815">
                  <c:v>4.1341666666666663</c:v>
                </c:pt>
                <c:pt idx="1816">
                  <c:v>4.1346527777777773</c:v>
                </c:pt>
                <c:pt idx="1817">
                  <c:v>4.1351388888888891</c:v>
                </c:pt>
                <c:pt idx="1818">
                  <c:v>4.1356250000000001</c:v>
                </c:pt>
                <c:pt idx="1819">
                  <c:v>4.1366041666666664</c:v>
                </c:pt>
                <c:pt idx="1820">
                  <c:v>4.1375763888888883</c:v>
                </c:pt>
                <c:pt idx="1821">
                  <c:v>4.1385486111111112</c:v>
                </c:pt>
                <c:pt idx="1822">
                  <c:v>4.1395277777777775</c:v>
                </c:pt>
                <c:pt idx="1823">
                  <c:v>4.1404999999999994</c:v>
                </c:pt>
                <c:pt idx="1824">
                  <c:v>4.1428194444444442</c:v>
                </c:pt>
                <c:pt idx="1825">
                  <c:v>4.1451388888888889</c:v>
                </c:pt>
                <c:pt idx="1826">
                  <c:v>4.1474583333333337</c:v>
                </c:pt>
                <c:pt idx="1827">
                  <c:v>4.1497777777777776</c:v>
                </c:pt>
                <c:pt idx="1828">
                  <c:v>4.1520972222222223</c:v>
                </c:pt>
                <c:pt idx="1829">
                  <c:v>4.1557777777777778</c:v>
                </c:pt>
                <c:pt idx="1830">
                  <c:v>4.1594583333333333</c:v>
                </c:pt>
                <c:pt idx="1831">
                  <c:v>4.1631319444444443</c:v>
                </c:pt>
                <c:pt idx="1832">
                  <c:v>4.1668124999999998</c:v>
                </c:pt>
                <c:pt idx="1833">
                  <c:v>4.1704930555555553</c:v>
                </c:pt>
                <c:pt idx="1834">
                  <c:v>4.1741736111111116</c:v>
                </c:pt>
                <c:pt idx="1835">
                  <c:v>4.1795694444444447</c:v>
                </c:pt>
                <c:pt idx="1836">
                  <c:v>4.1849722222222221</c:v>
                </c:pt>
                <c:pt idx="1837">
                  <c:v>4.190368055555556</c:v>
                </c:pt>
                <c:pt idx="1838">
                  <c:v>4.1957708333333334</c:v>
                </c:pt>
                <c:pt idx="1839">
                  <c:v>4.2011736111111109</c:v>
                </c:pt>
                <c:pt idx="1840">
                  <c:v>4.2065694444444448</c:v>
                </c:pt>
                <c:pt idx="1841">
                  <c:v>4.2133680555555557</c:v>
                </c:pt>
                <c:pt idx="1842">
                  <c:v>4.2201666666666666</c:v>
                </c:pt>
                <c:pt idx="1843">
                  <c:v>4.2269652777777775</c:v>
                </c:pt>
                <c:pt idx="1844">
                  <c:v>4.2337638888888884</c:v>
                </c:pt>
                <c:pt idx="1845">
                  <c:v>4.2405625000000002</c:v>
                </c:pt>
                <c:pt idx="1846">
                  <c:v>4.245916666666667</c:v>
                </c:pt>
                <c:pt idx="1847">
                  <c:v>4.2504236111111107</c:v>
                </c:pt>
                <c:pt idx="1848">
                  <c:v>4.2549305555555561</c:v>
                </c:pt>
                <c:pt idx="1849">
                  <c:v>4.2594374999999998</c:v>
                </c:pt>
                <c:pt idx="1850">
                  <c:v>4.2639444444444443</c:v>
                </c:pt>
                <c:pt idx="1851">
                  <c:v>4.2684444444444445</c:v>
                </c:pt>
                <c:pt idx="1852">
                  <c:v>4.2735416666666666</c:v>
                </c:pt>
                <c:pt idx="1853">
                  <c:v>4.2786319444444443</c:v>
                </c:pt>
                <c:pt idx="1854">
                  <c:v>4.2837291666666664</c:v>
                </c:pt>
                <c:pt idx="1855">
                  <c:v>4.287770833333334</c:v>
                </c:pt>
                <c:pt idx="1856">
                  <c:v>4.2918124999999998</c:v>
                </c:pt>
                <c:pt idx="1857">
                  <c:v>4.2958541666666665</c:v>
                </c:pt>
                <c:pt idx="1858">
                  <c:v>4.2998958333333333</c:v>
                </c:pt>
                <c:pt idx="1859">
                  <c:v>4.3039375</c:v>
                </c:pt>
                <c:pt idx="1860">
                  <c:v>4.3079791666666667</c:v>
                </c:pt>
                <c:pt idx="1861">
                  <c:v>4.3120208333333334</c:v>
                </c:pt>
                <c:pt idx="1862">
                  <c:v>4.3160625000000001</c:v>
                </c:pt>
                <c:pt idx="1863">
                  <c:v>4.3168263888888889</c:v>
                </c:pt>
                <c:pt idx="1864">
                  <c:v>4.3175972222222221</c:v>
                </c:pt>
                <c:pt idx="1865">
                  <c:v>4.3183611111111109</c:v>
                </c:pt>
                <c:pt idx="1866">
                  <c:v>4.3191319444444449</c:v>
                </c:pt>
                <c:pt idx="1867">
                  <c:v>4.3198958333333328</c:v>
                </c:pt>
                <c:pt idx="1868">
                  <c:v>4.3214027777777773</c:v>
                </c:pt>
                <c:pt idx="1869">
                  <c:v>4.3229027777777773</c:v>
                </c:pt>
                <c:pt idx="1870">
                  <c:v>4.3244097222222218</c:v>
                </c:pt>
                <c:pt idx="1871">
                  <c:v>4.3259097222222227</c:v>
                </c:pt>
                <c:pt idx="1872">
                  <c:v>4.3286041666666666</c:v>
                </c:pt>
                <c:pt idx="1873">
                  <c:v>4.331291666666667</c:v>
                </c:pt>
                <c:pt idx="1874">
                  <c:v>4.3339861111111109</c:v>
                </c:pt>
                <c:pt idx="1875">
                  <c:v>4.3366805555555556</c:v>
                </c:pt>
                <c:pt idx="1876">
                  <c:v>4.3405694444444443</c:v>
                </c:pt>
                <c:pt idx="1877">
                  <c:v>4.3444583333333338</c:v>
                </c:pt>
                <c:pt idx="1878">
                  <c:v>4.3483541666666667</c:v>
                </c:pt>
                <c:pt idx="1879">
                  <c:v>4.3522430555555554</c:v>
                </c:pt>
                <c:pt idx="1880">
                  <c:v>4.356131944444444</c:v>
                </c:pt>
                <c:pt idx="1881">
                  <c:v>4.3607152777777776</c:v>
                </c:pt>
                <c:pt idx="1882">
                  <c:v>4.3653055555555556</c:v>
                </c:pt>
                <c:pt idx="1883">
                  <c:v>4.3698888888888892</c:v>
                </c:pt>
                <c:pt idx="1884">
                  <c:v>4.3744791666666663</c:v>
                </c:pt>
                <c:pt idx="1885">
                  <c:v>4.3790624999999999</c:v>
                </c:pt>
                <c:pt idx="1886">
                  <c:v>4.384125</c:v>
                </c:pt>
                <c:pt idx="1887">
                  <c:v>4.3891875000000002</c:v>
                </c:pt>
                <c:pt idx="1888">
                  <c:v>4.3942500000000004</c:v>
                </c:pt>
                <c:pt idx="1889">
                  <c:v>4.3993124999999997</c:v>
                </c:pt>
                <c:pt idx="1890">
                  <c:v>4.4043680555555556</c:v>
                </c:pt>
                <c:pt idx="1891">
                  <c:v>4.4102986111111111</c:v>
                </c:pt>
                <c:pt idx="1892">
                  <c:v>4.4162222222222223</c:v>
                </c:pt>
                <c:pt idx="1893">
                  <c:v>4.4221458333333334</c:v>
                </c:pt>
                <c:pt idx="1894">
                  <c:v>4.4280694444444446</c:v>
                </c:pt>
                <c:pt idx="1895">
                  <c:v>4.4339930555555558</c:v>
                </c:pt>
                <c:pt idx="1896">
                  <c:v>4.4399166666666661</c:v>
                </c:pt>
                <c:pt idx="1897">
                  <c:v>4.4458472222222225</c:v>
                </c:pt>
                <c:pt idx="1898">
                  <c:v>4.4517708333333337</c:v>
                </c:pt>
                <c:pt idx="1899">
                  <c:v>4.457694444444444</c:v>
                </c:pt>
                <c:pt idx="1900">
                  <c:v>4.4636180555555551</c:v>
                </c:pt>
                <c:pt idx="1901">
                  <c:v>4.4695416666666672</c:v>
                </c:pt>
                <c:pt idx="1902">
                  <c:v>4.4754652777777775</c:v>
                </c:pt>
                <c:pt idx="1903">
                  <c:v>4.484486111111111</c:v>
                </c:pt>
                <c:pt idx="1904">
                  <c:v>4.4935</c:v>
                </c:pt>
                <c:pt idx="1905">
                  <c:v>4.5025208333333335</c:v>
                </c:pt>
                <c:pt idx="1906">
                  <c:v>4.5115347222222217</c:v>
                </c:pt>
                <c:pt idx="1907">
                  <c:v>4.5205555555555561</c:v>
                </c:pt>
                <c:pt idx="1908">
                  <c:v>4.5295694444444443</c:v>
                </c:pt>
                <c:pt idx="1909">
                  <c:v>4.5385902777777778</c:v>
                </c:pt>
                <c:pt idx="1910">
                  <c:v>4.5476041666666669</c:v>
                </c:pt>
                <c:pt idx="1911">
                  <c:v>4.5566250000000004</c:v>
                </c:pt>
                <c:pt idx="1912">
                  <c:v>4.5656388888888895</c:v>
                </c:pt>
                <c:pt idx="1913">
                  <c:v>4.5746597222222221</c:v>
                </c:pt>
                <c:pt idx="1914">
                  <c:v>4.5836736111111112</c:v>
                </c:pt>
                <c:pt idx="1915">
                  <c:v>4.5926944444444437</c:v>
                </c:pt>
                <c:pt idx="1916">
                  <c:v>4.6017083333333337</c:v>
                </c:pt>
                <c:pt idx="1917">
                  <c:v>4.6107291666666663</c:v>
                </c:pt>
                <c:pt idx="1918">
                  <c:v>4.6197430555555554</c:v>
                </c:pt>
                <c:pt idx="1919">
                  <c:v>4.6287638888888889</c:v>
                </c:pt>
                <c:pt idx="1920">
                  <c:v>4.6377777777777771</c:v>
                </c:pt>
                <c:pt idx="1921">
                  <c:v>4.6467986111111115</c:v>
                </c:pt>
                <c:pt idx="1922">
                  <c:v>4.6558124999999997</c:v>
                </c:pt>
                <c:pt idx="1923">
                  <c:v>4.6648333333333332</c:v>
                </c:pt>
                <c:pt idx="1924">
                  <c:v>4.6747500000000004</c:v>
                </c:pt>
                <c:pt idx="1925">
                  <c:v>4.6846736111111111</c:v>
                </c:pt>
                <c:pt idx="1926">
                  <c:v>4.6945972222222228</c:v>
                </c:pt>
                <c:pt idx="1927">
                  <c:v>4.7045138888888891</c:v>
                </c:pt>
                <c:pt idx="1928">
                  <c:v>4.7144374999999998</c:v>
                </c:pt>
                <c:pt idx="1929">
                  <c:v>4.7243611111111115</c:v>
                </c:pt>
                <c:pt idx="1930">
                  <c:v>4.7342777777777778</c:v>
                </c:pt>
                <c:pt idx="1931">
                  <c:v>4.7425208333333329</c:v>
                </c:pt>
                <c:pt idx="1932">
                  <c:v>4.7507638888888888</c:v>
                </c:pt>
                <c:pt idx="1933">
                  <c:v>4.7590069444444447</c:v>
                </c:pt>
                <c:pt idx="1934">
                  <c:v>4.7672499999999998</c:v>
                </c:pt>
                <c:pt idx="1935">
                  <c:v>4.7754930555555557</c:v>
                </c:pt>
                <c:pt idx="1936">
                  <c:v>4.7837291666666664</c:v>
                </c:pt>
                <c:pt idx="1937">
                  <c:v>4.7919722222222223</c:v>
                </c:pt>
                <c:pt idx="1938">
                  <c:v>4.8002152777777782</c:v>
                </c:pt>
                <c:pt idx="1939">
                  <c:v>4.8066250000000004</c:v>
                </c:pt>
                <c:pt idx="1940">
                  <c:v>4.8130277777777781</c:v>
                </c:pt>
                <c:pt idx="1941">
                  <c:v>4.8140625000000004</c:v>
                </c:pt>
                <c:pt idx="1942">
                  <c:v>4.815104166666667</c:v>
                </c:pt>
                <c:pt idx="1943">
                  <c:v>4.8159513888888892</c:v>
                </c:pt>
                <c:pt idx="1944">
                  <c:v>4.8168055555555558</c:v>
                </c:pt>
                <c:pt idx="1945">
                  <c:v>4.8176597222222224</c:v>
                </c:pt>
                <c:pt idx="1946">
                  <c:v>4.818513888888889</c:v>
                </c:pt>
                <c:pt idx="1947">
                  <c:v>4.8193611111111112</c:v>
                </c:pt>
                <c:pt idx="1948">
                  <c:v>4.8202152777777778</c:v>
                </c:pt>
                <c:pt idx="1949">
                  <c:v>4.8210694444444444</c:v>
                </c:pt>
                <c:pt idx="1950">
                  <c:v>4.8219166666666666</c:v>
                </c:pt>
                <c:pt idx="1951">
                  <c:v>4.8227708333333332</c:v>
                </c:pt>
                <c:pt idx="1952">
                  <c:v>4.8236250000000007</c:v>
                </c:pt>
                <c:pt idx="1953">
                  <c:v>4.8244791666666664</c:v>
                </c:pt>
                <c:pt idx="1954">
                  <c:v>4.8254166666666674</c:v>
                </c:pt>
                <c:pt idx="1955">
                  <c:v>4.8263611111111109</c:v>
                </c:pt>
                <c:pt idx="1956">
                  <c:v>4.8273055555555553</c:v>
                </c:pt>
                <c:pt idx="1957">
                  <c:v>4.8280486111111109</c:v>
                </c:pt>
                <c:pt idx="1958">
                  <c:v>4.828798611111111</c:v>
                </c:pt>
                <c:pt idx="1959">
                  <c:v>4.829548611111111</c:v>
                </c:pt>
                <c:pt idx="1960">
                  <c:v>4.830298611111111</c:v>
                </c:pt>
                <c:pt idx="1961">
                  <c:v>4.8310486111111111</c:v>
                </c:pt>
                <c:pt idx="1962">
                  <c:v>4.8317986111111111</c:v>
                </c:pt>
                <c:pt idx="1963">
                  <c:v>4.8325486111111111</c:v>
                </c:pt>
                <c:pt idx="1964">
                  <c:v>4.833576388888889</c:v>
                </c:pt>
                <c:pt idx="1965">
                  <c:v>4.8345972222222224</c:v>
                </c:pt>
                <c:pt idx="1966">
                  <c:v>4.8356250000000003</c:v>
                </c:pt>
                <c:pt idx="1967">
                  <c:v>4.8366458333333338</c:v>
                </c:pt>
                <c:pt idx="1968">
                  <c:v>4.8390486111111111</c:v>
                </c:pt>
                <c:pt idx="1969">
                  <c:v>4.8414444444444449</c:v>
                </c:pt>
                <c:pt idx="1970">
                  <c:v>4.8438472222222222</c:v>
                </c:pt>
                <c:pt idx="1971">
                  <c:v>4.8462500000000004</c:v>
                </c:pt>
                <c:pt idx="1972">
                  <c:v>4.8486458333333333</c:v>
                </c:pt>
                <c:pt idx="1973">
                  <c:v>4.853472222222222</c:v>
                </c:pt>
                <c:pt idx="1974">
                  <c:v>4.8582916666666662</c:v>
                </c:pt>
                <c:pt idx="1975">
                  <c:v>4.8622291666666664</c:v>
                </c:pt>
                <c:pt idx="1976">
                  <c:v>4.8661666666666665</c:v>
                </c:pt>
                <c:pt idx="1977">
                  <c:v>4.8701041666666667</c:v>
                </c:pt>
                <c:pt idx="1978">
                  <c:v>4.8740416666666668</c:v>
                </c:pt>
                <c:pt idx="1979">
                  <c:v>4.8779722222222217</c:v>
                </c:pt>
                <c:pt idx="1980">
                  <c:v>4.8819097222222219</c:v>
                </c:pt>
                <c:pt idx="1981">
                  <c:v>4.885847222222222</c:v>
                </c:pt>
                <c:pt idx="1982">
                  <c:v>4.8897847222222222</c:v>
                </c:pt>
                <c:pt idx="1983">
                  <c:v>4.8937222222222223</c:v>
                </c:pt>
                <c:pt idx="1984">
                  <c:v>4.8976597222222225</c:v>
                </c:pt>
                <c:pt idx="1985">
                  <c:v>4.9015972222222226</c:v>
                </c:pt>
                <c:pt idx="1986">
                  <c:v>4.9055347222222228</c:v>
                </c:pt>
                <c:pt idx="1987">
                  <c:v>4.909472222222222</c:v>
                </c:pt>
                <c:pt idx="1988">
                  <c:v>4.9134097222222222</c:v>
                </c:pt>
                <c:pt idx="1989">
                  <c:v>4.9173472222222223</c:v>
                </c:pt>
                <c:pt idx="1990">
                  <c:v>4.9212847222222216</c:v>
                </c:pt>
                <c:pt idx="1991">
                  <c:v>4.9244444444444442</c:v>
                </c:pt>
                <c:pt idx="1992">
                  <c:v>4.9269583333333333</c:v>
                </c:pt>
                <c:pt idx="1993">
                  <c:v>4.9294652777777781</c:v>
                </c:pt>
                <c:pt idx="1994">
                  <c:v>4.929875</c:v>
                </c:pt>
                <c:pt idx="1995">
                  <c:v>4.9302847222222219</c:v>
                </c:pt>
                <c:pt idx="1996">
                  <c:v>4.9306944444444447</c:v>
                </c:pt>
                <c:pt idx="1997">
                  <c:v>4.9311041666666666</c:v>
                </c:pt>
                <c:pt idx="1998">
                  <c:v>4.9315138888888885</c:v>
                </c:pt>
                <c:pt idx="1999">
                  <c:v>4.9323194444444445</c:v>
                </c:pt>
                <c:pt idx="2000">
                  <c:v>4.9331319444444448</c:v>
                </c:pt>
                <c:pt idx="2001">
                  <c:v>4.9339374999999999</c:v>
                </c:pt>
                <c:pt idx="2002">
                  <c:v>4.9347430555555558</c:v>
                </c:pt>
                <c:pt idx="2003">
                  <c:v>4.9364097222222227</c:v>
                </c:pt>
                <c:pt idx="2004">
                  <c:v>4.9380694444444444</c:v>
                </c:pt>
                <c:pt idx="2005">
                  <c:v>4.9397291666666669</c:v>
                </c:pt>
                <c:pt idx="2006">
                  <c:v>4.9413888888888895</c:v>
                </c:pt>
                <c:pt idx="2007">
                  <c:v>4.9436875000000002</c:v>
                </c:pt>
                <c:pt idx="2008">
                  <c:v>4.9459791666666666</c:v>
                </c:pt>
                <c:pt idx="2009">
                  <c:v>4.9482777777777782</c:v>
                </c:pt>
                <c:pt idx="2010">
                  <c:v>4.9505694444444446</c:v>
                </c:pt>
                <c:pt idx="2011">
                  <c:v>4.952263888888889</c:v>
                </c:pt>
                <c:pt idx="2012">
                  <c:v>4.9536597222222225</c:v>
                </c:pt>
                <c:pt idx="2013">
                  <c:v>4.9550555555555551</c:v>
                </c:pt>
                <c:pt idx="2014">
                  <c:v>4.9562291666666667</c:v>
                </c:pt>
                <c:pt idx="2015">
                  <c:v>4.9564236111111111</c:v>
                </c:pt>
                <c:pt idx="2016">
                  <c:v>4.9566180555555555</c:v>
                </c:pt>
                <c:pt idx="2017">
                  <c:v>4.9568124999999998</c:v>
                </c:pt>
                <c:pt idx="2018">
                  <c:v>4.9570069444444442</c:v>
                </c:pt>
                <c:pt idx="2019">
                  <c:v>4.9573263888888892</c:v>
                </c:pt>
                <c:pt idx="2020">
                  <c:v>4.9576388888888889</c:v>
                </c:pt>
                <c:pt idx="2021">
                  <c:v>4.9579513888888886</c:v>
                </c:pt>
                <c:pt idx="2022">
                  <c:v>4.9584930555555555</c:v>
                </c:pt>
                <c:pt idx="2023">
                  <c:v>4.959027777777778</c:v>
                </c:pt>
                <c:pt idx="2024">
                  <c:v>4.9595625000000005</c:v>
                </c:pt>
                <c:pt idx="2025">
                  <c:v>4.9604305555555559</c:v>
                </c:pt>
                <c:pt idx="2026">
                  <c:v>4.9612986111111113</c:v>
                </c:pt>
                <c:pt idx="2027">
                  <c:v>4.9621666666666666</c:v>
                </c:pt>
                <c:pt idx="2028">
                  <c:v>4.9630347222222229</c:v>
                </c:pt>
                <c:pt idx="2029">
                  <c:v>4.9644652777777774</c:v>
                </c:pt>
                <c:pt idx="2030">
                  <c:v>4.9658958333333336</c:v>
                </c:pt>
                <c:pt idx="2031">
                  <c:v>4.967326388888889</c:v>
                </c:pt>
                <c:pt idx="2032">
                  <c:v>4.9687638888888888</c:v>
                </c:pt>
                <c:pt idx="2033">
                  <c:v>4.9708472222222229</c:v>
                </c:pt>
                <c:pt idx="2034">
                  <c:v>4.9729305555555561</c:v>
                </c:pt>
                <c:pt idx="2035">
                  <c:v>4.9750138888888893</c:v>
                </c:pt>
                <c:pt idx="2036">
                  <c:v>4.9766597222222222</c:v>
                </c:pt>
                <c:pt idx="2037">
                  <c:v>4.9779791666666666</c:v>
                </c:pt>
                <c:pt idx="2038">
                  <c:v>4.9793055555555554</c:v>
                </c:pt>
                <c:pt idx="2039">
                  <c:v>4.9806319444444442</c:v>
                </c:pt>
                <c:pt idx="2040">
                  <c:v>4.9819583333333339</c:v>
                </c:pt>
                <c:pt idx="2041">
                  <c:v>4.9822152777777777</c:v>
                </c:pt>
                <c:pt idx="2042">
                  <c:v>4.9824722222222224</c:v>
                </c:pt>
                <c:pt idx="2043">
                  <c:v>4.9827291666666671</c:v>
                </c:pt>
                <c:pt idx="2044">
                  <c:v>4.9829791666666665</c:v>
                </c:pt>
                <c:pt idx="2045">
                  <c:v>4.9834097222222216</c:v>
                </c:pt>
                <c:pt idx="2046">
                  <c:v>4.9838402777777775</c:v>
                </c:pt>
                <c:pt idx="2047">
                  <c:v>4.9842708333333334</c:v>
                </c:pt>
                <c:pt idx="2048">
                  <c:v>4.9849027777777781</c:v>
                </c:pt>
                <c:pt idx="2049">
                  <c:v>4.9855416666666672</c:v>
                </c:pt>
                <c:pt idx="2050">
                  <c:v>4.986173611111111</c:v>
                </c:pt>
                <c:pt idx="2051">
                  <c:v>4.9868055555555557</c:v>
                </c:pt>
                <c:pt idx="2052">
                  <c:v>4.9875694444444445</c:v>
                </c:pt>
                <c:pt idx="2053">
                  <c:v>4.9883402777777777</c:v>
                </c:pt>
                <c:pt idx="2054">
                  <c:v>4.9891041666666673</c:v>
                </c:pt>
                <c:pt idx="2055">
                  <c:v>4.9898680555555552</c:v>
                </c:pt>
                <c:pt idx="2056">
                  <c:v>4.9911319444444437</c:v>
                </c:pt>
                <c:pt idx="2057">
                  <c:v>4.9923888888888888</c:v>
                </c:pt>
                <c:pt idx="2058">
                  <c:v>4.9936458333333338</c:v>
                </c:pt>
                <c:pt idx="2059">
                  <c:v>4.9949097222222223</c:v>
                </c:pt>
                <c:pt idx="2060">
                  <c:v>4.9966874999999993</c:v>
                </c:pt>
                <c:pt idx="2061">
                  <c:v>4.9984583333333328</c:v>
                </c:pt>
                <c:pt idx="2062">
                  <c:v>5</c:v>
                </c:pt>
              </c:numCache>
            </c:numRef>
          </c:xVal>
          <c:yVal>
            <c:numRef>
              <c:f>Sheet1!$L$4:$L$2066</c:f>
              <c:numCache>
                <c:formatCode>0.00E+00</c:formatCode>
                <c:ptCount val="2063"/>
                <c:pt idx="0">
                  <c:v>9.9999999999999995E-7</c:v>
                </c:pt>
                <c:pt idx="1">
                  <c:v>9.9999999999999995E-7</c:v>
                </c:pt>
                <c:pt idx="2">
                  <c:v>9.9999999999999995E-7</c:v>
                </c:pt>
                <c:pt idx="3">
                  <c:v>9.9999999999999995E-7</c:v>
                </c:pt>
                <c:pt idx="4">
                  <c:v>9.9999999999999995E-7</c:v>
                </c:pt>
                <c:pt idx="5">
                  <c:v>9.9999999999999995E-7</c:v>
                </c:pt>
                <c:pt idx="6">
                  <c:v>9.9999999999999995E-7</c:v>
                </c:pt>
                <c:pt idx="7">
                  <c:v>9.9999999999999995E-7</c:v>
                </c:pt>
                <c:pt idx="8">
                  <c:v>9.9999999999999995E-7</c:v>
                </c:pt>
                <c:pt idx="9">
                  <c:v>9.9999999999999995E-7</c:v>
                </c:pt>
                <c:pt idx="10">
                  <c:v>1.00001E-6</c:v>
                </c:pt>
                <c:pt idx="11">
                  <c:v>1.00001E-6</c:v>
                </c:pt>
                <c:pt idx="12">
                  <c:v>1.0000200000000001E-6</c:v>
                </c:pt>
                <c:pt idx="13">
                  <c:v>1.0000200000000001E-6</c:v>
                </c:pt>
                <c:pt idx="14">
                  <c:v>1.0000500000000001E-6</c:v>
                </c:pt>
                <c:pt idx="15">
                  <c:v>1.00008E-6</c:v>
                </c:pt>
                <c:pt idx="16">
                  <c:v>1.00011E-6</c:v>
                </c:pt>
                <c:pt idx="17">
                  <c:v>1.0001599999999999E-6</c:v>
                </c:pt>
                <c:pt idx="18">
                  <c:v>1.0002200000000001E-6</c:v>
                </c:pt>
                <c:pt idx="19">
                  <c:v>1.0002800000000001E-6</c:v>
                </c:pt>
                <c:pt idx="20">
                  <c:v>1.0003599999999999E-6</c:v>
                </c:pt>
                <c:pt idx="21">
                  <c:v>1.0004500000000001E-6</c:v>
                </c:pt>
                <c:pt idx="22">
                  <c:v>1.00053E-6</c:v>
                </c:pt>
                <c:pt idx="23">
                  <c:v>1.0006E-6</c:v>
                </c:pt>
                <c:pt idx="24">
                  <c:v>1.0006800000000001E-6</c:v>
                </c:pt>
                <c:pt idx="25">
                  <c:v>1.0007499999999999E-6</c:v>
                </c:pt>
                <c:pt idx="26">
                  <c:v>1.00079E-6</c:v>
                </c:pt>
                <c:pt idx="27">
                  <c:v>1.0008199999999999E-6</c:v>
                </c:pt>
                <c:pt idx="28">
                  <c:v>1.0008499999999999E-6</c:v>
                </c:pt>
                <c:pt idx="29">
                  <c:v>1.0008800000000001E-6</c:v>
                </c:pt>
                <c:pt idx="30">
                  <c:v>1.0009100000000001E-6</c:v>
                </c:pt>
                <c:pt idx="31">
                  <c:v>1.0009400000000001E-6</c:v>
                </c:pt>
                <c:pt idx="32">
                  <c:v>1.0009799999999999E-6</c:v>
                </c:pt>
                <c:pt idx="33">
                  <c:v>1.00103E-6</c:v>
                </c:pt>
                <c:pt idx="34">
                  <c:v>1.0010700000000001E-6</c:v>
                </c:pt>
                <c:pt idx="35">
                  <c:v>1.0013400000000001E-6</c:v>
                </c:pt>
                <c:pt idx="36">
                  <c:v>1.0014099999999999E-6</c:v>
                </c:pt>
                <c:pt idx="37">
                  <c:v>1.0014799999999999E-6</c:v>
                </c:pt>
                <c:pt idx="38">
                  <c:v>1.00155E-6</c:v>
                </c:pt>
                <c:pt idx="39">
                  <c:v>1.00162E-6</c:v>
                </c:pt>
                <c:pt idx="40">
                  <c:v>1.00165E-6</c:v>
                </c:pt>
                <c:pt idx="41">
                  <c:v>1.00168E-6</c:v>
                </c:pt>
                <c:pt idx="42">
                  <c:v>1.0017099999999999E-6</c:v>
                </c:pt>
                <c:pt idx="43">
                  <c:v>1.0017300000000001E-6</c:v>
                </c:pt>
                <c:pt idx="44">
                  <c:v>1.00176E-6</c:v>
                </c:pt>
                <c:pt idx="45">
                  <c:v>1.00179E-6</c:v>
                </c:pt>
                <c:pt idx="46">
                  <c:v>1.0018399999999999E-6</c:v>
                </c:pt>
                <c:pt idx="47">
                  <c:v>1.00189E-6</c:v>
                </c:pt>
                <c:pt idx="48">
                  <c:v>1.0019300000000001E-6</c:v>
                </c:pt>
                <c:pt idx="49">
                  <c:v>1.0022900000000001E-6</c:v>
                </c:pt>
                <c:pt idx="50">
                  <c:v>1.00238E-6</c:v>
                </c:pt>
                <c:pt idx="51">
                  <c:v>1.0025600000000001E-6</c:v>
                </c:pt>
                <c:pt idx="52">
                  <c:v>1.00274E-6</c:v>
                </c:pt>
                <c:pt idx="53">
                  <c:v>1.0029200000000001E-6</c:v>
                </c:pt>
                <c:pt idx="54">
                  <c:v>1.0031E-6</c:v>
                </c:pt>
                <c:pt idx="55">
                  <c:v>1.0035499999999999E-6</c:v>
                </c:pt>
                <c:pt idx="56">
                  <c:v>1.004E-6</c:v>
                </c:pt>
                <c:pt idx="57">
                  <c:v>1.00446E-6</c:v>
                </c:pt>
                <c:pt idx="58">
                  <c:v>1.00491E-6</c:v>
                </c:pt>
                <c:pt idx="59">
                  <c:v>1.0055299999999999E-6</c:v>
                </c:pt>
                <c:pt idx="60">
                  <c:v>1.00614E-6</c:v>
                </c:pt>
                <c:pt idx="61">
                  <c:v>1.00676E-6</c:v>
                </c:pt>
                <c:pt idx="62">
                  <c:v>1.00738E-6</c:v>
                </c:pt>
                <c:pt idx="63">
                  <c:v>1.00851E-6</c:v>
                </c:pt>
                <c:pt idx="64">
                  <c:v>1.0096400000000001E-6</c:v>
                </c:pt>
                <c:pt idx="65">
                  <c:v>1.01078E-6</c:v>
                </c:pt>
                <c:pt idx="66">
                  <c:v>1.0119100000000001E-6</c:v>
                </c:pt>
                <c:pt idx="67">
                  <c:v>1.01305E-6</c:v>
                </c:pt>
                <c:pt idx="68">
                  <c:v>1.0144800000000001E-6</c:v>
                </c:pt>
                <c:pt idx="69">
                  <c:v>1.0159000000000001E-6</c:v>
                </c:pt>
                <c:pt idx="70">
                  <c:v>1.01734E-6</c:v>
                </c:pt>
                <c:pt idx="71">
                  <c:v>1.0187699999999999E-6</c:v>
                </c:pt>
                <c:pt idx="72">
                  <c:v>1.0202100000000001E-6</c:v>
                </c:pt>
                <c:pt idx="73">
                  <c:v>1.02248E-6</c:v>
                </c:pt>
                <c:pt idx="74">
                  <c:v>1.0247600000000001E-6</c:v>
                </c:pt>
                <c:pt idx="75">
                  <c:v>1.02705E-6</c:v>
                </c:pt>
                <c:pt idx="76">
                  <c:v>1.0293499999999999E-6</c:v>
                </c:pt>
                <c:pt idx="77">
                  <c:v>1.03166E-6</c:v>
                </c:pt>
                <c:pt idx="78">
                  <c:v>1.0339800000000001E-6</c:v>
                </c:pt>
                <c:pt idx="79">
                  <c:v>1.03766E-6</c:v>
                </c:pt>
                <c:pt idx="80">
                  <c:v>1.0413600000000001E-6</c:v>
                </c:pt>
                <c:pt idx="81">
                  <c:v>1.0450900000000001E-6</c:v>
                </c:pt>
                <c:pt idx="82">
                  <c:v>1.0488400000000001E-6</c:v>
                </c:pt>
                <c:pt idx="83">
                  <c:v>1.05262E-6</c:v>
                </c:pt>
                <c:pt idx="84">
                  <c:v>1.0564200000000001E-6</c:v>
                </c:pt>
                <c:pt idx="85">
                  <c:v>1.06069E-6</c:v>
                </c:pt>
                <c:pt idx="86">
                  <c:v>1.0649899999999999E-6</c:v>
                </c:pt>
                <c:pt idx="87">
                  <c:v>1.0693300000000001E-6</c:v>
                </c:pt>
                <c:pt idx="88">
                  <c:v>1.0736899999999999E-6</c:v>
                </c:pt>
                <c:pt idx="89">
                  <c:v>1.07809E-6</c:v>
                </c:pt>
                <c:pt idx="90">
                  <c:v>1.0825100000000001E-6</c:v>
                </c:pt>
                <c:pt idx="91">
                  <c:v>1.08757E-6</c:v>
                </c:pt>
                <c:pt idx="92">
                  <c:v>1.09268E-6</c:v>
                </c:pt>
                <c:pt idx="93">
                  <c:v>1.09782E-6</c:v>
                </c:pt>
                <c:pt idx="94">
                  <c:v>1.1030099999999999E-6</c:v>
                </c:pt>
                <c:pt idx="95">
                  <c:v>1.1082400000000001E-6</c:v>
                </c:pt>
                <c:pt idx="96">
                  <c:v>1.1135E-6</c:v>
                </c:pt>
                <c:pt idx="97">
                  <c:v>1.11435E-6</c:v>
                </c:pt>
                <c:pt idx="98">
                  <c:v>1.1151900000000001E-6</c:v>
                </c:pt>
                <c:pt idx="99">
                  <c:v>1.11604E-6</c:v>
                </c:pt>
                <c:pt idx="100">
                  <c:v>1.1168799999999999E-6</c:v>
                </c:pt>
                <c:pt idx="101">
                  <c:v>1.1177300000000001E-6</c:v>
                </c:pt>
                <c:pt idx="102">
                  <c:v>1.11919E-6</c:v>
                </c:pt>
                <c:pt idx="103">
                  <c:v>1.12065E-6</c:v>
                </c:pt>
                <c:pt idx="104">
                  <c:v>1.1221199999999999E-6</c:v>
                </c:pt>
                <c:pt idx="105">
                  <c:v>1.12358E-6</c:v>
                </c:pt>
                <c:pt idx="106">
                  <c:v>1.12506E-6</c:v>
                </c:pt>
                <c:pt idx="107">
                  <c:v>1.12803E-6</c:v>
                </c:pt>
                <c:pt idx="108">
                  <c:v>1.13102E-6</c:v>
                </c:pt>
                <c:pt idx="109">
                  <c:v>1.13402E-6</c:v>
                </c:pt>
                <c:pt idx="110">
                  <c:v>1.1370300000000001E-6</c:v>
                </c:pt>
                <c:pt idx="111">
                  <c:v>1.1400600000000001E-6</c:v>
                </c:pt>
                <c:pt idx="112">
                  <c:v>1.1459399999999999E-6</c:v>
                </c:pt>
                <c:pt idx="113">
                  <c:v>1.15188E-6</c:v>
                </c:pt>
                <c:pt idx="114">
                  <c:v>1.1578599999999999E-6</c:v>
                </c:pt>
                <c:pt idx="115">
                  <c:v>1.1638899999999999E-6</c:v>
                </c:pt>
                <c:pt idx="116">
                  <c:v>1.16997E-6</c:v>
                </c:pt>
                <c:pt idx="117">
                  <c:v>1.1772299999999999E-6</c:v>
                </c:pt>
                <c:pt idx="118">
                  <c:v>1.1845499999999999E-6</c:v>
                </c:pt>
                <c:pt idx="119">
                  <c:v>1.1919500000000001E-6</c:v>
                </c:pt>
                <c:pt idx="120">
                  <c:v>1.19942E-6</c:v>
                </c:pt>
                <c:pt idx="121">
                  <c:v>1.2069700000000001E-6</c:v>
                </c:pt>
                <c:pt idx="122">
                  <c:v>1.2145899999999999E-6</c:v>
                </c:pt>
                <c:pt idx="123">
                  <c:v>1.2267799999999999E-6</c:v>
                </c:pt>
                <c:pt idx="124">
                  <c:v>1.2391699999999999E-6</c:v>
                </c:pt>
                <c:pt idx="125">
                  <c:v>1.2517400000000001E-6</c:v>
                </c:pt>
                <c:pt idx="126">
                  <c:v>1.2644999999999999E-6</c:v>
                </c:pt>
                <c:pt idx="127">
                  <c:v>1.2774499999999999E-6</c:v>
                </c:pt>
                <c:pt idx="128">
                  <c:v>1.2906E-6</c:v>
                </c:pt>
                <c:pt idx="129">
                  <c:v>1.3115799999999999E-6</c:v>
                </c:pt>
                <c:pt idx="130">
                  <c:v>1.33304E-6</c:v>
                </c:pt>
                <c:pt idx="131">
                  <c:v>1.3549999999999999E-6</c:v>
                </c:pt>
                <c:pt idx="132">
                  <c:v>1.37748E-6</c:v>
                </c:pt>
                <c:pt idx="133">
                  <c:v>1.4004599999999999E-6</c:v>
                </c:pt>
                <c:pt idx="134">
                  <c:v>1.4239700000000001E-6</c:v>
                </c:pt>
                <c:pt idx="135">
                  <c:v>1.46062E-6</c:v>
                </c:pt>
                <c:pt idx="136">
                  <c:v>1.4985299999999999E-6</c:v>
                </c:pt>
                <c:pt idx="137">
                  <c:v>1.53774E-6</c:v>
                </c:pt>
                <c:pt idx="138">
                  <c:v>1.5782899999999999E-6</c:v>
                </c:pt>
                <c:pt idx="139">
                  <c:v>1.62021E-6</c:v>
                </c:pt>
                <c:pt idx="140">
                  <c:v>1.6635400000000001E-6</c:v>
                </c:pt>
                <c:pt idx="141">
                  <c:v>1.7249E-6</c:v>
                </c:pt>
                <c:pt idx="142">
                  <c:v>1.78907E-6</c:v>
                </c:pt>
                <c:pt idx="143">
                  <c:v>1.8561600000000001E-6</c:v>
                </c:pt>
                <c:pt idx="144">
                  <c:v>1.9263000000000001E-6</c:v>
                </c:pt>
                <c:pt idx="145">
                  <c:v>1.9995999999999999E-6</c:v>
                </c:pt>
                <c:pt idx="146">
                  <c:v>2.0762000000000001E-6</c:v>
                </c:pt>
                <c:pt idx="147">
                  <c:v>2.2024100000000001E-6</c:v>
                </c:pt>
                <c:pt idx="148">
                  <c:v>2.3375099999999999E-6</c:v>
                </c:pt>
                <c:pt idx="149">
                  <c:v>2.4820600000000001E-6</c:v>
                </c:pt>
                <c:pt idx="150">
                  <c:v>2.63668E-6</c:v>
                </c:pt>
                <c:pt idx="151">
                  <c:v>2.8020399999999999E-6</c:v>
                </c:pt>
                <c:pt idx="152">
                  <c:v>3.0147799999999998E-6</c:v>
                </c:pt>
                <c:pt idx="153">
                  <c:v>3.24519E-6</c:v>
                </c:pt>
                <c:pt idx="154">
                  <c:v>3.4946800000000001E-6</c:v>
                </c:pt>
                <c:pt idx="155">
                  <c:v>3.76477E-6</c:v>
                </c:pt>
                <c:pt idx="156">
                  <c:v>4.0571100000000004E-6</c:v>
                </c:pt>
                <c:pt idx="157">
                  <c:v>4.3735100000000004E-6</c:v>
                </c:pt>
                <c:pt idx="158">
                  <c:v>4.8268600000000001E-6</c:v>
                </c:pt>
                <c:pt idx="159">
                  <c:v>5.3294199999999999E-6</c:v>
                </c:pt>
                <c:pt idx="160">
                  <c:v>5.8864199999999998E-6</c:v>
                </c:pt>
                <c:pt idx="161">
                  <c:v>6.5036800000000004E-6</c:v>
                </c:pt>
                <c:pt idx="162">
                  <c:v>7.1876399999999998E-6</c:v>
                </c:pt>
                <c:pt idx="163">
                  <c:v>7.9454399999999996E-6</c:v>
                </c:pt>
                <c:pt idx="164">
                  <c:v>8.9103300000000005E-6</c:v>
                </c:pt>
                <c:pt idx="165">
                  <c:v>9.9947400000000005E-6</c:v>
                </c:pt>
                <c:pt idx="166">
                  <c:v>1.12134E-5</c:v>
                </c:pt>
                <c:pt idx="167">
                  <c:v>1.2582700000000001E-5</c:v>
                </c:pt>
                <c:pt idx="168">
                  <c:v>1.41213E-5</c:v>
                </c:pt>
                <c:pt idx="169">
                  <c:v>1.5850099999999999E-5</c:v>
                </c:pt>
                <c:pt idx="170">
                  <c:v>1.7792399999999999E-5</c:v>
                </c:pt>
                <c:pt idx="171">
                  <c:v>1.99745E-5</c:v>
                </c:pt>
                <c:pt idx="172">
                  <c:v>2.2425999999999998E-5</c:v>
                </c:pt>
                <c:pt idx="173">
                  <c:v>2.51801E-5</c:v>
                </c:pt>
                <c:pt idx="174">
                  <c:v>2.8274000000000001E-5</c:v>
                </c:pt>
                <c:pt idx="175">
                  <c:v>3.1053200000000003E-5</c:v>
                </c:pt>
                <c:pt idx="176">
                  <c:v>3.35365E-5</c:v>
                </c:pt>
                <c:pt idx="177">
                  <c:v>3.6219E-5</c:v>
                </c:pt>
                <c:pt idx="178">
                  <c:v>3.6686300000000001E-5</c:v>
                </c:pt>
                <c:pt idx="179">
                  <c:v>3.7159800000000003E-5</c:v>
                </c:pt>
                <c:pt idx="180">
                  <c:v>3.7639299999999997E-5</c:v>
                </c:pt>
                <c:pt idx="181">
                  <c:v>3.8124999999999998E-5</c:v>
                </c:pt>
                <c:pt idx="182">
                  <c:v>3.86171E-5</c:v>
                </c:pt>
                <c:pt idx="183">
                  <c:v>3.9596099999999999E-5</c:v>
                </c:pt>
                <c:pt idx="184">
                  <c:v>4.0600099999999998E-5</c:v>
                </c:pt>
                <c:pt idx="185">
                  <c:v>4.1629599999999999E-5</c:v>
                </c:pt>
                <c:pt idx="186">
                  <c:v>4.2685200000000003E-5</c:v>
                </c:pt>
                <c:pt idx="187">
                  <c:v>4.4410699999999998E-5</c:v>
                </c:pt>
                <c:pt idx="188">
                  <c:v>4.6206099999999998E-5</c:v>
                </c:pt>
                <c:pt idx="189">
                  <c:v>4.8074200000000001E-5</c:v>
                </c:pt>
                <c:pt idx="190">
                  <c:v>5.0018000000000001E-5</c:v>
                </c:pt>
                <c:pt idx="191">
                  <c:v>5.2040499999999998E-5</c:v>
                </c:pt>
                <c:pt idx="192">
                  <c:v>5.7646199999999997E-5</c:v>
                </c:pt>
                <c:pt idx="193">
                  <c:v>6.2317900000000002E-5</c:v>
                </c:pt>
                <c:pt idx="194">
                  <c:v>6.7368799999999998E-5</c:v>
                </c:pt>
                <c:pt idx="195">
                  <c:v>7.2829600000000005E-5</c:v>
                </c:pt>
                <c:pt idx="196">
                  <c:v>7.8733500000000001E-5</c:v>
                </c:pt>
                <c:pt idx="197">
                  <c:v>8.5116400000000004E-5</c:v>
                </c:pt>
                <c:pt idx="198">
                  <c:v>9.3494300000000004E-5</c:v>
                </c:pt>
                <c:pt idx="199" formatCode="General">
                  <c:v>1.02697E-4</c:v>
                </c:pt>
                <c:pt idx="200" formatCode="General">
                  <c:v>1.1280700000000001E-4</c:v>
                </c:pt>
                <c:pt idx="201" formatCode="General">
                  <c:v>1.2391299999999999E-4</c:v>
                </c:pt>
                <c:pt idx="202" formatCode="General">
                  <c:v>1.36112E-4</c:v>
                </c:pt>
                <c:pt idx="203" formatCode="General">
                  <c:v>1.4951299999999999E-4</c:v>
                </c:pt>
                <c:pt idx="204" formatCode="General">
                  <c:v>1.661E-4</c:v>
                </c:pt>
                <c:pt idx="205" formatCode="General">
                  <c:v>1.8452799999999999E-4</c:v>
                </c:pt>
                <c:pt idx="206" formatCode="General">
                  <c:v>2.0500100000000001E-4</c:v>
                </c:pt>
                <c:pt idx="207" formatCode="General">
                  <c:v>2.2774700000000001E-4</c:v>
                </c:pt>
                <c:pt idx="208" formatCode="General">
                  <c:v>2.4722299999999997E-4</c:v>
                </c:pt>
                <c:pt idx="209" formatCode="General">
                  <c:v>2.5034299999999998E-4</c:v>
                </c:pt>
                <c:pt idx="210" formatCode="General">
                  <c:v>2.5350200000000001E-4</c:v>
                </c:pt>
                <c:pt idx="211" formatCode="General">
                  <c:v>2.5670100000000002E-4</c:v>
                </c:pt>
                <c:pt idx="212" formatCode="General">
                  <c:v>2.5994000000000001E-4</c:v>
                </c:pt>
                <c:pt idx="213" formatCode="General">
                  <c:v>2.6321999999999999E-4</c:v>
                </c:pt>
                <c:pt idx="214" formatCode="General">
                  <c:v>2.6990500000000003E-4</c:v>
                </c:pt>
                <c:pt idx="215" formatCode="General">
                  <c:v>2.7676000000000003E-4</c:v>
                </c:pt>
                <c:pt idx="216" formatCode="General">
                  <c:v>2.83789E-4</c:v>
                </c:pt>
                <c:pt idx="217" formatCode="General">
                  <c:v>2.9099600000000002E-4</c:v>
                </c:pt>
                <c:pt idx="218" formatCode="General">
                  <c:v>3.0380899999999999E-4</c:v>
                </c:pt>
                <c:pt idx="219" formatCode="General">
                  <c:v>3.1718600000000001E-4</c:v>
                </c:pt>
                <c:pt idx="220" formatCode="General">
                  <c:v>3.3115199999999998E-4</c:v>
                </c:pt>
                <c:pt idx="221" formatCode="General">
                  <c:v>3.4573299999999998E-4</c:v>
                </c:pt>
                <c:pt idx="222" formatCode="General">
                  <c:v>3.60956E-4</c:v>
                </c:pt>
                <c:pt idx="223" formatCode="General">
                  <c:v>4.0289900000000002E-4</c:v>
                </c:pt>
                <c:pt idx="224" formatCode="General">
                  <c:v>4.3586999999999999E-4</c:v>
                </c:pt>
                <c:pt idx="225" formatCode="General">
                  <c:v>4.7153899999999999E-4</c:v>
                </c:pt>
                <c:pt idx="226" formatCode="General">
                  <c:v>5.1012699999999998E-4</c:v>
                </c:pt>
                <c:pt idx="227" formatCode="General">
                  <c:v>5.5187300000000003E-4</c:v>
                </c:pt>
                <c:pt idx="228" formatCode="General">
                  <c:v>5.9703600000000001E-4</c:v>
                </c:pt>
                <c:pt idx="229" formatCode="General">
                  <c:v>6.5505999999999995E-4</c:v>
                </c:pt>
                <c:pt idx="230" formatCode="General">
                  <c:v>7.1872400000000001E-4</c:v>
                </c:pt>
                <c:pt idx="231" formatCode="General">
                  <c:v>7.88574E-4</c:v>
                </c:pt>
                <c:pt idx="232" formatCode="General">
                  <c:v>8.65214E-4</c:v>
                </c:pt>
                <c:pt idx="233" formatCode="General">
                  <c:v>9.4930199999999996E-4</c:v>
                </c:pt>
                <c:pt idx="234" formatCode="General">
                  <c:v>1.04156E-3</c:v>
                </c:pt>
                <c:pt idx="235" formatCode="General">
                  <c:v>1.1582000000000001E-3</c:v>
                </c:pt>
                <c:pt idx="236" formatCode="General">
                  <c:v>1.2878900000000001E-3</c:v>
                </c:pt>
                <c:pt idx="237" formatCode="General">
                  <c:v>1.4321099999999999E-3</c:v>
                </c:pt>
                <c:pt idx="238" formatCode="General">
                  <c:v>1.5924699999999999E-3</c:v>
                </c:pt>
                <c:pt idx="239" formatCode="General">
                  <c:v>1.7708000000000001E-3</c:v>
                </c:pt>
                <c:pt idx="240" formatCode="General">
                  <c:v>1.9690900000000002E-3</c:v>
                </c:pt>
                <c:pt idx="241" formatCode="General">
                  <c:v>2.1895899999999999E-3</c:v>
                </c:pt>
                <c:pt idx="242" formatCode="General">
                  <c:v>2.4347700000000002E-3</c:v>
                </c:pt>
                <c:pt idx="243" formatCode="General">
                  <c:v>2.7074199999999999E-3</c:v>
                </c:pt>
                <c:pt idx="244" formatCode="General">
                  <c:v>3.0105900000000001E-3</c:v>
                </c:pt>
                <c:pt idx="245" formatCode="General">
                  <c:v>3.3477099999999998E-3</c:v>
                </c:pt>
                <c:pt idx="246" formatCode="General">
                  <c:v>3.7225800000000001E-3</c:v>
                </c:pt>
                <c:pt idx="247" formatCode="General">
                  <c:v>4.1394300000000004E-3</c:v>
                </c:pt>
                <c:pt idx="248" formatCode="General">
                  <c:v>4.6029499999999998E-3</c:v>
                </c:pt>
                <c:pt idx="249" formatCode="General">
                  <c:v>5.1183699999999997E-3</c:v>
                </c:pt>
                <c:pt idx="250" formatCode="General">
                  <c:v>5.6915100000000003E-3</c:v>
                </c:pt>
                <c:pt idx="251" formatCode="General">
                  <c:v>6.3288199999999998E-3</c:v>
                </c:pt>
                <c:pt idx="252" formatCode="General">
                  <c:v>7.0374900000000004E-3</c:v>
                </c:pt>
                <c:pt idx="253" formatCode="General">
                  <c:v>7.8255100000000008E-3</c:v>
                </c:pt>
                <c:pt idx="254" formatCode="General">
                  <c:v>8.7017599999999994E-3</c:v>
                </c:pt>
                <c:pt idx="255" formatCode="General">
                  <c:v>9.6761199999999999E-3</c:v>
                </c:pt>
                <c:pt idx="256" formatCode="General">
                  <c:v>1.0759599999999999E-2</c:v>
                </c:pt>
                <c:pt idx="257" formatCode="General">
                  <c:v>1.1964300000000001E-2</c:v>
                </c:pt>
                <c:pt idx="258" formatCode="General">
                  <c:v>1.3304E-2</c:v>
                </c:pt>
                <c:pt idx="259" formatCode="General">
                  <c:v>1.47936E-2</c:v>
                </c:pt>
                <c:pt idx="260" formatCode="General">
                  <c:v>1.64499E-2</c:v>
                </c:pt>
                <c:pt idx="261" formatCode="General">
                  <c:v>1.8291700000000001E-2</c:v>
                </c:pt>
                <c:pt idx="262" formatCode="General">
                  <c:v>2.0339699999999999E-2</c:v>
                </c:pt>
                <c:pt idx="263" formatCode="General">
                  <c:v>2.2617000000000002E-2</c:v>
                </c:pt>
                <c:pt idx="264" formatCode="General">
                  <c:v>2.5149100000000001E-2</c:v>
                </c:pt>
                <c:pt idx="265" formatCode="General">
                  <c:v>2.7964599999999999E-2</c:v>
                </c:pt>
                <c:pt idx="266" formatCode="General">
                  <c:v>3.1095299999999999E-2</c:v>
                </c:pt>
                <c:pt idx="267" formatCode="General">
                  <c:v>3.45764E-2</c:v>
                </c:pt>
                <c:pt idx="268" formatCode="General">
                  <c:v>3.8447000000000002E-2</c:v>
                </c:pt>
                <c:pt idx="269" formatCode="General">
                  <c:v>4.2750700000000003E-2</c:v>
                </c:pt>
                <c:pt idx="270" formatCode="General">
                  <c:v>4.7536000000000002E-2</c:v>
                </c:pt>
                <c:pt idx="271" formatCode="General">
                  <c:v>5.2856599999999997E-2</c:v>
                </c:pt>
                <c:pt idx="272" formatCode="General">
                  <c:v>5.8772499999999998E-2</c:v>
                </c:pt>
                <c:pt idx="273" formatCode="General">
                  <c:v>6.5350099999999994E-2</c:v>
                </c:pt>
                <c:pt idx="274" formatCode="General">
                  <c:v>7.26633E-2</c:v>
                </c:pt>
                <c:pt idx="275" formatCode="General">
                  <c:v>8.0794299999999999E-2</c:v>
                </c:pt>
                <c:pt idx="276" formatCode="General">
                  <c:v>8.9834300000000006E-2</c:v>
                </c:pt>
                <c:pt idx="277" formatCode="General">
                  <c:v>9.9884899999999999E-2</c:v>
                </c:pt>
                <c:pt idx="278" formatCode="General">
                  <c:v>0.111059</c:v>
                </c:pt>
                <c:pt idx="279" formatCode="General">
                  <c:v>0.12348099999999999</c:v>
                </c:pt>
                <c:pt idx="280" formatCode="General">
                  <c:v>0.137291</c:v>
                </c:pt>
                <c:pt idx="281" formatCode="General">
                  <c:v>0.152643</c:v>
                </c:pt>
                <c:pt idx="282" formatCode="General">
                  <c:v>0.169708</c:v>
                </c:pt>
                <c:pt idx="283" formatCode="General">
                  <c:v>0.18867800000000001</c:v>
                </c:pt>
                <c:pt idx="284" formatCode="General">
                  <c:v>0.20976300000000001</c:v>
                </c:pt>
                <c:pt idx="285" formatCode="General">
                  <c:v>0.23319899999999999</c:v>
                </c:pt>
                <c:pt idx="286" formatCode="General">
                  <c:v>0.259245</c:v>
                </c:pt>
                <c:pt idx="287" formatCode="General">
                  <c:v>0.28281200000000001</c:v>
                </c:pt>
                <c:pt idx="288" formatCode="General">
                  <c:v>0.30851400000000001</c:v>
                </c:pt>
                <c:pt idx="289" formatCode="General">
                  <c:v>0.33654299999999998</c:v>
                </c:pt>
                <c:pt idx="290" formatCode="General">
                  <c:v>0.36710599999999999</c:v>
                </c:pt>
                <c:pt idx="291" formatCode="General">
                  <c:v>0.40043099999999998</c:v>
                </c:pt>
                <c:pt idx="292" formatCode="General">
                  <c:v>0.43676399999999999</c:v>
                </c:pt>
                <c:pt idx="293" formatCode="General">
                  <c:v>0.47637200000000002</c:v>
                </c:pt>
                <c:pt idx="294" formatCode="General">
                  <c:v>0.51954699999999998</c:v>
                </c:pt>
                <c:pt idx="295" formatCode="General">
                  <c:v>0.55693599999999999</c:v>
                </c:pt>
                <c:pt idx="296" formatCode="General">
                  <c:v>0.58872100000000005</c:v>
                </c:pt>
                <c:pt idx="297" formatCode="General">
                  <c:v>0.62230300000000005</c:v>
                </c:pt>
                <c:pt idx="298" formatCode="General">
                  <c:v>0.627807</c:v>
                </c:pt>
                <c:pt idx="299" formatCode="General">
                  <c:v>0.63335900000000001</c:v>
                </c:pt>
                <c:pt idx="300" formatCode="General">
                  <c:v>0.63895999999999997</c:v>
                </c:pt>
                <c:pt idx="301" formatCode="General">
                  <c:v>0.64461000000000002</c:v>
                </c:pt>
                <c:pt idx="302" formatCode="General">
                  <c:v>0.65030900000000003</c:v>
                </c:pt>
                <c:pt idx="303" formatCode="General">
                  <c:v>0.65849800000000003</c:v>
                </c:pt>
                <c:pt idx="304" formatCode="General">
                  <c:v>0.66678899999999997</c:v>
                </c:pt>
                <c:pt idx="305" formatCode="General">
                  <c:v>0.67518400000000001</c:v>
                </c:pt>
                <c:pt idx="306" formatCode="General">
                  <c:v>0.68368300000000004</c:v>
                </c:pt>
                <c:pt idx="307" formatCode="General">
                  <c:v>0.70018000000000002</c:v>
                </c:pt>
                <c:pt idx="308" formatCode="General">
                  <c:v>0.71706999999999999</c:v>
                </c:pt>
                <c:pt idx="309" formatCode="General">
                  <c:v>0.73436299999999999</c:v>
                </c:pt>
                <c:pt idx="310" formatCode="General">
                  <c:v>0.75206799999999996</c:v>
                </c:pt>
                <c:pt idx="311" formatCode="General">
                  <c:v>0.77769299999999997</c:v>
                </c:pt>
                <c:pt idx="312" formatCode="General">
                  <c:v>0.80417799999999995</c:v>
                </c:pt>
                <c:pt idx="313" formatCode="General">
                  <c:v>0.83155199999999996</c:v>
                </c:pt>
                <c:pt idx="314" formatCode="General">
                  <c:v>0.85984300000000002</c:v>
                </c:pt>
                <c:pt idx="315" formatCode="General">
                  <c:v>0.881965</c:v>
                </c:pt>
                <c:pt idx="316" formatCode="General">
                  <c:v>0.90029999999999999</c:v>
                </c:pt>
                <c:pt idx="317" formatCode="General">
                  <c:v>0.91900899999999996</c:v>
                </c:pt>
                <c:pt idx="318" formatCode="General">
                  <c:v>0.92246899999999998</c:v>
                </c:pt>
                <c:pt idx="319" formatCode="General">
                  <c:v>0.92594200000000004</c:v>
                </c:pt>
                <c:pt idx="320" formatCode="General">
                  <c:v>0.92942800000000003</c:v>
                </c:pt>
                <c:pt idx="321" formatCode="General">
                  <c:v>0.93292600000000003</c:v>
                </c:pt>
                <c:pt idx="322" formatCode="General">
                  <c:v>0.93996299999999999</c:v>
                </c:pt>
                <c:pt idx="323" formatCode="General">
                  <c:v>0.94705099999999998</c:v>
                </c:pt>
                <c:pt idx="324" formatCode="General">
                  <c:v>0.95419200000000004</c:v>
                </c:pt>
                <c:pt idx="325" formatCode="General">
                  <c:v>0.96138500000000005</c:v>
                </c:pt>
                <c:pt idx="326" formatCode="General">
                  <c:v>0.98211700000000002</c:v>
                </c:pt>
                <c:pt idx="327" formatCode="General">
                  <c:v>1.00329</c:v>
                </c:pt>
                <c:pt idx="328" formatCode="General">
                  <c:v>1.0248999999999999</c:v>
                </c:pt>
                <c:pt idx="329" formatCode="General">
                  <c:v>1.04698</c:v>
                </c:pt>
                <c:pt idx="330" formatCode="General">
                  <c:v>1.0769899999999999</c:v>
                </c:pt>
                <c:pt idx="331" formatCode="General">
                  <c:v>1.1078399999999999</c:v>
                </c:pt>
                <c:pt idx="332" formatCode="General">
                  <c:v>1.1395500000000001</c:v>
                </c:pt>
                <c:pt idx="333" formatCode="General">
                  <c:v>1.17215</c:v>
                </c:pt>
                <c:pt idx="334" formatCode="General">
                  <c:v>1.20566</c:v>
                </c:pt>
                <c:pt idx="335" formatCode="General">
                  <c:v>1.2400899999999999</c:v>
                </c:pt>
                <c:pt idx="336" formatCode="General">
                  <c:v>1.2665900000000001</c:v>
                </c:pt>
                <c:pt idx="337" formatCode="General">
                  <c:v>1.2936399999999999</c:v>
                </c:pt>
                <c:pt idx="338" formatCode="General">
                  <c:v>1.32125</c:v>
                </c:pt>
                <c:pt idx="339" formatCode="General">
                  <c:v>1.32612</c:v>
                </c:pt>
                <c:pt idx="340" formatCode="General">
                  <c:v>1.33101</c:v>
                </c:pt>
                <c:pt idx="341" formatCode="General">
                  <c:v>1.33592</c:v>
                </c:pt>
                <c:pt idx="342" formatCode="General">
                  <c:v>1.3408500000000001</c:v>
                </c:pt>
                <c:pt idx="343" formatCode="General">
                  <c:v>1.3507499999999999</c:v>
                </c:pt>
                <c:pt idx="344" formatCode="General">
                  <c:v>1.36073</c:v>
                </c:pt>
                <c:pt idx="345" formatCode="General">
                  <c:v>1.3707800000000001</c:v>
                </c:pt>
                <c:pt idx="346" formatCode="General">
                  <c:v>1.3809</c:v>
                </c:pt>
                <c:pt idx="347" formatCode="General">
                  <c:v>1.4073</c:v>
                </c:pt>
                <c:pt idx="348" formatCode="General">
                  <c:v>1.4341999999999999</c:v>
                </c:pt>
                <c:pt idx="349" formatCode="General">
                  <c:v>1.4615899999999999</c:v>
                </c:pt>
                <c:pt idx="350" formatCode="General">
                  <c:v>1.4894799999999999</c:v>
                </c:pt>
                <c:pt idx="351" formatCode="General">
                  <c:v>1.5275399999999999</c:v>
                </c:pt>
                <c:pt idx="352" formatCode="General">
                  <c:v>1.56653</c:v>
                </c:pt>
                <c:pt idx="353" formatCode="General">
                  <c:v>1.60646</c:v>
                </c:pt>
                <c:pt idx="354" formatCode="General">
                  <c:v>1.64737</c:v>
                </c:pt>
                <c:pt idx="355" formatCode="General">
                  <c:v>1.68927</c:v>
                </c:pt>
                <c:pt idx="356" formatCode="General">
                  <c:v>1.7237</c:v>
                </c:pt>
                <c:pt idx="357" formatCode="General">
                  <c:v>1.7587999999999999</c:v>
                </c:pt>
                <c:pt idx="358" formatCode="General">
                  <c:v>1.79457</c:v>
                </c:pt>
                <c:pt idx="359" formatCode="General">
                  <c:v>1.8310200000000001</c:v>
                </c:pt>
                <c:pt idx="360" formatCode="General">
                  <c:v>1.8681700000000001</c:v>
                </c:pt>
                <c:pt idx="361" formatCode="General">
                  <c:v>1.9060299999999999</c:v>
                </c:pt>
                <c:pt idx="362" formatCode="General">
                  <c:v>1.9446000000000001</c:v>
                </c:pt>
                <c:pt idx="363" formatCode="General">
                  <c:v>1.9838899999999999</c:v>
                </c:pt>
                <c:pt idx="364" formatCode="General">
                  <c:v>2.03179</c:v>
                </c:pt>
                <c:pt idx="365" formatCode="General">
                  <c:v>2.0807500000000001</c:v>
                </c:pt>
                <c:pt idx="366" formatCode="General">
                  <c:v>2.1307900000000002</c:v>
                </c:pt>
                <c:pt idx="367" formatCode="General">
                  <c:v>2.17137</c:v>
                </c:pt>
                <c:pt idx="368" formatCode="General">
                  <c:v>2.20485</c:v>
                </c:pt>
                <c:pt idx="369" formatCode="General">
                  <c:v>2.2387999999999999</c:v>
                </c:pt>
                <c:pt idx="370" formatCode="General">
                  <c:v>2.2732299999999999</c:v>
                </c:pt>
                <c:pt idx="371" formatCode="General">
                  <c:v>2.3081299999999998</c:v>
                </c:pt>
                <c:pt idx="372" formatCode="General">
                  <c:v>2.3435199999999998</c:v>
                </c:pt>
                <c:pt idx="373" formatCode="General">
                  <c:v>2.4008400000000001</c:v>
                </c:pt>
                <c:pt idx="374" formatCode="General">
                  <c:v>2.4594</c:v>
                </c:pt>
                <c:pt idx="375" formatCode="General">
                  <c:v>2.5192299999999999</c:v>
                </c:pt>
                <c:pt idx="376" formatCode="General">
                  <c:v>2.5803199999999999</c:v>
                </c:pt>
                <c:pt idx="377" formatCode="General">
                  <c:v>2.6427100000000001</c:v>
                </c:pt>
                <c:pt idx="378" formatCode="General">
                  <c:v>2.7356699999999998</c:v>
                </c:pt>
                <c:pt idx="379" formatCode="General">
                  <c:v>2.8313899999999999</c:v>
                </c:pt>
                <c:pt idx="380" formatCode="General">
                  <c:v>2.9298999999999999</c:v>
                </c:pt>
                <c:pt idx="381" formatCode="General">
                  <c:v>3.0311900000000001</c:v>
                </c:pt>
                <c:pt idx="382" formatCode="General">
                  <c:v>3.1352799999999998</c:v>
                </c:pt>
                <c:pt idx="383" formatCode="General">
                  <c:v>3.24213</c:v>
                </c:pt>
                <c:pt idx="384" formatCode="General">
                  <c:v>3.3517199999999998</c:v>
                </c:pt>
                <c:pt idx="385" formatCode="General">
                  <c:v>3.464</c:v>
                </c:pt>
                <c:pt idx="386" formatCode="General">
                  <c:v>3.5788899999999999</c:v>
                </c:pt>
                <c:pt idx="387" formatCode="General">
                  <c:v>3.6962899999999999</c:v>
                </c:pt>
                <c:pt idx="388" formatCode="General">
                  <c:v>3.8160799999999999</c:v>
                </c:pt>
                <c:pt idx="389" formatCode="General">
                  <c:v>3.9380899999999999</c:v>
                </c:pt>
                <c:pt idx="390" formatCode="General">
                  <c:v>4.0621200000000002</c:v>
                </c:pt>
                <c:pt idx="391" formatCode="General">
                  <c:v>4.1879099999999996</c:v>
                </c:pt>
                <c:pt idx="392" formatCode="General">
                  <c:v>4.2936199999999998</c:v>
                </c:pt>
                <c:pt idx="393" formatCode="General">
                  <c:v>4.4001299999999999</c:v>
                </c:pt>
                <c:pt idx="394" formatCode="General">
                  <c:v>4.5072000000000001</c:v>
                </c:pt>
                <c:pt idx="395" formatCode="General">
                  <c:v>4.6145500000000004</c:v>
                </c:pt>
                <c:pt idx="396" formatCode="General">
                  <c:v>4.7218499999999999</c:v>
                </c:pt>
                <c:pt idx="397" formatCode="General">
                  <c:v>4.8287199999999997</c:v>
                </c:pt>
                <c:pt idx="398" formatCode="General">
                  <c:v>4.9347500000000002</c:v>
                </c:pt>
                <c:pt idx="399" formatCode="General">
                  <c:v>5.0394199999999998</c:v>
                </c:pt>
                <c:pt idx="400" formatCode="General">
                  <c:v>5.1421700000000001</c:v>
                </c:pt>
                <c:pt idx="401" formatCode="General">
                  <c:v>5.2423599999999997</c:v>
                </c:pt>
                <c:pt idx="402" formatCode="General">
                  <c:v>5.3392400000000002</c:v>
                </c:pt>
                <c:pt idx="403" formatCode="General">
                  <c:v>5.4319699999999997</c:v>
                </c:pt>
                <c:pt idx="404" formatCode="General">
                  <c:v>5.5196100000000001</c:v>
                </c:pt>
                <c:pt idx="405" formatCode="General">
                  <c:v>5.6010600000000004</c:v>
                </c:pt>
                <c:pt idx="406" formatCode="General">
                  <c:v>5.6751100000000001</c:v>
                </c:pt>
                <c:pt idx="407" formatCode="General">
                  <c:v>5.74038</c:v>
                </c:pt>
                <c:pt idx="408" formatCode="General">
                  <c:v>5.7953400000000004</c:v>
                </c:pt>
                <c:pt idx="409" formatCode="General">
                  <c:v>5.8313600000000001</c:v>
                </c:pt>
                <c:pt idx="410" formatCode="General">
                  <c:v>5.8583499999999997</c:v>
                </c:pt>
                <c:pt idx="411" formatCode="General">
                  <c:v>5.8751899999999999</c:v>
                </c:pt>
                <c:pt idx="412" formatCode="General">
                  <c:v>5.8807</c:v>
                </c:pt>
                <c:pt idx="413" formatCode="General">
                  <c:v>5.8804999999999996</c:v>
                </c:pt>
                <c:pt idx="414" formatCode="General">
                  <c:v>5.8800499999999998</c:v>
                </c:pt>
                <c:pt idx="415" formatCode="General">
                  <c:v>5.87934</c:v>
                </c:pt>
                <c:pt idx="416" formatCode="General">
                  <c:v>5.8783799999999999</c:v>
                </c:pt>
                <c:pt idx="417" formatCode="General">
                  <c:v>5.8771500000000003</c:v>
                </c:pt>
                <c:pt idx="418" formatCode="General">
                  <c:v>5.87418</c:v>
                </c:pt>
                <c:pt idx="419" formatCode="General">
                  <c:v>5.8702699999999997</c:v>
                </c:pt>
                <c:pt idx="420" formatCode="General">
                  <c:v>5.8654099999999998</c:v>
                </c:pt>
                <c:pt idx="421" formatCode="General">
                  <c:v>5.8595699999999997</c:v>
                </c:pt>
                <c:pt idx="422" formatCode="General">
                  <c:v>5.8497599999999998</c:v>
                </c:pt>
                <c:pt idx="423" formatCode="General">
                  <c:v>5.8379500000000002</c:v>
                </c:pt>
                <c:pt idx="424" formatCode="General">
                  <c:v>5.8240600000000002</c:v>
                </c:pt>
                <c:pt idx="425" formatCode="General">
                  <c:v>5.8080400000000001</c:v>
                </c:pt>
                <c:pt idx="426" formatCode="General">
                  <c:v>5.7877099999999997</c:v>
                </c:pt>
                <c:pt idx="427" formatCode="General">
                  <c:v>5.7645900000000001</c:v>
                </c:pt>
                <c:pt idx="428" formatCode="General">
                  <c:v>5.7385900000000003</c:v>
                </c:pt>
                <c:pt idx="429" formatCode="General">
                  <c:v>5.7096200000000001</c:v>
                </c:pt>
                <c:pt idx="430" formatCode="General">
                  <c:v>5.6775900000000004</c:v>
                </c:pt>
                <c:pt idx="431" formatCode="General">
                  <c:v>5.6383299999999998</c:v>
                </c:pt>
                <c:pt idx="432" formatCode="General">
                  <c:v>5.5950899999999999</c:v>
                </c:pt>
                <c:pt idx="433" formatCode="General">
                  <c:v>5.5477699999999999</c:v>
                </c:pt>
                <c:pt idx="434" formatCode="General">
                  <c:v>5.4962600000000004</c:v>
                </c:pt>
                <c:pt idx="435" formatCode="General">
                  <c:v>5.44048</c:v>
                </c:pt>
                <c:pt idx="436" formatCode="General">
                  <c:v>5.3683199999999998</c:v>
                </c:pt>
                <c:pt idx="437" formatCode="General">
                  <c:v>5.2898699999999996</c:v>
                </c:pt>
                <c:pt idx="438" formatCode="General">
                  <c:v>5.2050400000000003</c:v>
                </c:pt>
                <c:pt idx="439" formatCode="General">
                  <c:v>5.1304100000000004</c:v>
                </c:pt>
                <c:pt idx="440" formatCode="General">
                  <c:v>5.0514099999999997</c:v>
                </c:pt>
                <c:pt idx="441" formatCode="General">
                  <c:v>4.9680499999999999</c:v>
                </c:pt>
                <c:pt idx="442" formatCode="General">
                  <c:v>4.88035</c:v>
                </c:pt>
                <c:pt idx="443" formatCode="General">
                  <c:v>4.7883599999999999</c:v>
                </c:pt>
                <c:pt idx="444" formatCode="General">
                  <c:v>4.6921499999999998</c:v>
                </c:pt>
                <c:pt idx="445" formatCode="General">
                  <c:v>4.5918200000000002</c:v>
                </c:pt>
                <c:pt idx="446" formatCode="General">
                  <c:v>4.4874799999999997</c:v>
                </c:pt>
                <c:pt idx="447" formatCode="General">
                  <c:v>4.37927</c:v>
                </c:pt>
                <c:pt idx="448" formatCode="General">
                  <c:v>4.24329</c:v>
                </c:pt>
                <c:pt idx="449" formatCode="General">
                  <c:v>4.1022600000000002</c:v>
                </c:pt>
                <c:pt idx="450" formatCode="General">
                  <c:v>3.95662</c:v>
                </c:pt>
                <c:pt idx="451" formatCode="General">
                  <c:v>3.8410099999999998</c:v>
                </c:pt>
                <c:pt idx="452" formatCode="General">
                  <c:v>3.82057</c:v>
                </c:pt>
                <c:pt idx="453" formatCode="General">
                  <c:v>3.8000600000000002</c:v>
                </c:pt>
                <c:pt idx="454" formatCode="General">
                  <c:v>3.77949</c:v>
                </c:pt>
                <c:pt idx="455" formatCode="General">
                  <c:v>3.7588499999999998</c:v>
                </c:pt>
                <c:pt idx="456" formatCode="General">
                  <c:v>3.7381500000000001</c:v>
                </c:pt>
                <c:pt idx="457" formatCode="General">
                  <c:v>3.7015699999999998</c:v>
                </c:pt>
                <c:pt idx="458" formatCode="General">
                  <c:v>3.6648100000000001</c:v>
                </c:pt>
                <c:pt idx="459" formatCode="General">
                  <c:v>3.6278800000000002</c:v>
                </c:pt>
                <c:pt idx="460" formatCode="General">
                  <c:v>3.5907800000000001</c:v>
                </c:pt>
                <c:pt idx="461" formatCode="General">
                  <c:v>3.5159799999999999</c:v>
                </c:pt>
                <c:pt idx="462" formatCode="General">
                  <c:v>3.4406400000000001</c:v>
                </c:pt>
                <c:pt idx="463" formatCode="General">
                  <c:v>3.3648099999999999</c:v>
                </c:pt>
                <c:pt idx="464" formatCode="General">
                  <c:v>3.2885900000000001</c:v>
                </c:pt>
                <c:pt idx="465" formatCode="General">
                  <c:v>3.2013799999999999</c:v>
                </c:pt>
                <c:pt idx="466" formatCode="General">
                  <c:v>3.1138699999999999</c:v>
                </c:pt>
                <c:pt idx="467" formatCode="General">
                  <c:v>3.0261900000000002</c:v>
                </c:pt>
                <c:pt idx="468" formatCode="General">
                  <c:v>2.93845</c:v>
                </c:pt>
                <c:pt idx="469" formatCode="General">
                  <c:v>2.8507699999999998</c:v>
                </c:pt>
                <c:pt idx="470" formatCode="General">
                  <c:v>2.74458</c:v>
                </c:pt>
                <c:pt idx="471" formatCode="General">
                  <c:v>2.63889</c:v>
                </c:pt>
                <c:pt idx="472" formatCode="General">
                  <c:v>2.5339299999999998</c:v>
                </c:pt>
                <c:pt idx="473" formatCode="General">
                  <c:v>2.4299200000000001</c:v>
                </c:pt>
                <c:pt idx="474" formatCode="General">
                  <c:v>2.32707</c:v>
                </c:pt>
                <c:pt idx="475" formatCode="General">
                  <c:v>2.2148599999999998</c:v>
                </c:pt>
                <c:pt idx="476" formatCode="General">
                  <c:v>2.1046</c:v>
                </c:pt>
                <c:pt idx="477" formatCode="General">
                  <c:v>1.99655</c:v>
                </c:pt>
                <c:pt idx="478" formatCode="General">
                  <c:v>1.89096</c:v>
                </c:pt>
                <c:pt idx="479" formatCode="General">
                  <c:v>1.78806</c:v>
                </c:pt>
                <c:pt idx="480" formatCode="General">
                  <c:v>1.6880299999999999</c:v>
                </c:pt>
                <c:pt idx="481" formatCode="General">
                  <c:v>1.59108</c:v>
                </c:pt>
                <c:pt idx="482" formatCode="General">
                  <c:v>1.49735</c:v>
                </c:pt>
                <c:pt idx="483" formatCode="General">
                  <c:v>1.4027400000000001</c:v>
                </c:pt>
                <c:pt idx="484" formatCode="General">
                  <c:v>1.3119400000000001</c:v>
                </c:pt>
                <c:pt idx="485" formatCode="General">
                  <c:v>1.22506</c:v>
                </c:pt>
                <c:pt idx="486" formatCode="General">
                  <c:v>1.1421600000000001</c:v>
                </c:pt>
                <c:pt idx="487" formatCode="General">
                  <c:v>1.0632900000000001</c:v>
                </c:pt>
                <c:pt idx="488" formatCode="General">
                  <c:v>0.98843700000000001</c:v>
                </c:pt>
                <c:pt idx="489" formatCode="General">
                  <c:v>0.917601</c:v>
                </c:pt>
                <c:pt idx="490" formatCode="General">
                  <c:v>0.90417099999999995</c:v>
                </c:pt>
                <c:pt idx="491" formatCode="General">
                  <c:v>0.89089300000000005</c:v>
                </c:pt>
                <c:pt idx="492" formatCode="General">
                  <c:v>0.87776799999999999</c:v>
                </c:pt>
                <c:pt idx="493" formatCode="General">
                  <c:v>0.86479499999999998</c:v>
                </c:pt>
                <c:pt idx="494" formatCode="General">
                  <c:v>0.85197199999999995</c:v>
                </c:pt>
                <c:pt idx="495" formatCode="General">
                  <c:v>0.83066600000000002</c:v>
                </c:pt>
                <c:pt idx="496" formatCode="General">
                  <c:v>0.80978700000000003</c:v>
                </c:pt>
                <c:pt idx="497" formatCode="General">
                  <c:v>0.789331</c:v>
                </c:pt>
                <c:pt idx="498" formatCode="General">
                  <c:v>0.76929400000000003</c:v>
                </c:pt>
                <c:pt idx="499" formatCode="General">
                  <c:v>0.74174899999999999</c:v>
                </c:pt>
                <c:pt idx="500" formatCode="General">
                  <c:v>0.71502100000000002</c:v>
                </c:pt>
                <c:pt idx="501" formatCode="General">
                  <c:v>0.68909900000000002</c:v>
                </c:pt>
                <c:pt idx="502" formatCode="General">
                  <c:v>0.66396999999999995</c:v>
                </c:pt>
                <c:pt idx="503" formatCode="General">
                  <c:v>0.63486200000000004</c:v>
                </c:pt>
                <c:pt idx="504" formatCode="General">
                  <c:v>0.606854</c:v>
                </c:pt>
                <c:pt idx="505" formatCode="General">
                  <c:v>0.57992299999999997</c:v>
                </c:pt>
                <c:pt idx="506" formatCode="General">
                  <c:v>0.55404399999999998</c:v>
                </c:pt>
                <c:pt idx="507" formatCode="General">
                  <c:v>0.52919099999999997</c:v>
                </c:pt>
                <c:pt idx="508" formatCode="General">
                  <c:v>0.495002</c:v>
                </c:pt>
                <c:pt idx="509" formatCode="General">
                  <c:v>0.46282400000000001</c:v>
                </c:pt>
                <c:pt idx="510" formatCode="General">
                  <c:v>0.43257099999999998</c:v>
                </c:pt>
                <c:pt idx="511" formatCode="General">
                  <c:v>0.40416000000000002</c:v>
                </c:pt>
                <c:pt idx="512" formatCode="General">
                  <c:v>0.37750499999999998</c:v>
                </c:pt>
                <c:pt idx="513" formatCode="General">
                  <c:v>0.34658699999999998</c:v>
                </c:pt>
                <c:pt idx="514" formatCode="General">
                  <c:v>0.31810899999999998</c:v>
                </c:pt>
                <c:pt idx="515" formatCode="General">
                  <c:v>0.29191</c:v>
                </c:pt>
                <c:pt idx="516" formatCode="General">
                  <c:v>0.26783600000000002</c:v>
                </c:pt>
                <c:pt idx="517" formatCode="General">
                  <c:v>0.25019999999999998</c:v>
                </c:pt>
                <c:pt idx="518" formatCode="General">
                  <c:v>0.24681500000000001</c:v>
                </c:pt>
                <c:pt idx="519" formatCode="General">
                  <c:v>0.243476</c:v>
                </c:pt>
                <c:pt idx="520" formatCode="General">
                  <c:v>0.24018300000000001</c:v>
                </c:pt>
                <c:pt idx="521" formatCode="General">
                  <c:v>0.23693400000000001</c:v>
                </c:pt>
                <c:pt idx="522" formatCode="General">
                  <c:v>0.23372899999999999</c:v>
                </c:pt>
                <c:pt idx="523" formatCode="General">
                  <c:v>0.22745099999999999</c:v>
                </c:pt>
                <c:pt idx="524" formatCode="General">
                  <c:v>0.22134400000000001</c:v>
                </c:pt>
                <c:pt idx="525" formatCode="General">
                  <c:v>0.21540400000000001</c:v>
                </c:pt>
                <c:pt idx="526" formatCode="General">
                  <c:v>0.20962600000000001</c:v>
                </c:pt>
                <c:pt idx="527" formatCode="General">
                  <c:v>0.20116999999999999</c:v>
                </c:pt>
                <c:pt idx="528" formatCode="General">
                  <c:v>0.19306400000000001</c:v>
                </c:pt>
                <c:pt idx="529" formatCode="General">
                  <c:v>0.18529399999999999</c:v>
                </c:pt>
                <c:pt idx="530" formatCode="General">
                  <c:v>0.17784900000000001</c:v>
                </c:pt>
                <c:pt idx="531" formatCode="General">
                  <c:v>0.16919600000000001</c:v>
                </c:pt>
                <c:pt idx="532" formatCode="General">
                  <c:v>0.16098299999999999</c:v>
                </c:pt>
                <c:pt idx="533" formatCode="General">
                  <c:v>0.15318699999999999</c:v>
                </c:pt>
                <c:pt idx="534" formatCode="General">
                  <c:v>0.14579</c:v>
                </c:pt>
                <c:pt idx="535" formatCode="General">
                  <c:v>0.13877</c:v>
                </c:pt>
                <c:pt idx="536" formatCode="General">
                  <c:v>0.13109000000000001</c:v>
                </c:pt>
                <c:pt idx="537" formatCode="General">
                  <c:v>0.123863</c:v>
                </c:pt>
                <c:pt idx="538" formatCode="General">
                  <c:v>0.118266</c:v>
                </c:pt>
                <c:pt idx="539" formatCode="General">
                  <c:v>0.11294</c:v>
                </c:pt>
                <c:pt idx="540" formatCode="General">
                  <c:v>0.107874</c:v>
                </c:pt>
                <c:pt idx="541" formatCode="General">
                  <c:v>0.10305400000000001</c:v>
                </c:pt>
                <c:pt idx="542" formatCode="General">
                  <c:v>9.8469000000000001E-2</c:v>
                </c:pt>
                <c:pt idx="543" formatCode="General">
                  <c:v>9.4106499999999996E-2</c:v>
                </c:pt>
                <c:pt idx="544" formatCode="General">
                  <c:v>8.9955800000000002E-2</c:v>
                </c:pt>
                <c:pt idx="545" formatCode="General">
                  <c:v>8.6006399999999997E-2</c:v>
                </c:pt>
                <c:pt idx="546" formatCode="General">
                  <c:v>8.1604300000000005E-2</c:v>
                </c:pt>
                <c:pt idx="547" formatCode="General">
                  <c:v>7.7451400000000004E-2</c:v>
                </c:pt>
                <c:pt idx="548" formatCode="General">
                  <c:v>7.3533200000000007E-2</c:v>
                </c:pt>
                <c:pt idx="549" formatCode="General">
                  <c:v>6.9835900000000006E-2</c:v>
                </c:pt>
                <c:pt idx="550" formatCode="General">
                  <c:v>6.6346500000000003E-2</c:v>
                </c:pt>
                <c:pt idx="551" formatCode="General">
                  <c:v>6.2564499999999995E-2</c:v>
                </c:pt>
                <c:pt idx="552" formatCode="General">
                  <c:v>5.9025099999999997E-2</c:v>
                </c:pt>
                <c:pt idx="553" formatCode="General">
                  <c:v>5.5711900000000002E-2</c:v>
                </c:pt>
                <c:pt idx="554" formatCode="General">
                  <c:v>5.2609499999999997E-2</c:v>
                </c:pt>
                <c:pt idx="555" formatCode="General">
                  <c:v>4.9703799999999999E-2</c:v>
                </c:pt>
                <c:pt idx="556" formatCode="General">
                  <c:v>4.69814E-2</c:v>
                </c:pt>
                <c:pt idx="557" formatCode="General">
                  <c:v>4.4429799999999998E-2</c:v>
                </c:pt>
                <c:pt idx="558" formatCode="General">
                  <c:v>4.2037699999999997E-2</c:v>
                </c:pt>
                <c:pt idx="559" formatCode="General">
                  <c:v>3.9794299999999998E-2</c:v>
                </c:pt>
                <c:pt idx="560" formatCode="General">
                  <c:v>3.7689500000000001E-2</c:v>
                </c:pt>
                <c:pt idx="561" formatCode="General">
                  <c:v>3.5714099999999999E-2</c:v>
                </c:pt>
                <c:pt idx="562" formatCode="General">
                  <c:v>3.3859399999999998E-2</c:v>
                </c:pt>
                <c:pt idx="563" formatCode="General">
                  <c:v>3.2117399999999997E-2</c:v>
                </c:pt>
                <c:pt idx="564" formatCode="General">
                  <c:v>3.04806E-2</c:v>
                </c:pt>
                <c:pt idx="565" formatCode="General">
                  <c:v>2.8942099999999998E-2</c:v>
                </c:pt>
                <c:pt idx="566" formatCode="General">
                  <c:v>2.74953E-2</c:v>
                </c:pt>
                <c:pt idx="567" formatCode="General">
                  <c:v>2.61342E-2</c:v>
                </c:pt>
                <c:pt idx="568" formatCode="General">
                  <c:v>2.4853299999999998E-2</c:v>
                </c:pt>
                <c:pt idx="569" formatCode="General">
                  <c:v>2.36472E-2</c:v>
                </c:pt>
                <c:pt idx="570" formatCode="General">
                  <c:v>2.2511199999999999E-2</c:v>
                </c:pt>
                <c:pt idx="571" formatCode="General">
                  <c:v>2.1440799999999999E-2</c:v>
                </c:pt>
                <c:pt idx="572" formatCode="General">
                  <c:v>2.0431600000000001E-2</c:v>
                </c:pt>
                <c:pt idx="573" formatCode="General">
                  <c:v>1.9479799999999999E-2</c:v>
                </c:pt>
                <c:pt idx="574" formatCode="General">
                  <c:v>1.83894E-2</c:v>
                </c:pt>
                <c:pt idx="575" formatCode="General">
                  <c:v>1.7373199999999998E-2</c:v>
                </c:pt>
                <c:pt idx="576" formatCode="General">
                  <c:v>1.64253E-2</c:v>
                </c:pt>
                <c:pt idx="577" formatCode="General">
                  <c:v>1.55408E-2</c:v>
                </c:pt>
                <c:pt idx="578" formatCode="General">
                  <c:v>1.4714700000000001E-2</c:v>
                </c:pt>
                <c:pt idx="579" formatCode="General">
                  <c:v>1.40965E-2</c:v>
                </c:pt>
                <c:pt idx="580" formatCode="General">
                  <c:v>1.3510400000000001E-2</c:v>
                </c:pt>
                <c:pt idx="581" formatCode="General">
                  <c:v>1.29547E-2</c:v>
                </c:pt>
                <c:pt idx="582" formatCode="General">
                  <c:v>1.28761E-2</c:v>
                </c:pt>
                <c:pt idx="583" formatCode="General">
                  <c:v>1.2798199999999999E-2</c:v>
                </c:pt>
                <c:pt idx="584" formatCode="General">
                  <c:v>1.2720800000000001E-2</c:v>
                </c:pt>
                <c:pt idx="585" formatCode="General">
                  <c:v>1.2644000000000001E-2</c:v>
                </c:pt>
                <c:pt idx="586" formatCode="General">
                  <c:v>1.2492100000000001E-2</c:v>
                </c:pt>
                <c:pt idx="587" formatCode="General">
                  <c:v>1.23426E-2</c:v>
                </c:pt>
                <c:pt idx="588" formatCode="General">
                  <c:v>1.2195299999999999E-2</c:v>
                </c:pt>
                <c:pt idx="589" formatCode="General">
                  <c:v>1.20503E-2</c:v>
                </c:pt>
                <c:pt idx="590" formatCode="General">
                  <c:v>1.17395E-2</c:v>
                </c:pt>
                <c:pt idx="591" formatCode="General">
                  <c:v>1.14389E-2</c:v>
                </c:pt>
                <c:pt idx="592" formatCode="General">
                  <c:v>1.1148E-2</c:v>
                </c:pt>
                <c:pt idx="593" formatCode="General">
                  <c:v>1.0866499999999999E-2</c:v>
                </c:pt>
                <c:pt idx="594" formatCode="General">
                  <c:v>1.04741E-2</c:v>
                </c:pt>
                <c:pt idx="595" formatCode="General">
                  <c:v>1.00997E-2</c:v>
                </c:pt>
                <c:pt idx="596" formatCode="General">
                  <c:v>9.7423300000000004E-3</c:v>
                </c:pt>
                <c:pt idx="597" formatCode="General">
                  <c:v>9.4011500000000005E-3</c:v>
                </c:pt>
                <c:pt idx="598" formatCode="General">
                  <c:v>9.0753099999999996E-3</c:v>
                </c:pt>
                <c:pt idx="599" formatCode="General">
                  <c:v>8.7035800000000007E-3</c:v>
                </c:pt>
                <c:pt idx="600" formatCode="General">
                  <c:v>8.3514699999999997E-3</c:v>
                </c:pt>
                <c:pt idx="601" formatCode="General">
                  <c:v>8.0178000000000003E-3</c:v>
                </c:pt>
                <c:pt idx="602" formatCode="General">
                  <c:v>7.7014500000000003E-3</c:v>
                </c:pt>
                <c:pt idx="603" formatCode="General">
                  <c:v>7.40137E-3</c:v>
                </c:pt>
                <c:pt idx="604" formatCode="General">
                  <c:v>7.1166099999999998E-3</c:v>
                </c:pt>
                <c:pt idx="605" formatCode="General">
                  <c:v>6.8462499999999999E-3</c:v>
                </c:pt>
                <c:pt idx="606" formatCode="General">
                  <c:v>6.5894500000000002E-3</c:v>
                </c:pt>
                <c:pt idx="607" formatCode="General">
                  <c:v>6.3551099999999998E-3</c:v>
                </c:pt>
                <c:pt idx="608" formatCode="General">
                  <c:v>6.1318700000000002E-3</c:v>
                </c:pt>
                <c:pt idx="609" formatCode="General">
                  <c:v>5.91911E-3</c:v>
                </c:pt>
                <c:pt idx="610" formatCode="General">
                  <c:v>5.7162699999999999E-3</c:v>
                </c:pt>
                <c:pt idx="611" formatCode="General">
                  <c:v>5.5227899999999996E-3</c:v>
                </c:pt>
                <c:pt idx="612" formatCode="General">
                  <c:v>5.3381899999999996E-3</c:v>
                </c:pt>
                <c:pt idx="613" formatCode="General">
                  <c:v>5.1619700000000001E-3</c:v>
                </c:pt>
                <c:pt idx="614" formatCode="General">
                  <c:v>4.9937000000000002E-3</c:v>
                </c:pt>
                <c:pt idx="615" formatCode="General">
                  <c:v>4.8329599999999999E-3</c:v>
                </c:pt>
                <c:pt idx="616" formatCode="General">
                  <c:v>4.6793399999999997E-3</c:v>
                </c:pt>
                <c:pt idx="617" formatCode="General">
                  <c:v>4.5324900000000001E-3</c:v>
                </c:pt>
                <c:pt idx="618" formatCode="General">
                  <c:v>4.3920399999999998E-3</c:v>
                </c:pt>
                <c:pt idx="619" formatCode="General">
                  <c:v>4.2576699999999999E-3</c:v>
                </c:pt>
                <c:pt idx="620" formatCode="General">
                  <c:v>4.1290800000000003E-3</c:v>
                </c:pt>
                <c:pt idx="621" formatCode="General">
                  <c:v>3.9629899999999996E-3</c:v>
                </c:pt>
                <c:pt idx="622" formatCode="General">
                  <c:v>3.8063400000000001E-3</c:v>
                </c:pt>
                <c:pt idx="623" formatCode="General">
                  <c:v>3.6585099999999998E-3</c:v>
                </c:pt>
                <c:pt idx="624" formatCode="General">
                  <c:v>3.5189000000000002E-3</c:v>
                </c:pt>
                <c:pt idx="625" formatCode="General">
                  <c:v>3.3869799999999999E-3</c:v>
                </c:pt>
                <c:pt idx="626" formatCode="General">
                  <c:v>3.2494899999999998E-3</c:v>
                </c:pt>
                <c:pt idx="627" formatCode="General">
                  <c:v>3.1201599999999999E-3</c:v>
                </c:pt>
                <c:pt idx="628" formatCode="General">
                  <c:v>2.9984199999999999E-3</c:v>
                </c:pt>
                <c:pt idx="629" formatCode="General">
                  <c:v>2.88375E-3</c:v>
                </c:pt>
                <c:pt idx="630" formatCode="General">
                  <c:v>2.7756600000000001E-3</c:v>
                </c:pt>
                <c:pt idx="631" formatCode="General">
                  <c:v>2.6737000000000002E-3</c:v>
                </c:pt>
                <c:pt idx="632" formatCode="General">
                  <c:v>2.5432900000000001E-3</c:v>
                </c:pt>
                <c:pt idx="633" formatCode="General">
                  <c:v>2.4226500000000002E-3</c:v>
                </c:pt>
                <c:pt idx="634" formatCode="General">
                  <c:v>2.3109200000000002E-3</c:v>
                </c:pt>
                <c:pt idx="635" formatCode="General">
                  <c:v>2.20732E-3</c:v>
                </c:pt>
                <c:pt idx="636" formatCode="General">
                  <c:v>2.11115E-3</c:v>
                </c:pt>
                <c:pt idx="637" formatCode="General">
                  <c:v>2.0217899999999999E-3</c:v>
                </c:pt>
                <c:pt idx="638" formatCode="General">
                  <c:v>1.93866E-3</c:v>
                </c:pt>
                <c:pt idx="639" formatCode="General">
                  <c:v>1.86126E-3</c:v>
                </c:pt>
                <c:pt idx="640" formatCode="General">
                  <c:v>1.7891199999999999E-3</c:v>
                </c:pt>
                <c:pt idx="641" formatCode="General">
                  <c:v>1.7218299999999999E-3</c:v>
                </c:pt>
                <c:pt idx="642" formatCode="General">
                  <c:v>1.6589899999999999E-3</c:v>
                </c:pt>
                <c:pt idx="643" formatCode="General">
                  <c:v>1.60027E-3</c:v>
                </c:pt>
                <c:pt idx="644" formatCode="General">
                  <c:v>1.5363099999999999E-3</c:v>
                </c:pt>
                <c:pt idx="645" formatCode="General">
                  <c:v>1.47712E-3</c:v>
                </c:pt>
                <c:pt idx="646" formatCode="General">
                  <c:v>1.42227E-3</c:v>
                </c:pt>
                <c:pt idx="647" formatCode="General">
                  <c:v>1.3714E-3</c:v>
                </c:pt>
                <c:pt idx="648" formatCode="General">
                  <c:v>1.3346899999999999E-3</c:v>
                </c:pt>
                <c:pt idx="649" formatCode="General">
                  <c:v>1.3280500000000001E-3</c:v>
                </c:pt>
                <c:pt idx="650" formatCode="General">
                  <c:v>1.3214800000000001E-3</c:v>
                </c:pt>
                <c:pt idx="651" formatCode="General">
                  <c:v>1.3149699999999999E-3</c:v>
                </c:pt>
                <c:pt idx="652" formatCode="General">
                  <c:v>1.30854E-3</c:v>
                </c:pt>
                <c:pt idx="653" formatCode="General">
                  <c:v>1.3021700000000001E-3</c:v>
                </c:pt>
                <c:pt idx="654" formatCode="General">
                  <c:v>1.2912500000000001E-3</c:v>
                </c:pt>
                <c:pt idx="655" formatCode="General">
                  <c:v>1.2805200000000001E-3</c:v>
                </c:pt>
                <c:pt idx="656" formatCode="General">
                  <c:v>1.2699899999999999E-3</c:v>
                </c:pt>
                <c:pt idx="657" formatCode="General">
                  <c:v>1.25965E-3</c:v>
                </c:pt>
                <c:pt idx="658" formatCode="General">
                  <c:v>1.2388799999999999E-3</c:v>
                </c:pt>
                <c:pt idx="659" formatCode="General">
                  <c:v>1.2188699999999999E-3</c:v>
                </c:pt>
                <c:pt idx="660" formatCode="General">
                  <c:v>1.1996000000000001E-3</c:v>
                </c:pt>
                <c:pt idx="661" formatCode="General">
                  <c:v>1.1810200000000001E-3</c:v>
                </c:pt>
                <c:pt idx="662" formatCode="General">
                  <c:v>1.1573899999999999E-3</c:v>
                </c:pt>
                <c:pt idx="663" formatCode="General">
                  <c:v>1.13488E-3</c:v>
                </c:pt>
                <c:pt idx="664" formatCode="General">
                  <c:v>1.11344E-3</c:v>
                </c:pt>
                <c:pt idx="665" formatCode="General">
                  <c:v>1.1103700000000001E-3</c:v>
                </c:pt>
                <c:pt idx="666" formatCode="General">
                  <c:v>1.1073299999999999E-3</c:v>
                </c:pt>
                <c:pt idx="667" formatCode="General">
                  <c:v>1.1043100000000001E-3</c:v>
                </c:pt>
                <c:pt idx="668" formatCode="General">
                  <c:v>1.1012999999999999E-3</c:v>
                </c:pt>
                <c:pt idx="669" formatCode="General">
                  <c:v>1.0983200000000001E-3</c:v>
                </c:pt>
                <c:pt idx="670" formatCode="General">
                  <c:v>1.0926099999999999E-3</c:v>
                </c:pt>
                <c:pt idx="671" formatCode="General">
                  <c:v>1.08698E-3</c:v>
                </c:pt>
                <c:pt idx="672" formatCode="General">
                  <c:v>1.08143E-3</c:v>
                </c:pt>
                <c:pt idx="673" formatCode="General">
                  <c:v>1.07595E-3</c:v>
                </c:pt>
                <c:pt idx="674" formatCode="General">
                  <c:v>1.0624499999999999E-3</c:v>
                </c:pt>
                <c:pt idx="675" formatCode="General">
                  <c:v>1.04941E-3</c:v>
                </c:pt>
                <c:pt idx="676" formatCode="General">
                  <c:v>1.03681E-3</c:v>
                </c:pt>
                <c:pt idx="677" formatCode="General">
                  <c:v>1.0246400000000001E-3</c:v>
                </c:pt>
                <c:pt idx="678" formatCode="General">
                  <c:v>1.00708E-3</c:v>
                </c:pt>
                <c:pt idx="679" formatCode="General">
                  <c:v>9.9040499999999997E-4</c:v>
                </c:pt>
                <c:pt idx="680" formatCode="General">
                  <c:v>9.7456799999999998E-4</c:v>
                </c:pt>
                <c:pt idx="681" formatCode="General">
                  <c:v>9.5952699999999995E-4</c:v>
                </c:pt>
                <c:pt idx="682" formatCode="General">
                  <c:v>9.4524400000000003E-4</c:v>
                </c:pt>
                <c:pt idx="683" formatCode="General">
                  <c:v>9.26519E-4</c:v>
                </c:pt>
                <c:pt idx="684" formatCode="General">
                  <c:v>9.09105E-4</c:v>
                </c:pt>
                <c:pt idx="685" formatCode="General">
                  <c:v>8.9291800000000003E-4</c:v>
                </c:pt>
                <c:pt idx="686" formatCode="General">
                  <c:v>8.7788099999999995E-4</c:v>
                </c:pt>
                <c:pt idx="687" formatCode="General">
                  <c:v>8.6392399999999996E-4</c:v>
                </c:pt>
                <c:pt idx="688" formatCode="General">
                  <c:v>8.4778399999999997E-4</c:v>
                </c:pt>
                <c:pt idx="689" formatCode="General">
                  <c:v>8.3313599999999995E-4</c:v>
                </c:pt>
                <c:pt idx="690" formatCode="General">
                  <c:v>8.1987599999999998E-4</c:v>
                </c:pt>
                <c:pt idx="691" formatCode="General">
                  <c:v>8.0790799999999998E-4</c:v>
                </c:pt>
                <c:pt idx="692" formatCode="General">
                  <c:v>7.9714800000000002E-4</c:v>
                </c:pt>
                <c:pt idx="693" formatCode="General">
                  <c:v>7.8751699999999995E-4</c:v>
                </c:pt>
                <c:pt idx="694" formatCode="General">
                  <c:v>7.77708E-4</c:v>
                </c:pt>
                <c:pt idx="695" formatCode="General">
                  <c:v>7.6921900000000002E-4</c:v>
                </c:pt>
                <c:pt idx="696" formatCode="General">
                  <c:v>7.6196499999999997E-4</c:v>
                </c:pt>
                <c:pt idx="697" formatCode="General">
                  <c:v>7.5587099999999997E-4</c:v>
                </c:pt>
                <c:pt idx="698" formatCode="General">
                  <c:v>7.5086900000000004E-4</c:v>
                </c:pt>
                <c:pt idx="699" formatCode="General">
                  <c:v>7.4689899999999998E-4</c:v>
                </c:pt>
                <c:pt idx="700" formatCode="General">
                  <c:v>7.4248900000000004E-4</c:v>
                </c:pt>
                <c:pt idx="701" formatCode="General">
                  <c:v>7.4050799999999996E-4</c:v>
                </c:pt>
                <c:pt idx="702" formatCode="General">
                  <c:v>7.4078999999999996E-4</c:v>
                </c:pt>
                <c:pt idx="703" formatCode="General">
                  <c:v>7.4320099999999997E-4</c:v>
                </c:pt>
                <c:pt idx="704" formatCode="General">
                  <c:v>7.4763200000000003E-4</c:v>
                </c:pt>
                <c:pt idx="705" formatCode="General">
                  <c:v>7.5399699999999996E-4</c:v>
                </c:pt>
                <c:pt idx="706" formatCode="General">
                  <c:v>7.6222699999999998E-4</c:v>
                </c:pt>
                <c:pt idx="707" formatCode="General">
                  <c:v>7.7227199999999995E-4</c:v>
                </c:pt>
                <c:pt idx="708" formatCode="General">
                  <c:v>7.8409499999999995E-4</c:v>
                </c:pt>
                <c:pt idx="709" formatCode="General">
                  <c:v>7.9767200000000003E-4</c:v>
                </c:pt>
                <c:pt idx="710" formatCode="General">
                  <c:v>8.12991E-4</c:v>
                </c:pt>
                <c:pt idx="711" formatCode="General">
                  <c:v>8.3005000000000004E-4</c:v>
                </c:pt>
                <c:pt idx="712" formatCode="General">
                  <c:v>8.5302200000000005E-4</c:v>
                </c:pt>
                <c:pt idx="713" formatCode="General">
                  <c:v>8.7858100000000002E-4</c:v>
                </c:pt>
                <c:pt idx="714" formatCode="General">
                  <c:v>9.0677399999999995E-4</c:v>
                </c:pt>
                <c:pt idx="715" formatCode="General">
                  <c:v>9.3766300000000004E-4</c:v>
                </c:pt>
                <c:pt idx="716" formatCode="General">
                  <c:v>9.4226200000000003E-4</c:v>
                </c:pt>
                <c:pt idx="717" formatCode="General">
                  <c:v>9.4691600000000001E-4</c:v>
                </c:pt>
                <c:pt idx="718" formatCode="General">
                  <c:v>9.5162700000000003E-4</c:v>
                </c:pt>
                <c:pt idx="719" formatCode="General">
                  <c:v>9.5639399999999995E-4</c:v>
                </c:pt>
                <c:pt idx="720" formatCode="General">
                  <c:v>9.61217E-4</c:v>
                </c:pt>
                <c:pt idx="721" formatCode="General">
                  <c:v>9.6811499999999997E-4</c:v>
                </c:pt>
                <c:pt idx="722" formatCode="General">
                  <c:v>9.75127E-4</c:v>
                </c:pt>
                <c:pt idx="723" formatCode="General">
                  <c:v>9.8100199999999992E-4</c:v>
                </c:pt>
                <c:pt idx="724" formatCode="General">
                  <c:v>9.8695599999999999E-4</c:v>
                </c:pt>
                <c:pt idx="725" formatCode="General">
                  <c:v>9.9298799999999999E-4</c:v>
                </c:pt>
                <c:pt idx="726" formatCode="General">
                  <c:v>9.9834699999999991E-4</c:v>
                </c:pt>
                <c:pt idx="727" formatCode="General">
                  <c:v>1.00377E-3</c:v>
                </c:pt>
                <c:pt idx="728" formatCode="General">
                  <c:v>1.0092499999999999E-3</c:v>
                </c:pt>
                <c:pt idx="729" formatCode="General">
                  <c:v>1.01479E-3</c:v>
                </c:pt>
                <c:pt idx="730" formatCode="General">
                  <c:v>1.0204000000000001E-3</c:v>
                </c:pt>
                <c:pt idx="731" formatCode="General">
                  <c:v>1.0297699999999999E-3</c:v>
                </c:pt>
                <c:pt idx="732" formatCode="General">
                  <c:v>1.0393100000000001E-3</c:v>
                </c:pt>
                <c:pt idx="733" formatCode="General">
                  <c:v>1.0490199999999999E-3</c:v>
                </c:pt>
                <c:pt idx="734" formatCode="General">
                  <c:v>1.0589099999999999E-3</c:v>
                </c:pt>
                <c:pt idx="735" formatCode="General">
                  <c:v>1.07993E-3</c:v>
                </c:pt>
                <c:pt idx="736" formatCode="General">
                  <c:v>1.10172E-3</c:v>
                </c:pt>
                <c:pt idx="737" formatCode="General">
                  <c:v>1.1243099999999999E-3</c:v>
                </c:pt>
                <c:pt idx="738" formatCode="General">
                  <c:v>1.1477E-3</c:v>
                </c:pt>
                <c:pt idx="739" formatCode="General">
                  <c:v>1.18356E-3</c:v>
                </c:pt>
                <c:pt idx="740" formatCode="General">
                  <c:v>1.2212600000000001E-3</c:v>
                </c:pt>
                <c:pt idx="741" formatCode="General">
                  <c:v>1.2608700000000001E-3</c:v>
                </c:pt>
                <c:pt idx="742" formatCode="General">
                  <c:v>1.3024600000000001E-3</c:v>
                </c:pt>
                <c:pt idx="743" formatCode="General">
                  <c:v>1.3460900000000001E-3</c:v>
                </c:pt>
                <c:pt idx="744" formatCode="General">
                  <c:v>1.3993499999999999E-3</c:v>
                </c:pt>
                <c:pt idx="745" formatCode="General">
                  <c:v>1.4555900000000001E-3</c:v>
                </c:pt>
                <c:pt idx="746" formatCode="General">
                  <c:v>1.51494E-3</c:v>
                </c:pt>
                <c:pt idx="747" formatCode="General">
                  <c:v>1.57755E-3</c:v>
                </c:pt>
                <c:pt idx="748" formatCode="General">
                  <c:v>1.64357E-3</c:v>
                </c:pt>
                <c:pt idx="749" formatCode="General">
                  <c:v>1.7205899999999999E-3</c:v>
                </c:pt>
                <c:pt idx="750" formatCode="General">
                  <c:v>1.8021700000000001E-3</c:v>
                </c:pt>
                <c:pt idx="751" formatCode="General">
                  <c:v>1.8885600000000001E-3</c:v>
                </c:pt>
                <c:pt idx="752" formatCode="General">
                  <c:v>1.9800099999999999E-3</c:v>
                </c:pt>
                <c:pt idx="753" formatCode="General">
                  <c:v>2.0767799999999999E-3</c:v>
                </c:pt>
                <c:pt idx="754" formatCode="General">
                  <c:v>2.1791599999999999E-3</c:v>
                </c:pt>
                <c:pt idx="755" formatCode="General">
                  <c:v>2.28744E-3</c:v>
                </c:pt>
                <c:pt idx="756" formatCode="General">
                  <c:v>2.4019499999999999E-3</c:v>
                </c:pt>
                <c:pt idx="757" formatCode="General">
                  <c:v>2.5525299999999999E-3</c:v>
                </c:pt>
                <c:pt idx="758" formatCode="General">
                  <c:v>2.7138000000000002E-3</c:v>
                </c:pt>
                <c:pt idx="759" formatCode="General">
                  <c:v>2.8864699999999999E-3</c:v>
                </c:pt>
                <c:pt idx="760" formatCode="General">
                  <c:v>3.0713099999999998E-3</c:v>
                </c:pt>
                <c:pt idx="761" formatCode="General">
                  <c:v>3.2691399999999998E-3</c:v>
                </c:pt>
                <c:pt idx="762" formatCode="General">
                  <c:v>3.4808500000000002E-3</c:v>
                </c:pt>
                <c:pt idx="763" formatCode="General">
                  <c:v>3.7635199999999998E-3</c:v>
                </c:pt>
                <c:pt idx="764" formatCode="General">
                  <c:v>4.0708200000000002E-3</c:v>
                </c:pt>
                <c:pt idx="765" formatCode="General">
                  <c:v>4.4048400000000001E-3</c:v>
                </c:pt>
                <c:pt idx="766" formatCode="General">
                  <c:v>4.4559100000000004E-3</c:v>
                </c:pt>
                <c:pt idx="767" formatCode="General">
                  <c:v>4.4658299999999996E-3</c:v>
                </c:pt>
                <c:pt idx="768" formatCode="General">
                  <c:v>4.4757699999999996E-3</c:v>
                </c:pt>
                <c:pt idx="769" formatCode="General">
                  <c:v>4.4857400000000002E-3</c:v>
                </c:pt>
                <c:pt idx="770" formatCode="General">
                  <c:v>4.4957299999999999E-3</c:v>
                </c:pt>
                <c:pt idx="771" formatCode="General">
                  <c:v>4.5157900000000004E-3</c:v>
                </c:pt>
                <c:pt idx="772" formatCode="General">
                  <c:v>4.5359299999999996E-3</c:v>
                </c:pt>
                <c:pt idx="773" formatCode="General">
                  <c:v>4.55617E-3</c:v>
                </c:pt>
                <c:pt idx="774" formatCode="General">
                  <c:v>4.5997700000000004E-3</c:v>
                </c:pt>
                <c:pt idx="775" formatCode="General">
                  <c:v>4.6438E-3</c:v>
                </c:pt>
                <c:pt idx="776" formatCode="General">
                  <c:v>4.6882800000000004E-3</c:v>
                </c:pt>
                <c:pt idx="777" formatCode="General">
                  <c:v>4.7633199999999997E-3</c:v>
                </c:pt>
                <c:pt idx="778" formatCode="General">
                  <c:v>4.8396300000000001E-3</c:v>
                </c:pt>
                <c:pt idx="779" formatCode="General">
                  <c:v>4.91721E-3</c:v>
                </c:pt>
                <c:pt idx="780" formatCode="General">
                  <c:v>4.9960999999999998E-3</c:v>
                </c:pt>
                <c:pt idx="781" formatCode="General">
                  <c:v>5.0975999999999999E-3</c:v>
                </c:pt>
                <c:pt idx="782" formatCode="General">
                  <c:v>5.2012600000000001E-3</c:v>
                </c:pt>
                <c:pt idx="783" formatCode="General">
                  <c:v>5.3071200000000002E-3</c:v>
                </c:pt>
                <c:pt idx="784" formatCode="General">
                  <c:v>5.4152200000000001E-3</c:v>
                </c:pt>
                <c:pt idx="785" formatCode="General">
                  <c:v>5.5797700000000004E-3</c:v>
                </c:pt>
                <c:pt idx="786" formatCode="General">
                  <c:v>5.7495200000000002E-3</c:v>
                </c:pt>
                <c:pt idx="787" formatCode="General">
                  <c:v>5.9246200000000002E-3</c:v>
                </c:pt>
                <c:pt idx="788" formatCode="General">
                  <c:v>6.1052499999999996E-3</c:v>
                </c:pt>
                <c:pt idx="789" formatCode="General">
                  <c:v>6.2915699999999998E-3</c:v>
                </c:pt>
                <c:pt idx="790" formatCode="General">
                  <c:v>6.5986200000000004E-3</c:v>
                </c:pt>
                <c:pt idx="791" formatCode="General">
                  <c:v>6.9211300000000002E-3</c:v>
                </c:pt>
                <c:pt idx="792" formatCode="General">
                  <c:v>7.2598599999999999E-3</c:v>
                </c:pt>
                <c:pt idx="793" formatCode="General">
                  <c:v>7.61563E-3</c:v>
                </c:pt>
                <c:pt idx="794" formatCode="General">
                  <c:v>7.9892899999999996E-3</c:v>
                </c:pt>
                <c:pt idx="795" formatCode="General">
                  <c:v>8.5915799999999997E-3</c:v>
                </c:pt>
                <c:pt idx="796" formatCode="General">
                  <c:v>9.2403099999999998E-3</c:v>
                </c:pt>
                <c:pt idx="797" formatCode="General">
                  <c:v>9.9390199999999998E-3</c:v>
                </c:pt>
                <c:pt idx="798" formatCode="General">
                  <c:v>1.06915E-2</c:v>
                </c:pt>
                <c:pt idx="799" formatCode="General">
                  <c:v>1.1502E-2</c:v>
                </c:pt>
                <c:pt idx="800" formatCode="General">
                  <c:v>1.23748E-2</c:v>
                </c:pt>
                <c:pt idx="801" formatCode="General">
                  <c:v>1.3602400000000001E-2</c:v>
                </c:pt>
                <c:pt idx="802" formatCode="General">
                  <c:v>1.4953299999999999E-2</c:v>
                </c:pt>
                <c:pt idx="803" formatCode="General">
                  <c:v>1.6439800000000001E-2</c:v>
                </c:pt>
                <c:pt idx="804" formatCode="General">
                  <c:v>1.7725500000000002E-2</c:v>
                </c:pt>
                <c:pt idx="805" formatCode="General">
                  <c:v>1.7924599999999999E-2</c:v>
                </c:pt>
                <c:pt idx="806" formatCode="General">
                  <c:v>1.81259E-2</c:v>
                </c:pt>
                <c:pt idx="807" formatCode="General">
                  <c:v>1.8329600000000001E-2</c:v>
                </c:pt>
                <c:pt idx="808" formatCode="General">
                  <c:v>1.85355E-2</c:v>
                </c:pt>
                <c:pt idx="809" formatCode="General">
                  <c:v>1.8743699999999999E-2</c:v>
                </c:pt>
                <c:pt idx="810" formatCode="General">
                  <c:v>1.9167300000000002E-2</c:v>
                </c:pt>
                <c:pt idx="811" formatCode="General">
                  <c:v>1.96005E-2</c:v>
                </c:pt>
                <c:pt idx="812" formatCode="General">
                  <c:v>2.0043600000000002E-2</c:v>
                </c:pt>
                <c:pt idx="813" formatCode="General">
                  <c:v>2.04967E-2</c:v>
                </c:pt>
                <c:pt idx="814" formatCode="General">
                  <c:v>2.1330200000000001E-2</c:v>
                </c:pt>
                <c:pt idx="815" formatCode="General">
                  <c:v>2.21978E-2</c:v>
                </c:pt>
                <c:pt idx="816" formatCode="General">
                  <c:v>2.3100800000000001E-2</c:v>
                </c:pt>
                <c:pt idx="817" formatCode="General">
                  <c:v>2.4040800000000001E-2</c:v>
                </c:pt>
                <c:pt idx="818" formatCode="General">
                  <c:v>2.5019300000000001E-2</c:v>
                </c:pt>
                <c:pt idx="819" formatCode="General">
                  <c:v>2.6424300000000001E-2</c:v>
                </c:pt>
                <c:pt idx="820" formatCode="General">
                  <c:v>2.7908700000000002E-2</c:v>
                </c:pt>
                <c:pt idx="821" formatCode="General">
                  <c:v>2.9476700000000002E-2</c:v>
                </c:pt>
                <c:pt idx="822" formatCode="General">
                  <c:v>3.1133299999999999E-2</c:v>
                </c:pt>
                <c:pt idx="823" formatCode="General">
                  <c:v>3.2883299999999997E-2</c:v>
                </c:pt>
                <c:pt idx="824" formatCode="General">
                  <c:v>3.5620499999999999E-2</c:v>
                </c:pt>
                <c:pt idx="825" formatCode="General">
                  <c:v>3.8586299999999997E-2</c:v>
                </c:pt>
                <c:pt idx="826" formatCode="General">
                  <c:v>4.1799799999999998E-2</c:v>
                </c:pt>
                <c:pt idx="827" formatCode="General">
                  <c:v>4.5281500000000002E-2</c:v>
                </c:pt>
                <c:pt idx="828" formatCode="General">
                  <c:v>4.9053800000000002E-2</c:v>
                </c:pt>
                <c:pt idx="829" formatCode="General">
                  <c:v>5.3141000000000001E-2</c:v>
                </c:pt>
                <c:pt idx="830" formatCode="General">
                  <c:v>5.9128600000000003E-2</c:v>
                </c:pt>
                <c:pt idx="831" formatCode="General">
                  <c:v>6.5791699999999995E-2</c:v>
                </c:pt>
                <c:pt idx="832" formatCode="General">
                  <c:v>7.3206400000000005E-2</c:v>
                </c:pt>
                <c:pt idx="833" formatCode="General">
                  <c:v>8.1457199999999994E-2</c:v>
                </c:pt>
                <c:pt idx="834" formatCode="General">
                  <c:v>9.0638200000000002E-2</c:v>
                </c:pt>
                <c:pt idx="835" formatCode="General">
                  <c:v>0.100854</c:v>
                </c:pt>
                <c:pt idx="836" formatCode="General">
                  <c:v>0.112221</c:v>
                </c:pt>
                <c:pt idx="837" formatCode="General">
                  <c:v>0.12486899999999999</c:v>
                </c:pt>
                <c:pt idx="838" formatCode="General">
                  <c:v>0.13894100000000001</c:v>
                </c:pt>
                <c:pt idx="839" formatCode="General">
                  <c:v>0.15459800000000001</c:v>
                </c:pt>
                <c:pt idx="840" formatCode="General">
                  <c:v>0.172016</c:v>
                </c:pt>
                <c:pt idx="841" formatCode="General">
                  <c:v>0.19139400000000001</c:v>
                </c:pt>
                <c:pt idx="842" formatCode="General">
                  <c:v>0.212951</c:v>
                </c:pt>
                <c:pt idx="843" formatCode="General">
                  <c:v>0.23271</c:v>
                </c:pt>
                <c:pt idx="844" formatCode="General">
                  <c:v>0.25429800000000002</c:v>
                </c:pt>
                <c:pt idx="845" formatCode="General">
                  <c:v>0.27788200000000002</c:v>
                </c:pt>
                <c:pt idx="846" formatCode="General">
                  <c:v>0.303647</c:v>
                </c:pt>
                <c:pt idx="847" formatCode="General">
                  <c:v>0.331791</c:v>
                </c:pt>
                <c:pt idx="848" formatCode="General">
                  <c:v>0.36253200000000002</c:v>
                </c:pt>
                <c:pt idx="849" formatCode="General">
                  <c:v>0.39610699999999999</c:v>
                </c:pt>
                <c:pt idx="850" formatCode="General">
                  <c:v>0.43277399999999999</c:v>
                </c:pt>
                <c:pt idx="851" formatCode="General">
                  <c:v>0.47281299999999998</c:v>
                </c:pt>
                <c:pt idx="852" formatCode="General">
                  <c:v>0.507633</c:v>
                </c:pt>
                <c:pt idx="853" formatCode="General">
                  <c:v>0.54499699999999995</c:v>
                </c:pt>
                <c:pt idx="854" formatCode="General">
                  <c:v>0.58508700000000002</c:v>
                </c:pt>
                <c:pt idx="855" formatCode="General">
                  <c:v>0.62809700000000002</c:v>
                </c:pt>
                <c:pt idx="856" formatCode="General">
                  <c:v>0.674234</c:v>
                </c:pt>
                <c:pt idx="857" formatCode="General">
                  <c:v>0.72371799999999997</c:v>
                </c:pt>
                <c:pt idx="858" formatCode="General">
                  <c:v>0.77678499999999995</c:v>
                </c:pt>
                <c:pt idx="859" formatCode="General">
                  <c:v>0.83368399999999998</c:v>
                </c:pt>
                <c:pt idx="860" formatCode="General">
                  <c:v>0.89468000000000003</c:v>
                </c:pt>
                <c:pt idx="861" formatCode="General">
                  <c:v>0.90452500000000002</c:v>
                </c:pt>
                <c:pt idx="862" formatCode="General">
                  <c:v>0.91447599999999996</c:v>
                </c:pt>
                <c:pt idx="863" formatCode="General">
                  <c:v>0.92257800000000001</c:v>
                </c:pt>
                <c:pt idx="864" formatCode="General">
                  <c:v>0.93074999999999997</c:v>
                </c:pt>
                <c:pt idx="865" formatCode="General">
                  <c:v>0.93899299999999997</c:v>
                </c:pt>
                <c:pt idx="866" formatCode="General">
                  <c:v>0.94730700000000001</c:v>
                </c:pt>
                <c:pt idx="867" formatCode="General">
                  <c:v>0.95569400000000004</c:v>
                </c:pt>
                <c:pt idx="868" formatCode="General">
                  <c:v>0.96415300000000004</c:v>
                </c:pt>
                <c:pt idx="869" formatCode="General">
                  <c:v>0.97268600000000005</c:v>
                </c:pt>
                <c:pt idx="870" formatCode="General">
                  <c:v>0.98129299999999997</c:v>
                </c:pt>
                <c:pt idx="871" formatCode="General">
                  <c:v>0.99267300000000003</c:v>
                </c:pt>
                <c:pt idx="872" formatCode="General">
                  <c:v>1.0041800000000001</c:v>
                </c:pt>
                <c:pt idx="873" formatCode="General">
                  <c:v>1.0158199999999999</c:v>
                </c:pt>
                <c:pt idx="874" formatCode="General">
                  <c:v>1.02759</c:v>
                </c:pt>
                <c:pt idx="875" formatCode="General">
                  <c:v>1.0481199999999999</c:v>
                </c:pt>
                <c:pt idx="876" formatCode="General">
                  <c:v>1.0690500000000001</c:v>
                </c:pt>
                <c:pt idx="877" formatCode="General">
                  <c:v>1.0903799999999999</c:v>
                </c:pt>
                <c:pt idx="878" formatCode="General">
                  <c:v>1.1121300000000001</c:v>
                </c:pt>
                <c:pt idx="879" formatCode="General">
                  <c:v>1.1449100000000001</c:v>
                </c:pt>
                <c:pt idx="880" formatCode="General">
                  <c:v>1.17862</c:v>
                </c:pt>
                <c:pt idx="881" formatCode="General">
                  <c:v>1.21329</c:v>
                </c:pt>
                <c:pt idx="882" formatCode="General">
                  <c:v>1.24895</c:v>
                </c:pt>
                <c:pt idx="883" formatCode="General">
                  <c:v>1.27752</c:v>
                </c:pt>
                <c:pt idx="884" formatCode="General">
                  <c:v>1.2821800000000001</c:v>
                </c:pt>
                <c:pt idx="885" formatCode="General">
                  <c:v>1.28685</c:v>
                </c:pt>
                <c:pt idx="886" formatCode="General">
                  <c:v>1.2915399999999999</c:v>
                </c:pt>
                <c:pt idx="887" formatCode="General">
                  <c:v>1.2962499999999999</c:v>
                </c:pt>
                <c:pt idx="888" formatCode="General">
                  <c:v>1.3054699999999999</c:v>
                </c:pt>
                <c:pt idx="889" formatCode="General">
                  <c:v>1.3147599999999999</c:v>
                </c:pt>
                <c:pt idx="890" formatCode="General">
                  <c:v>1.3241000000000001</c:v>
                </c:pt>
                <c:pt idx="891" formatCode="General">
                  <c:v>1.33352</c:v>
                </c:pt>
                <c:pt idx="892" formatCode="General">
                  <c:v>1.35876</c:v>
                </c:pt>
                <c:pt idx="893" formatCode="General">
                  <c:v>1.38446</c:v>
                </c:pt>
                <c:pt idx="894" formatCode="General">
                  <c:v>1.4106300000000001</c:v>
                </c:pt>
                <c:pt idx="895" formatCode="General">
                  <c:v>1.43727</c:v>
                </c:pt>
                <c:pt idx="896" formatCode="General">
                  <c:v>1.47353</c:v>
                </c:pt>
                <c:pt idx="897" formatCode="General">
                  <c:v>1.51065</c:v>
                </c:pt>
                <c:pt idx="898" formatCode="General">
                  <c:v>1.54867</c:v>
                </c:pt>
                <c:pt idx="899" formatCode="General">
                  <c:v>1.5875999999999999</c:v>
                </c:pt>
                <c:pt idx="900" formatCode="General">
                  <c:v>1.6274599999999999</c:v>
                </c:pt>
                <c:pt idx="901" formatCode="General">
                  <c:v>1.6607799999999999</c:v>
                </c:pt>
                <c:pt idx="902" formatCode="General">
                  <c:v>1.6947399999999999</c:v>
                </c:pt>
                <c:pt idx="903" formatCode="General">
                  <c:v>1.72936</c:v>
                </c:pt>
                <c:pt idx="904" formatCode="General">
                  <c:v>1.76464</c:v>
                </c:pt>
                <c:pt idx="905" formatCode="General">
                  <c:v>1.8006</c:v>
                </c:pt>
                <c:pt idx="906" formatCode="General">
                  <c:v>1.83724</c:v>
                </c:pt>
                <c:pt idx="907" formatCode="General">
                  <c:v>1.8745799999999999</c:v>
                </c:pt>
                <c:pt idx="908" formatCode="General">
                  <c:v>1.91262</c:v>
                </c:pt>
                <c:pt idx="909" formatCode="General">
                  <c:v>1.9586399999999999</c:v>
                </c:pt>
                <c:pt idx="910" formatCode="General">
                  <c:v>2.0056799999999999</c:v>
                </c:pt>
                <c:pt idx="911" formatCode="General">
                  <c:v>2.05376</c:v>
                </c:pt>
                <c:pt idx="912" formatCode="General">
                  <c:v>2.1028899999999999</c:v>
                </c:pt>
                <c:pt idx="913" formatCode="General">
                  <c:v>2.1530900000000002</c:v>
                </c:pt>
                <c:pt idx="914" formatCode="General">
                  <c:v>2.2043699999999999</c:v>
                </c:pt>
                <c:pt idx="915" formatCode="General">
                  <c:v>2.2567499999999998</c:v>
                </c:pt>
                <c:pt idx="916" formatCode="General">
                  <c:v>2.3102499999999999</c:v>
                </c:pt>
                <c:pt idx="917" formatCode="General">
                  <c:v>2.37297</c:v>
                </c:pt>
                <c:pt idx="918" formatCode="General">
                  <c:v>2.4371999999999998</c:v>
                </c:pt>
                <c:pt idx="919" formatCode="General">
                  <c:v>2.5029300000000001</c:v>
                </c:pt>
                <c:pt idx="920" formatCode="General">
                  <c:v>2.5701999999999998</c:v>
                </c:pt>
                <c:pt idx="921" formatCode="General">
                  <c:v>2.6390099999999999</c:v>
                </c:pt>
                <c:pt idx="922" formatCode="General">
                  <c:v>2.7246299999999999</c:v>
                </c:pt>
                <c:pt idx="923" formatCode="General">
                  <c:v>2.8125499999999999</c:v>
                </c:pt>
                <c:pt idx="924" formatCode="General">
                  <c:v>2.9027699999999999</c:v>
                </c:pt>
                <c:pt idx="925" formatCode="General">
                  <c:v>2.9169200000000002</c:v>
                </c:pt>
                <c:pt idx="926" formatCode="General">
                  <c:v>2.9311199999999999</c:v>
                </c:pt>
                <c:pt idx="927" formatCode="General">
                  <c:v>2.94537</c:v>
                </c:pt>
                <c:pt idx="928" formatCode="General">
                  <c:v>2.9596800000000001</c:v>
                </c:pt>
                <c:pt idx="929" formatCode="General">
                  <c:v>2.97404</c:v>
                </c:pt>
                <c:pt idx="930" formatCode="General">
                  <c:v>2.9951699999999999</c:v>
                </c:pt>
                <c:pt idx="931" formatCode="General">
                  <c:v>3.0164200000000001</c:v>
                </c:pt>
                <c:pt idx="932" formatCode="General">
                  <c:v>3.0377800000000001</c:v>
                </c:pt>
                <c:pt idx="933" formatCode="General">
                  <c:v>3.0592600000000001</c:v>
                </c:pt>
                <c:pt idx="934" formatCode="General">
                  <c:v>3.09653</c:v>
                </c:pt>
                <c:pt idx="935" formatCode="General">
                  <c:v>3.13415</c:v>
                </c:pt>
                <c:pt idx="936" formatCode="General">
                  <c:v>3.1720999999999999</c:v>
                </c:pt>
                <c:pt idx="937" formatCode="General">
                  <c:v>3.2103999999999999</c:v>
                </c:pt>
                <c:pt idx="938" formatCode="General">
                  <c:v>3.2650700000000001</c:v>
                </c:pt>
                <c:pt idx="939" formatCode="General">
                  <c:v>3.3203999999999998</c:v>
                </c:pt>
                <c:pt idx="940" formatCode="General">
                  <c:v>3.3763899999999998</c:v>
                </c:pt>
                <c:pt idx="941" formatCode="General">
                  <c:v>3.4216600000000001</c:v>
                </c:pt>
                <c:pt idx="942" formatCode="General">
                  <c:v>3.45939</c:v>
                </c:pt>
                <c:pt idx="943" formatCode="General">
                  <c:v>3.4973900000000002</c:v>
                </c:pt>
                <c:pt idx="944" formatCode="General">
                  <c:v>3.53565</c:v>
                </c:pt>
                <c:pt idx="945" formatCode="General">
                  <c:v>3.5741800000000001</c:v>
                </c:pt>
                <c:pt idx="946" formatCode="General">
                  <c:v>3.5812599999999999</c:v>
                </c:pt>
                <c:pt idx="947" formatCode="General">
                  <c:v>3.5883500000000002</c:v>
                </c:pt>
                <c:pt idx="948" formatCode="General">
                  <c:v>3.59544</c:v>
                </c:pt>
                <c:pt idx="949" formatCode="General">
                  <c:v>3.6025499999999999</c:v>
                </c:pt>
                <c:pt idx="950" formatCode="General">
                  <c:v>3.6146199999999999</c:v>
                </c:pt>
                <c:pt idx="951" formatCode="General">
                  <c:v>3.6267200000000002</c:v>
                </c:pt>
                <c:pt idx="952" formatCode="General">
                  <c:v>3.6388400000000001</c:v>
                </c:pt>
                <c:pt idx="953" formatCode="General">
                  <c:v>3.65672</c:v>
                </c:pt>
                <c:pt idx="954" formatCode="General">
                  <c:v>3.6746599999999998</c:v>
                </c:pt>
                <c:pt idx="955" formatCode="General">
                  <c:v>3.69265</c:v>
                </c:pt>
                <c:pt idx="956" formatCode="General">
                  <c:v>3.71068</c:v>
                </c:pt>
                <c:pt idx="957" formatCode="General">
                  <c:v>3.7331099999999999</c:v>
                </c:pt>
                <c:pt idx="958" formatCode="General">
                  <c:v>3.75562</c:v>
                </c:pt>
                <c:pt idx="959" formatCode="General">
                  <c:v>3.7782</c:v>
                </c:pt>
                <c:pt idx="960" formatCode="General">
                  <c:v>3.80084</c:v>
                </c:pt>
                <c:pt idx="961" formatCode="General">
                  <c:v>3.8372799999999998</c:v>
                </c:pt>
                <c:pt idx="962" formatCode="General">
                  <c:v>3.8738999999999999</c:v>
                </c:pt>
                <c:pt idx="963" formatCode="General">
                  <c:v>3.9106700000000001</c:v>
                </c:pt>
                <c:pt idx="964" formatCode="General">
                  <c:v>3.9476</c:v>
                </c:pt>
                <c:pt idx="965" formatCode="General">
                  <c:v>4.00129</c:v>
                </c:pt>
                <c:pt idx="966" formatCode="General">
                  <c:v>4.0552599999999996</c:v>
                </c:pt>
                <c:pt idx="967" formatCode="General">
                  <c:v>4.1094799999999996</c:v>
                </c:pt>
                <c:pt idx="968" formatCode="General">
                  <c:v>4.1531500000000001</c:v>
                </c:pt>
                <c:pt idx="969" formatCode="General">
                  <c:v>4.1888800000000002</c:v>
                </c:pt>
                <c:pt idx="970" formatCode="General">
                  <c:v>4.2246800000000002</c:v>
                </c:pt>
                <c:pt idx="971" formatCode="General">
                  <c:v>4.2605399999999998</c:v>
                </c:pt>
                <c:pt idx="972" formatCode="General">
                  <c:v>4.2964399999999996</c:v>
                </c:pt>
                <c:pt idx="973" formatCode="General">
                  <c:v>4.3323900000000002</c:v>
                </c:pt>
                <c:pt idx="974" formatCode="General">
                  <c:v>4.36836</c:v>
                </c:pt>
                <c:pt idx="975" formatCode="General">
                  <c:v>4.4043299999999999</c:v>
                </c:pt>
                <c:pt idx="976" formatCode="General">
                  <c:v>4.4330999999999996</c:v>
                </c:pt>
                <c:pt idx="977" formatCode="General">
                  <c:v>4.4618500000000001</c:v>
                </c:pt>
                <c:pt idx="978" formatCode="General">
                  <c:v>4.4905799999999996</c:v>
                </c:pt>
                <c:pt idx="979" formatCode="General">
                  <c:v>4.5192899999999998</c:v>
                </c:pt>
                <c:pt idx="980" formatCode="General">
                  <c:v>4.5479700000000003</c:v>
                </c:pt>
                <c:pt idx="981" formatCode="General">
                  <c:v>4.5823499999999999</c:v>
                </c:pt>
                <c:pt idx="982" formatCode="General">
                  <c:v>4.6166499999999999</c:v>
                </c:pt>
                <c:pt idx="983" formatCode="General">
                  <c:v>4.6508599999999998</c:v>
                </c:pt>
                <c:pt idx="984" formatCode="General">
                  <c:v>4.6849499999999997</c:v>
                </c:pt>
                <c:pt idx="985" formatCode="General">
                  <c:v>4.69076</c:v>
                </c:pt>
                <c:pt idx="986" formatCode="General">
                  <c:v>4.6965700000000004</c:v>
                </c:pt>
                <c:pt idx="987" formatCode="General">
                  <c:v>4.7023799999999998</c:v>
                </c:pt>
                <c:pt idx="988" formatCode="General">
                  <c:v>4.7081799999999996</c:v>
                </c:pt>
                <c:pt idx="989" formatCode="General">
                  <c:v>4.7183599999999997</c:v>
                </c:pt>
                <c:pt idx="990" formatCode="General">
                  <c:v>4.7285199999999996</c:v>
                </c:pt>
                <c:pt idx="991" formatCode="General">
                  <c:v>4.7386799999999996</c:v>
                </c:pt>
                <c:pt idx="992" formatCode="General">
                  <c:v>4.7536500000000004</c:v>
                </c:pt>
                <c:pt idx="993" formatCode="General">
                  <c:v>4.7685899999999997</c:v>
                </c:pt>
                <c:pt idx="994" formatCode="General">
                  <c:v>4.7834899999999996</c:v>
                </c:pt>
                <c:pt idx="995" formatCode="General">
                  <c:v>4.7983599999999997</c:v>
                </c:pt>
                <c:pt idx="996" formatCode="General">
                  <c:v>4.8187199999999999</c:v>
                </c:pt>
                <c:pt idx="997" formatCode="General">
                  <c:v>4.83901</c:v>
                </c:pt>
                <c:pt idx="998" formatCode="General">
                  <c:v>4.8592199999999997</c:v>
                </c:pt>
                <c:pt idx="999" formatCode="General">
                  <c:v>4.8793300000000004</c:v>
                </c:pt>
                <c:pt idx="1000" formatCode="General">
                  <c:v>4.9119999999999999</c:v>
                </c:pt>
                <c:pt idx="1001" formatCode="General">
                  <c:v>4.9443900000000003</c:v>
                </c:pt>
                <c:pt idx="1002" formatCode="General">
                  <c:v>4.9764900000000001</c:v>
                </c:pt>
                <c:pt idx="1003" formatCode="General">
                  <c:v>5.0082500000000003</c:v>
                </c:pt>
                <c:pt idx="1004" formatCode="General">
                  <c:v>5.0396599999999996</c:v>
                </c:pt>
                <c:pt idx="1005" formatCode="General">
                  <c:v>5.1029</c:v>
                </c:pt>
                <c:pt idx="1006" formatCode="General">
                  <c:v>5.1642599999999996</c:v>
                </c:pt>
                <c:pt idx="1007" formatCode="General">
                  <c:v>5.2121500000000003</c:v>
                </c:pt>
                <c:pt idx="1008" formatCode="General">
                  <c:v>5.25847</c:v>
                </c:pt>
                <c:pt idx="1009" formatCode="General">
                  <c:v>5.3030200000000001</c:v>
                </c:pt>
                <c:pt idx="1010" formatCode="General">
                  <c:v>5.3456299999999999</c:v>
                </c:pt>
                <c:pt idx="1011" formatCode="General">
                  <c:v>5.3860799999999998</c:v>
                </c:pt>
                <c:pt idx="1012" formatCode="General">
                  <c:v>5.4241599999999996</c:v>
                </c:pt>
                <c:pt idx="1013" formatCode="General">
                  <c:v>5.4596400000000003</c:v>
                </c:pt>
                <c:pt idx="1014" formatCode="General">
                  <c:v>5.4922700000000004</c:v>
                </c:pt>
                <c:pt idx="1015" formatCode="General">
                  <c:v>5.5217799999999997</c:v>
                </c:pt>
                <c:pt idx="1016" formatCode="General">
                  <c:v>5.5479099999999999</c:v>
                </c:pt>
                <c:pt idx="1017" formatCode="General">
                  <c:v>5.5703500000000004</c:v>
                </c:pt>
                <c:pt idx="1018" formatCode="General">
                  <c:v>5.5888</c:v>
                </c:pt>
                <c:pt idx="1019" formatCode="General">
                  <c:v>5.6029099999999996</c:v>
                </c:pt>
                <c:pt idx="1020" formatCode="General">
                  <c:v>5.6123599999999998</c:v>
                </c:pt>
                <c:pt idx="1021" formatCode="General">
                  <c:v>5.6167800000000003</c:v>
                </c:pt>
                <c:pt idx="1022" formatCode="General">
                  <c:v>5.61578</c:v>
                </c:pt>
                <c:pt idx="1023" formatCode="General">
                  <c:v>5.6151400000000002</c:v>
                </c:pt>
                <c:pt idx="1024" formatCode="General">
                  <c:v>5.61435</c:v>
                </c:pt>
                <c:pt idx="1025" formatCode="General">
                  <c:v>5.6134300000000001</c:v>
                </c:pt>
                <c:pt idx="1026" formatCode="General">
                  <c:v>5.6123799999999999</c:v>
                </c:pt>
                <c:pt idx="1027" formatCode="General">
                  <c:v>5.6111800000000001</c:v>
                </c:pt>
                <c:pt idx="1028" formatCode="General">
                  <c:v>5.6083699999999999</c:v>
                </c:pt>
                <c:pt idx="1029" formatCode="General">
                  <c:v>5.6049800000000003</c:v>
                </c:pt>
                <c:pt idx="1030" formatCode="General">
                  <c:v>5.601</c:v>
                </c:pt>
                <c:pt idx="1031" formatCode="General">
                  <c:v>5.5964299999999998</c:v>
                </c:pt>
                <c:pt idx="1032" formatCode="General">
                  <c:v>5.5867300000000002</c:v>
                </c:pt>
                <c:pt idx="1033" formatCode="General">
                  <c:v>5.5750000000000002</c:v>
                </c:pt>
                <c:pt idx="1034" formatCode="General">
                  <c:v>5.5612000000000004</c:v>
                </c:pt>
                <c:pt idx="1035" formatCode="General">
                  <c:v>5.5452399999999997</c:v>
                </c:pt>
                <c:pt idx="1036" formatCode="General">
                  <c:v>5.5270599999999996</c:v>
                </c:pt>
                <c:pt idx="1037" formatCode="General">
                  <c:v>5.4992599999999996</c:v>
                </c:pt>
                <c:pt idx="1038" formatCode="General">
                  <c:v>5.4672400000000003</c:v>
                </c:pt>
                <c:pt idx="1039" formatCode="General">
                  <c:v>5.4308399999999999</c:v>
                </c:pt>
                <c:pt idx="1040" formatCode="General">
                  <c:v>5.3899100000000004</c:v>
                </c:pt>
                <c:pt idx="1041" formatCode="General">
                  <c:v>5.3442999999999996</c:v>
                </c:pt>
                <c:pt idx="1042" formatCode="General">
                  <c:v>5.2772800000000002</c:v>
                </c:pt>
                <c:pt idx="1043" formatCode="General">
                  <c:v>5.2017300000000004</c:v>
                </c:pt>
                <c:pt idx="1044" formatCode="General">
                  <c:v>5.1173999999999999</c:v>
                </c:pt>
                <c:pt idx="1045" formatCode="General">
                  <c:v>5.0241100000000003</c:v>
                </c:pt>
                <c:pt idx="1046" formatCode="General">
                  <c:v>4.9217199999999997</c:v>
                </c:pt>
                <c:pt idx="1047" formatCode="General">
                  <c:v>4.8101700000000003</c:v>
                </c:pt>
                <c:pt idx="1048" formatCode="General">
                  <c:v>4.6894600000000004</c:v>
                </c:pt>
                <c:pt idx="1049" formatCode="General">
                  <c:v>4.5597099999999999</c:v>
                </c:pt>
                <c:pt idx="1050" formatCode="General">
                  <c:v>4.4211200000000002</c:v>
                </c:pt>
                <c:pt idx="1051" formatCode="General">
                  <c:v>4.2740200000000002</c:v>
                </c:pt>
                <c:pt idx="1052" formatCode="General">
                  <c:v>4.1188599999999997</c:v>
                </c:pt>
                <c:pt idx="1053" formatCode="General">
                  <c:v>3.95621</c:v>
                </c:pt>
                <c:pt idx="1054" formatCode="General">
                  <c:v>3.7867600000000001</c:v>
                </c:pt>
                <c:pt idx="1055" formatCode="General">
                  <c:v>3.61137</c:v>
                </c:pt>
                <c:pt idx="1056" formatCode="General">
                  <c:v>3.4309799999999999</c:v>
                </c:pt>
                <c:pt idx="1057" formatCode="General">
                  <c:v>3.24668</c:v>
                </c:pt>
                <c:pt idx="1058" formatCode="General">
                  <c:v>3.05966</c:v>
                </c:pt>
                <c:pt idx="1059" formatCode="General">
                  <c:v>2.8711700000000002</c:v>
                </c:pt>
                <c:pt idx="1060" formatCode="General">
                  <c:v>2.6825399999999999</c:v>
                </c:pt>
                <c:pt idx="1061" formatCode="General">
                  <c:v>2.4951300000000001</c:v>
                </c:pt>
                <c:pt idx="1062" formatCode="General">
                  <c:v>2.3414700000000002</c:v>
                </c:pt>
                <c:pt idx="1063" formatCode="General">
                  <c:v>2.19034</c:v>
                </c:pt>
                <c:pt idx="1064" formatCode="General">
                  <c:v>2.0424600000000002</c:v>
                </c:pt>
                <c:pt idx="1065" formatCode="General">
                  <c:v>1.8985300000000001</c:v>
                </c:pt>
                <c:pt idx="1066" formatCode="General">
                  <c:v>1.8780600000000001</c:v>
                </c:pt>
                <c:pt idx="1067" formatCode="General">
                  <c:v>1.85768</c:v>
                </c:pt>
                <c:pt idx="1068" formatCode="General">
                  <c:v>1.83741</c:v>
                </c:pt>
                <c:pt idx="1069" formatCode="General">
                  <c:v>1.8172299999999999</c:v>
                </c:pt>
                <c:pt idx="1070" formatCode="General">
                  <c:v>1.7971600000000001</c:v>
                </c:pt>
                <c:pt idx="1071" formatCode="General">
                  <c:v>1.76491</c:v>
                </c:pt>
                <c:pt idx="1072" formatCode="General">
                  <c:v>1.73295</c:v>
                </c:pt>
                <c:pt idx="1073" formatCode="General">
                  <c:v>1.7012700000000001</c:v>
                </c:pt>
                <c:pt idx="1074" formatCode="General">
                  <c:v>1.66988</c:v>
                </c:pt>
                <c:pt idx="1075" formatCode="General">
                  <c:v>1.6115299999999999</c:v>
                </c:pt>
                <c:pt idx="1076" formatCode="General">
                  <c:v>1.5542800000000001</c:v>
                </c:pt>
                <c:pt idx="1077" formatCode="General">
                  <c:v>1.49817</c:v>
                </c:pt>
                <c:pt idx="1078" formatCode="General">
                  <c:v>1.4432400000000001</c:v>
                </c:pt>
                <c:pt idx="1079" formatCode="General">
                  <c:v>1.3770500000000001</c:v>
                </c:pt>
                <c:pt idx="1080" formatCode="General">
                  <c:v>1.3127599999999999</c:v>
                </c:pt>
                <c:pt idx="1081" formatCode="General">
                  <c:v>1.2503899999999999</c:v>
                </c:pt>
                <c:pt idx="1082" formatCode="General">
                  <c:v>1.1899900000000001</c:v>
                </c:pt>
                <c:pt idx="1083" formatCode="General">
                  <c:v>1.13157</c:v>
                </c:pt>
                <c:pt idx="1084" formatCode="General">
                  <c:v>1.0751599999999999</c:v>
                </c:pt>
                <c:pt idx="1085" formatCode="General">
                  <c:v>1.02077</c:v>
                </c:pt>
                <c:pt idx="1086" formatCode="General">
                  <c:v>0.97864600000000002</c:v>
                </c:pt>
                <c:pt idx="1087" formatCode="General">
                  <c:v>0.93781800000000004</c:v>
                </c:pt>
                <c:pt idx="1088" formatCode="General">
                  <c:v>0.89827999999999997</c:v>
                </c:pt>
                <c:pt idx="1089" formatCode="General">
                  <c:v>0.86002500000000004</c:v>
                </c:pt>
                <c:pt idx="1090" formatCode="General">
                  <c:v>0.82304299999999997</c:v>
                </c:pt>
                <c:pt idx="1091" formatCode="General">
                  <c:v>0.787323</c:v>
                </c:pt>
                <c:pt idx="1092" formatCode="General">
                  <c:v>0.75284799999999996</c:v>
                </c:pt>
                <c:pt idx="1093" formatCode="General">
                  <c:v>0.71960500000000005</c:v>
                </c:pt>
                <c:pt idx="1094" formatCode="General">
                  <c:v>0.69319399999999998</c:v>
                </c:pt>
                <c:pt idx="1095" formatCode="General">
                  <c:v>0.66759100000000005</c:v>
                </c:pt>
                <c:pt idx="1096" formatCode="General">
                  <c:v>0.66414399999999996</c:v>
                </c:pt>
                <c:pt idx="1097" formatCode="General">
                  <c:v>0.66071299999999999</c:v>
                </c:pt>
                <c:pt idx="1098" formatCode="General">
                  <c:v>0.65729700000000002</c:v>
                </c:pt>
                <c:pt idx="1099" formatCode="General">
                  <c:v>0.653895</c:v>
                </c:pt>
                <c:pt idx="1100" formatCode="General">
                  <c:v>0.64713600000000004</c:v>
                </c:pt>
                <c:pt idx="1101" formatCode="General">
                  <c:v>0.64043600000000001</c:v>
                </c:pt>
                <c:pt idx="1102" formatCode="General">
                  <c:v>0.633795</c:v>
                </c:pt>
                <c:pt idx="1103" formatCode="General">
                  <c:v>0.62240300000000004</c:v>
                </c:pt>
                <c:pt idx="1104" formatCode="General">
                  <c:v>0.61118600000000001</c:v>
                </c:pt>
                <c:pt idx="1105" formatCode="General">
                  <c:v>0.60014299999999998</c:v>
                </c:pt>
                <c:pt idx="1106" formatCode="General">
                  <c:v>0.58927099999999999</c:v>
                </c:pt>
                <c:pt idx="1107" formatCode="General">
                  <c:v>0.57166700000000004</c:v>
                </c:pt>
                <c:pt idx="1108" formatCode="General">
                  <c:v>0.55452199999999996</c:v>
                </c:pt>
                <c:pt idx="1109" formatCode="General">
                  <c:v>0.53782799999999997</c:v>
                </c:pt>
                <c:pt idx="1110" formatCode="General">
                  <c:v>0.52157799999999999</c:v>
                </c:pt>
                <c:pt idx="1111" formatCode="General">
                  <c:v>0.495699</c:v>
                </c:pt>
                <c:pt idx="1112" formatCode="General">
                  <c:v>0.47097499999999998</c:v>
                </c:pt>
                <c:pt idx="1113" formatCode="General">
                  <c:v>0.44737199999999999</c:v>
                </c:pt>
                <c:pt idx="1114" formatCode="General">
                  <c:v>0.42485299999999998</c:v>
                </c:pt>
                <c:pt idx="1115" formatCode="General">
                  <c:v>0.40338400000000002</c:v>
                </c:pt>
                <c:pt idx="1116" formatCode="General">
                  <c:v>0.37689600000000001</c:v>
                </c:pt>
                <c:pt idx="1117" formatCode="General">
                  <c:v>0.352051</c:v>
                </c:pt>
                <c:pt idx="1118" formatCode="General">
                  <c:v>0.328768</c:v>
                </c:pt>
                <c:pt idx="1119" formatCode="General">
                  <c:v>0.30696699999999999</c:v>
                </c:pt>
                <c:pt idx="1120" formatCode="General">
                  <c:v>0.28657199999999999</c:v>
                </c:pt>
                <c:pt idx="1121" formatCode="General">
                  <c:v>0.26385799999999998</c:v>
                </c:pt>
                <c:pt idx="1122" formatCode="General">
                  <c:v>0.242927</c:v>
                </c:pt>
                <c:pt idx="1123" formatCode="General">
                  <c:v>0.22365599999999999</c:v>
                </c:pt>
                <c:pt idx="1124" formatCode="General">
                  <c:v>0.20882700000000001</c:v>
                </c:pt>
                <c:pt idx="1125" formatCode="General">
                  <c:v>0.19499900000000001</c:v>
                </c:pt>
                <c:pt idx="1126" formatCode="General">
                  <c:v>0.18210699999999999</c:v>
                </c:pt>
                <c:pt idx="1127" formatCode="General">
                  <c:v>0.170094</c:v>
                </c:pt>
                <c:pt idx="1128" formatCode="General">
                  <c:v>0.15890299999999999</c:v>
                </c:pt>
                <c:pt idx="1129" formatCode="General">
                  <c:v>0.15675900000000001</c:v>
                </c:pt>
                <c:pt idx="1130" formatCode="General">
                  <c:v>0.154645</c:v>
                </c:pt>
                <c:pt idx="1131" formatCode="General">
                  <c:v>0.152561</c:v>
                </c:pt>
                <c:pt idx="1132" formatCode="General">
                  <c:v>0.150506</c:v>
                </c:pt>
                <c:pt idx="1133" formatCode="General">
                  <c:v>0.148481</c:v>
                </c:pt>
                <c:pt idx="1134" formatCode="General">
                  <c:v>0.144956</c:v>
                </c:pt>
                <c:pt idx="1135" formatCode="General">
                  <c:v>0.14151900000000001</c:v>
                </c:pt>
                <c:pt idx="1136" formatCode="General">
                  <c:v>0.13816800000000001</c:v>
                </c:pt>
                <c:pt idx="1137" formatCode="General">
                  <c:v>0.13490199999999999</c:v>
                </c:pt>
                <c:pt idx="1138" formatCode="General">
                  <c:v>0.12992000000000001</c:v>
                </c:pt>
                <c:pt idx="1139" formatCode="General">
                  <c:v>0.12513299999999999</c:v>
                </c:pt>
                <c:pt idx="1140" formatCode="General">
                  <c:v>0.120535</c:v>
                </c:pt>
                <c:pt idx="1141" formatCode="General">
                  <c:v>0.116118</c:v>
                </c:pt>
                <c:pt idx="1142" formatCode="General">
                  <c:v>0.11032500000000001</c:v>
                </c:pt>
                <c:pt idx="1143" formatCode="General">
                  <c:v>0.10484400000000001</c:v>
                </c:pt>
                <c:pt idx="1144" formatCode="General">
                  <c:v>9.9656800000000004E-2</c:v>
                </c:pt>
                <c:pt idx="1145" formatCode="General">
                  <c:v>9.4748499999999999E-2</c:v>
                </c:pt>
                <c:pt idx="1146" formatCode="General">
                  <c:v>9.4037899999999994E-2</c:v>
                </c:pt>
                <c:pt idx="1147" formatCode="General">
                  <c:v>9.3333100000000002E-2</c:v>
                </c:pt>
                <c:pt idx="1148" formatCode="General">
                  <c:v>9.2634099999999997E-2</c:v>
                </c:pt>
                <c:pt idx="1149" formatCode="General">
                  <c:v>9.1940900000000006E-2</c:v>
                </c:pt>
                <c:pt idx="1150" formatCode="General">
                  <c:v>9.0864E-2</c:v>
                </c:pt>
                <c:pt idx="1151" formatCode="General">
                  <c:v>8.9801099999999995E-2</c:v>
                </c:pt>
                <c:pt idx="1152" formatCode="General">
                  <c:v>8.8751800000000006E-2</c:v>
                </c:pt>
                <c:pt idx="1153" formatCode="General">
                  <c:v>8.7715899999999999E-2</c:v>
                </c:pt>
                <c:pt idx="1154" formatCode="General">
                  <c:v>8.54438E-2</c:v>
                </c:pt>
                <c:pt idx="1155" formatCode="General">
                  <c:v>8.3236500000000005E-2</c:v>
                </c:pt>
                <c:pt idx="1156" formatCode="General">
                  <c:v>8.10921E-2</c:v>
                </c:pt>
                <c:pt idx="1157" formatCode="General">
                  <c:v>7.9008800000000004E-2</c:v>
                </c:pt>
                <c:pt idx="1158" formatCode="General">
                  <c:v>7.5739200000000007E-2</c:v>
                </c:pt>
                <c:pt idx="1159" formatCode="General">
                  <c:v>7.2619600000000006E-2</c:v>
                </c:pt>
                <c:pt idx="1160" formatCode="General">
                  <c:v>6.9642899999999994E-2</c:v>
                </c:pt>
                <c:pt idx="1161" formatCode="General">
                  <c:v>6.6802299999999995E-2</c:v>
                </c:pt>
                <c:pt idx="1162" formatCode="General">
                  <c:v>6.4091300000000004E-2</c:v>
                </c:pt>
                <c:pt idx="1163" formatCode="General">
                  <c:v>6.0601000000000002E-2</c:v>
                </c:pt>
                <c:pt idx="1164" formatCode="General">
                  <c:v>5.7324300000000002E-2</c:v>
                </c:pt>
                <c:pt idx="1165" formatCode="General">
                  <c:v>5.4247400000000001E-2</c:v>
                </c:pt>
                <c:pt idx="1166" formatCode="General">
                  <c:v>5.13575E-2</c:v>
                </c:pt>
                <c:pt idx="1167" formatCode="General">
                  <c:v>4.8642400000000002E-2</c:v>
                </c:pt>
                <c:pt idx="1168" formatCode="General">
                  <c:v>4.5260599999999998E-2</c:v>
                </c:pt>
                <c:pt idx="1169" formatCode="General">
                  <c:v>4.2147299999999999E-2</c:v>
                </c:pt>
                <c:pt idx="1170" formatCode="General">
                  <c:v>3.9279700000000001E-2</c:v>
                </c:pt>
                <c:pt idx="1171" formatCode="General">
                  <c:v>3.6636799999999997E-2</c:v>
                </c:pt>
                <c:pt idx="1172" formatCode="General">
                  <c:v>3.41997E-2</c:v>
                </c:pt>
                <c:pt idx="1173" formatCode="General">
                  <c:v>3.3827099999999999E-2</c:v>
                </c:pt>
                <c:pt idx="1174" formatCode="General">
                  <c:v>3.34594E-2</c:v>
                </c:pt>
                <c:pt idx="1175" formatCode="General">
                  <c:v>3.3096300000000002E-2</c:v>
                </c:pt>
                <c:pt idx="1176" formatCode="General">
                  <c:v>3.27379E-2</c:v>
                </c:pt>
                <c:pt idx="1177" formatCode="General">
                  <c:v>3.2384000000000003E-2</c:v>
                </c:pt>
                <c:pt idx="1178" formatCode="General">
                  <c:v>3.1869599999999998E-2</c:v>
                </c:pt>
                <c:pt idx="1179" formatCode="General">
                  <c:v>3.1364900000000001E-2</c:v>
                </c:pt>
                <c:pt idx="1180" formatCode="General">
                  <c:v>3.0869600000000001E-2</c:v>
                </c:pt>
                <c:pt idx="1181" formatCode="General">
                  <c:v>3.0383500000000001E-2</c:v>
                </c:pt>
                <c:pt idx="1182" formatCode="General">
                  <c:v>2.9906499999999999E-2</c:v>
                </c:pt>
                <c:pt idx="1183" formatCode="General">
                  <c:v>2.90172E-2</c:v>
                </c:pt>
                <c:pt idx="1184" formatCode="General">
                  <c:v>2.8159099999999999E-2</c:v>
                </c:pt>
                <c:pt idx="1185" formatCode="General">
                  <c:v>2.7331100000000001E-2</c:v>
                </c:pt>
                <c:pt idx="1186" formatCode="General">
                  <c:v>2.6532E-2</c:v>
                </c:pt>
                <c:pt idx="1187" formatCode="General">
                  <c:v>2.5760600000000002E-2</c:v>
                </c:pt>
                <c:pt idx="1188" formatCode="General">
                  <c:v>2.4358999999999999E-2</c:v>
                </c:pt>
                <c:pt idx="1189" formatCode="General">
                  <c:v>2.30479E-2</c:v>
                </c:pt>
                <c:pt idx="1190" formatCode="General">
                  <c:v>2.18211E-2</c:v>
                </c:pt>
                <c:pt idx="1191" formatCode="General">
                  <c:v>2.06724E-2</c:v>
                </c:pt>
                <c:pt idx="1192" formatCode="General">
                  <c:v>1.9596300000000001E-2</c:v>
                </c:pt>
                <c:pt idx="1193" formatCode="General">
                  <c:v>1.8587699999999999E-2</c:v>
                </c:pt>
                <c:pt idx="1194" formatCode="General">
                  <c:v>1.7641899999999999E-2</c:v>
                </c:pt>
                <c:pt idx="1195" formatCode="General">
                  <c:v>1.6754499999999999E-2</c:v>
                </c:pt>
                <c:pt idx="1196" formatCode="General">
                  <c:v>1.56735E-2</c:v>
                </c:pt>
                <c:pt idx="1197" formatCode="General">
                  <c:v>1.46775E-2</c:v>
                </c:pt>
                <c:pt idx="1198" formatCode="General">
                  <c:v>1.37591E-2</c:v>
                </c:pt>
                <c:pt idx="1199" formatCode="General">
                  <c:v>1.36379E-2</c:v>
                </c:pt>
                <c:pt idx="1200" formatCode="General">
                  <c:v>1.35181E-2</c:v>
                </c:pt>
                <c:pt idx="1201" formatCode="General">
                  <c:v>1.3399599999999999E-2</c:v>
                </c:pt>
                <c:pt idx="1202" formatCode="General">
                  <c:v>1.32824E-2</c:v>
                </c:pt>
                <c:pt idx="1203" formatCode="General">
                  <c:v>1.3166499999999999E-2</c:v>
                </c:pt>
                <c:pt idx="1204" formatCode="General">
                  <c:v>1.29806E-2</c:v>
                </c:pt>
                <c:pt idx="1205" formatCode="General">
                  <c:v>1.2798E-2</c:v>
                </c:pt>
                <c:pt idx="1206" formatCode="General">
                  <c:v>1.2618600000000001E-2</c:v>
                </c:pt>
                <c:pt idx="1207" formatCode="General">
                  <c:v>1.24423E-2</c:v>
                </c:pt>
                <c:pt idx="1208" formatCode="General">
                  <c:v>1.2157299999999999E-2</c:v>
                </c:pt>
                <c:pt idx="1209" formatCode="General">
                  <c:v>1.18805E-2</c:v>
                </c:pt>
                <c:pt idx="1210" formatCode="General">
                  <c:v>1.16116E-2</c:v>
                </c:pt>
                <c:pt idx="1211" formatCode="General">
                  <c:v>1.13504E-2</c:v>
                </c:pt>
                <c:pt idx="1212" formatCode="General">
                  <c:v>1.08945E-2</c:v>
                </c:pt>
                <c:pt idx="1213" formatCode="General">
                  <c:v>1.04616E-2</c:v>
                </c:pt>
                <c:pt idx="1214" formatCode="General">
                  <c:v>1.01228E-2</c:v>
                </c:pt>
                <c:pt idx="1215" formatCode="General">
                  <c:v>9.7978000000000006E-3</c:v>
                </c:pt>
                <c:pt idx="1216" formatCode="General">
                  <c:v>9.4861200000000007E-3</c:v>
                </c:pt>
                <c:pt idx="1217" formatCode="General">
                  <c:v>9.1870900000000002E-3</c:v>
                </c:pt>
                <c:pt idx="1218" formatCode="General">
                  <c:v>8.9001099999999993E-3</c:v>
                </c:pt>
                <c:pt idx="1219" formatCode="General">
                  <c:v>8.6246299999999994E-3</c:v>
                </c:pt>
                <c:pt idx="1220" formatCode="General">
                  <c:v>8.3601200000000004E-3</c:v>
                </c:pt>
                <c:pt idx="1221" formatCode="General">
                  <c:v>8.1060699999999999E-3</c:v>
                </c:pt>
                <c:pt idx="1222" formatCode="General">
                  <c:v>8.0550299999999995E-3</c:v>
                </c:pt>
                <c:pt idx="1223" formatCode="General">
                  <c:v>8.00441E-3</c:v>
                </c:pt>
                <c:pt idx="1224" formatCode="General">
                  <c:v>7.9542099999999998E-3</c:v>
                </c:pt>
                <c:pt idx="1225" formatCode="General">
                  <c:v>7.9044100000000006E-3</c:v>
                </c:pt>
                <c:pt idx="1226" formatCode="General">
                  <c:v>7.8550300000000007E-3</c:v>
                </c:pt>
                <c:pt idx="1227" formatCode="General">
                  <c:v>7.7574599999999999E-3</c:v>
                </c:pt>
                <c:pt idx="1228" formatCode="General">
                  <c:v>7.66148E-3</c:v>
                </c:pt>
                <c:pt idx="1229" formatCode="General">
                  <c:v>7.5670399999999997E-3</c:v>
                </c:pt>
                <c:pt idx="1230" formatCode="General">
                  <c:v>7.4741399999999998E-3</c:v>
                </c:pt>
                <c:pt idx="1231" formatCode="General">
                  <c:v>7.2952700000000004E-3</c:v>
                </c:pt>
                <c:pt idx="1232" formatCode="General">
                  <c:v>7.1219999999999999E-3</c:v>
                </c:pt>
                <c:pt idx="1233" formatCode="General">
                  <c:v>6.9541300000000002E-3</c:v>
                </c:pt>
                <c:pt idx="1234" formatCode="General">
                  <c:v>6.79147E-3</c:v>
                </c:pt>
                <c:pt idx="1235" formatCode="General">
                  <c:v>6.5685500000000003E-3</c:v>
                </c:pt>
                <c:pt idx="1236" formatCode="General">
                  <c:v>6.3552900000000004E-3</c:v>
                </c:pt>
                <c:pt idx="1237" formatCode="General">
                  <c:v>6.15118E-3</c:v>
                </c:pt>
                <c:pt idx="1238" formatCode="General">
                  <c:v>5.9557799999999999E-3</c:v>
                </c:pt>
                <c:pt idx="1239" formatCode="General">
                  <c:v>5.7686600000000001E-3</c:v>
                </c:pt>
                <c:pt idx="1240" formatCode="General">
                  <c:v>5.5564300000000002E-3</c:v>
                </c:pt>
                <c:pt idx="1241" formatCode="General">
                  <c:v>5.39815E-3</c:v>
                </c:pt>
                <c:pt idx="1242" formatCode="General">
                  <c:v>5.24596E-3</c:v>
                </c:pt>
                <c:pt idx="1243" formatCode="General">
                  <c:v>5.0995700000000003E-3</c:v>
                </c:pt>
                <c:pt idx="1244" formatCode="General">
                  <c:v>4.9587399999999997E-3</c:v>
                </c:pt>
                <c:pt idx="1245" formatCode="General">
                  <c:v>4.9393500000000003E-3</c:v>
                </c:pt>
                <c:pt idx="1246" formatCode="General">
                  <c:v>4.9200700000000003E-3</c:v>
                </c:pt>
                <c:pt idx="1247" formatCode="General">
                  <c:v>4.9008899999999998E-3</c:v>
                </c:pt>
                <c:pt idx="1248" formatCode="General">
                  <c:v>4.8818200000000003E-3</c:v>
                </c:pt>
                <c:pt idx="1249" formatCode="General">
                  <c:v>4.8439700000000004E-3</c:v>
                </c:pt>
                <c:pt idx="1250" formatCode="General">
                  <c:v>4.8065399999999998E-3</c:v>
                </c:pt>
                <c:pt idx="1251" formatCode="General">
                  <c:v>4.7695000000000003E-3</c:v>
                </c:pt>
                <c:pt idx="1252" formatCode="General">
                  <c:v>4.7203999999999996E-3</c:v>
                </c:pt>
                <c:pt idx="1253" formatCode="General">
                  <c:v>4.6720099999999999E-3</c:v>
                </c:pt>
                <c:pt idx="1254" formatCode="General">
                  <c:v>4.6243100000000004E-3</c:v>
                </c:pt>
                <c:pt idx="1255" formatCode="General">
                  <c:v>4.5772800000000004E-3</c:v>
                </c:pt>
                <c:pt idx="1256" formatCode="General">
                  <c:v>4.51338E-3</c:v>
                </c:pt>
                <c:pt idx="1257" formatCode="General">
                  <c:v>4.45072E-3</c:v>
                </c:pt>
                <c:pt idx="1258" formatCode="General">
                  <c:v>4.3892699999999998E-3</c:v>
                </c:pt>
                <c:pt idx="1259" formatCode="General">
                  <c:v>4.3290000000000004E-3</c:v>
                </c:pt>
                <c:pt idx="1260" formatCode="General">
                  <c:v>4.22595E-3</c:v>
                </c:pt>
                <c:pt idx="1261" formatCode="General">
                  <c:v>4.1263200000000002E-3</c:v>
                </c:pt>
                <c:pt idx="1262" formatCode="General">
                  <c:v>4.0299899999999998E-3</c:v>
                </c:pt>
                <c:pt idx="1263" formatCode="General">
                  <c:v>3.9368099999999998E-3</c:v>
                </c:pt>
                <c:pt idx="1264" formatCode="General">
                  <c:v>3.84667E-3</c:v>
                </c:pt>
                <c:pt idx="1265" formatCode="General">
                  <c:v>3.7107199999999998E-3</c:v>
                </c:pt>
                <c:pt idx="1266" formatCode="General">
                  <c:v>3.58158E-3</c:v>
                </c:pt>
                <c:pt idx="1267" formatCode="General">
                  <c:v>3.45883E-3</c:v>
                </c:pt>
                <c:pt idx="1268" formatCode="General">
                  <c:v>3.3421100000000001E-3</c:v>
                </c:pt>
                <c:pt idx="1269" formatCode="General">
                  <c:v>3.2310699999999999E-3</c:v>
                </c:pt>
                <c:pt idx="1270" formatCode="General">
                  <c:v>3.0809499999999998E-3</c:v>
                </c:pt>
                <c:pt idx="1271" formatCode="General">
                  <c:v>2.9409700000000002E-3</c:v>
                </c:pt>
                <c:pt idx="1272" formatCode="General">
                  <c:v>2.8103199999999998E-3</c:v>
                </c:pt>
                <c:pt idx="1273" formatCode="General">
                  <c:v>2.6882799999999999E-3</c:v>
                </c:pt>
                <c:pt idx="1274" formatCode="General">
                  <c:v>2.5741700000000002E-3</c:v>
                </c:pt>
                <c:pt idx="1275" formatCode="General">
                  <c:v>2.4673799999999999E-3</c:v>
                </c:pt>
                <c:pt idx="1276" formatCode="General">
                  <c:v>2.3673600000000002E-3</c:v>
                </c:pt>
                <c:pt idx="1277" formatCode="General">
                  <c:v>2.2736000000000002E-3</c:v>
                </c:pt>
                <c:pt idx="1278" formatCode="General">
                  <c:v>2.18563E-3</c:v>
                </c:pt>
                <c:pt idx="1279" formatCode="General">
                  <c:v>2.10305E-3</c:v>
                </c:pt>
                <c:pt idx="1280" formatCode="General">
                  <c:v>2.0254399999999999E-3</c:v>
                </c:pt>
                <c:pt idx="1281" formatCode="General">
                  <c:v>1.95247E-3</c:v>
                </c:pt>
                <c:pt idx="1282" formatCode="General">
                  <c:v>1.85731E-3</c:v>
                </c:pt>
                <c:pt idx="1283" formatCode="General">
                  <c:v>1.7698099999999999E-3</c:v>
                </c:pt>
                <c:pt idx="1284" formatCode="General">
                  <c:v>1.6892400000000001E-3</c:v>
                </c:pt>
                <c:pt idx="1285" formatCode="General">
                  <c:v>1.6149599999999999E-3</c:v>
                </c:pt>
                <c:pt idx="1286" formatCode="General">
                  <c:v>1.5464000000000001E-3</c:v>
                </c:pt>
                <c:pt idx="1287" formatCode="General">
                  <c:v>1.48303E-3</c:v>
                </c:pt>
                <c:pt idx="1288" formatCode="General">
                  <c:v>1.4243999999999999E-3</c:v>
                </c:pt>
                <c:pt idx="1289" formatCode="General">
                  <c:v>1.3701099999999999E-3</c:v>
                </c:pt>
                <c:pt idx="1290" formatCode="General">
                  <c:v>1.31978E-3</c:v>
                </c:pt>
                <c:pt idx="1291" formatCode="General">
                  <c:v>1.2730700000000001E-3</c:v>
                </c:pt>
                <c:pt idx="1292" formatCode="General">
                  <c:v>1.2296900000000001E-3</c:v>
                </c:pt>
                <c:pt idx="1293" formatCode="General">
                  <c:v>1.1893800000000001E-3</c:v>
                </c:pt>
                <c:pt idx="1294" formatCode="General">
                  <c:v>1.14723E-3</c:v>
                </c:pt>
                <c:pt idx="1295" formatCode="General">
                  <c:v>1.1083600000000001E-3</c:v>
                </c:pt>
                <c:pt idx="1296" formatCode="General">
                  <c:v>1.07248E-3</c:v>
                </c:pt>
                <c:pt idx="1297" formatCode="General">
                  <c:v>1.0393500000000001E-3</c:v>
                </c:pt>
                <c:pt idx="1298" formatCode="General">
                  <c:v>1.0137200000000001E-3</c:v>
                </c:pt>
                <c:pt idx="1299" formatCode="General">
                  <c:v>9.8970799999999995E-4</c:v>
                </c:pt>
                <c:pt idx="1300" formatCode="General">
                  <c:v>9.6721000000000003E-4</c:v>
                </c:pt>
                <c:pt idx="1301" formatCode="General">
                  <c:v>9.4612299999999999E-4</c:v>
                </c:pt>
                <c:pt idx="1302" formatCode="General">
                  <c:v>9.2635799999999996E-4</c:v>
                </c:pt>
                <c:pt idx="1303" formatCode="General">
                  <c:v>9.0782899999999997E-4</c:v>
                </c:pt>
                <c:pt idx="1304" formatCode="General">
                  <c:v>9.0413600000000005E-4</c:v>
                </c:pt>
                <c:pt idx="1305" formatCode="General">
                  <c:v>9.0049300000000004E-4</c:v>
                </c:pt>
                <c:pt idx="1306" formatCode="General">
                  <c:v>8.9689800000000003E-4</c:v>
                </c:pt>
                <c:pt idx="1307" formatCode="General">
                  <c:v>8.9335E-4</c:v>
                </c:pt>
                <c:pt idx="1308" formatCode="General">
                  <c:v>8.8985099999999999E-4</c:v>
                </c:pt>
                <c:pt idx="1309" formatCode="General">
                  <c:v>8.8639700000000003E-4</c:v>
                </c:pt>
                <c:pt idx="1310" formatCode="General">
                  <c:v>8.8104199999999996E-4</c:v>
                </c:pt>
                <c:pt idx="1311" formatCode="General">
                  <c:v>8.7579800000000001E-4</c:v>
                </c:pt>
                <c:pt idx="1312" formatCode="General">
                  <c:v>8.7066499999999996E-4</c:v>
                </c:pt>
                <c:pt idx="1313" formatCode="General">
                  <c:v>8.6563999999999999E-4</c:v>
                </c:pt>
                <c:pt idx="1314" formatCode="General">
                  <c:v>8.6072099999999995E-4</c:v>
                </c:pt>
                <c:pt idx="1315" formatCode="General">
                  <c:v>8.5590600000000003E-4</c:v>
                </c:pt>
                <c:pt idx="1316" formatCode="General">
                  <c:v>8.4779600000000005E-4</c:v>
                </c:pt>
                <c:pt idx="1317" formatCode="General">
                  <c:v>8.3998199999999997E-4</c:v>
                </c:pt>
                <c:pt idx="1318" formatCode="General">
                  <c:v>8.3245400000000005E-4</c:v>
                </c:pt>
                <c:pt idx="1319" formatCode="General">
                  <c:v>8.2520499999999997E-4</c:v>
                </c:pt>
                <c:pt idx="1320" formatCode="General">
                  <c:v>8.1822299999999998E-4</c:v>
                </c:pt>
                <c:pt idx="1321" formatCode="General">
                  <c:v>8.1150199999999997E-4</c:v>
                </c:pt>
                <c:pt idx="1322" formatCode="General">
                  <c:v>7.9604800000000005E-4</c:v>
                </c:pt>
                <c:pt idx="1323" formatCode="General">
                  <c:v>7.8200299999999997E-4</c:v>
                </c:pt>
                <c:pt idx="1324" formatCode="General">
                  <c:v>7.6926800000000004E-4</c:v>
                </c:pt>
                <c:pt idx="1325" formatCode="General">
                  <c:v>7.5775199999999999E-4</c:v>
                </c:pt>
                <c:pt idx="1326" formatCode="General">
                  <c:v>7.4737499999999999E-4</c:v>
                </c:pt>
                <c:pt idx="1327" formatCode="General">
                  <c:v>7.3806299999999996E-4</c:v>
                </c:pt>
                <c:pt idx="1328" formatCode="General">
                  <c:v>7.2714399999999999E-4</c:v>
                </c:pt>
                <c:pt idx="1329" formatCode="General">
                  <c:v>7.1787900000000004E-4</c:v>
                </c:pt>
                <c:pt idx="1330" formatCode="General">
                  <c:v>7.1014500000000003E-4</c:v>
                </c:pt>
                <c:pt idx="1331" formatCode="General">
                  <c:v>7.0383499999999999E-4</c:v>
                </c:pt>
                <c:pt idx="1332" formatCode="General">
                  <c:v>6.9885499999999996E-4</c:v>
                </c:pt>
                <c:pt idx="1333" formatCode="General">
                  <c:v>6.9512399999999998E-4</c:v>
                </c:pt>
                <c:pt idx="1334" formatCode="General">
                  <c:v>6.9216000000000004E-4</c:v>
                </c:pt>
                <c:pt idx="1335" formatCode="General">
                  <c:v>6.90835E-4</c:v>
                </c:pt>
                <c:pt idx="1336" formatCode="General">
                  <c:v>6.9105600000000001E-4</c:v>
                </c:pt>
                <c:pt idx="1337" formatCode="General">
                  <c:v>6.9274199999999999E-4</c:v>
                </c:pt>
                <c:pt idx="1338" formatCode="General">
                  <c:v>6.9582800000000001E-4</c:v>
                </c:pt>
                <c:pt idx="1339" formatCode="General">
                  <c:v>7.0025999999999997E-4</c:v>
                </c:pt>
                <c:pt idx="1340" formatCode="General">
                  <c:v>7.0599300000000003E-4</c:v>
                </c:pt>
                <c:pt idx="1341" formatCode="General">
                  <c:v>7.1299199999999997E-4</c:v>
                </c:pt>
                <c:pt idx="1342" formatCode="General">
                  <c:v>7.2122799999999997E-4</c:v>
                </c:pt>
                <c:pt idx="1343" formatCode="General">
                  <c:v>7.3068299999999998E-4</c:v>
                </c:pt>
                <c:pt idx="1344" formatCode="General">
                  <c:v>7.4134099999999996E-4</c:v>
                </c:pt>
                <c:pt idx="1345" formatCode="General">
                  <c:v>7.53194E-4</c:v>
                </c:pt>
                <c:pt idx="1346" formatCode="General">
                  <c:v>7.6623999999999995E-4</c:v>
                </c:pt>
                <c:pt idx="1347" formatCode="General">
                  <c:v>7.68756E-4</c:v>
                </c:pt>
                <c:pt idx="1348" formatCode="General">
                  <c:v>7.71311E-4</c:v>
                </c:pt>
                <c:pt idx="1349" formatCode="General">
                  <c:v>7.73907E-4</c:v>
                </c:pt>
                <c:pt idx="1350" formatCode="General">
                  <c:v>7.7654299999999998E-4</c:v>
                </c:pt>
                <c:pt idx="1351" formatCode="General">
                  <c:v>7.7921900000000005E-4</c:v>
                </c:pt>
                <c:pt idx="1352" formatCode="General">
                  <c:v>7.8469100000000001E-4</c:v>
                </c:pt>
                <c:pt idx="1353" formatCode="General">
                  <c:v>7.9032500000000003E-4</c:v>
                </c:pt>
                <c:pt idx="1354" formatCode="General">
                  <c:v>7.9611999999999999E-4</c:v>
                </c:pt>
                <c:pt idx="1355" formatCode="General">
                  <c:v>8.02077E-4</c:v>
                </c:pt>
                <c:pt idx="1356" formatCode="General">
                  <c:v>8.0819799999999999E-4</c:v>
                </c:pt>
                <c:pt idx="1357" formatCode="General">
                  <c:v>8.2366700000000004E-4</c:v>
                </c:pt>
                <c:pt idx="1358" formatCode="General">
                  <c:v>8.4010400000000005E-4</c:v>
                </c:pt>
                <c:pt idx="1359" formatCode="General">
                  <c:v>8.5752400000000002E-4</c:v>
                </c:pt>
                <c:pt idx="1360" formatCode="General">
                  <c:v>8.75942E-4</c:v>
                </c:pt>
                <c:pt idx="1361" formatCode="General">
                  <c:v>8.9537799999999995E-4</c:v>
                </c:pt>
                <c:pt idx="1362" formatCode="General">
                  <c:v>9.2976199999999999E-4</c:v>
                </c:pt>
                <c:pt idx="1363" formatCode="General">
                  <c:v>9.6708199999999997E-4</c:v>
                </c:pt>
                <c:pt idx="1364" formatCode="General">
                  <c:v>1.00746E-3</c:v>
                </c:pt>
                <c:pt idx="1365" formatCode="General">
                  <c:v>1.0510199999999999E-3</c:v>
                </c:pt>
                <c:pt idx="1366" formatCode="General">
                  <c:v>1.0979200000000001E-3</c:v>
                </c:pt>
                <c:pt idx="1367" formatCode="General">
                  <c:v>1.14832E-3</c:v>
                </c:pt>
                <c:pt idx="1368" formatCode="General">
                  <c:v>1.2339300000000001E-3</c:v>
                </c:pt>
                <c:pt idx="1369" formatCode="General">
                  <c:v>1.3291399999999999E-3</c:v>
                </c:pt>
                <c:pt idx="1370" formatCode="General">
                  <c:v>1.4347699999999999E-3</c:v>
                </c:pt>
                <c:pt idx="1371" formatCode="General">
                  <c:v>1.55174E-3</c:v>
                </c:pt>
                <c:pt idx="1372" formatCode="General">
                  <c:v>1.6810799999999999E-3</c:v>
                </c:pt>
                <c:pt idx="1373" formatCode="General">
                  <c:v>1.8239300000000001E-3</c:v>
                </c:pt>
                <c:pt idx="1374" formatCode="General">
                  <c:v>1.98154E-3</c:v>
                </c:pt>
                <c:pt idx="1375" formatCode="General">
                  <c:v>2.1552899999999998E-3</c:v>
                </c:pt>
                <c:pt idx="1376" formatCode="General">
                  <c:v>2.34673E-3</c:v>
                </c:pt>
                <c:pt idx="1377" formatCode="General">
                  <c:v>2.5575200000000002E-3</c:v>
                </c:pt>
                <c:pt idx="1378" formatCode="General">
                  <c:v>2.7895300000000001E-3</c:v>
                </c:pt>
                <c:pt idx="1379" formatCode="General">
                  <c:v>3.0447899999999999E-3</c:v>
                </c:pt>
                <c:pt idx="1380" formatCode="General">
                  <c:v>3.3255400000000001E-3</c:v>
                </c:pt>
                <c:pt idx="1381" formatCode="General">
                  <c:v>3.6342599999999998E-3</c:v>
                </c:pt>
                <c:pt idx="1382" formatCode="General">
                  <c:v>3.9736299999999997E-3</c:v>
                </c:pt>
                <c:pt idx="1383" formatCode="General">
                  <c:v>4.3466399999999997E-3</c:v>
                </c:pt>
                <c:pt idx="1384" formatCode="General">
                  <c:v>4.75655E-3</c:v>
                </c:pt>
                <c:pt idx="1385" formatCode="General">
                  <c:v>5.2069600000000001E-3</c:v>
                </c:pt>
                <c:pt idx="1386" formatCode="General">
                  <c:v>5.70178E-3</c:v>
                </c:pt>
                <c:pt idx="1387" formatCode="General">
                  <c:v>6.2453600000000001E-3</c:v>
                </c:pt>
                <c:pt idx="1388" formatCode="General">
                  <c:v>6.84243E-3</c:v>
                </c:pt>
                <c:pt idx="1389" formatCode="General">
                  <c:v>7.4982199999999999E-3</c:v>
                </c:pt>
                <c:pt idx="1390" formatCode="General">
                  <c:v>8.2184300000000005E-3</c:v>
                </c:pt>
                <c:pt idx="1391" formatCode="General">
                  <c:v>9.0093599999999992E-3</c:v>
                </c:pt>
                <c:pt idx="1392" formatCode="General">
                  <c:v>9.8779000000000002E-3</c:v>
                </c:pt>
                <c:pt idx="1393" formatCode="General">
                  <c:v>1.08316E-2</c:v>
                </c:pt>
                <c:pt idx="1394" formatCode="General">
                  <c:v>1.18788E-2</c:v>
                </c:pt>
                <c:pt idx="1395" formatCode="General">
                  <c:v>1.30286E-2</c:v>
                </c:pt>
                <c:pt idx="1396" formatCode="General">
                  <c:v>1.4291099999999999E-2</c:v>
                </c:pt>
                <c:pt idx="1397" formatCode="General">
                  <c:v>1.5677099999999999E-2</c:v>
                </c:pt>
                <c:pt idx="1398" formatCode="General">
                  <c:v>1.71989E-2</c:v>
                </c:pt>
                <c:pt idx="1399" formatCode="General">
                  <c:v>1.8869500000000001E-2</c:v>
                </c:pt>
                <c:pt idx="1400" formatCode="General">
                  <c:v>2.0703599999999999E-2</c:v>
                </c:pt>
                <c:pt idx="1401" formatCode="General">
                  <c:v>2.27171E-2</c:v>
                </c:pt>
                <c:pt idx="1402" formatCode="General">
                  <c:v>2.4927499999999998E-2</c:v>
                </c:pt>
                <c:pt idx="1403" formatCode="General">
                  <c:v>2.7354099999999999E-2</c:v>
                </c:pt>
                <c:pt idx="1404" formatCode="General">
                  <c:v>3.00179E-2</c:v>
                </c:pt>
                <c:pt idx="1405" formatCode="General">
                  <c:v>3.2941999999999999E-2</c:v>
                </c:pt>
                <c:pt idx="1406" formatCode="General">
                  <c:v>3.6151900000000001E-2</c:v>
                </c:pt>
                <c:pt idx="1407" formatCode="General">
                  <c:v>3.9675500000000002E-2</c:v>
                </c:pt>
                <c:pt idx="1408" formatCode="General">
                  <c:v>4.35433E-2</c:v>
                </c:pt>
                <c:pt idx="1409" formatCode="General">
                  <c:v>4.7788900000000002E-2</c:v>
                </c:pt>
                <c:pt idx="1410" formatCode="General">
                  <c:v>5.2449200000000001E-2</c:v>
                </c:pt>
                <c:pt idx="1411" formatCode="General">
                  <c:v>5.75646E-2</c:v>
                </c:pt>
                <c:pt idx="1412" formatCode="General">
                  <c:v>6.31795E-2</c:v>
                </c:pt>
                <c:pt idx="1413" formatCode="General">
                  <c:v>7.0094000000000004E-2</c:v>
                </c:pt>
                <c:pt idx="1414" formatCode="General">
                  <c:v>7.7765699999999993E-2</c:v>
                </c:pt>
                <c:pt idx="1415" formatCode="General">
                  <c:v>8.6277400000000004E-2</c:v>
                </c:pt>
                <c:pt idx="1416" formatCode="General">
                  <c:v>9.5720700000000006E-2</c:v>
                </c:pt>
                <c:pt idx="1417" formatCode="General">
                  <c:v>0.106197</c:v>
                </c:pt>
                <c:pt idx="1418" formatCode="General">
                  <c:v>0.11781999999999999</c:v>
                </c:pt>
                <c:pt idx="1419" formatCode="General">
                  <c:v>0.130715</c:v>
                </c:pt>
                <c:pt idx="1420" formatCode="General">
                  <c:v>0.14501900000000001</c:v>
                </c:pt>
                <c:pt idx="1421" formatCode="General">
                  <c:v>0.160886</c:v>
                </c:pt>
                <c:pt idx="1422" formatCode="General">
                  <c:v>0.17848700000000001</c:v>
                </c:pt>
                <c:pt idx="1423" formatCode="General">
                  <c:v>0.19800999999999999</c:v>
                </c:pt>
                <c:pt idx="1424" formatCode="General">
                  <c:v>0.219665</c:v>
                </c:pt>
                <c:pt idx="1425" formatCode="General">
                  <c:v>0.223139</c:v>
                </c:pt>
                <c:pt idx="1426" formatCode="General">
                  <c:v>0.22666800000000001</c:v>
                </c:pt>
                <c:pt idx="1427" formatCode="General">
                  <c:v>0.23025200000000001</c:v>
                </c:pt>
                <c:pt idx="1428" formatCode="General">
                  <c:v>0.23389299999999999</c:v>
                </c:pt>
                <c:pt idx="1429" formatCode="General">
                  <c:v>0.237592</c:v>
                </c:pt>
                <c:pt idx="1430" formatCode="General">
                  <c:v>0.24134900000000001</c:v>
                </c:pt>
                <c:pt idx="1431" formatCode="General">
                  <c:v>0.245945</c:v>
                </c:pt>
                <c:pt idx="1432" formatCode="General">
                  <c:v>0.25062899999999999</c:v>
                </c:pt>
                <c:pt idx="1433" formatCode="General">
                  <c:v>0.25540200000000002</c:v>
                </c:pt>
                <c:pt idx="1434" formatCode="General">
                  <c:v>0.26026500000000002</c:v>
                </c:pt>
                <c:pt idx="1435" formatCode="General">
                  <c:v>0.26522000000000001</c:v>
                </c:pt>
                <c:pt idx="1436" formatCode="General">
                  <c:v>0.27780899999999997</c:v>
                </c:pt>
                <c:pt idx="1437" formatCode="General">
                  <c:v>0.29099399999999997</c:v>
                </c:pt>
                <c:pt idx="1438" formatCode="General">
                  <c:v>0.30480200000000002</c:v>
                </c:pt>
                <c:pt idx="1439" formatCode="General">
                  <c:v>0.31926300000000002</c:v>
                </c:pt>
                <c:pt idx="1440" formatCode="General">
                  <c:v>0.33440700000000001</c:v>
                </c:pt>
                <c:pt idx="1441" formatCode="General">
                  <c:v>0.35836699999999999</c:v>
                </c:pt>
                <c:pt idx="1442" formatCode="General">
                  <c:v>0.38403700000000002</c:v>
                </c:pt>
                <c:pt idx="1443" formatCode="General">
                  <c:v>0.41153400000000001</c:v>
                </c:pt>
                <c:pt idx="1444" formatCode="General">
                  <c:v>0.44098900000000002</c:v>
                </c:pt>
                <c:pt idx="1445" formatCode="General">
                  <c:v>0.47253800000000001</c:v>
                </c:pt>
                <c:pt idx="1446" formatCode="General">
                  <c:v>0.50632699999999997</c:v>
                </c:pt>
                <c:pt idx="1447" formatCode="General">
                  <c:v>0.54251300000000002</c:v>
                </c:pt>
                <c:pt idx="1448" formatCode="General">
                  <c:v>0.58126199999999995</c:v>
                </c:pt>
                <c:pt idx="1449" formatCode="General">
                  <c:v>0.62275000000000003</c:v>
                </c:pt>
                <c:pt idx="1450" formatCode="General">
                  <c:v>0.66716799999999998</c:v>
                </c:pt>
                <c:pt idx="1451" formatCode="General">
                  <c:v>0.71471399999999996</c:v>
                </c:pt>
                <c:pt idx="1452" formatCode="General">
                  <c:v>0.765602</c:v>
                </c:pt>
                <c:pt idx="1453" formatCode="General">
                  <c:v>0.82005799999999995</c:v>
                </c:pt>
                <c:pt idx="1454" formatCode="General">
                  <c:v>0.87832100000000002</c:v>
                </c:pt>
                <c:pt idx="1455" formatCode="General">
                  <c:v>0.94064499999999995</c:v>
                </c:pt>
                <c:pt idx="1456" formatCode="General">
                  <c:v>1.0073000000000001</c:v>
                </c:pt>
                <c:pt idx="1457" formatCode="General">
                  <c:v>1.07856</c:v>
                </c:pt>
                <c:pt idx="1458" formatCode="General">
                  <c:v>1.14127</c:v>
                </c:pt>
                <c:pt idx="1459" formatCode="General">
                  <c:v>1.20753</c:v>
                </c:pt>
                <c:pt idx="1460" formatCode="General">
                  <c:v>1.2775099999999999</c:v>
                </c:pt>
                <c:pt idx="1461" formatCode="General">
                  <c:v>1.3513900000000001</c:v>
                </c:pt>
                <c:pt idx="1462" formatCode="General">
                  <c:v>1.4293800000000001</c:v>
                </c:pt>
                <c:pt idx="1463" formatCode="General">
                  <c:v>1.5116700000000001</c:v>
                </c:pt>
                <c:pt idx="1464" formatCode="General">
                  <c:v>1.59846</c:v>
                </c:pt>
                <c:pt idx="1465" formatCode="General">
                  <c:v>1.68997</c:v>
                </c:pt>
                <c:pt idx="1466" formatCode="General">
                  <c:v>1.7863800000000001</c:v>
                </c:pt>
                <c:pt idx="1467" formatCode="General">
                  <c:v>1.8696200000000001</c:v>
                </c:pt>
                <c:pt idx="1468" formatCode="General">
                  <c:v>1.95644</c:v>
                </c:pt>
                <c:pt idx="1469" formatCode="General">
                  <c:v>2.0469599999999999</c:v>
                </c:pt>
                <c:pt idx="1470" formatCode="General">
                  <c:v>2.1412900000000001</c:v>
                </c:pt>
                <c:pt idx="1471" formatCode="General">
                  <c:v>2.2395200000000002</c:v>
                </c:pt>
                <c:pt idx="1472" formatCode="General">
                  <c:v>2.3417500000000002</c:v>
                </c:pt>
                <c:pt idx="1473" formatCode="General">
                  <c:v>2.44807</c:v>
                </c:pt>
                <c:pt idx="1474" formatCode="General">
                  <c:v>2.5585399999999998</c:v>
                </c:pt>
                <c:pt idx="1475" formatCode="General">
                  <c:v>2.6490499999999999</c:v>
                </c:pt>
                <c:pt idx="1476" formatCode="General">
                  <c:v>2.7164799999999998</c:v>
                </c:pt>
                <c:pt idx="1477" formatCode="General">
                  <c:v>2.78531</c:v>
                </c:pt>
                <c:pt idx="1478" formatCode="General">
                  <c:v>2.7980900000000002</c:v>
                </c:pt>
                <c:pt idx="1479" formatCode="General">
                  <c:v>2.8003999999999998</c:v>
                </c:pt>
                <c:pt idx="1480" formatCode="General">
                  <c:v>2.8027000000000002</c:v>
                </c:pt>
                <c:pt idx="1481" formatCode="General">
                  <c:v>2.8050099999999998</c:v>
                </c:pt>
                <c:pt idx="1482" formatCode="General">
                  <c:v>2.8073199999999998</c:v>
                </c:pt>
                <c:pt idx="1483" formatCode="General">
                  <c:v>2.8119399999999999</c:v>
                </c:pt>
                <c:pt idx="1484" formatCode="General">
                  <c:v>2.81657</c:v>
                </c:pt>
                <c:pt idx="1485" formatCode="General">
                  <c:v>2.8212000000000002</c:v>
                </c:pt>
                <c:pt idx="1486" formatCode="General">
                  <c:v>2.8258399999999999</c:v>
                </c:pt>
                <c:pt idx="1487" formatCode="General">
                  <c:v>2.8424100000000001</c:v>
                </c:pt>
                <c:pt idx="1488" formatCode="General">
                  <c:v>2.8590599999999999</c:v>
                </c:pt>
                <c:pt idx="1489" formatCode="General">
                  <c:v>2.8757899999999998</c:v>
                </c:pt>
                <c:pt idx="1490" formatCode="General">
                  <c:v>2.8925900000000002</c:v>
                </c:pt>
                <c:pt idx="1491" formatCode="General">
                  <c:v>2.92841</c:v>
                </c:pt>
                <c:pt idx="1492" formatCode="General">
                  <c:v>2.9645700000000001</c:v>
                </c:pt>
                <c:pt idx="1493" formatCode="General">
                  <c:v>3.00108</c:v>
                </c:pt>
                <c:pt idx="1494" formatCode="General">
                  <c:v>3.0379399999999999</c:v>
                </c:pt>
                <c:pt idx="1495" formatCode="General">
                  <c:v>3.08908</c:v>
                </c:pt>
                <c:pt idx="1496" formatCode="General">
                  <c:v>3.1408700000000001</c:v>
                </c:pt>
                <c:pt idx="1497" formatCode="General">
                  <c:v>3.1932800000000001</c:v>
                </c:pt>
                <c:pt idx="1498" formatCode="General">
                  <c:v>3.2463199999999999</c:v>
                </c:pt>
                <c:pt idx="1499" formatCode="General">
                  <c:v>3.2872300000000001</c:v>
                </c:pt>
                <c:pt idx="1500" formatCode="General">
                  <c:v>3.3284899999999999</c:v>
                </c:pt>
                <c:pt idx="1501" formatCode="General">
                  <c:v>3.3700999999999999</c:v>
                </c:pt>
                <c:pt idx="1502" formatCode="General">
                  <c:v>3.4120400000000002</c:v>
                </c:pt>
                <c:pt idx="1503" formatCode="General">
                  <c:v>3.4543300000000001</c:v>
                </c:pt>
                <c:pt idx="1504" formatCode="General">
                  <c:v>3.4969399999999999</c:v>
                </c:pt>
                <c:pt idx="1505" formatCode="General">
                  <c:v>3.5398800000000001</c:v>
                </c:pt>
                <c:pt idx="1506" formatCode="General">
                  <c:v>3.5831200000000001</c:v>
                </c:pt>
                <c:pt idx="1507" formatCode="General">
                  <c:v>3.6265800000000001</c:v>
                </c:pt>
                <c:pt idx="1508" formatCode="General">
                  <c:v>3.6703399999999999</c:v>
                </c:pt>
                <c:pt idx="1509" formatCode="General">
                  <c:v>3.7143700000000002</c:v>
                </c:pt>
                <c:pt idx="1510" formatCode="General">
                  <c:v>3.75867</c:v>
                </c:pt>
                <c:pt idx="1511" formatCode="General">
                  <c:v>3.8032300000000001</c:v>
                </c:pt>
                <c:pt idx="1512" formatCode="General">
                  <c:v>3.8540100000000002</c:v>
                </c:pt>
                <c:pt idx="1513" formatCode="General">
                  <c:v>3.9050799999999999</c:v>
                </c:pt>
                <c:pt idx="1514" formatCode="General">
                  <c:v>3.95641</c:v>
                </c:pt>
                <c:pt idx="1515" formatCode="General">
                  <c:v>4.0079799999999999</c:v>
                </c:pt>
                <c:pt idx="1516" formatCode="General">
                  <c:v>4.0597500000000002</c:v>
                </c:pt>
                <c:pt idx="1517" formatCode="General">
                  <c:v>4.1117100000000004</c:v>
                </c:pt>
                <c:pt idx="1518" formatCode="General">
                  <c:v>4.1638099999999998</c:v>
                </c:pt>
                <c:pt idx="1519" formatCode="General">
                  <c:v>4.2160200000000003</c:v>
                </c:pt>
                <c:pt idx="1520" formatCode="General">
                  <c:v>4.2683</c:v>
                </c:pt>
                <c:pt idx="1521" formatCode="General">
                  <c:v>4.3206100000000003</c:v>
                </c:pt>
                <c:pt idx="1522" formatCode="General">
                  <c:v>4.3728999999999996</c:v>
                </c:pt>
                <c:pt idx="1523" formatCode="General">
                  <c:v>4.4251300000000002</c:v>
                </c:pt>
                <c:pt idx="1524" formatCode="General">
                  <c:v>4.4772499999999997</c:v>
                </c:pt>
                <c:pt idx="1525" formatCode="General">
                  <c:v>4.5291899999999998</c:v>
                </c:pt>
                <c:pt idx="1526" formatCode="General">
                  <c:v>4.5808999999999997</c:v>
                </c:pt>
                <c:pt idx="1527" formatCode="General">
                  <c:v>4.63232</c:v>
                </c:pt>
                <c:pt idx="1528" formatCode="General">
                  <c:v>4.68337</c:v>
                </c:pt>
                <c:pt idx="1529" formatCode="General">
                  <c:v>4.73996</c:v>
                </c:pt>
                <c:pt idx="1530" formatCode="General">
                  <c:v>4.79589</c:v>
                </c:pt>
                <c:pt idx="1531" formatCode="General">
                  <c:v>4.8395400000000004</c:v>
                </c:pt>
                <c:pt idx="1532" formatCode="General">
                  <c:v>4.8826499999999999</c:v>
                </c:pt>
                <c:pt idx="1533" formatCode="General">
                  <c:v>4.9251300000000002</c:v>
                </c:pt>
                <c:pt idx="1534" formatCode="General">
                  <c:v>4.9669100000000004</c:v>
                </c:pt>
                <c:pt idx="1535" formatCode="General">
                  <c:v>5.00793</c:v>
                </c:pt>
                <c:pt idx="1536" formatCode="General">
                  <c:v>5.0480900000000002</c:v>
                </c:pt>
                <c:pt idx="1537" formatCode="General">
                  <c:v>5.0873200000000001</c:v>
                </c:pt>
                <c:pt idx="1538" formatCode="General">
                  <c:v>5.1255199999999999</c:v>
                </c:pt>
                <c:pt idx="1539" formatCode="General">
                  <c:v>5.1625899999999998</c:v>
                </c:pt>
                <c:pt idx="1540" formatCode="General">
                  <c:v>5.1984300000000001</c:v>
                </c:pt>
                <c:pt idx="1541" formatCode="General">
                  <c:v>5.2329400000000001</c:v>
                </c:pt>
                <c:pt idx="1542" formatCode="General">
                  <c:v>5.2717599999999996</c:v>
                </c:pt>
                <c:pt idx="1543" formatCode="General">
                  <c:v>5.3083600000000004</c:v>
                </c:pt>
                <c:pt idx="1544" formatCode="General">
                  <c:v>5.34253</c:v>
                </c:pt>
                <c:pt idx="1545" formatCode="General">
                  <c:v>5.3740500000000004</c:v>
                </c:pt>
                <c:pt idx="1546" formatCode="General">
                  <c:v>5.40266</c:v>
                </c:pt>
                <c:pt idx="1547" formatCode="General">
                  <c:v>5.4281199999999998</c:v>
                </c:pt>
                <c:pt idx="1548" formatCode="General">
                  <c:v>5.45017</c:v>
                </c:pt>
                <c:pt idx="1549" formatCode="General">
                  <c:v>5.4684999999999997</c:v>
                </c:pt>
                <c:pt idx="1550" formatCode="General">
                  <c:v>5.4828299999999999</c:v>
                </c:pt>
                <c:pt idx="1551" formatCode="General">
                  <c:v>5.4928400000000002</c:v>
                </c:pt>
                <c:pt idx="1552" formatCode="General">
                  <c:v>5.4981999999999998</c:v>
                </c:pt>
                <c:pt idx="1553" formatCode="General">
                  <c:v>5.4985600000000003</c:v>
                </c:pt>
                <c:pt idx="1554" formatCode="General">
                  <c:v>5.4935799999999997</c:v>
                </c:pt>
                <c:pt idx="1555" formatCode="General">
                  <c:v>5.4828799999999998</c:v>
                </c:pt>
                <c:pt idx="1556" formatCode="General">
                  <c:v>5.4660799999999998</c:v>
                </c:pt>
                <c:pt idx="1557" formatCode="General">
                  <c:v>5.4428099999999997</c:v>
                </c:pt>
                <c:pt idx="1558" formatCode="General">
                  <c:v>5.4126700000000003</c:v>
                </c:pt>
                <c:pt idx="1559" formatCode="General">
                  <c:v>5.3752700000000004</c:v>
                </c:pt>
                <c:pt idx="1560" formatCode="General">
                  <c:v>5.3383900000000004</c:v>
                </c:pt>
                <c:pt idx="1561" formatCode="General">
                  <c:v>5.29603</c:v>
                </c:pt>
                <c:pt idx="1562" formatCode="General">
                  <c:v>5.2479699999999996</c:v>
                </c:pt>
                <c:pt idx="1563" formatCode="General">
                  <c:v>5.1940200000000001</c:v>
                </c:pt>
                <c:pt idx="1564" formatCode="General">
                  <c:v>5.1340000000000003</c:v>
                </c:pt>
                <c:pt idx="1565" formatCode="General">
                  <c:v>5.0677399999999997</c:v>
                </c:pt>
                <c:pt idx="1566" formatCode="General">
                  <c:v>4.99512</c:v>
                </c:pt>
                <c:pt idx="1567" formatCode="General">
                  <c:v>4.91601</c:v>
                </c:pt>
                <c:pt idx="1568" formatCode="General">
                  <c:v>4.8469300000000004</c:v>
                </c:pt>
                <c:pt idx="1569" formatCode="General">
                  <c:v>4.7734899999999998</c:v>
                </c:pt>
                <c:pt idx="1570" formatCode="General">
                  <c:v>4.6956800000000003</c:v>
                </c:pt>
                <c:pt idx="1571" formatCode="General">
                  <c:v>4.6135299999999999</c:v>
                </c:pt>
                <c:pt idx="1572" formatCode="General">
                  <c:v>4.5270599999999996</c:v>
                </c:pt>
                <c:pt idx="1573" formatCode="General">
                  <c:v>4.4363200000000003</c:v>
                </c:pt>
                <c:pt idx="1574" formatCode="General">
                  <c:v>4.3414099999999998</c:v>
                </c:pt>
                <c:pt idx="1575" formatCode="General">
                  <c:v>4.2424400000000002</c:v>
                </c:pt>
                <c:pt idx="1576" formatCode="General">
                  <c:v>4.12094</c:v>
                </c:pt>
                <c:pt idx="1577" formatCode="General">
                  <c:v>3.9942799999999998</c:v>
                </c:pt>
                <c:pt idx="1578" formatCode="General">
                  <c:v>3.8627799999999999</c:v>
                </c:pt>
                <c:pt idx="1579" formatCode="General">
                  <c:v>3.7268500000000002</c:v>
                </c:pt>
                <c:pt idx="1580" formatCode="General">
                  <c:v>3.5869200000000001</c:v>
                </c:pt>
                <c:pt idx="1581" formatCode="General">
                  <c:v>3.4434999999999998</c:v>
                </c:pt>
                <c:pt idx="1582" formatCode="General">
                  <c:v>3.26376</c:v>
                </c:pt>
                <c:pt idx="1583" formatCode="General">
                  <c:v>3.0807500000000001</c:v>
                </c:pt>
                <c:pt idx="1584" formatCode="General">
                  <c:v>2.8957000000000002</c:v>
                </c:pt>
                <c:pt idx="1585" formatCode="General">
                  <c:v>2.7099099999999998</c:v>
                </c:pt>
                <c:pt idx="1586" formatCode="General">
                  <c:v>2.5247099999999998</c:v>
                </c:pt>
                <c:pt idx="1587" formatCode="General">
                  <c:v>2.34145</c:v>
                </c:pt>
                <c:pt idx="1588" formatCode="General">
                  <c:v>2.19211</c:v>
                </c:pt>
                <c:pt idx="1589" formatCode="General">
                  <c:v>2.04575</c:v>
                </c:pt>
                <c:pt idx="1590" formatCode="General">
                  <c:v>1.90306</c:v>
                </c:pt>
                <c:pt idx="1591" formatCode="General">
                  <c:v>1.76468</c:v>
                </c:pt>
                <c:pt idx="1592" formatCode="General">
                  <c:v>1.7451099999999999</c:v>
                </c:pt>
                <c:pt idx="1593" formatCode="General">
                  <c:v>1.7256400000000001</c:v>
                </c:pt>
                <c:pt idx="1594" formatCode="General">
                  <c:v>1.70627</c:v>
                </c:pt>
                <c:pt idx="1595" formatCode="General">
                  <c:v>1.6870099999999999</c:v>
                </c:pt>
                <c:pt idx="1596" formatCode="General">
                  <c:v>1.6678599999999999</c:v>
                </c:pt>
                <c:pt idx="1597" formatCode="General">
                  <c:v>1.6368799999999999</c:v>
                </c:pt>
                <c:pt idx="1598" formatCode="General">
                  <c:v>1.6062099999999999</c:v>
                </c:pt>
                <c:pt idx="1599" formatCode="General">
                  <c:v>1.5758300000000001</c:v>
                </c:pt>
                <c:pt idx="1600" formatCode="General">
                  <c:v>1.5457700000000001</c:v>
                </c:pt>
                <c:pt idx="1601" formatCode="General">
                  <c:v>1.49156</c:v>
                </c:pt>
                <c:pt idx="1602" formatCode="General">
                  <c:v>1.4384399999999999</c:v>
                </c:pt>
                <c:pt idx="1603" formatCode="General">
                  <c:v>1.3864300000000001</c:v>
                </c:pt>
                <c:pt idx="1604" formatCode="General">
                  <c:v>1.3355699999999999</c:v>
                </c:pt>
                <c:pt idx="1605" formatCode="General">
                  <c:v>1.2726</c:v>
                </c:pt>
                <c:pt idx="1606" formatCode="General">
                  <c:v>1.21156</c:v>
                </c:pt>
                <c:pt idx="1607" formatCode="General">
                  <c:v>1.15246</c:v>
                </c:pt>
                <c:pt idx="1608" formatCode="General">
                  <c:v>1.10609</c:v>
                </c:pt>
                <c:pt idx="1609" formatCode="General">
                  <c:v>1.06101</c:v>
                </c:pt>
                <c:pt idx="1610" formatCode="General">
                  <c:v>1.0172399999999999</c:v>
                </c:pt>
                <c:pt idx="1611" formatCode="General">
                  <c:v>0.97478900000000002</c:v>
                </c:pt>
                <c:pt idx="1612" formatCode="General">
                  <c:v>0.933643</c:v>
                </c:pt>
                <c:pt idx="1613" formatCode="General">
                  <c:v>0.89380400000000004</c:v>
                </c:pt>
                <c:pt idx="1614" formatCode="General">
                  <c:v>0.85526599999999997</c:v>
                </c:pt>
                <c:pt idx="1615" formatCode="General">
                  <c:v>0.81801900000000005</c:v>
                </c:pt>
                <c:pt idx="1616" formatCode="General">
                  <c:v>0.78205199999999997</c:v>
                </c:pt>
                <c:pt idx="1617" formatCode="General">
                  <c:v>0.74734999999999996</c:v>
                </c:pt>
                <c:pt idx="1618" formatCode="General">
                  <c:v>0.71389800000000003</c:v>
                </c:pt>
                <c:pt idx="1619" formatCode="General">
                  <c:v>0.68238399999999999</c:v>
                </c:pt>
                <c:pt idx="1620" formatCode="General">
                  <c:v>0.65202700000000002</c:v>
                </c:pt>
                <c:pt idx="1621" formatCode="General">
                  <c:v>0.62280800000000003</c:v>
                </c:pt>
                <c:pt idx="1622" formatCode="General">
                  <c:v>0.59470400000000001</c:v>
                </c:pt>
                <c:pt idx="1623" formatCode="General">
                  <c:v>0.56769400000000003</c:v>
                </c:pt>
                <c:pt idx="1624" formatCode="General">
                  <c:v>0.53714300000000004</c:v>
                </c:pt>
                <c:pt idx="1625" formatCode="General">
                  <c:v>0.50804199999999999</c:v>
                </c:pt>
                <c:pt idx="1626" formatCode="General">
                  <c:v>0.48540299999999997</c:v>
                </c:pt>
                <c:pt idx="1627" formatCode="General">
                  <c:v>0.46367000000000003</c:v>
                </c:pt>
                <c:pt idx="1628" formatCode="General">
                  <c:v>0.44282100000000002</c:v>
                </c:pt>
                <c:pt idx="1629" formatCode="General">
                  <c:v>0.42282900000000001</c:v>
                </c:pt>
                <c:pt idx="1630" formatCode="General">
                  <c:v>0.403669</c:v>
                </c:pt>
                <c:pt idx="1631" formatCode="General">
                  <c:v>0.38531599999999999</c:v>
                </c:pt>
                <c:pt idx="1632" formatCode="General">
                  <c:v>0.36774400000000002</c:v>
                </c:pt>
                <c:pt idx="1633" formatCode="General">
                  <c:v>0.35092800000000002</c:v>
                </c:pt>
                <c:pt idx="1634" formatCode="General">
                  <c:v>0.329401</c:v>
                </c:pt>
                <c:pt idx="1635" formatCode="General">
                  <c:v>0.30914000000000003</c:v>
                </c:pt>
                <c:pt idx="1636" formatCode="General">
                  <c:v>0.29384300000000002</c:v>
                </c:pt>
                <c:pt idx="1637" formatCode="General">
                  <c:v>0.28316200000000002</c:v>
                </c:pt>
                <c:pt idx="1638" formatCode="General">
                  <c:v>0.27285999999999999</c:v>
                </c:pt>
                <c:pt idx="1639" formatCode="General">
                  <c:v>0.270845</c:v>
                </c:pt>
                <c:pt idx="1640" formatCode="General">
                  <c:v>0.268843</c:v>
                </c:pt>
                <c:pt idx="1641" formatCode="General">
                  <c:v>0.26685700000000001</c:v>
                </c:pt>
                <c:pt idx="1642" formatCode="General">
                  <c:v>0.26488499999999998</c:v>
                </c:pt>
                <c:pt idx="1643" formatCode="General">
                  <c:v>0.261293</c:v>
                </c:pt>
                <c:pt idx="1644" formatCode="General">
                  <c:v>0.25774900000000001</c:v>
                </c:pt>
                <c:pt idx="1645" formatCode="General">
                  <c:v>0.25425300000000001</c:v>
                </c:pt>
                <c:pt idx="1646" formatCode="General">
                  <c:v>0.25080400000000003</c:v>
                </c:pt>
                <c:pt idx="1647" formatCode="General">
                  <c:v>0.240811</c:v>
                </c:pt>
                <c:pt idx="1648" formatCode="General">
                  <c:v>0.231214</c:v>
                </c:pt>
                <c:pt idx="1649" formatCode="General">
                  <c:v>0.222002</c:v>
                </c:pt>
                <c:pt idx="1650" formatCode="General">
                  <c:v>0.21315899999999999</c:v>
                </c:pt>
                <c:pt idx="1651" formatCode="General">
                  <c:v>0.20213900000000001</c:v>
                </c:pt>
                <c:pt idx="1652" formatCode="General">
                  <c:v>0.19169800000000001</c:v>
                </c:pt>
                <c:pt idx="1653" formatCode="General">
                  <c:v>0.18181</c:v>
                </c:pt>
                <c:pt idx="1654" formatCode="General">
                  <c:v>0.17244599999999999</c:v>
                </c:pt>
                <c:pt idx="1655" formatCode="General">
                  <c:v>0.163581</c:v>
                </c:pt>
                <c:pt idx="1656" formatCode="General">
                  <c:v>0.15518899999999999</c:v>
                </c:pt>
                <c:pt idx="1657" formatCode="General">
                  <c:v>0.14724699999999999</c:v>
                </c:pt>
                <c:pt idx="1658" formatCode="General">
                  <c:v>0.139732</c:v>
                </c:pt>
                <c:pt idx="1659" formatCode="General">
                  <c:v>0.129189</c:v>
                </c:pt>
                <c:pt idx="1660" formatCode="General">
                  <c:v>0.119489</c:v>
                </c:pt>
                <c:pt idx="1661" formatCode="General">
                  <c:v>0.110565</c:v>
                </c:pt>
                <c:pt idx="1662" formatCode="General">
                  <c:v>0.102357</c:v>
                </c:pt>
                <c:pt idx="1663" formatCode="General">
                  <c:v>9.4806600000000005E-2</c:v>
                </c:pt>
                <c:pt idx="1664" formatCode="General">
                  <c:v>8.7860599999999997E-2</c:v>
                </c:pt>
                <c:pt idx="1665" formatCode="General">
                  <c:v>8.1470100000000004E-2</c:v>
                </c:pt>
                <c:pt idx="1666" formatCode="General">
                  <c:v>7.5589699999999996E-2</c:v>
                </c:pt>
                <c:pt idx="1667" formatCode="General">
                  <c:v>7.0177500000000004E-2</c:v>
                </c:pt>
                <c:pt idx="1668" formatCode="General">
                  <c:v>6.51949E-2</c:v>
                </c:pt>
                <c:pt idx="1669" formatCode="General">
                  <c:v>6.0606399999999998E-2</c:v>
                </c:pt>
                <c:pt idx="1670" formatCode="General">
                  <c:v>5.5907900000000003E-2</c:v>
                </c:pt>
                <c:pt idx="1671" formatCode="General">
                  <c:v>5.1618900000000002E-2</c:v>
                </c:pt>
                <c:pt idx="1672" formatCode="General">
                  <c:v>4.77017E-2</c:v>
                </c:pt>
                <c:pt idx="1673" formatCode="General">
                  <c:v>4.4122000000000001E-2</c:v>
                </c:pt>
                <c:pt idx="1674" formatCode="General">
                  <c:v>4.0848700000000002E-2</c:v>
                </c:pt>
                <c:pt idx="1675" formatCode="General">
                  <c:v>3.7853699999999997E-2</c:v>
                </c:pt>
                <c:pt idx="1676" formatCode="General">
                  <c:v>3.5111700000000003E-2</c:v>
                </c:pt>
                <c:pt idx="1677" formatCode="General">
                  <c:v>3.2599499999999997E-2</c:v>
                </c:pt>
                <c:pt idx="1678" formatCode="General">
                  <c:v>3.0296099999999999E-2</c:v>
                </c:pt>
                <c:pt idx="1679" formatCode="General">
                  <c:v>2.8182700000000002E-2</c:v>
                </c:pt>
                <c:pt idx="1680" formatCode="General">
                  <c:v>2.62422E-2</c:v>
                </c:pt>
                <c:pt idx="1681" formatCode="General">
                  <c:v>2.4459100000000001E-2</c:v>
                </c:pt>
                <c:pt idx="1682" formatCode="General">
                  <c:v>2.2601099999999999E-2</c:v>
                </c:pt>
                <c:pt idx="1683" formatCode="General">
                  <c:v>2.0910499999999999E-2</c:v>
                </c:pt>
                <c:pt idx="1684" formatCode="General">
                  <c:v>1.9370700000000001E-2</c:v>
                </c:pt>
                <c:pt idx="1685" formatCode="General">
                  <c:v>1.7966800000000002E-2</c:v>
                </c:pt>
                <c:pt idx="1686" formatCode="General">
                  <c:v>1.66854E-2</c:v>
                </c:pt>
                <c:pt idx="1687" formatCode="General">
                  <c:v>1.5514500000000001E-2</c:v>
                </c:pt>
                <c:pt idx="1688" formatCode="General">
                  <c:v>1.4443599999999999E-2</c:v>
                </c:pt>
                <c:pt idx="1689" formatCode="General">
                  <c:v>1.3462999999999999E-2</c:v>
                </c:pt>
                <c:pt idx="1690" formatCode="General">
                  <c:v>1.25641E-2</c:v>
                </c:pt>
                <c:pt idx="1691" formatCode="General">
                  <c:v>1.1739400000000001E-2</c:v>
                </c:pt>
                <c:pt idx="1692" formatCode="General">
                  <c:v>1.09817E-2</c:v>
                </c:pt>
                <c:pt idx="1693" formatCode="General">
                  <c:v>1.0406200000000001E-2</c:v>
                </c:pt>
                <c:pt idx="1694" formatCode="General">
                  <c:v>9.9617100000000004E-3</c:v>
                </c:pt>
                <c:pt idx="1695" formatCode="General">
                  <c:v>9.5412399999999994E-3</c:v>
                </c:pt>
                <c:pt idx="1696" formatCode="General">
                  <c:v>9.4694800000000006E-3</c:v>
                </c:pt>
                <c:pt idx="1697" formatCode="General">
                  <c:v>9.3984199999999993E-3</c:v>
                </c:pt>
                <c:pt idx="1698" formatCode="General">
                  <c:v>9.3280399999999992E-3</c:v>
                </c:pt>
                <c:pt idx="1699" formatCode="General">
                  <c:v>9.2583400000000003E-3</c:v>
                </c:pt>
                <c:pt idx="1700" formatCode="General">
                  <c:v>9.1893099999999991E-3</c:v>
                </c:pt>
                <c:pt idx="1701" formatCode="General">
                  <c:v>9.0532200000000007E-3</c:v>
                </c:pt>
                <c:pt idx="1702" formatCode="General">
                  <c:v>8.9197200000000008E-3</c:v>
                </c:pt>
                <c:pt idx="1703" formatCode="General">
                  <c:v>8.7887399999999997E-3</c:v>
                </c:pt>
                <c:pt idx="1704" formatCode="General">
                  <c:v>8.6602499999999995E-3</c:v>
                </c:pt>
                <c:pt idx="1705" formatCode="General">
                  <c:v>8.4595299999999998E-3</c:v>
                </c:pt>
                <c:pt idx="1706" formatCode="General">
                  <c:v>8.2647999999999992E-3</c:v>
                </c:pt>
                <c:pt idx="1707" formatCode="General">
                  <c:v>8.0758500000000007E-3</c:v>
                </c:pt>
                <c:pt idx="1708" formatCode="General">
                  <c:v>7.8925000000000002E-3</c:v>
                </c:pt>
                <c:pt idx="1709" formatCode="General">
                  <c:v>7.6093300000000001E-3</c:v>
                </c:pt>
                <c:pt idx="1710" formatCode="General">
                  <c:v>7.3393099999999999E-3</c:v>
                </c:pt>
                <c:pt idx="1711" formatCode="General">
                  <c:v>7.0817400000000004E-3</c:v>
                </c:pt>
                <c:pt idx="1712" formatCode="General">
                  <c:v>6.8359700000000002E-3</c:v>
                </c:pt>
                <c:pt idx="1713" formatCode="General">
                  <c:v>6.6013599999999997E-3</c:v>
                </c:pt>
                <c:pt idx="1714" formatCode="General">
                  <c:v>6.3457100000000001E-3</c:v>
                </c:pt>
                <c:pt idx="1715" formatCode="General">
                  <c:v>6.1030900000000003E-3</c:v>
                </c:pt>
                <c:pt idx="1716" formatCode="General">
                  <c:v>5.8727400000000004E-3</c:v>
                </c:pt>
                <c:pt idx="1717" formatCode="General">
                  <c:v>5.6539299999999997E-3</c:v>
                </c:pt>
                <c:pt idx="1718" formatCode="General">
                  <c:v>5.4460000000000003E-3</c:v>
                </c:pt>
                <c:pt idx="1719" formatCode="General">
                  <c:v>5.2483E-3</c:v>
                </c:pt>
                <c:pt idx="1720" formatCode="General">
                  <c:v>5.09173E-3</c:v>
                </c:pt>
                <c:pt idx="1721" formatCode="General">
                  <c:v>4.9414699999999999E-3</c:v>
                </c:pt>
                <c:pt idx="1722" formatCode="General">
                  <c:v>4.7972400000000004E-3</c:v>
                </c:pt>
                <c:pt idx="1723" formatCode="General">
                  <c:v>4.6587399999999998E-3</c:v>
                </c:pt>
                <c:pt idx="1724" formatCode="General">
                  <c:v>4.5257199999999996E-3</c:v>
                </c:pt>
                <c:pt idx="1725" formatCode="General">
                  <c:v>4.3620600000000001E-3</c:v>
                </c:pt>
                <c:pt idx="1726" formatCode="General">
                  <c:v>4.2065399999999999E-3</c:v>
                </c:pt>
                <c:pt idx="1727" formatCode="General">
                  <c:v>4.0846399999999996E-3</c:v>
                </c:pt>
                <c:pt idx="1728" formatCode="General">
                  <c:v>3.9938600000000001E-3</c:v>
                </c:pt>
                <c:pt idx="1729" formatCode="General">
                  <c:v>3.9059099999999999E-3</c:v>
                </c:pt>
                <c:pt idx="1730" formatCode="General">
                  <c:v>3.8891500000000001E-3</c:v>
                </c:pt>
                <c:pt idx="1731" formatCode="General">
                  <c:v>3.8724900000000001E-3</c:v>
                </c:pt>
                <c:pt idx="1732" formatCode="General">
                  <c:v>3.85593E-3</c:v>
                </c:pt>
                <c:pt idx="1733" formatCode="General">
                  <c:v>3.8394700000000002E-3</c:v>
                </c:pt>
                <c:pt idx="1734" formatCode="General">
                  <c:v>3.8068500000000001E-3</c:v>
                </c:pt>
                <c:pt idx="1735" formatCode="General">
                  <c:v>3.7746300000000002E-3</c:v>
                </c:pt>
                <c:pt idx="1736" formatCode="General">
                  <c:v>3.7427900000000002E-3</c:v>
                </c:pt>
                <c:pt idx="1737" formatCode="General">
                  <c:v>3.7113300000000001E-3</c:v>
                </c:pt>
                <c:pt idx="1738" formatCode="General">
                  <c:v>3.6258100000000001E-3</c:v>
                </c:pt>
                <c:pt idx="1739" formatCode="General">
                  <c:v>3.54309E-3</c:v>
                </c:pt>
                <c:pt idx="1740" formatCode="General">
                  <c:v>3.46306E-3</c:v>
                </c:pt>
                <c:pt idx="1741" formatCode="General">
                  <c:v>3.3856099999999998E-3</c:v>
                </c:pt>
                <c:pt idx="1742" formatCode="General">
                  <c:v>3.2782499999999999E-3</c:v>
                </c:pt>
                <c:pt idx="1743" formatCode="General">
                  <c:v>3.1757899999999999E-3</c:v>
                </c:pt>
                <c:pt idx="1744" formatCode="General">
                  <c:v>3.0959099999999999E-3</c:v>
                </c:pt>
                <c:pt idx="1745" formatCode="General">
                  <c:v>3.0189700000000002E-3</c:v>
                </c:pt>
                <c:pt idx="1746" formatCode="General">
                  <c:v>2.9448299999999998E-3</c:v>
                </c:pt>
                <c:pt idx="1747" formatCode="General">
                  <c:v>2.8733700000000001E-3</c:v>
                </c:pt>
                <c:pt idx="1748" formatCode="General">
                  <c:v>2.8044799999999998E-3</c:v>
                </c:pt>
                <c:pt idx="1749" formatCode="General">
                  <c:v>2.71427E-3</c:v>
                </c:pt>
                <c:pt idx="1750" formatCode="General">
                  <c:v>2.62839E-3</c:v>
                </c:pt>
                <c:pt idx="1751" formatCode="General">
                  <c:v>2.5465900000000001E-3</c:v>
                </c:pt>
                <c:pt idx="1752" formatCode="General">
                  <c:v>2.4686500000000002E-3</c:v>
                </c:pt>
                <c:pt idx="1753" formatCode="General">
                  <c:v>2.39435E-3</c:v>
                </c:pt>
                <c:pt idx="1754" formatCode="General">
                  <c:v>2.2969700000000002E-3</c:v>
                </c:pt>
                <c:pt idx="1755" formatCode="General">
                  <c:v>2.2057000000000001E-3</c:v>
                </c:pt>
                <c:pt idx="1756" formatCode="General">
                  <c:v>2.1200899999999998E-3</c:v>
                </c:pt>
                <c:pt idx="1757" formatCode="General">
                  <c:v>2.03973E-3</c:v>
                </c:pt>
                <c:pt idx="1758" formatCode="General">
                  <c:v>1.96423E-3</c:v>
                </c:pt>
                <c:pt idx="1759" formatCode="General">
                  <c:v>1.89325E-3</c:v>
                </c:pt>
                <c:pt idx="1760" formatCode="General">
                  <c:v>1.8191800000000001E-3</c:v>
                </c:pt>
                <c:pt idx="1761" formatCode="General">
                  <c:v>1.7499E-3</c:v>
                </c:pt>
                <c:pt idx="1762" formatCode="General">
                  <c:v>1.6850599999999999E-3</c:v>
                </c:pt>
                <c:pt idx="1763" formatCode="General">
                  <c:v>1.6243099999999999E-3</c:v>
                </c:pt>
                <c:pt idx="1764" formatCode="General">
                  <c:v>1.5673499999999999E-3</c:v>
                </c:pt>
                <c:pt idx="1765" formatCode="General">
                  <c:v>1.51391E-3</c:v>
                </c:pt>
                <c:pt idx="1766" formatCode="General">
                  <c:v>1.45711E-3</c:v>
                </c:pt>
                <c:pt idx="1767" formatCode="General">
                  <c:v>1.4041699999999999E-3</c:v>
                </c:pt>
                <c:pt idx="1768" formatCode="General">
                  <c:v>1.3548099999999999E-3</c:v>
                </c:pt>
                <c:pt idx="1769" formatCode="General">
                  <c:v>1.3087400000000001E-3</c:v>
                </c:pt>
                <c:pt idx="1770" formatCode="General">
                  <c:v>1.2657E-3</c:v>
                </c:pt>
                <c:pt idx="1771" formatCode="General">
                  <c:v>1.25833E-3</c:v>
                </c:pt>
                <c:pt idx="1772" formatCode="General">
                  <c:v>1.2510500000000001E-3</c:v>
                </c:pt>
                <c:pt idx="1773" formatCode="General">
                  <c:v>1.2438499999999999E-3</c:v>
                </c:pt>
                <c:pt idx="1774" formatCode="General">
                  <c:v>1.2367400000000001E-3</c:v>
                </c:pt>
                <c:pt idx="1775" formatCode="General">
                  <c:v>1.22971E-3</c:v>
                </c:pt>
                <c:pt idx="1776" formatCode="General">
                  <c:v>1.2161400000000001E-3</c:v>
                </c:pt>
                <c:pt idx="1777" formatCode="General">
                  <c:v>1.2028799999999999E-3</c:v>
                </c:pt>
                <c:pt idx="1778" formatCode="General">
                  <c:v>1.1899199999999999E-3</c:v>
                </c:pt>
                <c:pt idx="1779" formatCode="General">
                  <c:v>1.1772600000000001E-3</c:v>
                </c:pt>
                <c:pt idx="1780" formatCode="General">
                  <c:v>1.1588E-3</c:v>
                </c:pt>
                <c:pt idx="1781" formatCode="General">
                  <c:v>1.14097E-3</c:v>
                </c:pt>
                <c:pt idx="1782" formatCode="General">
                  <c:v>1.12374E-3</c:v>
                </c:pt>
                <c:pt idx="1783" formatCode="General">
                  <c:v>1.1070800000000001E-3</c:v>
                </c:pt>
                <c:pt idx="1784" formatCode="General">
                  <c:v>1.08449E-3</c:v>
                </c:pt>
                <c:pt idx="1785" formatCode="General">
                  <c:v>1.0629599999999999E-3</c:v>
                </c:pt>
                <c:pt idx="1786" formatCode="General">
                  <c:v>1.04243E-3</c:v>
                </c:pt>
                <c:pt idx="1787" formatCode="General">
                  <c:v>1.0228500000000001E-3</c:v>
                </c:pt>
                <c:pt idx="1788" formatCode="General">
                  <c:v>1.00417E-3</c:v>
                </c:pt>
                <c:pt idx="1789" formatCode="General">
                  <c:v>9.8457899999999997E-4</c:v>
                </c:pt>
                <c:pt idx="1790" formatCode="General">
                  <c:v>9.6597600000000001E-4</c:v>
                </c:pt>
                <c:pt idx="1791" formatCode="General">
                  <c:v>9.4830399999999997E-4</c:v>
                </c:pt>
                <c:pt idx="1792" formatCode="General">
                  <c:v>9.3151300000000002E-4</c:v>
                </c:pt>
                <c:pt idx="1793" formatCode="General">
                  <c:v>9.1555900000000003E-4</c:v>
                </c:pt>
                <c:pt idx="1794" formatCode="General">
                  <c:v>8.9270300000000001E-4</c:v>
                </c:pt>
                <c:pt idx="1795" formatCode="General">
                  <c:v>8.7155900000000005E-4</c:v>
                </c:pt>
                <c:pt idx="1796" formatCode="General">
                  <c:v>8.5200300000000005E-4</c:v>
                </c:pt>
                <c:pt idx="1797" formatCode="General">
                  <c:v>8.3391900000000002E-4</c:v>
                </c:pt>
                <c:pt idx="1798" formatCode="General">
                  <c:v>8.1720199999999995E-4</c:v>
                </c:pt>
                <c:pt idx="1799" formatCode="General">
                  <c:v>8.0175899999999998E-4</c:v>
                </c:pt>
                <c:pt idx="1800" formatCode="General">
                  <c:v>7.8281499999999996E-4</c:v>
                </c:pt>
                <c:pt idx="1801" formatCode="General">
                  <c:v>7.6584199999999998E-4</c:v>
                </c:pt>
                <c:pt idx="1802" formatCode="General">
                  <c:v>7.50674E-4</c:v>
                </c:pt>
                <c:pt idx="1803" formatCode="General">
                  <c:v>7.3716400000000001E-4</c:v>
                </c:pt>
                <c:pt idx="1804" formatCode="General">
                  <c:v>7.2518300000000001E-4</c:v>
                </c:pt>
                <c:pt idx="1805" formatCode="General">
                  <c:v>7.1461599999999995E-4</c:v>
                </c:pt>
                <c:pt idx="1806" formatCode="General">
                  <c:v>7.0536299999999998E-4</c:v>
                </c:pt>
                <c:pt idx="1807" formatCode="General">
                  <c:v>6.9733200000000005E-4</c:v>
                </c:pt>
                <c:pt idx="1808" formatCode="General">
                  <c:v>6.9044400000000002E-4</c:v>
                </c:pt>
                <c:pt idx="1809" formatCode="General">
                  <c:v>6.8370099999999999E-4</c:v>
                </c:pt>
                <c:pt idx="1810" formatCode="General">
                  <c:v>6.7834199999999996E-4</c:v>
                </c:pt>
                <c:pt idx="1811" formatCode="General">
                  <c:v>6.7427800000000005E-4</c:v>
                </c:pt>
                <c:pt idx="1812" formatCode="General">
                  <c:v>6.7142999999999999E-4</c:v>
                </c:pt>
                <c:pt idx="1813" formatCode="General">
                  <c:v>6.6996999999999998E-4</c:v>
                </c:pt>
                <c:pt idx="1814" formatCode="General">
                  <c:v>6.69778E-4</c:v>
                </c:pt>
                <c:pt idx="1815" formatCode="General">
                  <c:v>6.6961099999999997E-4</c:v>
                </c:pt>
                <c:pt idx="1816" formatCode="General">
                  <c:v>6.6946799999999999E-4</c:v>
                </c:pt>
                <c:pt idx="1817" formatCode="General">
                  <c:v>6.69351E-4</c:v>
                </c:pt>
                <c:pt idx="1818" formatCode="General">
                  <c:v>6.6925800000000005E-4</c:v>
                </c:pt>
                <c:pt idx="1819" formatCode="General">
                  <c:v>6.69145E-4</c:v>
                </c:pt>
                <c:pt idx="1820" formatCode="General">
                  <c:v>6.6912899999999997E-4</c:v>
                </c:pt>
                <c:pt idx="1821" formatCode="General">
                  <c:v>6.69207E-4</c:v>
                </c:pt>
                <c:pt idx="1822" formatCode="General">
                  <c:v>6.6938000000000002E-4</c:v>
                </c:pt>
                <c:pt idx="1823" formatCode="General">
                  <c:v>6.6964499999999996E-4</c:v>
                </c:pt>
                <c:pt idx="1824" formatCode="General">
                  <c:v>6.7064200000000005E-4</c:v>
                </c:pt>
                <c:pt idx="1825" formatCode="General">
                  <c:v>6.7214499999999997E-4</c:v>
                </c:pt>
                <c:pt idx="1826" formatCode="General">
                  <c:v>6.7413900000000003E-4</c:v>
                </c:pt>
                <c:pt idx="1827" formatCode="General">
                  <c:v>6.7661399999999997E-4</c:v>
                </c:pt>
                <c:pt idx="1828" formatCode="General">
                  <c:v>6.7955900000000004E-4</c:v>
                </c:pt>
                <c:pt idx="1829" formatCode="General">
                  <c:v>6.8517199999999995E-4</c:v>
                </c:pt>
                <c:pt idx="1830" formatCode="General">
                  <c:v>6.9191599999999999E-4</c:v>
                </c:pt>
                <c:pt idx="1831" formatCode="General">
                  <c:v>6.9976999999999995E-4</c:v>
                </c:pt>
                <c:pt idx="1832" formatCode="General">
                  <c:v>7.0871599999999997E-4</c:v>
                </c:pt>
                <c:pt idx="1833" formatCode="General">
                  <c:v>7.1874299999999999E-4</c:v>
                </c:pt>
                <c:pt idx="1834" formatCode="General">
                  <c:v>7.29844E-4</c:v>
                </c:pt>
                <c:pt idx="1835" formatCode="General">
                  <c:v>7.4808399999999999E-4</c:v>
                </c:pt>
                <c:pt idx="1836" formatCode="General">
                  <c:v>7.6864399999999997E-4</c:v>
                </c:pt>
                <c:pt idx="1837" formatCode="General">
                  <c:v>7.9154799999999999E-4</c:v>
                </c:pt>
                <c:pt idx="1838" formatCode="General">
                  <c:v>8.1683700000000005E-4</c:v>
                </c:pt>
                <c:pt idx="1839" formatCode="General">
                  <c:v>8.4456600000000004E-4</c:v>
                </c:pt>
                <c:pt idx="1840" formatCode="General">
                  <c:v>8.74806E-4</c:v>
                </c:pt>
                <c:pt idx="1841" formatCode="General">
                  <c:v>9.1656400000000003E-4</c:v>
                </c:pt>
                <c:pt idx="1842" formatCode="General">
                  <c:v>9.62622E-4</c:v>
                </c:pt>
                <c:pt idx="1843" formatCode="General">
                  <c:v>1.0131999999999999E-3</c:v>
                </c:pt>
                <c:pt idx="1844" formatCode="General">
                  <c:v>1.0685600000000001E-3</c:v>
                </c:pt>
                <c:pt idx="1845" formatCode="General">
                  <c:v>1.12897E-3</c:v>
                </c:pt>
                <c:pt idx="1846" formatCode="General">
                  <c:v>1.18037E-3</c:v>
                </c:pt>
                <c:pt idx="1847" formatCode="General">
                  <c:v>1.2262900000000001E-3</c:v>
                </c:pt>
                <c:pt idx="1848" formatCode="General">
                  <c:v>1.2748E-3</c:v>
                </c:pt>
                <c:pt idx="1849" formatCode="General">
                  <c:v>1.3260100000000001E-3</c:v>
                </c:pt>
                <c:pt idx="1850" formatCode="General">
                  <c:v>1.3800399999999999E-3</c:v>
                </c:pt>
                <c:pt idx="1851" formatCode="General">
                  <c:v>1.43702E-3</c:v>
                </c:pt>
                <c:pt idx="1852" formatCode="General">
                  <c:v>1.50515E-3</c:v>
                </c:pt>
                <c:pt idx="1853" formatCode="General">
                  <c:v>1.5774300000000001E-3</c:v>
                </c:pt>
                <c:pt idx="1854" formatCode="General">
                  <c:v>1.65408E-3</c:v>
                </c:pt>
                <c:pt idx="1855" formatCode="General">
                  <c:v>1.71816E-3</c:v>
                </c:pt>
                <c:pt idx="1856" formatCode="General">
                  <c:v>1.7852600000000001E-3</c:v>
                </c:pt>
                <c:pt idx="1857" formatCode="General">
                  <c:v>1.8554999999999999E-3</c:v>
                </c:pt>
                <c:pt idx="1858" formatCode="General">
                  <c:v>1.92903E-3</c:v>
                </c:pt>
                <c:pt idx="1859" formatCode="General">
                  <c:v>2.0059700000000001E-3</c:v>
                </c:pt>
                <c:pt idx="1860" formatCode="General">
                  <c:v>2.0864899999999999E-3</c:v>
                </c:pt>
                <c:pt idx="1861" formatCode="General">
                  <c:v>2.1707300000000001E-3</c:v>
                </c:pt>
                <c:pt idx="1862" formatCode="General">
                  <c:v>2.2588500000000002E-3</c:v>
                </c:pt>
                <c:pt idx="1863" formatCode="General">
                  <c:v>2.27604E-3</c:v>
                </c:pt>
                <c:pt idx="1864" formatCode="General">
                  <c:v>2.2933699999999999E-3</c:v>
                </c:pt>
                <c:pt idx="1865" formatCode="General">
                  <c:v>2.3108500000000001E-3</c:v>
                </c:pt>
                <c:pt idx="1866" formatCode="General">
                  <c:v>2.32848E-3</c:v>
                </c:pt>
                <c:pt idx="1867" formatCode="General">
                  <c:v>2.3462600000000002E-3</c:v>
                </c:pt>
                <c:pt idx="1868" formatCode="General">
                  <c:v>2.3815300000000002E-3</c:v>
                </c:pt>
                <c:pt idx="1869" formatCode="General">
                  <c:v>2.4174000000000001E-3</c:v>
                </c:pt>
                <c:pt idx="1870" formatCode="General">
                  <c:v>2.4538699999999999E-3</c:v>
                </c:pt>
                <c:pt idx="1871" formatCode="General">
                  <c:v>2.49096E-3</c:v>
                </c:pt>
                <c:pt idx="1872" formatCode="General">
                  <c:v>2.5589200000000001E-3</c:v>
                </c:pt>
                <c:pt idx="1873" formatCode="General">
                  <c:v>2.6289400000000002E-3</c:v>
                </c:pt>
                <c:pt idx="1874" formatCode="General">
                  <c:v>2.7010699999999999E-3</c:v>
                </c:pt>
                <c:pt idx="1875" formatCode="General">
                  <c:v>2.77538E-3</c:v>
                </c:pt>
                <c:pt idx="1876" formatCode="General">
                  <c:v>2.8867400000000001E-3</c:v>
                </c:pt>
                <c:pt idx="1877" formatCode="General">
                  <c:v>3.0029700000000002E-3</c:v>
                </c:pt>
                <c:pt idx="1878" formatCode="General">
                  <c:v>3.1242700000000002E-3</c:v>
                </c:pt>
                <c:pt idx="1879" formatCode="General">
                  <c:v>3.2508699999999999E-3</c:v>
                </c:pt>
                <c:pt idx="1880" formatCode="General">
                  <c:v>3.3829699999999999E-3</c:v>
                </c:pt>
                <c:pt idx="1881" formatCode="General">
                  <c:v>3.5460800000000001E-3</c:v>
                </c:pt>
                <c:pt idx="1882" formatCode="General">
                  <c:v>3.7175699999999999E-3</c:v>
                </c:pt>
                <c:pt idx="1883" formatCode="General">
                  <c:v>3.8978699999999999E-3</c:v>
                </c:pt>
                <c:pt idx="1884" formatCode="General">
                  <c:v>4.0874099999999997E-3</c:v>
                </c:pt>
                <c:pt idx="1885" formatCode="General">
                  <c:v>4.2866700000000002E-3</c:v>
                </c:pt>
                <c:pt idx="1886" formatCode="General">
                  <c:v>4.5184600000000002E-3</c:v>
                </c:pt>
                <c:pt idx="1887" formatCode="General">
                  <c:v>4.7633700000000003E-3</c:v>
                </c:pt>
                <c:pt idx="1888" formatCode="General">
                  <c:v>5.0221299999999996E-3</c:v>
                </c:pt>
                <c:pt idx="1889" formatCode="General">
                  <c:v>5.2955099999999998E-3</c:v>
                </c:pt>
                <c:pt idx="1890" formatCode="General">
                  <c:v>5.5843300000000002E-3</c:v>
                </c:pt>
                <c:pt idx="1891" formatCode="General">
                  <c:v>5.9431700000000002E-3</c:v>
                </c:pt>
                <c:pt idx="1892" formatCode="General">
                  <c:v>6.3258000000000003E-3</c:v>
                </c:pt>
                <c:pt idx="1893" formatCode="General">
                  <c:v>6.7337999999999999E-3</c:v>
                </c:pt>
                <c:pt idx="1894" formatCode="General">
                  <c:v>7.1688300000000002E-3</c:v>
                </c:pt>
                <c:pt idx="1895" formatCode="General">
                  <c:v>7.6326500000000004E-3</c:v>
                </c:pt>
                <c:pt idx="1896" formatCode="General">
                  <c:v>8.1271699999999995E-3</c:v>
                </c:pt>
                <c:pt idx="1897" formatCode="General">
                  <c:v>8.6543999999999996E-3</c:v>
                </c:pt>
                <c:pt idx="1898" formatCode="General">
                  <c:v>9.2164900000000008E-3</c:v>
                </c:pt>
                <c:pt idx="1899" formatCode="General">
                  <c:v>9.8157299999999999E-3</c:v>
                </c:pt>
                <c:pt idx="1900" formatCode="General">
                  <c:v>1.04546E-2</c:v>
                </c:pt>
                <c:pt idx="1901" formatCode="General">
                  <c:v>1.1135600000000001E-2</c:v>
                </c:pt>
                <c:pt idx="1902" formatCode="General">
                  <c:v>1.18616E-2</c:v>
                </c:pt>
                <c:pt idx="1903" formatCode="General">
                  <c:v>1.3059599999999999E-2</c:v>
                </c:pt>
                <c:pt idx="1904" formatCode="General">
                  <c:v>1.4379899999999999E-2</c:v>
                </c:pt>
                <c:pt idx="1905" formatCode="General">
                  <c:v>1.5835100000000001E-2</c:v>
                </c:pt>
                <c:pt idx="1906" formatCode="General">
                  <c:v>1.7438800000000001E-2</c:v>
                </c:pt>
                <c:pt idx="1907" formatCode="General">
                  <c:v>1.92062E-2</c:v>
                </c:pt>
                <c:pt idx="1908" formatCode="General">
                  <c:v>2.11539E-2</c:v>
                </c:pt>
                <c:pt idx="1909" formatCode="General">
                  <c:v>2.3300299999999999E-2</c:v>
                </c:pt>
                <c:pt idx="1910" formatCode="General">
                  <c:v>2.56656E-2</c:v>
                </c:pt>
                <c:pt idx="1911" formatCode="General">
                  <c:v>2.8272100000000001E-2</c:v>
                </c:pt>
                <c:pt idx="1912" formatCode="General">
                  <c:v>3.1144399999999999E-2</c:v>
                </c:pt>
                <c:pt idx="1913" formatCode="General">
                  <c:v>3.4309399999999997E-2</c:v>
                </c:pt>
                <c:pt idx="1914" formatCode="General">
                  <c:v>3.7796999999999997E-2</c:v>
                </c:pt>
                <c:pt idx="1915" formatCode="General">
                  <c:v>4.1640000000000003E-2</c:v>
                </c:pt>
                <c:pt idx="1916" formatCode="General">
                  <c:v>4.5874600000000001E-2</c:v>
                </c:pt>
                <c:pt idx="1917" formatCode="General">
                  <c:v>5.0540500000000002E-2</c:v>
                </c:pt>
                <c:pt idx="1918" formatCode="General">
                  <c:v>5.5681799999999997E-2</c:v>
                </c:pt>
                <c:pt idx="1919" formatCode="General">
                  <c:v>6.1346499999999998E-2</c:v>
                </c:pt>
                <c:pt idx="1920" formatCode="General">
                  <c:v>6.7588099999999998E-2</c:v>
                </c:pt>
                <c:pt idx="1921" formatCode="General">
                  <c:v>7.4465199999999995E-2</c:v>
                </c:pt>
                <c:pt idx="1922" formatCode="General">
                  <c:v>8.2042199999999996E-2</c:v>
                </c:pt>
                <c:pt idx="1923" formatCode="General">
                  <c:v>9.0390300000000007E-2</c:v>
                </c:pt>
                <c:pt idx="1924" formatCode="General">
                  <c:v>0.10056</c:v>
                </c:pt>
                <c:pt idx="1925" formatCode="General">
                  <c:v>0.111873</c:v>
                </c:pt>
                <c:pt idx="1926" formatCode="General">
                  <c:v>0.124459</c:v>
                </c:pt>
                <c:pt idx="1927" formatCode="General">
                  <c:v>0.138459</c:v>
                </c:pt>
                <c:pt idx="1928" formatCode="General">
                  <c:v>0.154032</c:v>
                </c:pt>
                <c:pt idx="1929" formatCode="General">
                  <c:v>0.17135400000000001</c:v>
                </c:pt>
                <c:pt idx="1930" formatCode="General">
                  <c:v>0.19062100000000001</c:v>
                </c:pt>
                <c:pt idx="1931" formatCode="General">
                  <c:v>0.208261</c:v>
                </c:pt>
                <c:pt idx="1932" formatCode="General">
                  <c:v>0.22752900000000001</c:v>
                </c:pt>
                <c:pt idx="1933" formatCode="General">
                  <c:v>0.24857499999999999</c:v>
                </c:pt>
                <c:pt idx="1934" formatCode="General">
                  <c:v>0.27156200000000003</c:v>
                </c:pt>
                <c:pt idx="1935" formatCode="General">
                  <c:v>0.29666799999999999</c:v>
                </c:pt>
                <c:pt idx="1936" formatCode="General">
                  <c:v>0.32408500000000001</c:v>
                </c:pt>
                <c:pt idx="1937" formatCode="General">
                  <c:v>0.35402600000000001</c:v>
                </c:pt>
                <c:pt idx="1938" formatCode="General">
                  <c:v>0.38671800000000001</c:v>
                </c:pt>
                <c:pt idx="1939" formatCode="General">
                  <c:v>0.414186</c:v>
                </c:pt>
                <c:pt idx="1940" formatCode="General">
                  <c:v>0.44359399999999999</c:v>
                </c:pt>
                <c:pt idx="1941" formatCode="General">
                  <c:v>0.448548</c:v>
                </c:pt>
                <c:pt idx="1942" formatCode="General">
                  <c:v>0.45355600000000001</c:v>
                </c:pt>
                <c:pt idx="1943" formatCode="General">
                  <c:v>0.45771299999999998</c:v>
                </c:pt>
                <c:pt idx="1944" formatCode="General">
                  <c:v>0.46190700000000001</c:v>
                </c:pt>
                <c:pt idx="1945" formatCode="General">
                  <c:v>0.46613900000000003</c:v>
                </c:pt>
                <c:pt idx="1946" formatCode="General">
                  <c:v>0.47040999999999999</c:v>
                </c:pt>
                <c:pt idx="1947" formatCode="General">
                  <c:v>0.474719</c:v>
                </c:pt>
                <c:pt idx="1948" formatCode="General">
                  <c:v>0.47906799999999999</c:v>
                </c:pt>
                <c:pt idx="1949" formatCode="General">
                  <c:v>0.48345700000000003</c:v>
                </c:pt>
                <c:pt idx="1950" formatCode="General">
                  <c:v>0.48788500000000001</c:v>
                </c:pt>
                <c:pt idx="1951" formatCode="General">
                  <c:v>0.49235299999999999</c:v>
                </c:pt>
                <c:pt idx="1952" formatCode="General">
                  <c:v>0.496863</c:v>
                </c:pt>
                <c:pt idx="1953" formatCode="General">
                  <c:v>0.501413</c:v>
                </c:pt>
                <c:pt idx="1954" formatCode="General">
                  <c:v>0.50649100000000002</c:v>
                </c:pt>
                <c:pt idx="1955" formatCode="General">
                  <c:v>0.51161999999999996</c:v>
                </c:pt>
                <c:pt idx="1956" formatCode="General">
                  <c:v>0.51680099999999995</c:v>
                </c:pt>
                <c:pt idx="1957" formatCode="General">
                  <c:v>0.52096100000000001</c:v>
                </c:pt>
                <c:pt idx="1958" formatCode="General">
                  <c:v>0.52515400000000001</c:v>
                </c:pt>
                <c:pt idx="1959" formatCode="General">
                  <c:v>0.52937999999999996</c:v>
                </c:pt>
                <c:pt idx="1960" formatCode="General">
                  <c:v>0.53364</c:v>
                </c:pt>
                <c:pt idx="1961" formatCode="General">
                  <c:v>0.53793400000000002</c:v>
                </c:pt>
                <c:pt idx="1962" formatCode="General">
                  <c:v>0.54226200000000002</c:v>
                </c:pt>
                <c:pt idx="1963" formatCode="General">
                  <c:v>0.54662500000000003</c:v>
                </c:pt>
                <c:pt idx="1964" formatCode="General">
                  <c:v>0.55264100000000005</c:v>
                </c:pt>
                <c:pt idx="1965" formatCode="General">
                  <c:v>0.55872200000000005</c:v>
                </c:pt>
                <c:pt idx="1966" formatCode="General">
                  <c:v>0.56486999999999998</c:v>
                </c:pt>
                <c:pt idx="1967" formatCode="General">
                  <c:v>0.57108499999999995</c:v>
                </c:pt>
                <c:pt idx="1968" formatCode="General">
                  <c:v>0.58592100000000003</c:v>
                </c:pt>
                <c:pt idx="1969" formatCode="General">
                  <c:v>0.60113899999999998</c:v>
                </c:pt>
                <c:pt idx="1970" formatCode="General">
                  <c:v>0.61674700000000005</c:v>
                </c:pt>
                <c:pt idx="1971" formatCode="General">
                  <c:v>0.63275700000000001</c:v>
                </c:pt>
                <c:pt idx="1972" formatCode="General">
                  <c:v>0.64917800000000003</c:v>
                </c:pt>
                <c:pt idx="1973" formatCode="General">
                  <c:v>0.68343799999999999</c:v>
                </c:pt>
                <c:pt idx="1974" formatCode="General">
                  <c:v>0.71948400000000001</c:v>
                </c:pt>
                <c:pt idx="1975" formatCode="General">
                  <c:v>0.750309</c:v>
                </c:pt>
                <c:pt idx="1976" formatCode="General">
                  <c:v>0.78243499999999999</c:v>
                </c:pt>
                <c:pt idx="1977" formatCode="General">
                  <c:v>0.81591499999999995</c:v>
                </c:pt>
                <c:pt idx="1978" formatCode="General">
                  <c:v>0.850804</c:v>
                </c:pt>
                <c:pt idx="1979" formatCode="General">
                  <c:v>0.88715900000000003</c:v>
                </c:pt>
                <c:pt idx="1980" formatCode="General">
                  <c:v>0.92503599999999997</c:v>
                </c:pt>
                <c:pt idx="1981" formatCode="General">
                  <c:v>0.96449799999999997</c:v>
                </c:pt>
                <c:pt idx="1982" formatCode="General">
                  <c:v>1.0056099999999999</c:v>
                </c:pt>
                <c:pt idx="1983" formatCode="General">
                  <c:v>1.04843</c:v>
                </c:pt>
                <c:pt idx="1984" formatCode="General">
                  <c:v>1.0930200000000001</c:v>
                </c:pt>
                <c:pt idx="1985" formatCode="General">
                  <c:v>1.1394599999999999</c:v>
                </c:pt>
                <c:pt idx="1986" formatCode="General">
                  <c:v>1.1878200000000001</c:v>
                </c:pt>
                <c:pt idx="1987" formatCode="General">
                  <c:v>1.2381599999999999</c:v>
                </c:pt>
                <c:pt idx="1988" formatCode="General">
                  <c:v>1.29057</c:v>
                </c:pt>
                <c:pt idx="1989" formatCode="General">
                  <c:v>1.34511</c:v>
                </c:pt>
                <c:pt idx="1990" formatCode="General">
                  <c:v>1.4018600000000001</c:v>
                </c:pt>
                <c:pt idx="1991" formatCode="General">
                  <c:v>1.44913</c:v>
                </c:pt>
                <c:pt idx="1992" formatCode="General">
                  <c:v>1.48769</c:v>
                </c:pt>
                <c:pt idx="1993" formatCode="General">
                  <c:v>1.5272399999999999</c:v>
                </c:pt>
                <c:pt idx="1994" formatCode="General">
                  <c:v>1.53379</c:v>
                </c:pt>
                <c:pt idx="1995" formatCode="General">
                  <c:v>1.54037</c:v>
                </c:pt>
                <c:pt idx="1996" formatCode="General">
                  <c:v>1.54697</c:v>
                </c:pt>
                <c:pt idx="1997" formatCode="General">
                  <c:v>1.5536000000000001</c:v>
                </c:pt>
                <c:pt idx="1998" formatCode="General">
                  <c:v>1.56026</c:v>
                </c:pt>
                <c:pt idx="1999" formatCode="General">
                  <c:v>1.5734699999999999</c:v>
                </c:pt>
                <c:pt idx="2000" formatCode="General">
                  <c:v>1.5867800000000001</c:v>
                </c:pt>
                <c:pt idx="2001" formatCode="General">
                  <c:v>1.6002000000000001</c:v>
                </c:pt>
                <c:pt idx="2002" formatCode="General">
                  <c:v>1.61372</c:v>
                </c:pt>
                <c:pt idx="2003" formatCode="General">
                  <c:v>1.6418699999999999</c:v>
                </c:pt>
                <c:pt idx="2004" formatCode="General">
                  <c:v>1.67049</c:v>
                </c:pt>
                <c:pt idx="2005" formatCode="General">
                  <c:v>1.69957</c:v>
                </c:pt>
                <c:pt idx="2006" formatCode="General">
                  <c:v>1.7291300000000001</c:v>
                </c:pt>
                <c:pt idx="2007" formatCode="General">
                  <c:v>1.77078</c:v>
                </c:pt>
                <c:pt idx="2008" formatCode="General">
                  <c:v>1.8133600000000001</c:v>
                </c:pt>
                <c:pt idx="2009" formatCode="General">
                  <c:v>1.8568899999999999</c:v>
                </c:pt>
                <c:pt idx="2010" formatCode="General">
                  <c:v>1.9013899999999999</c:v>
                </c:pt>
                <c:pt idx="2011" formatCode="General">
                  <c:v>1.93492</c:v>
                </c:pt>
                <c:pt idx="2012" formatCode="General">
                  <c:v>1.96286</c:v>
                </c:pt>
                <c:pt idx="2013" formatCode="General">
                  <c:v>1.9911700000000001</c:v>
                </c:pt>
                <c:pt idx="2014" formatCode="General">
                  <c:v>2.0153799999999999</c:v>
                </c:pt>
                <c:pt idx="2015" formatCode="General">
                  <c:v>2.0194100000000001</c:v>
                </c:pt>
                <c:pt idx="2016" formatCode="General">
                  <c:v>2.02345</c:v>
                </c:pt>
                <c:pt idx="2017" formatCode="General">
                  <c:v>2.0274999999999999</c:v>
                </c:pt>
                <c:pt idx="2018" formatCode="General">
                  <c:v>2.0315599999999998</c:v>
                </c:pt>
                <c:pt idx="2019" formatCode="General">
                  <c:v>2.0381200000000002</c:v>
                </c:pt>
                <c:pt idx="2020" formatCode="General">
                  <c:v>2.0446900000000001</c:v>
                </c:pt>
                <c:pt idx="2021" formatCode="General">
                  <c:v>2.0512899999999998</c:v>
                </c:pt>
                <c:pt idx="2022" formatCode="General">
                  <c:v>2.0626000000000002</c:v>
                </c:pt>
                <c:pt idx="2023" formatCode="General">
                  <c:v>2.07396</c:v>
                </c:pt>
                <c:pt idx="2024" formatCode="General">
                  <c:v>2.0853799999999998</c:v>
                </c:pt>
                <c:pt idx="2025" formatCode="General">
                  <c:v>2.1039599999999998</c:v>
                </c:pt>
                <c:pt idx="2026" formatCode="General">
                  <c:v>2.12269</c:v>
                </c:pt>
                <c:pt idx="2027" formatCode="General">
                  <c:v>2.1415700000000002</c:v>
                </c:pt>
                <c:pt idx="2028" formatCode="General">
                  <c:v>2.1606000000000001</c:v>
                </c:pt>
                <c:pt idx="2029" formatCode="General">
                  <c:v>2.1923400000000002</c:v>
                </c:pt>
                <c:pt idx="2030" formatCode="General">
                  <c:v>2.22451</c:v>
                </c:pt>
                <c:pt idx="2031" formatCode="General">
                  <c:v>2.2570899999999998</c:v>
                </c:pt>
                <c:pt idx="2032" formatCode="General">
                  <c:v>2.2900900000000002</c:v>
                </c:pt>
                <c:pt idx="2033" formatCode="General">
                  <c:v>2.33887</c:v>
                </c:pt>
                <c:pt idx="2034" formatCode="General">
                  <c:v>2.38855</c:v>
                </c:pt>
                <c:pt idx="2035" formatCode="General">
                  <c:v>2.4391500000000002</c:v>
                </c:pt>
                <c:pt idx="2036" formatCode="General">
                  <c:v>2.4797799999999999</c:v>
                </c:pt>
                <c:pt idx="2037" formatCode="General">
                  <c:v>2.5129199999999998</c:v>
                </c:pt>
                <c:pt idx="2038" formatCode="General">
                  <c:v>2.54643</c:v>
                </c:pt>
                <c:pt idx="2039" formatCode="General">
                  <c:v>2.58033</c:v>
                </c:pt>
                <c:pt idx="2040" formatCode="General">
                  <c:v>2.6146099999999999</c:v>
                </c:pt>
                <c:pt idx="2041" formatCode="General">
                  <c:v>2.62127</c:v>
                </c:pt>
                <c:pt idx="2042" formatCode="General">
                  <c:v>2.6279499999999998</c:v>
                </c:pt>
                <c:pt idx="2043" formatCode="General">
                  <c:v>2.6346400000000001</c:v>
                </c:pt>
                <c:pt idx="2044" formatCode="General">
                  <c:v>2.6413500000000001</c:v>
                </c:pt>
                <c:pt idx="2045" formatCode="General">
                  <c:v>2.65265</c:v>
                </c:pt>
                <c:pt idx="2046" formatCode="General">
                  <c:v>2.6640000000000001</c:v>
                </c:pt>
                <c:pt idx="2047" formatCode="General">
                  <c:v>2.6753800000000001</c:v>
                </c:pt>
                <c:pt idx="2048" formatCode="General">
                  <c:v>2.6922100000000002</c:v>
                </c:pt>
                <c:pt idx="2049" formatCode="General">
                  <c:v>2.70912</c:v>
                </c:pt>
                <c:pt idx="2050" formatCode="General">
                  <c:v>2.7261199999999999</c:v>
                </c:pt>
                <c:pt idx="2051" formatCode="General">
                  <c:v>2.7431999999999999</c:v>
                </c:pt>
                <c:pt idx="2052" formatCode="General">
                  <c:v>2.7639999999999998</c:v>
                </c:pt>
                <c:pt idx="2053" formatCode="General">
                  <c:v>2.78491</c:v>
                </c:pt>
                <c:pt idx="2054" formatCode="General">
                  <c:v>2.8059599999999998</c:v>
                </c:pt>
                <c:pt idx="2055" formatCode="General">
                  <c:v>2.8271299999999999</c:v>
                </c:pt>
                <c:pt idx="2056" formatCode="General">
                  <c:v>2.8622299999999998</c:v>
                </c:pt>
                <c:pt idx="2057" formatCode="General">
                  <c:v>2.8976600000000001</c:v>
                </c:pt>
                <c:pt idx="2058" formatCode="General">
                  <c:v>2.93344</c:v>
                </c:pt>
                <c:pt idx="2059" formatCode="General">
                  <c:v>2.96956</c:v>
                </c:pt>
                <c:pt idx="2060" formatCode="General">
                  <c:v>3.02108</c:v>
                </c:pt>
                <c:pt idx="2061" formatCode="General">
                  <c:v>3.0732699999999999</c:v>
                </c:pt>
                <c:pt idx="2062" formatCode="General">
                  <c:v>3.1190199999999999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10B1-4C6E-B0F8-FEF33391192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901432"/>
        <c:axId val="382903392"/>
      </c:scatterChart>
      <c:valAx>
        <c:axId val="382901432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903392"/>
        <c:crosses val="autoZero"/>
        <c:crossBetween val="midCat"/>
      </c:valAx>
      <c:valAx>
        <c:axId val="382903392"/>
        <c:scaling>
          <c:orientation val="minMax"/>
          <c:max val="10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901432"/>
        <c:crosses val="autoZero"/>
        <c:crossBetween val="midCat"/>
        <c:majorUnit val="20"/>
      </c:valAx>
      <c:spPr>
        <a:noFill/>
        <a:ln w="63500">
          <a:solidFill>
            <a:schemeClr val="tx1">
              <a:lumMod val="50000"/>
              <a:lumOff val="50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en-US"/>
    </a:p>
  </c:txPr>
  <c:externalData r:id="rId3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84378341596189"/>
          <c:y val="2.6373335277534753E-2"/>
          <c:w val="0.84468868474773984"/>
          <c:h val="0.88264946048410609"/>
        </c:manualLayout>
      </c:layout>
      <c:scatterChart>
        <c:scatterStyle val="smoothMarker"/>
        <c:varyColors val="0"/>
        <c:ser>
          <c:idx val="0"/>
          <c:order val="0"/>
          <c:spPr>
            <a:ln w="63500" cap="rnd">
              <a:solidFill>
                <a:srgbClr val="FF0000"/>
              </a:solidFill>
              <a:round/>
            </a:ln>
            <a:effectLst/>
          </c:spPr>
          <c:marker>
            <c:symbol val="none"/>
          </c:marker>
          <c:xVal>
            <c:numRef>
              <c:f>Sheet1!$N$4:$N$338</c:f>
              <c:numCache>
                <c:formatCode>General</c:formatCode>
                <c:ptCount val="335"/>
                <c:pt idx="0">
                  <c:v>0</c:v>
                </c:pt>
                <c:pt idx="1">
                  <c:v>6.9444444444444454E-13</c:v>
                </c:pt>
                <c:pt idx="2">
                  <c:v>1.3888888888888891E-12</c:v>
                </c:pt>
                <c:pt idx="3">
                  <c:v>6.9458333333333335E-9</c:v>
                </c:pt>
                <c:pt idx="4">
                  <c:v>1.3890277777777778E-8</c:v>
                </c:pt>
                <c:pt idx="5">
                  <c:v>2.0834722222222222E-8</c:v>
                </c:pt>
                <c:pt idx="6">
                  <c:v>9.0279166666666655E-8</c:v>
                </c:pt>
                <c:pt idx="7">
                  <c:v>1.5972361111111111E-7</c:v>
                </c:pt>
                <c:pt idx="8">
                  <c:v>2.2916805555555553E-7</c:v>
                </c:pt>
                <c:pt idx="9">
                  <c:v>2.9861250000000001E-7</c:v>
                </c:pt>
                <c:pt idx="10">
                  <c:v>9.9305555555555567E-7</c:v>
                </c:pt>
                <c:pt idx="11">
                  <c:v>1.6874999999999999E-6</c:v>
                </c:pt>
                <c:pt idx="12">
                  <c:v>2.3819444444444444E-6</c:v>
                </c:pt>
                <c:pt idx="13">
                  <c:v>3.0763888888888889E-6</c:v>
                </c:pt>
                <c:pt idx="14">
                  <c:v>7.0700694444444441E-6</c:v>
                </c:pt>
                <c:pt idx="15">
                  <c:v>1.1063749999999999E-5</c:v>
                </c:pt>
                <c:pt idx="16">
                  <c:v>1.5057430555555555E-5</c:v>
                </c:pt>
                <c:pt idx="17">
                  <c:v>2.2873402777777777E-5</c:v>
                </c:pt>
                <c:pt idx="18">
                  <c:v>3.0689305555555552E-5</c:v>
                </c:pt>
                <c:pt idx="19">
                  <c:v>3.850520833333333E-5</c:v>
                </c:pt>
                <c:pt idx="20">
                  <c:v>5.0255208333333331E-5</c:v>
                </c:pt>
                <c:pt idx="21">
                  <c:v>6.2005138888888888E-5</c:v>
                </c:pt>
                <c:pt idx="22">
                  <c:v>7.3754861111111113E-5</c:v>
                </c:pt>
                <c:pt idx="23">
                  <c:v>8.3892361111111109E-5</c:v>
                </c:pt>
                <c:pt idx="24">
                  <c:v>9.4029166666666664E-5</c:v>
                </c:pt>
                <c:pt idx="25">
                  <c:v>1.0416597222222222E-4</c:v>
                </c:pt>
                <c:pt idx="26">
                  <c:v>1.0882847222222222E-4</c:v>
                </c:pt>
                <c:pt idx="27">
                  <c:v>1.1349027777777778E-4</c:v>
                </c:pt>
                <c:pt idx="28">
                  <c:v>1.1815208333333335E-4</c:v>
                </c:pt>
                <c:pt idx="29">
                  <c:v>1.2213680555555557E-4</c:v>
                </c:pt>
                <c:pt idx="30">
                  <c:v>1.2612152777777779E-4</c:v>
                </c:pt>
                <c:pt idx="31">
                  <c:v>1.3010624999999998E-4</c:v>
                </c:pt>
                <c:pt idx="32">
                  <c:v>1.3605347222222223E-4</c:v>
                </c:pt>
                <c:pt idx="33">
                  <c:v>1.4200138888888889E-4</c:v>
                </c:pt>
                <c:pt idx="34">
                  <c:v>1.4794930555555555E-4</c:v>
                </c:pt>
                <c:pt idx="35">
                  <c:v>1.870659722222222E-4</c:v>
                </c:pt>
                <c:pt idx="36">
                  <c:v>1.968451388888889E-4</c:v>
                </c:pt>
                <c:pt idx="37">
                  <c:v>2.0662430555555555E-4</c:v>
                </c:pt>
                <c:pt idx="38">
                  <c:v>2.164034722222222E-4</c:v>
                </c:pt>
                <c:pt idx="39">
                  <c:v>2.2618263888888891E-4</c:v>
                </c:pt>
                <c:pt idx="40">
                  <c:v>2.3017013888888889E-4</c:v>
                </c:pt>
                <c:pt idx="41">
                  <c:v>2.3415833333333334E-4</c:v>
                </c:pt>
                <c:pt idx="42">
                  <c:v>2.3814652777777776E-4</c:v>
                </c:pt>
                <c:pt idx="43">
                  <c:v>2.4213958333333335E-4</c:v>
                </c:pt>
                <c:pt idx="44">
                  <c:v>2.4613263888888888E-4</c:v>
                </c:pt>
                <c:pt idx="45">
                  <c:v>2.501263888888889E-4</c:v>
                </c:pt>
                <c:pt idx="46">
                  <c:v>2.5641666666666667E-4</c:v>
                </c:pt>
                <c:pt idx="47">
                  <c:v>2.6270694444444445E-4</c:v>
                </c:pt>
                <c:pt idx="48">
                  <c:v>2.6899722222222222E-4</c:v>
                </c:pt>
                <c:pt idx="49">
                  <c:v>3.1345E-4</c:v>
                </c:pt>
                <c:pt idx="50">
                  <c:v>3.2456319444444442E-4</c:v>
                </c:pt>
                <c:pt idx="51">
                  <c:v>3.4679027777777775E-4</c:v>
                </c:pt>
                <c:pt idx="52">
                  <c:v>3.6901666666666665E-4</c:v>
                </c:pt>
                <c:pt idx="53">
                  <c:v>3.9124305555555554E-4</c:v>
                </c:pt>
                <c:pt idx="54">
                  <c:v>4.1346944444444449E-4</c:v>
                </c:pt>
                <c:pt idx="55">
                  <c:v>4.7298958333333329E-4</c:v>
                </c:pt>
                <c:pt idx="56">
                  <c:v>5.3250972222222226E-4</c:v>
                </c:pt>
                <c:pt idx="57">
                  <c:v>5.9202986111111112E-4</c:v>
                </c:pt>
                <c:pt idx="58">
                  <c:v>6.5154930555555554E-4</c:v>
                </c:pt>
                <c:pt idx="59">
                  <c:v>7.3526388888888892E-4</c:v>
                </c:pt>
                <c:pt idx="60">
                  <c:v>8.1897916666666664E-4</c:v>
                </c:pt>
                <c:pt idx="61">
                  <c:v>9.0269444444444436E-4</c:v>
                </c:pt>
                <c:pt idx="62">
                  <c:v>9.8640972222222229E-4</c:v>
                </c:pt>
                <c:pt idx="63">
                  <c:v>1.1451180555555557E-3</c:v>
                </c:pt>
                <c:pt idx="64">
                  <c:v>1.3038333333333335E-3</c:v>
                </c:pt>
                <c:pt idx="65">
                  <c:v>1.4625416666666665E-3</c:v>
                </c:pt>
                <c:pt idx="66">
                  <c:v>1.6212569444444445E-3</c:v>
                </c:pt>
                <c:pt idx="67">
                  <c:v>1.7799652777777777E-3</c:v>
                </c:pt>
                <c:pt idx="68">
                  <c:v>1.9722986111111113E-3</c:v>
                </c:pt>
                <c:pt idx="69">
                  <c:v>2.1646249999999999E-3</c:v>
                </c:pt>
                <c:pt idx="70">
                  <c:v>2.3569513888888889E-3</c:v>
                </c:pt>
                <c:pt idx="71">
                  <c:v>2.5492847222222223E-3</c:v>
                </c:pt>
                <c:pt idx="72">
                  <c:v>2.7416111111111109E-3</c:v>
                </c:pt>
                <c:pt idx="73">
                  <c:v>3.0413819444444446E-3</c:v>
                </c:pt>
                <c:pt idx="74">
                  <c:v>3.3411527777777775E-3</c:v>
                </c:pt>
                <c:pt idx="75">
                  <c:v>3.6409166666666664E-3</c:v>
                </c:pt>
                <c:pt idx="76">
                  <c:v>3.9406874999999997E-3</c:v>
                </c:pt>
                <c:pt idx="77">
                  <c:v>4.2404583333333331E-3</c:v>
                </c:pt>
                <c:pt idx="78">
                  <c:v>4.5402291666666672E-3</c:v>
                </c:pt>
                <c:pt idx="79">
                  <c:v>4.8399930555555557E-3</c:v>
                </c:pt>
                <c:pt idx="80">
                  <c:v>4.8907986111111114E-3</c:v>
                </c:pt>
                <c:pt idx="81">
                  <c:v>4.9415972222222222E-3</c:v>
                </c:pt>
                <c:pt idx="82">
                  <c:v>4.9924027777777779E-3</c:v>
                </c:pt>
                <c:pt idx="83">
                  <c:v>5.0432083333333336E-3</c:v>
                </c:pt>
                <c:pt idx="84">
                  <c:v>5.0940069444444444E-3</c:v>
                </c:pt>
                <c:pt idx="85">
                  <c:v>5.1806805555555556E-3</c:v>
                </c:pt>
                <c:pt idx="86">
                  <c:v>5.2673472222222219E-3</c:v>
                </c:pt>
                <c:pt idx="87">
                  <c:v>5.354020833333333E-3</c:v>
                </c:pt>
                <c:pt idx="88">
                  <c:v>5.4406875000000002E-3</c:v>
                </c:pt>
                <c:pt idx="89">
                  <c:v>5.6186180555555555E-3</c:v>
                </c:pt>
                <c:pt idx="90">
                  <c:v>5.7965486111111108E-3</c:v>
                </c:pt>
                <c:pt idx="91">
                  <c:v>5.9744861111111118E-3</c:v>
                </c:pt>
                <c:pt idx="92">
                  <c:v>6.1524166666666663E-3</c:v>
                </c:pt>
                <c:pt idx="93">
                  <c:v>6.4319722222222226E-3</c:v>
                </c:pt>
                <c:pt idx="94">
                  <c:v>6.7115277777777781E-3</c:v>
                </c:pt>
                <c:pt idx="95">
                  <c:v>6.9911111111111111E-3</c:v>
                </c:pt>
                <c:pt idx="96">
                  <c:v>7.2706249999999993E-3</c:v>
                </c:pt>
                <c:pt idx="97">
                  <c:v>7.5502083333333324E-3</c:v>
                </c:pt>
                <c:pt idx="98">
                  <c:v>7.8772222222222212E-3</c:v>
                </c:pt>
                <c:pt idx="99">
                  <c:v>8.2042361111111118E-3</c:v>
                </c:pt>
                <c:pt idx="100">
                  <c:v>8.5311805555555557E-3</c:v>
                </c:pt>
                <c:pt idx="101">
                  <c:v>8.8581944444444446E-3</c:v>
                </c:pt>
                <c:pt idx="102">
                  <c:v>9.1852083333333334E-3</c:v>
                </c:pt>
                <c:pt idx="103">
                  <c:v>9.6388194444444446E-3</c:v>
                </c:pt>
                <c:pt idx="104">
                  <c:v>1.0092430555555556E-2</c:v>
                </c:pt>
                <c:pt idx="105">
                  <c:v>1.0546041666666665E-2</c:v>
                </c:pt>
                <c:pt idx="106">
                  <c:v>1.0999652777777777E-2</c:v>
                </c:pt>
                <c:pt idx="107">
                  <c:v>1.1453333333333333E-2</c:v>
                </c:pt>
                <c:pt idx="108">
                  <c:v>1.1906944444444446E-2</c:v>
                </c:pt>
                <c:pt idx="109">
                  <c:v>1.2585555555555556E-2</c:v>
                </c:pt>
                <c:pt idx="110">
                  <c:v>1.3264166666666667E-2</c:v>
                </c:pt>
                <c:pt idx="111">
                  <c:v>1.3942777777777778E-2</c:v>
                </c:pt>
                <c:pt idx="112">
                  <c:v>1.4621388888888889E-2</c:v>
                </c:pt>
                <c:pt idx="113">
                  <c:v>1.5300069444444444E-2</c:v>
                </c:pt>
                <c:pt idx="114">
                  <c:v>1.5978680555555555E-2</c:v>
                </c:pt>
                <c:pt idx="115">
                  <c:v>1.6657291666666667E-2</c:v>
                </c:pt>
                <c:pt idx="116">
                  <c:v>1.7335902777777776E-2</c:v>
                </c:pt>
                <c:pt idx="117">
                  <c:v>1.8014513888888889E-2</c:v>
                </c:pt>
                <c:pt idx="118">
                  <c:v>1.8693124999999998E-2</c:v>
                </c:pt>
                <c:pt idx="119">
                  <c:v>1.9371805555555555E-2</c:v>
                </c:pt>
                <c:pt idx="120">
                  <c:v>2.0050416666666664E-2</c:v>
                </c:pt>
                <c:pt idx="121">
                  <c:v>2.0882569444444447E-2</c:v>
                </c:pt>
                <c:pt idx="122">
                  <c:v>2.1714652777777781E-2</c:v>
                </c:pt>
                <c:pt idx="123">
                  <c:v>2.2546805555555553E-2</c:v>
                </c:pt>
                <c:pt idx="124">
                  <c:v>2.3378958333333335E-2</c:v>
                </c:pt>
                <c:pt idx="125">
                  <c:v>2.4048819444444442E-2</c:v>
                </c:pt>
                <c:pt idx="126">
                  <c:v>2.4718680555555556E-2</c:v>
                </c:pt>
                <c:pt idx="127">
                  <c:v>2.5388541666666667E-2</c:v>
                </c:pt>
                <c:pt idx="128">
                  <c:v>2.6058402777777774E-2</c:v>
                </c:pt>
                <c:pt idx="129">
                  <c:v>2.6728263888888888E-2</c:v>
                </c:pt>
                <c:pt idx="130">
                  <c:v>2.7398194444444447E-2</c:v>
                </c:pt>
                <c:pt idx="131">
                  <c:v>2.8068055555555554E-2</c:v>
                </c:pt>
                <c:pt idx="132">
                  <c:v>2.8737916666666665E-2</c:v>
                </c:pt>
                <c:pt idx="133">
                  <c:v>2.9407777777777779E-2</c:v>
                </c:pt>
                <c:pt idx="134">
                  <c:v>2.9959027777777775E-2</c:v>
                </c:pt>
                <c:pt idx="135">
                  <c:v>3.0510277777777779E-2</c:v>
                </c:pt>
                <c:pt idx="136">
                  <c:v>3.1061527777777778E-2</c:v>
                </c:pt>
                <c:pt idx="137">
                  <c:v>3.1612777777777774E-2</c:v>
                </c:pt>
                <c:pt idx="138">
                  <c:v>3.2164027777777777E-2</c:v>
                </c:pt>
                <c:pt idx="139">
                  <c:v>3.2715208333333336E-2</c:v>
                </c:pt>
                <c:pt idx="140">
                  <c:v>3.3266458333333332E-2</c:v>
                </c:pt>
                <c:pt idx="141">
                  <c:v>3.3817708333333335E-2</c:v>
                </c:pt>
                <c:pt idx="142">
                  <c:v>3.4368958333333338E-2</c:v>
                </c:pt>
                <c:pt idx="143">
                  <c:v>3.4920208333333334E-2</c:v>
                </c:pt>
                <c:pt idx="144">
                  <c:v>3.5471458333333331E-2</c:v>
                </c:pt>
                <c:pt idx="145">
                  <c:v>3.6022708333333334E-2</c:v>
                </c:pt>
                <c:pt idx="146">
                  <c:v>3.6772569444444445E-2</c:v>
                </c:pt>
                <c:pt idx="147">
                  <c:v>3.7522430555555555E-2</c:v>
                </c:pt>
                <c:pt idx="148">
                  <c:v>3.8272291666666666E-2</c:v>
                </c:pt>
                <c:pt idx="149">
                  <c:v>3.8850277777777782E-2</c:v>
                </c:pt>
                <c:pt idx="150">
                  <c:v>3.9428194444444446E-2</c:v>
                </c:pt>
                <c:pt idx="151">
                  <c:v>4.0006180555555555E-2</c:v>
                </c:pt>
                <c:pt idx="152">
                  <c:v>4.0584166666666671E-2</c:v>
                </c:pt>
                <c:pt idx="153">
                  <c:v>4.1047708333333335E-2</c:v>
                </c:pt>
                <c:pt idx="154">
                  <c:v>4.1511319444444444E-2</c:v>
                </c:pt>
                <c:pt idx="155">
                  <c:v>4.1974861111111116E-2</c:v>
                </c:pt>
                <c:pt idx="156">
                  <c:v>4.2438472222222225E-2</c:v>
                </c:pt>
                <c:pt idx="157">
                  <c:v>4.2902013888888889E-2</c:v>
                </c:pt>
                <c:pt idx="158">
                  <c:v>4.3365624999999998E-2</c:v>
                </c:pt>
                <c:pt idx="159">
                  <c:v>4.3829166666666662E-2</c:v>
                </c:pt>
                <c:pt idx="160">
                  <c:v>4.4292777777777778E-2</c:v>
                </c:pt>
                <c:pt idx="161">
                  <c:v>4.4756319444444442E-2</c:v>
                </c:pt>
                <c:pt idx="162">
                  <c:v>4.5219930555555551E-2</c:v>
                </c:pt>
                <c:pt idx="163">
                  <c:v>4.5683541666666667E-2</c:v>
                </c:pt>
                <c:pt idx="164">
                  <c:v>4.6147083333333339E-2</c:v>
                </c:pt>
                <c:pt idx="165">
                  <c:v>4.653006944444444E-2</c:v>
                </c:pt>
                <c:pt idx="166">
                  <c:v>4.691298611111111E-2</c:v>
                </c:pt>
                <c:pt idx="167">
                  <c:v>4.7295972222222225E-2</c:v>
                </c:pt>
                <c:pt idx="168">
                  <c:v>4.7678888888888889E-2</c:v>
                </c:pt>
                <c:pt idx="169">
                  <c:v>4.8061875000000004E-2</c:v>
                </c:pt>
                <c:pt idx="170">
                  <c:v>4.844479166666666E-2</c:v>
                </c:pt>
                <c:pt idx="171">
                  <c:v>4.8827777777777776E-2</c:v>
                </c:pt>
                <c:pt idx="172">
                  <c:v>4.9210694444444446E-2</c:v>
                </c:pt>
                <c:pt idx="173">
                  <c:v>4.9593680555555561E-2</c:v>
                </c:pt>
                <c:pt idx="174">
                  <c:v>4.9976597222222224E-2</c:v>
                </c:pt>
                <c:pt idx="175">
                  <c:v>5.0359583333333333E-2</c:v>
                </c:pt>
                <c:pt idx="176">
                  <c:v>5.0742499999999996E-2</c:v>
                </c:pt>
                <c:pt idx="177">
                  <c:v>5.1125486111111111E-2</c:v>
                </c:pt>
                <c:pt idx="178">
                  <c:v>5.1508402777777781E-2</c:v>
                </c:pt>
                <c:pt idx="179">
                  <c:v>5.189138888888889E-2</c:v>
                </c:pt>
                <c:pt idx="180">
                  <c:v>5.227430555555556E-2</c:v>
                </c:pt>
                <c:pt idx="181">
                  <c:v>5.2657291666666661E-2</c:v>
                </c:pt>
                <c:pt idx="182">
                  <c:v>5.3040277777777776E-2</c:v>
                </c:pt>
                <c:pt idx="183">
                  <c:v>5.3423194444444447E-2</c:v>
                </c:pt>
                <c:pt idx="184">
                  <c:v>5.3806180555555562E-2</c:v>
                </c:pt>
                <c:pt idx="185">
                  <c:v>5.4189097222222225E-2</c:v>
                </c:pt>
                <c:pt idx="186">
                  <c:v>5.4572083333333334E-2</c:v>
                </c:pt>
                <c:pt idx="187">
                  <c:v>5.4954999999999997E-2</c:v>
                </c:pt>
                <c:pt idx="188">
                  <c:v>5.5337986111111112E-2</c:v>
                </c:pt>
                <c:pt idx="189">
                  <c:v>5.5655972222222218E-2</c:v>
                </c:pt>
                <c:pt idx="190">
                  <c:v>5.5974027777777775E-2</c:v>
                </c:pt>
                <c:pt idx="191">
                  <c:v>5.6292083333333326E-2</c:v>
                </c:pt>
                <c:pt idx="192">
                  <c:v>5.6610069444444445E-2</c:v>
                </c:pt>
                <c:pt idx="193">
                  <c:v>5.6928125000000003E-2</c:v>
                </c:pt>
                <c:pt idx="194">
                  <c:v>5.7246180555555554E-2</c:v>
                </c:pt>
                <c:pt idx="195">
                  <c:v>5.7564166666666666E-2</c:v>
                </c:pt>
                <c:pt idx="196">
                  <c:v>5.7882222222222217E-2</c:v>
                </c:pt>
                <c:pt idx="197">
                  <c:v>5.8200277777777781E-2</c:v>
                </c:pt>
                <c:pt idx="198">
                  <c:v>5.8518263888888887E-2</c:v>
                </c:pt>
                <c:pt idx="199">
                  <c:v>5.8836319444444445E-2</c:v>
                </c:pt>
                <c:pt idx="200">
                  <c:v>5.9154374999999995E-2</c:v>
                </c:pt>
                <c:pt idx="201">
                  <c:v>5.9472361111111108E-2</c:v>
                </c:pt>
                <c:pt idx="202">
                  <c:v>5.9790416666666672E-2</c:v>
                </c:pt>
                <c:pt idx="203">
                  <c:v>6.0108472222222223E-2</c:v>
                </c:pt>
                <c:pt idx="204">
                  <c:v>6.0426458333333335E-2</c:v>
                </c:pt>
                <c:pt idx="205">
                  <c:v>6.0744513888888886E-2</c:v>
                </c:pt>
                <c:pt idx="206">
                  <c:v>6.1062569444444444E-2</c:v>
                </c:pt>
                <c:pt idx="207">
                  <c:v>6.1380555555555556E-2</c:v>
                </c:pt>
                <c:pt idx="208">
                  <c:v>6.1698611111111114E-2</c:v>
                </c:pt>
                <c:pt idx="209">
                  <c:v>6.2016666666666671E-2</c:v>
                </c:pt>
                <c:pt idx="210">
                  <c:v>6.2334652777777777E-2</c:v>
                </c:pt>
                <c:pt idx="211">
                  <c:v>6.2652708333333335E-2</c:v>
                </c:pt>
                <c:pt idx="212">
                  <c:v>6.2970694444444447E-2</c:v>
                </c:pt>
                <c:pt idx="213">
                  <c:v>6.3288750000000005E-2</c:v>
                </c:pt>
                <c:pt idx="214">
                  <c:v>6.3606805555555562E-2</c:v>
                </c:pt>
                <c:pt idx="215">
                  <c:v>6.3924791666666661E-2</c:v>
                </c:pt>
                <c:pt idx="216">
                  <c:v>6.4285694444444444E-2</c:v>
                </c:pt>
                <c:pt idx="217">
                  <c:v>6.4646597222222227E-2</c:v>
                </c:pt>
                <c:pt idx="218">
                  <c:v>6.5007499999999996E-2</c:v>
                </c:pt>
                <c:pt idx="219">
                  <c:v>6.5368402777777779E-2</c:v>
                </c:pt>
                <c:pt idx="220">
                  <c:v>6.5729236111111103E-2</c:v>
                </c:pt>
                <c:pt idx="221">
                  <c:v>6.6090138888888886E-2</c:v>
                </c:pt>
                <c:pt idx="222">
                  <c:v>6.6491458333333336E-2</c:v>
                </c:pt>
                <c:pt idx="223">
                  <c:v>6.6892777777777773E-2</c:v>
                </c:pt>
                <c:pt idx="224">
                  <c:v>6.7294027777777779E-2</c:v>
                </c:pt>
                <c:pt idx="225">
                  <c:v>6.769534722222223E-2</c:v>
                </c:pt>
                <c:pt idx="226">
                  <c:v>6.8096666666666666E-2</c:v>
                </c:pt>
                <c:pt idx="227">
                  <c:v>6.8497986111111117E-2</c:v>
                </c:pt>
                <c:pt idx="228">
                  <c:v>6.8953750000000008E-2</c:v>
                </c:pt>
                <c:pt idx="229">
                  <c:v>6.9409513888888899E-2</c:v>
                </c:pt>
                <c:pt idx="230">
                  <c:v>6.9865277777777776E-2</c:v>
                </c:pt>
                <c:pt idx="231">
                  <c:v>7.0320833333333332E-2</c:v>
                </c:pt>
                <c:pt idx="232">
                  <c:v>7.0777083333333338E-2</c:v>
                </c:pt>
                <c:pt idx="233">
                  <c:v>7.1232638888888894E-2</c:v>
                </c:pt>
                <c:pt idx="234">
                  <c:v>7.1763194444444442E-2</c:v>
                </c:pt>
                <c:pt idx="235">
                  <c:v>7.229374999999999E-2</c:v>
                </c:pt>
                <c:pt idx="236">
                  <c:v>7.2824305555555552E-2</c:v>
                </c:pt>
                <c:pt idx="237">
                  <c:v>7.3354166666666665E-2</c:v>
                </c:pt>
                <c:pt idx="238">
                  <c:v>7.3884722222222227E-2</c:v>
                </c:pt>
                <c:pt idx="239">
                  <c:v>7.4415277777777775E-2</c:v>
                </c:pt>
                <c:pt idx="240">
                  <c:v>7.5065277777777772E-2</c:v>
                </c:pt>
                <c:pt idx="241">
                  <c:v>7.5714583333333335E-2</c:v>
                </c:pt>
                <c:pt idx="242">
                  <c:v>7.6364583333333333E-2</c:v>
                </c:pt>
                <c:pt idx="243">
                  <c:v>7.7013888888888896E-2</c:v>
                </c:pt>
                <c:pt idx="244">
                  <c:v>7.7663194444444444E-2</c:v>
                </c:pt>
                <c:pt idx="245">
                  <c:v>7.8313194444444442E-2</c:v>
                </c:pt>
                <c:pt idx="246">
                  <c:v>7.9138194444444449E-2</c:v>
                </c:pt>
                <c:pt idx="247">
                  <c:v>7.9963194444444455E-2</c:v>
                </c:pt>
                <c:pt idx="248">
                  <c:v>8.0788194444444433E-2</c:v>
                </c:pt>
                <c:pt idx="249">
                  <c:v>8.161319444444444E-2</c:v>
                </c:pt>
                <c:pt idx="250">
                  <c:v>8.2438194444444446E-2</c:v>
                </c:pt>
                <c:pt idx="251">
                  <c:v>8.3263888888888887E-2</c:v>
                </c:pt>
                <c:pt idx="252">
                  <c:v>8.4375000000000006E-2</c:v>
                </c:pt>
                <c:pt idx="253">
                  <c:v>8.548611111111111E-2</c:v>
                </c:pt>
                <c:pt idx="254">
                  <c:v>8.6597222222222228E-2</c:v>
                </c:pt>
                <c:pt idx="255">
                  <c:v>8.7708333333333333E-2</c:v>
                </c:pt>
                <c:pt idx="256">
                  <c:v>8.8820138888888886E-2</c:v>
                </c:pt>
                <c:pt idx="257">
                  <c:v>8.9931250000000004E-2</c:v>
                </c:pt>
                <c:pt idx="258">
                  <c:v>9.1763194444444446E-2</c:v>
                </c:pt>
                <c:pt idx="259">
                  <c:v>9.3595138888888874E-2</c:v>
                </c:pt>
                <c:pt idx="260">
                  <c:v>9.5427083333333329E-2</c:v>
                </c:pt>
                <c:pt idx="261">
                  <c:v>9.7258333333333322E-2</c:v>
                </c:pt>
                <c:pt idx="262">
                  <c:v>9.9090277777777777E-2</c:v>
                </c:pt>
                <c:pt idx="263">
                  <c:v>0.10092222222222222</c:v>
                </c:pt>
                <c:pt idx="264">
                  <c:v>0.10395416666666665</c:v>
                </c:pt>
                <c:pt idx="265">
                  <c:v>0.10698611111111112</c:v>
                </c:pt>
                <c:pt idx="266">
                  <c:v>0.11001805555555555</c:v>
                </c:pt>
                <c:pt idx="267">
                  <c:v>0.11305</c:v>
                </c:pt>
                <c:pt idx="268">
                  <c:v>0.11608194444444443</c:v>
                </c:pt>
                <c:pt idx="269">
                  <c:v>0.11911388888888889</c:v>
                </c:pt>
                <c:pt idx="270">
                  <c:v>0.1250361111111111</c:v>
                </c:pt>
                <c:pt idx="271">
                  <c:v>0.13095763888888889</c:v>
                </c:pt>
                <c:pt idx="272">
                  <c:v>0.13687986111111111</c:v>
                </c:pt>
                <c:pt idx="273">
                  <c:v>0.14280138888888888</c:v>
                </c:pt>
                <c:pt idx="274">
                  <c:v>0.14872361111111113</c:v>
                </c:pt>
                <c:pt idx="275">
                  <c:v>0.15584166666666668</c:v>
                </c:pt>
                <c:pt idx="276">
                  <c:v>0.16295902777777777</c:v>
                </c:pt>
                <c:pt idx="277">
                  <c:v>0.17007708333333332</c:v>
                </c:pt>
                <c:pt idx="278">
                  <c:v>0.17719444444444443</c:v>
                </c:pt>
                <c:pt idx="279">
                  <c:v>0.18431250000000002</c:v>
                </c:pt>
                <c:pt idx="280">
                  <c:v>0.19352430555555555</c:v>
                </c:pt>
                <c:pt idx="281">
                  <c:v>0.20273611111111112</c:v>
                </c:pt>
                <c:pt idx="282">
                  <c:v>0.21194791666666665</c:v>
                </c:pt>
                <c:pt idx="283">
                  <c:v>0.22115972222222224</c:v>
                </c:pt>
                <c:pt idx="284">
                  <c:v>0.23037152777777778</c:v>
                </c:pt>
                <c:pt idx="285">
                  <c:v>0.23958333333333334</c:v>
                </c:pt>
                <c:pt idx="286">
                  <c:v>0.25306458333333332</c:v>
                </c:pt>
                <c:pt idx="287">
                  <c:v>0.26654652777777776</c:v>
                </c:pt>
                <c:pt idx="288">
                  <c:v>0.28002777777777776</c:v>
                </c:pt>
                <c:pt idx="289">
                  <c:v>0.29350902777777776</c:v>
                </c:pt>
                <c:pt idx="290">
                  <c:v>0.30699097222222221</c:v>
                </c:pt>
                <c:pt idx="291">
                  <c:v>0.32047222222222221</c:v>
                </c:pt>
                <c:pt idx="292">
                  <c:v>0.33697013888888888</c:v>
                </c:pt>
                <c:pt idx="293">
                  <c:v>0.35346805555555555</c:v>
                </c:pt>
                <c:pt idx="294">
                  <c:v>0.36996597222222222</c:v>
                </c:pt>
                <c:pt idx="295">
                  <c:v>0.38646388888888894</c:v>
                </c:pt>
                <c:pt idx="296">
                  <c:v>0.40296180555555555</c:v>
                </c:pt>
                <c:pt idx="297">
                  <c:v>0.41945972222222228</c:v>
                </c:pt>
                <c:pt idx="298">
                  <c:v>0.43904166666666666</c:v>
                </c:pt>
                <c:pt idx="299">
                  <c:v>0.45862361111111111</c:v>
                </c:pt>
                <c:pt idx="300">
                  <c:v>0.47820555555555555</c:v>
                </c:pt>
                <c:pt idx="301">
                  <c:v>0.4977881944444445</c:v>
                </c:pt>
                <c:pt idx="302">
                  <c:v>0.51737013888888894</c:v>
                </c:pt>
                <c:pt idx="303">
                  <c:v>0.53695208333333333</c:v>
                </c:pt>
                <c:pt idx="304">
                  <c:v>0.56180972222222225</c:v>
                </c:pt>
                <c:pt idx="305">
                  <c:v>0.58666736111111117</c:v>
                </c:pt>
                <c:pt idx="306">
                  <c:v>0.61152430555555559</c:v>
                </c:pt>
                <c:pt idx="307">
                  <c:v>0.6363819444444444</c:v>
                </c:pt>
                <c:pt idx="308">
                  <c:v>0.66123958333333333</c:v>
                </c:pt>
                <c:pt idx="309">
                  <c:v>0.68609722222222225</c:v>
                </c:pt>
                <c:pt idx="310">
                  <c:v>0.71095138888888887</c:v>
                </c:pt>
                <c:pt idx="311">
                  <c:v>0.73581249999999998</c:v>
                </c:pt>
                <c:pt idx="312">
                  <c:v>0.7606666666666666</c:v>
                </c:pt>
                <c:pt idx="313">
                  <c:v>0.78552777777777782</c:v>
                </c:pt>
                <c:pt idx="314">
                  <c:v>0.81038194444444445</c:v>
                </c:pt>
                <c:pt idx="315">
                  <c:v>0.83524305555555556</c:v>
                </c:pt>
                <c:pt idx="316">
                  <c:v>0.87349305555555545</c:v>
                </c:pt>
                <c:pt idx="317">
                  <c:v>0.91175000000000006</c:v>
                </c:pt>
                <c:pt idx="318">
                  <c:v>0.95</c:v>
                </c:pt>
                <c:pt idx="319">
                  <c:v>0.98825694444444434</c:v>
                </c:pt>
                <c:pt idx="320">
                  <c:v>1.0265069444444446</c:v>
                </c:pt>
                <c:pt idx="321">
                  <c:v>1.0647569444444445</c:v>
                </c:pt>
                <c:pt idx="322">
                  <c:v>1.1258402777777778</c:v>
                </c:pt>
                <c:pt idx="323">
                  <c:v>1.1869236111111112</c:v>
                </c:pt>
                <c:pt idx="324">
                  <c:v>1.248013888888889</c:v>
                </c:pt>
                <c:pt idx="325">
                  <c:v>1.3090972222222221</c:v>
                </c:pt>
                <c:pt idx="326">
                  <c:v>1.3701805555555555</c:v>
                </c:pt>
                <c:pt idx="327">
                  <c:v>1.5930416666666667</c:v>
                </c:pt>
                <c:pt idx="328">
                  <c:v>1.8159027777777779</c:v>
                </c:pt>
                <c:pt idx="329">
                  <c:v>2.038763888888889</c:v>
                </c:pt>
                <c:pt idx="330">
                  <c:v>2.2616319444444444</c:v>
                </c:pt>
                <c:pt idx="331">
                  <c:v>2.833951388888889</c:v>
                </c:pt>
                <c:pt idx="332">
                  <c:v>3.406277777777778</c:v>
                </c:pt>
                <c:pt idx="333">
                  <c:v>3.9785972222222226</c:v>
                </c:pt>
                <c:pt idx="334">
                  <c:v>5</c:v>
                </c:pt>
              </c:numCache>
            </c:numRef>
          </c:xVal>
          <c:yVal>
            <c:numRef>
              <c:f>Sheet1!$O$4:$O$338</c:f>
              <c:numCache>
                <c:formatCode>0.00E+00</c:formatCode>
                <c:ptCount val="335"/>
                <c:pt idx="0">
                  <c:v>9.9999999999999995E-7</c:v>
                </c:pt>
                <c:pt idx="1">
                  <c:v>9.9999999999999995E-7</c:v>
                </c:pt>
                <c:pt idx="2">
                  <c:v>9.9999999999999995E-7</c:v>
                </c:pt>
                <c:pt idx="3">
                  <c:v>9.9999999999999995E-7</c:v>
                </c:pt>
                <c:pt idx="4">
                  <c:v>9.9999999999999995E-7</c:v>
                </c:pt>
                <c:pt idx="5">
                  <c:v>9.9999999999999995E-7</c:v>
                </c:pt>
                <c:pt idx="6">
                  <c:v>9.9999999999999995E-7</c:v>
                </c:pt>
                <c:pt idx="7">
                  <c:v>9.9999999999999995E-7</c:v>
                </c:pt>
                <c:pt idx="8">
                  <c:v>9.9999999999999995E-7</c:v>
                </c:pt>
                <c:pt idx="9">
                  <c:v>9.9999999999999995E-7</c:v>
                </c:pt>
                <c:pt idx="10">
                  <c:v>1.00001E-6</c:v>
                </c:pt>
                <c:pt idx="11">
                  <c:v>1.00001E-6</c:v>
                </c:pt>
                <c:pt idx="12">
                  <c:v>1.0000200000000001E-6</c:v>
                </c:pt>
                <c:pt idx="13">
                  <c:v>1.0000200000000001E-6</c:v>
                </c:pt>
                <c:pt idx="14">
                  <c:v>1.0000500000000001E-6</c:v>
                </c:pt>
                <c:pt idx="15">
                  <c:v>1.00008E-6</c:v>
                </c:pt>
                <c:pt idx="16">
                  <c:v>1.00011E-6</c:v>
                </c:pt>
                <c:pt idx="17">
                  <c:v>1.0001599999999999E-6</c:v>
                </c:pt>
                <c:pt idx="18">
                  <c:v>1.0002200000000001E-6</c:v>
                </c:pt>
                <c:pt idx="19">
                  <c:v>1.00027E-6</c:v>
                </c:pt>
                <c:pt idx="20">
                  <c:v>1.0003500000000001E-6</c:v>
                </c:pt>
                <c:pt idx="21">
                  <c:v>1.00043E-6</c:v>
                </c:pt>
                <c:pt idx="22">
                  <c:v>1.0005E-6</c:v>
                </c:pt>
                <c:pt idx="23">
                  <c:v>1.00057E-6</c:v>
                </c:pt>
                <c:pt idx="24">
                  <c:v>1.00063E-6</c:v>
                </c:pt>
                <c:pt idx="25">
                  <c:v>1.0006899999999999E-6</c:v>
                </c:pt>
                <c:pt idx="26">
                  <c:v>1.0007199999999999E-6</c:v>
                </c:pt>
                <c:pt idx="27">
                  <c:v>1.0007499999999999E-6</c:v>
                </c:pt>
                <c:pt idx="28">
                  <c:v>1.0007800000000001E-6</c:v>
                </c:pt>
                <c:pt idx="29">
                  <c:v>1.0008E-6</c:v>
                </c:pt>
                <c:pt idx="30">
                  <c:v>1.00083E-6</c:v>
                </c:pt>
                <c:pt idx="31">
                  <c:v>1.0008499999999999E-6</c:v>
                </c:pt>
                <c:pt idx="32">
                  <c:v>1.00089E-6</c:v>
                </c:pt>
                <c:pt idx="33">
                  <c:v>1.0009199999999999E-6</c:v>
                </c:pt>
                <c:pt idx="34">
                  <c:v>1.0009499999999999E-6</c:v>
                </c:pt>
                <c:pt idx="35">
                  <c:v>1.0011700000000001E-6</c:v>
                </c:pt>
                <c:pt idx="36">
                  <c:v>1.00122E-6</c:v>
                </c:pt>
                <c:pt idx="37">
                  <c:v>1.0012700000000001E-6</c:v>
                </c:pt>
                <c:pt idx="38">
                  <c:v>1.00132E-6</c:v>
                </c:pt>
                <c:pt idx="39">
                  <c:v>1.0013700000000001E-6</c:v>
                </c:pt>
                <c:pt idx="40">
                  <c:v>1.00139E-6</c:v>
                </c:pt>
                <c:pt idx="41">
                  <c:v>1.0014099999999999E-6</c:v>
                </c:pt>
                <c:pt idx="42">
                  <c:v>1.00142E-6</c:v>
                </c:pt>
                <c:pt idx="43">
                  <c:v>1.0014400000000001E-6</c:v>
                </c:pt>
                <c:pt idx="44">
                  <c:v>1.00146E-6</c:v>
                </c:pt>
                <c:pt idx="45">
                  <c:v>1.0014799999999999E-6</c:v>
                </c:pt>
                <c:pt idx="46">
                  <c:v>1.0015099999999999E-6</c:v>
                </c:pt>
                <c:pt idx="47">
                  <c:v>1.0015399999999999E-6</c:v>
                </c:pt>
                <c:pt idx="48">
                  <c:v>1.0015700000000001E-6</c:v>
                </c:pt>
                <c:pt idx="49">
                  <c:v>1.00175E-6</c:v>
                </c:pt>
                <c:pt idx="50">
                  <c:v>1.0018000000000001E-6</c:v>
                </c:pt>
                <c:pt idx="51">
                  <c:v>1.00188E-6</c:v>
                </c:pt>
                <c:pt idx="52">
                  <c:v>1.0019600000000001E-6</c:v>
                </c:pt>
                <c:pt idx="53">
                  <c:v>1.0020300000000001E-6</c:v>
                </c:pt>
                <c:pt idx="54">
                  <c:v>1.0020999999999999E-6</c:v>
                </c:pt>
                <c:pt idx="55">
                  <c:v>1.0022600000000001E-6</c:v>
                </c:pt>
                <c:pt idx="56">
                  <c:v>1.0023900000000001E-6</c:v>
                </c:pt>
                <c:pt idx="57">
                  <c:v>1.0024699999999999E-6</c:v>
                </c:pt>
                <c:pt idx="58">
                  <c:v>1.0025200000000001E-6</c:v>
                </c:pt>
                <c:pt idx="59">
                  <c:v>1.0025299999999999E-6</c:v>
                </c:pt>
                <c:pt idx="60">
                  <c:v>1.0024699999999999E-6</c:v>
                </c:pt>
                <c:pt idx="61">
                  <c:v>1.00234E-6</c:v>
                </c:pt>
                <c:pt idx="62">
                  <c:v>1.0021300000000001E-6</c:v>
                </c:pt>
                <c:pt idx="63">
                  <c:v>1.00155E-6</c:v>
                </c:pt>
                <c:pt idx="64">
                  <c:v>1.0007199999999999E-6</c:v>
                </c:pt>
                <c:pt idx="65">
                  <c:v>9.9962800000000006E-7</c:v>
                </c:pt>
                <c:pt idx="66">
                  <c:v>9.9828799999999992E-7</c:v>
                </c:pt>
                <c:pt idx="67">
                  <c:v>9.9669800000000008E-7</c:v>
                </c:pt>
                <c:pt idx="68">
                  <c:v>9.9443899999999998E-7</c:v>
                </c:pt>
                <c:pt idx="69">
                  <c:v>9.9181800000000005E-7</c:v>
                </c:pt>
                <c:pt idx="70">
                  <c:v>9.8884000000000001E-7</c:v>
                </c:pt>
                <c:pt idx="71">
                  <c:v>9.8550999999999999E-7</c:v>
                </c:pt>
                <c:pt idx="72">
                  <c:v>9.8183100000000008E-7</c:v>
                </c:pt>
                <c:pt idx="73">
                  <c:v>9.75415E-7</c:v>
                </c:pt>
                <c:pt idx="74">
                  <c:v>9.6818599999999993E-7</c:v>
                </c:pt>
                <c:pt idx="75">
                  <c:v>9.6016500000000002E-7</c:v>
                </c:pt>
                <c:pt idx="76">
                  <c:v>9.5137899999999996E-7</c:v>
                </c:pt>
                <c:pt idx="77">
                  <c:v>9.4185099999999995E-7</c:v>
                </c:pt>
                <c:pt idx="78">
                  <c:v>9.3160999999999996E-7</c:v>
                </c:pt>
                <c:pt idx="79">
                  <c:v>9.2068400000000001E-7</c:v>
                </c:pt>
                <c:pt idx="80">
                  <c:v>9.1876700000000004E-7</c:v>
                </c:pt>
                <c:pt idx="81">
                  <c:v>9.1683099999999996E-7</c:v>
                </c:pt>
                <c:pt idx="82">
                  <c:v>9.1487599999999999E-7</c:v>
                </c:pt>
                <c:pt idx="83">
                  <c:v>9.1290399999999998E-7</c:v>
                </c:pt>
                <c:pt idx="84">
                  <c:v>9.1091299999999997E-7</c:v>
                </c:pt>
                <c:pt idx="85">
                  <c:v>9.0747500000000004E-7</c:v>
                </c:pt>
                <c:pt idx="86">
                  <c:v>9.0398499999999995E-7</c:v>
                </c:pt>
                <c:pt idx="87">
                  <c:v>9.0044400000000004E-7</c:v>
                </c:pt>
                <c:pt idx="88">
                  <c:v>8.9685300000000002E-7</c:v>
                </c:pt>
                <c:pt idx="89">
                  <c:v>8.8932700000000001E-7</c:v>
                </c:pt>
                <c:pt idx="90">
                  <c:v>8.8159999999999995E-7</c:v>
                </c:pt>
                <c:pt idx="91">
                  <c:v>8.7367900000000005E-7</c:v>
                </c:pt>
                <c:pt idx="92">
                  <c:v>8.6557099999999996E-7</c:v>
                </c:pt>
                <c:pt idx="93">
                  <c:v>8.5247100000000004E-7</c:v>
                </c:pt>
                <c:pt idx="94">
                  <c:v>8.3895599999999999E-7</c:v>
                </c:pt>
                <c:pt idx="95">
                  <c:v>8.2505400000000005E-7</c:v>
                </c:pt>
                <c:pt idx="96">
                  <c:v>8.10795E-7</c:v>
                </c:pt>
                <c:pt idx="97">
                  <c:v>7.9620599999999995E-7</c:v>
                </c:pt>
                <c:pt idx="98">
                  <c:v>7.7876199999999997E-7</c:v>
                </c:pt>
                <c:pt idx="99">
                  <c:v>7.6095500000000003E-7</c:v>
                </c:pt>
                <c:pt idx="100">
                  <c:v>7.4282999999999999E-7</c:v>
                </c:pt>
                <c:pt idx="101">
                  <c:v>7.2443299999999996E-7</c:v>
                </c:pt>
                <c:pt idx="102">
                  <c:v>7.0581000000000004E-7</c:v>
                </c:pt>
                <c:pt idx="103">
                  <c:v>6.7968299999999999E-7</c:v>
                </c:pt>
                <c:pt idx="104">
                  <c:v>6.53321E-7</c:v>
                </c:pt>
                <c:pt idx="105">
                  <c:v>6.2683600000000002E-7</c:v>
                </c:pt>
                <c:pt idx="106">
                  <c:v>6.0033399999999998E-7</c:v>
                </c:pt>
                <c:pt idx="107">
                  <c:v>5.7391699999999996E-7</c:v>
                </c:pt>
                <c:pt idx="108">
                  <c:v>5.4768000000000004E-7</c:v>
                </c:pt>
                <c:pt idx="109">
                  <c:v>5.0895999999999997E-7</c:v>
                </c:pt>
                <c:pt idx="110">
                  <c:v>4.7111599999999999E-7</c:v>
                </c:pt>
                <c:pt idx="111">
                  <c:v>4.3438600000000001E-7</c:v>
                </c:pt>
                <c:pt idx="112">
                  <c:v>3.9897399999999998E-7</c:v>
                </c:pt>
                <c:pt idx="113">
                  <c:v>3.65048E-7</c:v>
                </c:pt>
                <c:pt idx="114">
                  <c:v>3.32742E-7</c:v>
                </c:pt>
                <c:pt idx="115">
                  <c:v>3.02158E-7</c:v>
                </c:pt>
                <c:pt idx="116">
                  <c:v>2.7336699999999999E-7</c:v>
                </c:pt>
                <c:pt idx="117">
                  <c:v>2.4640999999999999E-7</c:v>
                </c:pt>
                <c:pt idx="118">
                  <c:v>2.2130300000000001E-7</c:v>
                </c:pt>
                <c:pt idx="119">
                  <c:v>1.9803699999999999E-7</c:v>
                </c:pt>
                <c:pt idx="120">
                  <c:v>1.7658399999999999E-7</c:v>
                </c:pt>
                <c:pt idx="121">
                  <c:v>1.5268499999999999E-7</c:v>
                </c:pt>
                <c:pt idx="122">
                  <c:v>1.31327E-7</c:v>
                </c:pt>
                <c:pt idx="123">
                  <c:v>1.1237099999999999E-7</c:v>
                </c:pt>
                <c:pt idx="124">
                  <c:v>9.5658699999999994E-8</c:v>
                </c:pt>
                <c:pt idx="125">
                  <c:v>8.3719699999999995E-8</c:v>
                </c:pt>
                <c:pt idx="126">
                  <c:v>7.3032500000000002E-8</c:v>
                </c:pt>
                <c:pt idx="127">
                  <c:v>6.35043E-8</c:v>
                </c:pt>
                <c:pt idx="128">
                  <c:v>5.5042999999999999E-8</c:v>
                </c:pt>
                <c:pt idx="129">
                  <c:v>4.7558299999999998E-8</c:v>
                </c:pt>
                <c:pt idx="130">
                  <c:v>4.0962799999999997E-8</c:v>
                </c:pt>
                <c:pt idx="131">
                  <c:v>3.5172599999999998E-8</c:v>
                </c:pt>
                <c:pt idx="132">
                  <c:v>3.0108199999999998E-8</c:v>
                </c:pt>
                <c:pt idx="133">
                  <c:v>2.5694600000000001E-8</c:v>
                </c:pt>
                <c:pt idx="134">
                  <c:v>2.2501199999999998E-8</c:v>
                </c:pt>
                <c:pt idx="135">
                  <c:v>1.9664899999999999E-8</c:v>
                </c:pt>
                <c:pt idx="136">
                  <c:v>1.7151599999999999E-8</c:v>
                </c:pt>
                <c:pt idx="137">
                  <c:v>1.49296E-8</c:v>
                </c:pt>
                <c:pt idx="138">
                  <c:v>1.2969899999999999E-8</c:v>
                </c:pt>
                <c:pt idx="139">
                  <c:v>1.12453E-8</c:v>
                </c:pt>
                <c:pt idx="140">
                  <c:v>9.7310199999999993E-9</c:v>
                </c:pt>
                <c:pt idx="141">
                  <c:v>8.4044200000000002E-9</c:v>
                </c:pt>
                <c:pt idx="142">
                  <c:v>7.24477E-9</c:v>
                </c:pt>
                <c:pt idx="143">
                  <c:v>6.2332700000000003E-9</c:v>
                </c:pt>
                <c:pt idx="144">
                  <c:v>5.3528799999999998E-9</c:v>
                </c:pt>
                <c:pt idx="145">
                  <c:v>4.5882399999999999E-9</c:v>
                </c:pt>
                <c:pt idx="146">
                  <c:v>3.7093200000000002E-9</c:v>
                </c:pt>
                <c:pt idx="147">
                  <c:v>2.9885899999999999E-9</c:v>
                </c:pt>
                <c:pt idx="148">
                  <c:v>2.3998200000000001E-9</c:v>
                </c:pt>
                <c:pt idx="149">
                  <c:v>2.0218299999999998E-9</c:v>
                </c:pt>
                <c:pt idx="150">
                  <c:v>1.7000499999999999E-9</c:v>
                </c:pt>
                <c:pt idx="151">
                  <c:v>1.4267E-9</c:v>
                </c:pt>
                <c:pt idx="152">
                  <c:v>1.1949999999999999E-9</c:v>
                </c:pt>
                <c:pt idx="153">
                  <c:v>1.0352299999999999E-9</c:v>
                </c:pt>
                <c:pt idx="154">
                  <c:v>8.95722E-10</c:v>
                </c:pt>
                <c:pt idx="155">
                  <c:v>7.7407500000000004E-10</c:v>
                </c:pt>
                <c:pt idx="156">
                  <c:v>6.6814399999999996E-10</c:v>
                </c:pt>
                <c:pt idx="157">
                  <c:v>5.7601900000000004E-10</c:v>
                </c:pt>
                <c:pt idx="158">
                  <c:v>4.9600599999999999E-10</c:v>
                </c:pt>
                <c:pt idx="159">
                  <c:v>4.2660299999999998E-10</c:v>
                </c:pt>
                <c:pt idx="160">
                  <c:v>3.6648100000000002E-10</c:v>
                </c:pt>
                <c:pt idx="161">
                  <c:v>3.1446500000000001E-10</c:v>
                </c:pt>
                <c:pt idx="162">
                  <c:v>2.6952000000000002E-10</c:v>
                </c:pt>
                <c:pt idx="163">
                  <c:v>2.3073299999999999E-10</c:v>
                </c:pt>
                <c:pt idx="164">
                  <c:v>1.97302E-10</c:v>
                </c:pt>
                <c:pt idx="165">
                  <c:v>1.73223E-10</c:v>
                </c:pt>
                <c:pt idx="166">
                  <c:v>1.51965E-10</c:v>
                </c:pt>
                <c:pt idx="167">
                  <c:v>1.3321400000000001E-10</c:v>
                </c:pt>
                <c:pt idx="168">
                  <c:v>1.16688E-10</c:v>
                </c:pt>
                <c:pt idx="169">
                  <c:v>1.02134E-10</c:v>
                </c:pt>
                <c:pt idx="170">
                  <c:v>8.9328300000000004E-11</c:v>
                </c:pt>
                <c:pt idx="171">
                  <c:v>7.8069700000000003E-11</c:v>
                </c:pt>
                <c:pt idx="172">
                  <c:v>6.8179199999999994E-11</c:v>
                </c:pt>
                <c:pt idx="173">
                  <c:v>5.9497599999999999E-11</c:v>
                </c:pt>
                <c:pt idx="174">
                  <c:v>5.1883299999999998E-11</c:v>
                </c:pt>
                <c:pt idx="175">
                  <c:v>4.5210199999999997E-11</c:v>
                </c:pt>
                <c:pt idx="176">
                  <c:v>3.9366699999999997E-11</c:v>
                </c:pt>
                <c:pt idx="177">
                  <c:v>3.4253700000000001E-11</c:v>
                </c:pt>
                <c:pt idx="178">
                  <c:v>2.9783299999999998E-11</c:v>
                </c:pt>
                <c:pt idx="179">
                  <c:v>2.5877699999999999E-11</c:v>
                </c:pt>
                <c:pt idx="180">
                  <c:v>2.2468299999999999E-11</c:v>
                </c:pt>
                <c:pt idx="181">
                  <c:v>1.94942E-11</c:v>
                </c:pt>
                <c:pt idx="182">
                  <c:v>1.6901899999999999E-11</c:v>
                </c:pt>
                <c:pt idx="183">
                  <c:v>1.4643999999999999E-11</c:v>
                </c:pt>
                <c:pt idx="184">
                  <c:v>1.26789E-11</c:v>
                </c:pt>
                <c:pt idx="185">
                  <c:v>1.0969900000000001E-11</c:v>
                </c:pt>
                <c:pt idx="186">
                  <c:v>9.4847100000000007E-12</c:v>
                </c:pt>
                <c:pt idx="187">
                  <c:v>8.1949699999999994E-12</c:v>
                </c:pt>
                <c:pt idx="188">
                  <c:v>7.07578E-12</c:v>
                </c:pt>
                <c:pt idx="189">
                  <c:v>6.2602000000000003E-12</c:v>
                </c:pt>
                <c:pt idx="190">
                  <c:v>5.5360499999999996E-12</c:v>
                </c:pt>
                <c:pt idx="191">
                  <c:v>4.8934000000000001E-12</c:v>
                </c:pt>
                <c:pt idx="192">
                  <c:v>4.3233500000000002E-12</c:v>
                </c:pt>
                <c:pt idx="193">
                  <c:v>3.8179500000000003E-12</c:v>
                </c:pt>
                <c:pt idx="194">
                  <c:v>3.3700999999999999E-12</c:v>
                </c:pt>
                <c:pt idx="195">
                  <c:v>2.9734200000000001E-12</c:v>
                </c:pt>
                <c:pt idx="196">
                  <c:v>2.6222500000000001E-12</c:v>
                </c:pt>
                <c:pt idx="197">
                  <c:v>2.3115E-12</c:v>
                </c:pt>
                <c:pt idx="198">
                  <c:v>2.03667E-12</c:v>
                </c:pt>
                <c:pt idx="199">
                  <c:v>1.79371E-12</c:v>
                </c:pt>
                <c:pt idx="200">
                  <c:v>1.57903E-12</c:v>
                </c:pt>
                <c:pt idx="201">
                  <c:v>1.3894300000000001E-12</c:v>
                </c:pt>
                <c:pt idx="202">
                  <c:v>1.2220599999999999E-12</c:v>
                </c:pt>
                <c:pt idx="203">
                  <c:v>1.0743799999999999E-12</c:v>
                </c:pt>
                <c:pt idx="204">
                  <c:v>9.4412999999999994E-13</c:v>
                </c:pt>
                <c:pt idx="205">
                  <c:v>8.2931199999999997E-13</c:v>
                </c:pt>
                <c:pt idx="206">
                  <c:v>7.2814100000000004E-13</c:v>
                </c:pt>
                <c:pt idx="207">
                  <c:v>6.3903699999999996E-13</c:v>
                </c:pt>
                <c:pt idx="208">
                  <c:v>5.6059599999999997E-13</c:v>
                </c:pt>
                <c:pt idx="209">
                  <c:v>4.9157399999999998E-13</c:v>
                </c:pt>
                <c:pt idx="210">
                  <c:v>4.30867E-13</c:v>
                </c:pt>
                <c:pt idx="211">
                  <c:v>3.7749699999999999E-13</c:v>
                </c:pt>
                <c:pt idx="212">
                  <c:v>3.30599E-13</c:v>
                </c:pt>
                <c:pt idx="213">
                  <c:v>2.8940599999999999E-13</c:v>
                </c:pt>
                <c:pt idx="214">
                  <c:v>2.5323900000000002E-13</c:v>
                </c:pt>
                <c:pt idx="215">
                  <c:v>2.2150100000000001E-13</c:v>
                </c:pt>
                <c:pt idx="216">
                  <c:v>1.9018E-13</c:v>
                </c:pt>
                <c:pt idx="217">
                  <c:v>1.6320199999999999E-13</c:v>
                </c:pt>
                <c:pt idx="218">
                  <c:v>1.3997700000000001E-13</c:v>
                </c:pt>
                <c:pt idx="219">
                  <c:v>1.1999399999999999E-13</c:v>
                </c:pt>
                <c:pt idx="220">
                  <c:v>1.02811E-13</c:v>
                </c:pt>
                <c:pt idx="221">
                  <c:v>8.8042000000000002E-14</c:v>
                </c:pt>
                <c:pt idx="222">
                  <c:v>7.4052000000000003E-14</c:v>
                </c:pt>
                <c:pt idx="223">
                  <c:v>6.2245500000000002E-14</c:v>
                </c:pt>
                <c:pt idx="224">
                  <c:v>5.2288500000000002E-14</c:v>
                </c:pt>
                <c:pt idx="225">
                  <c:v>4.3896700000000002E-14</c:v>
                </c:pt>
                <c:pt idx="226">
                  <c:v>3.68287E-14</c:v>
                </c:pt>
                <c:pt idx="227">
                  <c:v>3.08796E-14</c:v>
                </c:pt>
                <c:pt idx="228">
                  <c:v>2.52609E-14</c:v>
                </c:pt>
                <c:pt idx="229">
                  <c:v>2.06484E-14</c:v>
                </c:pt>
                <c:pt idx="230">
                  <c:v>1.6864800000000001E-14</c:v>
                </c:pt>
                <c:pt idx="231">
                  <c:v>1.37638E-14</c:v>
                </c:pt>
                <c:pt idx="232">
                  <c:v>1.1224300000000001E-14</c:v>
                </c:pt>
                <c:pt idx="233">
                  <c:v>9.14628E-15</c:v>
                </c:pt>
                <c:pt idx="234">
                  <c:v>7.2002100000000003E-15</c:v>
                </c:pt>
                <c:pt idx="235">
                  <c:v>5.6625E-15</c:v>
                </c:pt>
                <c:pt idx="236">
                  <c:v>4.4486800000000003E-15</c:v>
                </c:pt>
                <c:pt idx="237">
                  <c:v>3.4915E-15</c:v>
                </c:pt>
                <c:pt idx="238">
                  <c:v>2.7375100000000002E-15</c:v>
                </c:pt>
                <c:pt idx="239">
                  <c:v>2.1442100000000002E-15</c:v>
                </c:pt>
                <c:pt idx="240">
                  <c:v>1.5877899999999999E-15</c:v>
                </c:pt>
                <c:pt idx="241">
                  <c:v>1.1741100000000001E-15</c:v>
                </c:pt>
                <c:pt idx="242">
                  <c:v>8.6696399999999996E-16</c:v>
                </c:pt>
                <c:pt idx="243">
                  <c:v>6.3922099999999998E-16</c:v>
                </c:pt>
                <c:pt idx="244">
                  <c:v>4.7062500000000003E-16</c:v>
                </c:pt>
                <c:pt idx="245">
                  <c:v>3.4602100000000002E-16</c:v>
                </c:pt>
                <c:pt idx="246">
                  <c:v>2.33793E-16</c:v>
                </c:pt>
                <c:pt idx="247">
                  <c:v>1.5776399999999999E-16</c:v>
                </c:pt>
                <c:pt idx="248">
                  <c:v>1.06291E-16</c:v>
                </c:pt>
                <c:pt idx="249">
                  <c:v>7.1442599999999996E-17</c:v>
                </c:pt>
                <c:pt idx="250">
                  <c:v>4.7889399999999997E-17</c:v>
                </c:pt>
                <c:pt idx="251">
                  <c:v>3.2034699999999998E-17</c:v>
                </c:pt>
                <c:pt idx="252">
                  <c:v>1.8666599999999999E-17</c:v>
                </c:pt>
                <c:pt idx="253">
                  <c:v>1.0924800000000001E-17</c:v>
                </c:pt>
                <c:pt idx="254">
                  <c:v>6.3809400000000002E-18</c:v>
                </c:pt>
                <c:pt idx="255">
                  <c:v>3.6821899999999998E-18</c:v>
                </c:pt>
                <c:pt idx="256">
                  <c:v>2.1062700000000001E-18</c:v>
                </c:pt>
                <c:pt idx="257">
                  <c:v>1.21711E-18</c:v>
                </c:pt>
                <c:pt idx="258">
                  <c:v>6.3311899999999999E-19</c:v>
                </c:pt>
                <c:pt idx="259">
                  <c:v>4.4028799999999996E-19</c:v>
                </c:pt>
                <c:pt idx="260">
                  <c:v>2.5678099999999999E-19</c:v>
                </c:pt>
                <c:pt idx="261">
                  <c:v>8.5658400000000002E-20</c:v>
                </c:pt>
                <c:pt idx="262">
                  <c:v>1.71537E-20</c:v>
                </c:pt>
                <c:pt idx="263">
                  <c:v>2.8704699999999998E-20</c:v>
                </c:pt>
                <c:pt idx="264">
                  <c:v>1.4128700000000001E-19</c:v>
                </c:pt>
                <c:pt idx="265">
                  <c:v>1.1364999999999999E-19</c:v>
                </c:pt>
                <c:pt idx="266">
                  <c:v>-6.6569699999999997E-21</c:v>
                </c:pt>
                <c:pt idx="267">
                  <c:v>-4.9174400000000001E-20</c:v>
                </c:pt>
                <c:pt idx="268">
                  <c:v>-2.8162200000000002E-21</c:v>
                </c:pt>
                <c:pt idx="269">
                  <c:v>3.14999E-20</c:v>
                </c:pt>
                <c:pt idx="270">
                  <c:v>3.9350600000000001E-20</c:v>
                </c:pt>
                <c:pt idx="271">
                  <c:v>-1.5689700000000001E-20</c:v>
                </c:pt>
                <c:pt idx="272">
                  <c:v>-2.2620700000000001E-20</c:v>
                </c:pt>
                <c:pt idx="273">
                  <c:v>-6.6474299999999998E-21</c:v>
                </c:pt>
                <c:pt idx="274">
                  <c:v>6.5692500000000003E-21</c:v>
                </c:pt>
                <c:pt idx="275">
                  <c:v>7.4246400000000002E-21</c:v>
                </c:pt>
                <c:pt idx="276">
                  <c:v>9.4385699999999993E-22</c:v>
                </c:pt>
                <c:pt idx="277">
                  <c:v>-6.1514600000000003E-21</c:v>
                </c:pt>
                <c:pt idx="278">
                  <c:v>-1.5353499999999999E-21</c:v>
                </c:pt>
                <c:pt idx="279">
                  <c:v>-4.8578599999999997E-21</c:v>
                </c:pt>
                <c:pt idx="280">
                  <c:v>-4.0396200000000001E-21</c:v>
                </c:pt>
                <c:pt idx="281">
                  <c:v>8.1960400000000005E-22</c:v>
                </c:pt>
                <c:pt idx="282">
                  <c:v>3.0303899999999998E-21</c:v>
                </c:pt>
                <c:pt idx="283">
                  <c:v>1.16594E-21</c:v>
                </c:pt>
                <c:pt idx="284">
                  <c:v>-5.3457799999999999E-22</c:v>
                </c:pt>
                <c:pt idx="285">
                  <c:v>-2.20745E-22</c:v>
                </c:pt>
                <c:pt idx="286">
                  <c:v>9.2507000000000009E-22</c:v>
                </c:pt>
                <c:pt idx="287">
                  <c:v>1.3965299999999999E-22</c:v>
                </c:pt>
                <c:pt idx="288">
                  <c:v>-3.4561899999999998E-22</c:v>
                </c:pt>
                <c:pt idx="289">
                  <c:v>-5.8525100000000001E-23</c:v>
                </c:pt>
                <c:pt idx="290">
                  <c:v>1.49255E-22</c:v>
                </c:pt>
                <c:pt idx="291">
                  <c:v>1.08657E-23</c:v>
                </c:pt>
                <c:pt idx="292">
                  <c:v>-6.8602899999999996E-22</c:v>
                </c:pt>
                <c:pt idx="293">
                  <c:v>-3.5534100000000002E-22</c:v>
                </c:pt>
                <c:pt idx="294">
                  <c:v>-8.4853600000000009E-22</c:v>
                </c:pt>
                <c:pt idx="295">
                  <c:v>2.1201699999999999E-21</c:v>
                </c:pt>
                <c:pt idx="296">
                  <c:v>-4.5391899999999998E-21</c:v>
                </c:pt>
                <c:pt idx="297">
                  <c:v>1.21353E-20</c:v>
                </c:pt>
                <c:pt idx="298">
                  <c:v>5.2378300000000001E-21</c:v>
                </c:pt>
                <c:pt idx="299">
                  <c:v>-2.82506E-21</c:v>
                </c:pt>
                <c:pt idx="300">
                  <c:v>1.2404700000000001E-22</c:v>
                </c:pt>
                <c:pt idx="301">
                  <c:v>1.07084E-21</c:v>
                </c:pt>
                <c:pt idx="302">
                  <c:v>-4.8976200000000002E-22</c:v>
                </c:pt>
                <c:pt idx="303">
                  <c:v>-2.2791900000000001E-22</c:v>
                </c:pt>
                <c:pt idx="304">
                  <c:v>-5.0426400000000004E-22</c:v>
                </c:pt>
                <c:pt idx="305">
                  <c:v>8.7285500000000004E-21</c:v>
                </c:pt>
                <c:pt idx="306">
                  <c:v>-1.22921E-20</c:v>
                </c:pt>
                <c:pt idx="307">
                  <c:v>4.29413E-20</c:v>
                </c:pt>
                <c:pt idx="308">
                  <c:v>-1.2612199999999999E-19</c:v>
                </c:pt>
                <c:pt idx="309">
                  <c:v>-1.3951299999999999E-19</c:v>
                </c:pt>
                <c:pt idx="310">
                  <c:v>1.2129300000000001E-19</c:v>
                </c:pt>
                <c:pt idx="311">
                  <c:v>1.5137E-19</c:v>
                </c:pt>
                <c:pt idx="312">
                  <c:v>-9.0736000000000001E-20</c:v>
                </c:pt>
                <c:pt idx="313">
                  <c:v>-2.51575E-19</c:v>
                </c:pt>
                <c:pt idx="314">
                  <c:v>-1.11076E-19</c:v>
                </c:pt>
                <c:pt idx="315">
                  <c:v>4.0459300000000001E-20</c:v>
                </c:pt>
                <c:pt idx="316">
                  <c:v>2.6716400000000001E-20</c:v>
                </c:pt>
                <c:pt idx="317">
                  <c:v>-2.3486599999999999E-20</c:v>
                </c:pt>
                <c:pt idx="318">
                  <c:v>5.0617399999999999E-21</c:v>
                </c:pt>
                <c:pt idx="319">
                  <c:v>4.6697999999999999E-21</c:v>
                </c:pt>
                <c:pt idx="320">
                  <c:v>-3.6041699999999998E-21</c:v>
                </c:pt>
                <c:pt idx="321">
                  <c:v>3.4706299999999999E-22</c:v>
                </c:pt>
                <c:pt idx="322">
                  <c:v>5.3348200000000001E-21</c:v>
                </c:pt>
                <c:pt idx="323">
                  <c:v>2.0910299999999999E-21</c:v>
                </c:pt>
                <c:pt idx="324">
                  <c:v>-9.5277200000000005E-23</c:v>
                </c:pt>
                <c:pt idx="325">
                  <c:v>8.2388599999999998E-24</c:v>
                </c:pt>
                <c:pt idx="326">
                  <c:v>3.9259200000000002E-23</c:v>
                </c:pt>
                <c:pt idx="327">
                  <c:v>4.6835400000000001E-22</c:v>
                </c:pt>
                <c:pt idx="328">
                  <c:v>7.3115699999999999E-23</c:v>
                </c:pt>
                <c:pt idx="329">
                  <c:v>-2.9271000000000001E-24</c:v>
                </c:pt>
                <c:pt idx="330">
                  <c:v>2.3000099999999999E-25</c:v>
                </c:pt>
                <c:pt idx="331">
                  <c:v>5.3676400000000003E-25</c:v>
                </c:pt>
                <c:pt idx="332">
                  <c:v>2.3646500000000001E-27</c:v>
                </c:pt>
                <c:pt idx="333">
                  <c:v>-6.5858499999999998E-28</c:v>
                </c:pt>
                <c:pt idx="334">
                  <c:v>-1.7556699999999999E-27</c:v>
                </c:pt>
              </c:numCache>
            </c:numRef>
          </c:yVal>
          <c:smooth val="1"/>
          <c:extLst>
            <c:ext xmlns:c16="http://schemas.microsoft.com/office/drawing/2014/chart" uri="{C3380CC4-5D6E-409C-BE32-E72D297353CC}">
              <c16:uniqueId val="{00000000-2BF2-4EE8-AD0B-A4C7732446E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382907704"/>
        <c:axId val="382906528"/>
      </c:scatterChart>
      <c:valAx>
        <c:axId val="382907704"/>
        <c:scaling>
          <c:orientation val="minMax"/>
          <c:max val="5"/>
          <c:min val="0"/>
        </c:scaling>
        <c:delete val="0"/>
        <c:axPos val="b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906528"/>
        <c:crosses val="autoZero"/>
        <c:crossBetween val="midCat"/>
        <c:majorUnit val="1"/>
      </c:valAx>
      <c:valAx>
        <c:axId val="382906528"/>
        <c:scaling>
          <c:orientation val="minMax"/>
          <c:max val="100"/>
          <c:min val="0"/>
        </c:scaling>
        <c:delete val="0"/>
        <c:axPos val="l"/>
        <c:majorGridlines>
          <c:spPr>
            <a:ln w="9525" cap="flat" cmpd="sng" algn="ctr">
              <a:noFill/>
              <a:round/>
            </a:ln>
            <a:effectLst/>
          </c:spPr>
        </c:majorGridlines>
        <c:numFmt formatCode="#,##0" sourceLinked="0"/>
        <c:majorTickMark val="in"/>
        <c:minorTickMark val="none"/>
        <c:tickLblPos val="nextTo"/>
        <c:spPr>
          <a:noFill/>
          <a:ln w="9525" cap="flat" cmpd="sng" algn="ctr">
            <a:solidFill>
              <a:schemeClr val="tx1">
                <a:lumMod val="25000"/>
                <a:lumOff val="7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382907704"/>
        <c:crosses val="autoZero"/>
        <c:crossBetween val="midCat"/>
        <c:majorUnit val="20"/>
      </c:valAx>
      <c:spPr>
        <a:noFill/>
        <a:ln w="63500">
          <a:solidFill>
            <a:schemeClr val="tx1">
              <a:lumMod val="65000"/>
              <a:lumOff val="35000"/>
            </a:schemeClr>
          </a:solidFill>
        </a:ln>
        <a:effectLst/>
      </c:spPr>
    </c:plotArea>
    <c:plotVisOnly val="1"/>
    <c:dispBlanksAs val="gap"/>
    <c:showDLblsOverMax val="0"/>
  </c:chart>
  <c:spPr>
    <a:noFill/>
    <a:ln>
      <a:noFill/>
    </a:ln>
    <a:effectLst/>
  </c:spPr>
  <c:txPr>
    <a:bodyPr/>
    <a:lstStyle/>
    <a:p>
      <a:pPr>
        <a:defRPr sz="14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4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5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4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5.xml><?xml version="1.0" encoding="utf-8"?>
<cs:chartStyle xmlns:cs="http://schemas.microsoft.com/office/drawing/2012/chartStyle" xmlns:a="http://schemas.openxmlformats.org/drawingml/2006/main" id="240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19050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0"/>
    <cs:effectRef idx="0"/>
    <cs:fontRef idx="minor">
      <a:schemeClr val="dk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tx1"/>
    </cs:fontRef>
    <cs:spPr>
      <a:solidFill>
        <a:schemeClr val="dk1">
          <a:lumMod val="75000"/>
          <a:lumOff val="25000"/>
        </a:schemeClr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0"/>
            <a:lumOff val="50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tx1"/>
    </cs:fontRef>
    <cs:spPr>
      <a:solidFill>
        <a:schemeClr val="lt1"/>
      </a:solidFill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25000"/>
            <a:lumOff val="75000"/>
          </a:schemeClr>
        </a:solidFill>
        <a:round/>
      </a:ln>
    </cs:spPr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86645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4709564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698512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89094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545147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5176891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771977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028030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164712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862577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1818575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46DD2DB-B92F-42BC-B6ED-81AEB26F71CD}" type="datetimeFigureOut">
              <a:rPr lang="en-US" smtClean="0"/>
              <a:t>1/28/2020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89FF13A-5B1D-4B19-9CA3-E9262B602E5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3266979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2"/>
          <p:cNvGrpSpPr/>
          <p:nvPr/>
        </p:nvGrpSpPr>
        <p:grpSpPr>
          <a:xfrm>
            <a:off x="142457" y="121457"/>
            <a:ext cx="3647236" cy="2298303"/>
            <a:chOff x="142457" y="121457"/>
            <a:chExt cx="3647236" cy="2298303"/>
          </a:xfrm>
        </p:grpSpPr>
        <p:grpSp>
          <p:nvGrpSpPr>
            <p:cNvPr id="62" name="Group 61"/>
            <p:cNvGrpSpPr/>
            <p:nvPr/>
          </p:nvGrpSpPr>
          <p:grpSpPr>
            <a:xfrm>
              <a:off x="142457" y="121457"/>
              <a:ext cx="3647236" cy="2298303"/>
              <a:chOff x="142457" y="232289"/>
              <a:chExt cx="3647236" cy="2298303"/>
            </a:xfrm>
          </p:grpSpPr>
          <p:grpSp>
            <p:nvGrpSpPr>
              <p:cNvPr id="13" name="Group 12"/>
              <p:cNvGrpSpPr/>
              <p:nvPr/>
            </p:nvGrpSpPr>
            <p:grpSpPr>
              <a:xfrm>
                <a:off x="406413" y="232289"/>
                <a:ext cx="3383280" cy="2165113"/>
                <a:chOff x="222785" y="18819"/>
                <a:chExt cx="3383280" cy="2165113"/>
              </a:xfrm>
            </p:grpSpPr>
            <p:graphicFrame>
              <p:nvGraphicFramePr>
                <p:cNvPr id="45" name="Chart 44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201528193"/>
                    </p:ext>
                  </p:extLst>
                </p:nvPr>
              </p:nvGraphicFramePr>
              <p:xfrm>
                <a:off x="222785" y="263692"/>
                <a:ext cx="3383280" cy="19202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2"/>
                </a:graphicData>
              </a:graphic>
            </p:graphicFrame>
            <p:sp>
              <p:nvSpPr>
                <p:cNvPr id="50" name="Rectangle 49"/>
                <p:cNvSpPr/>
                <p:nvPr/>
              </p:nvSpPr>
              <p:spPr>
                <a:xfrm>
                  <a:off x="836451" y="18819"/>
                  <a:ext cx="2457403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>
                    <a:defRPr sz="1600" b="0" i="0" u="none" strike="noStrike" kern="1200" spc="0" baseline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en-US" sz="1600" dirty="0"/>
                    <a:t>Protease influx 0 (unstable)</a:t>
                  </a:r>
                </a:p>
              </p:txBody>
            </p:sp>
          </p:grpSp>
          <p:sp>
            <p:nvSpPr>
              <p:cNvPr id="52" name="TextBox 51"/>
              <p:cNvSpPr txBox="1"/>
              <p:nvPr/>
            </p:nvSpPr>
            <p:spPr>
              <a:xfrm rot="16200000">
                <a:off x="-331961" y="875984"/>
                <a:ext cx="1392813" cy="443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Bacteria  (fM)</a:t>
                </a:r>
                <a:endParaRPr lang="en-US" sz="1600" dirty="0"/>
              </a:p>
            </p:txBody>
          </p:sp>
          <p:sp>
            <p:nvSpPr>
              <p:cNvPr id="57" name="TextBox 56"/>
              <p:cNvSpPr txBox="1"/>
              <p:nvPr/>
            </p:nvSpPr>
            <p:spPr>
              <a:xfrm>
                <a:off x="1491477" y="2225560"/>
                <a:ext cx="1856730" cy="305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Time (days)</a:t>
                </a:r>
                <a:endParaRPr lang="en-US" sz="1600" dirty="0"/>
              </a:p>
            </p:txBody>
          </p:sp>
        </p:grpSp>
        <p:sp>
          <p:nvSpPr>
            <p:cNvPr id="2" name="TextBox 1"/>
            <p:cNvSpPr txBox="1"/>
            <p:nvPr/>
          </p:nvSpPr>
          <p:spPr>
            <a:xfrm>
              <a:off x="851640" y="454053"/>
              <a:ext cx="221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A</a:t>
              </a:r>
              <a:endParaRPr lang="en-US" dirty="0"/>
            </a:p>
          </p:txBody>
        </p:sp>
      </p:grpSp>
      <p:grpSp>
        <p:nvGrpSpPr>
          <p:cNvPr id="4" name="Group 3"/>
          <p:cNvGrpSpPr/>
          <p:nvPr/>
        </p:nvGrpSpPr>
        <p:grpSpPr>
          <a:xfrm>
            <a:off x="4192995" y="121457"/>
            <a:ext cx="4071413" cy="2336448"/>
            <a:chOff x="4192995" y="121457"/>
            <a:chExt cx="4071413" cy="2336448"/>
          </a:xfrm>
        </p:grpSpPr>
        <p:grpSp>
          <p:nvGrpSpPr>
            <p:cNvPr id="67" name="Group 66"/>
            <p:cNvGrpSpPr/>
            <p:nvPr/>
          </p:nvGrpSpPr>
          <p:grpSpPr>
            <a:xfrm>
              <a:off x="4192995" y="121457"/>
              <a:ext cx="4071413" cy="2336448"/>
              <a:chOff x="4192995" y="232289"/>
              <a:chExt cx="4071413" cy="2336448"/>
            </a:xfrm>
          </p:grpSpPr>
          <p:grpSp>
            <p:nvGrpSpPr>
              <p:cNvPr id="14" name="Group 13"/>
              <p:cNvGrpSpPr/>
              <p:nvPr/>
            </p:nvGrpSpPr>
            <p:grpSpPr>
              <a:xfrm>
                <a:off x="4613920" y="232289"/>
                <a:ext cx="3650488" cy="2183932"/>
                <a:chOff x="4611905" y="0"/>
                <a:chExt cx="3650488" cy="2183932"/>
              </a:xfrm>
            </p:grpSpPr>
            <p:graphicFrame>
              <p:nvGraphicFramePr>
                <p:cNvPr id="46" name="Chart 45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337864665"/>
                    </p:ext>
                  </p:extLst>
                </p:nvPr>
              </p:nvGraphicFramePr>
              <p:xfrm>
                <a:off x="4611905" y="263692"/>
                <a:ext cx="3383280" cy="19202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3"/>
                </a:graphicData>
              </a:graphic>
            </p:graphicFrame>
            <p:sp>
              <p:nvSpPr>
                <p:cNvPr id="9" name="Rectangle 8"/>
                <p:cNvSpPr/>
                <p:nvPr/>
              </p:nvSpPr>
              <p:spPr>
                <a:xfrm>
                  <a:off x="4761435" y="0"/>
                  <a:ext cx="35009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</a:rPr>
                    <a:t>Protease influx 0.001 </a:t>
                  </a:r>
                  <a:r>
                    <a:rPr lang="en-US" sz="1600" dirty="0" err="1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</a:rPr>
                    <a:t>fM</a:t>
                  </a:r>
                  <a:r>
                    <a:rPr lang="en-US" sz="1600" dirty="0">
                      <a:solidFill>
                        <a:prstClr val="black">
                          <a:lumMod val="65000"/>
                          <a:lumOff val="35000"/>
                        </a:prstClr>
                      </a:solidFill>
                    </a:rPr>
                    <a:t>/min (unstable)</a:t>
                  </a:r>
                </a:p>
              </p:txBody>
            </p:sp>
          </p:grpSp>
          <p:sp>
            <p:nvSpPr>
              <p:cNvPr id="53" name="TextBox 52"/>
              <p:cNvSpPr txBox="1"/>
              <p:nvPr/>
            </p:nvSpPr>
            <p:spPr>
              <a:xfrm rot="16200000">
                <a:off x="3718577" y="1045261"/>
                <a:ext cx="1392813" cy="443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Bacteria  (fM)</a:t>
                </a:r>
                <a:endParaRPr lang="en-US" sz="1600" dirty="0"/>
              </a:p>
            </p:txBody>
          </p:sp>
          <p:sp>
            <p:nvSpPr>
              <p:cNvPr id="58" name="TextBox 57"/>
              <p:cNvSpPr txBox="1"/>
              <p:nvPr/>
            </p:nvSpPr>
            <p:spPr>
              <a:xfrm>
                <a:off x="5810667" y="2263705"/>
                <a:ext cx="1856730" cy="305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Time (days)</a:t>
                </a:r>
                <a:endParaRPr lang="en-US" sz="1600" dirty="0"/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5137297" y="517439"/>
              <a:ext cx="221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B</a:t>
              </a:r>
              <a:endParaRPr lang="en-US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151692" y="2478841"/>
            <a:ext cx="3908888" cy="2278469"/>
            <a:chOff x="151692" y="2478841"/>
            <a:chExt cx="3908888" cy="2278469"/>
          </a:xfrm>
        </p:grpSpPr>
        <p:grpSp>
          <p:nvGrpSpPr>
            <p:cNvPr id="65" name="Group 64"/>
            <p:cNvGrpSpPr/>
            <p:nvPr/>
          </p:nvGrpSpPr>
          <p:grpSpPr>
            <a:xfrm>
              <a:off x="151692" y="2478841"/>
              <a:ext cx="3908888" cy="2278469"/>
              <a:chOff x="142456" y="2580437"/>
              <a:chExt cx="3908888" cy="2278469"/>
            </a:xfrm>
          </p:grpSpPr>
          <p:grpSp>
            <p:nvGrpSpPr>
              <p:cNvPr id="16" name="Group 15"/>
              <p:cNvGrpSpPr/>
              <p:nvPr/>
            </p:nvGrpSpPr>
            <p:grpSpPr>
              <a:xfrm>
                <a:off x="420254" y="2580437"/>
                <a:ext cx="3631090" cy="2126266"/>
                <a:chOff x="263242" y="2580437"/>
                <a:chExt cx="3631090" cy="2126266"/>
              </a:xfrm>
            </p:grpSpPr>
            <p:graphicFrame>
              <p:nvGraphicFramePr>
                <p:cNvPr id="47" name="Chart 46" title="Time (days)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1287886354"/>
                    </p:ext>
                  </p:extLst>
                </p:nvPr>
              </p:nvGraphicFramePr>
              <p:xfrm>
                <a:off x="263242" y="2786463"/>
                <a:ext cx="3383280" cy="19202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4"/>
                </a:graphicData>
              </a:graphic>
            </p:graphicFrame>
            <p:sp>
              <p:nvSpPr>
                <p:cNvPr id="10" name="Rectangle 9"/>
                <p:cNvSpPr/>
                <p:nvPr/>
              </p:nvSpPr>
              <p:spPr>
                <a:xfrm>
                  <a:off x="393374" y="2580437"/>
                  <a:ext cx="3500958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pPr algn="ctr">
                    <a:defRPr sz="1400" b="0" i="0" u="none" strike="noStrike" kern="1200" spc="0" baseline="0">
                      <a:solidFill>
                        <a:sysClr val="windowText" lastClr="000000">
                          <a:lumMod val="65000"/>
                          <a:lumOff val="35000"/>
                        </a:sys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en-US" sz="1600" dirty="0"/>
                    <a:t>Protease influx 0.003 </a:t>
                  </a:r>
                  <a:r>
                    <a:rPr lang="en-US" sz="1600" dirty="0" err="1"/>
                    <a:t>fM</a:t>
                  </a:r>
                  <a:r>
                    <a:rPr lang="en-US" sz="1600" dirty="0"/>
                    <a:t>/min (unstable)</a:t>
                  </a:r>
                </a:p>
              </p:txBody>
            </p:sp>
          </p:grpSp>
          <p:sp>
            <p:nvSpPr>
              <p:cNvPr id="55" name="TextBox 54"/>
              <p:cNvSpPr txBox="1"/>
              <p:nvPr/>
            </p:nvSpPr>
            <p:spPr>
              <a:xfrm rot="16200000">
                <a:off x="-331962" y="3260595"/>
                <a:ext cx="1392813" cy="443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Bacteria  (fM)</a:t>
                </a:r>
                <a:endParaRPr lang="en-US" sz="1600" dirty="0"/>
              </a:p>
            </p:txBody>
          </p:sp>
          <p:sp>
            <p:nvSpPr>
              <p:cNvPr id="60" name="TextBox 59"/>
              <p:cNvSpPr txBox="1"/>
              <p:nvPr/>
            </p:nvSpPr>
            <p:spPr>
              <a:xfrm>
                <a:off x="1428118" y="4553874"/>
                <a:ext cx="1856730" cy="305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Time (days)</a:t>
                </a:r>
                <a:endParaRPr lang="en-US" sz="1600" dirty="0"/>
              </a:p>
            </p:txBody>
          </p:sp>
        </p:grpSp>
        <p:sp>
          <p:nvSpPr>
            <p:cNvPr id="34" name="TextBox 33"/>
            <p:cNvSpPr txBox="1"/>
            <p:nvPr/>
          </p:nvSpPr>
          <p:spPr>
            <a:xfrm>
              <a:off x="916153" y="2817395"/>
              <a:ext cx="221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C</a:t>
              </a:r>
              <a:endParaRPr lang="en-US" dirty="0"/>
            </a:p>
          </p:txBody>
        </p:sp>
      </p:grpSp>
      <p:grpSp>
        <p:nvGrpSpPr>
          <p:cNvPr id="5" name="Group 4"/>
          <p:cNvGrpSpPr/>
          <p:nvPr/>
        </p:nvGrpSpPr>
        <p:grpSpPr>
          <a:xfrm>
            <a:off x="4239174" y="2423438"/>
            <a:ext cx="4747809" cy="2320914"/>
            <a:chOff x="4239174" y="2423438"/>
            <a:chExt cx="4747809" cy="2320914"/>
          </a:xfrm>
        </p:grpSpPr>
        <p:grpSp>
          <p:nvGrpSpPr>
            <p:cNvPr id="64" name="Group 63"/>
            <p:cNvGrpSpPr/>
            <p:nvPr/>
          </p:nvGrpSpPr>
          <p:grpSpPr>
            <a:xfrm>
              <a:off x="4239174" y="2423438"/>
              <a:ext cx="4747809" cy="2320914"/>
              <a:chOff x="4239174" y="2617394"/>
              <a:chExt cx="4747809" cy="2320914"/>
            </a:xfrm>
          </p:grpSpPr>
          <p:grpSp>
            <p:nvGrpSpPr>
              <p:cNvPr id="15" name="Group 14"/>
              <p:cNvGrpSpPr/>
              <p:nvPr/>
            </p:nvGrpSpPr>
            <p:grpSpPr>
              <a:xfrm>
                <a:off x="4414983" y="2617394"/>
                <a:ext cx="4572000" cy="2164905"/>
                <a:chOff x="4461163" y="2617394"/>
                <a:chExt cx="4572000" cy="2164905"/>
              </a:xfrm>
            </p:grpSpPr>
            <p:graphicFrame>
              <p:nvGraphicFramePr>
                <p:cNvPr id="48" name="Chart 47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3993665061"/>
                    </p:ext>
                  </p:extLst>
                </p:nvPr>
              </p:nvGraphicFramePr>
              <p:xfrm>
                <a:off x="4669072" y="2862059"/>
                <a:ext cx="3383280" cy="19202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5"/>
                </a:graphicData>
              </a:graphic>
            </p:graphicFrame>
            <p:sp>
              <p:nvSpPr>
                <p:cNvPr id="51" name="Rectangle 50"/>
                <p:cNvSpPr/>
                <p:nvPr/>
              </p:nvSpPr>
              <p:spPr>
                <a:xfrm>
                  <a:off x="4461163" y="2617394"/>
                  <a:ext cx="4572000" cy="338554"/>
                </a:xfrm>
                <a:prstGeom prst="rect">
                  <a:avLst/>
                </a:prstGeom>
              </p:spPr>
              <p:txBody>
                <a:bodyPr>
                  <a:spAutoFit/>
                </a:bodyPr>
                <a:lstStyle/>
                <a:p>
                  <a:pPr algn="ctr">
                    <a:defRPr sz="3600" b="0" i="0" u="none" strike="noStrike" kern="1200" spc="0" baseline="0">
                      <a:solidFill>
                        <a:sysClr val="windowText" lastClr="000000">
                          <a:lumMod val="65000"/>
                          <a:lumOff val="35000"/>
                        </a:sysClr>
                      </a:solidFill>
                      <a:latin typeface="+mn-lt"/>
                      <a:ea typeface="+mn-ea"/>
                      <a:cs typeface="+mn-cs"/>
                    </a:defRPr>
                  </a:pPr>
                  <a:r>
                    <a:rPr lang="en-US" sz="1600" dirty="0"/>
                    <a:t>Protease influx 0.005 </a:t>
                  </a:r>
                  <a:r>
                    <a:rPr lang="en-US" sz="1600" dirty="0" err="1"/>
                    <a:t>fM</a:t>
                  </a:r>
                  <a:r>
                    <a:rPr lang="en-US" sz="1600" dirty="0"/>
                    <a:t>/min (unstable)</a:t>
                  </a:r>
                </a:p>
              </p:txBody>
            </p:sp>
          </p:grpSp>
          <p:sp>
            <p:nvSpPr>
              <p:cNvPr id="54" name="TextBox 53"/>
              <p:cNvSpPr txBox="1"/>
              <p:nvPr/>
            </p:nvSpPr>
            <p:spPr>
              <a:xfrm rot="16200000">
                <a:off x="3764756" y="3325902"/>
                <a:ext cx="1392813" cy="443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Bacteria  (fM)</a:t>
                </a:r>
                <a:endParaRPr lang="en-US" sz="1600" dirty="0"/>
              </a:p>
            </p:txBody>
          </p:sp>
          <p:sp>
            <p:nvSpPr>
              <p:cNvPr id="59" name="TextBox 58"/>
              <p:cNvSpPr txBox="1"/>
              <p:nvPr/>
            </p:nvSpPr>
            <p:spPr>
              <a:xfrm>
                <a:off x="5942667" y="4633276"/>
                <a:ext cx="1856730" cy="305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Time (days)</a:t>
                </a:r>
                <a:endParaRPr lang="en-US" sz="1600" dirty="0"/>
              </a:p>
            </p:txBody>
          </p:sp>
        </p:grpSp>
        <p:sp>
          <p:nvSpPr>
            <p:cNvPr id="35" name="TextBox 34"/>
            <p:cNvSpPr txBox="1"/>
            <p:nvPr/>
          </p:nvSpPr>
          <p:spPr>
            <a:xfrm>
              <a:off x="5111308" y="2802291"/>
              <a:ext cx="221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D</a:t>
              </a:r>
              <a:endParaRPr lang="en-US" dirty="0"/>
            </a:p>
          </p:txBody>
        </p:sp>
      </p:grpSp>
      <p:grpSp>
        <p:nvGrpSpPr>
          <p:cNvPr id="7" name="Group 6"/>
          <p:cNvGrpSpPr/>
          <p:nvPr/>
        </p:nvGrpSpPr>
        <p:grpSpPr>
          <a:xfrm>
            <a:off x="2202172" y="4564437"/>
            <a:ext cx="3756675" cy="2279831"/>
            <a:chOff x="2202172" y="4564437"/>
            <a:chExt cx="3756675" cy="2279831"/>
          </a:xfrm>
        </p:grpSpPr>
        <p:grpSp>
          <p:nvGrpSpPr>
            <p:cNvPr id="66" name="Group 65"/>
            <p:cNvGrpSpPr/>
            <p:nvPr/>
          </p:nvGrpSpPr>
          <p:grpSpPr>
            <a:xfrm>
              <a:off x="2202172" y="4564437"/>
              <a:ext cx="3756675" cy="2279831"/>
              <a:chOff x="2396128" y="4730685"/>
              <a:chExt cx="3756675" cy="2279831"/>
            </a:xfrm>
          </p:grpSpPr>
          <p:grpSp>
            <p:nvGrpSpPr>
              <p:cNvPr id="17" name="Group 16"/>
              <p:cNvGrpSpPr/>
              <p:nvPr/>
            </p:nvGrpSpPr>
            <p:grpSpPr>
              <a:xfrm>
                <a:off x="2769523" y="4730685"/>
                <a:ext cx="3383280" cy="2127315"/>
                <a:chOff x="2567757" y="4575224"/>
                <a:chExt cx="3383280" cy="2127315"/>
              </a:xfrm>
            </p:grpSpPr>
            <p:graphicFrame>
              <p:nvGraphicFramePr>
                <p:cNvPr id="49" name="Chart 48"/>
                <p:cNvGraphicFramePr>
                  <a:graphicFrameLocks/>
                </p:cNvGraphicFramePr>
                <p:nvPr>
                  <p:extLst>
                    <p:ext uri="{D42A27DB-BD31-4B8C-83A1-F6EECF244321}">
                      <p14:modId xmlns:p14="http://schemas.microsoft.com/office/powerpoint/2010/main" val="2782983"/>
                    </p:ext>
                  </p:extLst>
                </p:nvPr>
              </p:nvGraphicFramePr>
              <p:xfrm>
                <a:off x="2567757" y="4782299"/>
                <a:ext cx="3383280" cy="1920240"/>
              </p:xfrm>
              <a:graphic>
                <a:graphicData uri="http://schemas.openxmlformats.org/drawingml/2006/chart">
                  <c:chart xmlns:c="http://schemas.openxmlformats.org/drawingml/2006/chart" xmlns:r="http://schemas.openxmlformats.org/officeDocument/2006/relationships" r:id="rId6"/>
                </a:graphicData>
              </a:graphic>
            </p:graphicFrame>
            <p:sp>
              <p:nvSpPr>
                <p:cNvPr id="12" name="Rectangle 11"/>
                <p:cNvSpPr/>
                <p:nvPr/>
              </p:nvSpPr>
              <p:spPr>
                <a:xfrm>
                  <a:off x="2873271" y="4575224"/>
                  <a:ext cx="3077766" cy="338554"/>
                </a:xfrm>
                <a:prstGeom prst="rect">
                  <a:avLst/>
                </a:prstGeom>
              </p:spPr>
              <p:txBody>
                <a:bodyPr wrap="none">
                  <a:spAutoFit/>
                </a:bodyPr>
                <a:lstStyle/>
                <a:p>
                  <a:r>
                    <a:rPr lang="en-US" sz="1600" dirty="0">
                      <a:solidFill>
                        <a:sysClr val="windowText" lastClr="000000">
                          <a:lumMod val="65000"/>
                          <a:lumOff val="35000"/>
                        </a:sysClr>
                      </a:solidFill>
                    </a:rPr>
                    <a:t>Protease influx 1.0 </a:t>
                  </a:r>
                  <a:r>
                    <a:rPr lang="en-US" sz="1600" dirty="0" err="1">
                      <a:solidFill>
                        <a:sysClr val="windowText" lastClr="000000">
                          <a:lumMod val="65000"/>
                          <a:lumOff val="35000"/>
                        </a:sysClr>
                      </a:solidFill>
                    </a:rPr>
                    <a:t>fM</a:t>
                  </a:r>
                  <a:r>
                    <a:rPr lang="en-US" sz="1600" dirty="0">
                      <a:solidFill>
                        <a:sysClr val="windowText" lastClr="000000">
                          <a:lumMod val="65000"/>
                          <a:lumOff val="35000"/>
                        </a:sysClr>
                      </a:solidFill>
                    </a:rPr>
                    <a:t>/min (stable)</a:t>
                  </a:r>
                </a:p>
              </p:txBody>
            </p:sp>
          </p:grpSp>
          <p:sp>
            <p:nvSpPr>
              <p:cNvPr id="56" name="TextBox 55"/>
              <p:cNvSpPr txBox="1"/>
              <p:nvPr/>
            </p:nvSpPr>
            <p:spPr>
              <a:xfrm rot="16200000">
                <a:off x="1921710" y="5531217"/>
                <a:ext cx="1392813" cy="443978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Bacteria  (fM)</a:t>
                </a:r>
                <a:endParaRPr lang="en-US" sz="1600" dirty="0"/>
              </a:p>
            </p:txBody>
          </p:sp>
          <p:sp>
            <p:nvSpPr>
              <p:cNvPr id="61" name="TextBox 60"/>
              <p:cNvSpPr txBox="1"/>
              <p:nvPr/>
            </p:nvSpPr>
            <p:spPr>
              <a:xfrm>
                <a:off x="3915888" y="6705484"/>
                <a:ext cx="1856730" cy="305032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GB" sz="1600" dirty="0" smtClean="0"/>
                  <a:t>Time (days)</a:t>
                </a:r>
                <a:endParaRPr lang="en-US" sz="1600" dirty="0"/>
              </a:p>
            </p:txBody>
          </p:sp>
        </p:grpSp>
        <p:sp>
          <p:nvSpPr>
            <p:cNvPr id="36" name="TextBox 35"/>
            <p:cNvSpPr txBox="1"/>
            <p:nvPr/>
          </p:nvSpPr>
          <p:spPr>
            <a:xfrm>
              <a:off x="3066773" y="4917193"/>
              <a:ext cx="221673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dirty="0"/>
                <a:t>E</a:t>
              </a:r>
            </a:p>
          </p:txBody>
        </p:sp>
      </p:grpSp>
    </p:spTree>
    <p:extLst>
      <p:ext uri="{BB962C8B-B14F-4D97-AF65-F5344CB8AC3E}">
        <p14:creationId xmlns:p14="http://schemas.microsoft.com/office/powerpoint/2010/main" val="2863782273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41</TotalTime>
  <Words>79</Words>
  <Application>Microsoft Office PowerPoint</Application>
  <PresentationFormat>On-screen Show (4:3)</PresentationFormat>
  <Paragraphs>2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Mancheste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s V. Westerhoff</dc:creator>
  <cp:lastModifiedBy>Raju Sharma</cp:lastModifiedBy>
  <cp:revision>18</cp:revision>
  <dcterms:created xsi:type="dcterms:W3CDTF">2020-01-27T22:16:24Z</dcterms:created>
  <dcterms:modified xsi:type="dcterms:W3CDTF">2020-01-28T12:59:47Z</dcterms:modified>
</cp:coreProperties>
</file>